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28" d="100"/>
          <a:sy n="128" d="100"/>
        </p:scale>
        <p:origin x="60" y="-26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90345-FE42-43FF-BFBA-F215F2950B21}" type="datetimeFigureOut">
              <a:rPr lang="zh-CN" altLang="en-US" smtClean="0"/>
              <a:t>2021/3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1DFAE-B6EA-481C-ACB3-4C77833D4C2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90345-FE42-43FF-BFBA-F215F2950B21}" type="datetimeFigureOut">
              <a:rPr lang="zh-CN" altLang="en-US" smtClean="0"/>
              <a:t>2021/3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1DFAE-B6EA-481C-ACB3-4C77833D4C2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90345-FE42-43FF-BFBA-F215F2950B21}" type="datetimeFigureOut">
              <a:rPr lang="zh-CN" altLang="en-US" smtClean="0"/>
              <a:t>2021/3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1DFAE-B6EA-481C-ACB3-4C77833D4C2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90345-FE42-43FF-BFBA-F215F2950B21}" type="datetimeFigureOut">
              <a:rPr lang="zh-CN" altLang="en-US" smtClean="0"/>
              <a:t>2021/3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1DFAE-B6EA-481C-ACB3-4C77833D4C2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90345-FE42-43FF-BFBA-F215F2950B21}" type="datetimeFigureOut">
              <a:rPr lang="zh-CN" altLang="en-US" smtClean="0"/>
              <a:t>2021/3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1DFAE-B6EA-481C-ACB3-4C77833D4C2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90345-FE42-43FF-BFBA-F215F2950B21}" type="datetimeFigureOut">
              <a:rPr lang="zh-CN" altLang="en-US" smtClean="0"/>
              <a:t>2021/3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1DFAE-B6EA-481C-ACB3-4C77833D4C2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90345-FE42-43FF-BFBA-F215F2950B21}" type="datetimeFigureOut">
              <a:rPr lang="zh-CN" altLang="en-US" smtClean="0"/>
              <a:t>2021/3/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1DFAE-B6EA-481C-ACB3-4C77833D4C2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90345-FE42-43FF-BFBA-F215F2950B21}" type="datetimeFigureOut">
              <a:rPr lang="zh-CN" altLang="en-US" smtClean="0"/>
              <a:t>2021/3/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1DFAE-B6EA-481C-ACB3-4C77833D4C2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90345-FE42-43FF-BFBA-F215F2950B21}" type="datetimeFigureOut">
              <a:rPr lang="zh-CN" altLang="en-US" smtClean="0"/>
              <a:t>2021/3/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1DFAE-B6EA-481C-ACB3-4C77833D4C2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90345-FE42-43FF-BFBA-F215F2950B21}" type="datetimeFigureOut">
              <a:rPr lang="zh-CN" altLang="en-US" smtClean="0"/>
              <a:t>2021/3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1DFAE-B6EA-481C-ACB3-4C77833D4C2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90345-FE42-43FF-BFBA-F215F2950B21}" type="datetimeFigureOut">
              <a:rPr lang="zh-CN" altLang="en-US" smtClean="0"/>
              <a:t>2021/3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1DFAE-B6EA-481C-ACB3-4C77833D4C2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290345-FE42-43FF-BFBA-F215F2950B21}" type="datetimeFigureOut">
              <a:rPr lang="zh-CN" altLang="en-US" smtClean="0"/>
              <a:t>2021/3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D1DFAE-B6EA-481C-ACB3-4C77833D4C2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F77C8C22-4E83-48B2-B53F-95C72F7D2A87}"/>
              </a:ext>
            </a:extLst>
          </p:cNvPr>
          <p:cNvGrpSpPr/>
          <p:nvPr/>
        </p:nvGrpSpPr>
        <p:grpSpPr>
          <a:xfrm>
            <a:off x="1662475" y="94445"/>
            <a:ext cx="5692481" cy="5718952"/>
            <a:chOff x="2632076" y="-7937"/>
            <a:chExt cx="6827839" cy="6859588"/>
          </a:xfrm>
        </p:grpSpPr>
        <p:grpSp>
          <p:nvGrpSpPr>
            <p:cNvPr id="8" name="Group 4"/>
            <p:cNvGrpSpPr>
              <a:grpSpLocks noChangeAspect="1"/>
            </p:cNvGrpSpPr>
            <p:nvPr/>
          </p:nvGrpSpPr>
          <p:grpSpPr bwMode="auto">
            <a:xfrm>
              <a:off x="2632076" y="-7937"/>
              <a:ext cx="6827839" cy="6859588"/>
              <a:chOff x="1658" y="-5"/>
              <a:chExt cx="4301" cy="4321"/>
            </a:xfrm>
          </p:grpSpPr>
          <p:grpSp>
            <p:nvGrpSpPr>
              <p:cNvPr id="10" name="Group 205"/>
              <p:cNvGrpSpPr/>
              <p:nvPr/>
            </p:nvGrpSpPr>
            <p:grpSpPr bwMode="auto">
              <a:xfrm>
                <a:off x="3330" y="-5"/>
                <a:ext cx="2629" cy="4321"/>
                <a:chOff x="3330" y="-5"/>
                <a:chExt cx="2629" cy="4321"/>
              </a:xfrm>
            </p:grpSpPr>
            <p:sp>
              <p:nvSpPr>
                <p:cNvPr id="221" name="Rectangle 5"/>
                <p:cNvSpPr>
                  <a:spLocks noChangeArrowheads="1"/>
                </p:cNvSpPr>
                <p:nvPr/>
              </p:nvSpPr>
              <p:spPr bwMode="auto">
                <a:xfrm rot="16200000">
                  <a:off x="3699" y="124"/>
                  <a:ext cx="218" cy="87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Q-A1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2" name="Line 6"/>
                <p:cNvSpPr>
                  <a:spLocks noChangeShapeType="1"/>
                </p:cNvSpPr>
                <p:nvPr/>
              </p:nvSpPr>
              <p:spPr bwMode="auto">
                <a:xfrm flipV="1">
                  <a:off x="3800" y="402"/>
                  <a:ext cx="0" cy="63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3" name="Rectangle 7"/>
                <p:cNvSpPr>
                  <a:spLocks noChangeArrowheads="1"/>
                </p:cNvSpPr>
                <p:nvPr/>
              </p:nvSpPr>
              <p:spPr bwMode="auto">
                <a:xfrm rot="16440000">
                  <a:off x="3821" y="101"/>
                  <a:ext cx="299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LAIM-A1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4" name="Line 8"/>
                <p:cNvSpPr>
                  <a:spLocks noChangeShapeType="1"/>
                </p:cNvSpPr>
                <p:nvPr/>
              </p:nvSpPr>
              <p:spPr bwMode="auto">
                <a:xfrm flipV="1">
                  <a:off x="3942" y="408"/>
                  <a:ext cx="6" cy="63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5" name="Freeform 9"/>
                <p:cNvSpPr/>
                <p:nvPr/>
              </p:nvSpPr>
              <p:spPr bwMode="auto">
                <a:xfrm>
                  <a:off x="3800" y="468"/>
                  <a:ext cx="72" cy="1"/>
                </a:xfrm>
                <a:custGeom>
                  <a:avLst/>
                  <a:gdLst>
                    <a:gd name="T0" fmla="*/ 72 w 72"/>
                    <a:gd name="T1" fmla="*/ 1 h 1"/>
                    <a:gd name="T2" fmla="*/ 64 w 72"/>
                    <a:gd name="T3" fmla="*/ 1 h 1"/>
                    <a:gd name="T4" fmla="*/ 59 w 72"/>
                    <a:gd name="T5" fmla="*/ 1 h 1"/>
                    <a:gd name="T6" fmla="*/ 53 w 72"/>
                    <a:gd name="T7" fmla="*/ 1 h 1"/>
                    <a:gd name="T8" fmla="*/ 47 w 72"/>
                    <a:gd name="T9" fmla="*/ 0 h 1"/>
                    <a:gd name="T10" fmla="*/ 42 w 72"/>
                    <a:gd name="T11" fmla="*/ 0 h 1"/>
                    <a:gd name="T12" fmla="*/ 36 w 72"/>
                    <a:gd name="T13" fmla="*/ 0 h 1"/>
                    <a:gd name="T14" fmla="*/ 30 w 72"/>
                    <a:gd name="T15" fmla="*/ 0 h 1"/>
                    <a:gd name="T16" fmla="*/ 24 w 72"/>
                    <a:gd name="T17" fmla="*/ 0 h 1"/>
                    <a:gd name="T18" fmla="*/ 17 w 72"/>
                    <a:gd name="T19" fmla="*/ 0 h 1"/>
                    <a:gd name="T20" fmla="*/ 11 w 72"/>
                    <a:gd name="T21" fmla="*/ 0 h 1"/>
                    <a:gd name="T22" fmla="*/ 6 w 72"/>
                    <a:gd name="T23" fmla="*/ 0 h 1"/>
                    <a:gd name="T24" fmla="*/ 0 w 72"/>
                    <a:gd name="T25" fmla="*/ 0 h 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</a:cxnLst>
                  <a:rect l="0" t="0" r="r" b="b"/>
                  <a:pathLst>
                    <a:path w="72" h="1">
                      <a:moveTo>
                        <a:pt x="72" y="1"/>
                      </a:moveTo>
                      <a:lnTo>
                        <a:pt x="64" y="1"/>
                      </a:lnTo>
                      <a:lnTo>
                        <a:pt x="59" y="1"/>
                      </a:lnTo>
                      <a:lnTo>
                        <a:pt x="53" y="1"/>
                      </a:lnTo>
                      <a:lnTo>
                        <a:pt x="47" y="0"/>
                      </a:lnTo>
                      <a:lnTo>
                        <a:pt x="42" y="0"/>
                      </a:lnTo>
                      <a:lnTo>
                        <a:pt x="36" y="0"/>
                      </a:lnTo>
                      <a:lnTo>
                        <a:pt x="30" y="0"/>
                      </a:lnTo>
                      <a:lnTo>
                        <a:pt x="24" y="0"/>
                      </a:lnTo>
                      <a:lnTo>
                        <a:pt x="17" y="0"/>
                      </a:lnTo>
                      <a:lnTo>
                        <a:pt x="11" y="0"/>
                      </a:lnTo>
                      <a:lnTo>
                        <a:pt x="6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6" name="Freeform 10"/>
                <p:cNvSpPr/>
                <p:nvPr/>
              </p:nvSpPr>
              <p:spPr bwMode="auto">
                <a:xfrm>
                  <a:off x="3872" y="469"/>
                  <a:ext cx="70" cy="5"/>
                </a:xfrm>
                <a:custGeom>
                  <a:avLst/>
                  <a:gdLst>
                    <a:gd name="T0" fmla="*/ 0 w 70"/>
                    <a:gd name="T1" fmla="*/ 0 h 5"/>
                    <a:gd name="T2" fmla="*/ 4 w 70"/>
                    <a:gd name="T3" fmla="*/ 0 h 5"/>
                    <a:gd name="T4" fmla="*/ 10 w 70"/>
                    <a:gd name="T5" fmla="*/ 0 h 5"/>
                    <a:gd name="T6" fmla="*/ 15 w 70"/>
                    <a:gd name="T7" fmla="*/ 2 h 5"/>
                    <a:gd name="T8" fmla="*/ 21 w 70"/>
                    <a:gd name="T9" fmla="*/ 2 h 5"/>
                    <a:gd name="T10" fmla="*/ 27 w 70"/>
                    <a:gd name="T11" fmla="*/ 2 h 5"/>
                    <a:gd name="T12" fmla="*/ 31 w 70"/>
                    <a:gd name="T13" fmla="*/ 2 h 5"/>
                    <a:gd name="T14" fmla="*/ 37 w 70"/>
                    <a:gd name="T15" fmla="*/ 3 h 5"/>
                    <a:gd name="T16" fmla="*/ 43 w 70"/>
                    <a:gd name="T17" fmla="*/ 3 h 5"/>
                    <a:gd name="T18" fmla="*/ 48 w 70"/>
                    <a:gd name="T19" fmla="*/ 3 h 5"/>
                    <a:gd name="T20" fmla="*/ 54 w 70"/>
                    <a:gd name="T21" fmla="*/ 3 h 5"/>
                    <a:gd name="T22" fmla="*/ 58 w 70"/>
                    <a:gd name="T23" fmla="*/ 5 h 5"/>
                    <a:gd name="T24" fmla="*/ 64 w 70"/>
                    <a:gd name="T25" fmla="*/ 5 h 5"/>
                    <a:gd name="T26" fmla="*/ 70 w 70"/>
                    <a:gd name="T2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</a:cxnLst>
                  <a:rect l="0" t="0" r="r" b="b"/>
                  <a:pathLst>
                    <a:path w="70" h="5">
                      <a:moveTo>
                        <a:pt x="0" y="0"/>
                      </a:moveTo>
                      <a:lnTo>
                        <a:pt x="4" y="0"/>
                      </a:lnTo>
                      <a:lnTo>
                        <a:pt x="10" y="0"/>
                      </a:lnTo>
                      <a:lnTo>
                        <a:pt x="15" y="2"/>
                      </a:lnTo>
                      <a:lnTo>
                        <a:pt x="21" y="2"/>
                      </a:lnTo>
                      <a:lnTo>
                        <a:pt x="27" y="2"/>
                      </a:lnTo>
                      <a:lnTo>
                        <a:pt x="31" y="2"/>
                      </a:lnTo>
                      <a:lnTo>
                        <a:pt x="37" y="3"/>
                      </a:lnTo>
                      <a:lnTo>
                        <a:pt x="43" y="3"/>
                      </a:lnTo>
                      <a:lnTo>
                        <a:pt x="48" y="3"/>
                      </a:lnTo>
                      <a:lnTo>
                        <a:pt x="54" y="3"/>
                      </a:lnTo>
                      <a:lnTo>
                        <a:pt x="58" y="5"/>
                      </a:lnTo>
                      <a:lnTo>
                        <a:pt x="64" y="5"/>
                      </a:lnTo>
                      <a:lnTo>
                        <a:pt x="70" y="5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8" name="Line 12"/>
                <p:cNvSpPr>
                  <a:spLocks noChangeShapeType="1"/>
                </p:cNvSpPr>
                <p:nvPr/>
              </p:nvSpPr>
              <p:spPr bwMode="auto">
                <a:xfrm flipV="1">
                  <a:off x="3869" y="472"/>
                  <a:ext cx="3" cy="63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9" name="Rectangle 13"/>
                <p:cNvSpPr>
                  <a:spLocks noChangeArrowheads="1"/>
                </p:cNvSpPr>
                <p:nvPr/>
              </p:nvSpPr>
              <p:spPr bwMode="auto">
                <a:xfrm rot="16740000">
                  <a:off x="4024" y="157"/>
                  <a:ext cx="194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J-A4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0" name="Line 14"/>
                <p:cNvSpPr>
                  <a:spLocks noChangeShapeType="1"/>
                </p:cNvSpPr>
                <p:nvPr/>
              </p:nvSpPr>
              <p:spPr bwMode="auto">
                <a:xfrm flipV="1">
                  <a:off x="4071" y="428"/>
                  <a:ext cx="23" cy="130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1" name="Freeform 15"/>
                <p:cNvSpPr/>
                <p:nvPr/>
              </p:nvSpPr>
              <p:spPr bwMode="auto">
                <a:xfrm>
                  <a:off x="3867" y="538"/>
                  <a:ext cx="102" cy="7"/>
                </a:xfrm>
                <a:custGeom>
                  <a:avLst/>
                  <a:gdLst>
                    <a:gd name="T0" fmla="*/ 102 w 102"/>
                    <a:gd name="T1" fmla="*/ 7 h 7"/>
                    <a:gd name="T2" fmla="*/ 96 w 102"/>
                    <a:gd name="T3" fmla="*/ 7 h 7"/>
                    <a:gd name="T4" fmla="*/ 91 w 102"/>
                    <a:gd name="T5" fmla="*/ 7 h 7"/>
                    <a:gd name="T6" fmla="*/ 85 w 102"/>
                    <a:gd name="T7" fmla="*/ 6 h 7"/>
                    <a:gd name="T8" fmla="*/ 79 w 102"/>
                    <a:gd name="T9" fmla="*/ 6 h 7"/>
                    <a:gd name="T10" fmla="*/ 73 w 102"/>
                    <a:gd name="T11" fmla="*/ 4 h 7"/>
                    <a:gd name="T12" fmla="*/ 66 w 102"/>
                    <a:gd name="T13" fmla="*/ 4 h 7"/>
                    <a:gd name="T14" fmla="*/ 61 w 102"/>
                    <a:gd name="T15" fmla="*/ 4 h 7"/>
                    <a:gd name="T16" fmla="*/ 55 w 102"/>
                    <a:gd name="T17" fmla="*/ 3 h 7"/>
                    <a:gd name="T18" fmla="*/ 49 w 102"/>
                    <a:gd name="T19" fmla="*/ 3 h 7"/>
                    <a:gd name="T20" fmla="*/ 43 w 102"/>
                    <a:gd name="T21" fmla="*/ 3 h 7"/>
                    <a:gd name="T22" fmla="*/ 38 w 102"/>
                    <a:gd name="T23" fmla="*/ 2 h 7"/>
                    <a:gd name="T24" fmla="*/ 30 w 102"/>
                    <a:gd name="T25" fmla="*/ 2 h 7"/>
                    <a:gd name="T26" fmla="*/ 25 w 102"/>
                    <a:gd name="T27" fmla="*/ 2 h 7"/>
                    <a:gd name="T28" fmla="*/ 19 w 102"/>
                    <a:gd name="T29" fmla="*/ 2 h 7"/>
                    <a:gd name="T30" fmla="*/ 13 w 102"/>
                    <a:gd name="T31" fmla="*/ 0 h 7"/>
                    <a:gd name="T32" fmla="*/ 7 w 102"/>
                    <a:gd name="T33" fmla="*/ 0 h 7"/>
                    <a:gd name="T34" fmla="*/ 0 w 102"/>
                    <a:gd name="T35" fmla="*/ 0 h 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102" h="7">
                      <a:moveTo>
                        <a:pt x="102" y="7"/>
                      </a:moveTo>
                      <a:lnTo>
                        <a:pt x="96" y="7"/>
                      </a:lnTo>
                      <a:lnTo>
                        <a:pt x="91" y="7"/>
                      </a:lnTo>
                      <a:lnTo>
                        <a:pt x="85" y="6"/>
                      </a:lnTo>
                      <a:lnTo>
                        <a:pt x="79" y="6"/>
                      </a:lnTo>
                      <a:lnTo>
                        <a:pt x="73" y="4"/>
                      </a:lnTo>
                      <a:lnTo>
                        <a:pt x="66" y="4"/>
                      </a:lnTo>
                      <a:lnTo>
                        <a:pt x="61" y="4"/>
                      </a:lnTo>
                      <a:lnTo>
                        <a:pt x="55" y="3"/>
                      </a:lnTo>
                      <a:lnTo>
                        <a:pt x="49" y="3"/>
                      </a:lnTo>
                      <a:lnTo>
                        <a:pt x="43" y="3"/>
                      </a:lnTo>
                      <a:lnTo>
                        <a:pt x="38" y="2"/>
                      </a:lnTo>
                      <a:lnTo>
                        <a:pt x="30" y="2"/>
                      </a:lnTo>
                      <a:lnTo>
                        <a:pt x="25" y="2"/>
                      </a:lnTo>
                      <a:lnTo>
                        <a:pt x="19" y="2"/>
                      </a:lnTo>
                      <a:lnTo>
                        <a:pt x="13" y="0"/>
                      </a:lnTo>
                      <a:lnTo>
                        <a:pt x="7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2" name="Freeform 16"/>
                <p:cNvSpPr/>
                <p:nvPr/>
              </p:nvSpPr>
              <p:spPr bwMode="auto">
                <a:xfrm>
                  <a:off x="3969" y="545"/>
                  <a:ext cx="102" cy="15"/>
                </a:xfrm>
                <a:custGeom>
                  <a:avLst/>
                  <a:gdLst>
                    <a:gd name="T0" fmla="*/ 0 w 102"/>
                    <a:gd name="T1" fmla="*/ 0 h 15"/>
                    <a:gd name="T2" fmla="*/ 6 w 102"/>
                    <a:gd name="T3" fmla="*/ 2 h 15"/>
                    <a:gd name="T4" fmla="*/ 10 w 102"/>
                    <a:gd name="T5" fmla="*/ 2 h 15"/>
                    <a:gd name="T6" fmla="*/ 16 w 102"/>
                    <a:gd name="T7" fmla="*/ 3 h 15"/>
                    <a:gd name="T8" fmla="*/ 20 w 102"/>
                    <a:gd name="T9" fmla="*/ 3 h 15"/>
                    <a:gd name="T10" fmla="*/ 25 w 102"/>
                    <a:gd name="T11" fmla="*/ 3 h 15"/>
                    <a:gd name="T12" fmla="*/ 30 w 102"/>
                    <a:gd name="T13" fmla="*/ 5 h 15"/>
                    <a:gd name="T14" fmla="*/ 35 w 102"/>
                    <a:gd name="T15" fmla="*/ 5 h 15"/>
                    <a:gd name="T16" fmla="*/ 39 w 102"/>
                    <a:gd name="T17" fmla="*/ 6 h 15"/>
                    <a:gd name="T18" fmla="*/ 45 w 102"/>
                    <a:gd name="T19" fmla="*/ 6 h 15"/>
                    <a:gd name="T20" fmla="*/ 49 w 102"/>
                    <a:gd name="T21" fmla="*/ 7 h 15"/>
                    <a:gd name="T22" fmla="*/ 53 w 102"/>
                    <a:gd name="T23" fmla="*/ 7 h 15"/>
                    <a:gd name="T24" fmla="*/ 59 w 102"/>
                    <a:gd name="T25" fmla="*/ 7 h 15"/>
                    <a:gd name="T26" fmla="*/ 63 w 102"/>
                    <a:gd name="T27" fmla="*/ 9 h 15"/>
                    <a:gd name="T28" fmla="*/ 69 w 102"/>
                    <a:gd name="T29" fmla="*/ 9 h 15"/>
                    <a:gd name="T30" fmla="*/ 73 w 102"/>
                    <a:gd name="T31" fmla="*/ 10 h 15"/>
                    <a:gd name="T32" fmla="*/ 78 w 102"/>
                    <a:gd name="T33" fmla="*/ 12 h 15"/>
                    <a:gd name="T34" fmla="*/ 83 w 102"/>
                    <a:gd name="T35" fmla="*/ 12 h 15"/>
                    <a:gd name="T36" fmla="*/ 88 w 102"/>
                    <a:gd name="T37" fmla="*/ 13 h 15"/>
                    <a:gd name="T38" fmla="*/ 92 w 102"/>
                    <a:gd name="T39" fmla="*/ 13 h 15"/>
                    <a:gd name="T40" fmla="*/ 98 w 102"/>
                    <a:gd name="T41" fmla="*/ 15 h 15"/>
                    <a:gd name="T42" fmla="*/ 102 w 102"/>
                    <a:gd name="T43" fmla="*/ 15 h 1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</a:cxnLst>
                  <a:rect l="0" t="0" r="r" b="b"/>
                  <a:pathLst>
                    <a:path w="102" h="15">
                      <a:moveTo>
                        <a:pt x="0" y="0"/>
                      </a:moveTo>
                      <a:lnTo>
                        <a:pt x="6" y="2"/>
                      </a:lnTo>
                      <a:lnTo>
                        <a:pt x="10" y="2"/>
                      </a:lnTo>
                      <a:lnTo>
                        <a:pt x="16" y="3"/>
                      </a:lnTo>
                      <a:lnTo>
                        <a:pt x="20" y="3"/>
                      </a:lnTo>
                      <a:lnTo>
                        <a:pt x="25" y="3"/>
                      </a:lnTo>
                      <a:lnTo>
                        <a:pt x="30" y="5"/>
                      </a:lnTo>
                      <a:lnTo>
                        <a:pt x="35" y="5"/>
                      </a:lnTo>
                      <a:lnTo>
                        <a:pt x="39" y="6"/>
                      </a:lnTo>
                      <a:lnTo>
                        <a:pt x="45" y="6"/>
                      </a:lnTo>
                      <a:lnTo>
                        <a:pt x="49" y="7"/>
                      </a:lnTo>
                      <a:lnTo>
                        <a:pt x="53" y="7"/>
                      </a:lnTo>
                      <a:lnTo>
                        <a:pt x="59" y="7"/>
                      </a:lnTo>
                      <a:lnTo>
                        <a:pt x="63" y="9"/>
                      </a:lnTo>
                      <a:lnTo>
                        <a:pt x="69" y="9"/>
                      </a:lnTo>
                      <a:lnTo>
                        <a:pt x="73" y="10"/>
                      </a:lnTo>
                      <a:lnTo>
                        <a:pt x="78" y="12"/>
                      </a:lnTo>
                      <a:lnTo>
                        <a:pt x="83" y="12"/>
                      </a:lnTo>
                      <a:lnTo>
                        <a:pt x="88" y="13"/>
                      </a:lnTo>
                      <a:lnTo>
                        <a:pt x="92" y="13"/>
                      </a:lnTo>
                      <a:lnTo>
                        <a:pt x="98" y="15"/>
                      </a:lnTo>
                      <a:lnTo>
                        <a:pt x="102" y="15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4" name="Line 18"/>
                <p:cNvSpPr>
                  <a:spLocks noChangeShapeType="1"/>
                </p:cNvSpPr>
                <p:nvPr/>
              </p:nvSpPr>
              <p:spPr bwMode="auto">
                <a:xfrm flipV="1">
                  <a:off x="3962" y="548"/>
                  <a:ext cx="7" cy="63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5" name="Rectangle 19"/>
                <p:cNvSpPr>
                  <a:spLocks noChangeArrowheads="1"/>
                </p:cNvSpPr>
                <p:nvPr/>
              </p:nvSpPr>
              <p:spPr bwMode="auto">
                <a:xfrm rot="17040000">
                  <a:off x="4154" y="155"/>
                  <a:ext cx="287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QJPG-A1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6" name="Line 20"/>
                <p:cNvSpPr>
                  <a:spLocks noChangeShapeType="1"/>
                </p:cNvSpPr>
                <p:nvPr/>
              </p:nvSpPr>
              <p:spPr bwMode="auto">
                <a:xfrm flipV="1">
                  <a:off x="4187" y="459"/>
                  <a:ext cx="50" cy="194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7" name="Freeform 21"/>
                <p:cNvSpPr/>
                <p:nvPr/>
              </p:nvSpPr>
              <p:spPr bwMode="auto">
                <a:xfrm>
                  <a:off x="3962" y="614"/>
                  <a:ext cx="113" cy="17"/>
                </a:xfrm>
                <a:custGeom>
                  <a:avLst/>
                  <a:gdLst>
                    <a:gd name="T0" fmla="*/ 113 w 113"/>
                    <a:gd name="T1" fmla="*/ 17 h 17"/>
                    <a:gd name="T2" fmla="*/ 108 w 113"/>
                    <a:gd name="T3" fmla="*/ 16 h 17"/>
                    <a:gd name="T4" fmla="*/ 100 w 113"/>
                    <a:gd name="T5" fmla="*/ 14 h 17"/>
                    <a:gd name="T6" fmla="*/ 95 w 113"/>
                    <a:gd name="T7" fmla="*/ 13 h 17"/>
                    <a:gd name="T8" fmla="*/ 89 w 113"/>
                    <a:gd name="T9" fmla="*/ 13 h 17"/>
                    <a:gd name="T10" fmla="*/ 82 w 113"/>
                    <a:gd name="T11" fmla="*/ 12 h 17"/>
                    <a:gd name="T12" fmla="*/ 76 w 113"/>
                    <a:gd name="T13" fmla="*/ 10 h 17"/>
                    <a:gd name="T14" fmla="*/ 69 w 113"/>
                    <a:gd name="T15" fmla="*/ 9 h 17"/>
                    <a:gd name="T16" fmla="*/ 63 w 113"/>
                    <a:gd name="T17" fmla="*/ 9 h 17"/>
                    <a:gd name="T18" fmla="*/ 57 w 113"/>
                    <a:gd name="T19" fmla="*/ 7 h 17"/>
                    <a:gd name="T20" fmla="*/ 50 w 113"/>
                    <a:gd name="T21" fmla="*/ 6 h 17"/>
                    <a:gd name="T22" fmla="*/ 44 w 113"/>
                    <a:gd name="T23" fmla="*/ 6 h 17"/>
                    <a:gd name="T24" fmla="*/ 39 w 113"/>
                    <a:gd name="T25" fmla="*/ 4 h 17"/>
                    <a:gd name="T26" fmla="*/ 32 w 113"/>
                    <a:gd name="T27" fmla="*/ 4 h 17"/>
                    <a:gd name="T28" fmla="*/ 26 w 113"/>
                    <a:gd name="T29" fmla="*/ 3 h 17"/>
                    <a:gd name="T30" fmla="*/ 19 w 113"/>
                    <a:gd name="T31" fmla="*/ 3 h 17"/>
                    <a:gd name="T32" fmla="*/ 13 w 113"/>
                    <a:gd name="T33" fmla="*/ 2 h 17"/>
                    <a:gd name="T34" fmla="*/ 7 w 113"/>
                    <a:gd name="T35" fmla="*/ 2 h 17"/>
                    <a:gd name="T36" fmla="*/ 0 w 113"/>
                    <a:gd name="T37" fmla="*/ 0 h 1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</a:cxnLst>
                  <a:rect l="0" t="0" r="r" b="b"/>
                  <a:pathLst>
                    <a:path w="113" h="17">
                      <a:moveTo>
                        <a:pt x="113" y="17"/>
                      </a:moveTo>
                      <a:lnTo>
                        <a:pt x="108" y="16"/>
                      </a:lnTo>
                      <a:lnTo>
                        <a:pt x="100" y="14"/>
                      </a:lnTo>
                      <a:lnTo>
                        <a:pt x="95" y="13"/>
                      </a:lnTo>
                      <a:lnTo>
                        <a:pt x="89" y="13"/>
                      </a:lnTo>
                      <a:lnTo>
                        <a:pt x="82" y="12"/>
                      </a:lnTo>
                      <a:lnTo>
                        <a:pt x="76" y="10"/>
                      </a:lnTo>
                      <a:lnTo>
                        <a:pt x="69" y="9"/>
                      </a:lnTo>
                      <a:lnTo>
                        <a:pt x="63" y="9"/>
                      </a:lnTo>
                      <a:lnTo>
                        <a:pt x="57" y="7"/>
                      </a:lnTo>
                      <a:lnTo>
                        <a:pt x="50" y="6"/>
                      </a:lnTo>
                      <a:lnTo>
                        <a:pt x="44" y="6"/>
                      </a:lnTo>
                      <a:lnTo>
                        <a:pt x="39" y="4"/>
                      </a:lnTo>
                      <a:lnTo>
                        <a:pt x="32" y="4"/>
                      </a:lnTo>
                      <a:lnTo>
                        <a:pt x="26" y="3"/>
                      </a:lnTo>
                      <a:lnTo>
                        <a:pt x="19" y="3"/>
                      </a:lnTo>
                      <a:lnTo>
                        <a:pt x="13" y="2"/>
                      </a:lnTo>
                      <a:lnTo>
                        <a:pt x="7" y="2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8" name="Freeform 22"/>
                <p:cNvSpPr/>
                <p:nvPr/>
              </p:nvSpPr>
              <p:spPr bwMode="auto">
                <a:xfrm>
                  <a:off x="4075" y="631"/>
                  <a:ext cx="111" cy="25"/>
                </a:xfrm>
                <a:custGeom>
                  <a:avLst/>
                  <a:gdLst>
                    <a:gd name="T0" fmla="*/ 0 w 111"/>
                    <a:gd name="T1" fmla="*/ 0 h 25"/>
                    <a:gd name="T2" fmla="*/ 5 w 111"/>
                    <a:gd name="T3" fmla="*/ 0 h 25"/>
                    <a:gd name="T4" fmla="*/ 7 w 111"/>
                    <a:gd name="T5" fmla="*/ 2 h 25"/>
                    <a:gd name="T6" fmla="*/ 12 w 111"/>
                    <a:gd name="T7" fmla="*/ 2 h 25"/>
                    <a:gd name="T8" fmla="*/ 15 w 111"/>
                    <a:gd name="T9" fmla="*/ 3 h 25"/>
                    <a:gd name="T10" fmla="*/ 19 w 111"/>
                    <a:gd name="T11" fmla="*/ 3 h 25"/>
                    <a:gd name="T12" fmla="*/ 23 w 111"/>
                    <a:gd name="T13" fmla="*/ 5 h 25"/>
                    <a:gd name="T14" fmla="*/ 26 w 111"/>
                    <a:gd name="T15" fmla="*/ 5 h 25"/>
                    <a:gd name="T16" fmla="*/ 30 w 111"/>
                    <a:gd name="T17" fmla="*/ 6 h 25"/>
                    <a:gd name="T18" fmla="*/ 33 w 111"/>
                    <a:gd name="T19" fmla="*/ 6 h 25"/>
                    <a:gd name="T20" fmla="*/ 38 w 111"/>
                    <a:gd name="T21" fmla="*/ 8 h 25"/>
                    <a:gd name="T22" fmla="*/ 40 w 111"/>
                    <a:gd name="T23" fmla="*/ 8 h 25"/>
                    <a:gd name="T24" fmla="*/ 45 w 111"/>
                    <a:gd name="T25" fmla="*/ 9 h 25"/>
                    <a:gd name="T26" fmla="*/ 49 w 111"/>
                    <a:gd name="T27" fmla="*/ 9 h 25"/>
                    <a:gd name="T28" fmla="*/ 52 w 111"/>
                    <a:gd name="T29" fmla="*/ 10 h 25"/>
                    <a:gd name="T30" fmla="*/ 56 w 111"/>
                    <a:gd name="T31" fmla="*/ 12 h 25"/>
                    <a:gd name="T32" fmla="*/ 59 w 111"/>
                    <a:gd name="T33" fmla="*/ 12 h 25"/>
                    <a:gd name="T34" fmla="*/ 63 w 111"/>
                    <a:gd name="T35" fmla="*/ 13 h 25"/>
                    <a:gd name="T36" fmla="*/ 68 w 111"/>
                    <a:gd name="T37" fmla="*/ 13 h 25"/>
                    <a:gd name="T38" fmla="*/ 71 w 111"/>
                    <a:gd name="T39" fmla="*/ 15 h 25"/>
                    <a:gd name="T40" fmla="*/ 75 w 111"/>
                    <a:gd name="T41" fmla="*/ 16 h 25"/>
                    <a:gd name="T42" fmla="*/ 78 w 111"/>
                    <a:gd name="T43" fmla="*/ 16 h 25"/>
                    <a:gd name="T44" fmla="*/ 82 w 111"/>
                    <a:gd name="T45" fmla="*/ 18 h 25"/>
                    <a:gd name="T46" fmla="*/ 85 w 111"/>
                    <a:gd name="T47" fmla="*/ 18 h 25"/>
                    <a:gd name="T48" fmla="*/ 89 w 111"/>
                    <a:gd name="T49" fmla="*/ 19 h 25"/>
                    <a:gd name="T50" fmla="*/ 93 w 111"/>
                    <a:gd name="T51" fmla="*/ 20 h 25"/>
                    <a:gd name="T52" fmla="*/ 96 w 111"/>
                    <a:gd name="T53" fmla="*/ 20 h 25"/>
                    <a:gd name="T54" fmla="*/ 101 w 111"/>
                    <a:gd name="T55" fmla="*/ 22 h 25"/>
                    <a:gd name="T56" fmla="*/ 103 w 111"/>
                    <a:gd name="T57" fmla="*/ 23 h 25"/>
                    <a:gd name="T58" fmla="*/ 108 w 111"/>
                    <a:gd name="T59" fmla="*/ 23 h 25"/>
                    <a:gd name="T60" fmla="*/ 111 w 111"/>
                    <a:gd name="T61" fmla="*/ 25 h 2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</a:cxnLst>
                  <a:rect l="0" t="0" r="r" b="b"/>
                  <a:pathLst>
                    <a:path w="111" h="25">
                      <a:moveTo>
                        <a:pt x="0" y="0"/>
                      </a:moveTo>
                      <a:lnTo>
                        <a:pt x="5" y="0"/>
                      </a:lnTo>
                      <a:lnTo>
                        <a:pt x="7" y="2"/>
                      </a:lnTo>
                      <a:lnTo>
                        <a:pt x="12" y="2"/>
                      </a:lnTo>
                      <a:lnTo>
                        <a:pt x="15" y="3"/>
                      </a:lnTo>
                      <a:lnTo>
                        <a:pt x="19" y="3"/>
                      </a:lnTo>
                      <a:lnTo>
                        <a:pt x="23" y="5"/>
                      </a:lnTo>
                      <a:lnTo>
                        <a:pt x="26" y="5"/>
                      </a:lnTo>
                      <a:lnTo>
                        <a:pt x="30" y="6"/>
                      </a:lnTo>
                      <a:lnTo>
                        <a:pt x="33" y="6"/>
                      </a:lnTo>
                      <a:lnTo>
                        <a:pt x="38" y="8"/>
                      </a:lnTo>
                      <a:lnTo>
                        <a:pt x="40" y="8"/>
                      </a:lnTo>
                      <a:lnTo>
                        <a:pt x="45" y="9"/>
                      </a:lnTo>
                      <a:lnTo>
                        <a:pt x="49" y="9"/>
                      </a:lnTo>
                      <a:lnTo>
                        <a:pt x="52" y="10"/>
                      </a:lnTo>
                      <a:lnTo>
                        <a:pt x="56" y="12"/>
                      </a:lnTo>
                      <a:lnTo>
                        <a:pt x="59" y="12"/>
                      </a:lnTo>
                      <a:lnTo>
                        <a:pt x="63" y="13"/>
                      </a:lnTo>
                      <a:lnTo>
                        <a:pt x="68" y="13"/>
                      </a:lnTo>
                      <a:lnTo>
                        <a:pt x="71" y="15"/>
                      </a:lnTo>
                      <a:lnTo>
                        <a:pt x="75" y="16"/>
                      </a:lnTo>
                      <a:lnTo>
                        <a:pt x="78" y="16"/>
                      </a:lnTo>
                      <a:lnTo>
                        <a:pt x="82" y="18"/>
                      </a:lnTo>
                      <a:lnTo>
                        <a:pt x="85" y="18"/>
                      </a:lnTo>
                      <a:lnTo>
                        <a:pt x="89" y="19"/>
                      </a:lnTo>
                      <a:lnTo>
                        <a:pt x="93" y="20"/>
                      </a:lnTo>
                      <a:lnTo>
                        <a:pt x="96" y="20"/>
                      </a:lnTo>
                      <a:lnTo>
                        <a:pt x="101" y="22"/>
                      </a:lnTo>
                      <a:lnTo>
                        <a:pt x="103" y="23"/>
                      </a:lnTo>
                      <a:lnTo>
                        <a:pt x="108" y="23"/>
                      </a:lnTo>
                      <a:lnTo>
                        <a:pt x="111" y="25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0" name="Line 24"/>
                <p:cNvSpPr>
                  <a:spLocks noChangeShapeType="1"/>
                </p:cNvSpPr>
                <p:nvPr/>
              </p:nvSpPr>
              <p:spPr bwMode="auto">
                <a:xfrm flipV="1">
                  <a:off x="4064" y="634"/>
                  <a:ext cx="11" cy="62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1" name="Rectangle 25"/>
                <p:cNvSpPr>
                  <a:spLocks noChangeArrowheads="1"/>
                </p:cNvSpPr>
                <p:nvPr/>
              </p:nvSpPr>
              <p:spPr bwMode="auto">
                <a:xfrm rot="17340000">
                  <a:off x="4352" y="237"/>
                  <a:ext cx="206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F-A1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2" name="Line 26"/>
                <p:cNvSpPr>
                  <a:spLocks noChangeShapeType="1"/>
                </p:cNvSpPr>
                <p:nvPr/>
              </p:nvSpPr>
              <p:spPr bwMode="auto">
                <a:xfrm flipV="1">
                  <a:off x="4289" y="502"/>
                  <a:ext cx="90" cy="254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3" name="Freeform 27"/>
                <p:cNvSpPr/>
                <p:nvPr/>
              </p:nvSpPr>
              <p:spPr bwMode="auto">
                <a:xfrm>
                  <a:off x="4062" y="699"/>
                  <a:ext cx="114" cy="26"/>
                </a:xfrm>
                <a:custGeom>
                  <a:avLst/>
                  <a:gdLst>
                    <a:gd name="T0" fmla="*/ 114 w 114"/>
                    <a:gd name="T1" fmla="*/ 26 h 26"/>
                    <a:gd name="T2" fmla="*/ 108 w 114"/>
                    <a:gd name="T3" fmla="*/ 24 h 26"/>
                    <a:gd name="T4" fmla="*/ 101 w 114"/>
                    <a:gd name="T5" fmla="*/ 21 h 26"/>
                    <a:gd name="T6" fmla="*/ 95 w 114"/>
                    <a:gd name="T7" fmla="*/ 20 h 26"/>
                    <a:gd name="T8" fmla="*/ 88 w 114"/>
                    <a:gd name="T9" fmla="*/ 18 h 26"/>
                    <a:gd name="T10" fmla="*/ 81 w 114"/>
                    <a:gd name="T11" fmla="*/ 17 h 26"/>
                    <a:gd name="T12" fmla="*/ 75 w 114"/>
                    <a:gd name="T13" fmla="*/ 16 h 26"/>
                    <a:gd name="T14" fmla="*/ 68 w 114"/>
                    <a:gd name="T15" fmla="*/ 14 h 26"/>
                    <a:gd name="T16" fmla="*/ 61 w 114"/>
                    <a:gd name="T17" fmla="*/ 13 h 26"/>
                    <a:gd name="T18" fmla="*/ 55 w 114"/>
                    <a:gd name="T19" fmla="*/ 10 h 26"/>
                    <a:gd name="T20" fmla="*/ 48 w 114"/>
                    <a:gd name="T21" fmla="*/ 8 h 26"/>
                    <a:gd name="T22" fmla="*/ 40 w 114"/>
                    <a:gd name="T23" fmla="*/ 7 h 26"/>
                    <a:gd name="T24" fmla="*/ 35 w 114"/>
                    <a:gd name="T25" fmla="*/ 6 h 26"/>
                    <a:gd name="T26" fmla="*/ 28 w 114"/>
                    <a:gd name="T27" fmla="*/ 4 h 26"/>
                    <a:gd name="T28" fmla="*/ 20 w 114"/>
                    <a:gd name="T29" fmla="*/ 3 h 26"/>
                    <a:gd name="T30" fmla="*/ 15 w 114"/>
                    <a:gd name="T31" fmla="*/ 3 h 26"/>
                    <a:gd name="T32" fmla="*/ 8 w 114"/>
                    <a:gd name="T33" fmla="*/ 1 h 26"/>
                    <a:gd name="T34" fmla="*/ 0 w 114"/>
                    <a:gd name="T35" fmla="*/ 0 h 2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114" h="26">
                      <a:moveTo>
                        <a:pt x="114" y="26"/>
                      </a:moveTo>
                      <a:lnTo>
                        <a:pt x="108" y="24"/>
                      </a:lnTo>
                      <a:lnTo>
                        <a:pt x="101" y="21"/>
                      </a:lnTo>
                      <a:lnTo>
                        <a:pt x="95" y="20"/>
                      </a:lnTo>
                      <a:lnTo>
                        <a:pt x="88" y="18"/>
                      </a:lnTo>
                      <a:lnTo>
                        <a:pt x="81" y="17"/>
                      </a:lnTo>
                      <a:lnTo>
                        <a:pt x="75" y="16"/>
                      </a:lnTo>
                      <a:lnTo>
                        <a:pt x="68" y="14"/>
                      </a:lnTo>
                      <a:lnTo>
                        <a:pt x="61" y="13"/>
                      </a:lnTo>
                      <a:lnTo>
                        <a:pt x="55" y="10"/>
                      </a:lnTo>
                      <a:lnTo>
                        <a:pt x="48" y="8"/>
                      </a:lnTo>
                      <a:lnTo>
                        <a:pt x="40" y="7"/>
                      </a:lnTo>
                      <a:lnTo>
                        <a:pt x="35" y="6"/>
                      </a:lnTo>
                      <a:lnTo>
                        <a:pt x="28" y="4"/>
                      </a:lnTo>
                      <a:lnTo>
                        <a:pt x="20" y="3"/>
                      </a:lnTo>
                      <a:lnTo>
                        <a:pt x="15" y="3"/>
                      </a:lnTo>
                      <a:lnTo>
                        <a:pt x="8" y="1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4" name="Freeform 28"/>
                <p:cNvSpPr/>
                <p:nvPr/>
              </p:nvSpPr>
              <p:spPr bwMode="auto">
                <a:xfrm>
                  <a:off x="4176" y="725"/>
                  <a:ext cx="111" cy="34"/>
                </a:xfrm>
                <a:custGeom>
                  <a:avLst/>
                  <a:gdLst>
                    <a:gd name="T0" fmla="*/ 0 w 111"/>
                    <a:gd name="T1" fmla="*/ 0 h 34"/>
                    <a:gd name="T2" fmla="*/ 2 w 111"/>
                    <a:gd name="T3" fmla="*/ 0 h 34"/>
                    <a:gd name="T4" fmla="*/ 5 w 111"/>
                    <a:gd name="T5" fmla="*/ 1 h 34"/>
                    <a:gd name="T6" fmla="*/ 8 w 111"/>
                    <a:gd name="T7" fmla="*/ 1 h 34"/>
                    <a:gd name="T8" fmla="*/ 11 w 111"/>
                    <a:gd name="T9" fmla="*/ 3 h 34"/>
                    <a:gd name="T10" fmla="*/ 14 w 111"/>
                    <a:gd name="T11" fmla="*/ 4 h 34"/>
                    <a:gd name="T12" fmla="*/ 17 w 111"/>
                    <a:gd name="T13" fmla="*/ 4 h 34"/>
                    <a:gd name="T14" fmla="*/ 20 w 111"/>
                    <a:gd name="T15" fmla="*/ 5 h 34"/>
                    <a:gd name="T16" fmla="*/ 23 w 111"/>
                    <a:gd name="T17" fmla="*/ 5 h 34"/>
                    <a:gd name="T18" fmla="*/ 25 w 111"/>
                    <a:gd name="T19" fmla="*/ 7 h 34"/>
                    <a:gd name="T20" fmla="*/ 28 w 111"/>
                    <a:gd name="T21" fmla="*/ 7 h 34"/>
                    <a:gd name="T22" fmla="*/ 31 w 111"/>
                    <a:gd name="T23" fmla="*/ 8 h 34"/>
                    <a:gd name="T24" fmla="*/ 34 w 111"/>
                    <a:gd name="T25" fmla="*/ 10 h 34"/>
                    <a:gd name="T26" fmla="*/ 37 w 111"/>
                    <a:gd name="T27" fmla="*/ 10 h 34"/>
                    <a:gd name="T28" fmla="*/ 40 w 111"/>
                    <a:gd name="T29" fmla="*/ 11 h 34"/>
                    <a:gd name="T30" fmla="*/ 43 w 111"/>
                    <a:gd name="T31" fmla="*/ 11 h 34"/>
                    <a:gd name="T32" fmla="*/ 46 w 111"/>
                    <a:gd name="T33" fmla="*/ 13 h 34"/>
                    <a:gd name="T34" fmla="*/ 48 w 111"/>
                    <a:gd name="T35" fmla="*/ 14 h 34"/>
                    <a:gd name="T36" fmla="*/ 51 w 111"/>
                    <a:gd name="T37" fmla="*/ 14 h 34"/>
                    <a:gd name="T38" fmla="*/ 54 w 111"/>
                    <a:gd name="T39" fmla="*/ 15 h 34"/>
                    <a:gd name="T40" fmla="*/ 57 w 111"/>
                    <a:gd name="T41" fmla="*/ 15 h 34"/>
                    <a:gd name="T42" fmla="*/ 60 w 111"/>
                    <a:gd name="T43" fmla="*/ 17 h 34"/>
                    <a:gd name="T44" fmla="*/ 63 w 111"/>
                    <a:gd name="T45" fmla="*/ 18 h 34"/>
                    <a:gd name="T46" fmla="*/ 66 w 111"/>
                    <a:gd name="T47" fmla="*/ 18 h 34"/>
                    <a:gd name="T48" fmla="*/ 68 w 111"/>
                    <a:gd name="T49" fmla="*/ 20 h 34"/>
                    <a:gd name="T50" fmla="*/ 71 w 111"/>
                    <a:gd name="T51" fmla="*/ 21 h 34"/>
                    <a:gd name="T52" fmla="*/ 74 w 111"/>
                    <a:gd name="T53" fmla="*/ 21 h 34"/>
                    <a:gd name="T54" fmla="*/ 77 w 111"/>
                    <a:gd name="T55" fmla="*/ 23 h 34"/>
                    <a:gd name="T56" fmla="*/ 80 w 111"/>
                    <a:gd name="T57" fmla="*/ 24 h 34"/>
                    <a:gd name="T58" fmla="*/ 83 w 111"/>
                    <a:gd name="T59" fmla="*/ 24 h 34"/>
                    <a:gd name="T60" fmla="*/ 86 w 111"/>
                    <a:gd name="T61" fmla="*/ 25 h 34"/>
                    <a:gd name="T62" fmla="*/ 89 w 111"/>
                    <a:gd name="T63" fmla="*/ 27 h 34"/>
                    <a:gd name="T64" fmla="*/ 91 w 111"/>
                    <a:gd name="T65" fmla="*/ 27 h 34"/>
                    <a:gd name="T66" fmla="*/ 94 w 111"/>
                    <a:gd name="T67" fmla="*/ 28 h 34"/>
                    <a:gd name="T68" fmla="*/ 97 w 111"/>
                    <a:gd name="T69" fmla="*/ 30 h 34"/>
                    <a:gd name="T70" fmla="*/ 100 w 111"/>
                    <a:gd name="T71" fmla="*/ 30 h 34"/>
                    <a:gd name="T72" fmla="*/ 103 w 111"/>
                    <a:gd name="T73" fmla="*/ 31 h 34"/>
                    <a:gd name="T74" fmla="*/ 106 w 111"/>
                    <a:gd name="T75" fmla="*/ 33 h 34"/>
                    <a:gd name="T76" fmla="*/ 109 w 111"/>
                    <a:gd name="T77" fmla="*/ 33 h 34"/>
                    <a:gd name="T78" fmla="*/ 111 w 111"/>
                    <a:gd name="T79" fmla="*/ 34 h 3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</a:cxnLst>
                  <a:rect l="0" t="0" r="r" b="b"/>
                  <a:pathLst>
                    <a:path w="111" h="34">
                      <a:moveTo>
                        <a:pt x="0" y="0"/>
                      </a:moveTo>
                      <a:lnTo>
                        <a:pt x="2" y="0"/>
                      </a:lnTo>
                      <a:lnTo>
                        <a:pt x="5" y="1"/>
                      </a:lnTo>
                      <a:lnTo>
                        <a:pt x="8" y="1"/>
                      </a:lnTo>
                      <a:lnTo>
                        <a:pt x="11" y="3"/>
                      </a:lnTo>
                      <a:lnTo>
                        <a:pt x="14" y="4"/>
                      </a:lnTo>
                      <a:lnTo>
                        <a:pt x="17" y="4"/>
                      </a:lnTo>
                      <a:lnTo>
                        <a:pt x="20" y="5"/>
                      </a:lnTo>
                      <a:lnTo>
                        <a:pt x="23" y="5"/>
                      </a:lnTo>
                      <a:lnTo>
                        <a:pt x="25" y="7"/>
                      </a:lnTo>
                      <a:lnTo>
                        <a:pt x="28" y="7"/>
                      </a:lnTo>
                      <a:lnTo>
                        <a:pt x="31" y="8"/>
                      </a:lnTo>
                      <a:lnTo>
                        <a:pt x="34" y="10"/>
                      </a:lnTo>
                      <a:lnTo>
                        <a:pt x="37" y="10"/>
                      </a:lnTo>
                      <a:lnTo>
                        <a:pt x="40" y="11"/>
                      </a:lnTo>
                      <a:lnTo>
                        <a:pt x="43" y="11"/>
                      </a:lnTo>
                      <a:lnTo>
                        <a:pt x="46" y="13"/>
                      </a:lnTo>
                      <a:lnTo>
                        <a:pt x="48" y="14"/>
                      </a:lnTo>
                      <a:lnTo>
                        <a:pt x="51" y="14"/>
                      </a:lnTo>
                      <a:lnTo>
                        <a:pt x="54" y="15"/>
                      </a:lnTo>
                      <a:lnTo>
                        <a:pt x="57" y="15"/>
                      </a:lnTo>
                      <a:lnTo>
                        <a:pt x="60" y="17"/>
                      </a:lnTo>
                      <a:lnTo>
                        <a:pt x="63" y="18"/>
                      </a:lnTo>
                      <a:lnTo>
                        <a:pt x="66" y="18"/>
                      </a:lnTo>
                      <a:lnTo>
                        <a:pt x="68" y="20"/>
                      </a:lnTo>
                      <a:lnTo>
                        <a:pt x="71" y="21"/>
                      </a:lnTo>
                      <a:lnTo>
                        <a:pt x="74" y="21"/>
                      </a:lnTo>
                      <a:lnTo>
                        <a:pt x="77" y="23"/>
                      </a:lnTo>
                      <a:lnTo>
                        <a:pt x="80" y="24"/>
                      </a:lnTo>
                      <a:lnTo>
                        <a:pt x="83" y="24"/>
                      </a:lnTo>
                      <a:lnTo>
                        <a:pt x="86" y="25"/>
                      </a:lnTo>
                      <a:lnTo>
                        <a:pt x="89" y="27"/>
                      </a:lnTo>
                      <a:lnTo>
                        <a:pt x="91" y="27"/>
                      </a:lnTo>
                      <a:lnTo>
                        <a:pt x="94" y="28"/>
                      </a:lnTo>
                      <a:lnTo>
                        <a:pt x="97" y="30"/>
                      </a:lnTo>
                      <a:lnTo>
                        <a:pt x="100" y="30"/>
                      </a:lnTo>
                      <a:lnTo>
                        <a:pt x="103" y="31"/>
                      </a:lnTo>
                      <a:lnTo>
                        <a:pt x="106" y="33"/>
                      </a:lnTo>
                      <a:lnTo>
                        <a:pt x="109" y="33"/>
                      </a:lnTo>
                      <a:lnTo>
                        <a:pt x="111" y="34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6" name="Line 30"/>
                <p:cNvSpPr>
                  <a:spLocks noChangeShapeType="1"/>
                </p:cNvSpPr>
                <p:nvPr/>
              </p:nvSpPr>
              <p:spPr bwMode="auto">
                <a:xfrm flipV="1">
                  <a:off x="4158" y="728"/>
                  <a:ext cx="16" cy="60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7" name="Rectangle 31"/>
                <p:cNvSpPr>
                  <a:spLocks noChangeArrowheads="1"/>
                </p:cNvSpPr>
                <p:nvPr/>
              </p:nvSpPr>
              <p:spPr bwMode="auto">
                <a:xfrm rot="17640000">
                  <a:off x="4479" y="279"/>
                  <a:ext cx="259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SD-A3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8" name="Line 32"/>
                <p:cNvSpPr>
                  <a:spLocks noChangeShapeType="1"/>
                </p:cNvSpPr>
                <p:nvPr/>
              </p:nvSpPr>
              <p:spPr bwMode="auto">
                <a:xfrm flipV="1">
                  <a:off x="4375" y="558"/>
                  <a:ext cx="140" cy="307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9" name="Freeform 33"/>
                <p:cNvSpPr/>
                <p:nvPr/>
              </p:nvSpPr>
              <p:spPr bwMode="auto">
                <a:xfrm>
                  <a:off x="4158" y="791"/>
                  <a:ext cx="109" cy="34"/>
                </a:xfrm>
                <a:custGeom>
                  <a:avLst/>
                  <a:gdLst>
                    <a:gd name="T0" fmla="*/ 109 w 109"/>
                    <a:gd name="T1" fmla="*/ 34 h 34"/>
                    <a:gd name="T2" fmla="*/ 104 w 109"/>
                    <a:gd name="T3" fmla="*/ 33 h 34"/>
                    <a:gd name="T4" fmla="*/ 96 w 109"/>
                    <a:gd name="T5" fmla="*/ 30 h 34"/>
                    <a:gd name="T6" fmla="*/ 91 w 109"/>
                    <a:gd name="T7" fmla="*/ 27 h 34"/>
                    <a:gd name="T8" fmla="*/ 84 w 109"/>
                    <a:gd name="T9" fmla="*/ 25 h 34"/>
                    <a:gd name="T10" fmla="*/ 78 w 109"/>
                    <a:gd name="T11" fmla="*/ 23 h 34"/>
                    <a:gd name="T12" fmla="*/ 72 w 109"/>
                    <a:gd name="T13" fmla="*/ 21 h 34"/>
                    <a:gd name="T14" fmla="*/ 65 w 109"/>
                    <a:gd name="T15" fmla="*/ 18 h 34"/>
                    <a:gd name="T16" fmla="*/ 59 w 109"/>
                    <a:gd name="T17" fmla="*/ 17 h 34"/>
                    <a:gd name="T18" fmla="*/ 52 w 109"/>
                    <a:gd name="T19" fmla="*/ 15 h 34"/>
                    <a:gd name="T20" fmla="*/ 46 w 109"/>
                    <a:gd name="T21" fmla="*/ 13 h 34"/>
                    <a:gd name="T22" fmla="*/ 39 w 109"/>
                    <a:gd name="T23" fmla="*/ 11 h 34"/>
                    <a:gd name="T24" fmla="*/ 33 w 109"/>
                    <a:gd name="T25" fmla="*/ 10 h 34"/>
                    <a:gd name="T26" fmla="*/ 26 w 109"/>
                    <a:gd name="T27" fmla="*/ 7 h 34"/>
                    <a:gd name="T28" fmla="*/ 20 w 109"/>
                    <a:gd name="T29" fmla="*/ 5 h 34"/>
                    <a:gd name="T30" fmla="*/ 13 w 109"/>
                    <a:gd name="T31" fmla="*/ 4 h 34"/>
                    <a:gd name="T32" fmla="*/ 6 w 109"/>
                    <a:gd name="T33" fmla="*/ 1 h 34"/>
                    <a:gd name="T34" fmla="*/ 0 w 109"/>
                    <a:gd name="T35" fmla="*/ 0 h 3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109" h="34">
                      <a:moveTo>
                        <a:pt x="109" y="34"/>
                      </a:moveTo>
                      <a:lnTo>
                        <a:pt x="104" y="33"/>
                      </a:lnTo>
                      <a:lnTo>
                        <a:pt x="96" y="30"/>
                      </a:lnTo>
                      <a:lnTo>
                        <a:pt x="91" y="27"/>
                      </a:lnTo>
                      <a:lnTo>
                        <a:pt x="84" y="25"/>
                      </a:lnTo>
                      <a:lnTo>
                        <a:pt x="78" y="23"/>
                      </a:lnTo>
                      <a:lnTo>
                        <a:pt x="72" y="21"/>
                      </a:lnTo>
                      <a:lnTo>
                        <a:pt x="65" y="18"/>
                      </a:lnTo>
                      <a:lnTo>
                        <a:pt x="59" y="17"/>
                      </a:lnTo>
                      <a:lnTo>
                        <a:pt x="52" y="15"/>
                      </a:lnTo>
                      <a:lnTo>
                        <a:pt x="46" y="13"/>
                      </a:lnTo>
                      <a:lnTo>
                        <a:pt x="39" y="11"/>
                      </a:lnTo>
                      <a:lnTo>
                        <a:pt x="33" y="10"/>
                      </a:lnTo>
                      <a:lnTo>
                        <a:pt x="26" y="7"/>
                      </a:lnTo>
                      <a:lnTo>
                        <a:pt x="20" y="5"/>
                      </a:lnTo>
                      <a:lnTo>
                        <a:pt x="13" y="4"/>
                      </a:lnTo>
                      <a:lnTo>
                        <a:pt x="6" y="1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0" name="Freeform 34"/>
                <p:cNvSpPr/>
                <p:nvPr/>
              </p:nvSpPr>
              <p:spPr bwMode="auto">
                <a:xfrm>
                  <a:off x="4267" y="825"/>
                  <a:ext cx="107" cy="43"/>
                </a:xfrm>
                <a:custGeom>
                  <a:avLst/>
                  <a:gdLst>
                    <a:gd name="T0" fmla="*/ 0 w 107"/>
                    <a:gd name="T1" fmla="*/ 0 h 43"/>
                    <a:gd name="T2" fmla="*/ 3 w 107"/>
                    <a:gd name="T3" fmla="*/ 2 h 43"/>
                    <a:gd name="T4" fmla="*/ 5 w 107"/>
                    <a:gd name="T5" fmla="*/ 2 h 43"/>
                    <a:gd name="T6" fmla="*/ 8 w 107"/>
                    <a:gd name="T7" fmla="*/ 3 h 43"/>
                    <a:gd name="T8" fmla="*/ 10 w 107"/>
                    <a:gd name="T9" fmla="*/ 3 h 43"/>
                    <a:gd name="T10" fmla="*/ 12 w 107"/>
                    <a:gd name="T11" fmla="*/ 4 h 43"/>
                    <a:gd name="T12" fmla="*/ 15 w 107"/>
                    <a:gd name="T13" fmla="*/ 6 h 43"/>
                    <a:gd name="T14" fmla="*/ 16 w 107"/>
                    <a:gd name="T15" fmla="*/ 6 h 43"/>
                    <a:gd name="T16" fmla="*/ 19 w 107"/>
                    <a:gd name="T17" fmla="*/ 7 h 43"/>
                    <a:gd name="T18" fmla="*/ 22 w 107"/>
                    <a:gd name="T19" fmla="*/ 7 h 43"/>
                    <a:gd name="T20" fmla="*/ 23 w 107"/>
                    <a:gd name="T21" fmla="*/ 9 h 43"/>
                    <a:gd name="T22" fmla="*/ 26 w 107"/>
                    <a:gd name="T23" fmla="*/ 10 h 43"/>
                    <a:gd name="T24" fmla="*/ 28 w 107"/>
                    <a:gd name="T25" fmla="*/ 10 h 43"/>
                    <a:gd name="T26" fmla="*/ 31 w 107"/>
                    <a:gd name="T27" fmla="*/ 12 h 43"/>
                    <a:gd name="T28" fmla="*/ 33 w 107"/>
                    <a:gd name="T29" fmla="*/ 12 h 43"/>
                    <a:gd name="T30" fmla="*/ 35 w 107"/>
                    <a:gd name="T31" fmla="*/ 13 h 43"/>
                    <a:gd name="T32" fmla="*/ 38 w 107"/>
                    <a:gd name="T33" fmla="*/ 14 h 43"/>
                    <a:gd name="T34" fmla="*/ 39 w 107"/>
                    <a:gd name="T35" fmla="*/ 14 h 43"/>
                    <a:gd name="T36" fmla="*/ 42 w 107"/>
                    <a:gd name="T37" fmla="*/ 16 h 43"/>
                    <a:gd name="T38" fmla="*/ 43 w 107"/>
                    <a:gd name="T39" fmla="*/ 17 h 43"/>
                    <a:gd name="T40" fmla="*/ 46 w 107"/>
                    <a:gd name="T41" fmla="*/ 17 h 43"/>
                    <a:gd name="T42" fmla="*/ 49 w 107"/>
                    <a:gd name="T43" fmla="*/ 19 h 43"/>
                    <a:gd name="T44" fmla="*/ 51 w 107"/>
                    <a:gd name="T45" fmla="*/ 20 h 43"/>
                    <a:gd name="T46" fmla="*/ 53 w 107"/>
                    <a:gd name="T47" fmla="*/ 20 h 43"/>
                    <a:gd name="T48" fmla="*/ 55 w 107"/>
                    <a:gd name="T49" fmla="*/ 22 h 43"/>
                    <a:gd name="T50" fmla="*/ 58 w 107"/>
                    <a:gd name="T51" fmla="*/ 22 h 43"/>
                    <a:gd name="T52" fmla="*/ 59 w 107"/>
                    <a:gd name="T53" fmla="*/ 23 h 43"/>
                    <a:gd name="T54" fmla="*/ 62 w 107"/>
                    <a:gd name="T55" fmla="*/ 24 h 43"/>
                    <a:gd name="T56" fmla="*/ 65 w 107"/>
                    <a:gd name="T57" fmla="*/ 24 h 43"/>
                    <a:gd name="T58" fmla="*/ 66 w 107"/>
                    <a:gd name="T59" fmla="*/ 26 h 43"/>
                    <a:gd name="T60" fmla="*/ 69 w 107"/>
                    <a:gd name="T61" fmla="*/ 27 h 43"/>
                    <a:gd name="T62" fmla="*/ 71 w 107"/>
                    <a:gd name="T63" fmla="*/ 27 h 43"/>
                    <a:gd name="T64" fmla="*/ 74 w 107"/>
                    <a:gd name="T65" fmla="*/ 29 h 43"/>
                    <a:gd name="T66" fmla="*/ 75 w 107"/>
                    <a:gd name="T67" fmla="*/ 30 h 43"/>
                    <a:gd name="T68" fmla="*/ 78 w 107"/>
                    <a:gd name="T69" fmla="*/ 30 h 43"/>
                    <a:gd name="T70" fmla="*/ 81 w 107"/>
                    <a:gd name="T71" fmla="*/ 32 h 43"/>
                    <a:gd name="T72" fmla="*/ 82 w 107"/>
                    <a:gd name="T73" fmla="*/ 33 h 43"/>
                    <a:gd name="T74" fmla="*/ 85 w 107"/>
                    <a:gd name="T75" fmla="*/ 33 h 43"/>
                    <a:gd name="T76" fmla="*/ 86 w 107"/>
                    <a:gd name="T77" fmla="*/ 35 h 43"/>
                    <a:gd name="T78" fmla="*/ 89 w 107"/>
                    <a:gd name="T79" fmla="*/ 36 h 43"/>
                    <a:gd name="T80" fmla="*/ 91 w 107"/>
                    <a:gd name="T81" fmla="*/ 36 h 43"/>
                    <a:gd name="T82" fmla="*/ 94 w 107"/>
                    <a:gd name="T83" fmla="*/ 37 h 43"/>
                    <a:gd name="T84" fmla="*/ 95 w 107"/>
                    <a:gd name="T85" fmla="*/ 39 h 43"/>
                    <a:gd name="T86" fmla="*/ 98 w 107"/>
                    <a:gd name="T87" fmla="*/ 40 h 43"/>
                    <a:gd name="T88" fmla="*/ 101 w 107"/>
                    <a:gd name="T89" fmla="*/ 40 h 43"/>
                    <a:gd name="T90" fmla="*/ 102 w 107"/>
                    <a:gd name="T91" fmla="*/ 42 h 43"/>
                    <a:gd name="T92" fmla="*/ 105 w 107"/>
                    <a:gd name="T93" fmla="*/ 43 h 43"/>
                    <a:gd name="T94" fmla="*/ 107 w 107"/>
                    <a:gd name="T95" fmla="*/ 43 h 4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  <a:cxn ang="0">
                      <a:pos x="T90" y="T91"/>
                    </a:cxn>
                    <a:cxn ang="0">
                      <a:pos x="T92" y="T93"/>
                    </a:cxn>
                    <a:cxn ang="0">
                      <a:pos x="T94" y="T95"/>
                    </a:cxn>
                  </a:cxnLst>
                  <a:rect l="0" t="0" r="r" b="b"/>
                  <a:pathLst>
                    <a:path w="107" h="43">
                      <a:moveTo>
                        <a:pt x="0" y="0"/>
                      </a:moveTo>
                      <a:lnTo>
                        <a:pt x="3" y="2"/>
                      </a:lnTo>
                      <a:lnTo>
                        <a:pt x="5" y="2"/>
                      </a:lnTo>
                      <a:lnTo>
                        <a:pt x="8" y="3"/>
                      </a:lnTo>
                      <a:lnTo>
                        <a:pt x="10" y="3"/>
                      </a:lnTo>
                      <a:lnTo>
                        <a:pt x="12" y="4"/>
                      </a:lnTo>
                      <a:lnTo>
                        <a:pt x="15" y="6"/>
                      </a:lnTo>
                      <a:lnTo>
                        <a:pt x="16" y="6"/>
                      </a:lnTo>
                      <a:lnTo>
                        <a:pt x="19" y="7"/>
                      </a:lnTo>
                      <a:lnTo>
                        <a:pt x="22" y="7"/>
                      </a:lnTo>
                      <a:lnTo>
                        <a:pt x="23" y="9"/>
                      </a:lnTo>
                      <a:lnTo>
                        <a:pt x="26" y="10"/>
                      </a:lnTo>
                      <a:lnTo>
                        <a:pt x="28" y="10"/>
                      </a:lnTo>
                      <a:lnTo>
                        <a:pt x="31" y="12"/>
                      </a:lnTo>
                      <a:lnTo>
                        <a:pt x="33" y="12"/>
                      </a:lnTo>
                      <a:lnTo>
                        <a:pt x="35" y="13"/>
                      </a:lnTo>
                      <a:lnTo>
                        <a:pt x="38" y="14"/>
                      </a:lnTo>
                      <a:lnTo>
                        <a:pt x="39" y="14"/>
                      </a:lnTo>
                      <a:lnTo>
                        <a:pt x="42" y="16"/>
                      </a:lnTo>
                      <a:lnTo>
                        <a:pt x="43" y="17"/>
                      </a:lnTo>
                      <a:lnTo>
                        <a:pt x="46" y="17"/>
                      </a:lnTo>
                      <a:lnTo>
                        <a:pt x="49" y="19"/>
                      </a:lnTo>
                      <a:lnTo>
                        <a:pt x="51" y="20"/>
                      </a:lnTo>
                      <a:lnTo>
                        <a:pt x="53" y="20"/>
                      </a:lnTo>
                      <a:lnTo>
                        <a:pt x="55" y="22"/>
                      </a:lnTo>
                      <a:lnTo>
                        <a:pt x="58" y="22"/>
                      </a:lnTo>
                      <a:lnTo>
                        <a:pt x="59" y="23"/>
                      </a:lnTo>
                      <a:lnTo>
                        <a:pt x="62" y="24"/>
                      </a:lnTo>
                      <a:lnTo>
                        <a:pt x="65" y="24"/>
                      </a:lnTo>
                      <a:lnTo>
                        <a:pt x="66" y="26"/>
                      </a:lnTo>
                      <a:lnTo>
                        <a:pt x="69" y="27"/>
                      </a:lnTo>
                      <a:lnTo>
                        <a:pt x="71" y="27"/>
                      </a:lnTo>
                      <a:lnTo>
                        <a:pt x="74" y="29"/>
                      </a:lnTo>
                      <a:lnTo>
                        <a:pt x="75" y="30"/>
                      </a:lnTo>
                      <a:lnTo>
                        <a:pt x="78" y="30"/>
                      </a:lnTo>
                      <a:lnTo>
                        <a:pt x="81" y="32"/>
                      </a:lnTo>
                      <a:lnTo>
                        <a:pt x="82" y="33"/>
                      </a:lnTo>
                      <a:lnTo>
                        <a:pt x="85" y="33"/>
                      </a:lnTo>
                      <a:lnTo>
                        <a:pt x="86" y="35"/>
                      </a:lnTo>
                      <a:lnTo>
                        <a:pt x="89" y="36"/>
                      </a:lnTo>
                      <a:lnTo>
                        <a:pt x="91" y="36"/>
                      </a:lnTo>
                      <a:lnTo>
                        <a:pt x="94" y="37"/>
                      </a:lnTo>
                      <a:lnTo>
                        <a:pt x="95" y="39"/>
                      </a:lnTo>
                      <a:lnTo>
                        <a:pt x="98" y="40"/>
                      </a:lnTo>
                      <a:lnTo>
                        <a:pt x="101" y="40"/>
                      </a:lnTo>
                      <a:lnTo>
                        <a:pt x="102" y="42"/>
                      </a:lnTo>
                      <a:lnTo>
                        <a:pt x="105" y="43"/>
                      </a:lnTo>
                      <a:lnTo>
                        <a:pt x="107" y="43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2" name="Line 36"/>
                <p:cNvSpPr>
                  <a:spLocks noChangeShapeType="1"/>
                </p:cNvSpPr>
                <p:nvPr/>
              </p:nvSpPr>
              <p:spPr bwMode="auto">
                <a:xfrm flipV="1">
                  <a:off x="4244" y="828"/>
                  <a:ext cx="22" cy="59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3" name="Rectangle 37"/>
                <p:cNvSpPr>
                  <a:spLocks noChangeArrowheads="1"/>
                </p:cNvSpPr>
                <p:nvPr/>
              </p:nvSpPr>
              <p:spPr bwMode="auto">
                <a:xfrm rot="17940000">
                  <a:off x="4617" y="363"/>
                  <a:ext cx="254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LK-A1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4" name="Line 38"/>
                <p:cNvSpPr>
                  <a:spLocks noChangeShapeType="1"/>
                </p:cNvSpPr>
                <p:nvPr/>
              </p:nvSpPr>
              <p:spPr bwMode="auto">
                <a:xfrm flipV="1">
                  <a:off x="4447" y="626"/>
                  <a:ext cx="200" cy="354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5" name="Freeform 39"/>
                <p:cNvSpPr/>
                <p:nvPr/>
              </p:nvSpPr>
              <p:spPr bwMode="auto">
                <a:xfrm>
                  <a:off x="4244" y="890"/>
                  <a:ext cx="102" cy="43"/>
                </a:xfrm>
                <a:custGeom>
                  <a:avLst/>
                  <a:gdLst>
                    <a:gd name="T0" fmla="*/ 102 w 102"/>
                    <a:gd name="T1" fmla="*/ 43 h 43"/>
                    <a:gd name="T2" fmla="*/ 97 w 102"/>
                    <a:gd name="T3" fmla="*/ 40 h 43"/>
                    <a:gd name="T4" fmla="*/ 91 w 102"/>
                    <a:gd name="T5" fmla="*/ 37 h 43"/>
                    <a:gd name="T6" fmla="*/ 86 w 102"/>
                    <a:gd name="T7" fmla="*/ 34 h 43"/>
                    <a:gd name="T8" fmla="*/ 81 w 102"/>
                    <a:gd name="T9" fmla="*/ 33 h 43"/>
                    <a:gd name="T10" fmla="*/ 75 w 102"/>
                    <a:gd name="T11" fmla="*/ 30 h 43"/>
                    <a:gd name="T12" fmla="*/ 69 w 102"/>
                    <a:gd name="T13" fmla="*/ 27 h 43"/>
                    <a:gd name="T14" fmla="*/ 64 w 102"/>
                    <a:gd name="T15" fmla="*/ 24 h 43"/>
                    <a:gd name="T16" fmla="*/ 58 w 102"/>
                    <a:gd name="T17" fmla="*/ 23 h 43"/>
                    <a:gd name="T18" fmla="*/ 52 w 102"/>
                    <a:gd name="T19" fmla="*/ 20 h 43"/>
                    <a:gd name="T20" fmla="*/ 46 w 102"/>
                    <a:gd name="T21" fmla="*/ 18 h 43"/>
                    <a:gd name="T22" fmla="*/ 41 w 102"/>
                    <a:gd name="T23" fmla="*/ 15 h 43"/>
                    <a:gd name="T24" fmla="*/ 35 w 102"/>
                    <a:gd name="T25" fmla="*/ 13 h 43"/>
                    <a:gd name="T26" fmla="*/ 29 w 102"/>
                    <a:gd name="T27" fmla="*/ 11 h 43"/>
                    <a:gd name="T28" fmla="*/ 23 w 102"/>
                    <a:gd name="T29" fmla="*/ 8 h 43"/>
                    <a:gd name="T30" fmla="*/ 18 w 102"/>
                    <a:gd name="T31" fmla="*/ 7 h 43"/>
                    <a:gd name="T32" fmla="*/ 12 w 102"/>
                    <a:gd name="T33" fmla="*/ 4 h 43"/>
                    <a:gd name="T34" fmla="*/ 6 w 102"/>
                    <a:gd name="T35" fmla="*/ 3 h 43"/>
                    <a:gd name="T36" fmla="*/ 0 w 102"/>
                    <a:gd name="T37" fmla="*/ 0 h 4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</a:cxnLst>
                  <a:rect l="0" t="0" r="r" b="b"/>
                  <a:pathLst>
                    <a:path w="102" h="43">
                      <a:moveTo>
                        <a:pt x="102" y="43"/>
                      </a:moveTo>
                      <a:lnTo>
                        <a:pt x="97" y="40"/>
                      </a:lnTo>
                      <a:lnTo>
                        <a:pt x="91" y="37"/>
                      </a:lnTo>
                      <a:lnTo>
                        <a:pt x="86" y="34"/>
                      </a:lnTo>
                      <a:lnTo>
                        <a:pt x="81" y="33"/>
                      </a:lnTo>
                      <a:lnTo>
                        <a:pt x="75" y="30"/>
                      </a:lnTo>
                      <a:lnTo>
                        <a:pt x="69" y="27"/>
                      </a:lnTo>
                      <a:lnTo>
                        <a:pt x="64" y="24"/>
                      </a:lnTo>
                      <a:lnTo>
                        <a:pt x="58" y="23"/>
                      </a:lnTo>
                      <a:lnTo>
                        <a:pt x="52" y="20"/>
                      </a:lnTo>
                      <a:lnTo>
                        <a:pt x="46" y="18"/>
                      </a:lnTo>
                      <a:lnTo>
                        <a:pt x="41" y="15"/>
                      </a:lnTo>
                      <a:lnTo>
                        <a:pt x="35" y="13"/>
                      </a:lnTo>
                      <a:lnTo>
                        <a:pt x="29" y="11"/>
                      </a:lnTo>
                      <a:lnTo>
                        <a:pt x="23" y="8"/>
                      </a:lnTo>
                      <a:lnTo>
                        <a:pt x="18" y="7"/>
                      </a:lnTo>
                      <a:lnTo>
                        <a:pt x="12" y="4"/>
                      </a:lnTo>
                      <a:lnTo>
                        <a:pt x="6" y="3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6" name="Freeform 40"/>
                <p:cNvSpPr/>
                <p:nvPr/>
              </p:nvSpPr>
              <p:spPr bwMode="auto">
                <a:xfrm>
                  <a:off x="4346" y="933"/>
                  <a:ext cx="99" cy="50"/>
                </a:xfrm>
                <a:custGeom>
                  <a:avLst/>
                  <a:gdLst>
                    <a:gd name="T0" fmla="*/ 0 w 99"/>
                    <a:gd name="T1" fmla="*/ 0 h 50"/>
                    <a:gd name="T2" fmla="*/ 3 w 99"/>
                    <a:gd name="T3" fmla="*/ 0 h 50"/>
                    <a:gd name="T4" fmla="*/ 5 w 99"/>
                    <a:gd name="T5" fmla="*/ 1 h 50"/>
                    <a:gd name="T6" fmla="*/ 6 w 99"/>
                    <a:gd name="T7" fmla="*/ 1 h 50"/>
                    <a:gd name="T8" fmla="*/ 7 w 99"/>
                    <a:gd name="T9" fmla="*/ 3 h 50"/>
                    <a:gd name="T10" fmla="*/ 10 w 99"/>
                    <a:gd name="T11" fmla="*/ 4 h 50"/>
                    <a:gd name="T12" fmla="*/ 12 w 99"/>
                    <a:gd name="T13" fmla="*/ 4 h 50"/>
                    <a:gd name="T14" fmla="*/ 13 w 99"/>
                    <a:gd name="T15" fmla="*/ 5 h 50"/>
                    <a:gd name="T16" fmla="*/ 16 w 99"/>
                    <a:gd name="T17" fmla="*/ 5 h 50"/>
                    <a:gd name="T18" fmla="*/ 17 w 99"/>
                    <a:gd name="T19" fmla="*/ 7 h 50"/>
                    <a:gd name="T20" fmla="*/ 19 w 99"/>
                    <a:gd name="T21" fmla="*/ 8 h 50"/>
                    <a:gd name="T22" fmla="*/ 22 w 99"/>
                    <a:gd name="T23" fmla="*/ 8 h 50"/>
                    <a:gd name="T24" fmla="*/ 23 w 99"/>
                    <a:gd name="T25" fmla="*/ 10 h 50"/>
                    <a:gd name="T26" fmla="*/ 25 w 99"/>
                    <a:gd name="T27" fmla="*/ 10 h 50"/>
                    <a:gd name="T28" fmla="*/ 26 w 99"/>
                    <a:gd name="T29" fmla="*/ 11 h 50"/>
                    <a:gd name="T30" fmla="*/ 29 w 99"/>
                    <a:gd name="T31" fmla="*/ 13 h 50"/>
                    <a:gd name="T32" fmla="*/ 30 w 99"/>
                    <a:gd name="T33" fmla="*/ 13 h 50"/>
                    <a:gd name="T34" fmla="*/ 32 w 99"/>
                    <a:gd name="T35" fmla="*/ 14 h 50"/>
                    <a:gd name="T36" fmla="*/ 35 w 99"/>
                    <a:gd name="T37" fmla="*/ 15 h 50"/>
                    <a:gd name="T38" fmla="*/ 36 w 99"/>
                    <a:gd name="T39" fmla="*/ 15 h 50"/>
                    <a:gd name="T40" fmla="*/ 38 w 99"/>
                    <a:gd name="T41" fmla="*/ 17 h 50"/>
                    <a:gd name="T42" fmla="*/ 39 w 99"/>
                    <a:gd name="T43" fmla="*/ 18 h 50"/>
                    <a:gd name="T44" fmla="*/ 42 w 99"/>
                    <a:gd name="T45" fmla="*/ 18 h 50"/>
                    <a:gd name="T46" fmla="*/ 43 w 99"/>
                    <a:gd name="T47" fmla="*/ 20 h 50"/>
                    <a:gd name="T48" fmla="*/ 45 w 99"/>
                    <a:gd name="T49" fmla="*/ 20 h 50"/>
                    <a:gd name="T50" fmla="*/ 46 w 99"/>
                    <a:gd name="T51" fmla="*/ 21 h 50"/>
                    <a:gd name="T52" fmla="*/ 49 w 99"/>
                    <a:gd name="T53" fmla="*/ 23 h 50"/>
                    <a:gd name="T54" fmla="*/ 50 w 99"/>
                    <a:gd name="T55" fmla="*/ 23 h 50"/>
                    <a:gd name="T56" fmla="*/ 52 w 99"/>
                    <a:gd name="T57" fmla="*/ 24 h 50"/>
                    <a:gd name="T58" fmla="*/ 55 w 99"/>
                    <a:gd name="T59" fmla="*/ 26 h 50"/>
                    <a:gd name="T60" fmla="*/ 56 w 99"/>
                    <a:gd name="T61" fmla="*/ 26 h 50"/>
                    <a:gd name="T62" fmla="*/ 58 w 99"/>
                    <a:gd name="T63" fmla="*/ 27 h 50"/>
                    <a:gd name="T64" fmla="*/ 59 w 99"/>
                    <a:gd name="T65" fmla="*/ 28 h 50"/>
                    <a:gd name="T66" fmla="*/ 62 w 99"/>
                    <a:gd name="T67" fmla="*/ 28 h 50"/>
                    <a:gd name="T68" fmla="*/ 63 w 99"/>
                    <a:gd name="T69" fmla="*/ 30 h 50"/>
                    <a:gd name="T70" fmla="*/ 65 w 99"/>
                    <a:gd name="T71" fmla="*/ 31 h 50"/>
                    <a:gd name="T72" fmla="*/ 66 w 99"/>
                    <a:gd name="T73" fmla="*/ 31 h 50"/>
                    <a:gd name="T74" fmla="*/ 69 w 99"/>
                    <a:gd name="T75" fmla="*/ 33 h 50"/>
                    <a:gd name="T76" fmla="*/ 71 w 99"/>
                    <a:gd name="T77" fmla="*/ 34 h 50"/>
                    <a:gd name="T78" fmla="*/ 72 w 99"/>
                    <a:gd name="T79" fmla="*/ 34 h 50"/>
                    <a:gd name="T80" fmla="*/ 73 w 99"/>
                    <a:gd name="T81" fmla="*/ 36 h 50"/>
                    <a:gd name="T82" fmla="*/ 76 w 99"/>
                    <a:gd name="T83" fmla="*/ 37 h 50"/>
                    <a:gd name="T84" fmla="*/ 78 w 99"/>
                    <a:gd name="T85" fmla="*/ 37 h 50"/>
                    <a:gd name="T86" fmla="*/ 79 w 99"/>
                    <a:gd name="T87" fmla="*/ 38 h 50"/>
                    <a:gd name="T88" fmla="*/ 82 w 99"/>
                    <a:gd name="T89" fmla="*/ 40 h 50"/>
                    <a:gd name="T90" fmla="*/ 83 w 99"/>
                    <a:gd name="T91" fmla="*/ 40 h 50"/>
                    <a:gd name="T92" fmla="*/ 85 w 99"/>
                    <a:gd name="T93" fmla="*/ 41 h 50"/>
                    <a:gd name="T94" fmla="*/ 86 w 99"/>
                    <a:gd name="T95" fmla="*/ 43 h 50"/>
                    <a:gd name="T96" fmla="*/ 89 w 99"/>
                    <a:gd name="T97" fmla="*/ 44 h 50"/>
                    <a:gd name="T98" fmla="*/ 91 w 99"/>
                    <a:gd name="T99" fmla="*/ 44 h 50"/>
                    <a:gd name="T100" fmla="*/ 92 w 99"/>
                    <a:gd name="T101" fmla="*/ 46 h 50"/>
                    <a:gd name="T102" fmla="*/ 93 w 99"/>
                    <a:gd name="T103" fmla="*/ 47 h 50"/>
                    <a:gd name="T104" fmla="*/ 96 w 99"/>
                    <a:gd name="T105" fmla="*/ 47 h 50"/>
                    <a:gd name="T106" fmla="*/ 98 w 99"/>
                    <a:gd name="T107" fmla="*/ 48 h 50"/>
                    <a:gd name="T108" fmla="*/ 99 w 99"/>
                    <a:gd name="T109" fmla="*/ 50 h 5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  <a:cxn ang="0">
                      <a:pos x="T90" y="T91"/>
                    </a:cxn>
                    <a:cxn ang="0">
                      <a:pos x="T92" y="T93"/>
                    </a:cxn>
                    <a:cxn ang="0">
                      <a:pos x="T94" y="T95"/>
                    </a:cxn>
                    <a:cxn ang="0">
                      <a:pos x="T96" y="T97"/>
                    </a:cxn>
                    <a:cxn ang="0">
                      <a:pos x="T98" y="T99"/>
                    </a:cxn>
                    <a:cxn ang="0">
                      <a:pos x="T100" y="T101"/>
                    </a:cxn>
                    <a:cxn ang="0">
                      <a:pos x="T102" y="T103"/>
                    </a:cxn>
                    <a:cxn ang="0">
                      <a:pos x="T104" y="T105"/>
                    </a:cxn>
                    <a:cxn ang="0">
                      <a:pos x="T106" y="T107"/>
                    </a:cxn>
                    <a:cxn ang="0">
                      <a:pos x="T108" y="T109"/>
                    </a:cxn>
                  </a:cxnLst>
                  <a:rect l="0" t="0" r="r" b="b"/>
                  <a:pathLst>
                    <a:path w="99" h="50">
                      <a:moveTo>
                        <a:pt x="0" y="0"/>
                      </a:moveTo>
                      <a:lnTo>
                        <a:pt x="3" y="0"/>
                      </a:lnTo>
                      <a:lnTo>
                        <a:pt x="5" y="1"/>
                      </a:lnTo>
                      <a:lnTo>
                        <a:pt x="6" y="1"/>
                      </a:lnTo>
                      <a:lnTo>
                        <a:pt x="7" y="3"/>
                      </a:lnTo>
                      <a:lnTo>
                        <a:pt x="10" y="4"/>
                      </a:lnTo>
                      <a:lnTo>
                        <a:pt x="12" y="4"/>
                      </a:lnTo>
                      <a:lnTo>
                        <a:pt x="13" y="5"/>
                      </a:lnTo>
                      <a:lnTo>
                        <a:pt x="16" y="5"/>
                      </a:lnTo>
                      <a:lnTo>
                        <a:pt x="17" y="7"/>
                      </a:lnTo>
                      <a:lnTo>
                        <a:pt x="19" y="8"/>
                      </a:lnTo>
                      <a:lnTo>
                        <a:pt x="22" y="8"/>
                      </a:lnTo>
                      <a:lnTo>
                        <a:pt x="23" y="10"/>
                      </a:lnTo>
                      <a:lnTo>
                        <a:pt x="25" y="10"/>
                      </a:lnTo>
                      <a:lnTo>
                        <a:pt x="26" y="11"/>
                      </a:lnTo>
                      <a:lnTo>
                        <a:pt x="29" y="13"/>
                      </a:lnTo>
                      <a:lnTo>
                        <a:pt x="30" y="13"/>
                      </a:lnTo>
                      <a:lnTo>
                        <a:pt x="32" y="14"/>
                      </a:lnTo>
                      <a:lnTo>
                        <a:pt x="35" y="15"/>
                      </a:lnTo>
                      <a:lnTo>
                        <a:pt x="36" y="15"/>
                      </a:lnTo>
                      <a:lnTo>
                        <a:pt x="38" y="17"/>
                      </a:lnTo>
                      <a:lnTo>
                        <a:pt x="39" y="18"/>
                      </a:lnTo>
                      <a:lnTo>
                        <a:pt x="42" y="18"/>
                      </a:lnTo>
                      <a:lnTo>
                        <a:pt x="43" y="20"/>
                      </a:lnTo>
                      <a:lnTo>
                        <a:pt x="45" y="20"/>
                      </a:lnTo>
                      <a:lnTo>
                        <a:pt x="46" y="21"/>
                      </a:lnTo>
                      <a:lnTo>
                        <a:pt x="49" y="23"/>
                      </a:lnTo>
                      <a:lnTo>
                        <a:pt x="50" y="23"/>
                      </a:lnTo>
                      <a:lnTo>
                        <a:pt x="52" y="24"/>
                      </a:lnTo>
                      <a:lnTo>
                        <a:pt x="55" y="26"/>
                      </a:lnTo>
                      <a:lnTo>
                        <a:pt x="56" y="26"/>
                      </a:lnTo>
                      <a:lnTo>
                        <a:pt x="58" y="27"/>
                      </a:lnTo>
                      <a:lnTo>
                        <a:pt x="59" y="28"/>
                      </a:lnTo>
                      <a:lnTo>
                        <a:pt x="62" y="28"/>
                      </a:lnTo>
                      <a:lnTo>
                        <a:pt x="63" y="30"/>
                      </a:lnTo>
                      <a:lnTo>
                        <a:pt x="65" y="31"/>
                      </a:lnTo>
                      <a:lnTo>
                        <a:pt x="66" y="31"/>
                      </a:lnTo>
                      <a:lnTo>
                        <a:pt x="69" y="33"/>
                      </a:lnTo>
                      <a:lnTo>
                        <a:pt x="71" y="34"/>
                      </a:lnTo>
                      <a:lnTo>
                        <a:pt x="72" y="34"/>
                      </a:lnTo>
                      <a:lnTo>
                        <a:pt x="73" y="36"/>
                      </a:lnTo>
                      <a:lnTo>
                        <a:pt x="76" y="37"/>
                      </a:lnTo>
                      <a:lnTo>
                        <a:pt x="78" y="37"/>
                      </a:lnTo>
                      <a:lnTo>
                        <a:pt x="79" y="38"/>
                      </a:lnTo>
                      <a:lnTo>
                        <a:pt x="82" y="40"/>
                      </a:lnTo>
                      <a:lnTo>
                        <a:pt x="83" y="40"/>
                      </a:lnTo>
                      <a:lnTo>
                        <a:pt x="85" y="41"/>
                      </a:lnTo>
                      <a:lnTo>
                        <a:pt x="86" y="43"/>
                      </a:lnTo>
                      <a:lnTo>
                        <a:pt x="89" y="44"/>
                      </a:lnTo>
                      <a:lnTo>
                        <a:pt x="91" y="44"/>
                      </a:lnTo>
                      <a:lnTo>
                        <a:pt x="92" y="46"/>
                      </a:lnTo>
                      <a:lnTo>
                        <a:pt x="93" y="47"/>
                      </a:lnTo>
                      <a:lnTo>
                        <a:pt x="96" y="47"/>
                      </a:lnTo>
                      <a:lnTo>
                        <a:pt x="98" y="48"/>
                      </a:lnTo>
                      <a:lnTo>
                        <a:pt x="99" y="5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8" name="Line 42"/>
                <p:cNvSpPr>
                  <a:spLocks noChangeShapeType="1"/>
                </p:cNvSpPr>
                <p:nvPr/>
              </p:nvSpPr>
              <p:spPr bwMode="auto">
                <a:xfrm flipV="1">
                  <a:off x="4319" y="936"/>
                  <a:ext cx="26" cy="57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9" name="Rectangle 43"/>
                <p:cNvSpPr>
                  <a:spLocks noChangeArrowheads="1"/>
                </p:cNvSpPr>
                <p:nvPr/>
              </p:nvSpPr>
              <p:spPr bwMode="auto">
                <a:xfrm rot="18240000">
                  <a:off x="4766" y="420"/>
                  <a:ext cx="295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QJQC-A1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0" name="Line 44"/>
                <p:cNvSpPr>
                  <a:spLocks noChangeShapeType="1"/>
                </p:cNvSpPr>
                <p:nvPr/>
              </p:nvSpPr>
              <p:spPr bwMode="auto">
                <a:xfrm flipV="1">
                  <a:off x="4504" y="705"/>
                  <a:ext cx="270" cy="391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1" name="Freeform 45"/>
                <p:cNvSpPr/>
                <p:nvPr/>
              </p:nvSpPr>
              <p:spPr bwMode="auto">
                <a:xfrm>
                  <a:off x="4318" y="994"/>
                  <a:ext cx="94" cy="49"/>
                </a:xfrm>
                <a:custGeom>
                  <a:avLst/>
                  <a:gdLst>
                    <a:gd name="T0" fmla="*/ 94 w 94"/>
                    <a:gd name="T1" fmla="*/ 49 h 49"/>
                    <a:gd name="T2" fmla="*/ 88 w 94"/>
                    <a:gd name="T3" fmla="*/ 46 h 49"/>
                    <a:gd name="T4" fmla="*/ 84 w 94"/>
                    <a:gd name="T5" fmla="*/ 43 h 49"/>
                    <a:gd name="T6" fmla="*/ 80 w 94"/>
                    <a:gd name="T7" fmla="*/ 41 h 49"/>
                    <a:gd name="T8" fmla="*/ 74 w 94"/>
                    <a:gd name="T9" fmla="*/ 38 h 49"/>
                    <a:gd name="T10" fmla="*/ 70 w 94"/>
                    <a:gd name="T11" fmla="*/ 35 h 49"/>
                    <a:gd name="T12" fmla="*/ 64 w 94"/>
                    <a:gd name="T13" fmla="*/ 33 h 49"/>
                    <a:gd name="T14" fmla="*/ 60 w 94"/>
                    <a:gd name="T15" fmla="*/ 31 h 49"/>
                    <a:gd name="T16" fmla="*/ 56 w 94"/>
                    <a:gd name="T17" fmla="*/ 28 h 49"/>
                    <a:gd name="T18" fmla="*/ 50 w 94"/>
                    <a:gd name="T19" fmla="*/ 25 h 49"/>
                    <a:gd name="T20" fmla="*/ 45 w 94"/>
                    <a:gd name="T21" fmla="*/ 22 h 49"/>
                    <a:gd name="T22" fmla="*/ 40 w 94"/>
                    <a:gd name="T23" fmla="*/ 20 h 49"/>
                    <a:gd name="T24" fmla="*/ 35 w 94"/>
                    <a:gd name="T25" fmla="*/ 18 h 49"/>
                    <a:gd name="T26" fmla="*/ 30 w 94"/>
                    <a:gd name="T27" fmla="*/ 15 h 49"/>
                    <a:gd name="T28" fmla="*/ 25 w 94"/>
                    <a:gd name="T29" fmla="*/ 12 h 49"/>
                    <a:gd name="T30" fmla="*/ 20 w 94"/>
                    <a:gd name="T31" fmla="*/ 10 h 49"/>
                    <a:gd name="T32" fmla="*/ 15 w 94"/>
                    <a:gd name="T33" fmla="*/ 8 h 49"/>
                    <a:gd name="T34" fmla="*/ 10 w 94"/>
                    <a:gd name="T35" fmla="*/ 5 h 49"/>
                    <a:gd name="T36" fmla="*/ 5 w 94"/>
                    <a:gd name="T37" fmla="*/ 3 h 49"/>
                    <a:gd name="T38" fmla="*/ 0 w 94"/>
                    <a:gd name="T39" fmla="*/ 0 h 4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</a:cxnLst>
                  <a:rect l="0" t="0" r="r" b="b"/>
                  <a:pathLst>
                    <a:path w="94" h="49">
                      <a:moveTo>
                        <a:pt x="94" y="49"/>
                      </a:moveTo>
                      <a:lnTo>
                        <a:pt x="88" y="46"/>
                      </a:lnTo>
                      <a:lnTo>
                        <a:pt x="84" y="43"/>
                      </a:lnTo>
                      <a:lnTo>
                        <a:pt x="80" y="41"/>
                      </a:lnTo>
                      <a:lnTo>
                        <a:pt x="74" y="38"/>
                      </a:lnTo>
                      <a:lnTo>
                        <a:pt x="70" y="35"/>
                      </a:lnTo>
                      <a:lnTo>
                        <a:pt x="64" y="33"/>
                      </a:lnTo>
                      <a:lnTo>
                        <a:pt x="60" y="31"/>
                      </a:lnTo>
                      <a:lnTo>
                        <a:pt x="56" y="28"/>
                      </a:lnTo>
                      <a:lnTo>
                        <a:pt x="50" y="25"/>
                      </a:lnTo>
                      <a:lnTo>
                        <a:pt x="45" y="22"/>
                      </a:lnTo>
                      <a:lnTo>
                        <a:pt x="40" y="20"/>
                      </a:lnTo>
                      <a:lnTo>
                        <a:pt x="35" y="18"/>
                      </a:lnTo>
                      <a:lnTo>
                        <a:pt x="30" y="15"/>
                      </a:lnTo>
                      <a:lnTo>
                        <a:pt x="25" y="12"/>
                      </a:lnTo>
                      <a:lnTo>
                        <a:pt x="20" y="10"/>
                      </a:lnTo>
                      <a:lnTo>
                        <a:pt x="15" y="8"/>
                      </a:lnTo>
                      <a:lnTo>
                        <a:pt x="10" y="5"/>
                      </a:lnTo>
                      <a:lnTo>
                        <a:pt x="5" y="3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2" name="Freeform 46"/>
                <p:cNvSpPr/>
                <p:nvPr/>
              </p:nvSpPr>
              <p:spPr bwMode="auto">
                <a:xfrm>
                  <a:off x="4412" y="1043"/>
                  <a:ext cx="89" cy="56"/>
                </a:xfrm>
                <a:custGeom>
                  <a:avLst/>
                  <a:gdLst>
                    <a:gd name="T0" fmla="*/ 2 w 89"/>
                    <a:gd name="T1" fmla="*/ 0 h 56"/>
                    <a:gd name="T2" fmla="*/ 5 w 89"/>
                    <a:gd name="T3" fmla="*/ 3 h 56"/>
                    <a:gd name="T4" fmla="*/ 7 w 89"/>
                    <a:gd name="T5" fmla="*/ 4 h 56"/>
                    <a:gd name="T6" fmla="*/ 10 w 89"/>
                    <a:gd name="T7" fmla="*/ 6 h 56"/>
                    <a:gd name="T8" fmla="*/ 13 w 89"/>
                    <a:gd name="T9" fmla="*/ 7 h 56"/>
                    <a:gd name="T10" fmla="*/ 16 w 89"/>
                    <a:gd name="T11" fmla="*/ 9 h 56"/>
                    <a:gd name="T12" fmla="*/ 19 w 89"/>
                    <a:gd name="T13" fmla="*/ 10 h 56"/>
                    <a:gd name="T14" fmla="*/ 22 w 89"/>
                    <a:gd name="T15" fmla="*/ 13 h 56"/>
                    <a:gd name="T16" fmla="*/ 25 w 89"/>
                    <a:gd name="T17" fmla="*/ 15 h 56"/>
                    <a:gd name="T18" fmla="*/ 27 w 89"/>
                    <a:gd name="T19" fmla="*/ 16 h 56"/>
                    <a:gd name="T20" fmla="*/ 30 w 89"/>
                    <a:gd name="T21" fmla="*/ 17 h 56"/>
                    <a:gd name="T22" fmla="*/ 33 w 89"/>
                    <a:gd name="T23" fmla="*/ 19 h 56"/>
                    <a:gd name="T24" fmla="*/ 36 w 89"/>
                    <a:gd name="T25" fmla="*/ 22 h 56"/>
                    <a:gd name="T26" fmla="*/ 39 w 89"/>
                    <a:gd name="T27" fmla="*/ 23 h 56"/>
                    <a:gd name="T28" fmla="*/ 42 w 89"/>
                    <a:gd name="T29" fmla="*/ 25 h 56"/>
                    <a:gd name="T30" fmla="*/ 45 w 89"/>
                    <a:gd name="T31" fmla="*/ 26 h 56"/>
                    <a:gd name="T32" fmla="*/ 48 w 89"/>
                    <a:gd name="T33" fmla="*/ 29 h 56"/>
                    <a:gd name="T34" fmla="*/ 50 w 89"/>
                    <a:gd name="T35" fmla="*/ 30 h 56"/>
                    <a:gd name="T36" fmla="*/ 53 w 89"/>
                    <a:gd name="T37" fmla="*/ 32 h 56"/>
                    <a:gd name="T38" fmla="*/ 56 w 89"/>
                    <a:gd name="T39" fmla="*/ 33 h 56"/>
                    <a:gd name="T40" fmla="*/ 59 w 89"/>
                    <a:gd name="T41" fmla="*/ 36 h 56"/>
                    <a:gd name="T42" fmla="*/ 62 w 89"/>
                    <a:gd name="T43" fmla="*/ 37 h 56"/>
                    <a:gd name="T44" fmla="*/ 65 w 89"/>
                    <a:gd name="T45" fmla="*/ 39 h 56"/>
                    <a:gd name="T46" fmla="*/ 68 w 89"/>
                    <a:gd name="T47" fmla="*/ 40 h 56"/>
                    <a:gd name="T48" fmla="*/ 70 w 89"/>
                    <a:gd name="T49" fmla="*/ 43 h 56"/>
                    <a:gd name="T50" fmla="*/ 73 w 89"/>
                    <a:gd name="T51" fmla="*/ 45 h 56"/>
                    <a:gd name="T52" fmla="*/ 76 w 89"/>
                    <a:gd name="T53" fmla="*/ 46 h 56"/>
                    <a:gd name="T54" fmla="*/ 79 w 89"/>
                    <a:gd name="T55" fmla="*/ 49 h 56"/>
                    <a:gd name="T56" fmla="*/ 81 w 89"/>
                    <a:gd name="T57" fmla="*/ 50 h 56"/>
                    <a:gd name="T58" fmla="*/ 83 w 89"/>
                    <a:gd name="T59" fmla="*/ 52 h 56"/>
                    <a:gd name="T60" fmla="*/ 86 w 89"/>
                    <a:gd name="T61" fmla="*/ 55 h 56"/>
                    <a:gd name="T62" fmla="*/ 89 w 89"/>
                    <a:gd name="T63" fmla="*/ 56 h 5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</a:cxnLst>
                  <a:rect l="0" t="0" r="r" b="b"/>
                  <a:pathLst>
                    <a:path w="89" h="56">
                      <a:moveTo>
                        <a:pt x="0" y="0"/>
                      </a:moveTo>
                      <a:lnTo>
                        <a:pt x="2" y="0"/>
                      </a:lnTo>
                      <a:lnTo>
                        <a:pt x="3" y="2"/>
                      </a:lnTo>
                      <a:lnTo>
                        <a:pt x="5" y="3"/>
                      </a:lnTo>
                      <a:lnTo>
                        <a:pt x="6" y="3"/>
                      </a:lnTo>
                      <a:lnTo>
                        <a:pt x="7" y="4"/>
                      </a:lnTo>
                      <a:lnTo>
                        <a:pt x="9" y="4"/>
                      </a:lnTo>
                      <a:lnTo>
                        <a:pt x="10" y="6"/>
                      </a:lnTo>
                      <a:lnTo>
                        <a:pt x="12" y="6"/>
                      </a:lnTo>
                      <a:lnTo>
                        <a:pt x="13" y="7"/>
                      </a:lnTo>
                      <a:lnTo>
                        <a:pt x="15" y="9"/>
                      </a:lnTo>
                      <a:lnTo>
                        <a:pt x="16" y="9"/>
                      </a:lnTo>
                      <a:lnTo>
                        <a:pt x="17" y="10"/>
                      </a:lnTo>
                      <a:lnTo>
                        <a:pt x="19" y="10"/>
                      </a:lnTo>
                      <a:lnTo>
                        <a:pt x="20" y="12"/>
                      </a:lnTo>
                      <a:lnTo>
                        <a:pt x="22" y="13"/>
                      </a:lnTo>
                      <a:lnTo>
                        <a:pt x="23" y="13"/>
                      </a:lnTo>
                      <a:lnTo>
                        <a:pt x="25" y="15"/>
                      </a:lnTo>
                      <a:lnTo>
                        <a:pt x="26" y="15"/>
                      </a:lnTo>
                      <a:lnTo>
                        <a:pt x="27" y="16"/>
                      </a:lnTo>
                      <a:lnTo>
                        <a:pt x="29" y="17"/>
                      </a:lnTo>
                      <a:lnTo>
                        <a:pt x="30" y="17"/>
                      </a:lnTo>
                      <a:lnTo>
                        <a:pt x="32" y="19"/>
                      </a:lnTo>
                      <a:lnTo>
                        <a:pt x="33" y="19"/>
                      </a:lnTo>
                      <a:lnTo>
                        <a:pt x="35" y="20"/>
                      </a:lnTo>
                      <a:lnTo>
                        <a:pt x="36" y="22"/>
                      </a:lnTo>
                      <a:lnTo>
                        <a:pt x="38" y="22"/>
                      </a:lnTo>
                      <a:lnTo>
                        <a:pt x="39" y="23"/>
                      </a:lnTo>
                      <a:lnTo>
                        <a:pt x="40" y="25"/>
                      </a:lnTo>
                      <a:lnTo>
                        <a:pt x="42" y="25"/>
                      </a:lnTo>
                      <a:lnTo>
                        <a:pt x="43" y="26"/>
                      </a:lnTo>
                      <a:lnTo>
                        <a:pt x="45" y="26"/>
                      </a:lnTo>
                      <a:lnTo>
                        <a:pt x="46" y="27"/>
                      </a:lnTo>
                      <a:lnTo>
                        <a:pt x="48" y="29"/>
                      </a:lnTo>
                      <a:lnTo>
                        <a:pt x="49" y="29"/>
                      </a:lnTo>
                      <a:lnTo>
                        <a:pt x="50" y="30"/>
                      </a:lnTo>
                      <a:lnTo>
                        <a:pt x="52" y="30"/>
                      </a:lnTo>
                      <a:lnTo>
                        <a:pt x="53" y="32"/>
                      </a:lnTo>
                      <a:lnTo>
                        <a:pt x="55" y="33"/>
                      </a:lnTo>
                      <a:lnTo>
                        <a:pt x="56" y="33"/>
                      </a:lnTo>
                      <a:lnTo>
                        <a:pt x="58" y="35"/>
                      </a:lnTo>
                      <a:lnTo>
                        <a:pt x="59" y="36"/>
                      </a:lnTo>
                      <a:lnTo>
                        <a:pt x="60" y="36"/>
                      </a:lnTo>
                      <a:lnTo>
                        <a:pt x="62" y="37"/>
                      </a:lnTo>
                      <a:lnTo>
                        <a:pt x="63" y="39"/>
                      </a:lnTo>
                      <a:lnTo>
                        <a:pt x="65" y="39"/>
                      </a:lnTo>
                      <a:lnTo>
                        <a:pt x="66" y="40"/>
                      </a:lnTo>
                      <a:lnTo>
                        <a:pt x="68" y="40"/>
                      </a:lnTo>
                      <a:lnTo>
                        <a:pt x="69" y="42"/>
                      </a:lnTo>
                      <a:lnTo>
                        <a:pt x="70" y="43"/>
                      </a:lnTo>
                      <a:lnTo>
                        <a:pt x="72" y="43"/>
                      </a:lnTo>
                      <a:lnTo>
                        <a:pt x="73" y="45"/>
                      </a:lnTo>
                      <a:lnTo>
                        <a:pt x="75" y="46"/>
                      </a:lnTo>
                      <a:lnTo>
                        <a:pt x="76" y="46"/>
                      </a:lnTo>
                      <a:lnTo>
                        <a:pt x="78" y="48"/>
                      </a:lnTo>
                      <a:lnTo>
                        <a:pt x="79" y="49"/>
                      </a:lnTo>
                      <a:lnTo>
                        <a:pt x="81" y="49"/>
                      </a:lnTo>
                      <a:lnTo>
                        <a:pt x="81" y="50"/>
                      </a:lnTo>
                      <a:lnTo>
                        <a:pt x="82" y="52"/>
                      </a:lnTo>
                      <a:lnTo>
                        <a:pt x="83" y="52"/>
                      </a:lnTo>
                      <a:lnTo>
                        <a:pt x="85" y="53"/>
                      </a:lnTo>
                      <a:lnTo>
                        <a:pt x="86" y="55"/>
                      </a:lnTo>
                      <a:lnTo>
                        <a:pt x="88" y="55"/>
                      </a:lnTo>
                      <a:lnTo>
                        <a:pt x="89" y="56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4" name="Line 48"/>
                <p:cNvSpPr>
                  <a:spLocks noChangeShapeType="1"/>
                </p:cNvSpPr>
                <p:nvPr/>
              </p:nvSpPr>
              <p:spPr bwMode="auto">
                <a:xfrm flipV="1">
                  <a:off x="4379" y="1046"/>
                  <a:ext cx="32" cy="55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5" name="Rectangle 49"/>
                <p:cNvSpPr>
                  <a:spLocks noChangeArrowheads="1"/>
                </p:cNvSpPr>
                <p:nvPr/>
              </p:nvSpPr>
              <p:spPr bwMode="auto">
                <a:xfrm rot="18540000">
                  <a:off x="4914" y="536"/>
                  <a:ext cx="263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HE-A1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6" name="Line 50"/>
                <p:cNvSpPr>
                  <a:spLocks noChangeShapeType="1"/>
                </p:cNvSpPr>
                <p:nvPr/>
              </p:nvSpPr>
              <p:spPr bwMode="auto">
                <a:xfrm flipV="1">
                  <a:off x="4544" y="794"/>
                  <a:ext cx="347" cy="420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7" name="Freeform 51"/>
                <p:cNvSpPr/>
                <p:nvPr/>
              </p:nvSpPr>
              <p:spPr bwMode="auto">
                <a:xfrm>
                  <a:off x="4378" y="1103"/>
                  <a:ext cx="84" cy="54"/>
                </a:xfrm>
                <a:custGeom>
                  <a:avLst/>
                  <a:gdLst>
                    <a:gd name="T0" fmla="*/ 84 w 84"/>
                    <a:gd name="T1" fmla="*/ 54 h 54"/>
                    <a:gd name="T2" fmla="*/ 80 w 84"/>
                    <a:gd name="T3" fmla="*/ 51 h 54"/>
                    <a:gd name="T4" fmla="*/ 76 w 84"/>
                    <a:gd name="T5" fmla="*/ 46 h 54"/>
                    <a:gd name="T6" fmla="*/ 72 w 84"/>
                    <a:gd name="T7" fmla="*/ 43 h 54"/>
                    <a:gd name="T8" fmla="*/ 67 w 84"/>
                    <a:gd name="T9" fmla="*/ 41 h 54"/>
                    <a:gd name="T10" fmla="*/ 63 w 84"/>
                    <a:gd name="T11" fmla="*/ 38 h 54"/>
                    <a:gd name="T12" fmla="*/ 59 w 84"/>
                    <a:gd name="T13" fmla="*/ 35 h 54"/>
                    <a:gd name="T14" fmla="*/ 54 w 84"/>
                    <a:gd name="T15" fmla="*/ 32 h 54"/>
                    <a:gd name="T16" fmla="*/ 50 w 84"/>
                    <a:gd name="T17" fmla="*/ 29 h 54"/>
                    <a:gd name="T18" fmla="*/ 46 w 84"/>
                    <a:gd name="T19" fmla="*/ 26 h 54"/>
                    <a:gd name="T20" fmla="*/ 41 w 84"/>
                    <a:gd name="T21" fmla="*/ 23 h 54"/>
                    <a:gd name="T22" fmla="*/ 36 w 84"/>
                    <a:gd name="T23" fmla="*/ 22 h 54"/>
                    <a:gd name="T24" fmla="*/ 31 w 84"/>
                    <a:gd name="T25" fmla="*/ 19 h 54"/>
                    <a:gd name="T26" fmla="*/ 27 w 84"/>
                    <a:gd name="T27" fmla="*/ 16 h 54"/>
                    <a:gd name="T28" fmla="*/ 23 w 84"/>
                    <a:gd name="T29" fmla="*/ 13 h 54"/>
                    <a:gd name="T30" fmla="*/ 18 w 84"/>
                    <a:gd name="T31" fmla="*/ 10 h 54"/>
                    <a:gd name="T32" fmla="*/ 14 w 84"/>
                    <a:gd name="T33" fmla="*/ 8 h 54"/>
                    <a:gd name="T34" fmla="*/ 8 w 84"/>
                    <a:gd name="T35" fmla="*/ 5 h 54"/>
                    <a:gd name="T36" fmla="*/ 4 w 84"/>
                    <a:gd name="T37" fmla="*/ 2 h 54"/>
                    <a:gd name="T38" fmla="*/ 0 w 84"/>
                    <a:gd name="T39" fmla="*/ 0 h 5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</a:cxnLst>
                  <a:rect l="0" t="0" r="r" b="b"/>
                  <a:pathLst>
                    <a:path w="84" h="54">
                      <a:moveTo>
                        <a:pt x="84" y="54"/>
                      </a:moveTo>
                      <a:lnTo>
                        <a:pt x="80" y="51"/>
                      </a:lnTo>
                      <a:lnTo>
                        <a:pt x="76" y="46"/>
                      </a:lnTo>
                      <a:lnTo>
                        <a:pt x="72" y="43"/>
                      </a:lnTo>
                      <a:lnTo>
                        <a:pt x="67" y="41"/>
                      </a:lnTo>
                      <a:lnTo>
                        <a:pt x="63" y="38"/>
                      </a:lnTo>
                      <a:lnTo>
                        <a:pt x="59" y="35"/>
                      </a:lnTo>
                      <a:lnTo>
                        <a:pt x="54" y="32"/>
                      </a:lnTo>
                      <a:lnTo>
                        <a:pt x="50" y="29"/>
                      </a:lnTo>
                      <a:lnTo>
                        <a:pt x="46" y="26"/>
                      </a:lnTo>
                      <a:lnTo>
                        <a:pt x="41" y="23"/>
                      </a:lnTo>
                      <a:lnTo>
                        <a:pt x="36" y="22"/>
                      </a:lnTo>
                      <a:lnTo>
                        <a:pt x="31" y="19"/>
                      </a:lnTo>
                      <a:lnTo>
                        <a:pt x="27" y="16"/>
                      </a:lnTo>
                      <a:lnTo>
                        <a:pt x="23" y="13"/>
                      </a:lnTo>
                      <a:lnTo>
                        <a:pt x="18" y="10"/>
                      </a:lnTo>
                      <a:lnTo>
                        <a:pt x="14" y="8"/>
                      </a:lnTo>
                      <a:lnTo>
                        <a:pt x="8" y="5"/>
                      </a:lnTo>
                      <a:lnTo>
                        <a:pt x="4" y="2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8" name="Freeform 52"/>
                <p:cNvSpPr/>
                <p:nvPr/>
              </p:nvSpPr>
              <p:spPr bwMode="auto">
                <a:xfrm>
                  <a:off x="4462" y="1157"/>
                  <a:ext cx="81" cy="60"/>
                </a:xfrm>
                <a:custGeom>
                  <a:avLst/>
                  <a:gdLst>
                    <a:gd name="T0" fmla="*/ 2 w 81"/>
                    <a:gd name="T1" fmla="*/ 0 h 60"/>
                    <a:gd name="T2" fmla="*/ 5 w 81"/>
                    <a:gd name="T3" fmla="*/ 1 h 60"/>
                    <a:gd name="T4" fmla="*/ 6 w 81"/>
                    <a:gd name="T5" fmla="*/ 2 h 60"/>
                    <a:gd name="T6" fmla="*/ 9 w 81"/>
                    <a:gd name="T7" fmla="*/ 4 h 60"/>
                    <a:gd name="T8" fmla="*/ 10 w 81"/>
                    <a:gd name="T9" fmla="*/ 5 h 60"/>
                    <a:gd name="T10" fmla="*/ 13 w 81"/>
                    <a:gd name="T11" fmla="*/ 7 h 60"/>
                    <a:gd name="T12" fmla="*/ 15 w 81"/>
                    <a:gd name="T13" fmla="*/ 10 h 60"/>
                    <a:gd name="T14" fmla="*/ 18 w 81"/>
                    <a:gd name="T15" fmla="*/ 11 h 60"/>
                    <a:gd name="T16" fmla="*/ 19 w 81"/>
                    <a:gd name="T17" fmla="*/ 12 h 60"/>
                    <a:gd name="T18" fmla="*/ 22 w 81"/>
                    <a:gd name="T19" fmla="*/ 14 h 60"/>
                    <a:gd name="T20" fmla="*/ 23 w 81"/>
                    <a:gd name="T21" fmla="*/ 15 h 60"/>
                    <a:gd name="T22" fmla="*/ 26 w 81"/>
                    <a:gd name="T23" fmla="*/ 17 h 60"/>
                    <a:gd name="T24" fmla="*/ 28 w 81"/>
                    <a:gd name="T25" fmla="*/ 18 h 60"/>
                    <a:gd name="T26" fmla="*/ 31 w 81"/>
                    <a:gd name="T27" fmla="*/ 20 h 60"/>
                    <a:gd name="T28" fmla="*/ 32 w 81"/>
                    <a:gd name="T29" fmla="*/ 21 h 60"/>
                    <a:gd name="T30" fmla="*/ 35 w 81"/>
                    <a:gd name="T31" fmla="*/ 22 h 60"/>
                    <a:gd name="T32" fmla="*/ 36 w 81"/>
                    <a:gd name="T33" fmla="*/ 25 h 60"/>
                    <a:gd name="T34" fmla="*/ 39 w 81"/>
                    <a:gd name="T35" fmla="*/ 27 h 60"/>
                    <a:gd name="T36" fmla="*/ 41 w 81"/>
                    <a:gd name="T37" fmla="*/ 28 h 60"/>
                    <a:gd name="T38" fmla="*/ 43 w 81"/>
                    <a:gd name="T39" fmla="*/ 30 h 60"/>
                    <a:gd name="T40" fmla="*/ 45 w 81"/>
                    <a:gd name="T41" fmla="*/ 31 h 60"/>
                    <a:gd name="T42" fmla="*/ 48 w 81"/>
                    <a:gd name="T43" fmla="*/ 33 h 60"/>
                    <a:gd name="T44" fmla="*/ 49 w 81"/>
                    <a:gd name="T45" fmla="*/ 34 h 60"/>
                    <a:gd name="T46" fmla="*/ 52 w 81"/>
                    <a:gd name="T47" fmla="*/ 35 h 60"/>
                    <a:gd name="T48" fmla="*/ 53 w 81"/>
                    <a:gd name="T49" fmla="*/ 38 h 60"/>
                    <a:gd name="T50" fmla="*/ 56 w 81"/>
                    <a:gd name="T51" fmla="*/ 40 h 60"/>
                    <a:gd name="T52" fmla="*/ 58 w 81"/>
                    <a:gd name="T53" fmla="*/ 41 h 60"/>
                    <a:gd name="T54" fmla="*/ 61 w 81"/>
                    <a:gd name="T55" fmla="*/ 43 h 60"/>
                    <a:gd name="T56" fmla="*/ 62 w 81"/>
                    <a:gd name="T57" fmla="*/ 44 h 60"/>
                    <a:gd name="T58" fmla="*/ 65 w 81"/>
                    <a:gd name="T59" fmla="*/ 45 h 60"/>
                    <a:gd name="T60" fmla="*/ 66 w 81"/>
                    <a:gd name="T61" fmla="*/ 47 h 60"/>
                    <a:gd name="T62" fmla="*/ 68 w 81"/>
                    <a:gd name="T63" fmla="*/ 50 h 60"/>
                    <a:gd name="T64" fmla="*/ 71 w 81"/>
                    <a:gd name="T65" fmla="*/ 51 h 60"/>
                    <a:gd name="T66" fmla="*/ 72 w 81"/>
                    <a:gd name="T67" fmla="*/ 53 h 60"/>
                    <a:gd name="T68" fmla="*/ 75 w 81"/>
                    <a:gd name="T69" fmla="*/ 54 h 60"/>
                    <a:gd name="T70" fmla="*/ 76 w 81"/>
                    <a:gd name="T71" fmla="*/ 55 h 60"/>
                    <a:gd name="T72" fmla="*/ 79 w 81"/>
                    <a:gd name="T73" fmla="*/ 57 h 60"/>
                    <a:gd name="T74" fmla="*/ 81 w 81"/>
                    <a:gd name="T75" fmla="*/ 60 h 6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</a:cxnLst>
                  <a:rect l="0" t="0" r="r" b="b"/>
                  <a:pathLst>
                    <a:path w="81" h="60">
                      <a:moveTo>
                        <a:pt x="0" y="0"/>
                      </a:moveTo>
                      <a:lnTo>
                        <a:pt x="2" y="0"/>
                      </a:lnTo>
                      <a:lnTo>
                        <a:pt x="3" y="1"/>
                      </a:lnTo>
                      <a:lnTo>
                        <a:pt x="5" y="1"/>
                      </a:lnTo>
                      <a:lnTo>
                        <a:pt x="5" y="2"/>
                      </a:lnTo>
                      <a:lnTo>
                        <a:pt x="6" y="2"/>
                      </a:lnTo>
                      <a:lnTo>
                        <a:pt x="8" y="4"/>
                      </a:lnTo>
                      <a:lnTo>
                        <a:pt x="9" y="4"/>
                      </a:lnTo>
                      <a:lnTo>
                        <a:pt x="9" y="5"/>
                      </a:lnTo>
                      <a:lnTo>
                        <a:pt x="10" y="5"/>
                      </a:lnTo>
                      <a:lnTo>
                        <a:pt x="12" y="7"/>
                      </a:lnTo>
                      <a:lnTo>
                        <a:pt x="13" y="7"/>
                      </a:lnTo>
                      <a:lnTo>
                        <a:pt x="15" y="8"/>
                      </a:lnTo>
                      <a:lnTo>
                        <a:pt x="15" y="10"/>
                      </a:lnTo>
                      <a:lnTo>
                        <a:pt x="16" y="10"/>
                      </a:lnTo>
                      <a:lnTo>
                        <a:pt x="18" y="11"/>
                      </a:lnTo>
                      <a:lnTo>
                        <a:pt x="19" y="11"/>
                      </a:lnTo>
                      <a:lnTo>
                        <a:pt x="19" y="12"/>
                      </a:lnTo>
                      <a:lnTo>
                        <a:pt x="20" y="12"/>
                      </a:lnTo>
                      <a:lnTo>
                        <a:pt x="22" y="14"/>
                      </a:lnTo>
                      <a:lnTo>
                        <a:pt x="23" y="14"/>
                      </a:lnTo>
                      <a:lnTo>
                        <a:pt x="23" y="15"/>
                      </a:lnTo>
                      <a:lnTo>
                        <a:pt x="25" y="15"/>
                      </a:lnTo>
                      <a:lnTo>
                        <a:pt x="26" y="17"/>
                      </a:lnTo>
                      <a:lnTo>
                        <a:pt x="28" y="18"/>
                      </a:lnTo>
                      <a:lnTo>
                        <a:pt x="28" y="18"/>
                      </a:lnTo>
                      <a:lnTo>
                        <a:pt x="29" y="20"/>
                      </a:lnTo>
                      <a:lnTo>
                        <a:pt x="31" y="20"/>
                      </a:lnTo>
                      <a:lnTo>
                        <a:pt x="32" y="21"/>
                      </a:lnTo>
                      <a:lnTo>
                        <a:pt x="32" y="21"/>
                      </a:lnTo>
                      <a:lnTo>
                        <a:pt x="33" y="22"/>
                      </a:lnTo>
                      <a:lnTo>
                        <a:pt x="35" y="22"/>
                      </a:lnTo>
                      <a:lnTo>
                        <a:pt x="36" y="24"/>
                      </a:lnTo>
                      <a:lnTo>
                        <a:pt x="36" y="25"/>
                      </a:lnTo>
                      <a:lnTo>
                        <a:pt x="38" y="25"/>
                      </a:lnTo>
                      <a:lnTo>
                        <a:pt x="39" y="27"/>
                      </a:lnTo>
                      <a:lnTo>
                        <a:pt x="41" y="27"/>
                      </a:lnTo>
                      <a:lnTo>
                        <a:pt x="41" y="28"/>
                      </a:lnTo>
                      <a:lnTo>
                        <a:pt x="42" y="28"/>
                      </a:lnTo>
                      <a:lnTo>
                        <a:pt x="43" y="30"/>
                      </a:lnTo>
                      <a:lnTo>
                        <a:pt x="45" y="30"/>
                      </a:lnTo>
                      <a:lnTo>
                        <a:pt x="45" y="31"/>
                      </a:lnTo>
                      <a:lnTo>
                        <a:pt x="46" y="33"/>
                      </a:lnTo>
                      <a:lnTo>
                        <a:pt x="48" y="33"/>
                      </a:lnTo>
                      <a:lnTo>
                        <a:pt x="49" y="34"/>
                      </a:lnTo>
                      <a:lnTo>
                        <a:pt x="49" y="34"/>
                      </a:lnTo>
                      <a:lnTo>
                        <a:pt x="51" y="35"/>
                      </a:lnTo>
                      <a:lnTo>
                        <a:pt x="52" y="35"/>
                      </a:lnTo>
                      <a:lnTo>
                        <a:pt x="52" y="37"/>
                      </a:lnTo>
                      <a:lnTo>
                        <a:pt x="53" y="38"/>
                      </a:lnTo>
                      <a:lnTo>
                        <a:pt x="55" y="38"/>
                      </a:lnTo>
                      <a:lnTo>
                        <a:pt x="56" y="40"/>
                      </a:lnTo>
                      <a:lnTo>
                        <a:pt x="56" y="40"/>
                      </a:lnTo>
                      <a:lnTo>
                        <a:pt x="58" y="41"/>
                      </a:lnTo>
                      <a:lnTo>
                        <a:pt x="59" y="41"/>
                      </a:lnTo>
                      <a:lnTo>
                        <a:pt x="61" y="43"/>
                      </a:lnTo>
                      <a:lnTo>
                        <a:pt x="61" y="44"/>
                      </a:lnTo>
                      <a:lnTo>
                        <a:pt x="62" y="44"/>
                      </a:lnTo>
                      <a:lnTo>
                        <a:pt x="64" y="45"/>
                      </a:lnTo>
                      <a:lnTo>
                        <a:pt x="65" y="45"/>
                      </a:lnTo>
                      <a:lnTo>
                        <a:pt x="65" y="47"/>
                      </a:lnTo>
                      <a:lnTo>
                        <a:pt x="66" y="47"/>
                      </a:lnTo>
                      <a:lnTo>
                        <a:pt x="68" y="48"/>
                      </a:lnTo>
                      <a:lnTo>
                        <a:pt x="68" y="50"/>
                      </a:lnTo>
                      <a:lnTo>
                        <a:pt x="69" y="50"/>
                      </a:lnTo>
                      <a:lnTo>
                        <a:pt x="71" y="51"/>
                      </a:lnTo>
                      <a:lnTo>
                        <a:pt x="72" y="51"/>
                      </a:lnTo>
                      <a:lnTo>
                        <a:pt x="72" y="53"/>
                      </a:lnTo>
                      <a:lnTo>
                        <a:pt x="74" y="54"/>
                      </a:lnTo>
                      <a:lnTo>
                        <a:pt x="75" y="54"/>
                      </a:lnTo>
                      <a:lnTo>
                        <a:pt x="76" y="55"/>
                      </a:lnTo>
                      <a:lnTo>
                        <a:pt x="76" y="55"/>
                      </a:lnTo>
                      <a:lnTo>
                        <a:pt x="78" y="57"/>
                      </a:lnTo>
                      <a:lnTo>
                        <a:pt x="79" y="57"/>
                      </a:lnTo>
                      <a:lnTo>
                        <a:pt x="79" y="58"/>
                      </a:lnTo>
                      <a:lnTo>
                        <a:pt x="81" y="6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70" name="Line 54"/>
                <p:cNvSpPr>
                  <a:spLocks noChangeShapeType="1"/>
                </p:cNvSpPr>
                <p:nvPr/>
              </p:nvSpPr>
              <p:spPr bwMode="auto">
                <a:xfrm flipV="1">
                  <a:off x="4425" y="1159"/>
                  <a:ext cx="36" cy="52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71" name="Rectangle 55"/>
                <p:cNvSpPr>
                  <a:spLocks noChangeArrowheads="1"/>
                </p:cNvSpPr>
                <p:nvPr/>
              </p:nvSpPr>
              <p:spPr bwMode="auto">
                <a:xfrm rot="18840000">
                  <a:off x="5050" y="627"/>
                  <a:ext cx="315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RQC-A1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72" name="Line 56"/>
                <p:cNvSpPr>
                  <a:spLocks noChangeShapeType="1"/>
                </p:cNvSpPr>
                <p:nvPr/>
              </p:nvSpPr>
              <p:spPr bwMode="auto">
                <a:xfrm flipV="1">
                  <a:off x="4571" y="891"/>
                  <a:ext cx="431" cy="439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73" name="Freeform 57"/>
                <p:cNvSpPr/>
                <p:nvPr/>
              </p:nvSpPr>
              <p:spPr bwMode="auto">
                <a:xfrm>
                  <a:off x="4424" y="1212"/>
                  <a:ext cx="76" cy="58"/>
                </a:xfrm>
                <a:custGeom>
                  <a:avLst/>
                  <a:gdLst>
                    <a:gd name="T0" fmla="*/ 76 w 76"/>
                    <a:gd name="T1" fmla="*/ 58 h 58"/>
                    <a:gd name="T2" fmla="*/ 71 w 76"/>
                    <a:gd name="T3" fmla="*/ 55 h 58"/>
                    <a:gd name="T4" fmla="*/ 67 w 76"/>
                    <a:gd name="T5" fmla="*/ 51 h 58"/>
                    <a:gd name="T6" fmla="*/ 64 w 76"/>
                    <a:gd name="T7" fmla="*/ 48 h 58"/>
                    <a:gd name="T8" fmla="*/ 60 w 76"/>
                    <a:gd name="T9" fmla="*/ 45 h 58"/>
                    <a:gd name="T10" fmla="*/ 56 w 76"/>
                    <a:gd name="T11" fmla="*/ 42 h 58"/>
                    <a:gd name="T12" fmla="*/ 53 w 76"/>
                    <a:gd name="T13" fmla="*/ 39 h 58"/>
                    <a:gd name="T14" fmla="*/ 48 w 76"/>
                    <a:gd name="T15" fmla="*/ 36 h 58"/>
                    <a:gd name="T16" fmla="*/ 44 w 76"/>
                    <a:gd name="T17" fmla="*/ 33 h 58"/>
                    <a:gd name="T18" fmla="*/ 40 w 76"/>
                    <a:gd name="T19" fmla="*/ 29 h 58"/>
                    <a:gd name="T20" fmla="*/ 36 w 76"/>
                    <a:gd name="T21" fmla="*/ 26 h 58"/>
                    <a:gd name="T22" fmla="*/ 33 w 76"/>
                    <a:gd name="T23" fmla="*/ 23 h 58"/>
                    <a:gd name="T24" fmla="*/ 28 w 76"/>
                    <a:gd name="T25" fmla="*/ 21 h 58"/>
                    <a:gd name="T26" fmla="*/ 24 w 76"/>
                    <a:gd name="T27" fmla="*/ 18 h 58"/>
                    <a:gd name="T28" fmla="*/ 20 w 76"/>
                    <a:gd name="T29" fmla="*/ 15 h 58"/>
                    <a:gd name="T30" fmla="*/ 15 w 76"/>
                    <a:gd name="T31" fmla="*/ 12 h 58"/>
                    <a:gd name="T32" fmla="*/ 13 w 76"/>
                    <a:gd name="T33" fmla="*/ 9 h 58"/>
                    <a:gd name="T34" fmla="*/ 8 w 76"/>
                    <a:gd name="T35" fmla="*/ 6 h 58"/>
                    <a:gd name="T36" fmla="*/ 4 w 76"/>
                    <a:gd name="T37" fmla="*/ 3 h 58"/>
                    <a:gd name="T38" fmla="*/ 0 w 76"/>
                    <a:gd name="T39" fmla="*/ 0 h 5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</a:cxnLst>
                  <a:rect l="0" t="0" r="r" b="b"/>
                  <a:pathLst>
                    <a:path w="76" h="58">
                      <a:moveTo>
                        <a:pt x="76" y="58"/>
                      </a:moveTo>
                      <a:lnTo>
                        <a:pt x="71" y="55"/>
                      </a:lnTo>
                      <a:lnTo>
                        <a:pt x="67" y="51"/>
                      </a:lnTo>
                      <a:lnTo>
                        <a:pt x="64" y="48"/>
                      </a:lnTo>
                      <a:lnTo>
                        <a:pt x="60" y="45"/>
                      </a:lnTo>
                      <a:lnTo>
                        <a:pt x="56" y="42"/>
                      </a:lnTo>
                      <a:lnTo>
                        <a:pt x="53" y="39"/>
                      </a:lnTo>
                      <a:lnTo>
                        <a:pt x="48" y="36"/>
                      </a:lnTo>
                      <a:lnTo>
                        <a:pt x="44" y="33"/>
                      </a:lnTo>
                      <a:lnTo>
                        <a:pt x="40" y="29"/>
                      </a:lnTo>
                      <a:lnTo>
                        <a:pt x="36" y="26"/>
                      </a:lnTo>
                      <a:lnTo>
                        <a:pt x="33" y="23"/>
                      </a:lnTo>
                      <a:lnTo>
                        <a:pt x="28" y="21"/>
                      </a:lnTo>
                      <a:lnTo>
                        <a:pt x="24" y="18"/>
                      </a:lnTo>
                      <a:lnTo>
                        <a:pt x="20" y="15"/>
                      </a:lnTo>
                      <a:lnTo>
                        <a:pt x="15" y="12"/>
                      </a:lnTo>
                      <a:lnTo>
                        <a:pt x="13" y="9"/>
                      </a:lnTo>
                      <a:lnTo>
                        <a:pt x="8" y="6"/>
                      </a:lnTo>
                      <a:lnTo>
                        <a:pt x="4" y="3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74" name="Freeform 58"/>
                <p:cNvSpPr/>
                <p:nvPr/>
              </p:nvSpPr>
              <p:spPr bwMode="auto">
                <a:xfrm>
                  <a:off x="4500" y="1270"/>
                  <a:ext cx="70" cy="63"/>
                </a:xfrm>
                <a:custGeom>
                  <a:avLst/>
                  <a:gdLst>
                    <a:gd name="T0" fmla="*/ 0 w 70"/>
                    <a:gd name="T1" fmla="*/ 0 h 63"/>
                    <a:gd name="T2" fmla="*/ 3 w 70"/>
                    <a:gd name="T3" fmla="*/ 1 h 63"/>
                    <a:gd name="T4" fmla="*/ 4 w 70"/>
                    <a:gd name="T5" fmla="*/ 3 h 63"/>
                    <a:gd name="T6" fmla="*/ 5 w 70"/>
                    <a:gd name="T7" fmla="*/ 4 h 63"/>
                    <a:gd name="T8" fmla="*/ 7 w 70"/>
                    <a:gd name="T9" fmla="*/ 6 h 63"/>
                    <a:gd name="T10" fmla="*/ 8 w 70"/>
                    <a:gd name="T11" fmla="*/ 7 h 63"/>
                    <a:gd name="T12" fmla="*/ 10 w 70"/>
                    <a:gd name="T13" fmla="*/ 8 h 63"/>
                    <a:gd name="T14" fmla="*/ 13 w 70"/>
                    <a:gd name="T15" fmla="*/ 10 h 63"/>
                    <a:gd name="T16" fmla="*/ 14 w 70"/>
                    <a:gd name="T17" fmla="*/ 11 h 63"/>
                    <a:gd name="T18" fmla="*/ 15 w 70"/>
                    <a:gd name="T19" fmla="*/ 13 h 63"/>
                    <a:gd name="T20" fmla="*/ 17 w 70"/>
                    <a:gd name="T21" fmla="*/ 14 h 63"/>
                    <a:gd name="T22" fmla="*/ 18 w 70"/>
                    <a:gd name="T23" fmla="*/ 16 h 63"/>
                    <a:gd name="T24" fmla="*/ 20 w 70"/>
                    <a:gd name="T25" fmla="*/ 17 h 63"/>
                    <a:gd name="T26" fmla="*/ 21 w 70"/>
                    <a:gd name="T27" fmla="*/ 19 h 63"/>
                    <a:gd name="T28" fmla="*/ 24 w 70"/>
                    <a:gd name="T29" fmla="*/ 20 h 63"/>
                    <a:gd name="T30" fmla="*/ 26 w 70"/>
                    <a:gd name="T31" fmla="*/ 21 h 63"/>
                    <a:gd name="T32" fmla="*/ 27 w 70"/>
                    <a:gd name="T33" fmla="*/ 23 h 63"/>
                    <a:gd name="T34" fmla="*/ 28 w 70"/>
                    <a:gd name="T35" fmla="*/ 24 h 63"/>
                    <a:gd name="T36" fmla="*/ 30 w 70"/>
                    <a:gd name="T37" fmla="*/ 26 h 63"/>
                    <a:gd name="T38" fmla="*/ 31 w 70"/>
                    <a:gd name="T39" fmla="*/ 27 h 63"/>
                    <a:gd name="T40" fmla="*/ 33 w 70"/>
                    <a:gd name="T41" fmla="*/ 29 h 63"/>
                    <a:gd name="T42" fmla="*/ 36 w 70"/>
                    <a:gd name="T43" fmla="*/ 30 h 63"/>
                    <a:gd name="T44" fmla="*/ 37 w 70"/>
                    <a:gd name="T45" fmla="*/ 31 h 63"/>
                    <a:gd name="T46" fmla="*/ 38 w 70"/>
                    <a:gd name="T47" fmla="*/ 33 h 63"/>
                    <a:gd name="T48" fmla="*/ 40 w 70"/>
                    <a:gd name="T49" fmla="*/ 34 h 63"/>
                    <a:gd name="T50" fmla="*/ 41 w 70"/>
                    <a:gd name="T51" fmla="*/ 36 h 63"/>
                    <a:gd name="T52" fmla="*/ 43 w 70"/>
                    <a:gd name="T53" fmla="*/ 37 h 63"/>
                    <a:gd name="T54" fmla="*/ 44 w 70"/>
                    <a:gd name="T55" fmla="*/ 39 h 63"/>
                    <a:gd name="T56" fmla="*/ 46 w 70"/>
                    <a:gd name="T57" fmla="*/ 40 h 63"/>
                    <a:gd name="T58" fmla="*/ 47 w 70"/>
                    <a:gd name="T59" fmla="*/ 41 h 63"/>
                    <a:gd name="T60" fmla="*/ 50 w 70"/>
                    <a:gd name="T61" fmla="*/ 43 h 63"/>
                    <a:gd name="T62" fmla="*/ 51 w 70"/>
                    <a:gd name="T63" fmla="*/ 44 h 63"/>
                    <a:gd name="T64" fmla="*/ 53 w 70"/>
                    <a:gd name="T65" fmla="*/ 46 h 63"/>
                    <a:gd name="T66" fmla="*/ 54 w 70"/>
                    <a:gd name="T67" fmla="*/ 47 h 63"/>
                    <a:gd name="T68" fmla="*/ 56 w 70"/>
                    <a:gd name="T69" fmla="*/ 49 h 63"/>
                    <a:gd name="T70" fmla="*/ 57 w 70"/>
                    <a:gd name="T71" fmla="*/ 50 h 63"/>
                    <a:gd name="T72" fmla="*/ 59 w 70"/>
                    <a:gd name="T73" fmla="*/ 52 h 63"/>
                    <a:gd name="T74" fmla="*/ 60 w 70"/>
                    <a:gd name="T75" fmla="*/ 53 h 63"/>
                    <a:gd name="T76" fmla="*/ 61 w 70"/>
                    <a:gd name="T77" fmla="*/ 56 h 63"/>
                    <a:gd name="T78" fmla="*/ 63 w 70"/>
                    <a:gd name="T79" fmla="*/ 57 h 63"/>
                    <a:gd name="T80" fmla="*/ 66 w 70"/>
                    <a:gd name="T81" fmla="*/ 59 h 63"/>
                    <a:gd name="T82" fmla="*/ 67 w 70"/>
                    <a:gd name="T83" fmla="*/ 60 h 63"/>
                    <a:gd name="T84" fmla="*/ 69 w 70"/>
                    <a:gd name="T85" fmla="*/ 62 h 63"/>
                    <a:gd name="T86" fmla="*/ 70 w 70"/>
                    <a:gd name="T87" fmla="*/ 63 h 6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</a:cxnLst>
                  <a:rect l="0" t="0" r="r" b="b"/>
                  <a:pathLst>
                    <a:path w="70" h="63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1" y="1"/>
                      </a:lnTo>
                      <a:lnTo>
                        <a:pt x="3" y="1"/>
                      </a:lnTo>
                      <a:lnTo>
                        <a:pt x="3" y="3"/>
                      </a:lnTo>
                      <a:lnTo>
                        <a:pt x="4" y="3"/>
                      </a:lnTo>
                      <a:lnTo>
                        <a:pt x="4" y="4"/>
                      </a:lnTo>
                      <a:lnTo>
                        <a:pt x="5" y="4"/>
                      </a:lnTo>
                      <a:lnTo>
                        <a:pt x="5" y="6"/>
                      </a:lnTo>
                      <a:lnTo>
                        <a:pt x="7" y="6"/>
                      </a:lnTo>
                      <a:lnTo>
                        <a:pt x="8" y="7"/>
                      </a:lnTo>
                      <a:lnTo>
                        <a:pt x="8" y="7"/>
                      </a:lnTo>
                      <a:lnTo>
                        <a:pt x="10" y="8"/>
                      </a:lnTo>
                      <a:lnTo>
                        <a:pt x="10" y="8"/>
                      </a:lnTo>
                      <a:lnTo>
                        <a:pt x="11" y="10"/>
                      </a:lnTo>
                      <a:lnTo>
                        <a:pt x="13" y="10"/>
                      </a:lnTo>
                      <a:lnTo>
                        <a:pt x="13" y="11"/>
                      </a:lnTo>
                      <a:lnTo>
                        <a:pt x="14" y="11"/>
                      </a:lnTo>
                      <a:lnTo>
                        <a:pt x="14" y="13"/>
                      </a:lnTo>
                      <a:lnTo>
                        <a:pt x="15" y="13"/>
                      </a:lnTo>
                      <a:lnTo>
                        <a:pt x="15" y="14"/>
                      </a:lnTo>
                      <a:lnTo>
                        <a:pt x="17" y="14"/>
                      </a:lnTo>
                      <a:lnTo>
                        <a:pt x="18" y="16"/>
                      </a:lnTo>
                      <a:lnTo>
                        <a:pt x="18" y="16"/>
                      </a:lnTo>
                      <a:lnTo>
                        <a:pt x="20" y="17"/>
                      </a:lnTo>
                      <a:lnTo>
                        <a:pt x="20" y="17"/>
                      </a:lnTo>
                      <a:lnTo>
                        <a:pt x="21" y="19"/>
                      </a:lnTo>
                      <a:lnTo>
                        <a:pt x="21" y="19"/>
                      </a:lnTo>
                      <a:lnTo>
                        <a:pt x="23" y="19"/>
                      </a:lnTo>
                      <a:lnTo>
                        <a:pt x="24" y="20"/>
                      </a:lnTo>
                      <a:lnTo>
                        <a:pt x="24" y="20"/>
                      </a:lnTo>
                      <a:lnTo>
                        <a:pt x="26" y="21"/>
                      </a:lnTo>
                      <a:lnTo>
                        <a:pt x="26" y="21"/>
                      </a:lnTo>
                      <a:lnTo>
                        <a:pt x="27" y="23"/>
                      </a:lnTo>
                      <a:lnTo>
                        <a:pt x="27" y="23"/>
                      </a:lnTo>
                      <a:lnTo>
                        <a:pt x="28" y="24"/>
                      </a:lnTo>
                      <a:lnTo>
                        <a:pt x="30" y="24"/>
                      </a:lnTo>
                      <a:lnTo>
                        <a:pt x="30" y="26"/>
                      </a:lnTo>
                      <a:lnTo>
                        <a:pt x="31" y="26"/>
                      </a:lnTo>
                      <a:lnTo>
                        <a:pt x="31" y="27"/>
                      </a:lnTo>
                      <a:lnTo>
                        <a:pt x="33" y="29"/>
                      </a:lnTo>
                      <a:lnTo>
                        <a:pt x="33" y="29"/>
                      </a:lnTo>
                      <a:lnTo>
                        <a:pt x="34" y="30"/>
                      </a:lnTo>
                      <a:lnTo>
                        <a:pt x="36" y="30"/>
                      </a:lnTo>
                      <a:lnTo>
                        <a:pt x="36" y="31"/>
                      </a:lnTo>
                      <a:lnTo>
                        <a:pt x="37" y="31"/>
                      </a:lnTo>
                      <a:lnTo>
                        <a:pt x="37" y="33"/>
                      </a:lnTo>
                      <a:lnTo>
                        <a:pt x="38" y="33"/>
                      </a:lnTo>
                      <a:lnTo>
                        <a:pt x="38" y="34"/>
                      </a:lnTo>
                      <a:lnTo>
                        <a:pt x="40" y="34"/>
                      </a:lnTo>
                      <a:lnTo>
                        <a:pt x="40" y="36"/>
                      </a:lnTo>
                      <a:lnTo>
                        <a:pt x="41" y="36"/>
                      </a:lnTo>
                      <a:lnTo>
                        <a:pt x="43" y="37"/>
                      </a:lnTo>
                      <a:lnTo>
                        <a:pt x="43" y="37"/>
                      </a:lnTo>
                      <a:lnTo>
                        <a:pt x="44" y="39"/>
                      </a:lnTo>
                      <a:lnTo>
                        <a:pt x="44" y="39"/>
                      </a:lnTo>
                      <a:lnTo>
                        <a:pt x="46" y="40"/>
                      </a:lnTo>
                      <a:lnTo>
                        <a:pt x="46" y="40"/>
                      </a:lnTo>
                      <a:lnTo>
                        <a:pt x="47" y="41"/>
                      </a:lnTo>
                      <a:lnTo>
                        <a:pt x="47" y="41"/>
                      </a:lnTo>
                      <a:lnTo>
                        <a:pt x="48" y="43"/>
                      </a:lnTo>
                      <a:lnTo>
                        <a:pt x="50" y="43"/>
                      </a:lnTo>
                      <a:lnTo>
                        <a:pt x="50" y="44"/>
                      </a:lnTo>
                      <a:lnTo>
                        <a:pt x="51" y="44"/>
                      </a:lnTo>
                      <a:lnTo>
                        <a:pt x="51" y="46"/>
                      </a:lnTo>
                      <a:lnTo>
                        <a:pt x="53" y="46"/>
                      </a:lnTo>
                      <a:lnTo>
                        <a:pt x="53" y="47"/>
                      </a:lnTo>
                      <a:lnTo>
                        <a:pt x="54" y="47"/>
                      </a:lnTo>
                      <a:lnTo>
                        <a:pt x="54" y="49"/>
                      </a:lnTo>
                      <a:lnTo>
                        <a:pt x="56" y="49"/>
                      </a:lnTo>
                      <a:lnTo>
                        <a:pt x="57" y="50"/>
                      </a:lnTo>
                      <a:lnTo>
                        <a:pt x="57" y="50"/>
                      </a:lnTo>
                      <a:lnTo>
                        <a:pt x="59" y="52"/>
                      </a:lnTo>
                      <a:lnTo>
                        <a:pt x="59" y="52"/>
                      </a:lnTo>
                      <a:lnTo>
                        <a:pt x="60" y="53"/>
                      </a:lnTo>
                      <a:lnTo>
                        <a:pt x="60" y="53"/>
                      </a:lnTo>
                      <a:lnTo>
                        <a:pt x="61" y="54"/>
                      </a:lnTo>
                      <a:lnTo>
                        <a:pt x="61" y="56"/>
                      </a:lnTo>
                      <a:lnTo>
                        <a:pt x="63" y="56"/>
                      </a:lnTo>
                      <a:lnTo>
                        <a:pt x="63" y="57"/>
                      </a:lnTo>
                      <a:lnTo>
                        <a:pt x="64" y="57"/>
                      </a:lnTo>
                      <a:lnTo>
                        <a:pt x="66" y="59"/>
                      </a:lnTo>
                      <a:lnTo>
                        <a:pt x="66" y="59"/>
                      </a:lnTo>
                      <a:lnTo>
                        <a:pt x="67" y="60"/>
                      </a:lnTo>
                      <a:lnTo>
                        <a:pt x="67" y="60"/>
                      </a:lnTo>
                      <a:lnTo>
                        <a:pt x="69" y="62"/>
                      </a:lnTo>
                      <a:lnTo>
                        <a:pt x="69" y="62"/>
                      </a:lnTo>
                      <a:lnTo>
                        <a:pt x="70" y="63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76" name="Line 60"/>
                <p:cNvSpPr>
                  <a:spLocks noChangeShapeType="1"/>
                </p:cNvSpPr>
                <p:nvPr/>
              </p:nvSpPr>
              <p:spPr bwMode="auto">
                <a:xfrm flipV="1">
                  <a:off x="4458" y="1273"/>
                  <a:ext cx="40" cy="49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77" name="Rectangle 61"/>
                <p:cNvSpPr>
                  <a:spLocks noChangeArrowheads="1"/>
                </p:cNvSpPr>
                <p:nvPr/>
              </p:nvSpPr>
              <p:spPr bwMode="auto">
                <a:xfrm rot="19140000">
                  <a:off x="5163" y="767"/>
                  <a:ext cx="250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LX-A1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78" name="Line 62"/>
                <p:cNvSpPr>
                  <a:spLocks noChangeShapeType="1"/>
                </p:cNvSpPr>
                <p:nvPr/>
              </p:nvSpPr>
              <p:spPr bwMode="auto">
                <a:xfrm flipV="1">
                  <a:off x="4584" y="999"/>
                  <a:ext cx="517" cy="446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79" name="Freeform 63"/>
                <p:cNvSpPr/>
                <p:nvPr/>
              </p:nvSpPr>
              <p:spPr bwMode="auto">
                <a:xfrm>
                  <a:off x="4455" y="1323"/>
                  <a:ext cx="66" cy="59"/>
                </a:xfrm>
                <a:custGeom>
                  <a:avLst/>
                  <a:gdLst>
                    <a:gd name="T0" fmla="*/ 66 w 66"/>
                    <a:gd name="T1" fmla="*/ 59 h 59"/>
                    <a:gd name="T2" fmla="*/ 63 w 66"/>
                    <a:gd name="T3" fmla="*/ 56 h 59"/>
                    <a:gd name="T4" fmla="*/ 60 w 66"/>
                    <a:gd name="T5" fmla="*/ 53 h 59"/>
                    <a:gd name="T6" fmla="*/ 56 w 66"/>
                    <a:gd name="T7" fmla="*/ 49 h 59"/>
                    <a:gd name="T8" fmla="*/ 53 w 66"/>
                    <a:gd name="T9" fmla="*/ 46 h 59"/>
                    <a:gd name="T10" fmla="*/ 50 w 66"/>
                    <a:gd name="T11" fmla="*/ 43 h 59"/>
                    <a:gd name="T12" fmla="*/ 46 w 66"/>
                    <a:gd name="T13" fmla="*/ 40 h 59"/>
                    <a:gd name="T14" fmla="*/ 43 w 66"/>
                    <a:gd name="T15" fmla="*/ 36 h 59"/>
                    <a:gd name="T16" fmla="*/ 39 w 66"/>
                    <a:gd name="T17" fmla="*/ 33 h 59"/>
                    <a:gd name="T18" fmla="*/ 36 w 66"/>
                    <a:gd name="T19" fmla="*/ 30 h 59"/>
                    <a:gd name="T20" fmla="*/ 33 w 66"/>
                    <a:gd name="T21" fmla="*/ 27 h 59"/>
                    <a:gd name="T22" fmla="*/ 29 w 66"/>
                    <a:gd name="T23" fmla="*/ 24 h 59"/>
                    <a:gd name="T24" fmla="*/ 26 w 66"/>
                    <a:gd name="T25" fmla="*/ 21 h 59"/>
                    <a:gd name="T26" fmla="*/ 22 w 66"/>
                    <a:gd name="T27" fmla="*/ 17 h 59"/>
                    <a:gd name="T28" fmla="*/ 19 w 66"/>
                    <a:gd name="T29" fmla="*/ 14 h 59"/>
                    <a:gd name="T30" fmla="*/ 15 w 66"/>
                    <a:gd name="T31" fmla="*/ 11 h 59"/>
                    <a:gd name="T32" fmla="*/ 12 w 66"/>
                    <a:gd name="T33" fmla="*/ 9 h 59"/>
                    <a:gd name="T34" fmla="*/ 7 w 66"/>
                    <a:gd name="T35" fmla="*/ 6 h 59"/>
                    <a:gd name="T36" fmla="*/ 5 w 66"/>
                    <a:gd name="T37" fmla="*/ 3 h 59"/>
                    <a:gd name="T38" fmla="*/ 0 w 66"/>
                    <a:gd name="T39" fmla="*/ 0 h 5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</a:cxnLst>
                  <a:rect l="0" t="0" r="r" b="b"/>
                  <a:pathLst>
                    <a:path w="66" h="59">
                      <a:moveTo>
                        <a:pt x="66" y="59"/>
                      </a:moveTo>
                      <a:lnTo>
                        <a:pt x="63" y="56"/>
                      </a:lnTo>
                      <a:lnTo>
                        <a:pt x="60" y="53"/>
                      </a:lnTo>
                      <a:lnTo>
                        <a:pt x="56" y="49"/>
                      </a:lnTo>
                      <a:lnTo>
                        <a:pt x="53" y="46"/>
                      </a:lnTo>
                      <a:lnTo>
                        <a:pt x="50" y="43"/>
                      </a:lnTo>
                      <a:lnTo>
                        <a:pt x="46" y="40"/>
                      </a:lnTo>
                      <a:lnTo>
                        <a:pt x="43" y="36"/>
                      </a:lnTo>
                      <a:lnTo>
                        <a:pt x="39" y="33"/>
                      </a:lnTo>
                      <a:lnTo>
                        <a:pt x="36" y="30"/>
                      </a:lnTo>
                      <a:lnTo>
                        <a:pt x="33" y="27"/>
                      </a:lnTo>
                      <a:lnTo>
                        <a:pt x="29" y="24"/>
                      </a:lnTo>
                      <a:lnTo>
                        <a:pt x="26" y="21"/>
                      </a:lnTo>
                      <a:lnTo>
                        <a:pt x="22" y="17"/>
                      </a:lnTo>
                      <a:lnTo>
                        <a:pt x="19" y="14"/>
                      </a:lnTo>
                      <a:lnTo>
                        <a:pt x="15" y="11"/>
                      </a:lnTo>
                      <a:lnTo>
                        <a:pt x="12" y="9"/>
                      </a:lnTo>
                      <a:lnTo>
                        <a:pt x="7" y="6"/>
                      </a:lnTo>
                      <a:lnTo>
                        <a:pt x="5" y="3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80" name="Freeform 64"/>
                <p:cNvSpPr/>
                <p:nvPr/>
              </p:nvSpPr>
              <p:spPr bwMode="auto">
                <a:xfrm>
                  <a:off x="4521" y="1382"/>
                  <a:ext cx="62" cy="64"/>
                </a:xfrm>
                <a:custGeom>
                  <a:avLst/>
                  <a:gdLst>
                    <a:gd name="T0" fmla="*/ 2 w 62"/>
                    <a:gd name="T1" fmla="*/ 1 h 64"/>
                    <a:gd name="T2" fmla="*/ 3 w 62"/>
                    <a:gd name="T3" fmla="*/ 1 h 64"/>
                    <a:gd name="T4" fmla="*/ 5 w 62"/>
                    <a:gd name="T5" fmla="*/ 3 h 64"/>
                    <a:gd name="T6" fmla="*/ 5 w 62"/>
                    <a:gd name="T7" fmla="*/ 4 h 64"/>
                    <a:gd name="T8" fmla="*/ 6 w 62"/>
                    <a:gd name="T9" fmla="*/ 6 h 64"/>
                    <a:gd name="T10" fmla="*/ 7 w 62"/>
                    <a:gd name="T11" fmla="*/ 7 h 64"/>
                    <a:gd name="T12" fmla="*/ 9 w 62"/>
                    <a:gd name="T13" fmla="*/ 8 h 64"/>
                    <a:gd name="T14" fmla="*/ 10 w 62"/>
                    <a:gd name="T15" fmla="*/ 10 h 64"/>
                    <a:gd name="T16" fmla="*/ 12 w 62"/>
                    <a:gd name="T17" fmla="*/ 10 h 64"/>
                    <a:gd name="T18" fmla="*/ 13 w 62"/>
                    <a:gd name="T19" fmla="*/ 11 h 64"/>
                    <a:gd name="T20" fmla="*/ 13 w 62"/>
                    <a:gd name="T21" fmla="*/ 13 h 64"/>
                    <a:gd name="T22" fmla="*/ 15 w 62"/>
                    <a:gd name="T23" fmla="*/ 14 h 64"/>
                    <a:gd name="T24" fmla="*/ 16 w 62"/>
                    <a:gd name="T25" fmla="*/ 16 h 64"/>
                    <a:gd name="T26" fmla="*/ 17 w 62"/>
                    <a:gd name="T27" fmla="*/ 17 h 64"/>
                    <a:gd name="T28" fmla="*/ 19 w 62"/>
                    <a:gd name="T29" fmla="*/ 18 h 64"/>
                    <a:gd name="T30" fmla="*/ 20 w 62"/>
                    <a:gd name="T31" fmla="*/ 20 h 64"/>
                    <a:gd name="T32" fmla="*/ 22 w 62"/>
                    <a:gd name="T33" fmla="*/ 20 h 64"/>
                    <a:gd name="T34" fmla="*/ 22 w 62"/>
                    <a:gd name="T35" fmla="*/ 21 h 64"/>
                    <a:gd name="T36" fmla="*/ 23 w 62"/>
                    <a:gd name="T37" fmla="*/ 23 h 64"/>
                    <a:gd name="T38" fmla="*/ 25 w 62"/>
                    <a:gd name="T39" fmla="*/ 24 h 64"/>
                    <a:gd name="T40" fmla="*/ 26 w 62"/>
                    <a:gd name="T41" fmla="*/ 26 h 64"/>
                    <a:gd name="T42" fmla="*/ 27 w 62"/>
                    <a:gd name="T43" fmla="*/ 27 h 64"/>
                    <a:gd name="T44" fmla="*/ 29 w 62"/>
                    <a:gd name="T45" fmla="*/ 28 h 64"/>
                    <a:gd name="T46" fmla="*/ 30 w 62"/>
                    <a:gd name="T47" fmla="*/ 30 h 64"/>
                    <a:gd name="T48" fmla="*/ 30 w 62"/>
                    <a:gd name="T49" fmla="*/ 31 h 64"/>
                    <a:gd name="T50" fmla="*/ 32 w 62"/>
                    <a:gd name="T51" fmla="*/ 31 h 64"/>
                    <a:gd name="T52" fmla="*/ 33 w 62"/>
                    <a:gd name="T53" fmla="*/ 33 h 64"/>
                    <a:gd name="T54" fmla="*/ 35 w 62"/>
                    <a:gd name="T55" fmla="*/ 34 h 64"/>
                    <a:gd name="T56" fmla="*/ 36 w 62"/>
                    <a:gd name="T57" fmla="*/ 36 h 64"/>
                    <a:gd name="T58" fmla="*/ 38 w 62"/>
                    <a:gd name="T59" fmla="*/ 37 h 64"/>
                    <a:gd name="T60" fmla="*/ 38 w 62"/>
                    <a:gd name="T61" fmla="*/ 39 h 64"/>
                    <a:gd name="T62" fmla="*/ 39 w 62"/>
                    <a:gd name="T63" fmla="*/ 40 h 64"/>
                    <a:gd name="T64" fmla="*/ 40 w 62"/>
                    <a:gd name="T65" fmla="*/ 41 h 64"/>
                    <a:gd name="T66" fmla="*/ 42 w 62"/>
                    <a:gd name="T67" fmla="*/ 43 h 64"/>
                    <a:gd name="T68" fmla="*/ 43 w 62"/>
                    <a:gd name="T69" fmla="*/ 44 h 64"/>
                    <a:gd name="T70" fmla="*/ 43 w 62"/>
                    <a:gd name="T71" fmla="*/ 44 h 64"/>
                    <a:gd name="T72" fmla="*/ 45 w 62"/>
                    <a:gd name="T73" fmla="*/ 46 h 64"/>
                    <a:gd name="T74" fmla="*/ 46 w 62"/>
                    <a:gd name="T75" fmla="*/ 47 h 64"/>
                    <a:gd name="T76" fmla="*/ 48 w 62"/>
                    <a:gd name="T77" fmla="*/ 49 h 64"/>
                    <a:gd name="T78" fmla="*/ 49 w 62"/>
                    <a:gd name="T79" fmla="*/ 50 h 64"/>
                    <a:gd name="T80" fmla="*/ 50 w 62"/>
                    <a:gd name="T81" fmla="*/ 51 h 64"/>
                    <a:gd name="T82" fmla="*/ 50 w 62"/>
                    <a:gd name="T83" fmla="*/ 53 h 64"/>
                    <a:gd name="T84" fmla="*/ 52 w 62"/>
                    <a:gd name="T85" fmla="*/ 54 h 64"/>
                    <a:gd name="T86" fmla="*/ 53 w 62"/>
                    <a:gd name="T87" fmla="*/ 56 h 64"/>
                    <a:gd name="T88" fmla="*/ 55 w 62"/>
                    <a:gd name="T89" fmla="*/ 57 h 64"/>
                    <a:gd name="T90" fmla="*/ 56 w 62"/>
                    <a:gd name="T91" fmla="*/ 59 h 64"/>
                    <a:gd name="T92" fmla="*/ 56 w 62"/>
                    <a:gd name="T93" fmla="*/ 60 h 64"/>
                    <a:gd name="T94" fmla="*/ 58 w 62"/>
                    <a:gd name="T95" fmla="*/ 60 h 64"/>
                    <a:gd name="T96" fmla="*/ 59 w 62"/>
                    <a:gd name="T97" fmla="*/ 61 h 64"/>
                    <a:gd name="T98" fmla="*/ 60 w 62"/>
                    <a:gd name="T99" fmla="*/ 63 h 64"/>
                    <a:gd name="T100" fmla="*/ 62 w 62"/>
                    <a:gd name="T101" fmla="*/ 64 h 6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  <a:cxn ang="0">
                      <a:pos x="T90" y="T91"/>
                    </a:cxn>
                    <a:cxn ang="0">
                      <a:pos x="T92" y="T93"/>
                    </a:cxn>
                    <a:cxn ang="0">
                      <a:pos x="T94" y="T95"/>
                    </a:cxn>
                    <a:cxn ang="0">
                      <a:pos x="T96" y="T97"/>
                    </a:cxn>
                    <a:cxn ang="0">
                      <a:pos x="T98" y="T99"/>
                    </a:cxn>
                    <a:cxn ang="0">
                      <a:pos x="T100" y="T101"/>
                    </a:cxn>
                  </a:cxnLst>
                  <a:rect l="0" t="0" r="r" b="b"/>
                  <a:pathLst>
                    <a:path w="62" h="64">
                      <a:moveTo>
                        <a:pt x="0" y="0"/>
                      </a:moveTo>
                      <a:lnTo>
                        <a:pt x="2" y="1"/>
                      </a:lnTo>
                      <a:lnTo>
                        <a:pt x="2" y="1"/>
                      </a:lnTo>
                      <a:lnTo>
                        <a:pt x="3" y="1"/>
                      </a:lnTo>
                      <a:lnTo>
                        <a:pt x="3" y="3"/>
                      </a:lnTo>
                      <a:lnTo>
                        <a:pt x="5" y="3"/>
                      </a:lnTo>
                      <a:lnTo>
                        <a:pt x="5" y="4"/>
                      </a:lnTo>
                      <a:lnTo>
                        <a:pt x="5" y="4"/>
                      </a:lnTo>
                      <a:lnTo>
                        <a:pt x="6" y="6"/>
                      </a:lnTo>
                      <a:lnTo>
                        <a:pt x="6" y="6"/>
                      </a:lnTo>
                      <a:lnTo>
                        <a:pt x="7" y="6"/>
                      </a:lnTo>
                      <a:lnTo>
                        <a:pt x="7" y="7"/>
                      </a:lnTo>
                      <a:lnTo>
                        <a:pt x="9" y="7"/>
                      </a:lnTo>
                      <a:lnTo>
                        <a:pt x="9" y="8"/>
                      </a:lnTo>
                      <a:lnTo>
                        <a:pt x="9" y="8"/>
                      </a:lnTo>
                      <a:lnTo>
                        <a:pt x="10" y="10"/>
                      </a:lnTo>
                      <a:lnTo>
                        <a:pt x="10" y="10"/>
                      </a:lnTo>
                      <a:lnTo>
                        <a:pt x="12" y="10"/>
                      </a:lnTo>
                      <a:lnTo>
                        <a:pt x="12" y="11"/>
                      </a:lnTo>
                      <a:lnTo>
                        <a:pt x="13" y="11"/>
                      </a:lnTo>
                      <a:lnTo>
                        <a:pt x="13" y="13"/>
                      </a:lnTo>
                      <a:lnTo>
                        <a:pt x="13" y="13"/>
                      </a:lnTo>
                      <a:lnTo>
                        <a:pt x="15" y="14"/>
                      </a:lnTo>
                      <a:lnTo>
                        <a:pt x="15" y="14"/>
                      </a:lnTo>
                      <a:lnTo>
                        <a:pt x="16" y="16"/>
                      </a:lnTo>
                      <a:lnTo>
                        <a:pt x="16" y="16"/>
                      </a:lnTo>
                      <a:lnTo>
                        <a:pt x="17" y="16"/>
                      </a:lnTo>
                      <a:lnTo>
                        <a:pt x="17" y="17"/>
                      </a:lnTo>
                      <a:lnTo>
                        <a:pt x="17" y="17"/>
                      </a:lnTo>
                      <a:lnTo>
                        <a:pt x="19" y="18"/>
                      </a:lnTo>
                      <a:lnTo>
                        <a:pt x="19" y="18"/>
                      </a:lnTo>
                      <a:lnTo>
                        <a:pt x="20" y="20"/>
                      </a:lnTo>
                      <a:lnTo>
                        <a:pt x="20" y="20"/>
                      </a:lnTo>
                      <a:lnTo>
                        <a:pt x="22" y="20"/>
                      </a:lnTo>
                      <a:lnTo>
                        <a:pt x="22" y="21"/>
                      </a:lnTo>
                      <a:lnTo>
                        <a:pt x="22" y="21"/>
                      </a:lnTo>
                      <a:lnTo>
                        <a:pt x="23" y="23"/>
                      </a:lnTo>
                      <a:lnTo>
                        <a:pt x="23" y="23"/>
                      </a:lnTo>
                      <a:lnTo>
                        <a:pt x="25" y="24"/>
                      </a:lnTo>
                      <a:lnTo>
                        <a:pt x="25" y="24"/>
                      </a:lnTo>
                      <a:lnTo>
                        <a:pt x="26" y="26"/>
                      </a:lnTo>
                      <a:lnTo>
                        <a:pt x="26" y="26"/>
                      </a:lnTo>
                      <a:lnTo>
                        <a:pt x="26" y="26"/>
                      </a:lnTo>
                      <a:lnTo>
                        <a:pt x="27" y="27"/>
                      </a:lnTo>
                      <a:lnTo>
                        <a:pt x="27" y="27"/>
                      </a:lnTo>
                      <a:lnTo>
                        <a:pt x="29" y="28"/>
                      </a:lnTo>
                      <a:lnTo>
                        <a:pt x="29" y="28"/>
                      </a:lnTo>
                      <a:lnTo>
                        <a:pt x="30" y="30"/>
                      </a:lnTo>
                      <a:lnTo>
                        <a:pt x="30" y="30"/>
                      </a:lnTo>
                      <a:lnTo>
                        <a:pt x="30" y="31"/>
                      </a:lnTo>
                      <a:lnTo>
                        <a:pt x="32" y="31"/>
                      </a:lnTo>
                      <a:lnTo>
                        <a:pt x="32" y="31"/>
                      </a:lnTo>
                      <a:lnTo>
                        <a:pt x="33" y="33"/>
                      </a:lnTo>
                      <a:lnTo>
                        <a:pt x="33" y="33"/>
                      </a:lnTo>
                      <a:lnTo>
                        <a:pt x="33" y="34"/>
                      </a:lnTo>
                      <a:lnTo>
                        <a:pt x="35" y="34"/>
                      </a:lnTo>
                      <a:lnTo>
                        <a:pt x="35" y="36"/>
                      </a:lnTo>
                      <a:lnTo>
                        <a:pt x="36" y="36"/>
                      </a:lnTo>
                      <a:lnTo>
                        <a:pt x="36" y="37"/>
                      </a:lnTo>
                      <a:lnTo>
                        <a:pt x="38" y="37"/>
                      </a:lnTo>
                      <a:lnTo>
                        <a:pt x="38" y="39"/>
                      </a:lnTo>
                      <a:lnTo>
                        <a:pt x="38" y="39"/>
                      </a:lnTo>
                      <a:lnTo>
                        <a:pt x="39" y="39"/>
                      </a:lnTo>
                      <a:lnTo>
                        <a:pt x="39" y="40"/>
                      </a:lnTo>
                      <a:lnTo>
                        <a:pt x="40" y="40"/>
                      </a:lnTo>
                      <a:lnTo>
                        <a:pt x="40" y="41"/>
                      </a:lnTo>
                      <a:lnTo>
                        <a:pt x="40" y="41"/>
                      </a:lnTo>
                      <a:lnTo>
                        <a:pt x="42" y="43"/>
                      </a:lnTo>
                      <a:lnTo>
                        <a:pt x="42" y="43"/>
                      </a:lnTo>
                      <a:lnTo>
                        <a:pt x="43" y="44"/>
                      </a:lnTo>
                      <a:lnTo>
                        <a:pt x="43" y="44"/>
                      </a:lnTo>
                      <a:lnTo>
                        <a:pt x="43" y="44"/>
                      </a:lnTo>
                      <a:lnTo>
                        <a:pt x="45" y="46"/>
                      </a:lnTo>
                      <a:lnTo>
                        <a:pt x="45" y="46"/>
                      </a:lnTo>
                      <a:lnTo>
                        <a:pt x="46" y="47"/>
                      </a:lnTo>
                      <a:lnTo>
                        <a:pt x="46" y="47"/>
                      </a:lnTo>
                      <a:lnTo>
                        <a:pt x="48" y="49"/>
                      </a:lnTo>
                      <a:lnTo>
                        <a:pt x="48" y="49"/>
                      </a:lnTo>
                      <a:lnTo>
                        <a:pt x="48" y="50"/>
                      </a:lnTo>
                      <a:lnTo>
                        <a:pt x="49" y="50"/>
                      </a:lnTo>
                      <a:lnTo>
                        <a:pt x="49" y="51"/>
                      </a:lnTo>
                      <a:lnTo>
                        <a:pt x="50" y="51"/>
                      </a:lnTo>
                      <a:lnTo>
                        <a:pt x="50" y="51"/>
                      </a:lnTo>
                      <a:lnTo>
                        <a:pt x="50" y="53"/>
                      </a:lnTo>
                      <a:lnTo>
                        <a:pt x="52" y="53"/>
                      </a:lnTo>
                      <a:lnTo>
                        <a:pt x="52" y="54"/>
                      </a:lnTo>
                      <a:lnTo>
                        <a:pt x="53" y="54"/>
                      </a:lnTo>
                      <a:lnTo>
                        <a:pt x="53" y="56"/>
                      </a:lnTo>
                      <a:lnTo>
                        <a:pt x="53" y="56"/>
                      </a:lnTo>
                      <a:lnTo>
                        <a:pt x="55" y="57"/>
                      </a:lnTo>
                      <a:lnTo>
                        <a:pt x="55" y="57"/>
                      </a:lnTo>
                      <a:lnTo>
                        <a:pt x="56" y="59"/>
                      </a:lnTo>
                      <a:lnTo>
                        <a:pt x="56" y="59"/>
                      </a:lnTo>
                      <a:lnTo>
                        <a:pt x="56" y="60"/>
                      </a:lnTo>
                      <a:lnTo>
                        <a:pt x="58" y="60"/>
                      </a:lnTo>
                      <a:lnTo>
                        <a:pt x="58" y="60"/>
                      </a:lnTo>
                      <a:lnTo>
                        <a:pt x="59" y="61"/>
                      </a:lnTo>
                      <a:lnTo>
                        <a:pt x="59" y="61"/>
                      </a:lnTo>
                      <a:lnTo>
                        <a:pt x="59" y="63"/>
                      </a:lnTo>
                      <a:lnTo>
                        <a:pt x="60" y="63"/>
                      </a:lnTo>
                      <a:lnTo>
                        <a:pt x="60" y="64"/>
                      </a:lnTo>
                      <a:lnTo>
                        <a:pt x="62" y="64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82" name="Line 66"/>
                <p:cNvSpPr>
                  <a:spLocks noChangeShapeType="1"/>
                </p:cNvSpPr>
                <p:nvPr/>
              </p:nvSpPr>
              <p:spPr bwMode="auto">
                <a:xfrm flipV="1">
                  <a:off x="4475" y="1383"/>
                  <a:ext cx="45" cy="46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83" name="Rectangle 67"/>
                <p:cNvSpPr>
                  <a:spLocks noChangeArrowheads="1"/>
                </p:cNvSpPr>
                <p:nvPr/>
              </p:nvSpPr>
              <p:spPr bwMode="auto">
                <a:xfrm rot="19440000">
                  <a:off x="5263" y="909"/>
                  <a:ext cx="263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AL-A1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84" name="Line 68"/>
                <p:cNvSpPr>
                  <a:spLocks noChangeShapeType="1"/>
                </p:cNvSpPr>
                <p:nvPr/>
              </p:nvSpPr>
              <p:spPr bwMode="auto">
                <a:xfrm flipV="1">
                  <a:off x="4583" y="1115"/>
                  <a:ext cx="609" cy="440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85" name="Freeform 69"/>
                <p:cNvSpPr/>
                <p:nvPr/>
              </p:nvSpPr>
              <p:spPr bwMode="auto">
                <a:xfrm>
                  <a:off x="4474" y="1431"/>
                  <a:ext cx="56" cy="61"/>
                </a:xfrm>
                <a:custGeom>
                  <a:avLst/>
                  <a:gdLst>
                    <a:gd name="T0" fmla="*/ 56 w 56"/>
                    <a:gd name="T1" fmla="*/ 61 h 61"/>
                    <a:gd name="T2" fmla="*/ 53 w 56"/>
                    <a:gd name="T3" fmla="*/ 57 h 61"/>
                    <a:gd name="T4" fmla="*/ 50 w 56"/>
                    <a:gd name="T5" fmla="*/ 54 h 61"/>
                    <a:gd name="T6" fmla="*/ 47 w 56"/>
                    <a:gd name="T7" fmla="*/ 51 h 61"/>
                    <a:gd name="T8" fmla="*/ 44 w 56"/>
                    <a:gd name="T9" fmla="*/ 47 h 61"/>
                    <a:gd name="T10" fmla="*/ 41 w 56"/>
                    <a:gd name="T11" fmla="*/ 44 h 61"/>
                    <a:gd name="T12" fmla="*/ 39 w 56"/>
                    <a:gd name="T13" fmla="*/ 41 h 61"/>
                    <a:gd name="T14" fmla="*/ 36 w 56"/>
                    <a:gd name="T15" fmla="*/ 38 h 61"/>
                    <a:gd name="T16" fmla="*/ 33 w 56"/>
                    <a:gd name="T17" fmla="*/ 34 h 61"/>
                    <a:gd name="T18" fmla="*/ 30 w 56"/>
                    <a:gd name="T19" fmla="*/ 31 h 61"/>
                    <a:gd name="T20" fmla="*/ 27 w 56"/>
                    <a:gd name="T21" fmla="*/ 28 h 61"/>
                    <a:gd name="T22" fmla="*/ 24 w 56"/>
                    <a:gd name="T23" fmla="*/ 25 h 61"/>
                    <a:gd name="T24" fmla="*/ 21 w 56"/>
                    <a:gd name="T25" fmla="*/ 23 h 61"/>
                    <a:gd name="T26" fmla="*/ 19 w 56"/>
                    <a:gd name="T27" fmla="*/ 18 h 61"/>
                    <a:gd name="T28" fmla="*/ 16 w 56"/>
                    <a:gd name="T29" fmla="*/ 15 h 61"/>
                    <a:gd name="T30" fmla="*/ 11 w 56"/>
                    <a:gd name="T31" fmla="*/ 12 h 61"/>
                    <a:gd name="T32" fmla="*/ 8 w 56"/>
                    <a:gd name="T33" fmla="*/ 10 h 61"/>
                    <a:gd name="T34" fmla="*/ 6 w 56"/>
                    <a:gd name="T35" fmla="*/ 7 h 61"/>
                    <a:gd name="T36" fmla="*/ 3 w 56"/>
                    <a:gd name="T37" fmla="*/ 4 h 61"/>
                    <a:gd name="T38" fmla="*/ 0 w 56"/>
                    <a:gd name="T39" fmla="*/ 0 h 6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</a:cxnLst>
                  <a:rect l="0" t="0" r="r" b="b"/>
                  <a:pathLst>
                    <a:path w="56" h="61">
                      <a:moveTo>
                        <a:pt x="56" y="61"/>
                      </a:moveTo>
                      <a:lnTo>
                        <a:pt x="53" y="57"/>
                      </a:lnTo>
                      <a:lnTo>
                        <a:pt x="50" y="54"/>
                      </a:lnTo>
                      <a:lnTo>
                        <a:pt x="47" y="51"/>
                      </a:lnTo>
                      <a:lnTo>
                        <a:pt x="44" y="47"/>
                      </a:lnTo>
                      <a:lnTo>
                        <a:pt x="41" y="44"/>
                      </a:lnTo>
                      <a:lnTo>
                        <a:pt x="39" y="41"/>
                      </a:lnTo>
                      <a:lnTo>
                        <a:pt x="36" y="38"/>
                      </a:lnTo>
                      <a:lnTo>
                        <a:pt x="33" y="34"/>
                      </a:lnTo>
                      <a:lnTo>
                        <a:pt x="30" y="31"/>
                      </a:lnTo>
                      <a:lnTo>
                        <a:pt x="27" y="28"/>
                      </a:lnTo>
                      <a:lnTo>
                        <a:pt x="24" y="25"/>
                      </a:lnTo>
                      <a:lnTo>
                        <a:pt x="21" y="23"/>
                      </a:lnTo>
                      <a:lnTo>
                        <a:pt x="19" y="18"/>
                      </a:lnTo>
                      <a:lnTo>
                        <a:pt x="16" y="15"/>
                      </a:lnTo>
                      <a:lnTo>
                        <a:pt x="11" y="12"/>
                      </a:lnTo>
                      <a:lnTo>
                        <a:pt x="8" y="10"/>
                      </a:lnTo>
                      <a:lnTo>
                        <a:pt x="6" y="7"/>
                      </a:lnTo>
                      <a:lnTo>
                        <a:pt x="3" y="4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86" name="Freeform 70"/>
                <p:cNvSpPr/>
                <p:nvPr/>
              </p:nvSpPr>
              <p:spPr bwMode="auto">
                <a:xfrm>
                  <a:off x="4530" y="1492"/>
                  <a:ext cx="51" cy="65"/>
                </a:xfrm>
                <a:custGeom>
                  <a:avLst/>
                  <a:gdLst>
                    <a:gd name="T0" fmla="*/ 1 w 51"/>
                    <a:gd name="T1" fmla="*/ 0 h 65"/>
                    <a:gd name="T2" fmla="*/ 1 w 51"/>
                    <a:gd name="T3" fmla="*/ 2 h 65"/>
                    <a:gd name="T4" fmla="*/ 3 w 51"/>
                    <a:gd name="T5" fmla="*/ 2 h 65"/>
                    <a:gd name="T6" fmla="*/ 4 w 51"/>
                    <a:gd name="T7" fmla="*/ 3 h 65"/>
                    <a:gd name="T8" fmla="*/ 4 w 51"/>
                    <a:gd name="T9" fmla="*/ 5 h 65"/>
                    <a:gd name="T10" fmla="*/ 6 w 51"/>
                    <a:gd name="T11" fmla="*/ 6 h 65"/>
                    <a:gd name="T12" fmla="*/ 6 w 51"/>
                    <a:gd name="T13" fmla="*/ 7 h 65"/>
                    <a:gd name="T14" fmla="*/ 7 w 51"/>
                    <a:gd name="T15" fmla="*/ 7 h 65"/>
                    <a:gd name="T16" fmla="*/ 8 w 51"/>
                    <a:gd name="T17" fmla="*/ 9 h 65"/>
                    <a:gd name="T18" fmla="*/ 8 w 51"/>
                    <a:gd name="T19" fmla="*/ 10 h 65"/>
                    <a:gd name="T20" fmla="*/ 10 w 51"/>
                    <a:gd name="T21" fmla="*/ 12 h 65"/>
                    <a:gd name="T22" fmla="*/ 11 w 51"/>
                    <a:gd name="T23" fmla="*/ 12 h 65"/>
                    <a:gd name="T24" fmla="*/ 11 w 51"/>
                    <a:gd name="T25" fmla="*/ 13 h 65"/>
                    <a:gd name="T26" fmla="*/ 13 w 51"/>
                    <a:gd name="T27" fmla="*/ 15 h 65"/>
                    <a:gd name="T28" fmla="*/ 14 w 51"/>
                    <a:gd name="T29" fmla="*/ 16 h 65"/>
                    <a:gd name="T30" fmla="*/ 14 w 51"/>
                    <a:gd name="T31" fmla="*/ 16 h 65"/>
                    <a:gd name="T32" fmla="*/ 16 w 51"/>
                    <a:gd name="T33" fmla="*/ 18 h 65"/>
                    <a:gd name="T34" fmla="*/ 16 w 51"/>
                    <a:gd name="T35" fmla="*/ 19 h 65"/>
                    <a:gd name="T36" fmla="*/ 17 w 51"/>
                    <a:gd name="T37" fmla="*/ 20 h 65"/>
                    <a:gd name="T38" fmla="*/ 18 w 51"/>
                    <a:gd name="T39" fmla="*/ 20 h 65"/>
                    <a:gd name="T40" fmla="*/ 18 w 51"/>
                    <a:gd name="T41" fmla="*/ 22 h 65"/>
                    <a:gd name="T42" fmla="*/ 20 w 51"/>
                    <a:gd name="T43" fmla="*/ 23 h 65"/>
                    <a:gd name="T44" fmla="*/ 21 w 51"/>
                    <a:gd name="T45" fmla="*/ 25 h 65"/>
                    <a:gd name="T46" fmla="*/ 21 w 51"/>
                    <a:gd name="T47" fmla="*/ 26 h 65"/>
                    <a:gd name="T48" fmla="*/ 23 w 51"/>
                    <a:gd name="T49" fmla="*/ 26 h 65"/>
                    <a:gd name="T50" fmla="*/ 23 w 51"/>
                    <a:gd name="T51" fmla="*/ 28 h 65"/>
                    <a:gd name="T52" fmla="*/ 24 w 51"/>
                    <a:gd name="T53" fmla="*/ 29 h 65"/>
                    <a:gd name="T54" fmla="*/ 26 w 51"/>
                    <a:gd name="T55" fmla="*/ 30 h 65"/>
                    <a:gd name="T56" fmla="*/ 26 w 51"/>
                    <a:gd name="T57" fmla="*/ 30 h 65"/>
                    <a:gd name="T58" fmla="*/ 27 w 51"/>
                    <a:gd name="T59" fmla="*/ 32 h 65"/>
                    <a:gd name="T60" fmla="*/ 29 w 51"/>
                    <a:gd name="T61" fmla="*/ 33 h 65"/>
                    <a:gd name="T62" fmla="*/ 29 w 51"/>
                    <a:gd name="T63" fmla="*/ 35 h 65"/>
                    <a:gd name="T64" fmla="*/ 30 w 51"/>
                    <a:gd name="T65" fmla="*/ 36 h 65"/>
                    <a:gd name="T66" fmla="*/ 30 w 51"/>
                    <a:gd name="T67" fmla="*/ 36 h 65"/>
                    <a:gd name="T68" fmla="*/ 31 w 51"/>
                    <a:gd name="T69" fmla="*/ 38 h 65"/>
                    <a:gd name="T70" fmla="*/ 33 w 51"/>
                    <a:gd name="T71" fmla="*/ 39 h 65"/>
                    <a:gd name="T72" fmla="*/ 33 w 51"/>
                    <a:gd name="T73" fmla="*/ 40 h 65"/>
                    <a:gd name="T74" fmla="*/ 34 w 51"/>
                    <a:gd name="T75" fmla="*/ 42 h 65"/>
                    <a:gd name="T76" fmla="*/ 34 w 51"/>
                    <a:gd name="T77" fmla="*/ 42 h 65"/>
                    <a:gd name="T78" fmla="*/ 36 w 51"/>
                    <a:gd name="T79" fmla="*/ 43 h 65"/>
                    <a:gd name="T80" fmla="*/ 37 w 51"/>
                    <a:gd name="T81" fmla="*/ 45 h 65"/>
                    <a:gd name="T82" fmla="*/ 37 w 51"/>
                    <a:gd name="T83" fmla="*/ 46 h 65"/>
                    <a:gd name="T84" fmla="*/ 39 w 51"/>
                    <a:gd name="T85" fmla="*/ 48 h 65"/>
                    <a:gd name="T86" fmla="*/ 39 w 51"/>
                    <a:gd name="T87" fmla="*/ 48 h 65"/>
                    <a:gd name="T88" fmla="*/ 40 w 51"/>
                    <a:gd name="T89" fmla="*/ 49 h 65"/>
                    <a:gd name="T90" fmla="*/ 41 w 51"/>
                    <a:gd name="T91" fmla="*/ 51 h 65"/>
                    <a:gd name="T92" fmla="*/ 41 w 51"/>
                    <a:gd name="T93" fmla="*/ 52 h 65"/>
                    <a:gd name="T94" fmla="*/ 43 w 51"/>
                    <a:gd name="T95" fmla="*/ 53 h 65"/>
                    <a:gd name="T96" fmla="*/ 43 w 51"/>
                    <a:gd name="T97" fmla="*/ 53 h 65"/>
                    <a:gd name="T98" fmla="*/ 44 w 51"/>
                    <a:gd name="T99" fmla="*/ 55 h 65"/>
                    <a:gd name="T100" fmla="*/ 46 w 51"/>
                    <a:gd name="T101" fmla="*/ 56 h 65"/>
                    <a:gd name="T102" fmla="*/ 46 w 51"/>
                    <a:gd name="T103" fmla="*/ 58 h 65"/>
                    <a:gd name="T104" fmla="*/ 47 w 51"/>
                    <a:gd name="T105" fmla="*/ 59 h 65"/>
                    <a:gd name="T106" fmla="*/ 47 w 51"/>
                    <a:gd name="T107" fmla="*/ 59 h 65"/>
                    <a:gd name="T108" fmla="*/ 49 w 51"/>
                    <a:gd name="T109" fmla="*/ 61 h 65"/>
                    <a:gd name="T110" fmla="*/ 50 w 51"/>
                    <a:gd name="T111" fmla="*/ 62 h 65"/>
                    <a:gd name="T112" fmla="*/ 50 w 51"/>
                    <a:gd name="T113" fmla="*/ 63 h 65"/>
                    <a:gd name="T114" fmla="*/ 51 w 51"/>
                    <a:gd name="T115" fmla="*/ 65 h 6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  <a:cxn ang="0">
                      <a:pos x="T90" y="T91"/>
                    </a:cxn>
                    <a:cxn ang="0">
                      <a:pos x="T92" y="T93"/>
                    </a:cxn>
                    <a:cxn ang="0">
                      <a:pos x="T94" y="T95"/>
                    </a:cxn>
                    <a:cxn ang="0">
                      <a:pos x="T96" y="T97"/>
                    </a:cxn>
                    <a:cxn ang="0">
                      <a:pos x="T98" y="T99"/>
                    </a:cxn>
                    <a:cxn ang="0">
                      <a:pos x="T100" y="T101"/>
                    </a:cxn>
                    <a:cxn ang="0">
                      <a:pos x="T102" y="T103"/>
                    </a:cxn>
                    <a:cxn ang="0">
                      <a:pos x="T104" y="T105"/>
                    </a:cxn>
                    <a:cxn ang="0">
                      <a:pos x="T106" y="T107"/>
                    </a:cxn>
                    <a:cxn ang="0">
                      <a:pos x="T108" y="T109"/>
                    </a:cxn>
                    <a:cxn ang="0">
                      <a:pos x="T110" y="T111"/>
                    </a:cxn>
                    <a:cxn ang="0">
                      <a:pos x="T112" y="T113"/>
                    </a:cxn>
                    <a:cxn ang="0">
                      <a:pos x="T114" y="T115"/>
                    </a:cxn>
                  </a:cxnLst>
                  <a:rect l="0" t="0" r="r" b="b"/>
                  <a:pathLst>
                    <a:path w="51" h="65">
                      <a:moveTo>
                        <a:pt x="0" y="0"/>
                      </a:moveTo>
                      <a:lnTo>
                        <a:pt x="1" y="0"/>
                      </a:lnTo>
                      <a:lnTo>
                        <a:pt x="1" y="0"/>
                      </a:lnTo>
                      <a:lnTo>
                        <a:pt x="1" y="2"/>
                      </a:lnTo>
                      <a:lnTo>
                        <a:pt x="3" y="2"/>
                      </a:lnTo>
                      <a:lnTo>
                        <a:pt x="3" y="2"/>
                      </a:lnTo>
                      <a:lnTo>
                        <a:pt x="3" y="3"/>
                      </a:lnTo>
                      <a:lnTo>
                        <a:pt x="4" y="3"/>
                      </a:lnTo>
                      <a:lnTo>
                        <a:pt x="4" y="5"/>
                      </a:lnTo>
                      <a:lnTo>
                        <a:pt x="4" y="5"/>
                      </a:lnTo>
                      <a:lnTo>
                        <a:pt x="6" y="5"/>
                      </a:lnTo>
                      <a:lnTo>
                        <a:pt x="6" y="6"/>
                      </a:lnTo>
                      <a:lnTo>
                        <a:pt x="6" y="6"/>
                      </a:lnTo>
                      <a:lnTo>
                        <a:pt x="6" y="7"/>
                      </a:lnTo>
                      <a:lnTo>
                        <a:pt x="7" y="7"/>
                      </a:lnTo>
                      <a:lnTo>
                        <a:pt x="7" y="7"/>
                      </a:lnTo>
                      <a:lnTo>
                        <a:pt x="7" y="9"/>
                      </a:lnTo>
                      <a:lnTo>
                        <a:pt x="8" y="9"/>
                      </a:lnTo>
                      <a:lnTo>
                        <a:pt x="8" y="9"/>
                      </a:lnTo>
                      <a:lnTo>
                        <a:pt x="8" y="10"/>
                      </a:lnTo>
                      <a:lnTo>
                        <a:pt x="10" y="10"/>
                      </a:lnTo>
                      <a:lnTo>
                        <a:pt x="10" y="12"/>
                      </a:lnTo>
                      <a:lnTo>
                        <a:pt x="10" y="12"/>
                      </a:lnTo>
                      <a:lnTo>
                        <a:pt x="11" y="12"/>
                      </a:lnTo>
                      <a:lnTo>
                        <a:pt x="11" y="13"/>
                      </a:lnTo>
                      <a:lnTo>
                        <a:pt x="11" y="13"/>
                      </a:lnTo>
                      <a:lnTo>
                        <a:pt x="13" y="13"/>
                      </a:lnTo>
                      <a:lnTo>
                        <a:pt x="13" y="15"/>
                      </a:lnTo>
                      <a:lnTo>
                        <a:pt x="13" y="15"/>
                      </a:lnTo>
                      <a:lnTo>
                        <a:pt x="14" y="16"/>
                      </a:lnTo>
                      <a:lnTo>
                        <a:pt x="14" y="16"/>
                      </a:lnTo>
                      <a:lnTo>
                        <a:pt x="14" y="16"/>
                      </a:lnTo>
                      <a:lnTo>
                        <a:pt x="16" y="18"/>
                      </a:lnTo>
                      <a:lnTo>
                        <a:pt x="16" y="18"/>
                      </a:lnTo>
                      <a:lnTo>
                        <a:pt x="16" y="19"/>
                      </a:lnTo>
                      <a:lnTo>
                        <a:pt x="16" y="19"/>
                      </a:lnTo>
                      <a:lnTo>
                        <a:pt x="17" y="19"/>
                      </a:lnTo>
                      <a:lnTo>
                        <a:pt x="17" y="20"/>
                      </a:lnTo>
                      <a:lnTo>
                        <a:pt x="17" y="20"/>
                      </a:lnTo>
                      <a:lnTo>
                        <a:pt x="18" y="20"/>
                      </a:lnTo>
                      <a:lnTo>
                        <a:pt x="18" y="22"/>
                      </a:lnTo>
                      <a:lnTo>
                        <a:pt x="18" y="22"/>
                      </a:lnTo>
                      <a:lnTo>
                        <a:pt x="20" y="23"/>
                      </a:lnTo>
                      <a:lnTo>
                        <a:pt x="20" y="23"/>
                      </a:lnTo>
                      <a:lnTo>
                        <a:pt x="20" y="23"/>
                      </a:lnTo>
                      <a:lnTo>
                        <a:pt x="21" y="25"/>
                      </a:lnTo>
                      <a:lnTo>
                        <a:pt x="21" y="25"/>
                      </a:lnTo>
                      <a:lnTo>
                        <a:pt x="21" y="26"/>
                      </a:lnTo>
                      <a:lnTo>
                        <a:pt x="23" y="26"/>
                      </a:lnTo>
                      <a:lnTo>
                        <a:pt x="23" y="26"/>
                      </a:lnTo>
                      <a:lnTo>
                        <a:pt x="23" y="28"/>
                      </a:lnTo>
                      <a:lnTo>
                        <a:pt x="23" y="28"/>
                      </a:lnTo>
                      <a:lnTo>
                        <a:pt x="24" y="29"/>
                      </a:lnTo>
                      <a:lnTo>
                        <a:pt x="24" y="29"/>
                      </a:lnTo>
                      <a:lnTo>
                        <a:pt x="24" y="29"/>
                      </a:lnTo>
                      <a:lnTo>
                        <a:pt x="26" y="30"/>
                      </a:lnTo>
                      <a:lnTo>
                        <a:pt x="26" y="30"/>
                      </a:lnTo>
                      <a:lnTo>
                        <a:pt x="26" y="30"/>
                      </a:lnTo>
                      <a:lnTo>
                        <a:pt x="27" y="32"/>
                      </a:lnTo>
                      <a:lnTo>
                        <a:pt x="27" y="32"/>
                      </a:lnTo>
                      <a:lnTo>
                        <a:pt x="27" y="33"/>
                      </a:lnTo>
                      <a:lnTo>
                        <a:pt x="29" y="33"/>
                      </a:lnTo>
                      <a:lnTo>
                        <a:pt x="29" y="33"/>
                      </a:lnTo>
                      <a:lnTo>
                        <a:pt x="29" y="35"/>
                      </a:lnTo>
                      <a:lnTo>
                        <a:pt x="30" y="35"/>
                      </a:lnTo>
                      <a:lnTo>
                        <a:pt x="30" y="36"/>
                      </a:lnTo>
                      <a:lnTo>
                        <a:pt x="30" y="36"/>
                      </a:lnTo>
                      <a:lnTo>
                        <a:pt x="30" y="36"/>
                      </a:lnTo>
                      <a:lnTo>
                        <a:pt x="31" y="38"/>
                      </a:lnTo>
                      <a:lnTo>
                        <a:pt x="31" y="38"/>
                      </a:lnTo>
                      <a:lnTo>
                        <a:pt x="31" y="39"/>
                      </a:lnTo>
                      <a:lnTo>
                        <a:pt x="33" y="39"/>
                      </a:lnTo>
                      <a:lnTo>
                        <a:pt x="33" y="39"/>
                      </a:lnTo>
                      <a:lnTo>
                        <a:pt x="33" y="40"/>
                      </a:lnTo>
                      <a:lnTo>
                        <a:pt x="34" y="40"/>
                      </a:lnTo>
                      <a:lnTo>
                        <a:pt x="34" y="42"/>
                      </a:lnTo>
                      <a:lnTo>
                        <a:pt x="34" y="42"/>
                      </a:lnTo>
                      <a:lnTo>
                        <a:pt x="34" y="42"/>
                      </a:lnTo>
                      <a:lnTo>
                        <a:pt x="36" y="43"/>
                      </a:lnTo>
                      <a:lnTo>
                        <a:pt x="36" y="43"/>
                      </a:lnTo>
                      <a:lnTo>
                        <a:pt x="36" y="45"/>
                      </a:lnTo>
                      <a:lnTo>
                        <a:pt x="37" y="45"/>
                      </a:lnTo>
                      <a:lnTo>
                        <a:pt x="37" y="45"/>
                      </a:lnTo>
                      <a:lnTo>
                        <a:pt x="37" y="46"/>
                      </a:lnTo>
                      <a:lnTo>
                        <a:pt x="39" y="46"/>
                      </a:lnTo>
                      <a:lnTo>
                        <a:pt x="39" y="48"/>
                      </a:lnTo>
                      <a:lnTo>
                        <a:pt x="39" y="48"/>
                      </a:lnTo>
                      <a:lnTo>
                        <a:pt x="39" y="48"/>
                      </a:lnTo>
                      <a:lnTo>
                        <a:pt x="40" y="49"/>
                      </a:lnTo>
                      <a:lnTo>
                        <a:pt x="40" y="49"/>
                      </a:lnTo>
                      <a:lnTo>
                        <a:pt x="40" y="51"/>
                      </a:lnTo>
                      <a:lnTo>
                        <a:pt x="41" y="51"/>
                      </a:lnTo>
                      <a:lnTo>
                        <a:pt x="41" y="51"/>
                      </a:lnTo>
                      <a:lnTo>
                        <a:pt x="41" y="52"/>
                      </a:lnTo>
                      <a:lnTo>
                        <a:pt x="43" y="52"/>
                      </a:lnTo>
                      <a:lnTo>
                        <a:pt x="43" y="53"/>
                      </a:lnTo>
                      <a:lnTo>
                        <a:pt x="43" y="53"/>
                      </a:lnTo>
                      <a:lnTo>
                        <a:pt x="43" y="53"/>
                      </a:lnTo>
                      <a:lnTo>
                        <a:pt x="44" y="55"/>
                      </a:lnTo>
                      <a:lnTo>
                        <a:pt x="44" y="55"/>
                      </a:lnTo>
                      <a:lnTo>
                        <a:pt x="44" y="56"/>
                      </a:lnTo>
                      <a:lnTo>
                        <a:pt x="46" y="56"/>
                      </a:lnTo>
                      <a:lnTo>
                        <a:pt x="46" y="56"/>
                      </a:lnTo>
                      <a:lnTo>
                        <a:pt x="46" y="58"/>
                      </a:lnTo>
                      <a:lnTo>
                        <a:pt x="47" y="58"/>
                      </a:lnTo>
                      <a:lnTo>
                        <a:pt x="47" y="59"/>
                      </a:lnTo>
                      <a:lnTo>
                        <a:pt x="47" y="59"/>
                      </a:lnTo>
                      <a:lnTo>
                        <a:pt x="47" y="59"/>
                      </a:lnTo>
                      <a:lnTo>
                        <a:pt x="49" y="61"/>
                      </a:lnTo>
                      <a:lnTo>
                        <a:pt x="49" y="61"/>
                      </a:lnTo>
                      <a:lnTo>
                        <a:pt x="49" y="62"/>
                      </a:lnTo>
                      <a:lnTo>
                        <a:pt x="50" y="62"/>
                      </a:lnTo>
                      <a:lnTo>
                        <a:pt x="50" y="62"/>
                      </a:lnTo>
                      <a:lnTo>
                        <a:pt x="50" y="63"/>
                      </a:lnTo>
                      <a:lnTo>
                        <a:pt x="50" y="63"/>
                      </a:lnTo>
                      <a:lnTo>
                        <a:pt x="51" y="65"/>
                      </a:lnTo>
                      <a:lnTo>
                        <a:pt x="51" y="65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88" name="Line 72"/>
                <p:cNvSpPr>
                  <a:spLocks noChangeShapeType="1"/>
                </p:cNvSpPr>
                <p:nvPr/>
              </p:nvSpPr>
              <p:spPr bwMode="auto">
                <a:xfrm flipV="1">
                  <a:off x="4480" y="1494"/>
                  <a:ext cx="47" cy="41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89" name="Rectangle 73"/>
                <p:cNvSpPr>
                  <a:spLocks noChangeArrowheads="1"/>
                </p:cNvSpPr>
                <p:nvPr/>
              </p:nvSpPr>
              <p:spPr bwMode="auto">
                <a:xfrm rot="19740000">
                  <a:off x="5368" y="1066"/>
                  <a:ext cx="210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L-A1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90" name="Line 74"/>
                <p:cNvSpPr>
                  <a:spLocks noChangeShapeType="1"/>
                </p:cNvSpPr>
                <p:nvPr/>
              </p:nvSpPr>
              <p:spPr bwMode="auto">
                <a:xfrm flipV="1">
                  <a:off x="4570" y="1238"/>
                  <a:ext cx="704" cy="422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91" name="Freeform 75"/>
                <p:cNvSpPr/>
                <p:nvPr/>
              </p:nvSpPr>
              <p:spPr bwMode="auto">
                <a:xfrm>
                  <a:off x="4478" y="1537"/>
                  <a:ext cx="48" cy="60"/>
                </a:xfrm>
                <a:custGeom>
                  <a:avLst/>
                  <a:gdLst>
                    <a:gd name="T0" fmla="*/ 48 w 48"/>
                    <a:gd name="T1" fmla="*/ 60 h 60"/>
                    <a:gd name="T2" fmla="*/ 45 w 48"/>
                    <a:gd name="T3" fmla="*/ 57 h 60"/>
                    <a:gd name="T4" fmla="*/ 43 w 48"/>
                    <a:gd name="T5" fmla="*/ 53 h 60"/>
                    <a:gd name="T6" fmla="*/ 40 w 48"/>
                    <a:gd name="T7" fmla="*/ 50 h 60"/>
                    <a:gd name="T8" fmla="*/ 37 w 48"/>
                    <a:gd name="T9" fmla="*/ 46 h 60"/>
                    <a:gd name="T10" fmla="*/ 35 w 48"/>
                    <a:gd name="T11" fmla="*/ 43 h 60"/>
                    <a:gd name="T12" fmla="*/ 32 w 48"/>
                    <a:gd name="T13" fmla="*/ 40 h 60"/>
                    <a:gd name="T14" fmla="*/ 30 w 48"/>
                    <a:gd name="T15" fmla="*/ 36 h 60"/>
                    <a:gd name="T16" fmla="*/ 27 w 48"/>
                    <a:gd name="T17" fmla="*/ 33 h 60"/>
                    <a:gd name="T18" fmla="*/ 25 w 48"/>
                    <a:gd name="T19" fmla="*/ 30 h 60"/>
                    <a:gd name="T20" fmla="*/ 22 w 48"/>
                    <a:gd name="T21" fmla="*/ 26 h 60"/>
                    <a:gd name="T22" fmla="*/ 19 w 48"/>
                    <a:gd name="T23" fmla="*/ 23 h 60"/>
                    <a:gd name="T24" fmla="*/ 16 w 48"/>
                    <a:gd name="T25" fmla="*/ 20 h 60"/>
                    <a:gd name="T26" fmla="*/ 15 w 48"/>
                    <a:gd name="T27" fmla="*/ 16 h 60"/>
                    <a:gd name="T28" fmla="*/ 12 w 48"/>
                    <a:gd name="T29" fmla="*/ 13 h 60"/>
                    <a:gd name="T30" fmla="*/ 9 w 48"/>
                    <a:gd name="T31" fmla="*/ 10 h 60"/>
                    <a:gd name="T32" fmla="*/ 6 w 48"/>
                    <a:gd name="T33" fmla="*/ 6 h 60"/>
                    <a:gd name="T34" fmla="*/ 3 w 48"/>
                    <a:gd name="T35" fmla="*/ 3 h 60"/>
                    <a:gd name="T36" fmla="*/ 0 w 48"/>
                    <a:gd name="T37" fmla="*/ 0 h 6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</a:cxnLst>
                  <a:rect l="0" t="0" r="r" b="b"/>
                  <a:pathLst>
                    <a:path w="48" h="60">
                      <a:moveTo>
                        <a:pt x="48" y="60"/>
                      </a:moveTo>
                      <a:lnTo>
                        <a:pt x="45" y="57"/>
                      </a:lnTo>
                      <a:lnTo>
                        <a:pt x="43" y="53"/>
                      </a:lnTo>
                      <a:lnTo>
                        <a:pt x="40" y="50"/>
                      </a:lnTo>
                      <a:lnTo>
                        <a:pt x="37" y="46"/>
                      </a:lnTo>
                      <a:lnTo>
                        <a:pt x="35" y="43"/>
                      </a:lnTo>
                      <a:lnTo>
                        <a:pt x="32" y="40"/>
                      </a:lnTo>
                      <a:lnTo>
                        <a:pt x="30" y="36"/>
                      </a:lnTo>
                      <a:lnTo>
                        <a:pt x="27" y="33"/>
                      </a:lnTo>
                      <a:lnTo>
                        <a:pt x="25" y="30"/>
                      </a:lnTo>
                      <a:lnTo>
                        <a:pt x="22" y="26"/>
                      </a:lnTo>
                      <a:lnTo>
                        <a:pt x="19" y="23"/>
                      </a:lnTo>
                      <a:lnTo>
                        <a:pt x="16" y="20"/>
                      </a:lnTo>
                      <a:lnTo>
                        <a:pt x="15" y="16"/>
                      </a:lnTo>
                      <a:lnTo>
                        <a:pt x="12" y="13"/>
                      </a:lnTo>
                      <a:lnTo>
                        <a:pt x="9" y="10"/>
                      </a:lnTo>
                      <a:lnTo>
                        <a:pt x="6" y="6"/>
                      </a:lnTo>
                      <a:lnTo>
                        <a:pt x="3" y="3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92" name="Freeform 76"/>
                <p:cNvSpPr/>
                <p:nvPr/>
              </p:nvSpPr>
              <p:spPr bwMode="auto">
                <a:xfrm>
                  <a:off x="4526" y="1597"/>
                  <a:ext cx="43" cy="65"/>
                </a:xfrm>
                <a:custGeom>
                  <a:avLst/>
                  <a:gdLst>
                    <a:gd name="T0" fmla="*/ 1 w 43"/>
                    <a:gd name="T1" fmla="*/ 1 h 65"/>
                    <a:gd name="T2" fmla="*/ 1 w 43"/>
                    <a:gd name="T3" fmla="*/ 3 h 65"/>
                    <a:gd name="T4" fmla="*/ 2 w 43"/>
                    <a:gd name="T5" fmla="*/ 4 h 65"/>
                    <a:gd name="T6" fmla="*/ 4 w 43"/>
                    <a:gd name="T7" fmla="*/ 6 h 65"/>
                    <a:gd name="T8" fmla="*/ 4 w 43"/>
                    <a:gd name="T9" fmla="*/ 7 h 65"/>
                    <a:gd name="T10" fmla="*/ 5 w 43"/>
                    <a:gd name="T11" fmla="*/ 9 h 65"/>
                    <a:gd name="T12" fmla="*/ 7 w 43"/>
                    <a:gd name="T13" fmla="*/ 10 h 65"/>
                    <a:gd name="T14" fmla="*/ 8 w 43"/>
                    <a:gd name="T15" fmla="*/ 12 h 65"/>
                    <a:gd name="T16" fmla="*/ 8 w 43"/>
                    <a:gd name="T17" fmla="*/ 13 h 65"/>
                    <a:gd name="T18" fmla="*/ 10 w 43"/>
                    <a:gd name="T19" fmla="*/ 14 h 65"/>
                    <a:gd name="T20" fmla="*/ 11 w 43"/>
                    <a:gd name="T21" fmla="*/ 16 h 65"/>
                    <a:gd name="T22" fmla="*/ 11 w 43"/>
                    <a:gd name="T23" fmla="*/ 17 h 65"/>
                    <a:gd name="T24" fmla="*/ 12 w 43"/>
                    <a:gd name="T25" fmla="*/ 19 h 65"/>
                    <a:gd name="T26" fmla="*/ 14 w 43"/>
                    <a:gd name="T27" fmla="*/ 20 h 65"/>
                    <a:gd name="T28" fmla="*/ 14 w 43"/>
                    <a:gd name="T29" fmla="*/ 22 h 65"/>
                    <a:gd name="T30" fmla="*/ 15 w 43"/>
                    <a:gd name="T31" fmla="*/ 23 h 65"/>
                    <a:gd name="T32" fmla="*/ 17 w 43"/>
                    <a:gd name="T33" fmla="*/ 24 h 65"/>
                    <a:gd name="T34" fmla="*/ 18 w 43"/>
                    <a:gd name="T35" fmla="*/ 26 h 65"/>
                    <a:gd name="T36" fmla="*/ 18 w 43"/>
                    <a:gd name="T37" fmla="*/ 27 h 65"/>
                    <a:gd name="T38" fmla="*/ 20 w 43"/>
                    <a:gd name="T39" fmla="*/ 29 h 65"/>
                    <a:gd name="T40" fmla="*/ 21 w 43"/>
                    <a:gd name="T41" fmla="*/ 30 h 65"/>
                    <a:gd name="T42" fmla="*/ 21 w 43"/>
                    <a:gd name="T43" fmla="*/ 32 h 65"/>
                    <a:gd name="T44" fmla="*/ 22 w 43"/>
                    <a:gd name="T45" fmla="*/ 33 h 65"/>
                    <a:gd name="T46" fmla="*/ 24 w 43"/>
                    <a:gd name="T47" fmla="*/ 34 h 65"/>
                    <a:gd name="T48" fmla="*/ 24 w 43"/>
                    <a:gd name="T49" fmla="*/ 36 h 65"/>
                    <a:gd name="T50" fmla="*/ 25 w 43"/>
                    <a:gd name="T51" fmla="*/ 37 h 65"/>
                    <a:gd name="T52" fmla="*/ 27 w 43"/>
                    <a:gd name="T53" fmla="*/ 39 h 65"/>
                    <a:gd name="T54" fmla="*/ 27 w 43"/>
                    <a:gd name="T55" fmla="*/ 40 h 65"/>
                    <a:gd name="T56" fmla="*/ 28 w 43"/>
                    <a:gd name="T57" fmla="*/ 42 h 65"/>
                    <a:gd name="T58" fmla="*/ 30 w 43"/>
                    <a:gd name="T59" fmla="*/ 43 h 65"/>
                    <a:gd name="T60" fmla="*/ 30 w 43"/>
                    <a:gd name="T61" fmla="*/ 45 h 65"/>
                    <a:gd name="T62" fmla="*/ 31 w 43"/>
                    <a:gd name="T63" fmla="*/ 46 h 65"/>
                    <a:gd name="T64" fmla="*/ 33 w 43"/>
                    <a:gd name="T65" fmla="*/ 47 h 65"/>
                    <a:gd name="T66" fmla="*/ 33 w 43"/>
                    <a:gd name="T67" fmla="*/ 49 h 65"/>
                    <a:gd name="T68" fmla="*/ 34 w 43"/>
                    <a:gd name="T69" fmla="*/ 50 h 65"/>
                    <a:gd name="T70" fmla="*/ 34 w 43"/>
                    <a:gd name="T71" fmla="*/ 52 h 65"/>
                    <a:gd name="T72" fmla="*/ 35 w 43"/>
                    <a:gd name="T73" fmla="*/ 53 h 65"/>
                    <a:gd name="T74" fmla="*/ 37 w 43"/>
                    <a:gd name="T75" fmla="*/ 56 h 65"/>
                    <a:gd name="T76" fmla="*/ 37 w 43"/>
                    <a:gd name="T77" fmla="*/ 57 h 65"/>
                    <a:gd name="T78" fmla="*/ 38 w 43"/>
                    <a:gd name="T79" fmla="*/ 59 h 65"/>
                    <a:gd name="T80" fmla="*/ 40 w 43"/>
                    <a:gd name="T81" fmla="*/ 60 h 65"/>
                    <a:gd name="T82" fmla="*/ 40 w 43"/>
                    <a:gd name="T83" fmla="*/ 62 h 65"/>
                    <a:gd name="T84" fmla="*/ 41 w 43"/>
                    <a:gd name="T85" fmla="*/ 63 h 65"/>
                    <a:gd name="T86" fmla="*/ 43 w 43"/>
                    <a:gd name="T87" fmla="*/ 65 h 6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</a:cxnLst>
                  <a:rect l="0" t="0" r="r" b="b"/>
                  <a:pathLst>
                    <a:path w="43" h="65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1" y="1"/>
                      </a:lnTo>
                      <a:lnTo>
                        <a:pt x="1" y="1"/>
                      </a:lnTo>
                      <a:lnTo>
                        <a:pt x="1" y="1"/>
                      </a:lnTo>
                      <a:lnTo>
                        <a:pt x="1" y="3"/>
                      </a:lnTo>
                      <a:lnTo>
                        <a:pt x="2" y="3"/>
                      </a:lnTo>
                      <a:lnTo>
                        <a:pt x="2" y="3"/>
                      </a:lnTo>
                      <a:lnTo>
                        <a:pt x="2" y="4"/>
                      </a:lnTo>
                      <a:lnTo>
                        <a:pt x="2" y="4"/>
                      </a:lnTo>
                      <a:lnTo>
                        <a:pt x="4" y="4"/>
                      </a:lnTo>
                      <a:lnTo>
                        <a:pt x="4" y="6"/>
                      </a:lnTo>
                      <a:lnTo>
                        <a:pt x="4" y="6"/>
                      </a:lnTo>
                      <a:lnTo>
                        <a:pt x="4" y="6"/>
                      </a:lnTo>
                      <a:lnTo>
                        <a:pt x="4" y="7"/>
                      </a:lnTo>
                      <a:lnTo>
                        <a:pt x="5" y="7"/>
                      </a:lnTo>
                      <a:lnTo>
                        <a:pt x="5" y="7"/>
                      </a:lnTo>
                      <a:lnTo>
                        <a:pt x="5" y="9"/>
                      </a:lnTo>
                      <a:lnTo>
                        <a:pt x="5" y="9"/>
                      </a:lnTo>
                      <a:lnTo>
                        <a:pt x="7" y="9"/>
                      </a:lnTo>
                      <a:lnTo>
                        <a:pt x="7" y="10"/>
                      </a:lnTo>
                      <a:lnTo>
                        <a:pt x="7" y="10"/>
                      </a:lnTo>
                      <a:lnTo>
                        <a:pt x="7" y="10"/>
                      </a:lnTo>
                      <a:lnTo>
                        <a:pt x="8" y="12"/>
                      </a:lnTo>
                      <a:lnTo>
                        <a:pt x="8" y="12"/>
                      </a:lnTo>
                      <a:lnTo>
                        <a:pt x="8" y="12"/>
                      </a:lnTo>
                      <a:lnTo>
                        <a:pt x="8" y="13"/>
                      </a:lnTo>
                      <a:lnTo>
                        <a:pt x="10" y="13"/>
                      </a:lnTo>
                      <a:lnTo>
                        <a:pt x="10" y="13"/>
                      </a:lnTo>
                      <a:lnTo>
                        <a:pt x="10" y="14"/>
                      </a:lnTo>
                      <a:lnTo>
                        <a:pt x="10" y="14"/>
                      </a:lnTo>
                      <a:lnTo>
                        <a:pt x="10" y="14"/>
                      </a:lnTo>
                      <a:lnTo>
                        <a:pt x="11" y="16"/>
                      </a:lnTo>
                      <a:lnTo>
                        <a:pt x="11" y="16"/>
                      </a:lnTo>
                      <a:lnTo>
                        <a:pt x="11" y="16"/>
                      </a:lnTo>
                      <a:lnTo>
                        <a:pt x="11" y="17"/>
                      </a:lnTo>
                      <a:lnTo>
                        <a:pt x="12" y="17"/>
                      </a:lnTo>
                      <a:lnTo>
                        <a:pt x="12" y="17"/>
                      </a:lnTo>
                      <a:lnTo>
                        <a:pt x="12" y="19"/>
                      </a:lnTo>
                      <a:lnTo>
                        <a:pt x="12" y="19"/>
                      </a:lnTo>
                      <a:lnTo>
                        <a:pt x="14" y="19"/>
                      </a:lnTo>
                      <a:lnTo>
                        <a:pt x="14" y="20"/>
                      </a:lnTo>
                      <a:lnTo>
                        <a:pt x="14" y="20"/>
                      </a:lnTo>
                      <a:lnTo>
                        <a:pt x="14" y="20"/>
                      </a:lnTo>
                      <a:lnTo>
                        <a:pt x="14" y="22"/>
                      </a:lnTo>
                      <a:lnTo>
                        <a:pt x="15" y="22"/>
                      </a:lnTo>
                      <a:lnTo>
                        <a:pt x="15" y="22"/>
                      </a:lnTo>
                      <a:lnTo>
                        <a:pt x="15" y="23"/>
                      </a:lnTo>
                      <a:lnTo>
                        <a:pt x="15" y="23"/>
                      </a:lnTo>
                      <a:lnTo>
                        <a:pt x="17" y="23"/>
                      </a:lnTo>
                      <a:lnTo>
                        <a:pt x="17" y="24"/>
                      </a:lnTo>
                      <a:lnTo>
                        <a:pt x="17" y="24"/>
                      </a:lnTo>
                      <a:lnTo>
                        <a:pt x="17" y="26"/>
                      </a:lnTo>
                      <a:lnTo>
                        <a:pt x="18" y="26"/>
                      </a:lnTo>
                      <a:lnTo>
                        <a:pt x="18" y="26"/>
                      </a:lnTo>
                      <a:lnTo>
                        <a:pt x="18" y="27"/>
                      </a:lnTo>
                      <a:lnTo>
                        <a:pt x="18" y="27"/>
                      </a:lnTo>
                      <a:lnTo>
                        <a:pt x="18" y="27"/>
                      </a:lnTo>
                      <a:lnTo>
                        <a:pt x="20" y="29"/>
                      </a:lnTo>
                      <a:lnTo>
                        <a:pt x="20" y="29"/>
                      </a:lnTo>
                      <a:lnTo>
                        <a:pt x="20" y="29"/>
                      </a:lnTo>
                      <a:lnTo>
                        <a:pt x="20" y="30"/>
                      </a:lnTo>
                      <a:lnTo>
                        <a:pt x="21" y="30"/>
                      </a:lnTo>
                      <a:lnTo>
                        <a:pt x="21" y="30"/>
                      </a:lnTo>
                      <a:lnTo>
                        <a:pt x="21" y="32"/>
                      </a:lnTo>
                      <a:lnTo>
                        <a:pt x="21" y="32"/>
                      </a:lnTo>
                      <a:lnTo>
                        <a:pt x="21" y="32"/>
                      </a:lnTo>
                      <a:lnTo>
                        <a:pt x="22" y="33"/>
                      </a:lnTo>
                      <a:lnTo>
                        <a:pt x="22" y="33"/>
                      </a:lnTo>
                      <a:lnTo>
                        <a:pt x="22" y="33"/>
                      </a:lnTo>
                      <a:lnTo>
                        <a:pt x="22" y="34"/>
                      </a:lnTo>
                      <a:lnTo>
                        <a:pt x="24" y="34"/>
                      </a:lnTo>
                      <a:lnTo>
                        <a:pt x="24" y="34"/>
                      </a:lnTo>
                      <a:lnTo>
                        <a:pt x="24" y="36"/>
                      </a:lnTo>
                      <a:lnTo>
                        <a:pt x="24" y="36"/>
                      </a:lnTo>
                      <a:lnTo>
                        <a:pt x="24" y="36"/>
                      </a:lnTo>
                      <a:lnTo>
                        <a:pt x="25" y="37"/>
                      </a:lnTo>
                      <a:lnTo>
                        <a:pt x="25" y="37"/>
                      </a:lnTo>
                      <a:lnTo>
                        <a:pt x="25" y="37"/>
                      </a:lnTo>
                      <a:lnTo>
                        <a:pt x="25" y="39"/>
                      </a:lnTo>
                      <a:lnTo>
                        <a:pt x="27" y="39"/>
                      </a:lnTo>
                      <a:lnTo>
                        <a:pt x="27" y="39"/>
                      </a:lnTo>
                      <a:lnTo>
                        <a:pt x="27" y="40"/>
                      </a:lnTo>
                      <a:lnTo>
                        <a:pt x="27" y="40"/>
                      </a:lnTo>
                      <a:lnTo>
                        <a:pt x="27" y="40"/>
                      </a:lnTo>
                      <a:lnTo>
                        <a:pt x="28" y="42"/>
                      </a:lnTo>
                      <a:lnTo>
                        <a:pt x="28" y="42"/>
                      </a:lnTo>
                      <a:lnTo>
                        <a:pt x="28" y="43"/>
                      </a:lnTo>
                      <a:lnTo>
                        <a:pt x="28" y="43"/>
                      </a:lnTo>
                      <a:lnTo>
                        <a:pt x="30" y="43"/>
                      </a:lnTo>
                      <a:lnTo>
                        <a:pt x="30" y="45"/>
                      </a:lnTo>
                      <a:lnTo>
                        <a:pt x="30" y="45"/>
                      </a:lnTo>
                      <a:lnTo>
                        <a:pt x="30" y="45"/>
                      </a:lnTo>
                      <a:lnTo>
                        <a:pt x="30" y="46"/>
                      </a:lnTo>
                      <a:lnTo>
                        <a:pt x="31" y="46"/>
                      </a:lnTo>
                      <a:lnTo>
                        <a:pt x="31" y="46"/>
                      </a:lnTo>
                      <a:lnTo>
                        <a:pt x="31" y="47"/>
                      </a:lnTo>
                      <a:lnTo>
                        <a:pt x="31" y="47"/>
                      </a:lnTo>
                      <a:lnTo>
                        <a:pt x="33" y="47"/>
                      </a:lnTo>
                      <a:lnTo>
                        <a:pt x="33" y="49"/>
                      </a:lnTo>
                      <a:lnTo>
                        <a:pt x="33" y="49"/>
                      </a:lnTo>
                      <a:lnTo>
                        <a:pt x="33" y="49"/>
                      </a:lnTo>
                      <a:lnTo>
                        <a:pt x="33" y="50"/>
                      </a:lnTo>
                      <a:lnTo>
                        <a:pt x="34" y="50"/>
                      </a:lnTo>
                      <a:lnTo>
                        <a:pt x="34" y="50"/>
                      </a:lnTo>
                      <a:lnTo>
                        <a:pt x="34" y="52"/>
                      </a:lnTo>
                      <a:lnTo>
                        <a:pt x="34" y="52"/>
                      </a:lnTo>
                      <a:lnTo>
                        <a:pt x="34" y="52"/>
                      </a:lnTo>
                      <a:lnTo>
                        <a:pt x="35" y="53"/>
                      </a:lnTo>
                      <a:lnTo>
                        <a:pt x="35" y="53"/>
                      </a:lnTo>
                      <a:lnTo>
                        <a:pt x="35" y="53"/>
                      </a:lnTo>
                      <a:lnTo>
                        <a:pt x="35" y="55"/>
                      </a:lnTo>
                      <a:lnTo>
                        <a:pt x="37" y="55"/>
                      </a:lnTo>
                      <a:lnTo>
                        <a:pt x="37" y="56"/>
                      </a:lnTo>
                      <a:lnTo>
                        <a:pt x="37" y="56"/>
                      </a:lnTo>
                      <a:lnTo>
                        <a:pt x="37" y="56"/>
                      </a:lnTo>
                      <a:lnTo>
                        <a:pt x="37" y="57"/>
                      </a:lnTo>
                      <a:lnTo>
                        <a:pt x="38" y="57"/>
                      </a:lnTo>
                      <a:lnTo>
                        <a:pt x="38" y="57"/>
                      </a:lnTo>
                      <a:lnTo>
                        <a:pt x="38" y="59"/>
                      </a:lnTo>
                      <a:lnTo>
                        <a:pt x="38" y="59"/>
                      </a:lnTo>
                      <a:lnTo>
                        <a:pt x="38" y="59"/>
                      </a:lnTo>
                      <a:lnTo>
                        <a:pt x="40" y="60"/>
                      </a:lnTo>
                      <a:lnTo>
                        <a:pt x="40" y="60"/>
                      </a:lnTo>
                      <a:lnTo>
                        <a:pt x="40" y="60"/>
                      </a:lnTo>
                      <a:lnTo>
                        <a:pt x="40" y="62"/>
                      </a:lnTo>
                      <a:lnTo>
                        <a:pt x="41" y="62"/>
                      </a:lnTo>
                      <a:lnTo>
                        <a:pt x="41" y="62"/>
                      </a:lnTo>
                      <a:lnTo>
                        <a:pt x="41" y="63"/>
                      </a:lnTo>
                      <a:lnTo>
                        <a:pt x="41" y="63"/>
                      </a:lnTo>
                      <a:lnTo>
                        <a:pt x="41" y="63"/>
                      </a:lnTo>
                      <a:lnTo>
                        <a:pt x="43" y="65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94" name="Line 78"/>
                <p:cNvSpPr>
                  <a:spLocks noChangeShapeType="1"/>
                </p:cNvSpPr>
                <p:nvPr/>
              </p:nvSpPr>
              <p:spPr bwMode="auto">
                <a:xfrm flipV="1">
                  <a:off x="4472" y="1598"/>
                  <a:ext cx="51" cy="38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95" name="Rectangle 79"/>
                <p:cNvSpPr>
                  <a:spLocks noChangeArrowheads="1"/>
                </p:cNvSpPr>
                <p:nvPr/>
              </p:nvSpPr>
              <p:spPr bwMode="auto">
                <a:xfrm rot="20040000">
                  <a:off x="5437" y="1205"/>
                  <a:ext cx="206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F-A2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96" name="Line 80"/>
                <p:cNvSpPr>
                  <a:spLocks noChangeShapeType="1"/>
                </p:cNvSpPr>
                <p:nvPr/>
              </p:nvSpPr>
              <p:spPr bwMode="auto">
                <a:xfrm flipV="1">
                  <a:off x="4546" y="1369"/>
                  <a:ext cx="798" cy="389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97" name="Freeform 81"/>
                <p:cNvSpPr/>
                <p:nvPr/>
              </p:nvSpPr>
              <p:spPr bwMode="auto">
                <a:xfrm>
                  <a:off x="4470" y="1637"/>
                  <a:ext cx="38" cy="59"/>
                </a:xfrm>
                <a:custGeom>
                  <a:avLst/>
                  <a:gdLst>
                    <a:gd name="T0" fmla="*/ 38 w 38"/>
                    <a:gd name="T1" fmla="*/ 59 h 59"/>
                    <a:gd name="T2" fmla="*/ 37 w 38"/>
                    <a:gd name="T3" fmla="*/ 56 h 59"/>
                    <a:gd name="T4" fmla="*/ 34 w 38"/>
                    <a:gd name="T5" fmla="*/ 52 h 59"/>
                    <a:gd name="T6" fmla="*/ 33 w 38"/>
                    <a:gd name="T7" fmla="*/ 49 h 59"/>
                    <a:gd name="T8" fmla="*/ 30 w 38"/>
                    <a:gd name="T9" fmla="*/ 46 h 59"/>
                    <a:gd name="T10" fmla="*/ 28 w 38"/>
                    <a:gd name="T11" fmla="*/ 42 h 59"/>
                    <a:gd name="T12" fmla="*/ 25 w 38"/>
                    <a:gd name="T13" fmla="*/ 39 h 59"/>
                    <a:gd name="T14" fmla="*/ 24 w 38"/>
                    <a:gd name="T15" fmla="*/ 35 h 59"/>
                    <a:gd name="T16" fmla="*/ 21 w 38"/>
                    <a:gd name="T17" fmla="*/ 32 h 59"/>
                    <a:gd name="T18" fmla="*/ 18 w 38"/>
                    <a:gd name="T19" fmla="*/ 27 h 59"/>
                    <a:gd name="T20" fmla="*/ 17 w 38"/>
                    <a:gd name="T21" fmla="*/ 25 h 59"/>
                    <a:gd name="T22" fmla="*/ 14 w 38"/>
                    <a:gd name="T23" fmla="*/ 20 h 59"/>
                    <a:gd name="T24" fmla="*/ 12 w 38"/>
                    <a:gd name="T25" fmla="*/ 17 h 59"/>
                    <a:gd name="T26" fmla="*/ 10 w 38"/>
                    <a:gd name="T27" fmla="*/ 15 h 59"/>
                    <a:gd name="T28" fmla="*/ 7 w 38"/>
                    <a:gd name="T29" fmla="*/ 10 h 59"/>
                    <a:gd name="T30" fmla="*/ 5 w 38"/>
                    <a:gd name="T31" fmla="*/ 7 h 59"/>
                    <a:gd name="T32" fmla="*/ 2 w 38"/>
                    <a:gd name="T33" fmla="*/ 3 h 59"/>
                    <a:gd name="T34" fmla="*/ 0 w 38"/>
                    <a:gd name="T35" fmla="*/ 0 h 5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38" h="59">
                      <a:moveTo>
                        <a:pt x="38" y="59"/>
                      </a:moveTo>
                      <a:lnTo>
                        <a:pt x="37" y="56"/>
                      </a:lnTo>
                      <a:lnTo>
                        <a:pt x="34" y="52"/>
                      </a:lnTo>
                      <a:lnTo>
                        <a:pt x="33" y="49"/>
                      </a:lnTo>
                      <a:lnTo>
                        <a:pt x="30" y="46"/>
                      </a:lnTo>
                      <a:lnTo>
                        <a:pt x="28" y="42"/>
                      </a:lnTo>
                      <a:lnTo>
                        <a:pt x="25" y="39"/>
                      </a:lnTo>
                      <a:lnTo>
                        <a:pt x="24" y="35"/>
                      </a:lnTo>
                      <a:lnTo>
                        <a:pt x="21" y="32"/>
                      </a:lnTo>
                      <a:lnTo>
                        <a:pt x="18" y="27"/>
                      </a:lnTo>
                      <a:lnTo>
                        <a:pt x="17" y="25"/>
                      </a:lnTo>
                      <a:lnTo>
                        <a:pt x="14" y="20"/>
                      </a:lnTo>
                      <a:lnTo>
                        <a:pt x="12" y="17"/>
                      </a:lnTo>
                      <a:lnTo>
                        <a:pt x="10" y="15"/>
                      </a:lnTo>
                      <a:lnTo>
                        <a:pt x="7" y="10"/>
                      </a:lnTo>
                      <a:lnTo>
                        <a:pt x="5" y="7"/>
                      </a:lnTo>
                      <a:lnTo>
                        <a:pt x="2" y="3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98" name="Freeform 82"/>
                <p:cNvSpPr/>
                <p:nvPr/>
              </p:nvSpPr>
              <p:spPr bwMode="auto">
                <a:xfrm>
                  <a:off x="4508" y="1696"/>
                  <a:ext cx="35" cy="63"/>
                </a:xfrm>
                <a:custGeom>
                  <a:avLst/>
                  <a:gdLst>
                    <a:gd name="T0" fmla="*/ 2 w 35"/>
                    <a:gd name="T1" fmla="*/ 1 h 63"/>
                    <a:gd name="T2" fmla="*/ 2 w 35"/>
                    <a:gd name="T3" fmla="*/ 3 h 63"/>
                    <a:gd name="T4" fmla="*/ 3 w 35"/>
                    <a:gd name="T5" fmla="*/ 4 h 63"/>
                    <a:gd name="T6" fmla="*/ 3 w 35"/>
                    <a:gd name="T7" fmla="*/ 6 h 63"/>
                    <a:gd name="T8" fmla="*/ 5 w 35"/>
                    <a:gd name="T9" fmla="*/ 7 h 63"/>
                    <a:gd name="T10" fmla="*/ 5 w 35"/>
                    <a:gd name="T11" fmla="*/ 7 h 63"/>
                    <a:gd name="T12" fmla="*/ 6 w 35"/>
                    <a:gd name="T13" fmla="*/ 9 h 63"/>
                    <a:gd name="T14" fmla="*/ 6 w 35"/>
                    <a:gd name="T15" fmla="*/ 10 h 63"/>
                    <a:gd name="T16" fmla="*/ 7 w 35"/>
                    <a:gd name="T17" fmla="*/ 12 h 63"/>
                    <a:gd name="T18" fmla="*/ 7 w 35"/>
                    <a:gd name="T19" fmla="*/ 13 h 63"/>
                    <a:gd name="T20" fmla="*/ 9 w 35"/>
                    <a:gd name="T21" fmla="*/ 14 h 63"/>
                    <a:gd name="T22" fmla="*/ 9 w 35"/>
                    <a:gd name="T23" fmla="*/ 16 h 63"/>
                    <a:gd name="T24" fmla="*/ 10 w 35"/>
                    <a:gd name="T25" fmla="*/ 17 h 63"/>
                    <a:gd name="T26" fmla="*/ 10 w 35"/>
                    <a:gd name="T27" fmla="*/ 17 h 63"/>
                    <a:gd name="T28" fmla="*/ 12 w 35"/>
                    <a:gd name="T29" fmla="*/ 19 h 63"/>
                    <a:gd name="T30" fmla="*/ 12 w 35"/>
                    <a:gd name="T31" fmla="*/ 20 h 63"/>
                    <a:gd name="T32" fmla="*/ 13 w 35"/>
                    <a:gd name="T33" fmla="*/ 22 h 63"/>
                    <a:gd name="T34" fmla="*/ 13 w 35"/>
                    <a:gd name="T35" fmla="*/ 23 h 63"/>
                    <a:gd name="T36" fmla="*/ 15 w 35"/>
                    <a:gd name="T37" fmla="*/ 24 h 63"/>
                    <a:gd name="T38" fmla="*/ 15 w 35"/>
                    <a:gd name="T39" fmla="*/ 26 h 63"/>
                    <a:gd name="T40" fmla="*/ 16 w 35"/>
                    <a:gd name="T41" fmla="*/ 27 h 63"/>
                    <a:gd name="T42" fmla="*/ 16 w 35"/>
                    <a:gd name="T43" fmla="*/ 29 h 63"/>
                    <a:gd name="T44" fmla="*/ 18 w 35"/>
                    <a:gd name="T45" fmla="*/ 30 h 63"/>
                    <a:gd name="T46" fmla="*/ 18 w 35"/>
                    <a:gd name="T47" fmla="*/ 30 h 63"/>
                    <a:gd name="T48" fmla="*/ 19 w 35"/>
                    <a:gd name="T49" fmla="*/ 32 h 63"/>
                    <a:gd name="T50" fmla="*/ 19 w 35"/>
                    <a:gd name="T51" fmla="*/ 33 h 63"/>
                    <a:gd name="T52" fmla="*/ 20 w 35"/>
                    <a:gd name="T53" fmla="*/ 34 h 63"/>
                    <a:gd name="T54" fmla="*/ 20 w 35"/>
                    <a:gd name="T55" fmla="*/ 36 h 63"/>
                    <a:gd name="T56" fmla="*/ 22 w 35"/>
                    <a:gd name="T57" fmla="*/ 37 h 63"/>
                    <a:gd name="T58" fmla="*/ 22 w 35"/>
                    <a:gd name="T59" fmla="*/ 39 h 63"/>
                    <a:gd name="T60" fmla="*/ 23 w 35"/>
                    <a:gd name="T61" fmla="*/ 40 h 63"/>
                    <a:gd name="T62" fmla="*/ 23 w 35"/>
                    <a:gd name="T63" fmla="*/ 42 h 63"/>
                    <a:gd name="T64" fmla="*/ 25 w 35"/>
                    <a:gd name="T65" fmla="*/ 42 h 63"/>
                    <a:gd name="T66" fmla="*/ 25 w 35"/>
                    <a:gd name="T67" fmla="*/ 43 h 63"/>
                    <a:gd name="T68" fmla="*/ 26 w 35"/>
                    <a:gd name="T69" fmla="*/ 45 h 63"/>
                    <a:gd name="T70" fmla="*/ 26 w 35"/>
                    <a:gd name="T71" fmla="*/ 46 h 63"/>
                    <a:gd name="T72" fmla="*/ 28 w 35"/>
                    <a:gd name="T73" fmla="*/ 47 h 63"/>
                    <a:gd name="T74" fmla="*/ 28 w 35"/>
                    <a:gd name="T75" fmla="*/ 49 h 63"/>
                    <a:gd name="T76" fmla="*/ 28 w 35"/>
                    <a:gd name="T77" fmla="*/ 50 h 63"/>
                    <a:gd name="T78" fmla="*/ 29 w 35"/>
                    <a:gd name="T79" fmla="*/ 52 h 63"/>
                    <a:gd name="T80" fmla="*/ 29 w 35"/>
                    <a:gd name="T81" fmla="*/ 53 h 63"/>
                    <a:gd name="T82" fmla="*/ 30 w 35"/>
                    <a:gd name="T83" fmla="*/ 55 h 63"/>
                    <a:gd name="T84" fmla="*/ 30 w 35"/>
                    <a:gd name="T85" fmla="*/ 56 h 63"/>
                    <a:gd name="T86" fmla="*/ 32 w 35"/>
                    <a:gd name="T87" fmla="*/ 56 h 63"/>
                    <a:gd name="T88" fmla="*/ 32 w 35"/>
                    <a:gd name="T89" fmla="*/ 57 h 63"/>
                    <a:gd name="T90" fmla="*/ 33 w 35"/>
                    <a:gd name="T91" fmla="*/ 59 h 63"/>
                    <a:gd name="T92" fmla="*/ 33 w 35"/>
                    <a:gd name="T93" fmla="*/ 60 h 63"/>
                    <a:gd name="T94" fmla="*/ 35 w 35"/>
                    <a:gd name="T95" fmla="*/ 62 h 63"/>
                    <a:gd name="T96" fmla="*/ 35 w 35"/>
                    <a:gd name="T97" fmla="*/ 63 h 6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  <a:cxn ang="0">
                      <a:pos x="T90" y="T91"/>
                    </a:cxn>
                    <a:cxn ang="0">
                      <a:pos x="T92" y="T93"/>
                    </a:cxn>
                    <a:cxn ang="0">
                      <a:pos x="T94" y="T95"/>
                    </a:cxn>
                    <a:cxn ang="0">
                      <a:pos x="T96" y="T97"/>
                    </a:cxn>
                  </a:cxnLst>
                  <a:rect l="0" t="0" r="r" b="b"/>
                  <a:pathLst>
                    <a:path w="35" h="63">
                      <a:moveTo>
                        <a:pt x="0" y="0"/>
                      </a:moveTo>
                      <a:lnTo>
                        <a:pt x="2" y="1"/>
                      </a:lnTo>
                      <a:lnTo>
                        <a:pt x="2" y="1"/>
                      </a:lnTo>
                      <a:lnTo>
                        <a:pt x="2" y="1"/>
                      </a:lnTo>
                      <a:lnTo>
                        <a:pt x="2" y="3"/>
                      </a:lnTo>
                      <a:lnTo>
                        <a:pt x="2" y="3"/>
                      </a:lnTo>
                      <a:lnTo>
                        <a:pt x="2" y="3"/>
                      </a:lnTo>
                      <a:lnTo>
                        <a:pt x="3" y="4"/>
                      </a:lnTo>
                      <a:lnTo>
                        <a:pt x="3" y="4"/>
                      </a:lnTo>
                      <a:lnTo>
                        <a:pt x="3" y="4"/>
                      </a:lnTo>
                      <a:lnTo>
                        <a:pt x="3" y="4"/>
                      </a:lnTo>
                      <a:lnTo>
                        <a:pt x="3" y="6"/>
                      </a:lnTo>
                      <a:lnTo>
                        <a:pt x="3" y="6"/>
                      </a:lnTo>
                      <a:lnTo>
                        <a:pt x="5" y="6"/>
                      </a:lnTo>
                      <a:lnTo>
                        <a:pt x="5" y="7"/>
                      </a:lnTo>
                      <a:lnTo>
                        <a:pt x="5" y="7"/>
                      </a:lnTo>
                      <a:lnTo>
                        <a:pt x="5" y="7"/>
                      </a:lnTo>
                      <a:lnTo>
                        <a:pt x="5" y="7"/>
                      </a:lnTo>
                      <a:lnTo>
                        <a:pt x="6" y="9"/>
                      </a:lnTo>
                      <a:lnTo>
                        <a:pt x="6" y="9"/>
                      </a:lnTo>
                      <a:lnTo>
                        <a:pt x="6" y="9"/>
                      </a:lnTo>
                      <a:lnTo>
                        <a:pt x="6" y="10"/>
                      </a:lnTo>
                      <a:lnTo>
                        <a:pt x="6" y="10"/>
                      </a:lnTo>
                      <a:lnTo>
                        <a:pt x="6" y="10"/>
                      </a:lnTo>
                      <a:lnTo>
                        <a:pt x="7" y="10"/>
                      </a:lnTo>
                      <a:lnTo>
                        <a:pt x="7" y="12"/>
                      </a:lnTo>
                      <a:lnTo>
                        <a:pt x="7" y="12"/>
                      </a:lnTo>
                      <a:lnTo>
                        <a:pt x="7" y="12"/>
                      </a:lnTo>
                      <a:lnTo>
                        <a:pt x="7" y="13"/>
                      </a:lnTo>
                      <a:lnTo>
                        <a:pt x="7" y="13"/>
                      </a:lnTo>
                      <a:lnTo>
                        <a:pt x="9" y="13"/>
                      </a:lnTo>
                      <a:lnTo>
                        <a:pt x="9" y="14"/>
                      </a:lnTo>
                      <a:lnTo>
                        <a:pt x="9" y="14"/>
                      </a:lnTo>
                      <a:lnTo>
                        <a:pt x="9" y="14"/>
                      </a:lnTo>
                      <a:lnTo>
                        <a:pt x="9" y="14"/>
                      </a:lnTo>
                      <a:lnTo>
                        <a:pt x="9" y="16"/>
                      </a:lnTo>
                      <a:lnTo>
                        <a:pt x="10" y="16"/>
                      </a:lnTo>
                      <a:lnTo>
                        <a:pt x="10" y="16"/>
                      </a:lnTo>
                      <a:lnTo>
                        <a:pt x="10" y="17"/>
                      </a:lnTo>
                      <a:lnTo>
                        <a:pt x="10" y="17"/>
                      </a:lnTo>
                      <a:lnTo>
                        <a:pt x="10" y="17"/>
                      </a:lnTo>
                      <a:lnTo>
                        <a:pt x="10" y="17"/>
                      </a:lnTo>
                      <a:lnTo>
                        <a:pt x="12" y="19"/>
                      </a:lnTo>
                      <a:lnTo>
                        <a:pt x="12" y="19"/>
                      </a:lnTo>
                      <a:lnTo>
                        <a:pt x="12" y="19"/>
                      </a:lnTo>
                      <a:lnTo>
                        <a:pt x="12" y="20"/>
                      </a:lnTo>
                      <a:lnTo>
                        <a:pt x="12" y="20"/>
                      </a:lnTo>
                      <a:lnTo>
                        <a:pt x="12" y="20"/>
                      </a:lnTo>
                      <a:lnTo>
                        <a:pt x="13" y="22"/>
                      </a:lnTo>
                      <a:lnTo>
                        <a:pt x="13" y="22"/>
                      </a:lnTo>
                      <a:lnTo>
                        <a:pt x="13" y="22"/>
                      </a:lnTo>
                      <a:lnTo>
                        <a:pt x="13" y="22"/>
                      </a:lnTo>
                      <a:lnTo>
                        <a:pt x="13" y="23"/>
                      </a:lnTo>
                      <a:lnTo>
                        <a:pt x="13" y="23"/>
                      </a:lnTo>
                      <a:lnTo>
                        <a:pt x="15" y="23"/>
                      </a:lnTo>
                      <a:lnTo>
                        <a:pt x="15" y="24"/>
                      </a:lnTo>
                      <a:lnTo>
                        <a:pt x="15" y="24"/>
                      </a:lnTo>
                      <a:lnTo>
                        <a:pt x="15" y="24"/>
                      </a:lnTo>
                      <a:lnTo>
                        <a:pt x="15" y="26"/>
                      </a:lnTo>
                      <a:lnTo>
                        <a:pt x="15" y="26"/>
                      </a:lnTo>
                      <a:lnTo>
                        <a:pt x="16" y="26"/>
                      </a:lnTo>
                      <a:lnTo>
                        <a:pt x="16" y="26"/>
                      </a:lnTo>
                      <a:lnTo>
                        <a:pt x="16" y="27"/>
                      </a:lnTo>
                      <a:lnTo>
                        <a:pt x="16" y="27"/>
                      </a:lnTo>
                      <a:lnTo>
                        <a:pt x="16" y="27"/>
                      </a:lnTo>
                      <a:lnTo>
                        <a:pt x="16" y="29"/>
                      </a:lnTo>
                      <a:lnTo>
                        <a:pt x="18" y="29"/>
                      </a:lnTo>
                      <a:lnTo>
                        <a:pt x="18" y="29"/>
                      </a:lnTo>
                      <a:lnTo>
                        <a:pt x="18" y="30"/>
                      </a:lnTo>
                      <a:lnTo>
                        <a:pt x="18" y="30"/>
                      </a:lnTo>
                      <a:lnTo>
                        <a:pt x="18" y="30"/>
                      </a:lnTo>
                      <a:lnTo>
                        <a:pt x="18" y="30"/>
                      </a:lnTo>
                      <a:lnTo>
                        <a:pt x="18" y="32"/>
                      </a:lnTo>
                      <a:lnTo>
                        <a:pt x="19" y="32"/>
                      </a:lnTo>
                      <a:lnTo>
                        <a:pt x="19" y="32"/>
                      </a:lnTo>
                      <a:lnTo>
                        <a:pt x="19" y="33"/>
                      </a:lnTo>
                      <a:lnTo>
                        <a:pt x="19" y="33"/>
                      </a:lnTo>
                      <a:lnTo>
                        <a:pt x="19" y="33"/>
                      </a:lnTo>
                      <a:lnTo>
                        <a:pt x="19" y="33"/>
                      </a:lnTo>
                      <a:lnTo>
                        <a:pt x="20" y="34"/>
                      </a:lnTo>
                      <a:lnTo>
                        <a:pt x="20" y="34"/>
                      </a:lnTo>
                      <a:lnTo>
                        <a:pt x="20" y="34"/>
                      </a:lnTo>
                      <a:lnTo>
                        <a:pt x="20" y="36"/>
                      </a:lnTo>
                      <a:lnTo>
                        <a:pt x="20" y="36"/>
                      </a:lnTo>
                      <a:lnTo>
                        <a:pt x="20" y="36"/>
                      </a:lnTo>
                      <a:lnTo>
                        <a:pt x="22" y="37"/>
                      </a:lnTo>
                      <a:lnTo>
                        <a:pt x="22" y="37"/>
                      </a:lnTo>
                      <a:lnTo>
                        <a:pt x="22" y="37"/>
                      </a:lnTo>
                      <a:lnTo>
                        <a:pt x="22" y="37"/>
                      </a:lnTo>
                      <a:lnTo>
                        <a:pt x="22" y="39"/>
                      </a:lnTo>
                      <a:lnTo>
                        <a:pt x="22" y="39"/>
                      </a:lnTo>
                      <a:lnTo>
                        <a:pt x="23" y="39"/>
                      </a:lnTo>
                      <a:lnTo>
                        <a:pt x="23" y="40"/>
                      </a:lnTo>
                      <a:lnTo>
                        <a:pt x="23" y="40"/>
                      </a:lnTo>
                      <a:lnTo>
                        <a:pt x="23" y="40"/>
                      </a:lnTo>
                      <a:lnTo>
                        <a:pt x="23" y="42"/>
                      </a:lnTo>
                      <a:lnTo>
                        <a:pt x="23" y="42"/>
                      </a:lnTo>
                      <a:lnTo>
                        <a:pt x="23" y="42"/>
                      </a:lnTo>
                      <a:lnTo>
                        <a:pt x="25" y="42"/>
                      </a:lnTo>
                      <a:lnTo>
                        <a:pt x="25" y="43"/>
                      </a:lnTo>
                      <a:lnTo>
                        <a:pt x="25" y="43"/>
                      </a:lnTo>
                      <a:lnTo>
                        <a:pt x="25" y="43"/>
                      </a:lnTo>
                      <a:lnTo>
                        <a:pt x="25" y="45"/>
                      </a:lnTo>
                      <a:lnTo>
                        <a:pt x="25" y="45"/>
                      </a:lnTo>
                      <a:lnTo>
                        <a:pt x="26" y="45"/>
                      </a:lnTo>
                      <a:lnTo>
                        <a:pt x="26" y="46"/>
                      </a:lnTo>
                      <a:lnTo>
                        <a:pt x="26" y="46"/>
                      </a:lnTo>
                      <a:lnTo>
                        <a:pt x="26" y="46"/>
                      </a:lnTo>
                      <a:lnTo>
                        <a:pt x="26" y="46"/>
                      </a:lnTo>
                      <a:lnTo>
                        <a:pt x="26" y="47"/>
                      </a:lnTo>
                      <a:lnTo>
                        <a:pt x="28" y="47"/>
                      </a:lnTo>
                      <a:lnTo>
                        <a:pt x="28" y="47"/>
                      </a:lnTo>
                      <a:lnTo>
                        <a:pt x="28" y="49"/>
                      </a:lnTo>
                      <a:lnTo>
                        <a:pt x="28" y="49"/>
                      </a:lnTo>
                      <a:lnTo>
                        <a:pt x="28" y="49"/>
                      </a:lnTo>
                      <a:lnTo>
                        <a:pt x="28" y="50"/>
                      </a:lnTo>
                      <a:lnTo>
                        <a:pt x="28" y="50"/>
                      </a:lnTo>
                      <a:lnTo>
                        <a:pt x="29" y="50"/>
                      </a:lnTo>
                      <a:lnTo>
                        <a:pt x="29" y="52"/>
                      </a:lnTo>
                      <a:lnTo>
                        <a:pt x="29" y="52"/>
                      </a:lnTo>
                      <a:lnTo>
                        <a:pt x="29" y="52"/>
                      </a:lnTo>
                      <a:lnTo>
                        <a:pt x="29" y="52"/>
                      </a:lnTo>
                      <a:lnTo>
                        <a:pt x="29" y="53"/>
                      </a:lnTo>
                      <a:lnTo>
                        <a:pt x="29" y="53"/>
                      </a:lnTo>
                      <a:lnTo>
                        <a:pt x="30" y="53"/>
                      </a:lnTo>
                      <a:lnTo>
                        <a:pt x="30" y="55"/>
                      </a:lnTo>
                      <a:lnTo>
                        <a:pt x="30" y="55"/>
                      </a:lnTo>
                      <a:lnTo>
                        <a:pt x="30" y="55"/>
                      </a:lnTo>
                      <a:lnTo>
                        <a:pt x="30" y="56"/>
                      </a:lnTo>
                      <a:lnTo>
                        <a:pt x="30" y="56"/>
                      </a:lnTo>
                      <a:lnTo>
                        <a:pt x="32" y="56"/>
                      </a:lnTo>
                      <a:lnTo>
                        <a:pt x="32" y="56"/>
                      </a:lnTo>
                      <a:lnTo>
                        <a:pt x="32" y="57"/>
                      </a:lnTo>
                      <a:lnTo>
                        <a:pt x="32" y="57"/>
                      </a:lnTo>
                      <a:lnTo>
                        <a:pt x="32" y="57"/>
                      </a:lnTo>
                      <a:lnTo>
                        <a:pt x="32" y="59"/>
                      </a:lnTo>
                      <a:lnTo>
                        <a:pt x="32" y="59"/>
                      </a:lnTo>
                      <a:lnTo>
                        <a:pt x="33" y="59"/>
                      </a:lnTo>
                      <a:lnTo>
                        <a:pt x="33" y="60"/>
                      </a:lnTo>
                      <a:lnTo>
                        <a:pt x="33" y="60"/>
                      </a:lnTo>
                      <a:lnTo>
                        <a:pt x="33" y="60"/>
                      </a:lnTo>
                      <a:lnTo>
                        <a:pt x="33" y="60"/>
                      </a:lnTo>
                      <a:lnTo>
                        <a:pt x="33" y="62"/>
                      </a:lnTo>
                      <a:lnTo>
                        <a:pt x="35" y="62"/>
                      </a:lnTo>
                      <a:lnTo>
                        <a:pt x="35" y="62"/>
                      </a:lnTo>
                      <a:lnTo>
                        <a:pt x="35" y="63"/>
                      </a:lnTo>
                      <a:lnTo>
                        <a:pt x="35" y="63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99" name="Rectangle 83"/>
                <p:cNvSpPr>
                  <a:spLocks noChangeArrowheads="1"/>
                </p:cNvSpPr>
                <p:nvPr/>
              </p:nvSpPr>
              <p:spPr bwMode="auto">
                <a:xfrm rot="19740000">
                  <a:off x="4412" y="1640"/>
                  <a:ext cx="72" cy="87"/>
                </a:xfrm>
                <a:prstGeom prst="rect">
                  <a:avLst/>
                </a:prstGeom>
                <a:noFill/>
                <a:ln w="9525">
                  <a:noFill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1</a:t>
                  </a:r>
                </a:p>
              </p:txBody>
            </p:sp>
            <p:sp>
              <p:nvSpPr>
                <p:cNvPr id="300" name="Line 84"/>
                <p:cNvSpPr>
                  <a:spLocks noChangeShapeType="1"/>
                </p:cNvSpPr>
                <p:nvPr/>
              </p:nvSpPr>
              <p:spPr bwMode="auto">
                <a:xfrm flipV="1">
                  <a:off x="4452" y="1697"/>
                  <a:ext cx="53" cy="33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01" name="Rectangle 85"/>
                <p:cNvSpPr>
                  <a:spLocks noChangeArrowheads="1"/>
                </p:cNvSpPr>
                <p:nvPr/>
              </p:nvSpPr>
              <p:spPr bwMode="auto">
                <a:xfrm rot="20340000">
                  <a:off x="5498" y="1371"/>
                  <a:ext cx="210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JW-A7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02" name="Line 86"/>
                <p:cNvSpPr>
                  <a:spLocks noChangeShapeType="1"/>
                </p:cNvSpPr>
                <p:nvPr/>
              </p:nvSpPr>
              <p:spPr bwMode="auto">
                <a:xfrm flipV="1">
                  <a:off x="5023" y="1505"/>
                  <a:ext cx="380" cy="147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03" name="Rectangle 87"/>
                <p:cNvSpPr>
                  <a:spLocks noChangeArrowheads="1"/>
                </p:cNvSpPr>
                <p:nvPr/>
              </p:nvSpPr>
              <p:spPr bwMode="auto">
                <a:xfrm rot="20580000">
                  <a:off x="5546" y="1503"/>
                  <a:ext cx="327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LMD-A5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04" name="Line 88"/>
                <p:cNvSpPr>
                  <a:spLocks noChangeShapeType="1"/>
                </p:cNvSpPr>
                <p:nvPr/>
              </p:nvSpPr>
              <p:spPr bwMode="auto">
                <a:xfrm flipV="1">
                  <a:off x="5125" y="1644"/>
                  <a:ext cx="325" cy="94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05" name="Rectangle 89"/>
                <p:cNvSpPr>
                  <a:spLocks noChangeArrowheads="1"/>
                </p:cNvSpPr>
                <p:nvPr/>
              </p:nvSpPr>
              <p:spPr bwMode="auto">
                <a:xfrm rot="20880000">
                  <a:off x="5587" y="1678"/>
                  <a:ext cx="259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DZ-A6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06" name="Line 90"/>
                <p:cNvSpPr>
                  <a:spLocks noChangeShapeType="1"/>
                </p:cNvSpPr>
                <p:nvPr/>
              </p:nvSpPr>
              <p:spPr bwMode="auto">
                <a:xfrm flipV="1">
                  <a:off x="5221" y="1788"/>
                  <a:ext cx="264" cy="53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07" name="Rectangle 91"/>
                <p:cNvSpPr>
                  <a:spLocks noChangeArrowheads="1"/>
                </p:cNvSpPr>
                <p:nvPr/>
              </p:nvSpPr>
              <p:spPr bwMode="auto">
                <a:xfrm rot="21180000">
                  <a:off x="5619" y="1849"/>
                  <a:ext cx="238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ZHJ-A5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08" name="Line 92"/>
                <p:cNvSpPr>
                  <a:spLocks noChangeShapeType="1"/>
                </p:cNvSpPr>
                <p:nvPr/>
              </p:nvSpPr>
              <p:spPr bwMode="auto">
                <a:xfrm flipV="1">
                  <a:off x="5308" y="1934"/>
                  <a:ext cx="200" cy="22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09" name="Rectangle 93"/>
                <p:cNvSpPr>
                  <a:spLocks noChangeArrowheads="1"/>
                </p:cNvSpPr>
                <p:nvPr/>
              </p:nvSpPr>
              <p:spPr bwMode="auto">
                <a:xfrm rot="21480000">
                  <a:off x="5636" y="2017"/>
                  <a:ext cx="267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RH-A5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10" name="Line 94"/>
                <p:cNvSpPr>
                  <a:spLocks noChangeShapeType="1"/>
                </p:cNvSpPr>
                <p:nvPr/>
              </p:nvSpPr>
              <p:spPr bwMode="auto">
                <a:xfrm flipV="1">
                  <a:off x="5386" y="2082"/>
                  <a:ext cx="132" cy="3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11" name="Rectangle 95"/>
                <p:cNvSpPr>
                  <a:spLocks noChangeArrowheads="1"/>
                </p:cNvSpPr>
                <p:nvPr/>
              </p:nvSpPr>
              <p:spPr bwMode="auto">
                <a:xfrm rot="180000">
                  <a:off x="5632" y="2189"/>
                  <a:ext cx="327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AIRC-A5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12" name="Line 96"/>
                <p:cNvSpPr>
                  <a:spLocks noChangeShapeType="1"/>
                </p:cNvSpPr>
                <p:nvPr/>
              </p:nvSpPr>
              <p:spPr bwMode="auto">
                <a:xfrm>
                  <a:off x="5452" y="2225"/>
                  <a:ext cx="63" cy="5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13" name="Rectangle 97"/>
                <p:cNvSpPr>
                  <a:spLocks noChangeArrowheads="1"/>
                </p:cNvSpPr>
                <p:nvPr/>
              </p:nvSpPr>
              <p:spPr bwMode="auto">
                <a:xfrm rot="480000">
                  <a:off x="5626" y="2354"/>
                  <a:ext cx="263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YCC-A6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14" name="Line 98"/>
                <p:cNvSpPr>
                  <a:spLocks noChangeShapeType="1"/>
                </p:cNvSpPr>
                <p:nvPr/>
              </p:nvSpPr>
              <p:spPr bwMode="auto">
                <a:xfrm>
                  <a:off x="5438" y="2366"/>
                  <a:ext cx="61" cy="10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15" name="Freeform 99"/>
                <p:cNvSpPr/>
                <p:nvPr/>
              </p:nvSpPr>
              <p:spPr bwMode="auto">
                <a:xfrm>
                  <a:off x="5443" y="2225"/>
                  <a:ext cx="6" cy="71"/>
                </a:xfrm>
                <a:custGeom>
                  <a:avLst/>
                  <a:gdLst>
                    <a:gd name="T0" fmla="*/ 0 w 6"/>
                    <a:gd name="T1" fmla="*/ 71 h 71"/>
                    <a:gd name="T2" fmla="*/ 0 w 6"/>
                    <a:gd name="T3" fmla="*/ 65 h 71"/>
                    <a:gd name="T4" fmla="*/ 0 w 6"/>
                    <a:gd name="T5" fmla="*/ 61 h 71"/>
                    <a:gd name="T6" fmla="*/ 2 w 6"/>
                    <a:gd name="T7" fmla="*/ 55 h 71"/>
                    <a:gd name="T8" fmla="*/ 2 w 6"/>
                    <a:gd name="T9" fmla="*/ 49 h 71"/>
                    <a:gd name="T10" fmla="*/ 2 w 6"/>
                    <a:gd name="T11" fmla="*/ 44 h 71"/>
                    <a:gd name="T12" fmla="*/ 3 w 6"/>
                    <a:gd name="T13" fmla="*/ 38 h 71"/>
                    <a:gd name="T14" fmla="*/ 3 w 6"/>
                    <a:gd name="T15" fmla="*/ 33 h 71"/>
                    <a:gd name="T16" fmla="*/ 3 w 6"/>
                    <a:gd name="T17" fmla="*/ 28 h 71"/>
                    <a:gd name="T18" fmla="*/ 5 w 6"/>
                    <a:gd name="T19" fmla="*/ 22 h 71"/>
                    <a:gd name="T20" fmla="*/ 5 w 6"/>
                    <a:gd name="T21" fmla="*/ 16 h 71"/>
                    <a:gd name="T22" fmla="*/ 5 w 6"/>
                    <a:gd name="T23" fmla="*/ 11 h 71"/>
                    <a:gd name="T24" fmla="*/ 5 w 6"/>
                    <a:gd name="T25" fmla="*/ 6 h 71"/>
                    <a:gd name="T26" fmla="*/ 6 w 6"/>
                    <a:gd name="T27" fmla="*/ 0 h 7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</a:cxnLst>
                  <a:rect l="0" t="0" r="r" b="b"/>
                  <a:pathLst>
                    <a:path w="6" h="71">
                      <a:moveTo>
                        <a:pt x="0" y="71"/>
                      </a:moveTo>
                      <a:lnTo>
                        <a:pt x="0" y="65"/>
                      </a:lnTo>
                      <a:lnTo>
                        <a:pt x="0" y="61"/>
                      </a:lnTo>
                      <a:lnTo>
                        <a:pt x="2" y="55"/>
                      </a:lnTo>
                      <a:lnTo>
                        <a:pt x="2" y="49"/>
                      </a:lnTo>
                      <a:lnTo>
                        <a:pt x="2" y="44"/>
                      </a:lnTo>
                      <a:lnTo>
                        <a:pt x="3" y="38"/>
                      </a:lnTo>
                      <a:lnTo>
                        <a:pt x="3" y="33"/>
                      </a:lnTo>
                      <a:lnTo>
                        <a:pt x="3" y="28"/>
                      </a:lnTo>
                      <a:lnTo>
                        <a:pt x="5" y="22"/>
                      </a:lnTo>
                      <a:lnTo>
                        <a:pt x="5" y="16"/>
                      </a:lnTo>
                      <a:lnTo>
                        <a:pt x="5" y="11"/>
                      </a:lnTo>
                      <a:lnTo>
                        <a:pt x="5" y="6"/>
                      </a:lnTo>
                      <a:lnTo>
                        <a:pt x="6" y="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16" name="Freeform 100"/>
                <p:cNvSpPr/>
                <p:nvPr/>
              </p:nvSpPr>
              <p:spPr bwMode="auto">
                <a:xfrm>
                  <a:off x="5433" y="2296"/>
                  <a:ext cx="10" cy="70"/>
                </a:xfrm>
                <a:custGeom>
                  <a:avLst/>
                  <a:gdLst>
                    <a:gd name="T0" fmla="*/ 10 w 10"/>
                    <a:gd name="T1" fmla="*/ 0 h 70"/>
                    <a:gd name="T2" fmla="*/ 9 w 10"/>
                    <a:gd name="T3" fmla="*/ 6 h 70"/>
                    <a:gd name="T4" fmla="*/ 9 w 10"/>
                    <a:gd name="T5" fmla="*/ 10 h 70"/>
                    <a:gd name="T6" fmla="*/ 7 w 10"/>
                    <a:gd name="T7" fmla="*/ 16 h 70"/>
                    <a:gd name="T8" fmla="*/ 7 w 10"/>
                    <a:gd name="T9" fmla="*/ 20 h 70"/>
                    <a:gd name="T10" fmla="*/ 6 w 10"/>
                    <a:gd name="T11" fmla="*/ 26 h 70"/>
                    <a:gd name="T12" fmla="*/ 6 w 10"/>
                    <a:gd name="T13" fmla="*/ 30 h 70"/>
                    <a:gd name="T14" fmla="*/ 6 w 10"/>
                    <a:gd name="T15" fmla="*/ 36 h 70"/>
                    <a:gd name="T16" fmla="*/ 5 w 10"/>
                    <a:gd name="T17" fmla="*/ 40 h 70"/>
                    <a:gd name="T18" fmla="*/ 5 w 10"/>
                    <a:gd name="T19" fmla="*/ 46 h 70"/>
                    <a:gd name="T20" fmla="*/ 3 w 10"/>
                    <a:gd name="T21" fmla="*/ 50 h 70"/>
                    <a:gd name="T22" fmla="*/ 3 w 10"/>
                    <a:gd name="T23" fmla="*/ 56 h 70"/>
                    <a:gd name="T24" fmla="*/ 2 w 10"/>
                    <a:gd name="T25" fmla="*/ 60 h 70"/>
                    <a:gd name="T26" fmla="*/ 2 w 10"/>
                    <a:gd name="T27" fmla="*/ 66 h 70"/>
                    <a:gd name="T28" fmla="*/ 0 w 10"/>
                    <a:gd name="T29" fmla="*/ 70 h 7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</a:cxnLst>
                  <a:rect l="0" t="0" r="r" b="b"/>
                  <a:pathLst>
                    <a:path w="10" h="70">
                      <a:moveTo>
                        <a:pt x="10" y="0"/>
                      </a:moveTo>
                      <a:lnTo>
                        <a:pt x="9" y="6"/>
                      </a:lnTo>
                      <a:lnTo>
                        <a:pt x="9" y="10"/>
                      </a:lnTo>
                      <a:lnTo>
                        <a:pt x="7" y="16"/>
                      </a:lnTo>
                      <a:lnTo>
                        <a:pt x="7" y="20"/>
                      </a:lnTo>
                      <a:lnTo>
                        <a:pt x="6" y="26"/>
                      </a:lnTo>
                      <a:lnTo>
                        <a:pt x="6" y="30"/>
                      </a:lnTo>
                      <a:lnTo>
                        <a:pt x="6" y="36"/>
                      </a:lnTo>
                      <a:lnTo>
                        <a:pt x="5" y="40"/>
                      </a:lnTo>
                      <a:lnTo>
                        <a:pt x="5" y="46"/>
                      </a:lnTo>
                      <a:lnTo>
                        <a:pt x="3" y="50"/>
                      </a:lnTo>
                      <a:lnTo>
                        <a:pt x="3" y="56"/>
                      </a:lnTo>
                      <a:lnTo>
                        <a:pt x="2" y="60"/>
                      </a:lnTo>
                      <a:lnTo>
                        <a:pt x="2" y="66"/>
                      </a:lnTo>
                      <a:lnTo>
                        <a:pt x="0" y="7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18" name="Line 102"/>
                <p:cNvSpPr>
                  <a:spLocks noChangeShapeType="1"/>
                </p:cNvSpPr>
                <p:nvPr/>
              </p:nvSpPr>
              <p:spPr bwMode="auto">
                <a:xfrm>
                  <a:off x="5377" y="2289"/>
                  <a:ext cx="63" cy="7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19" name="Freeform 103"/>
                <p:cNvSpPr/>
                <p:nvPr/>
              </p:nvSpPr>
              <p:spPr bwMode="auto">
                <a:xfrm>
                  <a:off x="5382" y="2085"/>
                  <a:ext cx="1" cy="102"/>
                </a:xfrm>
                <a:custGeom>
                  <a:avLst/>
                  <a:gdLst>
                    <a:gd name="T0" fmla="*/ 0 w 1"/>
                    <a:gd name="T1" fmla="*/ 102 h 102"/>
                    <a:gd name="T2" fmla="*/ 0 w 1"/>
                    <a:gd name="T3" fmla="*/ 97 h 102"/>
                    <a:gd name="T4" fmla="*/ 0 w 1"/>
                    <a:gd name="T5" fmla="*/ 93 h 102"/>
                    <a:gd name="T6" fmla="*/ 0 w 1"/>
                    <a:gd name="T7" fmla="*/ 89 h 102"/>
                    <a:gd name="T8" fmla="*/ 0 w 1"/>
                    <a:gd name="T9" fmla="*/ 85 h 102"/>
                    <a:gd name="T10" fmla="*/ 1 w 1"/>
                    <a:gd name="T11" fmla="*/ 80 h 102"/>
                    <a:gd name="T12" fmla="*/ 1 w 1"/>
                    <a:gd name="T13" fmla="*/ 76 h 102"/>
                    <a:gd name="T14" fmla="*/ 1 w 1"/>
                    <a:gd name="T15" fmla="*/ 72 h 102"/>
                    <a:gd name="T16" fmla="*/ 1 w 1"/>
                    <a:gd name="T17" fmla="*/ 67 h 102"/>
                    <a:gd name="T18" fmla="*/ 1 w 1"/>
                    <a:gd name="T19" fmla="*/ 63 h 102"/>
                    <a:gd name="T20" fmla="*/ 1 w 1"/>
                    <a:gd name="T21" fmla="*/ 59 h 102"/>
                    <a:gd name="T22" fmla="*/ 1 w 1"/>
                    <a:gd name="T23" fmla="*/ 54 h 102"/>
                    <a:gd name="T24" fmla="*/ 1 w 1"/>
                    <a:gd name="T25" fmla="*/ 50 h 102"/>
                    <a:gd name="T26" fmla="*/ 1 w 1"/>
                    <a:gd name="T27" fmla="*/ 47 h 102"/>
                    <a:gd name="T28" fmla="*/ 1 w 1"/>
                    <a:gd name="T29" fmla="*/ 43 h 102"/>
                    <a:gd name="T30" fmla="*/ 1 w 1"/>
                    <a:gd name="T31" fmla="*/ 39 h 102"/>
                    <a:gd name="T32" fmla="*/ 1 w 1"/>
                    <a:gd name="T33" fmla="*/ 34 h 102"/>
                    <a:gd name="T34" fmla="*/ 1 w 1"/>
                    <a:gd name="T35" fmla="*/ 30 h 102"/>
                    <a:gd name="T36" fmla="*/ 1 w 1"/>
                    <a:gd name="T37" fmla="*/ 26 h 102"/>
                    <a:gd name="T38" fmla="*/ 1 w 1"/>
                    <a:gd name="T39" fmla="*/ 21 h 102"/>
                    <a:gd name="T40" fmla="*/ 1 w 1"/>
                    <a:gd name="T41" fmla="*/ 17 h 102"/>
                    <a:gd name="T42" fmla="*/ 1 w 1"/>
                    <a:gd name="T43" fmla="*/ 13 h 102"/>
                    <a:gd name="T44" fmla="*/ 1 w 1"/>
                    <a:gd name="T45" fmla="*/ 8 h 102"/>
                    <a:gd name="T46" fmla="*/ 1 w 1"/>
                    <a:gd name="T47" fmla="*/ 4 h 102"/>
                    <a:gd name="T48" fmla="*/ 1 w 1"/>
                    <a:gd name="T49" fmla="*/ 0 h 10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</a:cxnLst>
                  <a:rect l="0" t="0" r="r" b="b"/>
                  <a:pathLst>
                    <a:path w="1" h="102">
                      <a:moveTo>
                        <a:pt x="0" y="102"/>
                      </a:moveTo>
                      <a:lnTo>
                        <a:pt x="0" y="97"/>
                      </a:lnTo>
                      <a:lnTo>
                        <a:pt x="0" y="93"/>
                      </a:lnTo>
                      <a:lnTo>
                        <a:pt x="0" y="89"/>
                      </a:lnTo>
                      <a:lnTo>
                        <a:pt x="0" y="85"/>
                      </a:lnTo>
                      <a:lnTo>
                        <a:pt x="1" y="80"/>
                      </a:lnTo>
                      <a:lnTo>
                        <a:pt x="1" y="76"/>
                      </a:lnTo>
                      <a:lnTo>
                        <a:pt x="1" y="72"/>
                      </a:lnTo>
                      <a:lnTo>
                        <a:pt x="1" y="67"/>
                      </a:lnTo>
                      <a:lnTo>
                        <a:pt x="1" y="63"/>
                      </a:lnTo>
                      <a:lnTo>
                        <a:pt x="1" y="59"/>
                      </a:lnTo>
                      <a:lnTo>
                        <a:pt x="1" y="54"/>
                      </a:lnTo>
                      <a:lnTo>
                        <a:pt x="1" y="50"/>
                      </a:lnTo>
                      <a:lnTo>
                        <a:pt x="1" y="47"/>
                      </a:lnTo>
                      <a:lnTo>
                        <a:pt x="1" y="43"/>
                      </a:lnTo>
                      <a:lnTo>
                        <a:pt x="1" y="39"/>
                      </a:lnTo>
                      <a:lnTo>
                        <a:pt x="1" y="34"/>
                      </a:lnTo>
                      <a:lnTo>
                        <a:pt x="1" y="30"/>
                      </a:lnTo>
                      <a:lnTo>
                        <a:pt x="1" y="26"/>
                      </a:lnTo>
                      <a:lnTo>
                        <a:pt x="1" y="21"/>
                      </a:lnTo>
                      <a:lnTo>
                        <a:pt x="1" y="17"/>
                      </a:lnTo>
                      <a:lnTo>
                        <a:pt x="1" y="13"/>
                      </a:lnTo>
                      <a:lnTo>
                        <a:pt x="1" y="8"/>
                      </a:lnTo>
                      <a:lnTo>
                        <a:pt x="1" y="4"/>
                      </a:lnTo>
                      <a:lnTo>
                        <a:pt x="1" y="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20" name="Freeform 104"/>
                <p:cNvSpPr/>
                <p:nvPr/>
              </p:nvSpPr>
              <p:spPr bwMode="auto">
                <a:xfrm>
                  <a:off x="5374" y="2187"/>
                  <a:ext cx="8" cy="102"/>
                </a:xfrm>
                <a:custGeom>
                  <a:avLst/>
                  <a:gdLst>
                    <a:gd name="T0" fmla="*/ 8 w 8"/>
                    <a:gd name="T1" fmla="*/ 0 h 102"/>
                    <a:gd name="T2" fmla="*/ 8 w 8"/>
                    <a:gd name="T3" fmla="*/ 5 h 102"/>
                    <a:gd name="T4" fmla="*/ 8 w 8"/>
                    <a:gd name="T5" fmla="*/ 11 h 102"/>
                    <a:gd name="T6" fmla="*/ 8 w 8"/>
                    <a:gd name="T7" fmla="*/ 16 h 102"/>
                    <a:gd name="T8" fmla="*/ 6 w 8"/>
                    <a:gd name="T9" fmla="*/ 21 h 102"/>
                    <a:gd name="T10" fmla="*/ 6 w 8"/>
                    <a:gd name="T11" fmla="*/ 27 h 102"/>
                    <a:gd name="T12" fmla="*/ 6 w 8"/>
                    <a:gd name="T13" fmla="*/ 33 h 102"/>
                    <a:gd name="T14" fmla="*/ 6 w 8"/>
                    <a:gd name="T15" fmla="*/ 37 h 102"/>
                    <a:gd name="T16" fmla="*/ 5 w 8"/>
                    <a:gd name="T17" fmla="*/ 43 h 102"/>
                    <a:gd name="T18" fmla="*/ 5 w 8"/>
                    <a:gd name="T19" fmla="*/ 49 h 102"/>
                    <a:gd name="T20" fmla="*/ 5 w 8"/>
                    <a:gd name="T21" fmla="*/ 53 h 102"/>
                    <a:gd name="T22" fmla="*/ 5 w 8"/>
                    <a:gd name="T23" fmla="*/ 59 h 102"/>
                    <a:gd name="T24" fmla="*/ 3 w 8"/>
                    <a:gd name="T25" fmla="*/ 64 h 102"/>
                    <a:gd name="T26" fmla="*/ 3 w 8"/>
                    <a:gd name="T27" fmla="*/ 70 h 102"/>
                    <a:gd name="T28" fmla="*/ 3 w 8"/>
                    <a:gd name="T29" fmla="*/ 74 h 102"/>
                    <a:gd name="T30" fmla="*/ 2 w 8"/>
                    <a:gd name="T31" fmla="*/ 80 h 102"/>
                    <a:gd name="T32" fmla="*/ 2 w 8"/>
                    <a:gd name="T33" fmla="*/ 86 h 102"/>
                    <a:gd name="T34" fmla="*/ 2 w 8"/>
                    <a:gd name="T35" fmla="*/ 92 h 102"/>
                    <a:gd name="T36" fmla="*/ 0 w 8"/>
                    <a:gd name="T37" fmla="*/ 96 h 102"/>
                    <a:gd name="T38" fmla="*/ 0 w 8"/>
                    <a:gd name="T39" fmla="*/ 102 h 10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</a:cxnLst>
                  <a:rect l="0" t="0" r="r" b="b"/>
                  <a:pathLst>
                    <a:path w="8" h="102">
                      <a:moveTo>
                        <a:pt x="8" y="0"/>
                      </a:moveTo>
                      <a:lnTo>
                        <a:pt x="8" y="5"/>
                      </a:lnTo>
                      <a:lnTo>
                        <a:pt x="8" y="11"/>
                      </a:lnTo>
                      <a:lnTo>
                        <a:pt x="8" y="16"/>
                      </a:lnTo>
                      <a:lnTo>
                        <a:pt x="6" y="21"/>
                      </a:lnTo>
                      <a:lnTo>
                        <a:pt x="6" y="27"/>
                      </a:lnTo>
                      <a:lnTo>
                        <a:pt x="6" y="33"/>
                      </a:lnTo>
                      <a:lnTo>
                        <a:pt x="6" y="37"/>
                      </a:lnTo>
                      <a:lnTo>
                        <a:pt x="5" y="43"/>
                      </a:lnTo>
                      <a:lnTo>
                        <a:pt x="5" y="49"/>
                      </a:lnTo>
                      <a:lnTo>
                        <a:pt x="5" y="53"/>
                      </a:lnTo>
                      <a:lnTo>
                        <a:pt x="5" y="59"/>
                      </a:lnTo>
                      <a:lnTo>
                        <a:pt x="3" y="64"/>
                      </a:lnTo>
                      <a:lnTo>
                        <a:pt x="3" y="70"/>
                      </a:lnTo>
                      <a:lnTo>
                        <a:pt x="3" y="74"/>
                      </a:lnTo>
                      <a:lnTo>
                        <a:pt x="2" y="80"/>
                      </a:lnTo>
                      <a:lnTo>
                        <a:pt x="2" y="86"/>
                      </a:lnTo>
                      <a:lnTo>
                        <a:pt x="2" y="92"/>
                      </a:lnTo>
                      <a:lnTo>
                        <a:pt x="0" y="96"/>
                      </a:lnTo>
                      <a:lnTo>
                        <a:pt x="0" y="102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22" name="Line 106"/>
                <p:cNvSpPr>
                  <a:spLocks noChangeShapeType="1"/>
                </p:cNvSpPr>
                <p:nvPr/>
              </p:nvSpPr>
              <p:spPr bwMode="auto">
                <a:xfrm>
                  <a:off x="5316" y="2184"/>
                  <a:ext cx="63" cy="3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23" name="Freeform 107"/>
                <p:cNvSpPr/>
                <p:nvPr/>
              </p:nvSpPr>
              <p:spPr bwMode="auto">
                <a:xfrm>
                  <a:off x="5306" y="1956"/>
                  <a:ext cx="7" cy="115"/>
                </a:xfrm>
                <a:custGeom>
                  <a:avLst/>
                  <a:gdLst>
                    <a:gd name="T0" fmla="*/ 7 w 7"/>
                    <a:gd name="T1" fmla="*/ 115 h 115"/>
                    <a:gd name="T2" fmla="*/ 7 w 7"/>
                    <a:gd name="T3" fmla="*/ 110 h 115"/>
                    <a:gd name="T4" fmla="*/ 7 w 7"/>
                    <a:gd name="T5" fmla="*/ 107 h 115"/>
                    <a:gd name="T6" fmla="*/ 7 w 7"/>
                    <a:gd name="T7" fmla="*/ 104 h 115"/>
                    <a:gd name="T8" fmla="*/ 7 w 7"/>
                    <a:gd name="T9" fmla="*/ 100 h 115"/>
                    <a:gd name="T10" fmla="*/ 7 w 7"/>
                    <a:gd name="T11" fmla="*/ 97 h 115"/>
                    <a:gd name="T12" fmla="*/ 7 w 7"/>
                    <a:gd name="T13" fmla="*/ 94 h 115"/>
                    <a:gd name="T14" fmla="*/ 7 w 7"/>
                    <a:gd name="T15" fmla="*/ 90 h 115"/>
                    <a:gd name="T16" fmla="*/ 7 w 7"/>
                    <a:gd name="T17" fmla="*/ 87 h 115"/>
                    <a:gd name="T18" fmla="*/ 5 w 7"/>
                    <a:gd name="T19" fmla="*/ 84 h 115"/>
                    <a:gd name="T20" fmla="*/ 5 w 7"/>
                    <a:gd name="T21" fmla="*/ 80 h 115"/>
                    <a:gd name="T22" fmla="*/ 5 w 7"/>
                    <a:gd name="T23" fmla="*/ 77 h 115"/>
                    <a:gd name="T24" fmla="*/ 5 w 7"/>
                    <a:gd name="T25" fmla="*/ 74 h 115"/>
                    <a:gd name="T26" fmla="*/ 5 w 7"/>
                    <a:gd name="T27" fmla="*/ 70 h 115"/>
                    <a:gd name="T28" fmla="*/ 5 w 7"/>
                    <a:gd name="T29" fmla="*/ 67 h 115"/>
                    <a:gd name="T30" fmla="*/ 5 w 7"/>
                    <a:gd name="T31" fmla="*/ 64 h 115"/>
                    <a:gd name="T32" fmla="*/ 4 w 7"/>
                    <a:gd name="T33" fmla="*/ 60 h 115"/>
                    <a:gd name="T34" fmla="*/ 4 w 7"/>
                    <a:gd name="T35" fmla="*/ 57 h 115"/>
                    <a:gd name="T36" fmla="*/ 4 w 7"/>
                    <a:gd name="T37" fmla="*/ 54 h 115"/>
                    <a:gd name="T38" fmla="*/ 4 w 7"/>
                    <a:gd name="T39" fmla="*/ 50 h 115"/>
                    <a:gd name="T40" fmla="*/ 4 w 7"/>
                    <a:gd name="T41" fmla="*/ 47 h 115"/>
                    <a:gd name="T42" fmla="*/ 4 w 7"/>
                    <a:gd name="T43" fmla="*/ 44 h 115"/>
                    <a:gd name="T44" fmla="*/ 2 w 7"/>
                    <a:gd name="T45" fmla="*/ 40 h 115"/>
                    <a:gd name="T46" fmla="*/ 2 w 7"/>
                    <a:gd name="T47" fmla="*/ 37 h 115"/>
                    <a:gd name="T48" fmla="*/ 2 w 7"/>
                    <a:gd name="T49" fmla="*/ 34 h 115"/>
                    <a:gd name="T50" fmla="*/ 2 w 7"/>
                    <a:gd name="T51" fmla="*/ 30 h 115"/>
                    <a:gd name="T52" fmla="*/ 2 w 7"/>
                    <a:gd name="T53" fmla="*/ 27 h 115"/>
                    <a:gd name="T54" fmla="*/ 1 w 7"/>
                    <a:gd name="T55" fmla="*/ 24 h 115"/>
                    <a:gd name="T56" fmla="*/ 1 w 7"/>
                    <a:gd name="T57" fmla="*/ 20 h 115"/>
                    <a:gd name="T58" fmla="*/ 1 w 7"/>
                    <a:gd name="T59" fmla="*/ 17 h 115"/>
                    <a:gd name="T60" fmla="*/ 1 w 7"/>
                    <a:gd name="T61" fmla="*/ 14 h 115"/>
                    <a:gd name="T62" fmla="*/ 0 w 7"/>
                    <a:gd name="T63" fmla="*/ 10 h 115"/>
                    <a:gd name="T64" fmla="*/ 0 w 7"/>
                    <a:gd name="T65" fmla="*/ 7 h 115"/>
                    <a:gd name="T66" fmla="*/ 0 w 7"/>
                    <a:gd name="T67" fmla="*/ 4 h 115"/>
                    <a:gd name="T68" fmla="*/ 0 w 7"/>
                    <a:gd name="T69" fmla="*/ 0 h 11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</a:cxnLst>
                  <a:rect l="0" t="0" r="r" b="b"/>
                  <a:pathLst>
                    <a:path w="7" h="115">
                      <a:moveTo>
                        <a:pt x="7" y="115"/>
                      </a:moveTo>
                      <a:lnTo>
                        <a:pt x="7" y="110"/>
                      </a:lnTo>
                      <a:lnTo>
                        <a:pt x="7" y="107"/>
                      </a:lnTo>
                      <a:lnTo>
                        <a:pt x="7" y="104"/>
                      </a:lnTo>
                      <a:lnTo>
                        <a:pt x="7" y="100"/>
                      </a:lnTo>
                      <a:lnTo>
                        <a:pt x="7" y="97"/>
                      </a:lnTo>
                      <a:lnTo>
                        <a:pt x="7" y="94"/>
                      </a:lnTo>
                      <a:lnTo>
                        <a:pt x="7" y="90"/>
                      </a:lnTo>
                      <a:lnTo>
                        <a:pt x="7" y="87"/>
                      </a:lnTo>
                      <a:lnTo>
                        <a:pt x="5" y="84"/>
                      </a:lnTo>
                      <a:lnTo>
                        <a:pt x="5" y="80"/>
                      </a:lnTo>
                      <a:lnTo>
                        <a:pt x="5" y="77"/>
                      </a:lnTo>
                      <a:lnTo>
                        <a:pt x="5" y="74"/>
                      </a:lnTo>
                      <a:lnTo>
                        <a:pt x="5" y="70"/>
                      </a:lnTo>
                      <a:lnTo>
                        <a:pt x="5" y="67"/>
                      </a:lnTo>
                      <a:lnTo>
                        <a:pt x="5" y="64"/>
                      </a:lnTo>
                      <a:lnTo>
                        <a:pt x="4" y="60"/>
                      </a:lnTo>
                      <a:lnTo>
                        <a:pt x="4" y="57"/>
                      </a:lnTo>
                      <a:lnTo>
                        <a:pt x="4" y="54"/>
                      </a:lnTo>
                      <a:lnTo>
                        <a:pt x="4" y="50"/>
                      </a:lnTo>
                      <a:lnTo>
                        <a:pt x="4" y="47"/>
                      </a:lnTo>
                      <a:lnTo>
                        <a:pt x="4" y="44"/>
                      </a:lnTo>
                      <a:lnTo>
                        <a:pt x="2" y="40"/>
                      </a:lnTo>
                      <a:lnTo>
                        <a:pt x="2" y="37"/>
                      </a:lnTo>
                      <a:lnTo>
                        <a:pt x="2" y="34"/>
                      </a:lnTo>
                      <a:lnTo>
                        <a:pt x="2" y="30"/>
                      </a:lnTo>
                      <a:lnTo>
                        <a:pt x="2" y="27"/>
                      </a:lnTo>
                      <a:lnTo>
                        <a:pt x="1" y="24"/>
                      </a:lnTo>
                      <a:lnTo>
                        <a:pt x="1" y="20"/>
                      </a:lnTo>
                      <a:lnTo>
                        <a:pt x="1" y="17"/>
                      </a:lnTo>
                      <a:lnTo>
                        <a:pt x="1" y="14"/>
                      </a:lnTo>
                      <a:lnTo>
                        <a:pt x="0" y="10"/>
                      </a:lnTo>
                      <a:lnTo>
                        <a:pt x="0" y="7"/>
                      </a:lnTo>
                      <a:lnTo>
                        <a:pt x="0" y="4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24" name="Freeform 108"/>
                <p:cNvSpPr/>
                <p:nvPr/>
              </p:nvSpPr>
              <p:spPr bwMode="auto">
                <a:xfrm>
                  <a:off x="5313" y="2071"/>
                  <a:ext cx="1" cy="113"/>
                </a:xfrm>
                <a:custGeom>
                  <a:avLst/>
                  <a:gdLst>
                    <a:gd name="T0" fmla="*/ 0 w 1"/>
                    <a:gd name="T1" fmla="*/ 0 h 113"/>
                    <a:gd name="T2" fmla="*/ 1 w 1"/>
                    <a:gd name="T3" fmla="*/ 5 h 113"/>
                    <a:gd name="T4" fmla="*/ 1 w 1"/>
                    <a:gd name="T5" fmla="*/ 11 h 113"/>
                    <a:gd name="T6" fmla="*/ 1 w 1"/>
                    <a:gd name="T7" fmla="*/ 17 h 113"/>
                    <a:gd name="T8" fmla="*/ 1 w 1"/>
                    <a:gd name="T9" fmla="*/ 22 h 113"/>
                    <a:gd name="T10" fmla="*/ 1 w 1"/>
                    <a:gd name="T11" fmla="*/ 27 h 113"/>
                    <a:gd name="T12" fmla="*/ 1 w 1"/>
                    <a:gd name="T13" fmla="*/ 33 h 113"/>
                    <a:gd name="T14" fmla="*/ 1 w 1"/>
                    <a:gd name="T15" fmla="*/ 38 h 113"/>
                    <a:gd name="T16" fmla="*/ 1 w 1"/>
                    <a:gd name="T17" fmla="*/ 44 h 113"/>
                    <a:gd name="T18" fmla="*/ 1 w 1"/>
                    <a:gd name="T19" fmla="*/ 50 h 113"/>
                    <a:gd name="T20" fmla="*/ 1 w 1"/>
                    <a:gd name="T21" fmla="*/ 55 h 113"/>
                    <a:gd name="T22" fmla="*/ 1 w 1"/>
                    <a:gd name="T23" fmla="*/ 61 h 113"/>
                    <a:gd name="T24" fmla="*/ 1 w 1"/>
                    <a:gd name="T25" fmla="*/ 67 h 113"/>
                    <a:gd name="T26" fmla="*/ 1 w 1"/>
                    <a:gd name="T27" fmla="*/ 73 h 113"/>
                    <a:gd name="T28" fmla="*/ 1 w 1"/>
                    <a:gd name="T29" fmla="*/ 78 h 113"/>
                    <a:gd name="T30" fmla="*/ 1 w 1"/>
                    <a:gd name="T31" fmla="*/ 84 h 113"/>
                    <a:gd name="T32" fmla="*/ 1 w 1"/>
                    <a:gd name="T33" fmla="*/ 90 h 113"/>
                    <a:gd name="T34" fmla="*/ 1 w 1"/>
                    <a:gd name="T35" fmla="*/ 96 h 113"/>
                    <a:gd name="T36" fmla="*/ 0 w 1"/>
                    <a:gd name="T37" fmla="*/ 101 h 113"/>
                    <a:gd name="T38" fmla="*/ 0 w 1"/>
                    <a:gd name="T39" fmla="*/ 107 h 113"/>
                    <a:gd name="T40" fmla="*/ 0 w 1"/>
                    <a:gd name="T41" fmla="*/ 113 h 11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</a:cxnLst>
                  <a:rect l="0" t="0" r="r" b="b"/>
                  <a:pathLst>
                    <a:path w="1" h="113">
                      <a:moveTo>
                        <a:pt x="0" y="0"/>
                      </a:moveTo>
                      <a:lnTo>
                        <a:pt x="1" y="5"/>
                      </a:lnTo>
                      <a:lnTo>
                        <a:pt x="1" y="11"/>
                      </a:lnTo>
                      <a:lnTo>
                        <a:pt x="1" y="17"/>
                      </a:lnTo>
                      <a:lnTo>
                        <a:pt x="1" y="22"/>
                      </a:lnTo>
                      <a:lnTo>
                        <a:pt x="1" y="27"/>
                      </a:lnTo>
                      <a:lnTo>
                        <a:pt x="1" y="33"/>
                      </a:lnTo>
                      <a:lnTo>
                        <a:pt x="1" y="38"/>
                      </a:lnTo>
                      <a:lnTo>
                        <a:pt x="1" y="44"/>
                      </a:lnTo>
                      <a:lnTo>
                        <a:pt x="1" y="50"/>
                      </a:lnTo>
                      <a:lnTo>
                        <a:pt x="1" y="55"/>
                      </a:lnTo>
                      <a:lnTo>
                        <a:pt x="1" y="61"/>
                      </a:lnTo>
                      <a:lnTo>
                        <a:pt x="1" y="67"/>
                      </a:lnTo>
                      <a:lnTo>
                        <a:pt x="1" y="73"/>
                      </a:lnTo>
                      <a:lnTo>
                        <a:pt x="1" y="78"/>
                      </a:lnTo>
                      <a:lnTo>
                        <a:pt x="1" y="84"/>
                      </a:lnTo>
                      <a:lnTo>
                        <a:pt x="1" y="90"/>
                      </a:lnTo>
                      <a:lnTo>
                        <a:pt x="1" y="96"/>
                      </a:lnTo>
                      <a:lnTo>
                        <a:pt x="0" y="101"/>
                      </a:lnTo>
                      <a:lnTo>
                        <a:pt x="0" y="107"/>
                      </a:lnTo>
                      <a:lnTo>
                        <a:pt x="0" y="113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26" name="Line 110"/>
                <p:cNvSpPr>
                  <a:spLocks noChangeShapeType="1"/>
                </p:cNvSpPr>
                <p:nvPr/>
              </p:nvSpPr>
              <p:spPr bwMode="auto">
                <a:xfrm flipV="1">
                  <a:off x="5247" y="2071"/>
                  <a:ext cx="63" cy="2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27" name="Freeform 111"/>
                <p:cNvSpPr/>
                <p:nvPr/>
              </p:nvSpPr>
              <p:spPr bwMode="auto">
                <a:xfrm>
                  <a:off x="5218" y="1841"/>
                  <a:ext cx="17" cy="115"/>
                </a:xfrm>
                <a:custGeom>
                  <a:avLst/>
                  <a:gdLst>
                    <a:gd name="T0" fmla="*/ 17 w 17"/>
                    <a:gd name="T1" fmla="*/ 115 h 115"/>
                    <a:gd name="T2" fmla="*/ 17 w 17"/>
                    <a:gd name="T3" fmla="*/ 112 h 115"/>
                    <a:gd name="T4" fmla="*/ 17 w 17"/>
                    <a:gd name="T5" fmla="*/ 110 h 115"/>
                    <a:gd name="T6" fmla="*/ 17 w 17"/>
                    <a:gd name="T7" fmla="*/ 108 h 115"/>
                    <a:gd name="T8" fmla="*/ 17 w 17"/>
                    <a:gd name="T9" fmla="*/ 105 h 115"/>
                    <a:gd name="T10" fmla="*/ 16 w 17"/>
                    <a:gd name="T11" fmla="*/ 102 h 115"/>
                    <a:gd name="T12" fmla="*/ 16 w 17"/>
                    <a:gd name="T13" fmla="*/ 99 h 115"/>
                    <a:gd name="T14" fmla="*/ 16 w 17"/>
                    <a:gd name="T15" fmla="*/ 96 h 115"/>
                    <a:gd name="T16" fmla="*/ 16 w 17"/>
                    <a:gd name="T17" fmla="*/ 95 h 115"/>
                    <a:gd name="T18" fmla="*/ 14 w 17"/>
                    <a:gd name="T19" fmla="*/ 92 h 115"/>
                    <a:gd name="T20" fmla="*/ 14 w 17"/>
                    <a:gd name="T21" fmla="*/ 89 h 115"/>
                    <a:gd name="T22" fmla="*/ 14 w 17"/>
                    <a:gd name="T23" fmla="*/ 86 h 115"/>
                    <a:gd name="T24" fmla="*/ 14 w 17"/>
                    <a:gd name="T25" fmla="*/ 83 h 115"/>
                    <a:gd name="T26" fmla="*/ 13 w 17"/>
                    <a:gd name="T27" fmla="*/ 80 h 115"/>
                    <a:gd name="T28" fmla="*/ 13 w 17"/>
                    <a:gd name="T29" fmla="*/ 79 h 115"/>
                    <a:gd name="T30" fmla="*/ 13 w 17"/>
                    <a:gd name="T31" fmla="*/ 76 h 115"/>
                    <a:gd name="T32" fmla="*/ 13 w 17"/>
                    <a:gd name="T33" fmla="*/ 73 h 115"/>
                    <a:gd name="T34" fmla="*/ 12 w 17"/>
                    <a:gd name="T35" fmla="*/ 70 h 115"/>
                    <a:gd name="T36" fmla="*/ 12 w 17"/>
                    <a:gd name="T37" fmla="*/ 67 h 115"/>
                    <a:gd name="T38" fmla="*/ 12 w 17"/>
                    <a:gd name="T39" fmla="*/ 65 h 115"/>
                    <a:gd name="T40" fmla="*/ 12 w 17"/>
                    <a:gd name="T41" fmla="*/ 63 h 115"/>
                    <a:gd name="T42" fmla="*/ 10 w 17"/>
                    <a:gd name="T43" fmla="*/ 60 h 115"/>
                    <a:gd name="T44" fmla="*/ 10 w 17"/>
                    <a:gd name="T45" fmla="*/ 57 h 115"/>
                    <a:gd name="T46" fmla="*/ 10 w 17"/>
                    <a:gd name="T47" fmla="*/ 54 h 115"/>
                    <a:gd name="T48" fmla="*/ 9 w 17"/>
                    <a:gd name="T49" fmla="*/ 52 h 115"/>
                    <a:gd name="T50" fmla="*/ 9 w 17"/>
                    <a:gd name="T51" fmla="*/ 49 h 115"/>
                    <a:gd name="T52" fmla="*/ 9 w 17"/>
                    <a:gd name="T53" fmla="*/ 47 h 115"/>
                    <a:gd name="T54" fmla="*/ 9 w 17"/>
                    <a:gd name="T55" fmla="*/ 44 h 115"/>
                    <a:gd name="T56" fmla="*/ 7 w 17"/>
                    <a:gd name="T57" fmla="*/ 42 h 115"/>
                    <a:gd name="T58" fmla="*/ 7 w 17"/>
                    <a:gd name="T59" fmla="*/ 39 h 115"/>
                    <a:gd name="T60" fmla="*/ 7 w 17"/>
                    <a:gd name="T61" fmla="*/ 36 h 115"/>
                    <a:gd name="T62" fmla="*/ 6 w 17"/>
                    <a:gd name="T63" fmla="*/ 34 h 115"/>
                    <a:gd name="T64" fmla="*/ 6 w 17"/>
                    <a:gd name="T65" fmla="*/ 32 h 115"/>
                    <a:gd name="T66" fmla="*/ 6 w 17"/>
                    <a:gd name="T67" fmla="*/ 29 h 115"/>
                    <a:gd name="T68" fmla="*/ 4 w 17"/>
                    <a:gd name="T69" fmla="*/ 26 h 115"/>
                    <a:gd name="T70" fmla="*/ 4 w 17"/>
                    <a:gd name="T71" fmla="*/ 23 h 115"/>
                    <a:gd name="T72" fmla="*/ 4 w 17"/>
                    <a:gd name="T73" fmla="*/ 20 h 115"/>
                    <a:gd name="T74" fmla="*/ 3 w 17"/>
                    <a:gd name="T75" fmla="*/ 19 h 115"/>
                    <a:gd name="T76" fmla="*/ 3 w 17"/>
                    <a:gd name="T77" fmla="*/ 16 h 115"/>
                    <a:gd name="T78" fmla="*/ 3 w 17"/>
                    <a:gd name="T79" fmla="*/ 13 h 115"/>
                    <a:gd name="T80" fmla="*/ 2 w 17"/>
                    <a:gd name="T81" fmla="*/ 10 h 115"/>
                    <a:gd name="T82" fmla="*/ 2 w 17"/>
                    <a:gd name="T83" fmla="*/ 7 h 115"/>
                    <a:gd name="T84" fmla="*/ 2 w 17"/>
                    <a:gd name="T85" fmla="*/ 6 h 115"/>
                    <a:gd name="T86" fmla="*/ 0 w 17"/>
                    <a:gd name="T87" fmla="*/ 3 h 115"/>
                    <a:gd name="T88" fmla="*/ 0 w 17"/>
                    <a:gd name="T89" fmla="*/ 0 h 11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</a:cxnLst>
                  <a:rect l="0" t="0" r="r" b="b"/>
                  <a:pathLst>
                    <a:path w="17" h="115">
                      <a:moveTo>
                        <a:pt x="17" y="115"/>
                      </a:moveTo>
                      <a:lnTo>
                        <a:pt x="17" y="112"/>
                      </a:lnTo>
                      <a:lnTo>
                        <a:pt x="17" y="110"/>
                      </a:lnTo>
                      <a:lnTo>
                        <a:pt x="17" y="108"/>
                      </a:lnTo>
                      <a:lnTo>
                        <a:pt x="17" y="105"/>
                      </a:lnTo>
                      <a:lnTo>
                        <a:pt x="16" y="102"/>
                      </a:lnTo>
                      <a:lnTo>
                        <a:pt x="16" y="99"/>
                      </a:lnTo>
                      <a:lnTo>
                        <a:pt x="16" y="96"/>
                      </a:lnTo>
                      <a:lnTo>
                        <a:pt x="16" y="95"/>
                      </a:lnTo>
                      <a:lnTo>
                        <a:pt x="14" y="92"/>
                      </a:lnTo>
                      <a:lnTo>
                        <a:pt x="14" y="89"/>
                      </a:lnTo>
                      <a:lnTo>
                        <a:pt x="14" y="86"/>
                      </a:lnTo>
                      <a:lnTo>
                        <a:pt x="14" y="83"/>
                      </a:lnTo>
                      <a:lnTo>
                        <a:pt x="13" y="80"/>
                      </a:lnTo>
                      <a:lnTo>
                        <a:pt x="13" y="79"/>
                      </a:lnTo>
                      <a:lnTo>
                        <a:pt x="13" y="76"/>
                      </a:lnTo>
                      <a:lnTo>
                        <a:pt x="13" y="73"/>
                      </a:lnTo>
                      <a:lnTo>
                        <a:pt x="12" y="70"/>
                      </a:lnTo>
                      <a:lnTo>
                        <a:pt x="12" y="67"/>
                      </a:lnTo>
                      <a:lnTo>
                        <a:pt x="12" y="65"/>
                      </a:lnTo>
                      <a:lnTo>
                        <a:pt x="12" y="63"/>
                      </a:lnTo>
                      <a:lnTo>
                        <a:pt x="10" y="60"/>
                      </a:lnTo>
                      <a:lnTo>
                        <a:pt x="10" y="57"/>
                      </a:lnTo>
                      <a:lnTo>
                        <a:pt x="10" y="54"/>
                      </a:lnTo>
                      <a:lnTo>
                        <a:pt x="9" y="52"/>
                      </a:lnTo>
                      <a:lnTo>
                        <a:pt x="9" y="49"/>
                      </a:lnTo>
                      <a:lnTo>
                        <a:pt x="9" y="47"/>
                      </a:lnTo>
                      <a:lnTo>
                        <a:pt x="9" y="44"/>
                      </a:lnTo>
                      <a:lnTo>
                        <a:pt x="7" y="42"/>
                      </a:lnTo>
                      <a:lnTo>
                        <a:pt x="7" y="39"/>
                      </a:lnTo>
                      <a:lnTo>
                        <a:pt x="7" y="36"/>
                      </a:lnTo>
                      <a:lnTo>
                        <a:pt x="6" y="34"/>
                      </a:lnTo>
                      <a:lnTo>
                        <a:pt x="6" y="32"/>
                      </a:lnTo>
                      <a:lnTo>
                        <a:pt x="6" y="29"/>
                      </a:lnTo>
                      <a:lnTo>
                        <a:pt x="4" y="26"/>
                      </a:lnTo>
                      <a:lnTo>
                        <a:pt x="4" y="23"/>
                      </a:lnTo>
                      <a:lnTo>
                        <a:pt x="4" y="20"/>
                      </a:lnTo>
                      <a:lnTo>
                        <a:pt x="3" y="19"/>
                      </a:lnTo>
                      <a:lnTo>
                        <a:pt x="3" y="16"/>
                      </a:lnTo>
                      <a:lnTo>
                        <a:pt x="3" y="13"/>
                      </a:lnTo>
                      <a:lnTo>
                        <a:pt x="2" y="10"/>
                      </a:lnTo>
                      <a:lnTo>
                        <a:pt x="2" y="7"/>
                      </a:lnTo>
                      <a:lnTo>
                        <a:pt x="2" y="6"/>
                      </a:lnTo>
                      <a:lnTo>
                        <a:pt x="0" y="3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28" name="Freeform 112"/>
                <p:cNvSpPr/>
                <p:nvPr/>
              </p:nvSpPr>
              <p:spPr bwMode="auto">
                <a:xfrm>
                  <a:off x="5235" y="1956"/>
                  <a:ext cx="9" cy="116"/>
                </a:xfrm>
                <a:custGeom>
                  <a:avLst/>
                  <a:gdLst>
                    <a:gd name="T0" fmla="*/ 0 w 9"/>
                    <a:gd name="T1" fmla="*/ 0 h 116"/>
                    <a:gd name="T2" fmla="*/ 2 w 9"/>
                    <a:gd name="T3" fmla="*/ 5 h 116"/>
                    <a:gd name="T4" fmla="*/ 2 w 9"/>
                    <a:gd name="T5" fmla="*/ 11 h 116"/>
                    <a:gd name="T6" fmla="*/ 3 w 9"/>
                    <a:gd name="T7" fmla="*/ 17 h 116"/>
                    <a:gd name="T8" fmla="*/ 3 w 9"/>
                    <a:gd name="T9" fmla="*/ 23 h 116"/>
                    <a:gd name="T10" fmla="*/ 5 w 9"/>
                    <a:gd name="T11" fmla="*/ 28 h 116"/>
                    <a:gd name="T12" fmla="*/ 5 w 9"/>
                    <a:gd name="T13" fmla="*/ 34 h 116"/>
                    <a:gd name="T14" fmla="*/ 5 w 9"/>
                    <a:gd name="T15" fmla="*/ 40 h 116"/>
                    <a:gd name="T16" fmla="*/ 6 w 9"/>
                    <a:gd name="T17" fmla="*/ 47 h 116"/>
                    <a:gd name="T18" fmla="*/ 6 w 9"/>
                    <a:gd name="T19" fmla="*/ 53 h 116"/>
                    <a:gd name="T20" fmla="*/ 6 w 9"/>
                    <a:gd name="T21" fmla="*/ 59 h 116"/>
                    <a:gd name="T22" fmla="*/ 8 w 9"/>
                    <a:gd name="T23" fmla="*/ 64 h 116"/>
                    <a:gd name="T24" fmla="*/ 8 w 9"/>
                    <a:gd name="T25" fmla="*/ 70 h 116"/>
                    <a:gd name="T26" fmla="*/ 8 w 9"/>
                    <a:gd name="T27" fmla="*/ 76 h 116"/>
                    <a:gd name="T28" fmla="*/ 8 w 9"/>
                    <a:gd name="T29" fmla="*/ 82 h 116"/>
                    <a:gd name="T30" fmla="*/ 9 w 9"/>
                    <a:gd name="T31" fmla="*/ 87 h 116"/>
                    <a:gd name="T32" fmla="*/ 9 w 9"/>
                    <a:gd name="T33" fmla="*/ 93 h 116"/>
                    <a:gd name="T34" fmla="*/ 9 w 9"/>
                    <a:gd name="T35" fmla="*/ 99 h 116"/>
                    <a:gd name="T36" fmla="*/ 9 w 9"/>
                    <a:gd name="T37" fmla="*/ 104 h 116"/>
                    <a:gd name="T38" fmla="*/ 9 w 9"/>
                    <a:gd name="T39" fmla="*/ 110 h 116"/>
                    <a:gd name="T40" fmla="*/ 9 w 9"/>
                    <a:gd name="T41" fmla="*/ 116 h 11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</a:cxnLst>
                  <a:rect l="0" t="0" r="r" b="b"/>
                  <a:pathLst>
                    <a:path w="9" h="116">
                      <a:moveTo>
                        <a:pt x="0" y="0"/>
                      </a:moveTo>
                      <a:lnTo>
                        <a:pt x="2" y="5"/>
                      </a:lnTo>
                      <a:lnTo>
                        <a:pt x="2" y="11"/>
                      </a:lnTo>
                      <a:lnTo>
                        <a:pt x="3" y="17"/>
                      </a:lnTo>
                      <a:lnTo>
                        <a:pt x="3" y="23"/>
                      </a:lnTo>
                      <a:lnTo>
                        <a:pt x="5" y="28"/>
                      </a:lnTo>
                      <a:lnTo>
                        <a:pt x="5" y="34"/>
                      </a:lnTo>
                      <a:lnTo>
                        <a:pt x="5" y="40"/>
                      </a:lnTo>
                      <a:lnTo>
                        <a:pt x="6" y="47"/>
                      </a:lnTo>
                      <a:lnTo>
                        <a:pt x="6" y="53"/>
                      </a:lnTo>
                      <a:lnTo>
                        <a:pt x="6" y="59"/>
                      </a:lnTo>
                      <a:lnTo>
                        <a:pt x="8" y="64"/>
                      </a:lnTo>
                      <a:lnTo>
                        <a:pt x="8" y="70"/>
                      </a:lnTo>
                      <a:lnTo>
                        <a:pt x="8" y="76"/>
                      </a:lnTo>
                      <a:lnTo>
                        <a:pt x="8" y="82"/>
                      </a:lnTo>
                      <a:lnTo>
                        <a:pt x="9" y="87"/>
                      </a:lnTo>
                      <a:lnTo>
                        <a:pt x="9" y="93"/>
                      </a:lnTo>
                      <a:lnTo>
                        <a:pt x="9" y="99"/>
                      </a:lnTo>
                      <a:lnTo>
                        <a:pt x="9" y="104"/>
                      </a:lnTo>
                      <a:lnTo>
                        <a:pt x="9" y="110"/>
                      </a:lnTo>
                      <a:lnTo>
                        <a:pt x="9" y="116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30" name="Line 114"/>
                <p:cNvSpPr>
                  <a:spLocks noChangeShapeType="1"/>
                </p:cNvSpPr>
                <p:nvPr/>
              </p:nvSpPr>
              <p:spPr bwMode="auto">
                <a:xfrm flipV="1">
                  <a:off x="5169" y="1956"/>
                  <a:ext cx="63" cy="7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31" name="Freeform 115"/>
                <p:cNvSpPr/>
                <p:nvPr/>
              </p:nvSpPr>
              <p:spPr bwMode="auto">
                <a:xfrm>
                  <a:off x="5122" y="1739"/>
                  <a:ext cx="27" cy="112"/>
                </a:xfrm>
                <a:custGeom>
                  <a:avLst/>
                  <a:gdLst>
                    <a:gd name="T0" fmla="*/ 27 w 27"/>
                    <a:gd name="T1" fmla="*/ 112 h 112"/>
                    <a:gd name="T2" fmla="*/ 27 w 27"/>
                    <a:gd name="T3" fmla="*/ 109 h 112"/>
                    <a:gd name="T4" fmla="*/ 27 w 27"/>
                    <a:gd name="T5" fmla="*/ 108 h 112"/>
                    <a:gd name="T6" fmla="*/ 26 w 27"/>
                    <a:gd name="T7" fmla="*/ 105 h 112"/>
                    <a:gd name="T8" fmla="*/ 26 w 27"/>
                    <a:gd name="T9" fmla="*/ 103 h 112"/>
                    <a:gd name="T10" fmla="*/ 26 w 27"/>
                    <a:gd name="T11" fmla="*/ 101 h 112"/>
                    <a:gd name="T12" fmla="*/ 26 w 27"/>
                    <a:gd name="T13" fmla="*/ 99 h 112"/>
                    <a:gd name="T14" fmla="*/ 24 w 27"/>
                    <a:gd name="T15" fmla="*/ 96 h 112"/>
                    <a:gd name="T16" fmla="*/ 24 w 27"/>
                    <a:gd name="T17" fmla="*/ 95 h 112"/>
                    <a:gd name="T18" fmla="*/ 24 w 27"/>
                    <a:gd name="T19" fmla="*/ 92 h 112"/>
                    <a:gd name="T20" fmla="*/ 23 w 27"/>
                    <a:gd name="T21" fmla="*/ 90 h 112"/>
                    <a:gd name="T22" fmla="*/ 23 w 27"/>
                    <a:gd name="T23" fmla="*/ 88 h 112"/>
                    <a:gd name="T24" fmla="*/ 23 w 27"/>
                    <a:gd name="T25" fmla="*/ 86 h 112"/>
                    <a:gd name="T26" fmla="*/ 22 w 27"/>
                    <a:gd name="T27" fmla="*/ 83 h 112"/>
                    <a:gd name="T28" fmla="*/ 22 w 27"/>
                    <a:gd name="T29" fmla="*/ 82 h 112"/>
                    <a:gd name="T30" fmla="*/ 22 w 27"/>
                    <a:gd name="T31" fmla="*/ 80 h 112"/>
                    <a:gd name="T32" fmla="*/ 20 w 27"/>
                    <a:gd name="T33" fmla="*/ 78 h 112"/>
                    <a:gd name="T34" fmla="*/ 20 w 27"/>
                    <a:gd name="T35" fmla="*/ 76 h 112"/>
                    <a:gd name="T36" fmla="*/ 20 w 27"/>
                    <a:gd name="T37" fmla="*/ 73 h 112"/>
                    <a:gd name="T38" fmla="*/ 19 w 27"/>
                    <a:gd name="T39" fmla="*/ 72 h 112"/>
                    <a:gd name="T40" fmla="*/ 19 w 27"/>
                    <a:gd name="T41" fmla="*/ 69 h 112"/>
                    <a:gd name="T42" fmla="*/ 19 w 27"/>
                    <a:gd name="T43" fmla="*/ 68 h 112"/>
                    <a:gd name="T44" fmla="*/ 17 w 27"/>
                    <a:gd name="T45" fmla="*/ 65 h 112"/>
                    <a:gd name="T46" fmla="*/ 17 w 27"/>
                    <a:gd name="T47" fmla="*/ 63 h 112"/>
                    <a:gd name="T48" fmla="*/ 17 w 27"/>
                    <a:gd name="T49" fmla="*/ 60 h 112"/>
                    <a:gd name="T50" fmla="*/ 16 w 27"/>
                    <a:gd name="T51" fmla="*/ 59 h 112"/>
                    <a:gd name="T52" fmla="*/ 16 w 27"/>
                    <a:gd name="T53" fmla="*/ 56 h 112"/>
                    <a:gd name="T54" fmla="*/ 16 w 27"/>
                    <a:gd name="T55" fmla="*/ 55 h 112"/>
                    <a:gd name="T56" fmla="*/ 14 w 27"/>
                    <a:gd name="T57" fmla="*/ 52 h 112"/>
                    <a:gd name="T58" fmla="*/ 14 w 27"/>
                    <a:gd name="T59" fmla="*/ 50 h 112"/>
                    <a:gd name="T60" fmla="*/ 13 w 27"/>
                    <a:gd name="T61" fmla="*/ 49 h 112"/>
                    <a:gd name="T62" fmla="*/ 13 w 27"/>
                    <a:gd name="T63" fmla="*/ 46 h 112"/>
                    <a:gd name="T64" fmla="*/ 13 w 27"/>
                    <a:gd name="T65" fmla="*/ 45 h 112"/>
                    <a:gd name="T66" fmla="*/ 12 w 27"/>
                    <a:gd name="T67" fmla="*/ 42 h 112"/>
                    <a:gd name="T68" fmla="*/ 12 w 27"/>
                    <a:gd name="T69" fmla="*/ 40 h 112"/>
                    <a:gd name="T70" fmla="*/ 12 w 27"/>
                    <a:gd name="T71" fmla="*/ 37 h 112"/>
                    <a:gd name="T72" fmla="*/ 10 w 27"/>
                    <a:gd name="T73" fmla="*/ 36 h 112"/>
                    <a:gd name="T74" fmla="*/ 10 w 27"/>
                    <a:gd name="T75" fmla="*/ 33 h 112"/>
                    <a:gd name="T76" fmla="*/ 9 w 27"/>
                    <a:gd name="T77" fmla="*/ 32 h 112"/>
                    <a:gd name="T78" fmla="*/ 9 w 27"/>
                    <a:gd name="T79" fmla="*/ 29 h 112"/>
                    <a:gd name="T80" fmla="*/ 9 w 27"/>
                    <a:gd name="T81" fmla="*/ 27 h 112"/>
                    <a:gd name="T82" fmla="*/ 7 w 27"/>
                    <a:gd name="T83" fmla="*/ 24 h 112"/>
                    <a:gd name="T84" fmla="*/ 7 w 27"/>
                    <a:gd name="T85" fmla="*/ 23 h 112"/>
                    <a:gd name="T86" fmla="*/ 6 w 27"/>
                    <a:gd name="T87" fmla="*/ 22 h 112"/>
                    <a:gd name="T88" fmla="*/ 6 w 27"/>
                    <a:gd name="T89" fmla="*/ 19 h 112"/>
                    <a:gd name="T90" fmla="*/ 6 w 27"/>
                    <a:gd name="T91" fmla="*/ 17 h 112"/>
                    <a:gd name="T92" fmla="*/ 4 w 27"/>
                    <a:gd name="T93" fmla="*/ 14 h 112"/>
                    <a:gd name="T94" fmla="*/ 4 w 27"/>
                    <a:gd name="T95" fmla="*/ 13 h 112"/>
                    <a:gd name="T96" fmla="*/ 3 w 27"/>
                    <a:gd name="T97" fmla="*/ 10 h 112"/>
                    <a:gd name="T98" fmla="*/ 3 w 27"/>
                    <a:gd name="T99" fmla="*/ 9 h 112"/>
                    <a:gd name="T100" fmla="*/ 3 w 27"/>
                    <a:gd name="T101" fmla="*/ 6 h 112"/>
                    <a:gd name="T102" fmla="*/ 1 w 27"/>
                    <a:gd name="T103" fmla="*/ 4 h 112"/>
                    <a:gd name="T104" fmla="*/ 1 w 27"/>
                    <a:gd name="T105" fmla="*/ 2 h 112"/>
                    <a:gd name="T106" fmla="*/ 0 w 27"/>
                    <a:gd name="T107" fmla="*/ 0 h 11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  <a:cxn ang="0">
                      <a:pos x="T90" y="T91"/>
                    </a:cxn>
                    <a:cxn ang="0">
                      <a:pos x="T92" y="T93"/>
                    </a:cxn>
                    <a:cxn ang="0">
                      <a:pos x="T94" y="T95"/>
                    </a:cxn>
                    <a:cxn ang="0">
                      <a:pos x="T96" y="T97"/>
                    </a:cxn>
                    <a:cxn ang="0">
                      <a:pos x="T98" y="T99"/>
                    </a:cxn>
                    <a:cxn ang="0">
                      <a:pos x="T100" y="T101"/>
                    </a:cxn>
                    <a:cxn ang="0">
                      <a:pos x="T102" y="T103"/>
                    </a:cxn>
                    <a:cxn ang="0">
                      <a:pos x="T104" y="T105"/>
                    </a:cxn>
                    <a:cxn ang="0">
                      <a:pos x="T106" y="T107"/>
                    </a:cxn>
                  </a:cxnLst>
                  <a:rect l="0" t="0" r="r" b="b"/>
                  <a:pathLst>
                    <a:path w="27" h="112">
                      <a:moveTo>
                        <a:pt x="27" y="112"/>
                      </a:moveTo>
                      <a:lnTo>
                        <a:pt x="27" y="109"/>
                      </a:lnTo>
                      <a:lnTo>
                        <a:pt x="27" y="108"/>
                      </a:lnTo>
                      <a:lnTo>
                        <a:pt x="26" y="105"/>
                      </a:lnTo>
                      <a:lnTo>
                        <a:pt x="26" y="103"/>
                      </a:lnTo>
                      <a:lnTo>
                        <a:pt x="26" y="101"/>
                      </a:lnTo>
                      <a:lnTo>
                        <a:pt x="26" y="99"/>
                      </a:lnTo>
                      <a:lnTo>
                        <a:pt x="24" y="96"/>
                      </a:lnTo>
                      <a:lnTo>
                        <a:pt x="24" y="95"/>
                      </a:lnTo>
                      <a:lnTo>
                        <a:pt x="24" y="92"/>
                      </a:lnTo>
                      <a:lnTo>
                        <a:pt x="23" y="90"/>
                      </a:lnTo>
                      <a:lnTo>
                        <a:pt x="23" y="88"/>
                      </a:lnTo>
                      <a:lnTo>
                        <a:pt x="23" y="86"/>
                      </a:lnTo>
                      <a:lnTo>
                        <a:pt x="22" y="83"/>
                      </a:lnTo>
                      <a:lnTo>
                        <a:pt x="22" y="82"/>
                      </a:lnTo>
                      <a:lnTo>
                        <a:pt x="22" y="80"/>
                      </a:lnTo>
                      <a:lnTo>
                        <a:pt x="20" y="78"/>
                      </a:lnTo>
                      <a:lnTo>
                        <a:pt x="20" y="76"/>
                      </a:lnTo>
                      <a:lnTo>
                        <a:pt x="20" y="73"/>
                      </a:lnTo>
                      <a:lnTo>
                        <a:pt x="19" y="72"/>
                      </a:lnTo>
                      <a:lnTo>
                        <a:pt x="19" y="69"/>
                      </a:lnTo>
                      <a:lnTo>
                        <a:pt x="19" y="68"/>
                      </a:lnTo>
                      <a:lnTo>
                        <a:pt x="17" y="65"/>
                      </a:lnTo>
                      <a:lnTo>
                        <a:pt x="17" y="63"/>
                      </a:lnTo>
                      <a:lnTo>
                        <a:pt x="17" y="60"/>
                      </a:lnTo>
                      <a:lnTo>
                        <a:pt x="16" y="59"/>
                      </a:lnTo>
                      <a:lnTo>
                        <a:pt x="16" y="56"/>
                      </a:lnTo>
                      <a:lnTo>
                        <a:pt x="16" y="55"/>
                      </a:lnTo>
                      <a:lnTo>
                        <a:pt x="14" y="52"/>
                      </a:lnTo>
                      <a:lnTo>
                        <a:pt x="14" y="50"/>
                      </a:lnTo>
                      <a:lnTo>
                        <a:pt x="13" y="49"/>
                      </a:lnTo>
                      <a:lnTo>
                        <a:pt x="13" y="46"/>
                      </a:lnTo>
                      <a:lnTo>
                        <a:pt x="13" y="45"/>
                      </a:lnTo>
                      <a:lnTo>
                        <a:pt x="12" y="42"/>
                      </a:lnTo>
                      <a:lnTo>
                        <a:pt x="12" y="40"/>
                      </a:lnTo>
                      <a:lnTo>
                        <a:pt x="12" y="37"/>
                      </a:lnTo>
                      <a:lnTo>
                        <a:pt x="10" y="36"/>
                      </a:lnTo>
                      <a:lnTo>
                        <a:pt x="10" y="33"/>
                      </a:lnTo>
                      <a:lnTo>
                        <a:pt x="9" y="32"/>
                      </a:lnTo>
                      <a:lnTo>
                        <a:pt x="9" y="29"/>
                      </a:lnTo>
                      <a:lnTo>
                        <a:pt x="9" y="27"/>
                      </a:lnTo>
                      <a:lnTo>
                        <a:pt x="7" y="24"/>
                      </a:lnTo>
                      <a:lnTo>
                        <a:pt x="7" y="23"/>
                      </a:lnTo>
                      <a:lnTo>
                        <a:pt x="6" y="22"/>
                      </a:lnTo>
                      <a:lnTo>
                        <a:pt x="6" y="19"/>
                      </a:lnTo>
                      <a:lnTo>
                        <a:pt x="6" y="17"/>
                      </a:lnTo>
                      <a:lnTo>
                        <a:pt x="4" y="14"/>
                      </a:lnTo>
                      <a:lnTo>
                        <a:pt x="4" y="13"/>
                      </a:lnTo>
                      <a:lnTo>
                        <a:pt x="3" y="10"/>
                      </a:lnTo>
                      <a:lnTo>
                        <a:pt x="3" y="9"/>
                      </a:lnTo>
                      <a:lnTo>
                        <a:pt x="3" y="6"/>
                      </a:lnTo>
                      <a:lnTo>
                        <a:pt x="1" y="4"/>
                      </a:lnTo>
                      <a:lnTo>
                        <a:pt x="1" y="2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32" name="Freeform 116"/>
                <p:cNvSpPr/>
                <p:nvPr/>
              </p:nvSpPr>
              <p:spPr bwMode="auto">
                <a:xfrm>
                  <a:off x="5149" y="1851"/>
                  <a:ext cx="19" cy="113"/>
                </a:xfrm>
                <a:custGeom>
                  <a:avLst/>
                  <a:gdLst>
                    <a:gd name="T0" fmla="*/ 0 w 19"/>
                    <a:gd name="T1" fmla="*/ 0 h 113"/>
                    <a:gd name="T2" fmla="*/ 2 w 19"/>
                    <a:gd name="T3" fmla="*/ 6 h 113"/>
                    <a:gd name="T4" fmla="*/ 3 w 19"/>
                    <a:gd name="T5" fmla="*/ 11 h 113"/>
                    <a:gd name="T6" fmla="*/ 5 w 19"/>
                    <a:gd name="T7" fmla="*/ 19 h 113"/>
                    <a:gd name="T8" fmla="*/ 6 w 19"/>
                    <a:gd name="T9" fmla="*/ 24 h 113"/>
                    <a:gd name="T10" fmla="*/ 6 w 19"/>
                    <a:gd name="T11" fmla="*/ 32 h 113"/>
                    <a:gd name="T12" fmla="*/ 7 w 19"/>
                    <a:gd name="T13" fmla="*/ 37 h 113"/>
                    <a:gd name="T14" fmla="*/ 9 w 19"/>
                    <a:gd name="T15" fmla="*/ 43 h 113"/>
                    <a:gd name="T16" fmla="*/ 10 w 19"/>
                    <a:gd name="T17" fmla="*/ 50 h 113"/>
                    <a:gd name="T18" fmla="*/ 10 w 19"/>
                    <a:gd name="T19" fmla="*/ 56 h 113"/>
                    <a:gd name="T20" fmla="*/ 12 w 19"/>
                    <a:gd name="T21" fmla="*/ 62 h 113"/>
                    <a:gd name="T22" fmla="*/ 13 w 19"/>
                    <a:gd name="T23" fmla="*/ 69 h 113"/>
                    <a:gd name="T24" fmla="*/ 13 w 19"/>
                    <a:gd name="T25" fmla="*/ 75 h 113"/>
                    <a:gd name="T26" fmla="*/ 15 w 19"/>
                    <a:gd name="T27" fmla="*/ 82 h 113"/>
                    <a:gd name="T28" fmla="*/ 16 w 19"/>
                    <a:gd name="T29" fmla="*/ 88 h 113"/>
                    <a:gd name="T30" fmla="*/ 16 w 19"/>
                    <a:gd name="T31" fmla="*/ 93 h 113"/>
                    <a:gd name="T32" fmla="*/ 18 w 19"/>
                    <a:gd name="T33" fmla="*/ 100 h 113"/>
                    <a:gd name="T34" fmla="*/ 18 w 19"/>
                    <a:gd name="T35" fmla="*/ 106 h 113"/>
                    <a:gd name="T36" fmla="*/ 19 w 19"/>
                    <a:gd name="T37" fmla="*/ 113 h 11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</a:cxnLst>
                  <a:rect l="0" t="0" r="r" b="b"/>
                  <a:pathLst>
                    <a:path w="19" h="113">
                      <a:moveTo>
                        <a:pt x="0" y="0"/>
                      </a:moveTo>
                      <a:lnTo>
                        <a:pt x="2" y="6"/>
                      </a:lnTo>
                      <a:lnTo>
                        <a:pt x="3" y="11"/>
                      </a:lnTo>
                      <a:lnTo>
                        <a:pt x="5" y="19"/>
                      </a:lnTo>
                      <a:lnTo>
                        <a:pt x="6" y="24"/>
                      </a:lnTo>
                      <a:lnTo>
                        <a:pt x="6" y="32"/>
                      </a:lnTo>
                      <a:lnTo>
                        <a:pt x="7" y="37"/>
                      </a:lnTo>
                      <a:lnTo>
                        <a:pt x="9" y="43"/>
                      </a:lnTo>
                      <a:lnTo>
                        <a:pt x="10" y="50"/>
                      </a:lnTo>
                      <a:lnTo>
                        <a:pt x="10" y="56"/>
                      </a:lnTo>
                      <a:lnTo>
                        <a:pt x="12" y="62"/>
                      </a:lnTo>
                      <a:lnTo>
                        <a:pt x="13" y="69"/>
                      </a:lnTo>
                      <a:lnTo>
                        <a:pt x="13" y="75"/>
                      </a:lnTo>
                      <a:lnTo>
                        <a:pt x="15" y="82"/>
                      </a:lnTo>
                      <a:lnTo>
                        <a:pt x="16" y="88"/>
                      </a:lnTo>
                      <a:lnTo>
                        <a:pt x="16" y="93"/>
                      </a:lnTo>
                      <a:lnTo>
                        <a:pt x="18" y="100"/>
                      </a:lnTo>
                      <a:lnTo>
                        <a:pt x="18" y="106"/>
                      </a:lnTo>
                      <a:lnTo>
                        <a:pt x="19" y="113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33" name="Rectangle 117"/>
                <p:cNvSpPr>
                  <a:spLocks noChangeArrowheads="1"/>
                </p:cNvSpPr>
                <p:nvPr/>
              </p:nvSpPr>
              <p:spPr bwMode="auto">
                <a:xfrm rot="20880000">
                  <a:off x="5086" y="1877"/>
                  <a:ext cx="72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1</a:t>
                  </a:r>
                </a:p>
              </p:txBody>
            </p:sp>
            <p:sp>
              <p:nvSpPr>
                <p:cNvPr id="334" name="Line 118"/>
                <p:cNvSpPr>
                  <a:spLocks noChangeShapeType="1"/>
                </p:cNvSpPr>
                <p:nvPr/>
              </p:nvSpPr>
              <p:spPr bwMode="auto">
                <a:xfrm flipV="1">
                  <a:off x="5085" y="1851"/>
                  <a:ext cx="61" cy="13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35" name="Freeform 119"/>
                <p:cNvSpPr/>
                <p:nvPr/>
              </p:nvSpPr>
              <p:spPr bwMode="auto">
                <a:xfrm>
                  <a:off x="5020" y="1652"/>
                  <a:ext cx="36" cy="104"/>
                </a:xfrm>
                <a:custGeom>
                  <a:avLst/>
                  <a:gdLst>
                    <a:gd name="T0" fmla="*/ 36 w 36"/>
                    <a:gd name="T1" fmla="*/ 104 h 104"/>
                    <a:gd name="T2" fmla="*/ 36 w 36"/>
                    <a:gd name="T3" fmla="*/ 103 h 104"/>
                    <a:gd name="T4" fmla="*/ 35 w 36"/>
                    <a:gd name="T5" fmla="*/ 101 h 104"/>
                    <a:gd name="T6" fmla="*/ 35 w 36"/>
                    <a:gd name="T7" fmla="*/ 99 h 104"/>
                    <a:gd name="T8" fmla="*/ 35 w 36"/>
                    <a:gd name="T9" fmla="*/ 97 h 104"/>
                    <a:gd name="T10" fmla="*/ 33 w 36"/>
                    <a:gd name="T11" fmla="*/ 96 h 104"/>
                    <a:gd name="T12" fmla="*/ 33 w 36"/>
                    <a:gd name="T13" fmla="*/ 94 h 104"/>
                    <a:gd name="T14" fmla="*/ 32 w 36"/>
                    <a:gd name="T15" fmla="*/ 93 h 104"/>
                    <a:gd name="T16" fmla="*/ 32 w 36"/>
                    <a:gd name="T17" fmla="*/ 90 h 104"/>
                    <a:gd name="T18" fmla="*/ 32 w 36"/>
                    <a:gd name="T19" fmla="*/ 89 h 104"/>
                    <a:gd name="T20" fmla="*/ 30 w 36"/>
                    <a:gd name="T21" fmla="*/ 87 h 104"/>
                    <a:gd name="T22" fmla="*/ 30 w 36"/>
                    <a:gd name="T23" fmla="*/ 86 h 104"/>
                    <a:gd name="T24" fmla="*/ 30 w 36"/>
                    <a:gd name="T25" fmla="*/ 84 h 104"/>
                    <a:gd name="T26" fmla="*/ 29 w 36"/>
                    <a:gd name="T27" fmla="*/ 81 h 104"/>
                    <a:gd name="T28" fmla="*/ 29 w 36"/>
                    <a:gd name="T29" fmla="*/ 80 h 104"/>
                    <a:gd name="T30" fmla="*/ 27 w 36"/>
                    <a:gd name="T31" fmla="*/ 78 h 104"/>
                    <a:gd name="T32" fmla="*/ 27 w 36"/>
                    <a:gd name="T33" fmla="*/ 77 h 104"/>
                    <a:gd name="T34" fmla="*/ 27 w 36"/>
                    <a:gd name="T35" fmla="*/ 76 h 104"/>
                    <a:gd name="T36" fmla="*/ 26 w 36"/>
                    <a:gd name="T37" fmla="*/ 73 h 104"/>
                    <a:gd name="T38" fmla="*/ 26 w 36"/>
                    <a:gd name="T39" fmla="*/ 71 h 104"/>
                    <a:gd name="T40" fmla="*/ 26 w 36"/>
                    <a:gd name="T41" fmla="*/ 70 h 104"/>
                    <a:gd name="T42" fmla="*/ 25 w 36"/>
                    <a:gd name="T43" fmla="*/ 68 h 104"/>
                    <a:gd name="T44" fmla="*/ 25 w 36"/>
                    <a:gd name="T45" fmla="*/ 66 h 104"/>
                    <a:gd name="T46" fmla="*/ 23 w 36"/>
                    <a:gd name="T47" fmla="*/ 64 h 104"/>
                    <a:gd name="T48" fmla="*/ 23 w 36"/>
                    <a:gd name="T49" fmla="*/ 63 h 104"/>
                    <a:gd name="T50" fmla="*/ 23 w 36"/>
                    <a:gd name="T51" fmla="*/ 61 h 104"/>
                    <a:gd name="T52" fmla="*/ 22 w 36"/>
                    <a:gd name="T53" fmla="*/ 60 h 104"/>
                    <a:gd name="T54" fmla="*/ 22 w 36"/>
                    <a:gd name="T55" fmla="*/ 57 h 104"/>
                    <a:gd name="T56" fmla="*/ 20 w 36"/>
                    <a:gd name="T57" fmla="*/ 56 h 104"/>
                    <a:gd name="T58" fmla="*/ 20 w 36"/>
                    <a:gd name="T59" fmla="*/ 54 h 104"/>
                    <a:gd name="T60" fmla="*/ 20 w 36"/>
                    <a:gd name="T61" fmla="*/ 53 h 104"/>
                    <a:gd name="T62" fmla="*/ 19 w 36"/>
                    <a:gd name="T63" fmla="*/ 51 h 104"/>
                    <a:gd name="T64" fmla="*/ 19 w 36"/>
                    <a:gd name="T65" fmla="*/ 48 h 104"/>
                    <a:gd name="T66" fmla="*/ 17 w 36"/>
                    <a:gd name="T67" fmla="*/ 47 h 104"/>
                    <a:gd name="T68" fmla="*/ 17 w 36"/>
                    <a:gd name="T69" fmla="*/ 45 h 104"/>
                    <a:gd name="T70" fmla="*/ 17 w 36"/>
                    <a:gd name="T71" fmla="*/ 44 h 104"/>
                    <a:gd name="T72" fmla="*/ 16 w 36"/>
                    <a:gd name="T73" fmla="*/ 43 h 104"/>
                    <a:gd name="T74" fmla="*/ 16 w 36"/>
                    <a:gd name="T75" fmla="*/ 40 h 104"/>
                    <a:gd name="T76" fmla="*/ 15 w 36"/>
                    <a:gd name="T77" fmla="*/ 38 h 104"/>
                    <a:gd name="T78" fmla="*/ 15 w 36"/>
                    <a:gd name="T79" fmla="*/ 37 h 104"/>
                    <a:gd name="T80" fmla="*/ 15 w 36"/>
                    <a:gd name="T81" fmla="*/ 35 h 104"/>
                    <a:gd name="T82" fmla="*/ 13 w 36"/>
                    <a:gd name="T83" fmla="*/ 34 h 104"/>
                    <a:gd name="T84" fmla="*/ 13 w 36"/>
                    <a:gd name="T85" fmla="*/ 33 h 104"/>
                    <a:gd name="T86" fmla="*/ 12 w 36"/>
                    <a:gd name="T87" fmla="*/ 30 h 104"/>
                    <a:gd name="T88" fmla="*/ 12 w 36"/>
                    <a:gd name="T89" fmla="*/ 28 h 104"/>
                    <a:gd name="T90" fmla="*/ 10 w 36"/>
                    <a:gd name="T91" fmla="*/ 27 h 104"/>
                    <a:gd name="T92" fmla="*/ 10 w 36"/>
                    <a:gd name="T93" fmla="*/ 25 h 104"/>
                    <a:gd name="T94" fmla="*/ 10 w 36"/>
                    <a:gd name="T95" fmla="*/ 24 h 104"/>
                    <a:gd name="T96" fmla="*/ 9 w 36"/>
                    <a:gd name="T97" fmla="*/ 21 h 104"/>
                    <a:gd name="T98" fmla="*/ 9 w 36"/>
                    <a:gd name="T99" fmla="*/ 20 h 104"/>
                    <a:gd name="T100" fmla="*/ 7 w 36"/>
                    <a:gd name="T101" fmla="*/ 18 h 104"/>
                    <a:gd name="T102" fmla="*/ 7 w 36"/>
                    <a:gd name="T103" fmla="*/ 17 h 104"/>
                    <a:gd name="T104" fmla="*/ 6 w 36"/>
                    <a:gd name="T105" fmla="*/ 15 h 104"/>
                    <a:gd name="T106" fmla="*/ 6 w 36"/>
                    <a:gd name="T107" fmla="*/ 12 h 104"/>
                    <a:gd name="T108" fmla="*/ 5 w 36"/>
                    <a:gd name="T109" fmla="*/ 11 h 104"/>
                    <a:gd name="T110" fmla="*/ 5 w 36"/>
                    <a:gd name="T111" fmla="*/ 10 h 104"/>
                    <a:gd name="T112" fmla="*/ 5 w 36"/>
                    <a:gd name="T113" fmla="*/ 8 h 104"/>
                    <a:gd name="T114" fmla="*/ 3 w 36"/>
                    <a:gd name="T115" fmla="*/ 7 h 104"/>
                    <a:gd name="T116" fmla="*/ 3 w 36"/>
                    <a:gd name="T117" fmla="*/ 5 h 104"/>
                    <a:gd name="T118" fmla="*/ 2 w 36"/>
                    <a:gd name="T119" fmla="*/ 2 h 104"/>
                    <a:gd name="T120" fmla="*/ 2 w 36"/>
                    <a:gd name="T121" fmla="*/ 1 h 104"/>
                    <a:gd name="T122" fmla="*/ 0 w 36"/>
                    <a:gd name="T123" fmla="*/ 0 h 10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  <a:cxn ang="0">
                      <a:pos x="T90" y="T91"/>
                    </a:cxn>
                    <a:cxn ang="0">
                      <a:pos x="T92" y="T93"/>
                    </a:cxn>
                    <a:cxn ang="0">
                      <a:pos x="T94" y="T95"/>
                    </a:cxn>
                    <a:cxn ang="0">
                      <a:pos x="T96" y="T97"/>
                    </a:cxn>
                    <a:cxn ang="0">
                      <a:pos x="T98" y="T99"/>
                    </a:cxn>
                    <a:cxn ang="0">
                      <a:pos x="T100" y="T101"/>
                    </a:cxn>
                    <a:cxn ang="0">
                      <a:pos x="T102" y="T103"/>
                    </a:cxn>
                    <a:cxn ang="0">
                      <a:pos x="T104" y="T105"/>
                    </a:cxn>
                    <a:cxn ang="0">
                      <a:pos x="T106" y="T107"/>
                    </a:cxn>
                    <a:cxn ang="0">
                      <a:pos x="T108" y="T109"/>
                    </a:cxn>
                    <a:cxn ang="0">
                      <a:pos x="T110" y="T111"/>
                    </a:cxn>
                    <a:cxn ang="0">
                      <a:pos x="T112" y="T113"/>
                    </a:cxn>
                    <a:cxn ang="0">
                      <a:pos x="T114" y="T115"/>
                    </a:cxn>
                    <a:cxn ang="0">
                      <a:pos x="T116" y="T117"/>
                    </a:cxn>
                    <a:cxn ang="0">
                      <a:pos x="T118" y="T119"/>
                    </a:cxn>
                    <a:cxn ang="0">
                      <a:pos x="T120" y="T121"/>
                    </a:cxn>
                    <a:cxn ang="0">
                      <a:pos x="T122" y="T123"/>
                    </a:cxn>
                  </a:cxnLst>
                  <a:rect l="0" t="0" r="r" b="b"/>
                  <a:pathLst>
                    <a:path w="36" h="104">
                      <a:moveTo>
                        <a:pt x="36" y="104"/>
                      </a:moveTo>
                      <a:lnTo>
                        <a:pt x="36" y="103"/>
                      </a:lnTo>
                      <a:lnTo>
                        <a:pt x="35" y="101"/>
                      </a:lnTo>
                      <a:lnTo>
                        <a:pt x="35" y="99"/>
                      </a:lnTo>
                      <a:lnTo>
                        <a:pt x="35" y="97"/>
                      </a:lnTo>
                      <a:lnTo>
                        <a:pt x="33" y="96"/>
                      </a:lnTo>
                      <a:lnTo>
                        <a:pt x="33" y="94"/>
                      </a:lnTo>
                      <a:lnTo>
                        <a:pt x="32" y="93"/>
                      </a:lnTo>
                      <a:lnTo>
                        <a:pt x="32" y="90"/>
                      </a:lnTo>
                      <a:lnTo>
                        <a:pt x="32" y="89"/>
                      </a:lnTo>
                      <a:lnTo>
                        <a:pt x="30" y="87"/>
                      </a:lnTo>
                      <a:lnTo>
                        <a:pt x="30" y="86"/>
                      </a:lnTo>
                      <a:lnTo>
                        <a:pt x="30" y="84"/>
                      </a:lnTo>
                      <a:lnTo>
                        <a:pt x="29" y="81"/>
                      </a:lnTo>
                      <a:lnTo>
                        <a:pt x="29" y="80"/>
                      </a:lnTo>
                      <a:lnTo>
                        <a:pt x="27" y="78"/>
                      </a:lnTo>
                      <a:lnTo>
                        <a:pt x="27" y="77"/>
                      </a:lnTo>
                      <a:lnTo>
                        <a:pt x="27" y="76"/>
                      </a:lnTo>
                      <a:lnTo>
                        <a:pt x="26" y="73"/>
                      </a:lnTo>
                      <a:lnTo>
                        <a:pt x="26" y="71"/>
                      </a:lnTo>
                      <a:lnTo>
                        <a:pt x="26" y="70"/>
                      </a:lnTo>
                      <a:lnTo>
                        <a:pt x="25" y="68"/>
                      </a:lnTo>
                      <a:lnTo>
                        <a:pt x="25" y="66"/>
                      </a:lnTo>
                      <a:lnTo>
                        <a:pt x="23" y="64"/>
                      </a:lnTo>
                      <a:lnTo>
                        <a:pt x="23" y="63"/>
                      </a:lnTo>
                      <a:lnTo>
                        <a:pt x="23" y="61"/>
                      </a:lnTo>
                      <a:lnTo>
                        <a:pt x="22" y="60"/>
                      </a:lnTo>
                      <a:lnTo>
                        <a:pt x="22" y="57"/>
                      </a:lnTo>
                      <a:lnTo>
                        <a:pt x="20" y="56"/>
                      </a:lnTo>
                      <a:lnTo>
                        <a:pt x="20" y="54"/>
                      </a:lnTo>
                      <a:lnTo>
                        <a:pt x="20" y="53"/>
                      </a:lnTo>
                      <a:lnTo>
                        <a:pt x="19" y="51"/>
                      </a:lnTo>
                      <a:lnTo>
                        <a:pt x="19" y="48"/>
                      </a:lnTo>
                      <a:lnTo>
                        <a:pt x="17" y="47"/>
                      </a:lnTo>
                      <a:lnTo>
                        <a:pt x="17" y="45"/>
                      </a:lnTo>
                      <a:lnTo>
                        <a:pt x="17" y="44"/>
                      </a:lnTo>
                      <a:lnTo>
                        <a:pt x="16" y="43"/>
                      </a:lnTo>
                      <a:lnTo>
                        <a:pt x="16" y="40"/>
                      </a:lnTo>
                      <a:lnTo>
                        <a:pt x="15" y="38"/>
                      </a:lnTo>
                      <a:lnTo>
                        <a:pt x="15" y="37"/>
                      </a:lnTo>
                      <a:lnTo>
                        <a:pt x="15" y="35"/>
                      </a:lnTo>
                      <a:lnTo>
                        <a:pt x="13" y="34"/>
                      </a:lnTo>
                      <a:lnTo>
                        <a:pt x="13" y="33"/>
                      </a:lnTo>
                      <a:lnTo>
                        <a:pt x="12" y="30"/>
                      </a:lnTo>
                      <a:lnTo>
                        <a:pt x="12" y="28"/>
                      </a:lnTo>
                      <a:lnTo>
                        <a:pt x="10" y="27"/>
                      </a:lnTo>
                      <a:lnTo>
                        <a:pt x="10" y="25"/>
                      </a:lnTo>
                      <a:lnTo>
                        <a:pt x="10" y="24"/>
                      </a:lnTo>
                      <a:lnTo>
                        <a:pt x="9" y="21"/>
                      </a:lnTo>
                      <a:lnTo>
                        <a:pt x="9" y="20"/>
                      </a:lnTo>
                      <a:lnTo>
                        <a:pt x="7" y="18"/>
                      </a:lnTo>
                      <a:lnTo>
                        <a:pt x="7" y="17"/>
                      </a:lnTo>
                      <a:lnTo>
                        <a:pt x="6" y="15"/>
                      </a:lnTo>
                      <a:lnTo>
                        <a:pt x="6" y="12"/>
                      </a:lnTo>
                      <a:lnTo>
                        <a:pt x="5" y="11"/>
                      </a:lnTo>
                      <a:lnTo>
                        <a:pt x="5" y="10"/>
                      </a:lnTo>
                      <a:lnTo>
                        <a:pt x="5" y="8"/>
                      </a:lnTo>
                      <a:lnTo>
                        <a:pt x="3" y="7"/>
                      </a:lnTo>
                      <a:lnTo>
                        <a:pt x="3" y="5"/>
                      </a:lnTo>
                      <a:lnTo>
                        <a:pt x="2" y="2"/>
                      </a:lnTo>
                      <a:lnTo>
                        <a:pt x="2" y="1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36" name="Freeform 120"/>
                <p:cNvSpPr/>
                <p:nvPr/>
              </p:nvSpPr>
              <p:spPr bwMode="auto">
                <a:xfrm>
                  <a:off x="5056" y="1756"/>
                  <a:ext cx="26" cy="108"/>
                </a:xfrm>
                <a:custGeom>
                  <a:avLst/>
                  <a:gdLst>
                    <a:gd name="T0" fmla="*/ 0 w 26"/>
                    <a:gd name="T1" fmla="*/ 0 h 108"/>
                    <a:gd name="T2" fmla="*/ 2 w 26"/>
                    <a:gd name="T3" fmla="*/ 7 h 108"/>
                    <a:gd name="T4" fmla="*/ 4 w 26"/>
                    <a:gd name="T5" fmla="*/ 13 h 108"/>
                    <a:gd name="T6" fmla="*/ 6 w 26"/>
                    <a:gd name="T7" fmla="*/ 20 h 108"/>
                    <a:gd name="T8" fmla="*/ 7 w 26"/>
                    <a:gd name="T9" fmla="*/ 28 h 108"/>
                    <a:gd name="T10" fmla="*/ 9 w 26"/>
                    <a:gd name="T11" fmla="*/ 33 h 108"/>
                    <a:gd name="T12" fmla="*/ 12 w 26"/>
                    <a:gd name="T13" fmla="*/ 40 h 108"/>
                    <a:gd name="T14" fmla="*/ 13 w 26"/>
                    <a:gd name="T15" fmla="*/ 48 h 108"/>
                    <a:gd name="T16" fmla="*/ 14 w 26"/>
                    <a:gd name="T17" fmla="*/ 53 h 108"/>
                    <a:gd name="T18" fmla="*/ 16 w 26"/>
                    <a:gd name="T19" fmla="*/ 61 h 108"/>
                    <a:gd name="T20" fmla="*/ 17 w 26"/>
                    <a:gd name="T21" fmla="*/ 68 h 108"/>
                    <a:gd name="T22" fmla="*/ 19 w 26"/>
                    <a:gd name="T23" fmla="*/ 73 h 108"/>
                    <a:gd name="T24" fmla="*/ 20 w 26"/>
                    <a:gd name="T25" fmla="*/ 81 h 108"/>
                    <a:gd name="T26" fmla="*/ 22 w 26"/>
                    <a:gd name="T27" fmla="*/ 88 h 108"/>
                    <a:gd name="T28" fmla="*/ 23 w 26"/>
                    <a:gd name="T29" fmla="*/ 95 h 108"/>
                    <a:gd name="T30" fmla="*/ 24 w 26"/>
                    <a:gd name="T31" fmla="*/ 101 h 108"/>
                    <a:gd name="T32" fmla="*/ 26 w 26"/>
                    <a:gd name="T33" fmla="*/ 108 h 10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</a:cxnLst>
                  <a:rect l="0" t="0" r="r" b="b"/>
                  <a:pathLst>
                    <a:path w="26" h="108">
                      <a:moveTo>
                        <a:pt x="0" y="0"/>
                      </a:moveTo>
                      <a:lnTo>
                        <a:pt x="2" y="7"/>
                      </a:lnTo>
                      <a:lnTo>
                        <a:pt x="4" y="13"/>
                      </a:lnTo>
                      <a:lnTo>
                        <a:pt x="6" y="20"/>
                      </a:lnTo>
                      <a:lnTo>
                        <a:pt x="7" y="28"/>
                      </a:lnTo>
                      <a:lnTo>
                        <a:pt x="9" y="33"/>
                      </a:lnTo>
                      <a:lnTo>
                        <a:pt x="12" y="40"/>
                      </a:lnTo>
                      <a:lnTo>
                        <a:pt x="13" y="48"/>
                      </a:lnTo>
                      <a:lnTo>
                        <a:pt x="14" y="53"/>
                      </a:lnTo>
                      <a:lnTo>
                        <a:pt x="16" y="61"/>
                      </a:lnTo>
                      <a:lnTo>
                        <a:pt x="17" y="68"/>
                      </a:lnTo>
                      <a:lnTo>
                        <a:pt x="19" y="73"/>
                      </a:lnTo>
                      <a:lnTo>
                        <a:pt x="20" y="81"/>
                      </a:lnTo>
                      <a:lnTo>
                        <a:pt x="22" y="88"/>
                      </a:lnTo>
                      <a:lnTo>
                        <a:pt x="23" y="95"/>
                      </a:lnTo>
                      <a:lnTo>
                        <a:pt x="24" y="101"/>
                      </a:lnTo>
                      <a:lnTo>
                        <a:pt x="26" y="108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37" name="Rectangle 121"/>
                <p:cNvSpPr>
                  <a:spLocks noChangeArrowheads="1"/>
                </p:cNvSpPr>
                <p:nvPr/>
              </p:nvSpPr>
              <p:spPr bwMode="auto">
                <a:xfrm rot="20580000">
                  <a:off x="4994" y="1797"/>
                  <a:ext cx="72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2</a:t>
                  </a:r>
                </a:p>
              </p:txBody>
            </p:sp>
            <p:sp>
              <p:nvSpPr>
                <p:cNvPr id="338" name="Line 122"/>
                <p:cNvSpPr>
                  <a:spLocks noChangeShapeType="1"/>
                </p:cNvSpPr>
                <p:nvPr/>
              </p:nvSpPr>
              <p:spPr bwMode="auto">
                <a:xfrm flipV="1">
                  <a:off x="4530" y="1758"/>
                  <a:ext cx="523" cy="150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39" name="Freeform 123"/>
                <p:cNvSpPr/>
                <p:nvPr/>
              </p:nvSpPr>
              <p:spPr bwMode="auto">
                <a:xfrm>
                  <a:off x="4450" y="1732"/>
                  <a:ext cx="44" cy="86"/>
                </a:xfrm>
                <a:custGeom>
                  <a:avLst/>
                  <a:gdLst>
                    <a:gd name="T0" fmla="*/ 44 w 44"/>
                    <a:gd name="T1" fmla="*/ 86 h 86"/>
                    <a:gd name="T2" fmla="*/ 43 w 44"/>
                    <a:gd name="T3" fmla="*/ 82 h 86"/>
                    <a:gd name="T4" fmla="*/ 41 w 44"/>
                    <a:gd name="T5" fmla="*/ 77 h 86"/>
                    <a:gd name="T6" fmla="*/ 38 w 44"/>
                    <a:gd name="T7" fmla="*/ 73 h 86"/>
                    <a:gd name="T8" fmla="*/ 37 w 44"/>
                    <a:gd name="T9" fmla="*/ 70 h 86"/>
                    <a:gd name="T10" fmla="*/ 34 w 44"/>
                    <a:gd name="T11" fmla="*/ 66 h 86"/>
                    <a:gd name="T12" fmla="*/ 32 w 44"/>
                    <a:gd name="T13" fmla="*/ 62 h 86"/>
                    <a:gd name="T14" fmla="*/ 31 w 44"/>
                    <a:gd name="T15" fmla="*/ 57 h 86"/>
                    <a:gd name="T16" fmla="*/ 28 w 44"/>
                    <a:gd name="T17" fmla="*/ 53 h 86"/>
                    <a:gd name="T18" fmla="*/ 27 w 44"/>
                    <a:gd name="T19" fmla="*/ 49 h 86"/>
                    <a:gd name="T20" fmla="*/ 24 w 44"/>
                    <a:gd name="T21" fmla="*/ 44 h 86"/>
                    <a:gd name="T22" fmla="*/ 22 w 44"/>
                    <a:gd name="T23" fmla="*/ 40 h 86"/>
                    <a:gd name="T24" fmla="*/ 20 w 44"/>
                    <a:gd name="T25" fmla="*/ 36 h 86"/>
                    <a:gd name="T26" fmla="*/ 18 w 44"/>
                    <a:gd name="T27" fmla="*/ 33 h 86"/>
                    <a:gd name="T28" fmla="*/ 15 w 44"/>
                    <a:gd name="T29" fmla="*/ 29 h 86"/>
                    <a:gd name="T30" fmla="*/ 14 w 44"/>
                    <a:gd name="T31" fmla="*/ 24 h 86"/>
                    <a:gd name="T32" fmla="*/ 11 w 44"/>
                    <a:gd name="T33" fmla="*/ 20 h 86"/>
                    <a:gd name="T34" fmla="*/ 10 w 44"/>
                    <a:gd name="T35" fmla="*/ 16 h 86"/>
                    <a:gd name="T36" fmla="*/ 7 w 44"/>
                    <a:gd name="T37" fmla="*/ 11 h 86"/>
                    <a:gd name="T38" fmla="*/ 4 w 44"/>
                    <a:gd name="T39" fmla="*/ 9 h 86"/>
                    <a:gd name="T40" fmla="*/ 2 w 44"/>
                    <a:gd name="T41" fmla="*/ 4 h 86"/>
                    <a:gd name="T42" fmla="*/ 0 w 44"/>
                    <a:gd name="T43" fmla="*/ 0 h 8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</a:cxnLst>
                  <a:rect l="0" t="0" r="r" b="b"/>
                  <a:pathLst>
                    <a:path w="44" h="86">
                      <a:moveTo>
                        <a:pt x="44" y="86"/>
                      </a:moveTo>
                      <a:lnTo>
                        <a:pt x="43" y="82"/>
                      </a:lnTo>
                      <a:lnTo>
                        <a:pt x="41" y="77"/>
                      </a:lnTo>
                      <a:lnTo>
                        <a:pt x="38" y="73"/>
                      </a:lnTo>
                      <a:lnTo>
                        <a:pt x="37" y="70"/>
                      </a:lnTo>
                      <a:lnTo>
                        <a:pt x="34" y="66"/>
                      </a:lnTo>
                      <a:lnTo>
                        <a:pt x="32" y="62"/>
                      </a:lnTo>
                      <a:lnTo>
                        <a:pt x="31" y="57"/>
                      </a:lnTo>
                      <a:lnTo>
                        <a:pt x="28" y="53"/>
                      </a:lnTo>
                      <a:lnTo>
                        <a:pt x="27" y="49"/>
                      </a:lnTo>
                      <a:lnTo>
                        <a:pt x="24" y="44"/>
                      </a:lnTo>
                      <a:lnTo>
                        <a:pt x="22" y="40"/>
                      </a:lnTo>
                      <a:lnTo>
                        <a:pt x="20" y="36"/>
                      </a:lnTo>
                      <a:lnTo>
                        <a:pt x="18" y="33"/>
                      </a:lnTo>
                      <a:lnTo>
                        <a:pt x="15" y="29"/>
                      </a:lnTo>
                      <a:lnTo>
                        <a:pt x="14" y="24"/>
                      </a:lnTo>
                      <a:lnTo>
                        <a:pt x="11" y="20"/>
                      </a:lnTo>
                      <a:lnTo>
                        <a:pt x="10" y="16"/>
                      </a:lnTo>
                      <a:lnTo>
                        <a:pt x="7" y="11"/>
                      </a:lnTo>
                      <a:lnTo>
                        <a:pt x="4" y="9"/>
                      </a:lnTo>
                      <a:lnTo>
                        <a:pt x="2" y="4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40" name="Freeform 124"/>
                <p:cNvSpPr/>
                <p:nvPr/>
              </p:nvSpPr>
              <p:spPr bwMode="auto">
                <a:xfrm>
                  <a:off x="4494" y="1818"/>
                  <a:ext cx="33" cy="92"/>
                </a:xfrm>
                <a:custGeom>
                  <a:avLst/>
                  <a:gdLst>
                    <a:gd name="T0" fmla="*/ 0 w 33"/>
                    <a:gd name="T1" fmla="*/ 1 h 92"/>
                    <a:gd name="T2" fmla="*/ 1 w 33"/>
                    <a:gd name="T3" fmla="*/ 3 h 92"/>
                    <a:gd name="T4" fmla="*/ 3 w 33"/>
                    <a:gd name="T5" fmla="*/ 4 h 92"/>
                    <a:gd name="T6" fmla="*/ 3 w 33"/>
                    <a:gd name="T7" fmla="*/ 7 h 92"/>
                    <a:gd name="T8" fmla="*/ 4 w 33"/>
                    <a:gd name="T9" fmla="*/ 9 h 92"/>
                    <a:gd name="T10" fmla="*/ 4 w 33"/>
                    <a:gd name="T11" fmla="*/ 10 h 92"/>
                    <a:gd name="T12" fmla="*/ 6 w 33"/>
                    <a:gd name="T13" fmla="*/ 13 h 92"/>
                    <a:gd name="T14" fmla="*/ 6 w 33"/>
                    <a:gd name="T15" fmla="*/ 14 h 92"/>
                    <a:gd name="T16" fmla="*/ 7 w 33"/>
                    <a:gd name="T17" fmla="*/ 16 h 92"/>
                    <a:gd name="T18" fmla="*/ 7 w 33"/>
                    <a:gd name="T19" fmla="*/ 17 h 92"/>
                    <a:gd name="T20" fmla="*/ 9 w 33"/>
                    <a:gd name="T21" fmla="*/ 20 h 92"/>
                    <a:gd name="T22" fmla="*/ 9 w 33"/>
                    <a:gd name="T23" fmla="*/ 22 h 92"/>
                    <a:gd name="T24" fmla="*/ 10 w 33"/>
                    <a:gd name="T25" fmla="*/ 23 h 92"/>
                    <a:gd name="T26" fmla="*/ 10 w 33"/>
                    <a:gd name="T27" fmla="*/ 26 h 92"/>
                    <a:gd name="T28" fmla="*/ 11 w 33"/>
                    <a:gd name="T29" fmla="*/ 27 h 92"/>
                    <a:gd name="T30" fmla="*/ 11 w 33"/>
                    <a:gd name="T31" fmla="*/ 29 h 92"/>
                    <a:gd name="T32" fmla="*/ 13 w 33"/>
                    <a:gd name="T33" fmla="*/ 30 h 92"/>
                    <a:gd name="T34" fmla="*/ 13 w 33"/>
                    <a:gd name="T35" fmla="*/ 33 h 92"/>
                    <a:gd name="T36" fmla="*/ 14 w 33"/>
                    <a:gd name="T37" fmla="*/ 34 h 92"/>
                    <a:gd name="T38" fmla="*/ 14 w 33"/>
                    <a:gd name="T39" fmla="*/ 36 h 92"/>
                    <a:gd name="T40" fmla="*/ 16 w 33"/>
                    <a:gd name="T41" fmla="*/ 39 h 92"/>
                    <a:gd name="T42" fmla="*/ 16 w 33"/>
                    <a:gd name="T43" fmla="*/ 40 h 92"/>
                    <a:gd name="T44" fmla="*/ 17 w 33"/>
                    <a:gd name="T45" fmla="*/ 42 h 92"/>
                    <a:gd name="T46" fmla="*/ 17 w 33"/>
                    <a:gd name="T47" fmla="*/ 43 h 92"/>
                    <a:gd name="T48" fmla="*/ 19 w 33"/>
                    <a:gd name="T49" fmla="*/ 46 h 92"/>
                    <a:gd name="T50" fmla="*/ 19 w 33"/>
                    <a:gd name="T51" fmla="*/ 47 h 92"/>
                    <a:gd name="T52" fmla="*/ 20 w 33"/>
                    <a:gd name="T53" fmla="*/ 49 h 92"/>
                    <a:gd name="T54" fmla="*/ 20 w 33"/>
                    <a:gd name="T55" fmla="*/ 52 h 92"/>
                    <a:gd name="T56" fmla="*/ 21 w 33"/>
                    <a:gd name="T57" fmla="*/ 53 h 92"/>
                    <a:gd name="T58" fmla="*/ 21 w 33"/>
                    <a:gd name="T59" fmla="*/ 55 h 92"/>
                    <a:gd name="T60" fmla="*/ 21 w 33"/>
                    <a:gd name="T61" fmla="*/ 57 h 92"/>
                    <a:gd name="T62" fmla="*/ 23 w 33"/>
                    <a:gd name="T63" fmla="*/ 59 h 92"/>
                    <a:gd name="T64" fmla="*/ 23 w 33"/>
                    <a:gd name="T65" fmla="*/ 60 h 92"/>
                    <a:gd name="T66" fmla="*/ 24 w 33"/>
                    <a:gd name="T67" fmla="*/ 63 h 92"/>
                    <a:gd name="T68" fmla="*/ 24 w 33"/>
                    <a:gd name="T69" fmla="*/ 65 h 92"/>
                    <a:gd name="T70" fmla="*/ 26 w 33"/>
                    <a:gd name="T71" fmla="*/ 66 h 92"/>
                    <a:gd name="T72" fmla="*/ 26 w 33"/>
                    <a:gd name="T73" fmla="*/ 67 h 92"/>
                    <a:gd name="T74" fmla="*/ 26 w 33"/>
                    <a:gd name="T75" fmla="*/ 70 h 92"/>
                    <a:gd name="T76" fmla="*/ 27 w 33"/>
                    <a:gd name="T77" fmla="*/ 72 h 92"/>
                    <a:gd name="T78" fmla="*/ 27 w 33"/>
                    <a:gd name="T79" fmla="*/ 73 h 92"/>
                    <a:gd name="T80" fmla="*/ 29 w 33"/>
                    <a:gd name="T81" fmla="*/ 76 h 92"/>
                    <a:gd name="T82" fmla="*/ 29 w 33"/>
                    <a:gd name="T83" fmla="*/ 77 h 92"/>
                    <a:gd name="T84" fmla="*/ 30 w 33"/>
                    <a:gd name="T85" fmla="*/ 79 h 92"/>
                    <a:gd name="T86" fmla="*/ 30 w 33"/>
                    <a:gd name="T87" fmla="*/ 82 h 92"/>
                    <a:gd name="T88" fmla="*/ 30 w 33"/>
                    <a:gd name="T89" fmla="*/ 83 h 92"/>
                    <a:gd name="T90" fmla="*/ 32 w 33"/>
                    <a:gd name="T91" fmla="*/ 85 h 92"/>
                    <a:gd name="T92" fmla="*/ 32 w 33"/>
                    <a:gd name="T93" fmla="*/ 88 h 92"/>
                    <a:gd name="T94" fmla="*/ 33 w 33"/>
                    <a:gd name="T95" fmla="*/ 89 h 92"/>
                    <a:gd name="T96" fmla="*/ 33 w 33"/>
                    <a:gd name="T97" fmla="*/ 90 h 9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  <a:cxn ang="0">
                      <a:pos x="T90" y="T91"/>
                    </a:cxn>
                    <a:cxn ang="0">
                      <a:pos x="T92" y="T93"/>
                    </a:cxn>
                    <a:cxn ang="0">
                      <a:pos x="T94" y="T95"/>
                    </a:cxn>
                    <a:cxn ang="0">
                      <a:pos x="T96" y="T97"/>
                    </a:cxn>
                  </a:cxnLst>
                  <a:rect l="0" t="0" r="r" b="b"/>
                  <a:pathLst>
                    <a:path w="33" h="92">
                      <a:moveTo>
                        <a:pt x="0" y="0"/>
                      </a:moveTo>
                      <a:lnTo>
                        <a:pt x="0" y="1"/>
                      </a:lnTo>
                      <a:lnTo>
                        <a:pt x="1" y="3"/>
                      </a:lnTo>
                      <a:lnTo>
                        <a:pt x="1" y="3"/>
                      </a:lnTo>
                      <a:lnTo>
                        <a:pt x="1" y="4"/>
                      </a:lnTo>
                      <a:lnTo>
                        <a:pt x="3" y="4"/>
                      </a:lnTo>
                      <a:lnTo>
                        <a:pt x="3" y="6"/>
                      </a:lnTo>
                      <a:lnTo>
                        <a:pt x="3" y="7"/>
                      </a:lnTo>
                      <a:lnTo>
                        <a:pt x="3" y="7"/>
                      </a:lnTo>
                      <a:lnTo>
                        <a:pt x="4" y="9"/>
                      </a:lnTo>
                      <a:lnTo>
                        <a:pt x="4" y="10"/>
                      </a:lnTo>
                      <a:lnTo>
                        <a:pt x="4" y="10"/>
                      </a:lnTo>
                      <a:lnTo>
                        <a:pt x="4" y="11"/>
                      </a:lnTo>
                      <a:lnTo>
                        <a:pt x="6" y="13"/>
                      </a:lnTo>
                      <a:lnTo>
                        <a:pt x="6" y="13"/>
                      </a:lnTo>
                      <a:lnTo>
                        <a:pt x="6" y="14"/>
                      </a:lnTo>
                      <a:lnTo>
                        <a:pt x="6" y="16"/>
                      </a:lnTo>
                      <a:lnTo>
                        <a:pt x="7" y="16"/>
                      </a:lnTo>
                      <a:lnTo>
                        <a:pt x="7" y="17"/>
                      </a:lnTo>
                      <a:lnTo>
                        <a:pt x="7" y="17"/>
                      </a:lnTo>
                      <a:lnTo>
                        <a:pt x="7" y="19"/>
                      </a:lnTo>
                      <a:lnTo>
                        <a:pt x="9" y="20"/>
                      </a:lnTo>
                      <a:lnTo>
                        <a:pt x="9" y="20"/>
                      </a:lnTo>
                      <a:lnTo>
                        <a:pt x="9" y="22"/>
                      </a:lnTo>
                      <a:lnTo>
                        <a:pt x="10" y="23"/>
                      </a:lnTo>
                      <a:lnTo>
                        <a:pt x="10" y="23"/>
                      </a:lnTo>
                      <a:lnTo>
                        <a:pt x="10" y="24"/>
                      </a:lnTo>
                      <a:lnTo>
                        <a:pt x="10" y="26"/>
                      </a:lnTo>
                      <a:lnTo>
                        <a:pt x="11" y="26"/>
                      </a:lnTo>
                      <a:lnTo>
                        <a:pt x="11" y="27"/>
                      </a:lnTo>
                      <a:lnTo>
                        <a:pt x="11" y="27"/>
                      </a:lnTo>
                      <a:lnTo>
                        <a:pt x="11" y="29"/>
                      </a:lnTo>
                      <a:lnTo>
                        <a:pt x="13" y="30"/>
                      </a:lnTo>
                      <a:lnTo>
                        <a:pt x="13" y="30"/>
                      </a:lnTo>
                      <a:lnTo>
                        <a:pt x="13" y="32"/>
                      </a:lnTo>
                      <a:lnTo>
                        <a:pt x="13" y="33"/>
                      </a:lnTo>
                      <a:lnTo>
                        <a:pt x="14" y="33"/>
                      </a:lnTo>
                      <a:lnTo>
                        <a:pt x="14" y="34"/>
                      </a:lnTo>
                      <a:lnTo>
                        <a:pt x="14" y="36"/>
                      </a:lnTo>
                      <a:lnTo>
                        <a:pt x="14" y="36"/>
                      </a:lnTo>
                      <a:lnTo>
                        <a:pt x="16" y="37"/>
                      </a:lnTo>
                      <a:lnTo>
                        <a:pt x="16" y="39"/>
                      </a:lnTo>
                      <a:lnTo>
                        <a:pt x="16" y="39"/>
                      </a:lnTo>
                      <a:lnTo>
                        <a:pt x="16" y="40"/>
                      </a:lnTo>
                      <a:lnTo>
                        <a:pt x="16" y="42"/>
                      </a:lnTo>
                      <a:lnTo>
                        <a:pt x="17" y="42"/>
                      </a:lnTo>
                      <a:lnTo>
                        <a:pt x="17" y="43"/>
                      </a:lnTo>
                      <a:lnTo>
                        <a:pt x="17" y="43"/>
                      </a:lnTo>
                      <a:lnTo>
                        <a:pt x="17" y="44"/>
                      </a:lnTo>
                      <a:lnTo>
                        <a:pt x="19" y="46"/>
                      </a:lnTo>
                      <a:lnTo>
                        <a:pt x="19" y="46"/>
                      </a:lnTo>
                      <a:lnTo>
                        <a:pt x="19" y="47"/>
                      </a:lnTo>
                      <a:lnTo>
                        <a:pt x="19" y="49"/>
                      </a:lnTo>
                      <a:lnTo>
                        <a:pt x="20" y="49"/>
                      </a:lnTo>
                      <a:lnTo>
                        <a:pt x="20" y="50"/>
                      </a:lnTo>
                      <a:lnTo>
                        <a:pt x="20" y="52"/>
                      </a:lnTo>
                      <a:lnTo>
                        <a:pt x="20" y="52"/>
                      </a:lnTo>
                      <a:lnTo>
                        <a:pt x="21" y="53"/>
                      </a:lnTo>
                      <a:lnTo>
                        <a:pt x="21" y="55"/>
                      </a:lnTo>
                      <a:lnTo>
                        <a:pt x="21" y="55"/>
                      </a:lnTo>
                      <a:lnTo>
                        <a:pt x="21" y="56"/>
                      </a:lnTo>
                      <a:lnTo>
                        <a:pt x="21" y="57"/>
                      </a:lnTo>
                      <a:lnTo>
                        <a:pt x="23" y="57"/>
                      </a:lnTo>
                      <a:lnTo>
                        <a:pt x="23" y="59"/>
                      </a:lnTo>
                      <a:lnTo>
                        <a:pt x="23" y="60"/>
                      </a:lnTo>
                      <a:lnTo>
                        <a:pt x="23" y="60"/>
                      </a:lnTo>
                      <a:lnTo>
                        <a:pt x="24" y="62"/>
                      </a:lnTo>
                      <a:lnTo>
                        <a:pt x="24" y="63"/>
                      </a:lnTo>
                      <a:lnTo>
                        <a:pt x="24" y="63"/>
                      </a:lnTo>
                      <a:lnTo>
                        <a:pt x="24" y="65"/>
                      </a:lnTo>
                      <a:lnTo>
                        <a:pt x="24" y="66"/>
                      </a:lnTo>
                      <a:lnTo>
                        <a:pt x="26" y="66"/>
                      </a:lnTo>
                      <a:lnTo>
                        <a:pt x="26" y="67"/>
                      </a:lnTo>
                      <a:lnTo>
                        <a:pt x="26" y="67"/>
                      </a:lnTo>
                      <a:lnTo>
                        <a:pt x="26" y="69"/>
                      </a:lnTo>
                      <a:lnTo>
                        <a:pt x="26" y="70"/>
                      </a:lnTo>
                      <a:lnTo>
                        <a:pt x="27" y="70"/>
                      </a:lnTo>
                      <a:lnTo>
                        <a:pt x="27" y="72"/>
                      </a:lnTo>
                      <a:lnTo>
                        <a:pt x="27" y="73"/>
                      </a:lnTo>
                      <a:lnTo>
                        <a:pt x="27" y="73"/>
                      </a:lnTo>
                      <a:lnTo>
                        <a:pt x="29" y="75"/>
                      </a:lnTo>
                      <a:lnTo>
                        <a:pt x="29" y="76"/>
                      </a:lnTo>
                      <a:lnTo>
                        <a:pt x="29" y="76"/>
                      </a:lnTo>
                      <a:lnTo>
                        <a:pt x="29" y="77"/>
                      </a:lnTo>
                      <a:lnTo>
                        <a:pt x="29" y="79"/>
                      </a:lnTo>
                      <a:lnTo>
                        <a:pt x="30" y="79"/>
                      </a:lnTo>
                      <a:lnTo>
                        <a:pt x="30" y="80"/>
                      </a:lnTo>
                      <a:lnTo>
                        <a:pt x="30" y="82"/>
                      </a:lnTo>
                      <a:lnTo>
                        <a:pt x="30" y="82"/>
                      </a:lnTo>
                      <a:lnTo>
                        <a:pt x="30" y="83"/>
                      </a:lnTo>
                      <a:lnTo>
                        <a:pt x="32" y="85"/>
                      </a:lnTo>
                      <a:lnTo>
                        <a:pt x="32" y="85"/>
                      </a:lnTo>
                      <a:lnTo>
                        <a:pt x="32" y="86"/>
                      </a:lnTo>
                      <a:lnTo>
                        <a:pt x="32" y="88"/>
                      </a:lnTo>
                      <a:lnTo>
                        <a:pt x="32" y="88"/>
                      </a:lnTo>
                      <a:lnTo>
                        <a:pt x="33" y="89"/>
                      </a:lnTo>
                      <a:lnTo>
                        <a:pt x="33" y="90"/>
                      </a:lnTo>
                      <a:lnTo>
                        <a:pt x="33" y="90"/>
                      </a:lnTo>
                      <a:lnTo>
                        <a:pt x="33" y="92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41" name="Rectangle 125"/>
                <p:cNvSpPr>
                  <a:spLocks noChangeArrowheads="1"/>
                </p:cNvSpPr>
                <p:nvPr/>
              </p:nvSpPr>
              <p:spPr bwMode="auto">
                <a:xfrm rot="20160000">
                  <a:off x="4405" y="1752"/>
                  <a:ext cx="72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1</a:t>
                  </a:r>
                </a:p>
              </p:txBody>
            </p:sp>
            <p:sp>
              <p:nvSpPr>
                <p:cNvPr id="342" name="Line 126"/>
                <p:cNvSpPr>
                  <a:spLocks noChangeShapeType="1"/>
                </p:cNvSpPr>
                <p:nvPr/>
              </p:nvSpPr>
              <p:spPr bwMode="auto">
                <a:xfrm flipV="1">
                  <a:off x="4434" y="1819"/>
                  <a:ext cx="57" cy="25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43" name="Rectangle 127"/>
                <p:cNvSpPr>
                  <a:spLocks noChangeArrowheads="1"/>
                </p:cNvSpPr>
                <p:nvPr/>
              </p:nvSpPr>
              <p:spPr bwMode="auto">
                <a:xfrm rot="780000">
                  <a:off x="5599" y="2532"/>
                  <a:ext cx="210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ZK-A8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44" name="Line 128"/>
                <p:cNvSpPr>
                  <a:spLocks noChangeShapeType="1"/>
                </p:cNvSpPr>
                <p:nvPr/>
              </p:nvSpPr>
              <p:spPr bwMode="auto">
                <a:xfrm>
                  <a:off x="5409" y="2507"/>
                  <a:ext cx="62" cy="16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45" name="Rectangle 129"/>
                <p:cNvSpPr>
                  <a:spLocks noChangeArrowheads="1"/>
                </p:cNvSpPr>
                <p:nvPr/>
              </p:nvSpPr>
              <p:spPr bwMode="auto">
                <a:xfrm rot="1080000">
                  <a:off x="5548" y="2679"/>
                  <a:ext cx="210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ZK-A9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46" name="Line 130"/>
                <p:cNvSpPr>
                  <a:spLocks noChangeShapeType="1"/>
                </p:cNvSpPr>
                <p:nvPr/>
              </p:nvSpPr>
              <p:spPr bwMode="auto">
                <a:xfrm>
                  <a:off x="5370" y="2643"/>
                  <a:ext cx="60" cy="20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47" name="Freeform 131"/>
                <p:cNvSpPr/>
                <p:nvPr/>
              </p:nvSpPr>
              <p:spPr bwMode="auto">
                <a:xfrm>
                  <a:off x="5389" y="2507"/>
                  <a:ext cx="17" cy="67"/>
                </a:xfrm>
                <a:custGeom>
                  <a:avLst/>
                  <a:gdLst>
                    <a:gd name="T0" fmla="*/ 0 w 17"/>
                    <a:gd name="T1" fmla="*/ 67 h 67"/>
                    <a:gd name="T2" fmla="*/ 1 w 17"/>
                    <a:gd name="T3" fmla="*/ 63 h 67"/>
                    <a:gd name="T4" fmla="*/ 3 w 17"/>
                    <a:gd name="T5" fmla="*/ 59 h 67"/>
                    <a:gd name="T6" fmla="*/ 4 w 17"/>
                    <a:gd name="T7" fmla="*/ 53 h 67"/>
                    <a:gd name="T8" fmla="*/ 4 w 17"/>
                    <a:gd name="T9" fmla="*/ 49 h 67"/>
                    <a:gd name="T10" fmla="*/ 6 w 17"/>
                    <a:gd name="T11" fmla="*/ 43 h 67"/>
                    <a:gd name="T12" fmla="*/ 7 w 17"/>
                    <a:gd name="T13" fmla="*/ 38 h 67"/>
                    <a:gd name="T14" fmla="*/ 8 w 17"/>
                    <a:gd name="T15" fmla="*/ 34 h 67"/>
                    <a:gd name="T16" fmla="*/ 10 w 17"/>
                    <a:gd name="T17" fmla="*/ 28 h 67"/>
                    <a:gd name="T18" fmla="*/ 11 w 17"/>
                    <a:gd name="T19" fmla="*/ 24 h 67"/>
                    <a:gd name="T20" fmla="*/ 13 w 17"/>
                    <a:gd name="T21" fmla="*/ 18 h 67"/>
                    <a:gd name="T22" fmla="*/ 14 w 17"/>
                    <a:gd name="T23" fmla="*/ 14 h 67"/>
                    <a:gd name="T24" fmla="*/ 16 w 17"/>
                    <a:gd name="T25" fmla="*/ 8 h 67"/>
                    <a:gd name="T26" fmla="*/ 16 w 17"/>
                    <a:gd name="T27" fmla="*/ 4 h 67"/>
                    <a:gd name="T28" fmla="*/ 17 w 17"/>
                    <a:gd name="T29" fmla="*/ 0 h 6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</a:cxnLst>
                  <a:rect l="0" t="0" r="r" b="b"/>
                  <a:pathLst>
                    <a:path w="17" h="67">
                      <a:moveTo>
                        <a:pt x="0" y="67"/>
                      </a:moveTo>
                      <a:lnTo>
                        <a:pt x="1" y="63"/>
                      </a:lnTo>
                      <a:lnTo>
                        <a:pt x="3" y="59"/>
                      </a:lnTo>
                      <a:lnTo>
                        <a:pt x="4" y="53"/>
                      </a:lnTo>
                      <a:lnTo>
                        <a:pt x="4" y="49"/>
                      </a:lnTo>
                      <a:lnTo>
                        <a:pt x="6" y="43"/>
                      </a:lnTo>
                      <a:lnTo>
                        <a:pt x="7" y="38"/>
                      </a:lnTo>
                      <a:lnTo>
                        <a:pt x="8" y="34"/>
                      </a:lnTo>
                      <a:lnTo>
                        <a:pt x="10" y="28"/>
                      </a:lnTo>
                      <a:lnTo>
                        <a:pt x="11" y="24"/>
                      </a:lnTo>
                      <a:lnTo>
                        <a:pt x="13" y="18"/>
                      </a:lnTo>
                      <a:lnTo>
                        <a:pt x="14" y="14"/>
                      </a:lnTo>
                      <a:lnTo>
                        <a:pt x="16" y="8"/>
                      </a:lnTo>
                      <a:lnTo>
                        <a:pt x="16" y="4"/>
                      </a:lnTo>
                      <a:lnTo>
                        <a:pt x="17" y="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48" name="Freeform 132"/>
                <p:cNvSpPr/>
                <p:nvPr/>
              </p:nvSpPr>
              <p:spPr bwMode="auto">
                <a:xfrm>
                  <a:off x="5367" y="2574"/>
                  <a:ext cx="22" cy="69"/>
                </a:xfrm>
                <a:custGeom>
                  <a:avLst/>
                  <a:gdLst>
                    <a:gd name="T0" fmla="*/ 22 w 22"/>
                    <a:gd name="T1" fmla="*/ 0 h 69"/>
                    <a:gd name="T2" fmla="*/ 20 w 22"/>
                    <a:gd name="T3" fmla="*/ 6 h 69"/>
                    <a:gd name="T4" fmla="*/ 19 w 22"/>
                    <a:gd name="T5" fmla="*/ 10 h 69"/>
                    <a:gd name="T6" fmla="*/ 17 w 22"/>
                    <a:gd name="T7" fmla="*/ 15 h 69"/>
                    <a:gd name="T8" fmla="*/ 16 w 22"/>
                    <a:gd name="T9" fmla="*/ 19 h 69"/>
                    <a:gd name="T10" fmla="*/ 15 w 22"/>
                    <a:gd name="T11" fmla="*/ 23 h 69"/>
                    <a:gd name="T12" fmla="*/ 13 w 22"/>
                    <a:gd name="T13" fmla="*/ 27 h 69"/>
                    <a:gd name="T14" fmla="*/ 12 w 22"/>
                    <a:gd name="T15" fmla="*/ 33 h 69"/>
                    <a:gd name="T16" fmla="*/ 10 w 22"/>
                    <a:gd name="T17" fmla="*/ 37 h 69"/>
                    <a:gd name="T18" fmla="*/ 9 w 22"/>
                    <a:gd name="T19" fmla="*/ 42 h 69"/>
                    <a:gd name="T20" fmla="*/ 7 w 22"/>
                    <a:gd name="T21" fmla="*/ 46 h 69"/>
                    <a:gd name="T22" fmla="*/ 6 w 22"/>
                    <a:gd name="T23" fmla="*/ 50 h 69"/>
                    <a:gd name="T24" fmla="*/ 5 w 22"/>
                    <a:gd name="T25" fmla="*/ 55 h 69"/>
                    <a:gd name="T26" fmla="*/ 3 w 22"/>
                    <a:gd name="T27" fmla="*/ 59 h 69"/>
                    <a:gd name="T28" fmla="*/ 2 w 22"/>
                    <a:gd name="T29" fmla="*/ 65 h 69"/>
                    <a:gd name="T30" fmla="*/ 0 w 22"/>
                    <a:gd name="T31" fmla="*/ 69 h 6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</a:cxnLst>
                  <a:rect l="0" t="0" r="r" b="b"/>
                  <a:pathLst>
                    <a:path w="22" h="69">
                      <a:moveTo>
                        <a:pt x="22" y="0"/>
                      </a:moveTo>
                      <a:lnTo>
                        <a:pt x="20" y="6"/>
                      </a:lnTo>
                      <a:lnTo>
                        <a:pt x="19" y="10"/>
                      </a:lnTo>
                      <a:lnTo>
                        <a:pt x="17" y="15"/>
                      </a:lnTo>
                      <a:lnTo>
                        <a:pt x="16" y="19"/>
                      </a:lnTo>
                      <a:lnTo>
                        <a:pt x="15" y="23"/>
                      </a:lnTo>
                      <a:lnTo>
                        <a:pt x="13" y="27"/>
                      </a:lnTo>
                      <a:lnTo>
                        <a:pt x="12" y="33"/>
                      </a:lnTo>
                      <a:lnTo>
                        <a:pt x="10" y="37"/>
                      </a:lnTo>
                      <a:lnTo>
                        <a:pt x="9" y="42"/>
                      </a:lnTo>
                      <a:lnTo>
                        <a:pt x="7" y="46"/>
                      </a:lnTo>
                      <a:lnTo>
                        <a:pt x="6" y="50"/>
                      </a:lnTo>
                      <a:lnTo>
                        <a:pt x="5" y="55"/>
                      </a:lnTo>
                      <a:lnTo>
                        <a:pt x="3" y="59"/>
                      </a:lnTo>
                      <a:lnTo>
                        <a:pt x="2" y="65"/>
                      </a:lnTo>
                      <a:lnTo>
                        <a:pt x="0" y="69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49" name="Rectangle 133"/>
                <p:cNvSpPr>
                  <a:spLocks noChangeArrowheads="1"/>
                </p:cNvSpPr>
                <p:nvPr/>
              </p:nvSpPr>
              <p:spPr bwMode="auto">
                <a:xfrm rot="900000">
                  <a:off x="5292" y="2591"/>
                  <a:ext cx="72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86</a:t>
                  </a:r>
                </a:p>
              </p:txBody>
            </p:sp>
            <p:sp>
              <p:nvSpPr>
                <p:cNvPr id="350" name="Line 134"/>
                <p:cNvSpPr>
                  <a:spLocks noChangeShapeType="1"/>
                </p:cNvSpPr>
                <p:nvPr/>
              </p:nvSpPr>
              <p:spPr bwMode="auto">
                <a:xfrm>
                  <a:off x="4465" y="2310"/>
                  <a:ext cx="921" cy="263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51" name="Freeform 135"/>
                <p:cNvSpPr/>
                <p:nvPr/>
              </p:nvSpPr>
              <p:spPr bwMode="auto">
                <a:xfrm>
                  <a:off x="4431" y="1845"/>
                  <a:ext cx="56" cy="230"/>
                </a:xfrm>
                <a:custGeom>
                  <a:avLst/>
                  <a:gdLst>
                    <a:gd name="T0" fmla="*/ 56 w 56"/>
                    <a:gd name="T1" fmla="*/ 230 h 230"/>
                    <a:gd name="T2" fmla="*/ 56 w 56"/>
                    <a:gd name="T3" fmla="*/ 226 h 230"/>
                    <a:gd name="T4" fmla="*/ 54 w 56"/>
                    <a:gd name="T5" fmla="*/ 220 h 230"/>
                    <a:gd name="T6" fmla="*/ 54 w 56"/>
                    <a:gd name="T7" fmla="*/ 214 h 230"/>
                    <a:gd name="T8" fmla="*/ 54 w 56"/>
                    <a:gd name="T9" fmla="*/ 208 h 230"/>
                    <a:gd name="T10" fmla="*/ 53 w 56"/>
                    <a:gd name="T11" fmla="*/ 204 h 230"/>
                    <a:gd name="T12" fmla="*/ 53 w 56"/>
                    <a:gd name="T13" fmla="*/ 198 h 230"/>
                    <a:gd name="T14" fmla="*/ 51 w 56"/>
                    <a:gd name="T15" fmla="*/ 193 h 230"/>
                    <a:gd name="T16" fmla="*/ 51 w 56"/>
                    <a:gd name="T17" fmla="*/ 187 h 230"/>
                    <a:gd name="T18" fmla="*/ 51 w 56"/>
                    <a:gd name="T19" fmla="*/ 182 h 230"/>
                    <a:gd name="T20" fmla="*/ 50 w 56"/>
                    <a:gd name="T21" fmla="*/ 177 h 230"/>
                    <a:gd name="T22" fmla="*/ 49 w 56"/>
                    <a:gd name="T23" fmla="*/ 171 h 230"/>
                    <a:gd name="T24" fmla="*/ 49 w 56"/>
                    <a:gd name="T25" fmla="*/ 167 h 230"/>
                    <a:gd name="T26" fmla="*/ 47 w 56"/>
                    <a:gd name="T27" fmla="*/ 161 h 230"/>
                    <a:gd name="T28" fmla="*/ 47 w 56"/>
                    <a:gd name="T29" fmla="*/ 155 h 230"/>
                    <a:gd name="T30" fmla="*/ 46 w 56"/>
                    <a:gd name="T31" fmla="*/ 149 h 230"/>
                    <a:gd name="T32" fmla="*/ 44 w 56"/>
                    <a:gd name="T33" fmla="*/ 145 h 230"/>
                    <a:gd name="T34" fmla="*/ 44 w 56"/>
                    <a:gd name="T35" fmla="*/ 139 h 230"/>
                    <a:gd name="T36" fmla="*/ 43 w 56"/>
                    <a:gd name="T37" fmla="*/ 134 h 230"/>
                    <a:gd name="T38" fmla="*/ 41 w 56"/>
                    <a:gd name="T39" fmla="*/ 129 h 230"/>
                    <a:gd name="T40" fmla="*/ 40 w 56"/>
                    <a:gd name="T41" fmla="*/ 124 h 230"/>
                    <a:gd name="T42" fmla="*/ 39 w 56"/>
                    <a:gd name="T43" fmla="*/ 118 h 230"/>
                    <a:gd name="T44" fmla="*/ 37 w 56"/>
                    <a:gd name="T45" fmla="*/ 114 h 230"/>
                    <a:gd name="T46" fmla="*/ 37 w 56"/>
                    <a:gd name="T47" fmla="*/ 108 h 230"/>
                    <a:gd name="T48" fmla="*/ 36 w 56"/>
                    <a:gd name="T49" fmla="*/ 102 h 230"/>
                    <a:gd name="T50" fmla="*/ 34 w 56"/>
                    <a:gd name="T51" fmla="*/ 98 h 230"/>
                    <a:gd name="T52" fmla="*/ 33 w 56"/>
                    <a:gd name="T53" fmla="*/ 92 h 230"/>
                    <a:gd name="T54" fmla="*/ 31 w 56"/>
                    <a:gd name="T55" fmla="*/ 88 h 230"/>
                    <a:gd name="T56" fmla="*/ 30 w 56"/>
                    <a:gd name="T57" fmla="*/ 82 h 230"/>
                    <a:gd name="T58" fmla="*/ 29 w 56"/>
                    <a:gd name="T59" fmla="*/ 76 h 230"/>
                    <a:gd name="T60" fmla="*/ 26 w 56"/>
                    <a:gd name="T61" fmla="*/ 72 h 230"/>
                    <a:gd name="T62" fmla="*/ 24 w 56"/>
                    <a:gd name="T63" fmla="*/ 66 h 230"/>
                    <a:gd name="T64" fmla="*/ 23 w 56"/>
                    <a:gd name="T65" fmla="*/ 62 h 230"/>
                    <a:gd name="T66" fmla="*/ 21 w 56"/>
                    <a:gd name="T67" fmla="*/ 56 h 230"/>
                    <a:gd name="T68" fmla="*/ 20 w 56"/>
                    <a:gd name="T69" fmla="*/ 50 h 230"/>
                    <a:gd name="T70" fmla="*/ 19 w 56"/>
                    <a:gd name="T71" fmla="*/ 46 h 230"/>
                    <a:gd name="T72" fmla="*/ 16 w 56"/>
                    <a:gd name="T73" fmla="*/ 40 h 230"/>
                    <a:gd name="T74" fmla="*/ 14 w 56"/>
                    <a:gd name="T75" fmla="*/ 36 h 230"/>
                    <a:gd name="T76" fmla="*/ 13 w 56"/>
                    <a:gd name="T77" fmla="*/ 30 h 230"/>
                    <a:gd name="T78" fmla="*/ 10 w 56"/>
                    <a:gd name="T79" fmla="*/ 26 h 230"/>
                    <a:gd name="T80" fmla="*/ 8 w 56"/>
                    <a:gd name="T81" fmla="*/ 20 h 230"/>
                    <a:gd name="T82" fmla="*/ 7 w 56"/>
                    <a:gd name="T83" fmla="*/ 16 h 230"/>
                    <a:gd name="T84" fmla="*/ 4 w 56"/>
                    <a:gd name="T85" fmla="*/ 10 h 230"/>
                    <a:gd name="T86" fmla="*/ 3 w 56"/>
                    <a:gd name="T87" fmla="*/ 6 h 230"/>
                    <a:gd name="T88" fmla="*/ 0 w 56"/>
                    <a:gd name="T89" fmla="*/ 0 h 23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</a:cxnLst>
                  <a:rect l="0" t="0" r="r" b="b"/>
                  <a:pathLst>
                    <a:path w="56" h="230">
                      <a:moveTo>
                        <a:pt x="56" y="230"/>
                      </a:moveTo>
                      <a:lnTo>
                        <a:pt x="56" y="226"/>
                      </a:lnTo>
                      <a:lnTo>
                        <a:pt x="54" y="220"/>
                      </a:lnTo>
                      <a:lnTo>
                        <a:pt x="54" y="214"/>
                      </a:lnTo>
                      <a:lnTo>
                        <a:pt x="54" y="208"/>
                      </a:lnTo>
                      <a:lnTo>
                        <a:pt x="53" y="204"/>
                      </a:lnTo>
                      <a:lnTo>
                        <a:pt x="53" y="198"/>
                      </a:lnTo>
                      <a:lnTo>
                        <a:pt x="51" y="193"/>
                      </a:lnTo>
                      <a:lnTo>
                        <a:pt x="51" y="187"/>
                      </a:lnTo>
                      <a:lnTo>
                        <a:pt x="51" y="182"/>
                      </a:lnTo>
                      <a:lnTo>
                        <a:pt x="50" y="177"/>
                      </a:lnTo>
                      <a:lnTo>
                        <a:pt x="49" y="171"/>
                      </a:lnTo>
                      <a:lnTo>
                        <a:pt x="49" y="167"/>
                      </a:lnTo>
                      <a:lnTo>
                        <a:pt x="47" y="161"/>
                      </a:lnTo>
                      <a:lnTo>
                        <a:pt x="47" y="155"/>
                      </a:lnTo>
                      <a:lnTo>
                        <a:pt x="46" y="149"/>
                      </a:lnTo>
                      <a:lnTo>
                        <a:pt x="44" y="145"/>
                      </a:lnTo>
                      <a:lnTo>
                        <a:pt x="44" y="139"/>
                      </a:lnTo>
                      <a:lnTo>
                        <a:pt x="43" y="134"/>
                      </a:lnTo>
                      <a:lnTo>
                        <a:pt x="41" y="129"/>
                      </a:lnTo>
                      <a:lnTo>
                        <a:pt x="40" y="124"/>
                      </a:lnTo>
                      <a:lnTo>
                        <a:pt x="39" y="118"/>
                      </a:lnTo>
                      <a:lnTo>
                        <a:pt x="37" y="114"/>
                      </a:lnTo>
                      <a:lnTo>
                        <a:pt x="37" y="108"/>
                      </a:lnTo>
                      <a:lnTo>
                        <a:pt x="36" y="102"/>
                      </a:lnTo>
                      <a:lnTo>
                        <a:pt x="34" y="98"/>
                      </a:lnTo>
                      <a:lnTo>
                        <a:pt x="33" y="92"/>
                      </a:lnTo>
                      <a:lnTo>
                        <a:pt x="31" y="88"/>
                      </a:lnTo>
                      <a:lnTo>
                        <a:pt x="30" y="82"/>
                      </a:lnTo>
                      <a:lnTo>
                        <a:pt x="29" y="76"/>
                      </a:lnTo>
                      <a:lnTo>
                        <a:pt x="26" y="72"/>
                      </a:lnTo>
                      <a:lnTo>
                        <a:pt x="24" y="66"/>
                      </a:lnTo>
                      <a:lnTo>
                        <a:pt x="23" y="62"/>
                      </a:lnTo>
                      <a:lnTo>
                        <a:pt x="21" y="56"/>
                      </a:lnTo>
                      <a:lnTo>
                        <a:pt x="20" y="50"/>
                      </a:lnTo>
                      <a:lnTo>
                        <a:pt x="19" y="46"/>
                      </a:lnTo>
                      <a:lnTo>
                        <a:pt x="16" y="40"/>
                      </a:lnTo>
                      <a:lnTo>
                        <a:pt x="14" y="36"/>
                      </a:lnTo>
                      <a:lnTo>
                        <a:pt x="13" y="30"/>
                      </a:lnTo>
                      <a:lnTo>
                        <a:pt x="10" y="26"/>
                      </a:lnTo>
                      <a:lnTo>
                        <a:pt x="8" y="20"/>
                      </a:lnTo>
                      <a:lnTo>
                        <a:pt x="7" y="16"/>
                      </a:lnTo>
                      <a:lnTo>
                        <a:pt x="4" y="10"/>
                      </a:lnTo>
                      <a:lnTo>
                        <a:pt x="3" y="6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52" name="Freeform 136"/>
                <p:cNvSpPr/>
                <p:nvPr/>
              </p:nvSpPr>
              <p:spPr bwMode="auto">
                <a:xfrm>
                  <a:off x="4462" y="2075"/>
                  <a:ext cx="26" cy="235"/>
                </a:xfrm>
                <a:custGeom>
                  <a:avLst/>
                  <a:gdLst>
                    <a:gd name="T0" fmla="*/ 25 w 26"/>
                    <a:gd name="T1" fmla="*/ 3 h 235"/>
                    <a:gd name="T2" fmla="*/ 25 w 26"/>
                    <a:gd name="T3" fmla="*/ 8 h 235"/>
                    <a:gd name="T4" fmla="*/ 25 w 26"/>
                    <a:gd name="T5" fmla="*/ 13 h 235"/>
                    <a:gd name="T6" fmla="*/ 26 w 26"/>
                    <a:gd name="T7" fmla="*/ 17 h 235"/>
                    <a:gd name="T8" fmla="*/ 26 w 26"/>
                    <a:gd name="T9" fmla="*/ 21 h 235"/>
                    <a:gd name="T10" fmla="*/ 26 w 26"/>
                    <a:gd name="T11" fmla="*/ 26 h 235"/>
                    <a:gd name="T12" fmla="*/ 26 w 26"/>
                    <a:gd name="T13" fmla="*/ 30 h 235"/>
                    <a:gd name="T14" fmla="*/ 26 w 26"/>
                    <a:gd name="T15" fmla="*/ 34 h 235"/>
                    <a:gd name="T16" fmla="*/ 26 w 26"/>
                    <a:gd name="T17" fmla="*/ 40 h 235"/>
                    <a:gd name="T18" fmla="*/ 26 w 26"/>
                    <a:gd name="T19" fmla="*/ 44 h 235"/>
                    <a:gd name="T20" fmla="*/ 26 w 26"/>
                    <a:gd name="T21" fmla="*/ 49 h 235"/>
                    <a:gd name="T22" fmla="*/ 26 w 26"/>
                    <a:gd name="T23" fmla="*/ 53 h 235"/>
                    <a:gd name="T24" fmla="*/ 26 w 26"/>
                    <a:gd name="T25" fmla="*/ 57 h 235"/>
                    <a:gd name="T26" fmla="*/ 26 w 26"/>
                    <a:gd name="T27" fmla="*/ 62 h 235"/>
                    <a:gd name="T28" fmla="*/ 26 w 26"/>
                    <a:gd name="T29" fmla="*/ 67 h 235"/>
                    <a:gd name="T30" fmla="*/ 26 w 26"/>
                    <a:gd name="T31" fmla="*/ 72 h 235"/>
                    <a:gd name="T32" fmla="*/ 26 w 26"/>
                    <a:gd name="T33" fmla="*/ 76 h 235"/>
                    <a:gd name="T34" fmla="*/ 25 w 26"/>
                    <a:gd name="T35" fmla="*/ 80 h 235"/>
                    <a:gd name="T36" fmla="*/ 25 w 26"/>
                    <a:gd name="T37" fmla="*/ 84 h 235"/>
                    <a:gd name="T38" fmla="*/ 25 w 26"/>
                    <a:gd name="T39" fmla="*/ 89 h 235"/>
                    <a:gd name="T40" fmla="*/ 25 w 26"/>
                    <a:gd name="T41" fmla="*/ 95 h 235"/>
                    <a:gd name="T42" fmla="*/ 25 w 26"/>
                    <a:gd name="T43" fmla="*/ 99 h 235"/>
                    <a:gd name="T44" fmla="*/ 23 w 26"/>
                    <a:gd name="T45" fmla="*/ 103 h 235"/>
                    <a:gd name="T46" fmla="*/ 23 w 26"/>
                    <a:gd name="T47" fmla="*/ 107 h 235"/>
                    <a:gd name="T48" fmla="*/ 23 w 26"/>
                    <a:gd name="T49" fmla="*/ 112 h 235"/>
                    <a:gd name="T50" fmla="*/ 22 w 26"/>
                    <a:gd name="T51" fmla="*/ 116 h 235"/>
                    <a:gd name="T52" fmla="*/ 22 w 26"/>
                    <a:gd name="T53" fmla="*/ 120 h 235"/>
                    <a:gd name="T54" fmla="*/ 22 w 26"/>
                    <a:gd name="T55" fmla="*/ 126 h 235"/>
                    <a:gd name="T56" fmla="*/ 20 w 26"/>
                    <a:gd name="T57" fmla="*/ 130 h 235"/>
                    <a:gd name="T58" fmla="*/ 20 w 26"/>
                    <a:gd name="T59" fmla="*/ 135 h 235"/>
                    <a:gd name="T60" fmla="*/ 20 w 26"/>
                    <a:gd name="T61" fmla="*/ 139 h 235"/>
                    <a:gd name="T62" fmla="*/ 19 w 26"/>
                    <a:gd name="T63" fmla="*/ 143 h 235"/>
                    <a:gd name="T64" fmla="*/ 19 w 26"/>
                    <a:gd name="T65" fmla="*/ 148 h 235"/>
                    <a:gd name="T66" fmla="*/ 18 w 26"/>
                    <a:gd name="T67" fmla="*/ 152 h 235"/>
                    <a:gd name="T68" fmla="*/ 18 w 26"/>
                    <a:gd name="T69" fmla="*/ 156 h 235"/>
                    <a:gd name="T70" fmla="*/ 16 w 26"/>
                    <a:gd name="T71" fmla="*/ 162 h 235"/>
                    <a:gd name="T72" fmla="*/ 16 w 26"/>
                    <a:gd name="T73" fmla="*/ 166 h 235"/>
                    <a:gd name="T74" fmla="*/ 15 w 26"/>
                    <a:gd name="T75" fmla="*/ 171 h 235"/>
                    <a:gd name="T76" fmla="*/ 15 w 26"/>
                    <a:gd name="T77" fmla="*/ 175 h 235"/>
                    <a:gd name="T78" fmla="*/ 13 w 26"/>
                    <a:gd name="T79" fmla="*/ 179 h 235"/>
                    <a:gd name="T80" fmla="*/ 12 w 26"/>
                    <a:gd name="T81" fmla="*/ 183 h 235"/>
                    <a:gd name="T82" fmla="*/ 12 w 26"/>
                    <a:gd name="T83" fmla="*/ 188 h 235"/>
                    <a:gd name="T84" fmla="*/ 10 w 26"/>
                    <a:gd name="T85" fmla="*/ 192 h 235"/>
                    <a:gd name="T86" fmla="*/ 9 w 26"/>
                    <a:gd name="T87" fmla="*/ 196 h 235"/>
                    <a:gd name="T88" fmla="*/ 9 w 26"/>
                    <a:gd name="T89" fmla="*/ 201 h 235"/>
                    <a:gd name="T90" fmla="*/ 8 w 26"/>
                    <a:gd name="T91" fmla="*/ 205 h 235"/>
                    <a:gd name="T92" fmla="*/ 6 w 26"/>
                    <a:gd name="T93" fmla="*/ 211 h 235"/>
                    <a:gd name="T94" fmla="*/ 5 w 26"/>
                    <a:gd name="T95" fmla="*/ 215 h 235"/>
                    <a:gd name="T96" fmla="*/ 5 w 26"/>
                    <a:gd name="T97" fmla="*/ 219 h 235"/>
                    <a:gd name="T98" fmla="*/ 3 w 26"/>
                    <a:gd name="T99" fmla="*/ 224 h 235"/>
                    <a:gd name="T100" fmla="*/ 2 w 26"/>
                    <a:gd name="T101" fmla="*/ 228 h 235"/>
                    <a:gd name="T102" fmla="*/ 0 w 26"/>
                    <a:gd name="T103" fmla="*/ 232 h 23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  <a:cxn ang="0">
                      <a:pos x="T90" y="T91"/>
                    </a:cxn>
                    <a:cxn ang="0">
                      <a:pos x="T92" y="T93"/>
                    </a:cxn>
                    <a:cxn ang="0">
                      <a:pos x="T94" y="T95"/>
                    </a:cxn>
                    <a:cxn ang="0">
                      <a:pos x="T96" y="T97"/>
                    </a:cxn>
                    <a:cxn ang="0">
                      <a:pos x="T98" y="T99"/>
                    </a:cxn>
                    <a:cxn ang="0">
                      <a:pos x="T100" y="T101"/>
                    </a:cxn>
                    <a:cxn ang="0">
                      <a:pos x="T102" y="T103"/>
                    </a:cxn>
                  </a:cxnLst>
                  <a:rect l="0" t="0" r="r" b="b"/>
                  <a:pathLst>
                    <a:path w="26" h="235">
                      <a:moveTo>
                        <a:pt x="25" y="0"/>
                      </a:moveTo>
                      <a:lnTo>
                        <a:pt x="25" y="1"/>
                      </a:lnTo>
                      <a:lnTo>
                        <a:pt x="25" y="3"/>
                      </a:lnTo>
                      <a:lnTo>
                        <a:pt x="25" y="4"/>
                      </a:lnTo>
                      <a:lnTo>
                        <a:pt x="25" y="6"/>
                      </a:lnTo>
                      <a:lnTo>
                        <a:pt x="25" y="8"/>
                      </a:lnTo>
                      <a:lnTo>
                        <a:pt x="25" y="10"/>
                      </a:lnTo>
                      <a:lnTo>
                        <a:pt x="25" y="11"/>
                      </a:lnTo>
                      <a:lnTo>
                        <a:pt x="25" y="13"/>
                      </a:lnTo>
                      <a:lnTo>
                        <a:pt x="25" y="14"/>
                      </a:lnTo>
                      <a:lnTo>
                        <a:pt x="26" y="16"/>
                      </a:lnTo>
                      <a:lnTo>
                        <a:pt x="26" y="17"/>
                      </a:lnTo>
                      <a:lnTo>
                        <a:pt x="26" y="18"/>
                      </a:lnTo>
                      <a:lnTo>
                        <a:pt x="26" y="20"/>
                      </a:lnTo>
                      <a:lnTo>
                        <a:pt x="26" y="21"/>
                      </a:lnTo>
                      <a:lnTo>
                        <a:pt x="26" y="23"/>
                      </a:lnTo>
                      <a:lnTo>
                        <a:pt x="26" y="24"/>
                      </a:lnTo>
                      <a:lnTo>
                        <a:pt x="26" y="26"/>
                      </a:lnTo>
                      <a:lnTo>
                        <a:pt x="26" y="27"/>
                      </a:lnTo>
                      <a:lnTo>
                        <a:pt x="26" y="29"/>
                      </a:lnTo>
                      <a:lnTo>
                        <a:pt x="26" y="30"/>
                      </a:lnTo>
                      <a:lnTo>
                        <a:pt x="26" y="31"/>
                      </a:lnTo>
                      <a:lnTo>
                        <a:pt x="26" y="33"/>
                      </a:lnTo>
                      <a:lnTo>
                        <a:pt x="26" y="34"/>
                      </a:lnTo>
                      <a:lnTo>
                        <a:pt x="26" y="37"/>
                      </a:lnTo>
                      <a:lnTo>
                        <a:pt x="26" y="39"/>
                      </a:lnTo>
                      <a:lnTo>
                        <a:pt x="26" y="40"/>
                      </a:lnTo>
                      <a:lnTo>
                        <a:pt x="26" y="41"/>
                      </a:lnTo>
                      <a:lnTo>
                        <a:pt x="26" y="43"/>
                      </a:lnTo>
                      <a:lnTo>
                        <a:pt x="26" y="44"/>
                      </a:lnTo>
                      <a:lnTo>
                        <a:pt x="26" y="46"/>
                      </a:lnTo>
                      <a:lnTo>
                        <a:pt x="26" y="47"/>
                      </a:lnTo>
                      <a:lnTo>
                        <a:pt x="26" y="49"/>
                      </a:lnTo>
                      <a:lnTo>
                        <a:pt x="26" y="50"/>
                      </a:lnTo>
                      <a:lnTo>
                        <a:pt x="26" y="51"/>
                      </a:lnTo>
                      <a:lnTo>
                        <a:pt x="26" y="53"/>
                      </a:lnTo>
                      <a:lnTo>
                        <a:pt x="26" y="54"/>
                      </a:lnTo>
                      <a:lnTo>
                        <a:pt x="26" y="56"/>
                      </a:lnTo>
                      <a:lnTo>
                        <a:pt x="26" y="57"/>
                      </a:lnTo>
                      <a:lnTo>
                        <a:pt x="26" y="59"/>
                      </a:lnTo>
                      <a:lnTo>
                        <a:pt x="26" y="60"/>
                      </a:lnTo>
                      <a:lnTo>
                        <a:pt x="26" y="62"/>
                      </a:lnTo>
                      <a:lnTo>
                        <a:pt x="26" y="63"/>
                      </a:lnTo>
                      <a:lnTo>
                        <a:pt x="26" y="66"/>
                      </a:lnTo>
                      <a:lnTo>
                        <a:pt x="26" y="67"/>
                      </a:lnTo>
                      <a:lnTo>
                        <a:pt x="26" y="69"/>
                      </a:lnTo>
                      <a:lnTo>
                        <a:pt x="26" y="70"/>
                      </a:lnTo>
                      <a:lnTo>
                        <a:pt x="26" y="72"/>
                      </a:lnTo>
                      <a:lnTo>
                        <a:pt x="26" y="73"/>
                      </a:lnTo>
                      <a:lnTo>
                        <a:pt x="26" y="74"/>
                      </a:lnTo>
                      <a:lnTo>
                        <a:pt x="26" y="76"/>
                      </a:lnTo>
                      <a:lnTo>
                        <a:pt x="25" y="77"/>
                      </a:lnTo>
                      <a:lnTo>
                        <a:pt x="25" y="79"/>
                      </a:lnTo>
                      <a:lnTo>
                        <a:pt x="25" y="80"/>
                      </a:lnTo>
                      <a:lnTo>
                        <a:pt x="25" y="82"/>
                      </a:lnTo>
                      <a:lnTo>
                        <a:pt x="25" y="83"/>
                      </a:lnTo>
                      <a:lnTo>
                        <a:pt x="25" y="84"/>
                      </a:lnTo>
                      <a:lnTo>
                        <a:pt x="25" y="86"/>
                      </a:lnTo>
                      <a:lnTo>
                        <a:pt x="25" y="87"/>
                      </a:lnTo>
                      <a:lnTo>
                        <a:pt x="25" y="89"/>
                      </a:lnTo>
                      <a:lnTo>
                        <a:pt x="25" y="90"/>
                      </a:lnTo>
                      <a:lnTo>
                        <a:pt x="25" y="92"/>
                      </a:lnTo>
                      <a:lnTo>
                        <a:pt x="25" y="95"/>
                      </a:lnTo>
                      <a:lnTo>
                        <a:pt x="25" y="96"/>
                      </a:lnTo>
                      <a:lnTo>
                        <a:pt x="25" y="97"/>
                      </a:lnTo>
                      <a:lnTo>
                        <a:pt x="25" y="99"/>
                      </a:lnTo>
                      <a:lnTo>
                        <a:pt x="25" y="100"/>
                      </a:lnTo>
                      <a:lnTo>
                        <a:pt x="23" y="102"/>
                      </a:lnTo>
                      <a:lnTo>
                        <a:pt x="23" y="103"/>
                      </a:lnTo>
                      <a:lnTo>
                        <a:pt x="23" y="105"/>
                      </a:lnTo>
                      <a:lnTo>
                        <a:pt x="23" y="106"/>
                      </a:lnTo>
                      <a:lnTo>
                        <a:pt x="23" y="107"/>
                      </a:lnTo>
                      <a:lnTo>
                        <a:pt x="23" y="109"/>
                      </a:lnTo>
                      <a:lnTo>
                        <a:pt x="23" y="110"/>
                      </a:lnTo>
                      <a:lnTo>
                        <a:pt x="23" y="112"/>
                      </a:lnTo>
                      <a:lnTo>
                        <a:pt x="23" y="113"/>
                      </a:lnTo>
                      <a:lnTo>
                        <a:pt x="23" y="115"/>
                      </a:lnTo>
                      <a:lnTo>
                        <a:pt x="22" y="116"/>
                      </a:lnTo>
                      <a:lnTo>
                        <a:pt x="22" y="117"/>
                      </a:lnTo>
                      <a:lnTo>
                        <a:pt x="22" y="119"/>
                      </a:lnTo>
                      <a:lnTo>
                        <a:pt x="22" y="120"/>
                      </a:lnTo>
                      <a:lnTo>
                        <a:pt x="22" y="122"/>
                      </a:lnTo>
                      <a:lnTo>
                        <a:pt x="22" y="123"/>
                      </a:lnTo>
                      <a:lnTo>
                        <a:pt x="22" y="126"/>
                      </a:lnTo>
                      <a:lnTo>
                        <a:pt x="22" y="128"/>
                      </a:lnTo>
                      <a:lnTo>
                        <a:pt x="22" y="129"/>
                      </a:lnTo>
                      <a:lnTo>
                        <a:pt x="20" y="130"/>
                      </a:lnTo>
                      <a:lnTo>
                        <a:pt x="20" y="132"/>
                      </a:lnTo>
                      <a:lnTo>
                        <a:pt x="20" y="133"/>
                      </a:lnTo>
                      <a:lnTo>
                        <a:pt x="20" y="135"/>
                      </a:lnTo>
                      <a:lnTo>
                        <a:pt x="20" y="136"/>
                      </a:lnTo>
                      <a:lnTo>
                        <a:pt x="20" y="138"/>
                      </a:lnTo>
                      <a:lnTo>
                        <a:pt x="20" y="139"/>
                      </a:lnTo>
                      <a:lnTo>
                        <a:pt x="19" y="140"/>
                      </a:lnTo>
                      <a:lnTo>
                        <a:pt x="19" y="142"/>
                      </a:lnTo>
                      <a:lnTo>
                        <a:pt x="19" y="143"/>
                      </a:lnTo>
                      <a:lnTo>
                        <a:pt x="19" y="145"/>
                      </a:lnTo>
                      <a:lnTo>
                        <a:pt x="19" y="146"/>
                      </a:lnTo>
                      <a:lnTo>
                        <a:pt x="19" y="148"/>
                      </a:lnTo>
                      <a:lnTo>
                        <a:pt x="19" y="149"/>
                      </a:lnTo>
                      <a:lnTo>
                        <a:pt x="18" y="150"/>
                      </a:lnTo>
                      <a:lnTo>
                        <a:pt x="18" y="152"/>
                      </a:lnTo>
                      <a:lnTo>
                        <a:pt x="18" y="153"/>
                      </a:lnTo>
                      <a:lnTo>
                        <a:pt x="18" y="155"/>
                      </a:lnTo>
                      <a:lnTo>
                        <a:pt x="18" y="156"/>
                      </a:lnTo>
                      <a:lnTo>
                        <a:pt x="18" y="158"/>
                      </a:lnTo>
                      <a:lnTo>
                        <a:pt x="16" y="159"/>
                      </a:lnTo>
                      <a:lnTo>
                        <a:pt x="16" y="162"/>
                      </a:lnTo>
                      <a:lnTo>
                        <a:pt x="16" y="163"/>
                      </a:lnTo>
                      <a:lnTo>
                        <a:pt x="16" y="165"/>
                      </a:lnTo>
                      <a:lnTo>
                        <a:pt x="16" y="166"/>
                      </a:lnTo>
                      <a:lnTo>
                        <a:pt x="15" y="168"/>
                      </a:lnTo>
                      <a:lnTo>
                        <a:pt x="15" y="169"/>
                      </a:lnTo>
                      <a:lnTo>
                        <a:pt x="15" y="171"/>
                      </a:lnTo>
                      <a:lnTo>
                        <a:pt x="15" y="172"/>
                      </a:lnTo>
                      <a:lnTo>
                        <a:pt x="15" y="173"/>
                      </a:lnTo>
                      <a:lnTo>
                        <a:pt x="15" y="175"/>
                      </a:lnTo>
                      <a:lnTo>
                        <a:pt x="13" y="176"/>
                      </a:lnTo>
                      <a:lnTo>
                        <a:pt x="13" y="178"/>
                      </a:lnTo>
                      <a:lnTo>
                        <a:pt x="13" y="179"/>
                      </a:lnTo>
                      <a:lnTo>
                        <a:pt x="13" y="181"/>
                      </a:lnTo>
                      <a:lnTo>
                        <a:pt x="13" y="182"/>
                      </a:lnTo>
                      <a:lnTo>
                        <a:pt x="12" y="183"/>
                      </a:lnTo>
                      <a:lnTo>
                        <a:pt x="12" y="185"/>
                      </a:lnTo>
                      <a:lnTo>
                        <a:pt x="12" y="186"/>
                      </a:lnTo>
                      <a:lnTo>
                        <a:pt x="12" y="188"/>
                      </a:lnTo>
                      <a:lnTo>
                        <a:pt x="10" y="189"/>
                      </a:lnTo>
                      <a:lnTo>
                        <a:pt x="10" y="191"/>
                      </a:lnTo>
                      <a:lnTo>
                        <a:pt x="10" y="192"/>
                      </a:lnTo>
                      <a:lnTo>
                        <a:pt x="10" y="194"/>
                      </a:lnTo>
                      <a:lnTo>
                        <a:pt x="10" y="195"/>
                      </a:lnTo>
                      <a:lnTo>
                        <a:pt x="9" y="196"/>
                      </a:lnTo>
                      <a:lnTo>
                        <a:pt x="9" y="198"/>
                      </a:lnTo>
                      <a:lnTo>
                        <a:pt x="9" y="199"/>
                      </a:lnTo>
                      <a:lnTo>
                        <a:pt x="9" y="201"/>
                      </a:lnTo>
                      <a:lnTo>
                        <a:pt x="8" y="202"/>
                      </a:lnTo>
                      <a:lnTo>
                        <a:pt x="8" y="204"/>
                      </a:lnTo>
                      <a:lnTo>
                        <a:pt x="8" y="205"/>
                      </a:lnTo>
                      <a:lnTo>
                        <a:pt x="8" y="206"/>
                      </a:lnTo>
                      <a:lnTo>
                        <a:pt x="6" y="209"/>
                      </a:lnTo>
                      <a:lnTo>
                        <a:pt x="6" y="211"/>
                      </a:lnTo>
                      <a:lnTo>
                        <a:pt x="6" y="212"/>
                      </a:lnTo>
                      <a:lnTo>
                        <a:pt x="6" y="214"/>
                      </a:lnTo>
                      <a:lnTo>
                        <a:pt x="5" y="215"/>
                      </a:lnTo>
                      <a:lnTo>
                        <a:pt x="5" y="217"/>
                      </a:lnTo>
                      <a:lnTo>
                        <a:pt x="5" y="218"/>
                      </a:lnTo>
                      <a:lnTo>
                        <a:pt x="5" y="219"/>
                      </a:lnTo>
                      <a:lnTo>
                        <a:pt x="3" y="221"/>
                      </a:lnTo>
                      <a:lnTo>
                        <a:pt x="3" y="222"/>
                      </a:lnTo>
                      <a:lnTo>
                        <a:pt x="3" y="224"/>
                      </a:lnTo>
                      <a:lnTo>
                        <a:pt x="3" y="225"/>
                      </a:lnTo>
                      <a:lnTo>
                        <a:pt x="2" y="227"/>
                      </a:lnTo>
                      <a:lnTo>
                        <a:pt x="2" y="228"/>
                      </a:lnTo>
                      <a:lnTo>
                        <a:pt x="2" y="229"/>
                      </a:lnTo>
                      <a:lnTo>
                        <a:pt x="0" y="231"/>
                      </a:lnTo>
                      <a:lnTo>
                        <a:pt x="0" y="232"/>
                      </a:lnTo>
                      <a:lnTo>
                        <a:pt x="0" y="234"/>
                      </a:lnTo>
                      <a:lnTo>
                        <a:pt x="0" y="235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53" name="Rectangle 137"/>
                <p:cNvSpPr>
                  <a:spLocks noChangeArrowheads="1"/>
                </p:cNvSpPr>
                <p:nvPr/>
              </p:nvSpPr>
              <p:spPr bwMode="auto">
                <a:xfrm rot="21360000">
                  <a:off x="4407" y="1996"/>
                  <a:ext cx="72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5</a:t>
                  </a:r>
                </a:p>
              </p:txBody>
            </p:sp>
            <p:sp>
              <p:nvSpPr>
                <p:cNvPr id="354" name="Line 138"/>
                <p:cNvSpPr>
                  <a:spLocks noChangeShapeType="1"/>
                </p:cNvSpPr>
                <p:nvPr/>
              </p:nvSpPr>
              <p:spPr bwMode="auto">
                <a:xfrm flipV="1">
                  <a:off x="4421" y="2075"/>
                  <a:ext cx="63" cy="4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55" name="Rectangle 139"/>
                <p:cNvSpPr>
                  <a:spLocks noChangeArrowheads="1"/>
                </p:cNvSpPr>
                <p:nvPr/>
              </p:nvSpPr>
              <p:spPr bwMode="auto">
                <a:xfrm rot="1380000">
                  <a:off x="5493" y="2845"/>
                  <a:ext cx="230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S-A12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56" name="Line 140"/>
                <p:cNvSpPr>
                  <a:spLocks noChangeShapeType="1"/>
                </p:cNvSpPr>
                <p:nvPr/>
              </p:nvSpPr>
              <p:spPr bwMode="auto">
                <a:xfrm>
                  <a:off x="5320" y="2776"/>
                  <a:ext cx="57" cy="25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57" name="Rectangle 141"/>
                <p:cNvSpPr>
                  <a:spLocks noChangeArrowheads="1"/>
                </p:cNvSpPr>
                <p:nvPr/>
              </p:nvSpPr>
              <p:spPr bwMode="auto">
                <a:xfrm rot="1680000">
                  <a:off x="5417" y="3023"/>
                  <a:ext cx="283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LIM-A12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58" name="Line 142"/>
                <p:cNvSpPr>
                  <a:spLocks noChangeShapeType="1"/>
                </p:cNvSpPr>
                <p:nvPr/>
              </p:nvSpPr>
              <p:spPr bwMode="auto">
                <a:xfrm>
                  <a:off x="5257" y="2904"/>
                  <a:ext cx="56" cy="30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59" name="Freeform 143"/>
                <p:cNvSpPr/>
                <p:nvPr/>
              </p:nvSpPr>
              <p:spPr bwMode="auto">
                <a:xfrm>
                  <a:off x="5287" y="2775"/>
                  <a:ext cx="30" cy="65"/>
                </a:xfrm>
                <a:custGeom>
                  <a:avLst/>
                  <a:gdLst>
                    <a:gd name="T0" fmla="*/ 0 w 30"/>
                    <a:gd name="T1" fmla="*/ 65 h 65"/>
                    <a:gd name="T2" fmla="*/ 3 w 30"/>
                    <a:gd name="T3" fmla="*/ 62 h 65"/>
                    <a:gd name="T4" fmla="*/ 4 w 30"/>
                    <a:gd name="T5" fmla="*/ 57 h 65"/>
                    <a:gd name="T6" fmla="*/ 6 w 30"/>
                    <a:gd name="T7" fmla="*/ 53 h 65"/>
                    <a:gd name="T8" fmla="*/ 9 w 30"/>
                    <a:gd name="T9" fmla="*/ 49 h 65"/>
                    <a:gd name="T10" fmla="*/ 10 w 30"/>
                    <a:gd name="T11" fmla="*/ 45 h 65"/>
                    <a:gd name="T12" fmla="*/ 11 w 30"/>
                    <a:gd name="T13" fmla="*/ 42 h 65"/>
                    <a:gd name="T14" fmla="*/ 13 w 30"/>
                    <a:gd name="T15" fmla="*/ 37 h 65"/>
                    <a:gd name="T16" fmla="*/ 16 w 30"/>
                    <a:gd name="T17" fmla="*/ 33 h 65"/>
                    <a:gd name="T18" fmla="*/ 17 w 30"/>
                    <a:gd name="T19" fmla="*/ 29 h 65"/>
                    <a:gd name="T20" fmla="*/ 19 w 30"/>
                    <a:gd name="T21" fmla="*/ 24 h 65"/>
                    <a:gd name="T22" fmla="*/ 21 w 30"/>
                    <a:gd name="T23" fmla="*/ 20 h 65"/>
                    <a:gd name="T24" fmla="*/ 23 w 30"/>
                    <a:gd name="T25" fmla="*/ 17 h 65"/>
                    <a:gd name="T26" fmla="*/ 24 w 30"/>
                    <a:gd name="T27" fmla="*/ 13 h 65"/>
                    <a:gd name="T28" fmla="*/ 26 w 30"/>
                    <a:gd name="T29" fmla="*/ 9 h 65"/>
                    <a:gd name="T30" fmla="*/ 29 w 30"/>
                    <a:gd name="T31" fmla="*/ 4 h 65"/>
                    <a:gd name="T32" fmla="*/ 30 w 30"/>
                    <a:gd name="T33" fmla="*/ 0 h 6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</a:cxnLst>
                  <a:rect l="0" t="0" r="r" b="b"/>
                  <a:pathLst>
                    <a:path w="30" h="65">
                      <a:moveTo>
                        <a:pt x="0" y="65"/>
                      </a:moveTo>
                      <a:lnTo>
                        <a:pt x="3" y="62"/>
                      </a:lnTo>
                      <a:lnTo>
                        <a:pt x="4" y="57"/>
                      </a:lnTo>
                      <a:lnTo>
                        <a:pt x="6" y="53"/>
                      </a:lnTo>
                      <a:lnTo>
                        <a:pt x="9" y="49"/>
                      </a:lnTo>
                      <a:lnTo>
                        <a:pt x="10" y="45"/>
                      </a:lnTo>
                      <a:lnTo>
                        <a:pt x="11" y="42"/>
                      </a:lnTo>
                      <a:lnTo>
                        <a:pt x="13" y="37"/>
                      </a:lnTo>
                      <a:lnTo>
                        <a:pt x="16" y="33"/>
                      </a:lnTo>
                      <a:lnTo>
                        <a:pt x="17" y="29"/>
                      </a:lnTo>
                      <a:lnTo>
                        <a:pt x="19" y="24"/>
                      </a:lnTo>
                      <a:lnTo>
                        <a:pt x="21" y="20"/>
                      </a:lnTo>
                      <a:lnTo>
                        <a:pt x="23" y="17"/>
                      </a:lnTo>
                      <a:lnTo>
                        <a:pt x="24" y="13"/>
                      </a:lnTo>
                      <a:lnTo>
                        <a:pt x="26" y="9"/>
                      </a:lnTo>
                      <a:lnTo>
                        <a:pt x="29" y="4"/>
                      </a:lnTo>
                      <a:lnTo>
                        <a:pt x="30" y="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60" name="Freeform 144"/>
                <p:cNvSpPr/>
                <p:nvPr/>
              </p:nvSpPr>
              <p:spPr bwMode="auto">
                <a:xfrm>
                  <a:off x="5255" y="2840"/>
                  <a:ext cx="32" cy="63"/>
                </a:xfrm>
                <a:custGeom>
                  <a:avLst/>
                  <a:gdLst>
                    <a:gd name="T0" fmla="*/ 32 w 32"/>
                    <a:gd name="T1" fmla="*/ 0 h 63"/>
                    <a:gd name="T2" fmla="*/ 31 w 32"/>
                    <a:gd name="T3" fmla="*/ 4 h 63"/>
                    <a:gd name="T4" fmla="*/ 28 w 32"/>
                    <a:gd name="T5" fmla="*/ 8 h 63"/>
                    <a:gd name="T6" fmla="*/ 26 w 32"/>
                    <a:gd name="T7" fmla="*/ 13 h 63"/>
                    <a:gd name="T8" fmla="*/ 25 w 32"/>
                    <a:gd name="T9" fmla="*/ 15 h 63"/>
                    <a:gd name="T10" fmla="*/ 22 w 32"/>
                    <a:gd name="T11" fmla="*/ 20 h 63"/>
                    <a:gd name="T12" fmla="*/ 20 w 32"/>
                    <a:gd name="T13" fmla="*/ 24 h 63"/>
                    <a:gd name="T14" fmla="*/ 19 w 32"/>
                    <a:gd name="T15" fmla="*/ 28 h 63"/>
                    <a:gd name="T16" fmla="*/ 16 w 32"/>
                    <a:gd name="T17" fmla="*/ 33 h 63"/>
                    <a:gd name="T18" fmla="*/ 15 w 32"/>
                    <a:gd name="T19" fmla="*/ 35 h 63"/>
                    <a:gd name="T20" fmla="*/ 12 w 32"/>
                    <a:gd name="T21" fmla="*/ 40 h 63"/>
                    <a:gd name="T22" fmla="*/ 10 w 32"/>
                    <a:gd name="T23" fmla="*/ 44 h 63"/>
                    <a:gd name="T24" fmla="*/ 8 w 32"/>
                    <a:gd name="T25" fmla="*/ 48 h 63"/>
                    <a:gd name="T26" fmla="*/ 6 w 32"/>
                    <a:gd name="T27" fmla="*/ 51 h 63"/>
                    <a:gd name="T28" fmla="*/ 5 w 32"/>
                    <a:gd name="T29" fmla="*/ 56 h 63"/>
                    <a:gd name="T30" fmla="*/ 2 w 32"/>
                    <a:gd name="T31" fmla="*/ 60 h 63"/>
                    <a:gd name="T32" fmla="*/ 0 w 32"/>
                    <a:gd name="T33" fmla="*/ 63 h 6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</a:cxnLst>
                  <a:rect l="0" t="0" r="r" b="b"/>
                  <a:pathLst>
                    <a:path w="32" h="63">
                      <a:moveTo>
                        <a:pt x="32" y="0"/>
                      </a:moveTo>
                      <a:lnTo>
                        <a:pt x="31" y="4"/>
                      </a:lnTo>
                      <a:lnTo>
                        <a:pt x="28" y="8"/>
                      </a:lnTo>
                      <a:lnTo>
                        <a:pt x="26" y="13"/>
                      </a:lnTo>
                      <a:lnTo>
                        <a:pt x="25" y="15"/>
                      </a:lnTo>
                      <a:lnTo>
                        <a:pt x="22" y="20"/>
                      </a:lnTo>
                      <a:lnTo>
                        <a:pt x="20" y="24"/>
                      </a:lnTo>
                      <a:lnTo>
                        <a:pt x="19" y="28"/>
                      </a:lnTo>
                      <a:lnTo>
                        <a:pt x="16" y="33"/>
                      </a:lnTo>
                      <a:lnTo>
                        <a:pt x="15" y="35"/>
                      </a:lnTo>
                      <a:lnTo>
                        <a:pt x="12" y="40"/>
                      </a:lnTo>
                      <a:lnTo>
                        <a:pt x="10" y="44"/>
                      </a:lnTo>
                      <a:lnTo>
                        <a:pt x="8" y="48"/>
                      </a:lnTo>
                      <a:lnTo>
                        <a:pt x="6" y="51"/>
                      </a:lnTo>
                      <a:lnTo>
                        <a:pt x="5" y="56"/>
                      </a:lnTo>
                      <a:lnTo>
                        <a:pt x="2" y="60"/>
                      </a:lnTo>
                      <a:lnTo>
                        <a:pt x="0" y="63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61" name="Rectangle 145"/>
                <p:cNvSpPr>
                  <a:spLocks noChangeArrowheads="1"/>
                </p:cNvSpPr>
                <p:nvPr/>
              </p:nvSpPr>
              <p:spPr bwMode="auto">
                <a:xfrm rot="1500000">
                  <a:off x="5227" y="2742"/>
                  <a:ext cx="74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74</a:t>
                  </a:r>
                </a:p>
              </p:txBody>
            </p:sp>
            <p:sp>
              <p:nvSpPr>
                <p:cNvPr id="362" name="Line 146"/>
                <p:cNvSpPr>
                  <a:spLocks noChangeShapeType="1"/>
                </p:cNvSpPr>
                <p:nvPr/>
              </p:nvSpPr>
              <p:spPr bwMode="auto">
                <a:xfrm>
                  <a:off x="5228" y="2811"/>
                  <a:ext cx="56" cy="27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63" name="Rectangle 147"/>
                <p:cNvSpPr>
                  <a:spLocks noChangeArrowheads="1"/>
                </p:cNvSpPr>
                <p:nvPr/>
              </p:nvSpPr>
              <p:spPr bwMode="auto">
                <a:xfrm rot="1980000">
                  <a:off x="5316" y="3152"/>
                  <a:ext cx="299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YLK-A11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64" name="Line 148"/>
                <p:cNvSpPr>
                  <a:spLocks noChangeShapeType="1"/>
                </p:cNvSpPr>
                <p:nvPr/>
              </p:nvSpPr>
              <p:spPr bwMode="auto">
                <a:xfrm>
                  <a:off x="5126" y="2990"/>
                  <a:ext cx="111" cy="72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65" name="Freeform 149"/>
                <p:cNvSpPr/>
                <p:nvPr/>
              </p:nvSpPr>
              <p:spPr bwMode="auto">
                <a:xfrm>
                  <a:off x="5178" y="2809"/>
                  <a:ext cx="47" cy="92"/>
                </a:xfrm>
                <a:custGeom>
                  <a:avLst/>
                  <a:gdLst>
                    <a:gd name="T0" fmla="*/ 0 w 47"/>
                    <a:gd name="T1" fmla="*/ 92 h 92"/>
                    <a:gd name="T2" fmla="*/ 3 w 47"/>
                    <a:gd name="T3" fmla="*/ 87 h 92"/>
                    <a:gd name="T4" fmla="*/ 6 w 47"/>
                    <a:gd name="T5" fmla="*/ 82 h 92"/>
                    <a:gd name="T6" fmla="*/ 7 w 47"/>
                    <a:gd name="T7" fmla="*/ 78 h 92"/>
                    <a:gd name="T8" fmla="*/ 10 w 47"/>
                    <a:gd name="T9" fmla="*/ 72 h 92"/>
                    <a:gd name="T10" fmla="*/ 13 w 47"/>
                    <a:gd name="T11" fmla="*/ 68 h 92"/>
                    <a:gd name="T12" fmla="*/ 16 w 47"/>
                    <a:gd name="T13" fmla="*/ 64 h 92"/>
                    <a:gd name="T14" fmla="*/ 19 w 47"/>
                    <a:gd name="T15" fmla="*/ 59 h 92"/>
                    <a:gd name="T16" fmla="*/ 20 w 47"/>
                    <a:gd name="T17" fmla="*/ 54 h 92"/>
                    <a:gd name="T18" fmla="*/ 23 w 47"/>
                    <a:gd name="T19" fmla="*/ 49 h 92"/>
                    <a:gd name="T20" fmla="*/ 26 w 47"/>
                    <a:gd name="T21" fmla="*/ 45 h 92"/>
                    <a:gd name="T22" fmla="*/ 29 w 47"/>
                    <a:gd name="T23" fmla="*/ 39 h 92"/>
                    <a:gd name="T24" fmla="*/ 30 w 47"/>
                    <a:gd name="T25" fmla="*/ 35 h 92"/>
                    <a:gd name="T26" fmla="*/ 33 w 47"/>
                    <a:gd name="T27" fmla="*/ 31 h 92"/>
                    <a:gd name="T28" fmla="*/ 36 w 47"/>
                    <a:gd name="T29" fmla="*/ 25 h 92"/>
                    <a:gd name="T30" fmla="*/ 37 w 47"/>
                    <a:gd name="T31" fmla="*/ 21 h 92"/>
                    <a:gd name="T32" fmla="*/ 40 w 47"/>
                    <a:gd name="T33" fmla="*/ 16 h 92"/>
                    <a:gd name="T34" fmla="*/ 43 w 47"/>
                    <a:gd name="T35" fmla="*/ 11 h 92"/>
                    <a:gd name="T36" fmla="*/ 44 w 47"/>
                    <a:gd name="T37" fmla="*/ 6 h 92"/>
                    <a:gd name="T38" fmla="*/ 47 w 47"/>
                    <a:gd name="T39" fmla="*/ 0 h 9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</a:cxnLst>
                  <a:rect l="0" t="0" r="r" b="b"/>
                  <a:pathLst>
                    <a:path w="47" h="92">
                      <a:moveTo>
                        <a:pt x="0" y="92"/>
                      </a:moveTo>
                      <a:lnTo>
                        <a:pt x="3" y="87"/>
                      </a:lnTo>
                      <a:lnTo>
                        <a:pt x="6" y="82"/>
                      </a:lnTo>
                      <a:lnTo>
                        <a:pt x="7" y="78"/>
                      </a:lnTo>
                      <a:lnTo>
                        <a:pt x="10" y="72"/>
                      </a:lnTo>
                      <a:lnTo>
                        <a:pt x="13" y="68"/>
                      </a:lnTo>
                      <a:lnTo>
                        <a:pt x="16" y="64"/>
                      </a:lnTo>
                      <a:lnTo>
                        <a:pt x="19" y="59"/>
                      </a:lnTo>
                      <a:lnTo>
                        <a:pt x="20" y="54"/>
                      </a:lnTo>
                      <a:lnTo>
                        <a:pt x="23" y="49"/>
                      </a:lnTo>
                      <a:lnTo>
                        <a:pt x="26" y="45"/>
                      </a:lnTo>
                      <a:lnTo>
                        <a:pt x="29" y="39"/>
                      </a:lnTo>
                      <a:lnTo>
                        <a:pt x="30" y="35"/>
                      </a:lnTo>
                      <a:lnTo>
                        <a:pt x="33" y="31"/>
                      </a:lnTo>
                      <a:lnTo>
                        <a:pt x="36" y="25"/>
                      </a:lnTo>
                      <a:lnTo>
                        <a:pt x="37" y="21"/>
                      </a:lnTo>
                      <a:lnTo>
                        <a:pt x="40" y="16"/>
                      </a:lnTo>
                      <a:lnTo>
                        <a:pt x="43" y="11"/>
                      </a:lnTo>
                      <a:lnTo>
                        <a:pt x="44" y="6"/>
                      </a:lnTo>
                      <a:lnTo>
                        <a:pt x="47" y="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66" name="Freeform 150"/>
                <p:cNvSpPr/>
                <p:nvPr/>
              </p:nvSpPr>
              <p:spPr bwMode="auto">
                <a:xfrm>
                  <a:off x="5125" y="2901"/>
                  <a:ext cx="53" cy="86"/>
                </a:xfrm>
                <a:custGeom>
                  <a:avLst/>
                  <a:gdLst>
                    <a:gd name="T0" fmla="*/ 53 w 53"/>
                    <a:gd name="T1" fmla="*/ 0 h 86"/>
                    <a:gd name="T2" fmla="*/ 52 w 53"/>
                    <a:gd name="T3" fmla="*/ 3 h 86"/>
                    <a:gd name="T4" fmla="*/ 49 w 53"/>
                    <a:gd name="T5" fmla="*/ 6 h 86"/>
                    <a:gd name="T6" fmla="*/ 47 w 53"/>
                    <a:gd name="T7" fmla="*/ 9 h 86"/>
                    <a:gd name="T8" fmla="*/ 46 w 53"/>
                    <a:gd name="T9" fmla="*/ 12 h 86"/>
                    <a:gd name="T10" fmla="*/ 44 w 53"/>
                    <a:gd name="T11" fmla="*/ 16 h 86"/>
                    <a:gd name="T12" fmla="*/ 42 w 53"/>
                    <a:gd name="T13" fmla="*/ 19 h 86"/>
                    <a:gd name="T14" fmla="*/ 40 w 53"/>
                    <a:gd name="T15" fmla="*/ 22 h 86"/>
                    <a:gd name="T16" fmla="*/ 39 w 53"/>
                    <a:gd name="T17" fmla="*/ 25 h 86"/>
                    <a:gd name="T18" fmla="*/ 36 w 53"/>
                    <a:gd name="T19" fmla="*/ 28 h 86"/>
                    <a:gd name="T20" fmla="*/ 34 w 53"/>
                    <a:gd name="T21" fmla="*/ 32 h 86"/>
                    <a:gd name="T22" fmla="*/ 33 w 53"/>
                    <a:gd name="T23" fmla="*/ 35 h 86"/>
                    <a:gd name="T24" fmla="*/ 31 w 53"/>
                    <a:gd name="T25" fmla="*/ 38 h 86"/>
                    <a:gd name="T26" fmla="*/ 29 w 53"/>
                    <a:gd name="T27" fmla="*/ 40 h 86"/>
                    <a:gd name="T28" fmla="*/ 27 w 53"/>
                    <a:gd name="T29" fmla="*/ 43 h 86"/>
                    <a:gd name="T30" fmla="*/ 26 w 53"/>
                    <a:gd name="T31" fmla="*/ 46 h 86"/>
                    <a:gd name="T32" fmla="*/ 23 w 53"/>
                    <a:gd name="T33" fmla="*/ 51 h 86"/>
                    <a:gd name="T34" fmla="*/ 21 w 53"/>
                    <a:gd name="T35" fmla="*/ 53 h 86"/>
                    <a:gd name="T36" fmla="*/ 20 w 53"/>
                    <a:gd name="T37" fmla="*/ 56 h 86"/>
                    <a:gd name="T38" fmla="*/ 17 w 53"/>
                    <a:gd name="T39" fmla="*/ 59 h 86"/>
                    <a:gd name="T40" fmla="*/ 16 w 53"/>
                    <a:gd name="T41" fmla="*/ 62 h 86"/>
                    <a:gd name="T42" fmla="*/ 14 w 53"/>
                    <a:gd name="T43" fmla="*/ 65 h 86"/>
                    <a:gd name="T44" fmla="*/ 11 w 53"/>
                    <a:gd name="T45" fmla="*/ 68 h 86"/>
                    <a:gd name="T46" fmla="*/ 10 w 53"/>
                    <a:gd name="T47" fmla="*/ 72 h 86"/>
                    <a:gd name="T48" fmla="*/ 7 w 53"/>
                    <a:gd name="T49" fmla="*/ 75 h 86"/>
                    <a:gd name="T50" fmla="*/ 6 w 53"/>
                    <a:gd name="T51" fmla="*/ 78 h 86"/>
                    <a:gd name="T52" fmla="*/ 4 w 53"/>
                    <a:gd name="T53" fmla="*/ 81 h 86"/>
                    <a:gd name="T54" fmla="*/ 1 w 53"/>
                    <a:gd name="T55" fmla="*/ 84 h 86"/>
                    <a:gd name="T56" fmla="*/ 0 w 53"/>
                    <a:gd name="T57" fmla="*/ 86 h 8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</a:cxnLst>
                  <a:rect l="0" t="0" r="r" b="b"/>
                  <a:pathLst>
                    <a:path w="53" h="86">
                      <a:moveTo>
                        <a:pt x="53" y="0"/>
                      </a:moveTo>
                      <a:lnTo>
                        <a:pt x="52" y="3"/>
                      </a:lnTo>
                      <a:lnTo>
                        <a:pt x="49" y="6"/>
                      </a:lnTo>
                      <a:lnTo>
                        <a:pt x="47" y="9"/>
                      </a:lnTo>
                      <a:lnTo>
                        <a:pt x="46" y="12"/>
                      </a:lnTo>
                      <a:lnTo>
                        <a:pt x="44" y="16"/>
                      </a:lnTo>
                      <a:lnTo>
                        <a:pt x="42" y="19"/>
                      </a:lnTo>
                      <a:lnTo>
                        <a:pt x="40" y="22"/>
                      </a:lnTo>
                      <a:lnTo>
                        <a:pt x="39" y="25"/>
                      </a:lnTo>
                      <a:lnTo>
                        <a:pt x="36" y="28"/>
                      </a:lnTo>
                      <a:lnTo>
                        <a:pt x="34" y="32"/>
                      </a:lnTo>
                      <a:lnTo>
                        <a:pt x="33" y="35"/>
                      </a:lnTo>
                      <a:lnTo>
                        <a:pt x="31" y="38"/>
                      </a:lnTo>
                      <a:lnTo>
                        <a:pt x="29" y="40"/>
                      </a:lnTo>
                      <a:lnTo>
                        <a:pt x="27" y="43"/>
                      </a:lnTo>
                      <a:lnTo>
                        <a:pt x="26" y="46"/>
                      </a:lnTo>
                      <a:lnTo>
                        <a:pt x="23" y="51"/>
                      </a:lnTo>
                      <a:lnTo>
                        <a:pt x="21" y="53"/>
                      </a:lnTo>
                      <a:lnTo>
                        <a:pt x="20" y="56"/>
                      </a:lnTo>
                      <a:lnTo>
                        <a:pt x="17" y="59"/>
                      </a:lnTo>
                      <a:lnTo>
                        <a:pt x="16" y="62"/>
                      </a:lnTo>
                      <a:lnTo>
                        <a:pt x="14" y="65"/>
                      </a:lnTo>
                      <a:lnTo>
                        <a:pt x="11" y="68"/>
                      </a:lnTo>
                      <a:lnTo>
                        <a:pt x="10" y="72"/>
                      </a:lnTo>
                      <a:lnTo>
                        <a:pt x="7" y="75"/>
                      </a:lnTo>
                      <a:lnTo>
                        <a:pt x="6" y="78"/>
                      </a:lnTo>
                      <a:lnTo>
                        <a:pt x="4" y="81"/>
                      </a:lnTo>
                      <a:lnTo>
                        <a:pt x="1" y="84"/>
                      </a:lnTo>
                      <a:lnTo>
                        <a:pt x="0" y="86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67" name="Rectangle 151"/>
                <p:cNvSpPr>
                  <a:spLocks noChangeArrowheads="1"/>
                </p:cNvSpPr>
                <p:nvPr/>
              </p:nvSpPr>
              <p:spPr bwMode="auto">
                <a:xfrm rot="1740000">
                  <a:off x="5124" y="2812"/>
                  <a:ext cx="72" cy="87"/>
                </a:xfrm>
                <a:prstGeom prst="rect">
                  <a:avLst/>
                </a:prstGeom>
                <a:noFill/>
                <a:ln w="9525">
                  <a:noFill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98</a:t>
                  </a:r>
                </a:p>
              </p:txBody>
            </p:sp>
            <p:sp>
              <p:nvSpPr>
                <p:cNvPr id="368" name="Line 152"/>
                <p:cNvSpPr>
                  <a:spLocks noChangeShapeType="1"/>
                </p:cNvSpPr>
                <p:nvPr/>
              </p:nvSpPr>
              <p:spPr bwMode="auto">
                <a:xfrm>
                  <a:off x="4581" y="2564"/>
                  <a:ext cx="594" cy="336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69" name="Rectangle 153"/>
                <p:cNvSpPr>
                  <a:spLocks noChangeArrowheads="1"/>
                </p:cNvSpPr>
                <p:nvPr/>
              </p:nvSpPr>
              <p:spPr bwMode="auto">
                <a:xfrm rot="2280000">
                  <a:off x="5210" y="3306"/>
                  <a:ext cx="331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QJQC-A10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70" name="Line 154"/>
                <p:cNvSpPr>
                  <a:spLocks noChangeShapeType="1"/>
                </p:cNvSpPr>
                <p:nvPr/>
              </p:nvSpPr>
              <p:spPr bwMode="auto">
                <a:xfrm>
                  <a:off x="5102" y="3144"/>
                  <a:ext cx="49" cy="39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71" name="Rectangle 155"/>
                <p:cNvSpPr>
                  <a:spLocks noChangeArrowheads="1"/>
                </p:cNvSpPr>
                <p:nvPr/>
              </p:nvSpPr>
              <p:spPr bwMode="auto">
                <a:xfrm rot="2580000">
                  <a:off x="5113" y="3434"/>
                  <a:ext cx="291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LK-A10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72" name="Line 156"/>
                <p:cNvSpPr>
                  <a:spLocks noChangeShapeType="1"/>
                </p:cNvSpPr>
                <p:nvPr/>
              </p:nvSpPr>
              <p:spPr bwMode="auto">
                <a:xfrm>
                  <a:off x="5009" y="3251"/>
                  <a:ext cx="47" cy="43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73" name="Freeform 157"/>
                <p:cNvSpPr/>
                <p:nvPr/>
              </p:nvSpPr>
              <p:spPr bwMode="auto">
                <a:xfrm>
                  <a:off x="5055" y="3141"/>
                  <a:ext cx="44" cy="54"/>
                </a:xfrm>
                <a:custGeom>
                  <a:avLst/>
                  <a:gdLst>
                    <a:gd name="T0" fmla="*/ 0 w 44"/>
                    <a:gd name="T1" fmla="*/ 54 h 54"/>
                    <a:gd name="T2" fmla="*/ 3 w 44"/>
                    <a:gd name="T3" fmla="*/ 52 h 54"/>
                    <a:gd name="T4" fmla="*/ 5 w 44"/>
                    <a:gd name="T5" fmla="*/ 49 h 54"/>
                    <a:gd name="T6" fmla="*/ 8 w 44"/>
                    <a:gd name="T7" fmla="*/ 46 h 54"/>
                    <a:gd name="T8" fmla="*/ 10 w 44"/>
                    <a:gd name="T9" fmla="*/ 42 h 54"/>
                    <a:gd name="T10" fmla="*/ 13 w 44"/>
                    <a:gd name="T11" fmla="*/ 39 h 54"/>
                    <a:gd name="T12" fmla="*/ 15 w 44"/>
                    <a:gd name="T13" fmla="*/ 36 h 54"/>
                    <a:gd name="T14" fmla="*/ 18 w 44"/>
                    <a:gd name="T15" fmla="*/ 33 h 54"/>
                    <a:gd name="T16" fmla="*/ 21 w 44"/>
                    <a:gd name="T17" fmla="*/ 30 h 54"/>
                    <a:gd name="T18" fmla="*/ 24 w 44"/>
                    <a:gd name="T19" fmla="*/ 26 h 54"/>
                    <a:gd name="T20" fmla="*/ 27 w 44"/>
                    <a:gd name="T21" fmla="*/ 23 h 54"/>
                    <a:gd name="T22" fmla="*/ 28 w 44"/>
                    <a:gd name="T23" fmla="*/ 20 h 54"/>
                    <a:gd name="T24" fmla="*/ 31 w 44"/>
                    <a:gd name="T25" fmla="*/ 16 h 54"/>
                    <a:gd name="T26" fmla="*/ 34 w 44"/>
                    <a:gd name="T27" fmla="*/ 13 h 54"/>
                    <a:gd name="T28" fmla="*/ 37 w 44"/>
                    <a:gd name="T29" fmla="*/ 10 h 54"/>
                    <a:gd name="T30" fmla="*/ 40 w 44"/>
                    <a:gd name="T31" fmla="*/ 7 h 54"/>
                    <a:gd name="T32" fmla="*/ 43 w 44"/>
                    <a:gd name="T33" fmla="*/ 3 h 54"/>
                    <a:gd name="T34" fmla="*/ 44 w 44"/>
                    <a:gd name="T35" fmla="*/ 0 h 5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44" h="54">
                      <a:moveTo>
                        <a:pt x="0" y="54"/>
                      </a:moveTo>
                      <a:lnTo>
                        <a:pt x="3" y="52"/>
                      </a:lnTo>
                      <a:lnTo>
                        <a:pt x="5" y="49"/>
                      </a:lnTo>
                      <a:lnTo>
                        <a:pt x="8" y="46"/>
                      </a:lnTo>
                      <a:lnTo>
                        <a:pt x="10" y="42"/>
                      </a:lnTo>
                      <a:lnTo>
                        <a:pt x="13" y="39"/>
                      </a:lnTo>
                      <a:lnTo>
                        <a:pt x="15" y="36"/>
                      </a:lnTo>
                      <a:lnTo>
                        <a:pt x="18" y="33"/>
                      </a:lnTo>
                      <a:lnTo>
                        <a:pt x="21" y="30"/>
                      </a:lnTo>
                      <a:lnTo>
                        <a:pt x="24" y="26"/>
                      </a:lnTo>
                      <a:lnTo>
                        <a:pt x="27" y="23"/>
                      </a:lnTo>
                      <a:lnTo>
                        <a:pt x="28" y="20"/>
                      </a:lnTo>
                      <a:lnTo>
                        <a:pt x="31" y="16"/>
                      </a:lnTo>
                      <a:lnTo>
                        <a:pt x="34" y="13"/>
                      </a:lnTo>
                      <a:lnTo>
                        <a:pt x="37" y="10"/>
                      </a:lnTo>
                      <a:lnTo>
                        <a:pt x="40" y="7"/>
                      </a:lnTo>
                      <a:lnTo>
                        <a:pt x="43" y="3"/>
                      </a:lnTo>
                      <a:lnTo>
                        <a:pt x="44" y="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74" name="Freeform 158"/>
                <p:cNvSpPr/>
                <p:nvPr/>
              </p:nvSpPr>
              <p:spPr bwMode="auto">
                <a:xfrm>
                  <a:off x="5007" y="3195"/>
                  <a:ext cx="48" cy="54"/>
                </a:xfrm>
                <a:custGeom>
                  <a:avLst/>
                  <a:gdLst>
                    <a:gd name="T0" fmla="*/ 48 w 48"/>
                    <a:gd name="T1" fmla="*/ 0 h 54"/>
                    <a:gd name="T2" fmla="*/ 45 w 48"/>
                    <a:gd name="T3" fmla="*/ 5 h 54"/>
                    <a:gd name="T4" fmla="*/ 42 w 48"/>
                    <a:gd name="T5" fmla="*/ 8 h 54"/>
                    <a:gd name="T6" fmla="*/ 39 w 48"/>
                    <a:gd name="T7" fmla="*/ 11 h 54"/>
                    <a:gd name="T8" fmla="*/ 36 w 48"/>
                    <a:gd name="T9" fmla="*/ 13 h 54"/>
                    <a:gd name="T10" fmla="*/ 33 w 48"/>
                    <a:gd name="T11" fmla="*/ 16 h 54"/>
                    <a:gd name="T12" fmla="*/ 30 w 48"/>
                    <a:gd name="T13" fmla="*/ 21 h 54"/>
                    <a:gd name="T14" fmla="*/ 29 w 48"/>
                    <a:gd name="T15" fmla="*/ 23 h 54"/>
                    <a:gd name="T16" fmla="*/ 26 w 48"/>
                    <a:gd name="T17" fmla="*/ 26 h 54"/>
                    <a:gd name="T18" fmla="*/ 23 w 48"/>
                    <a:gd name="T19" fmla="*/ 29 h 54"/>
                    <a:gd name="T20" fmla="*/ 20 w 48"/>
                    <a:gd name="T21" fmla="*/ 32 h 54"/>
                    <a:gd name="T22" fmla="*/ 18 w 48"/>
                    <a:gd name="T23" fmla="*/ 35 h 54"/>
                    <a:gd name="T24" fmla="*/ 15 w 48"/>
                    <a:gd name="T25" fmla="*/ 39 h 54"/>
                    <a:gd name="T26" fmla="*/ 12 w 48"/>
                    <a:gd name="T27" fmla="*/ 42 h 54"/>
                    <a:gd name="T28" fmla="*/ 9 w 48"/>
                    <a:gd name="T29" fmla="*/ 45 h 54"/>
                    <a:gd name="T30" fmla="*/ 6 w 48"/>
                    <a:gd name="T31" fmla="*/ 48 h 54"/>
                    <a:gd name="T32" fmla="*/ 3 w 48"/>
                    <a:gd name="T33" fmla="*/ 51 h 54"/>
                    <a:gd name="T34" fmla="*/ 0 w 48"/>
                    <a:gd name="T35" fmla="*/ 54 h 5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48" h="54">
                      <a:moveTo>
                        <a:pt x="48" y="0"/>
                      </a:moveTo>
                      <a:lnTo>
                        <a:pt x="45" y="5"/>
                      </a:lnTo>
                      <a:lnTo>
                        <a:pt x="42" y="8"/>
                      </a:lnTo>
                      <a:lnTo>
                        <a:pt x="39" y="11"/>
                      </a:lnTo>
                      <a:lnTo>
                        <a:pt x="36" y="13"/>
                      </a:lnTo>
                      <a:lnTo>
                        <a:pt x="33" y="16"/>
                      </a:lnTo>
                      <a:lnTo>
                        <a:pt x="30" y="21"/>
                      </a:lnTo>
                      <a:lnTo>
                        <a:pt x="29" y="23"/>
                      </a:lnTo>
                      <a:lnTo>
                        <a:pt x="26" y="26"/>
                      </a:lnTo>
                      <a:lnTo>
                        <a:pt x="23" y="29"/>
                      </a:lnTo>
                      <a:lnTo>
                        <a:pt x="20" y="32"/>
                      </a:lnTo>
                      <a:lnTo>
                        <a:pt x="18" y="35"/>
                      </a:lnTo>
                      <a:lnTo>
                        <a:pt x="15" y="39"/>
                      </a:lnTo>
                      <a:lnTo>
                        <a:pt x="12" y="42"/>
                      </a:lnTo>
                      <a:lnTo>
                        <a:pt x="9" y="45"/>
                      </a:lnTo>
                      <a:lnTo>
                        <a:pt x="6" y="48"/>
                      </a:lnTo>
                      <a:lnTo>
                        <a:pt x="3" y="51"/>
                      </a:lnTo>
                      <a:lnTo>
                        <a:pt x="0" y="54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76" name="Line 160"/>
                <p:cNvSpPr>
                  <a:spLocks noChangeShapeType="1"/>
                </p:cNvSpPr>
                <p:nvPr/>
              </p:nvSpPr>
              <p:spPr bwMode="auto">
                <a:xfrm>
                  <a:off x="5004" y="3152"/>
                  <a:ext cx="48" cy="42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77" name="Rectangle 161"/>
                <p:cNvSpPr>
                  <a:spLocks noChangeArrowheads="1"/>
                </p:cNvSpPr>
                <p:nvPr/>
              </p:nvSpPr>
              <p:spPr bwMode="auto">
                <a:xfrm rot="2880000">
                  <a:off x="5000" y="3560"/>
                  <a:ext cx="299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HE-A10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78" name="Line 162"/>
                <p:cNvSpPr>
                  <a:spLocks noChangeShapeType="1"/>
                </p:cNvSpPr>
                <p:nvPr/>
              </p:nvSpPr>
              <p:spPr bwMode="auto">
                <a:xfrm>
                  <a:off x="4861" y="3299"/>
                  <a:ext cx="89" cy="99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79" name="Freeform 163"/>
                <p:cNvSpPr/>
                <p:nvPr/>
              </p:nvSpPr>
              <p:spPr bwMode="auto">
                <a:xfrm>
                  <a:off x="4933" y="3151"/>
                  <a:ext cx="69" cy="76"/>
                </a:xfrm>
                <a:custGeom>
                  <a:avLst/>
                  <a:gdLst>
                    <a:gd name="T0" fmla="*/ 0 w 69"/>
                    <a:gd name="T1" fmla="*/ 76 h 76"/>
                    <a:gd name="T2" fmla="*/ 4 w 69"/>
                    <a:gd name="T3" fmla="*/ 72 h 76"/>
                    <a:gd name="T4" fmla="*/ 7 w 69"/>
                    <a:gd name="T5" fmla="*/ 69 h 76"/>
                    <a:gd name="T6" fmla="*/ 11 w 69"/>
                    <a:gd name="T7" fmla="*/ 65 h 76"/>
                    <a:gd name="T8" fmla="*/ 14 w 69"/>
                    <a:gd name="T9" fmla="*/ 62 h 76"/>
                    <a:gd name="T10" fmla="*/ 17 w 69"/>
                    <a:gd name="T11" fmla="*/ 57 h 76"/>
                    <a:gd name="T12" fmla="*/ 21 w 69"/>
                    <a:gd name="T13" fmla="*/ 55 h 76"/>
                    <a:gd name="T14" fmla="*/ 24 w 69"/>
                    <a:gd name="T15" fmla="*/ 52 h 76"/>
                    <a:gd name="T16" fmla="*/ 27 w 69"/>
                    <a:gd name="T17" fmla="*/ 47 h 76"/>
                    <a:gd name="T18" fmla="*/ 30 w 69"/>
                    <a:gd name="T19" fmla="*/ 44 h 76"/>
                    <a:gd name="T20" fmla="*/ 34 w 69"/>
                    <a:gd name="T21" fmla="*/ 40 h 76"/>
                    <a:gd name="T22" fmla="*/ 37 w 69"/>
                    <a:gd name="T23" fmla="*/ 37 h 76"/>
                    <a:gd name="T24" fmla="*/ 40 w 69"/>
                    <a:gd name="T25" fmla="*/ 33 h 76"/>
                    <a:gd name="T26" fmla="*/ 44 w 69"/>
                    <a:gd name="T27" fmla="*/ 30 h 76"/>
                    <a:gd name="T28" fmla="*/ 47 w 69"/>
                    <a:gd name="T29" fmla="*/ 26 h 76"/>
                    <a:gd name="T30" fmla="*/ 50 w 69"/>
                    <a:gd name="T31" fmla="*/ 22 h 76"/>
                    <a:gd name="T32" fmla="*/ 53 w 69"/>
                    <a:gd name="T33" fmla="*/ 19 h 76"/>
                    <a:gd name="T34" fmla="*/ 57 w 69"/>
                    <a:gd name="T35" fmla="*/ 14 h 76"/>
                    <a:gd name="T36" fmla="*/ 60 w 69"/>
                    <a:gd name="T37" fmla="*/ 11 h 76"/>
                    <a:gd name="T38" fmla="*/ 63 w 69"/>
                    <a:gd name="T39" fmla="*/ 7 h 76"/>
                    <a:gd name="T40" fmla="*/ 66 w 69"/>
                    <a:gd name="T41" fmla="*/ 4 h 76"/>
                    <a:gd name="T42" fmla="*/ 69 w 69"/>
                    <a:gd name="T43" fmla="*/ 0 h 7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</a:cxnLst>
                  <a:rect l="0" t="0" r="r" b="b"/>
                  <a:pathLst>
                    <a:path w="69" h="76">
                      <a:moveTo>
                        <a:pt x="0" y="76"/>
                      </a:moveTo>
                      <a:lnTo>
                        <a:pt x="4" y="72"/>
                      </a:lnTo>
                      <a:lnTo>
                        <a:pt x="7" y="69"/>
                      </a:lnTo>
                      <a:lnTo>
                        <a:pt x="11" y="65"/>
                      </a:lnTo>
                      <a:lnTo>
                        <a:pt x="14" y="62"/>
                      </a:lnTo>
                      <a:lnTo>
                        <a:pt x="17" y="57"/>
                      </a:lnTo>
                      <a:lnTo>
                        <a:pt x="21" y="55"/>
                      </a:lnTo>
                      <a:lnTo>
                        <a:pt x="24" y="52"/>
                      </a:lnTo>
                      <a:lnTo>
                        <a:pt x="27" y="47"/>
                      </a:lnTo>
                      <a:lnTo>
                        <a:pt x="30" y="44"/>
                      </a:lnTo>
                      <a:lnTo>
                        <a:pt x="34" y="40"/>
                      </a:lnTo>
                      <a:lnTo>
                        <a:pt x="37" y="37"/>
                      </a:lnTo>
                      <a:lnTo>
                        <a:pt x="40" y="33"/>
                      </a:lnTo>
                      <a:lnTo>
                        <a:pt x="44" y="30"/>
                      </a:lnTo>
                      <a:lnTo>
                        <a:pt x="47" y="26"/>
                      </a:lnTo>
                      <a:lnTo>
                        <a:pt x="50" y="22"/>
                      </a:lnTo>
                      <a:lnTo>
                        <a:pt x="53" y="19"/>
                      </a:lnTo>
                      <a:lnTo>
                        <a:pt x="57" y="14"/>
                      </a:lnTo>
                      <a:lnTo>
                        <a:pt x="60" y="11"/>
                      </a:lnTo>
                      <a:lnTo>
                        <a:pt x="63" y="7"/>
                      </a:lnTo>
                      <a:lnTo>
                        <a:pt x="66" y="4"/>
                      </a:lnTo>
                      <a:lnTo>
                        <a:pt x="69" y="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80" name="Freeform 164"/>
                <p:cNvSpPr/>
                <p:nvPr/>
              </p:nvSpPr>
              <p:spPr bwMode="auto">
                <a:xfrm>
                  <a:off x="4860" y="3227"/>
                  <a:ext cx="73" cy="70"/>
                </a:xfrm>
                <a:custGeom>
                  <a:avLst/>
                  <a:gdLst>
                    <a:gd name="T0" fmla="*/ 73 w 73"/>
                    <a:gd name="T1" fmla="*/ 0 h 70"/>
                    <a:gd name="T2" fmla="*/ 71 w 73"/>
                    <a:gd name="T3" fmla="*/ 1 h 70"/>
                    <a:gd name="T4" fmla="*/ 68 w 73"/>
                    <a:gd name="T5" fmla="*/ 4 h 70"/>
                    <a:gd name="T6" fmla="*/ 66 w 73"/>
                    <a:gd name="T7" fmla="*/ 7 h 70"/>
                    <a:gd name="T8" fmla="*/ 64 w 73"/>
                    <a:gd name="T9" fmla="*/ 9 h 70"/>
                    <a:gd name="T10" fmla="*/ 61 w 73"/>
                    <a:gd name="T11" fmla="*/ 12 h 70"/>
                    <a:gd name="T12" fmla="*/ 58 w 73"/>
                    <a:gd name="T13" fmla="*/ 14 h 70"/>
                    <a:gd name="T14" fmla="*/ 57 w 73"/>
                    <a:gd name="T15" fmla="*/ 17 h 70"/>
                    <a:gd name="T16" fmla="*/ 54 w 73"/>
                    <a:gd name="T17" fmla="*/ 19 h 70"/>
                    <a:gd name="T18" fmla="*/ 51 w 73"/>
                    <a:gd name="T19" fmla="*/ 22 h 70"/>
                    <a:gd name="T20" fmla="*/ 50 w 73"/>
                    <a:gd name="T21" fmla="*/ 24 h 70"/>
                    <a:gd name="T22" fmla="*/ 47 w 73"/>
                    <a:gd name="T23" fmla="*/ 26 h 70"/>
                    <a:gd name="T24" fmla="*/ 44 w 73"/>
                    <a:gd name="T25" fmla="*/ 29 h 70"/>
                    <a:gd name="T26" fmla="*/ 43 w 73"/>
                    <a:gd name="T27" fmla="*/ 32 h 70"/>
                    <a:gd name="T28" fmla="*/ 40 w 73"/>
                    <a:gd name="T29" fmla="*/ 33 h 70"/>
                    <a:gd name="T30" fmla="*/ 37 w 73"/>
                    <a:gd name="T31" fmla="*/ 36 h 70"/>
                    <a:gd name="T32" fmla="*/ 34 w 73"/>
                    <a:gd name="T33" fmla="*/ 37 h 70"/>
                    <a:gd name="T34" fmla="*/ 33 w 73"/>
                    <a:gd name="T35" fmla="*/ 40 h 70"/>
                    <a:gd name="T36" fmla="*/ 30 w 73"/>
                    <a:gd name="T37" fmla="*/ 43 h 70"/>
                    <a:gd name="T38" fmla="*/ 27 w 73"/>
                    <a:gd name="T39" fmla="*/ 45 h 70"/>
                    <a:gd name="T40" fmla="*/ 25 w 73"/>
                    <a:gd name="T41" fmla="*/ 47 h 70"/>
                    <a:gd name="T42" fmla="*/ 23 w 73"/>
                    <a:gd name="T43" fmla="*/ 50 h 70"/>
                    <a:gd name="T44" fmla="*/ 20 w 73"/>
                    <a:gd name="T45" fmla="*/ 52 h 70"/>
                    <a:gd name="T46" fmla="*/ 17 w 73"/>
                    <a:gd name="T47" fmla="*/ 55 h 70"/>
                    <a:gd name="T48" fmla="*/ 15 w 73"/>
                    <a:gd name="T49" fmla="*/ 56 h 70"/>
                    <a:gd name="T50" fmla="*/ 13 w 73"/>
                    <a:gd name="T51" fmla="*/ 59 h 70"/>
                    <a:gd name="T52" fmla="*/ 10 w 73"/>
                    <a:gd name="T53" fmla="*/ 62 h 70"/>
                    <a:gd name="T54" fmla="*/ 7 w 73"/>
                    <a:gd name="T55" fmla="*/ 63 h 70"/>
                    <a:gd name="T56" fmla="*/ 5 w 73"/>
                    <a:gd name="T57" fmla="*/ 66 h 70"/>
                    <a:gd name="T58" fmla="*/ 3 w 73"/>
                    <a:gd name="T59" fmla="*/ 67 h 70"/>
                    <a:gd name="T60" fmla="*/ 0 w 73"/>
                    <a:gd name="T61" fmla="*/ 70 h 7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</a:cxnLst>
                  <a:rect l="0" t="0" r="r" b="b"/>
                  <a:pathLst>
                    <a:path w="73" h="70">
                      <a:moveTo>
                        <a:pt x="73" y="0"/>
                      </a:moveTo>
                      <a:lnTo>
                        <a:pt x="71" y="1"/>
                      </a:lnTo>
                      <a:lnTo>
                        <a:pt x="68" y="4"/>
                      </a:lnTo>
                      <a:lnTo>
                        <a:pt x="66" y="7"/>
                      </a:lnTo>
                      <a:lnTo>
                        <a:pt x="64" y="9"/>
                      </a:lnTo>
                      <a:lnTo>
                        <a:pt x="61" y="12"/>
                      </a:lnTo>
                      <a:lnTo>
                        <a:pt x="58" y="14"/>
                      </a:lnTo>
                      <a:lnTo>
                        <a:pt x="57" y="17"/>
                      </a:lnTo>
                      <a:lnTo>
                        <a:pt x="54" y="19"/>
                      </a:lnTo>
                      <a:lnTo>
                        <a:pt x="51" y="22"/>
                      </a:lnTo>
                      <a:lnTo>
                        <a:pt x="50" y="24"/>
                      </a:lnTo>
                      <a:lnTo>
                        <a:pt x="47" y="26"/>
                      </a:lnTo>
                      <a:lnTo>
                        <a:pt x="44" y="29"/>
                      </a:lnTo>
                      <a:lnTo>
                        <a:pt x="43" y="32"/>
                      </a:lnTo>
                      <a:lnTo>
                        <a:pt x="40" y="33"/>
                      </a:lnTo>
                      <a:lnTo>
                        <a:pt x="37" y="36"/>
                      </a:lnTo>
                      <a:lnTo>
                        <a:pt x="34" y="37"/>
                      </a:lnTo>
                      <a:lnTo>
                        <a:pt x="33" y="40"/>
                      </a:lnTo>
                      <a:lnTo>
                        <a:pt x="30" y="43"/>
                      </a:lnTo>
                      <a:lnTo>
                        <a:pt x="27" y="45"/>
                      </a:lnTo>
                      <a:lnTo>
                        <a:pt x="25" y="47"/>
                      </a:lnTo>
                      <a:lnTo>
                        <a:pt x="23" y="50"/>
                      </a:lnTo>
                      <a:lnTo>
                        <a:pt x="20" y="52"/>
                      </a:lnTo>
                      <a:lnTo>
                        <a:pt x="17" y="55"/>
                      </a:lnTo>
                      <a:lnTo>
                        <a:pt x="15" y="56"/>
                      </a:lnTo>
                      <a:lnTo>
                        <a:pt x="13" y="59"/>
                      </a:lnTo>
                      <a:lnTo>
                        <a:pt x="10" y="62"/>
                      </a:lnTo>
                      <a:lnTo>
                        <a:pt x="7" y="63"/>
                      </a:lnTo>
                      <a:lnTo>
                        <a:pt x="5" y="66"/>
                      </a:lnTo>
                      <a:lnTo>
                        <a:pt x="3" y="67"/>
                      </a:lnTo>
                      <a:lnTo>
                        <a:pt x="0" y="7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82" name="Line 166"/>
                <p:cNvSpPr>
                  <a:spLocks noChangeShapeType="1"/>
                </p:cNvSpPr>
                <p:nvPr/>
              </p:nvSpPr>
              <p:spPr bwMode="auto">
                <a:xfrm>
                  <a:off x="4885" y="3181"/>
                  <a:ext cx="46" cy="45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83" name="Rectangle 167"/>
                <p:cNvSpPr>
                  <a:spLocks noChangeArrowheads="1"/>
                </p:cNvSpPr>
                <p:nvPr/>
              </p:nvSpPr>
              <p:spPr bwMode="auto">
                <a:xfrm rot="3120000">
                  <a:off x="4854" y="3683"/>
                  <a:ext cx="351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RQC-A10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84" name="Line 168"/>
                <p:cNvSpPr>
                  <a:spLocks noChangeShapeType="1"/>
                </p:cNvSpPr>
                <p:nvPr/>
              </p:nvSpPr>
              <p:spPr bwMode="auto">
                <a:xfrm>
                  <a:off x="4715" y="3332"/>
                  <a:ext cx="122" cy="159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85" name="Freeform 169"/>
                <p:cNvSpPr/>
                <p:nvPr/>
              </p:nvSpPr>
              <p:spPr bwMode="auto">
                <a:xfrm>
                  <a:off x="4802" y="3178"/>
                  <a:ext cx="82" cy="79"/>
                </a:xfrm>
                <a:custGeom>
                  <a:avLst/>
                  <a:gdLst>
                    <a:gd name="T0" fmla="*/ 0 w 82"/>
                    <a:gd name="T1" fmla="*/ 79 h 79"/>
                    <a:gd name="T2" fmla="*/ 3 w 82"/>
                    <a:gd name="T3" fmla="*/ 76 h 79"/>
                    <a:gd name="T4" fmla="*/ 7 w 82"/>
                    <a:gd name="T5" fmla="*/ 72 h 79"/>
                    <a:gd name="T6" fmla="*/ 12 w 82"/>
                    <a:gd name="T7" fmla="*/ 69 h 79"/>
                    <a:gd name="T8" fmla="*/ 15 w 82"/>
                    <a:gd name="T9" fmla="*/ 65 h 79"/>
                    <a:gd name="T10" fmla="*/ 19 w 82"/>
                    <a:gd name="T11" fmla="*/ 62 h 79"/>
                    <a:gd name="T12" fmla="*/ 23 w 82"/>
                    <a:gd name="T13" fmla="*/ 58 h 79"/>
                    <a:gd name="T14" fmla="*/ 26 w 82"/>
                    <a:gd name="T15" fmla="*/ 55 h 79"/>
                    <a:gd name="T16" fmla="*/ 30 w 82"/>
                    <a:gd name="T17" fmla="*/ 52 h 79"/>
                    <a:gd name="T18" fmla="*/ 35 w 82"/>
                    <a:gd name="T19" fmla="*/ 48 h 79"/>
                    <a:gd name="T20" fmla="*/ 38 w 82"/>
                    <a:gd name="T21" fmla="*/ 45 h 79"/>
                    <a:gd name="T22" fmla="*/ 42 w 82"/>
                    <a:gd name="T23" fmla="*/ 40 h 79"/>
                    <a:gd name="T24" fmla="*/ 45 w 82"/>
                    <a:gd name="T25" fmla="*/ 38 h 79"/>
                    <a:gd name="T26" fmla="*/ 49 w 82"/>
                    <a:gd name="T27" fmla="*/ 33 h 79"/>
                    <a:gd name="T28" fmla="*/ 53 w 82"/>
                    <a:gd name="T29" fmla="*/ 30 h 79"/>
                    <a:gd name="T30" fmla="*/ 56 w 82"/>
                    <a:gd name="T31" fmla="*/ 26 h 79"/>
                    <a:gd name="T32" fmla="*/ 61 w 82"/>
                    <a:gd name="T33" fmla="*/ 23 h 79"/>
                    <a:gd name="T34" fmla="*/ 63 w 82"/>
                    <a:gd name="T35" fmla="*/ 19 h 79"/>
                    <a:gd name="T36" fmla="*/ 68 w 82"/>
                    <a:gd name="T37" fmla="*/ 15 h 79"/>
                    <a:gd name="T38" fmla="*/ 71 w 82"/>
                    <a:gd name="T39" fmla="*/ 12 h 79"/>
                    <a:gd name="T40" fmla="*/ 75 w 82"/>
                    <a:gd name="T41" fmla="*/ 7 h 79"/>
                    <a:gd name="T42" fmla="*/ 79 w 82"/>
                    <a:gd name="T43" fmla="*/ 5 h 79"/>
                    <a:gd name="T44" fmla="*/ 82 w 82"/>
                    <a:gd name="T45" fmla="*/ 0 h 7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</a:cxnLst>
                  <a:rect l="0" t="0" r="r" b="b"/>
                  <a:pathLst>
                    <a:path w="82" h="79">
                      <a:moveTo>
                        <a:pt x="0" y="79"/>
                      </a:moveTo>
                      <a:lnTo>
                        <a:pt x="3" y="76"/>
                      </a:lnTo>
                      <a:lnTo>
                        <a:pt x="7" y="72"/>
                      </a:lnTo>
                      <a:lnTo>
                        <a:pt x="12" y="69"/>
                      </a:lnTo>
                      <a:lnTo>
                        <a:pt x="15" y="65"/>
                      </a:lnTo>
                      <a:lnTo>
                        <a:pt x="19" y="62"/>
                      </a:lnTo>
                      <a:lnTo>
                        <a:pt x="23" y="58"/>
                      </a:lnTo>
                      <a:lnTo>
                        <a:pt x="26" y="55"/>
                      </a:lnTo>
                      <a:lnTo>
                        <a:pt x="30" y="52"/>
                      </a:lnTo>
                      <a:lnTo>
                        <a:pt x="35" y="48"/>
                      </a:lnTo>
                      <a:lnTo>
                        <a:pt x="38" y="45"/>
                      </a:lnTo>
                      <a:lnTo>
                        <a:pt x="42" y="40"/>
                      </a:lnTo>
                      <a:lnTo>
                        <a:pt x="45" y="38"/>
                      </a:lnTo>
                      <a:lnTo>
                        <a:pt x="49" y="33"/>
                      </a:lnTo>
                      <a:lnTo>
                        <a:pt x="53" y="30"/>
                      </a:lnTo>
                      <a:lnTo>
                        <a:pt x="56" y="26"/>
                      </a:lnTo>
                      <a:lnTo>
                        <a:pt x="61" y="23"/>
                      </a:lnTo>
                      <a:lnTo>
                        <a:pt x="63" y="19"/>
                      </a:lnTo>
                      <a:lnTo>
                        <a:pt x="68" y="15"/>
                      </a:lnTo>
                      <a:lnTo>
                        <a:pt x="71" y="12"/>
                      </a:lnTo>
                      <a:lnTo>
                        <a:pt x="75" y="7"/>
                      </a:lnTo>
                      <a:lnTo>
                        <a:pt x="79" y="5"/>
                      </a:lnTo>
                      <a:lnTo>
                        <a:pt x="82" y="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86" name="Freeform 170"/>
                <p:cNvSpPr/>
                <p:nvPr/>
              </p:nvSpPr>
              <p:spPr bwMode="auto">
                <a:xfrm>
                  <a:off x="4713" y="3257"/>
                  <a:ext cx="89" cy="72"/>
                </a:xfrm>
                <a:custGeom>
                  <a:avLst/>
                  <a:gdLst>
                    <a:gd name="T0" fmla="*/ 89 w 89"/>
                    <a:gd name="T1" fmla="*/ 0 h 72"/>
                    <a:gd name="T2" fmla="*/ 86 w 89"/>
                    <a:gd name="T3" fmla="*/ 2 h 72"/>
                    <a:gd name="T4" fmla="*/ 85 w 89"/>
                    <a:gd name="T5" fmla="*/ 4 h 72"/>
                    <a:gd name="T6" fmla="*/ 82 w 89"/>
                    <a:gd name="T7" fmla="*/ 6 h 72"/>
                    <a:gd name="T8" fmla="*/ 81 w 89"/>
                    <a:gd name="T9" fmla="*/ 7 h 72"/>
                    <a:gd name="T10" fmla="*/ 78 w 89"/>
                    <a:gd name="T11" fmla="*/ 9 h 72"/>
                    <a:gd name="T12" fmla="*/ 76 w 89"/>
                    <a:gd name="T13" fmla="*/ 12 h 72"/>
                    <a:gd name="T14" fmla="*/ 74 w 89"/>
                    <a:gd name="T15" fmla="*/ 13 h 72"/>
                    <a:gd name="T16" fmla="*/ 72 w 89"/>
                    <a:gd name="T17" fmla="*/ 15 h 72"/>
                    <a:gd name="T18" fmla="*/ 69 w 89"/>
                    <a:gd name="T19" fmla="*/ 16 h 72"/>
                    <a:gd name="T20" fmla="*/ 68 w 89"/>
                    <a:gd name="T21" fmla="*/ 19 h 72"/>
                    <a:gd name="T22" fmla="*/ 65 w 89"/>
                    <a:gd name="T23" fmla="*/ 20 h 72"/>
                    <a:gd name="T24" fmla="*/ 63 w 89"/>
                    <a:gd name="T25" fmla="*/ 22 h 72"/>
                    <a:gd name="T26" fmla="*/ 61 w 89"/>
                    <a:gd name="T27" fmla="*/ 23 h 72"/>
                    <a:gd name="T28" fmla="*/ 59 w 89"/>
                    <a:gd name="T29" fmla="*/ 26 h 72"/>
                    <a:gd name="T30" fmla="*/ 56 w 89"/>
                    <a:gd name="T31" fmla="*/ 27 h 72"/>
                    <a:gd name="T32" fmla="*/ 55 w 89"/>
                    <a:gd name="T33" fmla="*/ 29 h 72"/>
                    <a:gd name="T34" fmla="*/ 52 w 89"/>
                    <a:gd name="T35" fmla="*/ 30 h 72"/>
                    <a:gd name="T36" fmla="*/ 51 w 89"/>
                    <a:gd name="T37" fmla="*/ 33 h 72"/>
                    <a:gd name="T38" fmla="*/ 48 w 89"/>
                    <a:gd name="T39" fmla="*/ 35 h 72"/>
                    <a:gd name="T40" fmla="*/ 46 w 89"/>
                    <a:gd name="T41" fmla="*/ 36 h 72"/>
                    <a:gd name="T42" fmla="*/ 43 w 89"/>
                    <a:gd name="T43" fmla="*/ 37 h 72"/>
                    <a:gd name="T44" fmla="*/ 42 w 89"/>
                    <a:gd name="T45" fmla="*/ 40 h 72"/>
                    <a:gd name="T46" fmla="*/ 39 w 89"/>
                    <a:gd name="T47" fmla="*/ 42 h 72"/>
                    <a:gd name="T48" fmla="*/ 38 w 89"/>
                    <a:gd name="T49" fmla="*/ 43 h 72"/>
                    <a:gd name="T50" fmla="*/ 35 w 89"/>
                    <a:gd name="T51" fmla="*/ 45 h 72"/>
                    <a:gd name="T52" fmla="*/ 33 w 89"/>
                    <a:gd name="T53" fmla="*/ 46 h 72"/>
                    <a:gd name="T54" fmla="*/ 30 w 89"/>
                    <a:gd name="T55" fmla="*/ 49 h 72"/>
                    <a:gd name="T56" fmla="*/ 29 w 89"/>
                    <a:gd name="T57" fmla="*/ 50 h 72"/>
                    <a:gd name="T58" fmla="*/ 26 w 89"/>
                    <a:gd name="T59" fmla="*/ 52 h 72"/>
                    <a:gd name="T60" fmla="*/ 25 w 89"/>
                    <a:gd name="T61" fmla="*/ 53 h 72"/>
                    <a:gd name="T62" fmla="*/ 22 w 89"/>
                    <a:gd name="T63" fmla="*/ 55 h 72"/>
                    <a:gd name="T64" fmla="*/ 20 w 89"/>
                    <a:gd name="T65" fmla="*/ 58 h 72"/>
                    <a:gd name="T66" fmla="*/ 18 w 89"/>
                    <a:gd name="T67" fmla="*/ 59 h 72"/>
                    <a:gd name="T68" fmla="*/ 16 w 89"/>
                    <a:gd name="T69" fmla="*/ 60 h 72"/>
                    <a:gd name="T70" fmla="*/ 13 w 89"/>
                    <a:gd name="T71" fmla="*/ 62 h 72"/>
                    <a:gd name="T72" fmla="*/ 12 w 89"/>
                    <a:gd name="T73" fmla="*/ 63 h 72"/>
                    <a:gd name="T74" fmla="*/ 9 w 89"/>
                    <a:gd name="T75" fmla="*/ 66 h 72"/>
                    <a:gd name="T76" fmla="*/ 8 w 89"/>
                    <a:gd name="T77" fmla="*/ 68 h 72"/>
                    <a:gd name="T78" fmla="*/ 5 w 89"/>
                    <a:gd name="T79" fmla="*/ 69 h 72"/>
                    <a:gd name="T80" fmla="*/ 3 w 89"/>
                    <a:gd name="T81" fmla="*/ 70 h 72"/>
                    <a:gd name="T82" fmla="*/ 0 w 89"/>
                    <a:gd name="T83" fmla="*/ 72 h 7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</a:cxnLst>
                  <a:rect l="0" t="0" r="r" b="b"/>
                  <a:pathLst>
                    <a:path w="89" h="72">
                      <a:moveTo>
                        <a:pt x="89" y="0"/>
                      </a:moveTo>
                      <a:lnTo>
                        <a:pt x="86" y="2"/>
                      </a:lnTo>
                      <a:lnTo>
                        <a:pt x="85" y="4"/>
                      </a:lnTo>
                      <a:lnTo>
                        <a:pt x="82" y="6"/>
                      </a:lnTo>
                      <a:lnTo>
                        <a:pt x="81" y="7"/>
                      </a:lnTo>
                      <a:lnTo>
                        <a:pt x="78" y="9"/>
                      </a:lnTo>
                      <a:lnTo>
                        <a:pt x="76" y="12"/>
                      </a:lnTo>
                      <a:lnTo>
                        <a:pt x="74" y="13"/>
                      </a:lnTo>
                      <a:lnTo>
                        <a:pt x="72" y="15"/>
                      </a:lnTo>
                      <a:lnTo>
                        <a:pt x="69" y="16"/>
                      </a:lnTo>
                      <a:lnTo>
                        <a:pt x="68" y="19"/>
                      </a:lnTo>
                      <a:lnTo>
                        <a:pt x="65" y="20"/>
                      </a:lnTo>
                      <a:lnTo>
                        <a:pt x="63" y="22"/>
                      </a:lnTo>
                      <a:lnTo>
                        <a:pt x="61" y="23"/>
                      </a:lnTo>
                      <a:lnTo>
                        <a:pt x="59" y="26"/>
                      </a:lnTo>
                      <a:lnTo>
                        <a:pt x="56" y="27"/>
                      </a:lnTo>
                      <a:lnTo>
                        <a:pt x="55" y="29"/>
                      </a:lnTo>
                      <a:lnTo>
                        <a:pt x="52" y="30"/>
                      </a:lnTo>
                      <a:lnTo>
                        <a:pt x="51" y="33"/>
                      </a:lnTo>
                      <a:lnTo>
                        <a:pt x="48" y="35"/>
                      </a:lnTo>
                      <a:lnTo>
                        <a:pt x="46" y="36"/>
                      </a:lnTo>
                      <a:lnTo>
                        <a:pt x="43" y="37"/>
                      </a:lnTo>
                      <a:lnTo>
                        <a:pt x="42" y="40"/>
                      </a:lnTo>
                      <a:lnTo>
                        <a:pt x="39" y="42"/>
                      </a:lnTo>
                      <a:lnTo>
                        <a:pt x="38" y="43"/>
                      </a:lnTo>
                      <a:lnTo>
                        <a:pt x="35" y="45"/>
                      </a:lnTo>
                      <a:lnTo>
                        <a:pt x="33" y="46"/>
                      </a:lnTo>
                      <a:lnTo>
                        <a:pt x="30" y="49"/>
                      </a:lnTo>
                      <a:lnTo>
                        <a:pt x="29" y="50"/>
                      </a:lnTo>
                      <a:lnTo>
                        <a:pt x="26" y="52"/>
                      </a:lnTo>
                      <a:lnTo>
                        <a:pt x="25" y="53"/>
                      </a:lnTo>
                      <a:lnTo>
                        <a:pt x="22" y="55"/>
                      </a:lnTo>
                      <a:lnTo>
                        <a:pt x="20" y="58"/>
                      </a:lnTo>
                      <a:lnTo>
                        <a:pt x="18" y="59"/>
                      </a:lnTo>
                      <a:lnTo>
                        <a:pt x="16" y="60"/>
                      </a:lnTo>
                      <a:lnTo>
                        <a:pt x="13" y="62"/>
                      </a:lnTo>
                      <a:lnTo>
                        <a:pt x="12" y="63"/>
                      </a:lnTo>
                      <a:lnTo>
                        <a:pt x="9" y="66"/>
                      </a:lnTo>
                      <a:lnTo>
                        <a:pt x="8" y="68"/>
                      </a:lnTo>
                      <a:lnTo>
                        <a:pt x="5" y="69"/>
                      </a:lnTo>
                      <a:lnTo>
                        <a:pt x="3" y="70"/>
                      </a:lnTo>
                      <a:lnTo>
                        <a:pt x="0" y="72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88" name="Line 172"/>
                <p:cNvSpPr>
                  <a:spLocks noChangeShapeType="1"/>
                </p:cNvSpPr>
                <p:nvPr/>
              </p:nvSpPr>
              <p:spPr bwMode="auto">
                <a:xfrm>
                  <a:off x="4759" y="3208"/>
                  <a:ext cx="42" cy="48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89" name="Rectangle 173"/>
                <p:cNvSpPr>
                  <a:spLocks noChangeArrowheads="1"/>
                </p:cNvSpPr>
                <p:nvPr/>
              </p:nvSpPr>
              <p:spPr bwMode="auto">
                <a:xfrm rot="3420000">
                  <a:off x="4724" y="3748"/>
                  <a:ext cx="287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LX-A10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90" name="Line 174"/>
                <p:cNvSpPr>
                  <a:spLocks noChangeShapeType="1"/>
                </p:cNvSpPr>
                <p:nvPr/>
              </p:nvSpPr>
              <p:spPr bwMode="auto">
                <a:xfrm>
                  <a:off x="4571" y="3348"/>
                  <a:ext cx="144" cy="228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91" name="Freeform 175"/>
                <p:cNvSpPr/>
                <p:nvPr/>
              </p:nvSpPr>
              <p:spPr bwMode="auto">
                <a:xfrm>
                  <a:off x="4666" y="3206"/>
                  <a:ext cx="90" cy="73"/>
                </a:xfrm>
                <a:custGeom>
                  <a:avLst/>
                  <a:gdLst>
                    <a:gd name="T0" fmla="*/ 0 w 90"/>
                    <a:gd name="T1" fmla="*/ 73 h 73"/>
                    <a:gd name="T2" fmla="*/ 4 w 90"/>
                    <a:gd name="T3" fmla="*/ 70 h 73"/>
                    <a:gd name="T4" fmla="*/ 7 w 90"/>
                    <a:gd name="T5" fmla="*/ 67 h 73"/>
                    <a:gd name="T6" fmla="*/ 12 w 90"/>
                    <a:gd name="T7" fmla="*/ 64 h 73"/>
                    <a:gd name="T8" fmla="*/ 16 w 90"/>
                    <a:gd name="T9" fmla="*/ 61 h 73"/>
                    <a:gd name="T10" fmla="*/ 20 w 90"/>
                    <a:gd name="T11" fmla="*/ 58 h 73"/>
                    <a:gd name="T12" fmla="*/ 24 w 90"/>
                    <a:gd name="T13" fmla="*/ 54 h 73"/>
                    <a:gd name="T14" fmla="*/ 27 w 90"/>
                    <a:gd name="T15" fmla="*/ 51 h 73"/>
                    <a:gd name="T16" fmla="*/ 32 w 90"/>
                    <a:gd name="T17" fmla="*/ 48 h 73"/>
                    <a:gd name="T18" fmla="*/ 36 w 90"/>
                    <a:gd name="T19" fmla="*/ 45 h 73"/>
                    <a:gd name="T20" fmla="*/ 40 w 90"/>
                    <a:gd name="T21" fmla="*/ 43 h 73"/>
                    <a:gd name="T22" fmla="*/ 43 w 90"/>
                    <a:gd name="T23" fmla="*/ 38 h 73"/>
                    <a:gd name="T24" fmla="*/ 47 w 90"/>
                    <a:gd name="T25" fmla="*/ 35 h 73"/>
                    <a:gd name="T26" fmla="*/ 52 w 90"/>
                    <a:gd name="T27" fmla="*/ 33 h 73"/>
                    <a:gd name="T28" fmla="*/ 56 w 90"/>
                    <a:gd name="T29" fmla="*/ 30 h 73"/>
                    <a:gd name="T30" fmla="*/ 59 w 90"/>
                    <a:gd name="T31" fmla="*/ 25 h 73"/>
                    <a:gd name="T32" fmla="*/ 63 w 90"/>
                    <a:gd name="T33" fmla="*/ 22 h 73"/>
                    <a:gd name="T34" fmla="*/ 67 w 90"/>
                    <a:gd name="T35" fmla="*/ 20 h 73"/>
                    <a:gd name="T36" fmla="*/ 70 w 90"/>
                    <a:gd name="T37" fmla="*/ 17 h 73"/>
                    <a:gd name="T38" fmla="*/ 75 w 90"/>
                    <a:gd name="T39" fmla="*/ 12 h 73"/>
                    <a:gd name="T40" fmla="*/ 79 w 90"/>
                    <a:gd name="T41" fmla="*/ 10 h 73"/>
                    <a:gd name="T42" fmla="*/ 82 w 90"/>
                    <a:gd name="T43" fmla="*/ 7 h 73"/>
                    <a:gd name="T44" fmla="*/ 86 w 90"/>
                    <a:gd name="T45" fmla="*/ 2 h 73"/>
                    <a:gd name="T46" fmla="*/ 90 w 90"/>
                    <a:gd name="T47" fmla="*/ 0 h 7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</a:cxnLst>
                  <a:rect l="0" t="0" r="r" b="b"/>
                  <a:pathLst>
                    <a:path w="90" h="73">
                      <a:moveTo>
                        <a:pt x="0" y="73"/>
                      </a:moveTo>
                      <a:lnTo>
                        <a:pt x="4" y="70"/>
                      </a:lnTo>
                      <a:lnTo>
                        <a:pt x="7" y="67"/>
                      </a:lnTo>
                      <a:lnTo>
                        <a:pt x="12" y="64"/>
                      </a:lnTo>
                      <a:lnTo>
                        <a:pt x="16" y="61"/>
                      </a:lnTo>
                      <a:lnTo>
                        <a:pt x="20" y="58"/>
                      </a:lnTo>
                      <a:lnTo>
                        <a:pt x="24" y="54"/>
                      </a:lnTo>
                      <a:lnTo>
                        <a:pt x="27" y="51"/>
                      </a:lnTo>
                      <a:lnTo>
                        <a:pt x="32" y="48"/>
                      </a:lnTo>
                      <a:lnTo>
                        <a:pt x="36" y="45"/>
                      </a:lnTo>
                      <a:lnTo>
                        <a:pt x="40" y="43"/>
                      </a:lnTo>
                      <a:lnTo>
                        <a:pt x="43" y="38"/>
                      </a:lnTo>
                      <a:lnTo>
                        <a:pt x="47" y="35"/>
                      </a:lnTo>
                      <a:lnTo>
                        <a:pt x="52" y="33"/>
                      </a:lnTo>
                      <a:lnTo>
                        <a:pt x="56" y="30"/>
                      </a:lnTo>
                      <a:lnTo>
                        <a:pt x="59" y="25"/>
                      </a:lnTo>
                      <a:lnTo>
                        <a:pt x="63" y="22"/>
                      </a:lnTo>
                      <a:lnTo>
                        <a:pt x="67" y="20"/>
                      </a:lnTo>
                      <a:lnTo>
                        <a:pt x="70" y="17"/>
                      </a:lnTo>
                      <a:lnTo>
                        <a:pt x="75" y="12"/>
                      </a:lnTo>
                      <a:lnTo>
                        <a:pt x="79" y="10"/>
                      </a:lnTo>
                      <a:lnTo>
                        <a:pt x="82" y="7"/>
                      </a:lnTo>
                      <a:lnTo>
                        <a:pt x="86" y="2"/>
                      </a:lnTo>
                      <a:lnTo>
                        <a:pt x="90" y="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92" name="Freeform 176"/>
                <p:cNvSpPr/>
                <p:nvPr/>
              </p:nvSpPr>
              <p:spPr bwMode="auto">
                <a:xfrm>
                  <a:off x="4570" y="3279"/>
                  <a:ext cx="96" cy="66"/>
                </a:xfrm>
                <a:custGeom>
                  <a:avLst/>
                  <a:gdLst>
                    <a:gd name="T0" fmla="*/ 96 w 96"/>
                    <a:gd name="T1" fmla="*/ 0 h 66"/>
                    <a:gd name="T2" fmla="*/ 93 w 96"/>
                    <a:gd name="T3" fmla="*/ 1 h 66"/>
                    <a:gd name="T4" fmla="*/ 92 w 96"/>
                    <a:gd name="T5" fmla="*/ 3 h 66"/>
                    <a:gd name="T6" fmla="*/ 90 w 96"/>
                    <a:gd name="T7" fmla="*/ 4 h 66"/>
                    <a:gd name="T8" fmla="*/ 89 w 96"/>
                    <a:gd name="T9" fmla="*/ 5 h 66"/>
                    <a:gd name="T10" fmla="*/ 86 w 96"/>
                    <a:gd name="T11" fmla="*/ 7 h 66"/>
                    <a:gd name="T12" fmla="*/ 85 w 96"/>
                    <a:gd name="T13" fmla="*/ 8 h 66"/>
                    <a:gd name="T14" fmla="*/ 83 w 96"/>
                    <a:gd name="T15" fmla="*/ 10 h 66"/>
                    <a:gd name="T16" fmla="*/ 82 w 96"/>
                    <a:gd name="T17" fmla="*/ 11 h 66"/>
                    <a:gd name="T18" fmla="*/ 79 w 96"/>
                    <a:gd name="T19" fmla="*/ 13 h 66"/>
                    <a:gd name="T20" fmla="*/ 77 w 96"/>
                    <a:gd name="T21" fmla="*/ 13 h 66"/>
                    <a:gd name="T22" fmla="*/ 76 w 96"/>
                    <a:gd name="T23" fmla="*/ 14 h 66"/>
                    <a:gd name="T24" fmla="*/ 75 w 96"/>
                    <a:gd name="T25" fmla="*/ 15 h 66"/>
                    <a:gd name="T26" fmla="*/ 72 w 96"/>
                    <a:gd name="T27" fmla="*/ 17 h 66"/>
                    <a:gd name="T28" fmla="*/ 70 w 96"/>
                    <a:gd name="T29" fmla="*/ 18 h 66"/>
                    <a:gd name="T30" fmla="*/ 69 w 96"/>
                    <a:gd name="T31" fmla="*/ 20 h 66"/>
                    <a:gd name="T32" fmla="*/ 67 w 96"/>
                    <a:gd name="T33" fmla="*/ 21 h 66"/>
                    <a:gd name="T34" fmla="*/ 65 w 96"/>
                    <a:gd name="T35" fmla="*/ 23 h 66"/>
                    <a:gd name="T36" fmla="*/ 63 w 96"/>
                    <a:gd name="T37" fmla="*/ 24 h 66"/>
                    <a:gd name="T38" fmla="*/ 62 w 96"/>
                    <a:gd name="T39" fmla="*/ 26 h 66"/>
                    <a:gd name="T40" fmla="*/ 59 w 96"/>
                    <a:gd name="T41" fmla="*/ 27 h 66"/>
                    <a:gd name="T42" fmla="*/ 57 w 96"/>
                    <a:gd name="T43" fmla="*/ 27 h 66"/>
                    <a:gd name="T44" fmla="*/ 56 w 96"/>
                    <a:gd name="T45" fmla="*/ 28 h 66"/>
                    <a:gd name="T46" fmla="*/ 54 w 96"/>
                    <a:gd name="T47" fmla="*/ 30 h 66"/>
                    <a:gd name="T48" fmla="*/ 52 w 96"/>
                    <a:gd name="T49" fmla="*/ 31 h 66"/>
                    <a:gd name="T50" fmla="*/ 50 w 96"/>
                    <a:gd name="T51" fmla="*/ 33 h 66"/>
                    <a:gd name="T52" fmla="*/ 49 w 96"/>
                    <a:gd name="T53" fmla="*/ 34 h 66"/>
                    <a:gd name="T54" fmla="*/ 46 w 96"/>
                    <a:gd name="T55" fmla="*/ 36 h 66"/>
                    <a:gd name="T56" fmla="*/ 44 w 96"/>
                    <a:gd name="T57" fmla="*/ 37 h 66"/>
                    <a:gd name="T58" fmla="*/ 43 w 96"/>
                    <a:gd name="T59" fmla="*/ 38 h 66"/>
                    <a:gd name="T60" fmla="*/ 42 w 96"/>
                    <a:gd name="T61" fmla="*/ 38 h 66"/>
                    <a:gd name="T62" fmla="*/ 39 w 96"/>
                    <a:gd name="T63" fmla="*/ 40 h 66"/>
                    <a:gd name="T64" fmla="*/ 37 w 96"/>
                    <a:gd name="T65" fmla="*/ 41 h 66"/>
                    <a:gd name="T66" fmla="*/ 36 w 96"/>
                    <a:gd name="T67" fmla="*/ 43 h 66"/>
                    <a:gd name="T68" fmla="*/ 33 w 96"/>
                    <a:gd name="T69" fmla="*/ 44 h 66"/>
                    <a:gd name="T70" fmla="*/ 32 w 96"/>
                    <a:gd name="T71" fmla="*/ 46 h 66"/>
                    <a:gd name="T72" fmla="*/ 30 w 96"/>
                    <a:gd name="T73" fmla="*/ 47 h 66"/>
                    <a:gd name="T74" fmla="*/ 27 w 96"/>
                    <a:gd name="T75" fmla="*/ 47 h 66"/>
                    <a:gd name="T76" fmla="*/ 26 w 96"/>
                    <a:gd name="T77" fmla="*/ 48 h 66"/>
                    <a:gd name="T78" fmla="*/ 24 w 96"/>
                    <a:gd name="T79" fmla="*/ 50 h 66"/>
                    <a:gd name="T80" fmla="*/ 23 w 96"/>
                    <a:gd name="T81" fmla="*/ 51 h 66"/>
                    <a:gd name="T82" fmla="*/ 20 w 96"/>
                    <a:gd name="T83" fmla="*/ 53 h 66"/>
                    <a:gd name="T84" fmla="*/ 19 w 96"/>
                    <a:gd name="T85" fmla="*/ 54 h 66"/>
                    <a:gd name="T86" fmla="*/ 17 w 96"/>
                    <a:gd name="T87" fmla="*/ 56 h 66"/>
                    <a:gd name="T88" fmla="*/ 14 w 96"/>
                    <a:gd name="T89" fmla="*/ 56 h 66"/>
                    <a:gd name="T90" fmla="*/ 13 w 96"/>
                    <a:gd name="T91" fmla="*/ 57 h 66"/>
                    <a:gd name="T92" fmla="*/ 11 w 96"/>
                    <a:gd name="T93" fmla="*/ 59 h 66"/>
                    <a:gd name="T94" fmla="*/ 9 w 96"/>
                    <a:gd name="T95" fmla="*/ 60 h 66"/>
                    <a:gd name="T96" fmla="*/ 7 w 96"/>
                    <a:gd name="T97" fmla="*/ 61 h 66"/>
                    <a:gd name="T98" fmla="*/ 6 w 96"/>
                    <a:gd name="T99" fmla="*/ 63 h 66"/>
                    <a:gd name="T100" fmla="*/ 3 w 96"/>
                    <a:gd name="T101" fmla="*/ 64 h 66"/>
                    <a:gd name="T102" fmla="*/ 1 w 96"/>
                    <a:gd name="T103" fmla="*/ 64 h 66"/>
                    <a:gd name="T104" fmla="*/ 0 w 96"/>
                    <a:gd name="T105" fmla="*/ 66 h 6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  <a:cxn ang="0">
                      <a:pos x="T90" y="T91"/>
                    </a:cxn>
                    <a:cxn ang="0">
                      <a:pos x="T92" y="T93"/>
                    </a:cxn>
                    <a:cxn ang="0">
                      <a:pos x="T94" y="T95"/>
                    </a:cxn>
                    <a:cxn ang="0">
                      <a:pos x="T96" y="T97"/>
                    </a:cxn>
                    <a:cxn ang="0">
                      <a:pos x="T98" y="T99"/>
                    </a:cxn>
                    <a:cxn ang="0">
                      <a:pos x="T100" y="T101"/>
                    </a:cxn>
                    <a:cxn ang="0">
                      <a:pos x="T102" y="T103"/>
                    </a:cxn>
                    <a:cxn ang="0">
                      <a:pos x="T104" y="T105"/>
                    </a:cxn>
                  </a:cxnLst>
                  <a:rect l="0" t="0" r="r" b="b"/>
                  <a:pathLst>
                    <a:path w="96" h="66">
                      <a:moveTo>
                        <a:pt x="96" y="0"/>
                      </a:moveTo>
                      <a:lnTo>
                        <a:pt x="93" y="1"/>
                      </a:lnTo>
                      <a:lnTo>
                        <a:pt x="92" y="3"/>
                      </a:lnTo>
                      <a:lnTo>
                        <a:pt x="90" y="4"/>
                      </a:lnTo>
                      <a:lnTo>
                        <a:pt x="89" y="5"/>
                      </a:lnTo>
                      <a:lnTo>
                        <a:pt x="86" y="7"/>
                      </a:lnTo>
                      <a:lnTo>
                        <a:pt x="85" y="8"/>
                      </a:lnTo>
                      <a:lnTo>
                        <a:pt x="83" y="10"/>
                      </a:lnTo>
                      <a:lnTo>
                        <a:pt x="82" y="11"/>
                      </a:lnTo>
                      <a:lnTo>
                        <a:pt x="79" y="13"/>
                      </a:lnTo>
                      <a:lnTo>
                        <a:pt x="77" y="13"/>
                      </a:lnTo>
                      <a:lnTo>
                        <a:pt x="76" y="14"/>
                      </a:lnTo>
                      <a:lnTo>
                        <a:pt x="75" y="15"/>
                      </a:lnTo>
                      <a:lnTo>
                        <a:pt x="72" y="17"/>
                      </a:lnTo>
                      <a:lnTo>
                        <a:pt x="70" y="18"/>
                      </a:lnTo>
                      <a:lnTo>
                        <a:pt x="69" y="20"/>
                      </a:lnTo>
                      <a:lnTo>
                        <a:pt x="67" y="21"/>
                      </a:lnTo>
                      <a:lnTo>
                        <a:pt x="65" y="23"/>
                      </a:lnTo>
                      <a:lnTo>
                        <a:pt x="63" y="24"/>
                      </a:lnTo>
                      <a:lnTo>
                        <a:pt x="62" y="26"/>
                      </a:lnTo>
                      <a:lnTo>
                        <a:pt x="59" y="27"/>
                      </a:lnTo>
                      <a:lnTo>
                        <a:pt x="57" y="27"/>
                      </a:lnTo>
                      <a:lnTo>
                        <a:pt x="56" y="28"/>
                      </a:lnTo>
                      <a:lnTo>
                        <a:pt x="54" y="30"/>
                      </a:lnTo>
                      <a:lnTo>
                        <a:pt x="52" y="31"/>
                      </a:lnTo>
                      <a:lnTo>
                        <a:pt x="50" y="33"/>
                      </a:lnTo>
                      <a:lnTo>
                        <a:pt x="49" y="34"/>
                      </a:lnTo>
                      <a:lnTo>
                        <a:pt x="46" y="36"/>
                      </a:lnTo>
                      <a:lnTo>
                        <a:pt x="44" y="37"/>
                      </a:lnTo>
                      <a:lnTo>
                        <a:pt x="43" y="38"/>
                      </a:lnTo>
                      <a:lnTo>
                        <a:pt x="42" y="38"/>
                      </a:lnTo>
                      <a:lnTo>
                        <a:pt x="39" y="40"/>
                      </a:lnTo>
                      <a:lnTo>
                        <a:pt x="37" y="41"/>
                      </a:lnTo>
                      <a:lnTo>
                        <a:pt x="36" y="43"/>
                      </a:lnTo>
                      <a:lnTo>
                        <a:pt x="33" y="44"/>
                      </a:lnTo>
                      <a:lnTo>
                        <a:pt x="32" y="46"/>
                      </a:lnTo>
                      <a:lnTo>
                        <a:pt x="30" y="47"/>
                      </a:lnTo>
                      <a:lnTo>
                        <a:pt x="27" y="47"/>
                      </a:lnTo>
                      <a:lnTo>
                        <a:pt x="26" y="48"/>
                      </a:lnTo>
                      <a:lnTo>
                        <a:pt x="24" y="50"/>
                      </a:lnTo>
                      <a:lnTo>
                        <a:pt x="23" y="51"/>
                      </a:lnTo>
                      <a:lnTo>
                        <a:pt x="20" y="53"/>
                      </a:lnTo>
                      <a:lnTo>
                        <a:pt x="19" y="54"/>
                      </a:lnTo>
                      <a:lnTo>
                        <a:pt x="17" y="56"/>
                      </a:lnTo>
                      <a:lnTo>
                        <a:pt x="14" y="56"/>
                      </a:lnTo>
                      <a:lnTo>
                        <a:pt x="13" y="57"/>
                      </a:lnTo>
                      <a:lnTo>
                        <a:pt x="11" y="59"/>
                      </a:lnTo>
                      <a:lnTo>
                        <a:pt x="9" y="60"/>
                      </a:lnTo>
                      <a:lnTo>
                        <a:pt x="7" y="61"/>
                      </a:lnTo>
                      <a:lnTo>
                        <a:pt x="6" y="63"/>
                      </a:lnTo>
                      <a:lnTo>
                        <a:pt x="3" y="64"/>
                      </a:lnTo>
                      <a:lnTo>
                        <a:pt x="1" y="64"/>
                      </a:lnTo>
                      <a:lnTo>
                        <a:pt x="0" y="66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94" name="Line 178"/>
                <p:cNvSpPr>
                  <a:spLocks noChangeShapeType="1"/>
                </p:cNvSpPr>
                <p:nvPr/>
              </p:nvSpPr>
              <p:spPr bwMode="auto">
                <a:xfrm>
                  <a:off x="4626" y="3226"/>
                  <a:ext cx="39" cy="50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95" name="Rectangle 179"/>
                <p:cNvSpPr>
                  <a:spLocks noChangeArrowheads="1"/>
                </p:cNvSpPr>
                <p:nvPr/>
              </p:nvSpPr>
              <p:spPr bwMode="auto">
                <a:xfrm rot="3720000">
                  <a:off x="4566" y="3838"/>
                  <a:ext cx="299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AL-A10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96" name="Line 180"/>
                <p:cNvSpPr>
                  <a:spLocks noChangeShapeType="1"/>
                </p:cNvSpPr>
                <p:nvPr/>
              </p:nvSpPr>
              <p:spPr bwMode="auto">
                <a:xfrm>
                  <a:off x="4431" y="3348"/>
                  <a:ext cx="155" cy="301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97" name="Freeform 181"/>
                <p:cNvSpPr/>
                <p:nvPr/>
              </p:nvSpPr>
              <p:spPr bwMode="auto">
                <a:xfrm>
                  <a:off x="4530" y="3224"/>
                  <a:ext cx="94" cy="65"/>
                </a:xfrm>
                <a:custGeom>
                  <a:avLst/>
                  <a:gdLst>
                    <a:gd name="T0" fmla="*/ 0 w 94"/>
                    <a:gd name="T1" fmla="*/ 65 h 65"/>
                    <a:gd name="T2" fmla="*/ 4 w 94"/>
                    <a:gd name="T3" fmla="*/ 62 h 65"/>
                    <a:gd name="T4" fmla="*/ 8 w 94"/>
                    <a:gd name="T5" fmla="*/ 59 h 65"/>
                    <a:gd name="T6" fmla="*/ 13 w 94"/>
                    <a:gd name="T7" fmla="*/ 56 h 65"/>
                    <a:gd name="T8" fmla="*/ 17 w 94"/>
                    <a:gd name="T9" fmla="*/ 53 h 65"/>
                    <a:gd name="T10" fmla="*/ 21 w 94"/>
                    <a:gd name="T11" fmla="*/ 52 h 65"/>
                    <a:gd name="T12" fmla="*/ 26 w 94"/>
                    <a:gd name="T13" fmla="*/ 49 h 65"/>
                    <a:gd name="T14" fmla="*/ 29 w 94"/>
                    <a:gd name="T15" fmla="*/ 46 h 65"/>
                    <a:gd name="T16" fmla="*/ 33 w 94"/>
                    <a:gd name="T17" fmla="*/ 43 h 65"/>
                    <a:gd name="T18" fmla="*/ 37 w 94"/>
                    <a:gd name="T19" fmla="*/ 40 h 65"/>
                    <a:gd name="T20" fmla="*/ 41 w 94"/>
                    <a:gd name="T21" fmla="*/ 37 h 65"/>
                    <a:gd name="T22" fmla="*/ 46 w 94"/>
                    <a:gd name="T23" fmla="*/ 35 h 65"/>
                    <a:gd name="T24" fmla="*/ 50 w 94"/>
                    <a:gd name="T25" fmla="*/ 32 h 65"/>
                    <a:gd name="T26" fmla="*/ 54 w 94"/>
                    <a:gd name="T27" fmla="*/ 29 h 65"/>
                    <a:gd name="T28" fmla="*/ 59 w 94"/>
                    <a:gd name="T29" fmla="*/ 26 h 65"/>
                    <a:gd name="T30" fmla="*/ 61 w 94"/>
                    <a:gd name="T31" fmla="*/ 23 h 65"/>
                    <a:gd name="T32" fmla="*/ 66 w 94"/>
                    <a:gd name="T33" fmla="*/ 20 h 65"/>
                    <a:gd name="T34" fmla="*/ 70 w 94"/>
                    <a:gd name="T35" fmla="*/ 17 h 65"/>
                    <a:gd name="T36" fmla="*/ 74 w 94"/>
                    <a:gd name="T37" fmla="*/ 15 h 65"/>
                    <a:gd name="T38" fmla="*/ 79 w 94"/>
                    <a:gd name="T39" fmla="*/ 12 h 65"/>
                    <a:gd name="T40" fmla="*/ 83 w 94"/>
                    <a:gd name="T41" fmla="*/ 9 h 65"/>
                    <a:gd name="T42" fmla="*/ 86 w 94"/>
                    <a:gd name="T43" fmla="*/ 6 h 65"/>
                    <a:gd name="T44" fmla="*/ 90 w 94"/>
                    <a:gd name="T45" fmla="*/ 3 h 65"/>
                    <a:gd name="T46" fmla="*/ 94 w 94"/>
                    <a:gd name="T47" fmla="*/ 0 h 6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</a:cxnLst>
                  <a:rect l="0" t="0" r="r" b="b"/>
                  <a:pathLst>
                    <a:path w="94" h="65">
                      <a:moveTo>
                        <a:pt x="0" y="65"/>
                      </a:moveTo>
                      <a:lnTo>
                        <a:pt x="4" y="62"/>
                      </a:lnTo>
                      <a:lnTo>
                        <a:pt x="8" y="59"/>
                      </a:lnTo>
                      <a:lnTo>
                        <a:pt x="13" y="56"/>
                      </a:lnTo>
                      <a:lnTo>
                        <a:pt x="17" y="53"/>
                      </a:lnTo>
                      <a:lnTo>
                        <a:pt x="21" y="52"/>
                      </a:lnTo>
                      <a:lnTo>
                        <a:pt x="26" y="49"/>
                      </a:lnTo>
                      <a:lnTo>
                        <a:pt x="29" y="46"/>
                      </a:lnTo>
                      <a:lnTo>
                        <a:pt x="33" y="43"/>
                      </a:lnTo>
                      <a:lnTo>
                        <a:pt x="37" y="40"/>
                      </a:lnTo>
                      <a:lnTo>
                        <a:pt x="41" y="37"/>
                      </a:lnTo>
                      <a:lnTo>
                        <a:pt x="46" y="35"/>
                      </a:lnTo>
                      <a:lnTo>
                        <a:pt x="50" y="32"/>
                      </a:lnTo>
                      <a:lnTo>
                        <a:pt x="54" y="29"/>
                      </a:lnTo>
                      <a:lnTo>
                        <a:pt x="59" y="26"/>
                      </a:lnTo>
                      <a:lnTo>
                        <a:pt x="61" y="23"/>
                      </a:lnTo>
                      <a:lnTo>
                        <a:pt x="66" y="20"/>
                      </a:lnTo>
                      <a:lnTo>
                        <a:pt x="70" y="17"/>
                      </a:lnTo>
                      <a:lnTo>
                        <a:pt x="74" y="15"/>
                      </a:lnTo>
                      <a:lnTo>
                        <a:pt x="79" y="12"/>
                      </a:lnTo>
                      <a:lnTo>
                        <a:pt x="83" y="9"/>
                      </a:lnTo>
                      <a:lnTo>
                        <a:pt x="86" y="6"/>
                      </a:lnTo>
                      <a:lnTo>
                        <a:pt x="90" y="3"/>
                      </a:lnTo>
                      <a:lnTo>
                        <a:pt x="94" y="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98" name="Freeform 182"/>
                <p:cNvSpPr/>
                <p:nvPr/>
              </p:nvSpPr>
              <p:spPr bwMode="auto">
                <a:xfrm>
                  <a:off x="4431" y="3289"/>
                  <a:ext cx="99" cy="56"/>
                </a:xfrm>
                <a:custGeom>
                  <a:avLst/>
                  <a:gdLst>
                    <a:gd name="T0" fmla="*/ 97 w 99"/>
                    <a:gd name="T1" fmla="*/ 1 h 56"/>
                    <a:gd name="T2" fmla="*/ 95 w 99"/>
                    <a:gd name="T3" fmla="*/ 3 h 56"/>
                    <a:gd name="T4" fmla="*/ 92 w 99"/>
                    <a:gd name="T5" fmla="*/ 4 h 56"/>
                    <a:gd name="T6" fmla="*/ 87 w 99"/>
                    <a:gd name="T7" fmla="*/ 7 h 56"/>
                    <a:gd name="T8" fmla="*/ 84 w 99"/>
                    <a:gd name="T9" fmla="*/ 8 h 56"/>
                    <a:gd name="T10" fmla="*/ 82 w 99"/>
                    <a:gd name="T11" fmla="*/ 10 h 56"/>
                    <a:gd name="T12" fmla="*/ 79 w 99"/>
                    <a:gd name="T13" fmla="*/ 13 h 56"/>
                    <a:gd name="T14" fmla="*/ 76 w 99"/>
                    <a:gd name="T15" fmla="*/ 14 h 56"/>
                    <a:gd name="T16" fmla="*/ 73 w 99"/>
                    <a:gd name="T17" fmla="*/ 16 h 56"/>
                    <a:gd name="T18" fmla="*/ 69 w 99"/>
                    <a:gd name="T19" fmla="*/ 17 h 56"/>
                    <a:gd name="T20" fmla="*/ 66 w 99"/>
                    <a:gd name="T21" fmla="*/ 20 h 56"/>
                    <a:gd name="T22" fmla="*/ 63 w 99"/>
                    <a:gd name="T23" fmla="*/ 21 h 56"/>
                    <a:gd name="T24" fmla="*/ 60 w 99"/>
                    <a:gd name="T25" fmla="*/ 23 h 56"/>
                    <a:gd name="T26" fmla="*/ 57 w 99"/>
                    <a:gd name="T27" fmla="*/ 26 h 56"/>
                    <a:gd name="T28" fmla="*/ 53 w 99"/>
                    <a:gd name="T29" fmla="*/ 27 h 56"/>
                    <a:gd name="T30" fmla="*/ 50 w 99"/>
                    <a:gd name="T31" fmla="*/ 28 h 56"/>
                    <a:gd name="T32" fmla="*/ 47 w 99"/>
                    <a:gd name="T33" fmla="*/ 30 h 56"/>
                    <a:gd name="T34" fmla="*/ 44 w 99"/>
                    <a:gd name="T35" fmla="*/ 33 h 56"/>
                    <a:gd name="T36" fmla="*/ 41 w 99"/>
                    <a:gd name="T37" fmla="*/ 34 h 56"/>
                    <a:gd name="T38" fmla="*/ 37 w 99"/>
                    <a:gd name="T39" fmla="*/ 36 h 56"/>
                    <a:gd name="T40" fmla="*/ 34 w 99"/>
                    <a:gd name="T41" fmla="*/ 37 h 56"/>
                    <a:gd name="T42" fmla="*/ 31 w 99"/>
                    <a:gd name="T43" fmla="*/ 40 h 56"/>
                    <a:gd name="T44" fmla="*/ 29 w 99"/>
                    <a:gd name="T45" fmla="*/ 41 h 56"/>
                    <a:gd name="T46" fmla="*/ 24 w 99"/>
                    <a:gd name="T47" fmla="*/ 43 h 56"/>
                    <a:gd name="T48" fmla="*/ 21 w 99"/>
                    <a:gd name="T49" fmla="*/ 44 h 56"/>
                    <a:gd name="T50" fmla="*/ 19 w 99"/>
                    <a:gd name="T51" fmla="*/ 46 h 56"/>
                    <a:gd name="T52" fmla="*/ 16 w 99"/>
                    <a:gd name="T53" fmla="*/ 49 h 56"/>
                    <a:gd name="T54" fmla="*/ 13 w 99"/>
                    <a:gd name="T55" fmla="*/ 50 h 56"/>
                    <a:gd name="T56" fmla="*/ 8 w 99"/>
                    <a:gd name="T57" fmla="*/ 51 h 56"/>
                    <a:gd name="T58" fmla="*/ 6 w 99"/>
                    <a:gd name="T59" fmla="*/ 53 h 56"/>
                    <a:gd name="T60" fmla="*/ 3 w 99"/>
                    <a:gd name="T61" fmla="*/ 54 h 56"/>
                    <a:gd name="T62" fmla="*/ 0 w 99"/>
                    <a:gd name="T63" fmla="*/ 56 h 5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</a:cxnLst>
                  <a:rect l="0" t="0" r="r" b="b"/>
                  <a:pathLst>
                    <a:path w="99" h="56">
                      <a:moveTo>
                        <a:pt x="99" y="0"/>
                      </a:moveTo>
                      <a:lnTo>
                        <a:pt x="97" y="1"/>
                      </a:lnTo>
                      <a:lnTo>
                        <a:pt x="96" y="1"/>
                      </a:lnTo>
                      <a:lnTo>
                        <a:pt x="95" y="3"/>
                      </a:lnTo>
                      <a:lnTo>
                        <a:pt x="93" y="4"/>
                      </a:lnTo>
                      <a:lnTo>
                        <a:pt x="92" y="4"/>
                      </a:lnTo>
                      <a:lnTo>
                        <a:pt x="90" y="5"/>
                      </a:lnTo>
                      <a:lnTo>
                        <a:pt x="87" y="7"/>
                      </a:lnTo>
                      <a:lnTo>
                        <a:pt x="86" y="7"/>
                      </a:lnTo>
                      <a:lnTo>
                        <a:pt x="84" y="8"/>
                      </a:lnTo>
                      <a:lnTo>
                        <a:pt x="83" y="10"/>
                      </a:lnTo>
                      <a:lnTo>
                        <a:pt x="82" y="10"/>
                      </a:lnTo>
                      <a:lnTo>
                        <a:pt x="80" y="11"/>
                      </a:lnTo>
                      <a:lnTo>
                        <a:pt x="79" y="13"/>
                      </a:lnTo>
                      <a:lnTo>
                        <a:pt x="77" y="13"/>
                      </a:lnTo>
                      <a:lnTo>
                        <a:pt x="76" y="14"/>
                      </a:lnTo>
                      <a:lnTo>
                        <a:pt x="74" y="16"/>
                      </a:lnTo>
                      <a:lnTo>
                        <a:pt x="73" y="16"/>
                      </a:lnTo>
                      <a:lnTo>
                        <a:pt x="70" y="17"/>
                      </a:lnTo>
                      <a:lnTo>
                        <a:pt x="69" y="17"/>
                      </a:lnTo>
                      <a:lnTo>
                        <a:pt x="67" y="18"/>
                      </a:lnTo>
                      <a:lnTo>
                        <a:pt x="66" y="20"/>
                      </a:lnTo>
                      <a:lnTo>
                        <a:pt x="64" y="20"/>
                      </a:lnTo>
                      <a:lnTo>
                        <a:pt x="63" y="21"/>
                      </a:lnTo>
                      <a:lnTo>
                        <a:pt x="62" y="23"/>
                      </a:lnTo>
                      <a:lnTo>
                        <a:pt x="60" y="23"/>
                      </a:lnTo>
                      <a:lnTo>
                        <a:pt x="59" y="24"/>
                      </a:lnTo>
                      <a:lnTo>
                        <a:pt x="57" y="26"/>
                      </a:lnTo>
                      <a:lnTo>
                        <a:pt x="56" y="26"/>
                      </a:lnTo>
                      <a:lnTo>
                        <a:pt x="53" y="27"/>
                      </a:lnTo>
                      <a:lnTo>
                        <a:pt x="51" y="27"/>
                      </a:lnTo>
                      <a:lnTo>
                        <a:pt x="50" y="28"/>
                      </a:lnTo>
                      <a:lnTo>
                        <a:pt x="49" y="30"/>
                      </a:lnTo>
                      <a:lnTo>
                        <a:pt x="47" y="30"/>
                      </a:lnTo>
                      <a:lnTo>
                        <a:pt x="46" y="31"/>
                      </a:lnTo>
                      <a:lnTo>
                        <a:pt x="44" y="33"/>
                      </a:lnTo>
                      <a:lnTo>
                        <a:pt x="43" y="33"/>
                      </a:lnTo>
                      <a:lnTo>
                        <a:pt x="41" y="34"/>
                      </a:lnTo>
                      <a:lnTo>
                        <a:pt x="39" y="34"/>
                      </a:lnTo>
                      <a:lnTo>
                        <a:pt x="37" y="36"/>
                      </a:lnTo>
                      <a:lnTo>
                        <a:pt x="36" y="37"/>
                      </a:lnTo>
                      <a:lnTo>
                        <a:pt x="34" y="37"/>
                      </a:lnTo>
                      <a:lnTo>
                        <a:pt x="33" y="38"/>
                      </a:lnTo>
                      <a:lnTo>
                        <a:pt x="31" y="40"/>
                      </a:lnTo>
                      <a:lnTo>
                        <a:pt x="30" y="40"/>
                      </a:lnTo>
                      <a:lnTo>
                        <a:pt x="29" y="41"/>
                      </a:lnTo>
                      <a:lnTo>
                        <a:pt x="27" y="41"/>
                      </a:lnTo>
                      <a:lnTo>
                        <a:pt x="24" y="43"/>
                      </a:lnTo>
                      <a:lnTo>
                        <a:pt x="23" y="44"/>
                      </a:lnTo>
                      <a:lnTo>
                        <a:pt x="21" y="44"/>
                      </a:lnTo>
                      <a:lnTo>
                        <a:pt x="20" y="46"/>
                      </a:lnTo>
                      <a:lnTo>
                        <a:pt x="19" y="46"/>
                      </a:lnTo>
                      <a:lnTo>
                        <a:pt x="17" y="47"/>
                      </a:lnTo>
                      <a:lnTo>
                        <a:pt x="16" y="49"/>
                      </a:lnTo>
                      <a:lnTo>
                        <a:pt x="14" y="49"/>
                      </a:lnTo>
                      <a:lnTo>
                        <a:pt x="13" y="50"/>
                      </a:lnTo>
                      <a:lnTo>
                        <a:pt x="10" y="50"/>
                      </a:lnTo>
                      <a:lnTo>
                        <a:pt x="8" y="51"/>
                      </a:lnTo>
                      <a:lnTo>
                        <a:pt x="7" y="53"/>
                      </a:lnTo>
                      <a:lnTo>
                        <a:pt x="6" y="53"/>
                      </a:lnTo>
                      <a:lnTo>
                        <a:pt x="4" y="54"/>
                      </a:lnTo>
                      <a:lnTo>
                        <a:pt x="3" y="54"/>
                      </a:lnTo>
                      <a:lnTo>
                        <a:pt x="1" y="56"/>
                      </a:lnTo>
                      <a:lnTo>
                        <a:pt x="0" y="56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00" name="Line 184"/>
                <p:cNvSpPr>
                  <a:spLocks noChangeShapeType="1"/>
                </p:cNvSpPr>
                <p:nvPr/>
              </p:nvSpPr>
              <p:spPr bwMode="auto">
                <a:xfrm>
                  <a:off x="4495" y="3233"/>
                  <a:ext cx="33" cy="53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01" name="Rectangle 185"/>
                <p:cNvSpPr>
                  <a:spLocks noChangeArrowheads="1"/>
                </p:cNvSpPr>
                <p:nvPr/>
              </p:nvSpPr>
              <p:spPr bwMode="auto">
                <a:xfrm rot="4020000">
                  <a:off x="4428" y="3887"/>
                  <a:ext cx="246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L-A10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02" name="Line 186"/>
                <p:cNvSpPr>
                  <a:spLocks noChangeShapeType="1"/>
                </p:cNvSpPr>
                <p:nvPr/>
              </p:nvSpPr>
              <p:spPr bwMode="auto">
                <a:xfrm>
                  <a:off x="4298" y="3333"/>
                  <a:ext cx="154" cy="378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03" name="Freeform 187"/>
                <p:cNvSpPr/>
                <p:nvPr/>
              </p:nvSpPr>
              <p:spPr bwMode="auto">
                <a:xfrm>
                  <a:off x="4396" y="3230"/>
                  <a:ext cx="98" cy="54"/>
                </a:xfrm>
                <a:custGeom>
                  <a:avLst/>
                  <a:gdLst>
                    <a:gd name="T0" fmla="*/ 0 w 98"/>
                    <a:gd name="T1" fmla="*/ 54 h 54"/>
                    <a:gd name="T2" fmla="*/ 5 w 98"/>
                    <a:gd name="T3" fmla="*/ 53 h 54"/>
                    <a:gd name="T4" fmla="*/ 9 w 98"/>
                    <a:gd name="T5" fmla="*/ 50 h 54"/>
                    <a:gd name="T6" fmla="*/ 13 w 98"/>
                    <a:gd name="T7" fmla="*/ 49 h 54"/>
                    <a:gd name="T8" fmla="*/ 18 w 98"/>
                    <a:gd name="T9" fmla="*/ 46 h 54"/>
                    <a:gd name="T10" fmla="*/ 22 w 98"/>
                    <a:gd name="T11" fmla="*/ 44 h 54"/>
                    <a:gd name="T12" fmla="*/ 26 w 98"/>
                    <a:gd name="T13" fmla="*/ 42 h 54"/>
                    <a:gd name="T14" fmla="*/ 31 w 98"/>
                    <a:gd name="T15" fmla="*/ 39 h 54"/>
                    <a:gd name="T16" fmla="*/ 35 w 98"/>
                    <a:gd name="T17" fmla="*/ 37 h 54"/>
                    <a:gd name="T18" fmla="*/ 39 w 98"/>
                    <a:gd name="T19" fmla="*/ 34 h 54"/>
                    <a:gd name="T20" fmla="*/ 43 w 98"/>
                    <a:gd name="T21" fmla="*/ 31 h 54"/>
                    <a:gd name="T22" fmla="*/ 48 w 98"/>
                    <a:gd name="T23" fmla="*/ 30 h 54"/>
                    <a:gd name="T24" fmla="*/ 52 w 98"/>
                    <a:gd name="T25" fmla="*/ 27 h 54"/>
                    <a:gd name="T26" fmla="*/ 56 w 98"/>
                    <a:gd name="T27" fmla="*/ 26 h 54"/>
                    <a:gd name="T28" fmla="*/ 61 w 98"/>
                    <a:gd name="T29" fmla="*/ 23 h 54"/>
                    <a:gd name="T30" fmla="*/ 65 w 98"/>
                    <a:gd name="T31" fmla="*/ 20 h 54"/>
                    <a:gd name="T32" fmla="*/ 68 w 98"/>
                    <a:gd name="T33" fmla="*/ 17 h 54"/>
                    <a:gd name="T34" fmla="*/ 72 w 98"/>
                    <a:gd name="T35" fmla="*/ 16 h 54"/>
                    <a:gd name="T36" fmla="*/ 76 w 98"/>
                    <a:gd name="T37" fmla="*/ 13 h 54"/>
                    <a:gd name="T38" fmla="*/ 81 w 98"/>
                    <a:gd name="T39" fmla="*/ 10 h 54"/>
                    <a:gd name="T40" fmla="*/ 85 w 98"/>
                    <a:gd name="T41" fmla="*/ 9 h 54"/>
                    <a:gd name="T42" fmla="*/ 89 w 98"/>
                    <a:gd name="T43" fmla="*/ 6 h 54"/>
                    <a:gd name="T44" fmla="*/ 94 w 98"/>
                    <a:gd name="T45" fmla="*/ 3 h 54"/>
                    <a:gd name="T46" fmla="*/ 98 w 98"/>
                    <a:gd name="T47" fmla="*/ 0 h 5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</a:cxnLst>
                  <a:rect l="0" t="0" r="r" b="b"/>
                  <a:pathLst>
                    <a:path w="98" h="54">
                      <a:moveTo>
                        <a:pt x="0" y="54"/>
                      </a:moveTo>
                      <a:lnTo>
                        <a:pt x="5" y="53"/>
                      </a:lnTo>
                      <a:lnTo>
                        <a:pt x="9" y="50"/>
                      </a:lnTo>
                      <a:lnTo>
                        <a:pt x="13" y="49"/>
                      </a:lnTo>
                      <a:lnTo>
                        <a:pt x="18" y="46"/>
                      </a:lnTo>
                      <a:lnTo>
                        <a:pt x="22" y="44"/>
                      </a:lnTo>
                      <a:lnTo>
                        <a:pt x="26" y="42"/>
                      </a:lnTo>
                      <a:lnTo>
                        <a:pt x="31" y="39"/>
                      </a:lnTo>
                      <a:lnTo>
                        <a:pt x="35" y="37"/>
                      </a:lnTo>
                      <a:lnTo>
                        <a:pt x="39" y="34"/>
                      </a:lnTo>
                      <a:lnTo>
                        <a:pt x="43" y="31"/>
                      </a:lnTo>
                      <a:lnTo>
                        <a:pt x="48" y="30"/>
                      </a:lnTo>
                      <a:lnTo>
                        <a:pt x="52" y="27"/>
                      </a:lnTo>
                      <a:lnTo>
                        <a:pt x="56" y="26"/>
                      </a:lnTo>
                      <a:lnTo>
                        <a:pt x="61" y="23"/>
                      </a:lnTo>
                      <a:lnTo>
                        <a:pt x="65" y="20"/>
                      </a:lnTo>
                      <a:lnTo>
                        <a:pt x="68" y="17"/>
                      </a:lnTo>
                      <a:lnTo>
                        <a:pt x="72" y="16"/>
                      </a:lnTo>
                      <a:lnTo>
                        <a:pt x="76" y="13"/>
                      </a:lnTo>
                      <a:lnTo>
                        <a:pt x="81" y="10"/>
                      </a:lnTo>
                      <a:lnTo>
                        <a:pt x="85" y="9"/>
                      </a:lnTo>
                      <a:lnTo>
                        <a:pt x="89" y="6"/>
                      </a:lnTo>
                      <a:lnTo>
                        <a:pt x="94" y="3"/>
                      </a:lnTo>
                      <a:lnTo>
                        <a:pt x="98" y="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04" name="Freeform 188"/>
                <p:cNvSpPr/>
                <p:nvPr/>
              </p:nvSpPr>
              <p:spPr bwMode="auto">
                <a:xfrm>
                  <a:off x="4296" y="3284"/>
                  <a:ext cx="100" cy="48"/>
                </a:xfrm>
                <a:custGeom>
                  <a:avLst/>
                  <a:gdLst>
                    <a:gd name="T0" fmla="*/ 100 w 100"/>
                    <a:gd name="T1" fmla="*/ 2 h 48"/>
                    <a:gd name="T2" fmla="*/ 98 w 100"/>
                    <a:gd name="T3" fmla="*/ 3 h 48"/>
                    <a:gd name="T4" fmla="*/ 95 w 100"/>
                    <a:gd name="T5" fmla="*/ 5 h 48"/>
                    <a:gd name="T6" fmla="*/ 92 w 100"/>
                    <a:gd name="T7" fmla="*/ 6 h 48"/>
                    <a:gd name="T8" fmla="*/ 89 w 100"/>
                    <a:gd name="T9" fmla="*/ 8 h 48"/>
                    <a:gd name="T10" fmla="*/ 86 w 100"/>
                    <a:gd name="T11" fmla="*/ 9 h 48"/>
                    <a:gd name="T12" fmla="*/ 83 w 100"/>
                    <a:gd name="T13" fmla="*/ 9 h 48"/>
                    <a:gd name="T14" fmla="*/ 80 w 100"/>
                    <a:gd name="T15" fmla="*/ 10 h 48"/>
                    <a:gd name="T16" fmla="*/ 79 w 100"/>
                    <a:gd name="T17" fmla="*/ 12 h 48"/>
                    <a:gd name="T18" fmla="*/ 76 w 100"/>
                    <a:gd name="T19" fmla="*/ 13 h 48"/>
                    <a:gd name="T20" fmla="*/ 73 w 100"/>
                    <a:gd name="T21" fmla="*/ 15 h 48"/>
                    <a:gd name="T22" fmla="*/ 70 w 100"/>
                    <a:gd name="T23" fmla="*/ 16 h 48"/>
                    <a:gd name="T24" fmla="*/ 67 w 100"/>
                    <a:gd name="T25" fmla="*/ 18 h 48"/>
                    <a:gd name="T26" fmla="*/ 65 w 100"/>
                    <a:gd name="T27" fmla="*/ 19 h 48"/>
                    <a:gd name="T28" fmla="*/ 62 w 100"/>
                    <a:gd name="T29" fmla="*/ 21 h 48"/>
                    <a:gd name="T30" fmla="*/ 59 w 100"/>
                    <a:gd name="T31" fmla="*/ 22 h 48"/>
                    <a:gd name="T32" fmla="*/ 57 w 100"/>
                    <a:gd name="T33" fmla="*/ 23 h 48"/>
                    <a:gd name="T34" fmla="*/ 55 w 100"/>
                    <a:gd name="T35" fmla="*/ 23 h 48"/>
                    <a:gd name="T36" fmla="*/ 52 w 100"/>
                    <a:gd name="T37" fmla="*/ 25 h 48"/>
                    <a:gd name="T38" fmla="*/ 49 w 100"/>
                    <a:gd name="T39" fmla="*/ 26 h 48"/>
                    <a:gd name="T40" fmla="*/ 46 w 100"/>
                    <a:gd name="T41" fmla="*/ 28 h 48"/>
                    <a:gd name="T42" fmla="*/ 43 w 100"/>
                    <a:gd name="T43" fmla="*/ 29 h 48"/>
                    <a:gd name="T44" fmla="*/ 40 w 100"/>
                    <a:gd name="T45" fmla="*/ 31 h 48"/>
                    <a:gd name="T46" fmla="*/ 37 w 100"/>
                    <a:gd name="T47" fmla="*/ 32 h 48"/>
                    <a:gd name="T48" fmla="*/ 34 w 100"/>
                    <a:gd name="T49" fmla="*/ 32 h 48"/>
                    <a:gd name="T50" fmla="*/ 32 w 100"/>
                    <a:gd name="T51" fmla="*/ 33 h 48"/>
                    <a:gd name="T52" fmla="*/ 30 w 100"/>
                    <a:gd name="T53" fmla="*/ 35 h 48"/>
                    <a:gd name="T54" fmla="*/ 27 w 100"/>
                    <a:gd name="T55" fmla="*/ 36 h 48"/>
                    <a:gd name="T56" fmla="*/ 24 w 100"/>
                    <a:gd name="T57" fmla="*/ 38 h 48"/>
                    <a:gd name="T58" fmla="*/ 22 w 100"/>
                    <a:gd name="T59" fmla="*/ 39 h 48"/>
                    <a:gd name="T60" fmla="*/ 19 w 100"/>
                    <a:gd name="T61" fmla="*/ 39 h 48"/>
                    <a:gd name="T62" fmla="*/ 16 w 100"/>
                    <a:gd name="T63" fmla="*/ 41 h 48"/>
                    <a:gd name="T64" fmla="*/ 13 w 100"/>
                    <a:gd name="T65" fmla="*/ 42 h 48"/>
                    <a:gd name="T66" fmla="*/ 10 w 100"/>
                    <a:gd name="T67" fmla="*/ 43 h 48"/>
                    <a:gd name="T68" fmla="*/ 7 w 100"/>
                    <a:gd name="T69" fmla="*/ 45 h 48"/>
                    <a:gd name="T70" fmla="*/ 4 w 100"/>
                    <a:gd name="T71" fmla="*/ 45 h 48"/>
                    <a:gd name="T72" fmla="*/ 2 w 100"/>
                    <a:gd name="T73" fmla="*/ 46 h 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</a:cxnLst>
                  <a:rect l="0" t="0" r="r" b="b"/>
                  <a:pathLst>
                    <a:path w="100" h="48">
                      <a:moveTo>
                        <a:pt x="100" y="0"/>
                      </a:moveTo>
                      <a:lnTo>
                        <a:pt x="100" y="2"/>
                      </a:lnTo>
                      <a:lnTo>
                        <a:pt x="99" y="2"/>
                      </a:lnTo>
                      <a:lnTo>
                        <a:pt x="98" y="3"/>
                      </a:lnTo>
                      <a:lnTo>
                        <a:pt x="96" y="3"/>
                      </a:lnTo>
                      <a:lnTo>
                        <a:pt x="95" y="5"/>
                      </a:lnTo>
                      <a:lnTo>
                        <a:pt x="93" y="5"/>
                      </a:lnTo>
                      <a:lnTo>
                        <a:pt x="92" y="6"/>
                      </a:lnTo>
                      <a:lnTo>
                        <a:pt x="90" y="6"/>
                      </a:lnTo>
                      <a:lnTo>
                        <a:pt x="89" y="8"/>
                      </a:lnTo>
                      <a:lnTo>
                        <a:pt x="88" y="8"/>
                      </a:lnTo>
                      <a:lnTo>
                        <a:pt x="86" y="9"/>
                      </a:lnTo>
                      <a:lnTo>
                        <a:pt x="85" y="9"/>
                      </a:lnTo>
                      <a:lnTo>
                        <a:pt x="83" y="9"/>
                      </a:lnTo>
                      <a:lnTo>
                        <a:pt x="82" y="10"/>
                      </a:lnTo>
                      <a:lnTo>
                        <a:pt x="80" y="10"/>
                      </a:lnTo>
                      <a:lnTo>
                        <a:pt x="80" y="12"/>
                      </a:lnTo>
                      <a:lnTo>
                        <a:pt x="79" y="12"/>
                      </a:lnTo>
                      <a:lnTo>
                        <a:pt x="78" y="13"/>
                      </a:lnTo>
                      <a:lnTo>
                        <a:pt x="76" y="13"/>
                      </a:lnTo>
                      <a:lnTo>
                        <a:pt x="75" y="15"/>
                      </a:lnTo>
                      <a:lnTo>
                        <a:pt x="73" y="15"/>
                      </a:lnTo>
                      <a:lnTo>
                        <a:pt x="72" y="16"/>
                      </a:lnTo>
                      <a:lnTo>
                        <a:pt x="70" y="16"/>
                      </a:lnTo>
                      <a:lnTo>
                        <a:pt x="69" y="16"/>
                      </a:lnTo>
                      <a:lnTo>
                        <a:pt x="67" y="18"/>
                      </a:lnTo>
                      <a:lnTo>
                        <a:pt x="66" y="18"/>
                      </a:lnTo>
                      <a:lnTo>
                        <a:pt x="65" y="19"/>
                      </a:lnTo>
                      <a:lnTo>
                        <a:pt x="63" y="19"/>
                      </a:lnTo>
                      <a:lnTo>
                        <a:pt x="62" y="21"/>
                      </a:lnTo>
                      <a:lnTo>
                        <a:pt x="60" y="21"/>
                      </a:lnTo>
                      <a:lnTo>
                        <a:pt x="59" y="22"/>
                      </a:lnTo>
                      <a:lnTo>
                        <a:pt x="57" y="22"/>
                      </a:lnTo>
                      <a:lnTo>
                        <a:pt x="57" y="23"/>
                      </a:lnTo>
                      <a:lnTo>
                        <a:pt x="56" y="23"/>
                      </a:lnTo>
                      <a:lnTo>
                        <a:pt x="55" y="23"/>
                      </a:lnTo>
                      <a:lnTo>
                        <a:pt x="53" y="25"/>
                      </a:lnTo>
                      <a:lnTo>
                        <a:pt x="52" y="25"/>
                      </a:lnTo>
                      <a:lnTo>
                        <a:pt x="50" y="26"/>
                      </a:lnTo>
                      <a:lnTo>
                        <a:pt x="49" y="26"/>
                      </a:lnTo>
                      <a:lnTo>
                        <a:pt x="47" y="28"/>
                      </a:lnTo>
                      <a:lnTo>
                        <a:pt x="46" y="28"/>
                      </a:lnTo>
                      <a:lnTo>
                        <a:pt x="45" y="28"/>
                      </a:lnTo>
                      <a:lnTo>
                        <a:pt x="43" y="29"/>
                      </a:lnTo>
                      <a:lnTo>
                        <a:pt x="42" y="29"/>
                      </a:lnTo>
                      <a:lnTo>
                        <a:pt x="40" y="31"/>
                      </a:lnTo>
                      <a:lnTo>
                        <a:pt x="39" y="31"/>
                      </a:lnTo>
                      <a:lnTo>
                        <a:pt x="37" y="32"/>
                      </a:lnTo>
                      <a:lnTo>
                        <a:pt x="36" y="32"/>
                      </a:lnTo>
                      <a:lnTo>
                        <a:pt x="34" y="32"/>
                      </a:lnTo>
                      <a:lnTo>
                        <a:pt x="33" y="33"/>
                      </a:lnTo>
                      <a:lnTo>
                        <a:pt x="32" y="33"/>
                      </a:lnTo>
                      <a:lnTo>
                        <a:pt x="30" y="35"/>
                      </a:lnTo>
                      <a:lnTo>
                        <a:pt x="30" y="35"/>
                      </a:lnTo>
                      <a:lnTo>
                        <a:pt x="29" y="36"/>
                      </a:lnTo>
                      <a:lnTo>
                        <a:pt x="27" y="36"/>
                      </a:lnTo>
                      <a:lnTo>
                        <a:pt x="26" y="36"/>
                      </a:lnTo>
                      <a:lnTo>
                        <a:pt x="24" y="38"/>
                      </a:lnTo>
                      <a:lnTo>
                        <a:pt x="23" y="38"/>
                      </a:lnTo>
                      <a:lnTo>
                        <a:pt x="22" y="39"/>
                      </a:lnTo>
                      <a:lnTo>
                        <a:pt x="20" y="39"/>
                      </a:lnTo>
                      <a:lnTo>
                        <a:pt x="19" y="39"/>
                      </a:lnTo>
                      <a:lnTo>
                        <a:pt x="17" y="41"/>
                      </a:lnTo>
                      <a:lnTo>
                        <a:pt x="16" y="41"/>
                      </a:lnTo>
                      <a:lnTo>
                        <a:pt x="14" y="42"/>
                      </a:lnTo>
                      <a:lnTo>
                        <a:pt x="13" y="42"/>
                      </a:lnTo>
                      <a:lnTo>
                        <a:pt x="12" y="42"/>
                      </a:lnTo>
                      <a:lnTo>
                        <a:pt x="10" y="43"/>
                      </a:lnTo>
                      <a:lnTo>
                        <a:pt x="9" y="43"/>
                      </a:lnTo>
                      <a:lnTo>
                        <a:pt x="7" y="45"/>
                      </a:lnTo>
                      <a:lnTo>
                        <a:pt x="6" y="45"/>
                      </a:lnTo>
                      <a:lnTo>
                        <a:pt x="4" y="45"/>
                      </a:lnTo>
                      <a:lnTo>
                        <a:pt x="3" y="46"/>
                      </a:lnTo>
                      <a:lnTo>
                        <a:pt x="2" y="46"/>
                      </a:lnTo>
                      <a:lnTo>
                        <a:pt x="0" y="48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06" name="Line 190"/>
                <p:cNvSpPr>
                  <a:spLocks noChangeShapeType="1"/>
                </p:cNvSpPr>
                <p:nvPr/>
              </p:nvSpPr>
              <p:spPr bwMode="auto">
                <a:xfrm>
                  <a:off x="4240" y="2980"/>
                  <a:ext cx="155" cy="302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07" name="Rectangle 191"/>
                <p:cNvSpPr>
                  <a:spLocks noChangeArrowheads="1"/>
                </p:cNvSpPr>
                <p:nvPr/>
              </p:nvSpPr>
              <p:spPr bwMode="auto">
                <a:xfrm rot="4320000">
                  <a:off x="4257" y="3967"/>
                  <a:ext cx="295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SD-A10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08" name="Line 192"/>
                <p:cNvSpPr>
                  <a:spLocks noChangeShapeType="1"/>
                </p:cNvSpPr>
                <p:nvPr/>
              </p:nvSpPr>
              <p:spPr bwMode="auto">
                <a:xfrm>
                  <a:off x="4110" y="3109"/>
                  <a:ext cx="203" cy="652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09" name="Rectangle 193"/>
                <p:cNvSpPr>
                  <a:spLocks noChangeArrowheads="1"/>
                </p:cNvSpPr>
                <p:nvPr/>
              </p:nvSpPr>
              <p:spPr bwMode="auto">
                <a:xfrm rot="4620000">
                  <a:off x="4086" y="4030"/>
                  <a:ext cx="323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QJPG-A10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10" name="Line 194"/>
                <p:cNvSpPr>
                  <a:spLocks noChangeShapeType="1"/>
                </p:cNvSpPr>
                <p:nvPr/>
              </p:nvSpPr>
              <p:spPr bwMode="auto">
                <a:xfrm>
                  <a:off x="4038" y="3200"/>
                  <a:ext cx="133" cy="600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11" name="Rectangle 195"/>
                <p:cNvSpPr>
                  <a:spLocks noChangeArrowheads="1"/>
                </p:cNvSpPr>
                <p:nvPr/>
              </p:nvSpPr>
              <p:spPr bwMode="auto">
                <a:xfrm rot="4920000">
                  <a:off x="3956" y="4030"/>
                  <a:ext cx="230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J-A10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12" name="Line 196"/>
                <p:cNvSpPr>
                  <a:spLocks noChangeShapeType="1"/>
                </p:cNvSpPr>
                <p:nvPr/>
              </p:nvSpPr>
              <p:spPr bwMode="auto">
                <a:xfrm>
                  <a:off x="3953" y="3284"/>
                  <a:ext cx="72" cy="541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13" name="Rectangle 197"/>
                <p:cNvSpPr>
                  <a:spLocks noChangeArrowheads="1"/>
                </p:cNvSpPr>
                <p:nvPr/>
              </p:nvSpPr>
              <p:spPr bwMode="auto">
                <a:xfrm rot="5220000">
                  <a:off x="3719" y="4090"/>
                  <a:ext cx="364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LMD-A10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14" name="Line 198"/>
                <p:cNvSpPr>
                  <a:spLocks noChangeShapeType="1"/>
                </p:cNvSpPr>
                <p:nvPr/>
              </p:nvSpPr>
              <p:spPr bwMode="auto">
                <a:xfrm>
                  <a:off x="3857" y="3362"/>
                  <a:ext cx="22" cy="476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15" name="Rectangle 199"/>
                <p:cNvSpPr>
                  <a:spLocks noChangeArrowheads="1"/>
                </p:cNvSpPr>
                <p:nvPr/>
              </p:nvSpPr>
              <p:spPr bwMode="auto">
                <a:xfrm rot="5520000">
                  <a:off x="3598" y="4079"/>
                  <a:ext cx="275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ZHJ-A10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16" name="Line 200"/>
                <p:cNvSpPr>
                  <a:spLocks noChangeShapeType="1"/>
                </p:cNvSpPr>
                <p:nvPr/>
              </p:nvSpPr>
              <p:spPr bwMode="auto">
                <a:xfrm flipH="1">
                  <a:off x="3730" y="3431"/>
                  <a:ext cx="17" cy="407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17" name="Rectangle 201"/>
                <p:cNvSpPr>
                  <a:spLocks noChangeArrowheads="1"/>
                </p:cNvSpPr>
                <p:nvPr/>
              </p:nvSpPr>
              <p:spPr bwMode="auto">
                <a:xfrm rot="5820000">
                  <a:off x="3401" y="4064"/>
                  <a:ext cx="303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RH-A10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18" name="Line 202"/>
                <p:cNvSpPr>
                  <a:spLocks noChangeShapeType="1"/>
                </p:cNvSpPr>
                <p:nvPr/>
              </p:nvSpPr>
              <p:spPr bwMode="auto">
                <a:xfrm flipH="1">
                  <a:off x="3583" y="3490"/>
                  <a:ext cx="43" cy="335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19" name="Rectangle 203"/>
                <p:cNvSpPr>
                  <a:spLocks noChangeArrowheads="1"/>
                </p:cNvSpPr>
                <p:nvPr/>
              </p:nvSpPr>
              <p:spPr bwMode="auto">
                <a:xfrm rot="6120000">
                  <a:off x="3191" y="4057"/>
                  <a:ext cx="364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AIRC-A10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20" name="Line 204"/>
                <p:cNvSpPr>
                  <a:spLocks noChangeShapeType="1"/>
                </p:cNvSpPr>
                <p:nvPr/>
              </p:nvSpPr>
              <p:spPr bwMode="auto">
                <a:xfrm flipH="1">
                  <a:off x="3437" y="3537"/>
                  <a:ext cx="57" cy="264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11" name="Group 406"/>
              <p:cNvGrpSpPr/>
              <p:nvPr/>
            </p:nvGrpSpPr>
            <p:grpSpPr bwMode="auto">
              <a:xfrm>
                <a:off x="1658" y="150"/>
                <a:ext cx="2921" cy="3991"/>
                <a:chOff x="1658" y="150"/>
                <a:chExt cx="2921" cy="3991"/>
              </a:xfrm>
            </p:grpSpPr>
            <p:sp>
              <p:nvSpPr>
                <p:cNvPr id="21" name="Rectangle 206"/>
                <p:cNvSpPr>
                  <a:spLocks noChangeArrowheads="1"/>
                </p:cNvSpPr>
                <p:nvPr/>
              </p:nvSpPr>
              <p:spPr bwMode="auto">
                <a:xfrm rot="6420000">
                  <a:off x="3115" y="3967"/>
                  <a:ext cx="242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ZC-A10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" name="Line 207"/>
                <p:cNvSpPr>
                  <a:spLocks noChangeShapeType="1"/>
                </p:cNvSpPr>
                <p:nvPr/>
              </p:nvSpPr>
              <p:spPr bwMode="auto">
                <a:xfrm flipH="1">
                  <a:off x="3295" y="3571"/>
                  <a:ext cx="59" cy="193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" name="Rectangle 208"/>
                <p:cNvSpPr>
                  <a:spLocks noChangeArrowheads="1"/>
                </p:cNvSpPr>
                <p:nvPr/>
              </p:nvSpPr>
              <p:spPr bwMode="auto">
                <a:xfrm rot="6720000">
                  <a:off x="2894" y="3938"/>
                  <a:ext cx="319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MX-A10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" name="Line 209"/>
                <p:cNvSpPr>
                  <a:spLocks noChangeShapeType="1"/>
                </p:cNvSpPr>
                <p:nvPr/>
              </p:nvSpPr>
              <p:spPr bwMode="auto">
                <a:xfrm flipH="1">
                  <a:off x="3156" y="3591"/>
                  <a:ext cx="49" cy="122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" name="Rectangle 210"/>
                <p:cNvSpPr>
                  <a:spLocks noChangeArrowheads="1"/>
                </p:cNvSpPr>
                <p:nvPr/>
              </p:nvSpPr>
              <p:spPr bwMode="auto">
                <a:xfrm rot="7020000">
                  <a:off x="2784" y="3852"/>
                  <a:ext cx="267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X-A10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" name="Line 211"/>
                <p:cNvSpPr>
                  <a:spLocks noChangeShapeType="1"/>
                </p:cNvSpPr>
                <p:nvPr/>
              </p:nvSpPr>
              <p:spPr bwMode="auto">
                <a:xfrm flipH="1">
                  <a:off x="3021" y="3597"/>
                  <a:ext cx="29" cy="56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7" name="Rectangle 212"/>
                <p:cNvSpPr>
                  <a:spLocks noChangeArrowheads="1"/>
                </p:cNvSpPr>
                <p:nvPr/>
              </p:nvSpPr>
              <p:spPr bwMode="auto">
                <a:xfrm rot="7260000">
                  <a:off x="2609" y="3766"/>
                  <a:ext cx="303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XNB-A10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8" name="Line 213"/>
                <p:cNvSpPr>
                  <a:spLocks noChangeShapeType="1"/>
                </p:cNvSpPr>
                <p:nvPr/>
              </p:nvSpPr>
              <p:spPr bwMode="auto">
                <a:xfrm flipH="1">
                  <a:off x="2892" y="3527"/>
                  <a:ext cx="33" cy="53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9" name="Freeform 214"/>
                <p:cNvSpPr/>
                <p:nvPr/>
              </p:nvSpPr>
              <p:spPr bwMode="auto">
                <a:xfrm>
                  <a:off x="2988" y="3560"/>
                  <a:ext cx="63" cy="34"/>
                </a:xfrm>
                <a:custGeom>
                  <a:avLst/>
                  <a:gdLst>
                    <a:gd name="T0" fmla="*/ 0 w 63"/>
                    <a:gd name="T1" fmla="*/ 0 h 34"/>
                    <a:gd name="T2" fmla="*/ 5 w 63"/>
                    <a:gd name="T3" fmla="*/ 3 h 34"/>
                    <a:gd name="T4" fmla="*/ 9 w 63"/>
                    <a:gd name="T5" fmla="*/ 4 h 34"/>
                    <a:gd name="T6" fmla="*/ 12 w 63"/>
                    <a:gd name="T7" fmla="*/ 7 h 34"/>
                    <a:gd name="T8" fmla="*/ 16 w 63"/>
                    <a:gd name="T9" fmla="*/ 9 h 34"/>
                    <a:gd name="T10" fmla="*/ 20 w 63"/>
                    <a:gd name="T11" fmla="*/ 11 h 34"/>
                    <a:gd name="T12" fmla="*/ 23 w 63"/>
                    <a:gd name="T13" fmla="*/ 13 h 34"/>
                    <a:gd name="T14" fmla="*/ 28 w 63"/>
                    <a:gd name="T15" fmla="*/ 16 h 34"/>
                    <a:gd name="T16" fmla="*/ 32 w 63"/>
                    <a:gd name="T17" fmla="*/ 17 h 34"/>
                    <a:gd name="T18" fmla="*/ 36 w 63"/>
                    <a:gd name="T19" fmla="*/ 20 h 34"/>
                    <a:gd name="T20" fmla="*/ 39 w 63"/>
                    <a:gd name="T21" fmla="*/ 21 h 34"/>
                    <a:gd name="T22" fmla="*/ 43 w 63"/>
                    <a:gd name="T23" fmla="*/ 24 h 34"/>
                    <a:gd name="T24" fmla="*/ 48 w 63"/>
                    <a:gd name="T25" fmla="*/ 26 h 34"/>
                    <a:gd name="T26" fmla="*/ 52 w 63"/>
                    <a:gd name="T27" fmla="*/ 29 h 34"/>
                    <a:gd name="T28" fmla="*/ 55 w 63"/>
                    <a:gd name="T29" fmla="*/ 30 h 34"/>
                    <a:gd name="T30" fmla="*/ 59 w 63"/>
                    <a:gd name="T31" fmla="*/ 31 h 34"/>
                    <a:gd name="T32" fmla="*/ 63 w 63"/>
                    <a:gd name="T33" fmla="*/ 34 h 3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</a:cxnLst>
                  <a:rect l="0" t="0" r="r" b="b"/>
                  <a:pathLst>
                    <a:path w="63" h="34">
                      <a:moveTo>
                        <a:pt x="0" y="0"/>
                      </a:moveTo>
                      <a:lnTo>
                        <a:pt x="5" y="3"/>
                      </a:lnTo>
                      <a:lnTo>
                        <a:pt x="9" y="4"/>
                      </a:lnTo>
                      <a:lnTo>
                        <a:pt x="12" y="7"/>
                      </a:lnTo>
                      <a:lnTo>
                        <a:pt x="16" y="9"/>
                      </a:lnTo>
                      <a:lnTo>
                        <a:pt x="20" y="11"/>
                      </a:lnTo>
                      <a:lnTo>
                        <a:pt x="23" y="13"/>
                      </a:lnTo>
                      <a:lnTo>
                        <a:pt x="28" y="16"/>
                      </a:lnTo>
                      <a:lnTo>
                        <a:pt x="32" y="17"/>
                      </a:lnTo>
                      <a:lnTo>
                        <a:pt x="36" y="20"/>
                      </a:lnTo>
                      <a:lnTo>
                        <a:pt x="39" y="21"/>
                      </a:lnTo>
                      <a:lnTo>
                        <a:pt x="43" y="24"/>
                      </a:lnTo>
                      <a:lnTo>
                        <a:pt x="48" y="26"/>
                      </a:lnTo>
                      <a:lnTo>
                        <a:pt x="52" y="29"/>
                      </a:lnTo>
                      <a:lnTo>
                        <a:pt x="55" y="30"/>
                      </a:lnTo>
                      <a:lnTo>
                        <a:pt x="59" y="31"/>
                      </a:lnTo>
                      <a:lnTo>
                        <a:pt x="63" y="34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0" name="Freeform 215"/>
                <p:cNvSpPr/>
                <p:nvPr/>
              </p:nvSpPr>
              <p:spPr bwMode="auto">
                <a:xfrm>
                  <a:off x="2928" y="3524"/>
                  <a:ext cx="60" cy="36"/>
                </a:xfrm>
                <a:custGeom>
                  <a:avLst/>
                  <a:gdLst>
                    <a:gd name="T0" fmla="*/ 60 w 60"/>
                    <a:gd name="T1" fmla="*/ 36 h 36"/>
                    <a:gd name="T2" fmla="*/ 57 w 60"/>
                    <a:gd name="T3" fmla="*/ 34 h 36"/>
                    <a:gd name="T4" fmla="*/ 53 w 60"/>
                    <a:gd name="T5" fmla="*/ 33 h 36"/>
                    <a:gd name="T6" fmla="*/ 50 w 60"/>
                    <a:gd name="T7" fmla="*/ 30 h 36"/>
                    <a:gd name="T8" fmla="*/ 46 w 60"/>
                    <a:gd name="T9" fmla="*/ 29 h 36"/>
                    <a:gd name="T10" fmla="*/ 42 w 60"/>
                    <a:gd name="T11" fmla="*/ 26 h 36"/>
                    <a:gd name="T12" fmla="*/ 39 w 60"/>
                    <a:gd name="T13" fmla="*/ 24 h 36"/>
                    <a:gd name="T14" fmla="*/ 34 w 60"/>
                    <a:gd name="T15" fmla="*/ 22 h 36"/>
                    <a:gd name="T16" fmla="*/ 32 w 60"/>
                    <a:gd name="T17" fmla="*/ 20 h 36"/>
                    <a:gd name="T18" fmla="*/ 27 w 60"/>
                    <a:gd name="T19" fmla="*/ 17 h 36"/>
                    <a:gd name="T20" fmla="*/ 24 w 60"/>
                    <a:gd name="T21" fmla="*/ 16 h 36"/>
                    <a:gd name="T22" fmla="*/ 20 w 60"/>
                    <a:gd name="T23" fmla="*/ 13 h 36"/>
                    <a:gd name="T24" fmla="*/ 17 w 60"/>
                    <a:gd name="T25" fmla="*/ 12 h 36"/>
                    <a:gd name="T26" fmla="*/ 13 w 60"/>
                    <a:gd name="T27" fmla="*/ 9 h 36"/>
                    <a:gd name="T28" fmla="*/ 10 w 60"/>
                    <a:gd name="T29" fmla="*/ 7 h 36"/>
                    <a:gd name="T30" fmla="*/ 6 w 60"/>
                    <a:gd name="T31" fmla="*/ 4 h 36"/>
                    <a:gd name="T32" fmla="*/ 3 w 60"/>
                    <a:gd name="T33" fmla="*/ 3 h 36"/>
                    <a:gd name="T34" fmla="*/ 0 w 60"/>
                    <a:gd name="T35" fmla="*/ 0 h 3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60" h="36">
                      <a:moveTo>
                        <a:pt x="60" y="36"/>
                      </a:moveTo>
                      <a:lnTo>
                        <a:pt x="57" y="34"/>
                      </a:lnTo>
                      <a:lnTo>
                        <a:pt x="53" y="33"/>
                      </a:lnTo>
                      <a:lnTo>
                        <a:pt x="50" y="30"/>
                      </a:lnTo>
                      <a:lnTo>
                        <a:pt x="46" y="29"/>
                      </a:lnTo>
                      <a:lnTo>
                        <a:pt x="42" y="26"/>
                      </a:lnTo>
                      <a:lnTo>
                        <a:pt x="39" y="24"/>
                      </a:lnTo>
                      <a:lnTo>
                        <a:pt x="34" y="22"/>
                      </a:lnTo>
                      <a:lnTo>
                        <a:pt x="32" y="20"/>
                      </a:lnTo>
                      <a:lnTo>
                        <a:pt x="27" y="17"/>
                      </a:lnTo>
                      <a:lnTo>
                        <a:pt x="24" y="16"/>
                      </a:lnTo>
                      <a:lnTo>
                        <a:pt x="20" y="13"/>
                      </a:lnTo>
                      <a:lnTo>
                        <a:pt x="17" y="12"/>
                      </a:lnTo>
                      <a:lnTo>
                        <a:pt x="13" y="9"/>
                      </a:lnTo>
                      <a:lnTo>
                        <a:pt x="10" y="7"/>
                      </a:lnTo>
                      <a:lnTo>
                        <a:pt x="6" y="4"/>
                      </a:lnTo>
                      <a:lnTo>
                        <a:pt x="3" y="3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2" name="Line 217"/>
                <p:cNvSpPr>
                  <a:spLocks noChangeShapeType="1"/>
                </p:cNvSpPr>
                <p:nvPr/>
              </p:nvSpPr>
              <p:spPr bwMode="auto">
                <a:xfrm flipH="1">
                  <a:off x="2990" y="3503"/>
                  <a:ext cx="31" cy="54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3" name="Freeform 218"/>
                <p:cNvSpPr/>
                <p:nvPr/>
              </p:nvSpPr>
              <p:spPr bwMode="auto">
                <a:xfrm>
                  <a:off x="3113" y="3548"/>
                  <a:ext cx="93" cy="41"/>
                </a:xfrm>
                <a:custGeom>
                  <a:avLst/>
                  <a:gdLst>
                    <a:gd name="T0" fmla="*/ 0 w 93"/>
                    <a:gd name="T1" fmla="*/ 0 h 41"/>
                    <a:gd name="T2" fmla="*/ 3 w 93"/>
                    <a:gd name="T3" fmla="*/ 2 h 41"/>
                    <a:gd name="T4" fmla="*/ 6 w 93"/>
                    <a:gd name="T5" fmla="*/ 3 h 41"/>
                    <a:gd name="T6" fmla="*/ 9 w 93"/>
                    <a:gd name="T7" fmla="*/ 5 h 41"/>
                    <a:gd name="T8" fmla="*/ 13 w 93"/>
                    <a:gd name="T9" fmla="*/ 6 h 41"/>
                    <a:gd name="T10" fmla="*/ 16 w 93"/>
                    <a:gd name="T11" fmla="*/ 8 h 41"/>
                    <a:gd name="T12" fmla="*/ 19 w 93"/>
                    <a:gd name="T13" fmla="*/ 9 h 41"/>
                    <a:gd name="T14" fmla="*/ 22 w 93"/>
                    <a:gd name="T15" fmla="*/ 10 h 41"/>
                    <a:gd name="T16" fmla="*/ 26 w 93"/>
                    <a:gd name="T17" fmla="*/ 12 h 41"/>
                    <a:gd name="T18" fmla="*/ 29 w 93"/>
                    <a:gd name="T19" fmla="*/ 13 h 41"/>
                    <a:gd name="T20" fmla="*/ 32 w 93"/>
                    <a:gd name="T21" fmla="*/ 15 h 41"/>
                    <a:gd name="T22" fmla="*/ 34 w 93"/>
                    <a:gd name="T23" fmla="*/ 16 h 41"/>
                    <a:gd name="T24" fmla="*/ 39 w 93"/>
                    <a:gd name="T25" fmla="*/ 18 h 41"/>
                    <a:gd name="T26" fmla="*/ 42 w 93"/>
                    <a:gd name="T27" fmla="*/ 19 h 41"/>
                    <a:gd name="T28" fmla="*/ 44 w 93"/>
                    <a:gd name="T29" fmla="*/ 21 h 41"/>
                    <a:gd name="T30" fmla="*/ 47 w 93"/>
                    <a:gd name="T31" fmla="*/ 22 h 41"/>
                    <a:gd name="T32" fmla="*/ 52 w 93"/>
                    <a:gd name="T33" fmla="*/ 23 h 41"/>
                    <a:gd name="T34" fmla="*/ 55 w 93"/>
                    <a:gd name="T35" fmla="*/ 25 h 41"/>
                    <a:gd name="T36" fmla="*/ 57 w 93"/>
                    <a:gd name="T37" fmla="*/ 26 h 41"/>
                    <a:gd name="T38" fmla="*/ 60 w 93"/>
                    <a:gd name="T39" fmla="*/ 28 h 41"/>
                    <a:gd name="T40" fmla="*/ 65 w 93"/>
                    <a:gd name="T41" fmla="*/ 29 h 41"/>
                    <a:gd name="T42" fmla="*/ 67 w 93"/>
                    <a:gd name="T43" fmla="*/ 31 h 41"/>
                    <a:gd name="T44" fmla="*/ 70 w 93"/>
                    <a:gd name="T45" fmla="*/ 32 h 41"/>
                    <a:gd name="T46" fmla="*/ 73 w 93"/>
                    <a:gd name="T47" fmla="*/ 33 h 41"/>
                    <a:gd name="T48" fmla="*/ 77 w 93"/>
                    <a:gd name="T49" fmla="*/ 35 h 41"/>
                    <a:gd name="T50" fmla="*/ 80 w 93"/>
                    <a:gd name="T51" fmla="*/ 36 h 41"/>
                    <a:gd name="T52" fmla="*/ 83 w 93"/>
                    <a:gd name="T53" fmla="*/ 38 h 41"/>
                    <a:gd name="T54" fmla="*/ 86 w 93"/>
                    <a:gd name="T55" fmla="*/ 39 h 41"/>
                    <a:gd name="T56" fmla="*/ 90 w 93"/>
                    <a:gd name="T57" fmla="*/ 39 h 41"/>
                    <a:gd name="T58" fmla="*/ 93 w 93"/>
                    <a:gd name="T59" fmla="*/ 41 h 4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</a:cxnLst>
                  <a:rect l="0" t="0" r="r" b="b"/>
                  <a:pathLst>
                    <a:path w="93" h="41">
                      <a:moveTo>
                        <a:pt x="0" y="0"/>
                      </a:moveTo>
                      <a:lnTo>
                        <a:pt x="3" y="2"/>
                      </a:lnTo>
                      <a:lnTo>
                        <a:pt x="6" y="3"/>
                      </a:lnTo>
                      <a:lnTo>
                        <a:pt x="9" y="5"/>
                      </a:lnTo>
                      <a:lnTo>
                        <a:pt x="13" y="6"/>
                      </a:lnTo>
                      <a:lnTo>
                        <a:pt x="16" y="8"/>
                      </a:lnTo>
                      <a:lnTo>
                        <a:pt x="19" y="9"/>
                      </a:lnTo>
                      <a:lnTo>
                        <a:pt x="22" y="10"/>
                      </a:lnTo>
                      <a:lnTo>
                        <a:pt x="26" y="12"/>
                      </a:lnTo>
                      <a:lnTo>
                        <a:pt x="29" y="13"/>
                      </a:lnTo>
                      <a:lnTo>
                        <a:pt x="32" y="15"/>
                      </a:lnTo>
                      <a:lnTo>
                        <a:pt x="34" y="16"/>
                      </a:lnTo>
                      <a:lnTo>
                        <a:pt x="39" y="18"/>
                      </a:lnTo>
                      <a:lnTo>
                        <a:pt x="42" y="19"/>
                      </a:lnTo>
                      <a:lnTo>
                        <a:pt x="44" y="21"/>
                      </a:lnTo>
                      <a:lnTo>
                        <a:pt x="47" y="22"/>
                      </a:lnTo>
                      <a:lnTo>
                        <a:pt x="52" y="23"/>
                      </a:lnTo>
                      <a:lnTo>
                        <a:pt x="55" y="25"/>
                      </a:lnTo>
                      <a:lnTo>
                        <a:pt x="57" y="26"/>
                      </a:lnTo>
                      <a:lnTo>
                        <a:pt x="60" y="28"/>
                      </a:lnTo>
                      <a:lnTo>
                        <a:pt x="65" y="29"/>
                      </a:lnTo>
                      <a:lnTo>
                        <a:pt x="67" y="31"/>
                      </a:lnTo>
                      <a:lnTo>
                        <a:pt x="70" y="32"/>
                      </a:lnTo>
                      <a:lnTo>
                        <a:pt x="73" y="33"/>
                      </a:lnTo>
                      <a:lnTo>
                        <a:pt x="77" y="35"/>
                      </a:lnTo>
                      <a:lnTo>
                        <a:pt x="80" y="36"/>
                      </a:lnTo>
                      <a:lnTo>
                        <a:pt x="83" y="38"/>
                      </a:lnTo>
                      <a:lnTo>
                        <a:pt x="86" y="39"/>
                      </a:lnTo>
                      <a:lnTo>
                        <a:pt x="90" y="39"/>
                      </a:lnTo>
                      <a:lnTo>
                        <a:pt x="93" y="41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4" name="Freeform 219"/>
                <p:cNvSpPr/>
                <p:nvPr/>
              </p:nvSpPr>
              <p:spPr bwMode="auto">
                <a:xfrm>
                  <a:off x="3023" y="3501"/>
                  <a:ext cx="90" cy="47"/>
                </a:xfrm>
                <a:custGeom>
                  <a:avLst/>
                  <a:gdLst>
                    <a:gd name="T0" fmla="*/ 90 w 90"/>
                    <a:gd name="T1" fmla="*/ 47 h 47"/>
                    <a:gd name="T2" fmla="*/ 86 w 90"/>
                    <a:gd name="T3" fmla="*/ 45 h 47"/>
                    <a:gd name="T4" fmla="*/ 81 w 90"/>
                    <a:gd name="T5" fmla="*/ 43 h 47"/>
                    <a:gd name="T6" fmla="*/ 77 w 90"/>
                    <a:gd name="T7" fmla="*/ 40 h 47"/>
                    <a:gd name="T8" fmla="*/ 73 w 90"/>
                    <a:gd name="T9" fmla="*/ 39 h 47"/>
                    <a:gd name="T10" fmla="*/ 69 w 90"/>
                    <a:gd name="T11" fmla="*/ 36 h 47"/>
                    <a:gd name="T12" fmla="*/ 64 w 90"/>
                    <a:gd name="T13" fmla="*/ 35 h 47"/>
                    <a:gd name="T14" fmla="*/ 60 w 90"/>
                    <a:gd name="T15" fmla="*/ 32 h 47"/>
                    <a:gd name="T16" fmla="*/ 56 w 90"/>
                    <a:gd name="T17" fmla="*/ 30 h 47"/>
                    <a:gd name="T18" fmla="*/ 51 w 90"/>
                    <a:gd name="T19" fmla="*/ 27 h 47"/>
                    <a:gd name="T20" fmla="*/ 46 w 90"/>
                    <a:gd name="T21" fmla="*/ 24 h 47"/>
                    <a:gd name="T22" fmla="*/ 41 w 90"/>
                    <a:gd name="T23" fmla="*/ 23 h 47"/>
                    <a:gd name="T24" fmla="*/ 37 w 90"/>
                    <a:gd name="T25" fmla="*/ 20 h 47"/>
                    <a:gd name="T26" fmla="*/ 33 w 90"/>
                    <a:gd name="T27" fmla="*/ 19 h 47"/>
                    <a:gd name="T28" fmla="*/ 30 w 90"/>
                    <a:gd name="T29" fmla="*/ 16 h 47"/>
                    <a:gd name="T30" fmla="*/ 26 w 90"/>
                    <a:gd name="T31" fmla="*/ 13 h 47"/>
                    <a:gd name="T32" fmla="*/ 21 w 90"/>
                    <a:gd name="T33" fmla="*/ 12 h 47"/>
                    <a:gd name="T34" fmla="*/ 17 w 90"/>
                    <a:gd name="T35" fmla="*/ 9 h 47"/>
                    <a:gd name="T36" fmla="*/ 13 w 90"/>
                    <a:gd name="T37" fmla="*/ 7 h 47"/>
                    <a:gd name="T38" fmla="*/ 8 w 90"/>
                    <a:gd name="T39" fmla="*/ 4 h 47"/>
                    <a:gd name="T40" fmla="*/ 4 w 90"/>
                    <a:gd name="T41" fmla="*/ 2 h 47"/>
                    <a:gd name="T42" fmla="*/ 0 w 90"/>
                    <a:gd name="T43" fmla="*/ 0 h 4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</a:cxnLst>
                  <a:rect l="0" t="0" r="r" b="b"/>
                  <a:pathLst>
                    <a:path w="90" h="47">
                      <a:moveTo>
                        <a:pt x="90" y="47"/>
                      </a:moveTo>
                      <a:lnTo>
                        <a:pt x="86" y="45"/>
                      </a:lnTo>
                      <a:lnTo>
                        <a:pt x="81" y="43"/>
                      </a:lnTo>
                      <a:lnTo>
                        <a:pt x="77" y="40"/>
                      </a:lnTo>
                      <a:lnTo>
                        <a:pt x="73" y="39"/>
                      </a:lnTo>
                      <a:lnTo>
                        <a:pt x="69" y="36"/>
                      </a:lnTo>
                      <a:lnTo>
                        <a:pt x="64" y="35"/>
                      </a:lnTo>
                      <a:lnTo>
                        <a:pt x="60" y="32"/>
                      </a:lnTo>
                      <a:lnTo>
                        <a:pt x="56" y="30"/>
                      </a:lnTo>
                      <a:lnTo>
                        <a:pt x="51" y="27"/>
                      </a:lnTo>
                      <a:lnTo>
                        <a:pt x="46" y="24"/>
                      </a:lnTo>
                      <a:lnTo>
                        <a:pt x="41" y="23"/>
                      </a:lnTo>
                      <a:lnTo>
                        <a:pt x="37" y="20"/>
                      </a:lnTo>
                      <a:lnTo>
                        <a:pt x="33" y="19"/>
                      </a:lnTo>
                      <a:lnTo>
                        <a:pt x="30" y="16"/>
                      </a:lnTo>
                      <a:lnTo>
                        <a:pt x="26" y="13"/>
                      </a:lnTo>
                      <a:lnTo>
                        <a:pt x="21" y="12"/>
                      </a:lnTo>
                      <a:lnTo>
                        <a:pt x="17" y="9"/>
                      </a:lnTo>
                      <a:lnTo>
                        <a:pt x="13" y="7"/>
                      </a:lnTo>
                      <a:lnTo>
                        <a:pt x="8" y="4"/>
                      </a:lnTo>
                      <a:lnTo>
                        <a:pt x="4" y="2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6" name="Line 221"/>
                <p:cNvSpPr>
                  <a:spLocks noChangeShapeType="1"/>
                </p:cNvSpPr>
                <p:nvPr/>
              </p:nvSpPr>
              <p:spPr bwMode="auto">
                <a:xfrm flipH="1">
                  <a:off x="3114" y="3490"/>
                  <a:ext cx="28" cy="56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7" name="Freeform 222"/>
                <p:cNvSpPr/>
                <p:nvPr/>
              </p:nvSpPr>
              <p:spPr bwMode="auto">
                <a:xfrm>
                  <a:off x="3246" y="3531"/>
                  <a:ext cx="108" cy="38"/>
                </a:xfrm>
                <a:custGeom>
                  <a:avLst/>
                  <a:gdLst>
                    <a:gd name="T0" fmla="*/ 0 w 108"/>
                    <a:gd name="T1" fmla="*/ 0 h 38"/>
                    <a:gd name="T2" fmla="*/ 3 w 108"/>
                    <a:gd name="T3" fmla="*/ 2 h 38"/>
                    <a:gd name="T4" fmla="*/ 6 w 108"/>
                    <a:gd name="T5" fmla="*/ 3 h 38"/>
                    <a:gd name="T6" fmla="*/ 9 w 108"/>
                    <a:gd name="T7" fmla="*/ 3 h 38"/>
                    <a:gd name="T8" fmla="*/ 12 w 108"/>
                    <a:gd name="T9" fmla="*/ 5 h 38"/>
                    <a:gd name="T10" fmla="*/ 15 w 108"/>
                    <a:gd name="T11" fmla="*/ 6 h 38"/>
                    <a:gd name="T12" fmla="*/ 16 w 108"/>
                    <a:gd name="T13" fmla="*/ 6 h 38"/>
                    <a:gd name="T14" fmla="*/ 19 w 108"/>
                    <a:gd name="T15" fmla="*/ 7 h 38"/>
                    <a:gd name="T16" fmla="*/ 22 w 108"/>
                    <a:gd name="T17" fmla="*/ 9 h 38"/>
                    <a:gd name="T18" fmla="*/ 25 w 108"/>
                    <a:gd name="T19" fmla="*/ 9 h 38"/>
                    <a:gd name="T20" fmla="*/ 28 w 108"/>
                    <a:gd name="T21" fmla="*/ 10 h 38"/>
                    <a:gd name="T22" fmla="*/ 29 w 108"/>
                    <a:gd name="T23" fmla="*/ 12 h 38"/>
                    <a:gd name="T24" fmla="*/ 32 w 108"/>
                    <a:gd name="T25" fmla="*/ 12 h 38"/>
                    <a:gd name="T26" fmla="*/ 35 w 108"/>
                    <a:gd name="T27" fmla="*/ 13 h 38"/>
                    <a:gd name="T28" fmla="*/ 38 w 108"/>
                    <a:gd name="T29" fmla="*/ 15 h 38"/>
                    <a:gd name="T30" fmla="*/ 41 w 108"/>
                    <a:gd name="T31" fmla="*/ 15 h 38"/>
                    <a:gd name="T32" fmla="*/ 42 w 108"/>
                    <a:gd name="T33" fmla="*/ 16 h 38"/>
                    <a:gd name="T34" fmla="*/ 45 w 108"/>
                    <a:gd name="T35" fmla="*/ 17 h 38"/>
                    <a:gd name="T36" fmla="*/ 48 w 108"/>
                    <a:gd name="T37" fmla="*/ 17 h 38"/>
                    <a:gd name="T38" fmla="*/ 51 w 108"/>
                    <a:gd name="T39" fmla="*/ 19 h 38"/>
                    <a:gd name="T40" fmla="*/ 53 w 108"/>
                    <a:gd name="T41" fmla="*/ 20 h 38"/>
                    <a:gd name="T42" fmla="*/ 56 w 108"/>
                    <a:gd name="T43" fmla="*/ 20 h 38"/>
                    <a:gd name="T44" fmla="*/ 58 w 108"/>
                    <a:gd name="T45" fmla="*/ 22 h 38"/>
                    <a:gd name="T46" fmla="*/ 61 w 108"/>
                    <a:gd name="T47" fmla="*/ 23 h 38"/>
                    <a:gd name="T48" fmla="*/ 63 w 108"/>
                    <a:gd name="T49" fmla="*/ 23 h 38"/>
                    <a:gd name="T50" fmla="*/ 66 w 108"/>
                    <a:gd name="T51" fmla="*/ 25 h 38"/>
                    <a:gd name="T52" fmla="*/ 69 w 108"/>
                    <a:gd name="T53" fmla="*/ 25 h 38"/>
                    <a:gd name="T54" fmla="*/ 72 w 108"/>
                    <a:gd name="T55" fmla="*/ 26 h 38"/>
                    <a:gd name="T56" fmla="*/ 74 w 108"/>
                    <a:gd name="T57" fmla="*/ 27 h 38"/>
                    <a:gd name="T58" fmla="*/ 76 w 108"/>
                    <a:gd name="T59" fmla="*/ 27 h 38"/>
                    <a:gd name="T60" fmla="*/ 79 w 108"/>
                    <a:gd name="T61" fmla="*/ 29 h 38"/>
                    <a:gd name="T62" fmla="*/ 82 w 108"/>
                    <a:gd name="T63" fmla="*/ 29 h 38"/>
                    <a:gd name="T64" fmla="*/ 85 w 108"/>
                    <a:gd name="T65" fmla="*/ 30 h 38"/>
                    <a:gd name="T66" fmla="*/ 88 w 108"/>
                    <a:gd name="T67" fmla="*/ 32 h 38"/>
                    <a:gd name="T68" fmla="*/ 91 w 108"/>
                    <a:gd name="T69" fmla="*/ 32 h 38"/>
                    <a:gd name="T70" fmla="*/ 92 w 108"/>
                    <a:gd name="T71" fmla="*/ 33 h 38"/>
                    <a:gd name="T72" fmla="*/ 95 w 108"/>
                    <a:gd name="T73" fmla="*/ 33 h 38"/>
                    <a:gd name="T74" fmla="*/ 98 w 108"/>
                    <a:gd name="T75" fmla="*/ 35 h 38"/>
                    <a:gd name="T76" fmla="*/ 101 w 108"/>
                    <a:gd name="T77" fmla="*/ 36 h 38"/>
                    <a:gd name="T78" fmla="*/ 104 w 108"/>
                    <a:gd name="T79" fmla="*/ 36 h 38"/>
                    <a:gd name="T80" fmla="*/ 107 w 108"/>
                    <a:gd name="T81" fmla="*/ 38 h 38"/>
                    <a:gd name="T82" fmla="*/ 108 w 108"/>
                    <a:gd name="T83" fmla="*/ 38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</a:cxnLst>
                  <a:rect l="0" t="0" r="r" b="b"/>
                  <a:pathLst>
                    <a:path w="108" h="38">
                      <a:moveTo>
                        <a:pt x="0" y="0"/>
                      </a:moveTo>
                      <a:lnTo>
                        <a:pt x="3" y="2"/>
                      </a:lnTo>
                      <a:lnTo>
                        <a:pt x="6" y="3"/>
                      </a:lnTo>
                      <a:lnTo>
                        <a:pt x="9" y="3"/>
                      </a:lnTo>
                      <a:lnTo>
                        <a:pt x="12" y="5"/>
                      </a:lnTo>
                      <a:lnTo>
                        <a:pt x="15" y="6"/>
                      </a:lnTo>
                      <a:lnTo>
                        <a:pt x="16" y="6"/>
                      </a:lnTo>
                      <a:lnTo>
                        <a:pt x="19" y="7"/>
                      </a:lnTo>
                      <a:lnTo>
                        <a:pt x="22" y="9"/>
                      </a:lnTo>
                      <a:lnTo>
                        <a:pt x="25" y="9"/>
                      </a:lnTo>
                      <a:lnTo>
                        <a:pt x="28" y="10"/>
                      </a:lnTo>
                      <a:lnTo>
                        <a:pt x="29" y="12"/>
                      </a:lnTo>
                      <a:lnTo>
                        <a:pt x="32" y="12"/>
                      </a:lnTo>
                      <a:lnTo>
                        <a:pt x="35" y="13"/>
                      </a:lnTo>
                      <a:lnTo>
                        <a:pt x="38" y="15"/>
                      </a:lnTo>
                      <a:lnTo>
                        <a:pt x="41" y="15"/>
                      </a:lnTo>
                      <a:lnTo>
                        <a:pt x="42" y="16"/>
                      </a:lnTo>
                      <a:lnTo>
                        <a:pt x="45" y="17"/>
                      </a:lnTo>
                      <a:lnTo>
                        <a:pt x="48" y="17"/>
                      </a:lnTo>
                      <a:lnTo>
                        <a:pt x="51" y="19"/>
                      </a:lnTo>
                      <a:lnTo>
                        <a:pt x="53" y="20"/>
                      </a:lnTo>
                      <a:lnTo>
                        <a:pt x="56" y="20"/>
                      </a:lnTo>
                      <a:lnTo>
                        <a:pt x="58" y="22"/>
                      </a:lnTo>
                      <a:lnTo>
                        <a:pt x="61" y="23"/>
                      </a:lnTo>
                      <a:lnTo>
                        <a:pt x="63" y="23"/>
                      </a:lnTo>
                      <a:lnTo>
                        <a:pt x="66" y="25"/>
                      </a:lnTo>
                      <a:lnTo>
                        <a:pt x="69" y="25"/>
                      </a:lnTo>
                      <a:lnTo>
                        <a:pt x="72" y="26"/>
                      </a:lnTo>
                      <a:lnTo>
                        <a:pt x="74" y="27"/>
                      </a:lnTo>
                      <a:lnTo>
                        <a:pt x="76" y="27"/>
                      </a:lnTo>
                      <a:lnTo>
                        <a:pt x="79" y="29"/>
                      </a:lnTo>
                      <a:lnTo>
                        <a:pt x="82" y="29"/>
                      </a:lnTo>
                      <a:lnTo>
                        <a:pt x="85" y="30"/>
                      </a:lnTo>
                      <a:lnTo>
                        <a:pt x="88" y="32"/>
                      </a:lnTo>
                      <a:lnTo>
                        <a:pt x="91" y="32"/>
                      </a:lnTo>
                      <a:lnTo>
                        <a:pt x="92" y="33"/>
                      </a:lnTo>
                      <a:lnTo>
                        <a:pt x="95" y="33"/>
                      </a:lnTo>
                      <a:lnTo>
                        <a:pt x="98" y="35"/>
                      </a:lnTo>
                      <a:lnTo>
                        <a:pt x="101" y="36"/>
                      </a:lnTo>
                      <a:lnTo>
                        <a:pt x="104" y="36"/>
                      </a:lnTo>
                      <a:lnTo>
                        <a:pt x="107" y="38"/>
                      </a:lnTo>
                      <a:lnTo>
                        <a:pt x="108" y="38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8" name="Freeform 223"/>
                <p:cNvSpPr/>
                <p:nvPr/>
              </p:nvSpPr>
              <p:spPr bwMode="auto">
                <a:xfrm>
                  <a:off x="3143" y="3485"/>
                  <a:ext cx="103" cy="46"/>
                </a:xfrm>
                <a:custGeom>
                  <a:avLst/>
                  <a:gdLst>
                    <a:gd name="T0" fmla="*/ 103 w 103"/>
                    <a:gd name="T1" fmla="*/ 46 h 46"/>
                    <a:gd name="T2" fmla="*/ 99 w 103"/>
                    <a:gd name="T3" fmla="*/ 45 h 46"/>
                    <a:gd name="T4" fmla="*/ 95 w 103"/>
                    <a:gd name="T5" fmla="*/ 43 h 46"/>
                    <a:gd name="T6" fmla="*/ 90 w 103"/>
                    <a:gd name="T7" fmla="*/ 40 h 46"/>
                    <a:gd name="T8" fmla="*/ 86 w 103"/>
                    <a:gd name="T9" fmla="*/ 39 h 46"/>
                    <a:gd name="T10" fmla="*/ 80 w 103"/>
                    <a:gd name="T11" fmla="*/ 38 h 46"/>
                    <a:gd name="T12" fmla="*/ 76 w 103"/>
                    <a:gd name="T13" fmla="*/ 35 h 46"/>
                    <a:gd name="T14" fmla="*/ 72 w 103"/>
                    <a:gd name="T15" fmla="*/ 33 h 46"/>
                    <a:gd name="T16" fmla="*/ 68 w 103"/>
                    <a:gd name="T17" fmla="*/ 32 h 46"/>
                    <a:gd name="T18" fmla="*/ 63 w 103"/>
                    <a:gd name="T19" fmla="*/ 29 h 46"/>
                    <a:gd name="T20" fmla="*/ 59 w 103"/>
                    <a:gd name="T21" fmla="*/ 28 h 46"/>
                    <a:gd name="T22" fmla="*/ 53 w 103"/>
                    <a:gd name="T23" fmla="*/ 26 h 46"/>
                    <a:gd name="T24" fmla="*/ 49 w 103"/>
                    <a:gd name="T25" fmla="*/ 23 h 46"/>
                    <a:gd name="T26" fmla="*/ 45 w 103"/>
                    <a:gd name="T27" fmla="*/ 22 h 46"/>
                    <a:gd name="T28" fmla="*/ 40 w 103"/>
                    <a:gd name="T29" fmla="*/ 19 h 46"/>
                    <a:gd name="T30" fmla="*/ 36 w 103"/>
                    <a:gd name="T31" fmla="*/ 18 h 46"/>
                    <a:gd name="T32" fmla="*/ 32 w 103"/>
                    <a:gd name="T33" fmla="*/ 16 h 46"/>
                    <a:gd name="T34" fmla="*/ 26 w 103"/>
                    <a:gd name="T35" fmla="*/ 13 h 46"/>
                    <a:gd name="T36" fmla="*/ 22 w 103"/>
                    <a:gd name="T37" fmla="*/ 12 h 46"/>
                    <a:gd name="T38" fmla="*/ 17 w 103"/>
                    <a:gd name="T39" fmla="*/ 9 h 46"/>
                    <a:gd name="T40" fmla="*/ 13 w 103"/>
                    <a:gd name="T41" fmla="*/ 7 h 46"/>
                    <a:gd name="T42" fmla="*/ 9 w 103"/>
                    <a:gd name="T43" fmla="*/ 5 h 46"/>
                    <a:gd name="T44" fmla="*/ 4 w 103"/>
                    <a:gd name="T45" fmla="*/ 3 h 46"/>
                    <a:gd name="T46" fmla="*/ 0 w 103"/>
                    <a:gd name="T47" fmla="*/ 0 h 4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</a:cxnLst>
                  <a:rect l="0" t="0" r="r" b="b"/>
                  <a:pathLst>
                    <a:path w="103" h="46">
                      <a:moveTo>
                        <a:pt x="103" y="46"/>
                      </a:moveTo>
                      <a:lnTo>
                        <a:pt x="99" y="45"/>
                      </a:lnTo>
                      <a:lnTo>
                        <a:pt x="95" y="43"/>
                      </a:lnTo>
                      <a:lnTo>
                        <a:pt x="90" y="40"/>
                      </a:lnTo>
                      <a:lnTo>
                        <a:pt x="86" y="39"/>
                      </a:lnTo>
                      <a:lnTo>
                        <a:pt x="80" y="38"/>
                      </a:lnTo>
                      <a:lnTo>
                        <a:pt x="76" y="35"/>
                      </a:lnTo>
                      <a:lnTo>
                        <a:pt x="72" y="33"/>
                      </a:lnTo>
                      <a:lnTo>
                        <a:pt x="68" y="32"/>
                      </a:lnTo>
                      <a:lnTo>
                        <a:pt x="63" y="29"/>
                      </a:lnTo>
                      <a:lnTo>
                        <a:pt x="59" y="28"/>
                      </a:lnTo>
                      <a:lnTo>
                        <a:pt x="53" y="26"/>
                      </a:lnTo>
                      <a:lnTo>
                        <a:pt x="49" y="23"/>
                      </a:lnTo>
                      <a:lnTo>
                        <a:pt x="45" y="22"/>
                      </a:lnTo>
                      <a:lnTo>
                        <a:pt x="40" y="19"/>
                      </a:lnTo>
                      <a:lnTo>
                        <a:pt x="36" y="18"/>
                      </a:lnTo>
                      <a:lnTo>
                        <a:pt x="32" y="16"/>
                      </a:lnTo>
                      <a:lnTo>
                        <a:pt x="26" y="13"/>
                      </a:lnTo>
                      <a:lnTo>
                        <a:pt x="22" y="12"/>
                      </a:lnTo>
                      <a:lnTo>
                        <a:pt x="17" y="9"/>
                      </a:lnTo>
                      <a:lnTo>
                        <a:pt x="13" y="7"/>
                      </a:lnTo>
                      <a:lnTo>
                        <a:pt x="9" y="5"/>
                      </a:lnTo>
                      <a:lnTo>
                        <a:pt x="4" y="3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0" name="Line 225"/>
                <p:cNvSpPr>
                  <a:spLocks noChangeShapeType="1"/>
                </p:cNvSpPr>
                <p:nvPr/>
              </p:nvSpPr>
              <p:spPr bwMode="auto">
                <a:xfrm flipH="1">
                  <a:off x="3248" y="3470"/>
                  <a:ext cx="23" cy="58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1" name="Freeform 226"/>
                <p:cNvSpPr/>
                <p:nvPr/>
              </p:nvSpPr>
              <p:spPr bwMode="auto">
                <a:xfrm>
                  <a:off x="3383" y="3505"/>
                  <a:ext cx="111" cy="29"/>
                </a:xfrm>
                <a:custGeom>
                  <a:avLst/>
                  <a:gdLst>
                    <a:gd name="T0" fmla="*/ 0 w 111"/>
                    <a:gd name="T1" fmla="*/ 0 h 29"/>
                    <a:gd name="T2" fmla="*/ 1 w 111"/>
                    <a:gd name="T3" fmla="*/ 0 h 29"/>
                    <a:gd name="T4" fmla="*/ 4 w 111"/>
                    <a:gd name="T5" fmla="*/ 2 h 29"/>
                    <a:gd name="T6" fmla="*/ 5 w 111"/>
                    <a:gd name="T7" fmla="*/ 2 h 29"/>
                    <a:gd name="T8" fmla="*/ 8 w 111"/>
                    <a:gd name="T9" fmla="*/ 3 h 29"/>
                    <a:gd name="T10" fmla="*/ 10 w 111"/>
                    <a:gd name="T11" fmla="*/ 3 h 29"/>
                    <a:gd name="T12" fmla="*/ 13 w 111"/>
                    <a:gd name="T13" fmla="*/ 5 h 29"/>
                    <a:gd name="T14" fmla="*/ 14 w 111"/>
                    <a:gd name="T15" fmla="*/ 5 h 29"/>
                    <a:gd name="T16" fmla="*/ 17 w 111"/>
                    <a:gd name="T17" fmla="*/ 6 h 29"/>
                    <a:gd name="T18" fmla="*/ 18 w 111"/>
                    <a:gd name="T19" fmla="*/ 6 h 29"/>
                    <a:gd name="T20" fmla="*/ 21 w 111"/>
                    <a:gd name="T21" fmla="*/ 6 h 29"/>
                    <a:gd name="T22" fmla="*/ 23 w 111"/>
                    <a:gd name="T23" fmla="*/ 8 h 29"/>
                    <a:gd name="T24" fmla="*/ 25 w 111"/>
                    <a:gd name="T25" fmla="*/ 8 h 29"/>
                    <a:gd name="T26" fmla="*/ 27 w 111"/>
                    <a:gd name="T27" fmla="*/ 9 h 29"/>
                    <a:gd name="T28" fmla="*/ 30 w 111"/>
                    <a:gd name="T29" fmla="*/ 9 h 29"/>
                    <a:gd name="T30" fmla="*/ 31 w 111"/>
                    <a:gd name="T31" fmla="*/ 10 h 29"/>
                    <a:gd name="T32" fmla="*/ 34 w 111"/>
                    <a:gd name="T33" fmla="*/ 10 h 29"/>
                    <a:gd name="T34" fmla="*/ 35 w 111"/>
                    <a:gd name="T35" fmla="*/ 10 h 29"/>
                    <a:gd name="T36" fmla="*/ 38 w 111"/>
                    <a:gd name="T37" fmla="*/ 12 h 29"/>
                    <a:gd name="T38" fmla="*/ 40 w 111"/>
                    <a:gd name="T39" fmla="*/ 12 h 29"/>
                    <a:gd name="T40" fmla="*/ 43 w 111"/>
                    <a:gd name="T41" fmla="*/ 13 h 29"/>
                    <a:gd name="T42" fmla="*/ 44 w 111"/>
                    <a:gd name="T43" fmla="*/ 13 h 29"/>
                    <a:gd name="T44" fmla="*/ 47 w 111"/>
                    <a:gd name="T45" fmla="*/ 13 h 29"/>
                    <a:gd name="T46" fmla="*/ 48 w 111"/>
                    <a:gd name="T47" fmla="*/ 15 h 29"/>
                    <a:gd name="T48" fmla="*/ 51 w 111"/>
                    <a:gd name="T49" fmla="*/ 15 h 29"/>
                    <a:gd name="T50" fmla="*/ 53 w 111"/>
                    <a:gd name="T51" fmla="*/ 16 h 29"/>
                    <a:gd name="T52" fmla="*/ 56 w 111"/>
                    <a:gd name="T53" fmla="*/ 16 h 29"/>
                    <a:gd name="T54" fmla="*/ 57 w 111"/>
                    <a:gd name="T55" fmla="*/ 16 h 29"/>
                    <a:gd name="T56" fmla="*/ 60 w 111"/>
                    <a:gd name="T57" fmla="*/ 18 h 29"/>
                    <a:gd name="T58" fmla="*/ 61 w 111"/>
                    <a:gd name="T59" fmla="*/ 18 h 29"/>
                    <a:gd name="T60" fmla="*/ 64 w 111"/>
                    <a:gd name="T61" fmla="*/ 19 h 29"/>
                    <a:gd name="T62" fmla="*/ 66 w 111"/>
                    <a:gd name="T63" fmla="*/ 19 h 29"/>
                    <a:gd name="T64" fmla="*/ 68 w 111"/>
                    <a:gd name="T65" fmla="*/ 19 h 29"/>
                    <a:gd name="T66" fmla="*/ 71 w 111"/>
                    <a:gd name="T67" fmla="*/ 20 h 29"/>
                    <a:gd name="T68" fmla="*/ 73 w 111"/>
                    <a:gd name="T69" fmla="*/ 20 h 29"/>
                    <a:gd name="T70" fmla="*/ 76 w 111"/>
                    <a:gd name="T71" fmla="*/ 20 h 29"/>
                    <a:gd name="T72" fmla="*/ 77 w 111"/>
                    <a:gd name="T73" fmla="*/ 22 h 29"/>
                    <a:gd name="T74" fmla="*/ 80 w 111"/>
                    <a:gd name="T75" fmla="*/ 22 h 29"/>
                    <a:gd name="T76" fmla="*/ 81 w 111"/>
                    <a:gd name="T77" fmla="*/ 22 h 29"/>
                    <a:gd name="T78" fmla="*/ 84 w 111"/>
                    <a:gd name="T79" fmla="*/ 23 h 29"/>
                    <a:gd name="T80" fmla="*/ 86 w 111"/>
                    <a:gd name="T81" fmla="*/ 23 h 29"/>
                    <a:gd name="T82" fmla="*/ 89 w 111"/>
                    <a:gd name="T83" fmla="*/ 25 h 29"/>
                    <a:gd name="T84" fmla="*/ 90 w 111"/>
                    <a:gd name="T85" fmla="*/ 25 h 29"/>
                    <a:gd name="T86" fmla="*/ 93 w 111"/>
                    <a:gd name="T87" fmla="*/ 25 h 29"/>
                    <a:gd name="T88" fmla="*/ 94 w 111"/>
                    <a:gd name="T89" fmla="*/ 26 h 29"/>
                    <a:gd name="T90" fmla="*/ 97 w 111"/>
                    <a:gd name="T91" fmla="*/ 26 h 29"/>
                    <a:gd name="T92" fmla="*/ 99 w 111"/>
                    <a:gd name="T93" fmla="*/ 26 h 29"/>
                    <a:gd name="T94" fmla="*/ 101 w 111"/>
                    <a:gd name="T95" fmla="*/ 28 h 29"/>
                    <a:gd name="T96" fmla="*/ 103 w 111"/>
                    <a:gd name="T97" fmla="*/ 28 h 29"/>
                    <a:gd name="T98" fmla="*/ 106 w 111"/>
                    <a:gd name="T99" fmla="*/ 28 h 29"/>
                    <a:gd name="T100" fmla="*/ 107 w 111"/>
                    <a:gd name="T101" fmla="*/ 29 h 29"/>
                    <a:gd name="T102" fmla="*/ 110 w 111"/>
                    <a:gd name="T103" fmla="*/ 29 h 29"/>
                    <a:gd name="T104" fmla="*/ 111 w 111"/>
                    <a:gd name="T105" fmla="*/ 29 h 2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  <a:cxn ang="0">
                      <a:pos x="T90" y="T91"/>
                    </a:cxn>
                    <a:cxn ang="0">
                      <a:pos x="T92" y="T93"/>
                    </a:cxn>
                    <a:cxn ang="0">
                      <a:pos x="T94" y="T95"/>
                    </a:cxn>
                    <a:cxn ang="0">
                      <a:pos x="T96" y="T97"/>
                    </a:cxn>
                    <a:cxn ang="0">
                      <a:pos x="T98" y="T99"/>
                    </a:cxn>
                    <a:cxn ang="0">
                      <a:pos x="T100" y="T101"/>
                    </a:cxn>
                    <a:cxn ang="0">
                      <a:pos x="T102" y="T103"/>
                    </a:cxn>
                    <a:cxn ang="0">
                      <a:pos x="T104" y="T105"/>
                    </a:cxn>
                  </a:cxnLst>
                  <a:rect l="0" t="0" r="r" b="b"/>
                  <a:pathLst>
                    <a:path w="111" h="29">
                      <a:moveTo>
                        <a:pt x="0" y="0"/>
                      </a:moveTo>
                      <a:lnTo>
                        <a:pt x="1" y="0"/>
                      </a:lnTo>
                      <a:lnTo>
                        <a:pt x="4" y="2"/>
                      </a:lnTo>
                      <a:lnTo>
                        <a:pt x="5" y="2"/>
                      </a:lnTo>
                      <a:lnTo>
                        <a:pt x="8" y="3"/>
                      </a:lnTo>
                      <a:lnTo>
                        <a:pt x="10" y="3"/>
                      </a:lnTo>
                      <a:lnTo>
                        <a:pt x="13" y="5"/>
                      </a:lnTo>
                      <a:lnTo>
                        <a:pt x="14" y="5"/>
                      </a:lnTo>
                      <a:lnTo>
                        <a:pt x="17" y="6"/>
                      </a:lnTo>
                      <a:lnTo>
                        <a:pt x="18" y="6"/>
                      </a:lnTo>
                      <a:lnTo>
                        <a:pt x="21" y="6"/>
                      </a:lnTo>
                      <a:lnTo>
                        <a:pt x="23" y="8"/>
                      </a:lnTo>
                      <a:lnTo>
                        <a:pt x="25" y="8"/>
                      </a:lnTo>
                      <a:lnTo>
                        <a:pt x="27" y="9"/>
                      </a:lnTo>
                      <a:lnTo>
                        <a:pt x="30" y="9"/>
                      </a:lnTo>
                      <a:lnTo>
                        <a:pt x="31" y="10"/>
                      </a:lnTo>
                      <a:lnTo>
                        <a:pt x="34" y="10"/>
                      </a:lnTo>
                      <a:lnTo>
                        <a:pt x="35" y="10"/>
                      </a:lnTo>
                      <a:lnTo>
                        <a:pt x="38" y="12"/>
                      </a:lnTo>
                      <a:lnTo>
                        <a:pt x="40" y="12"/>
                      </a:lnTo>
                      <a:lnTo>
                        <a:pt x="43" y="13"/>
                      </a:lnTo>
                      <a:lnTo>
                        <a:pt x="44" y="13"/>
                      </a:lnTo>
                      <a:lnTo>
                        <a:pt x="47" y="13"/>
                      </a:lnTo>
                      <a:lnTo>
                        <a:pt x="48" y="15"/>
                      </a:lnTo>
                      <a:lnTo>
                        <a:pt x="51" y="15"/>
                      </a:lnTo>
                      <a:lnTo>
                        <a:pt x="53" y="16"/>
                      </a:lnTo>
                      <a:lnTo>
                        <a:pt x="56" y="16"/>
                      </a:lnTo>
                      <a:lnTo>
                        <a:pt x="57" y="16"/>
                      </a:lnTo>
                      <a:lnTo>
                        <a:pt x="60" y="18"/>
                      </a:lnTo>
                      <a:lnTo>
                        <a:pt x="61" y="18"/>
                      </a:lnTo>
                      <a:lnTo>
                        <a:pt x="64" y="19"/>
                      </a:lnTo>
                      <a:lnTo>
                        <a:pt x="66" y="19"/>
                      </a:lnTo>
                      <a:lnTo>
                        <a:pt x="68" y="19"/>
                      </a:lnTo>
                      <a:lnTo>
                        <a:pt x="71" y="20"/>
                      </a:lnTo>
                      <a:lnTo>
                        <a:pt x="73" y="20"/>
                      </a:lnTo>
                      <a:lnTo>
                        <a:pt x="76" y="20"/>
                      </a:lnTo>
                      <a:lnTo>
                        <a:pt x="77" y="22"/>
                      </a:lnTo>
                      <a:lnTo>
                        <a:pt x="80" y="22"/>
                      </a:lnTo>
                      <a:lnTo>
                        <a:pt x="81" y="22"/>
                      </a:lnTo>
                      <a:lnTo>
                        <a:pt x="84" y="23"/>
                      </a:lnTo>
                      <a:lnTo>
                        <a:pt x="86" y="23"/>
                      </a:lnTo>
                      <a:lnTo>
                        <a:pt x="89" y="25"/>
                      </a:lnTo>
                      <a:lnTo>
                        <a:pt x="90" y="25"/>
                      </a:lnTo>
                      <a:lnTo>
                        <a:pt x="93" y="25"/>
                      </a:lnTo>
                      <a:lnTo>
                        <a:pt x="94" y="26"/>
                      </a:lnTo>
                      <a:lnTo>
                        <a:pt x="97" y="26"/>
                      </a:lnTo>
                      <a:lnTo>
                        <a:pt x="99" y="26"/>
                      </a:lnTo>
                      <a:lnTo>
                        <a:pt x="101" y="28"/>
                      </a:lnTo>
                      <a:lnTo>
                        <a:pt x="103" y="28"/>
                      </a:lnTo>
                      <a:lnTo>
                        <a:pt x="106" y="28"/>
                      </a:lnTo>
                      <a:lnTo>
                        <a:pt x="107" y="29"/>
                      </a:lnTo>
                      <a:lnTo>
                        <a:pt x="110" y="29"/>
                      </a:lnTo>
                      <a:lnTo>
                        <a:pt x="111" y="29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2" name="Freeform 227"/>
                <p:cNvSpPr/>
                <p:nvPr/>
              </p:nvSpPr>
              <p:spPr bwMode="auto">
                <a:xfrm>
                  <a:off x="3272" y="3467"/>
                  <a:ext cx="111" cy="38"/>
                </a:xfrm>
                <a:custGeom>
                  <a:avLst/>
                  <a:gdLst>
                    <a:gd name="T0" fmla="*/ 111 w 111"/>
                    <a:gd name="T1" fmla="*/ 38 h 38"/>
                    <a:gd name="T2" fmla="*/ 105 w 111"/>
                    <a:gd name="T3" fmla="*/ 37 h 38"/>
                    <a:gd name="T4" fmla="*/ 101 w 111"/>
                    <a:gd name="T5" fmla="*/ 36 h 38"/>
                    <a:gd name="T6" fmla="*/ 96 w 111"/>
                    <a:gd name="T7" fmla="*/ 34 h 38"/>
                    <a:gd name="T8" fmla="*/ 91 w 111"/>
                    <a:gd name="T9" fmla="*/ 33 h 38"/>
                    <a:gd name="T10" fmla="*/ 86 w 111"/>
                    <a:gd name="T11" fmla="*/ 31 h 38"/>
                    <a:gd name="T12" fmla="*/ 82 w 111"/>
                    <a:gd name="T13" fmla="*/ 30 h 38"/>
                    <a:gd name="T14" fmla="*/ 76 w 111"/>
                    <a:gd name="T15" fmla="*/ 28 h 38"/>
                    <a:gd name="T16" fmla="*/ 72 w 111"/>
                    <a:gd name="T17" fmla="*/ 25 h 38"/>
                    <a:gd name="T18" fmla="*/ 66 w 111"/>
                    <a:gd name="T19" fmla="*/ 24 h 38"/>
                    <a:gd name="T20" fmla="*/ 62 w 111"/>
                    <a:gd name="T21" fmla="*/ 23 h 38"/>
                    <a:gd name="T22" fmla="*/ 58 w 111"/>
                    <a:gd name="T23" fmla="*/ 21 h 38"/>
                    <a:gd name="T24" fmla="*/ 52 w 111"/>
                    <a:gd name="T25" fmla="*/ 20 h 38"/>
                    <a:gd name="T26" fmla="*/ 48 w 111"/>
                    <a:gd name="T27" fmla="*/ 18 h 38"/>
                    <a:gd name="T28" fmla="*/ 43 w 111"/>
                    <a:gd name="T29" fmla="*/ 17 h 38"/>
                    <a:gd name="T30" fmla="*/ 37 w 111"/>
                    <a:gd name="T31" fmla="*/ 14 h 38"/>
                    <a:gd name="T32" fmla="*/ 33 w 111"/>
                    <a:gd name="T33" fmla="*/ 13 h 38"/>
                    <a:gd name="T34" fmla="*/ 29 w 111"/>
                    <a:gd name="T35" fmla="*/ 11 h 38"/>
                    <a:gd name="T36" fmla="*/ 23 w 111"/>
                    <a:gd name="T37" fmla="*/ 10 h 38"/>
                    <a:gd name="T38" fmla="*/ 19 w 111"/>
                    <a:gd name="T39" fmla="*/ 7 h 38"/>
                    <a:gd name="T40" fmla="*/ 15 w 111"/>
                    <a:gd name="T41" fmla="*/ 5 h 38"/>
                    <a:gd name="T42" fmla="*/ 10 w 111"/>
                    <a:gd name="T43" fmla="*/ 4 h 38"/>
                    <a:gd name="T44" fmla="*/ 5 w 111"/>
                    <a:gd name="T45" fmla="*/ 3 h 38"/>
                    <a:gd name="T46" fmla="*/ 0 w 111"/>
                    <a:gd name="T47" fmla="*/ 0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</a:cxnLst>
                  <a:rect l="0" t="0" r="r" b="b"/>
                  <a:pathLst>
                    <a:path w="111" h="38">
                      <a:moveTo>
                        <a:pt x="111" y="38"/>
                      </a:moveTo>
                      <a:lnTo>
                        <a:pt x="105" y="37"/>
                      </a:lnTo>
                      <a:lnTo>
                        <a:pt x="101" y="36"/>
                      </a:lnTo>
                      <a:lnTo>
                        <a:pt x="96" y="34"/>
                      </a:lnTo>
                      <a:lnTo>
                        <a:pt x="91" y="33"/>
                      </a:lnTo>
                      <a:lnTo>
                        <a:pt x="86" y="31"/>
                      </a:lnTo>
                      <a:lnTo>
                        <a:pt x="82" y="30"/>
                      </a:lnTo>
                      <a:lnTo>
                        <a:pt x="76" y="28"/>
                      </a:lnTo>
                      <a:lnTo>
                        <a:pt x="72" y="25"/>
                      </a:lnTo>
                      <a:lnTo>
                        <a:pt x="66" y="24"/>
                      </a:lnTo>
                      <a:lnTo>
                        <a:pt x="62" y="23"/>
                      </a:lnTo>
                      <a:lnTo>
                        <a:pt x="58" y="21"/>
                      </a:lnTo>
                      <a:lnTo>
                        <a:pt x="52" y="20"/>
                      </a:lnTo>
                      <a:lnTo>
                        <a:pt x="48" y="18"/>
                      </a:lnTo>
                      <a:lnTo>
                        <a:pt x="43" y="17"/>
                      </a:lnTo>
                      <a:lnTo>
                        <a:pt x="37" y="14"/>
                      </a:lnTo>
                      <a:lnTo>
                        <a:pt x="33" y="13"/>
                      </a:lnTo>
                      <a:lnTo>
                        <a:pt x="29" y="11"/>
                      </a:lnTo>
                      <a:lnTo>
                        <a:pt x="23" y="10"/>
                      </a:lnTo>
                      <a:lnTo>
                        <a:pt x="19" y="7"/>
                      </a:lnTo>
                      <a:lnTo>
                        <a:pt x="15" y="5"/>
                      </a:lnTo>
                      <a:lnTo>
                        <a:pt x="10" y="4"/>
                      </a:lnTo>
                      <a:lnTo>
                        <a:pt x="5" y="3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4" name="Line 229"/>
                <p:cNvSpPr>
                  <a:spLocks noChangeShapeType="1"/>
                </p:cNvSpPr>
                <p:nvPr/>
              </p:nvSpPr>
              <p:spPr bwMode="auto">
                <a:xfrm flipH="1">
                  <a:off x="3384" y="3442"/>
                  <a:ext cx="17" cy="61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5" name="Freeform 230"/>
                <p:cNvSpPr/>
                <p:nvPr/>
              </p:nvSpPr>
              <p:spPr bwMode="auto">
                <a:xfrm>
                  <a:off x="3513" y="3468"/>
                  <a:ext cx="113" cy="19"/>
                </a:xfrm>
                <a:custGeom>
                  <a:avLst/>
                  <a:gdLst>
                    <a:gd name="T0" fmla="*/ 0 w 113"/>
                    <a:gd name="T1" fmla="*/ 0 h 19"/>
                    <a:gd name="T2" fmla="*/ 2 w 113"/>
                    <a:gd name="T3" fmla="*/ 0 h 19"/>
                    <a:gd name="T4" fmla="*/ 4 w 113"/>
                    <a:gd name="T5" fmla="*/ 0 h 19"/>
                    <a:gd name="T6" fmla="*/ 6 w 113"/>
                    <a:gd name="T7" fmla="*/ 2 h 19"/>
                    <a:gd name="T8" fmla="*/ 7 w 113"/>
                    <a:gd name="T9" fmla="*/ 2 h 19"/>
                    <a:gd name="T10" fmla="*/ 9 w 113"/>
                    <a:gd name="T11" fmla="*/ 2 h 19"/>
                    <a:gd name="T12" fmla="*/ 12 w 113"/>
                    <a:gd name="T13" fmla="*/ 3 h 19"/>
                    <a:gd name="T14" fmla="*/ 13 w 113"/>
                    <a:gd name="T15" fmla="*/ 3 h 19"/>
                    <a:gd name="T16" fmla="*/ 14 w 113"/>
                    <a:gd name="T17" fmla="*/ 3 h 19"/>
                    <a:gd name="T18" fmla="*/ 16 w 113"/>
                    <a:gd name="T19" fmla="*/ 3 h 19"/>
                    <a:gd name="T20" fmla="*/ 19 w 113"/>
                    <a:gd name="T21" fmla="*/ 4 h 19"/>
                    <a:gd name="T22" fmla="*/ 20 w 113"/>
                    <a:gd name="T23" fmla="*/ 4 h 19"/>
                    <a:gd name="T24" fmla="*/ 22 w 113"/>
                    <a:gd name="T25" fmla="*/ 4 h 19"/>
                    <a:gd name="T26" fmla="*/ 25 w 113"/>
                    <a:gd name="T27" fmla="*/ 4 h 19"/>
                    <a:gd name="T28" fmla="*/ 26 w 113"/>
                    <a:gd name="T29" fmla="*/ 6 h 19"/>
                    <a:gd name="T30" fmla="*/ 27 w 113"/>
                    <a:gd name="T31" fmla="*/ 6 h 19"/>
                    <a:gd name="T32" fmla="*/ 29 w 113"/>
                    <a:gd name="T33" fmla="*/ 6 h 19"/>
                    <a:gd name="T34" fmla="*/ 32 w 113"/>
                    <a:gd name="T35" fmla="*/ 6 h 19"/>
                    <a:gd name="T36" fmla="*/ 33 w 113"/>
                    <a:gd name="T37" fmla="*/ 7 h 19"/>
                    <a:gd name="T38" fmla="*/ 35 w 113"/>
                    <a:gd name="T39" fmla="*/ 7 h 19"/>
                    <a:gd name="T40" fmla="*/ 36 w 113"/>
                    <a:gd name="T41" fmla="*/ 7 h 19"/>
                    <a:gd name="T42" fmla="*/ 39 w 113"/>
                    <a:gd name="T43" fmla="*/ 7 h 19"/>
                    <a:gd name="T44" fmla="*/ 40 w 113"/>
                    <a:gd name="T45" fmla="*/ 7 h 19"/>
                    <a:gd name="T46" fmla="*/ 42 w 113"/>
                    <a:gd name="T47" fmla="*/ 9 h 19"/>
                    <a:gd name="T48" fmla="*/ 43 w 113"/>
                    <a:gd name="T49" fmla="*/ 9 h 19"/>
                    <a:gd name="T50" fmla="*/ 46 w 113"/>
                    <a:gd name="T51" fmla="*/ 9 h 19"/>
                    <a:gd name="T52" fmla="*/ 47 w 113"/>
                    <a:gd name="T53" fmla="*/ 9 h 19"/>
                    <a:gd name="T54" fmla="*/ 49 w 113"/>
                    <a:gd name="T55" fmla="*/ 10 h 19"/>
                    <a:gd name="T56" fmla="*/ 52 w 113"/>
                    <a:gd name="T57" fmla="*/ 10 h 19"/>
                    <a:gd name="T58" fmla="*/ 53 w 113"/>
                    <a:gd name="T59" fmla="*/ 10 h 19"/>
                    <a:gd name="T60" fmla="*/ 55 w 113"/>
                    <a:gd name="T61" fmla="*/ 10 h 19"/>
                    <a:gd name="T62" fmla="*/ 56 w 113"/>
                    <a:gd name="T63" fmla="*/ 10 h 19"/>
                    <a:gd name="T64" fmla="*/ 59 w 113"/>
                    <a:gd name="T65" fmla="*/ 12 h 19"/>
                    <a:gd name="T66" fmla="*/ 60 w 113"/>
                    <a:gd name="T67" fmla="*/ 12 h 19"/>
                    <a:gd name="T68" fmla="*/ 62 w 113"/>
                    <a:gd name="T69" fmla="*/ 12 h 19"/>
                    <a:gd name="T70" fmla="*/ 63 w 113"/>
                    <a:gd name="T71" fmla="*/ 12 h 19"/>
                    <a:gd name="T72" fmla="*/ 66 w 113"/>
                    <a:gd name="T73" fmla="*/ 13 h 19"/>
                    <a:gd name="T74" fmla="*/ 68 w 113"/>
                    <a:gd name="T75" fmla="*/ 13 h 19"/>
                    <a:gd name="T76" fmla="*/ 69 w 113"/>
                    <a:gd name="T77" fmla="*/ 13 h 19"/>
                    <a:gd name="T78" fmla="*/ 72 w 113"/>
                    <a:gd name="T79" fmla="*/ 13 h 19"/>
                    <a:gd name="T80" fmla="*/ 73 w 113"/>
                    <a:gd name="T81" fmla="*/ 13 h 19"/>
                    <a:gd name="T82" fmla="*/ 75 w 113"/>
                    <a:gd name="T83" fmla="*/ 14 h 19"/>
                    <a:gd name="T84" fmla="*/ 76 w 113"/>
                    <a:gd name="T85" fmla="*/ 14 h 19"/>
                    <a:gd name="T86" fmla="*/ 79 w 113"/>
                    <a:gd name="T87" fmla="*/ 14 h 19"/>
                    <a:gd name="T88" fmla="*/ 80 w 113"/>
                    <a:gd name="T89" fmla="*/ 14 h 19"/>
                    <a:gd name="T90" fmla="*/ 82 w 113"/>
                    <a:gd name="T91" fmla="*/ 14 h 19"/>
                    <a:gd name="T92" fmla="*/ 83 w 113"/>
                    <a:gd name="T93" fmla="*/ 16 h 19"/>
                    <a:gd name="T94" fmla="*/ 86 w 113"/>
                    <a:gd name="T95" fmla="*/ 16 h 19"/>
                    <a:gd name="T96" fmla="*/ 88 w 113"/>
                    <a:gd name="T97" fmla="*/ 16 h 19"/>
                    <a:gd name="T98" fmla="*/ 89 w 113"/>
                    <a:gd name="T99" fmla="*/ 16 h 19"/>
                    <a:gd name="T100" fmla="*/ 92 w 113"/>
                    <a:gd name="T101" fmla="*/ 16 h 19"/>
                    <a:gd name="T102" fmla="*/ 93 w 113"/>
                    <a:gd name="T103" fmla="*/ 16 h 19"/>
                    <a:gd name="T104" fmla="*/ 95 w 113"/>
                    <a:gd name="T105" fmla="*/ 17 h 19"/>
                    <a:gd name="T106" fmla="*/ 96 w 113"/>
                    <a:gd name="T107" fmla="*/ 17 h 19"/>
                    <a:gd name="T108" fmla="*/ 99 w 113"/>
                    <a:gd name="T109" fmla="*/ 17 h 19"/>
                    <a:gd name="T110" fmla="*/ 101 w 113"/>
                    <a:gd name="T111" fmla="*/ 17 h 19"/>
                    <a:gd name="T112" fmla="*/ 102 w 113"/>
                    <a:gd name="T113" fmla="*/ 17 h 19"/>
                    <a:gd name="T114" fmla="*/ 105 w 113"/>
                    <a:gd name="T115" fmla="*/ 17 h 19"/>
                    <a:gd name="T116" fmla="*/ 106 w 113"/>
                    <a:gd name="T117" fmla="*/ 19 h 19"/>
                    <a:gd name="T118" fmla="*/ 108 w 113"/>
                    <a:gd name="T119" fmla="*/ 19 h 19"/>
                    <a:gd name="T120" fmla="*/ 109 w 113"/>
                    <a:gd name="T121" fmla="*/ 19 h 19"/>
                    <a:gd name="T122" fmla="*/ 112 w 113"/>
                    <a:gd name="T123" fmla="*/ 19 h 19"/>
                    <a:gd name="T124" fmla="*/ 113 w 113"/>
                    <a:gd name="T125" fmla="*/ 19 h 1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  <a:cxn ang="0">
                      <a:pos x="T90" y="T91"/>
                    </a:cxn>
                    <a:cxn ang="0">
                      <a:pos x="T92" y="T93"/>
                    </a:cxn>
                    <a:cxn ang="0">
                      <a:pos x="T94" y="T95"/>
                    </a:cxn>
                    <a:cxn ang="0">
                      <a:pos x="T96" y="T97"/>
                    </a:cxn>
                    <a:cxn ang="0">
                      <a:pos x="T98" y="T99"/>
                    </a:cxn>
                    <a:cxn ang="0">
                      <a:pos x="T100" y="T101"/>
                    </a:cxn>
                    <a:cxn ang="0">
                      <a:pos x="T102" y="T103"/>
                    </a:cxn>
                    <a:cxn ang="0">
                      <a:pos x="T104" y="T105"/>
                    </a:cxn>
                    <a:cxn ang="0">
                      <a:pos x="T106" y="T107"/>
                    </a:cxn>
                    <a:cxn ang="0">
                      <a:pos x="T108" y="T109"/>
                    </a:cxn>
                    <a:cxn ang="0">
                      <a:pos x="T110" y="T111"/>
                    </a:cxn>
                    <a:cxn ang="0">
                      <a:pos x="T112" y="T113"/>
                    </a:cxn>
                    <a:cxn ang="0">
                      <a:pos x="T114" y="T115"/>
                    </a:cxn>
                    <a:cxn ang="0">
                      <a:pos x="T116" y="T117"/>
                    </a:cxn>
                    <a:cxn ang="0">
                      <a:pos x="T118" y="T119"/>
                    </a:cxn>
                    <a:cxn ang="0">
                      <a:pos x="T120" y="T121"/>
                    </a:cxn>
                    <a:cxn ang="0">
                      <a:pos x="T122" y="T123"/>
                    </a:cxn>
                    <a:cxn ang="0">
                      <a:pos x="T124" y="T125"/>
                    </a:cxn>
                  </a:cxnLst>
                  <a:rect l="0" t="0" r="r" b="b"/>
                  <a:pathLst>
                    <a:path w="113" h="19">
                      <a:moveTo>
                        <a:pt x="0" y="0"/>
                      </a:moveTo>
                      <a:lnTo>
                        <a:pt x="2" y="0"/>
                      </a:lnTo>
                      <a:lnTo>
                        <a:pt x="4" y="0"/>
                      </a:lnTo>
                      <a:lnTo>
                        <a:pt x="6" y="2"/>
                      </a:lnTo>
                      <a:lnTo>
                        <a:pt x="7" y="2"/>
                      </a:lnTo>
                      <a:lnTo>
                        <a:pt x="9" y="2"/>
                      </a:lnTo>
                      <a:lnTo>
                        <a:pt x="12" y="3"/>
                      </a:lnTo>
                      <a:lnTo>
                        <a:pt x="13" y="3"/>
                      </a:lnTo>
                      <a:lnTo>
                        <a:pt x="14" y="3"/>
                      </a:lnTo>
                      <a:lnTo>
                        <a:pt x="16" y="3"/>
                      </a:lnTo>
                      <a:lnTo>
                        <a:pt x="19" y="4"/>
                      </a:lnTo>
                      <a:lnTo>
                        <a:pt x="20" y="4"/>
                      </a:lnTo>
                      <a:lnTo>
                        <a:pt x="22" y="4"/>
                      </a:lnTo>
                      <a:lnTo>
                        <a:pt x="25" y="4"/>
                      </a:lnTo>
                      <a:lnTo>
                        <a:pt x="26" y="6"/>
                      </a:lnTo>
                      <a:lnTo>
                        <a:pt x="27" y="6"/>
                      </a:lnTo>
                      <a:lnTo>
                        <a:pt x="29" y="6"/>
                      </a:lnTo>
                      <a:lnTo>
                        <a:pt x="32" y="6"/>
                      </a:lnTo>
                      <a:lnTo>
                        <a:pt x="33" y="7"/>
                      </a:lnTo>
                      <a:lnTo>
                        <a:pt x="35" y="7"/>
                      </a:lnTo>
                      <a:lnTo>
                        <a:pt x="36" y="7"/>
                      </a:lnTo>
                      <a:lnTo>
                        <a:pt x="39" y="7"/>
                      </a:lnTo>
                      <a:lnTo>
                        <a:pt x="40" y="7"/>
                      </a:lnTo>
                      <a:lnTo>
                        <a:pt x="42" y="9"/>
                      </a:lnTo>
                      <a:lnTo>
                        <a:pt x="43" y="9"/>
                      </a:lnTo>
                      <a:lnTo>
                        <a:pt x="46" y="9"/>
                      </a:lnTo>
                      <a:lnTo>
                        <a:pt x="47" y="9"/>
                      </a:lnTo>
                      <a:lnTo>
                        <a:pt x="49" y="10"/>
                      </a:lnTo>
                      <a:lnTo>
                        <a:pt x="52" y="10"/>
                      </a:lnTo>
                      <a:lnTo>
                        <a:pt x="53" y="10"/>
                      </a:lnTo>
                      <a:lnTo>
                        <a:pt x="55" y="10"/>
                      </a:lnTo>
                      <a:lnTo>
                        <a:pt x="56" y="10"/>
                      </a:lnTo>
                      <a:lnTo>
                        <a:pt x="59" y="12"/>
                      </a:lnTo>
                      <a:lnTo>
                        <a:pt x="60" y="12"/>
                      </a:lnTo>
                      <a:lnTo>
                        <a:pt x="62" y="12"/>
                      </a:lnTo>
                      <a:lnTo>
                        <a:pt x="63" y="12"/>
                      </a:lnTo>
                      <a:lnTo>
                        <a:pt x="66" y="13"/>
                      </a:lnTo>
                      <a:lnTo>
                        <a:pt x="68" y="13"/>
                      </a:lnTo>
                      <a:lnTo>
                        <a:pt x="69" y="13"/>
                      </a:lnTo>
                      <a:lnTo>
                        <a:pt x="72" y="13"/>
                      </a:lnTo>
                      <a:lnTo>
                        <a:pt x="73" y="13"/>
                      </a:lnTo>
                      <a:lnTo>
                        <a:pt x="75" y="14"/>
                      </a:lnTo>
                      <a:lnTo>
                        <a:pt x="76" y="14"/>
                      </a:lnTo>
                      <a:lnTo>
                        <a:pt x="79" y="14"/>
                      </a:lnTo>
                      <a:lnTo>
                        <a:pt x="80" y="14"/>
                      </a:lnTo>
                      <a:lnTo>
                        <a:pt x="82" y="14"/>
                      </a:lnTo>
                      <a:lnTo>
                        <a:pt x="83" y="16"/>
                      </a:lnTo>
                      <a:lnTo>
                        <a:pt x="86" y="16"/>
                      </a:lnTo>
                      <a:lnTo>
                        <a:pt x="88" y="16"/>
                      </a:lnTo>
                      <a:lnTo>
                        <a:pt x="89" y="16"/>
                      </a:lnTo>
                      <a:lnTo>
                        <a:pt x="92" y="16"/>
                      </a:lnTo>
                      <a:lnTo>
                        <a:pt x="93" y="16"/>
                      </a:lnTo>
                      <a:lnTo>
                        <a:pt x="95" y="17"/>
                      </a:lnTo>
                      <a:lnTo>
                        <a:pt x="96" y="17"/>
                      </a:lnTo>
                      <a:lnTo>
                        <a:pt x="99" y="17"/>
                      </a:lnTo>
                      <a:lnTo>
                        <a:pt x="101" y="17"/>
                      </a:lnTo>
                      <a:lnTo>
                        <a:pt x="102" y="17"/>
                      </a:lnTo>
                      <a:lnTo>
                        <a:pt x="105" y="17"/>
                      </a:lnTo>
                      <a:lnTo>
                        <a:pt x="106" y="19"/>
                      </a:lnTo>
                      <a:lnTo>
                        <a:pt x="108" y="19"/>
                      </a:lnTo>
                      <a:lnTo>
                        <a:pt x="109" y="19"/>
                      </a:lnTo>
                      <a:lnTo>
                        <a:pt x="112" y="19"/>
                      </a:lnTo>
                      <a:lnTo>
                        <a:pt x="113" y="19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6" name="Freeform 231"/>
                <p:cNvSpPr/>
                <p:nvPr/>
              </p:nvSpPr>
              <p:spPr bwMode="auto">
                <a:xfrm>
                  <a:off x="3403" y="3439"/>
                  <a:ext cx="110" cy="29"/>
                </a:xfrm>
                <a:custGeom>
                  <a:avLst/>
                  <a:gdLst>
                    <a:gd name="T0" fmla="*/ 110 w 110"/>
                    <a:gd name="T1" fmla="*/ 29 h 29"/>
                    <a:gd name="T2" fmla="*/ 106 w 110"/>
                    <a:gd name="T3" fmla="*/ 28 h 29"/>
                    <a:gd name="T4" fmla="*/ 100 w 110"/>
                    <a:gd name="T5" fmla="*/ 26 h 29"/>
                    <a:gd name="T6" fmla="*/ 94 w 110"/>
                    <a:gd name="T7" fmla="*/ 26 h 29"/>
                    <a:gd name="T8" fmla="*/ 90 w 110"/>
                    <a:gd name="T9" fmla="*/ 25 h 29"/>
                    <a:gd name="T10" fmla="*/ 84 w 110"/>
                    <a:gd name="T11" fmla="*/ 23 h 29"/>
                    <a:gd name="T12" fmla="*/ 80 w 110"/>
                    <a:gd name="T13" fmla="*/ 22 h 29"/>
                    <a:gd name="T14" fmla="*/ 74 w 110"/>
                    <a:gd name="T15" fmla="*/ 20 h 29"/>
                    <a:gd name="T16" fmla="*/ 70 w 110"/>
                    <a:gd name="T17" fmla="*/ 19 h 29"/>
                    <a:gd name="T18" fmla="*/ 64 w 110"/>
                    <a:gd name="T19" fmla="*/ 19 h 29"/>
                    <a:gd name="T20" fmla="*/ 60 w 110"/>
                    <a:gd name="T21" fmla="*/ 18 h 29"/>
                    <a:gd name="T22" fmla="*/ 54 w 110"/>
                    <a:gd name="T23" fmla="*/ 16 h 29"/>
                    <a:gd name="T24" fmla="*/ 50 w 110"/>
                    <a:gd name="T25" fmla="*/ 15 h 29"/>
                    <a:gd name="T26" fmla="*/ 44 w 110"/>
                    <a:gd name="T27" fmla="*/ 13 h 29"/>
                    <a:gd name="T28" fmla="*/ 40 w 110"/>
                    <a:gd name="T29" fmla="*/ 12 h 29"/>
                    <a:gd name="T30" fmla="*/ 34 w 110"/>
                    <a:gd name="T31" fmla="*/ 10 h 29"/>
                    <a:gd name="T32" fmla="*/ 30 w 110"/>
                    <a:gd name="T33" fmla="*/ 9 h 29"/>
                    <a:gd name="T34" fmla="*/ 24 w 110"/>
                    <a:gd name="T35" fmla="*/ 8 h 29"/>
                    <a:gd name="T36" fmla="*/ 20 w 110"/>
                    <a:gd name="T37" fmla="*/ 6 h 29"/>
                    <a:gd name="T38" fmla="*/ 14 w 110"/>
                    <a:gd name="T39" fmla="*/ 5 h 29"/>
                    <a:gd name="T40" fmla="*/ 10 w 110"/>
                    <a:gd name="T41" fmla="*/ 3 h 29"/>
                    <a:gd name="T42" fmla="*/ 4 w 110"/>
                    <a:gd name="T43" fmla="*/ 2 h 29"/>
                    <a:gd name="T44" fmla="*/ 0 w 110"/>
                    <a:gd name="T45" fmla="*/ 0 h 2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</a:cxnLst>
                  <a:rect l="0" t="0" r="r" b="b"/>
                  <a:pathLst>
                    <a:path w="110" h="29">
                      <a:moveTo>
                        <a:pt x="110" y="29"/>
                      </a:moveTo>
                      <a:lnTo>
                        <a:pt x="106" y="28"/>
                      </a:lnTo>
                      <a:lnTo>
                        <a:pt x="100" y="26"/>
                      </a:lnTo>
                      <a:lnTo>
                        <a:pt x="94" y="26"/>
                      </a:lnTo>
                      <a:lnTo>
                        <a:pt x="90" y="25"/>
                      </a:lnTo>
                      <a:lnTo>
                        <a:pt x="84" y="23"/>
                      </a:lnTo>
                      <a:lnTo>
                        <a:pt x="80" y="22"/>
                      </a:lnTo>
                      <a:lnTo>
                        <a:pt x="74" y="20"/>
                      </a:lnTo>
                      <a:lnTo>
                        <a:pt x="70" y="19"/>
                      </a:lnTo>
                      <a:lnTo>
                        <a:pt x="64" y="19"/>
                      </a:lnTo>
                      <a:lnTo>
                        <a:pt x="60" y="18"/>
                      </a:lnTo>
                      <a:lnTo>
                        <a:pt x="54" y="16"/>
                      </a:lnTo>
                      <a:lnTo>
                        <a:pt x="50" y="15"/>
                      </a:lnTo>
                      <a:lnTo>
                        <a:pt x="44" y="13"/>
                      </a:lnTo>
                      <a:lnTo>
                        <a:pt x="40" y="12"/>
                      </a:lnTo>
                      <a:lnTo>
                        <a:pt x="34" y="10"/>
                      </a:lnTo>
                      <a:lnTo>
                        <a:pt x="30" y="9"/>
                      </a:lnTo>
                      <a:lnTo>
                        <a:pt x="24" y="8"/>
                      </a:lnTo>
                      <a:lnTo>
                        <a:pt x="20" y="6"/>
                      </a:lnTo>
                      <a:lnTo>
                        <a:pt x="14" y="5"/>
                      </a:lnTo>
                      <a:lnTo>
                        <a:pt x="10" y="3"/>
                      </a:lnTo>
                      <a:lnTo>
                        <a:pt x="4" y="2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8" name="Line 233"/>
                <p:cNvSpPr>
                  <a:spLocks noChangeShapeType="1"/>
                </p:cNvSpPr>
                <p:nvPr/>
              </p:nvSpPr>
              <p:spPr bwMode="auto">
                <a:xfrm flipH="1">
                  <a:off x="3513" y="3404"/>
                  <a:ext cx="14" cy="61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9" name="Freeform 234"/>
                <p:cNvSpPr/>
                <p:nvPr/>
              </p:nvSpPr>
              <p:spPr bwMode="auto">
                <a:xfrm>
                  <a:off x="3636" y="3419"/>
                  <a:ext cx="111" cy="9"/>
                </a:xfrm>
                <a:custGeom>
                  <a:avLst/>
                  <a:gdLst>
                    <a:gd name="T0" fmla="*/ 2 w 111"/>
                    <a:gd name="T1" fmla="*/ 0 h 9"/>
                    <a:gd name="T2" fmla="*/ 5 w 111"/>
                    <a:gd name="T3" fmla="*/ 0 h 9"/>
                    <a:gd name="T4" fmla="*/ 8 w 111"/>
                    <a:gd name="T5" fmla="*/ 2 h 9"/>
                    <a:gd name="T6" fmla="*/ 12 w 111"/>
                    <a:gd name="T7" fmla="*/ 2 h 9"/>
                    <a:gd name="T8" fmla="*/ 15 w 111"/>
                    <a:gd name="T9" fmla="*/ 2 h 9"/>
                    <a:gd name="T10" fmla="*/ 18 w 111"/>
                    <a:gd name="T11" fmla="*/ 2 h 9"/>
                    <a:gd name="T12" fmla="*/ 21 w 111"/>
                    <a:gd name="T13" fmla="*/ 2 h 9"/>
                    <a:gd name="T14" fmla="*/ 23 w 111"/>
                    <a:gd name="T15" fmla="*/ 3 h 9"/>
                    <a:gd name="T16" fmla="*/ 26 w 111"/>
                    <a:gd name="T17" fmla="*/ 3 h 9"/>
                    <a:gd name="T18" fmla="*/ 29 w 111"/>
                    <a:gd name="T19" fmla="*/ 3 h 9"/>
                    <a:gd name="T20" fmla="*/ 32 w 111"/>
                    <a:gd name="T21" fmla="*/ 3 h 9"/>
                    <a:gd name="T22" fmla="*/ 35 w 111"/>
                    <a:gd name="T23" fmla="*/ 5 h 9"/>
                    <a:gd name="T24" fmla="*/ 38 w 111"/>
                    <a:gd name="T25" fmla="*/ 5 h 9"/>
                    <a:gd name="T26" fmla="*/ 42 w 111"/>
                    <a:gd name="T27" fmla="*/ 5 h 9"/>
                    <a:gd name="T28" fmla="*/ 45 w 111"/>
                    <a:gd name="T29" fmla="*/ 5 h 9"/>
                    <a:gd name="T30" fmla="*/ 48 w 111"/>
                    <a:gd name="T31" fmla="*/ 5 h 9"/>
                    <a:gd name="T32" fmla="*/ 51 w 111"/>
                    <a:gd name="T33" fmla="*/ 6 h 9"/>
                    <a:gd name="T34" fmla="*/ 54 w 111"/>
                    <a:gd name="T35" fmla="*/ 6 h 9"/>
                    <a:gd name="T36" fmla="*/ 56 w 111"/>
                    <a:gd name="T37" fmla="*/ 6 h 9"/>
                    <a:gd name="T38" fmla="*/ 59 w 111"/>
                    <a:gd name="T39" fmla="*/ 6 h 9"/>
                    <a:gd name="T40" fmla="*/ 62 w 111"/>
                    <a:gd name="T41" fmla="*/ 6 h 9"/>
                    <a:gd name="T42" fmla="*/ 65 w 111"/>
                    <a:gd name="T43" fmla="*/ 6 h 9"/>
                    <a:gd name="T44" fmla="*/ 69 w 111"/>
                    <a:gd name="T45" fmla="*/ 7 h 9"/>
                    <a:gd name="T46" fmla="*/ 72 w 111"/>
                    <a:gd name="T47" fmla="*/ 7 h 9"/>
                    <a:gd name="T48" fmla="*/ 75 w 111"/>
                    <a:gd name="T49" fmla="*/ 7 h 9"/>
                    <a:gd name="T50" fmla="*/ 78 w 111"/>
                    <a:gd name="T51" fmla="*/ 7 h 9"/>
                    <a:gd name="T52" fmla="*/ 81 w 111"/>
                    <a:gd name="T53" fmla="*/ 7 h 9"/>
                    <a:gd name="T54" fmla="*/ 84 w 111"/>
                    <a:gd name="T55" fmla="*/ 7 h 9"/>
                    <a:gd name="T56" fmla="*/ 86 w 111"/>
                    <a:gd name="T57" fmla="*/ 7 h 9"/>
                    <a:gd name="T58" fmla="*/ 89 w 111"/>
                    <a:gd name="T59" fmla="*/ 9 h 9"/>
                    <a:gd name="T60" fmla="*/ 92 w 111"/>
                    <a:gd name="T61" fmla="*/ 9 h 9"/>
                    <a:gd name="T62" fmla="*/ 97 w 111"/>
                    <a:gd name="T63" fmla="*/ 9 h 9"/>
                    <a:gd name="T64" fmla="*/ 99 w 111"/>
                    <a:gd name="T65" fmla="*/ 9 h 9"/>
                    <a:gd name="T66" fmla="*/ 102 w 111"/>
                    <a:gd name="T67" fmla="*/ 9 h 9"/>
                    <a:gd name="T68" fmla="*/ 105 w 111"/>
                    <a:gd name="T69" fmla="*/ 9 h 9"/>
                    <a:gd name="T70" fmla="*/ 108 w 111"/>
                    <a:gd name="T71" fmla="*/ 9 h 9"/>
                    <a:gd name="T72" fmla="*/ 111 w 111"/>
                    <a:gd name="T73" fmla="*/ 9 h 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</a:cxnLst>
                  <a:rect l="0" t="0" r="r" b="b"/>
                  <a:pathLst>
                    <a:path w="111" h="9">
                      <a:moveTo>
                        <a:pt x="0" y="0"/>
                      </a:moveTo>
                      <a:lnTo>
                        <a:pt x="2" y="0"/>
                      </a:lnTo>
                      <a:lnTo>
                        <a:pt x="3" y="0"/>
                      </a:lnTo>
                      <a:lnTo>
                        <a:pt x="5" y="0"/>
                      </a:lnTo>
                      <a:lnTo>
                        <a:pt x="6" y="0"/>
                      </a:lnTo>
                      <a:lnTo>
                        <a:pt x="8" y="2"/>
                      </a:lnTo>
                      <a:lnTo>
                        <a:pt x="9" y="2"/>
                      </a:lnTo>
                      <a:lnTo>
                        <a:pt x="12" y="2"/>
                      </a:lnTo>
                      <a:lnTo>
                        <a:pt x="13" y="2"/>
                      </a:lnTo>
                      <a:lnTo>
                        <a:pt x="15" y="2"/>
                      </a:lnTo>
                      <a:lnTo>
                        <a:pt x="16" y="2"/>
                      </a:lnTo>
                      <a:lnTo>
                        <a:pt x="18" y="2"/>
                      </a:lnTo>
                      <a:lnTo>
                        <a:pt x="19" y="2"/>
                      </a:lnTo>
                      <a:lnTo>
                        <a:pt x="21" y="2"/>
                      </a:lnTo>
                      <a:lnTo>
                        <a:pt x="22" y="3"/>
                      </a:lnTo>
                      <a:lnTo>
                        <a:pt x="23" y="3"/>
                      </a:lnTo>
                      <a:lnTo>
                        <a:pt x="25" y="3"/>
                      </a:lnTo>
                      <a:lnTo>
                        <a:pt x="26" y="3"/>
                      </a:lnTo>
                      <a:lnTo>
                        <a:pt x="28" y="3"/>
                      </a:lnTo>
                      <a:lnTo>
                        <a:pt x="29" y="3"/>
                      </a:lnTo>
                      <a:lnTo>
                        <a:pt x="31" y="3"/>
                      </a:lnTo>
                      <a:lnTo>
                        <a:pt x="32" y="3"/>
                      </a:lnTo>
                      <a:lnTo>
                        <a:pt x="33" y="3"/>
                      </a:lnTo>
                      <a:lnTo>
                        <a:pt x="35" y="5"/>
                      </a:lnTo>
                      <a:lnTo>
                        <a:pt x="36" y="5"/>
                      </a:lnTo>
                      <a:lnTo>
                        <a:pt x="38" y="5"/>
                      </a:lnTo>
                      <a:lnTo>
                        <a:pt x="41" y="5"/>
                      </a:lnTo>
                      <a:lnTo>
                        <a:pt x="42" y="5"/>
                      </a:lnTo>
                      <a:lnTo>
                        <a:pt x="43" y="5"/>
                      </a:lnTo>
                      <a:lnTo>
                        <a:pt x="45" y="5"/>
                      </a:lnTo>
                      <a:lnTo>
                        <a:pt x="46" y="5"/>
                      </a:lnTo>
                      <a:lnTo>
                        <a:pt x="48" y="5"/>
                      </a:lnTo>
                      <a:lnTo>
                        <a:pt x="49" y="5"/>
                      </a:lnTo>
                      <a:lnTo>
                        <a:pt x="51" y="6"/>
                      </a:lnTo>
                      <a:lnTo>
                        <a:pt x="52" y="6"/>
                      </a:lnTo>
                      <a:lnTo>
                        <a:pt x="54" y="6"/>
                      </a:lnTo>
                      <a:lnTo>
                        <a:pt x="55" y="6"/>
                      </a:lnTo>
                      <a:lnTo>
                        <a:pt x="56" y="6"/>
                      </a:lnTo>
                      <a:lnTo>
                        <a:pt x="58" y="6"/>
                      </a:lnTo>
                      <a:lnTo>
                        <a:pt x="59" y="6"/>
                      </a:lnTo>
                      <a:lnTo>
                        <a:pt x="61" y="6"/>
                      </a:lnTo>
                      <a:lnTo>
                        <a:pt x="62" y="6"/>
                      </a:lnTo>
                      <a:lnTo>
                        <a:pt x="64" y="6"/>
                      </a:lnTo>
                      <a:lnTo>
                        <a:pt x="65" y="6"/>
                      </a:lnTo>
                      <a:lnTo>
                        <a:pt x="66" y="6"/>
                      </a:lnTo>
                      <a:lnTo>
                        <a:pt x="69" y="7"/>
                      </a:lnTo>
                      <a:lnTo>
                        <a:pt x="71" y="7"/>
                      </a:lnTo>
                      <a:lnTo>
                        <a:pt x="72" y="7"/>
                      </a:lnTo>
                      <a:lnTo>
                        <a:pt x="74" y="7"/>
                      </a:lnTo>
                      <a:lnTo>
                        <a:pt x="75" y="7"/>
                      </a:lnTo>
                      <a:lnTo>
                        <a:pt x="76" y="7"/>
                      </a:lnTo>
                      <a:lnTo>
                        <a:pt x="78" y="7"/>
                      </a:lnTo>
                      <a:lnTo>
                        <a:pt x="79" y="7"/>
                      </a:lnTo>
                      <a:lnTo>
                        <a:pt x="81" y="7"/>
                      </a:lnTo>
                      <a:lnTo>
                        <a:pt x="82" y="7"/>
                      </a:lnTo>
                      <a:lnTo>
                        <a:pt x="84" y="7"/>
                      </a:lnTo>
                      <a:lnTo>
                        <a:pt x="85" y="7"/>
                      </a:lnTo>
                      <a:lnTo>
                        <a:pt x="86" y="7"/>
                      </a:lnTo>
                      <a:lnTo>
                        <a:pt x="88" y="7"/>
                      </a:lnTo>
                      <a:lnTo>
                        <a:pt x="89" y="9"/>
                      </a:lnTo>
                      <a:lnTo>
                        <a:pt x="91" y="9"/>
                      </a:lnTo>
                      <a:lnTo>
                        <a:pt x="92" y="9"/>
                      </a:lnTo>
                      <a:lnTo>
                        <a:pt x="94" y="9"/>
                      </a:lnTo>
                      <a:lnTo>
                        <a:pt x="97" y="9"/>
                      </a:lnTo>
                      <a:lnTo>
                        <a:pt x="98" y="9"/>
                      </a:lnTo>
                      <a:lnTo>
                        <a:pt x="99" y="9"/>
                      </a:lnTo>
                      <a:lnTo>
                        <a:pt x="101" y="9"/>
                      </a:lnTo>
                      <a:lnTo>
                        <a:pt x="102" y="9"/>
                      </a:lnTo>
                      <a:lnTo>
                        <a:pt x="104" y="9"/>
                      </a:lnTo>
                      <a:lnTo>
                        <a:pt x="105" y="9"/>
                      </a:lnTo>
                      <a:lnTo>
                        <a:pt x="107" y="9"/>
                      </a:lnTo>
                      <a:lnTo>
                        <a:pt x="108" y="9"/>
                      </a:lnTo>
                      <a:lnTo>
                        <a:pt x="109" y="9"/>
                      </a:lnTo>
                      <a:lnTo>
                        <a:pt x="111" y="9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0" name="Freeform 235"/>
                <p:cNvSpPr/>
                <p:nvPr/>
              </p:nvSpPr>
              <p:spPr bwMode="auto">
                <a:xfrm>
                  <a:off x="3527" y="3401"/>
                  <a:ext cx="109" cy="18"/>
                </a:xfrm>
                <a:custGeom>
                  <a:avLst/>
                  <a:gdLst>
                    <a:gd name="T0" fmla="*/ 109 w 109"/>
                    <a:gd name="T1" fmla="*/ 18 h 18"/>
                    <a:gd name="T2" fmla="*/ 105 w 109"/>
                    <a:gd name="T3" fmla="*/ 17 h 18"/>
                    <a:gd name="T4" fmla="*/ 99 w 109"/>
                    <a:gd name="T5" fmla="*/ 17 h 18"/>
                    <a:gd name="T6" fmla="*/ 94 w 109"/>
                    <a:gd name="T7" fmla="*/ 15 h 18"/>
                    <a:gd name="T8" fmla="*/ 89 w 109"/>
                    <a:gd name="T9" fmla="*/ 15 h 18"/>
                    <a:gd name="T10" fmla="*/ 84 w 109"/>
                    <a:gd name="T11" fmla="*/ 14 h 18"/>
                    <a:gd name="T12" fmla="*/ 78 w 109"/>
                    <a:gd name="T13" fmla="*/ 14 h 18"/>
                    <a:gd name="T14" fmla="*/ 74 w 109"/>
                    <a:gd name="T15" fmla="*/ 13 h 18"/>
                    <a:gd name="T16" fmla="*/ 68 w 109"/>
                    <a:gd name="T17" fmla="*/ 13 h 18"/>
                    <a:gd name="T18" fmla="*/ 62 w 109"/>
                    <a:gd name="T19" fmla="*/ 11 h 18"/>
                    <a:gd name="T20" fmla="*/ 58 w 109"/>
                    <a:gd name="T21" fmla="*/ 11 h 18"/>
                    <a:gd name="T22" fmla="*/ 52 w 109"/>
                    <a:gd name="T23" fmla="*/ 10 h 18"/>
                    <a:gd name="T24" fmla="*/ 48 w 109"/>
                    <a:gd name="T25" fmla="*/ 8 h 18"/>
                    <a:gd name="T26" fmla="*/ 42 w 109"/>
                    <a:gd name="T27" fmla="*/ 8 h 18"/>
                    <a:gd name="T28" fmla="*/ 36 w 109"/>
                    <a:gd name="T29" fmla="*/ 7 h 18"/>
                    <a:gd name="T30" fmla="*/ 32 w 109"/>
                    <a:gd name="T31" fmla="*/ 5 h 18"/>
                    <a:gd name="T32" fmla="*/ 26 w 109"/>
                    <a:gd name="T33" fmla="*/ 5 h 18"/>
                    <a:gd name="T34" fmla="*/ 21 w 109"/>
                    <a:gd name="T35" fmla="*/ 4 h 18"/>
                    <a:gd name="T36" fmla="*/ 16 w 109"/>
                    <a:gd name="T37" fmla="*/ 3 h 18"/>
                    <a:gd name="T38" fmla="*/ 11 w 109"/>
                    <a:gd name="T39" fmla="*/ 3 h 18"/>
                    <a:gd name="T40" fmla="*/ 6 w 109"/>
                    <a:gd name="T41" fmla="*/ 1 h 18"/>
                    <a:gd name="T42" fmla="*/ 0 w 109"/>
                    <a:gd name="T43" fmla="*/ 0 h 1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</a:cxnLst>
                  <a:rect l="0" t="0" r="r" b="b"/>
                  <a:pathLst>
                    <a:path w="109" h="18">
                      <a:moveTo>
                        <a:pt x="109" y="18"/>
                      </a:moveTo>
                      <a:lnTo>
                        <a:pt x="105" y="17"/>
                      </a:lnTo>
                      <a:lnTo>
                        <a:pt x="99" y="17"/>
                      </a:lnTo>
                      <a:lnTo>
                        <a:pt x="94" y="15"/>
                      </a:lnTo>
                      <a:lnTo>
                        <a:pt x="89" y="15"/>
                      </a:lnTo>
                      <a:lnTo>
                        <a:pt x="84" y="14"/>
                      </a:lnTo>
                      <a:lnTo>
                        <a:pt x="78" y="14"/>
                      </a:lnTo>
                      <a:lnTo>
                        <a:pt x="74" y="13"/>
                      </a:lnTo>
                      <a:lnTo>
                        <a:pt x="68" y="13"/>
                      </a:lnTo>
                      <a:lnTo>
                        <a:pt x="62" y="11"/>
                      </a:lnTo>
                      <a:lnTo>
                        <a:pt x="58" y="11"/>
                      </a:lnTo>
                      <a:lnTo>
                        <a:pt x="52" y="10"/>
                      </a:lnTo>
                      <a:lnTo>
                        <a:pt x="48" y="8"/>
                      </a:lnTo>
                      <a:lnTo>
                        <a:pt x="42" y="8"/>
                      </a:lnTo>
                      <a:lnTo>
                        <a:pt x="36" y="7"/>
                      </a:lnTo>
                      <a:lnTo>
                        <a:pt x="32" y="5"/>
                      </a:lnTo>
                      <a:lnTo>
                        <a:pt x="26" y="5"/>
                      </a:lnTo>
                      <a:lnTo>
                        <a:pt x="21" y="4"/>
                      </a:lnTo>
                      <a:lnTo>
                        <a:pt x="16" y="3"/>
                      </a:lnTo>
                      <a:lnTo>
                        <a:pt x="11" y="3"/>
                      </a:lnTo>
                      <a:lnTo>
                        <a:pt x="6" y="1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2" name="Line 237"/>
                <p:cNvSpPr>
                  <a:spLocks noChangeShapeType="1"/>
                </p:cNvSpPr>
                <p:nvPr/>
              </p:nvSpPr>
              <p:spPr bwMode="auto">
                <a:xfrm flipH="1">
                  <a:off x="3636" y="3353"/>
                  <a:ext cx="9" cy="63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3" name="Freeform 238"/>
                <p:cNvSpPr/>
                <p:nvPr/>
              </p:nvSpPr>
              <p:spPr bwMode="auto">
                <a:xfrm>
                  <a:off x="3751" y="3359"/>
                  <a:ext cx="105" cy="1"/>
                </a:xfrm>
                <a:custGeom>
                  <a:avLst/>
                  <a:gdLst>
                    <a:gd name="T0" fmla="*/ 0 w 105"/>
                    <a:gd name="T1" fmla="*/ 0 h 1"/>
                    <a:gd name="T2" fmla="*/ 3 w 105"/>
                    <a:gd name="T3" fmla="*/ 0 h 1"/>
                    <a:gd name="T4" fmla="*/ 6 w 105"/>
                    <a:gd name="T5" fmla="*/ 0 h 1"/>
                    <a:gd name="T6" fmla="*/ 9 w 105"/>
                    <a:gd name="T7" fmla="*/ 1 h 1"/>
                    <a:gd name="T8" fmla="*/ 12 w 105"/>
                    <a:gd name="T9" fmla="*/ 1 h 1"/>
                    <a:gd name="T10" fmla="*/ 13 w 105"/>
                    <a:gd name="T11" fmla="*/ 1 h 1"/>
                    <a:gd name="T12" fmla="*/ 16 w 105"/>
                    <a:gd name="T13" fmla="*/ 1 h 1"/>
                    <a:gd name="T14" fmla="*/ 19 w 105"/>
                    <a:gd name="T15" fmla="*/ 1 h 1"/>
                    <a:gd name="T16" fmla="*/ 22 w 105"/>
                    <a:gd name="T17" fmla="*/ 1 h 1"/>
                    <a:gd name="T18" fmla="*/ 23 w 105"/>
                    <a:gd name="T19" fmla="*/ 1 h 1"/>
                    <a:gd name="T20" fmla="*/ 26 w 105"/>
                    <a:gd name="T21" fmla="*/ 1 h 1"/>
                    <a:gd name="T22" fmla="*/ 29 w 105"/>
                    <a:gd name="T23" fmla="*/ 1 h 1"/>
                    <a:gd name="T24" fmla="*/ 32 w 105"/>
                    <a:gd name="T25" fmla="*/ 1 h 1"/>
                    <a:gd name="T26" fmla="*/ 33 w 105"/>
                    <a:gd name="T27" fmla="*/ 1 h 1"/>
                    <a:gd name="T28" fmla="*/ 36 w 105"/>
                    <a:gd name="T29" fmla="*/ 1 h 1"/>
                    <a:gd name="T30" fmla="*/ 39 w 105"/>
                    <a:gd name="T31" fmla="*/ 1 h 1"/>
                    <a:gd name="T32" fmla="*/ 42 w 105"/>
                    <a:gd name="T33" fmla="*/ 1 h 1"/>
                    <a:gd name="T34" fmla="*/ 43 w 105"/>
                    <a:gd name="T35" fmla="*/ 1 h 1"/>
                    <a:gd name="T36" fmla="*/ 46 w 105"/>
                    <a:gd name="T37" fmla="*/ 1 h 1"/>
                    <a:gd name="T38" fmla="*/ 49 w 105"/>
                    <a:gd name="T39" fmla="*/ 1 h 1"/>
                    <a:gd name="T40" fmla="*/ 52 w 105"/>
                    <a:gd name="T41" fmla="*/ 1 h 1"/>
                    <a:gd name="T42" fmla="*/ 53 w 105"/>
                    <a:gd name="T43" fmla="*/ 1 h 1"/>
                    <a:gd name="T44" fmla="*/ 56 w 105"/>
                    <a:gd name="T45" fmla="*/ 1 h 1"/>
                    <a:gd name="T46" fmla="*/ 59 w 105"/>
                    <a:gd name="T47" fmla="*/ 1 h 1"/>
                    <a:gd name="T48" fmla="*/ 62 w 105"/>
                    <a:gd name="T49" fmla="*/ 1 h 1"/>
                    <a:gd name="T50" fmla="*/ 63 w 105"/>
                    <a:gd name="T51" fmla="*/ 1 h 1"/>
                    <a:gd name="T52" fmla="*/ 66 w 105"/>
                    <a:gd name="T53" fmla="*/ 1 h 1"/>
                    <a:gd name="T54" fmla="*/ 69 w 105"/>
                    <a:gd name="T55" fmla="*/ 1 h 1"/>
                    <a:gd name="T56" fmla="*/ 72 w 105"/>
                    <a:gd name="T57" fmla="*/ 1 h 1"/>
                    <a:gd name="T58" fmla="*/ 73 w 105"/>
                    <a:gd name="T59" fmla="*/ 1 h 1"/>
                    <a:gd name="T60" fmla="*/ 76 w 105"/>
                    <a:gd name="T61" fmla="*/ 1 h 1"/>
                    <a:gd name="T62" fmla="*/ 79 w 105"/>
                    <a:gd name="T63" fmla="*/ 1 h 1"/>
                    <a:gd name="T64" fmla="*/ 82 w 105"/>
                    <a:gd name="T65" fmla="*/ 1 h 1"/>
                    <a:gd name="T66" fmla="*/ 83 w 105"/>
                    <a:gd name="T67" fmla="*/ 1 h 1"/>
                    <a:gd name="T68" fmla="*/ 86 w 105"/>
                    <a:gd name="T69" fmla="*/ 1 h 1"/>
                    <a:gd name="T70" fmla="*/ 89 w 105"/>
                    <a:gd name="T71" fmla="*/ 1 h 1"/>
                    <a:gd name="T72" fmla="*/ 92 w 105"/>
                    <a:gd name="T73" fmla="*/ 0 h 1"/>
                    <a:gd name="T74" fmla="*/ 93 w 105"/>
                    <a:gd name="T75" fmla="*/ 0 h 1"/>
                    <a:gd name="T76" fmla="*/ 96 w 105"/>
                    <a:gd name="T77" fmla="*/ 0 h 1"/>
                    <a:gd name="T78" fmla="*/ 99 w 105"/>
                    <a:gd name="T79" fmla="*/ 0 h 1"/>
                    <a:gd name="T80" fmla="*/ 102 w 105"/>
                    <a:gd name="T81" fmla="*/ 0 h 1"/>
                    <a:gd name="T82" fmla="*/ 103 w 105"/>
                    <a:gd name="T83" fmla="*/ 0 h 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</a:cxnLst>
                  <a:rect l="0" t="0" r="r" b="b"/>
                  <a:pathLst>
                    <a:path w="105" h="1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2" y="0"/>
                      </a:lnTo>
                      <a:lnTo>
                        <a:pt x="3" y="0"/>
                      </a:lnTo>
                      <a:lnTo>
                        <a:pt x="4" y="0"/>
                      </a:lnTo>
                      <a:lnTo>
                        <a:pt x="6" y="0"/>
                      </a:lnTo>
                      <a:lnTo>
                        <a:pt x="7" y="1"/>
                      </a:lnTo>
                      <a:lnTo>
                        <a:pt x="9" y="1"/>
                      </a:lnTo>
                      <a:lnTo>
                        <a:pt x="10" y="1"/>
                      </a:lnTo>
                      <a:lnTo>
                        <a:pt x="12" y="1"/>
                      </a:lnTo>
                      <a:lnTo>
                        <a:pt x="12" y="1"/>
                      </a:lnTo>
                      <a:lnTo>
                        <a:pt x="13" y="1"/>
                      </a:lnTo>
                      <a:lnTo>
                        <a:pt x="15" y="1"/>
                      </a:lnTo>
                      <a:lnTo>
                        <a:pt x="16" y="1"/>
                      </a:lnTo>
                      <a:lnTo>
                        <a:pt x="17" y="1"/>
                      </a:lnTo>
                      <a:lnTo>
                        <a:pt x="19" y="1"/>
                      </a:lnTo>
                      <a:lnTo>
                        <a:pt x="20" y="1"/>
                      </a:lnTo>
                      <a:lnTo>
                        <a:pt x="22" y="1"/>
                      </a:lnTo>
                      <a:lnTo>
                        <a:pt x="22" y="1"/>
                      </a:lnTo>
                      <a:lnTo>
                        <a:pt x="23" y="1"/>
                      </a:lnTo>
                      <a:lnTo>
                        <a:pt x="25" y="1"/>
                      </a:lnTo>
                      <a:lnTo>
                        <a:pt x="26" y="1"/>
                      </a:lnTo>
                      <a:lnTo>
                        <a:pt x="27" y="1"/>
                      </a:lnTo>
                      <a:lnTo>
                        <a:pt x="29" y="1"/>
                      </a:lnTo>
                      <a:lnTo>
                        <a:pt x="30" y="1"/>
                      </a:lnTo>
                      <a:lnTo>
                        <a:pt x="32" y="1"/>
                      </a:lnTo>
                      <a:lnTo>
                        <a:pt x="32" y="1"/>
                      </a:lnTo>
                      <a:lnTo>
                        <a:pt x="33" y="1"/>
                      </a:lnTo>
                      <a:lnTo>
                        <a:pt x="35" y="1"/>
                      </a:lnTo>
                      <a:lnTo>
                        <a:pt x="36" y="1"/>
                      </a:lnTo>
                      <a:lnTo>
                        <a:pt x="37" y="1"/>
                      </a:lnTo>
                      <a:lnTo>
                        <a:pt x="39" y="1"/>
                      </a:lnTo>
                      <a:lnTo>
                        <a:pt x="40" y="1"/>
                      </a:lnTo>
                      <a:lnTo>
                        <a:pt x="42" y="1"/>
                      </a:lnTo>
                      <a:lnTo>
                        <a:pt x="42" y="1"/>
                      </a:lnTo>
                      <a:lnTo>
                        <a:pt x="43" y="1"/>
                      </a:lnTo>
                      <a:lnTo>
                        <a:pt x="45" y="1"/>
                      </a:lnTo>
                      <a:lnTo>
                        <a:pt x="46" y="1"/>
                      </a:lnTo>
                      <a:lnTo>
                        <a:pt x="47" y="1"/>
                      </a:lnTo>
                      <a:lnTo>
                        <a:pt x="49" y="1"/>
                      </a:lnTo>
                      <a:lnTo>
                        <a:pt x="50" y="1"/>
                      </a:lnTo>
                      <a:lnTo>
                        <a:pt x="52" y="1"/>
                      </a:lnTo>
                      <a:lnTo>
                        <a:pt x="52" y="1"/>
                      </a:lnTo>
                      <a:lnTo>
                        <a:pt x="53" y="1"/>
                      </a:lnTo>
                      <a:lnTo>
                        <a:pt x="55" y="1"/>
                      </a:lnTo>
                      <a:lnTo>
                        <a:pt x="56" y="1"/>
                      </a:lnTo>
                      <a:lnTo>
                        <a:pt x="58" y="1"/>
                      </a:lnTo>
                      <a:lnTo>
                        <a:pt x="59" y="1"/>
                      </a:lnTo>
                      <a:lnTo>
                        <a:pt x="60" y="1"/>
                      </a:lnTo>
                      <a:lnTo>
                        <a:pt x="62" y="1"/>
                      </a:lnTo>
                      <a:lnTo>
                        <a:pt x="62" y="1"/>
                      </a:lnTo>
                      <a:lnTo>
                        <a:pt x="63" y="1"/>
                      </a:lnTo>
                      <a:lnTo>
                        <a:pt x="65" y="1"/>
                      </a:lnTo>
                      <a:lnTo>
                        <a:pt x="66" y="1"/>
                      </a:lnTo>
                      <a:lnTo>
                        <a:pt x="68" y="1"/>
                      </a:lnTo>
                      <a:lnTo>
                        <a:pt x="69" y="1"/>
                      </a:lnTo>
                      <a:lnTo>
                        <a:pt x="70" y="1"/>
                      </a:lnTo>
                      <a:lnTo>
                        <a:pt x="72" y="1"/>
                      </a:lnTo>
                      <a:lnTo>
                        <a:pt x="73" y="1"/>
                      </a:lnTo>
                      <a:lnTo>
                        <a:pt x="73" y="1"/>
                      </a:lnTo>
                      <a:lnTo>
                        <a:pt x="75" y="1"/>
                      </a:lnTo>
                      <a:lnTo>
                        <a:pt x="76" y="1"/>
                      </a:lnTo>
                      <a:lnTo>
                        <a:pt x="78" y="1"/>
                      </a:lnTo>
                      <a:lnTo>
                        <a:pt x="79" y="1"/>
                      </a:lnTo>
                      <a:lnTo>
                        <a:pt x="80" y="1"/>
                      </a:lnTo>
                      <a:lnTo>
                        <a:pt x="82" y="1"/>
                      </a:lnTo>
                      <a:lnTo>
                        <a:pt x="83" y="1"/>
                      </a:lnTo>
                      <a:lnTo>
                        <a:pt x="83" y="1"/>
                      </a:lnTo>
                      <a:lnTo>
                        <a:pt x="85" y="1"/>
                      </a:lnTo>
                      <a:lnTo>
                        <a:pt x="86" y="1"/>
                      </a:lnTo>
                      <a:lnTo>
                        <a:pt x="88" y="1"/>
                      </a:lnTo>
                      <a:lnTo>
                        <a:pt x="89" y="1"/>
                      </a:lnTo>
                      <a:lnTo>
                        <a:pt x="91" y="1"/>
                      </a:lnTo>
                      <a:lnTo>
                        <a:pt x="92" y="0"/>
                      </a:lnTo>
                      <a:lnTo>
                        <a:pt x="93" y="0"/>
                      </a:lnTo>
                      <a:lnTo>
                        <a:pt x="93" y="0"/>
                      </a:lnTo>
                      <a:lnTo>
                        <a:pt x="95" y="0"/>
                      </a:lnTo>
                      <a:lnTo>
                        <a:pt x="96" y="0"/>
                      </a:lnTo>
                      <a:lnTo>
                        <a:pt x="98" y="0"/>
                      </a:lnTo>
                      <a:lnTo>
                        <a:pt x="99" y="0"/>
                      </a:lnTo>
                      <a:lnTo>
                        <a:pt x="101" y="0"/>
                      </a:lnTo>
                      <a:lnTo>
                        <a:pt x="102" y="0"/>
                      </a:lnTo>
                      <a:lnTo>
                        <a:pt x="103" y="0"/>
                      </a:lnTo>
                      <a:lnTo>
                        <a:pt x="103" y="0"/>
                      </a:lnTo>
                      <a:lnTo>
                        <a:pt x="105" y="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4" name="Freeform 239"/>
                <p:cNvSpPr/>
                <p:nvPr/>
              </p:nvSpPr>
              <p:spPr bwMode="auto">
                <a:xfrm>
                  <a:off x="3645" y="3350"/>
                  <a:ext cx="106" cy="9"/>
                </a:xfrm>
                <a:custGeom>
                  <a:avLst/>
                  <a:gdLst>
                    <a:gd name="T0" fmla="*/ 106 w 106"/>
                    <a:gd name="T1" fmla="*/ 9 h 9"/>
                    <a:gd name="T2" fmla="*/ 100 w 106"/>
                    <a:gd name="T3" fmla="*/ 9 h 9"/>
                    <a:gd name="T4" fmla="*/ 95 w 106"/>
                    <a:gd name="T5" fmla="*/ 9 h 9"/>
                    <a:gd name="T6" fmla="*/ 90 w 106"/>
                    <a:gd name="T7" fmla="*/ 9 h 9"/>
                    <a:gd name="T8" fmla="*/ 85 w 106"/>
                    <a:gd name="T9" fmla="*/ 9 h 9"/>
                    <a:gd name="T10" fmla="*/ 79 w 106"/>
                    <a:gd name="T11" fmla="*/ 8 h 9"/>
                    <a:gd name="T12" fmla="*/ 75 w 106"/>
                    <a:gd name="T13" fmla="*/ 8 h 9"/>
                    <a:gd name="T14" fmla="*/ 69 w 106"/>
                    <a:gd name="T15" fmla="*/ 8 h 9"/>
                    <a:gd name="T16" fmla="*/ 63 w 106"/>
                    <a:gd name="T17" fmla="*/ 8 h 9"/>
                    <a:gd name="T18" fmla="*/ 59 w 106"/>
                    <a:gd name="T19" fmla="*/ 6 h 9"/>
                    <a:gd name="T20" fmla="*/ 53 w 106"/>
                    <a:gd name="T21" fmla="*/ 6 h 9"/>
                    <a:gd name="T22" fmla="*/ 47 w 106"/>
                    <a:gd name="T23" fmla="*/ 6 h 9"/>
                    <a:gd name="T24" fmla="*/ 42 w 106"/>
                    <a:gd name="T25" fmla="*/ 5 h 9"/>
                    <a:gd name="T26" fmla="*/ 37 w 106"/>
                    <a:gd name="T27" fmla="*/ 5 h 9"/>
                    <a:gd name="T28" fmla="*/ 32 w 106"/>
                    <a:gd name="T29" fmla="*/ 5 h 9"/>
                    <a:gd name="T30" fmla="*/ 26 w 106"/>
                    <a:gd name="T31" fmla="*/ 3 h 9"/>
                    <a:gd name="T32" fmla="*/ 22 w 106"/>
                    <a:gd name="T33" fmla="*/ 3 h 9"/>
                    <a:gd name="T34" fmla="*/ 16 w 106"/>
                    <a:gd name="T35" fmla="*/ 3 h 9"/>
                    <a:gd name="T36" fmla="*/ 10 w 106"/>
                    <a:gd name="T37" fmla="*/ 2 h 9"/>
                    <a:gd name="T38" fmla="*/ 6 w 106"/>
                    <a:gd name="T39" fmla="*/ 2 h 9"/>
                    <a:gd name="T40" fmla="*/ 0 w 106"/>
                    <a:gd name="T41" fmla="*/ 0 h 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</a:cxnLst>
                  <a:rect l="0" t="0" r="r" b="b"/>
                  <a:pathLst>
                    <a:path w="106" h="9">
                      <a:moveTo>
                        <a:pt x="106" y="9"/>
                      </a:moveTo>
                      <a:lnTo>
                        <a:pt x="100" y="9"/>
                      </a:lnTo>
                      <a:lnTo>
                        <a:pt x="95" y="9"/>
                      </a:lnTo>
                      <a:lnTo>
                        <a:pt x="90" y="9"/>
                      </a:lnTo>
                      <a:lnTo>
                        <a:pt x="85" y="9"/>
                      </a:lnTo>
                      <a:lnTo>
                        <a:pt x="79" y="8"/>
                      </a:lnTo>
                      <a:lnTo>
                        <a:pt x="75" y="8"/>
                      </a:lnTo>
                      <a:lnTo>
                        <a:pt x="69" y="8"/>
                      </a:lnTo>
                      <a:lnTo>
                        <a:pt x="63" y="8"/>
                      </a:lnTo>
                      <a:lnTo>
                        <a:pt x="59" y="6"/>
                      </a:lnTo>
                      <a:lnTo>
                        <a:pt x="53" y="6"/>
                      </a:lnTo>
                      <a:lnTo>
                        <a:pt x="47" y="6"/>
                      </a:lnTo>
                      <a:lnTo>
                        <a:pt x="42" y="5"/>
                      </a:lnTo>
                      <a:lnTo>
                        <a:pt x="37" y="5"/>
                      </a:lnTo>
                      <a:lnTo>
                        <a:pt x="32" y="5"/>
                      </a:lnTo>
                      <a:lnTo>
                        <a:pt x="26" y="3"/>
                      </a:lnTo>
                      <a:lnTo>
                        <a:pt x="22" y="3"/>
                      </a:lnTo>
                      <a:lnTo>
                        <a:pt x="16" y="3"/>
                      </a:lnTo>
                      <a:lnTo>
                        <a:pt x="10" y="2"/>
                      </a:lnTo>
                      <a:lnTo>
                        <a:pt x="6" y="2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6" name="Line 241"/>
                <p:cNvSpPr>
                  <a:spLocks noChangeShapeType="1"/>
                </p:cNvSpPr>
                <p:nvPr/>
              </p:nvSpPr>
              <p:spPr bwMode="auto">
                <a:xfrm flipH="1">
                  <a:off x="3751" y="3293"/>
                  <a:ext cx="3" cy="63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7" name="Freeform 242"/>
                <p:cNvSpPr/>
                <p:nvPr/>
              </p:nvSpPr>
              <p:spPr bwMode="auto">
                <a:xfrm>
                  <a:off x="3853" y="3282"/>
                  <a:ext cx="100" cy="8"/>
                </a:xfrm>
                <a:custGeom>
                  <a:avLst/>
                  <a:gdLst>
                    <a:gd name="T0" fmla="*/ 1 w 100"/>
                    <a:gd name="T1" fmla="*/ 8 h 8"/>
                    <a:gd name="T2" fmla="*/ 4 w 100"/>
                    <a:gd name="T3" fmla="*/ 8 h 8"/>
                    <a:gd name="T4" fmla="*/ 6 w 100"/>
                    <a:gd name="T5" fmla="*/ 8 h 8"/>
                    <a:gd name="T6" fmla="*/ 9 w 100"/>
                    <a:gd name="T7" fmla="*/ 8 h 8"/>
                    <a:gd name="T8" fmla="*/ 10 w 100"/>
                    <a:gd name="T9" fmla="*/ 8 h 8"/>
                    <a:gd name="T10" fmla="*/ 13 w 100"/>
                    <a:gd name="T11" fmla="*/ 8 h 8"/>
                    <a:gd name="T12" fmla="*/ 14 w 100"/>
                    <a:gd name="T13" fmla="*/ 8 h 8"/>
                    <a:gd name="T14" fmla="*/ 17 w 100"/>
                    <a:gd name="T15" fmla="*/ 8 h 8"/>
                    <a:gd name="T16" fmla="*/ 19 w 100"/>
                    <a:gd name="T17" fmla="*/ 7 h 8"/>
                    <a:gd name="T18" fmla="*/ 21 w 100"/>
                    <a:gd name="T19" fmla="*/ 7 h 8"/>
                    <a:gd name="T20" fmla="*/ 23 w 100"/>
                    <a:gd name="T21" fmla="*/ 7 h 8"/>
                    <a:gd name="T22" fmla="*/ 26 w 100"/>
                    <a:gd name="T23" fmla="*/ 7 h 8"/>
                    <a:gd name="T24" fmla="*/ 27 w 100"/>
                    <a:gd name="T25" fmla="*/ 7 h 8"/>
                    <a:gd name="T26" fmla="*/ 30 w 100"/>
                    <a:gd name="T27" fmla="*/ 7 h 8"/>
                    <a:gd name="T28" fmla="*/ 32 w 100"/>
                    <a:gd name="T29" fmla="*/ 7 h 8"/>
                    <a:gd name="T30" fmla="*/ 34 w 100"/>
                    <a:gd name="T31" fmla="*/ 7 h 8"/>
                    <a:gd name="T32" fmla="*/ 36 w 100"/>
                    <a:gd name="T33" fmla="*/ 7 h 8"/>
                    <a:gd name="T34" fmla="*/ 39 w 100"/>
                    <a:gd name="T35" fmla="*/ 7 h 8"/>
                    <a:gd name="T36" fmla="*/ 40 w 100"/>
                    <a:gd name="T37" fmla="*/ 5 h 8"/>
                    <a:gd name="T38" fmla="*/ 43 w 100"/>
                    <a:gd name="T39" fmla="*/ 5 h 8"/>
                    <a:gd name="T40" fmla="*/ 44 w 100"/>
                    <a:gd name="T41" fmla="*/ 5 h 8"/>
                    <a:gd name="T42" fmla="*/ 47 w 100"/>
                    <a:gd name="T43" fmla="*/ 5 h 8"/>
                    <a:gd name="T44" fmla="*/ 49 w 100"/>
                    <a:gd name="T45" fmla="*/ 5 h 8"/>
                    <a:gd name="T46" fmla="*/ 52 w 100"/>
                    <a:gd name="T47" fmla="*/ 5 h 8"/>
                    <a:gd name="T48" fmla="*/ 53 w 100"/>
                    <a:gd name="T49" fmla="*/ 5 h 8"/>
                    <a:gd name="T50" fmla="*/ 56 w 100"/>
                    <a:gd name="T51" fmla="*/ 4 h 8"/>
                    <a:gd name="T52" fmla="*/ 57 w 100"/>
                    <a:gd name="T53" fmla="*/ 4 h 8"/>
                    <a:gd name="T54" fmla="*/ 60 w 100"/>
                    <a:gd name="T55" fmla="*/ 4 h 8"/>
                    <a:gd name="T56" fmla="*/ 62 w 100"/>
                    <a:gd name="T57" fmla="*/ 4 h 8"/>
                    <a:gd name="T58" fmla="*/ 65 w 100"/>
                    <a:gd name="T59" fmla="*/ 4 h 8"/>
                    <a:gd name="T60" fmla="*/ 66 w 100"/>
                    <a:gd name="T61" fmla="*/ 4 h 8"/>
                    <a:gd name="T62" fmla="*/ 69 w 100"/>
                    <a:gd name="T63" fmla="*/ 4 h 8"/>
                    <a:gd name="T64" fmla="*/ 70 w 100"/>
                    <a:gd name="T65" fmla="*/ 2 h 8"/>
                    <a:gd name="T66" fmla="*/ 73 w 100"/>
                    <a:gd name="T67" fmla="*/ 2 h 8"/>
                    <a:gd name="T68" fmla="*/ 75 w 100"/>
                    <a:gd name="T69" fmla="*/ 2 h 8"/>
                    <a:gd name="T70" fmla="*/ 77 w 100"/>
                    <a:gd name="T71" fmla="*/ 2 h 8"/>
                    <a:gd name="T72" fmla="*/ 79 w 100"/>
                    <a:gd name="T73" fmla="*/ 2 h 8"/>
                    <a:gd name="T74" fmla="*/ 82 w 100"/>
                    <a:gd name="T75" fmla="*/ 2 h 8"/>
                    <a:gd name="T76" fmla="*/ 83 w 100"/>
                    <a:gd name="T77" fmla="*/ 1 h 8"/>
                    <a:gd name="T78" fmla="*/ 86 w 100"/>
                    <a:gd name="T79" fmla="*/ 1 h 8"/>
                    <a:gd name="T80" fmla="*/ 87 w 100"/>
                    <a:gd name="T81" fmla="*/ 1 h 8"/>
                    <a:gd name="T82" fmla="*/ 90 w 100"/>
                    <a:gd name="T83" fmla="*/ 1 h 8"/>
                    <a:gd name="T84" fmla="*/ 92 w 100"/>
                    <a:gd name="T85" fmla="*/ 1 h 8"/>
                    <a:gd name="T86" fmla="*/ 95 w 100"/>
                    <a:gd name="T87" fmla="*/ 1 h 8"/>
                    <a:gd name="T88" fmla="*/ 96 w 100"/>
                    <a:gd name="T89" fmla="*/ 0 h 8"/>
                    <a:gd name="T90" fmla="*/ 99 w 100"/>
                    <a:gd name="T91" fmla="*/ 0 h 8"/>
                    <a:gd name="T92" fmla="*/ 100 w 100"/>
                    <a:gd name="T93" fmla="*/ 0 h 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  <a:cxn ang="0">
                      <a:pos x="T90" y="T91"/>
                    </a:cxn>
                    <a:cxn ang="0">
                      <a:pos x="T92" y="T93"/>
                    </a:cxn>
                  </a:cxnLst>
                  <a:rect l="0" t="0" r="r" b="b"/>
                  <a:pathLst>
                    <a:path w="100" h="8">
                      <a:moveTo>
                        <a:pt x="0" y="8"/>
                      </a:moveTo>
                      <a:lnTo>
                        <a:pt x="1" y="8"/>
                      </a:lnTo>
                      <a:lnTo>
                        <a:pt x="3" y="8"/>
                      </a:lnTo>
                      <a:lnTo>
                        <a:pt x="4" y="8"/>
                      </a:lnTo>
                      <a:lnTo>
                        <a:pt x="4" y="8"/>
                      </a:lnTo>
                      <a:lnTo>
                        <a:pt x="6" y="8"/>
                      </a:lnTo>
                      <a:lnTo>
                        <a:pt x="7" y="8"/>
                      </a:lnTo>
                      <a:lnTo>
                        <a:pt x="9" y="8"/>
                      </a:lnTo>
                      <a:lnTo>
                        <a:pt x="9" y="8"/>
                      </a:lnTo>
                      <a:lnTo>
                        <a:pt x="10" y="8"/>
                      </a:lnTo>
                      <a:lnTo>
                        <a:pt x="11" y="8"/>
                      </a:lnTo>
                      <a:lnTo>
                        <a:pt x="13" y="8"/>
                      </a:lnTo>
                      <a:lnTo>
                        <a:pt x="13" y="8"/>
                      </a:lnTo>
                      <a:lnTo>
                        <a:pt x="14" y="8"/>
                      </a:lnTo>
                      <a:lnTo>
                        <a:pt x="16" y="8"/>
                      </a:lnTo>
                      <a:lnTo>
                        <a:pt x="17" y="8"/>
                      </a:lnTo>
                      <a:lnTo>
                        <a:pt x="17" y="8"/>
                      </a:lnTo>
                      <a:lnTo>
                        <a:pt x="19" y="7"/>
                      </a:lnTo>
                      <a:lnTo>
                        <a:pt x="20" y="7"/>
                      </a:lnTo>
                      <a:lnTo>
                        <a:pt x="21" y="7"/>
                      </a:lnTo>
                      <a:lnTo>
                        <a:pt x="21" y="7"/>
                      </a:lnTo>
                      <a:lnTo>
                        <a:pt x="23" y="7"/>
                      </a:lnTo>
                      <a:lnTo>
                        <a:pt x="24" y="7"/>
                      </a:lnTo>
                      <a:lnTo>
                        <a:pt x="26" y="7"/>
                      </a:lnTo>
                      <a:lnTo>
                        <a:pt x="26" y="7"/>
                      </a:lnTo>
                      <a:lnTo>
                        <a:pt x="27" y="7"/>
                      </a:lnTo>
                      <a:lnTo>
                        <a:pt x="29" y="7"/>
                      </a:lnTo>
                      <a:lnTo>
                        <a:pt x="30" y="7"/>
                      </a:lnTo>
                      <a:lnTo>
                        <a:pt x="30" y="7"/>
                      </a:lnTo>
                      <a:lnTo>
                        <a:pt x="32" y="7"/>
                      </a:lnTo>
                      <a:lnTo>
                        <a:pt x="33" y="7"/>
                      </a:lnTo>
                      <a:lnTo>
                        <a:pt x="34" y="7"/>
                      </a:lnTo>
                      <a:lnTo>
                        <a:pt x="34" y="7"/>
                      </a:lnTo>
                      <a:lnTo>
                        <a:pt x="36" y="7"/>
                      </a:lnTo>
                      <a:lnTo>
                        <a:pt x="37" y="7"/>
                      </a:lnTo>
                      <a:lnTo>
                        <a:pt x="39" y="7"/>
                      </a:lnTo>
                      <a:lnTo>
                        <a:pt x="39" y="5"/>
                      </a:lnTo>
                      <a:lnTo>
                        <a:pt x="40" y="5"/>
                      </a:lnTo>
                      <a:lnTo>
                        <a:pt x="42" y="5"/>
                      </a:lnTo>
                      <a:lnTo>
                        <a:pt x="43" y="5"/>
                      </a:lnTo>
                      <a:lnTo>
                        <a:pt x="43" y="5"/>
                      </a:lnTo>
                      <a:lnTo>
                        <a:pt x="44" y="5"/>
                      </a:lnTo>
                      <a:lnTo>
                        <a:pt x="46" y="5"/>
                      </a:lnTo>
                      <a:lnTo>
                        <a:pt x="47" y="5"/>
                      </a:lnTo>
                      <a:lnTo>
                        <a:pt x="47" y="5"/>
                      </a:lnTo>
                      <a:lnTo>
                        <a:pt x="49" y="5"/>
                      </a:lnTo>
                      <a:lnTo>
                        <a:pt x="50" y="5"/>
                      </a:lnTo>
                      <a:lnTo>
                        <a:pt x="52" y="5"/>
                      </a:lnTo>
                      <a:lnTo>
                        <a:pt x="52" y="5"/>
                      </a:lnTo>
                      <a:lnTo>
                        <a:pt x="53" y="5"/>
                      </a:lnTo>
                      <a:lnTo>
                        <a:pt x="54" y="5"/>
                      </a:lnTo>
                      <a:lnTo>
                        <a:pt x="56" y="4"/>
                      </a:lnTo>
                      <a:lnTo>
                        <a:pt x="56" y="4"/>
                      </a:lnTo>
                      <a:lnTo>
                        <a:pt x="57" y="4"/>
                      </a:lnTo>
                      <a:lnTo>
                        <a:pt x="59" y="4"/>
                      </a:lnTo>
                      <a:lnTo>
                        <a:pt x="60" y="4"/>
                      </a:lnTo>
                      <a:lnTo>
                        <a:pt x="60" y="4"/>
                      </a:lnTo>
                      <a:lnTo>
                        <a:pt x="62" y="4"/>
                      </a:lnTo>
                      <a:lnTo>
                        <a:pt x="63" y="4"/>
                      </a:lnTo>
                      <a:lnTo>
                        <a:pt x="65" y="4"/>
                      </a:lnTo>
                      <a:lnTo>
                        <a:pt x="65" y="4"/>
                      </a:lnTo>
                      <a:lnTo>
                        <a:pt x="66" y="4"/>
                      </a:lnTo>
                      <a:lnTo>
                        <a:pt x="67" y="4"/>
                      </a:lnTo>
                      <a:lnTo>
                        <a:pt x="69" y="4"/>
                      </a:lnTo>
                      <a:lnTo>
                        <a:pt x="69" y="4"/>
                      </a:lnTo>
                      <a:lnTo>
                        <a:pt x="70" y="2"/>
                      </a:lnTo>
                      <a:lnTo>
                        <a:pt x="72" y="2"/>
                      </a:lnTo>
                      <a:lnTo>
                        <a:pt x="73" y="2"/>
                      </a:lnTo>
                      <a:lnTo>
                        <a:pt x="73" y="2"/>
                      </a:lnTo>
                      <a:lnTo>
                        <a:pt x="75" y="2"/>
                      </a:lnTo>
                      <a:lnTo>
                        <a:pt x="76" y="2"/>
                      </a:lnTo>
                      <a:lnTo>
                        <a:pt x="77" y="2"/>
                      </a:lnTo>
                      <a:lnTo>
                        <a:pt x="77" y="2"/>
                      </a:lnTo>
                      <a:lnTo>
                        <a:pt x="79" y="2"/>
                      </a:lnTo>
                      <a:lnTo>
                        <a:pt x="80" y="2"/>
                      </a:lnTo>
                      <a:lnTo>
                        <a:pt x="82" y="2"/>
                      </a:lnTo>
                      <a:lnTo>
                        <a:pt x="82" y="2"/>
                      </a:lnTo>
                      <a:lnTo>
                        <a:pt x="83" y="1"/>
                      </a:lnTo>
                      <a:lnTo>
                        <a:pt x="85" y="1"/>
                      </a:lnTo>
                      <a:lnTo>
                        <a:pt x="86" y="1"/>
                      </a:lnTo>
                      <a:lnTo>
                        <a:pt x="86" y="1"/>
                      </a:lnTo>
                      <a:lnTo>
                        <a:pt x="87" y="1"/>
                      </a:lnTo>
                      <a:lnTo>
                        <a:pt x="89" y="1"/>
                      </a:lnTo>
                      <a:lnTo>
                        <a:pt x="90" y="1"/>
                      </a:lnTo>
                      <a:lnTo>
                        <a:pt x="90" y="1"/>
                      </a:lnTo>
                      <a:lnTo>
                        <a:pt x="92" y="1"/>
                      </a:lnTo>
                      <a:lnTo>
                        <a:pt x="93" y="1"/>
                      </a:lnTo>
                      <a:lnTo>
                        <a:pt x="95" y="1"/>
                      </a:lnTo>
                      <a:lnTo>
                        <a:pt x="95" y="0"/>
                      </a:lnTo>
                      <a:lnTo>
                        <a:pt x="96" y="0"/>
                      </a:lnTo>
                      <a:lnTo>
                        <a:pt x="97" y="0"/>
                      </a:lnTo>
                      <a:lnTo>
                        <a:pt x="99" y="0"/>
                      </a:lnTo>
                      <a:lnTo>
                        <a:pt x="99" y="0"/>
                      </a:lnTo>
                      <a:lnTo>
                        <a:pt x="100" y="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8" name="Freeform 243"/>
                <p:cNvSpPr/>
                <p:nvPr/>
              </p:nvSpPr>
              <p:spPr bwMode="auto">
                <a:xfrm>
                  <a:off x="3754" y="3290"/>
                  <a:ext cx="99" cy="2"/>
                </a:xfrm>
                <a:custGeom>
                  <a:avLst/>
                  <a:gdLst>
                    <a:gd name="T0" fmla="*/ 99 w 99"/>
                    <a:gd name="T1" fmla="*/ 0 h 2"/>
                    <a:gd name="T2" fmla="*/ 93 w 99"/>
                    <a:gd name="T3" fmla="*/ 0 h 2"/>
                    <a:gd name="T4" fmla="*/ 88 w 99"/>
                    <a:gd name="T5" fmla="*/ 0 h 2"/>
                    <a:gd name="T6" fmla="*/ 82 w 99"/>
                    <a:gd name="T7" fmla="*/ 2 h 2"/>
                    <a:gd name="T8" fmla="*/ 76 w 99"/>
                    <a:gd name="T9" fmla="*/ 2 h 2"/>
                    <a:gd name="T10" fmla="*/ 70 w 99"/>
                    <a:gd name="T11" fmla="*/ 2 h 2"/>
                    <a:gd name="T12" fmla="*/ 65 w 99"/>
                    <a:gd name="T13" fmla="*/ 2 h 2"/>
                    <a:gd name="T14" fmla="*/ 59 w 99"/>
                    <a:gd name="T15" fmla="*/ 2 h 2"/>
                    <a:gd name="T16" fmla="*/ 53 w 99"/>
                    <a:gd name="T17" fmla="*/ 2 h 2"/>
                    <a:gd name="T18" fmla="*/ 46 w 99"/>
                    <a:gd name="T19" fmla="*/ 2 h 2"/>
                    <a:gd name="T20" fmla="*/ 40 w 99"/>
                    <a:gd name="T21" fmla="*/ 2 h 2"/>
                    <a:gd name="T22" fmla="*/ 34 w 99"/>
                    <a:gd name="T23" fmla="*/ 2 h 2"/>
                    <a:gd name="T24" fmla="*/ 29 w 99"/>
                    <a:gd name="T25" fmla="*/ 2 h 2"/>
                    <a:gd name="T26" fmla="*/ 23 w 99"/>
                    <a:gd name="T27" fmla="*/ 2 h 2"/>
                    <a:gd name="T28" fmla="*/ 17 w 99"/>
                    <a:gd name="T29" fmla="*/ 2 h 2"/>
                    <a:gd name="T30" fmla="*/ 12 w 99"/>
                    <a:gd name="T31" fmla="*/ 2 h 2"/>
                    <a:gd name="T32" fmla="*/ 6 w 99"/>
                    <a:gd name="T33" fmla="*/ 2 h 2"/>
                    <a:gd name="T34" fmla="*/ 0 w 99"/>
                    <a:gd name="T35" fmla="*/ 0 h 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99" h="2">
                      <a:moveTo>
                        <a:pt x="99" y="0"/>
                      </a:moveTo>
                      <a:lnTo>
                        <a:pt x="93" y="0"/>
                      </a:lnTo>
                      <a:lnTo>
                        <a:pt x="88" y="0"/>
                      </a:lnTo>
                      <a:lnTo>
                        <a:pt x="82" y="2"/>
                      </a:lnTo>
                      <a:lnTo>
                        <a:pt x="76" y="2"/>
                      </a:lnTo>
                      <a:lnTo>
                        <a:pt x="70" y="2"/>
                      </a:lnTo>
                      <a:lnTo>
                        <a:pt x="65" y="2"/>
                      </a:lnTo>
                      <a:lnTo>
                        <a:pt x="59" y="2"/>
                      </a:lnTo>
                      <a:lnTo>
                        <a:pt x="53" y="2"/>
                      </a:lnTo>
                      <a:lnTo>
                        <a:pt x="46" y="2"/>
                      </a:lnTo>
                      <a:lnTo>
                        <a:pt x="40" y="2"/>
                      </a:lnTo>
                      <a:lnTo>
                        <a:pt x="34" y="2"/>
                      </a:lnTo>
                      <a:lnTo>
                        <a:pt x="29" y="2"/>
                      </a:lnTo>
                      <a:lnTo>
                        <a:pt x="23" y="2"/>
                      </a:lnTo>
                      <a:lnTo>
                        <a:pt x="17" y="2"/>
                      </a:lnTo>
                      <a:lnTo>
                        <a:pt x="12" y="2"/>
                      </a:lnTo>
                      <a:lnTo>
                        <a:pt x="6" y="2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0" name="Line 245"/>
                <p:cNvSpPr>
                  <a:spLocks noChangeShapeType="1"/>
                </p:cNvSpPr>
                <p:nvPr/>
              </p:nvSpPr>
              <p:spPr bwMode="auto">
                <a:xfrm>
                  <a:off x="3850" y="3224"/>
                  <a:ext cx="3" cy="63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1" name="Freeform 246"/>
                <p:cNvSpPr/>
                <p:nvPr/>
              </p:nvSpPr>
              <p:spPr bwMode="auto">
                <a:xfrm>
                  <a:off x="3945" y="3197"/>
                  <a:ext cx="93" cy="16"/>
                </a:xfrm>
                <a:custGeom>
                  <a:avLst/>
                  <a:gdLst>
                    <a:gd name="T0" fmla="*/ 0 w 93"/>
                    <a:gd name="T1" fmla="*/ 16 h 16"/>
                    <a:gd name="T2" fmla="*/ 3 w 93"/>
                    <a:gd name="T3" fmla="*/ 16 h 16"/>
                    <a:gd name="T4" fmla="*/ 4 w 93"/>
                    <a:gd name="T5" fmla="*/ 16 h 16"/>
                    <a:gd name="T6" fmla="*/ 5 w 93"/>
                    <a:gd name="T7" fmla="*/ 16 h 16"/>
                    <a:gd name="T8" fmla="*/ 8 w 93"/>
                    <a:gd name="T9" fmla="*/ 16 h 16"/>
                    <a:gd name="T10" fmla="*/ 10 w 93"/>
                    <a:gd name="T11" fmla="*/ 14 h 16"/>
                    <a:gd name="T12" fmla="*/ 11 w 93"/>
                    <a:gd name="T13" fmla="*/ 14 h 16"/>
                    <a:gd name="T14" fmla="*/ 13 w 93"/>
                    <a:gd name="T15" fmla="*/ 14 h 16"/>
                    <a:gd name="T16" fmla="*/ 16 w 93"/>
                    <a:gd name="T17" fmla="*/ 14 h 16"/>
                    <a:gd name="T18" fmla="*/ 17 w 93"/>
                    <a:gd name="T19" fmla="*/ 14 h 16"/>
                    <a:gd name="T20" fmla="*/ 18 w 93"/>
                    <a:gd name="T21" fmla="*/ 13 h 16"/>
                    <a:gd name="T22" fmla="*/ 21 w 93"/>
                    <a:gd name="T23" fmla="*/ 13 h 16"/>
                    <a:gd name="T24" fmla="*/ 23 w 93"/>
                    <a:gd name="T25" fmla="*/ 13 h 16"/>
                    <a:gd name="T26" fmla="*/ 24 w 93"/>
                    <a:gd name="T27" fmla="*/ 13 h 16"/>
                    <a:gd name="T28" fmla="*/ 26 w 93"/>
                    <a:gd name="T29" fmla="*/ 13 h 16"/>
                    <a:gd name="T30" fmla="*/ 28 w 93"/>
                    <a:gd name="T31" fmla="*/ 11 h 16"/>
                    <a:gd name="T32" fmla="*/ 30 w 93"/>
                    <a:gd name="T33" fmla="*/ 11 h 16"/>
                    <a:gd name="T34" fmla="*/ 31 w 93"/>
                    <a:gd name="T35" fmla="*/ 11 h 16"/>
                    <a:gd name="T36" fmla="*/ 34 w 93"/>
                    <a:gd name="T37" fmla="*/ 11 h 16"/>
                    <a:gd name="T38" fmla="*/ 36 w 93"/>
                    <a:gd name="T39" fmla="*/ 11 h 16"/>
                    <a:gd name="T40" fmla="*/ 37 w 93"/>
                    <a:gd name="T41" fmla="*/ 10 h 16"/>
                    <a:gd name="T42" fmla="*/ 38 w 93"/>
                    <a:gd name="T43" fmla="*/ 10 h 16"/>
                    <a:gd name="T44" fmla="*/ 41 w 93"/>
                    <a:gd name="T45" fmla="*/ 10 h 16"/>
                    <a:gd name="T46" fmla="*/ 43 w 93"/>
                    <a:gd name="T47" fmla="*/ 10 h 16"/>
                    <a:gd name="T48" fmla="*/ 44 w 93"/>
                    <a:gd name="T49" fmla="*/ 10 h 16"/>
                    <a:gd name="T50" fmla="*/ 46 w 93"/>
                    <a:gd name="T51" fmla="*/ 9 h 16"/>
                    <a:gd name="T52" fmla="*/ 49 w 93"/>
                    <a:gd name="T53" fmla="*/ 9 h 16"/>
                    <a:gd name="T54" fmla="*/ 50 w 93"/>
                    <a:gd name="T55" fmla="*/ 9 h 16"/>
                    <a:gd name="T56" fmla="*/ 51 w 93"/>
                    <a:gd name="T57" fmla="*/ 9 h 16"/>
                    <a:gd name="T58" fmla="*/ 54 w 93"/>
                    <a:gd name="T59" fmla="*/ 7 h 16"/>
                    <a:gd name="T60" fmla="*/ 56 w 93"/>
                    <a:gd name="T61" fmla="*/ 7 h 16"/>
                    <a:gd name="T62" fmla="*/ 57 w 93"/>
                    <a:gd name="T63" fmla="*/ 7 h 16"/>
                    <a:gd name="T64" fmla="*/ 59 w 93"/>
                    <a:gd name="T65" fmla="*/ 7 h 16"/>
                    <a:gd name="T66" fmla="*/ 61 w 93"/>
                    <a:gd name="T67" fmla="*/ 6 h 16"/>
                    <a:gd name="T68" fmla="*/ 63 w 93"/>
                    <a:gd name="T69" fmla="*/ 6 h 16"/>
                    <a:gd name="T70" fmla="*/ 64 w 93"/>
                    <a:gd name="T71" fmla="*/ 6 h 16"/>
                    <a:gd name="T72" fmla="*/ 66 w 93"/>
                    <a:gd name="T73" fmla="*/ 6 h 16"/>
                    <a:gd name="T74" fmla="*/ 69 w 93"/>
                    <a:gd name="T75" fmla="*/ 4 h 16"/>
                    <a:gd name="T76" fmla="*/ 70 w 93"/>
                    <a:gd name="T77" fmla="*/ 4 h 16"/>
                    <a:gd name="T78" fmla="*/ 71 w 93"/>
                    <a:gd name="T79" fmla="*/ 4 h 16"/>
                    <a:gd name="T80" fmla="*/ 73 w 93"/>
                    <a:gd name="T81" fmla="*/ 4 h 16"/>
                    <a:gd name="T82" fmla="*/ 76 w 93"/>
                    <a:gd name="T83" fmla="*/ 3 h 16"/>
                    <a:gd name="T84" fmla="*/ 77 w 93"/>
                    <a:gd name="T85" fmla="*/ 3 h 16"/>
                    <a:gd name="T86" fmla="*/ 79 w 93"/>
                    <a:gd name="T87" fmla="*/ 3 h 16"/>
                    <a:gd name="T88" fmla="*/ 81 w 93"/>
                    <a:gd name="T89" fmla="*/ 3 h 16"/>
                    <a:gd name="T90" fmla="*/ 83 w 93"/>
                    <a:gd name="T91" fmla="*/ 1 h 16"/>
                    <a:gd name="T92" fmla="*/ 84 w 93"/>
                    <a:gd name="T93" fmla="*/ 1 h 16"/>
                    <a:gd name="T94" fmla="*/ 86 w 93"/>
                    <a:gd name="T95" fmla="*/ 1 h 16"/>
                    <a:gd name="T96" fmla="*/ 89 w 93"/>
                    <a:gd name="T97" fmla="*/ 1 h 16"/>
                    <a:gd name="T98" fmla="*/ 90 w 93"/>
                    <a:gd name="T99" fmla="*/ 0 h 16"/>
                    <a:gd name="T100" fmla="*/ 92 w 93"/>
                    <a:gd name="T101" fmla="*/ 0 h 1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  <a:cxn ang="0">
                      <a:pos x="T90" y="T91"/>
                    </a:cxn>
                    <a:cxn ang="0">
                      <a:pos x="T92" y="T93"/>
                    </a:cxn>
                    <a:cxn ang="0">
                      <a:pos x="T94" y="T95"/>
                    </a:cxn>
                    <a:cxn ang="0">
                      <a:pos x="T96" y="T97"/>
                    </a:cxn>
                    <a:cxn ang="0">
                      <a:pos x="T98" y="T99"/>
                    </a:cxn>
                    <a:cxn ang="0">
                      <a:pos x="T100" y="T101"/>
                    </a:cxn>
                  </a:cxnLst>
                  <a:rect l="0" t="0" r="r" b="b"/>
                  <a:pathLst>
                    <a:path w="93" h="16">
                      <a:moveTo>
                        <a:pt x="0" y="16"/>
                      </a:moveTo>
                      <a:lnTo>
                        <a:pt x="0" y="16"/>
                      </a:lnTo>
                      <a:lnTo>
                        <a:pt x="1" y="16"/>
                      </a:lnTo>
                      <a:lnTo>
                        <a:pt x="3" y="16"/>
                      </a:lnTo>
                      <a:lnTo>
                        <a:pt x="3" y="16"/>
                      </a:lnTo>
                      <a:lnTo>
                        <a:pt x="4" y="16"/>
                      </a:lnTo>
                      <a:lnTo>
                        <a:pt x="5" y="16"/>
                      </a:lnTo>
                      <a:lnTo>
                        <a:pt x="5" y="16"/>
                      </a:lnTo>
                      <a:lnTo>
                        <a:pt x="7" y="16"/>
                      </a:lnTo>
                      <a:lnTo>
                        <a:pt x="8" y="16"/>
                      </a:lnTo>
                      <a:lnTo>
                        <a:pt x="8" y="14"/>
                      </a:lnTo>
                      <a:lnTo>
                        <a:pt x="10" y="14"/>
                      </a:lnTo>
                      <a:lnTo>
                        <a:pt x="11" y="14"/>
                      </a:lnTo>
                      <a:lnTo>
                        <a:pt x="11" y="14"/>
                      </a:lnTo>
                      <a:lnTo>
                        <a:pt x="13" y="14"/>
                      </a:lnTo>
                      <a:lnTo>
                        <a:pt x="13" y="14"/>
                      </a:lnTo>
                      <a:lnTo>
                        <a:pt x="14" y="14"/>
                      </a:lnTo>
                      <a:lnTo>
                        <a:pt x="16" y="14"/>
                      </a:lnTo>
                      <a:lnTo>
                        <a:pt x="16" y="14"/>
                      </a:lnTo>
                      <a:lnTo>
                        <a:pt x="17" y="14"/>
                      </a:lnTo>
                      <a:lnTo>
                        <a:pt x="18" y="14"/>
                      </a:lnTo>
                      <a:lnTo>
                        <a:pt x="18" y="13"/>
                      </a:lnTo>
                      <a:lnTo>
                        <a:pt x="20" y="13"/>
                      </a:lnTo>
                      <a:lnTo>
                        <a:pt x="21" y="13"/>
                      </a:lnTo>
                      <a:lnTo>
                        <a:pt x="21" y="13"/>
                      </a:lnTo>
                      <a:lnTo>
                        <a:pt x="23" y="13"/>
                      </a:lnTo>
                      <a:lnTo>
                        <a:pt x="23" y="13"/>
                      </a:lnTo>
                      <a:lnTo>
                        <a:pt x="24" y="13"/>
                      </a:lnTo>
                      <a:lnTo>
                        <a:pt x="26" y="13"/>
                      </a:lnTo>
                      <a:lnTo>
                        <a:pt x="26" y="13"/>
                      </a:lnTo>
                      <a:lnTo>
                        <a:pt x="27" y="13"/>
                      </a:lnTo>
                      <a:lnTo>
                        <a:pt x="28" y="11"/>
                      </a:lnTo>
                      <a:lnTo>
                        <a:pt x="28" y="11"/>
                      </a:lnTo>
                      <a:lnTo>
                        <a:pt x="30" y="11"/>
                      </a:lnTo>
                      <a:lnTo>
                        <a:pt x="31" y="11"/>
                      </a:lnTo>
                      <a:lnTo>
                        <a:pt x="31" y="11"/>
                      </a:lnTo>
                      <a:lnTo>
                        <a:pt x="33" y="11"/>
                      </a:lnTo>
                      <a:lnTo>
                        <a:pt x="34" y="11"/>
                      </a:lnTo>
                      <a:lnTo>
                        <a:pt x="34" y="11"/>
                      </a:lnTo>
                      <a:lnTo>
                        <a:pt x="36" y="11"/>
                      </a:lnTo>
                      <a:lnTo>
                        <a:pt x="36" y="11"/>
                      </a:lnTo>
                      <a:lnTo>
                        <a:pt x="37" y="10"/>
                      </a:lnTo>
                      <a:lnTo>
                        <a:pt x="38" y="10"/>
                      </a:lnTo>
                      <a:lnTo>
                        <a:pt x="38" y="10"/>
                      </a:lnTo>
                      <a:lnTo>
                        <a:pt x="40" y="10"/>
                      </a:lnTo>
                      <a:lnTo>
                        <a:pt x="41" y="10"/>
                      </a:lnTo>
                      <a:lnTo>
                        <a:pt x="41" y="10"/>
                      </a:lnTo>
                      <a:lnTo>
                        <a:pt x="43" y="10"/>
                      </a:lnTo>
                      <a:lnTo>
                        <a:pt x="44" y="10"/>
                      </a:lnTo>
                      <a:lnTo>
                        <a:pt x="44" y="10"/>
                      </a:lnTo>
                      <a:lnTo>
                        <a:pt x="46" y="9"/>
                      </a:lnTo>
                      <a:lnTo>
                        <a:pt x="46" y="9"/>
                      </a:lnTo>
                      <a:lnTo>
                        <a:pt x="47" y="9"/>
                      </a:lnTo>
                      <a:lnTo>
                        <a:pt x="49" y="9"/>
                      </a:lnTo>
                      <a:lnTo>
                        <a:pt x="49" y="9"/>
                      </a:lnTo>
                      <a:lnTo>
                        <a:pt x="50" y="9"/>
                      </a:lnTo>
                      <a:lnTo>
                        <a:pt x="51" y="9"/>
                      </a:lnTo>
                      <a:lnTo>
                        <a:pt x="51" y="9"/>
                      </a:lnTo>
                      <a:lnTo>
                        <a:pt x="53" y="9"/>
                      </a:lnTo>
                      <a:lnTo>
                        <a:pt x="54" y="7"/>
                      </a:lnTo>
                      <a:lnTo>
                        <a:pt x="54" y="7"/>
                      </a:lnTo>
                      <a:lnTo>
                        <a:pt x="56" y="7"/>
                      </a:lnTo>
                      <a:lnTo>
                        <a:pt x="56" y="7"/>
                      </a:lnTo>
                      <a:lnTo>
                        <a:pt x="57" y="7"/>
                      </a:lnTo>
                      <a:lnTo>
                        <a:pt x="59" y="7"/>
                      </a:lnTo>
                      <a:lnTo>
                        <a:pt x="59" y="7"/>
                      </a:lnTo>
                      <a:lnTo>
                        <a:pt x="60" y="7"/>
                      </a:lnTo>
                      <a:lnTo>
                        <a:pt x="61" y="6"/>
                      </a:lnTo>
                      <a:lnTo>
                        <a:pt x="61" y="6"/>
                      </a:lnTo>
                      <a:lnTo>
                        <a:pt x="63" y="6"/>
                      </a:lnTo>
                      <a:lnTo>
                        <a:pt x="64" y="6"/>
                      </a:lnTo>
                      <a:lnTo>
                        <a:pt x="64" y="6"/>
                      </a:lnTo>
                      <a:lnTo>
                        <a:pt x="66" y="6"/>
                      </a:lnTo>
                      <a:lnTo>
                        <a:pt x="66" y="6"/>
                      </a:lnTo>
                      <a:lnTo>
                        <a:pt x="67" y="6"/>
                      </a:lnTo>
                      <a:lnTo>
                        <a:pt x="69" y="4"/>
                      </a:lnTo>
                      <a:lnTo>
                        <a:pt x="69" y="4"/>
                      </a:lnTo>
                      <a:lnTo>
                        <a:pt x="70" y="4"/>
                      </a:lnTo>
                      <a:lnTo>
                        <a:pt x="71" y="4"/>
                      </a:lnTo>
                      <a:lnTo>
                        <a:pt x="71" y="4"/>
                      </a:lnTo>
                      <a:lnTo>
                        <a:pt x="73" y="4"/>
                      </a:lnTo>
                      <a:lnTo>
                        <a:pt x="73" y="4"/>
                      </a:lnTo>
                      <a:lnTo>
                        <a:pt x="74" y="4"/>
                      </a:lnTo>
                      <a:lnTo>
                        <a:pt x="76" y="3"/>
                      </a:lnTo>
                      <a:lnTo>
                        <a:pt x="76" y="3"/>
                      </a:lnTo>
                      <a:lnTo>
                        <a:pt x="77" y="3"/>
                      </a:lnTo>
                      <a:lnTo>
                        <a:pt x="79" y="3"/>
                      </a:lnTo>
                      <a:lnTo>
                        <a:pt x="79" y="3"/>
                      </a:lnTo>
                      <a:lnTo>
                        <a:pt x="80" y="3"/>
                      </a:lnTo>
                      <a:lnTo>
                        <a:pt x="81" y="3"/>
                      </a:lnTo>
                      <a:lnTo>
                        <a:pt x="81" y="3"/>
                      </a:lnTo>
                      <a:lnTo>
                        <a:pt x="83" y="1"/>
                      </a:lnTo>
                      <a:lnTo>
                        <a:pt x="83" y="1"/>
                      </a:lnTo>
                      <a:lnTo>
                        <a:pt x="84" y="1"/>
                      </a:lnTo>
                      <a:lnTo>
                        <a:pt x="86" y="1"/>
                      </a:lnTo>
                      <a:lnTo>
                        <a:pt x="86" y="1"/>
                      </a:lnTo>
                      <a:lnTo>
                        <a:pt x="87" y="1"/>
                      </a:lnTo>
                      <a:lnTo>
                        <a:pt x="89" y="1"/>
                      </a:lnTo>
                      <a:lnTo>
                        <a:pt x="89" y="0"/>
                      </a:lnTo>
                      <a:lnTo>
                        <a:pt x="90" y="0"/>
                      </a:lnTo>
                      <a:lnTo>
                        <a:pt x="90" y="0"/>
                      </a:lnTo>
                      <a:lnTo>
                        <a:pt x="92" y="0"/>
                      </a:lnTo>
                      <a:lnTo>
                        <a:pt x="93" y="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2" name="Freeform 247"/>
                <p:cNvSpPr/>
                <p:nvPr/>
              </p:nvSpPr>
              <p:spPr bwMode="auto">
                <a:xfrm>
                  <a:off x="3850" y="3213"/>
                  <a:ext cx="95" cy="8"/>
                </a:xfrm>
                <a:custGeom>
                  <a:avLst/>
                  <a:gdLst>
                    <a:gd name="T0" fmla="*/ 95 w 95"/>
                    <a:gd name="T1" fmla="*/ 0 h 8"/>
                    <a:gd name="T2" fmla="*/ 89 w 95"/>
                    <a:gd name="T3" fmla="*/ 1 h 8"/>
                    <a:gd name="T4" fmla="*/ 83 w 95"/>
                    <a:gd name="T5" fmla="*/ 1 h 8"/>
                    <a:gd name="T6" fmla="*/ 78 w 95"/>
                    <a:gd name="T7" fmla="*/ 3 h 8"/>
                    <a:gd name="T8" fmla="*/ 70 w 95"/>
                    <a:gd name="T9" fmla="*/ 3 h 8"/>
                    <a:gd name="T10" fmla="*/ 65 w 95"/>
                    <a:gd name="T11" fmla="*/ 4 h 8"/>
                    <a:gd name="T12" fmla="*/ 59 w 95"/>
                    <a:gd name="T13" fmla="*/ 4 h 8"/>
                    <a:gd name="T14" fmla="*/ 53 w 95"/>
                    <a:gd name="T15" fmla="*/ 5 h 8"/>
                    <a:gd name="T16" fmla="*/ 47 w 95"/>
                    <a:gd name="T17" fmla="*/ 5 h 8"/>
                    <a:gd name="T18" fmla="*/ 42 w 95"/>
                    <a:gd name="T19" fmla="*/ 5 h 8"/>
                    <a:gd name="T20" fmla="*/ 36 w 95"/>
                    <a:gd name="T21" fmla="*/ 7 h 8"/>
                    <a:gd name="T22" fmla="*/ 30 w 95"/>
                    <a:gd name="T23" fmla="*/ 7 h 8"/>
                    <a:gd name="T24" fmla="*/ 24 w 95"/>
                    <a:gd name="T25" fmla="*/ 7 h 8"/>
                    <a:gd name="T26" fmla="*/ 19 w 95"/>
                    <a:gd name="T27" fmla="*/ 8 h 8"/>
                    <a:gd name="T28" fmla="*/ 12 w 95"/>
                    <a:gd name="T29" fmla="*/ 8 h 8"/>
                    <a:gd name="T30" fmla="*/ 6 w 95"/>
                    <a:gd name="T31" fmla="*/ 8 h 8"/>
                    <a:gd name="T32" fmla="*/ 0 w 95"/>
                    <a:gd name="T33" fmla="*/ 8 h 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</a:cxnLst>
                  <a:rect l="0" t="0" r="r" b="b"/>
                  <a:pathLst>
                    <a:path w="95" h="8">
                      <a:moveTo>
                        <a:pt x="95" y="0"/>
                      </a:moveTo>
                      <a:lnTo>
                        <a:pt x="89" y="1"/>
                      </a:lnTo>
                      <a:lnTo>
                        <a:pt x="83" y="1"/>
                      </a:lnTo>
                      <a:lnTo>
                        <a:pt x="78" y="3"/>
                      </a:lnTo>
                      <a:lnTo>
                        <a:pt x="70" y="3"/>
                      </a:lnTo>
                      <a:lnTo>
                        <a:pt x="65" y="4"/>
                      </a:lnTo>
                      <a:lnTo>
                        <a:pt x="59" y="4"/>
                      </a:lnTo>
                      <a:lnTo>
                        <a:pt x="53" y="5"/>
                      </a:lnTo>
                      <a:lnTo>
                        <a:pt x="47" y="5"/>
                      </a:lnTo>
                      <a:lnTo>
                        <a:pt x="42" y="5"/>
                      </a:lnTo>
                      <a:lnTo>
                        <a:pt x="36" y="7"/>
                      </a:lnTo>
                      <a:lnTo>
                        <a:pt x="30" y="7"/>
                      </a:lnTo>
                      <a:lnTo>
                        <a:pt x="24" y="7"/>
                      </a:lnTo>
                      <a:lnTo>
                        <a:pt x="19" y="8"/>
                      </a:lnTo>
                      <a:lnTo>
                        <a:pt x="12" y="8"/>
                      </a:lnTo>
                      <a:lnTo>
                        <a:pt x="6" y="8"/>
                      </a:lnTo>
                      <a:lnTo>
                        <a:pt x="0" y="8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4" name="Line 249"/>
                <p:cNvSpPr>
                  <a:spLocks noChangeShapeType="1"/>
                </p:cNvSpPr>
                <p:nvPr/>
              </p:nvSpPr>
              <p:spPr bwMode="auto">
                <a:xfrm>
                  <a:off x="3936" y="3147"/>
                  <a:ext cx="9" cy="63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5" name="Freeform 250"/>
                <p:cNvSpPr/>
                <p:nvPr/>
              </p:nvSpPr>
              <p:spPr bwMode="auto">
                <a:xfrm>
                  <a:off x="4022" y="3106"/>
                  <a:ext cx="86" cy="23"/>
                </a:xfrm>
                <a:custGeom>
                  <a:avLst/>
                  <a:gdLst>
                    <a:gd name="T0" fmla="*/ 2 w 86"/>
                    <a:gd name="T1" fmla="*/ 23 h 23"/>
                    <a:gd name="T2" fmla="*/ 3 w 86"/>
                    <a:gd name="T3" fmla="*/ 23 h 23"/>
                    <a:gd name="T4" fmla="*/ 4 w 86"/>
                    <a:gd name="T5" fmla="*/ 22 h 23"/>
                    <a:gd name="T6" fmla="*/ 6 w 86"/>
                    <a:gd name="T7" fmla="*/ 22 h 23"/>
                    <a:gd name="T8" fmla="*/ 7 w 86"/>
                    <a:gd name="T9" fmla="*/ 22 h 23"/>
                    <a:gd name="T10" fmla="*/ 9 w 86"/>
                    <a:gd name="T11" fmla="*/ 22 h 23"/>
                    <a:gd name="T12" fmla="*/ 12 w 86"/>
                    <a:gd name="T13" fmla="*/ 21 h 23"/>
                    <a:gd name="T14" fmla="*/ 13 w 86"/>
                    <a:gd name="T15" fmla="*/ 21 h 23"/>
                    <a:gd name="T16" fmla="*/ 15 w 86"/>
                    <a:gd name="T17" fmla="*/ 21 h 23"/>
                    <a:gd name="T18" fmla="*/ 16 w 86"/>
                    <a:gd name="T19" fmla="*/ 21 h 23"/>
                    <a:gd name="T20" fmla="*/ 17 w 86"/>
                    <a:gd name="T21" fmla="*/ 19 h 23"/>
                    <a:gd name="T22" fmla="*/ 19 w 86"/>
                    <a:gd name="T23" fmla="*/ 19 h 23"/>
                    <a:gd name="T24" fmla="*/ 20 w 86"/>
                    <a:gd name="T25" fmla="*/ 19 h 23"/>
                    <a:gd name="T26" fmla="*/ 22 w 86"/>
                    <a:gd name="T27" fmla="*/ 19 h 23"/>
                    <a:gd name="T28" fmla="*/ 23 w 86"/>
                    <a:gd name="T29" fmla="*/ 18 h 23"/>
                    <a:gd name="T30" fmla="*/ 25 w 86"/>
                    <a:gd name="T31" fmla="*/ 18 h 23"/>
                    <a:gd name="T32" fmla="*/ 27 w 86"/>
                    <a:gd name="T33" fmla="*/ 18 h 23"/>
                    <a:gd name="T34" fmla="*/ 29 w 86"/>
                    <a:gd name="T35" fmla="*/ 18 h 23"/>
                    <a:gd name="T36" fmla="*/ 30 w 86"/>
                    <a:gd name="T37" fmla="*/ 16 h 23"/>
                    <a:gd name="T38" fmla="*/ 32 w 86"/>
                    <a:gd name="T39" fmla="*/ 16 h 23"/>
                    <a:gd name="T40" fmla="*/ 33 w 86"/>
                    <a:gd name="T41" fmla="*/ 16 h 23"/>
                    <a:gd name="T42" fmla="*/ 35 w 86"/>
                    <a:gd name="T43" fmla="*/ 15 h 23"/>
                    <a:gd name="T44" fmla="*/ 36 w 86"/>
                    <a:gd name="T45" fmla="*/ 15 h 23"/>
                    <a:gd name="T46" fmla="*/ 37 w 86"/>
                    <a:gd name="T47" fmla="*/ 15 h 23"/>
                    <a:gd name="T48" fmla="*/ 39 w 86"/>
                    <a:gd name="T49" fmla="*/ 15 h 23"/>
                    <a:gd name="T50" fmla="*/ 40 w 86"/>
                    <a:gd name="T51" fmla="*/ 13 h 23"/>
                    <a:gd name="T52" fmla="*/ 42 w 86"/>
                    <a:gd name="T53" fmla="*/ 13 h 23"/>
                    <a:gd name="T54" fmla="*/ 43 w 86"/>
                    <a:gd name="T55" fmla="*/ 13 h 23"/>
                    <a:gd name="T56" fmla="*/ 46 w 86"/>
                    <a:gd name="T57" fmla="*/ 12 h 23"/>
                    <a:gd name="T58" fmla="*/ 48 w 86"/>
                    <a:gd name="T59" fmla="*/ 12 h 23"/>
                    <a:gd name="T60" fmla="*/ 49 w 86"/>
                    <a:gd name="T61" fmla="*/ 12 h 23"/>
                    <a:gd name="T62" fmla="*/ 50 w 86"/>
                    <a:gd name="T63" fmla="*/ 12 h 23"/>
                    <a:gd name="T64" fmla="*/ 52 w 86"/>
                    <a:gd name="T65" fmla="*/ 11 h 23"/>
                    <a:gd name="T66" fmla="*/ 53 w 86"/>
                    <a:gd name="T67" fmla="*/ 11 h 23"/>
                    <a:gd name="T68" fmla="*/ 55 w 86"/>
                    <a:gd name="T69" fmla="*/ 11 h 23"/>
                    <a:gd name="T70" fmla="*/ 56 w 86"/>
                    <a:gd name="T71" fmla="*/ 9 h 23"/>
                    <a:gd name="T72" fmla="*/ 58 w 86"/>
                    <a:gd name="T73" fmla="*/ 9 h 23"/>
                    <a:gd name="T74" fmla="*/ 59 w 86"/>
                    <a:gd name="T75" fmla="*/ 9 h 23"/>
                    <a:gd name="T76" fmla="*/ 60 w 86"/>
                    <a:gd name="T77" fmla="*/ 8 h 23"/>
                    <a:gd name="T78" fmla="*/ 63 w 86"/>
                    <a:gd name="T79" fmla="*/ 8 h 23"/>
                    <a:gd name="T80" fmla="*/ 65 w 86"/>
                    <a:gd name="T81" fmla="*/ 8 h 23"/>
                    <a:gd name="T82" fmla="*/ 66 w 86"/>
                    <a:gd name="T83" fmla="*/ 6 h 23"/>
                    <a:gd name="T84" fmla="*/ 68 w 86"/>
                    <a:gd name="T85" fmla="*/ 6 h 23"/>
                    <a:gd name="T86" fmla="*/ 69 w 86"/>
                    <a:gd name="T87" fmla="*/ 6 h 23"/>
                    <a:gd name="T88" fmla="*/ 70 w 86"/>
                    <a:gd name="T89" fmla="*/ 6 h 23"/>
                    <a:gd name="T90" fmla="*/ 72 w 86"/>
                    <a:gd name="T91" fmla="*/ 5 h 23"/>
                    <a:gd name="T92" fmla="*/ 73 w 86"/>
                    <a:gd name="T93" fmla="*/ 5 h 23"/>
                    <a:gd name="T94" fmla="*/ 75 w 86"/>
                    <a:gd name="T95" fmla="*/ 5 h 23"/>
                    <a:gd name="T96" fmla="*/ 76 w 86"/>
                    <a:gd name="T97" fmla="*/ 3 h 23"/>
                    <a:gd name="T98" fmla="*/ 78 w 86"/>
                    <a:gd name="T99" fmla="*/ 3 h 23"/>
                    <a:gd name="T100" fmla="*/ 79 w 86"/>
                    <a:gd name="T101" fmla="*/ 3 h 23"/>
                    <a:gd name="T102" fmla="*/ 80 w 86"/>
                    <a:gd name="T103" fmla="*/ 2 h 23"/>
                    <a:gd name="T104" fmla="*/ 83 w 86"/>
                    <a:gd name="T105" fmla="*/ 2 h 23"/>
                    <a:gd name="T106" fmla="*/ 85 w 86"/>
                    <a:gd name="T107" fmla="*/ 2 h 23"/>
                    <a:gd name="T108" fmla="*/ 86 w 86"/>
                    <a:gd name="T109" fmla="*/ 0 h 2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  <a:cxn ang="0">
                      <a:pos x="T90" y="T91"/>
                    </a:cxn>
                    <a:cxn ang="0">
                      <a:pos x="T92" y="T93"/>
                    </a:cxn>
                    <a:cxn ang="0">
                      <a:pos x="T94" y="T95"/>
                    </a:cxn>
                    <a:cxn ang="0">
                      <a:pos x="T96" y="T97"/>
                    </a:cxn>
                    <a:cxn ang="0">
                      <a:pos x="T98" y="T99"/>
                    </a:cxn>
                    <a:cxn ang="0">
                      <a:pos x="T100" y="T101"/>
                    </a:cxn>
                    <a:cxn ang="0">
                      <a:pos x="T102" y="T103"/>
                    </a:cxn>
                    <a:cxn ang="0">
                      <a:pos x="T104" y="T105"/>
                    </a:cxn>
                    <a:cxn ang="0">
                      <a:pos x="T106" y="T107"/>
                    </a:cxn>
                    <a:cxn ang="0">
                      <a:pos x="T108" y="T109"/>
                    </a:cxn>
                  </a:cxnLst>
                  <a:rect l="0" t="0" r="r" b="b"/>
                  <a:pathLst>
                    <a:path w="86" h="23">
                      <a:moveTo>
                        <a:pt x="0" y="23"/>
                      </a:moveTo>
                      <a:lnTo>
                        <a:pt x="2" y="23"/>
                      </a:lnTo>
                      <a:lnTo>
                        <a:pt x="3" y="23"/>
                      </a:lnTo>
                      <a:lnTo>
                        <a:pt x="3" y="23"/>
                      </a:lnTo>
                      <a:lnTo>
                        <a:pt x="4" y="23"/>
                      </a:lnTo>
                      <a:lnTo>
                        <a:pt x="4" y="22"/>
                      </a:lnTo>
                      <a:lnTo>
                        <a:pt x="6" y="22"/>
                      </a:lnTo>
                      <a:lnTo>
                        <a:pt x="6" y="22"/>
                      </a:lnTo>
                      <a:lnTo>
                        <a:pt x="7" y="22"/>
                      </a:lnTo>
                      <a:lnTo>
                        <a:pt x="7" y="22"/>
                      </a:lnTo>
                      <a:lnTo>
                        <a:pt x="9" y="22"/>
                      </a:lnTo>
                      <a:lnTo>
                        <a:pt x="9" y="22"/>
                      </a:lnTo>
                      <a:lnTo>
                        <a:pt x="10" y="22"/>
                      </a:lnTo>
                      <a:lnTo>
                        <a:pt x="12" y="21"/>
                      </a:lnTo>
                      <a:lnTo>
                        <a:pt x="12" y="21"/>
                      </a:lnTo>
                      <a:lnTo>
                        <a:pt x="13" y="21"/>
                      </a:lnTo>
                      <a:lnTo>
                        <a:pt x="13" y="21"/>
                      </a:lnTo>
                      <a:lnTo>
                        <a:pt x="15" y="21"/>
                      </a:lnTo>
                      <a:lnTo>
                        <a:pt x="15" y="21"/>
                      </a:lnTo>
                      <a:lnTo>
                        <a:pt x="16" y="21"/>
                      </a:lnTo>
                      <a:lnTo>
                        <a:pt x="16" y="21"/>
                      </a:lnTo>
                      <a:lnTo>
                        <a:pt x="17" y="19"/>
                      </a:lnTo>
                      <a:lnTo>
                        <a:pt x="19" y="19"/>
                      </a:lnTo>
                      <a:lnTo>
                        <a:pt x="19" y="19"/>
                      </a:lnTo>
                      <a:lnTo>
                        <a:pt x="20" y="19"/>
                      </a:lnTo>
                      <a:lnTo>
                        <a:pt x="20" y="19"/>
                      </a:lnTo>
                      <a:lnTo>
                        <a:pt x="22" y="19"/>
                      </a:lnTo>
                      <a:lnTo>
                        <a:pt x="22" y="19"/>
                      </a:lnTo>
                      <a:lnTo>
                        <a:pt x="23" y="18"/>
                      </a:lnTo>
                      <a:lnTo>
                        <a:pt x="23" y="18"/>
                      </a:lnTo>
                      <a:lnTo>
                        <a:pt x="25" y="18"/>
                      </a:lnTo>
                      <a:lnTo>
                        <a:pt x="25" y="18"/>
                      </a:lnTo>
                      <a:lnTo>
                        <a:pt x="26" y="18"/>
                      </a:lnTo>
                      <a:lnTo>
                        <a:pt x="27" y="18"/>
                      </a:lnTo>
                      <a:lnTo>
                        <a:pt x="27" y="18"/>
                      </a:lnTo>
                      <a:lnTo>
                        <a:pt x="29" y="18"/>
                      </a:lnTo>
                      <a:lnTo>
                        <a:pt x="29" y="16"/>
                      </a:lnTo>
                      <a:lnTo>
                        <a:pt x="30" y="16"/>
                      </a:lnTo>
                      <a:lnTo>
                        <a:pt x="30" y="16"/>
                      </a:lnTo>
                      <a:lnTo>
                        <a:pt x="32" y="16"/>
                      </a:lnTo>
                      <a:lnTo>
                        <a:pt x="32" y="16"/>
                      </a:lnTo>
                      <a:lnTo>
                        <a:pt x="33" y="16"/>
                      </a:lnTo>
                      <a:lnTo>
                        <a:pt x="33" y="16"/>
                      </a:lnTo>
                      <a:lnTo>
                        <a:pt x="35" y="15"/>
                      </a:lnTo>
                      <a:lnTo>
                        <a:pt x="36" y="15"/>
                      </a:lnTo>
                      <a:lnTo>
                        <a:pt x="36" y="15"/>
                      </a:lnTo>
                      <a:lnTo>
                        <a:pt x="37" y="15"/>
                      </a:lnTo>
                      <a:lnTo>
                        <a:pt x="37" y="15"/>
                      </a:lnTo>
                      <a:lnTo>
                        <a:pt x="39" y="15"/>
                      </a:lnTo>
                      <a:lnTo>
                        <a:pt x="39" y="15"/>
                      </a:lnTo>
                      <a:lnTo>
                        <a:pt x="40" y="13"/>
                      </a:lnTo>
                      <a:lnTo>
                        <a:pt x="40" y="13"/>
                      </a:lnTo>
                      <a:lnTo>
                        <a:pt x="42" y="13"/>
                      </a:lnTo>
                      <a:lnTo>
                        <a:pt x="42" y="13"/>
                      </a:lnTo>
                      <a:lnTo>
                        <a:pt x="43" y="13"/>
                      </a:lnTo>
                      <a:lnTo>
                        <a:pt x="43" y="13"/>
                      </a:lnTo>
                      <a:lnTo>
                        <a:pt x="45" y="13"/>
                      </a:lnTo>
                      <a:lnTo>
                        <a:pt x="46" y="12"/>
                      </a:lnTo>
                      <a:lnTo>
                        <a:pt x="46" y="12"/>
                      </a:lnTo>
                      <a:lnTo>
                        <a:pt x="48" y="12"/>
                      </a:lnTo>
                      <a:lnTo>
                        <a:pt x="48" y="12"/>
                      </a:lnTo>
                      <a:lnTo>
                        <a:pt x="49" y="12"/>
                      </a:lnTo>
                      <a:lnTo>
                        <a:pt x="49" y="12"/>
                      </a:lnTo>
                      <a:lnTo>
                        <a:pt x="50" y="12"/>
                      </a:lnTo>
                      <a:lnTo>
                        <a:pt x="50" y="11"/>
                      </a:lnTo>
                      <a:lnTo>
                        <a:pt x="52" y="11"/>
                      </a:lnTo>
                      <a:lnTo>
                        <a:pt x="52" y="11"/>
                      </a:lnTo>
                      <a:lnTo>
                        <a:pt x="53" y="11"/>
                      </a:lnTo>
                      <a:lnTo>
                        <a:pt x="55" y="11"/>
                      </a:lnTo>
                      <a:lnTo>
                        <a:pt x="55" y="11"/>
                      </a:lnTo>
                      <a:lnTo>
                        <a:pt x="56" y="9"/>
                      </a:lnTo>
                      <a:lnTo>
                        <a:pt x="56" y="9"/>
                      </a:lnTo>
                      <a:lnTo>
                        <a:pt x="58" y="9"/>
                      </a:lnTo>
                      <a:lnTo>
                        <a:pt x="58" y="9"/>
                      </a:lnTo>
                      <a:lnTo>
                        <a:pt x="59" y="9"/>
                      </a:lnTo>
                      <a:lnTo>
                        <a:pt x="59" y="9"/>
                      </a:lnTo>
                      <a:lnTo>
                        <a:pt x="60" y="9"/>
                      </a:lnTo>
                      <a:lnTo>
                        <a:pt x="60" y="8"/>
                      </a:lnTo>
                      <a:lnTo>
                        <a:pt x="62" y="8"/>
                      </a:lnTo>
                      <a:lnTo>
                        <a:pt x="63" y="8"/>
                      </a:lnTo>
                      <a:lnTo>
                        <a:pt x="63" y="8"/>
                      </a:lnTo>
                      <a:lnTo>
                        <a:pt x="65" y="8"/>
                      </a:lnTo>
                      <a:lnTo>
                        <a:pt x="65" y="8"/>
                      </a:lnTo>
                      <a:lnTo>
                        <a:pt x="66" y="6"/>
                      </a:lnTo>
                      <a:lnTo>
                        <a:pt x="66" y="6"/>
                      </a:lnTo>
                      <a:lnTo>
                        <a:pt x="68" y="6"/>
                      </a:lnTo>
                      <a:lnTo>
                        <a:pt x="68" y="6"/>
                      </a:lnTo>
                      <a:lnTo>
                        <a:pt x="69" y="6"/>
                      </a:lnTo>
                      <a:lnTo>
                        <a:pt x="69" y="6"/>
                      </a:lnTo>
                      <a:lnTo>
                        <a:pt x="70" y="6"/>
                      </a:lnTo>
                      <a:lnTo>
                        <a:pt x="70" y="5"/>
                      </a:lnTo>
                      <a:lnTo>
                        <a:pt x="72" y="5"/>
                      </a:lnTo>
                      <a:lnTo>
                        <a:pt x="73" y="5"/>
                      </a:lnTo>
                      <a:lnTo>
                        <a:pt x="73" y="5"/>
                      </a:lnTo>
                      <a:lnTo>
                        <a:pt x="75" y="5"/>
                      </a:lnTo>
                      <a:lnTo>
                        <a:pt x="75" y="5"/>
                      </a:lnTo>
                      <a:lnTo>
                        <a:pt x="76" y="3"/>
                      </a:lnTo>
                      <a:lnTo>
                        <a:pt x="76" y="3"/>
                      </a:lnTo>
                      <a:lnTo>
                        <a:pt x="78" y="3"/>
                      </a:lnTo>
                      <a:lnTo>
                        <a:pt x="78" y="3"/>
                      </a:lnTo>
                      <a:lnTo>
                        <a:pt x="79" y="3"/>
                      </a:lnTo>
                      <a:lnTo>
                        <a:pt x="79" y="3"/>
                      </a:lnTo>
                      <a:lnTo>
                        <a:pt x="80" y="2"/>
                      </a:lnTo>
                      <a:lnTo>
                        <a:pt x="80" y="2"/>
                      </a:lnTo>
                      <a:lnTo>
                        <a:pt x="82" y="2"/>
                      </a:lnTo>
                      <a:lnTo>
                        <a:pt x="83" y="2"/>
                      </a:lnTo>
                      <a:lnTo>
                        <a:pt x="83" y="2"/>
                      </a:lnTo>
                      <a:lnTo>
                        <a:pt x="85" y="2"/>
                      </a:lnTo>
                      <a:lnTo>
                        <a:pt x="85" y="0"/>
                      </a:lnTo>
                      <a:lnTo>
                        <a:pt x="86" y="0"/>
                      </a:lnTo>
                      <a:lnTo>
                        <a:pt x="86" y="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6" name="Freeform 251"/>
                <p:cNvSpPr/>
                <p:nvPr/>
              </p:nvSpPr>
              <p:spPr bwMode="auto">
                <a:xfrm>
                  <a:off x="3936" y="3129"/>
                  <a:ext cx="86" cy="16"/>
                </a:xfrm>
                <a:custGeom>
                  <a:avLst/>
                  <a:gdLst>
                    <a:gd name="T0" fmla="*/ 86 w 86"/>
                    <a:gd name="T1" fmla="*/ 0 h 16"/>
                    <a:gd name="T2" fmla="*/ 80 w 86"/>
                    <a:gd name="T3" fmla="*/ 2 h 16"/>
                    <a:gd name="T4" fmla="*/ 75 w 86"/>
                    <a:gd name="T5" fmla="*/ 3 h 16"/>
                    <a:gd name="T6" fmla="*/ 68 w 86"/>
                    <a:gd name="T7" fmla="*/ 5 h 16"/>
                    <a:gd name="T8" fmla="*/ 62 w 86"/>
                    <a:gd name="T9" fmla="*/ 6 h 16"/>
                    <a:gd name="T10" fmla="*/ 56 w 86"/>
                    <a:gd name="T11" fmla="*/ 6 h 16"/>
                    <a:gd name="T12" fmla="*/ 49 w 86"/>
                    <a:gd name="T13" fmla="*/ 8 h 16"/>
                    <a:gd name="T14" fmla="*/ 43 w 86"/>
                    <a:gd name="T15" fmla="*/ 9 h 16"/>
                    <a:gd name="T16" fmla="*/ 37 w 86"/>
                    <a:gd name="T17" fmla="*/ 11 h 16"/>
                    <a:gd name="T18" fmla="*/ 30 w 86"/>
                    <a:gd name="T19" fmla="*/ 12 h 16"/>
                    <a:gd name="T20" fmla="*/ 25 w 86"/>
                    <a:gd name="T21" fmla="*/ 12 h 16"/>
                    <a:gd name="T22" fmla="*/ 19 w 86"/>
                    <a:gd name="T23" fmla="*/ 13 h 16"/>
                    <a:gd name="T24" fmla="*/ 12 w 86"/>
                    <a:gd name="T25" fmla="*/ 15 h 16"/>
                    <a:gd name="T26" fmla="*/ 6 w 86"/>
                    <a:gd name="T27" fmla="*/ 15 h 16"/>
                    <a:gd name="T28" fmla="*/ 0 w 86"/>
                    <a:gd name="T29" fmla="*/ 16 h 1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</a:cxnLst>
                  <a:rect l="0" t="0" r="r" b="b"/>
                  <a:pathLst>
                    <a:path w="86" h="16">
                      <a:moveTo>
                        <a:pt x="86" y="0"/>
                      </a:moveTo>
                      <a:lnTo>
                        <a:pt x="80" y="2"/>
                      </a:lnTo>
                      <a:lnTo>
                        <a:pt x="75" y="3"/>
                      </a:lnTo>
                      <a:lnTo>
                        <a:pt x="68" y="5"/>
                      </a:lnTo>
                      <a:lnTo>
                        <a:pt x="62" y="6"/>
                      </a:lnTo>
                      <a:lnTo>
                        <a:pt x="56" y="6"/>
                      </a:lnTo>
                      <a:lnTo>
                        <a:pt x="49" y="8"/>
                      </a:lnTo>
                      <a:lnTo>
                        <a:pt x="43" y="9"/>
                      </a:lnTo>
                      <a:lnTo>
                        <a:pt x="37" y="11"/>
                      </a:lnTo>
                      <a:lnTo>
                        <a:pt x="30" y="12"/>
                      </a:lnTo>
                      <a:lnTo>
                        <a:pt x="25" y="12"/>
                      </a:lnTo>
                      <a:lnTo>
                        <a:pt x="19" y="13"/>
                      </a:lnTo>
                      <a:lnTo>
                        <a:pt x="12" y="15"/>
                      </a:lnTo>
                      <a:lnTo>
                        <a:pt x="6" y="15"/>
                      </a:lnTo>
                      <a:lnTo>
                        <a:pt x="0" y="16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8" name="Line 253"/>
                <p:cNvSpPr>
                  <a:spLocks noChangeShapeType="1"/>
                </p:cNvSpPr>
                <p:nvPr/>
              </p:nvSpPr>
              <p:spPr bwMode="auto">
                <a:xfrm>
                  <a:off x="4008" y="3065"/>
                  <a:ext cx="14" cy="62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9" name="Freeform 254"/>
                <p:cNvSpPr/>
                <p:nvPr/>
              </p:nvSpPr>
              <p:spPr bwMode="auto">
                <a:xfrm>
                  <a:off x="4127" y="2979"/>
                  <a:ext cx="113" cy="49"/>
                </a:xfrm>
                <a:custGeom>
                  <a:avLst/>
                  <a:gdLst>
                    <a:gd name="T0" fmla="*/ 0 w 113"/>
                    <a:gd name="T1" fmla="*/ 49 h 49"/>
                    <a:gd name="T2" fmla="*/ 3 w 113"/>
                    <a:gd name="T3" fmla="*/ 49 h 49"/>
                    <a:gd name="T4" fmla="*/ 4 w 113"/>
                    <a:gd name="T5" fmla="*/ 47 h 49"/>
                    <a:gd name="T6" fmla="*/ 7 w 113"/>
                    <a:gd name="T7" fmla="*/ 46 h 49"/>
                    <a:gd name="T8" fmla="*/ 10 w 113"/>
                    <a:gd name="T9" fmla="*/ 46 h 49"/>
                    <a:gd name="T10" fmla="*/ 11 w 113"/>
                    <a:gd name="T11" fmla="*/ 44 h 49"/>
                    <a:gd name="T12" fmla="*/ 14 w 113"/>
                    <a:gd name="T13" fmla="*/ 43 h 49"/>
                    <a:gd name="T14" fmla="*/ 17 w 113"/>
                    <a:gd name="T15" fmla="*/ 43 h 49"/>
                    <a:gd name="T16" fmla="*/ 20 w 113"/>
                    <a:gd name="T17" fmla="*/ 41 h 49"/>
                    <a:gd name="T18" fmla="*/ 21 w 113"/>
                    <a:gd name="T19" fmla="*/ 40 h 49"/>
                    <a:gd name="T20" fmla="*/ 24 w 113"/>
                    <a:gd name="T21" fmla="*/ 40 h 49"/>
                    <a:gd name="T22" fmla="*/ 27 w 113"/>
                    <a:gd name="T23" fmla="*/ 39 h 49"/>
                    <a:gd name="T24" fmla="*/ 29 w 113"/>
                    <a:gd name="T25" fmla="*/ 37 h 49"/>
                    <a:gd name="T26" fmla="*/ 31 w 113"/>
                    <a:gd name="T27" fmla="*/ 37 h 49"/>
                    <a:gd name="T28" fmla="*/ 34 w 113"/>
                    <a:gd name="T29" fmla="*/ 36 h 49"/>
                    <a:gd name="T30" fmla="*/ 37 w 113"/>
                    <a:gd name="T31" fmla="*/ 34 h 49"/>
                    <a:gd name="T32" fmla="*/ 39 w 113"/>
                    <a:gd name="T33" fmla="*/ 34 h 49"/>
                    <a:gd name="T34" fmla="*/ 41 w 113"/>
                    <a:gd name="T35" fmla="*/ 33 h 49"/>
                    <a:gd name="T36" fmla="*/ 44 w 113"/>
                    <a:gd name="T37" fmla="*/ 31 h 49"/>
                    <a:gd name="T38" fmla="*/ 46 w 113"/>
                    <a:gd name="T39" fmla="*/ 31 h 49"/>
                    <a:gd name="T40" fmla="*/ 49 w 113"/>
                    <a:gd name="T41" fmla="*/ 30 h 49"/>
                    <a:gd name="T42" fmla="*/ 51 w 113"/>
                    <a:gd name="T43" fmla="*/ 28 h 49"/>
                    <a:gd name="T44" fmla="*/ 53 w 113"/>
                    <a:gd name="T45" fmla="*/ 27 h 49"/>
                    <a:gd name="T46" fmla="*/ 56 w 113"/>
                    <a:gd name="T47" fmla="*/ 27 h 49"/>
                    <a:gd name="T48" fmla="*/ 59 w 113"/>
                    <a:gd name="T49" fmla="*/ 26 h 49"/>
                    <a:gd name="T50" fmla="*/ 60 w 113"/>
                    <a:gd name="T51" fmla="*/ 24 h 49"/>
                    <a:gd name="T52" fmla="*/ 63 w 113"/>
                    <a:gd name="T53" fmla="*/ 23 h 49"/>
                    <a:gd name="T54" fmla="*/ 66 w 113"/>
                    <a:gd name="T55" fmla="*/ 23 h 49"/>
                    <a:gd name="T56" fmla="*/ 67 w 113"/>
                    <a:gd name="T57" fmla="*/ 21 h 49"/>
                    <a:gd name="T58" fmla="*/ 70 w 113"/>
                    <a:gd name="T59" fmla="*/ 20 h 49"/>
                    <a:gd name="T60" fmla="*/ 73 w 113"/>
                    <a:gd name="T61" fmla="*/ 18 h 49"/>
                    <a:gd name="T62" fmla="*/ 74 w 113"/>
                    <a:gd name="T63" fmla="*/ 18 h 49"/>
                    <a:gd name="T64" fmla="*/ 77 w 113"/>
                    <a:gd name="T65" fmla="*/ 17 h 49"/>
                    <a:gd name="T66" fmla="*/ 80 w 113"/>
                    <a:gd name="T67" fmla="*/ 16 h 49"/>
                    <a:gd name="T68" fmla="*/ 82 w 113"/>
                    <a:gd name="T69" fmla="*/ 14 h 49"/>
                    <a:gd name="T70" fmla="*/ 84 w 113"/>
                    <a:gd name="T71" fmla="*/ 14 h 49"/>
                    <a:gd name="T72" fmla="*/ 87 w 113"/>
                    <a:gd name="T73" fmla="*/ 13 h 49"/>
                    <a:gd name="T74" fmla="*/ 89 w 113"/>
                    <a:gd name="T75" fmla="*/ 11 h 49"/>
                    <a:gd name="T76" fmla="*/ 92 w 113"/>
                    <a:gd name="T77" fmla="*/ 10 h 49"/>
                    <a:gd name="T78" fmla="*/ 95 w 113"/>
                    <a:gd name="T79" fmla="*/ 8 h 49"/>
                    <a:gd name="T80" fmla="*/ 96 w 113"/>
                    <a:gd name="T81" fmla="*/ 8 h 49"/>
                    <a:gd name="T82" fmla="*/ 99 w 113"/>
                    <a:gd name="T83" fmla="*/ 7 h 49"/>
                    <a:gd name="T84" fmla="*/ 102 w 113"/>
                    <a:gd name="T85" fmla="*/ 6 h 49"/>
                    <a:gd name="T86" fmla="*/ 103 w 113"/>
                    <a:gd name="T87" fmla="*/ 4 h 49"/>
                    <a:gd name="T88" fmla="*/ 106 w 113"/>
                    <a:gd name="T89" fmla="*/ 3 h 49"/>
                    <a:gd name="T90" fmla="*/ 109 w 113"/>
                    <a:gd name="T91" fmla="*/ 3 h 49"/>
                    <a:gd name="T92" fmla="*/ 110 w 113"/>
                    <a:gd name="T93" fmla="*/ 1 h 49"/>
                    <a:gd name="T94" fmla="*/ 113 w 113"/>
                    <a:gd name="T95" fmla="*/ 0 h 4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  <a:cxn ang="0">
                      <a:pos x="T90" y="T91"/>
                    </a:cxn>
                    <a:cxn ang="0">
                      <a:pos x="T92" y="T93"/>
                    </a:cxn>
                    <a:cxn ang="0">
                      <a:pos x="T94" y="T95"/>
                    </a:cxn>
                  </a:cxnLst>
                  <a:rect l="0" t="0" r="r" b="b"/>
                  <a:pathLst>
                    <a:path w="113" h="49">
                      <a:moveTo>
                        <a:pt x="0" y="49"/>
                      </a:moveTo>
                      <a:lnTo>
                        <a:pt x="3" y="49"/>
                      </a:lnTo>
                      <a:lnTo>
                        <a:pt x="4" y="47"/>
                      </a:lnTo>
                      <a:lnTo>
                        <a:pt x="7" y="46"/>
                      </a:lnTo>
                      <a:lnTo>
                        <a:pt x="10" y="46"/>
                      </a:lnTo>
                      <a:lnTo>
                        <a:pt x="11" y="44"/>
                      </a:lnTo>
                      <a:lnTo>
                        <a:pt x="14" y="43"/>
                      </a:lnTo>
                      <a:lnTo>
                        <a:pt x="17" y="43"/>
                      </a:lnTo>
                      <a:lnTo>
                        <a:pt x="20" y="41"/>
                      </a:lnTo>
                      <a:lnTo>
                        <a:pt x="21" y="40"/>
                      </a:lnTo>
                      <a:lnTo>
                        <a:pt x="24" y="40"/>
                      </a:lnTo>
                      <a:lnTo>
                        <a:pt x="27" y="39"/>
                      </a:lnTo>
                      <a:lnTo>
                        <a:pt x="29" y="37"/>
                      </a:lnTo>
                      <a:lnTo>
                        <a:pt x="31" y="37"/>
                      </a:lnTo>
                      <a:lnTo>
                        <a:pt x="34" y="36"/>
                      </a:lnTo>
                      <a:lnTo>
                        <a:pt x="37" y="34"/>
                      </a:lnTo>
                      <a:lnTo>
                        <a:pt x="39" y="34"/>
                      </a:lnTo>
                      <a:lnTo>
                        <a:pt x="41" y="33"/>
                      </a:lnTo>
                      <a:lnTo>
                        <a:pt x="44" y="31"/>
                      </a:lnTo>
                      <a:lnTo>
                        <a:pt x="46" y="31"/>
                      </a:lnTo>
                      <a:lnTo>
                        <a:pt x="49" y="30"/>
                      </a:lnTo>
                      <a:lnTo>
                        <a:pt x="51" y="28"/>
                      </a:lnTo>
                      <a:lnTo>
                        <a:pt x="53" y="27"/>
                      </a:lnTo>
                      <a:lnTo>
                        <a:pt x="56" y="27"/>
                      </a:lnTo>
                      <a:lnTo>
                        <a:pt x="59" y="26"/>
                      </a:lnTo>
                      <a:lnTo>
                        <a:pt x="60" y="24"/>
                      </a:lnTo>
                      <a:lnTo>
                        <a:pt x="63" y="23"/>
                      </a:lnTo>
                      <a:lnTo>
                        <a:pt x="66" y="23"/>
                      </a:lnTo>
                      <a:lnTo>
                        <a:pt x="67" y="21"/>
                      </a:lnTo>
                      <a:lnTo>
                        <a:pt x="70" y="20"/>
                      </a:lnTo>
                      <a:lnTo>
                        <a:pt x="73" y="18"/>
                      </a:lnTo>
                      <a:lnTo>
                        <a:pt x="74" y="18"/>
                      </a:lnTo>
                      <a:lnTo>
                        <a:pt x="77" y="17"/>
                      </a:lnTo>
                      <a:lnTo>
                        <a:pt x="80" y="16"/>
                      </a:lnTo>
                      <a:lnTo>
                        <a:pt x="82" y="14"/>
                      </a:lnTo>
                      <a:lnTo>
                        <a:pt x="84" y="14"/>
                      </a:lnTo>
                      <a:lnTo>
                        <a:pt x="87" y="13"/>
                      </a:lnTo>
                      <a:lnTo>
                        <a:pt x="89" y="11"/>
                      </a:lnTo>
                      <a:lnTo>
                        <a:pt x="92" y="10"/>
                      </a:lnTo>
                      <a:lnTo>
                        <a:pt x="95" y="8"/>
                      </a:lnTo>
                      <a:lnTo>
                        <a:pt x="96" y="8"/>
                      </a:lnTo>
                      <a:lnTo>
                        <a:pt x="99" y="7"/>
                      </a:lnTo>
                      <a:lnTo>
                        <a:pt x="102" y="6"/>
                      </a:lnTo>
                      <a:lnTo>
                        <a:pt x="103" y="4"/>
                      </a:lnTo>
                      <a:lnTo>
                        <a:pt x="106" y="3"/>
                      </a:lnTo>
                      <a:lnTo>
                        <a:pt x="109" y="3"/>
                      </a:lnTo>
                      <a:lnTo>
                        <a:pt x="110" y="1"/>
                      </a:lnTo>
                      <a:lnTo>
                        <a:pt x="113" y="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0" name="Freeform 255"/>
                <p:cNvSpPr/>
                <p:nvPr/>
              </p:nvSpPr>
              <p:spPr bwMode="auto">
                <a:xfrm>
                  <a:off x="4008" y="3028"/>
                  <a:ext cx="119" cy="34"/>
                </a:xfrm>
                <a:custGeom>
                  <a:avLst/>
                  <a:gdLst>
                    <a:gd name="T0" fmla="*/ 119 w 119"/>
                    <a:gd name="T1" fmla="*/ 0 h 34"/>
                    <a:gd name="T2" fmla="*/ 112 w 119"/>
                    <a:gd name="T3" fmla="*/ 2 h 34"/>
                    <a:gd name="T4" fmla="*/ 106 w 119"/>
                    <a:gd name="T5" fmla="*/ 4 h 34"/>
                    <a:gd name="T6" fmla="*/ 99 w 119"/>
                    <a:gd name="T7" fmla="*/ 7 h 34"/>
                    <a:gd name="T8" fmla="*/ 93 w 119"/>
                    <a:gd name="T9" fmla="*/ 8 h 34"/>
                    <a:gd name="T10" fmla="*/ 86 w 119"/>
                    <a:gd name="T11" fmla="*/ 11 h 34"/>
                    <a:gd name="T12" fmla="*/ 80 w 119"/>
                    <a:gd name="T13" fmla="*/ 12 h 34"/>
                    <a:gd name="T14" fmla="*/ 73 w 119"/>
                    <a:gd name="T15" fmla="*/ 15 h 34"/>
                    <a:gd name="T16" fmla="*/ 66 w 119"/>
                    <a:gd name="T17" fmla="*/ 17 h 34"/>
                    <a:gd name="T18" fmla="*/ 60 w 119"/>
                    <a:gd name="T19" fmla="*/ 20 h 34"/>
                    <a:gd name="T20" fmla="*/ 53 w 119"/>
                    <a:gd name="T21" fmla="*/ 21 h 34"/>
                    <a:gd name="T22" fmla="*/ 47 w 119"/>
                    <a:gd name="T23" fmla="*/ 23 h 34"/>
                    <a:gd name="T24" fmla="*/ 40 w 119"/>
                    <a:gd name="T25" fmla="*/ 24 h 34"/>
                    <a:gd name="T26" fmla="*/ 33 w 119"/>
                    <a:gd name="T27" fmla="*/ 27 h 34"/>
                    <a:gd name="T28" fmla="*/ 27 w 119"/>
                    <a:gd name="T29" fmla="*/ 28 h 34"/>
                    <a:gd name="T30" fmla="*/ 20 w 119"/>
                    <a:gd name="T31" fmla="*/ 30 h 34"/>
                    <a:gd name="T32" fmla="*/ 13 w 119"/>
                    <a:gd name="T33" fmla="*/ 31 h 34"/>
                    <a:gd name="T34" fmla="*/ 7 w 119"/>
                    <a:gd name="T35" fmla="*/ 33 h 34"/>
                    <a:gd name="T36" fmla="*/ 0 w 119"/>
                    <a:gd name="T37" fmla="*/ 34 h 3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</a:cxnLst>
                  <a:rect l="0" t="0" r="r" b="b"/>
                  <a:pathLst>
                    <a:path w="119" h="34">
                      <a:moveTo>
                        <a:pt x="119" y="0"/>
                      </a:moveTo>
                      <a:lnTo>
                        <a:pt x="112" y="2"/>
                      </a:lnTo>
                      <a:lnTo>
                        <a:pt x="106" y="4"/>
                      </a:lnTo>
                      <a:lnTo>
                        <a:pt x="99" y="7"/>
                      </a:lnTo>
                      <a:lnTo>
                        <a:pt x="93" y="8"/>
                      </a:lnTo>
                      <a:lnTo>
                        <a:pt x="86" y="11"/>
                      </a:lnTo>
                      <a:lnTo>
                        <a:pt x="80" y="12"/>
                      </a:lnTo>
                      <a:lnTo>
                        <a:pt x="73" y="15"/>
                      </a:lnTo>
                      <a:lnTo>
                        <a:pt x="66" y="17"/>
                      </a:lnTo>
                      <a:lnTo>
                        <a:pt x="60" y="20"/>
                      </a:lnTo>
                      <a:lnTo>
                        <a:pt x="53" y="21"/>
                      </a:lnTo>
                      <a:lnTo>
                        <a:pt x="47" y="23"/>
                      </a:lnTo>
                      <a:lnTo>
                        <a:pt x="40" y="24"/>
                      </a:lnTo>
                      <a:lnTo>
                        <a:pt x="33" y="27"/>
                      </a:lnTo>
                      <a:lnTo>
                        <a:pt x="27" y="28"/>
                      </a:lnTo>
                      <a:lnTo>
                        <a:pt x="20" y="30"/>
                      </a:lnTo>
                      <a:lnTo>
                        <a:pt x="13" y="31"/>
                      </a:lnTo>
                      <a:lnTo>
                        <a:pt x="7" y="33"/>
                      </a:lnTo>
                      <a:lnTo>
                        <a:pt x="0" y="34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1" name="Rectangle 256"/>
                <p:cNvSpPr>
                  <a:spLocks noChangeArrowheads="1"/>
                </p:cNvSpPr>
                <p:nvPr/>
              </p:nvSpPr>
              <p:spPr bwMode="auto">
                <a:xfrm rot="4200000">
                  <a:off x="4006" y="2967"/>
                  <a:ext cx="72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86</a:t>
                  </a:r>
                </a:p>
              </p:txBody>
            </p:sp>
            <p:sp>
              <p:nvSpPr>
                <p:cNvPr id="72" name="Line 257"/>
                <p:cNvSpPr>
                  <a:spLocks noChangeShapeType="1"/>
                </p:cNvSpPr>
                <p:nvPr/>
              </p:nvSpPr>
              <p:spPr bwMode="auto">
                <a:xfrm>
                  <a:off x="4104" y="2966"/>
                  <a:ext cx="21" cy="59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3" name="Freeform 258"/>
                <p:cNvSpPr/>
                <p:nvPr/>
              </p:nvSpPr>
              <p:spPr bwMode="auto">
                <a:xfrm>
                  <a:off x="4376" y="2561"/>
                  <a:ext cx="203" cy="244"/>
                </a:xfrm>
                <a:custGeom>
                  <a:avLst/>
                  <a:gdLst>
                    <a:gd name="T0" fmla="*/ 5 w 203"/>
                    <a:gd name="T1" fmla="*/ 241 h 244"/>
                    <a:gd name="T2" fmla="*/ 10 w 203"/>
                    <a:gd name="T3" fmla="*/ 237 h 244"/>
                    <a:gd name="T4" fmla="*/ 15 w 203"/>
                    <a:gd name="T5" fmla="*/ 233 h 244"/>
                    <a:gd name="T6" fmla="*/ 20 w 203"/>
                    <a:gd name="T7" fmla="*/ 227 h 244"/>
                    <a:gd name="T8" fmla="*/ 25 w 203"/>
                    <a:gd name="T9" fmla="*/ 223 h 244"/>
                    <a:gd name="T10" fmla="*/ 30 w 203"/>
                    <a:gd name="T11" fmla="*/ 218 h 244"/>
                    <a:gd name="T12" fmla="*/ 35 w 203"/>
                    <a:gd name="T13" fmla="*/ 214 h 244"/>
                    <a:gd name="T14" fmla="*/ 41 w 203"/>
                    <a:gd name="T15" fmla="*/ 208 h 244"/>
                    <a:gd name="T16" fmla="*/ 45 w 203"/>
                    <a:gd name="T17" fmla="*/ 204 h 244"/>
                    <a:gd name="T18" fmla="*/ 51 w 203"/>
                    <a:gd name="T19" fmla="*/ 200 h 244"/>
                    <a:gd name="T20" fmla="*/ 55 w 203"/>
                    <a:gd name="T21" fmla="*/ 194 h 244"/>
                    <a:gd name="T22" fmla="*/ 59 w 203"/>
                    <a:gd name="T23" fmla="*/ 190 h 244"/>
                    <a:gd name="T24" fmla="*/ 65 w 203"/>
                    <a:gd name="T25" fmla="*/ 185 h 244"/>
                    <a:gd name="T26" fmla="*/ 69 w 203"/>
                    <a:gd name="T27" fmla="*/ 180 h 244"/>
                    <a:gd name="T28" fmla="*/ 74 w 203"/>
                    <a:gd name="T29" fmla="*/ 175 h 244"/>
                    <a:gd name="T30" fmla="*/ 79 w 203"/>
                    <a:gd name="T31" fmla="*/ 170 h 244"/>
                    <a:gd name="T32" fmla="*/ 84 w 203"/>
                    <a:gd name="T33" fmla="*/ 165 h 244"/>
                    <a:gd name="T34" fmla="*/ 88 w 203"/>
                    <a:gd name="T35" fmla="*/ 160 h 244"/>
                    <a:gd name="T36" fmla="*/ 92 w 203"/>
                    <a:gd name="T37" fmla="*/ 155 h 244"/>
                    <a:gd name="T38" fmla="*/ 96 w 203"/>
                    <a:gd name="T39" fmla="*/ 149 h 244"/>
                    <a:gd name="T40" fmla="*/ 102 w 203"/>
                    <a:gd name="T41" fmla="*/ 144 h 244"/>
                    <a:gd name="T42" fmla="*/ 106 w 203"/>
                    <a:gd name="T43" fmla="*/ 139 h 244"/>
                    <a:gd name="T44" fmla="*/ 111 w 203"/>
                    <a:gd name="T45" fmla="*/ 134 h 244"/>
                    <a:gd name="T46" fmla="*/ 115 w 203"/>
                    <a:gd name="T47" fmla="*/ 128 h 244"/>
                    <a:gd name="T48" fmla="*/ 119 w 203"/>
                    <a:gd name="T49" fmla="*/ 124 h 244"/>
                    <a:gd name="T50" fmla="*/ 124 w 203"/>
                    <a:gd name="T51" fmla="*/ 118 h 244"/>
                    <a:gd name="T52" fmla="*/ 128 w 203"/>
                    <a:gd name="T53" fmla="*/ 112 h 244"/>
                    <a:gd name="T54" fmla="*/ 132 w 203"/>
                    <a:gd name="T55" fmla="*/ 106 h 244"/>
                    <a:gd name="T56" fmla="*/ 137 w 203"/>
                    <a:gd name="T57" fmla="*/ 102 h 244"/>
                    <a:gd name="T58" fmla="*/ 141 w 203"/>
                    <a:gd name="T59" fmla="*/ 96 h 244"/>
                    <a:gd name="T60" fmla="*/ 144 w 203"/>
                    <a:gd name="T61" fmla="*/ 91 h 244"/>
                    <a:gd name="T62" fmla="*/ 148 w 203"/>
                    <a:gd name="T63" fmla="*/ 85 h 244"/>
                    <a:gd name="T64" fmla="*/ 152 w 203"/>
                    <a:gd name="T65" fmla="*/ 79 h 244"/>
                    <a:gd name="T66" fmla="*/ 157 w 203"/>
                    <a:gd name="T67" fmla="*/ 73 h 244"/>
                    <a:gd name="T68" fmla="*/ 161 w 203"/>
                    <a:gd name="T69" fmla="*/ 68 h 244"/>
                    <a:gd name="T70" fmla="*/ 164 w 203"/>
                    <a:gd name="T71" fmla="*/ 63 h 244"/>
                    <a:gd name="T72" fmla="*/ 168 w 203"/>
                    <a:gd name="T73" fmla="*/ 58 h 244"/>
                    <a:gd name="T74" fmla="*/ 172 w 203"/>
                    <a:gd name="T75" fmla="*/ 52 h 244"/>
                    <a:gd name="T76" fmla="*/ 175 w 203"/>
                    <a:gd name="T77" fmla="*/ 46 h 244"/>
                    <a:gd name="T78" fmla="*/ 180 w 203"/>
                    <a:gd name="T79" fmla="*/ 40 h 244"/>
                    <a:gd name="T80" fmla="*/ 183 w 203"/>
                    <a:gd name="T81" fmla="*/ 33 h 244"/>
                    <a:gd name="T82" fmla="*/ 187 w 203"/>
                    <a:gd name="T83" fmla="*/ 28 h 244"/>
                    <a:gd name="T84" fmla="*/ 190 w 203"/>
                    <a:gd name="T85" fmla="*/ 22 h 244"/>
                    <a:gd name="T86" fmla="*/ 194 w 203"/>
                    <a:gd name="T87" fmla="*/ 16 h 244"/>
                    <a:gd name="T88" fmla="*/ 197 w 203"/>
                    <a:gd name="T89" fmla="*/ 10 h 244"/>
                    <a:gd name="T90" fmla="*/ 201 w 203"/>
                    <a:gd name="T91" fmla="*/ 5 h 24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  <a:cxn ang="0">
                      <a:pos x="T90" y="T91"/>
                    </a:cxn>
                  </a:cxnLst>
                  <a:rect l="0" t="0" r="r" b="b"/>
                  <a:pathLst>
                    <a:path w="203" h="244">
                      <a:moveTo>
                        <a:pt x="0" y="244"/>
                      </a:moveTo>
                      <a:lnTo>
                        <a:pt x="3" y="243"/>
                      </a:lnTo>
                      <a:lnTo>
                        <a:pt x="5" y="241"/>
                      </a:lnTo>
                      <a:lnTo>
                        <a:pt x="6" y="240"/>
                      </a:lnTo>
                      <a:lnTo>
                        <a:pt x="8" y="238"/>
                      </a:lnTo>
                      <a:lnTo>
                        <a:pt x="10" y="237"/>
                      </a:lnTo>
                      <a:lnTo>
                        <a:pt x="12" y="236"/>
                      </a:lnTo>
                      <a:lnTo>
                        <a:pt x="13" y="234"/>
                      </a:lnTo>
                      <a:lnTo>
                        <a:pt x="15" y="233"/>
                      </a:lnTo>
                      <a:lnTo>
                        <a:pt x="16" y="230"/>
                      </a:lnTo>
                      <a:lnTo>
                        <a:pt x="19" y="228"/>
                      </a:lnTo>
                      <a:lnTo>
                        <a:pt x="20" y="227"/>
                      </a:lnTo>
                      <a:lnTo>
                        <a:pt x="22" y="226"/>
                      </a:lnTo>
                      <a:lnTo>
                        <a:pt x="23" y="224"/>
                      </a:lnTo>
                      <a:lnTo>
                        <a:pt x="25" y="223"/>
                      </a:lnTo>
                      <a:lnTo>
                        <a:pt x="26" y="221"/>
                      </a:lnTo>
                      <a:lnTo>
                        <a:pt x="29" y="220"/>
                      </a:lnTo>
                      <a:lnTo>
                        <a:pt x="30" y="218"/>
                      </a:lnTo>
                      <a:lnTo>
                        <a:pt x="32" y="217"/>
                      </a:lnTo>
                      <a:lnTo>
                        <a:pt x="33" y="215"/>
                      </a:lnTo>
                      <a:lnTo>
                        <a:pt x="35" y="214"/>
                      </a:lnTo>
                      <a:lnTo>
                        <a:pt x="36" y="213"/>
                      </a:lnTo>
                      <a:lnTo>
                        <a:pt x="39" y="211"/>
                      </a:lnTo>
                      <a:lnTo>
                        <a:pt x="41" y="208"/>
                      </a:lnTo>
                      <a:lnTo>
                        <a:pt x="42" y="207"/>
                      </a:lnTo>
                      <a:lnTo>
                        <a:pt x="43" y="205"/>
                      </a:lnTo>
                      <a:lnTo>
                        <a:pt x="45" y="204"/>
                      </a:lnTo>
                      <a:lnTo>
                        <a:pt x="46" y="203"/>
                      </a:lnTo>
                      <a:lnTo>
                        <a:pt x="49" y="201"/>
                      </a:lnTo>
                      <a:lnTo>
                        <a:pt x="51" y="200"/>
                      </a:lnTo>
                      <a:lnTo>
                        <a:pt x="52" y="198"/>
                      </a:lnTo>
                      <a:lnTo>
                        <a:pt x="53" y="197"/>
                      </a:lnTo>
                      <a:lnTo>
                        <a:pt x="55" y="194"/>
                      </a:lnTo>
                      <a:lnTo>
                        <a:pt x="56" y="193"/>
                      </a:lnTo>
                      <a:lnTo>
                        <a:pt x="58" y="191"/>
                      </a:lnTo>
                      <a:lnTo>
                        <a:pt x="59" y="190"/>
                      </a:lnTo>
                      <a:lnTo>
                        <a:pt x="62" y="188"/>
                      </a:lnTo>
                      <a:lnTo>
                        <a:pt x="63" y="187"/>
                      </a:lnTo>
                      <a:lnTo>
                        <a:pt x="65" y="185"/>
                      </a:lnTo>
                      <a:lnTo>
                        <a:pt x="66" y="182"/>
                      </a:lnTo>
                      <a:lnTo>
                        <a:pt x="68" y="181"/>
                      </a:lnTo>
                      <a:lnTo>
                        <a:pt x="69" y="180"/>
                      </a:lnTo>
                      <a:lnTo>
                        <a:pt x="71" y="178"/>
                      </a:lnTo>
                      <a:lnTo>
                        <a:pt x="72" y="177"/>
                      </a:lnTo>
                      <a:lnTo>
                        <a:pt x="74" y="175"/>
                      </a:lnTo>
                      <a:lnTo>
                        <a:pt x="75" y="174"/>
                      </a:lnTo>
                      <a:lnTo>
                        <a:pt x="78" y="171"/>
                      </a:lnTo>
                      <a:lnTo>
                        <a:pt x="79" y="170"/>
                      </a:lnTo>
                      <a:lnTo>
                        <a:pt x="81" y="168"/>
                      </a:lnTo>
                      <a:lnTo>
                        <a:pt x="82" y="167"/>
                      </a:lnTo>
                      <a:lnTo>
                        <a:pt x="84" y="165"/>
                      </a:lnTo>
                      <a:lnTo>
                        <a:pt x="85" y="164"/>
                      </a:lnTo>
                      <a:lnTo>
                        <a:pt x="86" y="161"/>
                      </a:lnTo>
                      <a:lnTo>
                        <a:pt x="88" y="160"/>
                      </a:lnTo>
                      <a:lnTo>
                        <a:pt x="89" y="158"/>
                      </a:lnTo>
                      <a:lnTo>
                        <a:pt x="91" y="157"/>
                      </a:lnTo>
                      <a:lnTo>
                        <a:pt x="92" y="155"/>
                      </a:lnTo>
                      <a:lnTo>
                        <a:pt x="94" y="152"/>
                      </a:lnTo>
                      <a:lnTo>
                        <a:pt x="95" y="151"/>
                      </a:lnTo>
                      <a:lnTo>
                        <a:pt x="96" y="149"/>
                      </a:lnTo>
                      <a:lnTo>
                        <a:pt x="99" y="148"/>
                      </a:lnTo>
                      <a:lnTo>
                        <a:pt x="101" y="147"/>
                      </a:lnTo>
                      <a:lnTo>
                        <a:pt x="102" y="144"/>
                      </a:lnTo>
                      <a:lnTo>
                        <a:pt x="104" y="142"/>
                      </a:lnTo>
                      <a:lnTo>
                        <a:pt x="105" y="141"/>
                      </a:lnTo>
                      <a:lnTo>
                        <a:pt x="106" y="139"/>
                      </a:lnTo>
                      <a:lnTo>
                        <a:pt x="108" y="138"/>
                      </a:lnTo>
                      <a:lnTo>
                        <a:pt x="109" y="135"/>
                      </a:lnTo>
                      <a:lnTo>
                        <a:pt x="111" y="134"/>
                      </a:lnTo>
                      <a:lnTo>
                        <a:pt x="112" y="132"/>
                      </a:lnTo>
                      <a:lnTo>
                        <a:pt x="114" y="131"/>
                      </a:lnTo>
                      <a:lnTo>
                        <a:pt x="115" y="128"/>
                      </a:lnTo>
                      <a:lnTo>
                        <a:pt x="117" y="127"/>
                      </a:lnTo>
                      <a:lnTo>
                        <a:pt x="118" y="125"/>
                      </a:lnTo>
                      <a:lnTo>
                        <a:pt x="119" y="124"/>
                      </a:lnTo>
                      <a:lnTo>
                        <a:pt x="121" y="122"/>
                      </a:lnTo>
                      <a:lnTo>
                        <a:pt x="122" y="119"/>
                      </a:lnTo>
                      <a:lnTo>
                        <a:pt x="124" y="118"/>
                      </a:lnTo>
                      <a:lnTo>
                        <a:pt x="125" y="116"/>
                      </a:lnTo>
                      <a:lnTo>
                        <a:pt x="127" y="115"/>
                      </a:lnTo>
                      <a:lnTo>
                        <a:pt x="128" y="112"/>
                      </a:lnTo>
                      <a:lnTo>
                        <a:pt x="129" y="111"/>
                      </a:lnTo>
                      <a:lnTo>
                        <a:pt x="131" y="109"/>
                      </a:lnTo>
                      <a:lnTo>
                        <a:pt x="132" y="106"/>
                      </a:lnTo>
                      <a:lnTo>
                        <a:pt x="134" y="105"/>
                      </a:lnTo>
                      <a:lnTo>
                        <a:pt x="135" y="104"/>
                      </a:lnTo>
                      <a:lnTo>
                        <a:pt x="137" y="102"/>
                      </a:lnTo>
                      <a:lnTo>
                        <a:pt x="138" y="99"/>
                      </a:lnTo>
                      <a:lnTo>
                        <a:pt x="139" y="98"/>
                      </a:lnTo>
                      <a:lnTo>
                        <a:pt x="141" y="96"/>
                      </a:lnTo>
                      <a:lnTo>
                        <a:pt x="142" y="95"/>
                      </a:lnTo>
                      <a:lnTo>
                        <a:pt x="142" y="92"/>
                      </a:lnTo>
                      <a:lnTo>
                        <a:pt x="144" y="91"/>
                      </a:lnTo>
                      <a:lnTo>
                        <a:pt x="145" y="89"/>
                      </a:lnTo>
                      <a:lnTo>
                        <a:pt x="147" y="86"/>
                      </a:lnTo>
                      <a:lnTo>
                        <a:pt x="148" y="85"/>
                      </a:lnTo>
                      <a:lnTo>
                        <a:pt x="150" y="83"/>
                      </a:lnTo>
                      <a:lnTo>
                        <a:pt x="151" y="82"/>
                      </a:lnTo>
                      <a:lnTo>
                        <a:pt x="152" y="79"/>
                      </a:lnTo>
                      <a:lnTo>
                        <a:pt x="154" y="78"/>
                      </a:lnTo>
                      <a:lnTo>
                        <a:pt x="155" y="76"/>
                      </a:lnTo>
                      <a:lnTo>
                        <a:pt x="157" y="73"/>
                      </a:lnTo>
                      <a:lnTo>
                        <a:pt x="158" y="72"/>
                      </a:lnTo>
                      <a:lnTo>
                        <a:pt x="160" y="71"/>
                      </a:lnTo>
                      <a:lnTo>
                        <a:pt x="161" y="68"/>
                      </a:lnTo>
                      <a:lnTo>
                        <a:pt x="161" y="66"/>
                      </a:lnTo>
                      <a:lnTo>
                        <a:pt x="162" y="65"/>
                      </a:lnTo>
                      <a:lnTo>
                        <a:pt x="164" y="63"/>
                      </a:lnTo>
                      <a:lnTo>
                        <a:pt x="165" y="61"/>
                      </a:lnTo>
                      <a:lnTo>
                        <a:pt x="167" y="59"/>
                      </a:lnTo>
                      <a:lnTo>
                        <a:pt x="168" y="58"/>
                      </a:lnTo>
                      <a:lnTo>
                        <a:pt x="170" y="55"/>
                      </a:lnTo>
                      <a:lnTo>
                        <a:pt x="171" y="53"/>
                      </a:lnTo>
                      <a:lnTo>
                        <a:pt x="172" y="52"/>
                      </a:lnTo>
                      <a:lnTo>
                        <a:pt x="172" y="49"/>
                      </a:lnTo>
                      <a:lnTo>
                        <a:pt x="174" y="48"/>
                      </a:lnTo>
                      <a:lnTo>
                        <a:pt x="175" y="46"/>
                      </a:lnTo>
                      <a:lnTo>
                        <a:pt x="177" y="43"/>
                      </a:lnTo>
                      <a:lnTo>
                        <a:pt x="178" y="42"/>
                      </a:lnTo>
                      <a:lnTo>
                        <a:pt x="180" y="40"/>
                      </a:lnTo>
                      <a:lnTo>
                        <a:pt x="181" y="38"/>
                      </a:lnTo>
                      <a:lnTo>
                        <a:pt x="181" y="36"/>
                      </a:lnTo>
                      <a:lnTo>
                        <a:pt x="183" y="33"/>
                      </a:lnTo>
                      <a:lnTo>
                        <a:pt x="184" y="32"/>
                      </a:lnTo>
                      <a:lnTo>
                        <a:pt x="185" y="30"/>
                      </a:lnTo>
                      <a:lnTo>
                        <a:pt x="187" y="28"/>
                      </a:lnTo>
                      <a:lnTo>
                        <a:pt x="188" y="26"/>
                      </a:lnTo>
                      <a:lnTo>
                        <a:pt x="188" y="25"/>
                      </a:lnTo>
                      <a:lnTo>
                        <a:pt x="190" y="22"/>
                      </a:lnTo>
                      <a:lnTo>
                        <a:pt x="191" y="20"/>
                      </a:lnTo>
                      <a:lnTo>
                        <a:pt x="193" y="19"/>
                      </a:lnTo>
                      <a:lnTo>
                        <a:pt x="194" y="16"/>
                      </a:lnTo>
                      <a:lnTo>
                        <a:pt x="195" y="15"/>
                      </a:lnTo>
                      <a:lnTo>
                        <a:pt x="195" y="12"/>
                      </a:lnTo>
                      <a:lnTo>
                        <a:pt x="197" y="10"/>
                      </a:lnTo>
                      <a:lnTo>
                        <a:pt x="198" y="9"/>
                      </a:lnTo>
                      <a:lnTo>
                        <a:pt x="200" y="6"/>
                      </a:lnTo>
                      <a:lnTo>
                        <a:pt x="201" y="5"/>
                      </a:lnTo>
                      <a:lnTo>
                        <a:pt x="201" y="3"/>
                      </a:lnTo>
                      <a:lnTo>
                        <a:pt x="203" y="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4" name="Freeform 259"/>
                <p:cNvSpPr/>
                <p:nvPr/>
              </p:nvSpPr>
              <p:spPr bwMode="auto">
                <a:xfrm>
                  <a:off x="4104" y="2805"/>
                  <a:ext cx="272" cy="158"/>
                </a:xfrm>
                <a:custGeom>
                  <a:avLst/>
                  <a:gdLst>
                    <a:gd name="T0" fmla="*/ 272 w 272"/>
                    <a:gd name="T1" fmla="*/ 0 h 158"/>
                    <a:gd name="T2" fmla="*/ 268 w 272"/>
                    <a:gd name="T3" fmla="*/ 4 h 158"/>
                    <a:gd name="T4" fmla="*/ 262 w 272"/>
                    <a:gd name="T5" fmla="*/ 9 h 158"/>
                    <a:gd name="T6" fmla="*/ 257 w 272"/>
                    <a:gd name="T7" fmla="*/ 15 h 158"/>
                    <a:gd name="T8" fmla="*/ 249 w 272"/>
                    <a:gd name="T9" fmla="*/ 19 h 158"/>
                    <a:gd name="T10" fmla="*/ 244 w 272"/>
                    <a:gd name="T11" fmla="*/ 23 h 158"/>
                    <a:gd name="T12" fmla="*/ 238 w 272"/>
                    <a:gd name="T13" fmla="*/ 27 h 158"/>
                    <a:gd name="T14" fmla="*/ 232 w 272"/>
                    <a:gd name="T15" fmla="*/ 32 h 158"/>
                    <a:gd name="T16" fmla="*/ 226 w 272"/>
                    <a:gd name="T17" fmla="*/ 36 h 158"/>
                    <a:gd name="T18" fmla="*/ 221 w 272"/>
                    <a:gd name="T19" fmla="*/ 40 h 158"/>
                    <a:gd name="T20" fmla="*/ 215 w 272"/>
                    <a:gd name="T21" fmla="*/ 45 h 158"/>
                    <a:gd name="T22" fmla="*/ 209 w 272"/>
                    <a:gd name="T23" fmla="*/ 49 h 158"/>
                    <a:gd name="T24" fmla="*/ 202 w 272"/>
                    <a:gd name="T25" fmla="*/ 53 h 158"/>
                    <a:gd name="T26" fmla="*/ 196 w 272"/>
                    <a:gd name="T27" fmla="*/ 58 h 158"/>
                    <a:gd name="T28" fmla="*/ 191 w 272"/>
                    <a:gd name="T29" fmla="*/ 62 h 158"/>
                    <a:gd name="T30" fmla="*/ 183 w 272"/>
                    <a:gd name="T31" fmla="*/ 66 h 158"/>
                    <a:gd name="T32" fmla="*/ 178 w 272"/>
                    <a:gd name="T33" fmla="*/ 70 h 158"/>
                    <a:gd name="T34" fmla="*/ 172 w 272"/>
                    <a:gd name="T35" fmla="*/ 73 h 158"/>
                    <a:gd name="T36" fmla="*/ 165 w 272"/>
                    <a:gd name="T37" fmla="*/ 78 h 158"/>
                    <a:gd name="T38" fmla="*/ 159 w 272"/>
                    <a:gd name="T39" fmla="*/ 82 h 158"/>
                    <a:gd name="T40" fmla="*/ 153 w 272"/>
                    <a:gd name="T41" fmla="*/ 86 h 158"/>
                    <a:gd name="T42" fmla="*/ 146 w 272"/>
                    <a:gd name="T43" fmla="*/ 89 h 158"/>
                    <a:gd name="T44" fmla="*/ 140 w 272"/>
                    <a:gd name="T45" fmla="*/ 93 h 158"/>
                    <a:gd name="T46" fmla="*/ 133 w 272"/>
                    <a:gd name="T47" fmla="*/ 96 h 158"/>
                    <a:gd name="T48" fmla="*/ 128 w 272"/>
                    <a:gd name="T49" fmla="*/ 101 h 158"/>
                    <a:gd name="T50" fmla="*/ 120 w 272"/>
                    <a:gd name="T51" fmla="*/ 103 h 158"/>
                    <a:gd name="T52" fmla="*/ 115 w 272"/>
                    <a:gd name="T53" fmla="*/ 108 h 158"/>
                    <a:gd name="T54" fmla="*/ 107 w 272"/>
                    <a:gd name="T55" fmla="*/ 111 h 158"/>
                    <a:gd name="T56" fmla="*/ 100 w 272"/>
                    <a:gd name="T57" fmla="*/ 114 h 158"/>
                    <a:gd name="T58" fmla="*/ 95 w 272"/>
                    <a:gd name="T59" fmla="*/ 118 h 158"/>
                    <a:gd name="T60" fmla="*/ 87 w 272"/>
                    <a:gd name="T61" fmla="*/ 121 h 158"/>
                    <a:gd name="T62" fmla="*/ 82 w 272"/>
                    <a:gd name="T63" fmla="*/ 124 h 158"/>
                    <a:gd name="T64" fmla="*/ 74 w 272"/>
                    <a:gd name="T65" fmla="*/ 126 h 158"/>
                    <a:gd name="T66" fmla="*/ 67 w 272"/>
                    <a:gd name="T67" fmla="*/ 131 h 158"/>
                    <a:gd name="T68" fmla="*/ 62 w 272"/>
                    <a:gd name="T69" fmla="*/ 134 h 158"/>
                    <a:gd name="T70" fmla="*/ 54 w 272"/>
                    <a:gd name="T71" fmla="*/ 136 h 158"/>
                    <a:gd name="T72" fmla="*/ 47 w 272"/>
                    <a:gd name="T73" fmla="*/ 139 h 158"/>
                    <a:gd name="T74" fmla="*/ 40 w 272"/>
                    <a:gd name="T75" fmla="*/ 142 h 158"/>
                    <a:gd name="T76" fmla="*/ 34 w 272"/>
                    <a:gd name="T77" fmla="*/ 145 h 158"/>
                    <a:gd name="T78" fmla="*/ 27 w 272"/>
                    <a:gd name="T79" fmla="*/ 148 h 158"/>
                    <a:gd name="T80" fmla="*/ 20 w 272"/>
                    <a:gd name="T81" fmla="*/ 151 h 158"/>
                    <a:gd name="T82" fmla="*/ 13 w 272"/>
                    <a:gd name="T83" fmla="*/ 152 h 158"/>
                    <a:gd name="T84" fmla="*/ 6 w 272"/>
                    <a:gd name="T85" fmla="*/ 155 h 158"/>
                    <a:gd name="T86" fmla="*/ 0 w 272"/>
                    <a:gd name="T87" fmla="*/ 158 h 15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</a:cxnLst>
                  <a:rect l="0" t="0" r="r" b="b"/>
                  <a:pathLst>
                    <a:path w="272" h="158">
                      <a:moveTo>
                        <a:pt x="272" y="0"/>
                      </a:moveTo>
                      <a:lnTo>
                        <a:pt x="268" y="4"/>
                      </a:lnTo>
                      <a:lnTo>
                        <a:pt x="262" y="9"/>
                      </a:lnTo>
                      <a:lnTo>
                        <a:pt x="257" y="15"/>
                      </a:lnTo>
                      <a:lnTo>
                        <a:pt x="249" y="19"/>
                      </a:lnTo>
                      <a:lnTo>
                        <a:pt x="244" y="23"/>
                      </a:lnTo>
                      <a:lnTo>
                        <a:pt x="238" y="27"/>
                      </a:lnTo>
                      <a:lnTo>
                        <a:pt x="232" y="32"/>
                      </a:lnTo>
                      <a:lnTo>
                        <a:pt x="226" y="36"/>
                      </a:lnTo>
                      <a:lnTo>
                        <a:pt x="221" y="40"/>
                      </a:lnTo>
                      <a:lnTo>
                        <a:pt x="215" y="45"/>
                      </a:lnTo>
                      <a:lnTo>
                        <a:pt x="209" y="49"/>
                      </a:lnTo>
                      <a:lnTo>
                        <a:pt x="202" y="53"/>
                      </a:lnTo>
                      <a:lnTo>
                        <a:pt x="196" y="58"/>
                      </a:lnTo>
                      <a:lnTo>
                        <a:pt x="191" y="62"/>
                      </a:lnTo>
                      <a:lnTo>
                        <a:pt x="183" y="66"/>
                      </a:lnTo>
                      <a:lnTo>
                        <a:pt x="178" y="70"/>
                      </a:lnTo>
                      <a:lnTo>
                        <a:pt x="172" y="73"/>
                      </a:lnTo>
                      <a:lnTo>
                        <a:pt x="165" y="78"/>
                      </a:lnTo>
                      <a:lnTo>
                        <a:pt x="159" y="82"/>
                      </a:lnTo>
                      <a:lnTo>
                        <a:pt x="153" y="86"/>
                      </a:lnTo>
                      <a:lnTo>
                        <a:pt x="146" y="89"/>
                      </a:lnTo>
                      <a:lnTo>
                        <a:pt x="140" y="93"/>
                      </a:lnTo>
                      <a:lnTo>
                        <a:pt x="133" y="96"/>
                      </a:lnTo>
                      <a:lnTo>
                        <a:pt x="128" y="101"/>
                      </a:lnTo>
                      <a:lnTo>
                        <a:pt x="120" y="103"/>
                      </a:lnTo>
                      <a:lnTo>
                        <a:pt x="115" y="108"/>
                      </a:lnTo>
                      <a:lnTo>
                        <a:pt x="107" y="111"/>
                      </a:lnTo>
                      <a:lnTo>
                        <a:pt x="100" y="114"/>
                      </a:lnTo>
                      <a:lnTo>
                        <a:pt x="95" y="118"/>
                      </a:lnTo>
                      <a:lnTo>
                        <a:pt x="87" y="121"/>
                      </a:lnTo>
                      <a:lnTo>
                        <a:pt x="82" y="124"/>
                      </a:lnTo>
                      <a:lnTo>
                        <a:pt x="74" y="126"/>
                      </a:lnTo>
                      <a:lnTo>
                        <a:pt x="67" y="131"/>
                      </a:lnTo>
                      <a:lnTo>
                        <a:pt x="62" y="134"/>
                      </a:lnTo>
                      <a:lnTo>
                        <a:pt x="54" y="136"/>
                      </a:lnTo>
                      <a:lnTo>
                        <a:pt x="47" y="139"/>
                      </a:lnTo>
                      <a:lnTo>
                        <a:pt x="40" y="142"/>
                      </a:lnTo>
                      <a:lnTo>
                        <a:pt x="34" y="145"/>
                      </a:lnTo>
                      <a:lnTo>
                        <a:pt x="27" y="148"/>
                      </a:lnTo>
                      <a:lnTo>
                        <a:pt x="20" y="151"/>
                      </a:lnTo>
                      <a:lnTo>
                        <a:pt x="13" y="152"/>
                      </a:lnTo>
                      <a:lnTo>
                        <a:pt x="6" y="155"/>
                      </a:lnTo>
                      <a:lnTo>
                        <a:pt x="0" y="158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6" name="Line 261"/>
                <p:cNvSpPr>
                  <a:spLocks noChangeShapeType="1"/>
                </p:cNvSpPr>
                <p:nvPr/>
              </p:nvSpPr>
              <p:spPr bwMode="auto">
                <a:xfrm>
                  <a:off x="4200" y="2597"/>
                  <a:ext cx="175" cy="205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7" name="Freeform 262"/>
                <p:cNvSpPr/>
                <p:nvPr/>
              </p:nvSpPr>
              <p:spPr bwMode="auto">
                <a:xfrm>
                  <a:off x="4371" y="2079"/>
                  <a:ext cx="48" cy="284"/>
                </a:xfrm>
                <a:custGeom>
                  <a:avLst/>
                  <a:gdLst>
                    <a:gd name="T0" fmla="*/ 0 w 48"/>
                    <a:gd name="T1" fmla="*/ 284 h 284"/>
                    <a:gd name="T2" fmla="*/ 1 w 48"/>
                    <a:gd name="T3" fmla="*/ 279 h 284"/>
                    <a:gd name="T4" fmla="*/ 4 w 48"/>
                    <a:gd name="T5" fmla="*/ 273 h 284"/>
                    <a:gd name="T6" fmla="*/ 5 w 48"/>
                    <a:gd name="T7" fmla="*/ 268 h 284"/>
                    <a:gd name="T8" fmla="*/ 8 w 48"/>
                    <a:gd name="T9" fmla="*/ 263 h 284"/>
                    <a:gd name="T10" fmla="*/ 10 w 48"/>
                    <a:gd name="T11" fmla="*/ 257 h 284"/>
                    <a:gd name="T12" fmla="*/ 11 w 48"/>
                    <a:gd name="T13" fmla="*/ 251 h 284"/>
                    <a:gd name="T14" fmla="*/ 14 w 48"/>
                    <a:gd name="T15" fmla="*/ 247 h 284"/>
                    <a:gd name="T16" fmla="*/ 15 w 48"/>
                    <a:gd name="T17" fmla="*/ 241 h 284"/>
                    <a:gd name="T18" fmla="*/ 17 w 48"/>
                    <a:gd name="T19" fmla="*/ 235 h 284"/>
                    <a:gd name="T20" fmla="*/ 20 w 48"/>
                    <a:gd name="T21" fmla="*/ 230 h 284"/>
                    <a:gd name="T22" fmla="*/ 21 w 48"/>
                    <a:gd name="T23" fmla="*/ 224 h 284"/>
                    <a:gd name="T24" fmla="*/ 23 w 48"/>
                    <a:gd name="T25" fmla="*/ 218 h 284"/>
                    <a:gd name="T26" fmla="*/ 24 w 48"/>
                    <a:gd name="T27" fmla="*/ 213 h 284"/>
                    <a:gd name="T28" fmla="*/ 25 w 48"/>
                    <a:gd name="T29" fmla="*/ 208 h 284"/>
                    <a:gd name="T30" fmla="*/ 27 w 48"/>
                    <a:gd name="T31" fmla="*/ 202 h 284"/>
                    <a:gd name="T32" fmla="*/ 28 w 48"/>
                    <a:gd name="T33" fmla="*/ 197 h 284"/>
                    <a:gd name="T34" fmla="*/ 30 w 48"/>
                    <a:gd name="T35" fmla="*/ 191 h 284"/>
                    <a:gd name="T36" fmla="*/ 31 w 48"/>
                    <a:gd name="T37" fmla="*/ 185 h 284"/>
                    <a:gd name="T38" fmla="*/ 33 w 48"/>
                    <a:gd name="T39" fmla="*/ 179 h 284"/>
                    <a:gd name="T40" fmla="*/ 34 w 48"/>
                    <a:gd name="T41" fmla="*/ 174 h 284"/>
                    <a:gd name="T42" fmla="*/ 35 w 48"/>
                    <a:gd name="T43" fmla="*/ 168 h 284"/>
                    <a:gd name="T44" fmla="*/ 37 w 48"/>
                    <a:gd name="T45" fmla="*/ 162 h 284"/>
                    <a:gd name="T46" fmla="*/ 38 w 48"/>
                    <a:gd name="T47" fmla="*/ 157 h 284"/>
                    <a:gd name="T48" fmla="*/ 38 w 48"/>
                    <a:gd name="T49" fmla="*/ 151 h 284"/>
                    <a:gd name="T50" fmla="*/ 40 w 48"/>
                    <a:gd name="T51" fmla="*/ 145 h 284"/>
                    <a:gd name="T52" fmla="*/ 41 w 48"/>
                    <a:gd name="T53" fmla="*/ 139 h 284"/>
                    <a:gd name="T54" fmla="*/ 41 w 48"/>
                    <a:gd name="T55" fmla="*/ 134 h 284"/>
                    <a:gd name="T56" fmla="*/ 43 w 48"/>
                    <a:gd name="T57" fmla="*/ 128 h 284"/>
                    <a:gd name="T58" fmla="*/ 43 w 48"/>
                    <a:gd name="T59" fmla="*/ 122 h 284"/>
                    <a:gd name="T60" fmla="*/ 44 w 48"/>
                    <a:gd name="T61" fmla="*/ 116 h 284"/>
                    <a:gd name="T62" fmla="*/ 44 w 48"/>
                    <a:gd name="T63" fmla="*/ 111 h 284"/>
                    <a:gd name="T64" fmla="*/ 46 w 48"/>
                    <a:gd name="T65" fmla="*/ 105 h 284"/>
                    <a:gd name="T66" fmla="*/ 46 w 48"/>
                    <a:gd name="T67" fmla="*/ 99 h 284"/>
                    <a:gd name="T68" fmla="*/ 46 w 48"/>
                    <a:gd name="T69" fmla="*/ 93 h 284"/>
                    <a:gd name="T70" fmla="*/ 47 w 48"/>
                    <a:gd name="T71" fmla="*/ 88 h 284"/>
                    <a:gd name="T72" fmla="*/ 47 w 48"/>
                    <a:gd name="T73" fmla="*/ 82 h 284"/>
                    <a:gd name="T74" fmla="*/ 47 w 48"/>
                    <a:gd name="T75" fmla="*/ 76 h 284"/>
                    <a:gd name="T76" fmla="*/ 48 w 48"/>
                    <a:gd name="T77" fmla="*/ 70 h 284"/>
                    <a:gd name="T78" fmla="*/ 48 w 48"/>
                    <a:gd name="T79" fmla="*/ 65 h 284"/>
                    <a:gd name="T80" fmla="*/ 48 w 48"/>
                    <a:gd name="T81" fmla="*/ 59 h 284"/>
                    <a:gd name="T82" fmla="*/ 48 w 48"/>
                    <a:gd name="T83" fmla="*/ 53 h 284"/>
                    <a:gd name="T84" fmla="*/ 48 w 48"/>
                    <a:gd name="T85" fmla="*/ 47 h 284"/>
                    <a:gd name="T86" fmla="*/ 48 w 48"/>
                    <a:gd name="T87" fmla="*/ 42 h 284"/>
                    <a:gd name="T88" fmla="*/ 48 w 48"/>
                    <a:gd name="T89" fmla="*/ 36 h 284"/>
                    <a:gd name="T90" fmla="*/ 48 w 48"/>
                    <a:gd name="T91" fmla="*/ 30 h 284"/>
                    <a:gd name="T92" fmla="*/ 48 w 48"/>
                    <a:gd name="T93" fmla="*/ 25 h 284"/>
                    <a:gd name="T94" fmla="*/ 48 w 48"/>
                    <a:gd name="T95" fmla="*/ 19 h 284"/>
                    <a:gd name="T96" fmla="*/ 48 w 48"/>
                    <a:gd name="T97" fmla="*/ 13 h 284"/>
                    <a:gd name="T98" fmla="*/ 47 w 48"/>
                    <a:gd name="T99" fmla="*/ 7 h 284"/>
                    <a:gd name="T100" fmla="*/ 47 w 48"/>
                    <a:gd name="T101" fmla="*/ 0 h 28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  <a:cxn ang="0">
                      <a:pos x="T90" y="T91"/>
                    </a:cxn>
                    <a:cxn ang="0">
                      <a:pos x="T92" y="T93"/>
                    </a:cxn>
                    <a:cxn ang="0">
                      <a:pos x="T94" y="T95"/>
                    </a:cxn>
                    <a:cxn ang="0">
                      <a:pos x="T96" y="T97"/>
                    </a:cxn>
                    <a:cxn ang="0">
                      <a:pos x="T98" y="T99"/>
                    </a:cxn>
                    <a:cxn ang="0">
                      <a:pos x="T100" y="T101"/>
                    </a:cxn>
                  </a:cxnLst>
                  <a:rect l="0" t="0" r="r" b="b"/>
                  <a:pathLst>
                    <a:path w="48" h="284">
                      <a:moveTo>
                        <a:pt x="0" y="284"/>
                      </a:moveTo>
                      <a:lnTo>
                        <a:pt x="1" y="279"/>
                      </a:lnTo>
                      <a:lnTo>
                        <a:pt x="4" y="273"/>
                      </a:lnTo>
                      <a:lnTo>
                        <a:pt x="5" y="268"/>
                      </a:lnTo>
                      <a:lnTo>
                        <a:pt x="8" y="263"/>
                      </a:lnTo>
                      <a:lnTo>
                        <a:pt x="10" y="257"/>
                      </a:lnTo>
                      <a:lnTo>
                        <a:pt x="11" y="251"/>
                      </a:lnTo>
                      <a:lnTo>
                        <a:pt x="14" y="247"/>
                      </a:lnTo>
                      <a:lnTo>
                        <a:pt x="15" y="241"/>
                      </a:lnTo>
                      <a:lnTo>
                        <a:pt x="17" y="235"/>
                      </a:lnTo>
                      <a:lnTo>
                        <a:pt x="20" y="230"/>
                      </a:lnTo>
                      <a:lnTo>
                        <a:pt x="21" y="224"/>
                      </a:lnTo>
                      <a:lnTo>
                        <a:pt x="23" y="218"/>
                      </a:lnTo>
                      <a:lnTo>
                        <a:pt x="24" y="213"/>
                      </a:lnTo>
                      <a:lnTo>
                        <a:pt x="25" y="208"/>
                      </a:lnTo>
                      <a:lnTo>
                        <a:pt x="27" y="202"/>
                      </a:lnTo>
                      <a:lnTo>
                        <a:pt x="28" y="197"/>
                      </a:lnTo>
                      <a:lnTo>
                        <a:pt x="30" y="191"/>
                      </a:lnTo>
                      <a:lnTo>
                        <a:pt x="31" y="185"/>
                      </a:lnTo>
                      <a:lnTo>
                        <a:pt x="33" y="179"/>
                      </a:lnTo>
                      <a:lnTo>
                        <a:pt x="34" y="174"/>
                      </a:lnTo>
                      <a:lnTo>
                        <a:pt x="35" y="168"/>
                      </a:lnTo>
                      <a:lnTo>
                        <a:pt x="37" y="162"/>
                      </a:lnTo>
                      <a:lnTo>
                        <a:pt x="38" y="157"/>
                      </a:lnTo>
                      <a:lnTo>
                        <a:pt x="38" y="151"/>
                      </a:lnTo>
                      <a:lnTo>
                        <a:pt x="40" y="145"/>
                      </a:lnTo>
                      <a:lnTo>
                        <a:pt x="41" y="139"/>
                      </a:lnTo>
                      <a:lnTo>
                        <a:pt x="41" y="134"/>
                      </a:lnTo>
                      <a:lnTo>
                        <a:pt x="43" y="128"/>
                      </a:lnTo>
                      <a:lnTo>
                        <a:pt x="43" y="122"/>
                      </a:lnTo>
                      <a:lnTo>
                        <a:pt x="44" y="116"/>
                      </a:lnTo>
                      <a:lnTo>
                        <a:pt x="44" y="111"/>
                      </a:lnTo>
                      <a:lnTo>
                        <a:pt x="46" y="105"/>
                      </a:lnTo>
                      <a:lnTo>
                        <a:pt x="46" y="99"/>
                      </a:lnTo>
                      <a:lnTo>
                        <a:pt x="46" y="93"/>
                      </a:lnTo>
                      <a:lnTo>
                        <a:pt x="47" y="88"/>
                      </a:lnTo>
                      <a:lnTo>
                        <a:pt x="47" y="82"/>
                      </a:lnTo>
                      <a:lnTo>
                        <a:pt x="47" y="76"/>
                      </a:lnTo>
                      <a:lnTo>
                        <a:pt x="48" y="70"/>
                      </a:lnTo>
                      <a:lnTo>
                        <a:pt x="48" y="65"/>
                      </a:lnTo>
                      <a:lnTo>
                        <a:pt x="48" y="59"/>
                      </a:lnTo>
                      <a:lnTo>
                        <a:pt x="48" y="53"/>
                      </a:lnTo>
                      <a:lnTo>
                        <a:pt x="48" y="47"/>
                      </a:lnTo>
                      <a:lnTo>
                        <a:pt x="48" y="42"/>
                      </a:lnTo>
                      <a:lnTo>
                        <a:pt x="48" y="36"/>
                      </a:lnTo>
                      <a:lnTo>
                        <a:pt x="48" y="30"/>
                      </a:lnTo>
                      <a:lnTo>
                        <a:pt x="48" y="25"/>
                      </a:lnTo>
                      <a:lnTo>
                        <a:pt x="48" y="19"/>
                      </a:lnTo>
                      <a:lnTo>
                        <a:pt x="48" y="13"/>
                      </a:lnTo>
                      <a:lnTo>
                        <a:pt x="47" y="7"/>
                      </a:lnTo>
                      <a:lnTo>
                        <a:pt x="47" y="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8" name="Freeform 263"/>
                <p:cNvSpPr/>
                <p:nvPr/>
              </p:nvSpPr>
              <p:spPr bwMode="auto">
                <a:xfrm>
                  <a:off x="4200" y="2363"/>
                  <a:ext cx="171" cy="231"/>
                </a:xfrm>
                <a:custGeom>
                  <a:avLst/>
                  <a:gdLst>
                    <a:gd name="T0" fmla="*/ 169 w 171"/>
                    <a:gd name="T1" fmla="*/ 3 h 231"/>
                    <a:gd name="T2" fmla="*/ 165 w 171"/>
                    <a:gd name="T3" fmla="*/ 10 h 231"/>
                    <a:gd name="T4" fmla="*/ 162 w 171"/>
                    <a:gd name="T5" fmla="*/ 17 h 231"/>
                    <a:gd name="T6" fmla="*/ 159 w 171"/>
                    <a:gd name="T7" fmla="*/ 25 h 231"/>
                    <a:gd name="T8" fmla="*/ 156 w 171"/>
                    <a:gd name="T9" fmla="*/ 30 h 231"/>
                    <a:gd name="T10" fmla="*/ 152 w 171"/>
                    <a:gd name="T11" fmla="*/ 38 h 231"/>
                    <a:gd name="T12" fmla="*/ 149 w 171"/>
                    <a:gd name="T13" fmla="*/ 45 h 231"/>
                    <a:gd name="T14" fmla="*/ 146 w 171"/>
                    <a:gd name="T15" fmla="*/ 50 h 231"/>
                    <a:gd name="T16" fmla="*/ 142 w 171"/>
                    <a:gd name="T17" fmla="*/ 58 h 231"/>
                    <a:gd name="T18" fmla="*/ 138 w 171"/>
                    <a:gd name="T19" fmla="*/ 65 h 231"/>
                    <a:gd name="T20" fmla="*/ 135 w 171"/>
                    <a:gd name="T21" fmla="*/ 71 h 231"/>
                    <a:gd name="T22" fmla="*/ 130 w 171"/>
                    <a:gd name="T23" fmla="*/ 78 h 231"/>
                    <a:gd name="T24" fmla="*/ 126 w 171"/>
                    <a:gd name="T25" fmla="*/ 83 h 231"/>
                    <a:gd name="T26" fmla="*/ 123 w 171"/>
                    <a:gd name="T27" fmla="*/ 91 h 231"/>
                    <a:gd name="T28" fmla="*/ 119 w 171"/>
                    <a:gd name="T29" fmla="*/ 96 h 231"/>
                    <a:gd name="T30" fmla="*/ 115 w 171"/>
                    <a:gd name="T31" fmla="*/ 102 h 231"/>
                    <a:gd name="T32" fmla="*/ 110 w 171"/>
                    <a:gd name="T33" fmla="*/ 109 h 231"/>
                    <a:gd name="T34" fmla="*/ 106 w 171"/>
                    <a:gd name="T35" fmla="*/ 115 h 231"/>
                    <a:gd name="T36" fmla="*/ 102 w 171"/>
                    <a:gd name="T37" fmla="*/ 121 h 231"/>
                    <a:gd name="T38" fmla="*/ 98 w 171"/>
                    <a:gd name="T39" fmla="*/ 128 h 231"/>
                    <a:gd name="T40" fmla="*/ 93 w 171"/>
                    <a:gd name="T41" fmla="*/ 134 h 231"/>
                    <a:gd name="T42" fmla="*/ 87 w 171"/>
                    <a:gd name="T43" fmla="*/ 139 h 231"/>
                    <a:gd name="T44" fmla="*/ 83 w 171"/>
                    <a:gd name="T45" fmla="*/ 145 h 231"/>
                    <a:gd name="T46" fmla="*/ 79 w 171"/>
                    <a:gd name="T47" fmla="*/ 151 h 231"/>
                    <a:gd name="T48" fmla="*/ 75 w 171"/>
                    <a:gd name="T49" fmla="*/ 157 h 231"/>
                    <a:gd name="T50" fmla="*/ 69 w 171"/>
                    <a:gd name="T51" fmla="*/ 162 h 231"/>
                    <a:gd name="T52" fmla="*/ 65 w 171"/>
                    <a:gd name="T53" fmla="*/ 168 h 231"/>
                    <a:gd name="T54" fmla="*/ 59 w 171"/>
                    <a:gd name="T55" fmla="*/ 174 h 231"/>
                    <a:gd name="T56" fmla="*/ 54 w 171"/>
                    <a:gd name="T57" fmla="*/ 180 h 231"/>
                    <a:gd name="T58" fmla="*/ 49 w 171"/>
                    <a:gd name="T59" fmla="*/ 185 h 231"/>
                    <a:gd name="T60" fmla="*/ 43 w 171"/>
                    <a:gd name="T61" fmla="*/ 191 h 231"/>
                    <a:gd name="T62" fmla="*/ 39 w 171"/>
                    <a:gd name="T63" fmla="*/ 195 h 231"/>
                    <a:gd name="T64" fmla="*/ 33 w 171"/>
                    <a:gd name="T65" fmla="*/ 201 h 231"/>
                    <a:gd name="T66" fmla="*/ 27 w 171"/>
                    <a:gd name="T67" fmla="*/ 207 h 231"/>
                    <a:gd name="T68" fmla="*/ 22 w 171"/>
                    <a:gd name="T69" fmla="*/ 211 h 231"/>
                    <a:gd name="T70" fmla="*/ 16 w 171"/>
                    <a:gd name="T71" fmla="*/ 217 h 231"/>
                    <a:gd name="T72" fmla="*/ 11 w 171"/>
                    <a:gd name="T73" fmla="*/ 221 h 231"/>
                    <a:gd name="T74" fmla="*/ 6 w 171"/>
                    <a:gd name="T75" fmla="*/ 227 h 231"/>
                    <a:gd name="T76" fmla="*/ 0 w 171"/>
                    <a:gd name="T77" fmla="*/ 231 h 23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</a:cxnLst>
                  <a:rect l="0" t="0" r="r" b="b"/>
                  <a:pathLst>
                    <a:path w="171" h="231">
                      <a:moveTo>
                        <a:pt x="171" y="0"/>
                      </a:moveTo>
                      <a:lnTo>
                        <a:pt x="169" y="3"/>
                      </a:lnTo>
                      <a:lnTo>
                        <a:pt x="168" y="7"/>
                      </a:lnTo>
                      <a:lnTo>
                        <a:pt x="165" y="10"/>
                      </a:lnTo>
                      <a:lnTo>
                        <a:pt x="163" y="15"/>
                      </a:lnTo>
                      <a:lnTo>
                        <a:pt x="162" y="17"/>
                      </a:lnTo>
                      <a:lnTo>
                        <a:pt x="161" y="20"/>
                      </a:lnTo>
                      <a:lnTo>
                        <a:pt x="159" y="25"/>
                      </a:lnTo>
                      <a:lnTo>
                        <a:pt x="158" y="28"/>
                      </a:lnTo>
                      <a:lnTo>
                        <a:pt x="156" y="30"/>
                      </a:lnTo>
                      <a:lnTo>
                        <a:pt x="155" y="35"/>
                      </a:lnTo>
                      <a:lnTo>
                        <a:pt x="152" y="38"/>
                      </a:lnTo>
                      <a:lnTo>
                        <a:pt x="151" y="40"/>
                      </a:lnTo>
                      <a:lnTo>
                        <a:pt x="149" y="45"/>
                      </a:lnTo>
                      <a:lnTo>
                        <a:pt x="148" y="48"/>
                      </a:lnTo>
                      <a:lnTo>
                        <a:pt x="146" y="50"/>
                      </a:lnTo>
                      <a:lnTo>
                        <a:pt x="143" y="55"/>
                      </a:lnTo>
                      <a:lnTo>
                        <a:pt x="142" y="58"/>
                      </a:lnTo>
                      <a:lnTo>
                        <a:pt x="141" y="61"/>
                      </a:lnTo>
                      <a:lnTo>
                        <a:pt x="138" y="65"/>
                      </a:lnTo>
                      <a:lnTo>
                        <a:pt x="136" y="68"/>
                      </a:lnTo>
                      <a:lnTo>
                        <a:pt x="135" y="71"/>
                      </a:lnTo>
                      <a:lnTo>
                        <a:pt x="133" y="73"/>
                      </a:lnTo>
                      <a:lnTo>
                        <a:pt x="130" y="78"/>
                      </a:lnTo>
                      <a:lnTo>
                        <a:pt x="129" y="81"/>
                      </a:lnTo>
                      <a:lnTo>
                        <a:pt x="126" y="83"/>
                      </a:lnTo>
                      <a:lnTo>
                        <a:pt x="125" y="86"/>
                      </a:lnTo>
                      <a:lnTo>
                        <a:pt x="123" y="91"/>
                      </a:lnTo>
                      <a:lnTo>
                        <a:pt x="120" y="94"/>
                      </a:lnTo>
                      <a:lnTo>
                        <a:pt x="119" y="96"/>
                      </a:lnTo>
                      <a:lnTo>
                        <a:pt x="116" y="99"/>
                      </a:lnTo>
                      <a:lnTo>
                        <a:pt x="115" y="102"/>
                      </a:lnTo>
                      <a:lnTo>
                        <a:pt x="112" y="106"/>
                      </a:lnTo>
                      <a:lnTo>
                        <a:pt x="110" y="109"/>
                      </a:lnTo>
                      <a:lnTo>
                        <a:pt x="108" y="112"/>
                      </a:lnTo>
                      <a:lnTo>
                        <a:pt x="106" y="115"/>
                      </a:lnTo>
                      <a:lnTo>
                        <a:pt x="103" y="118"/>
                      </a:lnTo>
                      <a:lnTo>
                        <a:pt x="102" y="121"/>
                      </a:lnTo>
                      <a:lnTo>
                        <a:pt x="99" y="124"/>
                      </a:lnTo>
                      <a:lnTo>
                        <a:pt x="98" y="128"/>
                      </a:lnTo>
                      <a:lnTo>
                        <a:pt x="95" y="131"/>
                      </a:lnTo>
                      <a:lnTo>
                        <a:pt x="93" y="134"/>
                      </a:lnTo>
                      <a:lnTo>
                        <a:pt x="90" y="137"/>
                      </a:lnTo>
                      <a:lnTo>
                        <a:pt x="87" y="139"/>
                      </a:lnTo>
                      <a:lnTo>
                        <a:pt x="86" y="142"/>
                      </a:lnTo>
                      <a:lnTo>
                        <a:pt x="83" y="145"/>
                      </a:lnTo>
                      <a:lnTo>
                        <a:pt x="82" y="148"/>
                      </a:lnTo>
                      <a:lnTo>
                        <a:pt x="79" y="151"/>
                      </a:lnTo>
                      <a:lnTo>
                        <a:pt x="76" y="154"/>
                      </a:lnTo>
                      <a:lnTo>
                        <a:pt x="75" y="157"/>
                      </a:lnTo>
                      <a:lnTo>
                        <a:pt x="72" y="160"/>
                      </a:lnTo>
                      <a:lnTo>
                        <a:pt x="69" y="162"/>
                      </a:lnTo>
                      <a:lnTo>
                        <a:pt x="66" y="165"/>
                      </a:lnTo>
                      <a:lnTo>
                        <a:pt x="65" y="168"/>
                      </a:lnTo>
                      <a:lnTo>
                        <a:pt x="62" y="171"/>
                      </a:lnTo>
                      <a:lnTo>
                        <a:pt x="59" y="174"/>
                      </a:lnTo>
                      <a:lnTo>
                        <a:pt x="56" y="177"/>
                      </a:lnTo>
                      <a:lnTo>
                        <a:pt x="54" y="180"/>
                      </a:lnTo>
                      <a:lnTo>
                        <a:pt x="52" y="182"/>
                      </a:lnTo>
                      <a:lnTo>
                        <a:pt x="49" y="185"/>
                      </a:lnTo>
                      <a:lnTo>
                        <a:pt x="46" y="188"/>
                      </a:lnTo>
                      <a:lnTo>
                        <a:pt x="43" y="191"/>
                      </a:lnTo>
                      <a:lnTo>
                        <a:pt x="42" y="193"/>
                      </a:lnTo>
                      <a:lnTo>
                        <a:pt x="39" y="195"/>
                      </a:lnTo>
                      <a:lnTo>
                        <a:pt x="36" y="198"/>
                      </a:lnTo>
                      <a:lnTo>
                        <a:pt x="33" y="201"/>
                      </a:lnTo>
                      <a:lnTo>
                        <a:pt x="30" y="204"/>
                      </a:lnTo>
                      <a:lnTo>
                        <a:pt x="27" y="207"/>
                      </a:lnTo>
                      <a:lnTo>
                        <a:pt x="24" y="208"/>
                      </a:lnTo>
                      <a:lnTo>
                        <a:pt x="22" y="211"/>
                      </a:lnTo>
                      <a:lnTo>
                        <a:pt x="19" y="214"/>
                      </a:lnTo>
                      <a:lnTo>
                        <a:pt x="16" y="217"/>
                      </a:lnTo>
                      <a:lnTo>
                        <a:pt x="14" y="220"/>
                      </a:lnTo>
                      <a:lnTo>
                        <a:pt x="11" y="221"/>
                      </a:lnTo>
                      <a:lnTo>
                        <a:pt x="9" y="224"/>
                      </a:lnTo>
                      <a:lnTo>
                        <a:pt x="6" y="227"/>
                      </a:lnTo>
                      <a:lnTo>
                        <a:pt x="3" y="228"/>
                      </a:lnTo>
                      <a:lnTo>
                        <a:pt x="0" y="231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9" name="Rectangle 264"/>
                <p:cNvSpPr>
                  <a:spLocks noChangeArrowheads="1"/>
                </p:cNvSpPr>
                <p:nvPr/>
              </p:nvSpPr>
              <p:spPr bwMode="auto">
                <a:xfrm rot="1380000">
                  <a:off x="4312" y="2268"/>
                  <a:ext cx="72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99</a:t>
                  </a:r>
                </a:p>
              </p:txBody>
            </p:sp>
            <p:sp>
              <p:nvSpPr>
                <p:cNvPr id="80" name="Line 265"/>
                <p:cNvSpPr>
                  <a:spLocks noChangeShapeType="1"/>
                </p:cNvSpPr>
                <p:nvPr/>
              </p:nvSpPr>
              <p:spPr bwMode="auto">
                <a:xfrm>
                  <a:off x="4310" y="2337"/>
                  <a:ext cx="58" cy="25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1" name="Rectangle 266"/>
                <p:cNvSpPr>
                  <a:spLocks noChangeArrowheads="1"/>
                </p:cNvSpPr>
                <p:nvPr/>
              </p:nvSpPr>
              <p:spPr bwMode="auto">
                <a:xfrm rot="18360000">
                  <a:off x="2427" y="3716"/>
                  <a:ext cx="283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LIM-A18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2" name="Line 267"/>
                <p:cNvSpPr>
                  <a:spLocks noChangeShapeType="1"/>
                </p:cNvSpPr>
                <p:nvPr/>
              </p:nvSpPr>
              <p:spPr bwMode="auto">
                <a:xfrm flipH="1">
                  <a:off x="2770" y="2564"/>
                  <a:ext cx="699" cy="933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3" name="Freeform 268"/>
                <p:cNvSpPr/>
                <p:nvPr/>
              </p:nvSpPr>
              <p:spPr bwMode="auto">
                <a:xfrm>
                  <a:off x="3943" y="2336"/>
                  <a:ext cx="363" cy="317"/>
                </a:xfrm>
                <a:custGeom>
                  <a:avLst/>
                  <a:gdLst>
                    <a:gd name="T0" fmla="*/ 6 w 363"/>
                    <a:gd name="T1" fmla="*/ 316 h 317"/>
                    <a:gd name="T2" fmla="*/ 19 w 363"/>
                    <a:gd name="T3" fmla="*/ 311 h 317"/>
                    <a:gd name="T4" fmla="*/ 32 w 363"/>
                    <a:gd name="T5" fmla="*/ 307 h 317"/>
                    <a:gd name="T6" fmla="*/ 45 w 363"/>
                    <a:gd name="T7" fmla="*/ 303 h 317"/>
                    <a:gd name="T8" fmla="*/ 58 w 363"/>
                    <a:gd name="T9" fmla="*/ 298 h 317"/>
                    <a:gd name="T10" fmla="*/ 71 w 363"/>
                    <a:gd name="T11" fmla="*/ 293 h 317"/>
                    <a:gd name="T12" fmla="*/ 82 w 363"/>
                    <a:gd name="T13" fmla="*/ 287 h 317"/>
                    <a:gd name="T14" fmla="*/ 95 w 363"/>
                    <a:gd name="T15" fmla="*/ 281 h 317"/>
                    <a:gd name="T16" fmla="*/ 106 w 363"/>
                    <a:gd name="T17" fmla="*/ 275 h 317"/>
                    <a:gd name="T18" fmla="*/ 119 w 363"/>
                    <a:gd name="T19" fmla="*/ 270 h 317"/>
                    <a:gd name="T20" fmla="*/ 131 w 363"/>
                    <a:gd name="T21" fmla="*/ 263 h 317"/>
                    <a:gd name="T22" fmla="*/ 142 w 363"/>
                    <a:gd name="T23" fmla="*/ 255 h 317"/>
                    <a:gd name="T24" fmla="*/ 154 w 363"/>
                    <a:gd name="T25" fmla="*/ 248 h 317"/>
                    <a:gd name="T26" fmla="*/ 165 w 363"/>
                    <a:gd name="T27" fmla="*/ 241 h 317"/>
                    <a:gd name="T28" fmla="*/ 177 w 363"/>
                    <a:gd name="T29" fmla="*/ 234 h 317"/>
                    <a:gd name="T30" fmla="*/ 187 w 363"/>
                    <a:gd name="T31" fmla="*/ 225 h 317"/>
                    <a:gd name="T32" fmla="*/ 198 w 363"/>
                    <a:gd name="T33" fmla="*/ 218 h 317"/>
                    <a:gd name="T34" fmla="*/ 208 w 363"/>
                    <a:gd name="T35" fmla="*/ 209 h 317"/>
                    <a:gd name="T36" fmla="*/ 218 w 363"/>
                    <a:gd name="T37" fmla="*/ 201 h 317"/>
                    <a:gd name="T38" fmla="*/ 228 w 363"/>
                    <a:gd name="T39" fmla="*/ 191 h 317"/>
                    <a:gd name="T40" fmla="*/ 238 w 363"/>
                    <a:gd name="T41" fmla="*/ 182 h 317"/>
                    <a:gd name="T42" fmla="*/ 248 w 363"/>
                    <a:gd name="T43" fmla="*/ 172 h 317"/>
                    <a:gd name="T44" fmla="*/ 257 w 363"/>
                    <a:gd name="T45" fmla="*/ 164 h 317"/>
                    <a:gd name="T46" fmla="*/ 267 w 363"/>
                    <a:gd name="T47" fmla="*/ 154 h 317"/>
                    <a:gd name="T48" fmla="*/ 276 w 363"/>
                    <a:gd name="T49" fmla="*/ 143 h 317"/>
                    <a:gd name="T50" fmla="*/ 284 w 363"/>
                    <a:gd name="T51" fmla="*/ 132 h 317"/>
                    <a:gd name="T52" fmla="*/ 293 w 363"/>
                    <a:gd name="T53" fmla="*/ 122 h 317"/>
                    <a:gd name="T54" fmla="*/ 300 w 363"/>
                    <a:gd name="T55" fmla="*/ 112 h 317"/>
                    <a:gd name="T56" fmla="*/ 309 w 363"/>
                    <a:gd name="T57" fmla="*/ 100 h 317"/>
                    <a:gd name="T58" fmla="*/ 316 w 363"/>
                    <a:gd name="T59" fmla="*/ 89 h 317"/>
                    <a:gd name="T60" fmla="*/ 323 w 363"/>
                    <a:gd name="T61" fmla="*/ 77 h 317"/>
                    <a:gd name="T62" fmla="*/ 330 w 363"/>
                    <a:gd name="T63" fmla="*/ 66 h 317"/>
                    <a:gd name="T64" fmla="*/ 337 w 363"/>
                    <a:gd name="T65" fmla="*/ 55 h 317"/>
                    <a:gd name="T66" fmla="*/ 343 w 363"/>
                    <a:gd name="T67" fmla="*/ 43 h 317"/>
                    <a:gd name="T68" fmla="*/ 350 w 363"/>
                    <a:gd name="T69" fmla="*/ 32 h 317"/>
                    <a:gd name="T70" fmla="*/ 356 w 363"/>
                    <a:gd name="T71" fmla="*/ 19 h 317"/>
                    <a:gd name="T72" fmla="*/ 362 w 363"/>
                    <a:gd name="T73" fmla="*/ 7 h 31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</a:cxnLst>
                  <a:rect l="0" t="0" r="r" b="b"/>
                  <a:pathLst>
                    <a:path w="363" h="317">
                      <a:moveTo>
                        <a:pt x="0" y="317"/>
                      </a:moveTo>
                      <a:lnTo>
                        <a:pt x="6" y="316"/>
                      </a:lnTo>
                      <a:lnTo>
                        <a:pt x="13" y="313"/>
                      </a:lnTo>
                      <a:lnTo>
                        <a:pt x="19" y="311"/>
                      </a:lnTo>
                      <a:lnTo>
                        <a:pt x="26" y="308"/>
                      </a:lnTo>
                      <a:lnTo>
                        <a:pt x="32" y="307"/>
                      </a:lnTo>
                      <a:lnTo>
                        <a:pt x="39" y="304"/>
                      </a:lnTo>
                      <a:lnTo>
                        <a:pt x="45" y="303"/>
                      </a:lnTo>
                      <a:lnTo>
                        <a:pt x="52" y="300"/>
                      </a:lnTo>
                      <a:lnTo>
                        <a:pt x="58" y="298"/>
                      </a:lnTo>
                      <a:lnTo>
                        <a:pt x="63" y="296"/>
                      </a:lnTo>
                      <a:lnTo>
                        <a:pt x="71" y="293"/>
                      </a:lnTo>
                      <a:lnTo>
                        <a:pt x="76" y="290"/>
                      </a:lnTo>
                      <a:lnTo>
                        <a:pt x="82" y="287"/>
                      </a:lnTo>
                      <a:lnTo>
                        <a:pt x="89" y="284"/>
                      </a:lnTo>
                      <a:lnTo>
                        <a:pt x="95" y="281"/>
                      </a:lnTo>
                      <a:lnTo>
                        <a:pt x="101" y="278"/>
                      </a:lnTo>
                      <a:lnTo>
                        <a:pt x="106" y="275"/>
                      </a:lnTo>
                      <a:lnTo>
                        <a:pt x="114" y="273"/>
                      </a:lnTo>
                      <a:lnTo>
                        <a:pt x="119" y="270"/>
                      </a:lnTo>
                      <a:lnTo>
                        <a:pt x="125" y="267"/>
                      </a:lnTo>
                      <a:lnTo>
                        <a:pt x="131" y="263"/>
                      </a:lnTo>
                      <a:lnTo>
                        <a:pt x="137" y="260"/>
                      </a:lnTo>
                      <a:lnTo>
                        <a:pt x="142" y="255"/>
                      </a:lnTo>
                      <a:lnTo>
                        <a:pt x="148" y="253"/>
                      </a:lnTo>
                      <a:lnTo>
                        <a:pt x="154" y="248"/>
                      </a:lnTo>
                      <a:lnTo>
                        <a:pt x="159" y="245"/>
                      </a:lnTo>
                      <a:lnTo>
                        <a:pt x="165" y="241"/>
                      </a:lnTo>
                      <a:lnTo>
                        <a:pt x="171" y="238"/>
                      </a:lnTo>
                      <a:lnTo>
                        <a:pt x="177" y="234"/>
                      </a:lnTo>
                      <a:lnTo>
                        <a:pt x="181" y="230"/>
                      </a:lnTo>
                      <a:lnTo>
                        <a:pt x="187" y="225"/>
                      </a:lnTo>
                      <a:lnTo>
                        <a:pt x="192" y="222"/>
                      </a:lnTo>
                      <a:lnTo>
                        <a:pt x="198" y="218"/>
                      </a:lnTo>
                      <a:lnTo>
                        <a:pt x="203" y="214"/>
                      </a:lnTo>
                      <a:lnTo>
                        <a:pt x="208" y="209"/>
                      </a:lnTo>
                      <a:lnTo>
                        <a:pt x="214" y="205"/>
                      </a:lnTo>
                      <a:lnTo>
                        <a:pt x="218" y="201"/>
                      </a:lnTo>
                      <a:lnTo>
                        <a:pt x="224" y="197"/>
                      </a:lnTo>
                      <a:lnTo>
                        <a:pt x="228" y="191"/>
                      </a:lnTo>
                      <a:lnTo>
                        <a:pt x="234" y="187"/>
                      </a:lnTo>
                      <a:lnTo>
                        <a:pt x="238" y="182"/>
                      </a:lnTo>
                      <a:lnTo>
                        <a:pt x="243" y="178"/>
                      </a:lnTo>
                      <a:lnTo>
                        <a:pt x="248" y="172"/>
                      </a:lnTo>
                      <a:lnTo>
                        <a:pt x="253" y="168"/>
                      </a:lnTo>
                      <a:lnTo>
                        <a:pt x="257" y="164"/>
                      </a:lnTo>
                      <a:lnTo>
                        <a:pt x="261" y="158"/>
                      </a:lnTo>
                      <a:lnTo>
                        <a:pt x="267" y="154"/>
                      </a:lnTo>
                      <a:lnTo>
                        <a:pt x="271" y="148"/>
                      </a:lnTo>
                      <a:lnTo>
                        <a:pt x="276" y="143"/>
                      </a:lnTo>
                      <a:lnTo>
                        <a:pt x="280" y="138"/>
                      </a:lnTo>
                      <a:lnTo>
                        <a:pt x="284" y="132"/>
                      </a:lnTo>
                      <a:lnTo>
                        <a:pt x="289" y="128"/>
                      </a:lnTo>
                      <a:lnTo>
                        <a:pt x="293" y="122"/>
                      </a:lnTo>
                      <a:lnTo>
                        <a:pt x="296" y="116"/>
                      </a:lnTo>
                      <a:lnTo>
                        <a:pt x="300" y="112"/>
                      </a:lnTo>
                      <a:lnTo>
                        <a:pt x="304" y="106"/>
                      </a:lnTo>
                      <a:lnTo>
                        <a:pt x="309" y="100"/>
                      </a:lnTo>
                      <a:lnTo>
                        <a:pt x="311" y="95"/>
                      </a:lnTo>
                      <a:lnTo>
                        <a:pt x="316" y="89"/>
                      </a:lnTo>
                      <a:lnTo>
                        <a:pt x="320" y="83"/>
                      </a:lnTo>
                      <a:lnTo>
                        <a:pt x="323" y="77"/>
                      </a:lnTo>
                      <a:lnTo>
                        <a:pt x="327" y="72"/>
                      </a:lnTo>
                      <a:lnTo>
                        <a:pt x="330" y="66"/>
                      </a:lnTo>
                      <a:lnTo>
                        <a:pt x="333" y="60"/>
                      </a:lnTo>
                      <a:lnTo>
                        <a:pt x="337" y="55"/>
                      </a:lnTo>
                      <a:lnTo>
                        <a:pt x="340" y="49"/>
                      </a:lnTo>
                      <a:lnTo>
                        <a:pt x="343" y="43"/>
                      </a:lnTo>
                      <a:lnTo>
                        <a:pt x="346" y="37"/>
                      </a:lnTo>
                      <a:lnTo>
                        <a:pt x="350" y="32"/>
                      </a:lnTo>
                      <a:lnTo>
                        <a:pt x="353" y="24"/>
                      </a:lnTo>
                      <a:lnTo>
                        <a:pt x="356" y="19"/>
                      </a:lnTo>
                      <a:lnTo>
                        <a:pt x="359" y="13"/>
                      </a:lnTo>
                      <a:lnTo>
                        <a:pt x="362" y="7"/>
                      </a:lnTo>
                      <a:lnTo>
                        <a:pt x="363" y="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4" name="Freeform 269"/>
                <p:cNvSpPr/>
                <p:nvPr/>
              </p:nvSpPr>
              <p:spPr bwMode="auto">
                <a:xfrm>
                  <a:off x="3470" y="2561"/>
                  <a:ext cx="473" cy="111"/>
                </a:xfrm>
                <a:custGeom>
                  <a:avLst/>
                  <a:gdLst>
                    <a:gd name="T0" fmla="*/ 466 w 473"/>
                    <a:gd name="T1" fmla="*/ 94 h 111"/>
                    <a:gd name="T2" fmla="*/ 456 w 473"/>
                    <a:gd name="T3" fmla="*/ 96 h 111"/>
                    <a:gd name="T4" fmla="*/ 448 w 473"/>
                    <a:gd name="T5" fmla="*/ 98 h 111"/>
                    <a:gd name="T6" fmla="*/ 437 w 473"/>
                    <a:gd name="T7" fmla="*/ 101 h 111"/>
                    <a:gd name="T8" fmla="*/ 427 w 473"/>
                    <a:gd name="T9" fmla="*/ 102 h 111"/>
                    <a:gd name="T10" fmla="*/ 419 w 473"/>
                    <a:gd name="T11" fmla="*/ 104 h 111"/>
                    <a:gd name="T12" fmla="*/ 409 w 473"/>
                    <a:gd name="T13" fmla="*/ 105 h 111"/>
                    <a:gd name="T14" fmla="*/ 399 w 473"/>
                    <a:gd name="T15" fmla="*/ 106 h 111"/>
                    <a:gd name="T16" fmla="*/ 389 w 473"/>
                    <a:gd name="T17" fmla="*/ 108 h 111"/>
                    <a:gd name="T18" fmla="*/ 380 w 473"/>
                    <a:gd name="T19" fmla="*/ 108 h 111"/>
                    <a:gd name="T20" fmla="*/ 370 w 473"/>
                    <a:gd name="T21" fmla="*/ 109 h 111"/>
                    <a:gd name="T22" fmla="*/ 360 w 473"/>
                    <a:gd name="T23" fmla="*/ 109 h 111"/>
                    <a:gd name="T24" fmla="*/ 350 w 473"/>
                    <a:gd name="T25" fmla="*/ 111 h 111"/>
                    <a:gd name="T26" fmla="*/ 340 w 473"/>
                    <a:gd name="T27" fmla="*/ 111 h 111"/>
                    <a:gd name="T28" fmla="*/ 330 w 473"/>
                    <a:gd name="T29" fmla="*/ 111 h 111"/>
                    <a:gd name="T30" fmla="*/ 321 w 473"/>
                    <a:gd name="T31" fmla="*/ 111 h 111"/>
                    <a:gd name="T32" fmla="*/ 311 w 473"/>
                    <a:gd name="T33" fmla="*/ 111 h 111"/>
                    <a:gd name="T34" fmla="*/ 301 w 473"/>
                    <a:gd name="T35" fmla="*/ 109 h 111"/>
                    <a:gd name="T36" fmla="*/ 291 w 473"/>
                    <a:gd name="T37" fmla="*/ 109 h 111"/>
                    <a:gd name="T38" fmla="*/ 281 w 473"/>
                    <a:gd name="T39" fmla="*/ 109 h 111"/>
                    <a:gd name="T40" fmla="*/ 273 w 473"/>
                    <a:gd name="T41" fmla="*/ 108 h 111"/>
                    <a:gd name="T42" fmla="*/ 263 w 473"/>
                    <a:gd name="T43" fmla="*/ 106 h 111"/>
                    <a:gd name="T44" fmla="*/ 252 w 473"/>
                    <a:gd name="T45" fmla="*/ 105 h 111"/>
                    <a:gd name="T46" fmla="*/ 242 w 473"/>
                    <a:gd name="T47" fmla="*/ 104 h 111"/>
                    <a:gd name="T48" fmla="*/ 234 w 473"/>
                    <a:gd name="T49" fmla="*/ 102 h 111"/>
                    <a:gd name="T50" fmla="*/ 224 w 473"/>
                    <a:gd name="T51" fmla="*/ 101 h 111"/>
                    <a:gd name="T52" fmla="*/ 214 w 473"/>
                    <a:gd name="T53" fmla="*/ 98 h 111"/>
                    <a:gd name="T54" fmla="*/ 205 w 473"/>
                    <a:gd name="T55" fmla="*/ 96 h 111"/>
                    <a:gd name="T56" fmla="*/ 195 w 473"/>
                    <a:gd name="T57" fmla="*/ 94 h 111"/>
                    <a:gd name="T58" fmla="*/ 185 w 473"/>
                    <a:gd name="T59" fmla="*/ 92 h 111"/>
                    <a:gd name="T60" fmla="*/ 176 w 473"/>
                    <a:gd name="T61" fmla="*/ 89 h 111"/>
                    <a:gd name="T62" fmla="*/ 166 w 473"/>
                    <a:gd name="T63" fmla="*/ 86 h 111"/>
                    <a:gd name="T64" fmla="*/ 158 w 473"/>
                    <a:gd name="T65" fmla="*/ 83 h 111"/>
                    <a:gd name="T66" fmla="*/ 148 w 473"/>
                    <a:gd name="T67" fmla="*/ 81 h 111"/>
                    <a:gd name="T68" fmla="*/ 139 w 473"/>
                    <a:gd name="T69" fmla="*/ 76 h 111"/>
                    <a:gd name="T70" fmla="*/ 131 w 473"/>
                    <a:gd name="T71" fmla="*/ 73 h 111"/>
                    <a:gd name="T72" fmla="*/ 121 w 473"/>
                    <a:gd name="T73" fmla="*/ 69 h 111"/>
                    <a:gd name="T74" fmla="*/ 112 w 473"/>
                    <a:gd name="T75" fmla="*/ 66 h 111"/>
                    <a:gd name="T76" fmla="*/ 103 w 473"/>
                    <a:gd name="T77" fmla="*/ 62 h 111"/>
                    <a:gd name="T78" fmla="*/ 95 w 473"/>
                    <a:gd name="T79" fmla="*/ 58 h 111"/>
                    <a:gd name="T80" fmla="*/ 85 w 473"/>
                    <a:gd name="T81" fmla="*/ 53 h 111"/>
                    <a:gd name="T82" fmla="*/ 76 w 473"/>
                    <a:gd name="T83" fmla="*/ 49 h 111"/>
                    <a:gd name="T84" fmla="*/ 68 w 473"/>
                    <a:gd name="T85" fmla="*/ 45 h 111"/>
                    <a:gd name="T86" fmla="*/ 59 w 473"/>
                    <a:gd name="T87" fmla="*/ 39 h 111"/>
                    <a:gd name="T88" fmla="*/ 50 w 473"/>
                    <a:gd name="T89" fmla="*/ 35 h 111"/>
                    <a:gd name="T90" fmla="*/ 43 w 473"/>
                    <a:gd name="T91" fmla="*/ 30 h 111"/>
                    <a:gd name="T92" fmla="*/ 35 w 473"/>
                    <a:gd name="T93" fmla="*/ 25 h 111"/>
                    <a:gd name="T94" fmla="*/ 26 w 473"/>
                    <a:gd name="T95" fmla="*/ 19 h 111"/>
                    <a:gd name="T96" fmla="*/ 17 w 473"/>
                    <a:gd name="T97" fmla="*/ 13 h 111"/>
                    <a:gd name="T98" fmla="*/ 10 w 473"/>
                    <a:gd name="T99" fmla="*/ 7 h 111"/>
                    <a:gd name="T100" fmla="*/ 2 w 473"/>
                    <a:gd name="T101" fmla="*/ 2 h 1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  <a:cxn ang="0">
                      <a:pos x="T90" y="T91"/>
                    </a:cxn>
                    <a:cxn ang="0">
                      <a:pos x="T92" y="T93"/>
                    </a:cxn>
                    <a:cxn ang="0">
                      <a:pos x="T94" y="T95"/>
                    </a:cxn>
                    <a:cxn ang="0">
                      <a:pos x="T96" y="T97"/>
                    </a:cxn>
                    <a:cxn ang="0">
                      <a:pos x="T98" y="T99"/>
                    </a:cxn>
                    <a:cxn ang="0">
                      <a:pos x="T100" y="T101"/>
                    </a:cxn>
                  </a:cxnLst>
                  <a:rect l="0" t="0" r="r" b="b"/>
                  <a:pathLst>
                    <a:path w="473" h="111">
                      <a:moveTo>
                        <a:pt x="473" y="92"/>
                      </a:moveTo>
                      <a:lnTo>
                        <a:pt x="470" y="92"/>
                      </a:lnTo>
                      <a:lnTo>
                        <a:pt x="469" y="94"/>
                      </a:lnTo>
                      <a:lnTo>
                        <a:pt x="466" y="94"/>
                      </a:lnTo>
                      <a:lnTo>
                        <a:pt x="463" y="94"/>
                      </a:lnTo>
                      <a:lnTo>
                        <a:pt x="462" y="95"/>
                      </a:lnTo>
                      <a:lnTo>
                        <a:pt x="459" y="95"/>
                      </a:lnTo>
                      <a:lnTo>
                        <a:pt x="456" y="96"/>
                      </a:lnTo>
                      <a:lnTo>
                        <a:pt x="455" y="96"/>
                      </a:lnTo>
                      <a:lnTo>
                        <a:pt x="452" y="96"/>
                      </a:lnTo>
                      <a:lnTo>
                        <a:pt x="449" y="98"/>
                      </a:lnTo>
                      <a:lnTo>
                        <a:pt x="448" y="98"/>
                      </a:lnTo>
                      <a:lnTo>
                        <a:pt x="445" y="99"/>
                      </a:lnTo>
                      <a:lnTo>
                        <a:pt x="442" y="99"/>
                      </a:lnTo>
                      <a:lnTo>
                        <a:pt x="440" y="99"/>
                      </a:lnTo>
                      <a:lnTo>
                        <a:pt x="437" y="101"/>
                      </a:lnTo>
                      <a:lnTo>
                        <a:pt x="435" y="101"/>
                      </a:lnTo>
                      <a:lnTo>
                        <a:pt x="433" y="101"/>
                      </a:lnTo>
                      <a:lnTo>
                        <a:pt x="430" y="102"/>
                      </a:lnTo>
                      <a:lnTo>
                        <a:pt x="427" y="102"/>
                      </a:lnTo>
                      <a:lnTo>
                        <a:pt x="426" y="102"/>
                      </a:lnTo>
                      <a:lnTo>
                        <a:pt x="423" y="102"/>
                      </a:lnTo>
                      <a:lnTo>
                        <a:pt x="420" y="104"/>
                      </a:lnTo>
                      <a:lnTo>
                        <a:pt x="419" y="104"/>
                      </a:lnTo>
                      <a:lnTo>
                        <a:pt x="416" y="104"/>
                      </a:lnTo>
                      <a:lnTo>
                        <a:pt x="413" y="105"/>
                      </a:lnTo>
                      <a:lnTo>
                        <a:pt x="412" y="105"/>
                      </a:lnTo>
                      <a:lnTo>
                        <a:pt x="409" y="105"/>
                      </a:lnTo>
                      <a:lnTo>
                        <a:pt x="406" y="105"/>
                      </a:lnTo>
                      <a:lnTo>
                        <a:pt x="403" y="106"/>
                      </a:lnTo>
                      <a:lnTo>
                        <a:pt x="402" y="106"/>
                      </a:lnTo>
                      <a:lnTo>
                        <a:pt x="399" y="106"/>
                      </a:lnTo>
                      <a:lnTo>
                        <a:pt x="396" y="106"/>
                      </a:lnTo>
                      <a:lnTo>
                        <a:pt x="394" y="106"/>
                      </a:lnTo>
                      <a:lnTo>
                        <a:pt x="392" y="108"/>
                      </a:lnTo>
                      <a:lnTo>
                        <a:pt x="389" y="108"/>
                      </a:lnTo>
                      <a:lnTo>
                        <a:pt x="387" y="108"/>
                      </a:lnTo>
                      <a:lnTo>
                        <a:pt x="384" y="108"/>
                      </a:lnTo>
                      <a:lnTo>
                        <a:pt x="382" y="108"/>
                      </a:lnTo>
                      <a:lnTo>
                        <a:pt x="380" y="108"/>
                      </a:lnTo>
                      <a:lnTo>
                        <a:pt x="377" y="109"/>
                      </a:lnTo>
                      <a:lnTo>
                        <a:pt x="374" y="109"/>
                      </a:lnTo>
                      <a:lnTo>
                        <a:pt x="372" y="109"/>
                      </a:lnTo>
                      <a:lnTo>
                        <a:pt x="370" y="109"/>
                      </a:lnTo>
                      <a:lnTo>
                        <a:pt x="367" y="109"/>
                      </a:lnTo>
                      <a:lnTo>
                        <a:pt x="364" y="109"/>
                      </a:lnTo>
                      <a:lnTo>
                        <a:pt x="363" y="109"/>
                      </a:lnTo>
                      <a:lnTo>
                        <a:pt x="360" y="109"/>
                      </a:lnTo>
                      <a:lnTo>
                        <a:pt x="357" y="111"/>
                      </a:lnTo>
                      <a:lnTo>
                        <a:pt x="356" y="111"/>
                      </a:lnTo>
                      <a:lnTo>
                        <a:pt x="353" y="111"/>
                      </a:lnTo>
                      <a:lnTo>
                        <a:pt x="350" y="111"/>
                      </a:lnTo>
                      <a:lnTo>
                        <a:pt x="347" y="111"/>
                      </a:lnTo>
                      <a:lnTo>
                        <a:pt x="346" y="111"/>
                      </a:lnTo>
                      <a:lnTo>
                        <a:pt x="343" y="111"/>
                      </a:lnTo>
                      <a:lnTo>
                        <a:pt x="340" y="111"/>
                      </a:lnTo>
                      <a:lnTo>
                        <a:pt x="339" y="111"/>
                      </a:lnTo>
                      <a:lnTo>
                        <a:pt x="336" y="111"/>
                      </a:lnTo>
                      <a:lnTo>
                        <a:pt x="333" y="111"/>
                      </a:lnTo>
                      <a:lnTo>
                        <a:pt x="330" y="111"/>
                      </a:lnTo>
                      <a:lnTo>
                        <a:pt x="328" y="111"/>
                      </a:lnTo>
                      <a:lnTo>
                        <a:pt x="326" y="111"/>
                      </a:lnTo>
                      <a:lnTo>
                        <a:pt x="323" y="111"/>
                      </a:lnTo>
                      <a:lnTo>
                        <a:pt x="321" y="111"/>
                      </a:lnTo>
                      <a:lnTo>
                        <a:pt x="318" y="111"/>
                      </a:lnTo>
                      <a:lnTo>
                        <a:pt x="316" y="111"/>
                      </a:lnTo>
                      <a:lnTo>
                        <a:pt x="314" y="111"/>
                      </a:lnTo>
                      <a:lnTo>
                        <a:pt x="311" y="111"/>
                      </a:lnTo>
                      <a:lnTo>
                        <a:pt x="308" y="111"/>
                      </a:lnTo>
                      <a:lnTo>
                        <a:pt x="306" y="111"/>
                      </a:lnTo>
                      <a:lnTo>
                        <a:pt x="304" y="111"/>
                      </a:lnTo>
                      <a:lnTo>
                        <a:pt x="301" y="109"/>
                      </a:lnTo>
                      <a:lnTo>
                        <a:pt x="298" y="109"/>
                      </a:lnTo>
                      <a:lnTo>
                        <a:pt x="297" y="109"/>
                      </a:lnTo>
                      <a:lnTo>
                        <a:pt x="294" y="109"/>
                      </a:lnTo>
                      <a:lnTo>
                        <a:pt x="291" y="109"/>
                      </a:lnTo>
                      <a:lnTo>
                        <a:pt x="290" y="109"/>
                      </a:lnTo>
                      <a:lnTo>
                        <a:pt x="287" y="109"/>
                      </a:lnTo>
                      <a:lnTo>
                        <a:pt x="284" y="109"/>
                      </a:lnTo>
                      <a:lnTo>
                        <a:pt x="281" y="109"/>
                      </a:lnTo>
                      <a:lnTo>
                        <a:pt x="280" y="108"/>
                      </a:lnTo>
                      <a:lnTo>
                        <a:pt x="277" y="108"/>
                      </a:lnTo>
                      <a:lnTo>
                        <a:pt x="274" y="108"/>
                      </a:lnTo>
                      <a:lnTo>
                        <a:pt x="273" y="108"/>
                      </a:lnTo>
                      <a:lnTo>
                        <a:pt x="270" y="108"/>
                      </a:lnTo>
                      <a:lnTo>
                        <a:pt x="267" y="108"/>
                      </a:lnTo>
                      <a:lnTo>
                        <a:pt x="265" y="106"/>
                      </a:lnTo>
                      <a:lnTo>
                        <a:pt x="263" y="106"/>
                      </a:lnTo>
                      <a:lnTo>
                        <a:pt x="260" y="106"/>
                      </a:lnTo>
                      <a:lnTo>
                        <a:pt x="257" y="106"/>
                      </a:lnTo>
                      <a:lnTo>
                        <a:pt x="255" y="105"/>
                      </a:lnTo>
                      <a:lnTo>
                        <a:pt x="252" y="105"/>
                      </a:lnTo>
                      <a:lnTo>
                        <a:pt x="250" y="105"/>
                      </a:lnTo>
                      <a:lnTo>
                        <a:pt x="248" y="105"/>
                      </a:lnTo>
                      <a:lnTo>
                        <a:pt x="245" y="104"/>
                      </a:lnTo>
                      <a:lnTo>
                        <a:pt x="242" y="104"/>
                      </a:lnTo>
                      <a:lnTo>
                        <a:pt x="241" y="104"/>
                      </a:lnTo>
                      <a:lnTo>
                        <a:pt x="238" y="104"/>
                      </a:lnTo>
                      <a:lnTo>
                        <a:pt x="235" y="102"/>
                      </a:lnTo>
                      <a:lnTo>
                        <a:pt x="234" y="102"/>
                      </a:lnTo>
                      <a:lnTo>
                        <a:pt x="231" y="102"/>
                      </a:lnTo>
                      <a:lnTo>
                        <a:pt x="228" y="101"/>
                      </a:lnTo>
                      <a:lnTo>
                        <a:pt x="227" y="101"/>
                      </a:lnTo>
                      <a:lnTo>
                        <a:pt x="224" y="101"/>
                      </a:lnTo>
                      <a:lnTo>
                        <a:pt x="221" y="99"/>
                      </a:lnTo>
                      <a:lnTo>
                        <a:pt x="220" y="99"/>
                      </a:lnTo>
                      <a:lnTo>
                        <a:pt x="217" y="99"/>
                      </a:lnTo>
                      <a:lnTo>
                        <a:pt x="214" y="98"/>
                      </a:lnTo>
                      <a:lnTo>
                        <a:pt x="212" y="98"/>
                      </a:lnTo>
                      <a:lnTo>
                        <a:pt x="209" y="98"/>
                      </a:lnTo>
                      <a:lnTo>
                        <a:pt x="207" y="96"/>
                      </a:lnTo>
                      <a:lnTo>
                        <a:pt x="205" y="96"/>
                      </a:lnTo>
                      <a:lnTo>
                        <a:pt x="202" y="96"/>
                      </a:lnTo>
                      <a:lnTo>
                        <a:pt x="199" y="95"/>
                      </a:lnTo>
                      <a:lnTo>
                        <a:pt x="198" y="95"/>
                      </a:lnTo>
                      <a:lnTo>
                        <a:pt x="195" y="94"/>
                      </a:lnTo>
                      <a:lnTo>
                        <a:pt x="192" y="94"/>
                      </a:lnTo>
                      <a:lnTo>
                        <a:pt x="191" y="92"/>
                      </a:lnTo>
                      <a:lnTo>
                        <a:pt x="188" y="92"/>
                      </a:lnTo>
                      <a:lnTo>
                        <a:pt x="185" y="92"/>
                      </a:lnTo>
                      <a:lnTo>
                        <a:pt x="184" y="91"/>
                      </a:lnTo>
                      <a:lnTo>
                        <a:pt x="181" y="91"/>
                      </a:lnTo>
                      <a:lnTo>
                        <a:pt x="178" y="89"/>
                      </a:lnTo>
                      <a:lnTo>
                        <a:pt x="176" y="89"/>
                      </a:lnTo>
                      <a:lnTo>
                        <a:pt x="174" y="88"/>
                      </a:lnTo>
                      <a:lnTo>
                        <a:pt x="172" y="88"/>
                      </a:lnTo>
                      <a:lnTo>
                        <a:pt x="169" y="86"/>
                      </a:lnTo>
                      <a:lnTo>
                        <a:pt x="166" y="86"/>
                      </a:lnTo>
                      <a:lnTo>
                        <a:pt x="165" y="85"/>
                      </a:lnTo>
                      <a:lnTo>
                        <a:pt x="162" y="85"/>
                      </a:lnTo>
                      <a:lnTo>
                        <a:pt x="159" y="83"/>
                      </a:lnTo>
                      <a:lnTo>
                        <a:pt x="158" y="83"/>
                      </a:lnTo>
                      <a:lnTo>
                        <a:pt x="155" y="82"/>
                      </a:lnTo>
                      <a:lnTo>
                        <a:pt x="154" y="82"/>
                      </a:lnTo>
                      <a:lnTo>
                        <a:pt x="151" y="81"/>
                      </a:lnTo>
                      <a:lnTo>
                        <a:pt x="148" y="81"/>
                      </a:lnTo>
                      <a:lnTo>
                        <a:pt x="146" y="79"/>
                      </a:lnTo>
                      <a:lnTo>
                        <a:pt x="144" y="78"/>
                      </a:lnTo>
                      <a:lnTo>
                        <a:pt x="142" y="78"/>
                      </a:lnTo>
                      <a:lnTo>
                        <a:pt x="139" y="76"/>
                      </a:lnTo>
                      <a:lnTo>
                        <a:pt x="136" y="76"/>
                      </a:lnTo>
                      <a:lnTo>
                        <a:pt x="135" y="75"/>
                      </a:lnTo>
                      <a:lnTo>
                        <a:pt x="132" y="73"/>
                      </a:lnTo>
                      <a:lnTo>
                        <a:pt x="131" y="73"/>
                      </a:lnTo>
                      <a:lnTo>
                        <a:pt x="128" y="72"/>
                      </a:lnTo>
                      <a:lnTo>
                        <a:pt x="125" y="72"/>
                      </a:lnTo>
                      <a:lnTo>
                        <a:pt x="123" y="71"/>
                      </a:lnTo>
                      <a:lnTo>
                        <a:pt x="121" y="69"/>
                      </a:lnTo>
                      <a:lnTo>
                        <a:pt x="119" y="69"/>
                      </a:lnTo>
                      <a:lnTo>
                        <a:pt x="116" y="68"/>
                      </a:lnTo>
                      <a:lnTo>
                        <a:pt x="113" y="66"/>
                      </a:lnTo>
                      <a:lnTo>
                        <a:pt x="112" y="66"/>
                      </a:lnTo>
                      <a:lnTo>
                        <a:pt x="109" y="65"/>
                      </a:lnTo>
                      <a:lnTo>
                        <a:pt x="108" y="63"/>
                      </a:lnTo>
                      <a:lnTo>
                        <a:pt x="105" y="63"/>
                      </a:lnTo>
                      <a:lnTo>
                        <a:pt x="103" y="62"/>
                      </a:lnTo>
                      <a:lnTo>
                        <a:pt x="100" y="61"/>
                      </a:lnTo>
                      <a:lnTo>
                        <a:pt x="99" y="59"/>
                      </a:lnTo>
                      <a:lnTo>
                        <a:pt x="96" y="59"/>
                      </a:lnTo>
                      <a:lnTo>
                        <a:pt x="95" y="58"/>
                      </a:lnTo>
                      <a:lnTo>
                        <a:pt x="92" y="56"/>
                      </a:lnTo>
                      <a:lnTo>
                        <a:pt x="89" y="56"/>
                      </a:lnTo>
                      <a:lnTo>
                        <a:pt x="88" y="55"/>
                      </a:lnTo>
                      <a:lnTo>
                        <a:pt x="85" y="53"/>
                      </a:lnTo>
                      <a:lnTo>
                        <a:pt x="83" y="52"/>
                      </a:lnTo>
                      <a:lnTo>
                        <a:pt x="80" y="50"/>
                      </a:lnTo>
                      <a:lnTo>
                        <a:pt x="79" y="50"/>
                      </a:lnTo>
                      <a:lnTo>
                        <a:pt x="76" y="49"/>
                      </a:lnTo>
                      <a:lnTo>
                        <a:pt x="75" y="48"/>
                      </a:lnTo>
                      <a:lnTo>
                        <a:pt x="72" y="46"/>
                      </a:lnTo>
                      <a:lnTo>
                        <a:pt x="70" y="46"/>
                      </a:lnTo>
                      <a:lnTo>
                        <a:pt x="68" y="45"/>
                      </a:lnTo>
                      <a:lnTo>
                        <a:pt x="66" y="43"/>
                      </a:lnTo>
                      <a:lnTo>
                        <a:pt x="63" y="42"/>
                      </a:lnTo>
                      <a:lnTo>
                        <a:pt x="62" y="40"/>
                      </a:lnTo>
                      <a:lnTo>
                        <a:pt x="59" y="39"/>
                      </a:lnTo>
                      <a:lnTo>
                        <a:pt x="57" y="39"/>
                      </a:lnTo>
                      <a:lnTo>
                        <a:pt x="55" y="38"/>
                      </a:lnTo>
                      <a:lnTo>
                        <a:pt x="53" y="36"/>
                      </a:lnTo>
                      <a:lnTo>
                        <a:pt x="50" y="35"/>
                      </a:lnTo>
                      <a:lnTo>
                        <a:pt x="49" y="33"/>
                      </a:lnTo>
                      <a:lnTo>
                        <a:pt x="46" y="32"/>
                      </a:lnTo>
                      <a:lnTo>
                        <a:pt x="45" y="30"/>
                      </a:lnTo>
                      <a:lnTo>
                        <a:pt x="43" y="30"/>
                      </a:lnTo>
                      <a:lnTo>
                        <a:pt x="40" y="29"/>
                      </a:lnTo>
                      <a:lnTo>
                        <a:pt x="39" y="28"/>
                      </a:lnTo>
                      <a:lnTo>
                        <a:pt x="36" y="26"/>
                      </a:lnTo>
                      <a:lnTo>
                        <a:pt x="35" y="25"/>
                      </a:lnTo>
                      <a:lnTo>
                        <a:pt x="32" y="23"/>
                      </a:lnTo>
                      <a:lnTo>
                        <a:pt x="30" y="22"/>
                      </a:lnTo>
                      <a:lnTo>
                        <a:pt x="27" y="20"/>
                      </a:lnTo>
                      <a:lnTo>
                        <a:pt x="26" y="19"/>
                      </a:lnTo>
                      <a:lnTo>
                        <a:pt x="24" y="17"/>
                      </a:lnTo>
                      <a:lnTo>
                        <a:pt x="22" y="16"/>
                      </a:lnTo>
                      <a:lnTo>
                        <a:pt x="20" y="15"/>
                      </a:lnTo>
                      <a:lnTo>
                        <a:pt x="17" y="13"/>
                      </a:lnTo>
                      <a:lnTo>
                        <a:pt x="16" y="12"/>
                      </a:lnTo>
                      <a:lnTo>
                        <a:pt x="14" y="10"/>
                      </a:lnTo>
                      <a:lnTo>
                        <a:pt x="12" y="9"/>
                      </a:lnTo>
                      <a:lnTo>
                        <a:pt x="10" y="7"/>
                      </a:lnTo>
                      <a:lnTo>
                        <a:pt x="7" y="6"/>
                      </a:lnTo>
                      <a:lnTo>
                        <a:pt x="6" y="5"/>
                      </a:lnTo>
                      <a:lnTo>
                        <a:pt x="4" y="3"/>
                      </a:lnTo>
                      <a:lnTo>
                        <a:pt x="2" y="2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5" name="Rectangle 270"/>
                <p:cNvSpPr>
                  <a:spLocks noChangeArrowheads="1"/>
                </p:cNvSpPr>
                <p:nvPr/>
              </p:nvSpPr>
              <p:spPr bwMode="auto">
                <a:xfrm rot="4440000">
                  <a:off x="3930" y="2564"/>
                  <a:ext cx="72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3</a:t>
                  </a:r>
                </a:p>
              </p:txBody>
            </p:sp>
            <p:sp>
              <p:nvSpPr>
                <p:cNvPr id="86" name="Line 271"/>
                <p:cNvSpPr>
                  <a:spLocks noChangeShapeType="1"/>
                </p:cNvSpPr>
                <p:nvPr/>
              </p:nvSpPr>
              <p:spPr bwMode="auto">
                <a:xfrm>
                  <a:off x="3926" y="2590"/>
                  <a:ext cx="16" cy="60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7" name="Rectangle 272"/>
                <p:cNvSpPr>
                  <a:spLocks noChangeArrowheads="1"/>
                </p:cNvSpPr>
                <p:nvPr/>
              </p:nvSpPr>
              <p:spPr bwMode="auto">
                <a:xfrm rot="18660000">
                  <a:off x="2267" y="3616"/>
                  <a:ext cx="299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YCC-A15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8" name="Line 273"/>
                <p:cNvSpPr>
                  <a:spLocks noChangeShapeType="1"/>
                </p:cNvSpPr>
                <p:nvPr/>
              </p:nvSpPr>
              <p:spPr bwMode="auto">
                <a:xfrm flipH="1">
                  <a:off x="2656" y="3305"/>
                  <a:ext cx="89" cy="99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9" name="Rectangle 274"/>
                <p:cNvSpPr>
                  <a:spLocks noChangeArrowheads="1"/>
                </p:cNvSpPr>
                <p:nvPr/>
              </p:nvSpPr>
              <p:spPr bwMode="auto">
                <a:xfrm rot="18960000">
                  <a:off x="2198" y="3470"/>
                  <a:ext cx="242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ZC-A14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0" name="Line 275"/>
                <p:cNvSpPr>
                  <a:spLocks noChangeShapeType="1"/>
                </p:cNvSpPr>
                <p:nvPr/>
              </p:nvSpPr>
              <p:spPr bwMode="auto">
                <a:xfrm flipH="1">
                  <a:off x="2549" y="3256"/>
                  <a:ext cx="46" cy="44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1" name="Rectangle 276"/>
                <p:cNvSpPr>
                  <a:spLocks noChangeArrowheads="1"/>
                </p:cNvSpPr>
                <p:nvPr/>
              </p:nvSpPr>
              <p:spPr bwMode="auto">
                <a:xfrm rot="19260000">
                  <a:off x="2080" y="3336"/>
                  <a:ext cx="246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ZY-A13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2" name="Line 277"/>
                <p:cNvSpPr>
                  <a:spLocks noChangeShapeType="1"/>
                </p:cNvSpPr>
                <p:nvPr/>
              </p:nvSpPr>
              <p:spPr bwMode="auto">
                <a:xfrm flipH="1">
                  <a:off x="2455" y="3148"/>
                  <a:ext cx="49" cy="40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3" name="Freeform 278"/>
                <p:cNvSpPr/>
                <p:nvPr/>
              </p:nvSpPr>
              <p:spPr bwMode="auto">
                <a:xfrm>
                  <a:off x="2551" y="3203"/>
                  <a:ext cx="47" cy="53"/>
                </a:xfrm>
                <a:custGeom>
                  <a:avLst/>
                  <a:gdLst>
                    <a:gd name="T0" fmla="*/ 0 w 47"/>
                    <a:gd name="T1" fmla="*/ 0 h 53"/>
                    <a:gd name="T2" fmla="*/ 3 w 47"/>
                    <a:gd name="T3" fmla="*/ 3 h 53"/>
                    <a:gd name="T4" fmla="*/ 6 w 47"/>
                    <a:gd name="T5" fmla="*/ 5 h 53"/>
                    <a:gd name="T6" fmla="*/ 9 w 47"/>
                    <a:gd name="T7" fmla="*/ 8 h 53"/>
                    <a:gd name="T8" fmla="*/ 11 w 47"/>
                    <a:gd name="T9" fmla="*/ 13 h 53"/>
                    <a:gd name="T10" fmla="*/ 13 w 47"/>
                    <a:gd name="T11" fmla="*/ 15 h 53"/>
                    <a:gd name="T12" fmla="*/ 16 w 47"/>
                    <a:gd name="T13" fmla="*/ 18 h 53"/>
                    <a:gd name="T14" fmla="*/ 19 w 47"/>
                    <a:gd name="T15" fmla="*/ 21 h 53"/>
                    <a:gd name="T16" fmla="*/ 21 w 47"/>
                    <a:gd name="T17" fmla="*/ 24 h 53"/>
                    <a:gd name="T18" fmla="*/ 24 w 47"/>
                    <a:gd name="T19" fmla="*/ 27 h 53"/>
                    <a:gd name="T20" fmla="*/ 27 w 47"/>
                    <a:gd name="T21" fmla="*/ 31 h 53"/>
                    <a:gd name="T22" fmla="*/ 30 w 47"/>
                    <a:gd name="T23" fmla="*/ 34 h 53"/>
                    <a:gd name="T24" fmla="*/ 33 w 47"/>
                    <a:gd name="T25" fmla="*/ 37 h 53"/>
                    <a:gd name="T26" fmla="*/ 36 w 47"/>
                    <a:gd name="T27" fmla="*/ 40 h 53"/>
                    <a:gd name="T28" fmla="*/ 39 w 47"/>
                    <a:gd name="T29" fmla="*/ 43 h 53"/>
                    <a:gd name="T30" fmla="*/ 42 w 47"/>
                    <a:gd name="T31" fmla="*/ 46 h 53"/>
                    <a:gd name="T32" fmla="*/ 44 w 47"/>
                    <a:gd name="T33" fmla="*/ 48 h 53"/>
                    <a:gd name="T34" fmla="*/ 47 w 47"/>
                    <a:gd name="T35" fmla="*/ 53 h 5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47" h="53">
                      <a:moveTo>
                        <a:pt x="0" y="0"/>
                      </a:moveTo>
                      <a:lnTo>
                        <a:pt x="3" y="3"/>
                      </a:lnTo>
                      <a:lnTo>
                        <a:pt x="6" y="5"/>
                      </a:lnTo>
                      <a:lnTo>
                        <a:pt x="9" y="8"/>
                      </a:lnTo>
                      <a:lnTo>
                        <a:pt x="11" y="13"/>
                      </a:lnTo>
                      <a:lnTo>
                        <a:pt x="13" y="15"/>
                      </a:lnTo>
                      <a:lnTo>
                        <a:pt x="16" y="18"/>
                      </a:lnTo>
                      <a:lnTo>
                        <a:pt x="19" y="21"/>
                      </a:lnTo>
                      <a:lnTo>
                        <a:pt x="21" y="24"/>
                      </a:lnTo>
                      <a:lnTo>
                        <a:pt x="24" y="27"/>
                      </a:lnTo>
                      <a:lnTo>
                        <a:pt x="27" y="31"/>
                      </a:lnTo>
                      <a:lnTo>
                        <a:pt x="30" y="34"/>
                      </a:lnTo>
                      <a:lnTo>
                        <a:pt x="33" y="37"/>
                      </a:lnTo>
                      <a:lnTo>
                        <a:pt x="36" y="40"/>
                      </a:lnTo>
                      <a:lnTo>
                        <a:pt x="39" y="43"/>
                      </a:lnTo>
                      <a:lnTo>
                        <a:pt x="42" y="46"/>
                      </a:lnTo>
                      <a:lnTo>
                        <a:pt x="44" y="48"/>
                      </a:lnTo>
                      <a:lnTo>
                        <a:pt x="47" y="53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4" name="Freeform 279"/>
                <p:cNvSpPr/>
                <p:nvPr/>
              </p:nvSpPr>
              <p:spPr bwMode="auto">
                <a:xfrm>
                  <a:off x="2505" y="3148"/>
                  <a:ext cx="46" cy="55"/>
                </a:xfrm>
                <a:custGeom>
                  <a:avLst/>
                  <a:gdLst>
                    <a:gd name="T0" fmla="*/ 46 w 46"/>
                    <a:gd name="T1" fmla="*/ 55 h 55"/>
                    <a:gd name="T2" fmla="*/ 43 w 46"/>
                    <a:gd name="T3" fmla="*/ 52 h 55"/>
                    <a:gd name="T4" fmla="*/ 40 w 46"/>
                    <a:gd name="T5" fmla="*/ 47 h 55"/>
                    <a:gd name="T6" fmla="*/ 37 w 46"/>
                    <a:gd name="T7" fmla="*/ 45 h 55"/>
                    <a:gd name="T8" fmla="*/ 34 w 46"/>
                    <a:gd name="T9" fmla="*/ 42 h 55"/>
                    <a:gd name="T10" fmla="*/ 32 w 46"/>
                    <a:gd name="T11" fmla="*/ 39 h 55"/>
                    <a:gd name="T12" fmla="*/ 30 w 46"/>
                    <a:gd name="T13" fmla="*/ 35 h 55"/>
                    <a:gd name="T14" fmla="*/ 27 w 46"/>
                    <a:gd name="T15" fmla="*/ 32 h 55"/>
                    <a:gd name="T16" fmla="*/ 24 w 46"/>
                    <a:gd name="T17" fmla="*/ 29 h 55"/>
                    <a:gd name="T18" fmla="*/ 22 w 46"/>
                    <a:gd name="T19" fmla="*/ 26 h 55"/>
                    <a:gd name="T20" fmla="*/ 19 w 46"/>
                    <a:gd name="T21" fmla="*/ 23 h 55"/>
                    <a:gd name="T22" fmla="*/ 16 w 46"/>
                    <a:gd name="T23" fmla="*/ 19 h 55"/>
                    <a:gd name="T24" fmla="*/ 13 w 46"/>
                    <a:gd name="T25" fmla="*/ 16 h 55"/>
                    <a:gd name="T26" fmla="*/ 11 w 46"/>
                    <a:gd name="T27" fmla="*/ 13 h 55"/>
                    <a:gd name="T28" fmla="*/ 9 w 46"/>
                    <a:gd name="T29" fmla="*/ 9 h 55"/>
                    <a:gd name="T30" fmla="*/ 6 w 46"/>
                    <a:gd name="T31" fmla="*/ 6 h 55"/>
                    <a:gd name="T32" fmla="*/ 3 w 46"/>
                    <a:gd name="T33" fmla="*/ 3 h 55"/>
                    <a:gd name="T34" fmla="*/ 0 w 46"/>
                    <a:gd name="T35" fmla="*/ 0 h 5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46" h="55">
                      <a:moveTo>
                        <a:pt x="46" y="55"/>
                      </a:moveTo>
                      <a:lnTo>
                        <a:pt x="43" y="52"/>
                      </a:lnTo>
                      <a:lnTo>
                        <a:pt x="40" y="47"/>
                      </a:lnTo>
                      <a:lnTo>
                        <a:pt x="37" y="45"/>
                      </a:lnTo>
                      <a:lnTo>
                        <a:pt x="34" y="42"/>
                      </a:lnTo>
                      <a:lnTo>
                        <a:pt x="32" y="39"/>
                      </a:lnTo>
                      <a:lnTo>
                        <a:pt x="30" y="35"/>
                      </a:lnTo>
                      <a:lnTo>
                        <a:pt x="27" y="32"/>
                      </a:lnTo>
                      <a:lnTo>
                        <a:pt x="24" y="29"/>
                      </a:lnTo>
                      <a:lnTo>
                        <a:pt x="22" y="26"/>
                      </a:lnTo>
                      <a:lnTo>
                        <a:pt x="19" y="23"/>
                      </a:lnTo>
                      <a:lnTo>
                        <a:pt x="16" y="19"/>
                      </a:lnTo>
                      <a:lnTo>
                        <a:pt x="13" y="16"/>
                      </a:lnTo>
                      <a:lnTo>
                        <a:pt x="11" y="13"/>
                      </a:lnTo>
                      <a:lnTo>
                        <a:pt x="9" y="9"/>
                      </a:lnTo>
                      <a:lnTo>
                        <a:pt x="6" y="6"/>
                      </a:lnTo>
                      <a:lnTo>
                        <a:pt x="3" y="3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5" name="Rectangle 280"/>
                <p:cNvSpPr>
                  <a:spLocks noChangeArrowheads="1"/>
                </p:cNvSpPr>
                <p:nvPr/>
              </p:nvSpPr>
              <p:spPr bwMode="auto">
                <a:xfrm rot="19140000">
                  <a:off x="2556" y="3086"/>
                  <a:ext cx="72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9</a:t>
                  </a:r>
                </a:p>
              </p:txBody>
            </p:sp>
            <p:sp>
              <p:nvSpPr>
                <p:cNvPr id="96" name="Line 281"/>
                <p:cNvSpPr>
                  <a:spLocks noChangeShapeType="1"/>
                </p:cNvSpPr>
                <p:nvPr/>
              </p:nvSpPr>
              <p:spPr bwMode="auto">
                <a:xfrm flipH="1">
                  <a:off x="2554" y="3160"/>
                  <a:ext cx="47" cy="41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7" name="Freeform 282"/>
                <p:cNvSpPr/>
                <p:nvPr/>
              </p:nvSpPr>
              <p:spPr bwMode="auto">
                <a:xfrm>
                  <a:off x="2671" y="3233"/>
                  <a:ext cx="75" cy="70"/>
                </a:xfrm>
                <a:custGeom>
                  <a:avLst/>
                  <a:gdLst>
                    <a:gd name="T0" fmla="*/ 0 w 75"/>
                    <a:gd name="T1" fmla="*/ 0 h 70"/>
                    <a:gd name="T2" fmla="*/ 3 w 75"/>
                    <a:gd name="T3" fmla="*/ 1 h 70"/>
                    <a:gd name="T4" fmla="*/ 6 w 75"/>
                    <a:gd name="T5" fmla="*/ 4 h 70"/>
                    <a:gd name="T6" fmla="*/ 8 w 75"/>
                    <a:gd name="T7" fmla="*/ 7 h 70"/>
                    <a:gd name="T8" fmla="*/ 10 w 75"/>
                    <a:gd name="T9" fmla="*/ 8 h 70"/>
                    <a:gd name="T10" fmla="*/ 13 w 75"/>
                    <a:gd name="T11" fmla="*/ 11 h 70"/>
                    <a:gd name="T12" fmla="*/ 16 w 75"/>
                    <a:gd name="T13" fmla="*/ 14 h 70"/>
                    <a:gd name="T14" fmla="*/ 18 w 75"/>
                    <a:gd name="T15" fmla="*/ 16 h 70"/>
                    <a:gd name="T16" fmla="*/ 20 w 75"/>
                    <a:gd name="T17" fmla="*/ 18 h 70"/>
                    <a:gd name="T18" fmla="*/ 23 w 75"/>
                    <a:gd name="T19" fmla="*/ 21 h 70"/>
                    <a:gd name="T20" fmla="*/ 25 w 75"/>
                    <a:gd name="T21" fmla="*/ 23 h 70"/>
                    <a:gd name="T22" fmla="*/ 28 w 75"/>
                    <a:gd name="T23" fmla="*/ 26 h 70"/>
                    <a:gd name="T24" fmla="*/ 30 w 75"/>
                    <a:gd name="T25" fmla="*/ 28 h 70"/>
                    <a:gd name="T26" fmla="*/ 32 w 75"/>
                    <a:gd name="T27" fmla="*/ 30 h 70"/>
                    <a:gd name="T28" fmla="*/ 35 w 75"/>
                    <a:gd name="T29" fmla="*/ 33 h 70"/>
                    <a:gd name="T30" fmla="*/ 38 w 75"/>
                    <a:gd name="T31" fmla="*/ 36 h 70"/>
                    <a:gd name="T32" fmla="*/ 41 w 75"/>
                    <a:gd name="T33" fmla="*/ 37 h 70"/>
                    <a:gd name="T34" fmla="*/ 42 w 75"/>
                    <a:gd name="T35" fmla="*/ 40 h 70"/>
                    <a:gd name="T36" fmla="*/ 45 w 75"/>
                    <a:gd name="T37" fmla="*/ 43 h 70"/>
                    <a:gd name="T38" fmla="*/ 48 w 75"/>
                    <a:gd name="T39" fmla="*/ 44 h 70"/>
                    <a:gd name="T40" fmla="*/ 49 w 75"/>
                    <a:gd name="T41" fmla="*/ 47 h 70"/>
                    <a:gd name="T42" fmla="*/ 52 w 75"/>
                    <a:gd name="T43" fmla="*/ 49 h 70"/>
                    <a:gd name="T44" fmla="*/ 55 w 75"/>
                    <a:gd name="T45" fmla="*/ 51 h 70"/>
                    <a:gd name="T46" fmla="*/ 58 w 75"/>
                    <a:gd name="T47" fmla="*/ 54 h 70"/>
                    <a:gd name="T48" fmla="*/ 59 w 75"/>
                    <a:gd name="T49" fmla="*/ 56 h 70"/>
                    <a:gd name="T50" fmla="*/ 62 w 75"/>
                    <a:gd name="T51" fmla="*/ 59 h 70"/>
                    <a:gd name="T52" fmla="*/ 65 w 75"/>
                    <a:gd name="T53" fmla="*/ 60 h 70"/>
                    <a:gd name="T54" fmla="*/ 68 w 75"/>
                    <a:gd name="T55" fmla="*/ 63 h 70"/>
                    <a:gd name="T56" fmla="*/ 69 w 75"/>
                    <a:gd name="T57" fmla="*/ 66 h 70"/>
                    <a:gd name="T58" fmla="*/ 72 w 75"/>
                    <a:gd name="T59" fmla="*/ 67 h 70"/>
                    <a:gd name="T60" fmla="*/ 75 w 75"/>
                    <a:gd name="T61" fmla="*/ 70 h 7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</a:cxnLst>
                  <a:rect l="0" t="0" r="r" b="b"/>
                  <a:pathLst>
                    <a:path w="75" h="70">
                      <a:moveTo>
                        <a:pt x="0" y="0"/>
                      </a:moveTo>
                      <a:lnTo>
                        <a:pt x="3" y="1"/>
                      </a:lnTo>
                      <a:lnTo>
                        <a:pt x="6" y="4"/>
                      </a:lnTo>
                      <a:lnTo>
                        <a:pt x="8" y="7"/>
                      </a:lnTo>
                      <a:lnTo>
                        <a:pt x="10" y="8"/>
                      </a:lnTo>
                      <a:lnTo>
                        <a:pt x="13" y="11"/>
                      </a:lnTo>
                      <a:lnTo>
                        <a:pt x="16" y="14"/>
                      </a:lnTo>
                      <a:lnTo>
                        <a:pt x="18" y="16"/>
                      </a:lnTo>
                      <a:lnTo>
                        <a:pt x="20" y="18"/>
                      </a:lnTo>
                      <a:lnTo>
                        <a:pt x="23" y="21"/>
                      </a:lnTo>
                      <a:lnTo>
                        <a:pt x="25" y="23"/>
                      </a:lnTo>
                      <a:lnTo>
                        <a:pt x="28" y="26"/>
                      </a:lnTo>
                      <a:lnTo>
                        <a:pt x="30" y="28"/>
                      </a:lnTo>
                      <a:lnTo>
                        <a:pt x="32" y="30"/>
                      </a:lnTo>
                      <a:lnTo>
                        <a:pt x="35" y="33"/>
                      </a:lnTo>
                      <a:lnTo>
                        <a:pt x="38" y="36"/>
                      </a:lnTo>
                      <a:lnTo>
                        <a:pt x="41" y="37"/>
                      </a:lnTo>
                      <a:lnTo>
                        <a:pt x="42" y="40"/>
                      </a:lnTo>
                      <a:lnTo>
                        <a:pt x="45" y="43"/>
                      </a:lnTo>
                      <a:lnTo>
                        <a:pt x="48" y="44"/>
                      </a:lnTo>
                      <a:lnTo>
                        <a:pt x="49" y="47"/>
                      </a:lnTo>
                      <a:lnTo>
                        <a:pt x="52" y="49"/>
                      </a:lnTo>
                      <a:lnTo>
                        <a:pt x="55" y="51"/>
                      </a:lnTo>
                      <a:lnTo>
                        <a:pt x="58" y="54"/>
                      </a:lnTo>
                      <a:lnTo>
                        <a:pt x="59" y="56"/>
                      </a:lnTo>
                      <a:lnTo>
                        <a:pt x="62" y="59"/>
                      </a:lnTo>
                      <a:lnTo>
                        <a:pt x="65" y="60"/>
                      </a:lnTo>
                      <a:lnTo>
                        <a:pt x="68" y="63"/>
                      </a:lnTo>
                      <a:lnTo>
                        <a:pt x="69" y="66"/>
                      </a:lnTo>
                      <a:lnTo>
                        <a:pt x="72" y="67"/>
                      </a:lnTo>
                      <a:lnTo>
                        <a:pt x="75" y="7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8" name="Freeform 283"/>
                <p:cNvSpPr/>
                <p:nvPr/>
              </p:nvSpPr>
              <p:spPr bwMode="auto">
                <a:xfrm>
                  <a:off x="2603" y="3157"/>
                  <a:ext cx="68" cy="76"/>
                </a:xfrm>
                <a:custGeom>
                  <a:avLst/>
                  <a:gdLst>
                    <a:gd name="T0" fmla="*/ 68 w 68"/>
                    <a:gd name="T1" fmla="*/ 76 h 76"/>
                    <a:gd name="T2" fmla="*/ 66 w 68"/>
                    <a:gd name="T3" fmla="*/ 71 h 76"/>
                    <a:gd name="T4" fmla="*/ 63 w 68"/>
                    <a:gd name="T5" fmla="*/ 69 h 76"/>
                    <a:gd name="T6" fmla="*/ 58 w 68"/>
                    <a:gd name="T7" fmla="*/ 64 h 76"/>
                    <a:gd name="T8" fmla="*/ 55 w 68"/>
                    <a:gd name="T9" fmla="*/ 61 h 76"/>
                    <a:gd name="T10" fmla="*/ 53 w 68"/>
                    <a:gd name="T11" fmla="*/ 59 h 76"/>
                    <a:gd name="T12" fmla="*/ 48 w 68"/>
                    <a:gd name="T13" fmla="*/ 54 h 76"/>
                    <a:gd name="T14" fmla="*/ 45 w 68"/>
                    <a:gd name="T15" fmla="*/ 51 h 76"/>
                    <a:gd name="T16" fmla="*/ 43 w 68"/>
                    <a:gd name="T17" fmla="*/ 47 h 76"/>
                    <a:gd name="T18" fmla="*/ 38 w 68"/>
                    <a:gd name="T19" fmla="*/ 44 h 76"/>
                    <a:gd name="T20" fmla="*/ 35 w 68"/>
                    <a:gd name="T21" fmla="*/ 40 h 76"/>
                    <a:gd name="T22" fmla="*/ 33 w 68"/>
                    <a:gd name="T23" fmla="*/ 37 h 76"/>
                    <a:gd name="T24" fmla="*/ 28 w 68"/>
                    <a:gd name="T25" fmla="*/ 33 h 76"/>
                    <a:gd name="T26" fmla="*/ 25 w 68"/>
                    <a:gd name="T27" fmla="*/ 30 h 76"/>
                    <a:gd name="T28" fmla="*/ 22 w 68"/>
                    <a:gd name="T29" fmla="*/ 26 h 76"/>
                    <a:gd name="T30" fmla="*/ 20 w 68"/>
                    <a:gd name="T31" fmla="*/ 23 h 76"/>
                    <a:gd name="T32" fmla="*/ 15 w 68"/>
                    <a:gd name="T33" fmla="*/ 18 h 76"/>
                    <a:gd name="T34" fmla="*/ 12 w 68"/>
                    <a:gd name="T35" fmla="*/ 16 h 76"/>
                    <a:gd name="T36" fmla="*/ 10 w 68"/>
                    <a:gd name="T37" fmla="*/ 11 h 76"/>
                    <a:gd name="T38" fmla="*/ 7 w 68"/>
                    <a:gd name="T39" fmla="*/ 8 h 76"/>
                    <a:gd name="T40" fmla="*/ 2 w 68"/>
                    <a:gd name="T41" fmla="*/ 4 h 76"/>
                    <a:gd name="T42" fmla="*/ 0 w 68"/>
                    <a:gd name="T43" fmla="*/ 0 h 7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</a:cxnLst>
                  <a:rect l="0" t="0" r="r" b="b"/>
                  <a:pathLst>
                    <a:path w="68" h="76">
                      <a:moveTo>
                        <a:pt x="68" y="76"/>
                      </a:moveTo>
                      <a:lnTo>
                        <a:pt x="66" y="71"/>
                      </a:lnTo>
                      <a:lnTo>
                        <a:pt x="63" y="69"/>
                      </a:lnTo>
                      <a:lnTo>
                        <a:pt x="58" y="64"/>
                      </a:lnTo>
                      <a:lnTo>
                        <a:pt x="55" y="61"/>
                      </a:lnTo>
                      <a:lnTo>
                        <a:pt x="53" y="59"/>
                      </a:lnTo>
                      <a:lnTo>
                        <a:pt x="48" y="54"/>
                      </a:lnTo>
                      <a:lnTo>
                        <a:pt x="45" y="51"/>
                      </a:lnTo>
                      <a:lnTo>
                        <a:pt x="43" y="47"/>
                      </a:lnTo>
                      <a:lnTo>
                        <a:pt x="38" y="44"/>
                      </a:lnTo>
                      <a:lnTo>
                        <a:pt x="35" y="40"/>
                      </a:lnTo>
                      <a:lnTo>
                        <a:pt x="33" y="37"/>
                      </a:lnTo>
                      <a:lnTo>
                        <a:pt x="28" y="33"/>
                      </a:lnTo>
                      <a:lnTo>
                        <a:pt x="25" y="30"/>
                      </a:lnTo>
                      <a:lnTo>
                        <a:pt x="22" y="26"/>
                      </a:lnTo>
                      <a:lnTo>
                        <a:pt x="20" y="23"/>
                      </a:lnTo>
                      <a:lnTo>
                        <a:pt x="15" y="18"/>
                      </a:lnTo>
                      <a:lnTo>
                        <a:pt x="12" y="16"/>
                      </a:lnTo>
                      <a:lnTo>
                        <a:pt x="10" y="11"/>
                      </a:lnTo>
                      <a:lnTo>
                        <a:pt x="7" y="8"/>
                      </a:lnTo>
                      <a:lnTo>
                        <a:pt x="2" y="4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9" name="Rectangle 284"/>
                <p:cNvSpPr>
                  <a:spLocks noChangeArrowheads="1"/>
                </p:cNvSpPr>
                <p:nvPr/>
              </p:nvSpPr>
              <p:spPr bwMode="auto">
                <a:xfrm rot="18900000">
                  <a:off x="2671" y="3116"/>
                  <a:ext cx="72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94</a:t>
                  </a:r>
                </a:p>
              </p:txBody>
            </p:sp>
            <p:sp>
              <p:nvSpPr>
                <p:cNvPr id="100" name="Line 285"/>
                <p:cNvSpPr>
                  <a:spLocks noChangeShapeType="1"/>
                </p:cNvSpPr>
                <p:nvPr/>
              </p:nvSpPr>
              <p:spPr bwMode="auto">
                <a:xfrm flipH="1">
                  <a:off x="2673" y="2461"/>
                  <a:ext cx="781" cy="770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1" name="Freeform 286"/>
                <p:cNvSpPr/>
                <p:nvPr/>
              </p:nvSpPr>
              <p:spPr bwMode="auto">
                <a:xfrm>
                  <a:off x="3674" y="2586"/>
                  <a:ext cx="251" cy="17"/>
                </a:xfrm>
                <a:custGeom>
                  <a:avLst/>
                  <a:gdLst>
                    <a:gd name="T0" fmla="*/ 0 w 251"/>
                    <a:gd name="T1" fmla="*/ 0 h 17"/>
                    <a:gd name="T2" fmla="*/ 5 w 251"/>
                    <a:gd name="T3" fmla="*/ 1 h 17"/>
                    <a:gd name="T4" fmla="*/ 10 w 251"/>
                    <a:gd name="T5" fmla="*/ 3 h 17"/>
                    <a:gd name="T6" fmla="*/ 16 w 251"/>
                    <a:gd name="T7" fmla="*/ 4 h 17"/>
                    <a:gd name="T8" fmla="*/ 21 w 251"/>
                    <a:gd name="T9" fmla="*/ 5 h 17"/>
                    <a:gd name="T10" fmla="*/ 26 w 251"/>
                    <a:gd name="T11" fmla="*/ 7 h 17"/>
                    <a:gd name="T12" fmla="*/ 31 w 251"/>
                    <a:gd name="T13" fmla="*/ 7 h 17"/>
                    <a:gd name="T14" fmla="*/ 37 w 251"/>
                    <a:gd name="T15" fmla="*/ 8 h 17"/>
                    <a:gd name="T16" fmla="*/ 43 w 251"/>
                    <a:gd name="T17" fmla="*/ 10 h 17"/>
                    <a:gd name="T18" fmla="*/ 47 w 251"/>
                    <a:gd name="T19" fmla="*/ 11 h 17"/>
                    <a:gd name="T20" fmla="*/ 53 w 251"/>
                    <a:gd name="T21" fmla="*/ 11 h 17"/>
                    <a:gd name="T22" fmla="*/ 59 w 251"/>
                    <a:gd name="T23" fmla="*/ 13 h 17"/>
                    <a:gd name="T24" fmla="*/ 63 w 251"/>
                    <a:gd name="T25" fmla="*/ 13 h 17"/>
                    <a:gd name="T26" fmla="*/ 69 w 251"/>
                    <a:gd name="T27" fmla="*/ 14 h 17"/>
                    <a:gd name="T28" fmla="*/ 74 w 251"/>
                    <a:gd name="T29" fmla="*/ 14 h 17"/>
                    <a:gd name="T30" fmla="*/ 80 w 251"/>
                    <a:gd name="T31" fmla="*/ 14 h 17"/>
                    <a:gd name="T32" fmla="*/ 84 w 251"/>
                    <a:gd name="T33" fmla="*/ 15 h 17"/>
                    <a:gd name="T34" fmla="*/ 90 w 251"/>
                    <a:gd name="T35" fmla="*/ 15 h 17"/>
                    <a:gd name="T36" fmla="*/ 96 w 251"/>
                    <a:gd name="T37" fmla="*/ 15 h 17"/>
                    <a:gd name="T38" fmla="*/ 102 w 251"/>
                    <a:gd name="T39" fmla="*/ 17 h 17"/>
                    <a:gd name="T40" fmla="*/ 107 w 251"/>
                    <a:gd name="T41" fmla="*/ 17 h 17"/>
                    <a:gd name="T42" fmla="*/ 112 w 251"/>
                    <a:gd name="T43" fmla="*/ 17 h 17"/>
                    <a:gd name="T44" fmla="*/ 117 w 251"/>
                    <a:gd name="T45" fmla="*/ 17 h 17"/>
                    <a:gd name="T46" fmla="*/ 123 w 251"/>
                    <a:gd name="T47" fmla="*/ 17 h 17"/>
                    <a:gd name="T48" fmla="*/ 129 w 251"/>
                    <a:gd name="T49" fmla="*/ 17 h 17"/>
                    <a:gd name="T50" fmla="*/ 133 w 251"/>
                    <a:gd name="T51" fmla="*/ 17 h 17"/>
                    <a:gd name="T52" fmla="*/ 139 w 251"/>
                    <a:gd name="T53" fmla="*/ 17 h 17"/>
                    <a:gd name="T54" fmla="*/ 145 w 251"/>
                    <a:gd name="T55" fmla="*/ 17 h 17"/>
                    <a:gd name="T56" fmla="*/ 150 w 251"/>
                    <a:gd name="T57" fmla="*/ 17 h 17"/>
                    <a:gd name="T58" fmla="*/ 155 w 251"/>
                    <a:gd name="T59" fmla="*/ 15 h 17"/>
                    <a:gd name="T60" fmla="*/ 160 w 251"/>
                    <a:gd name="T61" fmla="*/ 15 h 17"/>
                    <a:gd name="T62" fmla="*/ 166 w 251"/>
                    <a:gd name="T63" fmla="*/ 15 h 17"/>
                    <a:gd name="T64" fmla="*/ 172 w 251"/>
                    <a:gd name="T65" fmla="*/ 14 h 17"/>
                    <a:gd name="T66" fmla="*/ 178 w 251"/>
                    <a:gd name="T67" fmla="*/ 14 h 17"/>
                    <a:gd name="T68" fmla="*/ 182 w 251"/>
                    <a:gd name="T69" fmla="*/ 14 h 17"/>
                    <a:gd name="T70" fmla="*/ 188 w 251"/>
                    <a:gd name="T71" fmla="*/ 13 h 17"/>
                    <a:gd name="T72" fmla="*/ 193 w 251"/>
                    <a:gd name="T73" fmla="*/ 13 h 17"/>
                    <a:gd name="T74" fmla="*/ 198 w 251"/>
                    <a:gd name="T75" fmla="*/ 11 h 17"/>
                    <a:gd name="T76" fmla="*/ 203 w 251"/>
                    <a:gd name="T77" fmla="*/ 11 h 17"/>
                    <a:gd name="T78" fmla="*/ 209 w 251"/>
                    <a:gd name="T79" fmla="*/ 10 h 17"/>
                    <a:gd name="T80" fmla="*/ 215 w 251"/>
                    <a:gd name="T81" fmla="*/ 8 h 17"/>
                    <a:gd name="T82" fmla="*/ 219 w 251"/>
                    <a:gd name="T83" fmla="*/ 8 h 17"/>
                    <a:gd name="T84" fmla="*/ 225 w 251"/>
                    <a:gd name="T85" fmla="*/ 7 h 17"/>
                    <a:gd name="T86" fmla="*/ 231 w 251"/>
                    <a:gd name="T87" fmla="*/ 5 h 17"/>
                    <a:gd name="T88" fmla="*/ 235 w 251"/>
                    <a:gd name="T89" fmla="*/ 4 h 17"/>
                    <a:gd name="T90" fmla="*/ 241 w 251"/>
                    <a:gd name="T91" fmla="*/ 3 h 17"/>
                    <a:gd name="T92" fmla="*/ 246 w 251"/>
                    <a:gd name="T93" fmla="*/ 1 h 17"/>
                    <a:gd name="T94" fmla="*/ 251 w 251"/>
                    <a:gd name="T95" fmla="*/ 0 h 1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  <a:cxn ang="0">
                      <a:pos x="T90" y="T91"/>
                    </a:cxn>
                    <a:cxn ang="0">
                      <a:pos x="T92" y="T93"/>
                    </a:cxn>
                    <a:cxn ang="0">
                      <a:pos x="T94" y="T95"/>
                    </a:cxn>
                  </a:cxnLst>
                  <a:rect l="0" t="0" r="r" b="b"/>
                  <a:pathLst>
                    <a:path w="251" h="17">
                      <a:moveTo>
                        <a:pt x="0" y="0"/>
                      </a:moveTo>
                      <a:lnTo>
                        <a:pt x="5" y="1"/>
                      </a:lnTo>
                      <a:lnTo>
                        <a:pt x="10" y="3"/>
                      </a:lnTo>
                      <a:lnTo>
                        <a:pt x="16" y="4"/>
                      </a:lnTo>
                      <a:lnTo>
                        <a:pt x="21" y="5"/>
                      </a:lnTo>
                      <a:lnTo>
                        <a:pt x="26" y="7"/>
                      </a:lnTo>
                      <a:lnTo>
                        <a:pt x="31" y="7"/>
                      </a:lnTo>
                      <a:lnTo>
                        <a:pt x="37" y="8"/>
                      </a:lnTo>
                      <a:lnTo>
                        <a:pt x="43" y="10"/>
                      </a:lnTo>
                      <a:lnTo>
                        <a:pt x="47" y="11"/>
                      </a:lnTo>
                      <a:lnTo>
                        <a:pt x="53" y="11"/>
                      </a:lnTo>
                      <a:lnTo>
                        <a:pt x="59" y="13"/>
                      </a:lnTo>
                      <a:lnTo>
                        <a:pt x="63" y="13"/>
                      </a:lnTo>
                      <a:lnTo>
                        <a:pt x="69" y="14"/>
                      </a:lnTo>
                      <a:lnTo>
                        <a:pt x="74" y="14"/>
                      </a:lnTo>
                      <a:lnTo>
                        <a:pt x="80" y="14"/>
                      </a:lnTo>
                      <a:lnTo>
                        <a:pt x="84" y="15"/>
                      </a:lnTo>
                      <a:lnTo>
                        <a:pt x="90" y="15"/>
                      </a:lnTo>
                      <a:lnTo>
                        <a:pt x="96" y="15"/>
                      </a:lnTo>
                      <a:lnTo>
                        <a:pt x="102" y="17"/>
                      </a:lnTo>
                      <a:lnTo>
                        <a:pt x="107" y="17"/>
                      </a:lnTo>
                      <a:lnTo>
                        <a:pt x="112" y="17"/>
                      </a:lnTo>
                      <a:lnTo>
                        <a:pt x="117" y="17"/>
                      </a:lnTo>
                      <a:lnTo>
                        <a:pt x="123" y="17"/>
                      </a:lnTo>
                      <a:lnTo>
                        <a:pt x="129" y="17"/>
                      </a:lnTo>
                      <a:lnTo>
                        <a:pt x="133" y="17"/>
                      </a:lnTo>
                      <a:lnTo>
                        <a:pt x="139" y="17"/>
                      </a:lnTo>
                      <a:lnTo>
                        <a:pt x="145" y="17"/>
                      </a:lnTo>
                      <a:lnTo>
                        <a:pt x="150" y="17"/>
                      </a:lnTo>
                      <a:lnTo>
                        <a:pt x="155" y="15"/>
                      </a:lnTo>
                      <a:lnTo>
                        <a:pt x="160" y="15"/>
                      </a:lnTo>
                      <a:lnTo>
                        <a:pt x="166" y="15"/>
                      </a:lnTo>
                      <a:lnTo>
                        <a:pt x="172" y="14"/>
                      </a:lnTo>
                      <a:lnTo>
                        <a:pt x="178" y="14"/>
                      </a:lnTo>
                      <a:lnTo>
                        <a:pt x="182" y="14"/>
                      </a:lnTo>
                      <a:lnTo>
                        <a:pt x="188" y="13"/>
                      </a:lnTo>
                      <a:lnTo>
                        <a:pt x="193" y="13"/>
                      </a:lnTo>
                      <a:lnTo>
                        <a:pt x="198" y="11"/>
                      </a:lnTo>
                      <a:lnTo>
                        <a:pt x="203" y="11"/>
                      </a:lnTo>
                      <a:lnTo>
                        <a:pt x="209" y="10"/>
                      </a:lnTo>
                      <a:lnTo>
                        <a:pt x="215" y="8"/>
                      </a:lnTo>
                      <a:lnTo>
                        <a:pt x="219" y="8"/>
                      </a:lnTo>
                      <a:lnTo>
                        <a:pt x="225" y="7"/>
                      </a:lnTo>
                      <a:lnTo>
                        <a:pt x="231" y="5"/>
                      </a:lnTo>
                      <a:lnTo>
                        <a:pt x="235" y="4"/>
                      </a:lnTo>
                      <a:lnTo>
                        <a:pt x="241" y="3"/>
                      </a:lnTo>
                      <a:lnTo>
                        <a:pt x="246" y="1"/>
                      </a:lnTo>
                      <a:lnTo>
                        <a:pt x="251" y="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2" name="Freeform 287"/>
                <p:cNvSpPr/>
                <p:nvPr/>
              </p:nvSpPr>
              <p:spPr bwMode="auto">
                <a:xfrm>
                  <a:off x="3457" y="2459"/>
                  <a:ext cx="217" cy="127"/>
                </a:xfrm>
                <a:custGeom>
                  <a:avLst/>
                  <a:gdLst>
                    <a:gd name="T0" fmla="*/ 214 w 217"/>
                    <a:gd name="T1" fmla="*/ 127 h 127"/>
                    <a:gd name="T2" fmla="*/ 210 w 217"/>
                    <a:gd name="T3" fmla="*/ 125 h 127"/>
                    <a:gd name="T4" fmla="*/ 205 w 217"/>
                    <a:gd name="T5" fmla="*/ 124 h 127"/>
                    <a:gd name="T6" fmla="*/ 201 w 217"/>
                    <a:gd name="T7" fmla="*/ 122 h 127"/>
                    <a:gd name="T8" fmla="*/ 197 w 217"/>
                    <a:gd name="T9" fmla="*/ 121 h 127"/>
                    <a:gd name="T10" fmla="*/ 192 w 217"/>
                    <a:gd name="T11" fmla="*/ 119 h 127"/>
                    <a:gd name="T12" fmla="*/ 189 w 217"/>
                    <a:gd name="T13" fmla="*/ 118 h 127"/>
                    <a:gd name="T14" fmla="*/ 185 w 217"/>
                    <a:gd name="T15" fmla="*/ 117 h 127"/>
                    <a:gd name="T16" fmla="*/ 181 w 217"/>
                    <a:gd name="T17" fmla="*/ 115 h 127"/>
                    <a:gd name="T18" fmla="*/ 177 w 217"/>
                    <a:gd name="T19" fmla="*/ 114 h 127"/>
                    <a:gd name="T20" fmla="*/ 172 w 217"/>
                    <a:gd name="T21" fmla="*/ 112 h 127"/>
                    <a:gd name="T22" fmla="*/ 168 w 217"/>
                    <a:gd name="T23" fmla="*/ 111 h 127"/>
                    <a:gd name="T24" fmla="*/ 164 w 217"/>
                    <a:gd name="T25" fmla="*/ 109 h 127"/>
                    <a:gd name="T26" fmla="*/ 159 w 217"/>
                    <a:gd name="T27" fmla="*/ 108 h 127"/>
                    <a:gd name="T28" fmla="*/ 157 w 217"/>
                    <a:gd name="T29" fmla="*/ 107 h 127"/>
                    <a:gd name="T30" fmla="*/ 152 w 217"/>
                    <a:gd name="T31" fmla="*/ 104 h 127"/>
                    <a:gd name="T32" fmla="*/ 148 w 217"/>
                    <a:gd name="T33" fmla="*/ 102 h 127"/>
                    <a:gd name="T34" fmla="*/ 144 w 217"/>
                    <a:gd name="T35" fmla="*/ 101 h 127"/>
                    <a:gd name="T36" fmla="*/ 139 w 217"/>
                    <a:gd name="T37" fmla="*/ 99 h 127"/>
                    <a:gd name="T38" fmla="*/ 136 w 217"/>
                    <a:gd name="T39" fmla="*/ 97 h 127"/>
                    <a:gd name="T40" fmla="*/ 132 w 217"/>
                    <a:gd name="T41" fmla="*/ 95 h 127"/>
                    <a:gd name="T42" fmla="*/ 128 w 217"/>
                    <a:gd name="T43" fmla="*/ 94 h 127"/>
                    <a:gd name="T44" fmla="*/ 124 w 217"/>
                    <a:gd name="T45" fmla="*/ 91 h 127"/>
                    <a:gd name="T46" fmla="*/ 121 w 217"/>
                    <a:gd name="T47" fmla="*/ 89 h 127"/>
                    <a:gd name="T48" fmla="*/ 116 w 217"/>
                    <a:gd name="T49" fmla="*/ 88 h 127"/>
                    <a:gd name="T50" fmla="*/ 112 w 217"/>
                    <a:gd name="T51" fmla="*/ 85 h 127"/>
                    <a:gd name="T52" fmla="*/ 109 w 217"/>
                    <a:gd name="T53" fmla="*/ 84 h 127"/>
                    <a:gd name="T54" fmla="*/ 105 w 217"/>
                    <a:gd name="T55" fmla="*/ 81 h 127"/>
                    <a:gd name="T56" fmla="*/ 101 w 217"/>
                    <a:gd name="T57" fmla="*/ 79 h 127"/>
                    <a:gd name="T58" fmla="*/ 98 w 217"/>
                    <a:gd name="T59" fmla="*/ 76 h 127"/>
                    <a:gd name="T60" fmla="*/ 93 w 217"/>
                    <a:gd name="T61" fmla="*/ 74 h 127"/>
                    <a:gd name="T62" fmla="*/ 89 w 217"/>
                    <a:gd name="T63" fmla="*/ 72 h 127"/>
                    <a:gd name="T64" fmla="*/ 86 w 217"/>
                    <a:gd name="T65" fmla="*/ 69 h 127"/>
                    <a:gd name="T66" fmla="*/ 82 w 217"/>
                    <a:gd name="T67" fmla="*/ 68 h 127"/>
                    <a:gd name="T68" fmla="*/ 79 w 217"/>
                    <a:gd name="T69" fmla="*/ 65 h 127"/>
                    <a:gd name="T70" fmla="*/ 75 w 217"/>
                    <a:gd name="T71" fmla="*/ 62 h 127"/>
                    <a:gd name="T72" fmla="*/ 72 w 217"/>
                    <a:gd name="T73" fmla="*/ 61 h 127"/>
                    <a:gd name="T74" fmla="*/ 68 w 217"/>
                    <a:gd name="T75" fmla="*/ 58 h 127"/>
                    <a:gd name="T76" fmla="*/ 65 w 217"/>
                    <a:gd name="T77" fmla="*/ 55 h 127"/>
                    <a:gd name="T78" fmla="*/ 60 w 217"/>
                    <a:gd name="T79" fmla="*/ 52 h 127"/>
                    <a:gd name="T80" fmla="*/ 58 w 217"/>
                    <a:gd name="T81" fmla="*/ 49 h 127"/>
                    <a:gd name="T82" fmla="*/ 53 w 217"/>
                    <a:gd name="T83" fmla="*/ 48 h 127"/>
                    <a:gd name="T84" fmla="*/ 50 w 217"/>
                    <a:gd name="T85" fmla="*/ 45 h 127"/>
                    <a:gd name="T86" fmla="*/ 46 w 217"/>
                    <a:gd name="T87" fmla="*/ 42 h 127"/>
                    <a:gd name="T88" fmla="*/ 43 w 217"/>
                    <a:gd name="T89" fmla="*/ 39 h 127"/>
                    <a:gd name="T90" fmla="*/ 40 w 217"/>
                    <a:gd name="T91" fmla="*/ 36 h 127"/>
                    <a:gd name="T92" fmla="*/ 36 w 217"/>
                    <a:gd name="T93" fmla="*/ 33 h 127"/>
                    <a:gd name="T94" fmla="*/ 33 w 217"/>
                    <a:gd name="T95" fmla="*/ 31 h 127"/>
                    <a:gd name="T96" fmla="*/ 29 w 217"/>
                    <a:gd name="T97" fmla="*/ 28 h 127"/>
                    <a:gd name="T98" fmla="*/ 26 w 217"/>
                    <a:gd name="T99" fmla="*/ 25 h 127"/>
                    <a:gd name="T100" fmla="*/ 23 w 217"/>
                    <a:gd name="T101" fmla="*/ 22 h 127"/>
                    <a:gd name="T102" fmla="*/ 20 w 217"/>
                    <a:gd name="T103" fmla="*/ 19 h 127"/>
                    <a:gd name="T104" fmla="*/ 16 w 217"/>
                    <a:gd name="T105" fmla="*/ 16 h 127"/>
                    <a:gd name="T106" fmla="*/ 13 w 217"/>
                    <a:gd name="T107" fmla="*/ 13 h 127"/>
                    <a:gd name="T108" fmla="*/ 10 w 217"/>
                    <a:gd name="T109" fmla="*/ 10 h 127"/>
                    <a:gd name="T110" fmla="*/ 7 w 217"/>
                    <a:gd name="T111" fmla="*/ 8 h 127"/>
                    <a:gd name="T112" fmla="*/ 3 w 217"/>
                    <a:gd name="T113" fmla="*/ 5 h 127"/>
                    <a:gd name="T114" fmla="*/ 0 w 217"/>
                    <a:gd name="T115" fmla="*/ 2 h 12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  <a:cxn ang="0">
                      <a:pos x="T90" y="T91"/>
                    </a:cxn>
                    <a:cxn ang="0">
                      <a:pos x="T92" y="T93"/>
                    </a:cxn>
                    <a:cxn ang="0">
                      <a:pos x="T94" y="T95"/>
                    </a:cxn>
                    <a:cxn ang="0">
                      <a:pos x="T96" y="T97"/>
                    </a:cxn>
                    <a:cxn ang="0">
                      <a:pos x="T98" y="T99"/>
                    </a:cxn>
                    <a:cxn ang="0">
                      <a:pos x="T100" y="T101"/>
                    </a:cxn>
                    <a:cxn ang="0">
                      <a:pos x="T102" y="T103"/>
                    </a:cxn>
                    <a:cxn ang="0">
                      <a:pos x="T104" y="T105"/>
                    </a:cxn>
                    <a:cxn ang="0">
                      <a:pos x="T106" y="T107"/>
                    </a:cxn>
                    <a:cxn ang="0">
                      <a:pos x="T108" y="T109"/>
                    </a:cxn>
                    <a:cxn ang="0">
                      <a:pos x="T110" y="T111"/>
                    </a:cxn>
                    <a:cxn ang="0">
                      <a:pos x="T112" y="T113"/>
                    </a:cxn>
                    <a:cxn ang="0">
                      <a:pos x="T114" y="T115"/>
                    </a:cxn>
                  </a:cxnLst>
                  <a:rect l="0" t="0" r="r" b="b"/>
                  <a:pathLst>
                    <a:path w="217" h="127">
                      <a:moveTo>
                        <a:pt x="217" y="127"/>
                      </a:moveTo>
                      <a:lnTo>
                        <a:pt x="215" y="127"/>
                      </a:lnTo>
                      <a:lnTo>
                        <a:pt x="214" y="127"/>
                      </a:lnTo>
                      <a:lnTo>
                        <a:pt x="212" y="125"/>
                      </a:lnTo>
                      <a:lnTo>
                        <a:pt x="211" y="125"/>
                      </a:lnTo>
                      <a:lnTo>
                        <a:pt x="210" y="125"/>
                      </a:lnTo>
                      <a:lnTo>
                        <a:pt x="208" y="125"/>
                      </a:lnTo>
                      <a:lnTo>
                        <a:pt x="207" y="124"/>
                      </a:lnTo>
                      <a:lnTo>
                        <a:pt x="205" y="124"/>
                      </a:lnTo>
                      <a:lnTo>
                        <a:pt x="204" y="124"/>
                      </a:lnTo>
                      <a:lnTo>
                        <a:pt x="202" y="122"/>
                      </a:lnTo>
                      <a:lnTo>
                        <a:pt x="201" y="122"/>
                      </a:lnTo>
                      <a:lnTo>
                        <a:pt x="200" y="122"/>
                      </a:lnTo>
                      <a:lnTo>
                        <a:pt x="198" y="122"/>
                      </a:lnTo>
                      <a:lnTo>
                        <a:pt x="197" y="121"/>
                      </a:lnTo>
                      <a:lnTo>
                        <a:pt x="195" y="121"/>
                      </a:lnTo>
                      <a:lnTo>
                        <a:pt x="194" y="121"/>
                      </a:lnTo>
                      <a:lnTo>
                        <a:pt x="192" y="119"/>
                      </a:lnTo>
                      <a:lnTo>
                        <a:pt x="191" y="119"/>
                      </a:lnTo>
                      <a:lnTo>
                        <a:pt x="189" y="119"/>
                      </a:lnTo>
                      <a:lnTo>
                        <a:pt x="189" y="118"/>
                      </a:lnTo>
                      <a:lnTo>
                        <a:pt x="188" y="118"/>
                      </a:lnTo>
                      <a:lnTo>
                        <a:pt x="187" y="118"/>
                      </a:lnTo>
                      <a:lnTo>
                        <a:pt x="185" y="117"/>
                      </a:lnTo>
                      <a:lnTo>
                        <a:pt x="184" y="117"/>
                      </a:lnTo>
                      <a:lnTo>
                        <a:pt x="182" y="117"/>
                      </a:lnTo>
                      <a:lnTo>
                        <a:pt x="181" y="115"/>
                      </a:lnTo>
                      <a:lnTo>
                        <a:pt x="179" y="115"/>
                      </a:lnTo>
                      <a:lnTo>
                        <a:pt x="178" y="115"/>
                      </a:lnTo>
                      <a:lnTo>
                        <a:pt x="177" y="114"/>
                      </a:lnTo>
                      <a:lnTo>
                        <a:pt x="175" y="114"/>
                      </a:lnTo>
                      <a:lnTo>
                        <a:pt x="174" y="114"/>
                      </a:lnTo>
                      <a:lnTo>
                        <a:pt x="172" y="112"/>
                      </a:lnTo>
                      <a:lnTo>
                        <a:pt x="171" y="112"/>
                      </a:lnTo>
                      <a:lnTo>
                        <a:pt x="169" y="111"/>
                      </a:lnTo>
                      <a:lnTo>
                        <a:pt x="168" y="111"/>
                      </a:lnTo>
                      <a:lnTo>
                        <a:pt x="167" y="111"/>
                      </a:lnTo>
                      <a:lnTo>
                        <a:pt x="165" y="109"/>
                      </a:lnTo>
                      <a:lnTo>
                        <a:pt x="164" y="109"/>
                      </a:lnTo>
                      <a:lnTo>
                        <a:pt x="162" y="109"/>
                      </a:lnTo>
                      <a:lnTo>
                        <a:pt x="161" y="108"/>
                      </a:lnTo>
                      <a:lnTo>
                        <a:pt x="159" y="108"/>
                      </a:lnTo>
                      <a:lnTo>
                        <a:pt x="159" y="107"/>
                      </a:lnTo>
                      <a:lnTo>
                        <a:pt x="158" y="107"/>
                      </a:lnTo>
                      <a:lnTo>
                        <a:pt x="157" y="107"/>
                      </a:lnTo>
                      <a:lnTo>
                        <a:pt x="155" y="105"/>
                      </a:lnTo>
                      <a:lnTo>
                        <a:pt x="154" y="105"/>
                      </a:lnTo>
                      <a:lnTo>
                        <a:pt x="152" y="104"/>
                      </a:lnTo>
                      <a:lnTo>
                        <a:pt x="151" y="104"/>
                      </a:lnTo>
                      <a:lnTo>
                        <a:pt x="149" y="104"/>
                      </a:lnTo>
                      <a:lnTo>
                        <a:pt x="148" y="102"/>
                      </a:lnTo>
                      <a:lnTo>
                        <a:pt x="146" y="102"/>
                      </a:lnTo>
                      <a:lnTo>
                        <a:pt x="145" y="101"/>
                      </a:lnTo>
                      <a:lnTo>
                        <a:pt x="144" y="101"/>
                      </a:lnTo>
                      <a:lnTo>
                        <a:pt x="142" y="101"/>
                      </a:lnTo>
                      <a:lnTo>
                        <a:pt x="141" y="99"/>
                      </a:lnTo>
                      <a:lnTo>
                        <a:pt x="139" y="99"/>
                      </a:lnTo>
                      <a:lnTo>
                        <a:pt x="139" y="98"/>
                      </a:lnTo>
                      <a:lnTo>
                        <a:pt x="138" y="98"/>
                      </a:lnTo>
                      <a:lnTo>
                        <a:pt x="136" y="97"/>
                      </a:lnTo>
                      <a:lnTo>
                        <a:pt x="135" y="97"/>
                      </a:lnTo>
                      <a:lnTo>
                        <a:pt x="134" y="97"/>
                      </a:lnTo>
                      <a:lnTo>
                        <a:pt x="132" y="95"/>
                      </a:lnTo>
                      <a:lnTo>
                        <a:pt x="131" y="95"/>
                      </a:lnTo>
                      <a:lnTo>
                        <a:pt x="129" y="94"/>
                      </a:lnTo>
                      <a:lnTo>
                        <a:pt x="128" y="94"/>
                      </a:lnTo>
                      <a:lnTo>
                        <a:pt x="126" y="92"/>
                      </a:lnTo>
                      <a:lnTo>
                        <a:pt x="125" y="92"/>
                      </a:lnTo>
                      <a:lnTo>
                        <a:pt x="124" y="91"/>
                      </a:lnTo>
                      <a:lnTo>
                        <a:pt x="124" y="91"/>
                      </a:lnTo>
                      <a:lnTo>
                        <a:pt x="122" y="89"/>
                      </a:lnTo>
                      <a:lnTo>
                        <a:pt x="121" y="89"/>
                      </a:lnTo>
                      <a:lnTo>
                        <a:pt x="119" y="88"/>
                      </a:lnTo>
                      <a:lnTo>
                        <a:pt x="118" y="88"/>
                      </a:lnTo>
                      <a:lnTo>
                        <a:pt x="116" y="88"/>
                      </a:lnTo>
                      <a:lnTo>
                        <a:pt x="115" y="86"/>
                      </a:lnTo>
                      <a:lnTo>
                        <a:pt x="113" y="86"/>
                      </a:lnTo>
                      <a:lnTo>
                        <a:pt x="112" y="85"/>
                      </a:lnTo>
                      <a:lnTo>
                        <a:pt x="111" y="85"/>
                      </a:lnTo>
                      <a:lnTo>
                        <a:pt x="111" y="84"/>
                      </a:lnTo>
                      <a:lnTo>
                        <a:pt x="109" y="84"/>
                      </a:lnTo>
                      <a:lnTo>
                        <a:pt x="108" y="82"/>
                      </a:lnTo>
                      <a:lnTo>
                        <a:pt x="106" y="82"/>
                      </a:lnTo>
                      <a:lnTo>
                        <a:pt x="105" y="81"/>
                      </a:lnTo>
                      <a:lnTo>
                        <a:pt x="103" y="81"/>
                      </a:lnTo>
                      <a:lnTo>
                        <a:pt x="102" y="79"/>
                      </a:lnTo>
                      <a:lnTo>
                        <a:pt x="101" y="79"/>
                      </a:lnTo>
                      <a:lnTo>
                        <a:pt x="99" y="78"/>
                      </a:lnTo>
                      <a:lnTo>
                        <a:pt x="99" y="78"/>
                      </a:lnTo>
                      <a:lnTo>
                        <a:pt x="98" y="76"/>
                      </a:lnTo>
                      <a:lnTo>
                        <a:pt x="96" y="76"/>
                      </a:lnTo>
                      <a:lnTo>
                        <a:pt x="95" y="75"/>
                      </a:lnTo>
                      <a:lnTo>
                        <a:pt x="93" y="74"/>
                      </a:lnTo>
                      <a:lnTo>
                        <a:pt x="92" y="74"/>
                      </a:lnTo>
                      <a:lnTo>
                        <a:pt x="91" y="72"/>
                      </a:lnTo>
                      <a:lnTo>
                        <a:pt x="89" y="72"/>
                      </a:lnTo>
                      <a:lnTo>
                        <a:pt x="89" y="71"/>
                      </a:lnTo>
                      <a:lnTo>
                        <a:pt x="88" y="71"/>
                      </a:lnTo>
                      <a:lnTo>
                        <a:pt x="86" y="69"/>
                      </a:lnTo>
                      <a:lnTo>
                        <a:pt x="85" y="69"/>
                      </a:lnTo>
                      <a:lnTo>
                        <a:pt x="83" y="68"/>
                      </a:lnTo>
                      <a:lnTo>
                        <a:pt x="82" y="68"/>
                      </a:lnTo>
                      <a:lnTo>
                        <a:pt x="81" y="66"/>
                      </a:lnTo>
                      <a:lnTo>
                        <a:pt x="81" y="66"/>
                      </a:lnTo>
                      <a:lnTo>
                        <a:pt x="79" y="65"/>
                      </a:lnTo>
                      <a:lnTo>
                        <a:pt x="78" y="64"/>
                      </a:lnTo>
                      <a:lnTo>
                        <a:pt x="76" y="64"/>
                      </a:lnTo>
                      <a:lnTo>
                        <a:pt x="75" y="62"/>
                      </a:lnTo>
                      <a:lnTo>
                        <a:pt x="73" y="62"/>
                      </a:lnTo>
                      <a:lnTo>
                        <a:pt x="72" y="61"/>
                      </a:lnTo>
                      <a:lnTo>
                        <a:pt x="72" y="61"/>
                      </a:lnTo>
                      <a:lnTo>
                        <a:pt x="70" y="59"/>
                      </a:lnTo>
                      <a:lnTo>
                        <a:pt x="69" y="58"/>
                      </a:lnTo>
                      <a:lnTo>
                        <a:pt x="68" y="58"/>
                      </a:lnTo>
                      <a:lnTo>
                        <a:pt x="66" y="56"/>
                      </a:lnTo>
                      <a:lnTo>
                        <a:pt x="65" y="56"/>
                      </a:lnTo>
                      <a:lnTo>
                        <a:pt x="65" y="55"/>
                      </a:lnTo>
                      <a:lnTo>
                        <a:pt x="63" y="53"/>
                      </a:lnTo>
                      <a:lnTo>
                        <a:pt x="62" y="53"/>
                      </a:lnTo>
                      <a:lnTo>
                        <a:pt x="60" y="52"/>
                      </a:lnTo>
                      <a:lnTo>
                        <a:pt x="59" y="52"/>
                      </a:lnTo>
                      <a:lnTo>
                        <a:pt x="58" y="51"/>
                      </a:lnTo>
                      <a:lnTo>
                        <a:pt x="58" y="49"/>
                      </a:lnTo>
                      <a:lnTo>
                        <a:pt x="56" y="49"/>
                      </a:lnTo>
                      <a:lnTo>
                        <a:pt x="55" y="48"/>
                      </a:lnTo>
                      <a:lnTo>
                        <a:pt x="53" y="48"/>
                      </a:lnTo>
                      <a:lnTo>
                        <a:pt x="52" y="46"/>
                      </a:lnTo>
                      <a:lnTo>
                        <a:pt x="52" y="45"/>
                      </a:lnTo>
                      <a:lnTo>
                        <a:pt x="50" y="45"/>
                      </a:lnTo>
                      <a:lnTo>
                        <a:pt x="49" y="43"/>
                      </a:lnTo>
                      <a:lnTo>
                        <a:pt x="48" y="43"/>
                      </a:lnTo>
                      <a:lnTo>
                        <a:pt x="46" y="42"/>
                      </a:lnTo>
                      <a:lnTo>
                        <a:pt x="46" y="41"/>
                      </a:lnTo>
                      <a:lnTo>
                        <a:pt x="45" y="41"/>
                      </a:lnTo>
                      <a:lnTo>
                        <a:pt x="43" y="39"/>
                      </a:lnTo>
                      <a:lnTo>
                        <a:pt x="42" y="38"/>
                      </a:lnTo>
                      <a:lnTo>
                        <a:pt x="40" y="38"/>
                      </a:lnTo>
                      <a:lnTo>
                        <a:pt x="40" y="36"/>
                      </a:lnTo>
                      <a:lnTo>
                        <a:pt x="39" y="35"/>
                      </a:lnTo>
                      <a:lnTo>
                        <a:pt x="37" y="35"/>
                      </a:lnTo>
                      <a:lnTo>
                        <a:pt x="36" y="33"/>
                      </a:lnTo>
                      <a:lnTo>
                        <a:pt x="35" y="33"/>
                      </a:lnTo>
                      <a:lnTo>
                        <a:pt x="35" y="32"/>
                      </a:lnTo>
                      <a:lnTo>
                        <a:pt x="33" y="31"/>
                      </a:lnTo>
                      <a:lnTo>
                        <a:pt x="32" y="31"/>
                      </a:lnTo>
                      <a:lnTo>
                        <a:pt x="30" y="29"/>
                      </a:lnTo>
                      <a:lnTo>
                        <a:pt x="29" y="28"/>
                      </a:lnTo>
                      <a:lnTo>
                        <a:pt x="29" y="28"/>
                      </a:lnTo>
                      <a:lnTo>
                        <a:pt x="27" y="26"/>
                      </a:lnTo>
                      <a:lnTo>
                        <a:pt x="26" y="25"/>
                      </a:lnTo>
                      <a:lnTo>
                        <a:pt x="25" y="25"/>
                      </a:lnTo>
                      <a:lnTo>
                        <a:pt x="25" y="23"/>
                      </a:lnTo>
                      <a:lnTo>
                        <a:pt x="23" y="22"/>
                      </a:lnTo>
                      <a:lnTo>
                        <a:pt x="22" y="22"/>
                      </a:lnTo>
                      <a:lnTo>
                        <a:pt x="20" y="20"/>
                      </a:lnTo>
                      <a:lnTo>
                        <a:pt x="20" y="19"/>
                      </a:lnTo>
                      <a:lnTo>
                        <a:pt x="19" y="18"/>
                      </a:lnTo>
                      <a:lnTo>
                        <a:pt x="17" y="18"/>
                      </a:lnTo>
                      <a:lnTo>
                        <a:pt x="16" y="16"/>
                      </a:lnTo>
                      <a:lnTo>
                        <a:pt x="16" y="15"/>
                      </a:lnTo>
                      <a:lnTo>
                        <a:pt x="15" y="15"/>
                      </a:lnTo>
                      <a:lnTo>
                        <a:pt x="13" y="13"/>
                      </a:lnTo>
                      <a:lnTo>
                        <a:pt x="12" y="12"/>
                      </a:lnTo>
                      <a:lnTo>
                        <a:pt x="12" y="12"/>
                      </a:lnTo>
                      <a:lnTo>
                        <a:pt x="10" y="10"/>
                      </a:lnTo>
                      <a:lnTo>
                        <a:pt x="9" y="9"/>
                      </a:lnTo>
                      <a:lnTo>
                        <a:pt x="7" y="9"/>
                      </a:lnTo>
                      <a:lnTo>
                        <a:pt x="7" y="8"/>
                      </a:lnTo>
                      <a:lnTo>
                        <a:pt x="6" y="6"/>
                      </a:lnTo>
                      <a:lnTo>
                        <a:pt x="4" y="5"/>
                      </a:lnTo>
                      <a:lnTo>
                        <a:pt x="3" y="5"/>
                      </a:lnTo>
                      <a:lnTo>
                        <a:pt x="3" y="3"/>
                      </a:lnTo>
                      <a:lnTo>
                        <a:pt x="2" y="2"/>
                      </a:lnTo>
                      <a:lnTo>
                        <a:pt x="0" y="2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3" name="Rectangle 288"/>
                <p:cNvSpPr>
                  <a:spLocks noChangeArrowheads="1"/>
                </p:cNvSpPr>
                <p:nvPr/>
              </p:nvSpPr>
              <p:spPr bwMode="auto">
                <a:xfrm rot="17100000">
                  <a:off x="3733" y="2489"/>
                  <a:ext cx="72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80</a:t>
                  </a:r>
                </a:p>
              </p:txBody>
            </p:sp>
            <p:sp>
              <p:nvSpPr>
                <p:cNvPr id="104" name="Line 289"/>
                <p:cNvSpPr>
                  <a:spLocks noChangeShapeType="1"/>
                </p:cNvSpPr>
                <p:nvPr/>
              </p:nvSpPr>
              <p:spPr bwMode="auto">
                <a:xfrm flipH="1">
                  <a:off x="3675" y="2523"/>
                  <a:ext cx="16" cy="60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5" name="Rectangle 290"/>
                <p:cNvSpPr>
                  <a:spLocks noChangeArrowheads="1"/>
                </p:cNvSpPr>
                <p:nvPr/>
              </p:nvSpPr>
              <p:spPr bwMode="auto">
                <a:xfrm rot="19560000">
                  <a:off x="1912" y="3222"/>
                  <a:ext cx="315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NM-A16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6" name="Line 291"/>
                <p:cNvSpPr>
                  <a:spLocks noChangeShapeType="1"/>
                </p:cNvSpPr>
                <p:nvPr/>
              </p:nvSpPr>
              <p:spPr bwMode="auto">
                <a:xfrm flipH="1">
                  <a:off x="2367" y="3035"/>
                  <a:ext cx="52" cy="34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7" name="Rectangle 292"/>
                <p:cNvSpPr>
                  <a:spLocks noChangeArrowheads="1"/>
                </p:cNvSpPr>
                <p:nvPr/>
              </p:nvSpPr>
              <p:spPr bwMode="auto">
                <a:xfrm rot="19860000">
                  <a:off x="1814" y="3068"/>
                  <a:ext cx="335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LAIM-A17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8" name="Line 293"/>
                <p:cNvSpPr>
                  <a:spLocks noChangeShapeType="1"/>
                </p:cNvSpPr>
                <p:nvPr/>
              </p:nvSpPr>
              <p:spPr bwMode="auto">
                <a:xfrm flipH="1">
                  <a:off x="2291" y="2913"/>
                  <a:ext cx="55" cy="30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9" name="Freeform 294"/>
                <p:cNvSpPr/>
                <p:nvPr/>
              </p:nvSpPr>
              <p:spPr bwMode="auto">
                <a:xfrm>
                  <a:off x="2385" y="2973"/>
                  <a:ext cx="37" cy="59"/>
                </a:xfrm>
                <a:custGeom>
                  <a:avLst/>
                  <a:gdLst>
                    <a:gd name="T0" fmla="*/ 0 w 37"/>
                    <a:gd name="T1" fmla="*/ 0 h 59"/>
                    <a:gd name="T2" fmla="*/ 1 w 37"/>
                    <a:gd name="T3" fmla="*/ 3 h 59"/>
                    <a:gd name="T4" fmla="*/ 4 w 37"/>
                    <a:gd name="T5" fmla="*/ 7 h 59"/>
                    <a:gd name="T6" fmla="*/ 5 w 37"/>
                    <a:gd name="T7" fmla="*/ 10 h 59"/>
                    <a:gd name="T8" fmla="*/ 8 w 37"/>
                    <a:gd name="T9" fmla="*/ 14 h 59"/>
                    <a:gd name="T10" fmla="*/ 10 w 37"/>
                    <a:gd name="T11" fmla="*/ 17 h 59"/>
                    <a:gd name="T12" fmla="*/ 12 w 37"/>
                    <a:gd name="T13" fmla="*/ 20 h 59"/>
                    <a:gd name="T14" fmla="*/ 14 w 37"/>
                    <a:gd name="T15" fmla="*/ 24 h 59"/>
                    <a:gd name="T16" fmla="*/ 17 w 37"/>
                    <a:gd name="T17" fmla="*/ 27 h 59"/>
                    <a:gd name="T18" fmla="*/ 18 w 37"/>
                    <a:gd name="T19" fmla="*/ 32 h 59"/>
                    <a:gd name="T20" fmla="*/ 21 w 37"/>
                    <a:gd name="T21" fmla="*/ 34 h 59"/>
                    <a:gd name="T22" fmla="*/ 24 w 37"/>
                    <a:gd name="T23" fmla="*/ 39 h 59"/>
                    <a:gd name="T24" fmla="*/ 25 w 37"/>
                    <a:gd name="T25" fmla="*/ 42 h 59"/>
                    <a:gd name="T26" fmla="*/ 28 w 37"/>
                    <a:gd name="T27" fmla="*/ 46 h 59"/>
                    <a:gd name="T28" fmla="*/ 30 w 37"/>
                    <a:gd name="T29" fmla="*/ 49 h 59"/>
                    <a:gd name="T30" fmla="*/ 33 w 37"/>
                    <a:gd name="T31" fmla="*/ 53 h 59"/>
                    <a:gd name="T32" fmla="*/ 35 w 37"/>
                    <a:gd name="T33" fmla="*/ 56 h 59"/>
                    <a:gd name="T34" fmla="*/ 37 w 37"/>
                    <a:gd name="T35" fmla="*/ 59 h 5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37" h="59">
                      <a:moveTo>
                        <a:pt x="0" y="0"/>
                      </a:moveTo>
                      <a:lnTo>
                        <a:pt x="1" y="3"/>
                      </a:lnTo>
                      <a:lnTo>
                        <a:pt x="4" y="7"/>
                      </a:lnTo>
                      <a:lnTo>
                        <a:pt x="5" y="10"/>
                      </a:lnTo>
                      <a:lnTo>
                        <a:pt x="8" y="14"/>
                      </a:lnTo>
                      <a:lnTo>
                        <a:pt x="10" y="17"/>
                      </a:lnTo>
                      <a:lnTo>
                        <a:pt x="12" y="20"/>
                      </a:lnTo>
                      <a:lnTo>
                        <a:pt x="14" y="24"/>
                      </a:lnTo>
                      <a:lnTo>
                        <a:pt x="17" y="27"/>
                      </a:lnTo>
                      <a:lnTo>
                        <a:pt x="18" y="32"/>
                      </a:lnTo>
                      <a:lnTo>
                        <a:pt x="21" y="34"/>
                      </a:lnTo>
                      <a:lnTo>
                        <a:pt x="24" y="39"/>
                      </a:lnTo>
                      <a:lnTo>
                        <a:pt x="25" y="42"/>
                      </a:lnTo>
                      <a:lnTo>
                        <a:pt x="28" y="46"/>
                      </a:lnTo>
                      <a:lnTo>
                        <a:pt x="30" y="49"/>
                      </a:lnTo>
                      <a:lnTo>
                        <a:pt x="33" y="53"/>
                      </a:lnTo>
                      <a:lnTo>
                        <a:pt x="35" y="56"/>
                      </a:lnTo>
                      <a:lnTo>
                        <a:pt x="37" y="59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0" name="Freeform 295"/>
                <p:cNvSpPr/>
                <p:nvPr/>
              </p:nvSpPr>
              <p:spPr bwMode="auto">
                <a:xfrm>
                  <a:off x="2349" y="2911"/>
                  <a:ext cx="36" cy="62"/>
                </a:xfrm>
                <a:custGeom>
                  <a:avLst/>
                  <a:gdLst>
                    <a:gd name="T0" fmla="*/ 36 w 36"/>
                    <a:gd name="T1" fmla="*/ 62 h 62"/>
                    <a:gd name="T2" fmla="*/ 33 w 36"/>
                    <a:gd name="T3" fmla="*/ 58 h 62"/>
                    <a:gd name="T4" fmla="*/ 31 w 36"/>
                    <a:gd name="T5" fmla="*/ 53 h 62"/>
                    <a:gd name="T6" fmla="*/ 28 w 36"/>
                    <a:gd name="T7" fmla="*/ 51 h 62"/>
                    <a:gd name="T8" fmla="*/ 26 w 36"/>
                    <a:gd name="T9" fmla="*/ 46 h 62"/>
                    <a:gd name="T10" fmla="*/ 24 w 36"/>
                    <a:gd name="T11" fmla="*/ 42 h 62"/>
                    <a:gd name="T12" fmla="*/ 21 w 36"/>
                    <a:gd name="T13" fmla="*/ 39 h 62"/>
                    <a:gd name="T14" fmla="*/ 20 w 36"/>
                    <a:gd name="T15" fmla="*/ 35 h 62"/>
                    <a:gd name="T16" fmla="*/ 17 w 36"/>
                    <a:gd name="T17" fmla="*/ 30 h 62"/>
                    <a:gd name="T18" fmla="*/ 15 w 36"/>
                    <a:gd name="T19" fmla="*/ 28 h 62"/>
                    <a:gd name="T20" fmla="*/ 13 w 36"/>
                    <a:gd name="T21" fmla="*/ 23 h 62"/>
                    <a:gd name="T22" fmla="*/ 11 w 36"/>
                    <a:gd name="T23" fmla="*/ 19 h 62"/>
                    <a:gd name="T24" fmla="*/ 8 w 36"/>
                    <a:gd name="T25" fmla="*/ 15 h 62"/>
                    <a:gd name="T26" fmla="*/ 7 w 36"/>
                    <a:gd name="T27" fmla="*/ 12 h 62"/>
                    <a:gd name="T28" fmla="*/ 4 w 36"/>
                    <a:gd name="T29" fmla="*/ 8 h 62"/>
                    <a:gd name="T30" fmla="*/ 3 w 36"/>
                    <a:gd name="T31" fmla="*/ 3 h 62"/>
                    <a:gd name="T32" fmla="*/ 0 w 36"/>
                    <a:gd name="T33" fmla="*/ 0 h 6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</a:cxnLst>
                  <a:rect l="0" t="0" r="r" b="b"/>
                  <a:pathLst>
                    <a:path w="36" h="62">
                      <a:moveTo>
                        <a:pt x="36" y="62"/>
                      </a:moveTo>
                      <a:lnTo>
                        <a:pt x="33" y="58"/>
                      </a:lnTo>
                      <a:lnTo>
                        <a:pt x="31" y="53"/>
                      </a:lnTo>
                      <a:lnTo>
                        <a:pt x="28" y="51"/>
                      </a:lnTo>
                      <a:lnTo>
                        <a:pt x="26" y="46"/>
                      </a:lnTo>
                      <a:lnTo>
                        <a:pt x="24" y="42"/>
                      </a:lnTo>
                      <a:lnTo>
                        <a:pt x="21" y="39"/>
                      </a:lnTo>
                      <a:lnTo>
                        <a:pt x="20" y="35"/>
                      </a:lnTo>
                      <a:lnTo>
                        <a:pt x="17" y="30"/>
                      </a:lnTo>
                      <a:lnTo>
                        <a:pt x="15" y="28"/>
                      </a:lnTo>
                      <a:lnTo>
                        <a:pt x="13" y="23"/>
                      </a:lnTo>
                      <a:lnTo>
                        <a:pt x="11" y="19"/>
                      </a:lnTo>
                      <a:lnTo>
                        <a:pt x="8" y="15"/>
                      </a:lnTo>
                      <a:lnTo>
                        <a:pt x="7" y="12"/>
                      </a:lnTo>
                      <a:lnTo>
                        <a:pt x="4" y="8"/>
                      </a:lnTo>
                      <a:lnTo>
                        <a:pt x="3" y="3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2" name="Line 297"/>
                <p:cNvSpPr>
                  <a:spLocks noChangeShapeType="1"/>
                </p:cNvSpPr>
                <p:nvPr/>
              </p:nvSpPr>
              <p:spPr bwMode="auto">
                <a:xfrm flipH="1">
                  <a:off x="2387" y="2939"/>
                  <a:ext cx="53" cy="33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3" name="Rectangle 298"/>
                <p:cNvSpPr>
                  <a:spLocks noChangeArrowheads="1"/>
                </p:cNvSpPr>
                <p:nvPr/>
              </p:nvSpPr>
              <p:spPr bwMode="auto">
                <a:xfrm rot="20160000">
                  <a:off x="1770" y="2903"/>
                  <a:ext cx="299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YLK-A16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4" name="Line 299"/>
                <p:cNvSpPr>
                  <a:spLocks noChangeShapeType="1"/>
                </p:cNvSpPr>
                <p:nvPr/>
              </p:nvSpPr>
              <p:spPr bwMode="auto">
                <a:xfrm flipH="1">
                  <a:off x="2227" y="2785"/>
                  <a:ext cx="57" cy="24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5" name="Rectangle 300"/>
                <p:cNvSpPr>
                  <a:spLocks noChangeArrowheads="1"/>
                </p:cNvSpPr>
                <p:nvPr/>
              </p:nvSpPr>
              <p:spPr bwMode="auto">
                <a:xfrm rot="20460000">
                  <a:off x="1755" y="2728"/>
                  <a:ext cx="230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S-A16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6" name="Line 301"/>
                <p:cNvSpPr>
                  <a:spLocks noChangeShapeType="1"/>
                </p:cNvSpPr>
                <p:nvPr/>
              </p:nvSpPr>
              <p:spPr bwMode="auto">
                <a:xfrm flipH="1">
                  <a:off x="2172" y="2652"/>
                  <a:ext cx="61" cy="20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7" name="Freeform 302"/>
                <p:cNvSpPr/>
                <p:nvPr/>
              </p:nvSpPr>
              <p:spPr bwMode="auto">
                <a:xfrm>
                  <a:off x="2260" y="2718"/>
                  <a:ext cx="27" cy="66"/>
                </a:xfrm>
                <a:custGeom>
                  <a:avLst/>
                  <a:gdLst>
                    <a:gd name="T0" fmla="*/ 0 w 27"/>
                    <a:gd name="T1" fmla="*/ 0 h 66"/>
                    <a:gd name="T2" fmla="*/ 1 w 27"/>
                    <a:gd name="T3" fmla="*/ 4 h 66"/>
                    <a:gd name="T4" fmla="*/ 3 w 27"/>
                    <a:gd name="T5" fmla="*/ 8 h 66"/>
                    <a:gd name="T6" fmla="*/ 4 w 27"/>
                    <a:gd name="T7" fmla="*/ 11 h 66"/>
                    <a:gd name="T8" fmla="*/ 6 w 27"/>
                    <a:gd name="T9" fmla="*/ 15 h 66"/>
                    <a:gd name="T10" fmla="*/ 7 w 27"/>
                    <a:gd name="T11" fmla="*/ 20 h 66"/>
                    <a:gd name="T12" fmla="*/ 10 w 27"/>
                    <a:gd name="T13" fmla="*/ 24 h 66"/>
                    <a:gd name="T14" fmla="*/ 11 w 27"/>
                    <a:gd name="T15" fmla="*/ 28 h 66"/>
                    <a:gd name="T16" fmla="*/ 13 w 27"/>
                    <a:gd name="T17" fmla="*/ 33 h 66"/>
                    <a:gd name="T18" fmla="*/ 14 w 27"/>
                    <a:gd name="T19" fmla="*/ 37 h 66"/>
                    <a:gd name="T20" fmla="*/ 16 w 27"/>
                    <a:gd name="T21" fmla="*/ 41 h 66"/>
                    <a:gd name="T22" fmla="*/ 17 w 27"/>
                    <a:gd name="T23" fmla="*/ 44 h 66"/>
                    <a:gd name="T24" fmla="*/ 20 w 27"/>
                    <a:gd name="T25" fmla="*/ 48 h 66"/>
                    <a:gd name="T26" fmla="*/ 21 w 27"/>
                    <a:gd name="T27" fmla="*/ 53 h 66"/>
                    <a:gd name="T28" fmla="*/ 23 w 27"/>
                    <a:gd name="T29" fmla="*/ 57 h 66"/>
                    <a:gd name="T30" fmla="*/ 24 w 27"/>
                    <a:gd name="T31" fmla="*/ 61 h 66"/>
                    <a:gd name="T32" fmla="*/ 27 w 27"/>
                    <a:gd name="T33" fmla="*/ 66 h 6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</a:cxnLst>
                  <a:rect l="0" t="0" r="r" b="b"/>
                  <a:pathLst>
                    <a:path w="27" h="66">
                      <a:moveTo>
                        <a:pt x="0" y="0"/>
                      </a:moveTo>
                      <a:lnTo>
                        <a:pt x="1" y="4"/>
                      </a:lnTo>
                      <a:lnTo>
                        <a:pt x="3" y="8"/>
                      </a:lnTo>
                      <a:lnTo>
                        <a:pt x="4" y="11"/>
                      </a:lnTo>
                      <a:lnTo>
                        <a:pt x="6" y="15"/>
                      </a:lnTo>
                      <a:lnTo>
                        <a:pt x="7" y="20"/>
                      </a:lnTo>
                      <a:lnTo>
                        <a:pt x="10" y="24"/>
                      </a:lnTo>
                      <a:lnTo>
                        <a:pt x="11" y="28"/>
                      </a:lnTo>
                      <a:lnTo>
                        <a:pt x="13" y="33"/>
                      </a:lnTo>
                      <a:lnTo>
                        <a:pt x="14" y="37"/>
                      </a:lnTo>
                      <a:lnTo>
                        <a:pt x="16" y="41"/>
                      </a:lnTo>
                      <a:lnTo>
                        <a:pt x="17" y="44"/>
                      </a:lnTo>
                      <a:lnTo>
                        <a:pt x="20" y="48"/>
                      </a:lnTo>
                      <a:lnTo>
                        <a:pt x="21" y="53"/>
                      </a:lnTo>
                      <a:lnTo>
                        <a:pt x="23" y="57"/>
                      </a:lnTo>
                      <a:lnTo>
                        <a:pt x="24" y="61"/>
                      </a:lnTo>
                      <a:lnTo>
                        <a:pt x="27" y="66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8" name="Freeform 303"/>
                <p:cNvSpPr/>
                <p:nvPr/>
              </p:nvSpPr>
              <p:spPr bwMode="auto">
                <a:xfrm>
                  <a:off x="2235" y="2650"/>
                  <a:ext cx="25" cy="68"/>
                </a:xfrm>
                <a:custGeom>
                  <a:avLst/>
                  <a:gdLst>
                    <a:gd name="T0" fmla="*/ 25 w 25"/>
                    <a:gd name="T1" fmla="*/ 68 h 68"/>
                    <a:gd name="T2" fmla="*/ 22 w 25"/>
                    <a:gd name="T3" fmla="*/ 63 h 68"/>
                    <a:gd name="T4" fmla="*/ 21 w 25"/>
                    <a:gd name="T5" fmla="*/ 59 h 68"/>
                    <a:gd name="T6" fmla="*/ 19 w 25"/>
                    <a:gd name="T7" fmla="*/ 55 h 68"/>
                    <a:gd name="T8" fmla="*/ 18 w 25"/>
                    <a:gd name="T9" fmla="*/ 49 h 68"/>
                    <a:gd name="T10" fmla="*/ 16 w 25"/>
                    <a:gd name="T11" fmla="*/ 45 h 68"/>
                    <a:gd name="T12" fmla="*/ 15 w 25"/>
                    <a:gd name="T13" fmla="*/ 40 h 68"/>
                    <a:gd name="T14" fmla="*/ 13 w 25"/>
                    <a:gd name="T15" fmla="*/ 36 h 68"/>
                    <a:gd name="T16" fmla="*/ 10 w 25"/>
                    <a:gd name="T17" fmla="*/ 32 h 68"/>
                    <a:gd name="T18" fmla="*/ 9 w 25"/>
                    <a:gd name="T19" fmla="*/ 27 h 68"/>
                    <a:gd name="T20" fmla="*/ 8 w 25"/>
                    <a:gd name="T21" fmla="*/ 23 h 68"/>
                    <a:gd name="T22" fmla="*/ 6 w 25"/>
                    <a:gd name="T23" fmla="*/ 19 h 68"/>
                    <a:gd name="T24" fmla="*/ 5 w 25"/>
                    <a:gd name="T25" fmla="*/ 15 h 68"/>
                    <a:gd name="T26" fmla="*/ 3 w 25"/>
                    <a:gd name="T27" fmla="*/ 10 h 68"/>
                    <a:gd name="T28" fmla="*/ 2 w 25"/>
                    <a:gd name="T29" fmla="*/ 5 h 68"/>
                    <a:gd name="T30" fmla="*/ 0 w 25"/>
                    <a:gd name="T31" fmla="*/ 0 h 6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</a:cxnLst>
                  <a:rect l="0" t="0" r="r" b="b"/>
                  <a:pathLst>
                    <a:path w="25" h="68">
                      <a:moveTo>
                        <a:pt x="25" y="68"/>
                      </a:moveTo>
                      <a:lnTo>
                        <a:pt x="22" y="63"/>
                      </a:lnTo>
                      <a:lnTo>
                        <a:pt x="21" y="59"/>
                      </a:lnTo>
                      <a:lnTo>
                        <a:pt x="19" y="55"/>
                      </a:lnTo>
                      <a:lnTo>
                        <a:pt x="18" y="49"/>
                      </a:lnTo>
                      <a:lnTo>
                        <a:pt x="16" y="45"/>
                      </a:lnTo>
                      <a:lnTo>
                        <a:pt x="15" y="40"/>
                      </a:lnTo>
                      <a:lnTo>
                        <a:pt x="13" y="36"/>
                      </a:lnTo>
                      <a:lnTo>
                        <a:pt x="10" y="32"/>
                      </a:lnTo>
                      <a:lnTo>
                        <a:pt x="9" y="27"/>
                      </a:lnTo>
                      <a:lnTo>
                        <a:pt x="8" y="23"/>
                      </a:lnTo>
                      <a:lnTo>
                        <a:pt x="6" y="19"/>
                      </a:lnTo>
                      <a:lnTo>
                        <a:pt x="5" y="15"/>
                      </a:lnTo>
                      <a:lnTo>
                        <a:pt x="3" y="10"/>
                      </a:lnTo>
                      <a:lnTo>
                        <a:pt x="2" y="5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0" name="Line 305"/>
                <p:cNvSpPr>
                  <a:spLocks noChangeShapeType="1"/>
                </p:cNvSpPr>
                <p:nvPr/>
              </p:nvSpPr>
              <p:spPr bwMode="auto">
                <a:xfrm flipH="1">
                  <a:off x="2263" y="2693"/>
                  <a:ext cx="58" cy="23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1" name="Freeform 306"/>
                <p:cNvSpPr/>
                <p:nvPr/>
              </p:nvSpPr>
              <p:spPr bwMode="auto">
                <a:xfrm>
                  <a:off x="2377" y="2817"/>
                  <a:ext cx="66" cy="120"/>
                </a:xfrm>
                <a:custGeom>
                  <a:avLst/>
                  <a:gdLst>
                    <a:gd name="T0" fmla="*/ 0 w 66"/>
                    <a:gd name="T1" fmla="*/ 0 h 120"/>
                    <a:gd name="T2" fmla="*/ 3 w 66"/>
                    <a:gd name="T3" fmla="*/ 5 h 120"/>
                    <a:gd name="T4" fmla="*/ 6 w 66"/>
                    <a:gd name="T5" fmla="*/ 10 h 120"/>
                    <a:gd name="T6" fmla="*/ 8 w 66"/>
                    <a:gd name="T7" fmla="*/ 14 h 120"/>
                    <a:gd name="T8" fmla="*/ 10 w 66"/>
                    <a:gd name="T9" fmla="*/ 18 h 120"/>
                    <a:gd name="T10" fmla="*/ 12 w 66"/>
                    <a:gd name="T11" fmla="*/ 23 h 120"/>
                    <a:gd name="T12" fmla="*/ 15 w 66"/>
                    <a:gd name="T13" fmla="*/ 27 h 120"/>
                    <a:gd name="T14" fmla="*/ 18 w 66"/>
                    <a:gd name="T15" fmla="*/ 31 h 120"/>
                    <a:gd name="T16" fmla="*/ 19 w 66"/>
                    <a:gd name="T17" fmla="*/ 37 h 120"/>
                    <a:gd name="T18" fmla="*/ 22 w 66"/>
                    <a:gd name="T19" fmla="*/ 41 h 120"/>
                    <a:gd name="T20" fmla="*/ 23 w 66"/>
                    <a:gd name="T21" fmla="*/ 46 h 120"/>
                    <a:gd name="T22" fmla="*/ 26 w 66"/>
                    <a:gd name="T23" fmla="*/ 50 h 120"/>
                    <a:gd name="T24" fmla="*/ 29 w 66"/>
                    <a:gd name="T25" fmla="*/ 54 h 120"/>
                    <a:gd name="T26" fmla="*/ 31 w 66"/>
                    <a:gd name="T27" fmla="*/ 58 h 120"/>
                    <a:gd name="T28" fmla="*/ 33 w 66"/>
                    <a:gd name="T29" fmla="*/ 63 h 120"/>
                    <a:gd name="T30" fmla="*/ 36 w 66"/>
                    <a:gd name="T31" fmla="*/ 67 h 120"/>
                    <a:gd name="T32" fmla="*/ 38 w 66"/>
                    <a:gd name="T33" fmla="*/ 71 h 120"/>
                    <a:gd name="T34" fmla="*/ 41 w 66"/>
                    <a:gd name="T35" fmla="*/ 76 h 120"/>
                    <a:gd name="T36" fmla="*/ 43 w 66"/>
                    <a:gd name="T37" fmla="*/ 80 h 120"/>
                    <a:gd name="T38" fmla="*/ 46 w 66"/>
                    <a:gd name="T39" fmla="*/ 86 h 120"/>
                    <a:gd name="T40" fmla="*/ 48 w 66"/>
                    <a:gd name="T41" fmla="*/ 90 h 120"/>
                    <a:gd name="T42" fmla="*/ 51 w 66"/>
                    <a:gd name="T43" fmla="*/ 94 h 120"/>
                    <a:gd name="T44" fmla="*/ 53 w 66"/>
                    <a:gd name="T45" fmla="*/ 99 h 120"/>
                    <a:gd name="T46" fmla="*/ 56 w 66"/>
                    <a:gd name="T47" fmla="*/ 103 h 120"/>
                    <a:gd name="T48" fmla="*/ 58 w 66"/>
                    <a:gd name="T49" fmla="*/ 107 h 120"/>
                    <a:gd name="T50" fmla="*/ 61 w 66"/>
                    <a:gd name="T51" fmla="*/ 112 h 120"/>
                    <a:gd name="T52" fmla="*/ 63 w 66"/>
                    <a:gd name="T53" fmla="*/ 116 h 120"/>
                    <a:gd name="T54" fmla="*/ 66 w 66"/>
                    <a:gd name="T55" fmla="*/ 120 h 12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</a:cxnLst>
                  <a:rect l="0" t="0" r="r" b="b"/>
                  <a:pathLst>
                    <a:path w="66" h="120">
                      <a:moveTo>
                        <a:pt x="0" y="0"/>
                      </a:moveTo>
                      <a:lnTo>
                        <a:pt x="3" y="5"/>
                      </a:lnTo>
                      <a:lnTo>
                        <a:pt x="6" y="10"/>
                      </a:lnTo>
                      <a:lnTo>
                        <a:pt x="8" y="14"/>
                      </a:lnTo>
                      <a:lnTo>
                        <a:pt x="10" y="18"/>
                      </a:lnTo>
                      <a:lnTo>
                        <a:pt x="12" y="23"/>
                      </a:lnTo>
                      <a:lnTo>
                        <a:pt x="15" y="27"/>
                      </a:lnTo>
                      <a:lnTo>
                        <a:pt x="18" y="31"/>
                      </a:lnTo>
                      <a:lnTo>
                        <a:pt x="19" y="37"/>
                      </a:lnTo>
                      <a:lnTo>
                        <a:pt x="22" y="41"/>
                      </a:lnTo>
                      <a:lnTo>
                        <a:pt x="23" y="46"/>
                      </a:lnTo>
                      <a:lnTo>
                        <a:pt x="26" y="50"/>
                      </a:lnTo>
                      <a:lnTo>
                        <a:pt x="29" y="54"/>
                      </a:lnTo>
                      <a:lnTo>
                        <a:pt x="31" y="58"/>
                      </a:lnTo>
                      <a:lnTo>
                        <a:pt x="33" y="63"/>
                      </a:lnTo>
                      <a:lnTo>
                        <a:pt x="36" y="67"/>
                      </a:lnTo>
                      <a:lnTo>
                        <a:pt x="38" y="71"/>
                      </a:lnTo>
                      <a:lnTo>
                        <a:pt x="41" y="76"/>
                      </a:lnTo>
                      <a:lnTo>
                        <a:pt x="43" y="80"/>
                      </a:lnTo>
                      <a:lnTo>
                        <a:pt x="46" y="86"/>
                      </a:lnTo>
                      <a:lnTo>
                        <a:pt x="48" y="90"/>
                      </a:lnTo>
                      <a:lnTo>
                        <a:pt x="51" y="94"/>
                      </a:lnTo>
                      <a:lnTo>
                        <a:pt x="53" y="99"/>
                      </a:lnTo>
                      <a:lnTo>
                        <a:pt x="56" y="103"/>
                      </a:lnTo>
                      <a:lnTo>
                        <a:pt x="58" y="107"/>
                      </a:lnTo>
                      <a:lnTo>
                        <a:pt x="61" y="112"/>
                      </a:lnTo>
                      <a:lnTo>
                        <a:pt x="63" y="116"/>
                      </a:lnTo>
                      <a:lnTo>
                        <a:pt x="66" y="12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2" name="Freeform 307"/>
                <p:cNvSpPr/>
                <p:nvPr/>
              </p:nvSpPr>
              <p:spPr bwMode="auto">
                <a:xfrm>
                  <a:off x="2323" y="2693"/>
                  <a:ext cx="54" cy="124"/>
                </a:xfrm>
                <a:custGeom>
                  <a:avLst/>
                  <a:gdLst>
                    <a:gd name="T0" fmla="*/ 54 w 54"/>
                    <a:gd name="T1" fmla="*/ 124 h 124"/>
                    <a:gd name="T2" fmla="*/ 52 w 54"/>
                    <a:gd name="T3" fmla="*/ 118 h 124"/>
                    <a:gd name="T4" fmla="*/ 49 w 54"/>
                    <a:gd name="T5" fmla="*/ 112 h 124"/>
                    <a:gd name="T6" fmla="*/ 46 w 54"/>
                    <a:gd name="T7" fmla="*/ 106 h 124"/>
                    <a:gd name="T8" fmla="*/ 43 w 54"/>
                    <a:gd name="T9" fmla="*/ 99 h 124"/>
                    <a:gd name="T10" fmla="*/ 40 w 54"/>
                    <a:gd name="T11" fmla="*/ 94 h 124"/>
                    <a:gd name="T12" fmla="*/ 37 w 54"/>
                    <a:gd name="T13" fmla="*/ 88 h 124"/>
                    <a:gd name="T14" fmla="*/ 34 w 54"/>
                    <a:gd name="T15" fmla="*/ 81 h 124"/>
                    <a:gd name="T16" fmla="*/ 31 w 54"/>
                    <a:gd name="T17" fmla="*/ 75 h 124"/>
                    <a:gd name="T18" fmla="*/ 29 w 54"/>
                    <a:gd name="T19" fmla="*/ 69 h 124"/>
                    <a:gd name="T20" fmla="*/ 27 w 54"/>
                    <a:gd name="T21" fmla="*/ 62 h 124"/>
                    <a:gd name="T22" fmla="*/ 24 w 54"/>
                    <a:gd name="T23" fmla="*/ 56 h 124"/>
                    <a:gd name="T24" fmla="*/ 21 w 54"/>
                    <a:gd name="T25" fmla="*/ 50 h 124"/>
                    <a:gd name="T26" fmla="*/ 19 w 54"/>
                    <a:gd name="T27" fmla="*/ 43 h 124"/>
                    <a:gd name="T28" fmla="*/ 16 w 54"/>
                    <a:gd name="T29" fmla="*/ 38 h 124"/>
                    <a:gd name="T30" fmla="*/ 13 w 54"/>
                    <a:gd name="T31" fmla="*/ 32 h 124"/>
                    <a:gd name="T32" fmla="*/ 10 w 54"/>
                    <a:gd name="T33" fmla="*/ 25 h 124"/>
                    <a:gd name="T34" fmla="*/ 9 w 54"/>
                    <a:gd name="T35" fmla="*/ 19 h 124"/>
                    <a:gd name="T36" fmla="*/ 6 w 54"/>
                    <a:gd name="T37" fmla="*/ 12 h 124"/>
                    <a:gd name="T38" fmla="*/ 3 w 54"/>
                    <a:gd name="T39" fmla="*/ 6 h 124"/>
                    <a:gd name="T40" fmla="*/ 0 w 54"/>
                    <a:gd name="T41" fmla="*/ 0 h 12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</a:cxnLst>
                  <a:rect l="0" t="0" r="r" b="b"/>
                  <a:pathLst>
                    <a:path w="54" h="124">
                      <a:moveTo>
                        <a:pt x="54" y="124"/>
                      </a:moveTo>
                      <a:lnTo>
                        <a:pt x="52" y="118"/>
                      </a:lnTo>
                      <a:lnTo>
                        <a:pt x="49" y="112"/>
                      </a:lnTo>
                      <a:lnTo>
                        <a:pt x="46" y="106"/>
                      </a:lnTo>
                      <a:lnTo>
                        <a:pt x="43" y="99"/>
                      </a:lnTo>
                      <a:lnTo>
                        <a:pt x="40" y="94"/>
                      </a:lnTo>
                      <a:lnTo>
                        <a:pt x="37" y="88"/>
                      </a:lnTo>
                      <a:lnTo>
                        <a:pt x="34" y="81"/>
                      </a:lnTo>
                      <a:lnTo>
                        <a:pt x="31" y="75"/>
                      </a:lnTo>
                      <a:lnTo>
                        <a:pt x="29" y="69"/>
                      </a:lnTo>
                      <a:lnTo>
                        <a:pt x="27" y="62"/>
                      </a:lnTo>
                      <a:lnTo>
                        <a:pt x="24" y="56"/>
                      </a:lnTo>
                      <a:lnTo>
                        <a:pt x="21" y="50"/>
                      </a:lnTo>
                      <a:lnTo>
                        <a:pt x="19" y="43"/>
                      </a:lnTo>
                      <a:lnTo>
                        <a:pt x="16" y="38"/>
                      </a:lnTo>
                      <a:lnTo>
                        <a:pt x="13" y="32"/>
                      </a:lnTo>
                      <a:lnTo>
                        <a:pt x="10" y="25"/>
                      </a:lnTo>
                      <a:lnTo>
                        <a:pt x="9" y="19"/>
                      </a:lnTo>
                      <a:lnTo>
                        <a:pt x="6" y="12"/>
                      </a:lnTo>
                      <a:lnTo>
                        <a:pt x="3" y="6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3" name="Rectangle 308"/>
                <p:cNvSpPr>
                  <a:spLocks noChangeArrowheads="1"/>
                </p:cNvSpPr>
                <p:nvPr/>
              </p:nvSpPr>
              <p:spPr bwMode="auto">
                <a:xfrm rot="19980000">
                  <a:off x="2401" y="2712"/>
                  <a:ext cx="72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99</a:t>
                  </a:r>
                </a:p>
              </p:txBody>
            </p:sp>
            <p:sp>
              <p:nvSpPr>
                <p:cNvPr id="124" name="Line 309"/>
                <p:cNvSpPr>
                  <a:spLocks noChangeShapeType="1"/>
                </p:cNvSpPr>
                <p:nvPr/>
              </p:nvSpPr>
              <p:spPr bwMode="auto">
                <a:xfrm flipH="1">
                  <a:off x="2380" y="2303"/>
                  <a:ext cx="1046" cy="512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5" name="Freeform 310"/>
                <p:cNvSpPr/>
                <p:nvPr/>
              </p:nvSpPr>
              <p:spPr bwMode="auto">
                <a:xfrm>
                  <a:off x="3538" y="2439"/>
                  <a:ext cx="154" cy="81"/>
                </a:xfrm>
                <a:custGeom>
                  <a:avLst/>
                  <a:gdLst>
                    <a:gd name="T0" fmla="*/ 0 w 154"/>
                    <a:gd name="T1" fmla="*/ 0 h 81"/>
                    <a:gd name="T2" fmla="*/ 4 w 154"/>
                    <a:gd name="T3" fmla="*/ 5 h 81"/>
                    <a:gd name="T4" fmla="*/ 10 w 154"/>
                    <a:gd name="T5" fmla="*/ 9 h 81"/>
                    <a:gd name="T6" fmla="*/ 15 w 154"/>
                    <a:gd name="T7" fmla="*/ 13 h 81"/>
                    <a:gd name="T8" fmla="*/ 21 w 154"/>
                    <a:gd name="T9" fmla="*/ 18 h 81"/>
                    <a:gd name="T10" fmla="*/ 27 w 154"/>
                    <a:gd name="T11" fmla="*/ 22 h 81"/>
                    <a:gd name="T12" fmla="*/ 32 w 154"/>
                    <a:gd name="T13" fmla="*/ 26 h 81"/>
                    <a:gd name="T14" fmla="*/ 38 w 154"/>
                    <a:gd name="T15" fmla="*/ 29 h 81"/>
                    <a:gd name="T16" fmla="*/ 44 w 154"/>
                    <a:gd name="T17" fmla="*/ 33 h 81"/>
                    <a:gd name="T18" fmla="*/ 51 w 154"/>
                    <a:gd name="T19" fmla="*/ 36 h 81"/>
                    <a:gd name="T20" fmla="*/ 57 w 154"/>
                    <a:gd name="T21" fmla="*/ 40 h 81"/>
                    <a:gd name="T22" fmla="*/ 63 w 154"/>
                    <a:gd name="T23" fmla="*/ 43 h 81"/>
                    <a:gd name="T24" fmla="*/ 68 w 154"/>
                    <a:gd name="T25" fmla="*/ 48 h 81"/>
                    <a:gd name="T26" fmla="*/ 76 w 154"/>
                    <a:gd name="T27" fmla="*/ 51 h 81"/>
                    <a:gd name="T28" fmla="*/ 81 w 154"/>
                    <a:gd name="T29" fmla="*/ 53 h 81"/>
                    <a:gd name="T30" fmla="*/ 88 w 154"/>
                    <a:gd name="T31" fmla="*/ 56 h 81"/>
                    <a:gd name="T32" fmla="*/ 94 w 154"/>
                    <a:gd name="T33" fmla="*/ 59 h 81"/>
                    <a:gd name="T34" fmla="*/ 101 w 154"/>
                    <a:gd name="T35" fmla="*/ 62 h 81"/>
                    <a:gd name="T36" fmla="*/ 107 w 154"/>
                    <a:gd name="T37" fmla="*/ 65 h 81"/>
                    <a:gd name="T38" fmla="*/ 114 w 154"/>
                    <a:gd name="T39" fmla="*/ 68 h 81"/>
                    <a:gd name="T40" fmla="*/ 120 w 154"/>
                    <a:gd name="T41" fmla="*/ 71 h 81"/>
                    <a:gd name="T42" fmla="*/ 127 w 154"/>
                    <a:gd name="T43" fmla="*/ 72 h 81"/>
                    <a:gd name="T44" fmla="*/ 134 w 154"/>
                    <a:gd name="T45" fmla="*/ 75 h 81"/>
                    <a:gd name="T46" fmla="*/ 140 w 154"/>
                    <a:gd name="T47" fmla="*/ 76 h 81"/>
                    <a:gd name="T48" fmla="*/ 147 w 154"/>
                    <a:gd name="T49" fmla="*/ 79 h 81"/>
                    <a:gd name="T50" fmla="*/ 154 w 154"/>
                    <a:gd name="T51" fmla="*/ 81 h 8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</a:cxnLst>
                  <a:rect l="0" t="0" r="r" b="b"/>
                  <a:pathLst>
                    <a:path w="154" h="81">
                      <a:moveTo>
                        <a:pt x="0" y="0"/>
                      </a:moveTo>
                      <a:lnTo>
                        <a:pt x="4" y="5"/>
                      </a:lnTo>
                      <a:lnTo>
                        <a:pt x="10" y="9"/>
                      </a:lnTo>
                      <a:lnTo>
                        <a:pt x="15" y="13"/>
                      </a:lnTo>
                      <a:lnTo>
                        <a:pt x="21" y="18"/>
                      </a:lnTo>
                      <a:lnTo>
                        <a:pt x="27" y="22"/>
                      </a:lnTo>
                      <a:lnTo>
                        <a:pt x="32" y="26"/>
                      </a:lnTo>
                      <a:lnTo>
                        <a:pt x="38" y="29"/>
                      </a:lnTo>
                      <a:lnTo>
                        <a:pt x="44" y="33"/>
                      </a:lnTo>
                      <a:lnTo>
                        <a:pt x="51" y="36"/>
                      </a:lnTo>
                      <a:lnTo>
                        <a:pt x="57" y="40"/>
                      </a:lnTo>
                      <a:lnTo>
                        <a:pt x="63" y="43"/>
                      </a:lnTo>
                      <a:lnTo>
                        <a:pt x="68" y="48"/>
                      </a:lnTo>
                      <a:lnTo>
                        <a:pt x="76" y="51"/>
                      </a:lnTo>
                      <a:lnTo>
                        <a:pt x="81" y="53"/>
                      </a:lnTo>
                      <a:lnTo>
                        <a:pt x="88" y="56"/>
                      </a:lnTo>
                      <a:lnTo>
                        <a:pt x="94" y="59"/>
                      </a:lnTo>
                      <a:lnTo>
                        <a:pt x="101" y="62"/>
                      </a:lnTo>
                      <a:lnTo>
                        <a:pt x="107" y="65"/>
                      </a:lnTo>
                      <a:lnTo>
                        <a:pt x="114" y="68"/>
                      </a:lnTo>
                      <a:lnTo>
                        <a:pt x="120" y="71"/>
                      </a:lnTo>
                      <a:lnTo>
                        <a:pt x="127" y="72"/>
                      </a:lnTo>
                      <a:lnTo>
                        <a:pt x="134" y="75"/>
                      </a:lnTo>
                      <a:lnTo>
                        <a:pt x="140" y="76"/>
                      </a:lnTo>
                      <a:lnTo>
                        <a:pt x="147" y="79"/>
                      </a:lnTo>
                      <a:lnTo>
                        <a:pt x="154" y="81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6" name="Freeform 311"/>
                <p:cNvSpPr/>
                <p:nvPr/>
              </p:nvSpPr>
              <p:spPr bwMode="auto">
                <a:xfrm>
                  <a:off x="3429" y="2303"/>
                  <a:ext cx="109" cy="136"/>
                </a:xfrm>
                <a:custGeom>
                  <a:avLst/>
                  <a:gdLst>
                    <a:gd name="T0" fmla="*/ 106 w 109"/>
                    <a:gd name="T1" fmla="*/ 135 h 136"/>
                    <a:gd name="T2" fmla="*/ 103 w 109"/>
                    <a:gd name="T3" fmla="*/ 132 h 136"/>
                    <a:gd name="T4" fmla="*/ 101 w 109"/>
                    <a:gd name="T5" fmla="*/ 131 h 136"/>
                    <a:gd name="T6" fmla="*/ 98 w 109"/>
                    <a:gd name="T7" fmla="*/ 128 h 136"/>
                    <a:gd name="T8" fmla="*/ 96 w 109"/>
                    <a:gd name="T9" fmla="*/ 126 h 136"/>
                    <a:gd name="T10" fmla="*/ 93 w 109"/>
                    <a:gd name="T11" fmla="*/ 123 h 136"/>
                    <a:gd name="T12" fmla="*/ 90 w 109"/>
                    <a:gd name="T13" fmla="*/ 121 h 136"/>
                    <a:gd name="T14" fmla="*/ 88 w 109"/>
                    <a:gd name="T15" fmla="*/ 119 h 136"/>
                    <a:gd name="T16" fmla="*/ 86 w 109"/>
                    <a:gd name="T17" fmla="*/ 116 h 136"/>
                    <a:gd name="T18" fmla="*/ 83 w 109"/>
                    <a:gd name="T19" fmla="*/ 113 h 136"/>
                    <a:gd name="T20" fmla="*/ 80 w 109"/>
                    <a:gd name="T21" fmla="*/ 112 h 136"/>
                    <a:gd name="T22" fmla="*/ 78 w 109"/>
                    <a:gd name="T23" fmla="*/ 109 h 136"/>
                    <a:gd name="T24" fmla="*/ 76 w 109"/>
                    <a:gd name="T25" fmla="*/ 106 h 136"/>
                    <a:gd name="T26" fmla="*/ 73 w 109"/>
                    <a:gd name="T27" fmla="*/ 103 h 136"/>
                    <a:gd name="T28" fmla="*/ 71 w 109"/>
                    <a:gd name="T29" fmla="*/ 102 h 136"/>
                    <a:gd name="T30" fmla="*/ 68 w 109"/>
                    <a:gd name="T31" fmla="*/ 99 h 136"/>
                    <a:gd name="T32" fmla="*/ 65 w 109"/>
                    <a:gd name="T33" fmla="*/ 96 h 136"/>
                    <a:gd name="T34" fmla="*/ 64 w 109"/>
                    <a:gd name="T35" fmla="*/ 93 h 136"/>
                    <a:gd name="T36" fmla="*/ 61 w 109"/>
                    <a:gd name="T37" fmla="*/ 90 h 136"/>
                    <a:gd name="T38" fmla="*/ 58 w 109"/>
                    <a:gd name="T39" fmla="*/ 89 h 136"/>
                    <a:gd name="T40" fmla="*/ 57 w 109"/>
                    <a:gd name="T41" fmla="*/ 86 h 136"/>
                    <a:gd name="T42" fmla="*/ 54 w 109"/>
                    <a:gd name="T43" fmla="*/ 83 h 136"/>
                    <a:gd name="T44" fmla="*/ 53 w 109"/>
                    <a:gd name="T45" fmla="*/ 80 h 136"/>
                    <a:gd name="T46" fmla="*/ 50 w 109"/>
                    <a:gd name="T47" fmla="*/ 77 h 136"/>
                    <a:gd name="T48" fmla="*/ 48 w 109"/>
                    <a:gd name="T49" fmla="*/ 75 h 136"/>
                    <a:gd name="T50" fmla="*/ 45 w 109"/>
                    <a:gd name="T51" fmla="*/ 72 h 136"/>
                    <a:gd name="T52" fmla="*/ 44 w 109"/>
                    <a:gd name="T53" fmla="*/ 70 h 136"/>
                    <a:gd name="T54" fmla="*/ 41 w 109"/>
                    <a:gd name="T55" fmla="*/ 67 h 136"/>
                    <a:gd name="T56" fmla="*/ 40 w 109"/>
                    <a:gd name="T57" fmla="*/ 65 h 136"/>
                    <a:gd name="T58" fmla="*/ 37 w 109"/>
                    <a:gd name="T59" fmla="*/ 62 h 136"/>
                    <a:gd name="T60" fmla="*/ 35 w 109"/>
                    <a:gd name="T61" fmla="*/ 59 h 136"/>
                    <a:gd name="T62" fmla="*/ 32 w 109"/>
                    <a:gd name="T63" fmla="*/ 56 h 136"/>
                    <a:gd name="T64" fmla="*/ 31 w 109"/>
                    <a:gd name="T65" fmla="*/ 53 h 136"/>
                    <a:gd name="T66" fmla="*/ 30 w 109"/>
                    <a:gd name="T67" fmla="*/ 50 h 136"/>
                    <a:gd name="T68" fmla="*/ 27 w 109"/>
                    <a:gd name="T69" fmla="*/ 47 h 136"/>
                    <a:gd name="T70" fmla="*/ 25 w 109"/>
                    <a:gd name="T71" fmla="*/ 44 h 136"/>
                    <a:gd name="T72" fmla="*/ 24 w 109"/>
                    <a:gd name="T73" fmla="*/ 42 h 136"/>
                    <a:gd name="T74" fmla="*/ 21 w 109"/>
                    <a:gd name="T75" fmla="*/ 39 h 136"/>
                    <a:gd name="T76" fmla="*/ 20 w 109"/>
                    <a:gd name="T77" fmla="*/ 36 h 136"/>
                    <a:gd name="T78" fmla="*/ 18 w 109"/>
                    <a:gd name="T79" fmla="*/ 33 h 136"/>
                    <a:gd name="T80" fmla="*/ 17 w 109"/>
                    <a:gd name="T81" fmla="*/ 29 h 136"/>
                    <a:gd name="T82" fmla="*/ 14 w 109"/>
                    <a:gd name="T83" fmla="*/ 26 h 136"/>
                    <a:gd name="T84" fmla="*/ 12 w 109"/>
                    <a:gd name="T85" fmla="*/ 23 h 136"/>
                    <a:gd name="T86" fmla="*/ 11 w 109"/>
                    <a:gd name="T87" fmla="*/ 20 h 136"/>
                    <a:gd name="T88" fmla="*/ 10 w 109"/>
                    <a:gd name="T89" fmla="*/ 17 h 136"/>
                    <a:gd name="T90" fmla="*/ 8 w 109"/>
                    <a:gd name="T91" fmla="*/ 14 h 136"/>
                    <a:gd name="T92" fmla="*/ 5 w 109"/>
                    <a:gd name="T93" fmla="*/ 11 h 136"/>
                    <a:gd name="T94" fmla="*/ 4 w 109"/>
                    <a:gd name="T95" fmla="*/ 9 h 136"/>
                    <a:gd name="T96" fmla="*/ 2 w 109"/>
                    <a:gd name="T97" fmla="*/ 4 h 136"/>
                    <a:gd name="T98" fmla="*/ 1 w 109"/>
                    <a:gd name="T99" fmla="*/ 1 h 13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  <a:cxn ang="0">
                      <a:pos x="T90" y="T91"/>
                    </a:cxn>
                    <a:cxn ang="0">
                      <a:pos x="T92" y="T93"/>
                    </a:cxn>
                    <a:cxn ang="0">
                      <a:pos x="T94" y="T95"/>
                    </a:cxn>
                    <a:cxn ang="0">
                      <a:pos x="T96" y="T97"/>
                    </a:cxn>
                    <a:cxn ang="0">
                      <a:pos x="T98" y="T99"/>
                    </a:cxn>
                  </a:cxnLst>
                  <a:rect l="0" t="0" r="r" b="b"/>
                  <a:pathLst>
                    <a:path w="109" h="136">
                      <a:moveTo>
                        <a:pt x="109" y="136"/>
                      </a:moveTo>
                      <a:lnTo>
                        <a:pt x="107" y="136"/>
                      </a:lnTo>
                      <a:lnTo>
                        <a:pt x="107" y="135"/>
                      </a:lnTo>
                      <a:lnTo>
                        <a:pt x="106" y="135"/>
                      </a:lnTo>
                      <a:lnTo>
                        <a:pt x="106" y="135"/>
                      </a:lnTo>
                      <a:lnTo>
                        <a:pt x="104" y="133"/>
                      </a:lnTo>
                      <a:lnTo>
                        <a:pt x="104" y="133"/>
                      </a:lnTo>
                      <a:lnTo>
                        <a:pt x="103" y="132"/>
                      </a:lnTo>
                      <a:lnTo>
                        <a:pt x="103" y="132"/>
                      </a:lnTo>
                      <a:lnTo>
                        <a:pt x="101" y="132"/>
                      </a:lnTo>
                      <a:lnTo>
                        <a:pt x="101" y="131"/>
                      </a:lnTo>
                      <a:lnTo>
                        <a:pt x="101" y="131"/>
                      </a:lnTo>
                      <a:lnTo>
                        <a:pt x="100" y="129"/>
                      </a:lnTo>
                      <a:lnTo>
                        <a:pt x="100" y="129"/>
                      </a:lnTo>
                      <a:lnTo>
                        <a:pt x="98" y="129"/>
                      </a:lnTo>
                      <a:lnTo>
                        <a:pt x="98" y="128"/>
                      </a:lnTo>
                      <a:lnTo>
                        <a:pt x="97" y="128"/>
                      </a:lnTo>
                      <a:lnTo>
                        <a:pt x="97" y="126"/>
                      </a:lnTo>
                      <a:lnTo>
                        <a:pt x="96" y="126"/>
                      </a:lnTo>
                      <a:lnTo>
                        <a:pt x="96" y="126"/>
                      </a:lnTo>
                      <a:lnTo>
                        <a:pt x="94" y="125"/>
                      </a:lnTo>
                      <a:lnTo>
                        <a:pt x="94" y="125"/>
                      </a:lnTo>
                      <a:lnTo>
                        <a:pt x="94" y="123"/>
                      </a:lnTo>
                      <a:lnTo>
                        <a:pt x="93" y="123"/>
                      </a:lnTo>
                      <a:lnTo>
                        <a:pt x="93" y="123"/>
                      </a:lnTo>
                      <a:lnTo>
                        <a:pt x="91" y="122"/>
                      </a:lnTo>
                      <a:lnTo>
                        <a:pt x="91" y="122"/>
                      </a:lnTo>
                      <a:lnTo>
                        <a:pt x="90" y="121"/>
                      </a:lnTo>
                      <a:lnTo>
                        <a:pt x="90" y="121"/>
                      </a:lnTo>
                      <a:lnTo>
                        <a:pt x="88" y="119"/>
                      </a:lnTo>
                      <a:lnTo>
                        <a:pt x="88" y="119"/>
                      </a:lnTo>
                      <a:lnTo>
                        <a:pt x="88" y="119"/>
                      </a:lnTo>
                      <a:lnTo>
                        <a:pt x="87" y="118"/>
                      </a:lnTo>
                      <a:lnTo>
                        <a:pt x="87" y="118"/>
                      </a:lnTo>
                      <a:lnTo>
                        <a:pt x="86" y="116"/>
                      </a:lnTo>
                      <a:lnTo>
                        <a:pt x="86" y="116"/>
                      </a:lnTo>
                      <a:lnTo>
                        <a:pt x="84" y="116"/>
                      </a:lnTo>
                      <a:lnTo>
                        <a:pt x="84" y="115"/>
                      </a:lnTo>
                      <a:lnTo>
                        <a:pt x="83" y="115"/>
                      </a:lnTo>
                      <a:lnTo>
                        <a:pt x="83" y="113"/>
                      </a:lnTo>
                      <a:lnTo>
                        <a:pt x="83" y="113"/>
                      </a:lnTo>
                      <a:lnTo>
                        <a:pt x="81" y="112"/>
                      </a:lnTo>
                      <a:lnTo>
                        <a:pt x="81" y="112"/>
                      </a:lnTo>
                      <a:lnTo>
                        <a:pt x="80" y="112"/>
                      </a:lnTo>
                      <a:lnTo>
                        <a:pt x="80" y="110"/>
                      </a:lnTo>
                      <a:lnTo>
                        <a:pt x="78" y="110"/>
                      </a:lnTo>
                      <a:lnTo>
                        <a:pt x="78" y="109"/>
                      </a:lnTo>
                      <a:lnTo>
                        <a:pt x="78" y="109"/>
                      </a:lnTo>
                      <a:lnTo>
                        <a:pt x="77" y="108"/>
                      </a:lnTo>
                      <a:lnTo>
                        <a:pt x="77" y="108"/>
                      </a:lnTo>
                      <a:lnTo>
                        <a:pt x="76" y="108"/>
                      </a:lnTo>
                      <a:lnTo>
                        <a:pt x="76" y="106"/>
                      </a:lnTo>
                      <a:lnTo>
                        <a:pt x="74" y="106"/>
                      </a:lnTo>
                      <a:lnTo>
                        <a:pt x="74" y="105"/>
                      </a:lnTo>
                      <a:lnTo>
                        <a:pt x="74" y="105"/>
                      </a:lnTo>
                      <a:lnTo>
                        <a:pt x="73" y="103"/>
                      </a:lnTo>
                      <a:lnTo>
                        <a:pt x="73" y="103"/>
                      </a:lnTo>
                      <a:lnTo>
                        <a:pt x="71" y="103"/>
                      </a:lnTo>
                      <a:lnTo>
                        <a:pt x="71" y="102"/>
                      </a:lnTo>
                      <a:lnTo>
                        <a:pt x="71" y="102"/>
                      </a:lnTo>
                      <a:lnTo>
                        <a:pt x="70" y="100"/>
                      </a:lnTo>
                      <a:lnTo>
                        <a:pt x="70" y="100"/>
                      </a:lnTo>
                      <a:lnTo>
                        <a:pt x="68" y="99"/>
                      </a:lnTo>
                      <a:lnTo>
                        <a:pt x="68" y="99"/>
                      </a:lnTo>
                      <a:lnTo>
                        <a:pt x="67" y="98"/>
                      </a:lnTo>
                      <a:lnTo>
                        <a:pt x="67" y="98"/>
                      </a:lnTo>
                      <a:lnTo>
                        <a:pt x="67" y="98"/>
                      </a:lnTo>
                      <a:lnTo>
                        <a:pt x="65" y="96"/>
                      </a:lnTo>
                      <a:lnTo>
                        <a:pt x="65" y="96"/>
                      </a:lnTo>
                      <a:lnTo>
                        <a:pt x="64" y="95"/>
                      </a:lnTo>
                      <a:lnTo>
                        <a:pt x="64" y="95"/>
                      </a:lnTo>
                      <a:lnTo>
                        <a:pt x="64" y="93"/>
                      </a:lnTo>
                      <a:lnTo>
                        <a:pt x="63" y="93"/>
                      </a:lnTo>
                      <a:lnTo>
                        <a:pt x="63" y="92"/>
                      </a:lnTo>
                      <a:lnTo>
                        <a:pt x="61" y="92"/>
                      </a:lnTo>
                      <a:lnTo>
                        <a:pt x="61" y="90"/>
                      </a:lnTo>
                      <a:lnTo>
                        <a:pt x="61" y="90"/>
                      </a:lnTo>
                      <a:lnTo>
                        <a:pt x="60" y="90"/>
                      </a:lnTo>
                      <a:lnTo>
                        <a:pt x="60" y="89"/>
                      </a:lnTo>
                      <a:lnTo>
                        <a:pt x="58" y="89"/>
                      </a:lnTo>
                      <a:lnTo>
                        <a:pt x="58" y="88"/>
                      </a:lnTo>
                      <a:lnTo>
                        <a:pt x="58" y="88"/>
                      </a:lnTo>
                      <a:lnTo>
                        <a:pt x="57" y="86"/>
                      </a:lnTo>
                      <a:lnTo>
                        <a:pt x="57" y="86"/>
                      </a:lnTo>
                      <a:lnTo>
                        <a:pt x="55" y="85"/>
                      </a:lnTo>
                      <a:lnTo>
                        <a:pt x="55" y="85"/>
                      </a:lnTo>
                      <a:lnTo>
                        <a:pt x="55" y="83"/>
                      </a:lnTo>
                      <a:lnTo>
                        <a:pt x="54" y="83"/>
                      </a:lnTo>
                      <a:lnTo>
                        <a:pt x="54" y="83"/>
                      </a:lnTo>
                      <a:lnTo>
                        <a:pt x="53" y="82"/>
                      </a:lnTo>
                      <a:lnTo>
                        <a:pt x="53" y="82"/>
                      </a:lnTo>
                      <a:lnTo>
                        <a:pt x="53" y="80"/>
                      </a:lnTo>
                      <a:lnTo>
                        <a:pt x="51" y="80"/>
                      </a:lnTo>
                      <a:lnTo>
                        <a:pt x="51" y="79"/>
                      </a:lnTo>
                      <a:lnTo>
                        <a:pt x="51" y="79"/>
                      </a:lnTo>
                      <a:lnTo>
                        <a:pt x="50" y="77"/>
                      </a:lnTo>
                      <a:lnTo>
                        <a:pt x="50" y="77"/>
                      </a:lnTo>
                      <a:lnTo>
                        <a:pt x="48" y="76"/>
                      </a:lnTo>
                      <a:lnTo>
                        <a:pt x="48" y="76"/>
                      </a:lnTo>
                      <a:lnTo>
                        <a:pt x="48" y="75"/>
                      </a:lnTo>
                      <a:lnTo>
                        <a:pt x="47" y="75"/>
                      </a:lnTo>
                      <a:lnTo>
                        <a:pt x="47" y="73"/>
                      </a:lnTo>
                      <a:lnTo>
                        <a:pt x="47" y="73"/>
                      </a:lnTo>
                      <a:lnTo>
                        <a:pt x="45" y="72"/>
                      </a:lnTo>
                      <a:lnTo>
                        <a:pt x="45" y="72"/>
                      </a:lnTo>
                      <a:lnTo>
                        <a:pt x="44" y="70"/>
                      </a:lnTo>
                      <a:lnTo>
                        <a:pt x="44" y="70"/>
                      </a:lnTo>
                      <a:lnTo>
                        <a:pt x="44" y="70"/>
                      </a:lnTo>
                      <a:lnTo>
                        <a:pt x="43" y="69"/>
                      </a:lnTo>
                      <a:lnTo>
                        <a:pt x="43" y="69"/>
                      </a:lnTo>
                      <a:lnTo>
                        <a:pt x="43" y="67"/>
                      </a:lnTo>
                      <a:lnTo>
                        <a:pt x="41" y="67"/>
                      </a:lnTo>
                      <a:lnTo>
                        <a:pt x="41" y="66"/>
                      </a:lnTo>
                      <a:lnTo>
                        <a:pt x="40" y="66"/>
                      </a:lnTo>
                      <a:lnTo>
                        <a:pt x="40" y="65"/>
                      </a:lnTo>
                      <a:lnTo>
                        <a:pt x="40" y="65"/>
                      </a:lnTo>
                      <a:lnTo>
                        <a:pt x="38" y="63"/>
                      </a:lnTo>
                      <a:lnTo>
                        <a:pt x="38" y="63"/>
                      </a:lnTo>
                      <a:lnTo>
                        <a:pt x="38" y="62"/>
                      </a:lnTo>
                      <a:lnTo>
                        <a:pt x="37" y="62"/>
                      </a:lnTo>
                      <a:lnTo>
                        <a:pt x="37" y="60"/>
                      </a:lnTo>
                      <a:lnTo>
                        <a:pt x="37" y="60"/>
                      </a:lnTo>
                      <a:lnTo>
                        <a:pt x="35" y="59"/>
                      </a:lnTo>
                      <a:lnTo>
                        <a:pt x="35" y="59"/>
                      </a:lnTo>
                      <a:lnTo>
                        <a:pt x="35" y="57"/>
                      </a:lnTo>
                      <a:lnTo>
                        <a:pt x="34" y="57"/>
                      </a:lnTo>
                      <a:lnTo>
                        <a:pt x="34" y="56"/>
                      </a:lnTo>
                      <a:lnTo>
                        <a:pt x="32" y="56"/>
                      </a:lnTo>
                      <a:lnTo>
                        <a:pt x="32" y="55"/>
                      </a:lnTo>
                      <a:lnTo>
                        <a:pt x="32" y="55"/>
                      </a:lnTo>
                      <a:lnTo>
                        <a:pt x="31" y="53"/>
                      </a:lnTo>
                      <a:lnTo>
                        <a:pt x="31" y="53"/>
                      </a:lnTo>
                      <a:lnTo>
                        <a:pt x="31" y="52"/>
                      </a:lnTo>
                      <a:lnTo>
                        <a:pt x="30" y="52"/>
                      </a:lnTo>
                      <a:lnTo>
                        <a:pt x="30" y="50"/>
                      </a:lnTo>
                      <a:lnTo>
                        <a:pt x="30" y="50"/>
                      </a:lnTo>
                      <a:lnTo>
                        <a:pt x="28" y="49"/>
                      </a:lnTo>
                      <a:lnTo>
                        <a:pt x="28" y="49"/>
                      </a:lnTo>
                      <a:lnTo>
                        <a:pt x="28" y="47"/>
                      </a:lnTo>
                      <a:lnTo>
                        <a:pt x="27" y="47"/>
                      </a:lnTo>
                      <a:lnTo>
                        <a:pt x="27" y="46"/>
                      </a:lnTo>
                      <a:lnTo>
                        <a:pt x="27" y="46"/>
                      </a:lnTo>
                      <a:lnTo>
                        <a:pt x="25" y="44"/>
                      </a:lnTo>
                      <a:lnTo>
                        <a:pt x="25" y="44"/>
                      </a:lnTo>
                      <a:lnTo>
                        <a:pt x="25" y="43"/>
                      </a:lnTo>
                      <a:lnTo>
                        <a:pt x="24" y="43"/>
                      </a:lnTo>
                      <a:lnTo>
                        <a:pt x="24" y="42"/>
                      </a:lnTo>
                      <a:lnTo>
                        <a:pt x="24" y="42"/>
                      </a:lnTo>
                      <a:lnTo>
                        <a:pt x="22" y="40"/>
                      </a:lnTo>
                      <a:lnTo>
                        <a:pt x="22" y="40"/>
                      </a:lnTo>
                      <a:lnTo>
                        <a:pt x="22" y="39"/>
                      </a:lnTo>
                      <a:lnTo>
                        <a:pt x="21" y="39"/>
                      </a:lnTo>
                      <a:lnTo>
                        <a:pt x="21" y="37"/>
                      </a:lnTo>
                      <a:lnTo>
                        <a:pt x="21" y="37"/>
                      </a:lnTo>
                      <a:lnTo>
                        <a:pt x="20" y="36"/>
                      </a:lnTo>
                      <a:lnTo>
                        <a:pt x="20" y="36"/>
                      </a:lnTo>
                      <a:lnTo>
                        <a:pt x="20" y="34"/>
                      </a:lnTo>
                      <a:lnTo>
                        <a:pt x="18" y="34"/>
                      </a:lnTo>
                      <a:lnTo>
                        <a:pt x="18" y="33"/>
                      </a:lnTo>
                      <a:lnTo>
                        <a:pt x="18" y="33"/>
                      </a:lnTo>
                      <a:lnTo>
                        <a:pt x="18" y="32"/>
                      </a:lnTo>
                      <a:lnTo>
                        <a:pt x="17" y="30"/>
                      </a:lnTo>
                      <a:lnTo>
                        <a:pt x="17" y="30"/>
                      </a:lnTo>
                      <a:lnTo>
                        <a:pt x="17" y="29"/>
                      </a:lnTo>
                      <a:lnTo>
                        <a:pt x="15" y="29"/>
                      </a:lnTo>
                      <a:lnTo>
                        <a:pt x="15" y="27"/>
                      </a:lnTo>
                      <a:lnTo>
                        <a:pt x="15" y="27"/>
                      </a:lnTo>
                      <a:lnTo>
                        <a:pt x="14" y="26"/>
                      </a:lnTo>
                      <a:lnTo>
                        <a:pt x="14" y="26"/>
                      </a:lnTo>
                      <a:lnTo>
                        <a:pt x="14" y="24"/>
                      </a:lnTo>
                      <a:lnTo>
                        <a:pt x="12" y="24"/>
                      </a:lnTo>
                      <a:lnTo>
                        <a:pt x="12" y="23"/>
                      </a:lnTo>
                      <a:lnTo>
                        <a:pt x="12" y="23"/>
                      </a:lnTo>
                      <a:lnTo>
                        <a:pt x="12" y="22"/>
                      </a:lnTo>
                      <a:lnTo>
                        <a:pt x="11" y="22"/>
                      </a:lnTo>
                      <a:lnTo>
                        <a:pt x="11" y="20"/>
                      </a:lnTo>
                      <a:lnTo>
                        <a:pt x="11" y="20"/>
                      </a:lnTo>
                      <a:lnTo>
                        <a:pt x="10" y="19"/>
                      </a:lnTo>
                      <a:lnTo>
                        <a:pt x="10" y="19"/>
                      </a:lnTo>
                      <a:lnTo>
                        <a:pt x="10" y="17"/>
                      </a:lnTo>
                      <a:lnTo>
                        <a:pt x="8" y="16"/>
                      </a:lnTo>
                      <a:lnTo>
                        <a:pt x="8" y="16"/>
                      </a:lnTo>
                      <a:lnTo>
                        <a:pt x="8" y="14"/>
                      </a:lnTo>
                      <a:lnTo>
                        <a:pt x="8" y="14"/>
                      </a:lnTo>
                      <a:lnTo>
                        <a:pt x="7" y="13"/>
                      </a:lnTo>
                      <a:lnTo>
                        <a:pt x="7" y="13"/>
                      </a:lnTo>
                      <a:lnTo>
                        <a:pt x="7" y="11"/>
                      </a:lnTo>
                      <a:lnTo>
                        <a:pt x="5" y="11"/>
                      </a:lnTo>
                      <a:lnTo>
                        <a:pt x="5" y="10"/>
                      </a:lnTo>
                      <a:lnTo>
                        <a:pt x="5" y="10"/>
                      </a:lnTo>
                      <a:lnTo>
                        <a:pt x="5" y="9"/>
                      </a:lnTo>
                      <a:lnTo>
                        <a:pt x="4" y="9"/>
                      </a:lnTo>
                      <a:lnTo>
                        <a:pt x="4" y="7"/>
                      </a:lnTo>
                      <a:lnTo>
                        <a:pt x="4" y="7"/>
                      </a:lnTo>
                      <a:lnTo>
                        <a:pt x="4" y="6"/>
                      </a:lnTo>
                      <a:lnTo>
                        <a:pt x="2" y="4"/>
                      </a:lnTo>
                      <a:lnTo>
                        <a:pt x="2" y="4"/>
                      </a:lnTo>
                      <a:lnTo>
                        <a:pt x="2" y="3"/>
                      </a:lnTo>
                      <a:lnTo>
                        <a:pt x="1" y="3"/>
                      </a:lnTo>
                      <a:lnTo>
                        <a:pt x="1" y="1"/>
                      </a:lnTo>
                      <a:lnTo>
                        <a:pt x="1" y="1"/>
                      </a:lnTo>
                      <a:lnTo>
                        <a:pt x="1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7" name="Rectangle 312"/>
                <p:cNvSpPr>
                  <a:spLocks noChangeArrowheads="1"/>
                </p:cNvSpPr>
                <p:nvPr/>
              </p:nvSpPr>
              <p:spPr bwMode="auto">
                <a:xfrm rot="18540000">
                  <a:off x="3611" y="2386"/>
                  <a:ext cx="72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99</a:t>
                  </a:r>
                </a:p>
              </p:txBody>
            </p:sp>
            <p:sp>
              <p:nvSpPr>
                <p:cNvPr id="128" name="Line 313"/>
                <p:cNvSpPr>
                  <a:spLocks noChangeShapeType="1"/>
                </p:cNvSpPr>
                <p:nvPr/>
              </p:nvSpPr>
              <p:spPr bwMode="auto">
                <a:xfrm flipH="1">
                  <a:off x="3539" y="2389"/>
                  <a:ext cx="40" cy="47"/>
                </a:xfrm>
                <a:prstGeom prst="line">
                  <a:avLst/>
                </a:prstGeom>
                <a:noFill/>
                <a:ln w="9525" cap="sq">
                  <a:solidFill>
                    <a:srgbClr val="C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9" name="Rectangle 314"/>
                <p:cNvSpPr>
                  <a:spLocks noChangeArrowheads="1"/>
                </p:cNvSpPr>
                <p:nvPr/>
              </p:nvSpPr>
              <p:spPr bwMode="auto">
                <a:xfrm rot="20760000">
                  <a:off x="1678" y="2569"/>
                  <a:ext cx="275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NM-B3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0" name="Line 315"/>
                <p:cNvSpPr>
                  <a:spLocks noChangeShapeType="1"/>
                </p:cNvSpPr>
                <p:nvPr/>
              </p:nvSpPr>
              <p:spPr bwMode="auto">
                <a:xfrm flipH="1">
                  <a:off x="2131" y="2352"/>
                  <a:ext cx="730" cy="179"/>
                </a:xfrm>
                <a:prstGeom prst="line">
                  <a:avLst/>
                </a:pr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1" name="Rectangle 316"/>
                <p:cNvSpPr>
                  <a:spLocks noChangeArrowheads="1"/>
                </p:cNvSpPr>
                <p:nvPr/>
              </p:nvSpPr>
              <p:spPr bwMode="auto">
                <a:xfrm rot="21060000">
                  <a:off x="1676" y="2395"/>
                  <a:ext cx="246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TY-B4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2" name="Line 317"/>
                <p:cNvSpPr>
                  <a:spLocks noChangeShapeType="1"/>
                </p:cNvSpPr>
                <p:nvPr/>
              </p:nvSpPr>
              <p:spPr bwMode="auto">
                <a:xfrm flipH="1">
                  <a:off x="2102" y="2280"/>
                  <a:ext cx="674" cy="105"/>
                </a:xfrm>
                <a:prstGeom prst="line">
                  <a:avLst/>
                </a:pr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3" name="Rectangle 318"/>
                <p:cNvSpPr>
                  <a:spLocks noChangeArrowheads="1"/>
                </p:cNvSpPr>
                <p:nvPr/>
              </p:nvSpPr>
              <p:spPr bwMode="auto">
                <a:xfrm rot="21360000">
                  <a:off x="1702" y="2218"/>
                  <a:ext cx="210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H-C3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4" name="Line 319"/>
                <p:cNvSpPr>
                  <a:spLocks noChangeShapeType="1"/>
                </p:cNvSpPr>
                <p:nvPr/>
              </p:nvSpPr>
              <p:spPr bwMode="auto">
                <a:xfrm flipH="1">
                  <a:off x="2086" y="2234"/>
                  <a:ext cx="63" cy="4"/>
                </a:xfrm>
                <a:prstGeom prst="line">
                  <a:avLst/>
                </a:pr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5" name="Rectangle 320"/>
                <p:cNvSpPr>
                  <a:spLocks noChangeArrowheads="1"/>
                </p:cNvSpPr>
                <p:nvPr/>
              </p:nvSpPr>
              <p:spPr bwMode="auto">
                <a:xfrm rot="60000">
                  <a:off x="1711" y="2041"/>
                  <a:ext cx="198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C-C2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6" name="Line 321"/>
                <p:cNvSpPr>
                  <a:spLocks noChangeShapeType="1"/>
                </p:cNvSpPr>
                <p:nvPr/>
              </p:nvSpPr>
              <p:spPr bwMode="auto">
                <a:xfrm flipH="1" flipV="1">
                  <a:off x="2082" y="2091"/>
                  <a:ext cx="63" cy="1"/>
                </a:xfrm>
                <a:prstGeom prst="line">
                  <a:avLst/>
                </a:pr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7" name="Freeform 322"/>
                <p:cNvSpPr/>
                <p:nvPr/>
              </p:nvSpPr>
              <p:spPr bwMode="auto">
                <a:xfrm>
                  <a:off x="2148" y="2162"/>
                  <a:ext cx="4" cy="72"/>
                </a:xfrm>
                <a:custGeom>
                  <a:avLst/>
                  <a:gdLst>
                    <a:gd name="T0" fmla="*/ 0 w 4"/>
                    <a:gd name="T1" fmla="*/ 0 h 72"/>
                    <a:gd name="T2" fmla="*/ 0 w 4"/>
                    <a:gd name="T3" fmla="*/ 6 h 72"/>
                    <a:gd name="T4" fmla="*/ 1 w 4"/>
                    <a:gd name="T5" fmla="*/ 12 h 72"/>
                    <a:gd name="T6" fmla="*/ 1 w 4"/>
                    <a:gd name="T7" fmla="*/ 18 h 72"/>
                    <a:gd name="T8" fmla="*/ 1 w 4"/>
                    <a:gd name="T9" fmla="*/ 22 h 72"/>
                    <a:gd name="T10" fmla="*/ 1 w 4"/>
                    <a:gd name="T11" fmla="*/ 28 h 72"/>
                    <a:gd name="T12" fmla="*/ 1 w 4"/>
                    <a:gd name="T13" fmla="*/ 33 h 72"/>
                    <a:gd name="T14" fmla="*/ 1 w 4"/>
                    <a:gd name="T15" fmla="*/ 39 h 72"/>
                    <a:gd name="T16" fmla="*/ 3 w 4"/>
                    <a:gd name="T17" fmla="*/ 45 h 72"/>
                    <a:gd name="T18" fmla="*/ 3 w 4"/>
                    <a:gd name="T19" fmla="*/ 49 h 72"/>
                    <a:gd name="T20" fmla="*/ 3 w 4"/>
                    <a:gd name="T21" fmla="*/ 55 h 72"/>
                    <a:gd name="T22" fmla="*/ 3 w 4"/>
                    <a:gd name="T23" fmla="*/ 61 h 72"/>
                    <a:gd name="T24" fmla="*/ 3 w 4"/>
                    <a:gd name="T25" fmla="*/ 66 h 72"/>
                    <a:gd name="T26" fmla="*/ 4 w 4"/>
                    <a:gd name="T27" fmla="*/ 72 h 7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</a:cxnLst>
                  <a:rect l="0" t="0" r="r" b="b"/>
                  <a:pathLst>
                    <a:path w="4" h="72">
                      <a:moveTo>
                        <a:pt x="0" y="0"/>
                      </a:moveTo>
                      <a:lnTo>
                        <a:pt x="0" y="6"/>
                      </a:lnTo>
                      <a:lnTo>
                        <a:pt x="1" y="12"/>
                      </a:lnTo>
                      <a:lnTo>
                        <a:pt x="1" y="18"/>
                      </a:lnTo>
                      <a:lnTo>
                        <a:pt x="1" y="22"/>
                      </a:lnTo>
                      <a:lnTo>
                        <a:pt x="1" y="28"/>
                      </a:lnTo>
                      <a:lnTo>
                        <a:pt x="1" y="33"/>
                      </a:lnTo>
                      <a:lnTo>
                        <a:pt x="1" y="39"/>
                      </a:lnTo>
                      <a:lnTo>
                        <a:pt x="3" y="45"/>
                      </a:lnTo>
                      <a:lnTo>
                        <a:pt x="3" y="49"/>
                      </a:lnTo>
                      <a:lnTo>
                        <a:pt x="3" y="55"/>
                      </a:lnTo>
                      <a:lnTo>
                        <a:pt x="3" y="61"/>
                      </a:lnTo>
                      <a:lnTo>
                        <a:pt x="3" y="66"/>
                      </a:lnTo>
                      <a:lnTo>
                        <a:pt x="4" y="72"/>
                      </a:lnTo>
                    </a:path>
                  </a:pathLst>
                </a:cu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8" name="Freeform 323"/>
                <p:cNvSpPr/>
                <p:nvPr/>
              </p:nvSpPr>
              <p:spPr bwMode="auto">
                <a:xfrm>
                  <a:off x="2148" y="2092"/>
                  <a:ext cx="0" cy="70"/>
                </a:xfrm>
                <a:custGeom>
                  <a:avLst/>
                  <a:gdLst>
                    <a:gd name="T0" fmla="*/ 70 h 70"/>
                    <a:gd name="T1" fmla="*/ 65 h 70"/>
                    <a:gd name="T2" fmla="*/ 59 h 70"/>
                    <a:gd name="T3" fmla="*/ 53 h 70"/>
                    <a:gd name="T4" fmla="*/ 47 h 70"/>
                    <a:gd name="T5" fmla="*/ 40 h 70"/>
                    <a:gd name="T6" fmla="*/ 34 h 70"/>
                    <a:gd name="T7" fmla="*/ 29 h 70"/>
                    <a:gd name="T8" fmla="*/ 23 h 70"/>
                    <a:gd name="T9" fmla="*/ 17 h 70"/>
                    <a:gd name="T10" fmla="*/ 12 h 70"/>
                    <a:gd name="T11" fmla="*/ 6 h 70"/>
                    <a:gd name="T12" fmla="*/ 0 h 70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  <a:cxn ang="0">
                      <a:pos x="0" y="T3"/>
                    </a:cxn>
                    <a:cxn ang="0">
                      <a:pos x="0" y="T4"/>
                    </a:cxn>
                    <a:cxn ang="0">
                      <a:pos x="0" y="T5"/>
                    </a:cxn>
                    <a:cxn ang="0">
                      <a:pos x="0" y="T6"/>
                    </a:cxn>
                    <a:cxn ang="0">
                      <a:pos x="0" y="T7"/>
                    </a:cxn>
                    <a:cxn ang="0">
                      <a:pos x="0" y="T8"/>
                    </a:cxn>
                    <a:cxn ang="0">
                      <a:pos x="0" y="T9"/>
                    </a:cxn>
                    <a:cxn ang="0">
                      <a:pos x="0" y="T10"/>
                    </a:cxn>
                    <a:cxn ang="0">
                      <a:pos x="0" y="T11"/>
                    </a:cxn>
                    <a:cxn ang="0">
                      <a:pos x="0" y="T12"/>
                    </a:cxn>
                  </a:cxnLst>
                  <a:rect l="0" t="0" r="r" b="b"/>
                  <a:pathLst>
                    <a:path h="70">
                      <a:moveTo>
                        <a:pt x="0" y="70"/>
                      </a:moveTo>
                      <a:lnTo>
                        <a:pt x="0" y="65"/>
                      </a:lnTo>
                      <a:lnTo>
                        <a:pt x="0" y="59"/>
                      </a:lnTo>
                      <a:lnTo>
                        <a:pt x="0" y="53"/>
                      </a:lnTo>
                      <a:lnTo>
                        <a:pt x="0" y="47"/>
                      </a:lnTo>
                      <a:lnTo>
                        <a:pt x="0" y="40"/>
                      </a:lnTo>
                      <a:lnTo>
                        <a:pt x="0" y="34"/>
                      </a:lnTo>
                      <a:lnTo>
                        <a:pt x="0" y="29"/>
                      </a:lnTo>
                      <a:lnTo>
                        <a:pt x="0" y="23"/>
                      </a:lnTo>
                      <a:lnTo>
                        <a:pt x="0" y="17"/>
                      </a:lnTo>
                      <a:lnTo>
                        <a:pt x="0" y="12"/>
                      </a:lnTo>
                      <a:lnTo>
                        <a:pt x="0" y="6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9" name="Rectangle 324"/>
                <p:cNvSpPr>
                  <a:spLocks noChangeArrowheads="1"/>
                </p:cNvSpPr>
                <p:nvPr/>
              </p:nvSpPr>
              <p:spPr bwMode="auto">
                <a:xfrm rot="21480000">
                  <a:off x="2196" y="2195"/>
                  <a:ext cx="72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90</a:t>
                  </a:r>
                </a:p>
              </p:txBody>
            </p:sp>
            <p:sp>
              <p:nvSpPr>
                <p:cNvPr id="140" name="Line 325"/>
                <p:cNvSpPr>
                  <a:spLocks noChangeShapeType="1"/>
                </p:cNvSpPr>
                <p:nvPr/>
              </p:nvSpPr>
              <p:spPr bwMode="auto">
                <a:xfrm flipH="1">
                  <a:off x="2151" y="2161"/>
                  <a:ext cx="63" cy="1"/>
                </a:xfrm>
                <a:prstGeom prst="line">
                  <a:avLst/>
                </a:pr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1" name="Rectangle 326"/>
                <p:cNvSpPr>
                  <a:spLocks noChangeArrowheads="1"/>
                </p:cNvSpPr>
                <p:nvPr/>
              </p:nvSpPr>
              <p:spPr bwMode="auto">
                <a:xfrm rot="300000">
                  <a:off x="1676" y="1864"/>
                  <a:ext cx="246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TY-C1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2" name="Line 327"/>
                <p:cNvSpPr>
                  <a:spLocks noChangeShapeType="1"/>
                </p:cNvSpPr>
                <p:nvPr/>
              </p:nvSpPr>
              <p:spPr bwMode="auto">
                <a:xfrm flipH="1" flipV="1">
                  <a:off x="2091" y="1943"/>
                  <a:ext cx="130" cy="14"/>
                </a:xfrm>
                <a:prstGeom prst="line">
                  <a:avLst/>
                </a:pr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3" name="Freeform 328"/>
                <p:cNvSpPr/>
                <p:nvPr/>
              </p:nvSpPr>
              <p:spPr bwMode="auto">
                <a:xfrm>
                  <a:off x="2217" y="2059"/>
                  <a:ext cx="1" cy="102"/>
                </a:xfrm>
                <a:custGeom>
                  <a:avLst/>
                  <a:gdLst>
                    <a:gd name="T0" fmla="*/ 1 w 1"/>
                    <a:gd name="T1" fmla="*/ 0 h 102"/>
                    <a:gd name="T2" fmla="*/ 1 w 1"/>
                    <a:gd name="T3" fmla="*/ 6 h 102"/>
                    <a:gd name="T4" fmla="*/ 1 w 1"/>
                    <a:gd name="T5" fmla="*/ 12 h 102"/>
                    <a:gd name="T6" fmla="*/ 0 w 1"/>
                    <a:gd name="T7" fmla="*/ 17 h 102"/>
                    <a:gd name="T8" fmla="*/ 0 w 1"/>
                    <a:gd name="T9" fmla="*/ 23 h 102"/>
                    <a:gd name="T10" fmla="*/ 0 w 1"/>
                    <a:gd name="T11" fmla="*/ 27 h 102"/>
                    <a:gd name="T12" fmla="*/ 0 w 1"/>
                    <a:gd name="T13" fmla="*/ 33 h 102"/>
                    <a:gd name="T14" fmla="*/ 0 w 1"/>
                    <a:gd name="T15" fmla="*/ 39 h 102"/>
                    <a:gd name="T16" fmla="*/ 0 w 1"/>
                    <a:gd name="T17" fmla="*/ 45 h 102"/>
                    <a:gd name="T18" fmla="*/ 0 w 1"/>
                    <a:gd name="T19" fmla="*/ 50 h 102"/>
                    <a:gd name="T20" fmla="*/ 0 w 1"/>
                    <a:gd name="T21" fmla="*/ 56 h 102"/>
                    <a:gd name="T22" fmla="*/ 0 w 1"/>
                    <a:gd name="T23" fmla="*/ 62 h 102"/>
                    <a:gd name="T24" fmla="*/ 0 w 1"/>
                    <a:gd name="T25" fmla="*/ 67 h 102"/>
                    <a:gd name="T26" fmla="*/ 0 w 1"/>
                    <a:gd name="T27" fmla="*/ 73 h 102"/>
                    <a:gd name="T28" fmla="*/ 0 w 1"/>
                    <a:gd name="T29" fmla="*/ 79 h 102"/>
                    <a:gd name="T30" fmla="*/ 0 w 1"/>
                    <a:gd name="T31" fmla="*/ 85 h 102"/>
                    <a:gd name="T32" fmla="*/ 0 w 1"/>
                    <a:gd name="T33" fmla="*/ 90 h 102"/>
                    <a:gd name="T34" fmla="*/ 0 w 1"/>
                    <a:gd name="T35" fmla="*/ 96 h 102"/>
                    <a:gd name="T36" fmla="*/ 0 w 1"/>
                    <a:gd name="T37" fmla="*/ 102 h 10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</a:cxnLst>
                  <a:rect l="0" t="0" r="r" b="b"/>
                  <a:pathLst>
                    <a:path w="1" h="102">
                      <a:moveTo>
                        <a:pt x="1" y="0"/>
                      </a:moveTo>
                      <a:lnTo>
                        <a:pt x="1" y="6"/>
                      </a:lnTo>
                      <a:lnTo>
                        <a:pt x="1" y="12"/>
                      </a:lnTo>
                      <a:lnTo>
                        <a:pt x="0" y="17"/>
                      </a:lnTo>
                      <a:lnTo>
                        <a:pt x="0" y="23"/>
                      </a:lnTo>
                      <a:lnTo>
                        <a:pt x="0" y="27"/>
                      </a:lnTo>
                      <a:lnTo>
                        <a:pt x="0" y="33"/>
                      </a:lnTo>
                      <a:lnTo>
                        <a:pt x="0" y="39"/>
                      </a:lnTo>
                      <a:lnTo>
                        <a:pt x="0" y="45"/>
                      </a:lnTo>
                      <a:lnTo>
                        <a:pt x="0" y="50"/>
                      </a:lnTo>
                      <a:lnTo>
                        <a:pt x="0" y="56"/>
                      </a:lnTo>
                      <a:lnTo>
                        <a:pt x="0" y="62"/>
                      </a:lnTo>
                      <a:lnTo>
                        <a:pt x="0" y="67"/>
                      </a:lnTo>
                      <a:lnTo>
                        <a:pt x="0" y="73"/>
                      </a:lnTo>
                      <a:lnTo>
                        <a:pt x="0" y="79"/>
                      </a:lnTo>
                      <a:lnTo>
                        <a:pt x="0" y="85"/>
                      </a:lnTo>
                      <a:lnTo>
                        <a:pt x="0" y="90"/>
                      </a:lnTo>
                      <a:lnTo>
                        <a:pt x="0" y="96"/>
                      </a:lnTo>
                      <a:lnTo>
                        <a:pt x="0" y="102"/>
                      </a:lnTo>
                    </a:path>
                  </a:pathLst>
                </a:cu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4" name="Freeform 329"/>
                <p:cNvSpPr/>
                <p:nvPr/>
              </p:nvSpPr>
              <p:spPr bwMode="auto">
                <a:xfrm>
                  <a:off x="2218" y="1957"/>
                  <a:ext cx="7" cy="102"/>
                </a:xfrm>
                <a:custGeom>
                  <a:avLst/>
                  <a:gdLst>
                    <a:gd name="T0" fmla="*/ 0 w 7"/>
                    <a:gd name="T1" fmla="*/ 102 h 102"/>
                    <a:gd name="T2" fmla="*/ 0 w 7"/>
                    <a:gd name="T3" fmla="*/ 96 h 102"/>
                    <a:gd name="T4" fmla="*/ 0 w 7"/>
                    <a:gd name="T5" fmla="*/ 92 h 102"/>
                    <a:gd name="T6" fmla="*/ 0 w 7"/>
                    <a:gd name="T7" fmla="*/ 88 h 102"/>
                    <a:gd name="T8" fmla="*/ 0 w 7"/>
                    <a:gd name="T9" fmla="*/ 83 h 102"/>
                    <a:gd name="T10" fmla="*/ 2 w 7"/>
                    <a:gd name="T11" fmla="*/ 79 h 102"/>
                    <a:gd name="T12" fmla="*/ 2 w 7"/>
                    <a:gd name="T13" fmla="*/ 73 h 102"/>
                    <a:gd name="T14" fmla="*/ 2 w 7"/>
                    <a:gd name="T15" fmla="*/ 69 h 102"/>
                    <a:gd name="T16" fmla="*/ 2 w 7"/>
                    <a:gd name="T17" fmla="*/ 65 h 102"/>
                    <a:gd name="T18" fmla="*/ 2 w 7"/>
                    <a:gd name="T19" fmla="*/ 60 h 102"/>
                    <a:gd name="T20" fmla="*/ 3 w 7"/>
                    <a:gd name="T21" fmla="*/ 55 h 102"/>
                    <a:gd name="T22" fmla="*/ 3 w 7"/>
                    <a:gd name="T23" fmla="*/ 50 h 102"/>
                    <a:gd name="T24" fmla="*/ 3 w 7"/>
                    <a:gd name="T25" fmla="*/ 46 h 102"/>
                    <a:gd name="T26" fmla="*/ 3 w 7"/>
                    <a:gd name="T27" fmla="*/ 42 h 102"/>
                    <a:gd name="T28" fmla="*/ 5 w 7"/>
                    <a:gd name="T29" fmla="*/ 36 h 102"/>
                    <a:gd name="T30" fmla="*/ 5 w 7"/>
                    <a:gd name="T31" fmla="*/ 32 h 102"/>
                    <a:gd name="T32" fmla="*/ 5 w 7"/>
                    <a:gd name="T33" fmla="*/ 27 h 102"/>
                    <a:gd name="T34" fmla="*/ 5 w 7"/>
                    <a:gd name="T35" fmla="*/ 23 h 102"/>
                    <a:gd name="T36" fmla="*/ 6 w 7"/>
                    <a:gd name="T37" fmla="*/ 19 h 102"/>
                    <a:gd name="T38" fmla="*/ 6 w 7"/>
                    <a:gd name="T39" fmla="*/ 13 h 102"/>
                    <a:gd name="T40" fmla="*/ 6 w 7"/>
                    <a:gd name="T41" fmla="*/ 9 h 102"/>
                    <a:gd name="T42" fmla="*/ 7 w 7"/>
                    <a:gd name="T43" fmla="*/ 4 h 102"/>
                    <a:gd name="T44" fmla="*/ 7 w 7"/>
                    <a:gd name="T45" fmla="*/ 0 h 10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</a:cxnLst>
                  <a:rect l="0" t="0" r="r" b="b"/>
                  <a:pathLst>
                    <a:path w="7" h="102">
                      <a:moveTo>
                        <a:pt x="0" y="102"/>
                      </a:moveTo>
                      <a:lnTo>
                        <a:pt x="0" y="96"/>
                      </a:lnTo>
                      <a:lnTo>
                        <a:pt x="0" y="92"/>
                      </a:lnTo>
                      <a:lnTo>
                        <a:pt x="0" y="88"/>
                      </a:lnTo>
                      <a:lnTo>
                        <a:pt x="0" y="83"/>
                      </a:lnTo>
                      <a:lnTo>
                        <a:pt x="2" y="79"/>
                      </a:lnTo>
                      <a:lnTo>
                        <a:pt x="2" y="73"/>
                      </a:lnTo>
                      <a:lnTo>
                        <a:pt x="2" y="69"/>
                      </a:lnTo>
                      <a:lnTo>
                        <a:pt x="2" y="65"/>
                      </a:lnTo>
                      <a:lnTo>
                        <a:pt x="2" y="60"/>
                      </a:lnTo>
                      <a:lnTo>
                        <a:pt x="3" y="55"/>
                      </a:lnTo>
                      <a:lnTo>
                        <a:pt x="3" y="50"/>
                      </a:lnTo>
                      <a:lnTo>
                        <a:pt x="3" y="46"/>
                      </a:lnTo>
                      <a:lnTo>
                        <a:pt x="3" y="42"/>
                      </a:lnTo>
                      <a:lnTo>
                        <a:pt x="5" y="36"/>
                      </a:lnTo>
                      <a:lnTo>
                        <a:pt x="5" y="32"/>
                      </a:lnTo>
                      <a:lnTo>
                        <a:pt x="5" y="27"/>
                      </a:lnTo>
                      <a:lnTo>
                        <a:pt x="5" y="23"/>
                      </a:lnTo>
                      <a:lnTo>
                        <a:pt x="6" y="19"/>
                      </a:lnTo>
                      <a:lnTo>
                        <a:pt x="6" y="13"/>
                      </a:lnTo>
                      <a:lnTo>
                        <a:pt x="6" y="9"/>
                      </a:lnTo>
                      <a:lnTo>
                        <a:pt x="7" y="4"/>
                      </a:lnTo>
                      <a:lnTo>
                        <a:pt x="7" y="0"/>
                      </a:lnTo>
                    </a:path>
                  </a:pathLst>
                </a:cu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5" name="Rectangle 330"/>
                <p:cNvSpPr>
                  <a:spLocks noChangeArrowheads="1"/>
                </p:cNvSpPr>
                <p:nvPr/>
              </p:nvSpPr>
              <p:spPr bwMode="auto">
                <a:xfrm rot="120000">
                  <a:off x="2261" y="2097"/>
                  <a:ext cx="108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</a:p>
              </p:txBody>
            </p:sp>
            <p:sp>
              <p:nvSpPr>
                <p:cNvPr id="146" name="Line 331"/>
                <p:cNvSpPr>
                  <a:spLocks noChangeShapeType="1"/>
                </p:cNvSpPr>
                <p:nvPr/>
              </p:nvSpPr>
              <p:spPr bwMode="auto">
                <a:xfrm flipH="1" flipV="1">
                  <a:off x="2221" y="2059"/>
                  <a:ext cx="476" cy="19"/>
                </a:xfrm>
                <a:prstGeom prst="line">
                  <a:avLst/>
                </a:pr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7" name="Rectangle 332"/>
                <p:cNvSpPr>
                  <a:spLocks noChangeArrowheads="1"/>
                </p:cNvSpPr>
                <p:nvPr/>
              </p:nvSpPr>
              <p:spPr bwMode="auto">
                <a:xfrm rot="600000">
                  <a:off x="1658" y="1679"/>
                  <a:ext cx="279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MX-B2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8" name="Line 333"/>
                <p:cNvSpPr>
                  <a:spLocks noChangeShapeType="1"/>
                </p:cNvSpPr>
                <p:nvPr/>
              </p:nvSpPr>
              <p:spPr bwMode="auto">
                <a:xfrm flipH="1" flipV="1">
                  <a:off x="2114" y="1796"/>
                  <a:ext cx="534" cy="104"/>
                </a:xfrm>
                <a:prstGeom prst="line">
                  <a:avLst/>
                </a:pr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9" name="Rectangle 334"/>
                <p:cNvSpPr>
                  <a:spLocks noChangeArrowheads="1"/>
                </p:cNvSpPr>
                <p:nvPr/>
              </p:nvSpPr>
              <p:spPr bwMode="auto">
                <a:xfrm rot="900000">
                  <a:off x="1771" y="1504"/>
                  <a:ext cx="206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ZY-B1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0" name="Line 335"/>
                <p:cNvSpPr>
                  <a:spLocks noChangeShapeType="1"/>
                </p:cNvSpPr>
                <p:nvPr/>
              </p:nvSpPr>
              <p:spPr bwMode="auto">
                <a:xfrm flipH="1" flipV="1">
                  <a:off x="2147" y="1653"/>
                  <a:ext cx="457" cy="129"/>
                </a:xfrm>
                <a:prstGeom prst="line">
                  <a:avLst/>
                </a:pr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1" name="Rectangle 336"/>
                <p:cNvSpPr>
                  <a:spLocks noChangeArrowheads="1"/>
                </p:cNvSpPr>
                <p:nvPr/>
              </p:nvSpPr>
              <p:spPr bwMode="auto">
                <a:xfrm rot="1200000">
                  <a:off x="1806" y="1341"/>
                  <a:ext cx="226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X-B2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2" name="Line 337"/>
                <p:cNvSpPr>
                  <a:spLocks noChangeShapeType="1"/>
                </p:cNvSpPr>
                <p:nvPr/>
              </p:nvSpPr>
              <p:spPr bwMode="auto">
                <a:xfrm flipH="1" flipV="1">
                  <a:off x="2194" y="1512"/>
                  <a:ext cx="380" cy="144"/>
                </a:xfrm>
                <a:prstGeom prst="line">
                  <a:avLst/>
                </a:pr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3" name="Rectangle 338"/>
                <p:cNvSpPr>
                  <a:spLocks noChangeArrowheads="1"/>
                </p:cNvSpPr>
                <p:nvPr/>
              </p:nvSpPr>
              <p:spPr bwMode="auto">
                <a:xfrm rot="1500000">
                  <a:off x="1876" y="1185"/>
                  <a:ext cx="206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JW-B2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4" name="Line 339"/>
                <p:cNvSpPr>
                  <a:spLocks noChangeShapeType="1"/>
                </p:cNvSpPr>
                <p:nvPr/>
              </p:nvSpPr>
              <p:spPr bwMode="auto">
                <a:xfrm flipH="1" flipV="1">
                  <a:off x="2251" y="1377"/>
                  <a:ext cx="306" cy="147"/>
                </a:xfrm>
                <a:prstGeom prst="line">
                  <a:avLst/>
                </a:pr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5" name="Rectangle 340"/>
                <p:cNvSpPr>
                  <a:spLocks noChangeArrowheads="1"/>
                </p:cNvSpPr>
                <p:nvPr/>
              </p:nvSpPr>
              <p:spPr bwMode="auto">
                <a:xfrm rot="1800000">
                  <a:off x="1934" y="1026"/>
                  <a:ext cx="263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XNB-B2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6" name="Line 341"/>
                <p:cNvSpPr>
                  <a:spLocks noChangeShapeType="1"/>
                </p:cNvSpPr>
                <p:nvPr/>
              </p:nvSpPr>
              <p:spPr bwMode="auto">
                <a:xfrm flipH="1" flipV="1">
                  <a:off x="2321" y="1247"/>
                  <a:ext cx="233" cy="138"/>
                </a:xfrm>
                <a:prstGeom prst="line">
                  <a:avLst/>
                </a:pr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7" name="Rectangle 342"/>
                <p:cNvSpPr>
                  <a:spLocks noChangeArrowheads="1"/>
                </p:cNvSpPr>
                <p:nvPr/>
              </p:nvSpPr>
              <p:spPr bwMode="auto">
                <a:xfrm rot="2100000">
                  <a:off x="2090" y="903"/>
                  <a:ext cx="210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H-B2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8" name="Line 343"/>
                <p:cNvSpPr>
                  <a:spLocks noChangeShapeType="1"/>
                </p:cNvSpPr>
                <p:nvPr/>
              </p:nvSpPr>
              <p:spPr bwMode="auto">
                <a:xfrm flipH="1" flipV="1">
                  <a:off x="2402" y="1122"/>
                  <a:ext cx="163" cy="116"/>
                </a:xfrm>
                <a:prstGeom prst="line">
                  <a:avLst/>
                </a:pr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9" name="Rectangle 344"/>
                <p:cNvSpPr>
                  <a:spLocks noChangeArrowheads="1"/>
                </p:cNvSpPr>
                <p:nvPr/>
              </p:nvSpPr>
              <p:spPr bwMode="auto">
                <a:xfrm rot="2400000">
                  <a:off x="2209" y="787"/>
                  <a:ext cx="198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C-B2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0" name="Line 345"/>
                <p:cNvSpPr>
                  <a:spLocks noChangeShapeType="1"/>
                </p:cNvSpPr>
                <p:nvPr/>
              </p:nvSpPr>
              <p:spPr bwMode="auto">
                <a:xfrm flipH="1" flipV="1">
                  <a:off x="2494" y="1006"/>
                  <a:ext cx="100" cy="86"/>
                </a:xfrm>
                <a:prstGeom prst="line">
                  <a:avLst/>
                </a:pr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1" name="Rectangle 346"/>
                <p:cNvSpPr>
                  <a:spLocks noChangeArrowheads="1"/>
                </p:cNvSpPr>
                <p:nvPr/>
              </p:nvSpPr>
              <p:spPr bwMode="auto">
                <a:xfrm rot="2700000">
                  <a:off x="2309" y="662"/>
                  <a:ext cx="214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X-B2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2" name="Line 347"/>
                <p:cNvSpPr>
                  <a:spLocks noChangeShapeType="1"/>
                </p:cNvSpPr>
                <p:nvPr/>
              </p:nvSpPr>
              <p:spPr bwMode="auto">
                <a:xfrm flipH="1" flipV="1">
                  <a:off x="2593" y="897"/>
                  <a:ext cx="44" cy="46"/>
                </a:xfrm>
                <a:prstGeom prst="line">
                  <a:avLst/>
                </a:pr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3" name="Rectangle 348"/>
                <p:cNvSpPr>
                  <a:spLocks noChangeArrowheads="1"/>
                </p:cNvSpPr>
                <p:nvPr/>
              </p:nvSpPr>
              <p:spPr bwMode="auto">
                <a:xfrm rot="3000000">
                  <a:off x="2427" y="538"/>
                  <a:ext cx="210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B-B2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4" name="Line 349"/>
                <p:cNvSpPr>
                  <a:spLocks noChangeShapeType="1"/>
                </p:cNvSpPr>
                <p:nvPr/>
              </p:nvSpPr>
              <p:spPr bwMode="auto">
                <a:xfrm flipH="1" flipV="1">
                  <a:off x="2701" y="799"/>
                  <a:ext cx="41" cy="48"/>
                </a:xfrm>
                <a:prstGeom prst="line">
                  <a:avLst/>
                </a:pr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5" name="Freeform 350"/>
                <p:cNvSpPr/>
                <p:nvPr/>
              </p:nvSpPr>
              <p:spPr bwMode="auto">
                <a:xfrm>
                  <a:off x="2640" y="895"/>
                  <a:ext cx="51" cy="49"/>
                </a:xfrm>
                <a:custGeom>
                  <a:avLst/>
                  <a:gdLst>
                    <a:gd name="T0" fmla="*/ 51 w 51"/>
                    <a:gd name="T1" fmla="*/ 0 h 49"/>
                    <a:gd name="T2" fmla="*/ 47 w 51"/>
                    <a:gd name="T3" fmla="*/ 3 h 49"/>
                    <a:gd name="T4" fmla="*/ 44 w 51"/>
                    <a:gd name="T5" fmla="*/ 6 h 49"/>
                    <a:gd name="T6" fmla="*/ 41 w 51"/>
                    <a:gd name="T7" fmla="*/ 9 h 49"/>
                    <a:gd name="T8" fmla="*/ 39 w 51"/>
                    <a:gd name="T9" fmla="*/ 12 h 49"/>
                    <a:gd name="T10" fmla="*/ 36 w 51"/>
                    <a:gd name="T11" fmla="*/ 15 h 49"/>
                    <a:gd name="T12" fmla="*/ 33 w 51"/>
                    <a:gd name="T13" fmla="*/ 18 h 49"/>
                    <a:gd name="T14" fmla="*/ 30 w 51"/>
                    <a:gd name="T15" fmla="*/ 20 h 49"/>
                    <a:gd name="T16" fmla="*/ 26 w 51"/>
                    <a:gd name="T17" fmla="*/ 23 h 49"/>
                    <a:gd name="T18" fmla="*/ 23 w 51"/>
                    <a:gd name="T19" fmla="*/ 26 h 49"/>
                    <a:gd name="T20" fmla="*/ 20 w 51"/>
                    <a:gd name="T21" fmla="*/ 29 h 49"/>
                    <a:gd name="T22" fmla="*/ 17 w 51"/>
                    <a:gd name="T23" fmla="*/ 32 h 49"/>
                    <a:gd name="T24" fmla="*/ 14 w 51"/>
                    <a:gd name="T25" fmla="*/ 35 h 49"/>
                    <a:gd name="T26" fmla="*/ 11 w 51"/>
                    <a:gd name="T27" fmla="*/ 38 h 49"/>
                    <a:gd name="T28" fmla="*/ 8 w 51"/>
                    <a:gd name="T29" fmla="*/ 41 h 49"/>
                    <a:gd name="T30" fmla="*/ 6 w 51"/>
                    <a:gd name="T31" fmla="*/ 43 h 49"/>
                    <a:gd name="T32" fmla="*/ 3 w 51"/>
                    <a:gd name="T33" fmla="*/ 46 h 49"/>
                    <a:gd name="T34" fmla="*/ 0 w 51"/>
                    <a:gd name="T35" fmla="*/ 49 h 4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51" h="49">
                      <a:moveTo>
                        <a:pt x="51" y="0"/>
                      </a:moveTo>
                      <a:lnTo>
                        <a:pt x="47" y="3"/>
                      </a:lnTo>
                      <a:lnTo>
                        <a:pt x="44" y="6"/>
                      </a:lnTo>
                      <a:lnTo>
                        <a:pt x="41" y="9"/>
                      </a:lnTo>
                      <a:lnTo>
                        <a:pt x="39" y="12"/>
                      </a:lnTo>
                      <a:lnTo>
                        <a:pt x="36" y="15"/>
                      </a:lnTo>
                      <a:lnTo>
                        <a:pt x="33" y="18"/>
                      </a:lnTo>
                      <a:lnTo>
                        <a:pt x="30" y="20"/>
                      </a:lnTo>
                      <a:lnTo>
                        <a:pt x="26" y="23"/>
                      </a:lnTo>
                      <a:lnTo>
                        <a:pt x="23" y="26"/>
                      </a:lnTo>
                      <a:lnTo>
                        <a:pt x="20" y="29"/>
                      </a:lnTo>
                      <a:lnTo>
                        <a:pt x="17" y="32"/>
                      </a:lnTo>
                      <a:lnTo>
                        <a:pt x="14" y="35"/>
                      </a:lnTo>
                      <a:lnTo>
                        <a:pt x="11" y="38"/>
                      </a:lnTo>
                      <a:lnTo>
                        <a:pt x="8" y="41"/>
                      </a:lnTo>
                      <a:lnTo>
                        <a:pt x="6" y="43"/>
                      </a:lnTo>
                      <a:lnTo>
                        <a:pt x="3" y="46"/>
                      </a:lnTo>
                      <a:lnTo>
                        <a:pt x="0" y="49"/>
                      </a:lnTo>
                    </a:path>
                  </a:pathLst>
                </a:cu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6" name="Freeform 351"/>
                <p:cNvSpPr/>
                <p:nvPr/>
              </p:nvSpPr>
              <p:spPr bwMode="auto">
                <a:xfrm>
                  <a:off x="2691" y="849"/>
                  <a:ext cx="54" cy="46"/>
                </a:xfrm>
                <a:custGeom>
                  <a:avLst/>
                  <a:gdLst>
                    <a:gd name="T0" fmla="*/ 0 w 54"/>
                    <a:gd name="T1" fmla="*/ 46 h 46"/>
                    <a:gd name="T2" fmla="*/ 3 w 54"/>
                    <a:gd name="T3" fmla="*/ 44 h 46"/>
                    <a:gd name="T4" fmla="*/ 6 w 54"/>
                    <a:gd name="T5" fmla="*/ 41 h 46"/>
                    <a:gd name="T6" fmla="*/ 9 w 54"/>
                    <a:gd name="T7" fmla="*/ 38 h 46"/>
                    <a:gd name="T8" fmla="*/ 12 w 54"/>
                    <a:gd name="T9" fmla="*/ 35 h 46"/>
                    <a:gd name="T10" fmla="*/ 15 w 54"/>
                    <a:gd name="T11" fmla="*/ 33 h 46"/>
                    <a:gd name="T12" fmla="*/ 19 w 54"/>
                    <a:gd name="T13" fmla="*/ 31 h 46"/>
                    <a:gd name="T14" fmla="*/ 22 w 54"/>
                    <a:gd name="T15" fmla="*/ 28 h 46"/>
                    <a:gd name="T16" fmla="*/ 25 w 54"/>
                    <a:gd name="T17" fmla="*/ 25 h 46"/>
                    <a:gd name="T18" fmla="*/ 28 w 54"/>
                    <a:gd name="T19" fmla="*/ 22 h 46"/>
                    <a:gd name="T20" fmla="*/ 31 w 54"/>
                    <a:gd name="T21" fmla="*/ 19 h 46"/>
                    <a:gd name="T22" fmla="*/ 35 w 54"/>
                    <a:gd name="T23" fmla="*/ 16 h 46"/>
                    <a:gd name="T24" fmla="*/ 38 w 54"/>
                    <a:gd name="T25" fmla="*/ 13 h 46"/>
                    <a:gd name="T26" fmla="*/ 41 w 54"/>
                    <a:gd name="T27" fmla="*/ 11 h 46"/>
                    <a:gd name="T28" fmla="*/ 43 w 54"/>
                    <a:gd name="T29" fmla="*/ 8 h 46"/>
                    <a:gd name="T30" fmla="*/ 48 w 54"/>
                    <a:gd name="T31" fmla="*/ 6 h 46"/>
                    <a:gd name="T32" fmla="*/ 51 w 54"/>
                    <a:gd name="T33" fmla="*/ 3 h 46"/>
                    <a:gd name="T34" fmla="*/ 54 w 54"/>
                    <a:gd name="T35" fmla="*/ 0 h 4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54" h="46">
                      <a:moveTo>
                        <a:pt x="0" y="46"/>
                      </a:moveTo>
                      <a:lnTo>
                        <a:pt x="3" y="44"/>
                      </a:lnTo>
                      <a:lnTo>
                        <a:pt x="6" y="41"/>
                      </a:lnTo>
                      <a:lnTo>
                        <a:pt x="9" y="38"/>
                      </a:lnTo>
                      <a:lnTo>
                        <a:pt x="12" y="35"/>
                      </a:lnTo>
                      <a:lnTo>
                        <a:pt x="15" y="33"/>
                      </a:lnTo>
                      <a:lnTo>
                        <a:pt x="19" y="31"/>
                      </a:lnTo>
                      <a:lnTo>
                        <a:pt x="22" y="28"/>
                      </a:lnTo>
                      <a:lnTo>
                        <a:pt x="25" y="25"/>
                      </a:lnTo>
                      <a:lnTo>
                        <a:pt x="28" y="22"/>
                      </a:lnTo>
                      <a:lnTo>
                        <a:pt x="31" y="19"/>
                      </a:lnTo>
                      <a:lnTo>
                        <a:pt x="35" y="16"/>
                      </a:lnTo>
                      <a:lnTo>
                        <a:pt x="38" y="13"/>
                      </a:lnTo>
                      <a:lnTo>
                        <a:pt x="41" y="11"/>
                      </a:lnTo>
                      <a:lnTo>
                        <a:pt x="43" y="8"/>
                      </a:lnTo>
                      <a:lnTo>
                        <a:pt x="48" y="6"/>
                      </a:lnTo>
                      <a:lnTo>
                        <a:pt x="51" y="3"/>
                      </a:lnTo>
                      <a:lnTo>
                        <a:pt x="54" y="0"/>
                      </a:lnTo>
                    </a:path>
                  </a:pathLst>
                </a:cu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8" name="Line 353"/>
                <p:cNvSpPr>
                  <a:spLocks noChangeShapeType="1"/>
                </p:cNvSpPr>
                <p:nvPr/>
              </p:nvSpPr>
              <p:spPr bwMode="auto">
                <a:xfrm flipH="1" flipV="1">
                  <a:off x="2693" y="897"/>
                  <a:ext cx="43" cy="47"/>
                </a:xfrm>
                <a:prstGeom prst="line">
                  <a:avLst/>
                </a:pr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9" name="Freeform 354"/>
                <p:cNvSpPr/>
                <p:nvPr/>
              </p:nvSpPr>
              <p:spPr bwMode="auto">
                <a:xfrm>
                  <a:off x="2595" y="1017"/>
                  <a:ext cx="69" cy="76"/>
                </a:xfrm>
                <a:custGeom>
                  <a:avLst/>
                  <a:gdLst>
                    <a:gd name="T0" fmla="*/ 69 w 69"/>
                    <a:gd name="T1" fmla="*/ 0 h 76"/>
                    <a:gd name="T2" fmla="*/ 66 w 69"/>
                    <a:gd name="T3" fmla="*/ 3 h 76"/>
                    <a:gd name="T4" fmla="*/ 63 w 69"/>
                    <a:gd name="T5" fmla="*/ 6 h 76"/>
                    <a:gd name="T6" fmla="*/ 62 w 69"/>
                    <a:gd name="T7" fmla="*/ 8 h 76"/>
                    <a:gd name="T8" fmla="*/ 59 w 69"/>
                    <a:gd name="T9" fmla="*/ 10 h 76"/>
                    <a:gd name="T10" fmla="*/ 56 w 69"/>
                    <a:gd name="T11" fmla="*/ 13 h 76"/>
                    <a:gd name="T12" fmla="*/ 55 w 69"/>
                    <a:gd name="T13" fmla="*/ 16 h 76"/>
                    <a:gd name="T14" fmla="*/ 52 w 69"/>
                    <a:gd name="T15" fmla="*/ 18 h 76"/>
                    <a:gd name="T16" fmla="*/ 49 w 69"/>
                    <a:gd name="T17" fmla="*/ 20 h 76"/>
                    <a:gd name="T18" fmla="*/ 48 w 69"/>
                    <a:gd name="T19" fmla="*/ 23 h 76"/>
                    <a:gd name="T20" fmla="*/ 45 w 69"/>
                    <a:gd name="T21" fmla="*/ 26 h 76"/>
                    <a:gd name="T22" fmla="*/ 43 w 69"/>
                    <a:gd name="T23" fmla="*/ 28 h 76"/>
                    <a:gd name="T24" fmla="*/ 41 w 69"/>
                    <a:gd name="T25" fmla="*/ 30 h 76"/>
                    <a:gd name="T26" fmla="*/ 38 w 69"/>
                    <a:gd name="T27" fmla="*/ 33 h 76"/>
                    <a:gd name="T28" fmla="*/ 36 w 69"/>
                    <a:gd name="T29" fmla="*/ 35 h 76"/>
                    <a:gd name="T30" fmla="*/ 33 w 69"/>
                    <a:gd name="T31" fmla="*/ 38 h 76"/>
                    <a:gd name="T32" fmla="*/ 32 w 69"/>
                    <a:gd name="T33" fmla="*/ 41 h 76"/>
                    <a:gd name="T34" fmla="*/ 29 w 69"/>
                    <a:gd name="T35" fmla="*/ 43 h 76"/>
                    <a:gd name="T36" fmla="*/ 26 w 69"/>
                    <a:gd name="T37" fmla="*/ 46 h 76"/>
                    <a:gd name="T38" fmla="*/ 25 w 69"/>
                    <a:gd name="T39" fmla="*/ 48 h 76"/>
                    <a:gd name="T40" fmla="*/ 22 w 69"/>
                    <a:gd name="T41" fmla="*/ 51 h 76"/>
                    <a:gd name="T42" fmla="*/ 20 w 69"/>
                    <a:gd name="T43" fmla="*/ 53 h 76"/>
                    <a:gd name="T44" fmla="*/ 18 w 69"/>
                    <a:gd name="T45" fmla="*/ 56 h 76"/>
                    <a:gd name="T46" fmla="*/ 16 w 69"/>
                    <a:gd name="T47" fmla="*/ 58 h 76"/>
                    <a:gd name="T48" fmla="*/ 13 w 69"/>
                    <a:gd name="T49" fmla="*/ 61 h 76"/>
                    <a:gd name="T50" fmla="*/ 10 w 69"/>
                    <a:gd name="T51" fmla="*/ 63 h 76"/>
                    <a:gd name="T52" fmla="*/ 9 w 69"/>
                    <a:gd name="T53" fmla="*/ 66 h 76"/>
                    <a:gd name="T54" fmla="*/ 6 w 69"/>
                    <a:gd name="T55" fmla="*/ 69 h 76"/>
                    <a:gd name="T56" fmla="*/ 5 w 69"/>
                    <a:gd name="T57" fmla="*/ 71 h 76"/>
                    <a:gd name="T58" fmla="*/ 2 w 69"/>
                    <a:gd name="T59" fmla="*/ 74 h 76"/>
                    <a:gd name="T60" fmla="*/ 0 w 69"/>
                    <a:gd name="T61" fmla="*/ 76 h 7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</a:cxnLst>
                  <a:rect l="0" t="0" r="r" b="b"/>
                  <a:pathLst>
                    <a:path w="69" h="76">
                      <a:moveTo>
                        <a:pt x="69" y="0"/>
                      </a:moveTo>
                      <a:lnTo>
                        <a:pt x="66" y="3"/>
                      </a:lnTo>
                      <a:lnTo>
                        <a:pt x="63" y="6"/>
                      </a:lnTo>
                      <a:lnTo>
                        <a:pt x="62" y="8"/>
                      </a:lnTo>
                      <a:lnTo>
                        <a:pt x="59" y="10"/>
                      </a:lnTo>
                      <a:lnTo>
                        <a:pt x="56" y="13"/>
                      </a:lnTo>
                      <a:lnTo>
                        <a:pt x="55" y="16"/>
                      </a:lnTo>
                      <a:lnTo>
                        <a:pt x="52" y="18"/>
                      </a:lnTo>
                      <a:lnTo>
                        <a:pt x="49" y="20"/>
                      </a:lnTo>
                      <a:lnTo>
                        <a:pt x="48" y="23"/>
                      </a:lnTo>
                      <a:lnTo>
                        <a:pt x="45" y="26"/>
                      </a:lnTo>
                      <a:lnTo>
                        <a:pt x="43" y="28"/>
                      </a:lnTo>
                      <a:lnTo>
                        <a:pt x="41" y="30"/>
                      </a:lnTo>
                      <a:lnTo>
                        <a:pt x="38" y="33"/>
                      </a:lnTo>
                      <a:lnTo>
                        <a:pt x="36" y="35"/>
                      </a:lnTo>
                      <a:lnTo>
                        <a:pt x="33" y="38"/>
                      </a:lnTo>
                      <a:lnTo>
                        <a:pt x="32" y="41"/>
                      </a:lnTo>
                      <a:lnTo>
                        <a:pt x="29" y="43"/>
                      </a:lnTo>
                      <a:lnTo>
                        <a:pt x="26" y="46"/>
                      </a:lnTo>
                      <a:lnTo>
                        <a:pt x="25" y="48"/>
                      </a:lnTo>
                      <a:lnTo>
                        <a:pt x="22" y="51"/>
                      </a:lnTo>
                      <a:lnTo>
                        <a:pt x="20" y="53"/>
                      </a:lnTo>
                      <a:lnTo>
                        <a:pt x="18" y="56"/>
                      </a:lnTo>
                      <a:lnTo>
                        <a:pt x="16" y="58"/>
                      </a:lnTo>
                      <a:lnTo>
                        <a:pt x="13" y="61"/>
                      </a:lnTo>
                      <a:lnTo>
                        <a:pt x="10" y="63"/>
                      </a:lnTo>
                      <a:lnTo>
                        <a:pt x="9" y="66"/>
                      </a:lnTo>
                      <a:lnTo>
                        <a:pt x="6" y="69"/>
                      </a:lnTo>
                      <a:lnTo>
                        <a:pt x="5" y="71"/>
                      </a:lnTo>
                      <a:lnTo>
                        <a:pt x="2" y="74"/>
                      </a:lnTo>
                      <a:lnTo>
                        <a:pt x="0" y="76"/>
                      </a:lnTo>
                    </a:path>
                  </a:pathLst>
                </a:cu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0" name="Freeform 355"/>
                <p:cNvSpPr/>
                <p:nvPr/>
              </p:nvSpPr>
              <p:spPr bwMode="auto">
                <a:xfrm>
                  <a:off x="2664" y="947"/>
                  <a:ext cx="73" cy="70"/>
                </a:xfrm>
                <a:custGeom>
                  <a:avLst/>
                  <a:gdLst>
                    <a:gd name="T0" fmla="*/ 0 w 73"/>
                    <a:gd name="T1" fmla="*/ 70 h 70"/>
                    <a:gd name="T2" fmla="*/ 3 w 73"/>
                    <a:gd name="T3" fmla="*/ 67 h 70"/>
                    <a:gd name="T4" fmla="*/ 6 w 73"/>
                    <a:gd name="T5" fmla="*/ 63 h 70"/>
                    <a:gd name="T6" fmla="*/ 10 w 73"/>
                    <a:gd name="T7" fmla="*/ 60 h 70"/>
                    <a:gd name="T8" fmla="*/ 13 w 73"/>
                    <a:gd name="T9" fmla="*/ 57 h 70"/>
                    <a:gd name="T10" fmla="*/ 16 w 73"/>
                    <a:gd name="T11" fmla="*/ 53 h 70"/>
                    <a:gd name="T12" fmla="*/ 20 w 73"/>
                    <a:gd name="T13" fmla="*/ 50 h 70"/>
                    <a:gd name="T14" fmla="*/ 23 w 73"/>
                    <a:gd name="T15" fmla="*/ 46 h 70"/>
                    <a:gd name="T16" fmla="*/ 27 w 73"/>
                    <a:gd name="T17" fmla="*/ 43 h 70"/>
                    <a:gd name="T18" fmla="*/ 30 w 73"/>
                    <a:gd name="T19" fmla="*/ 40 h 70"/>
                    <a:gd name="T20" fmla="*/ 35 w 73"/>
                    <a:gd name="T21" fmla="*/ 36 h 70"/>
                    <a:gd name="T22" fmla="*/ 37 w 73"/>
                    <a:gd name="T23" fmla="*/ 33 h 70"/>
                    <a:gd name="T24" fmla="*/ 40 w 73"/>
                    <a:gd name="T25" fmla="*/ 30 h 70"/>
                    <a:gd name="T26" fmla="*/ 45 w 73"/>
                    <a:gd name="T27" fmla="*/ 26 h 70"/>
                    <a:gd name="T28" fmla="*/ 48 w 73"/>
                    <a:gd name="T29" fmla="*/ 23 h 70"/>
                    <a:gd name="T30" fmla="*/ 52 w 73"/>
                    <a:gd name="T31" fmla="*/ 20 h 70"/>
                    <a:gd name="T32" fmla="*/ 55 w 73"/>
                    <a:gd name="T33" fmla="*/ 16 h 70"/>
                    <a:gd name="T34" fmla="*/ 59 w 73"/>
                    <a:gd name="T35" fmla="*/ 13 h 70"/>
                    <a:gd name="T36" fmla="*/ 62 w 73"/>
                    <a:gd name="T37" fmla="*/ 10 h 70"/>
                    <a:gd name="T38" fmla="*/ 66 w 73"/>
                    <a:gd name="T39" fmla="*/ 6 h 70"/>
                    <a:gd name="T40" fmla="*/ 69 w 73"/>
                    <a:gd name="T41" fmla="*/ 3 h 70"/>
                    <a:gd name="T42" fmla="*/ 73 w 73"/>
                    <a:gd name="T43" fmla="*/ 0 h 7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</a:cxnLst>
                  <a:rect l="0" t="0" r="r" b="b"/>
                  <a:pathLst>
                    <a:path w="73" h="70">
                      <a:moveTo>
                        <a:pt x="0" y="70"/>
                      </a:moveTo>
                      <a:lnTo>
                        <a:pt x="3" y="67"/>
                      </a:lnTo>
                      <a:lnTo>
                        <a:pt x="6" y="63"/>
                      </a:lnTo>
                      <a:lnTo>
                        <a:pt x="10" y="60"/>
                      </a:lnTo>
                      <a:lnTo>
                        <a:pt x="13" y="57"/>
                      </a:lnTo>
                      <a:lnTo>
                        <a:pt x="16" y="53"/>
                      </a:lnTo>
                      <a:lnTo>
                        <a:pt x="20" y="50"/>
                      </a:lnTo>
                      <a:lnTo>
                        <a:pt x="23" y="46"/>
                      </a:lnTo>
                      <a:lnTo>
                        <a:pt x="27" y="43"/>
                      </a:lnTo>
                      <a:lnTo>
                        <a:pt x="30" y="40"/>
                      </a:lnTo>
                      <a:lnTo>
                        <a:pt x="35" y="36"/>
                      </a:lnTo>
                      <a:lnTo>
                        <a:pt x="37" y="33"/>
                      </a:lnTo>
                      <a:lnTo>
                        <a:pt x="40" y="30"/>
                      </a:lnTo>
                      <a:lnTo>
                        <a:pt x="45" y="26"/>
                      </a:lnTo>
                      <a:lnTo>
                        <a:pt x="48" y="23"/>
                      </a:lnTo>
                      <a:lnTo>
                        <a:pt x="52" y="20"/>
                      </a:lnTo>
                      <a:lnTo>
                        <a:pt x="55" y="16"/>
                      </a:lnTo>
                      <a:lnTo>
                        <a:pt x="59" y="13"/>
                      </a:lnTo>
                      <a:lnTo>
                        <a:pt x="62" y="10"/>
                      </a:lnTo>
                      <a:lnTo>
                        <a:pt x="66" y="6"/>
                      </a:lnTo>
                      <a:lnTo>
                        <a:pt x="69" y="3"/>
                      </a:lnTo>
                      <a:lnTo>
                        <a:pt x="73" y="0"/>
                      </a:lnTo>
                    </a:path>
                  </a:pathLst>
                </a:cu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2" name="Line 357"/>
                <p:cNvSpPr>
                  <a:spLocks noChangeShapeType="1"/>
                </p:cNvSpPr>
                <p:nvPr/>
              </p:nvSpPr>
              <p:spPr bwMode="auto">
                <a:xfrm flipH="1" flipV="1">
                  <a:off x="2666" y="1019"/>
                  <a:ext cx="46" cy="44"/>
                </a:xfrm>
                <a:prstGeom prst="line">
                  <a:avLst/>
                </a:pr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3" name="Freeform 358"/>
                <p:cNvSpPr/>
                <p:nvPr/>
              </p:nvSpPr>
              <p:spPr bwMode="auto">
                <a:xfrm>
                  <a:off x="2567" y="1151"/>
                  <a:ext cx="70" cy="90"/>
                </a:xfrm>
                <a:custGeom>
                  <a:avLst/>
                  <a:gdLst>
                    <a:gd name="T0" fmla="*/ 70 w 70"/>
                    <a:gd name="T1" fmla="*/ 0 h 90"/>
                    <a:gd name="T2" fmla="*/ 69 w 70"/>
                    <a:gd name="T3" fmla="*/ 1 h 90"/>
                    <a:gd name="T4" fmla="*/ 66 w 70"/>
                    <a:gd name="T5" fmla="*/ 4 h 90"/>
                    <a:gd name="T6" fmla="*/ 64 w 70"/>
                    <a:gd name="T7" fmla="*/ 6 h 90"/>
                    <a:gd name="T8" fmla="*/ 63 w 70"/>
                    <a:gd name="T9" fmla="*/ 8 h 90"/>
                    <a:gd name="T10" fmla="*/ 61 w 70"/>
                    <a:gd name="T11" fmla="*/ 10 h 90"/>
                    <a:gd name="T12" fmla="*/ 60 w 70"/>
                    <a:gd name="T13" fmla="*/ 13 h 90"/>
                    <a:gd name="T14" fmla="*/ 57 w 70"/>
                    <a:gd name="T15" fmla="*/ 14 h 90"/>
                    <a:gd name="T16" fmla="*/ 56 w 70"/>
                    <a:gd name="T17" fmla="*/ 17 h 90"/>
                    <a:gd name="T18" fmla="*/ 54 w 70"/>
                    <a:gd name="T19" fmla="*/ 18 h 90"/>
                    <a:gd name="T20" fmla="*/ 53 w 70"/>
                    <a:gd name="T21" fmla="*/ 21 h 90"/>
                    <a:gd name="T22" fmla="*/ 50 w 70"/>
                    <a:gd name="T23" fmla="*/ 23 h 90"/>
                    <a:gd name="T24" fmla="*/ 48 w 70"/>
                    <a:gd name="T25" fmla="*/ 26 h 90"/>
                    <a:gd name="T26" fmla="*/ 47 w 70"/>
                    <a:gd name="T27" fmla="*/ 27 h 90"/>
                    <a:gd name="T28" fmla="*/ 46 w 70"/>
                    <a:gd name="T29" fmla="*/ 30 h 90"/>
                    <a:gd name="T30" fmla="*/ 44 w 70"/>
                    <a:gd name="T31" fmla="*/ 31 h 90"/>
                    <a:gd name="T32" fmla="*/ 41 w 70"/>
                    <a:gd name="T33" fmla="*/ 34 h 90"/>
                    <a:gd name="T34" fmla="*/ 40 w 70"/>
                    <a:gd name="T35" fmla="*/ 36 h 90"/>
                    <a:gd name="T36" fmla="*/ 38 w 70"/>
                    <a:gd name="T37" fmla="*/ 39 h 90"/>
                    <a:gd name="T38" fmla="*/ 37 w 70"/>
                    <a:gd name="T39" fmla="*/ 40 h 90"/>
                    <a:gd name="T40" fmla="*/ 36 w 70"/>
                    <a:gd name="T41" fmla="*/ 43 h 90"/>
                    <a:gd name="T42" fmla="*/ 33 w 70"/>
                    <a:gd name="T43" fmla="*/ 46 h 90"/>
                    <a:gd name="T44" fmla="*/ 31 w 70"/>
                    <a:gd name="T45" fmla="*/ 47 h 90"/>
                    <a:gd name="T46" fmla="*/ 30 w 70"/>
                    <a:gd name="T47" fmla="*/ 50 h 90"/>
                    <a:gd name="T48" fmla="*/ 28 w 70"/>
                    <a:gd name="T49" fmla="*/ 51 h 90"/>
                    <a:gd name="T50" fmla="*/ 27 w 70"/>
                    <a:gd name="T51" fmla="*/ 54 h 90"/>
                    <a:gd name="T52" fmla="*/ 26 w 70"/>
                    <a:gd name="T53" fmla="*/ 56 h 90"/>
                    <a:gd name="T54" fmla="*/ 23 w 70"/>
                    <a:gd name="T55" fmla="*/ 59 h 90"/>
                    <a:gd name="T56" fmla="*/ 21 w 70"/>
                    <a:gd name="T57" fmla="*/ 60 h 90"/>
                    <a:gd name="T58" fmla="*/ 20 w 70"/>
                    <a:gd name="T59" fmla="*/ 63 h 90"/>
                    <a:gd name="T60" fmla="*/ 18 w 70"/>
                    <a:gd name="T61" fmla="*/ 64 h 90"/>
                    <a:gd name="T62" fmla="*/ 17 w 70"/>
                    <a:gd name="T63" fmla="*/ 67 h 90"/>
                    <a:gd name="T64" fmla="*/ 15 w 70"/>
                    <a:gd name="T65" fmla="*/ 70 h 90"/>
                    <a:gd name="T66" fmla="*/ 13 w 70"/>
                    <a:gd name="T67" fmla="*/ 72 h 90"/>
                    <a:gd name="T68" fmla="*/ 11 w 70"/>
                    <a:gd name="T69" fmla="*/ 74 h 90"/>
                    <a:gd name="T70" fmla="*/ 10 w 70"/>
                    <a:gd name="T71" fmla="*/ 76 h 90"/>
                    <a:gd name="T72" fmla="*/ 8 w 70"/>
                    <a:gd name="T73" fmla="*/ 79 h 90"/>
                    <a:gd name="T74" fmla="*/ 7 w 70"/>
                    <a:gd name="T75" fmla="*/ 80 h 90"/>
                    <a:gd name="T76" fmla="*/ 5 w 70"/>
                    <a:gd name="T77" fmla="*/ 83 h 90"/>
                    <a:gd name="T78" fmla="*/ 4 w 70"/>
                    <a:gd name="T79" fmla="*/ 86 h 90"/>
                    <a:gd name="T80" fmla="*/ 1 w 70"/>
                    <a:gd name="T81" fmla="*/ 87 h 90"/>
                    <a:gd name="T82" fmla="*/ 0 w 70"/>
                    <a:gd name="T83" fmla="*/ 90 h 9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</a:cxnLst>
                  <a:rect l="0" t="0" r="r" b="b"/>
                  <a:pathLst>
                    <a:path w="70" h="90">
                      <a:moveTo>
                        <a:pt x="70" y="0"/>
                      </a:moveTo>
                      <a:lnTo>
                        <a:pt x="69" y="1"/>
                      </a:lnTo>
                      <a:lnTo>
                        <a:pt x="66" y="4"/>
                      </a:lnTo>
                      <a:lnTo>
                        <a:pt x="64" y="6"/>
                      </a:lnTo>
                      <a:lnTo>
                        <a:pt x="63" y="8"/>
                      </a:lnTo>
                      <a:lnTo>
                        <a:pt x="61" y="10"/>
                      </a:lnTo>
                      <a:lnTo>
                        <a:pt x="60" y="13"/>
                      </a:lnTo>
                      <a:lnTo>
                        <a:pt x="57" y="14"/>
                      </a:lnTo>
                      <a:lnTo>
                        <a:pt x="56" y="17"/>
                      </a:lnTo>
                      <a:lnTo>
                        <a:pt x="54" y="18"/>
                      </a:lnTo>
                      <a:lnTo>
                        <a:pt x="53" y="21"/>
                      </a:lnTo>
                      <a:lnTo>
                        <a:pt x="50" y="23"/>
                      </a:lnTo>
                      <a:lnTo>
                        <a:pt x="48" y="26"/>
                      </a:lnTo>
                      <a:lnTo>
                        <a:pt x="47" y="27"/>
                      </a:lnTo>
                      <a:lnTo>
                        <a:pt x="46" y="30"/>
                      </a:lnTo>
                      <a:lnTo>
                        <a:pt x="44" y="31"/>
                      </a:lnTo>
                      <a:lnTo>
                        <a:pt x="41" y="34"/>
                      </a:lnTo>
                      <a:lnTo>
                        <a:pt x="40" y="36"/>
                      </a:lnTo>
                      <a:lnTo>
                        <a:pt x="38" y="39"/>
                      </a:lnTo>
                      <a:lnTo>
                        <a:pt x="37" y="40"/>
                      </a:lnTo>
                      <a:lnTo>
                        <a:pt x="36" y="43"/>
                      </a:lnTo>
                      <a:lnTo>
                        <a:pt x="33" y="46"/>
                      </a:lnTo>
                      <a:lnTo>
                        <a:pt x="31" y="47"/>
                      </a:lnTo>
                      <a:lnTo>
                        <a:pt x="30" y="50"/>
                      </a:lnTo>
                      <a:lnTo>
                        <a:pt x="28" y="51"/>
                      </a:lnTo>
                      <a:lnTo>
                        <a:pt x="27" y="54"/>
                      </a:lnTo>
                      <a:lnTo>
                        <a:pt x="26" y="56"/>
                      </a:lnTo>
                      <a:lnTo>
                        <a:pt x="23" y="59"/>
                      </a:lnTo>
                      <a:lnTo>
                        <a:pt x="21" y="60"/>
                      </a:lnTo>
                      <a:lnTo>
                        <a:pt x="20" y="63"/>
                      </a:lnTo>
                      <a:lnTo>
                        <a:pt x="18" y="64"/>
                      </a:lnTo>
                      <a:lnTo>
                        <a:pt x="17" y="67"/>
                      </a:lnTo>
                      <a:lnTo>
                        <a:pt x="15" y="70"/>
                      </a:lnTo>
                      <a:lnTo>
                        <a:pt x="13" y="72"/>
                      </a:lnTo>
                      <a:lnTo>
                        <a:pt x="11" y="74"/>
                      </a:lnTo>
                      <a:lnTo>
                        <a:pt x="10" y="76"/>
                      </a:lnTo>
                      <a:lnTo>
                        <a:pt x="8" y="79"/>
                      </a:lnTo>
                      <a:lnTo>
                        <a:pt x="7" y="80"/>
                      </a:lnTo>
                      <a:lnTo>
                        <a:pt x="5" y="83"/>
                      </a:lnTo>
                      <a:lnTo>
                        <a:pt x="4" y="86"/>
                      </a:lnTo>
                      <a:lnTo>
                        <a:pt x="1" y="87"/>
                      </a:lnTo>
                      <a:lnTo>
                        <a:pt x="0" y="90"/>
                      </a:lnTo>
                    </a:path>
                  </a:pathLst>
                </a:cu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4" name="Freeform 359"/>
                <p:cNvSpPr/>
                <p:nvPr/>
              </p:nvSpPr>
              <p:spPr bwMode="auto">
                <a:xfrm>
                  <a:off x="2637" y="1066"/>
                  <a:ext cx="76" cy="85"/>
                </a:xfrm>
                <a:custGeom>
                  <a:avLst/>
                  <a:gdLst>
                    <a:gd name="T0" fmla="*/ 0 w 76"/>
                    <a:gd name="T1" fmla="*/ 85 h 85"/>
                    <a:gd name="T2" fmla="*/ 3 w 76"/>
                    <a:gd name="T3" fmla="*/ 80 h 85"/>
                    <a:gd name="T4" fmla="*/ 6 w 76"/>
                    <a:gd name="T5" fmla="*/ 76 h 85"/>
                    <a:gd name="T6" fmla="*/ 10 w 76"/>
                    <a:gd name="T7" fmla="*/ 73 h 85"/>
                    <a:gd name="T8" fmla="*/ 13 w 76"/>
                    <a:gd name="T9" fmla="*/ 69 h 85"/>
                    <a:gd name="T10" fmla="*/ 16 w 76"/>
                    <a:gd name="T11" fmla="*/ 66 h 85"/>
                    <a:gd name="T12" fmla="*/ 19 w 76"/>
                    <a:gd name="T13" fmla="*/ 62 h 85"/>
                    <a:gd name="T14" fmla="*/ 23 w 76"/>
                    <a:gd name="T15" fmla="*/ 58 h 85"/>
                    <a:gd name="T16" fmla="*/ 26 w 76"/>
                    <a:gd name="T17" fmla="*/ 55 h 85"/>
                    <a:gd name="T18" fmla="*/ 29 w 76"/>
                    <a:gd name="T19" fmla="*/ 50 h 85"/>
                    <a:gd name="T20" fmla="*/ 32 w 76"/>
                    <a:gd name="T21" fmla="*/ 47 h 85"/>
                    <a:gd name="T22" fmla="*/ 36 w 76"/>
                    <a:gd name="T23" fmla="*/ 43 h 85"/>
                    <a:gd name="T24" fmla="*/ 39 w 76"/>
                    <a:gd name="T25" fmla="*/ 39 h 85"/>
                    <a:gd name="T26" fmla="*/ 42 w 76"/>
                    <a:gd name="T27" fmla="*/ 36 h 85"/>
                    <a:gd name="T28" fmla="*/ 46 w 76"/>
                    <a:gd name="T29" fmla="*/ 32 h 85"/>
                    <a:gd name="T30" fmla="*/ 49 w 76"/>
                    <a:gd name="T31" fmla="*/ 29 h 85"/>
                    <a:gd name="T32" fmla="*/ 52 w 76"/>
                    <a:gd name="T33" fmla="*/ 25 h 85"/>
                    <a:gd name="T34" fmla="*/ 56 w 76"/>
                    <a:gd name="T35" fmla="*/ 22 h 85"/>
                    <a:gd name="T36" fmla="*/ 59 w 76"/>
                    <a:gd name="T37" fmla="*/ 17 h 85"/>
                    <a:gd name="T38" fmla="*/ 62 w 76"/>
                    <a:gd name="T39" fmla="*/ 14 h 85"/>
                    <a:gd name="T40" fmla="*/ 66 w 76"/>
                    <a:gd name="T41" fmla="*/ 10 h 85"/>
                    <a:gd name="T42" fmla="*/ 69 w 76"/>
                    <a:gd name="T43" fmla="*/ 7 h 85"/>
                    <a:gd name="T44" fmla="*/ 73 w 76"/>
                    <a:gd name="T45" fmla="*/ 3 h 85"/>
                    <a:gd name="T46" fmla="*/ 76 w 76"/>
                    <a:gd name="T47" fmla="*/ 0 h 8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</a:cxnLst>
                  <a:rect l="0" t="0" r="r" b="b"/>
                  <a:pathLst>
                    <a:path w="76" h="85">
                      <a:moveTo>
                        <a:pt x="0" y="85"/>
                      </a:moveTo>
                      <a:lnTo>
                        <a:pt x="3" y="80"/>
                      </a:lnTo>
                      <a:lnTo>
                        <a:pt x="6" y="76"/>
                      </a:lnTo>
                      <a:lnTo>
                        <a:pt x="10" y="73"/>
                      </a:lnTo>
                      <a:lnTo>
                        <a:pt x="13" y="69"/>
                      </a:lnTo>
                      <a:lnTo>
                        <a:pt x="16" y="66"/>
                      </a:lnTo>
                      <a:lnTo>
                        <a:pt x="19" y="62"/>
                      </a:lnTo>
                      <a:lnTo>
                        <a:pt x="23" y="58"/>
                      </a:lnTo>
                      <a:lnTo>
                        <a:pt x="26" y="55"/>
                      </a:lnTo>
                      <a:lnTo>
                        <a:pt x="29" y="50"/>
                      </a:lnTo>
                      <a:lnTo>
                        <a:pt x="32" y="47"/>
                      </a:lnTo>
                      <a:lnTo>
                        <a:pt x="36" y="43"/>
                      </a:lnTo>
                      <a:lnTo>
                        <a:pt x="39" y="39"/>
                      </a:lnTo>
                      <a:lnTo>
                        <a:pt x="42" y="36"/>
                      </a:lnTo>
                      <a:lnTo>
                        <a:pt x="46" y="32"/>
                      </a:lnTo>
                      <a:lnTo>
                        <a:pt x="49" y="29"/>
                      </a:lnTo>
                      <a:lnTo>
                        <a:pt x="52" y="25"/>
                      </a:lnTo>
                      <a:lnTo>
                        <a:pt x="56" y="22"/>
                      </a:lnTo>
                      <a:lnTo>
                        <a:pt x="59" y="17"/>
                      </a:lnTo>
                      <a:lnTo>
                        <a:pt x="62" y="14"/>
                      </a:lnTo>
                      <a:lnTo>
                        <a:pt x="66" y="10"/>
                      </a:lnTo>
                      <a:lnTo>
                        <a:pt x="69" y="7"/>
                      </a:lnTo>
                      <a:lnTo>
                        <a:pt x="73" y="3"/>
                      </a:lnTo>
                      <a:lnTo>
                        <a:pt x="76" y="0"/>
                      </a:lnTo>
                    </a:path>
                  </a:pathLst>
                </a:cu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6" name="Line 361"/>
                <p:cNvSpPr>
                  <a:spLocks noChangeShapeType="1"/>
                </p:cNvSpPr>
                <p:nvPr/>
              </p:nvSpPr>
              <p:spPr bwMode="auto">
                <a:xfrm flipH="1" flipV="1">
                  <a:off x="2640" y="1152"/>
                  <a:ext cx="47" cy="40"/>
                </a:xfrm>
                <a:prstGeom prst="line">
                  <a:avLst/>
                </a:pr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7" name="Freeform 362"/>
                <p:cNvSpPr/>
                <p:nvPr/>
              </p:nvSpPr>
              <p:spPr bwMode="auto">
                <a:xfrm>
                  <a:off x="2555" y="1287"/>
                  <a:ext cx="63" cy="98"/>
                </a:xfrm>
                <a:custGeom>
                  <a:avLst/>
                  <a:gdLst>
                    <a:gd name="T0" fmla="*/ 63 w 63"/>
                    <a:gd name="T1" fmla="*/ 0 h 98"/>
                    <a:gd name="T2" fmla="*/ 62 w 63"/>
                    <a:gd name="T3" fmla="*/ 2 h 98"/>
                    <a:gd name="T4" fmla="*/ 62 w 63"/>
                    <a:gd name="T5" fmla="*/ 4 h 98"/>
                    <a:gd name="T6" fmla="*/ 60 w 63"/>
                    <a:gd name="T7" fmla="*/ 6 h 98"/>
                    <a:gd name="T8" fmla="*/ 59 w 63"/>
                    <a:gd name="T9" fmla="*/ 7 h 98"/>
                    <a:gd name="T10" fmla="*/ 58 w 63"/>
                    <a:gd name="T11" fmla="*/ 9 h 98"/>
                    <a:gd name="T12" fmla="*/ 56 w 63"/>
                    <a:gd name="T13" fmla="*/ 12 h 98"/>
                    <a:gd name="T14" fmla="*/ 55 w 63"/>
                    <a:gd name="T15" fmla="*/ 13 h 98"/>
                    <a:gd name="T16" fmla="*/ 53 w 63"/>
                    <a:gd name="T17" fmla="*/ 14 h 98"/>
                    <a:gd name="T18" fmla="*/ 52 w 63"/>
                    <a:gd name="T19" fmla="*/ 17 h 98"/>
                    <a:gd name="T20" fmla="*/ 50 w 63"/>
                    <a:gd name="T21" fmla="*/ 19 h 98"/>
                    <a:gd name="T22" fmla="*/ 50 w 63"/>
                    <a:gd name="T23" fmla="*/ 20 h 98"/>
                    <a:gd name="T24" fmla="*/ 49 w 63"/>
                    <a:gd name="T25" fmla="*/ 22 h 98"/>
                    <a:gd name="T26" fmla="*/ 48 w 63"/>
                    <a:gd name="T27" fmla="*/ 24 h 98"/>
                    <a:gd name="T28" fmla="*/ 46 w 63"/>
                    <a:gd name="T29" fmla="*/ 26 h 98"/>
                    <a:gd name="T30" fmla="*/ 45 w 63"/>
                    <a:gd name="T31" fmla="*/ 27 h 98"/>
                    <a:gd name="T32" fmla="*/ 43 w 63"/>
                    <a:gd name="T33" fmla="*/ 30 h 98"/>
                    <a:gd name="T34" fmla="*/ 42 w 63"/>
                    <a:gd name="T35" fmla="*/ 32 h 98"/>
                    <a:gd name="T36" fmla="*/ 40 w 63"/>
                    <a:gd name="T37" fmla="*/ 33 h 98"/>
                    <a:gd name="T38" fmla="*/ 40 w 63"/>
                    <a:gd name="T39" fmla="*/ 35 h 98"/>
                    <a:gd name="T40" fmla="*/ 39 w 63"/>
                    <a:gd name="T41" fmla="*/ 37 h 98"/>
                    <a:gd name="T42" fmla="*/ 38 w 63"/>
                    <a:gd name="T43" fmla="*/ 39 h 98"/>
                    <a:gd name="T44" fmla="*/ 36 w 63"/>
                    <a:gd name="T45" fmla="*/ 40 h 98"/>
                    <a:gd name="T46" fmla="*/ 35 w 63"/>
                    <a:gd name="T47" fmla="*/ 43 h 98"/>
                    <a:gd name="T48" fmla="*/ 33 w 63"/>
                    <a:gd name="T49" fmla="*/ 45 h 98"/>
                    <a:gd name="T50" fmla="*/ 32 w 63"/>
                    <a:gd name="T51" fmla="*/ 46 h 98"/>
                    <a:gd name="T52" fmla="*/ 32 w 63"/>
                    <a:gd name="T53" fmla="*/ 49 h 98"/>
                    <a:gd name="T54" fmla="*/ 30 w 63"/>
                    <a:gd name="T55" fmla="*/ 50 h 98"/>
                    <a:gd name="T56" fmla="*/ 29 w 63"/>
                    <a:gd name="T57" fmla="*/ 52 h 98"/>
                    <a:gd name="T58" fmla="*/ 27 w 63"/>
                    <a:gd name="T59" fmla="*/ 55 h 98"/>
                    <a:gd name="T60" fmla="*/ 26 w 63"/>
                    <a:gd name="T61" fmla="*/ 56 h 98"/>
                    <a:gd name="T62" fmla="*/ 25 w 63"/>
                    <a:gd name="T63" fmla="*/ 57 h 98"/>
                    <a:gd name="T64" fmla="*/ 25 w 63"/>
                    <a:gd name="T65" fmla="*/ 60 h 98"/>
                    <a:gd name="T66" fmla="*/ 23 w 63"/>
                    <a:gd name="T67" fmla="*/ 62 h 98"/>
                    <a:gd name="T68" fmla="*/ 22 w 63"/>
                    <a:gd name="T69" fmla="*/ 63 h 98"/>
                    <a:gd name="T70" fmla="*/ 20 w 63"/>
                    <a:gd name="T71" fmla="*/ 65 h 98"/>
                    <a:gd name="T72" fmla="*/ 19 w 63"/>
                    <a:gd name="T73" fmla="*/ 68 h 98"/>
                    <a:gd name="T74" fmla="*/ 17 w 63"/>
                    <a:gd name="T75" fmla="*/ 69 h 98"/>
                    <a:gd name="T76" fmla="*/ 17 w 63"/>
                    <a:gd name="T77" fmla="*/ 70 h 98"/>
                    <a:gd name="T78" fmla="*/ 16 w 63"/>
                    <a:gd name="T79" fmla="*/ 73 h 98"/>
                    <a:gd name="T80" fmla="*/ 15 w 63"/>
                    <a:gd name="T81" fmla="*/ 75 h 98"/>
                    <a:gd name="T82" fmla="*/ 13 w 63"/>
                    <a:gd name="T83" fmla="*/ 76 h 98"/>
                    <a:gd name="T84" fmla="*/ 12 w 63"/>
                    <a:gd name="T85" fmla="*/ 79 h 98"/>
                    <a:gd name="T86" fmla="*/ 10 w 63"/>
                    <a:gd name="T87" fmla="*/ 80 h 98"/>
                    <a:gd name="T88" fmla="*/ 10 w 63"/>
                    <a:gd name="T89" fmla="*/ 82 h 98"/>
                    <a:gd name="T90" fmla="*/ 9 w 63"/>
                    <a:gd name="T91" fmla="*/ 85 h 98"/>
                    <a:gd name="T92" fmla="*/ 7 w 63"/>
                    <a:gd name="T93" fmla="*/ 86 h 98"/>
                    <a:gd name="T94" fmla="*/ 6 w 63"/>
                    <a:gd name="T95" fmla="*/ 88 h 98"/>
                    <a:gd name="T96" fmla="*/ 5 w 63"/>
                    <a:gd name="T97" fmla="*/ 90 h 98"/>
                    <a:gd name="T98" fmla="*/ 5 w 63"/>
                    <a:gd name="T99" fmla="*/ 92 h 98"/>
                    <a:gd name="T100" fmla="*/ 3 w 63"/>
                    <a:gd name="T101" fmla="*/ 95 h 98"/>
                    <a:gd name="T102" fmla="*/ 2 w 63"/>
                    <a:gd name="T103" fmla="*/ 96 h 98"/>
                    <a:gd name="T104" fmla="*/ 0 w 63"/>
                    <a:gd name="T105" fmla="*/ 98 h 9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  <a:cxn ang="0">
                      <a:pos x="T90" y="T91"/>
                    </a:cxn>
                    <a:cxn ang="0">
                      <a:pos x="T92" y="T93"/>
                    </a:cxn>
                    <a:cxn ang="0">
                      <a:pos x="T94" y="T95"/>
                    </a:cxn>
                    <a:cxn ang="0">
                      <a:pos x="T96" y="T97"/>
                    </a:cxn>
                    <a:cxn ang="0">
                      <a:pos x="T98" y="T99"/>
                    </a:cxn>
                    <a:cxn ang="0">
                      <a:pos x="T100" y="T101"/>
                    </a:cxn>
                    <a:cxn ang="0">
                      <a:pos x="T102" y="T103"/>
                    </a:cxn>
                    <a:cxn ang="0">
                      <a:pos x="T104" y="T105"/>
                    </a:cxn>
                  </a:cxnLst>
                  <a:rect l="0" t="0" r="r" b="b"/>
                  <a:pathLst>
                    <a:path w="63" h="98">
                      <a:moveTo>
                        <a:pt x="63" y="0"/>
                      </a:moveTo>
                      <a:lnTo>
                        <a:pt x="62" y="2"/>
                      </a:lnTo>
                      <a:lnTo>
                        <a:pt x="62" y="4"/>
                      </a:lnTo>
                      <a:lnTo>
                        <a:pt x="60" y="6"/>
                      </a:lnTo>
                      <a:lnTo>
                        <a:pt x="59" y="7"/>
                      </a:lnTo>
                      <a:lnTo>
                        <a:pt x="58" y="9"/>
                      </a:lnTo>
                      <a:lnTo>
                        <a:pt x="56" y="12"/>
                      </a:lnTo>
                      <a:lnTo>
                        <a:pt x="55" y="13"/>
                      </a:lnTo>
                      <a:lnTo>
                        <a:pt x="53" y="14"/>
                      </a:lnTo>
                      <a:lnTo>
                        <a:pt x="52" y="17"/>
                      </a:lnTo>
                      <a:lnTo>
                        <a:pt x="50" y="19"/>
                      </a:lnTo>
                      <a:lnTo>
                        <a:pt x="50" y="20"/>
                      </a:lnTo>
                      <a:lnTo>
                        <a:pt x="49" y="22"/>
                      </a:lnTo>
                      <a:lnTo>
                        <a:pt x="48" y="24"/>
                      </a:lnTo>
                      <a:lnTo>
                        <a:pt x="46" y="26"/>
                      </a:lnTo>
                      <a:lnTo>
                        <a:pt x="45" y="27"/>
                      </a:lnTo>
                      <a:lnTo>
                        <a:pt x="43" y="30"/>
                      </a:lnTo>
                      <a:lnTo>
                        <a:pt x="42" y="32"/>
                      </a:lnTo>
                      <a:lnTo>
                        <a:pt x="40" y="33"/>
                      </a:lnTo>
                      <a:lnTo>
                        <a:pt x="40" y="35"/>
                      </a:lnTo>
                      <a:lnTo>
                        <a:pt x="39" y="37"/>
                      </a:lnTo>
                      <a:lnTo>
                        <a:pt x="38" y="39"/>
                      </a:lnTo>
                      <a:lnTo>
                        <a:pt x="36" y="40"/>
                      </a:lnTo>
                      <a:lnTo>
                        <a:pt x="35" y="43"/>
                      </a:lnTo>
                      <a:lnTo>
                        <a:pt x="33" y="45"/>
                      </a:lnTo>
                      <a:lnTo>
                        <a:pt x="32" y="46"/>
                      </a:lnTo>
                      <a:lnTo>
                        <a:pt x="32" y="49"/>
                      </a:lnTo>
                      <a:lnTo>
                        <a:pt x="30" y="50"/>
                      </a:lnTo>
                      <a:lnTo>
                        <a:pt x="29" y="52"/>
                      </a:lnTo>
                      <a:lnTo>
                        <a:pt x="27" y="55"/>
                      </a:lnTo>
                      <a:lnTo>
                        <a:pt x="26" y="56"/>
                      </a:lnTo>
                      <a:lnTo>
                        <a:pt x="25" y="57"/>
                      </a:lnTo>
                      <a:lnTo>
                        <a:pt x="25" y="60"/>
                      </a:lnTo>
                      <a:lnTo>
                        <a:pt x="23" y="62"/>
                      </a:lnTo>
                      <a:lnTo>
                        <a:pt x="22" y="63"/>
                      </a:lnTo>
                      <a:lnTo>
                        <a:pt x="20" y="65"/>
                      </a:lnTo>
                      <a:lnTo>
                        <a:pt x="19" y="68"/>
                      </a:lnTo>
                      <a:lnTo>
                        <a:pt x="17" y="69"/>
                      </a:lnTo>
                      <a:lnTo>
                        <a:pt x="17" y="70"/>
                      </a:lnTo>
                      <a:lnTo>
                        <a:pt x="16" y="73"/>
                      </a:lnTo>
                      <a:lnTo>
                        <a:pt x="15" y="75"/>
                      </a:lnTo>
                      <a:lnTo>
                        <a:pt x="13" y="76"/>
                      </a:lnTo>
                      <a:lnTo>
                        <a:pt x="12" y="79"/>
                      </a:lnTo>
                      <a:lnTo>
                        <a:pt x="10" y="80"/>
                      </a:lnTo>
                      <a:lnTo>
                        <a:pt x="10" y="82"/>
                      </a:lnTo>
                      <a:lnTo>
                        <a:pt x="9" y="85"/>
                      </a:lnTo>
                      <a:lnTo>
                        <a:pt x="7" y="86"/>
                      </a:lnTo>
                      <a:lnTo>
                        <a:pt x="6" y="88"/>
                      </a:lnTo>
                      <a:lnTo>
                        <a:pt x="5" y="90"/>
                      </a:lnTo>
                      <a:lnTo>
                        <a:pt x="5" y="92"/>
                      </a:lnTo>
                      <a:lnTo>
                        <a:pt x="3" y="95"/>
                      </a:lnTo>
                      <a:lnTo>
                        <a:pt x="2" y="96"/>
                      </a:lnTo>
                      <a:lnTo>
                        <a:pt x="0" y="98"/>
                      </a:lnTo>
                    </a:path>
                  </a:pathLst>
                </a:cu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8" name="Freeform 363"/>
                <p:cNvSpPr/>
                <p:nvPr/>
              </p:nvSpPr>
              <p:spPr bwMode="auto">
                <a:xfrm>
                  <a:off x="2618" y="1195"/>
                  <a:ext cx="72" cy="92"/>
                </a:xfrm>
                <a:custGeom>
                  <a:avLst/>
                  <a:gdLst>
                    <a:gd name="T0" fmla="*/ 0 w 72"/>
                    <a:gd name="T1" fmla="*/ 92 h 92"/>
                    <a:gd name="T2" fmla="*/ 3 w 72"/>
                    <a:gd name="T3" fmla="*/ 88 h 92"/>
                    <a:gd name="T4" fmla="*/ 6 w 72"/>
                    <a:gd name="T5" fmla="*/ 83 h 92"/>
                    <a:gd name="T6" fmla="*/ 9 w 72"/>
                    <a:gd name="T7" fmla="*/ 79 h 92"/>
                    <a:gd name="T8" fmla="*/ 13 w 72"/>
                    <a:gd name="T9" fmla="*/ 75 h 92"/>
                    <a:gd name="T10" fmla="*/ 16 w 72"/>
                    <a:gd name="T11" fmla="*/ 72 h 92"/>
                    <a:gd name="T12" fmla="*/ 19 w 72"/>
                    <a:gd name="T13" fmla="*/ 68 h 92"/>
                    <a:gd name="T14" fmla="*/ 22 w 72"/>
                    <a:gd name="T15" fmla="*/ 63 h 92"/>
                    <a:gd name="T16" fmla="*/ 25 w 72"/>
                    <a:gd name="T17" fmla="*/ 59 h 92"/>
                    <a:gd name="T18" fmla="*/ 28 w 72"/>
                    <a:gd name="T19" fmla="*/ 55 h 92"/>
                    <a:gd name="T20" fmla="*/ 30 w 72"/>
                    <a:gd name="T21" fmla="*/ 50 h 92"/>
                    <a:gd name="T22" fmla="*/ 33 w 72"/>
                    <a:gd name="T23" fmla="*/ 48 h 92"/>
                    <a:gd name="T24" fmla="*/ 36 w 72"/>
                    <a:gd name="T25" fmla="*/ 43 h 92"/>
                    <a:gd name="T26" fmla="*/ 40 w 72"/>
                    <a:gd name="T27" fmla="*/ 39 h 92"/>
                    <a:gd name="T28" fmla="*/ 43 w 72"/>
                    <a:gd name="T29" fmla="*/ 35 h 92"/>
                    <a:gd name="T30" fmla="*/ 46 w 72"/>
                    <a:gd name="T31" fmla="*/ 30 h 92"/>
                    <a:gd name="T32" fmla="*/ 49 w 72"/>
                    <a:gd name="T33" fmla="*/ 28 h 92"/>
                    <a:gd name="T34" fmla="*/ 52 w 72"/>
                    <a:gd name="T35" fmla="*/ 23 h 92"/>
                    <a:gd name="T36" fmla="*/ 56 w 72"/>
                    <a:gd name="T37" fmla="*/ 19 h 92"/>
                    <a:gd name="T38" fmla="*/ 59 w 72"/>
                    <a:gd name="T39" fmla="*/ 15 h 92"/>
                    <a:gd name="T40" fmla="*/ 62 w 72"/>
                    <a:gd name="T41" fmla="*/ 12 h 92"/>
                    <a:gd name="T42" fmla="*/ 65 w 72"/>
                    <a:gd name="T43" fmla="*/ 7 h 92"/>
                    <a:gd name="T44" fmla="*/ 69 w 72"/>
                    <a:gd name="T45" fmla="*/ 3 h 92"/>
                    <a:gd name="T46" fmla="*/ 72 w 72"/>
                    <a:gd name="T47" fmla="*/ 0 h 9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</a:cxnLst>
                  <a:rect l="0" t="0" r="r" b="b"/>
                  <a:pathLst>
                    <a:path w="72" h="92">
                      <a:moveTo>
                        <a:pt x="0" y="92"/>
                      </a:moveTo>
                      <a:lnTo>
                        <a:pt x="3" y="88"/>
                      </a:lnTo>
                      <a:lnTo>
                        <a:pt x="6" y="83"/>
                      </a:lnTo>
                      <a:lnTo>
                        <a:pt x="9" y="79"/>
                      </a:lnTo>
                      <a:lnTo>
                        <a:pt x="13" y="75"/>
                      </a:lnTo>
                      <a:lnTo>
                        <a:pt x="16" y="72"/>
                      </a:lnTo>
                      <a:lnTo>
                        <a:pt x="19" y="68"/>
                      </a:lnTo>
                      <a:lnTo>
                        <a:pt x="22" y="63"/>
                      </a:lnTo>
                      <a:lnTo>
                        <a:pt x="25" y="59"/>
                      </a:lnTo>
                      <a:lnTo>
                        <a:pt x="28" y="55"/>
                      </a:lnTo>
                      <a:lnTo>
                        <a:pt x="30" y="50"/>
                      </a:lnTo>
                      <a:lnTo>
                        <a:pt x="33" y="48"/>
                      </a:lnTo>
                      <a:lnTo>
                        <a:pt x="36" y="43"/>
                      </a:lnTo>
                      <a:lnTo>
                        <a:pt x="40" y="39"/>
                      </a:lnTo>
                      <a:lnTo>
                        <a:pt x="43" y="35"/>
                      </a:lnTo>
                      <a:lnTo>
                        <a:pt x="46" y="30"/>
                      </a:lnTo>
                      <a:lnTo>
                        <a:pt x="49" y="28"/>
                      </a:lnTo>
                      <a:lnTo>
                        <a:pt x="52" y="23"/>
                      </a:lnTo>
                      <a:lnTo>
                        <a:pt x="56" y="19"/>
                      </a:lnTo>
                      <a:lnTo>
                        <a:pt x="59" y="15"/>
                      </a:lnTo>
                      <a:lnTo>
                        <a:pt x="62" y="12"/>
                      </a:lnTo>
                      <a:lnTo>
                        <a:pt x="65" y="7"/>
                      </a:lnTo>
                      <a:lnTo>
                        <a:pt x="69" y="3"/>
                      </a:lnTo>
                      <a:lnTo>
                        <a:pt x="72" y="0"/>
                      </a:lnTo>
                    </a:path>
                  </a:pathLst>
                </a:cu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0" name="Line 365"/>
                <p:cNvSpPr>
                  <a:spLocks noChangeShapeType="1"/>
                </p:cNvSpPr>
                <p:nvPr/>
              </p:nvSpPr>
              <p:spPr bwMode="auto">
                <a:xfrm flipH="1" flipV="1">
                  <a:off x="2621" y="1289"/>
                  <a:ext cx="52" cy="37"/>
                </a:xfrm>
                <a:prstGeom prst="line">
                  <a:avLst/>
                </a:pr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1" name="Freeform 366"/>
                <p:cNvSpPr/>
                <p:nvPr/>
              </p:nvSpPr>
              <p:spPr bwMode="auto">
                <a:xfrm>
                  <a:off x="2560" y="1423"/>
                  <a:ext cx="53" cy="101"/>
                </a:xfrm>
                <a:custGeom>
                  <a:avLst/>
                  <a:gdLst>
                    <a:gd name="T0" fmla="*/ 53 w 53"/>
                    <a:gd name="T1" fmla="*/ 2 h 101"/>
                    <a:gd name="T2" fmla="*/ 50 w 53"/>
                    <a:gd name="T3" fmla="*/ 5 h 101"/>
                    <a:gd name="T4" fmla="*/ 48 w 53"/>
                    <a:gd name="T5" fmla="*/ 8 h 101"/>
                    <a:gd name="T6" fmla="*/ 47 w 53"/>
                    <a:gd name="T7" fmla="*/ 12 h 101"/>
                    <a:gd name="T8" fmla="*/ 44 w 53"/>
                    <a:gd name="T9" fmla="*/ 15 h 101"/>
                    <a:gd name="T10" fmla="*/ 43 w 53"/>
                    <a:gd name="T11" fmla="*/ 18 h 101"/>
                    <a:gd name="T12" fmla="*/ 41 w 53"/>
                    <a:gd name="T13" fmla="*/ 20 h 101"/>
                    <a:gd name="T14" fmla="*/ 40 w 53"/>
                    <a:gd name="T15" fmla="*/ 23 h 101"/>
                    <a:gd name="T16" fmla="*/ 37 w 53"/>
                    <a:gd name="T17" fmla="*/ 28 h 101"/>
                    <a:gd name="T18" fmla="*/ 35 w 53"/>
                    <a:gd name="T19" fmla="*/ 31 h 101"/>
                    <a:gd name="T20" fmla="*/ 34 w 53"/>
                    <a:gd name="T21" fmla="*/ 33 h 101"/>
                    <a:gd name="T22" fmla="*/ 33 w 53"/>
                    <a:gd name="T23" fmla="*/ 36 h 101"/>
                    <a:gd name="T24" fmla="*/ 31 w 53"/>
                    <a:gd name="T25" fmla="*/ 39 h 101"/>
                    <a:gd name="T26" fmla="*/ 28 w 53"/>
                    <a:gd name="T27" fmla="*/ 43 h 101"/>
                    <a:gd name="T28" fmla="*/ 27 w 53"/>
                    <a:gd name="T29" fmla="*/ 46 h 101"/>
                    <a:gd name="T30" fmla="*/ 25 w 53"/>
                    <a:gd name="T31" fmla="*/ 49 h 101"/>
                    <a:gd name="T32" fmla="*/ 24 w 53"/>
                    <a:gd name="T33" fmla="*/ 52 h 101"/>
                    <a:gd name="T34" fmla="*/ 22 w 53"/>
                    <a:gd name="T35" fmla="*/ 56 h 101"/>
                    <a:gd name="T36" fmla="*/ 20 w 53"/>
                    <a:gd name="T37" fmla="*/ 59 h 101"/>
                    <a:gd name="T38" fmla="*/ 18 w 53"/>
                    <a:gd name="T39" fmla="*/ 62 h 101"/>
                    <a:gd name="T40" fmla="*/ 17 w 53"/>
                    <a:gd name="T41" fmla="*/ 65 h 101"/>
                    <a:gd name="T42" fmla="*/ 15 w 53"/>
                    <a:gd name="T43" fmla="*/ 69 h 101"/>
                    <a:gd name="T44" fmla="*/ 14 w 53"/>
                    <a:gd name="T45" fmla="*/ 72 h 101"/>
                    <a:gd name="T46" fmla="*/ 12 w 53"/>
                    <a:gd name="T47" fmla="*/ 75 h 101"/>
                    <a:gd name="T48" fmla="*/ 10 w 53"/>
                    <a:gd name="T49" fmla="*/ 78 h 101"/>
                    <a:gd name="T50" fmla="*/ 8 w 53"/>
                    <a:gd name="T51" fmla="*/ 82 h 101"/>
                    <a:gd name="T52" fmla="*/ 7 w 53"/>
                    <a:gd name="T53" fmla="*/ 85 h 101"/>
                    <a:gd name="T54" fmla="*/ 5 w 53"/>
                    <a:gd name="T55" fmla="*/ 88 h 101"/>
                    <a:gd name="T56" fmla="*/ 4 w 53"/>
                    <a:gd name="T57" fmla="*/ 92 h 101"/>
                    <a:gd name="T58" fmla="*/ 2 w 53"/>
                    <a:gd name="T59" fmla="*/ 95 h 101"/>
                    <a:gd name="T60" fmla="*/ 1 w 53"/>
                    <a:gd name="T61" fmla="*/ 98 h 101"/>
                    <a:gd name="T62" fmla="*/ 0 w 53"/>
                    <a:gd name="T63" fmla="*/ 101 h 10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</a:cxnLst>
                  <a:rect l="0" t="0" r="r" b="b"/>
                  <a:pathLst>
                    <a:path w="53" h="101">
                      <a:moveTo>
                        <a:pt x="53" y="0"/>
                      </a:moveTo>
                      <a:lnTo>
                        <a:pt x="53" y="2"/>
                      </a:lnTo>
                      <a:lnTo>
                        <a:pt x="51" y="3"/>
                      </a:lnTo>
                      <a:lnTo>
                        <a:pt x="50" y="5"/>
                      </a:lnTo>
                      <a:lnTo>
                        <a:pt x="50" y="6"/>
                      </a:lnTo>
                      <a:lnTo>
                        <a:pt x="48" y="8"/>
                      </a:lnTo>
                      <a:lnTo>
                        <a:pt x="47" y="9"/>
                      </a:lnTo>
                      <a:lnTo>
                        <a:pt x="47" y="12"/>
                      </a:lnTo>
                      <a:lnTo>
                        <a:pt x="45" y="13"/>
                      </a:lnTo>
                      <a:lnTo>
                        <a:pt x="44" y="15"/>
                      </a:lnTo>
                      <a:lnTo>
                        <a:pt x="44" y="16"/>
                      </a:lnTo>
                      <a:lnTo>
                        <a:pt x="43" y="18"/>
                      </a:lnTo>
                      <a:lnTo>
                        <a:pt x="43" y="19"/>
                      </a:lnTo>
                      <a:lnTo>
                        <a:pt x="41" y="20"/>
                      </a:lnTo>
                      <a:lnTo>
                        <a:pt x="40" y="22"/>
                      </a:lnTo>
                      <a:lnTo>
                        <a:pt x="40" y="23"/>
                      </a:lnTo>
                      <a:lnTo>
                        <a:pt x="38" y="25"/>
                      </a:lnTo>
                      <a:lnTo>
                        <a:pt x="37" y="28"/>
                      </a:lnTo>
                      <a:lnTo>
                        <a:pt x="37" y="29"/>
                      </a:lnTo>
                      <a:lnTo>
                        <a:pt x="35" y="31"/>
                      </a:lnTo>
                      <a:lnTo>
                        <a:pt x="35" y="32"/>
                      </a:lnTo>
                      <a:lnTo>
                        <a:pt x="34" y="33"/>
                      </a:lnTo>
                      <a:lnTo>
                        <a:pt x="33" y="35"/>
                      </a:lnTo>
                      <a:lnTo>
                        <a:pt x="33" y="36"/>
                      </a:lnTo>
                      <a:lnTo>
                        <a:pt x="31" y="38"/>
                      </a:lnTo>
                      <a:lnTo>
                        <a:pt x="31" y="39"/>
                      </a:lnTo>
                      <a:lnTo>
                        <a:pt x="30" y="42"/>
                      </a:lnTo>
                      <a:lnTo>
                        <a:pt x="28" y="43"/>
                      </a:lnTo>
                      <a:lnTo>
                        <a:pt x="28" y="45"/>
                      </a:lnTo>
                      <a:lnTo>
                        <a:pt x="27" y="46"/>
                      </a:lnTo>
                      <a:lnTo>
                        <a:pt x="27" y="48"/>
                      </a:lnTo>
                      <a:lnTo>
                        <a:pt x="25" y="49"/>
                      </a:lnTo>
                      <a:lnTo>
                        <a:pt x="24" y="51"/>
                      </a:lnTo>
                      <a:lnTo>
                        <a:pt x="24" y="52"/>
                      </a:lnTo>
                      <a:lnTo>
                        <a:pt x="22" y="55"/>
                      </a:lnTo>
                      <a:lnTo>
                        <a:pt x="22" y="56"/>
                      </a:lnTo>
                      <a:lnTo>
                        <a:pt x="21" y="58"/>
                      </a:lnTo>
                      <a:lnTo>
                        <a:pt x="20" y="59"/>
                      </a:lnTo>
                      <a:lnTo>
                        <a:pt x="20" y="61"/>
                      </a:lnTo>
                      <a:lnTo>
                        <a:pt x="18" y="62"/>
                      </a:lnTo>
                      <a:lnTo>
                        <a:pt x="18" y="64"/>
                      </a:lnTo>
                      <a:lnTo>
                        <a:pt x="17" y="65"/>
                      </a:lnTo>
                      <a:lnTo>
                        <a:pt x="15" y="68"/>
                      </a:lnTo>
                      <a:lnTo>
                        <a:pt x="15" y="69"/>
                      </a:lnTo>
                      <a:lnTo>
                        <a:pt x="14" y="71"/>
                      </a:lnTo>
                      <a:lnTo>
                        <a:pt x="14" y="72"/>
                      </a:lnTo>
                      <a:lnTo>
                        <a:pt x="12" y="74"/>
                      </a:lnTo>
                      <a:lnTo>
                        <a:pt x="12" y="75"/>
                      </a:lnTo>
                      <a:lnTo>
                        <a:pt x="11" y="76"/>
                      </a:lnTo>
                      <a:lnTo>
                        <a:pt x="10" y="78"/>
                      </a:lnTo>
                      <a:lnTo>
                        <a:pt x="10" y="81"/>
                      </a:lnTo>
                      <a:lnTo>
                        <a:pt x="8" y="82"/>
                      </a:lnTo>
                      <a:lnTo>
                        <a:pt x="8" y="84"/>
                      </a:lnTo>
                      <a:lnTo>
                        <a:pt x="7" y="85"/>
                      </a:lnTo>
                      <a:lnTo>
                        <a:pt x="7" y="87"/>
                      </a:lnTo>
                      <a:lnTo>
                        <a:pt x="5" y="88"/>
                      </a:lnTo>
                      <a:lnTo>
                        <a:pt x="5" y="89"/>
                      </a:lnTo>
                      <a:lnTo>
                        <a:pt x="4" y="92"/>
                      </a:lnTo>
                      <a:lnTo>
                        <a:pt x="2" y="94"/>
                      </a:lnTo>
                      <a:lnTo>
                        <a:pt x="2" y="95"/>
                      </a:lnTo>
                      <a:lnTo>
                        <a:pt x="1" y="97"/>
                      </a:lnTo>
                      <a:lnTo>
                        <a:pt x="1" y="98"/>
                      </a:lnTo>
                      <a:lnTo>
                        <a:pt x="0" y="99"/>
                      </a:lnTo>
                      <a:lnTo>
                        <a:pt x="0" y="101"/>
                      </a:lnTo>
                    </a:path>
                  </a:pathLst>
                </a:cu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2" name="Freeform 367"/>
                <p:cNvSpPr/>
                <p:nvPr/>
              </p:nvSpPr>
              <p:spPr bwMode="auto">
                <a:xfrm>
                  <a:off x="2613" y="1327"/>
                  <a:ext cx="63" cy="96"/>
                </a:xfrm>
                <a:custGeom>
                  <a:avLst/>
                  <a:gdLst>
                    <a:gd name="T0" fmla="*/ 0 w 63"/>
                    <a:gd name="T1" fmla="*/ 96 h 96"/>
                    <a:gd name="T2" fmla="*/ 2 w 63"/>
                    <a:gd name="T3" fmla="*/ 92 h 96"/>
                    <a:gd name="T4" fmla="*/ 5 w 63"/>
                    <a:gd name="T5" fmla="*/ 88 h 96"/>
                    <a:gd name="T6" fmla="*/ 8 w 63"/>
                    <a:gd name="T7" fmla="*/ 83 h 96"/>
                    <a:gd name="T8" fmla="*/ 10 w 63"/>
                    <a:gd name="T9" fmla="*/ 79 h 96"/>
                    <a:gd name="T10" fmla="*/ 12 w 63"/>
                    <a:gd name="T11" fmla="*/ 75 h 96"/>
                    <a:gd name="T12" fmla="*/ 15 w 63"/>
                    <a:gd name="T13" fmla="*/ 71 h 96"/>
                    <a:gd name="T14" fmla="*/ 18 w 63"/>
                    <a:gd name="T15" fmla="*/ 66 h 96"/>
                    <a:gd name="T16" fmla="*/ 21 w 63"/>
                    <a:gd name="T17" fmla="*/ 62 h 96"/>
                    <a:gd name="T18" fmla="*/ 23 w 63"/>
                    <a:gd name="T19" fmla="*/ 58 h 96"/>
                    <a:gd name="T20" fmla="*/ 25 w 63"/>
                    <a:gd name="T21" fmla="*/ 53 h 96"/>
                    <a:gd name="T22" fmla="*/ 28 w 63"/>
                    <a:gd name="T23" fmla="*/ 49 h 96"/>
                    <a:gd name="T24" fmla="*/ 31 w 63"/>
                    <a:gd name="T25" fmla="*/ 45 h 96"/>
                    <a:gd name="T26" fmla="*/ 34 w 63"/>
                    <a:gd name="T27" fmla="*/ 40 h 96"/>
                    <a:gd name="T28" fmla="*/ 37 w 63"/>
                    <a:gd name="T29" fmla="*/ 36 h 96"/>
                    <a:gd name="T30" fmla="*/ 40 w 63"/>
                    <a:gd name="T31" fmla="*/ 33 h 96"/>
                    <a:gd name="T32" fmla="*/ 43 w 63"/>
                    <a:gd name="T33" fmla="*/ 29 h 96"/>
                    <a:gd name="T34" fmla="*/ 45 w 63"/>
                    <a:gd name="T35" fmla="*/ 25 h 96"/>
                    <a:gd name="T36" fmla="*/ 48 w 63"/>
                    <a:gd name="T37" fmla="*/ 20 h 96"/>
                    <a:gd name="T38" fmla="*/ 51 w 63"/>
                    <a:gd name="T39" fmla="*/ 16 h 96"/>
                    <a:gd name="T40" fmla="*/ 54 w 63"/>
                    <a:gd name="T41" fmla="*/ 12 h 96"/>
                    <a:gd name="T42" fmla="*/ 57 w 63"/>
                    <a:gd name="T43" fmla="*/ 7 h 96"/>
                    <a:gd name="T44" fmla="*/ 60 w 63"/>
                    <a:gd name="T45" fmla="*/ 3 h 96"/>
                    <a:gd name="T46" fmla="*/ 63 w 63"/>
                    <a:gd name="T47" fmla="*/ 0 h 9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</a:cxnLst>
                  <a:rect l="0" t="0" r="r" b="b"/>
                  <a:pathLst>
                    <a:path w="63" h="96">
                      <a:moveTo>
                        <a:pt x="0" y="96"/>
                      </a:moveTo>
                      <a:lnTo>
                        <a:pt x="2" y="92"/>
                      </a:lnTo>
                      <a:lnTo>
                        <a:pt x="5" y="88"/>
                      </a:lnTo>
                      <a:lnTo>
                        <a:pt x="8" y="83"/>
                      </a:lnTo>
                      <a:lnTo>
                        <a:pt x="10" y="79"/>
                      </a:lnTo>
                      <a:lnTo>
                        <a:pt x="12" y="75"/>
                      </a:lnTo>
                      <a:lnTo>
                        <a:pt x="15" y="71"/>
                      </a:lnTo>
                      <a:lnTo>
                        <a:pt x="18" y="66"/>
                      </a:lnTo>
                      <a:lnTo>
                        <a:pt x="21" y="62"/>
                      </a:lnTo>
                      <a:lnTo>
                        <a:pt x="23" y="58"/>
                      </a:lnTo>
                      <a:lnTo>
                        <a:pt x="25" y="53"/>
                      </a:lnTo>
                      <a:lnTo>
                        <a:pt x="28" y="49"/>
                      </a:lnTo>
                      <a:lnTo>
                        <a:pt x="31" y="45"/>
                      </a:lnTo>
                      <a:lnTo>
                        <a:pt x="34" y="40"/>
                      </a:lnTo>
                      <a:lnTo>
                        <a:pt x="37" y="36"/>
                      </a:lnTo>
                      <a:lnTo>
                        <a:pt x="40" y="33"/>
                      </a:lnTo>
                      <a:lnTo>
                        <a:pt x="43" y="29"/>
                      </a:lnTo>
                      <a:lnTo>
                        <a:pt x="45" y="25"/>
                      </a:lnTo>
                      <a:lnTo>
                        <a:pt x="48" y="20"/>
                      </a:lnTo>
                      <a:lnTo>
                        <a:pt x="51" y="16"/>
                      </a:lnTo>
                      <a:lnTo>
                        <a:pt x="54" y="12"/>
                      </a:lnTo>
                      <a:lnTo>
                        <a:pt x="57" y="7"/>
                      </a:lnTo>
                      <a:lnTo>
                        <a:pt x="60" y="3"/>
                      </a:lnTo>
                      <a:lnTo>
                        <a:pt x="63" y="0"/>
                      </a:lnTo>
                    </a:path>
                  </a:pathLst>
                </a:cu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4" name="Line 369"/>
                <p:cNvSpPr>
                  <a:spLocks noChangeShapeType="1"/>
                </p:cNvSpPr>
                <p:nvPr/>
              </p:nvSpPr>
              <p:spPr bwMode="auto">
                <a:xfrm flipH="1" flipV="1">
                  <a:off x="2615" y="1425"/>
                  <a:ext cx="55" cy="31"/>
                </a:xfrm>
                <a:prstGeom prst="line">
                  <a:avLst/>
                </a:pr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5" name="Freeform 370"/>
                <p:cNvSpPr/>
                <p:nvPr/>
              </p:nvSpPr>
              <p:spPr bwMode="auto">
                <a:xfrm>
                  <a:off x="2577" y="1555"/>
                  <a:ext cx="43" cy="102"/>
                </a:xfrm>
                <a:custGeom>
                  <a:avLst/>
                  <a:gdLst>
                    <a:gd name="T0" fmla="*/ 43 w 43"/>
                    <a:gd name="T1" fmla="*/ 2 h 102"/>
                    <a:gd name="T2" fmla="*/ 41 w 43"/>
                    <a:gd name="T3" fmla="*/ 5 h 102"/>
                    <a:gd name="T4" fmla="*/ 40 w 43"/>
                    <a:gd name="T5" fmla="*/ 8 h 102"/>
                    <a:gd name="T6" fmla="*/ 38 w 43"/>
                    <a:gd name="T7" fmla="*/ 10 h 102"/>
                    <a:gd name="T8" fmla="*/ 37 w 43"/>
                    <a:gd name="T9" fmla="*/ 13 h 102"/>
                    <a:gd name="T10" fmla="*/ 36 w 43"/>
                    <a:gd name="T11" fmla="*/ 16 h 102"/>
                    <a:gd name="T12" fmla="*/ 36 w 43"/>
                    <a:gd name="T13" fmla="*/ 19 h 102"/>
                    <a:gd name="T14" fmla="*/ 34 w 43"/>
                    <a:gd name="T15" fmla="*/ 21 h 102"/>
                    <a:gd name="T16" fmla="*/ 33 w 43"/>
                    <a:gd name="T17" fmla="*/ 23 h 102"/>
                    <a:gd name="T18" fmla="*/ 31 w 43"/>
                    <a:gd name="T19" fmla="*/ 26 h 102"/>
                    <a:gd name="T20" fmla="*/ 30 w 43"/>
                    <a:gd name="T21" fmla="*/ 29 h 102"/>
                    <a:gd name="T22" fmla="*/ 28 w 43"/>
                    <a:gd name="T23" fmla="*/ 32 h 102"/>
                    <a:gd name="T24" fmla="*/ 27 w 43"/>
                    <a:gd name="T25" fmla="*/ 35 h 102"/>
                    <a:gd name="T26" fmla="*/ 27 w 43"/>
                    <a:gd name="T27" fmla="*/ 38 h 102"/>
                    <a:gd name="T28" fmla="*/ 26 w 43"/>
                    <a:gd name="T29" fmla="*/ 41 h 102"/>
                    <a:gd name="T30" fmla="*/ 24 w 43"/>
                    <a:gd name="T31" fmla="*/ 43 h 102"/>
                    <a:gd name="T32" fmla="*/ 23 w 43"/>
                    <a:gd name="T33" fmla="*/ 46 h 102"/>
                    <a:gd name="T34" fmla="*/ 21 w 43"/>
                    <a:gd name="T35" fmla="*/ 49 h 102"/>
                    <a:gd name="T36" fmla="*/ 20 w 43"/>
                    <a:gd name="T37" fmla="*/ 51 h 102"/>
                    <a:gd name="T38" fmla="*/ 20 w 43"/>
                    <a:gd name="T39" fmla="*/ 54 h 102"/>
                    <a:gd name="T40" fmla="*/ 18 w 43"/>
                    <a:gd name="T41" fmla="*/ 56 h 102"/>
                    <a:gd name="T42" fmla="*/ 17 w 43"/>
                    <a:gd name="T43" fmla="*/ 59 h 102"/>
                    <a:gd name="T44" fmla="*/ 16 w 43"/>
                    <a:gd name="T45" fmla="*/ 62 h 102"/>
                    <a:gd name="T46" fmla="*/ 14 w 43"/>
                    <a:gd name="T47" fmla="*/ 65 h 102"/>
                    <a:gd name="T48" fmla="*/ 14 w 43"/>
                    <a:gd name="T49" fmla="*/ 68 h 102"/>
                    <a:gd name="T50" fmla="*/ 13 w 43"/>
                    <a:gd name="T51" fmla="*/ 71 h 102"/>
                    <a:gd name="T52" fmla="*/ 11 w 43"/>
                    <a:gd name="T53" fmla="*/ 74 h 102"/>
                    <a:gd name="T54" fmla="*/ 10 w 43"/>
                    <a:gd name="T55" fmla="*/ 76 h 102"/>
                    <a:gd name="T56" fmla="*/ 8 w 43"/>
                    <a:gd name="T57" fmla="*/ 79 h 102"/>
                    <a:gd name="T58" fmla="*/ 8 w 43"/>
                    <a:gd name="T59" fmla="*/ 82 h 102"/>
                    <a:gd name="T60" fmla="*/ 7 w 43"/>
                    <a:gd name="T61" fmla="*/ 85 h 102"/>
                    <a:gd name="T62" fmla="*/ 5 w 43"/>
                    <a:gd name="T63" fmla="*/ 88 h 102"/>
                    <a:gd name="T64" fmla="*/ 4 w 43"/>
                    <a:gd name="T65" fmla="*/ 89 h 102"/>
                    <a:gd name="T66" fmla="*/ 4 w 43"/>
                    <a:gd name="T67" fmla="*/ 92 h 102"/>
                    <a:gd name="T68" fmla="*/ 3 w 43"/>
                    <a:gd name="T69" fmla="*/ 95 h 102"/>
                    <a:gd name="T70" fmla="*/ 1 w 43"/>
                    <a:gd name="T71" fmla="*/ 98 h 102"/>
                    <a:gd name="T72" fmla="*/ 0 w 43"/>
                    <a:gd name="T73" fmla="*/ 101 h 10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</a:cxnLst>
                  <a:rect l="0" t="0" r="r" b="b"/>
                  <a:pathLst>
                    <a:path w="43" h="102">
                      <a:moveTo>
                        <a:pt x="43" y="0"/>
                      </a:moveTo>
                      <a:lnTo>
                        <a:pt x="43" y="2"/>
                      </a:lnTo>
                      <a:lnTo>
                        <a:pt x="41" y="3"/>
                      </a:lnTo>
                      <a:lnTo>
                        <a:pt x="41" y="5"/>
                      </a:lnTo>
                      <a:lnTo>
                        <a:pt x="41" y="6"/>
                      </a:lnTo>
                      <a:lnTo>
                        <a:pt x="40" y="8"/>
                      </a:lnTo>
                      <a:lnTo>
                        <a:pt x="40" y="9"/>
                      </a:lnTo>
                      <a:lnTo>
                        <a:pt x="38" y="10"/>
                      </a:lnTo>
                      <a:lnTo>
                        <a:pt x="38" y="12"/>
                      </a:lnTo>
                      <a:lnTo>
                        <a:pt x="37" y="13"/>
                      </a:lnTo>
                      <a:lnTo>
                        <a:pt x="37" y="15"/>
                      </a:lnTo>
                      <a:lnTo>
                        <a:pt x="36" y="16"/>
                      </a:lnTo>
                      <a:lnTo>
                        <a:pt x="36" y="18"/>
                      </a:lnTo>
                      <a:lnTo>
                        <a:pt x="36" y="19"/>
                      </a:lnTo>
                      <a:lnTo>
                        <a:pt x="34" y="21"/>
                      </a:lnTo>
                      <a:lnTo>
                        <a:pt x="34" y="21"/>
                      </a:lnTo>
                      <a:lnTo>
                        <a:pt x="33" y="22"/>
                      </a:lnTo>
                      <a:lnTo>
                        <a:pt x="33" y="23"/>
                      </a:lnTo>
                      <a:lnTo>
                        <a:pt x="31" y="25"/>
                      </a:lnTo>
                      <a:lnTo>
                        <a:pt x="31" y="26"/>
                      </a:lnTo>
                      <a:lnTo>
                        <a:pt x="31" y="28"/>
                      </a:lnTo>
                      <a:lnTo>
                        <a:pt x="30" y="29"/>
                      </a:lnTo>
                      <a:lnTo>
                        <a:pt x="30" y="31"/>
                      </a:lnTo>
                      <a:lnTo>
                        <a:pt x="28" y="32"/>
                      </a:lnTo>
                      <a:lnTo>
                        <a:pt x="28" y="33"/>
                      </a:lnTo>
                      <a:lnTo>
                        <a:pt x="27" y="35"/>
                      </a:lnTo>
                      <a:lnTo>
                        <a:pt x="27" y="36"/>
                      </a:lnTo>
                      <a:lnTo>
                        <a:pt x="27" y="38"/>
                      </a:lnTo>
                      <a:lnTo>
                        <a:pt x="26" y="39"/>
                      </a:lnTo>
                      <a:lnTo>
                        <a:pt x="26" y="41"/>
                      </a:lnTo>
                      <a:lnTo>
                        <a:pt x="24" y="42"/>
                      </a:lnTo>
                      <a:lnTo>
                        <a:pt x="24" y="43"/>
                      </a:lnTo>
                      <a:lnTo>
                        <a:pt x="23" y="45"/>
                      </a:lnTo>
                      <a:lnTo>
                        <a:pt x="23" y="46"/>
                      </a:lnTo>
                      <a:lnTo>
                        <a:pt x="23" y="48"/>
                      </a:lnTo>
                      <a:lnTo>
                        <a:pt x="21" y="49"/>
                      </a:lnTo>
                      <a:lnTo>
                        <a:pt x="21" y="49"/>
                      </a:lnTo>
                      <a:lnTo>
                        <a:pt x="20" y="51"/>
                      </a:lnTo>
                      <a:lnTo>
                        <a:pt x="20" y="52"/>
                      </a:lnTo>
                      <a:lnTo>
                        <a:pt x="20" y="54"/>
                      </a:lnTo>
                      <a:lnTo>
                        <a:pt x="18" y="55"/>
                      </a:lnTo>
                      <a:lnTo>
                        <a:pt x="18" y="56"/>
                      </a:lnTo>
                      <a:lnTo>
                        <a:pt x="17" y="58"/>
                      </a:lnTo>
                      <a:lnTo>
                        <a:pt x="17" y="59"/>
                      </a:lnTo>
                      <a:lnTo>
                        <a:pt x="17" y="61"/>
                      </a:lnTo>
                      <a:lnTo>
                        <a:pt x="16" y="62"/>
                      </a:lnTo>
                      <a:lnTo>
                        <a:pt x="16" y="64"/>
                      </a:lnTo>
                      <a:lnTo>
                        <a:pt x="14" y="65"/>
                      </a:lnTo>
                      <a:lnTo>
                        <a:pt x="14" y="66"/>
                      </a:lnTo>
                      <a:lnTo>
                        <a:pt x="14" y="68"/>
                      </a:lnTo>
                      <a:lnTo>
                        <a:pt x="13" y="69"/>
                      </a:lnTo>
                      <a:lnTo>
                        <a:pt x="13" y="71"/>
                      </a:lnTo>
                      <a:lnTo>
                        <a:pt x="11" y="72"/>
                      </a:lnTo>
                      <a:lnTo>
                        <a:pt x="11" y="74"/>
                      </a:lnTo>
                      <a:lnTo>
                        <a:pt x="11" y="75"/>
                      </a:lnTo>
                      <a:lnTo>
                        <a:pt x="10" y="76"/>
                      </a:lnTo>
                      <a:lnTo>
                        <a:pt x="10" y="78"/>
                      </a:lnTo>
                      <a:lnTo>
                        <a:pt x="8" y="79"/>
                      </a:lnTo>
                      <a:lnTo>
                        <a:pt x="8" y="81"/>
                      </a:lnTo>
                      <a:lnTo>
                        <a:pt x="8" y="82"/>
                      </a:lnTo>
                      <a:lnTo>
                        <a:pt x="7" y="84"/>
                      </a:lnTo>
                      <a:lnTo>
                        <a:pt x="7" y="85"/>
                      </a:lnTo>
                      <a:lnTo>
                        <a:pt x="7" y="87"/>
                      </a:lnTo>
                      <a:lnTo>
                        <a:pt x="5" y="88"/>
                      </a:lnTo>
                      <a:lnTo>
                        <a:pt x="5" y="89"/>
                      </a:lnTo>
                      <a:lnTo>
                        <a:pt x="4" y="89"/>
                      </a:lnTo>
                      <a:lnTo>
                        <a:pt x="4" y="91"/>
                      </a:lnTo>
                      <a:lnTo>
                        <a:pt x="4" y="92"/>
                      </a:lnTo>
                      <a:lnTo>
                        <a:pt x="3" y="94"/>
                      </a:lnTo>
                      <a:lnTo>
                        <a:pt x="3" y="95"/>
                      </a:lnTo>
                      <a:lnTo>
                        <a:pt x="1" y="97"/>
                      </a:lnTo>
                      <a:lnTo>
                        <a:pt x="1" y="98"/>
                      </a:lnTo>
                      <a:lnTo>
                        <a:pt x="1" y="99"/>
                      </a:lnTo>
                      <a:lnTo>
                        <a:pt x="0" y="101"/>
                      </a:lnTo>
                      <a:lnTo>
                        <a:pt x="0" y="102"/>
                      </a:lnTo>
                    </a:path>
                  </a:pathLst>
                </a:cu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6" name="Freeform 371"/>
                <p:cNvSpPr/>
                <p:nvPr/>
              </p:nvSpPr>
              <p:spPr bwMode="auto">
                <a:xfrm>
                  <a:off x="2620" y="1458"/>
                  <a:ext cx="53" cy="97"/>
                </a:xfrm>
                <a:custGeom>
                  <a:avLst/>
                  <a:gdLst>
                    <a:gd name="T0" fmla="*/ 0 w 53"/>
                    <a:gd name="T1" fmla="*/ 97 h 97"/>
                    <a:gd name="T2" fmla="*/ 3 w 53"/>
                    <a:gd name="T3" fmla="*/ 93 h 97"/>
                    <a:gd name="T4" fmla="*/ 4 w 53"/>
                    <a:gd name="T5" fmla="*/ 89 h 97"/>
                    <a:gd name="T6" fmla="*/ 7 w 53"/>
                    <a:gd name="T7" fmla="*/ 85 h 97"/>
                    <a:gd name="T8" fmla="*/ 8 w 53"/>
                    <a:gd name="T9" fmla="*/ 80 h 97"/>
                    <a:gd name="T10" fmla="*/ 11 w 53"/>
                    <a:gd name="T11" fmla="*/ 76 h 97"/>
                    <a:gd name="T12" fmla="*/ 13 w 53"/>
                    <a:gd name="T13" fmla="*/ 72 h 97"/>
                    <a:gd name="T14" fmla="*/ 16 w 53"/>
                    <a:gd name="T15" fmla="*/ 67 h 97"/>
                    <a:gd name="T16" fmla="*/ 17 w 53"/>
                    <a:gd name="T17" fmla="*/ 63 h 97"/>
                    <a:gd name="T18" fmla="*/ 20 w 53"/>
                    <a:gd name="T19" fmla="*/ 59 h 97"/>
                    <a:gd name="T20" fmla="*/ 21 w 53"/>
                    <a:gd name="T21" fmla="*/ 54 h 97"/>
                    <a:gd name="T22" fmla="*/ 24 w 53"/>
                    <a:gd name="T23" fmla="*/ 50 h 97"/>
                    <a:gd name="T24" fmla="*/ 27 w 53"/>
                    <a:gd name="T25" fmla="*/ 46 h 97"/>
                    <a:gd name="T26" fmla="*/ 28 w 53"/>
                    <a:gd name="T27" fmla="*/ 41 h 97"/>
                    <a:gd name="T28" fmla="*/ 31 w 53"/>
                    <a:gd name="T29" fmla="*/ 37 h 97"/>
                    <a:gd name="T30" fmla="*/ 33 w 53"/>
                    <a:gd name="T31" fmla="*/ 33 h 97"/>
                    <a:gd name="T32" fmla="*/ 36 w 53"/>
                    <a:gd name="T33" fmla="*/ 30 h 97"/>
                    <a:gd name="T34" fmla="*/ 38 w 53"/>
                    <a:gd name="T35" fmla="*/ 26 h 97"/>
                    <a:gd name="T36" fmla="*/ 40 w 53"/>
                    <a:gd name="T37" fmla="*/ 21 h 97"/>
                    <a:gd name="T38" fmla="*/ 43 w 53"/>
                    <a:gd name="T39" fmla="*/ 17 h 97"/>
                    <a:gd name="T40" fmla="*/ 46 w 53"/>
                    <a:gd name="T41" fmla="*/ 13 h 97"/>
                    <a:gd name="T42" fmla="*/ 47 w 53"/>
                    <a:gd name="T43" fmla="*/ 8 h 97"/>
                    <a:gd name="T44" fmla="*/ 50 w 53"/>
                    <a:gd name="T45" fmla="*/ 4 h 97"/>
                    <a:gd name="T46" fmla="*/ 53 w 53"/>
                    <a:gd name="T47" fmla="*/ 0 h 9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</a:cxnLst>
                  <a:rect l="0" t="0" r="r" b="b"/>
                  <a:pathLst>
                    <a:path w="53" h="97">
                      <a:moveTo>
                        <a:pt x="0" y="97"/>
                      </a:moveTo>
                      <a:lnTo>
                        <a:pt x="3" y="93"/>
                      </a:lnTo>
                      <a:lnTo>
                        <a:pt x="4" y="89"/>
                      </a:lnTo>
                      <a:lnTo>
                        <a:pt x="7" y="85"/>
                      </a:lnTo>
                      <a:lnTo>
                        <a:pt x="8" y="80"/>
                      </a:lnTo>
                      <a:lnTo>
                        <a:pt x="11" y="76"/>
                      </a:lnTo>
                      <a:lnTo>
                        <a:pt x="13" y="72"/>
                      </a:lnTo>
                      <a:lnTo>
                        <a:pt x="16" y="67"/>
                      </a:lnTo>
                      <a:lnTo>
                        <a:pt x="17" y="63"/>
                      </a:lnTo>
                      <a:lnTo>
                        <a:pt x="20" y="59"/>
                      </a:lnTo>
                      <a:lnTo>
                        <a:pt x="21" y="54"/>
                      </a:lnTo>
                      <a:lnTo>
                        <a:pt x="24" y="50"/>
                      </a:lnTo>
                      <a:lnTo>
                        <a:pt x="27" y="46"/>
                      </a:lnTo>
                      <a:lnTo>
                        <a:pt x="28" y="41"/>
                      </a:lnTo>
                      <a:lnTo>
                        <a:pt x="31" y="37"/>
                      </a:lnTo>
                      <a:lnTo>
                        <a:pt x="33" y="33"/>
                      </a:lnTo>
                      <a:lnTo>
                        <a:pt x="36" y="30"/>
                      </a:lnTo>
                      <a:lnTo>
                        <a:pt x="38" y="26"/>
                      </a:lnTo>
                      <a:lnTo>
                        <a:pt x="40" y="21"/>
                      </a:lnTo>
                      <a:lnTo>
                        <a:pt x="43" y="17"/>
                      </a:lnTo>
                      <a:lnTo>
                        <a:pt x="46" y="13"/>
                      </a:lnTo>
                      <a:lnTo>
                        <a:pt x="47" y="8"/>
                      </a:lnTo>
                      <a:lnTo>
                        <a:pt x="50" y="4"/>
                      </a:lnTo>
                      <a:lnTo>
                        <a:pt x="53" y="0"/>
                      </a:lnTo>
                    </a:path>
                  </a:pathLst>
                </a:cu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8" name="Line 373"/>
                <p:cNvSpPr>
                  <a:spLocks noChangeShapeType="1"/>
                </p:cNvSpPr>
                <p:nvPr/>
              </p:nvSpPr>
              <p:spPr bwMode="auto">
                <a:xfrm flipH="1" flipV="1">
                  <a:off x="2623" y="1557"/>
                  <a:ext cx="56" cy="27"/>
                </a:xfrm>
                <a:prstGeom prst="line">
                  <a:avLst/>
                </a:pr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9" name="Freeform 374"/>
                <p:cNvSpPr/>
                <p:nvPr/>
              </p:nvSpPr>
              <p:spPr bwMode="auto">
                <a:xfrm>
                  <a:off x="2608" y="1683"/>
                  <a:ext cx="33" cy="101"/>
                </a:xfrm>
                <a:custGeom>
                  <a:avLst/>
                  <a:gdLst>
                    <a:gd name="T0" fmla="*/ 32 w 33"/>
                    <a:gd name="T1" fmla="*/ 2 h 101"/>
                    <a:gd name="T2" fmla="*/ 32 w 33"/>
                    <a:gd name="T3" fmla="*/ 3 h 101"/>
                    <a:gd name="T4" fmla="*/ 30 w 33"/>
                    <a:gd name="T5" fmla="*/ 6 h 101"/>
                    <a:gd name="T6" fmla="*/ 30 w 33"/>
                    <a:gd name="T7" fmla="*/ 7 h 101"/>
                    <a:gd name="T8" fmla="*/ 29 w 33"/>
                    <a:gd name="T9" fmla="*/ 10 h 101"/>
                    <a:gd name="T10" fmla="*/ 28 w 33"/>
                    <a:gd name="T11" fmla="*/ 13 h 101"/>
                    <a:gd name="T12" fmla="*/ 28 w 33"/>
                    <a:gd name="T13" fmla="*/ 14 h 101"/>
                    <a:gd name="T14" fmla="*/ 26 w 33"/>
                    <a:gd name="T15" fmla="*/ 17 h 101"/>
                    <a:gd name="T16" fmla="*/ 26 w 33"/>
                    <a:gd name="T17" fmla="*/ 19 h 101"/>
                    <a:gd name="T18" fmla="*/ 25 w 33"/>
                    <a:gd name="T19" fmla="*/ 22 h 101"/>
                    <a:gd name="T20" fmla="*/ 25 w 33"/>
                    <a:gd name="T21" fmla="*/ 25 h 101"/>
                    <a:gd name="T22" fmla="*/ 23 w 33"/>
                    <a:gd name="T23" fmla="*/ 26 h 101"/>
                    <a:gd name="T24" fmla="*/ 22 w 33"/>
                    <a:gd name="T25" fmla="*/ 29 h 101"/>
                    <a:gd name="T26" fmla="*/ 22 w 33"/>
                    <a:gd name="T27" fmla="*/ 32 h 101"/>
                    <a:gd name="T28" fmla="*/ 20 w 33"/>
                    <a:gd name="T29" fmla="*/ 33 h 101"/>
                    <a:gd name="T30" fmla="*/ 20 w 33"/>
                    <a:gd name="T31" fmla="*/ 36 h 101"/>
                    <a:gd name="T32" fmla="*/ 19 w 33"/>
                    <a:gd name="T33" fmla="*/ 37 h 101"/>
                    <a:gd name="T34" fmla="*/ 19 w 33"/>
                    <a:gd name="T35" fmla="*/ 40 h 101"/>
                    <a:gd name="T36" fmla="*/ 17 w 33"/>
                    <a:gd name="T37" fmla="*/ 43 h 101"/>
                    <a:gd name="T38" fmla="*/ 17 w 33"/>
                    <a:gd name="T39" fmla="*/ 45 h 101"/>
                    <a:gd name="T40" fmla="*/ 16 w 33"/>
                    <a:gd name="T41" fmla="*/ 47 h 101"/>
                    <a:gd name="T42" fmla="*/ 15 w 33"/>
                    <a:gd name="T43" fmla="*/ 50 h 101"/>
                    <a:gd name="T44" fmla="*/ 15 w 33"/>
                    <a:gd name="T45" fmla="*/ 52 h 101"/>
                    <a:gd name="T46" fmla="*/ 13 w 33"/>
                    <a:gd name="T47" fmla="*/ 55 h 101"/>
                    <a:gd name="T48" fmla="*/ 13 w 33"/>
                    <a:gd name="T49" fmla="*/ 56 h 101"/>
                    <a:gd name="T50" fmla="*/ 12 w 33"/>
                    <a:gd name="T51" fmla="*/ 59 h 101"/>
                    <a:gd name="T52" fmla="*/ 12 w 33"/>
                    <a:gd name="T53" fmla="*/ 62 h 101"/>
                    <a:gd name="T54" fmla="*/ 10 w 33"/>
                    <a:gd name="T55" fmla="*/ 63 h 101"/>
                    <a:gd name="T56" fmla="*/ 10 w 33"/>
                    <a:gd name="T57" fmla="*/ 66 h 101"/>
                    <a:gd name="T58" fmla="*/ 9 w 33"/>
                    <a:gd name="T59" fmla="*/ 69 h 101"/>
                    <a:gd name="T60" fmla="*/ 9 w 33"/>
                    <a:gd name="T61" fmla="*/ 70 h 101"/>
                    <a:gd name="T62" fmla="*/ 7 w 33"/>
                    <a:gd name="T63" fmla="*/ 73 h 101"/>
                    <a:gd name="T64" fmla="*/ 7 w 33"/>
                    <a:gd name="T65" fmla="*/ 76 h 101"/>
                    <a:gd name="T66" fmla="*/ 6 w 33"/>
                    <a:gd name="T67" fmla="*/ 78 h 101"/>
                    <a:gd name="T68" fmla="*/ 6 w 33"/>
                    <a:gd name="T69" fmla="*/ 80 h 101"/>
                    <a:gd name="T70" fmla="*/ 5 w 33"/>
                    <a:gd name="T71" fmla="*/ 82 h 101"/>
                    <a:gd name="T72" fmla="*/ 5 w 33"/>
                    <a:gd name="T73" fmla="*/ 85 h 101"/>
                    <a:gd name="T74" fmla="*/ 3 w 33"/>
                    <a:gd name="T75" fmla="*/ 88 h 101"/>
                    <a:gd name="T76" fmla="*/ 3 w 33"/>
                    <a:gd name="T77" fmla="*/ 89 h 101"/>
                    <a:gd name="T78" fmla="*/ 2 w 33"/>
                    <a:gd name="T79" fmla="*/ 92 h 101"/>
                    <a:gd name="T80" fmla="*/ 2 w 33"/>
                    <a:gd name="T81" fmla="*/ 95 h 101"/>
                    <a:gd name="T82" fmla="*/ 0 w 33"/>
                    <a:gd name="T83" fmla="*/ 96 h 101"/>
                    <a:gd name="T84" fmla="*/ 0 w 33"/>
                    <a:gd name="T85" fmla="*/ 99 h 10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</a:cxnLst>
                  <a:rect l="0" t="0" r="r" b="b"/>
                  <a:pathLst>
                    <a:path w="33" h="101">
                      <a:moveTo>
                        <a:pt x="33" y="0"/>
                      </a:moveTo>
                      <a:lnTo>
                        <a:pt x="32" y="2"/>
                      </a:lnTo>
                      <a:lnTo>
                        <a:pt x="32" y="2"/>
                      </a:lnTo>
                      <a:lnTo>
                        <a:pt x="32" y="3"/>
                      </a:lnTo>
                      <a:lnTo>
                        <a:pt x="30" y="4"/>
                      </a:lnTo>
                      <a:lnTo>
                        <a:pt x="30" y="6"/>
                      </a:lnTo>
                      <a:lnTo>
                        <a:pt x="30" y="7"/>
                      </a:lnTo>
                      <a:lnTo>
                        <a:pt x="30" y="7"/>
                      </a:lnTo>
                      <a:lnTo>
                        <a:pt x="29" y="9"/>
                      </a:lnTo>
                      <a:lnTo>
                        <a:pt x="29" y="10"/>
                      </a:lnTo>
                      <a:lnTo>
                        <a:pt x="29" y="12"/>
                      </a:lnTo>
                      <a:lnTo>
                        <a:pt x="28" y="13"/>
                      </a:lnTo>
                      <a:lnTo>
                        <a:pt x="28" y="13"/>
                      </a:lnTo>
                      <a:lnTo>
                        <a:pt x="28" y="14"/>
                      </a:lnTo>
                      <a:lnTo>
                        <a:pt x="28" y="16"/>
                      </a:lnTo>
                      <a:lnTo>
                        <a:pt x="26" y="17"/>
                      </a:lnTo>
                      <a:lnTo>
                        <a:pt x="26" y="19"/>
                      </a:lnTo>
                      <a:lnTo>
                        <a:pt x="26" y="19"/>
                      </a:lnTo>
                      <a:lnTo>
                        <a:pt x="25" y="20"/>
                      </a:lnTo>
                      <a:lnTo>
                        <a:pt x="25" y="22"/>
                      </a:lnTo>
                      <a:lnTo>
                        <a:pt x="25" y="23"/>
                      </a:lnTo>
                      <a:lnTo>
                        <a:pt x="25" y="25"/>
                      </a:lnTo>
                      <a:lnTo>
                        <a:pt x="23" y="26"/>
                      </a:lnTo>
                      <a:lnTo>
                        <a:pt x="23" y="26"/>
                      </a:lnTo>
                      <a:lnTo>
                        <a:pt x="23" y="27"/>
                      </a:lnTo>
                      <a:lnTo>
                        <a:pt x="22" y="29"/>
                      </a:lnTo>
                      <a:lnTo>
                        <a:pt x="22" y="30"/>
                      </a:lnTo>
                      <a:lnTo>
                        <a:pt x="22" y="32"/>
                      </a:lnTo>
                      <a:lnTo>
                        <a:pt x="22" y="32"/>
                      </a:lnTo>
                      <a:lnTo>
                        <a:pt x="20" y="33"/>
                      </a:lnTo>
                      <a:lnTo>
                        <a:pt x="20" y="35"/>
                      </a:lnTo>
                      <a:lnTo>
                        <a:pt x="20" y="36"/>
                      </a:lnTo>
                      <a:lnTo>
                        <a:pt x="19" y="37"/>
                      </a:lnTo>
                      <a:lnTo>
                        <a:pt x="19" y="37"/>
                      </a:lnTo>
                      <a:lnTo>
                        <a:pt x="19" y="39"/>
                      </a:lnTo>
                      <a:lnTo>
                        <a:pt x="19" y="40"/>
                      </a:lnTo>
                      <a:lnTo>
                        <a:pt x="17" y="42"/>
                      </a:lnTo>
                      <a:lnTo>
                        <a:pt x="17" y="43"/>
                      </a:lnTo>
                      <a:lnTo>
                        <a:pt x="17" y="43"/>
                      </a:lnTo>
                      <a:lnTo>
                        <a:pt x="17" y="45"/>
                      </a:lnTo>
                      <a:lnTo>
                        <a:pt x="16" y="46"/>
                      </a:lnTo>
                      <a:lnTo>
                        <a:pt x="16" y="47"/>
                      </a:lnTo>
                      <a:lnTo>
                        <a:pt x="16" y="49"/>
                      </a:lnTo>
                      <a:lnTo>
                        <a:pt x="15" y="50"/>
                      </a:lnTo>
                      <a:lnTo>
                        <a:pt x="15" y="50"/>
                      </a:lnTo>
                      <a:lnTo>
                        <a:pt x="15" y="52"/>
                      </a:lnTo>
                      <a:lnTo>
                        <a:pt x="15" y="53"/>
                      </a:lnTo>
                      <a:lnTo>
                        <a:pt x="13" y="55"/>
                      </a:lnTo>
                      <a:lnTo>
                        <a:pt x="13" y="56"/>
                      </a:lnTo>
                      <a:lnTo>
                        <a:pt x="13" y="56"/>
                      </a:lnTo>
                      <a:lnTo>
                        <a:pt x="13" y="58"/>
                      </a:lnTo>
                      <a:lnTo>
                        <a:pt x="12" y="59"/>
                      </a:lnTo>
                      <a:lnTo>
                        <a:pt x="12" y="60"/>
                      </a:lnTo>
                      <a:lnTo>
                        <a:pt x="12" y="62"/>
                      </a:lnTo>
                      <a:lnTo>
                        <a:pt x="12" y="63"/>
                      </a:lnTo>
                      <a:lnTo>
                        <a:pt x="10" y="63"/>
                      </a:lnTo>
                      <a:lnTo>
                        <a:pt x="10" y="65"/>
                      </a:lnTo>
                      <a:lnTo>
                        <a:pt x="10" y="66"/>
                      </a:lnTo>
                      <a:lnTo>
                        <a:pt x="9" y="68"/>
                      </a:lnTo>
                      <a:lnTo>
                        <a:pt x="9" y="69"/>
                      </a:lnTo>
                      <a:lnTo>
                        <a:pt x="9" y="69"/>
                      </a:lnTo>
                      <a:lnTo>
                        <a:pt x="9" y="70"/>
                      </a:lnTo>
                      <a:lnTo>
                        <a:pt x="7" y="72"/>
                      </a:lnTo>
                      <a:lnTo>
                        <a:pt x="7" y="73"/>
                      </a:lnTo>
                      <a:lnTo>
                        <a:pt x="7" y="75"/>
                      </a:lnTo>
                      <a:lnTo>
                        <a:pt x="7" y="76"/>
                      </a:lnTo>
                      <a:lnTo>
                        <a:pt x="6" y="76"/>
                      </a:lnTo>
                      <a:lnTo>
                        <a:pt x="6" y="78"/>
                      </a:lnTo>
                      <a:lnTo>
                        <a:pt x="6" y="79"/>
                      </a:lnTo>
                      <a:lnTo>
                        <a:pt x="6" y="80"/>
                      </a:lnTo>
                      <a:lnTo>
                        <a:pt x="5" y="82"/>
                      </a:lnTo>
                      <a:lnTo>
                        <a:pt x="5" y="82"/>
                      </a:lnTo>
                      <a:lnTo>
                        <a:pt x="5" y="83"/>
                      </a:lnTo>
                      <a:lnTo>
                        <a:pt x="5" y="85"/>
                      </a:lnTo>
                      <a:lnTo>
                        <a:pt x="3" y="86"/>
                      </a:lnTo>
                      <a:lnTo>
                        <a:pt x="3" y="88"/>
                      </a:lnTo>
                      <a:lnTo>
                        <a:pt x="3" y="89"/>
                      </a:lnTo>
                      <a:lnTo>
                        <a:pt x="3" y="89"/>
                      </a:lnTo>
                      <a:lnTo>
                        <a:pt x="3" y="91"/>
                      </a:lnTo>
                      <a:lnTo>
                        <a:pt x="2" y="92"/>
                      </a:lnTo>
                      <a:lnTo>
                        <a:pt x="2" y="93"/>
                      </a:lnTo>
                      <a:lnTo>
                        <a:pt x="2" y="95"/>
                      </a:lnTo>
                      <a:lnTo>
                        <a:pt x="2" y="95"/>
                      </a:lnTo>
                      <a:lnTo>
                        <a:pt x="0" y="96"/>
                      </a:lnTo>
                      <a:lnTo>
                        <a:pt x="0" y="98"/>
                      </a:lnTo>
                      <a:lnTo>
                        <a:pt x="0" y="99"/>
                      </a:lnTo>
                      <a:lnTo>
                        <a:pt x="0" y="101"/>
                      </a:lnTo>
                    </a:path>
                  </a:pathLst>
                </a:cu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0" name="Freeform 375"/>
                <p:cNvSpPr/>
                <p:nvPr/>
              </p:nvSpPr>
              <p:spPr bwMode="auto">
                <a:xfrm>
                  <a:off x="2641" y="1586"/>
                  <a:ext cx="42" cy="97"/>
                </a:xfrm>
                <a:custGeom>
                  <a:avLst/>
                  <a:gdLst>
                    <a:gd name="T0" fmla="*/ 0 w 42"/>
                    <a:gd name="T1" fmla="*/ 97 h 97"/>
                    <a:gd name="T2" fmla="*/ 2 w 42"/>
                    <a:gd name="T3" fmla="*/ 93 h 97"/>
                    <a:gd name="T4" fmla="*/ 3 w 42"/>
                    <a:gd name="T5" fmla="*/ 89 h 97"/>
                    <a:gd name="T6" fmla="*/ 5 w 42"/>
                    <a:gd name="T7" fmla="*/ 83 h 97"/>
                    <a:gd name="T8" fmla="*/ 7 w 42"/>
                    <a:gd name="T9" fmla="*/ 78 h 97"/>
                    <a:gd name="T10" fmla="*/ 9 w 42"/>
                    <a:gd name="T11" fmla="*/ 74 h 97"/>
                    <a:gd name="T12" fmla="*/ 10 w 42"/>
                    <a:gd name="T13" fmla="*/ 70 h 97"/>
                    <a:gd name="T14" fmla="*/ 12 w 42"/>
                    <a:gd name="T15" fmla="*/ 66 h 97"/>
                    <a:gd name="T16" fmla="*/ 15 w 42"/>
                    <a:gd name="T17" fmla="*/ 61 h 97"/>
                    <a:gd name="T18" fmla="*/ 16 w 42"/>
                    <a:gd name="T19" fmla="*/ 57 h 97"/>
                    <a:gd name="T20" fmla="*/ 17 w 42"/>
                    <a:gd name="T21" fmla="*/ 53 h 97"/>
                    <a:gd name="T22" fmla="*/ 19 w 42"/>
                    <a:gd name="T23" fmla="*/ 48 h 97"/>
                    <a:gd name="T24" fmla="*/ 22 w 42"/>
                    <a:gd name="T25" fmla="*/ 44 h 97"/>
                    <a:gd name="T26" fmla="*/ 23 w 42"/>
                    <a:gd name="T27" fmla="*/ 38 h 97"/>
                    <a:gd name="T28" fmla="*/ 25 w 42"/>
                    <a:gd name="T29" fmla="*/ 34 h 97"/>
                    <a:gd name="T30" fmla="*/ 28 w 42"/>
                    <a:gd name="T31" fmla="*/ 30 h 97"/>
                    <a:gd name="T32" fmla="*/ 29 w 42"/>
                    <a:gd name="T33" fmla="*/ 25 h 97"/>
                    <a:gd name="T34" fmla="*/ 32 w 42"/>
                    <a:gd name="T35" fmla="*/ 21 h 97"/>
                    <a:gd name="T36" fmla="*/ 33 w 42"/>
                    <a:gd name="T37" fmla="*/ 17 h 97"/>
                    <a:gd name="T38" fmla="*/ 35 w 42"/>
                    <a:gd name="T39" fmla="*/ 12 h 97"/>
                    <a:gd name="T40" fmla="*/ 38 w 42"/>
                    <a:gd name="T41" fmla="*/ 8 h 97"/>
                    <a:gd name="T42" fmla="*/ 39 w 42"/>
                    <a:gd name="T43" fmla="*/ 4 h 97"/>
                    <a:gd name="T44" fmla="*/ 42 w 42"/>
                    <a:gd name="T45" fmla="*/ 0 h 9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</a:cxnLst>
                  <a:rect l="0" t="0" r="r" b="b"/>
                  <a:pathLst>
                    <a:path w="42" h="97">
                      <a:moveTo>
                        <a:pt x="0" y="97"/>
                      </a:moveTo>
                      <a:lnTo>
                        <a:pt x="2" y="93"/>
                      </a:lnTo>
                      <a:lnTo>
                        <a:pt x="3" y="89"/>
                      </a:lnTo>
                      <a:lnTo>
                        <a:pt x="5" y="83"/>
                      </a:lnTo>
                      <a:lnTo>
                        <a:pt x="7" y="78"/>
                      </a:lnTo>
                      <a:lnTo>
                        <a:pt x="9" y="74"/>
                      </a:lnTo>
                      <a:lnTo>
                        <a:pt x="10" y="70"/>
                      </a:lnTo>
                      <a:lnTo>
                        <a:pt x="12" y="66"/>
                      </a:lnTo>
                      <a:lnTo>
                        <a:pt x="15" y="61"/>
                      </a:lnTo>
                      <a:lnTo>
                        <a:pt x="16" y="57"/>
                      </a:lnTo>
                      <a:lnTo>
                        <a:pt x="17" y="53"/>
                      </a:lnTo>
                      <a:lnTo>
                        <a:pt x="19" y="48"/>
                      </a:lnTo>
                      <a:lnTo>
                        <a:pt x="22" y="44"/>
                      </a:lnTo>
                      <a:lnTo>
                        <a:pt x="23" y="38"/>
                      </a:lnTo>
                      <a:lnTo>
                        <a:pt x="25" y="34"/>
                      </a:lnTo>
                      <a:lnTo>
                        <a:pt x="28" y="30"/>
                      </a:lnTo>
                      <a:lnTo>
                        <a:pt x="29" y="25"/>
                      </a:lnTo>
                      <a:lnTo>
                        <a:pt x="32" y="21"/>
                      </a:lnTo>
                      <a:lnTo>
                        <a:pt x="33" y="17"/>
                      </a:lnTo>
                      <a:lnTo>
                        <a:pt x="35" y="12"/>
                      </a:lnTo>
                      <a:lnTo>
                        <a:pt x="38" y="8"/>
                      </a:lnTo>
                      <a:lnTo>
                        <a:pt x="39" y="4"/>
                      </a:lnTo>
                      <a:lnTo>
                        <a:pt x="42" y="0"/>
                      </a:lnTo>
                    </a:path>
                  </a:pathLst>
                </a:cu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2" name="Line 377"/>
                <p:cNvSpPr>
                  <a:spLocks noChangeShapeType="1"/>
                </p:cNvSpPr>
                <p:nvPr/>
              </p:nvSpPr>
              <p:spPr bwMode="auto">
                <a:xfrm flipH="1" flipV="1">
                  <a:off x="2644" y="1685"/>
                  <a:ext cx="59" cy="21"/>
                </a:xfrm>
                <a:prstGeom prst="line">
                  <a:avLst/>
                </a:pr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3" name="Freeform 378"/>
                <p:cNvSpPr/>
                <p:nvPr/>
              </p:nvSpPr>
              <p:spPr bwMode="auto">
                <a:xfrm>
                  <a:off x="2651" y="1802"/>
                  <a:ext cx="23" cy="98"/>
                </a:xfrm>
                <a:custGeom>
                  <a:avLst/>
                  <a:gdLst>
                    <a:gd name="T0" fmla="*/ 23 w 23"/>
                    <a:gd name="T1" fmla="*/ 2 h 98"/>
                    <a:gd name="T2" fmla="*/ 22 w 23"/>
                    <a:gd name="T3" fmla="*/ 3 h 98"/>
                    <a:gd name="T4" fmla="*/ 22 w 23"/>
                    <a:gd name="T5" fmla="*/ 6 h 98"/>
                    <a:gd name="T6" fmla="*/ 20 w 23"/>
                    <a:gd name="T7" fmla="*/ 7 h 98"/>
                    <a:gd name="T8" fmla="*/ 20 w 23"/>
                    <a:gd name="T9" fmla="*/ 9 h 98"/>
                    <a:gd name="T10" fmla="*/ 20 w 23"/>
                    <a:gd name="T11" fmla="*/ 12 h 98"/>
                    <a:gd name="T12" fmla="*/ 19 w 23"/>
                    <a:gd name="T13" fmla="*/ 13 h 98"/>
                    <a:gd name="T14" fmla="*/ 19 w 23"/>
                    <a:gd name="T15" fmla="*/ 15 h 98"/>
                    <a:gd name="T16" fmla="*/ 19 w 23"/>
                    <a:gd name="T17" fmla="*/ 17 h 98"/>
                    <a:gd name="T18" fmla="*/ 18 w 23"/>
                    <a:gd name="T19" fmla="*/ 19 h 98"/>
                    <a:gd name="T20" fmla="*/ 18 w 23"/>
                    <a:gd name="T21" fmla="*/ 22 h 98"/>
                    <a:gd name="T22" fmla="*/ 16 w 23"/>
                    <a:gd name="T23" fmla="*/ 23 h 98"/>
                    <a:gd name="T24" fmla="*/ 16 w 23"/>
                    <a:gd name="T25" fmla="*/ 25 h 98"/>
                    <a:gd name="T26" fmla="*/ 16 w 23"/>
                    <a:gd name="T27" fmla="*/ 27 h 98"/>
                    <a:gd name="T28" fmla="*/ 15 w 23"/>
                    <a:gd name="T29" fmla="*/ 29 h 98"/>
                    <a:gd name="T30" fmla="*/ 15 w 23"/>
                    <a:gd name="T31" fmla="*/ 30 h 98"/>
                    <a:gd name="T32" fmla="*/ 15 w 23"/>
                    <a:gd name="T33" fmla="*/ 33 h 98"/>
                    <a:gd name="T34" fmla="*/ 13 w 23"/>
                    <a:gd name="T35" fmla="*/ 35 h 98"/>
                    <a:gd name="T36" fmla="*/ 13 w 23"/>
                    <a:gd name="T37" fmla="*/ 38 h 98"/>
                    <a:gd name="T38" fmla="*/ 13 w 23"/>
                    <a:gd name="T39" fmla="*/ 39 h 98"/>
                    <a:gd name="T40" fmla="*/ 12 w 23"/>
                    <a:gd name="T41" fmla="*/ 40 h 98"/>
                    <a:gd name="T42" fmla="*/ 12 w 23"/>
                    <a:gd name="T43" fmla="*/ 43 h 98"/>
                    <a:gd name="T44" fmla="*/ 12 w 23"/>
                    <a:gd name="T45" fmla="*/ 45 h 98"/>
                    <a:gd name="T46" fmla="*/ 10 w 23"/>
                    <a:gd name="T47" fmla="*/ 48 h 98"/>
                    <a:gd name="T48" fmla="*/ 10 w 23"/>
                    <a:gd name="T49" fmla="*/ 49 h 98"/>
                    <a:gd name="T50" fmla="*/ 10 w 23"/>
                    <a:gd name="T51" fmla="*/ 50 h 98"/>
                    <a:gd name="T52" fmla="*/ 9 w 23"/>
                    <a:gd name="T53" fmla="*/ 53 h 98"/>
                    <a:gd name="T54" fmla="*/ 9 w 23"/>
                    <a:gd name="T55" fmla="*/ 55 h 98"/>
                    <a:gd name="T56" fmla="*/ 9 w 23"/>
                    <a:gd name="T57" fmla="*/ 58 h 98"/>
                    <a:gd name="T58" fmla="*/ 7 w 23"/>
                    <a:gd name="T59" fmla="*/ 59 h 98"/>
                    <a:gd name="T60" fmla="*/ 7 w 23"/>
                    <a:gd name="T61" fmla="*/ 60 h 98"/>
                    <a:gd name="T62" fmla="*/ 7 w 23"/>
                    <a:gd name="T63" fmla="*/ 63 h 98"/>
                    <a:gd name="T64" fmla="*/ 6 w 23"/>
                    <a:gd name="T65" fmla="*/ 65 h 98"/>
                    <a:gd name="T66" fmla="*/ 6 w 23"/>
                    <a:gd name="T67" fmla="*/ 66 h 98"/>
                    <a:gd name="T68" fmla="*/ 6 w 23"/>
                    <a:gd name="T69" fmla="*/ 69 h 98"/>
                    <a:gd name="T70" fmla="*/ 5 w 23"/>
                    <a:gd name="T71" fmla="*/ 71 h 98"/>
                    <a:gd name="T72" fmla="*/ 5 w 23"/>
                    <a:gd name="T73" fmla="*/ 73 h 98"/>
                    <a:gd name="T74" fmla="*/ 5 w 23"/>
                    <a:gd name="T75" fmla="*/ 75 h 98"/>
                    <a:gd name="T76" fmla="*/ 5 w 23"/>
                    <a:gd name="T77" fmla="*/ 76 h 98"/>
                    <a:gd name="T78" fmla="*/ 3 w 23"/>
                    <a:gd name="T79" fmla="*/ 79 h 98"/>
                    <a:gd name="T80" fmla="*/ 3 w 23"/>
                    <a:gd name="T81" fmla="*/ 81 h 98"/>
                    <a:gd name="T82" fmla="*/ 3 w 23"/>
                    <a:gd name="T83" fmla="*/ 83 h 98"/>
                    <a:gd name="T84" fmla="*/ 2 w 23"/>
                    <a:gd name="T85" fmla="*/ 85 h 98"/>
                    <a:gd name="T86" fmla="*/ 2 w 23"/>
                    <a:gd name="T87" fmla="*/ 86 h 98"/>
                    <a:gd name="T88" fmla="*/ 2 w 23"/>
                    <a:gd name="T89" fmla="*/ 89 h 98"/>
                    <a:gd name="T90" fmla="*/ 2 w 23"/>
                    <a:gd name="T91" fmla="*/ 91 h 98"/>
                    <a:gd name="T92" fmla="*/ 0 w 23"/>
                    <a:gd name="T93" fmla="*/ 93 h 98"/>
                    <a:gd name="T94" fmla="*/ 0 w 23"/>
                    <a:gd name="T95" fmla="*/ 95 h 98"/>
                    <a:gd name="T96" fmla="*/ 0 w 23"/>
                    <a:gd name="T97" fmla="*/ 96 h 9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  <a:cxn ang="0">
                      <a:pos x="T90" y="T91"/>
                    </a:cxn>
                    <a:cxn ang="0">
                      <a:pos x="T92" y="T93"/>
                    </a:cxn>
                    <a:cxn ang="0">
                      <a:pos x="T94" y="T95"/>
                    </a:cxn>
                    <a:cxn ang="0">
                      <a:pos x="T96" y="T97"/>
                    </a:cxn>
                  </a:cxnLst>
                  <a:rect l="0" t="0" r="r" b="b"/>
                  <a:pathLst>
                    <a:path w="23" h="98">
                      <a:moveTo>
                        <a:pt x="23" y="0"/>
                      </a:moveTo>
                      <a:lnTo>
                        <a:pt x="23" y="2"/>
                      </a:lnTo>
                      <a:lnTo>
                        <a:pt x="22" y="2"/>
                      </a:lnTo>
                      <a:lnTo>
                        <a:pt x="22" y="3"/>
                      </a:lnTo>
                      <a:lnTo>
                        <a:pt x="22" y="5"/>
                      </a:lnTo>
                      <a:lnTo>
                        <a:pt x="22" y="6"/>
                      </a:lnTo>
                      <a:lnTo>
                        <a:pt x="22" y="6"/>
                      </a:lnTo>
                      <a:lnTo>
                        <a:pt x="20" y="7"/>
                      </a:lnTo>
                      <a:lnTo>
                        <a:pt x="20" y="9"/>
                      </a:lnTo>
                      <a:lnTo>
                        <a:pt x="20" y="9"/>
                      </a:lnTo>
                      <a:lnTo>
                        <a:pt x="20" y="10"/>
                      </a:lnTo>
                      <a:lnTo>
                        <a:pt x="20" y="12"/>
                      </a:lnTo>
                      <a:lnTo>
                        <a:pt x="19" y="12"/>
                      </a:lnTo>
                      <a:lnTo>
                        <a:pt x="19" y="13"/>
                      </a:lnTo>
                      <a:lnTo>
                        <a:pt x="19" y="15"/>
                      </a:lnTo>
                      <a:lnTo>
                        <a:pt x="19" y="15"/>
                      </a:lnTo>
                      <a:lnTo>
                        <a:pt x="19" y="16"/>
                      </a:lnTo>
                      <a:lnTo>
                        <a:pt x="19" y="17"/>
                      </a:lnTo>
                      <a:lnTo>
                        <a:pt x="18" y="19"/>
                      </a:lnTo>
                      <a:lnTo>
                        <a:pt x="18" y="19"/>
                      </a:lnTo>
                      <a:lnTo>
                        <a:pt x="18" y="20"/>
                      </a:lnTo>
                      <a:lnTo>
                        <a:pt x="18" y="22"/>
                      </a:lnTo>
                      <a:lnTo>
                        <a:pt x="18" y="22"/>
                      </a:lnTo>
                      <a:lnTo>
                        <a:pt x="16" y="23"/>
                      </a:lnTo>
                      <a:lnTo>
                        <a:pt x="16" y="25"/>
                      </a:lnTo>
                      <a:lnTo>
                        <a:pt x="16" y="25"/>
                      </a:lnTo>
                      <a:lnTo>
                        <a:pt x="16" y="26"/>
                      </a:lnTo>
                      <a:lnTo>
                        <a:pt x="16" y="27"/>
                      </a:lnTo>
                      <a:lnTo>
                        <a:pt x="16" y="27"/>
                      </a:lnTo>
                      <a:lnTo>
                        <a:pt x="15" y="29"/>
                      </a:lnTo>
                      <a:lnTo>
                        <a:pt x="15" y="30"/>
                      </a:lnTo>
                      <a:lnTo>
                        <a:pt x="15" y="30"/>
                      </a:lnTo>
                      <a:lnTo>
                        <a:pt x="15" y="32"/>
                      </a:lnTo>
                      <a:lnTo>
                        <a:pt x="15" y="33"/>
                      </a:lnTo>
                      <a:lnTo>
                        <a:pt x="13" y="35"/>
                      </a:lnTo>
                      <a:lnTo>
                        <a:pt x="13" y="35"/>
                      </a:lnTo>
                      <a:lnTo>
                        <a:pt x="13" y="36"/>
                      </a:lnTo>
                      <a:lnTo>
                        <a:pt x="13" y="38"/>
                      </a:lnTo>
                      <a:lnTo>
                        <a:pt x="13" y="38"/>
                      </a:lnTo>
                      <a:lnTo>
                        <a:pt x="13" y="39"/>
                      </a:lnTo>
                      <a:lnTo>
                        <a:pt x="12" y="40"/>
                      </a:lnTo>
                      <a:lnTo>
                        <a:pt x="12" y="40"/>
                      </a:lnTo>
                      <a:lnTo>
                        <a:pt x="12" y="42"/>
                      </a:lnTo>
                      <a:lnTo>
                        <a:pt x="12" y="43"/>
                      </a:lnTo>
                      <a:lnTo>
                        <a:pt x="12" y="43"/>
                      </a:lnTo>
                      <a:lnTo>
                        <a:pt x="12" y="45"/>
                      </a:lnTo>
                      <a:lnTo>
                        <a:pt x="10" y="46"/>
                      </a:lnTo>
                      <a:lnTo>
                        <a:pt x="10" y="48"/>
                      </a:lnTo>
                      <a:lnTo>
                        <a:pt x="10" y="48"/>
                      </a:lnTo>
                      <a:lnTo>
                        <a:pt x="10" y="49"/>
                      </a:lnTo>
                      <a:lnTo>
                        <a:pt x="10" y="50"/>
                      </a:lnTo>
                      <a:lnTo>
                        <a:pt x="10" y="50"/>
                      </a:lnTo>
                      <a:lnTo>
                        <a:pt x="9" y="52"/>
                      </a:lnTo>
                      <a:lnTo>
                        <a:pt x="9" y="53"/>
                      </a:lnTo>
                      <a:lnTo>
                        <a:pt x="9" y="53"/>
                      </a:lnTo>
                      <a:lnTo>
                        <a:pt x="9" y="55"/>
                      </a:lnTo>
                      <a:lnTo>
                        <a:pt x="9" y="56"/>
                      </a:lnTo>
                      <a:lnTo>
                        <a:pt x="9" y="58"/>
                      </a:lnTo>
                      <a:lnTo>
                        <a:pt x="9" y="58"/>
                      </a:lnTo>
                      <a:lnTo>
                        <a:pt x="7" y="59"/>
                      </a:lnTo>
                      <a:lnTo>
                        <a:pt x="7" y="60"/>
                      </a:lnTo>
                      <a:lnTo>
                        <a:pt x="7" y="60"/>
                      </a:lnTo>
                      <a:lnTo>
                        <a:pt x="7" y="62"/>
                      </a:lnTo>
                      <a:lnTo>
                        <a:pt x="7" y="63"/>
                      </a:lnTo>
                      <a:lnTo>
                        <a:pt x="7" y="63"/>
                      </a:lnTo>
                      <a:lnTo>
                        <a:pt x="6" y="65"/>
                      </a:lnTo>
                      <a:lnTo>
                        <a:pt x="6" y="66"/>
                      </a:lnTo>
                      <a:lnTo>
                        <a:pt x="6" y="66"/>
                      </a:lnTo>
                      <a:lnTo>
                        <a:pt x="6" y="68"/>
                      </a:lnTo>
                      <a:lnTo>
                        <a:pt x="6" y="69"/>
                      </a:lnTo>
                      <a:lnTo>
                        <a:pt x="6" y="71"/>
                      </a:lnTo>
                      <a:lnTo>
                        <a:pt x="5" y="71"/>
                      </a:lnTo>
                      <a:lnTo>
                        <a:pt x="5" y="72"/>
                      </a:lnTo>
                      <a:lnTo>
                        <a:pt x="5" y="73"/>
                      </a:lnTo>
                      <a:lnTo>
                        <a:pt x="5" y="73"/>
                      </a:lnTo>
                      <a:lnTo>
                        <a:pt x="5" y="75"/>
                      </a:lnTo>
                      <a:lnTo>
                        <a:pt x="5" y="76"/>
                      </a:lnTo>
                      <a:lnTo>
                        <a:pt x="5" y="76"/>
                      </a:lnTo>
                      <a:lnTo>
                        <a:pt x="3" y="78"/>
                      </a:lnTo>
                      <a:lnTo>
                        <a:pt x="3" y="79"/>
                      </a:lnTo>
                      <a:lnTo>
                        <a:pt x="3" y="81"/>
                      </a:lnTo>
                      <a:lnTo>
                        <a:pt x="3" y="81"/>
                      </a:lnTo>
                      <a:lnTo>
                        <a:pt x="3" y="82"/>
                      </a:lnTo>
                      <a:lnTo>
                        <a:pt x="3" y="83"/>
                      </a:lnTo>
                      <a:lnTo>
                        <a:pt x="3" y="83"/>
                      </a:lnTo>
                      <a:lnTo>
                        <a:pt x="2" y="85"/>
                      </a:lnTo>
                      <a:lnTo>
                        <a:pt x="2" y="86"/>
                      </a:lnTo>
                      <a:lnTo>
                        <a:pt x="2" y="86"/>
                      </a:lnTo>
                      <a:lnTo>
                        <a:pt x="2" y="88"/>
                      </a:lnTo>
                      <a:lnTo>
                        <a:pt x="2" y="89"/>
                      </a:lnTo>
                      <a:lnTo>
                        <a:pt x="2" y="91"/>
                      </a:lnTo>
                      <a:lnTo>
                        <a:pt x="2" y="91"/>
                      </a:lnTo>
                      <a:lnTo>
                        <a:pt x="0" y="92"/>
                      </a:lnTo>
                      <a:lnTo>
                        <a:pt x="0" y="93"/>
                      </a:lnTo>
                      <a:lnTo>
                        <a:pt x="0" y="93"/>
                      </a:lnTo>
                      <a:lnTo>
                        <a:pt x="0" y="95"/>
                      </a:lnTo>
                      <a:lnTo>
                        <a:pt x="0" y="96"/>
                      </a:lnTo>
                      <a:lnTo>
                        <a:pt x="0" y="96"/>
                      </a:lnTo>
                      <a:lnTo>
                        <a:pt x="0" y="98"/>
                      </a:lnTo>
                    </a:path>
                  </a:pathLst>
                </a:cu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4" name="Freeform 379"/>
                <p:cNvSpPr/>
                <p:nvPr/>
              </p:nvSpPr>
              <p:spPr bwMode="auto">
                <a:xfrm>
                  <a:off x="2674" y="1708"/>
                  <a:ext cx="32" cy="94"/>
                </a:xfrm>
                <a:custGeom>
                  <a:avLst/>
                  <a:gdLst>
                    <a:gd name="T0" fmla="*/ 0 w 32"/>
                    <a:gd name="T1" fmla="*/ 94 h 94"/>
                    <a:gd name="T2" fmla="*/ 2 w 32"/>
                    <a:gd name="T3" fmla="*/ 90 h 94"/>
                    <a:gd name="T4" fmla="*/ 3 w 32"/>
                    <a:gd name="T5" fmla="*/ 84 h 94"/>
                    <a:gd name="T6" fmla="*/ 5 w 32"/>
                    <a:gd name="T7" fmla="*/ 80 h 94"/>
                    <a:gd name="T8" fmla="*/ 6 w 32"/>
                    <a:gd name="T9" fmla="*/ 76 h 94"/>
                    <a:gd name="T10" fmla="*/ 7 w 32"/>
                    <a:gd name="T11" fmla="*/ 70 h 94"/>
                    <a:gd name="T12" fmla="*/ 9 w 32"/>
                    <a:gd name="T13" fmla="*/ 66 h 94"/>
                    <a:gd name="T14" fmla="*/ 10 w 32"/>
                    <a:gd name="T15" fmla="*/ 61 h 94"/>
                    <a:gd name="T16" fmla="*/ 12 w 32"/>
                    <a:gd name="T17" fmla="*/ 55 h 94"/>
                    <a:gd name="T18" fmla="*/ 13 w 32"/>
                    <a:gd name="T19" fmla="*/ 51 h 94"/>
                    <a:gd name="T20" fmla="*/ 15 w 32"/>
                    <a:gd name="T21" fmla="*/ 47 h 94"/>
                    <a:gd name="T22" fmla="*/ 16 w 32"/>
                    <a:gd name="T23" fmla="*/ 41 h 94"/>
                    <a:gd name="T24" fmla="*/ 17 w 32"/>
                    <a:gd name="T25" fmla="*/ 37 h 94"/>
                    <a:gd name="T26" fmla="*/ 19 w 32"/>
                    <a:gd name="T27" fmla="*/ 33 h 94"/>
                    <a:gd name="T28" fmla="*/ 20 w 32"/>
                    <a:gd name="T29" fmla="*/ 27 h 94"/>
                    <a:gd name="T30" fmla="*/ 23 w 32"/>
                    <a:gd name="T31" fmla="*/ 22 h 94"/>
                    <a:gd name="T32" fmla="*/ 25 w 32"/>
                    <a:gd name="T33" fmla="*/ 18 h 94"/>
                    <a:gd name="T34" fmla="*/ 26 w 32"/>
                    <a:gd name="T35" fmla="*/ 14 h 94"/>
                    <a:gd name="T36" fmla="*/ 27 w 32"/>
                    <a:gd name="T37" fmla="*/ 8 h 94"/>
                    <a:gd name="T38" fmla="*/ 29 w 32"/>
                    <a:gd name="T39" fmla="*/ 4 h 94"/>
                    <a:gd name="T40" fmla="*/ 32 w 32"/>
                    <a:gd name="T41" fmla="*/ 0 h 9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</a:cxnLst>
                  <a:rect l="0" t="0" r="r" b="b"/>
                  <a:pathLst>
                    <a:path w="32" h="94">
                      <a:moveTo>
                        <a:pt x="0" y="94"/>
                      </a:moveTo>
                      <a:lnTo>
                        <a:pt x="2" y="90"/>
                      </a:lnTo>
                      <a:lnTo>
                        <a:pt x="3" y="84"/>
                      </a:lnTo>
                      <a:lnTo>
                        <a:pt x="5" y="80"/>
                      </a:lnTo>
                      <a:lnTo>
                        <a:pt x="6" y="76"/>
                      </a:lnTo>
                      <a:lnTo>
                        <a:pt x="7" y="70"/>
                      </a:lnTo>
                      <a:lnTo>
                        <a:pt x="9" y="66"/>
                      </a:lnTo>
                      <a:lnTo>
                        <a:pt x="10" y="61"/>
                      </a:lnTo>
                      <a:lnTo>
                        <a:pt x="12" y="55"/>
                      </a:lnTo>
                      <a:lnTo>
                        <a:pt x="13" y="51"/>
                      </a:lnTo>
                      <a:lnTo>
                        <a:pt x="15" y="47"/>
                      </a:lnTo>
                      <a:lnTo>
                        <a:pt x="16" y="41"/>
                      </a:lnTo>
                      <a:lnTo>
                        <a:pt x="17" y="37"/>
                      </a:lnTo>
                      <a:lnTo>
                        <a:pt x="19" y="33"/>
                      </a:lnTo>
                      <a:lnTo>
                        <a:pt x="20" y="27"/>
                      </a:lnTo>
                      <a:lnTo>
                        <a:pt x="23" y="22"/>
                      </a:lnTo>
                      <a:lnTo>
                        <a:pt x="25" y="18"/>
                      </a:lnTo>
                      <a:lnTo>
                        <a:pt x="26" y="14"/>
                      </a:lnTo>
                      <a:lnTo>
                        <a:pt x="27" y="8"/>
                      </a:lnTo>
                      <a:lnTo>
                        <a:pt x="29" y="4"/>
                      </a:lnTo>
                      <a:lnTo>
                        <a:pt x="32" y="0"/>
                      </a:lnTo>
                    </a:path>
                  </a:pathLst>
                </a:cu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5" name="Rectangle 380"/>
                <p:cNvSpPr>
                  <a:spLocks noChangeArrowheads="1"/>
                </p:cNvSpPr>
                <p:nvPr/>
              </p:nvSpPr>
              <p:spPr bwMode="auto">
                <a:xfrm rot="900000">
                  <a:off x="2725" y="1752"/>
                  <a:ext cx="72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94</a:t>
                  </a:r>
                </a:p>
              </p:txBody>
            </p:sp>
            <p:sp>
              <p:nvSpPr>
                <p:cNvPr id="196" name="Line 381"/>
                <p:cNvSpPr>
                  <a:spLocks noChangeShapeType="1"/>
                </p:cNvSpPr>
                <p:nvPr/>
              </p:nvSpPr>
              <p:spPr bwMode="auto">
                <a:xfrm flipH="1" flipV="1">
                  <a:off x="2677" y="1804"/>
                  <a:ext cx="60" cy="17"/>
                </a:xfrm>
                <a:prstGeom prst="line">
                  <a:avLst/>
                </a:pr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7" name="Freeform 382"/>
                <p:cNvSpPr/>
                <p:nvPr/>
              </p:nvSpPr>
              <p:spPr bwMode="auto">
                <a:xfrm>
                  <a:off x="2700" y="1949"/>
                  <a:ext cx="12" cy="129"/>
                </a:xfrm>
                <a:custGeom>
                  <a:avLst/>
                  <a:gdLst>
                    <a:gd name="T0" fmla="*/ 12 w 12"/>
                    <a:gd name="T1" fmla="*/ 1 h 129"/>
                    <a:gd name="T2" fmla="*/ 12 w 12"/>
                    <a:gd name="T3" fmla="*/ 4 h 129"/>
                    <a:gd name="T4" fmla="*/ 12 w 12"/>
                    <a:gd name="T5" fmla="*/ 7 h 129"/>
                    <a:gd name="T6" fmla="*/ 10 w 12"/>
                    <a:gd name="T7" fmla="*/ 10 h 129"/>
                    <a:gd name="T8" fmla="*/ 10 w 12"/>
                    <a:gd name="T9" fmla="*/ 12 h 129"/>
                    <a:gd name="T10" fmla="*/ 10 w 12"/>
                    <a:gd name="T11" fmla="*/ 15 h 129"/>
                    <a:gd name="T12" fmla="*/ 9 w 12"/>
                    <a:gd name="T13" fmla="*/ 18 h 129"/>
                    <a:gd name="T14" fmla="*/ 9 w 12"/>
                    <a:gd name="T15" fmla="*/ 21 h 129"/>
                    <a:gd name="T16" fmla="*/ 9 w 12"/>
                    <a:gd name="T17" fmla="*/ 24 h 129"/>
                    <a:gd name="T18" fmla="*/ 9 w 12"/>
                    <a:gd name="T19" fmla="*/ 28 h 129"/>
                    <a:gd name="T20" fmla="*/ 7 w 12"/>
                    <a:gd name="T21" fmla="*/ 31 h 129"/>
                    <a:gd name="T22" fmla="*/ 7 w 12"/>
                    <a:gd name="T23" fmla="*/ 34 h 129"/>
                    <a:gd name="T24" fmla="*/ 7 w 12"/>
                    <a:gd name="T25" fmla="*/ 37 h 129"/>
                    <a:gd name="T26" fmla="*/ 7 w 12"/>
                    <a:gd name="T27" fmla="*/ 40 h 129"/>
                    <a:gd name="T28" fmla="*/ 6 w 12"/>
                    <a:gd name="T29" fmla="*/ 43 h 129"/>
                    <a:gd name="T30" fmla="*/ 6 w 12"/>
                    <a:gd name="T31" fmla="*/ 45 h 129"/>
                    <a:gd name="T32" fmla="*/ 6 w 12"/>
                    <a:gd name="T33" fmla="*/ 48 h 129"/>
                    <a:gd name="T34" fmla="*/ 6 w 12"/>
                    <a:gd name="T35" fmla="*/ 51 h 129"/>
                    <a:gd name="T36" fmla="*/ 4 w 12"/>
                    <a:gd name="T37" fmla="*/ 54 h 129"/>
                    <a:gd name="T38" fmla="*/ 4 w 12"/>
                    <a:gd name="T39" fmla="*/ 57 h 129"/>
                    <a:gd name="T40" fmla="*/ 4 w 12"/>
                    <a:gd name="T41" fmla="*/ 61 h 129"/>
                    <a:gd name="T42" fmla="*/ 4 w 12"/>
                    <a:gd name="T43" fmla="*/ 64 h 129"/>
                    <a:gd name="T44" fmla="*/ 3 w 12"/>
                    <a:gd name="T45" fmla="*/ 67 h 129"/>
                    <a:gd name="T46" fmla="*/ 3 w 12"/>
                    <a:gd name="T47" fmla="*/ 70 h 129"/>
                    <a:gd name="T48" fmla="*/ 3 w 12"/>
                    <a:gd name="T49" fmla="*/ 73 h 129"/>
                    <a:gd name="T50" fmla="*/ 3 w 12"/>
                    <a:gd name="T51" fmla="*/ 76 h 129"/>
                    <a:gd name="T52" fmla="*/ 3 w 12"/>
                    <a:gd name="T53" fmla="*/ 78 h 129"/>
                    <a:gd name="T54" fmla="*/ 3 w 12"/>
                    <a:gd name="T55" fmla="*/ 81 h 129"/>
                    <a:gd name="T56" fmla="*/ 1 w 12"/>
                    <a:gd name="T57" fmla="*/ 84 h 129"/>
                    <a:gd name="T58" fmla="*/ 1 w 12"/>
                    <a:gd name="T59" fmla="*/ 87 h 129"/>
                    <a:gd name="T60" fmla="*/ 1 w 12"/>
                    <a:gd name="T61" fmla="*/ 91 h 129"/>
                    <a:gd name="T62" fmla="*/ 1 w 12"/>
                    <a:gd name="T63" fmla="*/ 94 h 129"/>
                    <a:gd name="T64" fmla="*/ 1 w 12"/>
                    <a:gd name="T65" fmla="*/ 97 h 129"/>
                    <a:gd name="T66" fmla="*/ 1 w 12"/>
                    <a:gd name="T67" fmla="*/ 100 h 129"/>
                    <a:gd name="T68" fmla="*/ 1 w 12"/>
                    <a:gd name="T69" fmla="*/ 103 h 129"/>
                    <a:gd name="T70" fmla="*/ 0 w 12"/>
                    <a:gd name="T71" fmla="*/ 106 h 129"/>
                    <a:gd name="T72" fmla="*/ 0 w 12"/>
                    <a:gd name="T73" fmla="*/ 109 h 129"/>
                    <a:gd name="T74" fmla="*/ 0 w 12"/>
                    <a:gd name="T75" fmla="*/ 111 h 129"/>
                    <a:gd name="T76" fmla="*/ 0 w 12"/>
                    <a:gd name="T77" fmla="*/ 114 h 129"/>
                    <a:gd name="T78" fmla="*/ 0 w 12"/>
                    <a:gd name="T79" fmla="*/ 119 h 129"/>
                    <a:gd name="T80" fmla="*/ 0 w 12"/>
                    <a:gd name="T81" fmla="*/ 122 h 129"/>
                    <a:gd name="T82" fmla="*/ 0 w 12"/>
                    <a:gd name="T83" fmla="*/ 124 h 129"/>
                    <a:gd name="T84" fmla="*/ 0 w 12"/>
                    <a:gd name="T85" fmla="*/ 127 h 12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</a:cxnLst>
                  <a:rect l="0" t="0" r="r" b="b"/>
                  <a:pathLst>
                    <a:path w="12" h="129">
                      <a:moveTo>
                        <a:pt x="12" y="0"/>
                      </a:moveTo>
                      <a:lnTo>
                        <a:pt x="12" y="1"/>
                      </a:lnTo>
                      <a:lnTo>
                        <a:pt x="12" y="2"/>
                      </a:lnTo>
                      <a:lnTo>
                        <a:pt x="12" y="4"/>
                      </a:lnTo>
                      <a:lnTo>
                        <a:pt x="12" y="5"/>
                      </a:lnTo>
                      <a:lnTo>
                        <a:pt x="12" y="7"/>
                      </a:lnTo>
                      <a:lnTo>
                        <a:pt x="12" y="8"/>
                      </a:lnTo>
                      <a:lnTo>
                        <a:pt x="10" y="10"/>
                      </a:lnTo>
                      <a:lnTo>
                        <a:pt x="10" y="11"/>
                      </a:lnTo>
                      <a:lnTo>
                        <a:pt x="10" y="12"/>
                      </a:lnTo>
                      <a:lnTo>
                        <a:pt x="10" y="14"/>
                      </a:lnTo>
                      <a:lnTo>
                        <a:pt x="10" y="15"/>
                      </a:lnTo>
                      <a:lnTo>
                        <a:pt x="10" y="17"/>
                      </a:lnTo>
                      <a:lnTo>
                        <a:pt x="9" y="18"/>
                      </a:lnTo>
                      <a:lnTo>
                        <a:pt x="9" y="20"/>
                      </a:lnTo>
                      <a:lnTo>
                        <a:pt x="9" y="21"/>
                      </a:lnTo>
                      <a:lnTo>
                        <a:pt x="9" y="23"/>
                      </a:lnTo>
                      <a:lnTo>
                        <a:pt x="9" y="24"/>
                      </a:lnTo>
                      <a:lnTo>
                        <a:pt x="9" y="25"/>
                      </a:lnTo>
                      <a:lnTo>
                        <a:pt x="9" y="28"/>
                      </a:lnTo>
                      <a:lnTo>
                        <a:pt x="7" y="30"/>
                      </a:lnTo>
                      <a:lnTo>
                        <a:pt x="7" y="31"/>
                      </a:lnTo>
                      <a:lnTo>
                        <a:pt x="7" y="33"/>
                      </a:lnTo>
                      <a:lnTo>
                        <a:pt x="7" y="34"/>
                      </a:lnTo>
                      <a:lnTo>
                        <a:pt x="7" y="35"/>
                      </a:lnTo>
                      <a:lnTo>
                        <a:pt x="7" y="37"/>
                      </a:lnTo>
                      <a:lnTo>
                        <a:pt x="7" y="38"/>
                      </a:lnTo>
                      <a:lnTo>
                        <a:pt x="7" y="40"/>
                      </a:lnTo>
                      <a:lnTo>
                        <a:pt x="6" y="41"/>
                      </a:lnTo>
                      <a:lnTo>
                        <a:pt x="6" y="43"/>
                      </a:lnTo>
                      <a:lnTo>
                        <a:pt x="6" y="44"/>
                      </a:lnTo>
                      <a:lnTo>
                        <a:pt x="6" y="45"/>
                      </a:lnTo>
                      <a:lnTo>
                        <a:pt x="6" y="47"/>
                      </a:lnTo>
                      <a:lnTo>
                        <a:pt x="6" y="48"/>
                      </a:lnTo>
                      <a:lnTo>
                        <a:pt x="6" y="50"/>
                      </a:lnTo>
                      <a:lnTo>
                        <a:pt x="6" y="51"/>
                      </a:lnTo>
                      <a:lnTo>
                        <a:pt x="4" y="53"/>
                      </a:lnTo>
                      <a:lnTo>
                        <a:pt x="4" y="54"/>
                      </a:lnTo>
                      <a:lnTo>
                        <a:pt x="4" y="56"/>
                      </a:lnTo>
                      <a:lnTo>
                        <a:pt x="4" y="57"/>
                      </a:lnTo>
                      <a:lnTo>
                        <a:pt x="4" y="60"/>
                      </a:lnTo>
                      <a:lnTo>
                        <a:pt x="4" y="61"/>
                      </a:lnTo>
                      <a:lnTo>
                        <a:pt x="4" y="63"/>
                      </a:lnTo>
                      <a:lnTo>
                        <a:pt x="4" y="64"/>
                      </a:lnTo>
                      <a:lnTo>
                        <a:pt x="4" y="66"/>
                      </a:lnTo>
                      <a:lnTo>
                        <a:pt x="3" y="67"/>
                      </a:lnTo>
                      <a:lnTo>
                        <a:pt x="3" y="68"/>
                      </a:lnTo>
                      <a:lnTo>
                        <a:pt x="3" y="70"/>
                      </a:lnTo>
                      <a:lnTo>
                        <a:pt x="3" y="71"/>
                      </a:lnTo>
                      <a:lnTo>
                        <a:pt x="3" y="73"/>
                      </a:lnTo>
                      <a:lnTo>
                        <a:pt x="3" y="74"/>
                      </a:lnTo>
                      <a:lnTo>
                        <a:pt x="3" y="76"/>
                      </a:lnTo>
                      <a:lnTo>
                        <a:pt x="3" y="77"/>
                      </a:lnTo>
                      <a:lnTo>
                        <a:pt x="3" y="78"/>
                      </a:lnTo>
                      <a:lnTo>
                        <a:pt x="3" y="80"/>
                      </a:lnTo>
                      <a:lnTo>
                        <a:pt x="3" y="81"/>
                      </a:lnTo>
                      <a:lnTo>
                        <a:pt x="1" y="83"/>
                      </a:lnTo>
                      <a:lnTo>
                        <a:pt x="1" y="84"/>
                      </a:lnTo>
                      <a:lnTo>
                        <a:pt x="1" y="86"/>
                      </a:lnTo>
                      <a:lnTo>
                        <a:pt x="1" y="87"/>
                      </a:lnTo>
                      <a:lnTo>
                        <a:pt x="1" y="90"/>
                      </a:lnTo>
                      <a:lnTo>
                        <a:pt x="1" y="91"/>
                      </a:lnTo>
                      <a:lnTo>
                        <a:pt x="1" y="93"/>
                      </a:lnTo>
                      <a:lnTo>
                        <a:pt x="1" y="94"/>
                      </a:lnTo>
                      <a:lnTo>
                        <a:pt x="1" y="96"/>
                      </a:lnTo>
                      <a:lnTo>
                        <a:pt x="1" y="97"/>
                      </a:lnTo>
                      <a:lnTo>
                        <a:pt x="1" y="99"/>
                      </a:lnTo>
                      <a:lnTo>
                        <a:pt x="1" y="100"/>
                      </a:lnTo>
                      <a:lnTo>
                        <a:pt x="1" y="101"/>
                      </a:lnTo>
                      <a:lnTo>
                        <a:pt x="1" y="103"/>
                      </a:lnTo>
                      <a:lnTo>
                        <a:pt x="0" y="104"/>
                      </a:lnTo>
                      <a:lnTo>
                        <a:pt x="0" y="106"/>
                      </a:lnTo>
                      <a:lnTo>
                        <a:pt x="0" y="107"/>
                      </a:lnTo>
                      <a:lnTo>
                        <a:pt x="0" y="109"/>
                      </a:lnTo>
                      <a:lnTo>
                        <a:pt x="0" y="110"/>
                      </a:lnTo>
                      <a:lnTo>
                        <a:pt x="0" y="111"/>
                      </a:lnTo>
                      <a:lnTo>
                        <a:pt x="0" y="113"/>
                      </a:lnTo>
                      <a:lnTo>
                        <a:pt x="0" y="114"/>
                      </a:lnTo>
                      <a:lnTo>
                        <a:pt x="0" y="116"/>
                      </a:lnTo>
                      <a:lnTo>
                        <a:pt x="0" y="119"/>
                      </a:lnTo>
                      <a:lnTo>
                        <a:pt x="0" y="120"/>
                      </a:lnTo>
                      <a:lnTo>
                        <a:pt x="0" y="122"/>
                      </a:lnTo>
                      <a:lnTo>
                        <a:pt x="0" y="123"/>
                      </a:lnTo>
                      <a:lnTo>
                        <a:pt x="0" y="124"/>
                      </a:lnTo>
                      <a:lnTo>
                        <a:pt x="0" y="126"/>
                      </a:lnTo>
                      <a:lnTo>
                        <a:pt x="0" y="127"/>
                      </a:lnTo>
                      <a:lnTo>
                        <a:pt x="0" y="129"/>
                      </a:lnTo>
                    </a:path>
                  </a:pathLst>
                </a:cu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8" name="Freeform 383"/>
                <p:cNvSpPr/>
                <p:nvPr/>
              </p:nvSpPr>
              <p:spPr bwMode="auto">
                <a:xfrm>
                  <a:off x="2712" y="1821"/>
                  <a:ext cx="28" cy="128"/>
                </a:xfrm>
                <a:custGeom>
                  <a:avLst/>
                  <a:gdLst>
                    <a:gd name="T0" fmla="*/ 0 w 28"/>
                    <a:gd name="T1" fmla="*/ 128 h 128"/>
                    <a:gd name="T2" fmla="*/ 1 w 28"/>
                    <a:gd name="T3" fmla="*/ 122 h 128"/>
                    <a:gd name="T4" fmla="*/ 2 w 28"/>
                    <a:gd name="T5" fmla="*/ 118 h 128"/>
                    <a:gd name="T6" fmla="*/ 2 w 28"/>
                    <a:gd name="T7" fmla="*/ 112 h 128"/>
                    <a:gd name="T8" fmla="*/ 4 w 28"/>
                    <a:gd name="T9" fmla="*/ 106 h 128"/>
                    <a:gd name="T10" fmla="*/ 5 w 28"/>
                    <a:gd name="T11" fmla="*/ 102 h 128"/>
                    <a:gd name="T12" fmla="*/ 5 w 28"/>
                    <a:gd name="T13" fmla="*/ 96 h 128"/>
                    <a:gd name="T14" fmla="*/ 7 w 28"/>
                    <a:gd name="T15" fmla="*/ 92 h 128"/>
                    <a:gd name="T16" fmla="*/ 8 w 28"/>
                    <a:gd name="T17" fmla="*/ 86 h 128"/>
                    <a:gd name="T18" fmla="*/ 8 w 28"/>
                    <a:gd name="T19" fmla="*/ 82 h 128"/>
                    <a:gd name="T20" fmla="*/ 10 w 28"/>
                    <a:gd name="T21" fmla="*/ 76 h 128"/>
                    <a:gd name="T22" fmla="*/ 11 w 28"/>
                    <a:gd name="T23" fmla="*/ 70 h 128"/>
                    <a:gd name="T24" fmla="*/ 12 w 28"/>
                    <a:gd name="T25" fmla="*/ 66 h 128"/>
                    <a:gd name="T26" fmla="*/ 12 w 28"/>
                    <a:gd name="T27" fmla="*/ 60 h 128"/>
                    <a:gd name="T28" fmla="*/ 14 w 28"/>
                    <a:gd name="T29" fmla="*/ 56 h 128"/>
                    <a:gd name="T30" fmla="*/ 15 w 28"/>
                    <a:gd name="T31" fmla="*/ 50 h 128"/>
                    <a:gd name="T32" fmla="*/ 17 w 28"/>
                    <a:gd name="T33" fmla="*/ 46 h 128"/>
                    <a:gd name="T34" fmla="*/ 18 w 28"/>
                    <a:gd name="T35" fmla="*/ 40 h 128"/>
                    <a:gd name="T36" fmla="*/ 18 w 28"/>
                    <a:gd name="T37" fmla="*/ 36 h 128"/>
                    <a:gd name="T38" fmla="*/ 20 w 28"/>
                    <a:gd name="T39" fmla="*/ 30 h 128"/>
                    <a:gd name="T40" fmla="*/ 21 w 28"/>
                    <a:gd name="T41" fmla="*/ 26 h 128"/>
                    <a:gd name="T42" fmla="*/ 22 w 28"/>
                    <a:gd name="T43" fmla="*/ 20 h 128"/>
                    <a:gd name="T44" fmla="*/ 24 w 28"/>
                    <a:gd name="T45" fmla="*/ 16 h 128"/>
                    <a:gd name="T46" fmla="*/ 25 w 28"/>
                    <a:gd name="T47" fmla="*/ 10 h 128"/>
                    <a:gd name="T48" fmla="*/ 27 w 28"/>
                    <a:gd name="T49" fmla="*/ 6 h 128"/>
                    <a:gd name="T50" fmla="*/ 28 w 28"/>
                    <a:gd name="T51" fmla="*/ 0 h 12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</a:cxnLst>
                  <a:rect l="0" t="0" r="r" b="b"/>
                  <a:pathLst>
                    <a:path w="28" h="128">
                      <a:moveTo>
                        <a:pt x="0" y="128"/>
                      </a:moveTo>
                      <a:lnTo>
                        <a:pt x="1" y="122"/>
                      </a:lnTo>
                      <a:lnTo>
                        <a:pt x="2" y="118"/>
                      </a:lnTo>
                      <a:lnTo>
                        <a:pt x="2" y="112"/>
                      </a:lnTo>
                      <a:lnTo>
                        <a:pt x="4" y="106"/>
                      </a:lnTo>
                      <a:lnTo>
                        <a:pt x="5" y="102"/>
                      </a:lnTo>
                      <a:lnTo>
                        <a:pt x="5" y="96"/>
                      </a:lnTo>
                      <a:lnTo>
                        <a:pt x="7" y="92"/>
                      </a:lnTo>
                      <a:lnTo>
                        <a:pt x="8" y="86"/>
                      </a:lnTo>
                      <a:lnTo>
                        <a:pt x="8" y="82"/>
                      </a:lnTo>
                      <a:lnTo>
                        <a:pt x="10" y="76"/>
                      </a:lnTo>
                      <a:lnTo>
                        <a:pt x="11" y="70"/>
                      </a:lnTo>
                      <a:lnTo>
                        <a:pt x="12" y="66"/>
                      </a:lnTo>
                      <a:lnTo>
                        <a:pt x="12" y="60"/>
                      </a:lnTo>
                      <a:lnTo>
                        <a:pt x="14" y="56"/>
                      </a:lnTo>
                      <a:lnTo>
                        <a:pt x="15" y="50"/>
                      </a:lnTo>
                      <a:lnTo>
                        <a:pt x="17" y="46"/>
                      </a:lnTo>
                      <a:lnTo>
                        <a:pt x="18" y="40"/>
                      </a:lnTo>
                      <a:lnTo>
                        <a:pt x="18" y="36"/>
                      </a:lnTo>
                      <a:lnTo>
                        <a:pt x="20" y="30"/>
                      </a:lnTo>
                      <a:lnTo>
                        <a:pt x="21" y="26"/>
                      </a:lnTo>
                      <a:lnTo>
                        <a:pt x="22" y="20"/>
                      </a:lnTo>
                      <a:lnTo>
                        <a:pt x="24" y="16"/>
                      </a:lnTo>
                      <a:lnTo>
                        <a:pt x="25" y="10"/>
                      </a:lnTo>
                      <a:lnTo>
                        <a:pt x="27" y="6"/>
                      </a:lnTo>
                      <a:lnTo>
                        <a:pt x="28" y="0"/>
                      </a:lnTo>
                    </a:path>
                  </a:pathLst>
                </a:cu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0" name="Line 385"/>
                <p:cNvSpPr>
                  <a:spLocks noChangeShapeType="1"/>
                </p:cNvSpPr>
                <p:nvPr/>
              </p:nvSpPr>
              <p:spPr bwMode="auto">
                <a:xfrm flipH="1" flipV="1">
                  <a:off x="2714" y="1949"/>
                  <a:ext cx="62" cy="10"/>
                </a:xfrm>
                <a:prstGeom prst="line">
                  <a:avLst/>
                </a:pr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1" name="Freeform 386"/>
                <p:cNvSpPr/>
                <p:nvPr/>
              </p:nvSpPr>
              <p:spPr bwMode="auto">
                <a:xfrm>
                  <a:off x="2767" y="2119"/>
                  <a:ext cx="13" cy="161"/>
                </a:xfrm>
                <a:custGeom>
                  <a:avLst/>
                  <a:gdLst>
                    <a:gd name="T0" fmla="*/ 0 w 13"/>
                    <a:gd name="T1" fmla="*/ 2 h 161"/>
                    <a:gd name="T2" fmla="*/ 0 w 13"/>
                    <a:gd name="T3" fmla="*/ 5 h 161"/>
                    <a:gd name="T4" fmla="*/ 0 w 13"/>
                    <a:gd name="T5" fmla="*/ 7 h 161"/>
                    <a:gd name="T6" fmla="*/ 0 w 13"/>
                    <a:gd name="T7" fmla="*/ 10 h 161"/>
                    <a:gd name="T8" fmla="*/ 0 w 13"/>
                    <a:gd name="T9" fmla="*/ 13 h 161"/>
                    <a:gd name="T10" fmla="*/ 0 w 13"/>
                    <a:gd name="T11" fmla="*/ 16 h 161"/>
                    <a:gd name="T12" fmla="*/ 0 w 13"/>
                    <a:gd name="T13" fmla="*/ 18 h 161"/>
                    <a:gd name="T14" fmla="*/ 0 w 13"/>
                    <a:gd name="T15" fmla="*/ 20 h 161"/>
                    <a:gd name="T16" fmla="*/ 0 w 13"/>
                    <a:gd name="T17" fmla="*/ 23 h 161"/>
                    <a:gd name="T18" fmla="*/ 0 w 13"/>
                    <a:gd name="T19" fmla="*/ 26 h 161"/>
                    <a:gd name="T20" fmla="*/ 0 w 13"/>
                    <a:gd name="T21" fmla="*/ 29 h 161"/>
                    <a:gd name="T22" fmla="*/ 0 w 13"/>
                    <a:gd name="T23" fmla="*/ 32 h 161"/>
                    <a:gd name="T24" fmla="*/ 0 w 13"/>
                    <a:gd name="T25" fmla="*/ 35 h 161"/>
                    <a:gd name="T26" fmla="*/ 0 w 13"/>
                    <a:gd name="T27" fmla="*/ 38 h 161"/>
                    <a:gd name="T28" fmla="*/ 2 w 13"/>
                    <a:gd name="T29" fmla="*/ 40 h 161"/>
                    <a:gd name="T30" fmla="*/ 2 w 13"/>
                    <a:gd name="T31" fmla="*/ 43 h 161"/>
                    <a:gd name="T32" fmla="*/ 2 w 13"/>
                    <a:gd name="T33" fmla="*/ 46 h 161"/>
                    <a:gd name="T34" fmla="*/ 2 w 13"/>
                    <a:gd name="T35" fmla="*/ 49 h 161"/>
                    <a:gd name="T36" fmla="*/ 2 w 13"/>
                    <a:gd name="T37" fmla="*/ 52 h 161"/>
                    <a:gd name="T38" fmla="*/ 2 w 13"/>
                    <a:gd name="T39" fmla="*/ 55 h 161"/>
                    <a:gd name="T40" fmla="*/ 2 w 13"/>
                    <a:gd name="T41" fmla="*/ 58 h 161"/>
                    <a:gd name="T42" fmla="*/ 2 w 13"/>
                    <a:gd name="T43" fmla="*/ 59 h 161"/>
                    <a:gd name="T44" fmla="*/ 2 w 13"/>
                    <a:gd name="T45" fmla="*/ 62 h 161"/>
                    <a:gd name="T46" fmla="*/ 2 w 13"/>
                    <a:gd name="T47" fmla="*/ 65 h 161"/>
                    <a:gd name="T48" fmla="*/ 2 w 13"/>
                    <a:gd name="T49" fmla="*/ 68 h 161"/>
                    <a:gd name="T50" fmla="*/ 3 w 13"/>
                    <a:gd name="T51" fmla="*/ 71 h 161"/>
                    <a:gd name="T52" fmla="*/ 3 w 13"/>
                    <a:gd name="T53" fmla="*/ 73 h 161"/>
                    <a:gd name="T54" fmla="*/ 3 w 13"/>
                    <a:gd name="T55" fmla="*/ 76 h 161"/>
                    <a:gd name="T56" fmla="*/ 3 w 13"/>
                    <a:gd name="T57" fmla="*/ 79 h 161"/>
                    <a:gd name="T58" fmla="*/ 3 w 13"/>
                    <a:gd name="T59" fmla="*/ 82 h 161"/>
                    <a:gd name="T60" fmla="*/ 3 w 13"/>
                    <a:gd name="T61" fmla="*/ 85 h 161"/>
                    <a:gd name="T62" fmla="*/ 3 w 13"/>
                    <a:gd name="T63" fmla="*/ 88 h 161"/>
                    <a:gd name="T64" fmla="*/ 5 w 13"/>
                    <a:gd name="T65" fmla="*/ 91 h 161"/>
                    <a:gd name="T66" fmla="*/ 5 w 13"/>
                    <a:gd name="T67" fmla="*/ 94 h 161"/>
                    <a:gd name="T68" fmla="*/ 5 w 13"/>
                    <a:gd name="T69" fmla="*/ 96 h 161"/>
                    <a:gd name="T70" fmla="*/ 5 w 13"/>
                    <a:gd name="T71" fmla="*/ 98 h 161"/>
                    <a:gd name="T72" fmla="*/ 5 w 13"/>
                    <a:gd name="T73" fmla="*/ 101 h 161"/>
                    <a:gd name="T74" fmla="*/ 6 w 13"/>
                    <a:gd name="T75" fmla="*/ 104 h 161"/>
                    <a:gd name="T76" fmla="*/ 6 w 13"/>
                    <a:gd name="T77" fmla="*/ 106 h 161"/>
                    <a:gd name="T78" fmla="*/ 6 w 13"/>
                    <a:gd name="T79" fmla="*/ 109 h 161"/>
                    <a:gd name="T80" fmla="*/ 6 w 13"/>
                    <a:gd name="T81" fmla="*/ 112 h 161"/>
                    <a:gd name="T82" fmla="*/ 6 w 13"/>
                    <a:gd name="T83" fmla="*/ 115 h 161"/>
                    <a:gd name="T84" fmla="*/ 8 w 13"/>
                    <a:gd name="T85" fmla="*/ 118 h 161"/>
                    <a:gd name="T86" fmla="*/ 8 w 13"/>
                    <a:gd name="T87" fmla="*/ 121 h 161"/>
                    <a:gd name="T88" fmla="*/ 8 w 13"/>
                    <a:gd name="T89" fmla="*/ 124 h 161"/>
                    <a:gd name="T90" fmla="*/ 8 w 13"/>
                    <a:gd name="T91" fmla="*/ 127 h 161"/>
                    <a:gd name="T92" fmla="*/ 8 w 13"/>
                    <a:gd name="T93" fmla="*/ 129 h 161"/>
                    <a:gd name="T94" fmla="*/ 9 w 13"/>
                    <a:gd name="T95" fmla="*/ 132 h 161"/>
                    <a:gd name="T96" fmla="*/ 9 w 13"/>
                    <a:gd name="T97" fmla="*/ 134 h 161"/>
                    <a:gd name="T98" fmla="*/ 9 w 13"/>
                    <a:gd name="T99" fmla="*/ 137 h 161"/>
                    <a:gd name="T100" fmla="*/ 9 w 13"/>
                    <a:gd name="T101" fmla="*/ 139 h 161"/>
                    <a:gd name="T102" fmla="*/ 10 w 13"/>
                    <a:gd name="T103" fmla="*/ 142 h 161"/>
                    <a:gd name="T104" fmla="*/ 10 w 13"/>
                    <a:gd name="T105" fmla="*/ 145 h 161"/>
                    <a:gd name="T106" fmla="*/ 10 w 13"/>
                    <a:gd name="T107" fmla="*/ 148 h 161"/>
                    <a:gd name="T108" fmla="*/ 12 w 13"/>
                    <a:gd name="T109" fmla="*/ 151 h 161"/>
                    <a:gd name="T110" fmla="*/ 12 w 13"/>
                    <a:gd name="T111" fmla="*/ 154 h 161"/>
                    <a:gd name="T112" fmla="*/ 12 w 13"/>
                    <a:gd name="T113" fmla="*/ 157 h 161"/>
                    <a:gd name="T114" fmla="*/ 12 w 13"/>
                    <a:gd name="T115" fmla="*/ 160 h 16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  <a:cxn ang="0">
                      <a:pos x="T90" y="T91"/>
                    </a:cxn>
                    <a:cxn ang="0">
                      <a:pos x="T92" y="T93"/>
                    </a:cxn>
                    <a:cxn ang="0">
                      <a:pos x="T94" y="T95"/>
                    </a:cxn>
                    <a:cxn ang="0">
                      <a:pos x="T96" y="T97"/>
                    </a:cxn>
                    <a:cxn ang="0">
                      <a:pos x="T98" y="T99"/>
                    </a:cxn>
                    <a:cxn ang="0">
                      <a:pos x="T100" y="T101"/>
                    </a:cxn>
                    <a:cxn ang="0">
                      <a:pos x="T102" y="T103"/>
                    </a:cxn>
                    <a:cxn ang="0">
                      <a:pos x="T104" y="T105"/>
                    </a:cxn>
                    <a:cxn ang="0">
                      <a:pos x="T106" y="T107"/>
                    </a:cxn>
                    <a:cxn ang="0">
                      <a:pos x="T108" y="T109"/>
                    </a:cxn>
                    <a:cxn ang="0">
                      <a:pos x="T110" y="T111"/>
                    </a:cxn>
                    <a:cxn ang="0">
                      <a:pos x="T112" y="T113"/>
                    </a:cxn>
                    <a:cxn ang="0">
                      <a:pos x="T114" y="T115"/>
                    </a:cxn>
                  </a:cxnLst>
                  <a:rect l="0" t="0" r="r" b="b"/>
                  <a:pathLst>
                    <a:path w="13" h="161">
                      <a:moveTo>
                        <a:pt x="0" y="0"/>
                      </a:moveTo>
                      <a:lnTo>
                        <a:pt x="0" y="2"/>
                      </a:lnTo>
                      <a:lnTo>
                        <a:pt x="0" y="3"/>
                      </a:lnTo>
                      <a:lnTo>
                        <a:pt x="0" y="5"/>
                      </a:lnTo>
                      <a:lnTo>
                        <a:pt x="0" y="6"/>
                      </a:lnTo>
                      <a:lnTo>
                        <a:pt x="0" y="7"/>
                      </a:lnTo>
                      <a:lnTo>
                        <a:pt x="0" y="9"/>
                      </a:lnTo>
                      <a:lnTo>
                        <a:pt x="0" y="10"/>
                      </a:lnTo>
                      <a:lnTo>
                        <a:pt x="0" y="12"/>
                      </a:lnTo>
                      <a:lnTo>
                        <a:pt x="0" y="13"/>
                      </a:lnTo>
                      <a:lnTo>
                        <a:pt x="0" y="15"/>
                      </a:lnTo>
                      <a:lnTo>
                        <a:pt x="0" y="16"/>
                      </a:lnTo>
                      <a:lnTo>
                        <a:pt x="0" y="18"/>
                      </a:lnTo>
                      <a:lnTo>
                        <a:pt x="0" y="18"/>
                      </a:lnTo>
                      <a:lnTo>
                        <a:pt x="0" y="19"/>
                      </a:lnTo>
                      <a:lnTo>
                        <a:pt x="0" y="20"/>
                      </a:lnTo>
                      <a:lnTo>
                        <a:pt x="0" y="22"/>
                      </a:lnTo>
                      <a:lnTo>
                        <a:pt x="0" y="23"/>
                      </a:lnTo>
                      <a:lnTo>
                        <a:pt x="0" y="25"/>
                      </a:lnTo>
                      <a:lnTo>
                        <a:pt x="0" y="26"/>
                      </a:lnTo>
                      <a:lnTo>
                        <a:pt x="0" y="28"/>
                      </a:lnTo>
                      <a:lnTo>
                        <a:pt x="0" y="29"/>
                      </a:lnTo>
                      <a:lnTo>
                        <a:pt x="0" y="30"/>
                      </a:lnTo>
                      <a:lnTo>
                        <a:pt x="0" y="32"/>
                      </a:lnTo>
                      <a:lnTo>
                        <a:pt x="0" y="33"/>
                      </a:lnTo>
                      <a:lnTo>
                        <a:pt x="0" y="35"/>
                      </a:lnTo>
                      <a:lnTo>
                        <a:pt x="0" y="36"/>
                      </a:lnTo>
                      <a:lnTo>
                        <a:pt x="0" y="38"/>
                      </a:lnTo>
                      <a:lnTo>
                        <a:pt x="0" y="39"/>
                      </a:lnTo>
                      <a:lnTo>
                        <a:pt x="2" y="40"/>
                      </a:lnTo>
                      <a:lnTo>
                        <a:pt x="2" y="42"/>
                      </a:lnTo>
                      <a:lnTo>
                        <a:pt x="2" y="43"/>
                      </a:lnTo>
                      <a:lnTo>
                        <a:pt x="2" y="45"/>
                      </a:lnTo>
                      <a:lnTo>
                        <a:pt x="2" y="46"/>
                      </a:lnTo>
                      <a:lnTo>
                        <a:pt x="2" y="48"/>
                      </a:lnTo>
                      <a:lnTo>
                        <a:pt x="2" y="49"/>
                      </a:lnTo>
                      <a:lnTo>
                        <a:pt x="2" y="51"/>
                      </a:lnTo>
                      <a:lnTo>
                        <a:pt x="2" y="52"/>
                      </a:lnTo>
                      <a:lnTo>
                        <a:pt x="2" y="53"/>
                      </a:lnTo>
                      <a:lnTo>
                        <a:pt x="2" y="55"/>
                      </a:lnTo>
                      <a:lnTo>
                        <a:pt x="2" y="56"/>
                      </a:lnTo>
                      <a:lnTo>
                        <a:pt x="2" y="58"/>
                      </a:lnTo>
                      <a:lnTo>
                        <a:pt x="2" y="59"/>
                      </a:lnTo>
                      <a:lnTo>
                        <a:pt x="2" y="59"/>
                      </a:lnTo>
                      <a:lnTo>
                        <a:pt x="2" y="61"/>
                      </a:lnTo>
                      <a:lnTo>
                        <a:pt x="2" y="62"/>
                      </a:lnTo>
                      <a:lnTo>
                        <a:pt x="2" y="63"/>
                      </a:lnTo>
                      <a:lnTo>
                        <a:pt x="2" y="65"/>
                      </a:lnTo>
                      <a:lnTo>
                        <a:pt x="2" y="66"/>
                      </a:lnTo>
                      <a:lnTo>
                        <a:pt x="2" y="68"/>
                      </a:lnTo>
                      <a:lnTo>
                        <a:pt x="3" y="69"/>
                      </a:lnTo>
                      <a:lnTo>
                        <a:pt x="3" y="71"/>
                      </a:lnTo>
                      <a:lnTo>
                        <a:pt x="3" y="72"/>
                      </a:lnTo>
                      <a:lnTo>
                        <a:pt x="3" y="73"/>
                      </a:lnTo>
                      <a:lnTo>
                        <a:pt x="3" y="75"/>
                      </a:lnTo>
                      <a:lnTo>
                        <a:pt x="3" y="76"/>
                      </a:lnTo>
                      <a:lnTo>
                        <a:pt x="3" y="78"/>
                      </a:lnTo>
                      <a:lnTo>
                        <a:pt x="3" y="79"/>
                      </a:lnTo>
                      <a:lnTo>
                        <a:pt x="3" y="81"/>
                      </a:lnTo>
                      <a:lnTo>
                        <a:pt x="3" y="82"/>
                      </a:lnTo>
                      <a:lnTo>
                        <a:pt x="3" y="84"/>
                      </a:lnTo>
                      <a:lnTo>
                        <a:pt x="3" y="85"/>
                      </a:lnTo>
                      <a:lnTo>
                        <a:pt x="3" y="86"/>
                      </a:lnTo>
                      <a:lnTo>
                        <a:pt x="3" y="88"/>
                      </a:lnTo>
                      <a:lnTo>
                        <a:pt x="5" y="89"/>
                      </a:lnTo>
                      <a:lnTo>
                        <a:pt x="5" y="91"/>
                      </a:lnTo>
                      <a:lnTo>
                        <a:pt x="5" y="92"/>
                      </a:lnTo>
                      <a:lnTo>
                        <a:pt x="5" y="94"/>
                      </a:lnTo>
                      <a:lnTo>
                        <a:pt x="5" y="95"/>
                      </a:lnTo>
                      <a:lnTo>
                        <a:pt x="5" y="96"/>
                      </a:lnTo>
                      <a:lnTo>
                        <a:pt x="5" y="98"/>
                      </a:lnTo>
                      <a:lnTo>
                        <a:pt x="5" y="98"/>
                      </a:lnTo>
                      <a:lnTo>
                        <a:pt x="5" y="99"/>
                      </a:lnTo>
                      <a:lnTo>
                        <a:pt x="5" y="101"/>
                      </a:lnTo>
                      <a:lnTo>
                        <a:pt x="5" y="102"/>
                      </a:lnTo>
                      <a:lnTo>
                        <a:pt x="6" y="104"/>
                      </a:lnTo>
                      <a:lnTo>
                        <a:pt x="6" y="105"/>
                      </a:lnTo>
                      <a:lnTo>
                        <a:pt x="6" y="106"/>
                      </a:lnTo>
                      <a:lnTo>
                        <a:pt x="6" y="108"/>
                      </a:lnTo>
                      <a:lnTo>
                        <a:pt x="6" y="109"/>
                      </a:lnTo>
                      <a:lnTo>
                        <a:pt x="6" y="111"/>
                      </a:lnTo>
                      <a:lnTo>
                        <a:pt x="6" y="112"/>
                      </a:lnTo>
                      <a:lnTo>
                        <a:pt x="6" y="114"/>
                      </a:lnTo>
                      <a:lnTo>
                        <a:pt x="6" y="115"/>
                      </a:lnTo>
                      <a:lnTo>
                        <a:pt x="6" y="117"/>
                      </a:lnTo>
                      <a:lnTo>
                        <a:pt x="8" y="118"/>
                      </a:lnTo>
                      <a:lnTo>
                        <a:pt x="8" y="119"/>
                      </a:lnTo>
                      <a:lnTo>
                        <a:pt x="8" y="121"/>
                      </a:lnTo>
                      <a:lnTo>
                        <a:pt x="8" y="122"/>
                      </a:lnTo>
                      <a:lnTo>
                        <a:pt x="8" y="124"/>
                      </a:lnTo>
                      <a:lnTo>
                        <a:pt x="8" y="125"/>
                      </a:lnTo>
                      <a:lnTo>
                        <a:pt x="8" y="127"/>
                      </a:lnTo>
                      <a:lnTo>
                        <a:pt x="8" y="128"/>
                      </a:lnTo>
                      <a:lnTo>
                        <a:pt x="8" y="129"/>
                      </a:lnTo>
                      <a:lnTo>
                        <a:pt x="9" y="131"/>
                      </a:lnTo>
                      <a:lnTo>
                        <a:pt x="9" y="132"/>
                      </a:lnTo>
                      <a:lnTo>
                        <a:pt x="9" y="134"/>
                      </a:lnTo>
                      <a:lnTo>
                        <a:pt x="9" y="134"/>
                      </a:lnTo>
                      <a:lnTo>
                        <a:pt x="9" y="135"/>
                      </a:lnTo>
                      <a:lnTo>
                        <a:pt x="9" y="137"/>
                      </a:lnTo>
                      <a:lnTo>
                        <a:pt x="9" y="138"/>
                      </a:lnTo>
                      <a:lnTo>
                        <a:pt x="9" y="139"/>
                      </a:lnTo>
                      <a:lnTo>
                        <a:pt x="10" y="141"/>
                      </a:lnTo>
                      <a:lnTo>
                        <a:pt x="10" y="142"/>
                      </a:lnTo>
                      <a:lnTo>
                        <a:pt x="10" y="144"/>
                      </a:lnTo>
                      <a:lnTo>
                        <a:pt x="10" y="145"/>
                      </a:lnTo>
                      <a:lnTo>
                        <a:pt x="10" y="147"/>
                      </a:lnTo>
                      <a:lnTo>
                        <a:pt x="10" y="148"/>
                      </a:lnTo>
                      <a:lnTo>
                        <a:pt x="10" y="150"/>
                      </a:lnTo>
                      <a:lnTo>
                        <a:pt x="12" y="151"/>
                      </a:lnTo>
                      <a:lnTo>
                        <a:pt x="12" y="152"/>
                      </a:lnTo>
                      <a:lnTo>
                        <a:pt x="12" y="154"/>
                      </a:lnTo>
                      <a:lnTo>
                        <a:pt x="12" y="155"/>
                      </a:lnTo>
                      <a:lnTo>
                        <a:pt x="12" y="157"/>
                      </a:lnTo>
                      <a:lnTo>
                        <a:pt x="12" y="158"/>
                      </a:lnTo>
                      <a:lnTo>
                        <a:pt x="12" y="160"/>
                      </a:lnTo>
                      <a:lnTo>
                        <a:pt x="13" y="161"/>
                      </a:lnTo>
                    </a:path>
                  </a:pathLst>
                </a:cu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2" name="Freeform 387"/>
                <p:cNvSpPr/>
                <p:nvPr/>
              </p:nvSpPr>
              <p:spPr bwMode="auto">
                <a:xfrm>
                  <a:off x="2767" y="1959"/>
                  <a:ext cx="13" cy="160"/>
                </a:xfrm>
                <a:custGeom>
                  <a:avLst/>
                  <a:gdLst>
                    <a:gd name="T0" fmla="*/ 0 w 13"/>
                    <a:gd name="T1" fmla="*/ 160 h 160"/>
                    <a:gd name="T2" fmla="*/ 0 w 13"/>
                    <a:gd name="T3" fmla="*/ 155 h 160"/>
                    <a:gd name="T4" fmla="*/ 0 w 13"/>
                    <a:gd name="T5" fmla="*/ 149 h 160"/>
                    <a:gd name="T6" fmla="*/ 0 w 13"/>
                    <a:gd name="T7" fmla="*/ 143 h 160"/>
                    <a:gd name="T8" fmla="*/ 0 w 13"/>
                    <a:gd name="T9" fmla="*/ 137 h 160"/>
                    <a:gd name="T10" fmla="*/ 0 w 13"/>
                    <a:gd name="T11" fmla="*/ 133 h 160"/>
                    <a:gd name="T12" fmla="*/ 0 w 13"/>
                    <a:gd name="T13" fmla="*/ 127 h 160"/>
                    <a:gd name="T14" fmla="*/ 2 w 13"/>
                    <a:gd name="T15" fmla="*/ 122 h 160"/>
                    <a:gd name="T16" fmla="*/ 2 w 13"/>
                    <a:gd name="T17" fmla="*/ 116 h 160"/>
                    <a:gd name="T18" fmla="*/ 2 w 13"/>
                    <a:gd name="T19" fmla="*/ 110 h 160"/>
                    <a:gd name="T20" fmla="*/ 2 w 13"/>
                    <a:gd name="T21" fmla="*/ 104 h 160"/>
                    <a:gd name="T22" fmla="*/ 2 w 13"/>
                    <a:gd name="T23" fmla="*/ 99 h 160"/>
                    <a:gd name="T24" fmla="*/ 3 w 13"/>
                    <a:gd name="T25" fmla="*/ 94 h 160"/>
                    <a:gd name="T26" fmla="*/ 3 w 13"/>
                    <a:gd name="T27" fmla="*/ 89 h 160"/>
                    <a:gd name="T28" fmla="*/ 3 w 13"/>
                    <a:gd name="T29" fmla="*/ 83 h 160"/>
                    <a:gd name="T30" fmla="*/ 3 w 13"/>
                    <a:gd name="T31" fmla="*/ 77 h 160"/>
                    <a:gd name="T32" fmla="*/ 5 w 13"/>
                    <a:gd name="T33" fmla="*/ 71 h 160"/>
                    <a:gd name="T34" fmla="*/ 5 w 13"/>
                    <a:gd name="T35" fmla="*/ 66 h 160"/>
                    <a:gd name="T36" fmla="*/ 5 w 13"/>
                    <a:gd name="T37" fmla="*/ 60 h 160"/>
                    <a:gd name="T38" fmla="*/ 6 w 13"/>
                    <a:gd name="T39" fmla="*/ 56 h 160"/>
                    <a:gd name="T40" fmla="*/ 6 w 13"/>
                    <a:gd name="T41" fmla="*/ 50 h 160"/>
                    <a:gd name="T42" fmla="*/ 8 w 13"/>
                    <a:gd name="T43" fmla="*/ 44 h 160"/>
                    <a:gd name="T44" fmla="*/ 8 w 13"/>
                    <a:gd name="T45" fmla="*/ 38 h 160"/>
                    <a:gd name="T46" fmla="*/ 9 w 13"/>
                    <a:gd name="T47" fmla="*/ 33 h 160"/>
                    <a:gd name="T48" fmla="*/ 9 w 13"/>
                    <a:gd name="T49" fmla="*/ 27 h 160"/>
                    <a:gd name="T50" fmla="*/ 10 w 13"/>
                    <a:gd name="T51" fmla="*/ 23 h 160"/>
                    <a:gd name="T52" fmla="*/ 10 w 13"/>
                    <a:gd name="T53" fmla="*/ 17 h 160"/>
                    <a:gd name="T54" fmla="*/ 12 w 13"/>
                    <a:gd name="T55" fmla="*/ 11 h 160"/>
                    <a:gd name="T56" fmla="*/ 12 w 13"/>
                    <a:gd name="T57" fmla="*/ 5 h 160"/>
                    <a:gd name="T58" fmla="*/ 13 w 13"/>
                    <a:gd name="T59" fmla="*/ 0 h 16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</a:cxnLst>
                  <a:rect l="0" t="0" r="r" b="b"/>
                  <a:pathLst>
                    <a:path w="13" h="160">
                      <a:moveTo>
                        <a:pt x="0" y="160"/>
                      </a:moveTo>
                      <a:lnTo>
                        <a:pt x="0" y="155"/>
                      </a:lnTo>
                      <a:lnTo>
                        <a:pt x="0" y="149"/>
                      </a:lnTo>
                      <a:lnTo>
                        <a:pt x="0" y="143"/>
                      </a:lnTo>
                      <a:lnTo>
                        <a:pt x="0" y="137"/>
                      </a:lnTo>
                      <a:lnTo>
                        <a:pt x="0" y="133"/>
                      </a:lnTo>
                      <a:lnTo>
                        <a:pt x="0" y="127"/>
                      </a:lnTo>
                      <a:lnTo>
                        <a:pt x="2" y="122"/>
                      </a:lnTo>
                      <a:lnTo>
                        <a:pt x="2" y="116"/>
                      </a:lnTo>
                      <a:lnTo>
                        <a:pt x="2" y="110"/>
                      </a:lnTo>
                      <a:lnTo>
                        <a:pt x="2" y="104"/>
                      </a:lnTo>
                      <a:lnTo>
                        <a:pt x="2" y="99"/>
                      </a:lnTo>
                      <a:lnTo>
                        <a:pt x="3" y="94"/>
                      </a:lnTo>
                      <a:lnTo>
                        <a:pt x="3" y="89"/>
                      </a:lnTo>
                      <a:lnTo>
                        <a:pt x="3" y="83"/>
                      </a:lnTo>
                      <a:lnTo>
                        <a:pt x="3" y="77"/>
                      </a:lnTo>
                      <a:lnTo>
                        <a:pt x="5" y="71"/>
                      </a:lnTo>
                      <a:lnTo>
                        <a:pt x="5" y="66"/>
                      </a:lnTo>
                      <a:lnTo>
                        <a:pt x="5" y="60"/>
                      </a:lnTo>
                      <a:lnTo>
                        <a:pt x="6" y="56"/>
                      </a:lnTo>
                      <a:lnTo>
                        <a:pt x="6" y="50"/>
                      </a:lnTo>
                      <a:lnTo>
                        <a:pt x="8" y="44"/>
                      </a:lnTo>
                      <a:lnTo>
                        <a:pt x="8" y="38"/>
                      </a:lnTo>
                      <a:lnTo>
                        <a:pt x="9" y="33"/>
                      </a:lnTo>
                      <a:lnTo>
                        <a:pt x="9" y="27"/>
                      </a:lnTo>
                      <a:lnTo>
                        <a:pt x="10" y="23"/>
                      </a:lnTo>
                      <a:lnTo>
                        <a:pt x="10" y="17"/>
                      </a:lnTo>
                      <a:lnTo>
                        <a:pt x="12" y="11"/>
                      </a:lnTo>
                      <a:lnTo>
                        <a:pt x="12" y="5"/>
                      </a:lnTo>
                      <a:lnTo>
                        <a:pt x="13" y="0"/>
                      </a:lnTo>
                    </a:path>
                  </a:pathLst>
                </a:cu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4" name="Line 389"/>
                <p:cNvSpPr>
                  <a:spLocks noChangeShapeType="1"/>
                </p:cNvSpPr>
                <p:nvPr/>
              </p:nvSpPr>
              <p:spPr bwMode="auto">
                <a:xfrm flipH="1">
                  <a:off x="2770" y="2119"/>
                  <a:ext cx="63" cy="0"/>
                </a:xfrm>
                <a:prstGeom prst="line">
                  <a:avLst/>
                </a:pr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5" name="Freeform 390"/>
                <p:cNvSpPr/>
                <p:nvPr/>
              </p:nvSpPr>
              <p:spPr bwMode="auto">
                <a:xfrm>
                  <a:off x="2843" y="2236"/>
                  <a:ext cx="21" cy="114"/>
                </a:xfrm>
                <a:custGeom>
                  <a:avLst/>
                  <a:gdLst>
                    <a:gd name="T0" fmla="*/ 0 w 21"/>
                    <a:gd name="T1" fmla="*/ 1 h 114"/>
                    <a:gd name="T2" fmla="*/ 0 w 21"/>
                    <a:gd name="T3" fmla="*/ 2 h 114"/>
                    <a:gd name="T4" fmla="*/ 0 w 21"/>
                    <a:gd name="T5" fmla="*/ 4 h 114"/>
                    <a:gd name="T6" fmla="*/ 0 w 21"/>
                    <a:gd name="T7" fmla="*/ 7 h 114"/>
                    <a:gd name="T8" fmla="*/ 2 w 21"/>
                    <a:gd name="T9" fmla="*/ 8 h 114"/>
                    <a:gd name="T10" fmla="*/ 2 w 21"/>
                    <a:gd name="T11" fmla="*/ 10 h 114"/>
                    <a:gd name="T12" fmla="*/ 2 w 21"/>
                    <a:gd name="T13" fmla="*/ 11 h 114"/>
                    <a:gd name="T14" fmla="*/ 2 w 21"/>
                    <a:gd name="T15" fmla="*/ 14 h 114"/>
                    <a:gd name="T16" fmla="*/ 2 w 21"/>
                    <a:gd name="T17" fmla="*/ 15 h 114"/>
                    <a:gd name="T18" fmla="*/ 2 w 21"/>
                    <a:gd name="T19" fmla="*/ 17 h 114"/>
                    <a:gd name="T20" fmla="*/ 3 w 21"/>
                    <a:gd name="T21" fmla="*/ 20 h 114"/>
                    <a:gd name="T22" fmla="*/ 3 w 21"/>
                    <a:gd name="T23" fmla="*/ 21 h 114"/>
                    <a:gd name="T24" fmla="*/ 3 w 21"/>
                    <a:gd name="T25" fmla="*/ 22 h 114"/>
                    <a:gd name="T26" fmla="*/ 3 w 21"/>
                    <a:gd name="T27" fmla="*/ 25 h 114"/>
                    <a:gd name="T28" fmla="*/ 3 w 21"/>
                    <a:gd name="T29" fmla="*/ 27 h 114"/>
                    <a:gd name="T30" fmla="*/ 5 w 21"/>
                    <a:gd name="T31" fmla="*/ 28 h 114"/>
                    <a:gd name="T32" fmla="*/ 5 w 21"/>
                    <a:gd name="T33" fmla="*/ 30 h 114"/>
                    <a:gd name="T34" fmla="*/ 5 w 21"/>
                    <a:gd name="T35" fmla="*/ 33 h 114"/>
                    <a:gd name="T36" fmla="*/ 5 w 21"/>
                    <a:gd name="T37" fmla="*/ 34 h 114"/>
                    <a:gd name="T38" fmla="*/ 5 w 21"/>
                    <a:gd name="T39" fmla="*/ 35 h 114"/>
                    <a:gd name="T40" fmla="*/ 6 w 21"/>
                    <a:gd name="T41" fmla="*/ 38 h 114"/>
                    <a:gd name="T42" fmla="*/ 6 w 21"/>
                    <a:gd name="T43" fmla="*/ 40 h 114"/>
                    <a:gd name="T44" fmla="*/ 6 w 21"/>
                    <a:gd name="T45" fmla="*/ 41 h 114"/>
                    <a:gd name="T46" fmla="*/ 6 w 21"/>
                    <a:gd name="T47" fmla="*/ 44 h 114"/>
                    <a:gd name="T48" fmla="*/ 6 w 21"/>
                    <a:gd name="T49" fmla="*/ 45 h 114"/>
                    <a:gd name="T50" fmla="*/ 8 w 21"/>
                    <a:gd name="T51" fmla="*/ 47 h 114"/>
                    <a:gd name="T52" fmla="*/ 8 w 21"/>
                    <a:gd name="T53" fmla="*/ 48 h 114"/>
                    <a:gd name="T54" fmla="*/ 8 w 21"/>
                    <a:gd name="T55" fmla="*/ 51 h 114"/>
                    <a:gd name="T56" fmla="*/ 8 w 21"/>
                    <a:gd name="T57" fmla="*/ 53 h 114"/>
                    <a:gd name="T58" fmla="*/ 8 w 21"/>
                    <a:gd name="T59" fmla="*/ 54 h 114"/>
                    <a:gd name="T60" fmla="*/ 9 w 21"/>
                    <a:gd name="T61" fmla="*/ 57 h 114"/>
                    <a:gd name="T62" fmla="*/ 9 w 21"/>
                    <a:gd name="T63" fmla="*/ 58 h 114"/>
                    <a:gd name="T64" fmla="*/ 9 w 21"/>
                    <a:gd name="T65" fmla="*/ 60 h 114"/>
                    <a:gd name="T66" fmla="*/ 9 w 21"/>
                    <a:gd name="T67" fmla="*/ 61 h 114"/>
                    <a:gd name="T68" fmla="*/ 10 w 21"/>
                    <a:gd name="T69" fmla="*/ 64 h 114"/>
                    <a:gd name="T70" fmla="*/ 10 w 21"/>
                    <a:gd name="T71" fmla="*/ 66 h 114"/>
                    <a:gd name="T72" fmla="*/ 10 w 21"/>
                    <a:gd name="T73" fmla="*/ 67 h 114"/>
                    <a:gd name="T74" fmla="*/ 10 w 21"/>
                    <a:gd name="T75" fmla="*/ 70 h 114"/>
                    <a:gd name="T76" fmla="*/ 12 w 21"/>
                    <a:gd name="T77" fmla="*/ 71 h 114"/>
                    <a:gd name="T78" fmla="*/ 12 w 21"/>
                    <a:gd name="T79" fmla="*/ 73 h 114"/>
                    <a:gd name="T80" fmla="*/ 12 w 21"/>
                    <a:gd name="T81" fmla="*/ 74 h 114"/>
                    <a:gd name="T82" fmla="*/ 12 w 21"/>
                    <a:gd name="T83" fmla="*/ 77 h 114"/>
                    <a:gd name="T84" fmla="*/ 13 w 21"/>
                    <a:gd name="T85" fmla="*/ 78 h 114"/>
                    <a:gd name="T86" fmla="*/ 13 w 21"/>
                    <a:gd name="T87" fmla="*/ 80 h 114"/>
                    <a:gd name="T88" fmla="*/ 13 w 21"/>
                    <a:gd name="T89" fmla="*/ 83 h 114"/>
                    <a:gd name="T90" fmla="*/ 15 w 21"/>
                    <a:gd name="T91" fmla="*/ 84 h 114"/>
                    <a:gd name="T92" fmla="*/ 15 w 21"/>
                    <a:gd name="T93" fmla="*/ 86 h 114"/>
                    <a:gd name="T94" fmla="*/ 15 w 21"/>
                    <a:gd name="T95" fmla="*/ 87 h 114"/>
                    <a:gd name="T96" fmla="*/ 15 w 21"/>
                    <a:gd name="T97" fmla="*/ 90 h 114"/>
                    <a:gd name="T98" fmla="*/ 16 w 21"/>
                    <a:gd name="T99" fmla="*/ 91 h 114"/>
                    <a:gd name="T100" fmla="*/ 16 w 21"/>
                    <a:gd name="T101" fmla="*/ 93 h 114"/>
                    <a:gd name="T102" fmla="*/ 16 w 21"/>
                    <a:gd name="T103" fmla="*/ 96 h 114"/>
                    <a:gd name="T104" fmla="*/ 16 w 21"/>
                    <a:gd name="T105" fmla="*/ 97 h 114"/>
                    <a:gd name="T106" fmla="*/ 18 w 21"/>
                    <a:gd name="T107" fmla="*/ 99 h 114"/>
                    <a:gd name="T108" fmla="*/ 18 w 21"/>
                    <a:gd name="T109" fmla="*/ 100 h 114"/>
                    <a:gd name="T110" fmla="*/ 18 w 21"/>
                    <a:gd name="T111" fmla="*/ 103 h 114"/>
                    <a:gd name="T112" fmla="*/ 19 w 21"/>
                    <a:gd name="T113" fmla="*/ 104 h 114"/>
                    <a:gd name="T114" fmla="*/ 19 w 21"/>
                    <a:gd name="T115" fmla="*/ 106 h 114"/>
                    <a:gd name="T116" fmla="*/ 19 w 21"/>
                    <a:gd name="T117" fmla="*/ 107 h 114"/>
                    <a:gd name="T118" fmla="*/ 21 w 21"/>
                    <a:gd name="T119" fmla="*/ 110 h 114"/>
                    <a:gd name="T120" fmla="*/ 21 w 21"/>
                    <a:gd name="T121" fmla="*/ 111 h 114"/>
                    <a:gd name="T122" fmla="*/ 21 w 21"/>
                    <a:gd name="T123" fmla="*/ 113 h 11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  <a:cxn ang="0">
                      <a:pos x="T90" y="T91"/>
                    </a:cxn>
                    <a:cxn ang="0">
                      <a:pos x="T92" y="T93"/>
                    </a:cxn>
                    <a:cxn ang="0">
                      <a:pos x="T94" y="T95"/>
                    </a:cxn>
                    <a:cxn ang="0">
                      <a:pos x="T96" y="T97"/>
                    </a:cxn>
                    <a:cxn ang="0">
                      <a:pos x="T98" y="T99"/>
                    </a:cxn>
                    <a:cxn ang="0">
                      <a:pos x="T100" y="T101"/>
                    </a:cxn>
                    <a:cxn ang="0">
                      <a:pos x="T102" y="T103"/>
                    </a:cxn>
                    <a:cxn ang="0">
                      <a:pos x="T104" y="T105"/>
                    </a:cxn>
                    <a:cxn ang="0">
                      <a:pos x="T106" y="T107"/>
                    </a:cxn>
                    <a:cxn ang="0">
                      <a:pos x="T108" y="T109"/>
                    </a:cxn>
                    <a:cxn ang="0">
                      <a:pos x="T110" y="T111"/>
                    </a:cxn>
                    <a:cxn ang="0">
                      <a:pos x="T112" y="T113"/>
                    </a:cxn>
                    <a:cxn ang="0">
                      <a:pos x="T114" y="T115"/>
                    </a:cxn>
                    <a:cxn ang="0">
                      <a:pos x="T116" y="T117"/>
                    </a:cxn>
                    <a:cxn ang="0">
                      <a:pos x="T118" y="T119"/>
                    </a:cxn>
                    <a:cxn ang="0">
                      <a:pos x="T120" y="T121"/>
                    </a:cxn>
                    <a:cxn ang="0">
                      <a:pos x="T122" y="T123"/>
                    </a:cxn>
                  </a:cxnLst>
                  <a:rect l="0" t="0" r="r" b="b"/>
                  <a:pathLst>
                    <a:path w="21" h="114">
                      <a:moveTo>
                        <a:pt x="0" y="0"/>
                      </a:moveTo>
                      <a:lnTo>
                        <a:pt x="0" y="1"/>
                      </a:lnTo>
                      <a:lnTo>
                        <a:pt x="0" y="1"/>
                      </a:lnTo>
                      <a:lnTo>
                        <a:pt x="0" y="2"/>
                      </a:lnTo>
                      <a:lnTo>
                        <a:pt x="0" y="4"/>
                      </a:lnTo>
                      <a:lnTo>
                        <a:pt x="0" y="4"/>
                      </a:lnTo>
                      <a:lnTo>
                        <a:pt x="0" y="5"/>
                      </a:lnTo>
                      <a:lnTo>
                        <a:pt x="0" y="7"/>
                      </a:lnTo>
                      <a:lnTo>
                        <a:pt x="0" y="7"/>
                      </a:lnTo>
                      <a:lnTo>
                        <a:pt x="2" y="8"/>
                      </a:lnTo>
                      <a:lnTo>
                        <a:pt x="2" y="10"/>
                      </a:lnTo>
                      <a:lnTo>
                        <a:pt x="2" y="10"/>
                      </a:lnTo>
                      <a:lnTo>
                        <a:pt x="2" y="11"/>
                      </a:lnTo>
                      <a:lnTo>
                        <a:pt x="2" y="11"/>
                      </a:lnTo>
                      <a:lnTo>
                        <a:pt x="2" y="12"/>
                      </a:lnTo>
                      <a:lnTo>
                        <a:pt x="2" y="14"/>
                      </a:lnTo>
                      <a:lnTo>
                        <a:pt x="2" y="14"/>
                      </a:lnTo>
                      <a:lnTo>
                        <a:pt x="2" y="15"/>
                      </a:lnTo>
                      <a:lnTo>
                        <a:pt x="2" y="17"/>
                      </a:lnTo>
                      <a:lnTo>
                        <a:pt x="2" y="17"/>
                      </a:lnTo>
                      <a:lnTo>
                        <a:pt x="2" y="18"/>
                      </a:lnTo>
                      <a:lnTo>
                        <a:pt x="3" y="20"/>
                      </a:lnTo>
                      <a:lnTo>
                        <a:pt x="3" y="20"/>
                      </a:lnTo>
                      <a:lnTo>
                        <a:pt x="3" y="21"/>
                      </a:lnTo>
                      <a:lnTo>
                        <a:pt x="3" y="22"/>
                      </a:lnTo>
                      <a:lnTo>
                        <a:pt x="3" y="22"/>
                      </a:lnTo>
                      <a:lnTo>
                        <a:pt x="3" y="24"/>
                      </a:lnTo>
                      <a:lnTo>
                        <a:pt x="3" y="25"/>
                      </a:lnTo>
                      <a:lnTo>
                        <a:pt x="3" y="25"/>
                      </a:lnTo>
                      <a:lnTo>
                        <a:pt x="3" y="27"/>
                      </a:lnTo>
                      <a:lnTo>
                        <a:pt x="3" y="28"/>
                      </a:lnTo>
                      <a:lnTo>
                        <a:pt x="5" y="28"/>
                      </a:lnTo>
                      <a:lnTo>
                        <a:pt x="5" y="30"/>
                      </a:lnTo>
                      <a:lnTo>
                        <a:pt x="5" y="30"/>
                      </a:lnTo>
                      <a:lnTo>
                        <a:pt x="5" y="31"/>
                      </a:lnTo>
                      <a:lnTo>
                        <a:pt x="5" y="33"/>
                      </a:lnTo>
                      <a:lnTo>
                        <a:pt x="5" y="33"/>
                      </a:lnTo>
                      <a:lnTo>
                        <a:pt x="5" y="34"/>
                      </a:lnTo>
                      <a:lnTo>
                        <a:pt x="5" y="35"/>
                      </a:lnTo>
                      <a:lnTo>
                        <a:pt x="5" y="35"/>
                      </a:lnTo>
                      <a:lnTo>
                        <a:pt x="5" y="37"/>
                      </a:lnTo>
                      <a:lnTo>
                        <a:pt x="6" y="38"/>
                      </a:lnTo>
                      <a:lnTo>
                        <a:pt x="6" y="38"/>
                      </a:lnTo>
                      <a:lnTo>
                        <a:pt x="6" y="40"/>
                      </a:lnTo>
                      <a:lnTo>
                        <a:pt x="6" y="41"/>
                      </a:lnTo>
                      <a:lnTo>
                        <a:pt x="6" y="41"/>
                      </a:lnTo>
                      <a:lnTo>
                        <a:pt x="6" y="43"/>
                      </a:lnTo>
                      <a:lnTo>
                        <a:pt x="6" y="44"/>
                      </a:lnTo>
                      <a:lnTo>
                        <a:pt x="6" y="44"/>
                      </a:lnTo>
                      <a:lnTo>
                        <a:pt x="6" y="45"/>
                      </a:lnTo>
                      <a:lnTo>
                        <a:pt x="6" y="45"/>
                      </a:lnTo>
                      <a:lnTo>
                        <a:pt x="8" y="47"/>
                      </a:lnTo>
                      <a:lnTo>
                        <a:pt x="8" y="48"/>
                      </a:lnTo>
                      <a:lnTo>
                        <a:pt x="8" y="48"/>
                      </a:lnTo>
                      <a:lnTo>
                        <a:pt x="8" y="50"/>
                      </a:lnTo>
                      <a:lnTo>
                        <a:pt x="8" y="51"/>
                      </a:lnTo>
                      <a:lnTo>
                        <a:pt x="8" y="51"/>
                      </a:lnTo>
                      <a:lnTo>
                        <a:pt x="8" y="53"/>
                      </a:lnTo>
                      <a:lnTo>
                        <a:pt x="8" y="54"/>
                      </a:lnTo>
                      <a:lnTo>
                        <a:pt x="8" y="54"/>
                      </a:lnTo>
                      <a:lnTo>
                        <a:pt x="9" y="56"/>
                      </a:lnTo>
                      <a:lnTo>
                        <a:pt x="9" y="57"/>
                      </a:lnTo>
                      <a:lnTo>
                        <a:pt x="9" y="57"/>
                      </a:lnTo>
                      <a:lnTo>
                        <a:pt x="9" y="58"/>
                      </a:lnTo>
                      <a:lnTo>
                        <a:pt x="9" y="58"/>
                      </a:lnTo>
                      <a:lnTo>
                        <a:pt x="9" y="60"/>
                      </a:lnTo>
                      <a:lnTo>
                        <a:pt x="9" y="61"/>
                      </a:lnTo>
                      <a:lnTo>
                        <a:pt x="9" y="61"/>
                      </a:lnTo>
                      <a:lnTo>
                        <a:pt x="10" y="63"/>
                      </a:lnTo>
                      <a:lnTo>
                        <a:pt x="10" y="64"/>
                      </a:lnTo>
                      <a:lnTo>
                        <a:pt x="10" y="64"/>
                      </a:lnTo>
                      <a:lnTo>
                        <a:pt x="10" y="66"/>
                      </a:lnTo>
                      <a:lnTo>
                        <a:pt x="10" y="67"/>
                      </a:lnTo>
                      <a:lnTo>
                        <a:pt x="10" y="67"/>
                      </a:lnTo>
                      <a:lnTo>
                        <a:pt x="10" y="68"/>
                      </a:lnTo>
                      <a:lnTo>
                        <a:pt x="10" y="70"/>
                      </a:lnTo>
                      <a:lnTo>
                        <a:pt x="12" y="70"/>
                      </a:lnTo>
                      <a:lnTo>
                        <a:pt x="12" y="71"/>
                      </a:lnTo>
                      <a:lnTo>
                        <a:pt x="12" y="73"/>
                      </a:lnTo>
                      <a:lnTo>
                        <a:pt x="12" y="73"/>
                      </a:lnTo>
                      <a:lnTo>
                        <a:pt x="12" y="74"/>
                      </a:lnTo>
                      <a:lnTo>
                        <a:pt x="12" y="74"/>
                      </a:lnTo>
                      <a:lnTo>
                        <a:pt x="12" y="76"/>
                      </a:lnTo>
                      <a:lnTo>
                        <a:pt x="12" y="77"/>
                      </a:lnTo>
                      <a:lnTo>
                        <a:pt x="13" y="77"/>
                      </a:lnTo>
                      <a:lnTo>
                        <a:pt x="13" y="78"/>
                      </a:lnTo>
                      <a:lnTo>
                        <a:pt x="13" y="80"/>
                      </a:lnTo>
                      <a:lnTo>
                        <a:pt x="13" y="80"/>
                      </a:lnTo>
                      <a:lnTo>
                        <a:pt x="13" y="81"/>
                      </a:lnTo>
                      <a:lnTo>
                        <a:pt x="13" y="83"/>
                      </a:lnTo>
                      <a:lnTo>
                        <a:pt x="13" y="83"/>
                      </a:lnTo>
                      <a:lnTo>
                        <a:pt x="15" y="84"/>
                      </a:lnTo>
                      <a:lnTo>
                        <a:pt x="15" y="84"/>
                      </a:lnTo>
                      <a:lnTo>
                        <a:pt x="15" y="86"/>
                      </a:lnTo>
                      <a:lnTo>
                        <a:pt x="15" y="87"/>
                      </a:lnTo>
                      <a:lnTo>
                        <a:pt x="15" y="87"/>
                      </a:lnTo>
                      <a:lnTo>
                        <a:pt x="15" y="89"/>
                      </a:lnTo>
                      <a:lnTo>
                        <a:pt x="15" y="90"/>
                      </a:lnTo>
                      <a:lnTo>
                        <a:pt x="15" y="90"/>
                      </a:lnTo>
                      <a:lnTo>
                        <a:pt x="16" y="91"/>
                      </a:lnTo>
                      <a:lnTo>
                        <a:pt x="16" y="93"/>
                      </a:lnTo>
                      <a:lnTo>
                        <a:pt x="16" y="93"/>
                      </a:lnTo>
                      <a:lnTo>
                        <a:pt x="16" y="94"/>
                      </a:lnTo>
                      <a:lnTo>
                        <a:pt x="16" y="96"/>
                      </a:lnTo>
                      <a:lnTo>
                        <a:pt x="16" y="96"/>
                      </a:lnTo>
                      <a:lnTo>
                        <a:pt x="16" y="97"/>
                      </a:lnTo>
                      <a:lnTo>
                        <a:pt x="18" y="97"/>
                      </a:lnTo>
                      <a:lnTo>
                        <a:pt x="18" y="99"/>
                      </a:lnTo>
                      <a:lnTo>
                        <a:pt x="18" y="100"/>
                      </a:lnTo>
                      <a:lnTo>
                        <a:pt x="18" y="100"/>
                      </a:lnTo>
                      <a:lnTo>
                        <a:pt x="18" y="101"/>
                      </a:lnTo>
                      <a:lnTo>
                        <a:pt x="18" y="103"/>
                      </a:lnTo>
                      <a:lnTo>
                        <a:pt x="18" y="103"/>
                      </a:lnTo>
                      <a:lnTo>
                        <a:pt x="19" y="104"/>
                      </a:lnTo>
                      <a:lnTo>
                        <a:pt x="19" y="106"/>
                      </a:lnTo>
                      <a:lnTo>
                        <a:pt x="19" y="106"/>
                      </a:lnTo>
                      <a:lnTo>
                        <a:pt x="19" y="107"/>
                      </a:lnTo>
                      <a:lnTo>
                        <a:pt x="19" y="107"/>
                      </a:lnTo>
                      <a:lnTo>
                        <a:pt x="19" y="109"/>
                      </a:lnTo>
                      <a:lnTo>
                        <a:pt x="21" y="110"/>
                      </a:lnTo>
                      <a:lnTo>
                        <a:pt x="21" y="110"/>
                      </a:lnTo>
                      <a:lnTo>
                        <a:pt x="21" y="111"/>
                      </a:lnTo>
                      <a:lnTo>
                        <a:pt x="21" y="113"/>
                      </a:lnTo>
                      <a:lnTo>
                        <a:pt x="21" y="113"/>
                      </a:lnTo>
                      <a:lnTo>
                        <a:pt x="21" y="114"/>
                      </a:lnTo>
                    </a:path>
                  </a:pathLst>
                </a:cu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6" name="Freeform 391"/>
                <p:cNvSpPr/>
                <p:nvPr/>
              </p:nvSpPr>
              <p:spPr bwMode="auto">
                <a:xfrm>
                  <a:off x="2836" y="2119"/>
                  <a:ext cx="7" cy="117"/>
                </a:xfrm>
                <a:custGeom>
                  <a:avLst/>
                  <a:gdLst>
                    <a:gd name="T0" fmla="*/ 7 w 7"/>
                    <a:gd name="T1" fmla="*/ 117 h 117"/>
                    <a:gd name="T2" fmla="*/ 6 w 7"/>
                    <a:gd name="T3" fmla="*/ 111 h 117"/>
                    <a:gd name="T4" fmla="*/ 6 w 7"/>
                    <a:gd name="T5" fmla="*/ 105 h 117"/>
                    <a:gd name="T6" fmla="*/ 5 w 7"/>
                    <a:gd name="T7" fmla="*/ 99 h 117"/>
                    <a:gd name="T8" fmla="*/ 5 w 7"/>
                    <a:gd name="T9" fmla="*/ 94 h 117"/>
                    <a:gd name="T10" fmla="*/ 5 w 7"/>
                    <a:gd name="T11" fmla="*/ 88 h 117"/>
                    <a:gd name="T12" fmla="*/ 3 w 7"/>
                    <a:gd name="T13" fmla="*/ 82 h 117"/>
                    <a:gd name="T14" fmla="*/ 3 w 7"/>
                    <a:gd name="T15" fmla="*/ 76 h 117"/>
                    <a:gd name="T16" fmla="*/ 3 w 7"/>
                    <a:gd name="T17" fmla="*/ 71 h 117"/>
                    <a:gd name="T18" fmla="*/ 2 w 7"/>
                    <a:gd name="T19" fmla="*/ 65 h 117"/>
                    <a:gd name="T20" fmla="*/ 2 w 7"/>
                    <a:gd name="T21" fmla="*/ 59 h 117"/>
                    <a:gd name="T22" fmla="*/ 2 w 7"/>
                    <a:gd name="T23" fmla="*/ 53 h 117"/>
                    <a:gd name="T24" fmla="*/ 2 w 7"/>
                    <a:gd name="T25" fmla="*/ 46 h 117"/>
                    <a:gd name="T26" fmla="*/ 2 w 7"/>
                    <a:gd name="T27" fmla="*/ 40 h 117"/>
                    <a:gd name="T28" fmla="*/ 0 w 7"/>
                    <a:gd name="T29" fmla="*/ 35 h 117"/>
                    <a:gd name="T30" fmla="*/ 0 w 7"/>
                    <a:gd name="T31" fmla="*/ 29 h 117"/>
                    <a:gd name="T32" fmla="*/ 0 w 7"/>
                    <a:gd name="T33" fmla="*/ 23 h 117"/>
                    <a:gd name="T34" fmla="*/ 0 w 7"/>
                    <a:gd name="T35" fmla="*/ 18 h 117"/>
                    <a:gd name="T36" fmla="*/ 0 w 7"/>
                    <a:gd name="T37" fmla="*/ 12 h 117"/>
                    <a:gd name="T38" fmla="*/ 0 w 7"/>
                    <a:gd name="T39" fmla="*/ 6 h 117"/>
                    <a:gd name="T40" fmla="*/ 0 w 7"/>
                    <a:gd name="T41" fmla="*/ 0 h 11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</a:cxnLst>
                  <a:rect l="0" t="0" r="r" b="b"/>
                  <a:pathLst>
                    <a:path w="7" h="117">
                      <a:moveTo>
                        <a:pt x="7" y="117"/>
                      </a:moveTo>
                      <a:lnTo>
                        <a:pt x="6" y="111"/>
                      </a:lnTo>
                      <a:lnTo>
                        <a:pt x="6" y="105"/>
                      </a:lnTo>
                      <a:lnTo>
                        <a:pt x="5" y="99"/>
                      </a:lnTo>
                      <a:lnTo>
                        <a:pt x="5" y="94"/>
                      </a:lnTo>
                      <a:lnTo>
                        <a:pt x="5" y="88"/>
                      </a:lnTo>
                      <a:lnTo>
                        <a:pt x="3" y="82"/>
                      </a:lnTo>
                      <a:lnTo>
                        <a:pt x="3" y="76"/>
                      </a:lnTo>
                      <a:lnTo>
                        <a:pt x="3" y="71"/>
                      </a:lnTo>
                      <a:lnTo>
                        <a:pt x="2" y="65"/>
                      </a:lnTo>
                      <a:lnTo>
                        <a:pt x="2" y="59"/>
                      </a:lnTo>
                      <a:lnTo>
                        <a:pt x="2" y="53"/>
                      </a:lnTo>
                      <a:lnTo>
                        <a:pt x="2" y="46"/>
                      </a:lnTo>
                      <a:lnTo>
                        <a:pt x="2" y="40"/>
                      </a:lnTo>
                      <a:lnTo>
                        <a:pt x="0" y="35"/>
                      </a:lnTo>
                      <a:lnTo>
                        <a:pt x="0" y="29"/>
                      </a:lnTo>
                      <a:lnTo>
                        <a:pt x="0" y="23"/>
                      </a:lnTo>
                      <a:lnTo>
                        <a:pt x="0" y="18"/>
                      </a:lnTo>
                      <a:lnTo>
                        <a:pt x="0" y="12"/>
                      </a:lnTo>
                      <a:lnTo>
                        <a:pt x="0" y="6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7" name="Rectangle 392"/>
                <p:cNvSpPr>
                  <a:spLocks noChangeArrowheads="1"/>
                </p:cNvSpPr>
                <p:nvPr/>
              </p:nvSpPr>
              <p:spPr bwMode="auto">
                <a:xfrm rot="21180000">
                  <a:off x="2886" y="2152"/>
                  <a:ext cx="108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</a:p>
              </p:txBody>
            </p:sp>
            <p:sp>
              <p:nvSpPr>
                <p:cNvPr id="208" name="Line 393"/>
                <p:cNvSpPr>
                  <a:spLocks noChangeShapeType="1"/>
                </p:cNvSpPr>
                <p:nvPr/>
              </p:nvSpPr>
              <p:spPr bwMode="auto">
                <a:xfrm flipH="1">
                  <a:off x="2846" y="2162"/>
                  <a:ext cx="610" cy="74"/>
                </a:xfrm>
                <a:prstGeom prst="line">
                  <a:avLst/>
                </a:pr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9" name="Rectangle 394"/>
                <p:cNvSpPr>
                  <a:spLocks noChangeArrowheads="1"/>
                </p:cNvSpPr>
                <p:nvPr/>
              </p:nvSpPr>
              <p:spPr bwMode="auto">
                <a:xfrm rot="3300000">
                  <a:off x="2590" y="446"/>
                  <a:ext cx="190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JG-C5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0" name="Line 395"/>
                <p:cNvSpPr>
                  <a:spLocks noChangeShapeType="1"/>
                </p:cNvSpPr>
                <p:nvPr/>
              </p:nvSpPr>
              <p:spPr bwMode="auto">
                <a:xfrm flipH="1" flipV="1">
                  <a:off x="2819" y="709"/>
                  <a:ext cx="115" cy="165"/>
                </a:xfrm>
                <a:prstGeom prst="line">
                  <a:avLst/>
                </a:pr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1" name="Rectangle 396"/>
                <p:cNvSpPr>
                  <a:spLocks noChangeArrowheads="1"/>
                </p:cNvSpPr>
                <p:nvPr/>
              </p:nvSpPr>
              <p:spPr bwMode="auto">
                <a:xfrm rot="3600000">
                  <a:off x="2740" y="356"/>
                  <a:ext cx="190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JG-C6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2" name="Line 397"/>
                <p:cNvSpPr>
                  <a:spLocks noChangeShapeType="1"/>
                </p:cNvSpPr>
                <p:nvPr/>
              </p:nvSpPr>
              <p:spPr bwMode="auto">
                <a:xfrm flipH="1" flipV="1">
                  <a:off x="2945" y="630"/>
                  <a:ext cx="66" cy="115"/>
                </a:xfrm>
                <a:prstGeom prst="line">
                  <a:avLst/>
                </a:pr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3" name="Rectangle 398"/>
                <p:cNvSpPr>
                  <a:spLocks noChangeArrowheads="1"/>
                </p:cNvSpPr>
                <p:nvPr/>
              </p:nvSpPr>
              <p:spPr bwMode="auto">
                <a:xfrm rot="3900000">
                  <a:off x="2877" y="256"/>
                  <a:ext cx="214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X-C4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4" name="Line 399"/>
                <p:cNvSpPr>
                  <a:spLocks noChangeShapeType="1"/>
                </p:cNvSpPr>
                <p:nvPr/>
              </p:nvSpPr>
              <p:spPr bwMode="auto">
                <a:xfrm flipH="1" flipV="1">
                  <a:off x="3076" y="562"/>
                  <a:ext cx="26" cy="58"/>
                </a:xfrm>
                <a:prstGeom prst="line">
                  <a:avLst/>
                </a:pr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5" name="Rectangle 400"/>
                <p:cNvSpPr>
                  <a:spLocks noChangeArrowheads="1"/>
                </p:cNvSpPr>
                <p:nvPr/>
              </p:nvSpPr>
              <p:spPr bwMode="auto">
                <a:xfrm rot="4200000">
                  <a:off x="3034" y="211"/>
                  <a:ext cx="210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B-C4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6" name="Line 401"/>
                <p:cNvSpPr>
                  <a:spLocks noChangeShapeType="1"/>
                </p:cNvSpPr>
                <p:nvPr/>
              </p:nvSpPr>
              <p:spPr bwMode="auto">
                <a:xfrm flipH="1" flipV="1">
                  <a:off x="3213" y="505"/>
                  <a:ext cx="22" cy="59"/>
                </a:xfrm>
                <a:prstGeom prst="line">
                  <a:avLst/>
                </a:pr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7" name="Freeform 402"/>
                <p:cNvSpPr/>
                <p:nvPr/>
              </p:nvSpPr>
              <p:spPr bwMode="auto">
                <a:xfrm>
                  <a:off x="3103" y="593"/>
                  <a:ext cx="66" cy="28"/>
                </a:xfrm>
                <a:custGeom>
                  <a:avLst/>
                  <a:gdLst>
                    <a:gd name="T0" fmla="*/ 66 w 66"/>
                    <a:gd name="T1" fmla="*/ 0 h 28"/>
                    <a:gd name="T2" fmla="*/ 62 w 66"/>
                    <a:gd name="T3" fmla="*/ 2 h 28"/>
                    <a:gd name="T4" fmla="*/ 57 w 66"/>
                    <a:gd name="T5" fmla="*/ 4 h 28"/>
                    <a:gd name="T6" fmla="*/ 53 w 66"/>
                    <a:gd name="T7" fmla="*/ 5 h 28"/>
                    <a:gd name="T8" fmla="*/ 49 w 66"/>
                    <a:gd name="T9" fmla="*/ 7 h 28"/>
                    <a:gd name="T10" fmla="*/ 46 w 66"/>
                    <a:gd name="T11" fmla="*/ 8 h 28"/>
                    <a:gd name="T12" fmla="*/ 42 w 66"/>
                    <a:gd name="T13" fmla="*/ 11 h 28"/>
                    <a:gd name="T14" fmla="*/ 37 w 66"/>
                    <a:gd name="T15" fmla="*/ 13 h 28"/>
                    <a:gd name="T16" fmla="*/ 33 w 66"/>
                    <a:gd name="T17" fmla="*/ 14 h 28"/>
                    <a:gd name="T18" fmla="*/ 29 w 66"/>
                    <a:gd name="T19" fmla="*/ 15 h 28"/>
                    <a:gd name="T20" fmla="*/ 24 w 66"/>
                    <a:gd name="T21" fmla="*/ 18 h 28"/>
                    <a:gd name="T22" fmla="*/ 22 w 66"/>
                    <a:gd name="T23" fmla="*/ 20 h 28"/>
                    <a:gd name="T24" fmla="*/ 17 w 66"/>
                    <a:gd name="T25" fmla="*/ 21 h 28"/>
                    <a:gd name="T26" fmla="*/ 13 w 66"/>
                    <a:gd name="T27" fmla="*/ 23 h 28"/>
                    <a:gd name="T28" fmla="*/ 9 w 66"/>
                    <a:gd name="T29" fmla="*/ 25 h 28"/>
                    <a:gd name="T30" fmla="*/ 4 w 66"/>
                    <a:gd name="T31" fmla="*/ 27 h 28"/>
                    <a:gd name="T32" fmla="*/ 0 w 66"/>
                    <a:gd name="T33" fmla="*/ 28 h 2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</a:cxnLst>
                  <a:rect l="0" t="0" r="r" b="b"/>
                  <a:pathLst>
                    <a:path w="66" h="28">
                      <a:moveTo>
                        <a:pt x="66" y="0"/>
                      </a:moveTo>
                      <a:lnTo>
                        <a:pt x="62" y="2"/>
                      </a:lnTo>
                      <a:lnTo>
                        <a:pt x="57" y="4"/>
                      </a:lnTo>
                      <a:lnTo>
                        <a:pt x="53" y="5"/>
                      </a:lnTo>
                      <a:lnTo>
                        <a:pt x="49" y="7"/>
                      </a:lnTo>
                      <a:lnTo>
                        <a:pt x="46" y="8"/>
                      </a:lnTo>
                      <a:lnTo>
                        <a:pt x="42" y="11"/>
                      </a:lnTo>
                      <a:lnTo>
                        <a:pt x="37" y="13"/>
                      </a:lnTo>
                      <a:lnTo>
                        <a:pt x="33" y="14"/>
                      </a:lnTo>
                      <a:lnTo>
                        <a:pt x="29" y="15"/>
                      </a:lnTo>
                      <a:lnTo>
                        <a:pt x="24" y="18"/>
                      </a:lnTo>
                      <a:lnTo>
                        <a:pt x="22" y="20"/>
                      </a:lnTo>
                      <a:lnTo>
                        <a:pt x="17" y="21"/>
                      </a:lnTo>
                      <a:lnTo>
                        <a:pt x="13" y="23"/>
                      </a:lnTo>
                      <a:lnTo>
                        <a:pt x="9" y="25"/>
                      </a:lnTo>
                      <a:lnTo>
                        <a:pt x="4" y="27"/>
                      </a:lnTo>
                      <a:lnTo>
                        <a:pt x="0" y="28"/>
                      </a:lnTo>
                    </a:path>
                  </a:pathLst>
                </a:cu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8" name="Freeform 403"/>
                <p:cNvSpPr/>
                <p:nvPr/>
              </p:nvSpPr>
              <p:spPr bwMode="auto">
                <a:xfrm>
                  <a:off x="3169" y="567"/>
                  <a:ext cx="66" cy="26"/>
                </a:xfrm>
                <a:custGeom>
                  <a:avLst/>
                  <a:gdLst>
                    <a:gd name="T0" fmla="*/ 0 w 66"/>
                    <a:gd name="T1" fmla="*/ 26 h 26"/>
                    <a:gd name="T2" fmla="*/ 4 w 66"/>
                    <a:gd name="T3" fmla="*/ 24 h 26"/>
                    <a:gd name="T4" fmla="*/ 9 w 66"/>
                    <a:gd name="T5" fmla="*/ 23 h 26"/>
                    <a:gd name="T6" fmla="*/ 13 w 66"/>
                    <a:gd name="T7" fmla="*/ 21 h 26"/>
                    <a:gd name="T8" fmla="*/ 17 w 66"/>
                    <a:gd name="T9" fmla="*/ 18 h 26"/>
                    <a:gd name="T10" fmla="*/ 21 w 66"/>
                    <a:gd name="T11" fmla="*/ 17 h 26"/>
                    <a:gd name="T12" fmla="*/ 26 w 66"/>
                    <a:gd name="T13" fmla="*/ 16 h 26"/>
                    <a:gd name="T14" fmla="*/ 30 w 66"/>
                    <a:gd name="T15" fmla="*/ 14 h 26"/>
                    <a:gd name="T16" fmla="*/ 34 w 66"/>
                    <a:gd name="T17" fmla="*/ 13 h 26"/>
                    <a:gd name="T18" fmla="*/ 39 w 66"/>
                    <a:gd name="T19" fmla="*/ 10 h 26"/>
                    <a:gd name="T20" fmla="*/ 44 w 66"/>
                    <a:gd name="T21" fmla="*/ 8 h 26"/>
                    <a:gd name="T22" fmla="*/ 49 w 66"/>
                    <a:gd name="T23" fmla="*/ 7 h 26"/>
                    <a:gd name="T24" fmla="*/ 53 w 66"/>
                    <a:gd name="T25" fmla="*/ 6 h 26"/>
                    <a:gd name="T26" fmla="*/ 57 w 66"/>
                    <a:gd name="T27" fmla="*/ 4 h 26"/>
                    <a:gd name="T28" fmla="*/ 62 w 66"/>
                    <a:gd name="T29" fmla="*/ 3 h 26"/>
                    <a:gd name="T30" fmla="*/ 66 w 66"/>
                    <a:gd name="T31" fmla="*/ 0 h 2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</a:cxnLst>
                  <a:rect l="0" t="0" r="r" b="b"/>
                  <a:pathLst>
                    <a:path w="66" h="26">
                      <a:moveTo>
                        <a:pt x="0" y="26"/>
                      </a:moveTo>
                      <a:lnTo>
                        <a:pt x="4" y="24"/>
                      </a:lnTo>
                      <a:lnTo>
                        <a:pt x="9" y="23"/>
                      </a:lnTo>
                      <a:lnTo>
                        <a:pt x="13" y="21"/>
                      </a:lnTo>
                      <a:lnTo>
                        <a:pt x="17" y="18"/>
                      </a:lnTo>
                      <a:lnTo>
                        <a:pt x="21" y="17"/>
                      </a:lnTo>
                      <a:lnTo>
                        <a:pt x="26" y="16"/>
                      </a:lnTo>
                      <a:lnTo>
                        <a:pt x="30" y="14"/>
                      </a:lnTo>
                      <a:lnTo>
                        <a:pt x="34" y="13"/>
                      </a:lnTo>
                      <a:lnTo>
                        <a:pt x="39" y="10"/>
                      </a:lnTo>
                      <a:lnTo>
                        <a:pt x="44" y="8"/>
                      </a:lnTo>
                      <a:lnTo>
                        <a:pt x="49" y="7"/>
                      </a:lnTo>
                      <a:lnTo>
                        <a:pt x="53" y="6"/>
                      </a:lnTo>
                      <a:lnTo>
                        <a:pt x="57" y="4"/>
                      </a:lnTo>
                      <a:lnTo>
                        <a:pt x="62" y="3"/>
                      </a:lnTo>
                      <a:lnTo>
                        <a:pt x="66" y="0"/>
                      </a:lnTo>
                    </a:path>
                  </a:pathLst>
                </a:cu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9" name="Rectangle 404"/>
                <p:cNvSpPr>
                  <a:spLocks noChangeArrowheads="1"/>
                </p:cNvSpPr>
                <p:nvPr/>
              </p:nvSpPr>
              <p:spPr bwMode="auto">
                <a:xfrm rot="4020000">
                  <a:off x="3186" y="628"/>
                  <a:ext cx="108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sz="9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</a:p>
              </p:txBody>
            </p:sp>
            <p:sp>
              <p:nvSpPr>
                <p:cNvPr id="220" name="Line 405"/>
                <p:cNvSpPr>
                  <a:spLocks noChangeShapeType="1"/>
                </p:cNvSpPr>
                <p:nvPr/>
              </p:nvSpPr>
              <p:spPr bwMode="auto">
                <a:xfrm flipH="1" flipV="1">
                  <a:off x="3170" y="595"/>
                  <a:ext cx="25" cy="59"/>
                </a:xfrm>
                <a:prstGeom prst="line">
                  <a:avLst/>
                </a:prstGeom>
                <a:noFill/>
                <a:ln w="9525" cap="sq">
                  <a:solidFill>
                    <a:srgbClr val="0070C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12" name="Freeform 407"/>
              <p:cNvSpPr/>
              <p:nvPr/>
            </p:nvSpPr>
            <p:spPr bwMode="auto">
              <a:xfrm>
                <a:off x="3011" y="699"/>
                <a:ext cx="91" cy="49"/>
              </a:xfrm>
              <a:custGeom>
                <a:avLst/>
                <a:gdLst>
                  <a:gd name="T0" fmla="*/ 91 w 91"/>
                  <a:gd name="T1" fmla="*/ 0 h 49"/>
                  <a:gd name="T2" fmla="*/ 88 w 91"/>
                  <a:gd name="T3" fmla="*/ 1 h 49"/>
                  <a:gd name="T4" fmla="*/ 85 w 91"/>
                  <a:gd name="T5" fmla="*/ 3 h 49"/>
                  <a:gd name="T6" fmla="*/ 81 w 91"/>
                  <a:gd name="T7" fmla="*/ 6 h 49"/>
                  <a:gd name="T8" fmla="*/ 78 w 91"/>
                  <a:gd name="T9" fmla="*/ 7 h 49"/>
                  <a:gd name="T10" fmla="*/ 73 w 91"/>
                  <a:gd name="T11" fmla="*/ 8 h 49"/>
                  <a:gd name="T12" fmla="*/ 70 w 91"/>
                  <a:gd name="T13" fmla="*/ 10 h 49"/>
                  <a:gd name="T14" fmla="*/ 68 w 91"/>
                  <a:gd name="T15" fmla="*/ 11 h 49"/>
                  <a:gd name="T16" fmla="*/ 63 w 91"/>
                  <a:gd name="T17" fmla="*/ 14 h 49"/>
                  <a:gd name="T18" fmla="*/ 60 w 91"/>
                  <a:gd name="T19" fmla="*/ 16 h 49"/>
                  <a:gd name="T20" fmla="*/ 58 w 91"/>
                  <a:gd name="T21" fmla="*/ 17 h 49"/>
                  <a:gd name="T22" fmla="*/ 53 w 91"/>
                  <a:gd name="T23" fmla="*/ 18 h 49"/>
                  <a:gd name="T24" fmla="*/ 50 w 91"/>
                  <a:gd name="T25" fmla="*/ 20 h 49"/>
                  <a:gd name="T26" fmla="*/ 48 w 91"/>
                  <a:gd name="T27" fmla="*/ 23 h 49"/>
                  <a:gd name="T28" fmla="*/ 43 w 91"/>
                  <a:gd name="T29" fmla="*/ 24 h 49"/>
                  <a:gd name="T30" fmla="*/ 40 w 91"/>
                  <a:gd name="T31" fmla="*/ 26 h 49"/>
                  <a:gd name="T32" fmla="*/ 38 w 91"/>
                  <a:gd name="T33" fmla="*/ 27 h 49"/>
                  <a:gd name="T34" fmla="*/ 33 w 91"/>
                  <a:gd name="T35" fmla="*/ 30 h 49"/>
                  <a:gd name="T36" fmla="*/ 30 w 91"/>
                  <a:gd name="T37" fmla="*/ 31 h 49"/>
                  <a:gd name="T38" fmla="*/ 27 w 91"/>
                  <a:gd name="T39" fmla="*/ 33 h 49"/>
                  <a:gd name="T40" fmla="*/ 25 w 91"/>
                  <a:gd name="T41" fmla="*/ 34 h 49"/>
                  <a:gd name="T42" fmla="*/ 20 w 91"/>
                  <a:gd name="T43" fmla="*/ 37 h 49"/>
                  <a:gd name="T44" fmla="*/ 17 w 91"/>
                  <a:gd name="T45" fmla="*/ 39 h 49"/>
                  <a:gd name="T46" fmla="*/ 15 w 91"/>
                  <a:gd name="T47" fmla="*/ 40 h 49"/>
                  <a:gd name="T48" fmla="*/ 10 w 91"/>
                  <a:gd name="T49" fmla="*/ 43 h 49"/>
                  <a:gd name="T50" fmla="*/ 7 w 91"/>
                  <a:gd name="T51" fmla="*/ 44 h 49"/>
                  <a:gd name="T52" fmla="*/ 5 w 91"/>
                  <a:gd name="T53" fmla="*/ 46 h 49"/>
                  <a:gd name="T54" fmla="*/ 0 w 91"/>
                  <a:gd name="T55" fmla="*/ 49 h 4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</a:cxnLst>
                <a:rect l="0" t="0" r="r" b="b"/>
                <a:pathLst>
                  <a:path w="91" h="49">
                    <a:moveTo>
                      <a:pt x="91" y="0"/>
                    </a:moveTo>
                    <a:lnTo>
                      <a:pt x="88" y="1"/>
                    </a:lnTo>
                    <a:lnTo>
                      <a:pt x="85" y="3"/>
                    </a:lnTo>
                    <a:lnTo>
                      <a:pt x="81" y="6"/>
                    </a:lnTo>
                    <a:lnTo>
                      <a:pt x="78" y="7"/>
                    </a:lnTo>
                    <a:lnTo>
                      <a:pt x="73" y="8"/>
                    </a:lnTo>
                    <a:lnTo>
                      <a:pt x="70" y="10"/>
                    </a:lnTo>
                    <a:lnTo>
                      <a:pt x="68" y="11"/>
                    </a:lnTo>
                    <a:lnTo>
                      <a:pt x="63" y="14"/>
                    </a:lnTo>
                    <a:lnTo>
                      <a:pt x="60" y="16"/>
                    </a:lnTo>
                    <a:lnTo>
                      <a:pt x="58" y="17"/>
                    </a:lnTo>
                    <a:lnTo>
                      <a:pt x="53" y="18"/>
                    </a:lnTo>
                    <a:lnTo>
                      <a:pt x="50" y="20"/>
                    </a:lnTo>
                    <a:lnTo>
                      <a:pt x="48" y="23"/>
                    </a:lnTo>
                    <a:lnTo>
                      <a:pt x="43" y="24"/>
                    </a:lnTo>
                    <a:lnTo>
                      <a:pt x="40" y="26"/>
                    </a:lnTo>
                    <a:lnTo>
                      <a:pt x="38" y="27"/>
                    </a:lnTo>
                    <a:lnTo>
                      <a:pt x="33" y="30"/>
                    </a:lnTo>
                    <a:lnTo>
                      <a:pt x="30" y="31"/>
                    </a:lnTo>
                    <a:lnTo>
                      <a:pt x="27" y="33"/>
                    </a:lnTo>
                    <a:lnTo>
                      <a:pt x="25" y="34"/>
                    </a:lnTo>
                    <a:lnTo>
                      <a:pt x="20" y="37"/>
                    </a:lnTo>
                    <a:lnTo>
                      <a:pt x="17" y="39"/>
                    </a:lnTo>
                    <a:lnTo>
                      <a:pt x="15" y="40"/>
                    </a:lnTo>
                    <a:lnTo>
                      <a:pt x="10" y="43"/>
                    </a:lnTo>
                    <a:lnTo>
                      <a:pt x="7" y="44"/>
                    </a:lnTo>
                    <a:lnTo>
                      <a:pt x="5" y="46"/>
                    </a:lnTo>
                    <a:lnTo>
                      <a:pt x="0" y="49"/>
                    </a:lnTo>
                  </a:path>
                </a:pathLst>
              </a:custGeom>
              <a:noFill/>
              <a:ln w="9525" cap="sq">
                <a:solidFill>
                  <a:srgbClr val="0070C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Freeform 408"/>
              <p:cNvSpPr/>
              <p:nvPr/>
            </p:nvSpPr>
            <p:spPr bwMode="auto">
              <a:xfrm>
                <a:off x="3102" y="657"/>
                <a:ext cx="93" cy="42"/>
              </a:xfrm>
              <a:custGeom>
                <a:avLst/>
                <a:gdLst>
                  <a:gd name="T0" fmla="*/ 0 w 93"/>
                  <a:gd name="T1" fmla="*/ 42 h 42"/>
                  <a:gd name="T2" fmla="*/ 5 w 93"/>
                  <a:gd name="T3" fmla="*/ 39 h 42"/>
                  <a:gd name="T4" fmla="*/ 10 w 93"/>
                  <a:gd name="T5" fmla="*/ 38 h 42"/>
                  <a:gd name="T6" fmla="*/ 15 w 93"/>
                  <a:gd name="T7" fmla="*/ 35 h 42"/>
                  <a:gd name="T8" fmla="*/ 21 w 93"/>
                  <a:gd name="T9" fmla="*/ 32 h 42"/>
                  <a:gd name="T10" fmla="*/ 25 w 93"/>
                  <a:gd name="T11" fmla="*/ 30 h 42"/>
                  <a:gd name="T12" fmla="*/ 31 w 93"/>
                  <a:gd name="T13" fmla="*/ 27 h 42"/>
                  <a:gd name="T14" fmla="*/ 35 w 93"/>
                  <a:gd name="T15" fmla="*/ 25 h 42"/>
                  <a:gd name="T16" fmla="*/ 41 w 93"/>
                  <a:gd name="T17" fmla="*/ 23 h 42"/>
                  <a:gd name="T18" fmla="*/ 45 w 93"/>
                  <a:gd name="T19" fmla="*/ 20 h 42"/>
                  <a:gd name="T20" fmla="*/ 51 w 93"/>
                  <a:gd name="T21" fmla="*/ 17 h 42"/>
                  <a:gd name="T22" fmla="*/ 57 w 93"/>
                  <a:gd name="T23" fmla="*/ 16 h 42"/>
                  <a:gd name="T24" fmla="*/ 61 w 93"/>
                  <a:gd name="T25" fmla="*/ 13 h 42"/>
                  <a:gd name="T26" fmla="*/ 67 w 93"/>
                  <a:gd name="T27" fmla="*/ 10 h 42"/>
                  <a:gd name="T28" fmla="*/ 73 w 93"/>
                  <a:gd name="T29" fmla="*/ 9 h 42"/>
                  <a:gd name="T30" fmla="*/ 77 w 93"/>
                  <a:gd name="T31" fmla="*/ 6 h 42"/>
                  <a:gd name="T32" fmla="*/ 83 w 93"/>
                  <a:gd name="T33" fmla="*/ 5 h 42"/>
                  <a:gd name="T34" fmla="*/ 88 w 93"/>
                  <a:gd name="T35" fmla="*/ 2 h 42"/>
                  <a:gd name="T36" fmla="*/ 93 w 93"/>
                  <a:gd name="T37" fmla="*/ 0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</a:cxnLst>
                <a:rect l="0" t="0" r="r" b="b"/>
                <a:pathLst>
                  <a:path w="93" h="42">
                    <a:moveTo>
                      <a:pt x="0" y="42"/>
                    </a:moveTo>
                    <a:lnTo>
                      <a:pt x="5" y="39"/>
                    </a:lnTo>
                    <a:lnTo>
                      <a:pt x="10" y="38"/>
                    </a:lnTo>
                    <a:lnTo>
                      <a:pt x="15" y="35"/>
                    </a:lnTo>
                    <a:lnTo>
                      <a:pt x="21" y="32"/>
                    </a:lnTo>
                    <a:lnTo>
                      <a:pt x="25" y="30"/>
                    </a:lnTo>
                    <a:lnTo>
                      <a:pt x="31" y="27"/>
                    </a:lnTo>
                    <a:lnTo>
                      <a:pt x="35" y="25"/>
                    </a:lnTo>
                    <a:lnTo>
                      <a:pt x="41" y="23"/>
                    </a:lnTo>
                    <a:lnTo>
                      <a:pt x="45" y="20"/>
                    </a:lnTo>
                    <a:lnTo>
                      <a:pt x="51" y="17"/>
                    </a:lnTo>
                    <a:lnTo>
                      <a:pt x="57" y="16"/>
                    </a:lnTo>
                    <a:lnTo>
                      <a:pt x="61" y="13"/>
                    </a:lnTo>
                    <a:lnTo>
                      <a:pt x="67" y="10"/>
                    </a:lnTo>
                    <a:lnTo>
                      <a:pt x="73" y="9"/>
                    </a:lnTo>
                    <a:lnTo>
                      <a:pt x="77" y="6"/>
                    </a:lnTo>
                    <a:lnTo>
                      <a:pt x="83" y="5"/>
                    </a:lnTo>
                    <a:lnTo>
                      <a:pt x="88" y="2"/>
                    </a:lnTo>
                    <a:lnTo>
                      <a:pt x="93" y="0"/>
                    </a:lnTo>
                  </a:path>
                </a:pathLst>
              </a:custGeom>
              <a:noFill/>
              <a:ln w="9525" cap="sq">
                <a:solidFill>
                  <a:srgbClr val="0070C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Rectangle 409"/>
              <p:cNvSpPr>
                <a:spLocks noChangeArrowheads="1"/>
              </p:cNvSpPr>
              <p:nvPr/>
            </p:nvSpPr>
            <p:spPr bwMode="auto">
              <a:xfrm rot="3780000">
                <a:off x="3133" y="716"/>
                <a:ext cx="72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9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3</a:t>
                </a:r>
              </a:p>
            </p:txBody>
          </p:sp>
          <p:sp>
            <p:nvSpPr>
              <p:cNvPr id="15" name="Line 410"/>
              <p:cNvSpPr>
                <a:spLocks noChangeShapeType="1"/>
              </p:cNvSpPr>
              <p:nvPr/>
            </p:nvSpPr>
            <p:spPr bwMode="auto">
              <a:xfrm flipH="1" flipV="1">
                <a:off x="3103" y="702"/>
                <a:ext cx="27" cy="56"/>
              </a:xfrm>
              <a:prstGeom prst="line">
                <a:avLst/>
              </a:prstGeom>
              <a:noFill/>
              <a:ln w="9525" cap="sq">
                <a:solidFill>
                  <a:srgbClr val="0070C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Freeform 411"/>
              <p:cNvSpPr/>
              <p:nvPr/>
            </p:nvSpPr>
            <p:spPr bwMode="auto">
              <a:xfrm>
                <a:off x="2937" y="815"/>
                <a:ext cx="94" cy="62"/>
              </a:xfrm>
              <a:custGeom>
                <a:avLst/>
                <a:gdLst>
                  <a:gd name="T0" fmla="*/ 94 w 94"/>
                  <a:gd name="T1" fmla="*/ 0 h 62"/>
                  <a:gd name="T2" fmla="*/ 93 w 94"/>
                  <a:gd name="T3" fmla="*/ 1 h 62"/>
                  <a:gd name="T4" fmla="*/ 90 w 94"/>
                  <a:gd name="T5" fmla="*/ 3 h 62"/>
                  <a:gd name="T6" fmla="*/ 87 w 94"/>
                  <a:gd name="T7" fmla="*/ 4 h 62"/>
                  <a:gd name="T8" fmla="*/ 84 w 94"/>
                  <a:gd name="T9" fmla="*/ 6 h 62"/>
                  <a:gd name="T10" fmla="*/ 81 w 94"/>
                  <a:gd name="T11" fmla="*/ 7 h 62"/>
                  <a:gd name="T12" fmla="*/ 79 w 94"/>
                  <a:gd name="T13" fmla="*/ 9 h 62"/>
                  <a:gd name="T14" fmla="*/ 77 w 94"/>
                  <a:gd name="T15" fmla="*/ 12 h 62"/>
                  <a:gd name="T16" fmla="*/ 74 w 94"/>
                  <a:gd name="T17" fmla="*/ 13 h 62"/>
                  <a:gd name="T18" fmla="*/ 71 w 94"/>
                  <a:gd name="T19" fmla="*/ 14 h 62"/>
                  <a:gd name="T20" fmla="*/ 68 w 94"/>
                  <a:gd name="T21" fmla="*/ 16 h 62"/>
                  <a:gd name="T22" fmla="*/ 66 w 94"/>
                  <a:gd name="T23" fmla="*/ 17 h 62"/>
                  <a:gd name="T24" fmla="*/ 63 w 94"/>
                  <a:gd name="T25" fmla="*/ 19 h 62"/>
                  <a:gd name="T26" fmla="*/ 61 w 94"/>
                  <a:gd name="T27" fmla="*/ 20 h 62"/>
                  <a:gd name="T28" fmla="*/ 58 w 94"/>
                  <a:gd name="T29" fmla="*/ 22 h 62"/>
                  <a:gd name="T30" fmla="*/ 56 w 94"/>
                  <a:gd name="T31" fmla="*/ 24 h 62"/>
                  <a:gd name="T32" fmla="*/ 53 w 94"/>
                  <a:gd name="T33" fmla="*/ 26 h 62"/>
                  <a:gd name="T34" fmla="*/ 50 w 94"/>
                  <a:gd name="T35" fmla="*/ 27 h 62"/>
                  <a:gd name="T36" fmla="*/ 48 w 94"/>
                  <a:gd name="T37" fmla="*/ 29 h 62"/>
                  <a:gd name="T38" fmla="*/ 46 w 94"/>
                  <a:gd name="T39" fmla="*/ 30 h 62"/>
                  <a:gd name="T40" fmla="*/ 43 w 94"/>
                  <a:gd name="T41" fmla="*/ 32 h 62"/>
                  <a:gd name="T42" fmla="*/ 40 w 94"/>
                  <a:gd name="T43" fmla="*/ 34 h 62"/>
                  <a:gd name="T44" fmla="*/ 37 w 94"/>
                  <a:gd name="T45" fmla="*/ 36 h 62"/>
                  <a:gd name="T46" fmla="*/ 36 w 94"/>
                  <a:gd name="T47" fmla="*/ 37 h 62"/>
                  <a:gd name="T48" fmla="*/ 33 w 94"/>
                  <a:gd name="T49" fmla="*/ 39 h 62"/>
                  <a:gd name="T50" fmla="*/ 30 w 94"/>
                  <a:gd name="T51" fmla="*/ 40 h 62"/>
                  <a:gd name="T52" fmla="*/ 27 w 94"/>
                  <a:gd name="T53" fmla="*/ 42 h 62"/>
                  <a:gd name="T54" fmla="*/ 24 w 94"/>
                  <a:gd name="T55" fmla="*/ 45 h 62"/>
                  <a:gd name="T56" fmla="*/ 23 w 94"/>
                  <a:gd name="T57" fmla="*/ 46 h 62"/>
                  <a:gd name="T58" fmla="*/ 20 w 94"/>
                  <a:gd name="T59" fmla="*/ 47 h 62"/>
                  <a:gd name="T60" fmla="*/ 17 w 94"/>
                  <a:gd name="T61" fmla="*/ 49 h 62"/>
                  <a:gd name="T62" fmla="*/ 14 w 94"/>
                  <a:gd name="T63" fmla="*/ 50 h 62"/>
                  <a:gd name="T64" fmla="*/ 11 w 94"/>
                  <a:gd name="T65" fmla="*/ 53 h 62"/>
                  <a:gd name="T66" fmla="*/ 10 w 94"/>
                  <a:gd name="T67" fmla="*/ 55 h 62"/>
                  <a:gd name="T68" fmla="*/ 7 w 94"/>
                  <a:gd name="T69" fmla="*/ 56 h 62"/>
                  <a:gd name="T70" fmla="*/ 4 w 94"/>
                  <a:gd name="T71" fmla="*/ 57 h 62"/>
                  <a:gd name="T72" fmla="*/ 1 w 94"/>
                  <a:gd name="T73" fmla="*/ 59 h 62"/>
                  <a:gd name="T74" fmla="*/ 0 w 94"/>
                  <a:gd name="T75" fmla="*/ 62 h 6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</a:cxnLst>
                <a:rect l="0" t="0" r="r" b="b"/>
                <a:pathLst>
                  <a:path w="94" h="62">
                    <a:moveTo>
                      <a:pt x="94" y="0"/>
                    </a:moveTo>
                    <a:lnTo>
                      <a:pt x="93" y="1"/>
                    </a:lnTo>
                    <a:lnTo>
                      <a:pt x="90" y="3"/>
                    </a:lnTo>
                    <a:lnTo>
                      <a:pt x="87" y="4"/>
                    </a:lnTo>
                    <a:lnTo>
                      <a:pt x="84" y="6"/>
                    </a:lnTo>
                    <a:lnTo>
                      <a:pt x="81" y="7"/>
                    </a:lnTo>
                    <a:lnTo>
                      <a:pt x="79" y="9"/>
                    </a:lnTo>
                    <a:lnTo>
                      <a:pt x="77" y="12"/>
                    </a:lnTo>
                    <a:lnTo>
                      <a:pt x="74" y="13"/>
                    </a:lnTo>
                    <a:lnTo>
                      <a:pt x="71" y="14"/>
                    </a:lnTo>
                    <a:lnTo>
                      <a:pt x="68" y="16"/>
                    </a:lnTo>
                    <a:lnTo>
                      <a:pt x="66" y="17"/>
                    </a:lnTo>
                    <a:lnTo>
                      <a:pt x="63" y="19"/>
                    </a:lnTo>
                    <a:lnTo>
                      <a:pt x="61" y="20"/>
                    </a:lnTo>
                    <a:lnTo>
                      <a:pt x="58" y="22"/>
                    </a:lnTo>
                    <a:lnTo>
                      <a:pt x="56" y="24"/>
                    </a:lnTo>
                    <a:lnTo>
                      <a:pt x="53" y="26"/>
                    </a:lnTo>
                    <a:lnTo>
                      <a:pt x="50" y="27"/>
                    </a:lnTo>
                    <a:lnTo>
                      <a:pt x="48" y="29"/>
                    </a:lnTo>
                    <a:lnTo>
                      <a:pt x="46" y="30"/>
                    </a:lnTo>
                    <a:lnTo>
                      <a:pt x="43" y="32"/>
                    </a:lnTo>
                    <a:lnTo>
                      <a:pt x="40" y="34"/>
                    </a:lnTo>
                    <a:lnTo>
                      <a:pt x="37" y="36"/>
                    </a:lnTo>
                    <a:lnTo>
                      <a:pt x="36" y="37"/>
                    </a:lnTo>
                    <a:lnTo>
                      <a:pt x="33" y="39"/>
                    </a:lnTo>
                    <a:lnTo>
                      <a:pt x="30" y="40"/>
                    </a:lnTo>
                    <a:lnTo>
                      <a:pt x="27" y="42"/>
                    </a:lnTo>
                    <a:lnTo>
                      <a:pt x="24" y="45"/>
                    </a:lnTo>
                    <a:lnTo>
                      <a:pt x="23" y="46"/>
                    </a:lnTo>
                    <a:lnTo>
                      <a:pt x="20" y="47"/>
                    </a:lnTo>
                    <a:lnTo>
                      <a:pt x="17" y="49"/>
                    </a:lnTo>
                    <a:lnTo>
                      <a:pt x="14" y="50"/>
                    </a:lnTo>
                    <a:lnTo>
                      <a:pt x="11" y="53"/>
                    </a:lnTo>
                    <a:lnTo>
                      <a:pt x="10" y="55"/>
                    </a:lnTo>
                    <a:lnTo>
                      <a:pt x="7" y="56"/>
                    </a:lnTo>
                    <a:lnTo>
                      <a:pt x="4" y="57"/>
                    </a:lnTo>
                    <a:lnTo>
                      <a:pt x="1" y="59"/>
                    </a:lnTo>
                    <a:lnTo>
                      <a:pt x="0" y="62"/>
                    </a:lnTo>
                  </a:path>
                </a:pathLst>
              </a:custGeom>
              <a:noFill/>
              <a:ln w="9525" cap="sq">
                <a:solidFill>
                  <a:srgbClr val="0070C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Freeform 412"/>
              <p:cNvSpPr/>
              <p:nvPr/>
            </p:nvSpPr>
            <p:spPr bwMode="auto">
              <a:xfrm>
                <a:off x="3031" y="761"/>
                <a:ext cx="101" cy="54"/>
              </a:xfrm>
              <a:custGeom>
                <a:avLst/>
                <a:gdLst>
                  <a:gd name="T0" fmla="*/ 0 w 101"/>
                  <a:gd name="T1" fmla="*/ 54 h 54"/>
                  <a:gd name="T2" fmla="*/ 6 w 101"/>
                  <a:gd name="T3" fmla="*/ 51 h 54"/>
                  <a:gd name="T4" fmla="*/ 10 w 101"/>
                  <a:gd name="T5" fmla="*/ 48 h 54"/>
                  <a:gd name="T6" fmla="*/ 16 w 101"/>
                  <a:gd name="T7" fmla="*/ 45 h 54"/>
                  <a:gd name="T8" fmla="*/ 20 w 101"/>
                  <a:gd name="T9" fmla="*/ 43 h 54"/>
                  <a:gd name="T10" fmla="*/ 26 w 101"/>
                  <a:gd name="T11" fmla="*/ 40 h 54"/>
                  <a:gd name="T12" fmla="*/ 30 w 101"/>
                  <a:gd name="T13" fmla="*/ 37 h 54"/>
                  <a:gd name="T14" fmla="*/ 36 w 101"/>
                  <a:gd name="T15" fmla="*/ 34 h 54"/>
                  <a:gd name="T16" fmla="*/ 40 w 101"/>
                  <a:gd name="T17" fmla="*/ 31 h 54"/>
                  <a:gd name="T18" fmla="*/ 46 w 101"/>
                  <a:gd name="T19" fmla="*/ 28 h 54"/>
                  <a:gd name="T20" fmla="*/ 50 w 101"/>
                  <a:gd name="T21" fmla="*/ 25 h 54"/>
                  <a:gd name="T22" fmla="*/ 56 w 101"/>
                  <a:gd name="T23" fmla="*/ 22 h 54"/>
                  <a:gd name="T24" fmla="*/ 61 w 101"/>
                  <a:gd name="T25" fmla="*/ 21 h 54"/>
                  <a:gd name="T26" fmla="*/ 66 w 101"/>
                  <a:gd name="T27" fmla="*/ 18 h 54"/>
                  <a:gd name="T28" fmla="*/ 71 w 101"/>
                  <a:gd name="T29" fmla="*/ 15 h 54"/>
                  <a:gd name="T30" fmla="*/ 76 w 101"/>
                  <a:gd name="T31" fmla="*/ 12 h 54"/>
                  <a:gd name="T32" fmla="*/ 81 w 101"/>
                  <a:gd name="T33" fmla="*/ 10 h 54"/>
                  <a:gd name="T34" fmla="*/ 86 w 101"/>
                  <a:gd name="T35" fmla="*/ 7 h 54"/>
                  <a:gd name="T36" fmla="*/ 91 w 101"/>
                  <a:gd name="T37" fmla="*/ 5 h 54"/>
                  <a:gd name="T38" fmla="*/ 96 w 101"/>
                  <a:gd name="T39" fmla="*/ 2 h 54"/>
                  <a:gd name="T40" fmla="*/ 101 w 101"/>
                  <a:gd name="T41" fmla="*/ 0 h 5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</a:cxnLst>
                <a:rect l="0" t="0" r="r" b="b"/>
                <a:pathLst>
                  <a:path w="101" h="54">
                    <a:moveTo>
                      <a:pt x="0" y="54"/>
                    </a:moveTo>
                    <a:lnTo>
                      <a:pt x="6" y="51"/>
                    </a:lnTo>
                    <a:lnTo>
                      <a:pt x="10" y="48"/>
                    </a:lnTo>
                    <a:lnTo>
                      <a:pt x="16" y="45"/>
                    </a:lnTo>
                    <a:lnTo>
                      <a:pt x="20" y="43"/>
                    </a:lnTo>
                    <a:lnTo>
                      <a:pt x="26" y="40"/>
                    </a:lnTo>
                    <a:lnTo>
                      <a:pt x="30" y="37"/>
                    </a:lnTo>
                    <a:lnTo>
                      <a:pt x="36" y="34"/>
                    </a:lnTo>
                    <a:lnTo>
                      <a:pt x="40" y="31"/>
                    </a:lnTo>
                    <a:lnTo>
                      <a:pt x="46" y="28"/>
                    </a:lnTo>
                    <a:lnTo>
                      <a:pt x="50" y="25"/>
                    </a:lnTo>
                    <a:lnTo>
                      <a:pt x="56" y="22"/>
                    </a:lnTo>
                    <a:lnTo>
                      <a:pt x="61" y="21"/>
                    </a:lnTo>
                    <a:lnTo>
                      <a:pt x="66" y="18"/>
                    </a:lnTo>
                    <a:lnTo>
                      <a:pt x="71" y="15"/>
                    </a:lnTo>
                    <a:lnTo>
                      <a:pt x="76" y="12"/>
                    </a:lnTo>
                    <a:lnTo>
                      <a:pt x="81" y="10"/>
                    </a:lnTo>
                    <a:lnTo>
                      <a:pt x="86" y="7"/>
                    </a:lnTo>
                    <a:lnTo>
                      <a:pt x="91" y="5"/>
                    </a:lnTo>
                    <a:lnTo>
                      <a:pt x="96" y="2"/>
                    </a:lnTo>
                    <a:lnTo>
                      <a:pt x="101" y="0"/>
                    </a:lnTo>
                  </a:path>
                </a:pathLst>
              </a:custGeom>
              <a:noFill/>
              <a:ln w="9525" cap="sq">
                <a:solidFill>
                  <a:srgbClr val="0070C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" name="Line 413"/>
              <p:cNvSpPr>
                <a:spLocks noChangeShapeType="1"/>
              </p:cNvSpPr>
              <p:nvPr/>
            </p:nvSpPr>
            <p:spPr bwMode="auto">
              <a:xfrm flipH="1" flipV="1">
                <a:off x="3033" y="818"/>
                <a:ext cx="591" cy="1004"/>
              </a:xfrm>
              <a:prstGeom prst="line">
                <a:avLst/>
              </a:prstGeom>
              <a:noFill/>
              <a:ln w="9525" cap="sq">
                <a:solidFill>
                  <a:srgbClr val="0070C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" name="Freeform 414"/>
              <p:cNvSpPr/>
              <p:nvPr/>
            </p:nvSpPr>
            <p:spPr bwMode="auto">
              <a:xfrm>
                <a:off x="3459" y="2165"/>
                <a:ext cx="122" cy="221"/>
              </a:xfrm>
              <a:custGeom>
                <a:avLst/>
                <a:gdLst>
                  <a:gd name="T0" fmla="*/ 1 w 125"/>
                  <a:gd name="T1" fmla="*/ 0 h 293"/>
                  <a:gd name="T2" fmla="*/ 0 w 125"/>
                  <a:gd name="T3" fmla="*/ 6 h 293"/>
                  <a:gd name="T4" fmla="*/ 0 w 125"/>
                  <a:gd name="T5" fmla="*/ 12 h 293"/>
                  <a:gd name="T6" fmla="*/ 0 w 125"/>
                  <a:gd name="T7" fmla="*/ 18 h 293"/>
                  <a:gd name="T8" fmla="*/ 0 w 125"/>
                  <a:gd name="T9" fmla="*/ 22 h 293"/>
                  <a:gd name="T10" fmla="*/ 0 w 125"/>
                  <a:gd name="T11" fmla="*/ 28 h 293"/>
                  <a:gd name="T12" fmla="*/ 0 w 125"/>
                  <a:gd name="T13" fmla="*/ 33 h 293"/>
                  <a:gd name="T14" fmla="*/ 0 w 125"/>
                  <a:gd name="T15" fmla="*/ 39 h 293"/>
                  <a:gd name="T16" fmla="*/ 0 w 125"/>
                  <a:gd name="T17" fmla="*/ 45 h 293"/>
                  <a:gd name="T18" fmla="*/ 1 w 125"/>
                  <a:gd name="T19" fmla="*/ 51 h 293"/>
                  <a:gd name="T20" fmla="*/ 1 w 125"/>
                  <a:gd name="T21" fmla="*/ 55 h 293"/>
                  <a:gd name="T22" fmla="*/ 1 w 125"/>
                  <a:gd name="T23" fmla="*/ 61 h 293"/>
                  <a:gd name="T24" fmla="*/ 3 w 125"/>
                  <a:gd name="T25" fmla="*/ 66 h 293"/>
                  <a:gd name="T26" fmla="*/ 3 w 125"/>
                  <a:gd name="T27" fmla="*/ 72 h 293"/>
                  <a:gd name="T28" fmla="*/ 4 w 125"/>
                  <a:gd name="T29" fmla="*/ 78 h 293"/>
                  <a:gd name="T30" fmla="*/ 4 w 125"/>
                  <a:gd name="T31" fmla="*/ 82 h 293"/>
                  <a:gd name="T32" fmla="*/ 5 w 125"/>
                  <a:gd name="T33" fmla="*/ 88 h 293"/>
                  <a:gd name="T34" fmla="*/ 5 w 125"/>
                  <a:gd name="T35" fmla="*/ 94 h 293"/>
                  <a:gd name="T36" fmla="*/ 7 w 125"/>
                  <a:gd name="T37" fmla="*/ 99 h 293"/>
                  <a:gd name="T38" fmla="*/ 8 w 125"/>
                  <a:gd name="T39" fmla="*/ 104 h 293"/>
                  <a:gd name="T40" fmla="*/ 10 w 125"/>
                  <a:gd name="T41" fmla="*/ 110 h 293"/>
                  <a:gd name="T42" fmla="*/ 11 w 125"/>
                  <a:gd name="T43" fmla="*/ 115 h 293"/>
                  <a:gd name="T44" fmla="*/ 13 w 125"/>
                  <a:gd name="T45" fmla="*/ 121 h 293"/>
                  <a:gd name="T46" fmla="*/ 14 w 125"/>
                  <a:gd name="T47" fmla="*/ 125 h 293"/>
                  <a:gd name="T48" fmla="*/ 16 w 125"/>
                  <a:gd name="T49" fmla="*/ 131 h 293"/>
                  <a:gd name="T50" fmla="*/ 17 w 125"/>
                  <a:gd name="T51" fmla="*/ 137 h 293"/>
                  <a:gd name="T52" fmla="*/ 18 w 125"/>
                  <a:gd name="T53" fmla="*/ 141 h 293"/>
                  <a:gd name="T54" fmla="*/ 21 w 125"/>
                  <a:gd name="T55" fmla="*/ 147 h 293"/>
                  <a:gd name="T56" fmla="*/ 23 w 125"/>
                  <a:gd name="T57" fmla="*/ 153 h 293"/>
                  <a:gd name="T58" fmla="*/ 26 w 125"/>
                  <a:gd name="T59" fmla="*/ 157 h 293"/>
                  <a:gd name="T60" fmla="*/ 27 w 125"/>
                  <a:gd name="T61" fmla="*/ 163 h 293"/>
                  <a:gd name="T62" fmla="*/ 30 w 125"/>
                  <a:gd name="T63" fmla="*/ 167 h 293"/>
                  <a:gd name="T64" fmla="*/ 31 w 125"/>
                  <a:gd name="T65" fmla="*/ 173 h 293"/>
                  <a:gd name="T66" fmla="*/ 34 w 125"/>
                  <a:gd name="T67" fmla="*/ 177 h 293"/>
                  <a:gd name="T68" fmla="*/ 36 w 125"/>
                  <a:gd name="T69" fmla="*/ 183 h 293"/>
                  <a:gd name="T70" fmla="*/ 38 w 125"/>
                  <a:gd name="T71" fmla="*/ 187 h 293"/>
                  <a:gd name="T72" fmla="*/ 41 w 125"/>
                  <a:gd name="T73" fmla="*/ 191 h 293"/>
                  <a:gd name="T74" fmla="*/ 44 w 125"/>
                  <a:gd name="T75" fmla="*/ 197 h 293"/>
                  <a:gd name="T76" fmla="*/ 47 w 125"/>
                  <a:gd name="T77" fmla="*/ 201 h 293"/>
                  <a:gd name="T78" fmla="*/ 50 w 125"/>
                  <a:gd name="T79" fmla="*/ 206 h 293"/>
                  <a:gd name="T80" fmla="*/ 53 w 125"/>
                  <a:gd name="T81" fmla="*/ 211 h 293"/>
                  <a:gd name="T82" fmla="*/ 56 w 125"/>
                  <a:gd name="T83" fmla="*/ 216 h 293"/>
                  <a:gd name="T84" fmla="*/ 59 w 125"/>
                  <a:gd name="T85" fmla="*/ 220 h 293"/>
                  <a:gd name="T86" fmla="*/ 61 w 125"/>
                  <a:gd name="T87" fmla="*/ 224 h 293"/>
                  <a:gd name="T88" fmla="*/ 64 w 125"/>
                  <a:gd name="T89" fmla="*/ 229 h 293"/>
                  <a:gd name="T90" fmla="*/ 69 w 125"/>
                  <a:gd name="T91" fmla="*/ 233 h 293"/>
                  <a:gd name="T92" fmla="*/ 71 w 125"/>
                  <a:gd name="T93" fmla="*/ 239 h 293"/>
                  <a:gd name="T94" fmla="*/ 74 w 125"/>
                  <a:gd name="T95" fmla="*/ 243 h 293"/>
                  <a:gd name="T96" fmla="*/ 79 w 125"/>
                  <a:gd name="T97" fmla="*/ 247 h 293"/>
                  <a:gd name="T98" fmla="*/ 82 w 125"/>
                  <a:gd name="T99" fmla="*/ 250 h 293"/>
                  <a:gd name="T100" fmla="*/ 86 w 125"/>
                  <a:gd name="T101" fmla="*/ 254 h 293"/>
                  <a:gd name="T102" fmla="*/ 89 w 125"/>
                  <a:gd name="T103" fmla="*/ 259 h 293"/>
                  <a:gd name="T104" fmla="*/ 93 w 125"/>
                  <a:gd name="T105" fmla="*/ 263 h 293"/>
                  <a:gd name="T106" fmla="*/ 96 w 125"/>
                  <a:gd name="T107" fmla="*/ 267 h 293"/>
                  <a:gd name="T108" fmla="*/ 100 w 125"/>
                  <a:gd name="T109" fmla="*/ 272 h 293"/>
                  <a:gd name="T110" fmla="*/ 104 w 125"/>
                  <a:gd name="T111" fmla="*/ 275 h 293"/>
                  <a:gd name="T112" fmla="*/ 109 w 125"/>
                  <a:gd name="T113" fmla="*/ 279 h 293"/>
                  <a:gd name="T114" fmla="*/ 112 w 125"/>
                  <a:gd name="T115" fmla="*/ 283 h 293"/>
                  <a:gd name="T116" fmla="*/ 116 w 125"/>
                  <a:gd name="T117" fmla="*/ 286 h 293"/>
                  <a:gd name="T118" fmla="*/ 120 w 125"/>
                  <a:gd name="T119" fmla="*/ 290 h 293"/>
                  <a:gd name="T120" fmla="*/ 125 w 125"/>
                  <a:gd name="T121" fmla="*/ 293 h 293"/>
                  <a:gd name="connsiteX0" fmla="*/ 80 w 10000"/>
                  <a:gd name="connsiteY0" fmla="*/ 0 h 10000"/>
                  <a:gd name="connsiteX1" fmla="*/ 0 w 10000"/>
                  <a:gd name="connsiteY1" fmla="*/ 205 h 10000"/>
                  <a:gd name="connsiteX2" fmla="*/ 0 w 10000"/>
                  <a:gd name="connsiteY2" fmla="*/ 410 h 10000"/>
                  <a:gd name="connsiteX3" fmla="*/ 0 w 10000"/>
                  <a:gd name="connsiteY3" fmla="*/ 614 h 10000"/>
                  <a:gd name="connsiteX4" fmla="*/ 0 w 10000"/>
                  <a:gd name="connsiteY4" fmla="*/ 751 h 10000"/>
                  <a:gd name="connsiteX5" fmla="*/ 0 w 10000"/>
                  <a:gd name="connsiteY5" fmla="*/ 1126 h 10000"/>
                  <a:gd name="connsiteX6" fmla="*/ 0 w 10000"/>
                  <a:gd name="connsiteY6" fmla="*/ 1331 h 10000"/>
                  <a:gd name="connsiteX7" fmla="*/ 0 w 10000"/>
                  <a:gd name="connsiteY7" fmla="*/ 1536 h 10000"/>
                  <a:gd name="connsiteX8" fmla="*/ 80 w 10000"/>
                  <a:gd name="connsiteY8" fmla="*/ 1741 h 10000"/>
                  <a:gd name="connsiteX9" fmla="*/ 80 w 10000"/>
                  <a:gd name="connsiteY9" fmla="*/ 1877 h 10000"/>
                  <a:gd name="connsiteX10" fmla="*/ 80 w 10000"/>
                  <a:gd name="connsiteY10" fmla="*/ 2082 h 10000"/>
                  <a:gd name="connsiteX11" fmla="*/ 240 w 10000"/>
                  <a:gd name="connsiteY11" fmla="*/ 2253 h 10000"/>
                  <a:gd name="connsiteX12" fmla="*/ 240 w 10000"/>
                  <a:gd name="connsiteY12" fmla="*/ 2457 h 10000"/>
                  <a:gd name="connsiteX13" fmla="*/ 320 w 10000"/>
                  <a:gd name="connsiteY13" fmla="*/ 2662 h 10000"/>
                  <a:gd name="connsiteX14" fmla="*/ 320 w 10000"/>
                  <a:gd name="connsiteY14" fmla="*/ 2799 h 10000"/>
                  <a:gd name="connsiteX15" fmla="*/ 400 w 10000"/>
                  <a:gd name="connsiteY15" fmla="*/ 3003 h 10000"/>
                  <a:gd name="connsiteX16" fmla="*/ 400 w 10000"/>
                  <a:gd name="connsiteY16" fmla="*/ 3208 h 10000"/>
                  <a:gd name="connsiteX17" fmla="*/ 560 w 10000"/>
                  <a:gd name="connsiteY17" fmla="*/ 3379 h 10000"/>
                  <a:gd name="connsiteX18" fmla="*/ 640 w 10000"/>
                  <a:gd name="connsiteY18" fmla="*/ 3549 h 10000"/>
                  <a:gd name="connsiteX19" fmla="*/ 800 w 10000"/>
                  <a:gd name="connsiteY19" fmla="*/ 3754 h 10000"/>
                  <a:gd name="connsiteX20" fmla="*/ 880 w 10000"/>
                  <a:gd name="connsiteY20" fmla="*/ 3925 h 10000"/>
                  <a:gd name="connsiteX21" fmla="*/ 1040 w 10000"/>
                  <a:gd name="connsiteY21" fmla="*/ 4130 h 10000"/>
                  <a:gd name="connsiteX22" fmla="*/ 1120 w 10000"/>
                  <a:gd name="connsiteY22" fmla="*/ 4266 h 10000"/>
                  <a:gd name="connsiteX23" fmla="*/ 1280 w 10000"/>
                  <a:gd name="connsiteY23" fmla="*/ 4471 h 10000"/>
                  <a:gd name="connsiteX24" fmla="*/ 1360 w 10000"/>
                  <a:gd name="connsiteY24" fmla="*/ 4676 h 10000"/>
                  <a:gd name="connsiteX25" fmla="*/ 1440 w 10000"/>
                  <a:gd name="connsiteY25" fmla="*/ 4812 h 10000"/>
                  <a:gd name="connsiteX26" fmla="*/ 1680 w 10000"/>
                  <a:gd name="connsiteY26" fmla="*/ 5017 h 10000"/>
                  <a:gd name="connsiteX27" fmla="*/ 1840 w 10000"/>
                  <a:gd name="connsiteY27" fmla="*/ 5222 h 10000"/>
                  <a:gd name="connsiteX28" fmla="*/ 2080 w 10000"/>
                  <a:gd name="connsiteY28" fmla="*/ 5358 h 10000"/>
                  <a:gd name="connsiteX29" fmla="*/ 2160 w 10000"/>
                  <a:gd name="connsiteY29" fmla="*/ 5563 h 10000"/>
                  <a:gd name="connsiteX30" fmla="*/ 2400 w 10000"/>
                  <a:gd name="connsiteY30" fmla="*/ 5700 h 10000"/>
                  <a:gd name="connsiteX31" fmla="*/ 2480 w 10000"/>
                  <a:gd name="connsiteY31" fmla="*/ 5904 h 10000"/>
                  <a:gd name="connsiteX32" fmla="*/ 2720 w 10000"/>
                  <a:gd name="connsiteY32" fmla="*/ 6041 h 10000"/>
                  <a:gd name="connsiteX33" fmla="*/ 2880 w 10000"/>
                  <a:gd name="connsiteY33" fmla="*/ 6246 h 10000"/>
                  <a:gd name="connsiteX34" fmla="*/ 3040 w 10000"/>
                  <a:gd name="connsiteY34" fmla="*/ 6382 h 10000"/>
                  <a:gd name="connsiteX35" fmla="*/ 3280 w 10000"/>
                  <a:gd name="connsiteY35" fmla="*/ 6519 h 10000"/>
                  <a:gd name="connsiteX36" fmla="*/ 3520 w 10000"/>
                  <a:gd name="connsiteY36" fmla="*/ 6724 h 10000"/>
                  <a:gd name="connsiteX37" fmla="*/ 3760 w 10000"/>
                  <a:gd name="connsiteY37" fmla="*/ 6860 h 10000"/>
                  <a:gd name="connsiteX38" fmla="*/ 4000 w 10000"/>
                  <a:gd name="connsiteY38" fmla="*/ 7031 h 10000"/>
                  <a:gd name="connsiteX39" fmla="*/ 4240 w 10000"/>
                  <a:gd name="connsiteY39" fmla="*/ 7201 h 10000"/>
                  <a:gd name="connsiteX40" fmla="*/ 4480 w 10000"/>
                  <a:gd name="connsiteY40" fmla="*/ 7372 h 10000"/>
                  <a:gd name="connsiteX41" fmla="*/ 4720 w 10000"/>
                  <a:gd name="connsiteY41" fmla="*/ 7509 h 10000"/>
                  <a:gd name="connsiteX42" fmla="*/ 4880 w 10000"/>
                  <a:gd name="connsiteY42" fmla="*/ 7645 h 10000"/>
                  <a:gd name="connsiteX43" fmla="*/ 5120 w 10000"/>
                  <a:gd name="connsiteY43" fmla="*/ 7816 h 10000"/>
                  <a:gd name="connsiteX44" fmla="*/ 5520 w 10000"/>
                  <a:gd name="connsiteY44" fmla="*/ 7952 h 10000"/>
                  <a:gd name="connsiteX45" fmla="*/ 5680 w 10000"/>
                  <a:gd name="connsiteY45" fmla="*/ 8157 h 10000"/>
                  <a:gd name="connsiteX46" fmla="*/ 5920 w 10000"/>
                  <a:gd name="connsiteY46" fmla="*/ 8294 h 10000"/>
                  <a:gd name="connsiteX47" fmla="*/ 6320 w 10000"/>
                  <a:gd name="connsiteY47" fmla="*/ 8430 h 10000"/>
                  <a:gd name="connsiteX48" fmla="*/ 6560 w 10000"/>
                  <a:gd name="connsiteY48" fmla="*/ 8532 h 10000"/>
                  <a:gd name="connsiteX49" fmla="*/ 6880 w 10000"/>
                  <a:gd name="connsiteY49" fmla="*/ 8669 h 10000"/>
                  <a:gd name="connsiteX50" fmla="*/ 7120 w 10000"/>
                  <a:gd name="connsiteY50" fmla="*/ 8840 h 10000"/>
                  <a:gd name="connsiteX51" fmla="*/ 7440 w 10000"/>
                  <a:gd name="connsiteY51" fmla="*/ 8976 h 10000"/>
                  <a:gd name="connsiteX52" fmla="*/ 7680 w 10000"/>
                  <a:gd name="connsiteY52" fmla="*/ 9113 h 10000"/>
                  <a:gd name="connsiteX53" fmla="*/ 8000 w 10000"/>
                  <a:gd name="connsiteY53" fmla="*/ 9283 h 10000"/>
                  <a:gd name="connsiteX54" fmla="*/ 8320 w 10000"/>
                  <a:gd name="connsiteY54" fmla="*/ 9386 h 10000"/>
                  <a:gd name="connsiteX55" fmla="*/ 8720 w 10000"/>
                  <a:gd name="connsiteY55" fmla="*/ 9522 h 10000"/>
                  <a:gd name="connsiteX56" fmla="*/ 8960 w 10000"/>
                  <a:gd name="connsiteY56" fmla="*/ 9659 h 10000"/>
                  <a:gd name="connsiteX57" fmla="*/ 9280 w 10000"/>
                  <a:gd name="connsiteY57" fmla="*/ 9761 h 10000"/>
                  <a:gd name="connsiteX58" fmla="*/ 9600 w 10000"/>
                  <a:gd name="connsiteY58" fmla="*/ 9898 h 10000"/>
                  <a:gd name="connsiteX59" fmla="*/ 10000 w 10000"/>
                  <a:gd name="connsiteY59" fmla="*/ 10000 h 10000"/>
                  <a:gd name="connsiteX0-1" fmla="*/ 80 w 10000"/>
                  <a:gd name="connsiteY0-2" fmla="*/ 0 h 10000"/>
                  <a:gd name="connsiteX1-3" fmla="*/ 0 w 10000"/>
                  <a:gd name="connsiteY1-4" fmla="*/ 205 h 10000"/>
                  <a:gd name="connsiteX2-5" fmla="*/ 0 w 10000"/>
                  <a:gd name="connsiteY2-6" fmla="*/ 410 h 10000"/>
                  <a:gd name="connsiteX3-7" fmla="*/ 0 w 10000"/>
                  <a:gd name="connsiteY3-8" fmla="*/ 614 h 10000"/>
                  <a:gd name="connsiteX4-9" fmla="*/ 0 w 10000"/>
                  <a:gd name="connsiteY4-10" fmla="*/ 751 h 10000"/>
                  <a:gd name="connsiteX5-11" fmla="*/ 0 w 10000"/>
                  <a:gd name="connsiteY5-12" fmla="*/ 1331 h 10000"/>
                  <a:gd name="connsiteX6-13" fmla="*/ 0 w 10000"/>
                  <a:gd name="connsiteY6-14" fmla="*/ 1536 h 10000"/>
                  <a:gd name="connsiteX7-15" fmla="*/ 80 w 10000"/>
                  <a:gd name="connsiteY7-16" fmla="*/ 1741 h 10000"/>
                  <a:gd name="connsiteX8-17" fmla="*/ 80 w 10000"/>
                  <a:gd name="connsiteY8-18" fmla="*/ 1877 h 10000"/>
                  <a:gd name="connsiteX9-19" fmla="*/ 80 w 10000"/>
                  <a:gd name="connsiteY9-20" fmla="*/ 2082 h 10000"/>
                  <a:gd name="connsiteX10-21" fmla="*/ 240 w 10000"/>
                  <a:gd name="connsiteY10-22" fmla="*/ 2253 h 10000"/>
                  <a:gd name="connsiteX11-23" fmla="*/ 240 w 10000"/>
                  <a:gd name="connsiteY11-24" fmla="*/ 2457 h 10000"/>
                  <a:gd name="connsiteX12-25" fmla="*/ 320 w 10000"/>
                  <a:gd name="connsiteY12-26" fmla="*/ 2662 h 10000"/>
                  <a:gd name="connsiteX13-27" fmla="*/ 320 w 10000"/>
                  <a:gd name="connsiteY13-28" fmla="*/ 2799 h 10000"/>
                  <a:gd name="connsiteX14-29" fmla="*/ 400 w 10000"/>
                  <a:gd name="connsiteY14-30" fmla="*/ 3003 h 10000"/>
                  <a:gd name="connsiteX15-31" fmla="*/ 400 w 10000"/>
                  <a:gd name="connsiteY15-32" fmla="*/ 3208 h 10000"/>
                  <a:gd name="connsiteX16-33" fmla="*/ 560 w 10000"/>
                  <a:gd name="connsiteY16-34" fmla="*/ 3379 h 10000"/>
                  <a:gd name="connsiteX17-35" fmla="*/ 640 w 10000"/>
                  <a:gd name="connsiteY17-36" fmla="*/ 3549 h 10000"/>
                  <a:gd name="connsiteX18-37" fmla="*/ 800 w 10000"/>
                  <a:gd name="connsiteY18-38" fmla="*/ 3754 h 10000"/>
                  <a:gd name="connsiteX19-39" fmla="*/ 880 w 10000"/>
                  <a:gd name="connsiteY19-40" fmla="*/ 3925 h 10000"/>
                  <a:gd name="connsiteX20-41" fmla="*/ 1040 w 10000"/>
                  <a:gd name="connsiteY20-42" fmla="*/ 4130 h 10000"/>
                  <a:gd name="connsiteX21-43" fmla="*/ 1120 w 10000"/>
                  <a:gd name="connsiteY21-44" fmla="*/ 4266 h 10000"/>
                  <a:gd name="connsiteX22-45" fmla="*/ 1280 w 10000"/>
                  <a:gd name="connsiteY22-46" fmla="*/ 4471 h 10000"/>
                  <a:gd name="connsiteX23-47" fmla="*/ 1360 w 10000"/>
                  <a:gd name="connsiteY23-48" fmla="*/ 4676 h 10000"/>
                  <a:gd name="connsiteX24-49" fmla="*/ 1440 w 10000"/>
                  <a:gd name="connsiteY24-50" fmla="*/ 4812 h 10000"/>
                  <a:gd name="connsiteX25-51" fmla="*/ 1680 w 10000"/>
                  <a:gd name="connsiteY25-52" fmla="*/ 5017 h 10000"/>
                  <a:gd name="connsiteX26-53" fmla="*/ 1840 w 10000"/>
                  <a:gd name="connsiteY26-54" fmla="*/ 5222 h 10000"/>
                  <a:gd name="connsiteX27-55" fmla="*/ 2080 w 10000"/>
                  <a:gd name="connsiteY27-56" fmla="*/ 5358 h 10000"/>
                  <a:gd name="connsiteX28-57" fmla="*/ 2160 w 10000"/>
                  <a:gd name="connsiteY28-58" fmla="*/ 5563 h 10000"/>
                  <a:gd name="connsiteX29-59" fmla="*/ 2400 w 10000"/>
                  <a:gd name="connsiteY29-60" fmla="*/ 5700 h 10000"/>
                  <a:gd name="connsiteX30-61" fmla="*/ 2480 w 10000"/>
                  <a:gd name="connsiteY30-62" fmla="*/ 5904 h 10000"/>
                  <a:gd name="connsiteX31-63" fmla="*/ 2720 w 10000"/>
                  <a:gd name="connsiteY31-64" fmla="*/ 6041 h 10000"/>
                  <a:gd name="connsiteX32-65" fmla="*/ 2880 w 10000"/>
                  <a:gd name="connsiteY32-66" fmla="*/ 6246 h 10000"/>
                  <a:gd name="connsiteX33-67" fmla="*/ 3040 w 10000"/>
                  <a:gd name="connsiteY33-68" fmla="*/ 6382 h 10000"/>
                  <a:gd name="connsiteX34-69" fmla="*/ 3280 w 10000"/>
                  <a:gd name="connsiteY34-70" fmla="*/ 6519 h 10000"/>
                  <a:gd name="connsiteX35-71" fmla="*/ 3520 w 10000"/>
                  <a:gd name="connsiteY35-72" fmla="*/ 6724 h 10000"/>
                  <a:gd name="connsiteX36-73" fmla="*/ 3760 w 10000"/>
                  <a:gd name="connsiteY36-74" fmla="*/ 6860 h 10000"/>
                  <a:gd name="connsiteX37-75" fmla="*/ 4000 w 10000"/>
                  <a:gd name="connsiteY37-76" fmla="*/ 7031 h 10000"/>
                  <a:gd name="connsiteX38-77" fmla="*/ 4240 w 10000"/>
                  <a:gd name="connsiteY38-78" fmla="*/ 7201 h 10000"/>
                  <a:gd name="connsiteX39-79" fmla="*/ 4480 w 10000"/>
                  <a:gd name="connsiteY39-80" fmla="*/ 7372 h 10000"/>
                  <a:gd name="connsiteX40-81" fmla="*/ 4720 w 10000"/>
                  <a:gd name="connsiteY40-82" fmla="*/ 7509 h 10000"/>
                  <a:gd name="connsiteX41-83" fmla="*/ 4880 w 10000"/>
                  <a:gd name="connsiteY41-84" fmla="*/ 7645 h 10000"/>
                  <a:gd name="connsiteX42-85" fmla="*/ 5120 w 10000"/>
                  <a:gd name="connsiteY42-86" fmla="*/ 7816 h 10000"/>
                  <a:gd name="connsiteX43-87" fmla="*/ 5520 w 10000"/>
                  <a:gd name="connsiteY43-88" fmla="*/ 7952 h 10000"/>
                  <a:gd name="connsiteX44-89" fmla="*/ 5680 w 10000"/>
                  <a:gd name="connsiteY44-90" fmla="*/ 8157 h 10000"/>
                  <a:gd name="connsiteX45-91" fmla="*/ 5920 w 10000"/>
                  <a:gd name="connsiteY45-92" fmla="*/ 8294 h 10000"/>
                  <a:gd name="connsiteX46-93" fmla="*/ 6320 w 10000"/>
                  <a:gd name="connsiteY46-94" fmla="*/ 8430 h 10000"/>
                  <a:gd name="connsiteX47-95" fmla="*/ 6560 w 10000"/>
                  <a:gd name="connsiteY47-96" fmla="*/ 8532 h 10000"/>
                  <a:gd name="connsiteX48-97" fmla="*/ 6880 w 10000"/>
                  <a:gd name="connsiteY48-98" fmla="*/ 8669 h 10000"/>
                  <a:gd name="connsiteX49-99" fmla="*/ 7120 w 10000"/>
                  <a:gd name="connsiteY49-100" fmla="*/ 8840 h 10000"/>
                  <a:gd name="connsiteX50-101" fmla="*/ 7440 w 10000"/>
                  <a:gd name="connsiteY50-102" fmla="*/ 8976 h 10000"/>
                  <a:gd name="connsiteX51-103" fmla="*/ 7680 w 10000"/>
                  <a:gd name="connsiteY51-104" fmla="*/ 9113 h 10000"/>
                  <a:gd name="connsiteX52-105" fmla="*/ 8000 w 10000"/>
                  <a:gd name="connsiteY52-106" fmla="*/ 9283 h 10000"/>
                  <a:gd name="connsiteX53-107" fmla="*/ 8320 w 10000"/>
                  <a:gd name="connsiteY53-108" fmla="*/ 9386 h 10000"/>
                  <a:gd name="connsiteX54-109" fmla="*/ 8720 w 10000"/>
                  <a:gd name="connsiteY54-110" fmla="*/ 9522 h 10000"/>
                  <a:gd name="connsiteX55-111" fmla="*/ 8960 w 10000"/>
                  <a:gd name="connsiteY55-112" fmla="*/ 9659 h 10000"/>
                  <a:gd name="connsiteX56-113" fmla="*/ 9280 w 10000"/>
                  <a:gd name="connsiteY56-114" fmla="*/ 9761 h 10000"/>
                  <a:gd name="connsiteX57-115" fmla="*/ 9600 w 10000"/>
                  <a:gd name="connsiteY57-116" fmla="*/ 9898 h 10000"/>
                  <a:gd name="connsiteX58-117" fmla="*/ 10000 w 10000"/>
                  <a:gd name="connsiteY58-118" fmla="*/ 10000 h 10000"/>
                  <a:gd name="connsiteX0-119" fmla="*/ 80 w 10000"/>
                  <a:gd name="connsiteY0-120" fmla="*/ 0 h 10000"/>
                  <a:gd name="connsiteX1-121" fmla="*/ 0 w 10000"/>
                  <a:gd name="connsiteY1-122" fmla="*/ 205 h 10000"/>
                  <a:gd name="connsiteX2-123" fmla="*/ 0 w 10000"/>
                  <a:gd name="connsiteY2-124" fmla="*/ 410 h 10000"/>
                  <a:gd name="connsiteX3-125" fmla="*/ 0 w 10000"/>
                  <a:gd name="connsiteY3-126" fmla="*/ 614 h 10000"/>
                  <a:gd name="connsiteX4-127" fmla="*/ 0 w 10000"/>
                  <a:gd name="connsiteY4-128" fmla="*/ 751 h 10000"/>
                  <a:gd name="connsiteX5-129" fmla="*/ 0 w 10000"/>
                  <a:gd name="connsiteY5-130" fmla="*/ 1331 h 10000"/>
                  <a:gd name="connsiteX6-131" fmla="*/ 0 w 10000"/>
                  <a:gd name="connsiteY6-132" fmla="*/ 1536 h 10000"/>
                  <a:gd name="connsiteX7-133" fmla="*/ 80 w 10000"/>
                  <a:gd name="connsiteY7-134" fmla="*/ 1741 h 10000"/>
                  <a:gd name="connsiteX8-135" fmla="*/ 80 w 10000"/>
                  <a:gd name="connsiteY8-136" fmla="*/ 1877 h 10000"/>
                  <a:gd name="connsiteX9-137" fmla="*/ 80 w 10000"/>
                  <a:gd name="connsiteY9-138" fmla="*/ 2082 h 10000"/>
                  <a:gd name="connsiteX10-139" fmla="*/ 240 w 10000"/>
                  <a:gd name="connsiteY10-140" fmla="*/ 2457 h 10000"/>
                  <a:gd name="connsiteX11-141" fmla="*/ 320 w 10000"/>
                  <a:gd name="connsiteY11-142" fmla="*/ 2662 h 10000"/>
                  <a:gd name="connsiteX12-143" fmla="*/ 320 w 10000"/>
                  <a:gd name="connsiteY12-144" fmla="*/ 2799 h 10000"/>
                  <a:gd name="connsiteX13-145" fmla="*/ 400 w 10000"/>
                  <a:gd name="connsiteY13-146" fmla="*/ 3003 h 10000"/>
                  <a:gd name="connsiteX14-147" fmla="*/ 400 w 10000"/>
                  <a:gd name="connsiteY14-148" fmla="*/ 3208 h 10000"/>
                  <a:gd name="connsiteX15-149" fmla="*/ 560 w 10000"/>
                  <a:gd name="connsiteY15-150" fmla="*/ 3379 h 10000"/>
                  <a:gd name="connsiteX16-151" fmla="*/ 640 w 10000"/>
                  <a:gd name="connsiteY16-152" fmla="*/ 3549 h 10000"/>
                  <a:gd name="connsiteX17-153" fmla="*/ 800 w 10000"/>
                  <a:gd name="connsiteY17-154" fmla="*/ 3754 h 10000"/>
                  <a:gd name="connsiteX18-155" fmla="*/ 880 w 10000"/>
                  <a:gd name="connsiteY18-156" fmla="*/ 3925 h 10000"/>
                  <a:gd name="connsiteX19-157" fmla="*/ 1040 w 10000"/>
                  <a:gd name="connsiteY19-158" fmla="*/ 4130 h 10000"/>
                  <a:gd name="connsiteX20-159" fmla="*/ 1120 w 10000"/>
                  <a:gd name="connsiteY20-160" fmla="*/ 4266 h 10000"/>
                  <a:gd name="connsiteX21-161" fmla="*/ 1280 w 10000"/>
                  <a:gd name="connsiteY21-162" fmla="*/ 4471 h 10000"/>
                  <a:gd name="connsiteX22-163" fmla="*/ 1360 w 10000"/>
                  <a:gd name="connsiteY22-164" fmla="*/ 4676 h 10000"/>
                  <a:gd name="connsiteX23-165" fmla="*/ 1440 w 10000"/>
                  <a:gd name="connsiteY23-166" fmla="*/ 4812 h 10000"/>
                  <a:gd name="connsiteX24-167" fmla="*/ 1680 w 10000"/>
                  <a:gd name="connsiteY24-168" fmla="*/ 5017 h 10000"/>
                  <a:gd name="connsiteX25-169" fmla="*/ 1840 w 10000"/>
                  <a:gd name="connsiteY25-170" fmla="*/ 5222 h 10000"/>
                  <a:gd name="connsiteX26-171" fmla="*/ 2080 w 10000"/>
                  <a:gd name="connsiteY26-172" fmla="*/ 5358 h 10000"/>
                  <a:gd name="connsiteX27-173" fmla="*/ 2160 w 10000"/>
                  <a:gd name="connsiteY27-174" fmla="*/ 5563 h 10000"/>
                  <a:gd name="connsiteX28-175" fmla="*/ 2400 w 10000"/>
                  <a:gd name="connsiteY28-176" fmla="*/ 5700 h 10000"/>
                  <a:gd name="connsiteX29-177" fmla="*/ 2480 w 10000"/>
                  <a:gd name="connsiteY29-178" fmla="*/ 5904 h 10000"/>
                  <a:gd name="connsiteX30-179" fmla="*/ 2720 w 10000"/>
                  <a:gd name="connsiteY30-180" fmla="*/ 6041 h 10000"/>
                  <a:gd name="connsiteX31-181" fmla="*/ 2880 w 10000"/>
                  <a:gd name="connsiteY31-182" fmla="*/ 6246 h 10000"/>
                  <a:gd name="connsiteX32-183" fmla="*/ 3040 w 10000"/>
                  <a:gd name="connsiteY32-184" fmla="*/ 6382 h 10000"/>
                  <a:gd name="connsiteX33-185" fmla="*/ 3280 w 10000"/>
                  <a:gd name="connsiteY33-186" fmla="*/ 6519 h 10000"/>
                  <a:gd name="connsiteX34-187" fmla="*/ 3520 w 10000"/>
                  <a:gd name="connsiteY34-188" fmla="*/ 6724 h 10000"/>
                  <a:gd name="connsiteX35-189" fmla="*/ 3760 w 10000"/>
                  <a:gd name="connsiteY35-190" fmla="*/ 6860 h 10000"/>
                  <a:gd name="connsiteX36-191" fmla="*/ 4000 w 10000"/>
                  <a:gd name="connsiteY36-192" fmla="*/ 7031 h 10000"/>
                  <a:gd name="connsiteX37-193" fmla="*/ 4240 w 10000"/>
                  <a:gd name="connsiteY37-194" fmla="*/ 7201 h 10000"/>
                  <a:gd name="connsiteX38-195" fmla="*/ 4480 w 10000"/>
                  <a:gd name="connsiteY38-196" fmla="*/ 7372 h 10000"/>
                  <a:gd name="connsiteX39-197" fmla="*/ 4720 w 10000"/>
                  <a:gd name="connsiteY39-198" fmla="*/ 7509 h 10000"/>
                  <a:gd name="connsiteX40-199" fmla="*/ 4880 w 10000"/>
                  <a:gd name="connsiteY40-200" fmla="*/ 7645 h 10000"/>
                  <a:gd name="connsiteX41-201" fmla="*/ 5120 w 10000"/>
                  <a:gd name="connsiteY41-202" fmla="*/ 7816 h 10000"/>
                  <a:gd name="connsiteX42-203" fmla="*/ 5520 w 10000"/>
                  <a:gd name="connsiteY42-204" fmla="*/ 7952 h 10000"/>
                  <a:gd name="connsiteX43-205" fmla="*/ 5680 w 10000"/>
                  <a:gd name="connsiteY43-206" fmla="*/ 8157 h 10000"/>
                  <a:gd name="connsiteX44-207" fmla="*/ 5920 w 10000"/>
                  <a:gd name="connsiteY44-208" fmla="*/ 8294 h 10000"/>
                  <a:gd name="connsiteX45-209" fmla="*/ 6320 w 10000"/>
                  <a:gd name="connsiteY45-210" fmla="*/ 8430 h 10000"/>
                  <a:gd name="connsiteX46-211" fmla="*/ 6560 w 10000"/>
                  <a:gd name="connsiteY46-212" fmla="*/ 8532 h 10000"/>
                  <a:gd name="connsiteX47-213" fmla="*/ 6880 w 10000"/>
                  <a:gd name="connsiteY47-214" fmla="*/ 8669 h 10000"/>
                  <a:gd name="connsiteX48-215" fmla="*/ 7120 w 10000"/>
                  <a:gd name="connsiteY48-216" fmla="*/ 8840 h 10000"/>
                  <a:gd name="connsiteX49-217" fmla="*/ 7440 w 10000"/>
                  <a:gd name="connsiteY49-218" fmla="*/ 8976 h 10000"/>
                  <a:gd name="connsiteX50-219" fmla="*/ 7680 w 10000"/>
                  <a:gd name="connsiteY50-220" fmla="*/ 9113 h 10000"/>
                  <a:gd name="connsiteX51-221" fmla="*/ 8000 w 10000"/>
                  <a:gd name="connsiteY51-222" fmla="*/ 9283 h 10000"/>
                  <a:gd name="connsiteX52-223" fmla="*/ 8320 w 10000"/>
                  <a:gd name="connsiteY52-224" fmla="*/ 9386 h 10000"/>
                  <a:gd name="connsiteX53-225" fmla="*/ 8720 w 10000"/>
                  <a:gd name="connsiteY53-226" fmla="*/ 9522 h 10000"/>
                  <a:gd name="connsiteX54-227" fmla="*/ 8960 w 10000"/>
                  <a:gd name="connsiteY54-228" fmla="*/ 9659 h 10000"/>
                  <a:gd name="connsiteX55-229" fmla="*/ 9280 w 10000"/>
                  <a:gd name="connsiteY55-230" fmla="*/ 9761 h 10000"/>
                  <a:gd name="connsiteX56-231" fmla="*/ 9600 w 10000"/>
                  <a:gd name="connsiteY56-232" fmla="*/ 9898 h 10000"/>
                  <a:gd name="connsiteX57-233" fmla="*/ 10000 w 10000"/>
                  <a:gd name="connsiteY57-234" fmla="*/ 10000 h 10000"/>
                  <a:gd name="connsiteX0-235" fmla="*/ 80 w 10000"/>
                  <a:gd name="connsiteY0-236" fmla="*/ 0 h 10000"/>
                  <a:gd name="connsiteX1-237" fmla="*/ 0 w 10000"/>
                  <a:gd name="connsiteY1-238" fmla="*/ 205 h 10000"/>
                  <a:gd name="connsiteX2-239" fmla="*/ 0 w 10000"/>
                  <a:gd name="connsiteY2-240" fmla="*/ 410 h 10000"/>
                  <a:gd name="connsiteX3-241" fmla="*/ 0 w 10000"/>
                  <a:gd name="connsiteY3-242" fmla="*/ 614 h 10000"/>
                  <a:gd name="connsiteX4-243" fmla="*/ 0 w 10000"/>
                  <a:gd name="connsiteY4-244" fmla="*/ 751 h 10000"/>
                  <a:gd name="connsiteX5-245" fmla="*/ 0 w 10000"/>
                  <a:gd name="connsiteY5-246" fmla="*/ 1331 h 10000"/>
                  <a:gd name="connsiteX6-247" fmla="*/ 0 w 10000"/>
                  <a:gd name="connsiteY6-248" fmla="*/ 1536 h 10000"/>
                  <a:gd name="connsiteX7-249" fmla="*/ 80 w 10000"/>
                  <a:gd name="connsiteY7-250" fmla="*/ 1741 h 10000"/>
                  <a:gd name="connsiteX8-251" fmla="*/ 80 w 10000"/>
                  <a:gd name="connsiteY8-252" fmla="*/ 1877 h 10000"/>
                  <a:gd name="connsiteX9-253" fmla="*/ 240 w 10000"/>
                  <a:gd name="connsiteY9-254" fmla="*/ 2457 h 10000"/>
                  <a:gd name="connsiteX10-255" fmla="*/ 320 w 10000"/>
                  <a:gd name="connsiteY10-256" fmla="*/ 2662 h 10000"/>
                  <a:gd name="connsiteX11-257" fmla="*/ 320 w 10000"/>
                  <a:gd name="connsiteY11-258" fmla="*/ 2799 h 10000"/>
                  <a:gd name="connsiteX12-259" fmla="*/ 400 w 10000"/>
                  <a:gd name="connsiteY12-260" fmla="*/ 3003 h 10000"/>
                  <a:gd name="connsiteX13-261" fmla="*/ 400 w 10000"/>
                  <a:gd name="connsiteY13-262" fmla="*/ 3208 h 10000"/>
                  <a:gd name="connsiteX14-263" fmla="*/ 560 w 10000"/>
                  <a:gd name="connsiteY14-264" fmla="*/ 3379 h 10000"/>
                  <a:gd name="connsiteX15-265" fmla="*/ 640 w 10000"/>
                  <a:gd name="connsiteY15-266" fmla="*/ 3549 h 10000"/>
                  <a:gd name="connsiteX16-267" fmla="*/ 800 w 10000"/>
                  <a:gd name="connsiteY16-268" fmla="*/ 3754 h 10000"/>
                  <a:gd name="connsiteX17-269" fmla="*/ 880 w 10000"/>
                  <a:gd name="connsiteY17-270" fmla="*/ 3925 h 10000"/>
                  <a:gd name="connsiteX18-271" fmla="*/ 1040 w 10000"/>
                  <a:gd name="connsiteY18-272" fmla="*/ 4130 h 10000"/>
                  <a:gd name="connsiteX19-273" fmla="*/ 1120 w 10000"/>
                  <a:gd name="connsiteY19-274" fmla="*/ 4266 h 10000"/>
                  <a:gd name="connsiteX20-275" fmla="*/ 1280 w 10000"/>
                  <a:gd name="connsiteY20-276" fmla="*/ 4471 h 10000"/>
                  <a:gd name="connsiteX21-277" fmla="*/ 1360 w 10000"/>
                  <a:gd name="connsiteY21-278" fmla="*/ 4676 h 10000"/>
                  <a:gd name="connsiteX22-279" fmla="*/ 1440 w 10000"/>
                  <a:gd name="connsiteY22-280" fmla="*/ 4812 h 10000"/>
                  <a:gd name="connsiteX23-281" fmla="*/ 1680 w 10000"/>
                  <a:gd name="connsiteY23-282" fmla="*/ 5017 h 10000"/>
                  <a:gd name="connsiteX24-283" fmla="*/ 1840 w 10000"/>
                  <a:gd name="connsiteY24-284" fmla="*/ 5222 h 10000"/>
                  <a:gd name="connsiteX25-285" fmla="*/ 2080 w 10000"/>
                  <a:gd name="connsiteY25-286" fmla="*/ 5358 h 10000"/>
                  <a:gd name="connsiteX26-287" fmla="*/ 2160 w 10000"/>
                  <a:gd name="connsiteY26-288" fmla="*/ 5563 h 10000"/>
                  <a:gd name="connsiteX27-289" fmla="*/ 2400 w 10000"/>
                  <a:gd name="connsiteY27-290" fmla="*/ 5700 h 10000"/>
                  <a:gd name="connsiteX28-291" fmla="*/ 2480 w 10000"/>
                  <a:gd name="connsiteY28-292" fmla="*/ 5904 h 10000"/>
                  <a:gd name="connsiteX29-293" fmla="*/ 2720 w 10000"/>
                  <a:gd name="connsiteY29-294" fmla="*/ 6041 h 10000"/>
                  <a:gd name="connsiteX30-295" fmla="*/ 2880 w 10000"/>
                  <a:gd name="connsiteY30-296" fmla="*/ 6246 h 10000"/>
                  <a:gd name="connsiteX31-297" fmla="*/ 3040 w 10000"/>
                  <a:gd name="connsiteY31-298" fmla="*/ 6382 h 10000"/>
                  <a:gd name="connsiteX32-299" fmla="*/ 3280 w 10000"/>
                  <a:gd name="connsiteY32-300" fmla="*/ 6519 h 10000"/>
                  <a:gd name="connsiteX33-301" fmla="*/ 3520 w 10000"/>
                  <a:gd name="connsiteY33-302" fmla="*/ 6724 h 10000"/>
                  <a:gd name="connsiteX34-303" fmla="*/ 3760 w 10000"/>
                  <a:gd name="connsiteY34-304" fmla="*/ 6860 h 10000"/>
                  <a:gd name="connsiteX35-305" fmla="*/ 4000 w 10000"/>
                  <a:gd name="connsiteY35-306" fmla="*/ 7031 h 10000"/>
                  <a:gd name="connsiteX36-307" fmla="*/ 4240 w 10000"/>
                  <a:gd name="connsiteY36-308" fmla="*/ 7201 h 10000"/>
                  <a:gd name="connsiteX37-309" fmla="*/ 4480 w 10000"/>
                  <a:gd name="connsiteY37-310" fmla="*/ 7372 h 10000"/>
                  <a:gd name="connsiteX38-311" fmla="*/ 4720 w 10000"/>
                  <a:gd name="connsiteY38-312" fmla="*/ 7509 h 10000"/>
                  <a:gd name="connsiteX39-313" fmla="*/ 4880 w 10000"/>
                  <a:gd name="connsiteY39-314" fmla="*/ 7645 h 10000"/>
                  <a:gd name="connsiteX40-315" fmla="*/ 5120 w 10000"/>
                  <a:gd name="connsiteY40-316" fmla="*/ 7816 h 10000"/>
                  <a:gd name="connsiteX41-317" fmla="*/ 5520 w 10000"/>
                  <a:gd name="connsiteY41-318" fmla="*/ 7952 h 10000"/>
                  <a:gd name="connsiteX42-319" fmla="*/ 5680 w 10000"/>
                  <a:gd name="connsiteY42-320" fmla="*/ 8157 h 10000"/>
                  <a:gd name="connsiteX43-321" fmla="*/ 5920 w 10000"/>
                  <a:gd name="connsiteY43-322" fmla="*/ 8294 h 10000"/>
                  <a:gd name="connsiteX44-323" fmla="*/ 6320 w 10000"/>
                  <a:gd name="connsiteY44-324" fmla="*/ 8430 h 10000"/>
                  <a:gd name="connsiteX45-325" fmla="*/ 6560 w 10000"/>
                  <a:gd name="connsiteY45-326" fmla="*/ 8532 h 10000"/>
                  <a:gd name="connsiteX46-327" fmla="*/ 6880 w 10000"/>
                  <a:gd name="connsiteY46-328" fmla="*/ 8669 h 10000"/>
                  <a:gd name="connsiteX47-329" fmla="*/ 7120 w 10000"/>
                  <a:gd name="connsiteY47-330" fmla="*/ 8840 h 10000"/>
                  <a:gd name="connsiteX48-331" fmla="*/ 7440 w 10000"/>
                  <a:gd name="connsiteY48-332" fmla="*/ 8976 h 10000"/>
                  <a:gd name="connsiteX49-333" fmla="*/ 7680 w 10000"/>
                  <a:gd name="connsiteY49-334" fmla="*/ 9113 h 10000"/>
                  <a:gd name="connsiteX50-335" fmla="*/ 8000 w 10000"/>
                  <a:gd name="connsiteY50-336" fmla="*/ 9283 h 10000"/>
                  <a:gd name="connsiteX51-337" fmla="*/ 8320 w 10000"/>
                  <a:gd name="connsiteY51-338" fmla="*/ 9386 h 10000"/>
                  <a:gd name="connsiteX52-339" fmla="*/ 8720 w 10000"/>
                  <a:gd name="connsiteY52-340" fmla="*/ 9522 h 10000"/>
                  <a:gd name="connsiteX53-341" fmla="*/ 8960 w 10000"/>
                  <a:gd name="connsiteY53-342" fmla="*/ 9659 h 10000"/>
                  <a:gd name="connsiteX54-343" fmla="*/ 9280 w 10000"/>
                  <a:gd name="connsiteY54-344" fmla="*/ 9761 h 10000"/>
                  <a:gd name="connsiteX55-345" fmla="*/ 9600 w 10000"/>
                  <a:gd name="connsiteY55-346" fmla="*/ 9898 h 10000"/>
                  <a:gd name="connsiteX56-347" fmla="*/ 10000 w 10000"/>
                  <a:gd name="connsiteY56-348" fmla="*/ 10000 h 10000"/>
                  <a:gd name="connsiteX0-349" fmla="*/ 80 w 10000"/>
                  <a:gd name="connsiteY0-350" fmla="*/ 0 h 10000"/>
                  <a:gd name="connsiteX1-351" fmla="*/ 0 w 10000"/>
                  <a:gd name="connsiteY1-352" fmla="*/ 205 h 10000"/>
                  <a:gd name="connsiteX2-353" fmla="*/ 0 w 10000"/>
                  <a:gd name="connsiteY2-354" fmla="*/ 410 h 10000"/>
                  <a:gd name="connsiteX3-355" fmla="*/ 0 w 10000"/>
                  <a:gd name="connsiteY3-356" fmla="*/ 614 h 10000"/>
                  <a:gd name="connsiteX4-357" fmla="*/ 0 w 10000"/>
                  <a:gd name="connsiteY4-358" fmla="*/ 751 h 10000"/>
                  <a:gd name="connsiteX5-359" fmla="*/ 0 w 10000"/>
                  <a:gd name="connsiteY5-360" fmla="*/ 1536 h 10000"/>
                  <a:gd name="connsiteX6-361" fmla="*/ 80 w 10000"/>
                  <a:gd name="connsiteY6-362" fmla="*/ 1741 h 10000"/>
                  <a:gd name="connsiteX7-363" fmla="*/ 80 w 10000"/>
                  <a:gd name="connsiteY7-364" fmla="*/ 1877 h 10000"/>
                  <a:gd name="connsiteX8-365" fmla="*/ 240 w 10000"/>
                  <a:gd name="connsiteY8-366" fmla="*/ 2457 h 10000"/>
                  <a:gd name="connsiteX9-367" fmla="*/ 320 w 10000"/>
                  <a:gd name="connsiteY9-368" fmla="*/ 2662 h 10000"/>
                  <a:gd name="connsiteX10-369" fmla="*/ 320 w 10000"/>
                  <a:gd name="connsiteY10-370" fmla="*/ 2799 h 10000"/>
                  <a:gd name="connsiteX11-371" fmla="*/ 400 w 10000"/>
                  <a:gd name="connsiteY11-372" fmla="*/ 3003 h 10000"/>
                  <a:gd name="connsiteX12-373" fmla="*/ 400 w 10000"/>
                  <a:gd name="connsiteY12-374" fmla="*/ 3208 h 10000"/>
                  <a:gd name="connsiteX13-375" fmla="*/ 560 w 10000"/>
                  <a:gd name="connsiteY13-376" fmla="*/ 3379 h 10000"/>
                  <a:gd name="connsiteX14-377" fmla="*/ 640 w 10000"/>
                  <a:gd name="connsiteY14-378" fmla="*/ 3549 h 10000"/>
                  <a:gd name="connsiteX15-379" fmla="*/ 800 w 10000"/>
                  <a:gd name="connsiteY15-380" fmla="*/ 3754 h 10000"/>
                  <a:gd name="connsiteX16-381" fmla="*/ 880 w 10000"/>
                  <a:gd name="connsiteY16-382" fmla="*/ 3925 h 10000"/>
                  <a:gd name="connsiteX17-383" fmla="*/ 1040 w 10000"/>
                  <a:gd name="connsiteY17-384" fmla="*/ 4130 h 10000"/>
                  <a:gd name="connsiteX18-385" fmla="*/ 1120 w 10000"/>
                  <a:gd name="connsiteY18-386" fmla="*/ 4266 h 10000"/>
                  <a:gd name="connsiteX19-387" fmla="*/ 1280 w 10000"/>
                  <a:gd name="connsiteY19-388" fmla="*/ 4471 h 10000"/>
                  <a:gd name="connsiteX20-389" fmla="*/ 1360 w 10000"/>
                  <a:gd name="connsiteY20-390" fmla="*/ 4676 h 10000"/>
                  <a:gd name="connsiteX21-391" fmla="*/ 1440 w 10000"/>
                  <a:gd name="connsiteY21-392" fmla="*/ 4812 h 10000"/>
                  <a:gd name="connsiteX22-393" fmla="*/ 1680 w 10000"/>
                  <a:gd name="connsiteY22-394" fmla="*/ 5017 h 10000"/>
                  <a:gd name="connsiteX23-395" fmla="*/ 1840 w 10000"/>
                  <a:gd name="connsiteY23-396" fmla="*/ 5222 h 10000"/>
                  <a:gd name="connsiteX24-397" fmla="*/ 2080 w 10000"/>
                  <a:gd name="connsiteY24-398" fmla="*/ 5358 h 10000"/>
                  <a:gd name="connsiteX25-399" fmla="*/ 2160 w 10000"/>
                  <a:gd name="connsiteY25-400" fmla="*/ 5563 h 10000"/>
                  <a:gd name="connsiteX26-401" fmla="*/ 2400 w 10000"/>
                  <a:gd name="connsiteY26-402" fmla="*/ 5700 h 10000"/>
                  <a:gd name="connsiteX27-403" fmla="*/ 2480 w 10000"/>
                  <a:gd name="connsiteY27-404" fmla="*/ 5904 h 10000"/>
                  <a:gd name="connsiteX28-405" fmla="*/ 2720 w 10000"/>
                  <a:gd name="connsiteY28-406" fmla="*/ 6041 h 10000"/>
                  <a:gd name="connsiteX29-407" fmla="*/ 2880 w 10000"/>
                  <a:gd name="connsiteY29-408" fmla="*/ 6246 h 10000"/>
                  <a:gd name="connsiteX30-409" fmla="*/ 3040 w 10000"/>
                  <a:gd name="connsiteY30-410" fmla="*/ 6382 h 10000"/>
                  <a:gd name="connsiteX31-411" fmla="*/ 3280 w 10000"/>
                  <a:gd name="connsiteY31-412" fmla="*/ 6519 h 10000"/>
                  <a:gd name="connsiteX32-413" fmla="*/ 3520 w 10000"/>
                  <a:gd name="connsiteY32-414" fmla="*/ 6724 h 10000"/>
                  <a:gd name="connsiteX33-415" fmla="*/ 3760 w 10000"/>
                  <a:gd name="connsiteY33-416" fmla="*/ 6860 h 10000"/>
                  <a:gd name="connsiteX34-417" fmla="*/ 4000 w 10000"/>
                  <a:gd name="connsiteY34-418" fmla="*/ 7031 h 10000"/>
                  <a:gd name="connsiteX35-419" fmla="*/ 4240 w 10000"/>
                  <a:gd name="connsiteY35-420" fmla="*/ 7201 h 10000"/>
                  <a:gd name="connsiteX36-421" fmla="*/ 4480 w 10000"/>
                  <a:gd name="connsiteY36-422" fmla="*/ 7372 h 10000"/>
                  <a:gd name="connsiteX37-423" fmla="*/ 4720 w 10000"/>
                  <a:gd name="connsiteY37-424" fmla="*/ 7509 h 10000"/>
                  <a:gd name="connsiteX38-425" fmla="*/ 4880 w 10000"/>
                  <a:gd name="connsiteY38-426" fmla="*/ 7645 h 10000"/>
                  <a:gd name="connsiteX39-427" fmla="*/ 5120 w 10000"/>
                  <a:gd name="connsiteY39-428" fmla="*/ 7816 h 10000"/>
                  <a:gd name="connsiteX40-429" fmla="*/ 5520 w 10000"/>
                  <a:gd name="connsiteY40-430" fmla="*/ 7952 h 10000"/>
                  <a:gd name="connsiteX41-431" fmla="*/ 5680 w 10000"/>
                  <a:gd name="connsiteY41-432" fmla="*/ 8157 h 10000"/>
                  <a:gd name="connsiteX42-433" fmla="*/ 5920 w 10000"/>
                  <a:gd name="connsiteY42-434" fmla="*/ 8294 h 10000"/>
                  <a:gd name="connsiteX43-435" fmla="*/ 6320 w 10000"/>
                  <a:gd name="connsiteY43-436" fmla="*/ 8430 h 10000"/>
                  <a:gd name="connsiteX44-437" fmla="*/ 6560 w 10000"/>
                  <a:gd name="connsiteY44-438" fmla="*/ 8532 h 10000"/>
                  <a:gd name="connsiteX45-439" fmla="*/ 6880 w 10000"/>
                  <a:gd name="connsiteY45-440" fmla="*/ 8669 h 10000"/>
                  <a:gd name="connsiteX46-441" fmla="*/ 7120 w 10000"/>
                  <a:gd name="connsiteY46-442" fmla="*/ 8840 h 10000"/>
                  <a:gd name="connsiteX47-443" fmla="*/ 7440 w 10000"/>
                  <a:gd name="connsiteY47-444" fmla="*/ 8976 h 10000"/>
                  <a:gd name="connsiteX48-445" fmla="*/ 7680 w 10000"/>
                  <a:gd name="connsiteY48-446" fmla="*/ 9113 h 10000"/>
                  <a:gd name="connsiteX49-447" fmla="*/ 8000 w 10000"/>
                  <a:gd name="connsiteY49-448" fmla="*/ 9283 h 10000"/>
                  <a:gd name="connsiteX50-449" fmla="*/ 8320 w 10000"/>
                  <a:gd name="connsiteY50-450" fmla="*/ 9386 h 10000"/>
                  <a:gd name="connsiteX51-451" fmla="*/ 8720 w 10000"/>
                  <a:gd name="connsiteY51-452" fmla="*/ 9522 h 10000"/>
                  <a:gd name="connsiteX52-453" fmla="*/ 8960 w 10000"/>
                  <a:gd name="connsiteY52-454" fmla="*/ 9659 h 10000"/>
                  <a:gd name="connsiteX53-455" fmla="*/ 9280 w 10000"/>
                  <a:gd name="connsiteY53-456" fmla="*/ 9761 h 10000"/>
                  <a:gd name="connsiteX54-457" fmla="*/ 9600 w 10000"/>
                  <a:gd name="connsiteY54-458" fmla="*/ 9898 h 10000"/>
                  <a:gd name="connsiteX55-459" fmla="*/ 10000 w 10000"/>
                  <a:gd name="connsiteY55-460" fmla="*/ 10000 h 10000"/>
                  <a:gd name="connsiteX0-461" fmla="*/ 80 w 10000"/>
                  <a:gd name="connsiteY0-462" fmla="*/ 0 h 10000"/>
                  <a:gd name="connsiteX1-463" fmla="*/ 0 w 10000"/>
                  <a:gd name="connsiteY1-464" fmla="*/ 205 h 10000"/>
                  <a:gd name="connsiteX2-465" fmla="*/ 0 w 10000"/>
                  <a:gd name="connsiteY2-466" fmla="*/ 410 h 10000"/>
                  <a:gd name="connsiteX3-467" fmla="*/ 0 w 10000"/>
                  <a:gd name="connsiteY3-468" fmla="*/ 614 h 10000"/>
                  <a:gd name="connsiteX4-469" fmla="*/ 0 w 10000"/>
                  <a:gd name="connsiteY4-470" fmla="*/ 1536 h 10000"/>
                  <a:gd name="connsiteX5-471" fmla="*/ 80 w 10000"/>
                  <a:gd name="connsiteY5-472" fmla="*/ 1741 h 10000"/>
                  <a:gd name="connsiteX6-473" fmla="*/ 80 w 10000"/>
                  <a:gd name="connsiteY6-474" fmla="*/ 1877 h 10000"/>
                  <a:gd name="connsiteX7-475" fmla="*/ 240 w 10000"/>
                  <a:gd name="connsiteY7-476" fmla="*/ 2457 h 10000"/>
                  <a:gd name="connsiteX8-477" fmla="*/ 320 w 10000"/>
                  <a:gd name="connsiteY8-478" fmla="*/ 2662 h 10000"/>
                  <a:gd name="connsiteX9-479" fmla="*/ 320 w 10000"/>
                  <a:gd name="connsiteY9-480" fmla="*/ 2799 h 10000"/>
                  <a:gd name="connsiteX10-481" fmla="*/ 400 w 10000"/>
                  <a:gd name="connsiteY10-482" fmla="*/ 3003 h 10000"/>
                  <a:gd name="connsiteX11-483" fmla="*/ 400 w 10000"/>
                  <a:gd name="connsiteY11-484" fmla="*/ 3208 h 10000"/>
                  <a:gd name="connsiteX12-485" fmla="*/ 560 w 10000"/>
                  <a:gd name="connsiteY12-486" fmla="*/ 3379 h 10000"/>
                  <a:gd name="connsiteX13-487" fmla="*/ 640 w 10000"/>
                  <a:gd name="connsiteY13-488" fmla="*/ 3549 h 10000"/>
                  <a:gd name="connsiteX14-489" fmla="*/ 800 w 10000"/>
                  <a:gd name="connsiteY14-490" fmla="*/ 3754 h 10000"/>
                  <a:gd name="connsiteX15-491" fmla="*/ 880 w 10000"/>
                  <a:gd name="connsiteY15-492" fmla="*/ 3925 h 10000"/>
                  <a:gd name="connsiteX16-493" fmla="*/ 1040 w 10000"/>
                  <a:gd name="connsiteY16-494" fmla="*/ 4130 h 10000"/>
                  <a:gd name="connsiteX17-495" fmla="*/ 1120 w 10000"/>
                  <a:gd name="connsiteY17-496" fmla="*/ 4266 h 10000"/>
                  <a:gd name="connsiteX18-497" fmla="*/ 1280 w 10000"/>
                  <a:gd name="connsiteY18-498" fmla="*/ 4471 h 10000"/>
                  <a:gd name="connsiteX19-499" fmla="*/ 1360 w 10000"/>
                  <a:gd name="connsiteY19-500" fmla="*/ 4676 h 10000"/>
                  <a:gd name="connsiteX20-501" fmla="*/ 1440 w 10000"/>
                  <a:gd name="connsiteY20-502" fmla="*/ 4812 h 10000"/>
                  <a:gd name="connsiteX21-503" fmla="*/ 1680 w 10000"/>
                  <a:gd name="connsiteY21-504" fmla="*/ 5017 h 10000"/>
                  <a:gd name="connsiteX22-505" fmla="*/ 1840 w 10000"/>
                  <a:gd name="connsiteY22-506" fmla="*/ 5222 h 10000"/>
                  <a:gd name="connsiteX23-507" fmla="*/ 2080 w 10000"/>
                  <a:gd name="connsiteY23-508" fmla="*/ 5358 h 10000"/>
                  <a:gd name="connsiteX24-509" fmla="*/ 2160 w 10000"/>
                  <a:gd name="connsiteY24-510" fmla="*/ 5563 h 10000"/>
                  <a:gd name="connsiteX25-511" fmla="*/ 2400 w 10000"/>
                  <a:gd name="connsiteY25-512" fmla="*/ 5700 h 10000"/>
                  <a:gd name="connsiteX26-513" fmla="*/ 2480 w 10000"/>
                  <a:gd name="connsiteY26-514" fmla="*/ 5904 h 10000"/>
                  <a:gd name="connsiteX27-515" fmla="*/ 2720 w 10000"/>
                  <a:gd name="connsiteY27-516" fmla="*/ 6041 h 10000"/>
                  <a:gd name="connsiteX28-517" fmla="*/ 2880 w 10000"/>
                  <a:gd name="connsiteY28-518" fmla="*/ 6246 h 10000"/>
                  <a:gd name="connsiteX29-519" fmla="*/ 3040 w 10000"/>
                  <a:gd name="connsiteY29-520" fmla="*/ 6382 h 10000"/>
                  <a:gd name="connsiteX30-521" fmla="*/ 3280 w 10000"/>
                  <a:gd name="connsiteY30-522" fmla="*/ 6519 h 10000"/>
                  <a:gd name="connsiteX31-523" fmla="*/ 3520 w 10000"/>
                  <a:gd name="connsiteY31-524" fmla="*/ 6724 h 10000"/>
                  <a:gd name="connsiteX32-525" fmla="*/ 3760 w 10000"/>
                  <a:gd name="connsiteY32-526" fmla="*/ 6860 h 10000"/>
                  <a:gd name="connsiteX33-527" fmla="*/ 4000 w 10000"/>
                  <a:gd name="connsiteY33-528" fmla="*/ 7031 h 10000"/>
                  <a:gd name="connsiteX34-529" fmla="*/ 4240 w 10000"/>
                  <a:gd name="connsiteY34-530" fmla="*/ 7201 h 10000"/>
                  <a:gd name="connsiteX35-531" fmla="*/ 4480 w 10000"/>
                  <a:gd name="connsiteY35-532" fmla="*/ 7372 h 10000"/>
                  <a:gd name="connsiteX36-533" fmla="*/ 4720 w 10000"/>
                  <a:gd name="connsiteY36-534" fmla="*/ 7509 h 10000"/>
                  <a:gd name="connsiteX37-535" fmla="*/ 4880 w 10000"/>
                  <a:gd name="connsiteY37-536" fmla="*/ 7645 h 10000"/>
                  <a:gd name="connsiteX38-537" fmla="*/ 5120 w 10000"/>
                  <a:gd name="connsiteY38-538" fmla="*/ 7816 h 10000"/>
                  <a:gd name="connsiteX39-539" fmla="*/ 5520 w 10000"/>
                  <a:gd name="connsiteY39-540" fmla="*/ 7952 h 10000"/>
                  <a:gd name="connsiteX40-541" fmla="*/ 5680 w 10000"/>
                  <a:gd name="connsiteY40-542" fmla="*/ 8157 h 10000"/>
                  <a:gd name="connsiteX41-543" fmla="*/ 5920 w 10000"/>
                  <a:gd name="connsiteY41-544" fmla="*/ 8294 h 10000"/>
                  <a:gd name="connsiteX42-545" fmla="*/ 6320 w 10000"/>
                  <a:gd name="connsiteY42-546" fmla="*/ 8430 h 10000"/>
                  <a:gd name="connsiteX43-547" fmla="*/ 6560 w 10000"/>
                  <a:gd name="connsiteY43-548" fmla="*/ 8532 h 10000"/>
                  <a:gd name="connsiteX44-549" fmla="*/ 6880 w 10000"/>
                  <a:gd name="connsiteY44-550" fmla="*/ 8669 h 10000"/>
                  <a:gd name="connsiteX45-551" fmla="*/ 7120 w 10000"/>
                  <a:gd name="connsiteY45-552" fmla="*/ 8840 h 10000"/>
                  <a:gd name="connsiteX46-553" fmla="*/ 7440 w 10000"/>
                  <a:gd name="connsiteY46-554" fmla="*/ 8976 h 10000"/>
                  <a:gd name="connsiteX47-555" fmla="*/ 7680 w 10000"/>
                  <a:gd name="connsiteY47-556" fmla="*/ 9113 h 10000"/>
                  <a:gd name="connsiteX48-557" fmla="*/ 8000 w 10000"/>
                  <a:gd name="connsiteY48-558" fmla="*/ 9283 h 10000"/>
                  <a:gd name="connsiteX49-559" fmla="*/ 8320 w 10000"/>
                  <a:gd name="connsiteY49-560" fmla="*/ 9386 h 10000"/>
                  <a:gd name="connsiteX50-561" fmla="*/ 8720 w 10000"/>
                  <a:gd name="connsiteY50-562" fmla="*/ 9522 h 10000"/>
                  <a:gd name="connsiteX51-563" fmla="*/ 8960 w 10000"/>
                  <a:gd name="connsiteY51-564" fmla="*/ 9659 h 10000"/>
                  <a:gd name="connsiteX52-565" fmla="*/ 9280 w 10000"/>
                  <a:gd name="connsiteY52-566" fmla="*/ 9761 h 10000"/>
                  <a:gd name="connsiteX53-567" fmla="*/ 9600 w 10000"/>
                  <a:gd name="connsiteY53-568" fmla="*/ 9898 h 10000"/>
                  <a:gd name="connsiteX54-569" fmla="*/ 10000 w 10000"/>
                  <a:gd name="connsiteY54-570" fmla="*/ 10000 h 10000"/>
                  <a:gd name="connsiteX0-571" fmla="*/ 80 w 10000"/>
                  <a:gd name="connsiteY0-572" fmla="*/ 0 h 10000"/>
                  <a:gd name="connsiteX1-573" fmla="*/ 0 w 10000"/>
                  <a:gd name="connsiteY1-574" fmla="*/ 205 h 10000"/>
                  <a:gd name="connsiteX2-575" fmla="*/ 0 w 10000"/>
                  <a:gd name="connsiteY2-576" fmla="*/ 410 h 10000"/>
                  <a:gd name="connsiteX3-577" fmla="*/ 0 w 10000"/>
                  <a:gd name="connsiteY3-578" fmla="*/ 1536 h 10000"/>
                  <a:gd name="connsiteX4-579" fmla="*/ 80 w 10000"/>
                  <a:gd name="connsiteY4-580" fmla="*/ 1741 h 10000"/>
                  <a:gd name="connsiteX5-581" fmla="*/ 80 w 10000"/>
                  <a:gd name="connsiteY5-582" fmla="*/ 1877 h 10000"/>
                  <a:gd name="connsiteX6-583" fmla="*/ 240 w 10000"/>
                  <a:gd name="connsiteY6-584" fmla="*/ 2457 h 10000"/>
                  <a:gd name="connsiteX7-585" fmla="*/ 320 w 10000"/>
                  <a:gd name="connsiteY7-586" fmla="*/ 2662 h 10000"/>
                  <a:gd name="connsiteX8-587" fmla="*/ 320 w 10000"/>
                  <a:gd name="connsiteY8-588" fmla="*/ 2799 h 10000"/>
                  <a:gd name="connsiteX9-589" fmla="*/ 400 w 10000"/>
                  <a:gd name="connsiteY9-590" fmla="*/ 3003 h 10000"/>
                  <a:gd name="connsiteX10-591" fmla="*/ 400 w 10000"/>
                  <a:gd name="connsiteY10-592" fmla="*/ 3208 h 10000"/>
                  <a:gd name="connsiteX11-593" fmla="*/ 560 w 10000"/>
                  <a:gd name="connsiteY11-594" fmla="*/ 3379 h 10000"/>
                  <a:gd name="connsiteX12-595" fmla="*/ 640 w 10000"/>
                  <a:gd name="connsiteY12-596" fmla="*/ 3549 h 10000"/>
                  <a:gd name="connsiteX13-597" fmla="*/ 800 w 10000"/>
                  <a:gd name="connsiteY13-598" fmla="*/ 3754 h 10000"/>
                  <a:gd name="connsiteX14-599" fmla="*/ 880 w 10000"/>
                  <a:gd name="connsiteY14-600" fmla="*/ 3925 h 10000"/>
                  <a:gd name="connsiteX15-601" fmla="*/ 1040 w 10000"/>
                  <a:gd name="connsiteY15-602" fmla="*/ 4130 h 10000"/>
                  <a:gd name="connsiteX16-603" fmla="*/ 1120 w 10000"/>
                  <a:gd name="connsiteY16-604" fmla="*/ 4266 h 10000"/>
                  <a:gd name="connsiteX17-605" fmla="*/ 1280 w 10000"/>
                  <a:gd name="connsiteY17-606" fmla="*/ 4471 h 10000"/>
                  <a:gd name="connsiteX18-607" fmla="*/ 1360 w 10000"/>
                  <a:gd name="connsiteY18-608" fmla="*/ 4676 h 10000"/>
                  <a:gd name="connsiteX19-609" fmla="*/ 1440 w 10000"/>
                  <a:gd name="connsiteY19-610" fmla="*/ 4812 h 10000"/>
                  <a:gd name="connsiteX20-611" fmla="*/ 1680 w 10000"/>
                  <a:gd name="connsiteY20-612" fmla="*/ 5017 h 10000"/>
                  <a:gd name="connsiteX21-613" fmla="*/ 1840 w 10000"/>
                  <a:gd name="connsiteY21-614" fmla="*/ 5222 h 10000"/>
                  <a:gd name="connsiteX22-615" fmla="*/ 2080 w 10000"/>
                  <a:gd name="connsiteY22-616" fmla="*/ 5358 h 10000"/>
                  <a:gd name="connsiteX23-617" fmla="*/ 2160 w 10000"/>
                  <a:gd name="connsiteY23-618" fmla="*/ 5563 h 10000"/>
                  <a:gd name="connsiteX24-619" fmla="*/ 2400 w 10000"/>
                  <a:gd name="connsiteY24-620" fmla="*/ 5700 h 10000"/>
                  <a:gd name="connsiteX25-621" fmla="*/ 2480 w 10000"/>
                  <a:gd name="connsiteY25-622" fmla="*/ 5904 h 10000"/>
                  <a:gd name="connsiteX26-623" fmla="*/ 2720 w 10000"/>
                  <a:gd name="connsiteY26-624" fmla="*/ 6041 h 10000"/>
                  <a:gd name="connsiteX27-625" fmla="*/ 2880 w 10000"/>
                  <a:gd name="connsiteY27-626" fmla="*/ 6246 h 10000"/>
                  <a:gd name="connsiteX28-627" fmla="*/ 3040 w 10000"/>
                  <a:gd name="connsiteY28-628" fmla="*/ 6382 h 10000"/>
                  <a:gd name="connsiteX29-629" fmla="*/ 3280 w 10000"/>
                  <a:gd name="connsiteY29-630" fmla="*/ 6519 h 10000"/>
                  <a:gd name="connsiteX30-631" fmla="*/ 3520 w 10000"/>
                  <a:gd name="connsiteY30-632" fmla="*/ 6724 h 10000"/>
                  <a:gd name="connsiteX31-633" fmla="*/ 3760 w 10000"/>
                  <a:gd name="connsiteY31-634" fmla="*/ 6860 h 10000"/>
                  <a:gd name="connsiteX32-635" fmla="*/ 4000 w 10000"/>
                  <a:gd name="connsiteY32-636" fmla="*/ 7031 h 10000"/>
                  <a:gd name="connsiteX33-637" fmla="*/ 4240 w 10000"/>
                  <a:gd name="connsiteY33-638" fmla="*/ 7201 h 10000"/>
                  <a:gd name="connsiteX34-639" fmla="*/ 4480 w 10000"/>
                  <a:gd name="connsiteY34-640" fmla="*/ 7372 h 10000"/>
                  <a:gd name="connsiteX35-641" fmla="*/ 4720 w 10000"/>
                  <a:gd name="connsiteY35-642" fmla="*/ 7509 h 10000"/>
                  <a:gd name="connsiteX36-643" fmla="*/ 4880 w 10000"/>
                  <a:gd name="connsiteY36-644" fmla="*/ 7645 h 10000"/>
                  <a:gd name="connsiteX37-645" fmla="*/ 5120 w 10000"/>
                  <a:gd name="connsiteY37-646" fmla="*/ 7816 h 10000"/>
                  <a:gd name="connsiteX38-647" fmla="*/ 5520 w 10000"/>
                  <a:gd name="connsiteY38-648" fmla="*/ 7952 h 10000"/>
                  <a:gd name="connsiteX39-649" fmla="*/ 5680 w 10000"/>
                  <a:gd name="connsiteY39-650" fmla="*/ 8157 h 10000"/>
                  <a:gd name="connsiteX40-651" fmla="*/ 5920 w 10000"/>
                  <a:gd name="connsiteY40-652" fmla="*/ 8294 h 10000"/>
                  <a:gd name="connsiteX41-653" fmla="*/ 6320 w 10000"/>
                  <a:gd name="connsiteY41-654" fmla="*/ 8430 h 10000"/>
                  <a:gd name="connsiteX42-655" fmla="*/ 6560 w 10000"/>
                  <a:gd name="connsiteY42-656" fmla="*/ 8532 h 10000"/>
                  <a:gd name="connsiteX43-657" fmla="*/ 6880 w 10000"/>
                  <a:gd name="connsiteY43-658" fmla="*/ 8669 h 10000"/>
                  <a:gd name="connsiteX44-659" fmla="*/ 7120 w 10000"/>
                  <a:gd name="connsiteY44-660" fmla="*/ 8840 h 10000"/>
                  <a:gd name="connsiteX45-661" fmla="*/ 7440 w 10000"/>
                  <a:gd name="connsiteY45-662" fmla="*/ 8976 h 10000"/>
                  <a:gd name="connsiteX46-663" fmla="*/ 7680 w 10000"/>
                  <a:gd name="connsiteY46-664" fmla="*/ 9113 h 10000"/>
                  <a:gd name="connsiteX47-665" fmla="*/ 8000 w 10000"/>
                  <a:gd name="connsiteY47-666" fmla="*/ 9283 h 10000"/>
                  <a:gd name="connsiteX48-667" fmla="*/ 8320 w 10000"/>
                  <a:gd name="connsiteY48-668" fmla="*/ 9386 h 10000"/>
                  <a:gd name="connsiteX49-669" fmla="*/ 8720 w 10000"/>
                  <a:gd name="connsiteY49-670" fmla="*/ 9522 h 10000"/>
                  <a:gd name="connsiteX50-671" fmla="*/ 8960 w 10000"/>
                  <a:gd name="connsiteY50-672" fmla="*/ 9659 h 10000"/>
                  <a:gd name="connsiteX51-673" fmla="*/ 9280 w 10000"/>
                  <a:gd name="connsiteY51-674" fmla="*/ 9761 h 10000"/>
                  <a:gd name="connsiteX52-675" fmla="*/ 9600 w 10000"/>
                  <a:gd name="connsiteY52-676" fmla="*/ 9898 h 10000"/>
                  <a:gd name="connsiteX53-677" fmla="*/ 10000 w 10000"/>
                  <a:gd name="connsiteY53-678" fmla="*/ 10000 h 10000"/>
                  <a:gd name="connsiteX0-679" fmla="*/ 80 w 10000"/>
                  <a:gd name="connsiteY0-680" fmla="*/ 0 h 10000"/>
                  <a:gd name="connsiteX1-681" fmla="*/ 0 w 10000"/>
                  <a:gd name="connsiteY1-682" fmla="*/ 410 h 10000"/>
                  <a:gd name="connsiteX2-683" fmla="*/ 0 w 10000"/>
                  <a:gd name="connsiteY2-684" fmla="*/ 1536 h 10000"/>
                  <a:gd name="connsiteX3-685" fmla="*/ 80 w 10000"/>
                  <a:gd name="connsiteY3-686" fmla="*/ 1741 h 10000"/>
                  <a:gd name="connsiteX4-687" fmla="*/ 80 w 10000"/>
                  <a:gd name="connsiteY4-688" fmla="*/ 1877 h 10000"/>
                  <a:gd name="connsiteX5-689" fmla="*/ 240 w 10000"/>
                  <a:gd name="connsiteY5-690" fmla="*/ 2457 h 10000"/>
                  <a:gd name="connsiteX6-691" fmla="*/ 320 w 10000"/>
                  <a:gd name="connsiteY6-692" fmla="*/ 2662 h 10000"/>
                  <a:gd name="connsiteX7-693" fmla="*/ 320 w 10000"/>
                  <a:gd name="connsiteY7-694" fmla="*/ 2799 h 10000"/>
                  <a:gd name="connsiteX8-695" fmla="*/ 400 w 10000"/>
                  <a:gd name="connsiteY8-696" fmla="*/ 3003 h 10000"/>
                  <a:gd name="connsiteX9-697" fmla="*/ 400 w 10000"/>
                  <a:gd name="connsiteY9-698" fmla="*/ 3208 h 10000"/>
                  <a:gd name="connsiteX10-699" fmla="*/ 560 w 10000"/>
                  <a:gd name="connsiteY10-700" fmla="*/ 3379 h 10000"/>
                  <a:gd name="connsiteX11-701" fmla="*/ 640 w 10000"/>
                  <a:gd name="connsiteY11-702" fmla="*/ 3549 h 10000"/>
                  <a:gd name="connsiteX12-703" fmla="*/ 800 w 10000"/>
                  <a:gd name="connsiteY12-704" fmla="*/ 3754 h 10000"/>
                  <a:gd name="connsiteX13-705" fmla="*/ 880 w 10000"/>
                  <a:gd name="connsiteY13-706" fmla="*/ 3925 h 10000"/>
                  <a:gd name="connsiteX14-707" fmla="*/ 1040 w 10000"/>
                  <a:gd name="connsiteY14-708" fmla="*/ 4130 h 10000"/>
                  <a:gd name="connsiteX15-709" fmla="*/ 1120 w 10000"/>
                  <a:gd name="connsiteY15-710" fmla="*/ 4266 h 10000"/>
                  <a:gd name="connsiteX16-711" fmla="*/ 1280 w 10000"/>
                  <a:gd name="connsiteY16-712" fmla="*/ 4471 h 10000"/>
                  <a:gd name="connsiteX17-713" fmla="*/ 1360 w 10000"/>
                  <a:gd name="connsiteY17-714" fmla="*/ 4676 h 10000"/>
                  <a:gd name="connsiteX18-715" fmla="*/ 1440 w 10000"/>
                  <a:gd name="connsiteY18-716" fmla="*/ 4812 h 10000"/>
                  <a:gd name="connsiteX19-717" fmla="*/ 1680 w 10000"/>
                  <a:gd name="connsiteY19-718" fmla="*/ 5017 h 10000"/>
                  <a:gd name="connsiteX20-719" fmla="*/ 1840 w 10000"/>
                  <a:gd name="connsiteY20-720" fmla="*/ 5222 h 10000"/>
                  <a:gd name="connsiteX21-721" fmla="*/ 2080 w 10000"/>
                  <a:gd name="connsiteY21-722" fmla="*/ 5358 h 10000"/>
                  <a:gd name="connsiteX22-723" fmla="*/ 2160 w 10000"/>
                  <a:gd name="connsiteY22-724" fmla="*/ 5563 h 10000"/>
                  <a:gd name="connsiteX23-725" fmla="*/ 2400 w 10000"/>
                  <a:gd name="connsiteY23-726" fmla="*/ 5700 h 10000"/>
                  <a:gd name="connsiteX24-727" fmla="*/ 2480 w 10000"/>
                  <a:gd name="connsiteY24-728" fmla="*/ 5904 h 10000"/>
                  <a:gd name="connsiteX25-729" fmla="*/ 2720 w 10000"/>
                  <a:gd name="connsiteY25-730" fmla="*/ 6041 h 10000"/>
                  <a:gd name="connsiteX26-731" fmla="*/ 2880 w 10000"/>
                  <a:gd name="connsiteY26-732" fmla="*/ 6246 h 10000"/>
                  <a:gd name="connsiteX27-733" fmla="*/ 3040 w 10000"/>
                  <a:gd name="connsiteY27-734" fmla="*/ 6382 h 10000"/>
                  <a:gd name="connsiteX28-735" fmla="*/ 3280 w 10000"/>
                  <a:gd name="connsiteY28-736" fmla="*/ 6519 h 10000"/>
                  <a:gd name="connsiteX29-737" fmla="*/ 3520 w 10000"/>
                  <a:gd name="connsiteY29-738" fmla="*/ 6724 h 10000"/>
                  <a:gd name="connsiteX30-739" fmla="*/ 3760 w 10000"/>
                  <a:gd name="connsiteY30-740" fmla="*/ 6860 h 10000"/>
                  <a:gd name="connsiteX31-741" fmla="*/ 4000 w 10000"/>
                  <a:gd name="connsiteY31-742" fmla="*/ 7031 h 10000"/>
                  <a:gd name="connsiteX32-743" fmla="*/ 4240 w 10000"/>
                  <a:gd name="connsiteY32-744" fmla="*/ 7201 h 10000"/>
                  <a:gd name="connsiteX33-745" fmla="*/ 4480 w 10000"/>
                  <a:gd name="connsiteY33-746" fmla="*/ 7372 h 10000"/>
                  <a:gd name="connsiteX34-747" fmla="*/ 4720 w 10000"/>
                  <a:gd name="connsiteY34-748" fmla="*/ 7509 h 10000"/>
                  <a:gd name="connsiteX35-749" fmla="*/ 4880 w 10000"/>
                  <a:gd name="connsiteY35-750" fmla="*/ 7645 h 10000"/>
                  <a:gd name="connsiteX36-751" fmla="*/ 5120 w 10000"/>
                  <a:gd name="connsiteY36-752" fmla="*/ 7816 h 10000"/>
                  <a:gd name="connsiteX37-753" fmla="*/ 5520 w 10000"/>
                  <a:gd name="connsiteY37-754" fmla="*/ 7952 h 10000"/>
                  <a:gd name="connsiteX38-755" fmla="*/ 5680 w 10000"/>
                  <a:gd name="connsiteY38-756" fmla="*/ 8157 h 10000"/>
                  <a:gd name="connsiteX39-757" fmla="*/ 5920 w 10000"/>
                  <a:gd name="connsiteY39-758" fmla="*/ 8294 h 10000"/>
                  <a:gd name="connsiteX40-759" fmla="*/ 6320 w 10000"/>
                  <a:gd name="connsiteY40-760" fmla="*/ 8430 h 10000"/>
                  <a:gd name="connsiteX41-761" fmla="*/ 6560 w 10000"/>
                  <a:gd name="connsiteY41-762" fmla="*/ 8532 h 10000"/>
                  <a:gd name="connsiteX42-763" fmla="*/ 6880 w 10000"/>
                  <a:gd name="connsiteY42-764" fmla="*/ 8669 h 10000"/>
                  <a:gd name="connsiteX43-765" fmla="*/ 7120 w 10000"/>
                  <a:gd name="connsiteY43-766" fmla="*/ 8840 h 10000"/>
                  <a:gd name="connsiteX44-767" fmla="*/ 7440 w 10000"/>
                  <a:gd name="connsiteY44-768" fmla="*/ 8976 h 10000"/>
                  <a:gd name="connsiteX45-769" fmla="*/ 7680 w 10000"/>
                  <a:gd name="connsiteY45-770" fmla="*/ 9113 h 10000"/>
                  <a:gd name="connsiteX46-771" fmla="*/ 8000 w 10000"/>
                  <a:gd name="connsiteY46-772" fmla="*/ 9283 h 10000"/>
                  <a:gd name="connsiteX47-773" fmla="*/ 8320 w 10000"/>
                  <a:gd name="connsiteY47-774" fmla="*/ 9386 h 10000"/>
                  <a:gd name="connsiteX48-775" fmla="*/ 8720 w 10000"/>
                  <a:gd name="connsiteY48-776" fmla="*/ 9522 h 10000"/>
                  <a:gd name="connsiteX49-777" fmla="*/ 8960 w 10000"/>
                  <a:gd name="connsiteY49-778" fmla="*/ 9659 h 10000"/>
                  <a:gd name="connsiteX50-779" fmla="*/ 9280 w 10000"/>
                  <a:gd name="connsiteY50-780" fmla="*/ 9761 h 10000"/>
                  <a:gd name="connsiteX51-781" fmla="*/ 9600 w 10000"/>
                  <a:gd name="connsiteY51-782" fmla="*/ 9898 h 10000"/>
                  <a:gd name="connsiteX52-783" fmla="*/ 10000 w 10000"/>
                  <a:gd name="connsiteY52-784" fmla="*/ 10000 h 10000"/>
                  <a:gd name="connsiteX0-785" fmla="*/ 80 w 10000"/>
                  <a:gd name="connsiteY0-786" fmla="*/ 0 h 10000"/>
                  <a:gd name="connsiteX1-787" fmla="*/ 0 w 10000"/>
                  <a:gd name="connsiteY1-788" fmla="*/ 1536 h 10000"/>
                  <a:gd name="connsiteX2-789" fmla="*/ 80 w 10000"/>
                  <a:gd name="connsiteY2-790" fmla="*/ 1741 h 10000"/>
                  <a:gd name="connsiteX3-791" fmla="*/ 80 w 10000"/>
                  <a:gd name="connsiteY3-792" fmla="*/ 1877 h 10000"/>
                  <a:gd name="connsiteX4-793" fmla="*/ 240 w 10000"/>
                  <a:gd name="connsiteY4-794" fmla="*/ 2457 h 10000"/>
                  <a:gd name="connsiteX5-795" fmla="*/ 320 w 10000"/>
                  <a:gd name="connsiteY5-796" fmla="*/ 2662 h 10000"/>
                  <a:gd name="connsiteX6-797" fmla="*/ 320 w 10000"/>
                  <a:gd name="connsiteY6-798" fmla="*/ 2799 h 10000"/>
                  <a:gd name="connsiteX7-799" fmla="*/ 400 w 10000"/>
                  <a:gd name="connsiteY7-800" fmla="*/ 3003 h 10000"/>
                  <a:gd name="connsiteX8-801" fmla="*/ 400 w 10000"/>
                  <a:gd name="connsiteY8-802" fmla="*/ 3208 h 10000"/>
                  <a:gd name="connsiteX9-803" fmla="*/ 560 w 10000"/>
                  <a:gd name="connsiteY9-804" fmla="*/ 3379 h 10000"/>
                  <a:gd name="connsiteX10-805" fmla="*/ 640 w 10000"/>
                  <a:gd name="connsiteY10-806" fmla="*/ 3549 h 10000"/>
                  <a:gd name="connsiteX11-807" fmla="*/ 800 w 10000"/>
                  <a:gd name="connsiteY11-808" fmla="*/ 3754 h 10000"/>
                  <a:gd name="connsiteX12-809" fmla="*/ 880 w 10000"/>
                  <a:gd name="connsiteY12-810" fmla="*/ 3925 h 10000"/>
                  <a:gd name="connsiteX13-811" fmla="*/ 1040 w 10000"/>
                  <a:gd name="connsiteY13-812" fmla="*/ 4130 h 10000"/>
                  <a:gd name="connsiteX14-813" fmla="*/ 1120 w 10000"/>
                  <a:gd name="connsiteY14-814" fmla="*/ 4266 h 10000"/>
                  <a:gd name="connsiteX15-815" fmla="*/ 1280 w 10000"/>
                  <a:gd name="connsiteY15-816" fmla="*/ 4471 h 10000"/>
                  <a:gd name="connsiteX16-817" fmla="*/ 1360 w 10000"/>
                  <a:gd name="connsiteY16-818" fmla="*/ 4676 h 10000"/>
                  <a:gd name="connsiteX17-819" fmla="*/ 1440 w 10000"/>
                  <a:gd name="connsiteY17-820" fmla="*/ 4812 h 10000"/>
                  <a:gd name="connsiteX18-821" fmla="*/ 1680 w 10000"/>
                  <a:gd name="connsiteY18-822" fmla="*/ 5017 h 10000"/>
                  <a:gd name="connsiteX19-823" fmla="*/ 1840 w 10000"/>
                  <a:gd name="connsiteY19-824" fmla="*/ 5222 h 10000"/>
                  <a:gd name="connsiteX20-825" fmla="*/ 2080 w 10000"/>
                  <a:gd name="connsiteY20-826" fmla="*/ 5358 h 10000"/>
                  <a:gd name="connsiteX21-827" fmla="*/ 2160 w 10000"/>
                  <a:gd name="connsiteY21-828" fmla="*/ 5563 h 10000"/>
                  <a:gd name="connsiteX22-829" fmla="*/ 2400 w 10000"/>
                  <a:gd name="connsiteY22-830" fmla="*/ 5700 h 10000"/>
                  <a:gd name="connsiteX23-831" fmla="*/ 2480 w 10000"/>
                  <a:gd name="connsiteY23-832" fmla="*/ 5904 h 10000"/>
                  <a:gd name="connsiteX24-833" fmla="*/ 2720 w 10000"/>
                  <a:gd name="connsiteY24-834" fmla="*/ 6041 h 10000"/>
                  <a:gd name="connsiteX25-835" fmla="*/ 2880 w 10000"/>
                  <a:gd name="connsiteY25-836" fmla="*/ 6246 h 10000"/>
                  <a:gd name="connsiteX26-837" fmla="*/ 3040 w 10000"/>
                  <a:gd name="connsiteY26-838" fmla="*/ 6382 h 10000"/>
                  <a:gd name="connsiteX27-839" fmla="*/ 3280 w 10000"/>
                  <a:gd name="connsiteY27-840" fmla="*/ 6519 h 10000"/>
                  <a:gd name="connsiteX28-841" fmla="*/ 3520 w 10000"/>
                  <a:gd name="connsiteY28-842" fmla="*/ 6724 h 10000"/>
                  <a:gd name="connsiteX29-843" fmla="*/ 3760 w 10000"/>
                  <a:gd name="connsiteY29-844" fmla="*/ 6860 h 10000"/>
                  <a:gd name="connsiteX30-845" fmla="*/ 4000 w 10000"/>
                  <a:gd name="connsiteY30-846" fmla="*/ 7031 h 10000"/>
                  <a:gd name="connsiteX31-847" fmla="*/ 4240 w 10000"/>
                  <a:gd name="connsiteY31-848" fmla="*/ 7201 h 10000"/>
                  <a:gd name="connsiteX32-849" fmla="*/ 4480 w 10000"/>
                  <a:gd name="connsiteY32-850" fmla="*/ 7372 h 10000"/>
                  <a:gd name="connsiteX33-851" fmla="*/ 4720 w 10000"/>
                  <a:gd name="connsiteY33-852" fmla="*/ 7509 h 10000"/>
                  <a:gd name="connsiteX34-853" fmla="*/ 4880 w 10000"/>
                  <a:gd name="connsiteY34-854" fmla="*/ 7645 h 10000"/>
                  <a:gd name="connsiteX35-855" fmla="*/ 5120 w 10000"/>
                  <a:gd name="connsiteY35-856" fmla="*/ 7816 h 10000"/>
                  <a:gd name="connsiteX36-857" fmla="*/ 5520 w 10000"/>
                  <a:gd name="connsiteY36-858" fmla="*/ 7952 h 10000"/>
                  <a:gd name="connsiteX37-859" fmla="*/ 5680 w 10000"/>
                  <a:gd name="connsiteY37-860" fmla="*/ 8157 h 10000"/>
                  <a:gd name="connsiteX38-861" fmla="*/ 5920 w 10000"/>
                  <a:gd name="connsiteY38-862" fmla="*/ 8294 h 10000"/>
                  <a:gd name="connsiteX39-863" fmla="*/ 6320 w 10000"/>
                  <a:gd name="connsiteY39-864" fmla="*/ 8430 h 10000"/>
                  <a:gd name="connsiteX40-865" fmla="*/ 6560 w 10000"/>
                  <a:gd name="connsiteY40-866" fmla="*/ 8532 h 10000"/>
                  <a:gd name="connsiteX41-867" fmla="*/ 6880 w 10000"/>
                  <a:gd name="connsiteY41-868" fmla="*/ 8669 h 10000"/>
                  <a:gd name="connsiteX42-869" fmla="*/ 7120 w 10000"/>
                  <a:gd name="connsiteY42-870" fmla="*/ 8840 h 10000"/>
                  <a:gd name="connsiteX43-871" fmla="*/ 7440 w 10000"/>
                  <a:gd name="connsiteY43-872" fmla="*/ 8976 h 10000"/>
                  <a:gd name="connsiteX44-873" fmla="*/ 7680 w 10000"/>
                  <a:gd name="connsiteY44-874" fmla="*/ 9113 h 10000"/>
                  <a:gd name="connsiteX45-875" fmla="*/ 8000 w 10000"/>
                  <a:gd name="connsiteY45-876" fmla="*/ 9283 h 10000"/>
                  <a:gd name="connsiteX46-877" fmla="*/ 8320 w 10000"/>
                  <a:gd name="connsiteY46-878" fmla="*/ 9386 h 10000"/>
                  <a:gd name="connsiteX47-879" fmla="*/ 8720 w 10000"/>
                  <a:gd name="connsiteY47-880" fmla="*/ 9522 h 10000"/>
                  <a:gd name="connsiteX48-881" fmla="*/ 8960 w 10000"/>
                  <a:gd name="connsiteY48-882" fmla="*/ 9659 h 10000"/>
                  <a:gd name="connsiteX49-883" fmla="*/ 9280 w 10000"/>
                  <a:gd name="connsiteY49-884" fmla="*/ 9761 h 10000"/>
                  <a:gd name="connsiteX50-885" fmla="*/ 9600 w 10000"/>
                  <a:gd name="connsiteY50-886" fmla="*/ 9898 h 10000"/>
                  <a:gd name="connsiteX51-887" fmla="*/ 10000 w 10000"/>
                  <a:gd name="connsiteY51-888" fmla="*/ 10000 h 10000"/>
                  <a:gd name="connsiteX0-889" fmla="*/ 0 w 10000"/>
                  <a:gd name="connsiteY0-890" fmla="*/ 0 h 8464"/>
                  <a:gd name="connsiteX1-891" fmla="*/ 80 w 10000"/>
                  <a:gd name="connsiteY1-892" fmla="*/ 205 h 8464"/>
                  <a:gd name="connsiteX2-893" fmla="*/ 80 w 10000"/>
                  <a:gd name="connsiteY2-894" fmla="*/ 341 h 8464"/>
                  <a:gd name="connsiteX3-895" fmla="*/ 240 w 10000"/>
                  <a:gd name="connsiteY3-896" fmla="*/ 921 h 8464"/>
                  <a:gd name="connsiteX4-897" fmla="*/ 320 w 10000"/>
                  <a:gd name="connsiteY4-898" fmla="*/ 1126 h 8464"/>
                  <a:gd name="connsiteX5-899" fmla="*/ 320 w 10000"/>
                  <a:gd name="connsiteY5-900" fmla="*/ 1263 h 8464"/>
                  <a:gd name="connsiteX6-901" fmla="*/ 400 w 10000"/>
                  <a:gd name="connsiteY6-902" fmla="*/ 1467 h 8464"/>
                  <a:gd name="connsiteX7-903" fmla="*/ 400 w 10000"/>
                  <a:gd name="connsiteY7-904" fmla="*/ 1672 h 8464"/>
                  <a:gd name="connsiteX8-905" fmla="*/ 560 w 10000"/>
                  <a:gd name="connsiteY8-906" fmla="*/ 1843 h 8464"/>
                  <a:gd name="connsiteX9-907" fmla="*/ 640 w 10000"/>
                  <a:gd name="connsiteY9-908" fmla="*/ 2013 h 8464"/>
                  <a:gd name="connsiteX10-909" fmla="*/ 800 w 10000"/>
                  <a:gd name="connsiteY10-910" fmla="*/ 2218 h 8464"/>
                  <a:gd name="connsiteX11-911" fmla="*/ 880 w 10000"/>
                  <a:gd name="connsiteY11-912" fmla="*/ 2389 h 8464"/>
                  <a:gd name="connsiteX12-913" fmla="*/ 1040 w 10000"/>
                  <a:gd name="connsiteY12-914" fmla="*/ 2594 h 8464"/>
                  <a:gd name="connsiteX13-915" fmla="*/ 1120 w 10000"/>
                  <a:gd name="connsiteY13-916" fmla="*/ 2730 h 8464"/>
                  <a:gd name="connsiteX14-917" fmla="*/ 1280 w 10000"/>
                  <a:gd name="connsiteY14-918" fmla="*/ 2935 h 8464"/>
                  <a:gd name="connsiteX15-919" fmla="*/ 1360 w 10000"/>
                  <a:gd name="connsiteY15-920" fmla="*/ 3140 h 8464"/>
                  <a:gd name="connsiteX16-921" fmla="*/ 1440 w 10000"/>
                  <a:gd name="connsiteY16-922" fmla="*/ 3276 h 8464"/>
                  <a:gd name="connsiteX17-923" fmla="*/ 1680 w 10000"/>
                  <a:gd name="connsiteY17-924" fmla="*/ 3481 h 8464"/>
                  <a:gd name="connsiteX18-925" fmla="*/ 1840 w 10000"/>
                  <a:gd name="connsiteY18-926" fmla="*/ 3686 h 8464"/>
                  <a:gd name="connsiteX19-927" fmla="*/ 2080 w 10000"/>
                  <a:gd name="connsiteY19-928" fmla="*/ 3822 h 8464"/>
                  <a:gd name="connsiteX20-929" fmla="*/ 2160 w 10000"/>
                  <a:gd name="connsiteY20-930" fmla="*/ 4027 h 8464"/>
                  <a:gd name="connsiteX21-931" fmla="*/ 2400 w 10000"/>
                  <a:gd name="connsiteY21-932" fmla="*/ 4164 h 8464"/>
                  <a:gd name="connsiteX22-933" fmla="*/ 2480 w 10000"/>
                  <a:gd name="connsiteY22-934" fmla="*/ 4368 h 8464"/>
                  <a:gd name="connsiteX23-935" fmla="*/ 2720 w 10000"/>
                  <a:gd name="connsiteY23-936" fmla="*/ 4505 h 8464"/>
                  <a:gd name="connsiteX24-937" fmla="*/ 2880 w 10000"/>
                  <a:gd name="connsiteY24-938" fmla="*/ 4710 h 8464"/>
                  <a:gd name="connsiteX25-939" fmla="*/ 3040 w 10000"/>
                  <a:gd name="connsiteY25-940" fmla="*/ 4846 h 8464"/>
                  <a:gd name="connsiteX26-941" fmla="*/ 3280 w 10000"/>
                  <a:gd name="connsiteY26-942" fmla="*/ 4983 h 8464"/>
                  <a:gd name="connsiteX27-943" fmla="*/ 3520 w 10000"/>
                  <a:gd name="connsiteY27-944" fmla="*/ 5188 h 8464"/>
                  <a:gd name="connsiteX28-945" fmla="*/ 3760 w 10000"/>
                  <a:gd name="connsiteY28-946" fmla="*/ 5324 h 8464"/>
                  <a:gd name="connsiteX29-947" fmla="*/ 4000 w 10000"/>
                  <a:gd name="connsiteY29-948" fmla="*/ 5495 h 8464"/>
                  <a:gd name="connsiteX30-949" fmla="*/ 4240 w 10000"/>
                  <a:gd name="connsiteY30-950" fmla="*/ 5665 h 8464"/>
                  <a:gd name="connsiteX31-951" fmla="*/ 4480 w 10000"/>
                  <a:gd name="connsiteY31-952" fmla="*/ 5836 h 8464"/>
                  <a:gd name="connsiteX32-953" fmla="*/ 4720 w 10000"/>
                  <a:gd name="connsiteY32-954" fmla="*/ 5973 h 8464"/>
                  <a:gd name="connsiteX33-955" fmla="*/ 4880 w 10000"/>
                  <a:gd name="connsiteY33-956" fmla="*/ 6109 h 8464"/>
                  <a:gd name="connsiteX34-957" fmla="*/ 5120 w 10000"/>
                  <a:gd name="connsiteY34-958" fmla="*/ 6280 h 8464"/>
                  <a:gd name="connsiteX35-959" fmla="*/ 5520 w 10000"/>
                  <a:gd name="connsiteY35-960" fmla="*/ 6416 h 8464"/>
                  <a:gd name="connsiteX36-961" fmla="*/ 5680 w 10000"/>
                  <a:gd name="connsiteY36-962" fmla="*/ 6621 h 8464"/>
                  <a:gd name="connsiteX37-963" fmla="*/ 5920 w 10000"/>
                  <a:gd name="connsiteY37-964" fmla="*/ 6758 h 8464"/>
                  <a:gd name="connsiteX38-965" fmla="*/ 6320 w 10000"/>
                  <a:gd name="connsiteY38-966" fmla="*/ 6894 h 8464"/>
                  <a:gd name="connsiteX39-967" fmla="*/ 6560 w 10000"/>
                  <a:gd name="connsiteY39-968" fmla="*/ 6996 h 8464"/>
                  <a:gd name="connsiteX40-969" fmla="*/ 6880 w 10000"/>
                  <a:gd name="connsiteY40-970" fmla="*/ 7133 h 8464"/>
                  <a:gd name="connsiteX41-971" fmla="*/ 7120 w 10000"/>
                  <a:gd name="connsiteY41-972" fmla="*/ 7304 h 8464"/>
                  <a:gd name="connsiteX42-973" fmla="*/ 7440 w 10000"/>
                  <a:gd name="connsiteY42-974" fmla="*/ 7440 h 8464"/>
                  <a:gd name="connsiteX43-975" fmla="*/ 7680 w 10000"/>
                  <a:gd name="connsiteY43-976" fmla="*/ 7577 h 8464"/>
                  <a:gd name="connsiteX44-977" fmla="*/ 8000 w 10000"/>
                  <a:gd name="connsiteY44-978" fmla="*/ 7747 h 8464"/>
                  <a:gd name="connsiteX45-979" fmla="*/ 8320 w 10000"/>
                  <a:gd name="connsiteY45-980" fmla="*/ 7850 h 8464"/>
                  <a:gd name="connsiteX46-981" fmla="*/ 8720 w 10000"/>
                  <a:gd name="connsiteY46-982" fmla="*/ 7986 h 8464"/>
                  <a:gd name="connsiteX47-983" fmla="*/ 8960 w 10000"/>
                  <a:gd name="connsiteY47-984" fmla="*/ 8123 h 8464"/>
                  <a:gd name="connsiteX48-985" fmla="*/ 9280 w 10000"/>
                  <a:gd name="connsiteY48-986" fmla="*/ 8225 h 8464"/>
                  <a:gd name="connsiteX49-987" fmla="*/ 9600 w 10000"/>
                  <a:gd name="connsiteY49-988" fmla="*/ 8362 h 8464"/>
                  <a:gd name="connsiteX50-989" fmla="*/ 10000 w 10000"/>
                  <a:gd name="connsiteY50-990" fmla="*/ 8464 h 8464"/>
                  <a:gd name="connsiteX0-991" fmla="*/ 0 w 9920"/>
                  <a:gd name="connsiteY0-992" fmla="*/ 0 h 9758"/>
                  <a:gd name="connsiteX1-993" fmla="*/ 0 w 9920"/>
                  <a:gd name="connsiteY1-994" fmla="*/ 161 h 9758"/>
                  <a:gd name="connsiteX2-995" fmla="*/ 160 w 9920"/>
                  <a:gd name="connsiteY2-996" fmla="*/ 846 h 9758"/>
                  <a:gd name="connsiteX3-997" fmla="*/ 240 w 9920"/>
                  <a:gd name="connsiteY3-998" fmla="*/ 1088 h 9758"/>
                  <a:gd name="connsiteX4-999" fmla="*/ 240 w 9920"/>
                  <a:gd name="connsiteY4-1000" fmla="*/ 1250 h 9758"/>
                  <a:gd name="connsiteX5-1001" fmla="*/ 320 w 9920"/>
                  <a:gd name="connsiteY5-1002" fmla="*/ 1491 h 9758"/>
                  <a:gd name="connsiteX6-1003" fmla="*/ 320 w 9920"/>
                  <a:gd name="connsiteY6-1004" fmla="*/ 1733 h 9758"/>
                  <a:gd name="connsiteX7-1005" fmla="*/ 480 w 9920"/>
                  <a:gd name="connsiteY7-1006" fmla="*/ 1935 h 9758"/>
                  <a:gd name="connsiteX8-1007" fmla="*/ 560 w 9920"/>
                  <a:gd name="connsiteY8-1008" fmla="*/ 2136 h 9758"/>
                  <a:gd name="connsiteX9-1009" fmla="*/ 720 w 9920"/>
                  <a:gd name="connsiteY9-1010" fmla="*/ 2379 h 9758"/>
                  <a:gd name="connsiteX10-1011" fmla="*/ 800 w 9920"/>
                  <a:gd name="connsiteY10-1012" fmla="*/ 2581 h 9758"/>
                  <a:gd name="connsiteX11-1013" fmla="*/ 960 w 9920"/>
                  <a:gd name="connsiteY11-1014" fmla="*/ 2823 h 9758"/>
                  <a:gd name="connsiteX12-1015" fmla="*/ 1040 w 9920"/>
                  <a:gd name="connsiteY12-1016" fmla="*/ 2983 h 9758"/>
                  <a:gd name="connsiteX13-1017" fmla="*/ 1200 w 9920"/>
                  <a:gd name="connsiteY13-1018" fmla="*/ 3226 h 9758"/>
                  <a:gd name="connsiteX14-1019" fmla="*/ 1280 w 9920"/>
                  <a:gd name="connsiteY14-1020" fmla="*/ 3468 h 9758"/>
                  <a:gd name="connsiteX15-1021" fmla="*/ 1360 w 9920"/>
                  <a:gd name="connsiteY15-1022" fmla="*/ 3629 h 9758"/>
                  <a:gd name="connsiteX16-1023" fmla="*/ 1600 w 9920"/>
                  <a:gd name="connsiteY16-1024" fmla="*/ 3871 h 9758"/>
                  <a:gd name="connsiteX17-1025" fmla="*/ 1760 w 9920"/>
                  <a:gd name="connsiteY17-1026" fmla="*/ 4113 h 9758"/>
                  <a:gd name="connsiteX18-1027" fmla="*/ 2000 w 9920"/>
                  <a:gd name="connsiteY18-1028" fmla="*/ 4274 h 9758"/>
                  <a:gd name="connsiteX19-1029" fmla="*/ 2080 w 9920"/>
                  <a:gd name="connsiteY19-1030" fmla="*/ 4516 h 9758"/>
                  <a:gd name="connsiteX20-1031" fmla="*/ 2320 w 9920"/>
                  <a:gd name="connsiteY20-1032" fmla="*/ 4678 h 9758"/>
                  <a:gd name="connsiteX21-1033" fmla="*/ 2400 w 9920"/>
                  <a:gd name="connsiteY21-1034" fmla="*/ 4919 h 9758"/>
                  <a:gd name="connsiteX22-1035" fmla="*/ 2640 w 9920"/>
                  <a:gd name="connsiteY22-1036" fmla="*/ 5081 h 9758"/>
                  <a:gd name="connsiteX23-1037" fmla="*/ 2800 w 9920"/>
                  <a:gd name="connsiteY23-1038" fmla="*/ 5323 h 9758"/>
                  <a:gd name="connsiteX24-1039" fmla="*/ 2960 w 9920"/>
                  <a:gd name="connsiteY24-1040" fmla="*/ 5483 h 9758"/>
                  <a:gd name="connsiteX25-1041" fmla="*/ 3200 w 9920"/>
                  <a:gd name="connsiteY25-1042" fmla="*/ 5645 h 9758"/>
                  <a:gd name="connsiteX26-1043" fmla="*/ 3440 w 9920"/>
                  <a:gd name="connsiteY26-1044" fmla="*/ 5887 h 9758"/>
                  <a:gd name="connsiteX27-1045" fmla="*/ 3680 w 9920"/>
                  <a:gd name="connsiteY27-1046" fmla="*/ 6048 h 9758"/>
                  <a:gd name="connsiteX28-1047" fmla="*/ 3920 w 9920"/>
                  <a:gd name="connsiteY28-1048" fmla="*/ 6250 h 9758"/>
                  <a:gd name="connsiteX29-1049" fmla="*/ 4160 w 9920"/>
                  <a:gd name="connsiteY29-1050" fmla="*/ 6451 h 9758"/>
                  <a:gd name="connsiteX30-1051" fmla="*/ 4400 w 9920"/>
                  <a:gd name="connsiteY30-1052" fmla="*/ 6653 h 9758"/>
                  <a:gd name="connsiteX31-1053" fmla="*/ 4640 w 9920"/>
                  <a:gd name="connsiteY31-1054" fmla="*/ 6815 h 9758"/>
                  <a:gd name="connsiteX32-1055" fmla="*/ 4800 w 9920"/>
                  <a:gd name="connsiteY32-1056" fmla="*/ 6976 h 9758"/>
                  <a:gd name="connsiteX33-1057" fmla="*/ 5040 w 9920"/>
                  <a:gd name="connsiteY33-1058" fmla="*/ 7178 h 9758"/>
                  <a:gd name="connsiteX34-1059" fmla="*/ 5440 w 9920"/>
                  <a:gd name="connsiteY34-1060" fmla="*/ 7338 h 9758"/>
                  <a:gd name="connsiteX35-1061" fmla="*/ 5600 w 9920"/>
                  <a:gd name="connsiteY35-1062" fmla="*/ 7581 h 9758"/>
                  <a:gd name="connsiteX36-1063" fmla="*/ 5840 w 9920"/>
                  <a:gd name="connsiteY36-1064" fmla="*/ 7742 h 9758"/>
                  <a:gd name="connsiteX37-1065" fmla="*/ 6240 w 9920"/>
                  <a:gd name="connsiteY37-1066" fmla="*/ 7903 h 9758"/>
                  <a:gd name="connsiteX38-1067" fmla="*/ 6480 w 9920"/>
                  <a:gd name="connsiteY38-1068" fmla="*/ 8024 h 9758"/>
                  <a:gd name="connsiteX39-1069" fmla="*/ 6800 w 9920"/>
                  <a:gd name="connsiteY39-1070" fmla="*/ 8185 h 9758"/>
                  <a:gd name="connsiteX40-1071" fmla="*/ 7040 w 9920"/>
                  <a:gd name="connsiteY40-1072" fmla="*/ 8387 h 9758"/>
                  <a:gd name="connsiteX41-1073" fmla="*/ 7360 w 9920"/>
                  <a:gd name="connsiteY41-1074" fmla="*/ 8548 h 9758"/>
                  <a:gd name="connsiteX42-1075" fmla="*/ 7600 w 9920"/>
                  <a:gd name="connsiteY42-1076" fmla="*/ 8710 h 9758"/>
                  <a:gd name="connsiteX43-1077" fmla="*/ 7920 w 9920"/>
                  <a:gd name="connsiteY43-1078" fmla="*/ 8911 h 9758"/>
                  <a:gd name="connsiteX44-1079" fmla="*/ 8240 w 9920"/>
                  <a:gd name="connsiteY44-1080" fmla="*/ 9033 h 9758"/>
                  <a:gd name="connsiteX45-1081" fmla="*/ 8640 w 9920"/>
                  <a:gd name="connsiteY45-1082" fmla="*/ 9193 h 9758"/>
                  <a:gd name="connsiteX46-1083" fmla="*/ 8880 w 9920"/>
                  <a:gd name="connsiteY46-1084" fmla="*/ 9355 h 9758"/>
                  <a:gd name="connsiteX47-1085" fmla="*/ 9200 w 9920"/>
                  <a:gd name="connsiteY47-1086" fmla="*/ 9476 h 9758"/>
                  <a:gd name="connsiteX48-1087" fmla="*/ 9520 w 9920"/>
                  <a:gd name="connsiteY48-1088" fmla="*/ 9637 h 9758"/>
                  <a:gd name="connsiteX49-1089" fmla="*/ 9920 w 9920"/>
                  <a:gd name="connsiteY49-1090" fmla="*/ 9758 h 9758"/>
                  <a:gd name="connsiteX0-1091" fmla="*/ 0 w 10000"/>
                  <a:gd name="connsiteY0-1092" fmla="*/ 0 h 10000"/>
                  <a:gd name="connsiteX1-1093" fmla="*/ 161 w 10000"/>
                  <a:gd name="connsiteY1-1094" fmla="*/ 867 h 10000"/>
                  <a:gd name="connsiteX2-1095" fmla="*/ 242 w 10000"/>
                  <a:gd name="connsiteY2-1096" fmla="*/ 1115 h 10000"/>
                  <a:gd name="connsiteX3-1097" fmla="*/ 242 w 10000"/>
                  <a:gd name="connsiteY3-1098" fmla="*/ 1281 h 10000"/>
                  <a:gd name="connsiteX4-1099" fmla="*/ 323 w 10000"/>
                  <a:gd name="connsiteY4-1100" fmla="*/ 1528 h 10000"/>
                  <a:gd name="connsiteX5-1101" fmla="*/ 323 w 10000"/>
                  <a:gd name="connsiteY5-1102" fmla="*/ 1776 h 10000"/>
                  <a:gd name="connsiteX6-1103" fmla="*/ 484 w 10000"/>
                  <a:gd name="connsiteY6-1104" fmla="*/ 1983 h 10000"/>
                  <a:gd name="connsiteX7-1105" fmla="*/ 565 w 10000"/>
                  <a:gd name="connsiteY7-1106" fmla="*/ 2189 h 10000"/>
                  <a:gd name="connsiteX8-1107" fmla="*/ 726 w 10000"/>
                  <a:gd name="connsiteY8-1108" fmla="*/ 2438 h 10000"/>
                  <a:gd name="connsiteX9-1109" fmla="*/ 806 w 10000"/>
                  <a:gd name="connsiteY9-1110" fmla="*/ 2645 h 10000"/>
                  <a:gd name="connsiteX10-1111" fmla="*/ 968 w 10000"/>
                  <a:gd name="connsiteY10-1112" fmla="*/ 2893 h 10000"/>
                  <a:gd name="connsiteX11-1113" fmla="*/ 1048 w 10000"/>
                  <a:gd name="connsiteY11-1114" fmla="*/ 3057 h 10000"/>
                  <a:gd name="connsiteX12-1115" fmla="*/ 1210 w 10000"/>
                  <a:gd name="connsiteY12-1116" fmla="*/ 3306 h 10000"/>
                  <a:gd name="connsiteX13-1117" fmla="*/ 1290 w 10000"/>
                  <a:gd name="connsiteY13-1118" fmla="*/ 3554 h 10000"/>
                  <a:gd name="connsiteX14-1119" fmla="*/ 1371 w 10000"/>
                  <a:gd name="connsiteY14-1120" fmla="*/ 3719 h 10000"/>
                  <a:gd name="connsiteX15-1121" fmla="*/ 1613 w 10000"/>
                  <a:gd name="connsiteY15-1122" fmla="*/ 3967 h 10000"/>
                  <a:gd name="connsiteX16-1123" fmla="*/ 1774 w 10000"/>
                  <a:gd name="connsiteY16-1124" fmla="*/ 4215 h 10000"/>
                  <a:gd name="connsiteX17-1125" fmla="*/ 2016 w 10000"/>
                  <a:gd name="connsiteY17-1126" fmla="*/ 4380 h 10000"/>
                  <a:gd name="connsiteX18-1127" fmla="*/ 2097 w 10000"/>
                  <a:gd name="connsiteY18-1128" fmla="*/ 4628 h 10000"/>
                  <a:gd name="connsiteX19-1129" fmla="*/ 2339 w 10000"/>
                  <a:gd name="connsiteY19-1130" fmla="*/ 4794 h 10000"/>
                  <a:gd name="connsiteX20-1131" fmla="*/ 2419 w 10000"/>
                  <a:gd name="connsiteY20-1132" fmla="*/ 5041 h 10000"/>
                  <a:gd name="connsiteX21-1133" fmla="*/ 2661 w 10000"/>
                  <a:gd name="connsiteY21-1134" fmla="*/ 5207 h 10000"/>
                  <a:gd name="connsiteX22-1135" fmla="*/ 2823 w 10000"/>
                  <a:gd name="connsiteY22-1136" fmla="*/ 5455 h 10000"/>
                  <a:gd name="connsiteX23-1137" fmla="*/ 2984 w 10000"/>
                  <a:gd name="connsiteY23-1138" fmla="*/ 5619 h 10000"/>
                  <a:gd name="connsiteX24-1139" fmla="*/ 3226 w 10000"/>
                  <a:gd name="connsiteY24-1140" fmla="*/ 5785 h 10000"/>
                  <a:gd name="connsiteX25-1141" fmla="*/ 3468 w 10000"/>
                  <a:gd name="connsiteY25-1142" fmla="*/ 6033 h 10000"/>
                  <a:gd name="connsiteX26-1143" fmla="*/ 3710 w 10000"/>
                  <a:gd name="connsiteY26-1144" fmla="*/ 6198 h 10000"/>
                  <a:gd name="connsiteX27-1145" fmla="*/ 3952 w 10000"/>
                  <a:gd name="connsiteY27-1146" fmla="*/ 6405 h 10000"/>
                  <a:gd name="connsiteX28-1147" fmla="*/ 4194 w 10000"/>
                  <a:gd name="connsiteY28-1148" fmla="*/ 6611 h 10000"/>
                  <a:gd name="connsiteX29-1149" fmla="*/ 4435 w 10000"/>
                  <a:gd name="connsiteY29-1150" fmla="*/ 6818 h 10000"/>
                  <a:gd name="connsiteX30-1151" fmla="*/ 4677 w 10000"/>
                  <a:gd name="connsiteY30-1152" fmla="*/ 6984 h 10000"/>
                  <a:gd name="connsiteX31-1153" fmla="*/ 4839 w 10000"/>
                  <a:gd name="connsiteY31-1154" fmla="*/ 7149 h 10000"/>
                  <a:gd name="connsiteX32-1155" fmla="*/ 5081 w 10000"/>
                  <a:gd name="connsiteY32-1156" fmla="*/ 7356 h 10000"/>
                  <a:gd name="connsiteX33-1157" fmla="*/ 5484 w 10000"/>
                  <a:gd name="connsiteY33-1158" fmla="*/ 7520 h 10000"/>
                  <a:gd name="connsiteX34-1159" fmla="*/ 5645 w 10000"/>
                  <a:gd name="connsiteY34-1160" fmla="*/ 7769 h 10000"/>
                  <a:gd name="connsiteX35-1161" fmla="*/ 5887 w 10000"/>
                  <a:gd name="connsiteY35-1162" fmla="*/ 7934 h 10000"/>
                  <a:gd name="connsiteX36-1163" fmla="*/ 6290 w 10000"/>
                  <a:gd name="connsiteY36-1164" fmla="*/ 8099 h 10000"/>
                  <a:gd name="connsiteX37-1165" fmla="*/ 6532 w 10000"/>
                  <a:gd name="connsiteY37-1166" fmla="*/ 8223 h 10000"/>
                  <a:gd name="connsiteX38-1167" fmla="*/ 6855 w 10000"/>
                  <a:gd name="connsiteY38-1168" fmla="*/ 8388 h 10000"/>
                  <a:gd name="connsiteX39-1169" fmla="*/ 7097 w 10000"/>
                  <a:gd name="connsiteY39-1170" fmla="*/ 8595 h 10000"/>
                  <a:gd name="connsiteX40-1171" fmla="*/ 7419 w 10000"/>
                  <a:gd name="connsiteY40-1172" fmla="*/ 8760 h 10000"/>
                  <a:gd name="connsiteX41-1173" fmla="*/ 7661 w 10000"/>
                  <a:gd name="connsiteY41-1174" fmla="*/ 8926 h 10000"/>
                  <a:gd name="connsiteX42-1175" fmla="*/ 7984 w 10000"/>
                  <a:gd name="connsiteY42-1176" fmla="*/ 9132 h 10000"/>
                  <a:gd name="connsiteX43-1177" fmla="*/ 8306 w 10000"/>
                  <a:gd name="connsiteY43-1178" fmla="*/ 9257 h 10000"/>
                  <a:gd name="connsiteX44-1179" fmla="*/ 8710 w 10000"/>
                  <a:gd name="connsiteY44-1180" fmla="*/ 9421 h 10000"/>
                  <a:gd name="connsiteX45-1181" fmla="*/ 8952 w 10000"/>
                  <a:gd name="connsiteY45-1182" fmla="*/ 9587 h 10000"/>
                  <a:gd name="connsiteX46-1183" fmla="*/ 9274 w 10000"/>
                  <a:gd name="connsiteY46-1184" fmla="*/ 9711 h 10000"/>
                  <a:gd name="connsiteX47-1185" fmla="*/ 9597 w 10000"/>
                  <a:gd name="connsiteY47-1186" fmla="*/ 9876 h 10000"/>
                  <a:gd name="connsiteX48-1187" fmla="*/ 10000 w 10000"/>
                  <a:gd name="connsiteY48-1188" fmla="*/ 10000 h 10000"/>
                  <a:gd name="connsiteX0-1189" fmla="*/ 0 w 9839"/>
                  <a:gd name="connsiteY0-1190" fmla="*/ 0 h 9133"/>
                  <a:gd name="connsiteX1-1191" fmla="*/ 81 w 9839"/>
                  <a:gd name="connsiteY1-1192" fmla="*/ 248 h 9133"/>
                  <a:gd name="connsiteX2-1193" fmla="*/ 81 w 9839"/>
                  <a:gd name="connsiteY2-1194" fmla="*/ 414 h 9133"/>
                  <a:gd name="connsiteX3-1195" fmla="*/ 162 w 9839"/>
                  <a:gd name="connsiteY3-1196" fmla="*/ 661 h 9133"/>
                  <a:gd name="connsiteX4-1197" fmla="*/ 162 w 9839"/>
                  <a:gd name="connsiteY4-1198" fmla="*/ 909 h 9133"/>
                  <a:gd name="connsiteX5-1199" fmla="*/ 323 w 9839"/>
                  <a:gd name="connsiteY5-1200" fmla="*/ 1116 h 9133"/>
                  <a:gd name="connsiteX6-1201" fmla="*/ 404 w 9839"/>
                  <a:gd name="connsiteY6-1202" fmla="*/ 1322 h 9133"/>
                  <a:gd name="connsiteX7-1203" fmla="*/ 565 w 9839"/>
                  <a:gd name="connsiteY7-1204" fmla="*/ 1571 h 9133"/>
                  <a:gd name="connsiteX8-1205" fmla="*/ 645 w 9839"/>
                  <a:gd name="connsiteY8-1206" fmla="*/ 1778 h 9133"/>
                  <a:gd name="connsiteX9-1207" fmla="*/ 807 w 9839"/>
                  <a:gd name="connsiteY9-1208" fmla="*/ 2026 h 9133"/>
                  <a:gd name="connsiteX10-1209" fmla="*/ 887 w 9839"/>
                  <a:gd name="connsiteY10-1210" fmla="*/ 2190 h 9133"/>
                  <a:gd name="connsiteX11-1211" fmla="*/ 1049 w 9839"/>
                  <a:gd name="connsiteY11-1212" fmla="*/ 2439 h 9133"/>
                  <a:gd name="connsiteX12-1213" fmla="*/ 1129 w 9839"/>
                  <a:gd name="connsiteY12-1214" fmla="*/ 2687 h 9133"/>
                  <a:gd name="connsiteX13-1215" fmla="*/ 1210 w 9839"/>
                  <a:gd name="connsiteY13-1216" fmla="*/ 2852 h 9133"/>
                  <a:gd name="connsiteX14-1217" fmla="*/ 1452 w 9839"/>
                  <a:gd name="connsiteY14-1218" fmla="*/ 3100 h 9133"/>
                  <a:gd name="connsiteX15-1219" fmla="*/ 1613 w 9839"/>
                  <a:gd name="connsiteY15-1220" fmla="*/ 3348 h 9133"/>
                  <a:gd name="connsiteX16-1221" fmla="*/ 1855 w 9839"/>
                  <a:gd name="connsiteY16-1222" fmla="*/ 3513 h 9133"/>
                  <a:gd name="connsiteX17-1223" fmla="*/ 1936 w 9839"/>
                  <a:gd name="connsiteY17-1224" fmla="*/ 3761 h 9133"/>
                  <a:gd name="connsiteX18-1225" fmla="*/ 2178 w 9839"/>
                  <a:gd name="connsiteY18-1226" fmla="*/ 3927 h 9133"/>
                  <a:gd name="connsiteX19-1227" fmla="*/ 2258 w 9839"/>
                  <a:gd name="connsiteY19-1228" fmla="*/ 4174 h 9133"/>
                  <a:gd name="connsiteX20-1229" fmla="*/ 2500 w 9839"/>
                  <a:gd name="connsiteY20-1230" fmla="*/ 4340 h 9133"/>
                  <a:gd name="connsiteX21-1231" fmla="*/ 2662 w 9839"/>
                  <a:gd name="connsiteY21-1232" fmla="*/ 4588 h 9133"/>
                  <a:gd name="connsiteX22-1233" fmla="*/ 2823 w 9839"/>
                  <a:gd name="connsiteY22-1234" fmla="*/ 4752 h 9133"/>
                  <a:gd name="connsiteX23-1235" fmla="*/ 3065 w 9839"/>
                  <a:gd name="connsiteY23-1236" fmla="*/ 4918 h 9133"/>
                  <a:gd name="connsiteX24-1237" fmla="*/ 3307 w 9839"/>
                  <a:gd name="connsiteY24-1238" fmla="*/ 5166 h 9133"/>
                  <a:gd name="connsiteX25-1239" fmla="*/ 3549 w 9839"/>
                  <a:gd name="connsiteY25-1240" fmla="*/ 5331 h 9133"/>
                  <a:gd name="connsiteX26-1241" fmla="*/ 3791 w 9839"/>
                  <a:gd name="connsiteY26-1242" fmla="*/ 5538 h 9133"/>
                  <a:gd name="connsiteX27-1243" fmla="*/ 4033 w 9839"/>
                  <a:gd name="connsiteY27-1244" fmla="*/ 5744 h 9133"/>
                  <a:gd name="connsiteX28-1245" fmla="*/ 4274 w 9839"/>
                  <a:gd name="connsiteY28-1246" fmla="*/ 5951 h 9133"/>
                  <a:gd name="connsiteX29-1247" fmla="*/ 4516 w 9839"/>
                  <a:gd name="connsiteY29-1248" fmla="*/ 6117 h 9133"/>
                  <a:gd name="connsiteX30-1249" fmla="*/ 4678 w 9839"/>
                  <a:gd name="connsiteY30-1250" fmla="*/ 6282 h 9133"/>
                  <a:gd name="connsiteX31-1251" fmla="*/ 4920 w 9839"/>
                  <a:gd name="connsiteY31-1252" fmla="*/ 6489 h 9133"/>
                  <a:gd name="connsiteX32-1253" fmla="*/ 5323 w 9839"/>
                  <a:gd name="connsiteY32-1254" fmla="*/ 6653 h 9133"/>
                  <a:gd name="connsiteX33-1255" fmla="*/ 5484 w 9839"/>
                  <a:gd name="connsiteY33-1256" fmla="*/ 6902 h 9133"/>
                  <a:gd name="connsiteX34-1257" fmla="*/ 5726 w 9839"/>
                  <a:gd name="connsiteY34-1258" fmla="*/ 7067 h 9133"/>
                  <a:gd name="connsiteX35-1259" fmla="*/ 6129 w 9839"/>
                  <a:gd name="connsiteY35-1260" fmla="*/ 7232 h 9133"/>
                  <a:gd name="connsiteX36-1261" fmla="*/ 6371 w 9839"/>
                  <a:gd name="connsiteY36-1262" fmla="*/ 7356 h 9133"/>
                  <a:gd name="connsiteX37-1263" fmla="*/ 6694 w 9839"/>
                  <a:gd name="connsiteY37-1264" fmla="*/ 7521 h 9133"/>
                  <a:gd name="connsiteX38-1265" fmla="*/ 6936 w 9839"/>
                  <a:gd name="connsiteY38-1266" fmla="*/ 7728 h 9133"/>
                  <a:gd name="connsiteX39-1267" fmla="*/ 7258 w 9839"/>
                  <a:gd name="connsiteY39-1268" fmla="*/ 7893 h 9133"/>
                  <a:gd name="connsiteX40-1269" fmla="*/ 7500 w 9839"/>
                  <a:gd name="connsiteY40-1270" fmla="*/ 8059 h 9133"/>
                  <a:gd name="connsiteX41-1271" fmla="*/ 7823 w 9839"/>
                  <a:gd name="connsiteY41-1272" fmla="*/ 8265 h 9133"/>
                  <a:gd name="connsiteX42-1273" fmla="*/ 8145 w 9839"/>
                  <a:gd name="connsiteY42-1274" fmla="*/ 8390 h 9133"/>
                  <a:gd name="connsiteX43-1275" fmla="*/ 8549 w 9839"/>
                  <a:gd name="connsiteY43-1276" fmla="*/ 8554 h 9133"/>
                  <a:gd name="connsiteX44-1277" fmla="*/ 8791 w 9839"/>
                  <a:gd name="connsiteY44-1278" fmla="*/ 8720 h 9133"/>
                  <a:gd name="connsiteX45-1279" fmla="*/ 9113 w 9839"/>
                  <a:gd name="connsiteY45-1280" fmla="*/ 8844 h 9133"/>
                  <a:gd name="connsiteX46-1281" fmla="*/ 9436 w 9839"/>
                  <a:gd name="connsiteY46-1282" fmla="*/ 9009 h 9133"/>
                  <a:gd name="connsiteX47-1283" fmla="*/ 9839 w 9839"/>
                  <a:gd name="connsiteY47-1284" fmla="*/ 9133 h 9133"/>
                </a:gdLst>
                <a:ahLst/>
                <a:cxnLst>
                  <a:cxn ang="0">
                    <a:pos x="connsiteX0-1" y="connsiteY0-2"/>
                  </a:cxn>
                  <a:cxn ang="0">
                    <a:pos x="connsiteX1-3" y="connsiteY1-4"/>
                  </a:cxn>
                  <a:cxn ang="0">
                    <a:pos x="connsiteX2-5" y="connsiteY2-6"/>
                  </a:cxn>
                  <a:cxn ang="0">
                    <a:pos x="connsiteX3-7" y="connsiteY3-8"/>
                  </a:cxn>
                  <a:cxn ang="0">
                    <a:pos x="connsiteX4-9" y="connsiteY4-10"/>
                  </a:cxn>
                  <a:cxn ang="0">
                    <a:pos x="connsiteX5-11" y="connsiteY5-12"/>
                  </a:cxn>
                  <a:cxn ang="0">
                    <a:pos x="connsiteX6-13" y="connsiteY6-14"/>
                  </a:cxn>
                  <a:cxn ang="0">
                    <a:pos x="connsiteX7-15" y="connsiteY7-16"/>
                  </a:cxn>
                  <a:cxn ang="0">
                    <a:pos x="connsiteX8-17" y="connsiteY8-18"/>
                  </a:cxn>
                  <a:cxn ang="0">
                    <a:pos x="connsiteX9-19" y="connsiteY9-20"/>
                  </a:cxn>
                  <a:cxn ang="0">
                    <a:pos x="connsiteX10-21" y="connsiteY10-22"/>
                  </a:cxn>
                  <a:cxn ang="0">
                    <a:pos x="connsiteX11-23" y="connsiteY11-24"/>
                  </a:cxn>
                  <a:cxn ang="0">
                    <a:pos x="connsiteX12-25" y="connsiteY12-26"/>
                  </a:cxn>
                  <a:cxn ang="0">
                    <a:pos x="connsiteX13-27" y="connsiteY13-28"/>
                  </a:cxn>
                  <a:cxn ang="0">
                    <a:pos x="connsiteX14-29" y="connsiteY14-30"/>
                  </a:cxn>
                  <a:cxn ang="0">
                    <a:pos x="connsiteX15-31" y="connsiteY15-32"/>
                  </a:cxn>
                  <a:cxn ang="0">
                    <a:pos x="connsiteX16-33" y="connsiteY16-34"/>
                  </a:cxn>
                  <a:cxn ang="0">
                    <a:pos x="connsiteX17-35" y="connsiteY17-36"/>
                  </a:cxn>
                  <a:cxn ang="0">
                    <a:pos x="connsiteX18-37" y="connsiteY18-38"/>
                  </a:cxn>
                  <a:cxn ang="0">
                    <a:pos x="connsiteX19-39" y="connsiteY19-40"/>
                  </a:cxn>
                  <a:cxn ang="0">
                    <a:pos x="connsiteX20-41" y="connsiteY20-42"/>
                  </a:cxn>
                  <a:cxn ang="0">
                    <a:pos x="connsiteX21-43" y="connsiteY21-44"/>
                  </a:cxn>
                  <a:cxn ang="0">
                    <a:pos x="connsiteX22-45" y="connsiteY22-46"/>
                  </a:cxn>
                  <a:cxn ang="0">
                    <a:pos x="connsiteX23-47" y="connsiteY23-48"/>
                  </a:cxn>
                  <a:cxn ang="0">
                    <a:pos x="connsiteX24-49" y="connsiteY24-50"/>
                  </a:cxn>
                  <a:cxn ang="0">
                    <a:pos x="connsiteX25-51" y="connsiteY25-52"/>
                  </a:cxn>
                  <a:cxn ang="0">
                    <a:pos x="connsiteX26-53" y="connsiteY26-54"/>
                  </a:cxn>
                  <a:cxn ang="0">
                    <a:pos x="connsiteX27-55" y="connsiteY27-56"/>
                  </a:cxn>
                  <a:cxn ang="0">
                    <a:pos x="connsiteX28-57" y="connsiteY28-58"/>
                  </a:cxn>
                  <a:cxn ang="0">
                    <a:pos x="connsiteX29-59" y="connsiteY29-60"/>
                  </a:cxn>
                  <a:cxn ang="0">
                    <a:pos x="connsiteX30-61" y="connsiteY30-62"/>
                  </a:cxn>
                  <a:cxn ang="0">
                    <a:pos x="connsiteX31-63" y="connsiteY31-64"/>
                  </a:cxn>
                  <a:cxn ang="0">
                    <a:pos x="connsiteX32-65" y="connsiteY32-66"/>
                  </a:cxn>
                  <a:cxn ang="0">
                    <a:pos x="connsiteX33-67" y="connsiteY33-68"/>
                  </a:cxn>
                  <a:cxn ang="0">
                    <a:pos x="connsiteX34-69" y="connsiteY34-70"/>
                  </a:cxn>
                  <a:cxn ang="0">
                    <a:pos x="connsiteX35-71" y="connsiteY35-72"/>
                  </a:cxn>
                  <a:cxn ang="0">
                    <a:pos x="connsiteX36-73" y="connsiteY36-74"/>
                  </a:cxn>
                  <a:cxn ang="0">
                    <a:pos x="connsiteX37-75" y="connsiteY37-76"/>
                  </a:cxn>
                  <a:cxn ang="0">
                    <a:pos x="connsiteX38-77" y="connsiteY38-78"/>
                  </a:cxn>
                  <a:cxn ang="0">
                    <a:pos x="connsiteX39-79" y="connsiteY39-80"/>
                  </a:cxn>
                  <a:cxn ang="0">
                    <a:pos x="connsiteX40-81" y="connsiteY40-82"/>
                  </a:cxn>
                  <a:cxn ang="0">
                    <a:pos x="connsiteX41-83" y="connsiteY41-84"/>
                  </a:cxn>
                  <a:cxn ang="0">
                    <a:pos x="connsiteX42-85" y="connsiteY42-86"/>
                  </a:cxn>
                  <a:cxn ang="0">
                    <a:pos x="connsiteX43-87" y="connsiteY43-88"/>
                  </a:cxn>
                  <a:cxn ang="0">
                    <a:pos x="connsiteX44-89" y="connsiteY44-90"/>
                  </a:cxn>
                  <a:cxn ang="0">
                    <a:pos x="connsiteX45-91" y="connsiteY45-92"/>
                  </a:cxn>
                  <a:cxn ang="0">
                    <a:pos x="connsiteX46-93" y="connsiteY46-94"/>
                  </a:cxn>
                  <a:cxn ang="0">
                    <a:pos x="connsiteX47-95" y="connsiteY47-96"/>
                  </a:cxn>
                </a:cxnLst>
                <a:rect l="l" t="t" r="r" b="b"/>
                <a:pathLst>
                  <a:path w="9839" h="9133">
                    <a:moveTo>
                      <a:pt x="0" y="0"/>
                    </a:moveTo>
                    <a:cubicBezTo>
                      <a:pt x="28" y="82"/>
                      <a:pt x="54" y="166"/>
                      <a:pt x="81" y="248"/>
                    </a:cubicBezTo>
                    <a:lnTo>
                      <a:pt x="81" y="414"/>
                    </a:lnTo>
                    <a:cubicBezTo>
                      <a:pt x="108" y="497"/>
                      <a:pt x="134" y="579"/>
                      <a:pt x="162" y="661"/>
                    </a:cubicBezTo>
                    <a:lnTo>
                      <a:pt x="162" y="909"/>
                    </a:lnTo>
                    <a:lnTo>
                      <a:pt x="323" y="1116"/>
                    </a:lnTo>
                    <a:cubicBezTo>
                      <a:pt x="350" y="1186"/>
                      <a:pt x="376" y="1253"/>
                      <a:pt x="404" y="1322"/>
                    </a:cubicBezTo>
                    <a:lnTo>
                      <a:pt x="565" y="1571"/>
                    </a:lnTo>
                    <a:cubicBezTo>
                      <a:pt x="592" y="1640"/>
                      <a:pt x="618" y="1708"/>
                      <a:pt x="645" y="1778"/>
                    </a:cubicBezTo>
                    <a:lnTo>
                      <a:pt x="807" y="2026"/>
                    </a:lnTo>
                    <a:cubicBezTo>
                      <a:pt x="834" y="2080"/>
                      <a:pt x="860" y="2136"/>
                      <a:pt x="887" y="2190"/>
                    </a:cubicBezTo>
                    <a:lnTo>
                      <a:pt x="1049" y="2439"/>
                    </a:lnTo>
                    <a:cubicBezTo>
                      <a:pt x="1076" y="2521"/>
                      <a:pt x="1102" y="2604"/>
                      <a:pt x="1129" y="2687"/>
                    </a:cubicBezTo>
                    <a:cubicBezTo>
                      <a:pt x="1157" y="2741"/>
                      <a:pt x="1183" y="2797"/>
                      <a:pt x="1210" y="2852"/>
                    </a:cubicBezTo>
                    <a:lnTo>
                      <a:pt x="1452" y="3100"/>
                    </a:lnTo>
                    <a:cubicBezTo>
                      <a:pt x="1505" y="3183"/>
                      <a:pt x="1560" y="3265"/>
                      <a:pt x="1613" y="3348"/>
                    </a:cubicBezTo>
                    <a:lnTo>
                      <a:pt x="1855" y="3513"/>
                    </a:lnTo>
                    <a:cubicBezTo>
                      <a:pt x="1882" y="3595"/>
                      <a:pt x="1909" y="3678"/>
                      <a:pt x="1936" y="3761"/>
                    </a:cubicBezTo>
                    <a:lnTo>
                      <a:pt x="2178" y="3927"/>
                    </a:lnTo>
                    <a:cubicBezTo>
                      <a:pt x="2205" y="4009"/>
                      <a:pt x="2231" y="4091"/>
                      <a:pt x="2258" y="4174"/>
                    </a:cubicBezTo>
                    <a:lnTo>
                      <a:pt x="2500" y="4340"/>
                    </a:lnTo>
                    <a:lnTo>
                      <a:pt x="2662" y="4588"/>
                    </a:lnTo>
                    <a:lnTo>
                      <a:pt x="2823" y="4752"/>
                    </a:lnTo>
                    <a:lnTo>
                      <a:pt x="3065" y="4918"/>
                    </a:lnTo>
                    <a:lnTo>
                      <a:pt x="3307" y="5166"/>
                    </a:lnTo>
                    <a:lnTo>
                      <a:pt x="3549" y="5331"/>
                    </a:lnTo>
                    <a:lnTo>
                      <a:pt x="3791" y="5538"/>
                    </a:lnTo>
                    <a:lnTo>
                      <a:pt x="4033" y="5744"/>
                    </a:lnTo>
                    <a:lnTo>
                      <a:pt x="4274" y="5951"/>
                    </a:lnTo>
                    <a:lnTo>
                      <a:pt x="4516" y="6117"/>
                    </a:lnTo>
                    <a:lnTo>
                      <a:pt x="4678" y="6282"/>
                    </a:lnTo>
                    <a:lnTo>
                      <a:pt x="4920" y="6489"/>
                    </a:lnTo>
                    <a:lnTo>
                      <a:pt x="5323" y="6653"/>
                    </a:lnTo>
                    <a:lnTo>
                      <a:pt x="5484" y="6902"/>
                    </a:lnTo>
                    <a:lnTo>
                      <a:pt x="5726" y="7067"/>
                    </a:lnTo>
                    <a:lnTo>
                      <a:pt x="6129" y="7232"/>
                    </a:lnTo>
                    <a:lnTo>
                      <a:pt x="6371" y="7356"/>
                    </a:lnTo>
                    <a:lnTo>
                      <a:pt x="6694" y="7521"/>
                    </a:lnTo>
                    <a:lnTo>
                      <a:pt x="6936" y="7728"/>
                    </a:lnTo>
                    <a:lnTo>
                      <a:pt x="7258" y="7893"/>
                    </a:lnTo>
                    <a:lnTo>
                      <a:pt x="7500" y="8059"/>
                    </a:lnTo>
                    <a:lnTo>
                      <a:pt x="7823" y="8265"/>
                    </a:lnTo>
                    <a:lnTo>
                      <a:pt x="8145" y="8390"/>
                    </a:lnTo>
                    <a:lnTo>
                      <a:pt x="8549" y="8554"/>
                    </a:lnTo>
                    <a:lnTo>
                      <a:pt x="8791" y="8720"/>
                    </a:lnTo>
                    <a:lnTo>
                      <a:pt x="9113" y="8844"/>
                    </a:lnTo>
                    <a:lnTo>
                      <a:pt x="9436" y="9009"/>
                    </a:lnTo>
                    <a:lnTo>
                      <a:pt x="9839" y="9133"/>
                    </a:lnTo>
                  </a:path>
                </a:pathLst>
              </a:custGeom>
              <a:solidFill>
                <a:srgbClr val="FFFFFF"/>
              </a:solidFill>
              <a:ln w="9525" cap="sq">
                <a:solidFill>
                  <a:srgbClr val="C00000"/>
                </a:solidFill>
                <a:prstDash val="solid"/>
                <a:miter lim="800000"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" name="Freeform 415"/>
              <p:cNvSpPr/>
              <p:nvPr/>
            </p:nvSpPr>
            <p:spPr bwMode="auto">
              <a:xfrm>
                <a:off x="3457" y="1824"/>
                <a:ext cx="168" cy="331"/>
              </a:xfrm>
              <a:custGeom>
                <a:avLst/>
                <a:gdLst>
                  <a:gd name="T0" fmla="*/ 0 w 168"/>
                  <a:gd name="T1" fmla="*/ 265 h 269"/>
                  <a:gd name="T2" fmla="*/ 0 w 168"/>
                  <a:gd name="T3" fmla="*/ 259 h 269"/>
                  <a:gd name="T4" fmla="*/ 2 w 168"/>
                  <a:gd name="T5" fmla="*/ 254 h 269"/>
                  <a:gd name="T6" fmla="*/ 2 w 168"/>
                  <a:gd name="T7" fmla="*/ 248 h 269"/>
                  <a:gd name="T8" fmla="*/ 3 w 168"/>
                  <a:gd name="T9" fmla="*/ 241 h 269"/>
                  <a:gd name="T10" fmla="*/ 4 w 168"/>
                  <a:gd name="T11" fmla="*/ 235 h 269"/>
                  <a:gd name="T12" fmla="*/ 6 w 168"/>
                  <a:gd name="T13" fmla="*/ 229 h 269"/>
                  <a:gd name="T14" fmla="*/ 6 w 168"/>
                  <a:gd name="T15" fmla="*/ 224 h 269"/>
                  <a:gd name="T16" fmla="*/ 7 w 168"/>
                  <a:gd name="T17" fmla="*/ 218 h 269"/>
                  <a:gd name="T18" fmla="*/ 9 w 168"/>
                  <a:gd name="T19" fmla="*/ 212 h 269"/>
                  <a:gd name="T20" fmla="*/ 10 w 168"/>
                  <a:gd name="T21" fmla="*/ 206 h 269"/>
                  <a:gd name="T22" fmla="*/ 13 w 168"/>
                  <a:gd name="T23" fmla="*/ 201 h 269"/>
                  <a:gd name="T24" fmla="*/ 15 w 168"/>
                  <a:gd name="T25" fmla="*/ 195 h 269"/>
                  <a:gd name="T26" fmla="*/ 16 w 168"/>
                  <a:gd name="T27" fmla="*/ 189 h 269"/>
                  <a:gd name="T28" fmla="*/ 17 w 168"/>
                  <a:gd name="T29" fmla="*/ 183 h 269"/>
                  <a:gd name="T30" fmla="*/ 20 w 168"/>
                  <a:gd name="T31" fmla="*/ 178 h 269"/>
                  <a:gd name="T32" fmla="*/ 22 w 168"/>
                  <a:gd name="T33" fmla="*/ 172 h 269"/>
                  <a:gd name="T34" fmla="*/ 25 w 168"/>
                  <a:gd name="T35" fmla="*/ 168 h 269"/>
                  <a:gd name="T36" fmla="*/ 26 w 168"/>
                  <a:gd name="T37" fmla="*/ 162 h 269"/>
                  <a:gd name="T38" fmla="*/ 29 w 168"/>
                  <a:gd name="T39" fmla="*/ 156 h 269"/>
                  <a:gd name="T40" fmla="*/ 32 w 168"/>
                  <a:gd name="T41" fmla="*/ 150 h 269"/>
                  <a:gd name="T42" fmla="*/ 33 w 168"/>
                  <a:gd name="T43" fmla="*/ 145 h 269"/>
                  <a:gd name="T44" fmla="*/ 36 w 168"/>
                  <a:gd name="T45" fmla="*/ 140 h 269"/>
                  <a:gd name="T46" fmla="*/ 39 w 168"/>
                  <a:gd name="T47" fmla="*/ 135 h 269"/>
                  <a:gd name="T48" fmla="*/ 42 w 168"/>
                  <a:gd name="T49" fmla="*/ 129 h 269"/>
                  <a:gd name="T50" fmla="*/ 45 w 168"/>
                  <a:gd name="T51" fmla="*/ 125 h 269"/>
                  <a:gd name="T52" fmla="*/ 48 w 168"/>
                  <a:gd name="T53" fmla="*/ 119 h 269"/>
                  <a:gd name="T54" fmla="*/ 52 w 168"/>
                  <a:gd name="T55" fmla="*/ 115 h 269"/>
                  <a:gd name="T56" fmla="*/ 55 w 168"/>
                  <a:gd name="T57" fmla="*/ 109 h 269"/>
                  <a:gd name="T58" fmla="*/ 58 w 168"/>
                  <a:gd name="T59" fmla="*/ 104 h 269"/>
                  <a:gd name="T60" fmla="*/ 60 w 168"/>
                  <a:gd name="T61" fmla="*/ 99 h 269"/>
                  <a:gd name="T62" fmla="*/ 65 w 168"/>
                  <a:gd name="T63" fmla="*/ 94 h 269"/>
                  <a:gd name="T64" fmla="*/ 68 w 168"/>
                  <a:gd name="T65" fmla="*/ 90 h 269"/>
                  <a:gd name="T66" fmla="*/ 72 w 168"/>
                  <a:gd name="T67" fmla="*/ 84 h 269"/>
                  <a:gd name="T68" fmla="*/ 75 w 168"/>
                  <a:gd name="T69" fmla="*/ 80 h 269"/>
                  <a:gd name="T70" fmla="*/ 79 w 168"/>
                  <a:gd name="T71" fmla="*/ 76 h 269"/>
                  <a:gd name="T72" fmla="*/ 83 w 168"/>
                  <a:gd name="T73" fmla="*/ 71 h 269"/>
                  <a:gd name="T74" fmla="*/ 86 w 168"/>
                  <a:gd name="T75" fmla="*/ 67 h 269"/>
                  <a:gd name="T76" fmla="*/ 91 w 168"/>
                  <a:gd name="T77" fmla="*/ 63 h 269"/>
                  <a:gd name="T78" fmla="*/ 95 w 168"/>
                  <a:gd name="T79" fmla="*/ 59 h 269"/>
                  <a:gd name="T80" fmla="*/ 99 w 168"/>
                  <a:gd name="T81" fmla="*/ 54 h 269"/>
                  <a:gd name="T82" fmla="*/ 103 w 168"/>
                  <a:gd name="T83" fmla="*/ 50 h 269"/>
                  <a:gd name="T84" fmla="*/ 108 w 168"/>
                  <a:gd name="T85" fmla="*/ 46 h 269"/>
                  <a:gd name="T86" fmla="*/ 112 w 168"/>
                  <a:gd name="T87" fmla="*/ 41 h 269"/>
                  <a:gd name="T88" fmla="*/ 116 w 168"/>
                  <a:gd name="T89" fmla="*/ 37 h 269"/>
                  <a:gd name="T90" fmla="*/ 121 w 168"/>
                  <a:gd name="T91" fmla="*/ 34 h 269"/>
                  <a:gd name="T92" fmla="*/ 126 w 168"/>
                  <a:gd name="T93" fmla="*/ 30 h 269"/>
                  <a:gd name="T94" fmla="*/ 131 w 168"/>
                  <a:gd name="T95" fmla="*/ 26 h 269"/>
                  <a:gd name="T96" fmla="*/ 135 w 168"/>
                  <a:gd name="T97" fmla="*/ 23 h 269"/>
                  <a:gd name="T98" fmla="*/ 139 w 168"/>
                  <a:gd name="T99" fmla="*/ 18 h 269"/>
                  <a:gd name="T100" fmla="*/ 145 w 168"/>
                  <a:gd name="T101" fmla="*/ 16 h 269"/>
                  <a:gd name="T102" fmla="*/ 149 w 168"/>
                  <a:gd name="T103" fmla="*/ 11 h 269"/>
                  <a:gd name="T104" fmla="*/ 155 w 168"/>
                  <a:gd name="T105" fmla="*/ 8 h 269"/>
                  <a:gd name="T106" fmla="*/ 159 w 168"/>
                  <a:gd name="T107" fmla="*/ 5 h 269"/>
                  <a:gd name="T108" fmla="*/ 165 w 168"/>
                  <a:gd name="T109" fmla="*/ 3 h 269"/>
                  <a:gd name="connsiteX0" fmla="*/ 0 w 10000"/>
                  <a:gd name="connsiteY0" fmla="*/ 10000 h 10000"/>
                  <a:gd name="connsiteX1" fmla="*/ 0 w 10000"/>
                  <a:gd name="connsiteY1" fmla="*/ 9963 h 10000"/>
                  <a:gd name="connsiteX2" fmla="*/ 0 w 10000"/>
                  <a:gd name="connsiteY2" fmla="*/ 9926 h 10000"/>
                  <a:gd name="connsiteX3" fmla="*/ 0 w 10000"/>
                  <a:gd name="connsiteY3" fmla="*/ 9851 h 10000"/>
                  <a:gd name="connsiteX4" fmla="*/ 0 w 10000"/>
                  <a:gd name="connsiteY4" fmla="*/ 9814 h 10000"/>
                  <a:gd name="connsiteX5" fmla="*/ 0 w 10000"/>
                  <a:gd name="connsiteY5" fmla="*/ 9740 h 10000"/>
                  <a:gd name="connsiteX6" fmla="*/ 0 w 10000"/>
                  <a:gd name="connsiteY6" fmla="*/ 9703 h 10000"/>
                  <a:gd name="connsiteX7" fmla="*/ 0 w 10000"/>
                  <a:gd name="connsiteY7" fmla="*/ 9628 h 10000"/>
                  <a:gd name="connsiteX8" fmla="*/ 119 w 10000"/>
                  <a:gd name="connsiteY8" fmla="*/ 9591 h 10000"/>
                  <a:gd name="connsiteX9" fmla="*/ 119 w 10000"/>
                  <a:gd name="connsiteY9" fmla="*/ 9554 h 10000"/>
                  <a:gd name="connsiteX10" fmla="*/ 119 w 10000"/>
                  <a:gd name="connsiteY10" fmla="*/ 9480 h 10000"/>
                  <a:gd name="connsiteX11" fmla="*/ 119 w 10000"/>
                  <a:gd name="connsiteY11" fmla="*/ 9442 h 10000"/>
                  <a:gd name="connsiteX12" fmla="*/ 119 w 10000"/>
                  <a:gd name="connsiteY12" fmla="*/ 9368 h 10000"/>
                  <a:gd name="connsiteX13" fmla="*/ 23 w 10000"/>
                  <a:gd name="connsiteY13" fmla="*/ 9775 h 10000"/>
                  <a:gd name="connsiteX14" fmla="*/ 119 w 10000"/>
                  <a:gd name="connsiteY14" fmla="*/ 9331 h 10000"/>
                  <a:gd name="connsiteX15" fmla="*/ 119 w 10000"/>
                  <a:gd name="connsiteY15" fmla="*/ 9257 h 10000"/>
                  <a:gd name="connsiteX16" fmla="*/ 119 w 10000"/>
                  <a:gd name="connsiteY16" fmla="*/ 9219 h 10000"/>
                  <a:gd name="connsiteX17" fmla="*/ 179 w 10000"/>
                  <a:gd name="connsiteY17" fmla="*/ 9182 h 10000"/>
                  <a:gd name="connsiteX18" fmla="*/ 179 w 10000"/>
                  <a:gd name="connsiteY18" fmla="*/ 9071 h 10000"/>
                  <a:gd name="connsiteX19" fmla="*/ 179 w 10000"/>
                  <a:gd name="connsiteY19" fmla="*/ 8996 h 10000"/>
                  <a:gd name="connsiteX20" fmla="*/ 179 w 10000"/>
                  <a:gd name="connsiteY20" fmla="*/ 8959 h 10000"/>
                  <a:gd name="connsiteX21" fmla="*/ 179 w 10000"/>
                  <a:gd name="connsiteY21" fmla="*/ 8885 h 10000"/>
                  <a:gd name="connsiteX22" fmla="*/ 179 w 10000"/>
                  <a:gd name="connsiteY22" fmla="*/ 8848 h 10000"/>
                  <a:gd name="connsiteX23" fmla="*/ 238 w 10000"/>
                  <a:gd name="connsiteY23" fmla="*/ 8773 h 10000"/>
                  <a:gd name="connsiteX24" fmla="*/ 238 w 10000"/>
                  <a:gd name="connsiteY24" fmla="*/ 8736 h 10000"/>
                  <a:gd name="connsiteX25" fmla="*/ 238 w 10000"/>
                  <a:gd name="connsiteY25" fmla="*/ 8699 h 10000"/>
                  <a:gd name="connsiteX26" fmla="*/ 238 w 10000"/>
                  <a:gd name="connsiteY26" fmla="*/ 8625 h 10000"/>
                  <a:gd name="connsiteX27" fmla="*/ 238 w 10000"/>
                  <a:gd name="connsiteY27" fmla="*/ 8587 h 10000"/>
                  <a:gd name="connsiteX28" fmla="*/ 357 w 10000"/>
                  <a:gd name="connsiteY28" fmla="*/ 8513 h 10000"/>
                  <a:gd name="connsiteX29" fmla="*/ 357 w 10000"/>
                  <a:gd name="connsiteY29" fmla="*/ 8476 h 10000"/>
                  <a:gd name="connsiteX30" fmla="*/ 357 w 10000"/>
                  <a:gd name="connsiteY30" fmla="*/ 8401 h 10000"/>
                  <a:gd name="connsiteX31" fmla="*/ 357 w 10000"/>
                  <a:gd name="connsiteY31" fmla="*/ 8364 h 10000"/>
                  <a:gd name="connsiteX32" fmla="*/ 357 w 10000"/>
                  <a:gd name="connsiteY32" fmla="*/ 8327 h 10000"/>
                  <a:gd name="connsiteX33" fmla="*/ 417 w 10000"/>
                  <a:gd name="connsiteY33" fmla="*/ 8253 h 10000"/>
                  <a:gd name="connsiteX34" fmla="*/ 417 w 10000"/>
                  <a:gd name="connsiteY34" fmla="*/ 8216 h 10000"/>
                  <a:gd name="connsiteX35" fmla="*/ 417 w 10000"/>
                  <a:gd name="connsiteY35" fmla="*/ 8141 h 10000"/>
                  <a:gd name="connsiteX36" fmla="*/ 417 w 10000"/>
                  <a:gd name="connsiteY36" fmla="*/ 8104 h 10000"/>
                  <a:gd name="connsiteX37" fmla="*/ 536 w 10000"/>
                  <a:gd name="connsiteY37" fmla="*/ 8030 h 10000"/>
                  <a:gd name="connsiteX38" fmla="*/ 536 w 10000"/>
                  <a:gd name="connsiteY38" fmla="*/ 7993 h 10000"/>
                  <a:gd name="connsiteX39" fmla="*/ 536 w 10000"/>
                  <a:gd name="connsiteY39" fmla="*/ 7955 h 10000"/>
                  <a:gd name="connsiteX40" fmla="*/ 536 w 10000"/>
                  <a:gd name="connsiteY40" fmla="*/ 7881 h 10000"/>
                  <a:gd name="connsiteX41" fmla="*/ 595 w 10000"/>
                  <a:gd name="connsiteY41" fmla="*/ 7844 h 10000"/>
                  <a:gd name="connsiteX42" fmla="*/ 595 w 10000"/>
                  <a:gd name="connsiteY42" fmla="*/ 7770 h 10000"/>
                  <a:gd name="connsiteX43" fmla="*/ 595 w 10000"/>
                  <a:gd name="connsiteY43" fmla="*/ 7732 h 10000"/>
                  <a:gd name="connsiteX44" fmla="*/ 595 w 10000"/>
                  <a:gd name="connsiteY44" fmla="*/ 7658 h 10000"/>
                  <a:gd name="connsiteX45" fmla="*/ 714 w 10000"/>
                  <a:gd name="connsiteY45" fmla="*/ 7621 h 10000"/>
                  <a:gd name="connsiteX46" fmla="*/ 714 w 10000"/>
                  <a:gd name="connsiteY46" fmla="*/ 7546 h 10000"/>
                  <a:gd name="connsiteX47" fmla="*/ 714 w 10000"/>
                  <a:gd name="connsiteY47" fmla="*/ 7509 h 10000"/>
                  <a:gd name="connsiteX48" fmla="*/ 774 w 10000"/>
                  <a:gd name="connsiteY48" fmla="*/ 7472 h 10000"/>
                  <a:gd name="connsiteX49" fmla="*/ 774 w 10000"/>
                  <a:gd name="connsiteY49" fmla="*/ 7398 h 10000"/>
                  <a:gd name="connsiteX50" fmla="*/ 774 w 10000"/>
                  <a:gd name="connsiteY50" fmla="*/ 7361 h 10000"/>
                  <a:gd name="connsiteX51" fmla="*/ 774 w 10000"/>
                  <a:gd name="connsiteY51" fmla="*/ 7286 h 10000"/>
                  <a:gd name="connsiteX52" fmla="*/ 893 w 10000"/>
                  <a:gd name="connsiteY52" fmla="*/ 7249 h 10000"/>
                  <a:gd name="connsiteX53" fmla="*/ 893 w 10000"/>
                  <a:gd name="connsiteY53" fmla="*/ 7175 h 10000"/>
                  <a:gd name="connsiteX54" fmla="*/ 893 w 10000"/>
                  <a:gd name="connsiteY54" fmla="*/ 7138 h 10000"/>
                  <a:gd name="connsiteX55" fmla="*/ 952 w 10000"/>
                  <a:gd name="connsiteY55" fmla="*/ 7100 h 10000"/>
                  <a:gd name="connsiteX56" fmla="*/ 952 w 10000"/>
                  <a:gd name="connsiteY56" fmla="*/ 7026 h 10000"/>
                  <a:gd name="connsiteX57" fmla="*/ 952 w 10000"/>
                  <a:gd name="connsiteY57" fmla="*/ 6989 h 10000"/>
                  <a:gd name="connsiteX58" fmla="*/ 1012 w 10000"/>
                  <a:gd name="connsiteY58" fmla="*/ 6914 h 10000"/>
                  <a:gd name="connsiteX59" fmla="*/ 1012 w 10000"/>
                  <a:gd name="connsiteY59" fmla="*/ 6877 h 10000"/>
                  <a:gd name="connsiteX60" fmla="*/ 1012 w 10000"/>
                  <a:gd name="connsiteY60" fmla="*/ 6803 h 10000"/>
                  <a:gd name="connsiteX61" fmla="*/ 1131 w 10000"/>
                  <a:gd name="connsiteY61" fmla="*/ 6766 h 10000"/>
                  <a:gd name="connsiteX62" fmla="*/ 1131 w 10000"/>
                  <a:gd name="connsiteY62" fmla="*/ 6729 h 10000"/>
                  <a:gd name="connsiteX63" fmla="*/ 1131 w 10000"/>
                  <a:gd name="connsiteY63" fmla="*/ 6654 h 10000"/>
                  <a:gd name="connsiteX64" fmla="*/ 1190 w 10000"/>
                  <a:gd name="connsiteY64" fmla="*/ 6617 h 10000"/>
                  <a:gd name="connsiteX65" fmla="*/ 1190 w 10000"/>
                  <a:gd name="connsiteY65" fmla="*/ 6543 h 10000"/>
                  <a:gd name="connsiteX66" fmla="*/ 1190 w 10000"/>
                  <a:gd name="connsiteY66" fmla="*/ 6506 h 10000"/>
                  <a:gd name="connsiteX67" fmla="*/ 1310 w 10000"/>
                  <a:gd name="connsiteY67" fmla="*/ 6431 h 10000"/>
                  <a:gd name="connsiteX68" fmla="*/ 1310 w 10000"/>
                  <a:gd name="connsiteY68" fmla="*/ 6394 h 10000"/>
                  <a:gd name="connsiteX69" fmla="*/ 1369 w 10000"/>
                  <a:gd name="connsiteY69" fmla="*/ 6394 h 10000"/>
                  <a:gd name="connsiteX70" fmla="*/ 1369 w 10000"/>
                  <a:gd name="connsiteY70" fmla="*/ 6320 h 10000"/>
                  <a:gd name="connsiteX71" fmla="*/ 1369 w 10000"/>
                  <a:gd name="connsiteY71" fmla="*/ 6283 h 10000"/>
                  <a:gd name="connsiteX72" fmla="*/ 1488 w 10000"/>
                  <a:gd name="connsiteY72" fmla="*/ 6245 h 10000"/>
                  <a:gd name="connsiteX73" fmla="*/ 1488 w 10000"/>
                  <a:gd name="connsiteY73" fmla="*/ 6171 h 10000"/>
                  <a:gd name="connsiteX74" fmla="*/ 1488 w 10000"/>
                  <a:gd name="connsiteY74" fmla="*/ 6134 h 10000"/>
                  <a:gd name="connsiteX75" fmla="*/ 1548 w 10000"/>
                  <a:gd name="connsiteY75" fmla="*/ 6059 h 10000"/>
                  <a:gd name="connsiteX76" fmla="*/ 1548 w 10000"/>
                  <a:gd name="connsiteY76" fmla="*/ 6022 h 10000"/>
                  <a:gd name="connsiteX77" fmla="*/ 1607 w 10000"/>
                  <a:gd name="connsiteY77" fmla="*/ 5948 h 10000"/>
                  <a:gd name="connsiteX78" fmla="*/ 1607 w 10000"/>
                  <a:gd name="connsiteY78" fmla="*/ 5911 h 10000"/>
                  <a:gd name="connsiteX79" fmla="*/ 1726 w 10000"/>
                  <a:gd name="connsiteY79" fmla="*/ 5874 h 10000"/>
                  <a:gd name="connsiteX80" fmla="*/ 1726 w 10000"/>
                  <a:gd name="connsiteY80" fmla="*/ 5799 h 10000"/>
                  <a:gd name="connsiteX81" fmla="*/ 1726 w 10000"/>
                  <a:gd name="connsiteY81" fmla="*/ 5762 h 10000"/>
                  <a:gd name="connsiteX82" fmla="*/ 1786 w 10000"/>
                  <a:gd name="connsiteY82" fmla="*/ 5688 h 10000"/>
                  <a:gd name="connsiteX83" fmla="*/ 1786 w 10000"/>
                  <a:gd name="connsiteY83" fmla="*/ 5651 h 10000"/>
                  <a:gd name="connsiteX84" fmla="*/ 1905 w 10000"/>
                  <a:gd name="connsiteY84" fmla="*/ 5576 h 10000"/>
                  <a:gd name="connsiteX85" fmla="*/ 1905 w 10000"/>
                  <a:gd name="connsiteY85" fmla="*/ 5539 h 10000"/>
                  <a:gd name="connsiteX86" fmla="*/ 1964 w 10000"/>
                  <a:gd name="connsiteY86" fmla="*/ 5502 h 10000"/>
                  <a:gd name="connsiteX87" fmla="*/ 1964 w 10000"/>
                  <a:gd name="connsiteY87" fmla="*/ 5428 h 10000"/>
                  <a:gd name="connsiteX88" fmla="*/ 1964 w 10000"/>
                  <a:gd name="connsiteY88" fmla="*/ 5390 h 10000"/>
                  <a:gd name="connsiteX89" fmla="*/ 2083 w 10000"/>
                  <a:gd name="connsiteY89" fmla="*/ 5390 h 10000"/>
                  <a:gd name="connsiteX90" fmla="*/ 2083 w 10000"/>
                  <a:gd name="connsiteY90" fmla="*/ 5316 h 10000"/>
                  <a:gd name="connsiteX91" fmla="*/ 2143 w 10000"/>
                  <a:gd name="connsiteY91" fmla="*/ 5279 h 10000"/>
                  <a:gd name="connsiteX92" fmla="*/ 2143 w 10000"/>
                  <a:gd name="connsiteY92" fmla="*/ 5204 h 10000"/>
                  <a:gd name="connsiteX93" fmla="*/ 2202 w 10000"/>
                  <a:gd name="connsiteY93" fmla="*/ 5167 h 10000"/>
                  <a:gd name="connsiteX94" fmla="*/ 2202 w 10000"/>
                  <a:gd name="connsiteY94" fmla="*/ 5093 h 10000"/>
                  <a:gd name="connsiteX95" fmla="*/ 2321 w 10000"/>
                  <a:gd name="connsiteY95" fmla="*/ 5056 h 10000"/>
                  <a:gd name="connsiteX96" fmla="*/ 2321 w 10000"/>
                  <a:gd name="connsiteY96" fmla="*/ 5019 h 10000"/>
                  <a:gd name="connsiteX97" fmla="*/ 2381 w 10000"/>
                  <a:gd name="connsiteY97" fmla="*/ 4944 h 10000"/>
                  <a:gd name="connsiteX98" fmla="*/ 2381 w 10000"/>
                  <a:gd name="connsiteY98" fmla="*/ 4907 h 10000"/>
                  <a:gd name="connsiteX99" fmla="*/ 2500 w 10000"/>
                  <a:gd name="connsiteY99" fmla="*/ 4833 h 10000"/>
                  <a:gd name="connsiteX100" fmla="*/ 2500 w 10000"/>
                  <a:gd name="connsiteY100" fmla="*/ 4796 h 10000"/>
                  <a:gd name="connsiteX101" fmla="*/ 2560 w 10000"/>
                  <a:gd name="connsiteY101" fmla="*/ 4796 h 10000"/>
                  <a:gd name="connsiteX102" fmla="*/ 2560 w 10000"/>
                  <a:gd name="connsiteY102" fmla="*/ 4721 h 10000"/>
                  <a:gd name="connsiteX103" fmla="*/ 2679 w 10000"/>
                  <a:gd name="connsiteY103" fmla="*/ 4684 h 10000"/>
                  <a:gd name="connsiteX104" fmla="*/ 2679 w 10000"/>
                  <a:gd name="connsiteY104" fmla="*/ 4647 h 10000"/>
                  <a:gd name="connsiteX105" fmla="*/ 2738 w 10000"/>
                  <a:gd name="connsiteY105" fmla="*/ 4572 h 10000"/>
                  <a:gd name="connsiteX106" fmla="*/ 2738 w 10000"/>
                  <a:gd name="connsiteY106" fmla="*/ 4535 h 10000"/>
                  <a:gd name="connsiteX107" fmla="*/ 2857 w 10000"/>
                  <a:gd name="connsiteY107" fmla="*/ 4461 h 10000"/>
                  <a:gd name="connsiteX108" fmla="*/ 2857 w 10000"/>
                  <a:gd name="connsiteY108" fmla="*/ 4424 h 10000"/>
                  <a:gd name="connsiteX109" fmla="*/ 2917 w 10000"/>
                  <a:gd name="connsiteY109" fmla="*/ 4349 h 10000"/>
                  <a:gd name="connsiteX110" fmla="*/ 2917 w 10000"/>
                  <a:gd name="connsiteY110" fmla="*/ 4312 h 10000"/>
                  <a:gd name="connsiteX111" fmla="*/ 2976 w 10000"/>
                  <a:gd name="connsiteY111" fmla="*/ 4312 h 10000"/>
                  <a:gd name="connsiteX112" fmla="*/ 3095 w 10000"/>
                  <a:gd name="connsiteY112" fmla="*/ 4275 h 10000"/>
                  <a:gd name="connsiteX113" fmla="*/ 3095 w 10000"/>
                  <a:gd name="connsiteY113" fmla="*/ 4201 h 10000"/>
                  <a:gd name="connsiteX114" fmla="*/ 3155 w 10000"/>
                  <a:gd name="connsiteY114" fmla="*/ 4164 h 10000"/>
                  <a:gd name="connsiteX115" fmla="*/ 3155 w 10000"/>
                  <a:gd name="connsiteY115" fmla="*/ 4089 h 10000"/>
                  <a:gd name="connsiteX116" fmla="*/ 3274 w 10000"/>
                  <a:gd name="connsiteY116" fmla="*/ 4052 h 10000"/>
                  <a:gd name="connsiteX117" fmla="*/ 3274 w 10000"/>
                  <a:gd name="connsiteY117" fmla="*/ 3978 h 10000"/>
                  <a:gd name="connsiteX118" fmla="*/ 3333 w 10000"/>
                  <a:gd name="connsiteY118" fmla="*/ 3941 h 10000"/>
                  <a:gd name="connsiteX119" fmla="*/ 3333 w 10000"/>
                  <a:gd name="connsiteY119" fmla="*/ 3941 h 10000"/>
                  <a:gd name="connsiteX120" fmla="*/ 3452 w 10000"/>
                  <a:gd name="connsiteY120" fmla="*/ 3866 h 10000"/>
                  <a:gd name="connsiteX121" fmla="*/ 3512 w 10000"/>
                  <a:gd name="connsiteY121" fmla="*/ 3829 h 10000"/>
                  <a:gd name="connsiteX122" fmla="*/ 3512 w 10000"/>
                  <a:gd name="connsiteY122" fmla="*/ 3792 h 10000"/>
                  <a:gd name="connsiteX123" fmla="*/ 3571 w 10000"/>
                  <a:gd name="connsiteY123" fmla="*/ 3717 h 10000"/>
                  <a:gd name="connsiteX124" fmla="*/ 3571 w 10000"/>
                  <a:gd name="connsiteY124" fmla="*/ 3680 h 10000"/>
                  <a:gd name="connsiteX125" fmla="*/ 3690 w 10000"/>
                  <a:gd name="connsiteY125" fmla="*/ 3606 h 10000"/>
                  <a:gd name="connsiteX126" fmla="*/ 3750 w 10000"/>
                  <a:gd name="connsiteY126" fmla="*/ 3606 h 10000"/>
                  <a:gd name="connsiteX127" fmla="*/ 3750 w 10000"/>
                  <a:gd name="connsiteY127" fmla="*/ 3569 h 10000"/>
                  <a:gd name="connsiteX128" fmla="*/ 3869 w 10000"/>
                  <a:gd name="connsiteY128" fmla="*/ 3494 h 10000"/>
                  <a:gd name="connsiteX129" fmla="*/ 3869 w 10000"/>
                  <a:gd name="connsiteY129" fmla="*/ 3457 h 10000"/>
                  <a:gd name="connsiteX130" fmla="*/ 3929 w 10000"/>
                  <a:gd name="connsiteY130" fmla="*/ 3420 h 10000"/>
                  <a:gd name="connsiteX131" fmla="*/ 4048 w 10000"/>
                  <a:gd name="connsiteY131" fmla="*/ 3346 h 10000"/>
                  <a:gd name="connsiteX132" fmla="*/ 4048 w 10000"/>
                  <a:gd name="connsiteY132" fmla="*/ 3346 h 10000"/>
                  <a:gd name="connsiteX133" fmla="*/ 4107 w 10000"/>
                  <a:gd name="connsiteY133" fmla="*/ 3309 h 10000"/>
                  <a:gd name="connsiteX134" fmla="*/ 4167 w 10000"/>
                  <a:gd name="connsiteY134" fmla="*/ 3234 h 10000"/>
                  <a:gd name="connsiteX135" fmla="*/ 4167 w 10000"/>
                  <a:gd name="connsiteY135" fmla="*/ 3197 h 10000"/>
                  <a:gd name="connsiteX136" fmla="*/ 4286 w 10000"/>
                  <a:gd name="connsiteY136" fmla="*/ 3123 h 10000"/>
                  <a:gd name="connsiteX137" fmla="*/ 4286 w 10000"/>
                  <a:gd name="connsiteY137" fmla="*/ 3086 h 10000"/>
                  <a:gd name="connsiteX138" fmla="*/ 4345 w 10000"/>
                  <a:gd name="connsiteY138" fmla="*/ 3086 h 10000"/>
                  <a:gd name="connsiteX139" fmla="*/ 4464 w 10000"/>
                  <a:gd name="connsiteY139" fmla="*/ 3048 h 10000"/>
                  <a:gd name="connsiteX140" fmla="*/ 4464 w 10000"/>
                  <a:gd name="connsiteY140" fmla="*/ 2974 h 10000"/>
                  <a:gd name="connsiteX141" fmla="*/ 4524 w 10000"/>
                  <a:gd name="connsiteY141" fmla="*/ 2937 h 10000"/>
                  <a:gd name="connsiteX142" fmla="*/ 4643 w 10000"/>
                  <a:gd name="connsiteY142" fmla="*/ 2862 h 10000"/>
                  <a:gd name="connsiteX143" fmla="*/ 4643 w 10000"/>
                  <a:gd name="connsiteY143" fmla="*/ 2862 h 10000"/>
                  <a:gd name="connsiteX144" fmla="*/ 4702 w 10000"/>
                  <a:gd name="connsiteY144" fmla="*/ 2825 h 10000"/>
                  <a:gd name="connsiteX145" fmla="*/ 4821 w 10000"/>
                  <a:gd name="connsiteY145" fmla="*/ 2751 h 10000"/>
                  <a:gd name="connsiteX146" fmla="*/ 4821 w 10000"/>
                  <a:gd name="connsiteY146" fmla="*/ 2714 h 10000"/>
                  <a:gd name="connsiteX147" fmla="*/ 4881 w 10000"/>
                  <a:gd name="connsiteY147" fmla="*/ 2639 h 10000"/>
                  <a:gd name="connsiteX148" fmla="*/ 4940 w 10000"/>
                  <a:gd name="connsiteY148" fmla="*/ 2639 h 10000"/>
                  <a:gd name="connsiteX149" fmla="*/ 4940 w 10000"/>
                  <a:gd name="connsiteY149" fmla="*/ 2602 h 10000"/>
                  <a:gd name="connsiteX150" fmla="*/ 5060 w 10000"/>
                  <a:gd name="connsiteY150" fmla="*/ 2565 h 10000"/>
                  <a:gd name="connsiteX151" fmla="*/ 5119 w 10000"/>
                  <a:gd name="connsiteY151" fmla="*/ 2491 h 10000"/>
                  <a:gd name="connsiteX152" fmla="*/ 5119 w 10000"/>
                  <a:gd name="connsiteY152" fmla="*/ 2491 h 10000"/>
                  <a:gd name="connsiteX153" fmla="*/ 5238 w 10000"/>
                  <a:gd name="connsiteY153" fmla="*/ 2454 h 10000"/>
                  <a:gd name="connsiteX154" fmla="*/ 5298 w 10000"/>
                  <a:gd name="connsiteY154" fmla="*/ 2379 h 10000"/>
                  <a:gd name="connsiteX155" fmla="*/ 5417 w 10000"/>
                  <a:gd name="connsiteY155" fmla="*/ 2342 h 10000"/>
                  <a:gd name="connsiteX156" fmla="*/ 5417 w 10000"/>
                  <a:gd name="connsiteY156" fmla="*/ 2342 h 10000"/>
                  <a:gd name="connsiteX157" fmla="*/ 5476 w 10000"/>
                  <a:gd name="connsiteY157" fmla="*/ 2268 h 10000"/>
                  <a:gd name="connsiteX158" fmla="*/ 5536 w 10000"/>
                  <a:gd name="connsiteY158" fmla="*/ 2230 h 10000"/>
                  <a:gd name="connsiteX159" fmla="*/ 5536 w 10000"/>
                  <a:gd name="connsiteY159" fmla="*/ 2193 h 10000"/>
                  <a:gd name="connsiteX160" fmla="*/ 5655 w 10000"/>
                  <a:gd name="connsiteY160" fmla="*/ 2193 h 10000"/>
                  <a:gd name="connsiteX161" fmla="*/ 5714 w 10000"/>
                  <a:gd name="connsiteY161" fmla="*/ 2119 h 10000"/>
                  <a:gd name="connsiteX162" fmla="*/ 5833 w 10000"/>
                  <a:gd name="connsiteY162" fmla="*/ 2082 h 10000"/>
                  <a:gd name="connsiteX163" fmla="*/ 5833 w 10000"/>
                  <a:gd name="connsiteY163" fmla="*/ 2007 h 10000"/>
                  <a:gd name="connsiteX164" fmla="*/ 5893 w 10000"/>
                  <a:gd name="connsiteY164" fmla="*/ 2007 h 10000"/>
                  <a:gd name="connsiteX165" fmla="*/ 6012 w 10000"/>
                  <a:gd name="connsiteY165" fmla="*/ 1970 h 10000"/>
                  <a:gd name="connsiteX166" fmla="*/ 6071 w 10000"/>
                  <a:gd name="connsiteY166" fmla="*/ 1896 h 10000"/>
                  <a:gd name="connsiteX167" fmla="*/ 6071 w 10000"/>
                  <a:gd name="connsiteY167" fmla="*/ 1859 h 10000"/>
                  <a:gd name="connsiteX168" fmla="*/ 6131 w 10000"/>
                  <a:gd name="connsiteY168" fmla="*/ 1859 h 10000"/>
                  <a:gd name="connsiteX169" fmla="*/ 6250 w 10000"/>
                  <a:gd name="connsiteY169" fmla="*/ 1822 h 10000"/>
                  <a:gd name="connsiteX170" fmla="*/ 6250 w 10000"/>
                  <a:gd name="connsiteY170" fmla="*/ 1747 h 10000"/>
                  <a:gd name="connsiteX171" fmla="*/ 6310 w 10000"/>
                  <a:gd name="connsiteY171" fmla="*/ 1710 h 10000"/>
                  <a:gd name="connsiteX172" fmla="*/ 6429 w 10000"/>
                  <a:gd name="connsiteY172" fmla="*/ 1710 h 10000"/>
                  <a:gd name="connsiteX173" fmla="*/ 6488 w 10000"/>
                  <a:gd name="connsiteY173" fmla="*/ 1636 h 10000"/>
                  <a:gd name="connsiteX174" fmla="*/ 6607 w 10000"/>
                  <a:gd name="connsiteY174" fmla="*/ 1599 h 10000"/>
                  <a:gd name="connsiteX175" fmla="*/ 6607 w 10000"/>
                  <a:gd name="connsiteY175" fmla="*/ 1599 h 10000"/>
                  <a:gd name="connsiteX176" fmla="*/ 6667 w 10000"/>
                  <a:gd name="connsiteY176" fmla="*/ 1524 h 10000"/>
                  <a:gd name="connsiteX177" fmla="*/ 6726 w 10000"/>
                  <a:gd name="connsiteY177" fmla="*/ 1487 h 10000"/>
                  <a:gd name="connsiteX178" fmla="*/ 6845 w 10000"/>
                  <a:gd name="connsiteY178" fmla="*/ 1487 h 10000"/>
                  <a:gd name="connsiteX179" fmla="*/ 6845 w 10000"/>
                  <a:gd name="connsiteY179" fmla="*/ 1413 h 10000"/>
                  <a:gd name="connsiteX180" fmla="*/ 6905 w 10000"/>
                  <a:gd name="connsiteY180" fmla="*/ 1375 h 10000"/>
                  <a:gd name="connsiteX181" fmla="*/ 7024 w 10000"/>
                  <a:gd name="connsiteY181" fmla="*/ 1375 h 10000"/>
                  <a:gd name="connsiteX182" fmla="*/ 7083 w 10000"/>
                  <a:gd name="connsiteY182" fmla="*/ 1338 h 10000"/>
                  <a:gd name="connsiteX183" fmla="*/ 7202 w 10000"/>
                  <a:gd name="connsiteY183" fmla="*/ 1264 h 10000"/>
                  <a:gd name="connsiteX184" fmla="*/ 7202 w 10000"/>
                  <a:gd name="connsiteY184" fmla="*/ 1264 h 10000"/>
                  <a:gd name="connsiteX185" fmla="*/ 7262 w 10000"/>
                  <a:gd name="connsiteY185" fmla="*/ 1227 h 10000"/>
                  <a:gd name="connsiteX186" fmla="*/ 7381 w 10000"/>
                  <a:gd name="connsiteY186" fmla="*/ 1152 h 10000"/>
                  <a:gd name="connsiteX187" fmla="*/ 7440 w 10000"/>
                  <a:gd name="connsiteY187" fmla="*/ 1152 h 10000"/>
                  <a:gd name="connsiteX188" fmla="*/ 7500 w 10000"/>
                  <a:gd name="connsiteY188" fmla="*/ 1115 h 10000"/>
                  <a:gd name="connsiteX189" fmla="*/ 7500 w 10000"/>
                  <a:gd name="connsiteY189" fmla="*/ 1041 h 10000"/>
                  <a:gd name="connsiteX190" fmla="*/ 7619 w 10000"/>
                  <a:gd name="connsiteY190" fmla="*/ 1041 h 10000"/>
                  <a:gd name="connsiteX191" fmla="*/ 7679 w 10000"/>
                  <a:gd name="connsiteY191" fmla="*/ 1004 h 10000"/>
                  <a:gd name="connsiteX192" fmla="*/ 7798 w 10000"/>
                  <a:gd name="connsiteY192" fmla="*/ 967 h 10000"/>
                  <a:gd name="connsiteX193" fmla="*/ 7857 w 10000"/>
                  <a:gd name="connsiteY193" fmla="*/ 967 h 10000"/>
                  <a:gd name="connsiteX194" fmla="*/ 7857 w 10000"/>
                  <a:gd name="connsiteY194" fmla="*/ 892 h 10000"/>
                  <a:gd name="connsiteX195" fmla="*/ 7976 w 10000"/>
                  <a:gd name="connsiteY195" fmla="*/ 855 h 10000"/>
                  <a:gd name="connsiteX196" fmla="*/ 8036 w 10000"/>
                  <a:gd name="connsiteY196" fmla="*/ 855 h 10000"/>
                  <a:gd name="connsiteX197" fmla="*/ 8095 w 10000"/>
                  <a:gd name="connsiteY197" fmla="*/ 781 h 10000"/>
                  <a:gd name="connsiteX198" fmla="*/ 8214 w 10000"/>
                  <a:gd name="connsiteY198" fmla="*/ 743 h 10000"/>
                  <a:gd name="connsiteX199" fmla="*/ 8274 w 10000"/>
                  <a:gd name="connsiteY199" fmla="*/ 743 h 10000"/>
                  <a:gd name="connsiteX200" fmla="*/ 8274 w 10000"/>
                  <a:gd name="connsiteY200" fmla="*/ 669 h 10000"/>
                  <a:gd name="connsiteX201" fmla="*/ 8393 w 10000"/>
                  <a:gd name="connsiteY201" fmla="*/ 669 h 10000"/>
                  <a:gd name="connsiteX202" fmla="*/ 8452 w 10000"/>
                  <a:gd name="connsiteY202" fmla="*/ 632 h 10000"/>
                  <a:gd name="connsiteX203" fmla="*/ 8571 w 10000"/>
                  <a:gd name="connsiteY203" fmla="*/ 595 h 10000"/>
                  <a:gd name="connsiteX204" fmla="*/ 8631 w 10000"/>
                  <a:gd name="connsiteY204" fmla="*/ 595 h 10000"/>
                  <a:gd name="connsiteX205" fmla="*/ 8690 w 10000"/>
                  <a:gd name="connsiteY205" fmla="*/ 520 h 10000"/>
                  <a:gd name="connsiteX206" fmla="*/ 8690 w 10000"/>
                  <a:gd name="connsiteY206" fmla="*/ 520 h 10000"/>
                  <a:gd name="connsiteX207" fmla="*/ 8810 w 10000"/>
                  <a:gd name="connsiteY207" fmla="*/ 483 h 10000"/>
                  <a:gd name="connsiteX208" fmla="*/ 8869 w 10000"/>
                  <a:gd name="connsiteY208" fmla="*/ 409 h 10000"/>
                  <a:gd name="connsiteX209" fmla="*/ 8988 w 10000"/>
                  <a:gd name="connsiteY209" fmla="*/ 409 h 10000"/>
                  <a:gd name="connsiteX210" fmla="*/ 9048 w 10000"/>
                  <a:gd name="connsiteY210" fmla="*/ 372 h 10000"/>
                  <a:gd name="connsiteX211" fmla="*/ 9167 w 10000"/>
                  <a:gd name="connsiteY211" fmla="*/ 372 h 10000"/>
                  <a:gd name="connsiteX212" fmla="*/ 9226 w 10000"/>
                  <a:gd name="connsiteY212" fmla="*/ 297 h 10000"/>
                  <a:gd name="connsiteX213" fmla="*/ 9226 w 10000"/>
                  <a:gd name="connsiteY213" fmla="*/ 297 h 10000"/>
                  <a:gd name="connsiteX214" fmla="*/ 9345 w 10000"/>
                  <a:gd name="connsiteY214" fmla="*/ 260 h 10000"/>
                  <a:gd name="connsiteX215" fmla="*/ 9405 w 10000"/>
                  <a:gd name="connsiteY215" fmla="*/ 186 h 10000"/>
                  <a:gd name="connsiteX216" fmla="*/ 9464 w 10000"/>
                  <a:gd name="connsiteY216" fmla="*/ 186 h 10000"/>
                  <a:gd name="connsiteX217" fmla="*/ 9583 w 10000"/>
                  <a:gd name="connsiteY217" fmla="*/ 149 h 10000"/>
                  <a:gd name="connsiteX218" fmla="*/ 9643 w 10000"/>
                  <a:gd name="connsiteY218" fmla="*/ 149 h 10000"/>
                  <a:gd name="connsiteX219" fmla="*/ 9762 w 10000"/>
                  <a:gd name="connsiteY219" fmla="*/ 112 h 10000"/>
                  <a:gd name="connsiteX220" fmla="*/ 9821 w 10000"/>
                  <a:gd name="connsiteY220" fmla="*/ 112 h 10000"/>
                  <a:gd name="connsiteX221" fmla="*/ 9940 w 10000"/>
                  <a:gd name="connsiteY221" fmla="*/ 37 h 10000"/>
                  <a:gd name="connsiteX222" fmla="*/ 9940 w 10000"/>
                  <a:gd name="connsiteY222" fmla="*/ 37 h 10000"/>
                  <a:gd name="connsiteX223" fmla="*/ 10000 w 10000"/>
                  <a:gd name="connsiteY223" fmla="*/ 0 h 10000"/>
                  <a:gd name="connsiteX0-1" fmla="*/ 0 w 10000"/>
                  <a:gd name="connsiteY0-2" fmla="*/ 10000 h 12290"/>
                  <a:gd name="connsiteX1-3" fmla="*/ 0 w 10000"/>
                  <a:gd name="connsiteY1-4" fmla="*/ 12290 h 12290"/>
                  <a:gd name="connsiteX2-5" fmla="*/ 0 w 10000"/>
                  <a:gd name="connsiteY2-6" fmla="*/ 9926 h 12290"/>
                  <a:gd name="connsiteX3-7" fmla="*/ 0 w 10000"/>
                  <a:gd name="connsiteY3-8" fmla="*/ 9851 h 12290"/>
                  <a:gd name="connsiteX4-9" fmla="*/ 0 w 10000"/>
                  <a:gd name="connsiteY4-10" fmla="*/ 9814 h 12290"/>
                  <a:gd name="connsiteX5-11" fmla="*/ 0 w 10000"/>
                  <a:gd name="connsiteY5-12" fmla="*/ 9740 h 12290"/>
                  <a:gd name="connsiteX6-13" fmla="*/ 0 w 10000"/>
                  <a:gd name="connsiteY6-14" fmla="*/ 9703 h 12290"/>
                  <a:gd name="connsiteX7-15" fmla="*/ 0 w 10000"/>
                  <a:gd name="connsiteY7-16" fmla="*/ 9628 h 12290"/>
                  <a:gd name="connsiteX8-17" fmla="*/ 119 w 10000"/>
                  <a:gd name="connsiteY8-18" fmla="*/ 9591 h 12290"/>
                  <a:gd name="connsiteX9-19" fmla="*/ 119 w 10000"/>
                  <a:gd name="connsiteY9-20" fmla="*/ 9554 h 12290"/>
                  <a:gd name="connsiteX10-21" fmla="*/ 119 w 10000"/>
                  <a:gd name="connsiteY10-22" fmla="*/ 9480 h 12290"/>
                  <a:gd name="connsiteX11-23" fmla="*/ 119 w 10000"/>
                  <a:gd name="connsiteY11-24" fmla="*/ 9442 h 12290"/>
                  <a:gd name="connsiteX12-25" fmla="*/ 119 w 10000"/>
                  <a:gd name="connsiteY12-26" fmla="*/ 9368 h 12290"/>
                  <a:gd name="connsiteX13-27" fmla="*/ 23 w 10000"/>
                  <a:gd name="connsiteY13-28" fmla="*/ 9775 h 12290"/>
                  <a:gd name="connsiteX14-29" fmla="*/ 119 w 10000"/>
                  <a:gd name="connsiteY14-30" fmla="*/ 9331 h 12290"/>
                  <a:gd name="connsiteX15-31" fmla="*/ 119 w 10000"/>
                  <a:gd name="connsiteY15-32" fmla="*/ 9257 h 12290"/>
                  <a:gd name="connsiteX16-33" fmla="*/ 119 w 10000"/>
                  <a:gd name="connsiteY16-34" fmla="*/ 9219 h 12290"/>
                  <a:gd name="connsiteX17-35" fmla="*/ 179 w 10000"/>
                  <a:gd name="connsiteY17-36" fmla="*/ 9182 h 12290"/>
                  <a:gd name="connsiteX18-37" fmla="*/ 179 w 10000"/>
                  <a:gd name="connsiteY18-38" fmla="*/ 9071 h 12290"/>
                  <a:gd name="connsiteX19-39" fmla="*/ 179 w 10000"/>
                  <a:gd name="connsiteY19-40" fmla="*/ 8996 h 12290"/>
                  <a:gd name="connsiteX20-41" fmla="*/ 179 w 10000"/>
                  <a:gd name="connsiteY20-42" fmla="*/ 8959 h 12290"/>
                  <a:gd name="connsiteX21-43" fmla="*/ 179 w 10000"/>
                  <a:gd name="connsiteY21-44" fmla="*/ 8885 h 12290"/>
                  <a:gd name="connsiteX22-45" fmla="*/ 179 w 10000"/>
                  <a:gd name="connsiteY22-46" fmla="*/ 8848 h 12290"/>
                  <a:gd name="connsiteX23-47" fmla="*/ 238 w 10000"/>
                  <a:gd name="connsiteY23-48" fmla="*/ 8773 h 12290"/>
                  <a:gd name="connsiteX24-49" fmla="*/ 238 w 10000"/>
                  <a:gd name="connsiteY24-50" fmla="*/ 8736 h 12290"/>
                  <a:gd name="connsiteX25-51" fmla="*/ 238 w 10000"/>
                  <a:gd name="connsiteY25-52" fmla="*/ 8699 h 12290"/>
                  <a:gd name="connsiteX26-53" fmla="*/ 238 w 10000"/>
                  <a:gd name="connsiteY26-54" fmla="*/ 8625 h 12290"/>
                  <a:gd name="connsiteX27-55" fmla="*/ 238 w 10000"/>
                  <a:gd name="connsiteY27-56" fmla="*/ 8587 h 12290"/>
                  <a:gd name="connsiteX28-57" fmla="*/ 357 w 10000"/>
                  <a:gd name="connsiteY28-58" fmla="*/ 8513 h 12290"/>
                  <a:gd name="connsiteX29-59" fmla="*/ 357 w 10000"/>
                  <a:gd name="connsiteY29-60" fmla="*/ 8476 h 12290"/>
                  <a:gd name="connsiteX30-61" fmla="*/ 357 w 10000"/>
                  <a:gd name="connsiteY30-62" fmla="*/ 8401 h 12290"/>
                  <a:gd name="connsiteX31-63" fmla="*/ 357 w 10000"/>
                  <a:gd name="connsiteY31-64" fmla="*/ 8364 h 12290"/>
                  <a:gd name="connsiteX32-65" fmla="*/ 357 w 10000"/>
                  <a:gd name="connsiteY32-66" fmla="*/ 8327 h 12290"/>
                  <a:gd name="connsiteX33-67" fmla="*/ 417 w 10000"/>
                  <a:gd name="connsiteY33-68" fmla="*/ 8253 h 12290"/>
                  <a:gd name="connsiteX34-69" fmla="*/ 417 w 10000"/>
                  <a:gd name="connsiteY34-70" fmla="*/ 8216 h 12290"/>
                  <a:gd name="connsiteX35-71" fmla="*/ 417 w 10000"/>
                  <a:gd name="connsiteY35-72" fmla="*/ 8141 h 12290"/>
                  <a:gd name="connsiteX36-73" fmla="*/ 417 w 10000"/>
                  <a:gd name="connsiteY36-74" fmla="*/ 8104 h 12290"/>
                  <a:gd name="connsiteX37-75" fmla="*/ 536 w 10000"/>
                  <a:gd name="connsiteY37-76" fmla="*/ 8030 h 12290"/>
                  <a:gd name="connsiteX38-77" fmla="*/ 536 w 10000"/>
                  <a:gd name="connsiteY38-78" fmla="*/ 7993 h 12290"/>
                  <a:gd name="connsiteX39-79" fmla="*/ 536 w 10000"/>
                  <a:gd name="connsiteY39-80" fmla="*/ 7955 h 12290"/>
                  <a:gd name="connsiteX40-81" fmla="*/ 536 w 10000"/>
                  <a:gd name="connsiteY40-82" fmla="*/ 7881 h 12290"/>
                  <a:gd name="connsiteX41-83" fmla="*/ 595 w 10000"/>
                  <a:gd name="connsiteY41-84" fmla="*/ 7844 h 12290"/>
                  <a:gd name="connsiteX42-85" fmla="*/ 595 w 10000"/>
                  <a:gd name="connsiteY42-86" fmla="*/ 7770 h 12290"/>
                  <a:gd name="connsiteX43-87" fmla="*/ 595 w 10000"/>
                  <a:gd name="connsiteY43-88" fmla="*/ 7732 h 12290"/>
                  <a:gd name="connsiteX44-89" fmla="*/ 595 w 10000"/>
                  <a:gd name="connsiteY44-90" fmla="*/ 7658 h 12290"/>
                  <a:gd name="connsiteX45-91" fmla="*/ 714 w 10000"/>
                  <a:gd name="connsiteY45-92" fmla="*/ 7621 h 12290"/>
                  <a:gd name="connsiteX46-93" fmla="*/ 714 w 10000"/>
                  <a:gd name="connsiteY46-94" fmla="*/ 7546 h 12290"/>
                  <a:gd name="connsiteX47-95" fmla="*/ 714 w 10000"/>
                  <a:gd name="connsiteY47-96" fmla="*/ 7509 h 12290"/>
                  <a:gd name="connsiteX48-97" fmla="*/ 774 w 10000"/>
                  <a:gd name="connsiteY48-98" fmla="*/ 7472 h 12290"/>
                  <a:gd name="connsiteX49-99" fmla="*/ 774 w 10000"/>
                  <a:gd name="connsiteY49-100" fmla="*/ 7398 h 12290"/>
                  <a:gd name="connsiteX50-101" fmla="*/ 774 w 10000"/>
                  <a:gd name="connsiteY50-102" fmla="*/ 7361 h 12290"/>
                  <a:gd name="connsiteX51-103" fmla="*/ 774 w 10000"/>
                  <a:gd name="connsiteY51-104" fmla="*/ 7286 h 12290"/>
                  <a:gd name="connsiteX52-105" fmla="*/ 893 w 10000"/>
                  <a:gd name="connsiteY52-106" fmla="*/ 7249 h 12290"/>
                  <a:gd name="connsiteX53-107" fmla="*/ 893 w 10000"/>
                  <a:gd name="connsiteY53-108" fmla="*/ 7175 h 12290"/>
                  <a:gd name="connsiteX54-109" fmla="*/ 893 w 10000"/>
                  <a:gd name="connsiteY54-110" fmla="*/ 7138 h 12290"/>
                  <a:gd name="connsiteX55-111" fmla="*/ 952 w 10000"/>
                  <a:gd name="connsiteY55-112" fmla="*/ 7100 h 12290"/>
                  <a:gd name="connsiteX56-113" fmla="*/ 952 w 10000"/>
                  <a:gd name="connsiteY56-114" fmla="*/ 7026 h 12290"/>
                  <a:gd name="connsiteX57-115" fmla="*/ 952 w 10000"/>
                  <a:gd name="connsiteY57-116" fmla="*/ 6989 h 12290"/>
                  <a:gd name="connsiteX58-117" fmla="*/ 1012 w 10000"/>
                  <a:gd name="connsiteY58-118" fmla="*/ 6914 h 12290"/>
                  <a:gd name="connsiteX59-119" fmla="*/ 1012 w 10000"/>
                  <a:gd name="connsiteY59-120" fmla="*/ 6877 h 12290"/>
                  <a:gd name="connsiteX60-121" fmla="*/ 1012 w 10000"/>
                  <a:gd name="connsiteY60-122" fmla="*/ 6803 h 12290"/>
                  <a:gd name="connsiteX61-123" fmla="*/ 1131 w 10000"/>
                  <a:gd name="connsiteY61-124" fmla="*/ 6766 h 12290"/>
                  <a:gd name="connsiteX62-125" fmla="*/ 1131 w 10000"/>
                  <a:gd name="connsiteY62-126" fmla="*/ 6729 h 12290"/>
                  <a:gd name="connsiteX63-127" fmla="*/ 1131 w 10000"/>
                  <a:gd name="connsiteY63-128" fmla="*/ 6654 h 12290"/>
                  <a:gd name="connsiteX64-129" fmla="*/ 1190 w 10000"/>
                  <a:gd name="connsiteY64-130" fmla="*/ 6617 h 12290"/>
                  <a:gd name="connsiteX65-131" fmla="*/ 1190 w 10000"/>
                  <a:gd name="connsiteY65-132" fmla="*/ 6543 h 12290"/>
                  <a:gd name="connsiteX66-133" fmla="*/ 1190 w 10000"/>
                  <a:gd name="connsiteY66-134" fmla="*/ 6506 h 12290"/>
                  <a:gd name="connsiteX67-135" fmla="*/ 1310 w 10000"/>
                  <a:gd name="connsiteY67-136" fmla="*/ 6431 h 12290"/>
                  <a:gd name="connsiteX68-137" fmla="*/ 1310 w 10000"/>
                  <a:gd name="connsiteY68-138" fmla="*/ 6394 h 12290"/>
                  <a:gd name="connsiteX69-139" fmla="*/ 1369 w 10000"/>
                  <a:gd name="connsiteY69-140" fmla="*/ 6394 h 12290"/>
                  <a:gd name="connsiteX70-141" fmla="*/ 1369 w 10000"/>
                  <a:gd name="connsiteY70-142" fmla="*/ 6320 h 12290"/>
                  <a:gd name="connsiteX71-143" fmla="*/ 1369 w 10000"/>
                  <a:gd name="connsiteY71-144" fmla="*/ 6283 h 12290"/>
                  <a:gd name="connsiteX72-145" fmla="*/ 1488 w 10000"/>
                  <a:gd name="connsiteY72-146" fmla="*/ 6245 h 12290"/>
                  <a:gd name="connsiteX73-147" fmla="*/ 1488 w 10000"/>
                  <a:gd name="connsiteY73-148" fmla="*/ 6171 h 12290"/>
                  <a:gd name="connsiteX74-149" fmla="*/ 1488 w 10000"/>
                  <a:gd name="connsiteY74-150" fmla="*/ 6134 h 12290"/>
                  <a:gd name="connsiteX75-151" fmla="*/ 1548 w 10000"/>
                  <a:gd name="connsiteY75-152" fmla="*/ 6059 h 12290"/>
                  <a:gd name="connsiteX76-153" fmla="*/ 1548 w 10000"/>
                  <a:gd name="connsiteY76-154" fmla="*/ 6022 h 12290"/>
                  <a:gd name="connsiteX77-155" fmla="*/ 1607 w 10000"/>
                  <a:gd name="connsiteY77-156" fmla="*/ 5948 h 12290"/>
                  <a:gd name="connsiteX78-157" fmla="*/ 1607 w 10000"/>
                  <a:gd name="connsiteY78-158" fmla="*/ 5911 h 12290"/>
                  <a:gd name="connsiteX79-159" fmla="*/ 1726 w 10000"/>
                  <a:gd name="connsiteY79-160" fmla="*/ 5874 h 12290"/>
                  <a:gd name="connsiteX80-161" fmla="*/ 1726 w 10000"/>
                  <a:gd name="connsiteY80-162" fmla="*/ 5799 h 12290"/>
                  <a:gd name="connsiteX81-163" fmla="*/ 1726 w 10000"/>
                  <a:gd name="connsiteY81-164" fmla="*/ 5762 h 12290"/>
                  <a:gd name="connsiteX82-165" fmla="*/ 1786 w 10000"/>
                  <a:gd name="connsiteY82-166" fmla="*/ 5688 h 12290"/>
                  <a:gd name="connsiteX83-167" fmla="*/ 1786 w 10000"/>
                  <a:gd name="connsiteY83-168" fmla="*/ 5651 h 12290"/>
                  <a:gd name="connsiteX84-169" fmla="*/ 1905 w 10000"/>
                  <a:gd name="connsiteY84-170" fmla="*/ 5576 h 12290"/>
                  <a:gd name="connsiteX85-171" fmla="*/ 1905 w 10000"/>
                  <a:gd name="connsiteY85-172" fmla="*/ 5539 h 12290"/>
                  <a:gd name="connsiteX86-173" fmla="*/ 1964 w 10000"/>
                  <a:gd name="connsiteY86-174" fmla="*/ 5502 h 12290"/>
                  <a:gd name="connsiteX87-175" fmla="*/ 1964 w 10000"/>
                  <a:gd name="connsiteY87-176" fmla="*/ 5428 h 12290"/>
                  <a:gd name="connsiteX88-177" fmla="*/ 1964 w 10000"/>
                  <a:gd name="connsiteY88-178" fmla="*/ 5390 h 12290"/>
                  <a:gd name="connsiteX89-179" fmla="*/ 2083 w 10000"/>
                  <a:gd name="connsiteY89-180" fmla="*/ 5390 h 12290"/>
                  <a:gd name="connsiteX90-181" fmla="*/ 2083 w 10000"/>
                  <a:gd name="connsiteY90-182" fmla="*/ 5316 h 12290"/>
                  <a:gd name="connsiteX91-183" fmla="*/ 2143 w 10000"/>
                  <a:gd name="connsiteY91-184" fmla="*/ 5279 h 12290"/>
                  <a:gd name="connsiteX92-185" fmla="*/ 2143 w 10000"/>
                  <a:gd name="connsiteY92-186" fmla="*/ 5204 h 12290"/>
                  <a:gd name="connsiteX93-187" fmla="*/ 2202 w 10000"/>
                  <a:gd name="connsiteY93-188" fmla="*/ 5167 h 12290"/>
                  <a:gd name="connsiteX94-189" fmla="*/ 2202 w 10000"/>
                  <a:gd name="connsiteY94-190" fmla="*/ 5093 h 12290"/>
                  <a:gd name="connsiteX95-191" fmla="*/ 2321 w 10000"/>
                  <a:gd name="connsiteY95-192" fmla="*/ 5056 h 12290"/>
                  <a:gd name="connsiteX96-193" fmla="*/ 2321 w 10000"/>
                  <a:gd name="connsiteY96-194" fmla="*/ 5019 h 12290"/>
                  <a:gd name="connsiteX97-195" fmla="*/ 2381 w 10000"/>
                  <a:gd name="connsiteY97-196" fmla="*/ 4944 h 12290"/>
                  <a:gd name="connsiteX98-197" fmla="*/ 2381 w 10000"/>
                  <a:gd name="connsiteY98-198" fmla="*/ 4907 h 12290"/>
                  <a:gd name="connsiteX99-199" fmla="*/ 2500 w 10000"/>
                  <a:gd name="connsiteY99-200" fmla="*/ 4833 h 12290"/>
                  <a:gd name="connsiteX100-201" fmla="*/ 2500 w 10000"/>
                  <a:gd name="connsiteY100-202" fmla="*/ 4796 h 12290"/>
                  <a:gd name="connsiteX101-203" fmla="*/ 2560 w 10000"/>
                  <a:gd name="connsiteY101-204" fmla="*/ 4796 h 12290"/>
                  <a:gd name="connsiteX102-205" fmla="*/ 2560 w 10000"/>
                  <a:gd name="connsiteY102-206" fmla="*/ 4721 h 12290"/>
                  <a:gd name="connsiteX103-207" fmla="*/ 2679 w 10000"/>
                  <a:gd name="connsiteY103-208" fmla="*/ 4684 h 12290"/>
                  <a:gd name="connsiteX104-209" fmla="*/ 2679 w 10000"/>
                  <a:gd name="connsiteY104-210" fmla="*/ 4647 h 12290"/>
                  <a:gd name="connsiteX105-211" fmla="*/ 2738 w 10000"/>
                  <a:gd name="connsiteY105-212" fmla="*/ 4572 h 12290"/>
                  <a:gd name="connsiteX106-213" fmla="*/ 2738 w 10000"/>
                  <a:gd name="connsiteY106-214" fmla="*/ 4535 h 12290"/>
                  <a:gd name="connsiteX107-215" fmla="*/ 2857 w 10000"/>
                  <a:gd name="connsiteY107-216" fmla="*/ 4461 h 12290"/>
                  <a:gd name="connsiteX108-217" fmla="*/ 2857 w 10000"/>
                  <a:gd name="connsiteY108-218" fmla="*/ 4424 h 12290"/>
                  <a:gd name="connsiteX109-219" fmla="*/ 2917 w 10000"/>
                  <a:gd name="connsiteY109-220" fmla="*/ 4349 h 12290"/>
                  <a:gd name="connsiteX110-221" fmla="*/ 2917 w 10000"/>
                  <a:gd name="connsiteY110-222" fmla="*/ 4312 h 12290"/>
                  <a:gd name="connsiteX111-223" fmla="*/ 2976 w 10000"/>
                  <a:gd name="connsiteY111-224" fmla="*/ 4312 h 12290"/>
                  <a:gd name="connsiteX112-225" fmla="*/ 3095 w 10000"/>
                  <a:gd name="connsiteY112-226" fmla="*/ 4275 h 12290"/>
                  <a:gd name="connsiteX113-227" fmla="*/ 3095 w 10000"/>
                  <a:gd name="connsiteY113-228" fmla="*/ 4201 h 12290"/>
                  <a:gd name="connsiteX114-229" fmla="*/ 3155 w 10000"/>
                  <a:gd name="connsiteY114-230" fmla="*/ 4164 h 12290"/>
                  <a:gd name="connsiteX115-231" fmla="*/ 3155 w 10000"/>
                  <a:gd name="connsiteY115-232" fmla="*/ 4089 h 12290"/>
                  <a:gd name="connsiteX116-233" fmla="*/ 3274 w 10000"/>
                  <a:gd name="connsiteY116-234" fmla="*/ 4052 h 12290"/>
                  <a:gd name="connsiteX117-235" fmla="*/ 3274 w 10000"/>
                  <a:gd name="connsiteY117-236" fmla="*/ 3978 h 12290"/>
                  <a:gd name="connsiteX118-237" fmla="*/ 3333 w 10000"/>
                  <a:gd name="connsiteY118-238" fmla="*/ 3941 h 12290"/>
                  <a:gd name="connsiteX119-239" fmla="*/ 3333 w 10000"/>
                  <a:gd name="connsiteY119-240" fmla="*/ 3941 h 12290"/>
                  <a:gd name="connsiteX120-241" fmla="*/ 3452 w 10000"/>
                  <a:gd name="connsiteY120-242" fmla="*/ 3866 h 12290"/>
                  <a:gd name="connsiteX121-243" fmla="*/ 3512 w 10000"/>
                  <a:gd name="connsiteY121-244" fmla="*/ 3829 h 12290"/>
                  <a:gd name="connsiteX122-245" fmla="*/ 3512 w 10000"/>
                  <a:gd name="connsiteY122-246" fmla="*/ 3792 h 12290"/>
                  <a:gd name="connsiteX123-247" fmla="*/ 3571 w 10000"/>
                  <a:gd name="connsiteY123-248" fmla="*/ 3717 h 12290"/>
                  <a:gd name="connsiteX124-249" fmla="*/ 3571 w 10000"/>
                  <a:gd name="connsiteY124-250" fmla="*/ 3680 h 12290"/>
                  <a:gd name="connsiteX125-251" fmla="*/ 3690 w 10000"/>
                  <a:gd name="connsiteY125-252" fmla="*/ 3606 h 12290"/>
                  <a:gd name="connsiteX126-253" fmla="*/ 3750 w 10000"/>
                  <a:gd name="connsiteY126-254" fmla="*/ 3606 h 12290"/>
                  <a:gd name="connsiteX127-255" fmla="*/ 3750 w 10000"/>
                  <a:gd name="connsiteY127-256" fmla="*/ 3569 h 12290"/>
                  <a:gd name="connsiteX128-257" fmla="*/ 3869 w 10000"/>
                  <a:gd name="connsiteY128-258" fmla="*/ 3494 h 12290"/>
                  <a:gd name="connsiteX129-259" fmla="*/ 3869 w 10000"/>
                  <a:gd name="connsiteY129-260" fmla="*/ 3457 h 12290"/>
                  <a:gd name="connsiteX130-261" fmla="*/ 3929 w 10000"/>
                  <a:gd name="connsiteY130-262" fmla="*/ 3420 h 12290"/>
                  <a:gd name="connsiteX131-263" fmla="*/ 4048 w 10000"/>
                  <a:gd name="connsiteY131-264" fmla="*/ 3346 h 12290"/>
                  <a:gd name="connsiteX132-265" fmla="*/ 4048 w 10000"/>
                  <a:gd name="connsiteY132-266" fmla="*/ 3346 h 12290"/>
                  <a:gd name="connsiteX133-267" fmla="*/ 4107 w 10000"/>
                  <a:gd name="connsiteY133-268" fmla="*/ 3309 h 12290"/>
                  <a:gd name="connsiteX134-269" fmla="*/ 4167 w 10000"/>
                  <a:gd name="connsiteY134-270" fmla="*/ 3234 h 12290"/>
                  <a:gd name="connsiteX135-271" fmla="*/ 4167 w 10000"/>
                  <a:gd name="connsiteY135-272" fmla="*/ 3197 h 12290"/>
                  <a:gd name="connsiteX136-273" fmla="*/ 4286 w 10000"/>
                  <a:gd name="connsiteY136-274" fmla="*/ 3123 h 12290"/>
                  <a:gd name="connsiteX137-275" fmla="*/ 4286 w 10000"/>
                  <a:gd name="connsiteY137-276" fmla="*/ 3086 h 12290"/>
                  <a:gd name="connsiteX138-277" fmla="*/ 4345 w 10000"/>
                  <a:gd name="connsiteY138-278" fmla="*/ 3086 h 12290"/>
                  <a:gd name="connsiteX139-279" fmla="*/ 4464 w 10000"/>
                  <a:gd name="connsiteY139-280" fmla="*/ 3048 h 12290"/>
                  <a:gd name="connsiteX140-281" fmla="*/ 4464 w 10000"/>
                  <a:gd name="connsiteY140-282" fmla="*/ 2974 h 12290"/>
                  <a:gd name="connsiteX141-283" fmla="*/ 4524 w 10000"/>
                  <a:gd name="connsiteY141-284" fmla="*/ 2937 h 12290"/>
                  <a:gd name="connsiteX142-285" fmla="*/ 4643 w 10000"/>
                  <a:gd name="connsiteY142-286" fmla="*/ 2862 h 12290"/>
                  <a:gd name="connsiteX143-287" fmla="*/ 4643 w 10000"/>
                  <a:gd name="connsiteY143-288" fmla="*/ 2862 h 12290"/>
                  <a:gd name="connsiteX144-289" fmla="*/ 4702 w 10000"/>
                  <a:gd name="connsiteY144-290" fmla="*/ 2825 h 12290"/>
                  <a:gd name="connsiteX145-291" fmla="*/ 4821 w 10000"/>
                  <a:gd name="connsiteY145-292" fmla="*/ 2751 h 12290"/>
                  <a:gd name="connsiteX146-293" fmla="*/ 4821 w 10000"/>
                  <a:gd name="connsiteY146-294" fmla="*/ 2714 h 12290"/>
                  <a:gd name="connsiteX147-295" fmla="*/ 4881 w 10000"/>
                  <a:gd name="connsiteY147-296" fmla="*/ 2639 h 12290"/>
                  <a:gd name="connsiteX148-297" fmla="*/ 4940 w 10000"/>
                  <a:gd name="connsiteY148-298" fmla="*/ 2639 h 12290"/>
                  <a:gd name="connsiteX149-299" fmla="*/ 4940 w 10000"/>
                  <a:gd name="connsiteY149-300" fmla="*/ 2602 h 12290"/>
                  <a:gd name="connsiteX150-301" fmla="*/ 5060 w 10000"/>
                  <a:gd name="connsiteY150-302" fmla="*/ 2565 h 12290"/>
                  <a:gd name="connsiteX151-303" fmla="*/ 5119 w 10000"/>
                  <a:gd name="connsiteY151-304" fmla="*/ 2491 h 12290"/>
                  <a:gd name="connsiteX152-305" fmla="*/ 5119 w 10000"/>
                  <a:gd name="connsiteY152-306" fmla="*/ 2491 h 12290"/>
                  <a:gd name="connsiteX153-307" fmla="*/ 5238 w 10000"/>
                  <a:gd name="connsiteY153-308" fmla="*/ 2454 h 12290"/>
                  <a:gd name="connsiteX154-309" fmla="*/ 5298 w 10000"/>
                  <a:gd name="connsiteY154-310" fmla="*/ 2379 h 12290"/>
                  <a:gd name="connsiteX155-311" fmla="*/ 5417 w 10000"/>
                  <a:gd name="connsiteY155-312" fmla="*/ 2342 h 12290"/>
                  <a:gd name="connsiteX156-313" fmla="*/ 5417 w 10000"/>
                  <a:gd name="connsiteY156-314" fmla="*/ 2342 h 12290"/>
                  <a:gd name="connsiteX157-315" fmla="*/ 5476 w 10000"/>
                  <a:gd name="connsiteY157-316" fmla="*/ 2268 h 12290"/>
                  <a:gd name="connsiteX158-317" fmla="*/ 5536 w 10000"/>
                  <a:gd name="connsiteY158-318" fmla="*/ 2230 h 12290"/>
                  <a:gd name="connsiteX159-319" fmla="*/ 5536 w 10000"/>
                  <a:gd name="connsiteY159-320" fmla="*/ 2193 h 12290"/>
                  <a:gd name="connsiteX160-321" fmla="*/ 5655 w 10000"/>
                  <a:gd name="connsiteY160-322" fmla="*/ 2193 h 12290"/>
                  <a:gd name="connsiteX161-323" fmla="*/ 5714 w 10000"/>
                  <a:gd name="connsiteY161-324" fmla="*/ 2119 h 12290"/>
                  <a:gd name="connsiteX162-325" fmla="*/ 5833 w 10000"/>
                  <a:gd name="connsiteY162-326" fmla="*/ 2082 h 12290"/>
                  <a:gd name="connsiteX163-327" fmla="*/ 5833 w 10000"/>
                  <a:gd name="connsiteY163-328" fmla="*/ 2007 h 12290"/>
                  <a:gd name="connsiteX164-329" fmla="*/ 5893 w 10000"/>
                  <a:gd name="connsiteY164-330" fmla="*/ 2007 h 12290"/>
                  <a:gd name="connsiteX165-331" fmla="*/ 6012 w 10000"/>
                  <a:gd name="connsiteY165-332" fmla="*/ 1970 h 12290"/>
                  <a:gd name="connsiteX166-333" fmla="*/ 6071 w 10000"/>
                  <a:gd name="connsiteY166-334" fmla="*/ 1896 h 12290"/>
                  <a:gd name="connsiteX167-335" fmla="*/ 6071 w 10000"/>
                  <a:gd name="connsiteY167-336" fmla="*/ 1859 h 12290"/>
                  <a:gd name="connsiteX168-337" fmla="*/ 6131 w 10000"/>
                  <a:gd name="connsiteY168-338" fmla="*/ 1859 h 12290"/>
                  <a:gd name="connsiteX169-339" fmla="*/ 6250 w 10000"/>
                  <a:gd name="connsiteY169-340" fmla="*/ 1822 h 12290"/>
                  <a:gd name="connsiteX170-341" fmla="*/ 6250 w 10000"/>
                  <a:gd name="connsiteY170-342" fmla="*/ 1747 h 12290"/>
                  <a:gd name="connsiteX171-343" fmla="*/ 6310 w 10000"/>
                  <a:gd name="connsiteY171-344" fmla="*/ 1710 h 12290"/>
                  <a:gd name="connsiteX172-345" fmla="*/ 6429 w 10000"/>
                  <a:gd name="connsiteY172-346" fmla="*/ 1710 h 12290"/>
                  <a:gd name="connsiteX173-347" fmla="*/ 6488 w 10000"/>
                  <a:gd name="connsiteY173-348" fmla="*/ 1636 h 12290"/>
                  <a:gd name="connsiteX174-349" fmla="*/ 6607 w 10000"/>
                  <a:gd name="connsiteY174-350" fmla="*/ 1599 h 12290"/>
                  <a:gd name="connsiteX175-351" fmla="*/ 6607 w 10000"/>
                  <a:gd name="connsiteY175-352" fmla="*/ 1599 h 12290"/>
                  <a:gd name="connsiteX176-353" fmla="*/ 6667 w 10000"/>
                  <a:gd name="connsiteY176-354" fmla="*/ 1524 h 12290"/>
                  <a:gd name="connsiteX177-355" fmla="*/ 6726 w 10000"/>
                  <a:gd name="connsiteY177-356" fmla="*/ 1487 h 12290"/>
                  <a:gd name="connsiteX178-357" fmla="*/ 6845 w 10000"/>
                  <a:gd name="connsiteY178-358" fmla="*/ 1487 h 12290"/>
                  <a:gd name="connsiteX179-359" fmla="*/ 6845 w 10000"/>
                  <a:gd name="connsiteY179-360" fmla="*/ 1413 h 12290"/>
                  <a:gd name="connsiteX180-361" fmla="*/ 6905 w 10000"/>
                  <a:gd name="connsiteY180-362" fmla="*/ 1375 h 12290"/>
                  <a:gd name="connsiteX181-363" fmla="*/ 7024 w 10000"/>
                  <a:gd name="connsiteY181-364" fmla="*/ 1375 h 12290"/>
                  <a:gd name="connsiteX182-365" fmla="*/ 7083 w 10000"/>
                  <a:gd name="connsiteY182-366" fmla="*/ 1338 h 12290"/>
                  <a:gd name="connsiteX183-367" fmla="*/ 7202 w 10000"/>
                  <a:gd name="connsiteY183-368" fmla="*/ 1264 h 12290"/>
                  <a:gd name="connsiteX184-369" fmla="*/ 7202 w 10000"/>
                  <a:gd name="connsiteY184-370" fmla="*/ 1264 h 12290"/>
                  <a:gd name="connsiteX185-371" fmla="*/ 7262 w 10000"/>
                  <a:gd name="connsiteY185-372" fmla="*/ 1227 h 12290"/>
                  <a:gd name="connsiteX186-373" fmla="*/ 7381 w 10000"/>
                  <a:gd name="connsiteY186-374" fmla="*/ 1152 h 12290"/>
                  <a:gd name="connsiteX187-375" fmla="*/ 7440 w 10000"/>
                  <a:gd name="connsiteY187-376" fmla="*/ 1152 h 12290"/>
                  <a:gd name="connsiteX188-377" fmla="*/ 7500 w 10000"/>
                  <a:gd name="connsiteY188-378" fmla="*/ 1115 h 12290"/>
                  <a:gd name="connsiteX189-379" fmla="*/ 7500 w 10000"/>
                  <a:gd name="connsiteY189-380" fmla="*/ 1041 h 12290"/>
                  <a:gd name="connsiteX190-381" fmla="*/ 7619 w 10000"/>
                  <a:gd name="connsiteY190-382" fmla="*/ 1041 h 12290"/>
                  <a:gd name="connsiteX191-383" fmla="*/ 7679 w 10000"/>
                  <a:gd name="connsiteY191-384" fmla="*/ 1004 h 12290"/>
                  <a:gd name="connsiteX192-385" fmla="*/ 7798 w 10000"/>
                  <a:gd name="connsiteY192-386" fmla="*/ 967 h 12290"/>
                  <a:gd name="connsiteX193-387" fmla="*/ 7857 w 10000"/>
                  <a:gd name="connsiteY193-388" fmla="*/ 967 h 12290"/>
                  <a:gd name="connsiteX194-389" fmla="*/ 7857 w 10000"/>
                  <a:gd name="connsiteY194-390" fmla="*/ 892 h 12290"/>
                  <a:gd name="connsiteX195-391" fmla="*/ 7976 w 10000"/>
                  <a:gd name="connsiteY195-392" fmla="*/ 855 h 12290"/>
                  <a:gd name="connsiteX196-393" fmla="*/ 8036 w 10000"/>
                  <a:gd name="connsiteY196-394" fmla="*/ 855 h 12290"/>
                  <a:gd name="connsiteX197-395" fmla="*/ 8095 w 10000"/>
                  <a:gd name="connsiteY197-396" fmla="*/ 781 h 12290"/>
                  <a:gd name="connsiteX198-397" fmla="*/ 8214 w 10000"/>
                  <a:gd name="connsiteY198-398" fmla="*/ 743 h 12290"/>
                  <a:gd name="connsiteX199-399" fmla="*/ 8274 w 10000"/>
                  <a:gd name="connsiteY199-400" fmla="*/ 743 h 12290"/>
                  <a:gd name="connsiteX200-401" fmla="*/ 8274 w 10000"/>
                  <a:gd name="connsiteY200-402" fmla="*/ 669 h 12290"/>
                  <a:gd name="connsiteX201-403" fmla="*/ 8393 w 10000"/>
                  <a:gd name="connsiteY201-404" fmla="*/ 669 h 12290"/>
                  <a:gd name="connsiteX202-405" fmla="*/ 8452 w 10000"/>
                  <a:gd name="connsiteY202-406" fmla="*/ 632 h 12290"/>
                  <a:gd name="connsiteX203-407" fmla="*/ 8571 w 10000"/>
                  <a:gd name="connsiteY203-408" fmla="*/ 595 h 12290"/>
                  <a:gd name="connsiteX204-409" fmla="*/ 8631 w 10000"/>
                  <a:gd name="connsiteY204-410" fmla="*/ 595 h 12290"/>
                  <a:gd name="connsiteX205-411" fmla="*/ 8690 w 10000"/>
                  <a:gd name="connsiteY205-412" fmla="*/ 520 h 12290"/>
                  <a:gd name="connsiteX206-413" fmla="*/ 8690 w 10000"/>
                  <a:gd name="connsiteY206-414" fmla="*/ 520 h 12290"/>
                  <a:gd name="connsiteX207-415" fmla="*/ 8810 w 10000"/>
                  <a:gd name="connsiteY207-416" fmla="*/ 483 h 12290"/>
                  <a:gd name="connsiteX208-417" fmla="*/ 8869 w 10000"/>
                  <a:gd name="connsiteY208-418" fmla="*/ 409 h 12290"/>
                  <a:gd name="connsiteX209-419" fmla="*/ 8988 w 10000"/>
                  <a:gd name="connsiteY209-420" fmla="*/ 409 h 12290"/>
                  <a:gd name="connsiteX210-421" fmla="*/ 9048 w 10000"/>
                  <a:gd name="connsiteY210-422" fmla="*/ 372 h 12290"/>
                  <a:gd name="connsiteX211-423" fmla="*/ 9167 w 10000"/>
                  <a:gd name="connsiteY211-424" fmla="*/ 372 h 12290"/>
                  <a:gd name="connsiteX212-425" fmla="*/ 9226 w 10000"/>
                  <a:gd name="connsiteY212-426" fmla="*/ 297 h 12290"/>
                  <a:gd name="connsiteX213-427" fmla="*/ 9226 w 10000"/>
                  <a:gd name="connsiteY213-428" fmla="*/ 297 h 12290"/>
                  <a:gd name="connsiteX214-429" fmla="*/ 9345 w 10000"/>
                  <a:gd name="connsiteY214-430" fmla="*/ 260 h 12290"/>
                  <a:gd name="connsiteX215-431" fmla="*/ 9405 w 10000"/>
                  <a:gd name="connsiteY215-432" fmla="*/ 186 h 12290"/>
                  <a:gd name="connsiteX216-433" fmla="*/ 9464 w 10000"/>
                  <a:gd name="connsiteY216-434" fmla="*/ 186 h 12290"/>
                  <a:gd name="connsiteX217-435" fmla="*/ 9583 w 10000"/>
                  <a:gd name="connsiteY217-436" fmla="*/ 149 h 12290"/>
                  <a:gd name="connsiteX218-437" fmla="*/ 9643 w 10000"/>
                  <a:gd name="connsiteY218-438" fmla="*/ 149 h 12290"/>
                  <a:gd name="connsiteX219-439" fmla="*/ 9762 w 10000"/>
                  <a:gd name="connsiteY219-440" fmla="*/ 112 h 12290"/>
                  <a:gd name="connsiteX220-441" fmla="*/ 9821 w 10000"/>
                  <a:gd name="connsiteY220-442" fmla="*/ 112 h 12290"/>
                  <a:gd name="connsiteX221-443" fmla="*/ 9940 w 10000"/>
                  <a:gd name="connsiteY221-444" fmla="*/ 37 h 12290"/>
                  <a:gd name="connsiteX222-445" fmla="*/ 9940 w 10000"/>
                  <a:gd name="connsiteY222-446" fmla="*/ 37 h 12290"/>
                  <a:gd name="connsiteX223-447" fmla="*/ 10000 w 10000"/>
                  <a:gd name="connsiteY223-448" fmla="*/ 0 h 12290"/>
                </a:gdLst>
                <a:ahLst/>
                <a:cxnLst>
                  <a:cxn ang="0">
                    <a:pos x="connsiteX0-1" y="connsiteY0-2"/>
                  </a:cxn>
                  <a:cxn ang="0">
                    <a:pos x="connsiteX1-3" y="connsiteY1-4"/>
                  </a:cxn>
                  <a:cxn ang="0">
                    <a:pos x="connsiteX2-5" y="connsiteY2-6"/>
                  </a:cxn>
                  <a:cxn ang="0">
                    <a:pos x="connsiteX3-7" y="connsiteY3-8"/>
                  </a:cxn>
                  <a:cxn ang="0">
                    <a:pos x="connsiteX4-9" y="connsiteY4-10"/>
                  </a:cxn>
                  <a:cxn ang="0">
                    <a:pos x="connsiteX5-11" y="connsiteY5-12"/>
                  </a:cxn>
                  <a:cxn ang="0">
                    <a:pos x="connsiteX6-13" y="connsiteY6-14"/>
                  </a:cxn>
                  <a:cxn ang="0">
                    <a:pos x="connsiteX7-15" y="connsiteY7-16"/>
                  </a:cxn>
                  <a:cxn ang="0">
                    <a:pos x="connsiteX8-17" y="connsiteY8-18"/>
                  </a:cxn>
                  <a:cxn ang="0">
                    <a:pos x="connsiteX9-19" y="connsiteY9-20"/>
                  </a:cxn>
                  <a:cxn ang="0">
                    <a:pos x="connsiteX10-21" y="connsiteY10-22"/>
                  </a:cxn>
                  <a:cxn ang="0">
                    <a:pos x="connsiteX11-23" y="connsiteY11-24"/>
                  </a:cxn>
                  <a:cxn ang="0">
                    <a:pos x="connsiteX12-25" y="connsiteY12-26"/>
                  </a:cxn>
                  <a:cxn ang="0">
                    <a:pos x="connsiteX13-27" y="connsiteY13-28"/>
                  </a:cxn>
                  <a:cxn ang="0">
                    <a:pos x="connsiteX14-29" y="connsiteY14-30"/>
                  </a:cxn>
                  <a:cxn ang="0">
                    <a:pos x="connsiteX15-31" y="connsiteY15-32"/>
                  </a:cxn>
                  <a:cxn ang="0">
                    <a:pos x="connsiteX16-33" y="connsiteY16-34"/>
                  </a:cxn>
                  <a:cxn ang="0">
                    <a:pos x="connsiteX17-35" y="connsiteY17-36"/>
                  </a:cxn>
                  <a:cxn ang="0">
                    <a:pos x="connsiteX18-37" y="connsiteY18-38"/>
                  </a:cxn>
                  <a:cxn ang="0">
                    <a:pos x="connsiteX19-39" y="connsiteY19-40"/>
                  </a:cxn>
                  <a:cxn ang="0">
                    <a:pos x="connsiteX20-41" y="connsiteY20-42"/>
                  </a:cxn>
                  <a:cxn ang="0">
                    <a:pos x="connsiteX21-43" y="connsiteY21-44"/>
                  </a:cxn>
                  <a:cxn ang="0">
                    <a:pos x="connsiteX22-45" y="connsiteY22-46"/>
                  </a:cxn>
                  <a:cxn ang="0">
                    <a:pos x="connsiteX23-47" y="connsiteY23-48"/>
                  </a:cxn>
                  <a:cxn ang="0">
                    <a:pos x="connsiteX24-49" y="connsiteY24-50"/>
                  </a:cxn>
                  <a:cxn ang="0">
                    <a:pos x="connsiteX25-51" y="connsiteY25-52"/>
                  </a:cxn>
                  <a:cxn ang="0">
                    <a:pos x="connsiteX26-53" y="connsiteY26-54"/>
                  </a:cxn>
                  <a:cxn ang="0">
                    <a:pos x="connsiteX27-55" y="connsiteY27-56"/>
                  </a:cxn>
                  <a:cxn ang="0">
                    <a:pos x="connsiteX28-57" y="connsiteY28-58"/>
                  </a:cxn>
                  <a:cxn ang="0">
                    <a:pos x="connsiteX29-59" y="connsiteY29-60"/>
                  </a:cxn>
                  <a:cxn ang="0">
                    <a:pos x="connsiteX30-61" y="connsiteY30-62"/>
                  </a:cxn>
                  <a:cxn ang="0">
                    <a:pos x="connsiteX31-63" y="connsiteY31-64"/>
                  </a:cxn>
                  <a:cxn ang="0">
                    <a:pos x="connsiteX32-65" y="connsiteY32-66"/>
                  </a:cxn>
                  <a:cxn ang="0">
                    <a:pos x="connsiteX33-67" y="connsiteY33-68"/>
                  </a:cxn>
                  <a:cxn ang="0">
                    <a:pos x="connsiteX34-69" y="connsiteY34-70"/>
                  </a:cxn>
                  <a:cxn ang="0">
                    <a:pos x="connsiteX35-71" y="connsiteY35-72"/>
                  </a:cxn>
                  <a:cxn ang="0">
                    <a:pos x="connsiteX36-73" y="connsiteY36-74"/>
                  </a:cxn>
                  <a:cxn ang="0">
                    <a:pos x="connsiteX37-75" y="connsiteY37-76"/>
                  </a:cxn>
                  <a:cxn ang="0">
                    <a:pos x="connsiteX38-77" y="connsiteY38-78"/>
                  </a:cxn>
                  <a:cxn ang="0">
                    <a:pos x="connsiteX39-79" y="connsiteY39-80"/>
                  </a:cxn>
                  <a:cxn ang="0">
                    <a:pos x="connsiteX40-81" y="connsiteY40-82"/>
                  </a:cxn>
                  <a:cxn ang="0">
                    <a:pos x="connsiteX41-83" y="connsiteY41-84"/>
                  </a:cxn>
                  <a:cxn ang="0">
                    <a:pos x="connsiteX42-85" y="connsiteY42-86"/>
                  </a:cxn>
                  <a:cxn ang="0">
                    <a:pos x="connsiteX43-87" y="connsiteY43-88"/>
                  </a:cxn>
                  <a:cxn ang="0">
                    <a:pos x="connsiteX44-89" y="connsiteY44-90"/>
                  </a:cxn>
                  <a:cxn ang="0">
                    <a:pos x="connsiteX45-91" y="connsiteY45-92"/>
                  </a:cxn>
                  <a:cxn ang="0">
                    <a:pos x="connsiteX46-93" y="connsiteY46-94"/>
                  </a:cxn>
                  <a:cxn ang="0">
                    <a:pos x="connsiteX47-95" y="connsiteY47-96"/>
                  </a:cxn>
                  <a:cxn ang="0">
                    <a:pos x="connsiteX48-97" y="connsiteY48-98"/>
                  </a:cxn>
                  <a:cxn ang="0">
                    <a:pos x="connsiteX49-99" y="connsiteY49-100"/>
                  </a:cxn>
                  <a:cxn ang="0">
                    <a:pos x="connsiteX50-101" y="connsiteY50-102"/>
                  </a:cxn>
                  <a:cxn ang="0">
                    <a:pos x="connsiteX51-103" y="connsiteY51-104"/>
                  </a:cxn>
                  <a:cxn ang="0">
                    <a:pos x="connsiteX52-105" y="connsiteY52-106"/>
                  </a:cxn>
                  <a:cxn ang="0">
                    <a:pos x="connsiteX53-107" y="connsiteY53-108"/>
                  </a:cxn>
                  <a:cxn ang="0">
                    <a:pos x="connsiteX54-109" y="connsiteY54-110"/>
                  </a:cxn>
                  <a:cxn ang="0">
                    <a:pos x="connsiteX55-111" y="connsiteY55-112"/>
                  </a:cxn>
                  <a:cxn ang="0">
                    <a:pos x="connsiteX56-113" y="connsiteY56-114"/>
                  </a:cxn>
                  <a:cxn ang="0">
                    <a:pos x="connsiteX57-115" y="connsiteY57-116"/>
                  </a:cxn>
                  <a:cxn ang="0">
                    <a:pos x="connsiteX58-117" y="connsiteY58-118"/>
                  </a:cxn>
                  <a:cxn ang="0">
                    <a:pos x="connsiteX59-119" y="connsiteY59-120"/>
                  </a:cxn>
                  <a:cxn ang="0">
                    <a:pos x="connsiteX60-121" y="connsiteY60-122"/>
                  </a:cxn>
                  <a:cxn ang="0">
                    <a:pos x="connsiteX61-123" y="connsiteY61-124"/>
                  </a:cxn>
                  <a:cxn ang="0">
                    <a:pos x="connsiteX62-125" y="connsiteY62-126"/>
                  </a:cxn>
                  <a:cxn ang="0">
                    <a:pos x="connsiteX63-127" y="connsiteY63-128"/>
                  </a:cxn>
                  <a:cxn ang="0">
                    <a:pos x="connsiteX64-129" y="connsiteY64-130"/>
                  </a:cxn>
                  <a:cxn ang="0">
                    <a:pos x="connsiteX65-131" y="connsiteY65-132"/>
                  </a:cxn>
                  <a:cxn ang="0">
                    <a:pos x="connsiteX66-133" y="connsiteY66-134"/>
                  </a:cxn>
                  <a:cxn ang="0">
                    <a:pos x="connsiteX67-135" y="connsiteY67-136"/>
                  </a:cxn>
                  <a:cxn ang="0">
                    <a:pos x="connsiteX68-137" y="connsiteY68-138"/>
                  </a:cxn>
                  <a:cxn ang="0">
                    <a:pos x="connsiteX69-139" y="connsiteY69-140"/>
                  </a:cxn>
                  <a:cxn ang="0">
                    <a:pos x="connsiteX70-141" y="connsiteY70-142"/>
                  </a:cxn>
                  <a:cxn ang="0">
                    <a:pos x="connsiteX71-143" y="connsiteY71-144"/>
                  </a:cxn>
                  <a:cxn ang="0">
                    <a:pos x="connsiteX72-145" y="connsiteY72-146"/>
                  </a:cxn>
                  <a:cxn ang="0">
                    <a:pos x="connsiteX73-147" y="connsiteY73-148"/>
                  </a:cxn>
                  <a:cxn ang="0">
                    <a:pos x="connsiteX74-149" y="connsiteY74-150"/>
                  </a:cxn>
                  <a:cxn ang="0">
                    <a:pos x="connsiteX75-151" y="connsiteY75-152"/>
                  </a:cxn>
                  <a:cxn ang="0">
                    <a:pos x="connsiteX76-153" y="connsiteY76-154"/>
                  </a:cxn>
                  <a:cxn ang="0">
                    <a:pos x="connsiteX77-155" y="connsiteY77-156"/>
                  </a:cxn>
                  <a:cxn ang="0">
                    <a:pos x="connsiteX78-157" y="connsiteY78-158"/>
                  </a:cxn>
                  <a:cxn ang="0">
                    <a:pos x="connsiteX79-159" y="connsiteY79-160"/>
                  </a:cxn>
                  <a:cxn ang="0">
                    <a:pos x="connsiteX80-161" y="connsiteY80-162"/>
                  </a:cxn>
                  <a:cxn ang="0">
                    <a:pos x="connsiteX81-163" y="connsiteY81-164"/>
                  </a:cxn>
                  <a:cxn ang="0">
                    <a:pos x="connsiteX82-165" y="connsiteY82-166"/>
                  </a:cxn>
                  <a:cxn ang="0">
                    <a:pos x="connsiteX83-167" y="connsiteY83-168"/>
                  </a:cxn>
                  <a:cxn ang="0">
                    <a:pos x="connsiteX84-169" y="connsiteY84-170"/>
                  </a:cxn>
                  <a:cxn ang="0">
                    <a:pos x="connsiteX85-171" y="connsiteY85-172"/>
                  </a:cxn>
                  <a:cxn ang="0">
                    <a:pos x="connsiteX86-173" y="connsiteY86-174"/>
                  </a:cxn>
                  <a:cxn ang="0">
                    <a:pos x="connsiteX87-175" y="connsiteY87-176"/>
                  </a:cxn>
                  <a:cxn ang="0">
                    <a:pos x="connsiteX88-177" y="connsiteY88-178"/>
                  </a:cxn>
                  <a:cxn ang="0">
                    <a:pos x="connsiteX89-179" y="connsiteY89-180"/>
                  </a:cxn>
                  <a:cxn ang="0">
                    <a:pos x="connsiteX90-181" y="connsiteY90-182"/>
                  </a:cxn>
                  <a:cxn ang="0">
                    <a:pos x="connsiteX91-183" y="connsiteY91-184"/>
                  </a:cxn>
                  <a:cxn ang="0">
                    <a:pos x="connsiteX92-185" y="connsiteY92-186"/>
                  </a:cxn>
                  <a:cxn ang="0">
                    <a:pos x="connsiteX93-187" y="connsiteY93-188"/>
                  </a:cxn>
                  <a:cxn ang="0">
                    <a:pos x="connsiteX94-189" y="connsiteY94-190"/>
                  </a:cxn>
                  <a:cxn ang="0">
                    <a:pos x="connsiteX95-191" y="connsiteY95-192"/>
                  </a:cxn>
                  <a:cxn ang="0">
                    <a:pos x="connsiteX96-193" y="connsiteY96-194"/>
                  </a:cxn>
                  <a:cxn ang="0">
                    <a:pos x="connsiteX97-195" y="connsiteY97-196"/>
                  </a:cxn>
                  <a:cxn ang="0">
                    <a:pos x="connsiteX98-197" y="connsiteY98-198"/>
                  </a:cxn>
                  <a:cxn ang="0">
                    <a:pos x="connsiteX99-199" y="connsiteY99-200"/>
                  </a:cxn>
                  <a:cxn ang="0">
                    <a:pos x="connsiteX100-201" y="connsiteY100-202"/>
                  </a:cxn>
                  <a:cxn ang="0">
                    <a:pos x="connsiteX101-203" y="connsiteY101-204"/>
                  </a:cxn>
                  <a:cxn ang="0">
                    <a:pos x="connsiteX102-205" y="connsiteY102-206"/>
                  </a:cxn>
                  <a:cxn ang="0">
                    <a:pos x="connsiteX103-207" y="connsiteY103-208"/>
                  </a:cxn>
                  <a:cxn ang="0">
                    <a:pos x="connsiteX104-209" y="connsiteY104-210"/>
                  </a:cxn>
                  <a:cxn ang="0">
                    <a:pos x="connsiteX105-211" y="connsiteY105-212"/>
                  </a:cxn>
                  <a:cxn ang="0">
                    <a:pos x="connsiteX106-213" y="connsiteY106-214"/>
                  </a:cxn>
                  <a:cxn ang="0">
                    <a:pos x="connsiteX107-215" y="connsiteY107-216"/>
                  </a:cxn>
                  <a:cxn ang="0">
                    <a:pos x="connsiteX108-217" y="connsiteY108-218"/>
                  </a:cxn>
                  <a:cxn ang="0">
                    <a:pos x="connsiteX109-219" y="connsiteY109-220"/>
                  </a:cxn>
                  <a:cxn ang="0">
                    <a:pos x="connsiteX110-221" y="connsiteY110-222"/>
                  </a:cxn>
                  <a:cxn ang="0">
                    <a:pos x="connsiteX111-223" y="connsiteY111-224"/>
                  </a:cxn>
                  <a:cxn ang="0">
                    <a:pos x="connsiteX112-225" y="connsiteY112-226"/>
                  </a:cxn>
                  <a:cxn ang="0">
                    <a:pos x="connsiteX113-227" y="connsiteY113-228"/>
                  </a:cxn>
                  <a:cxn ang="0">
                    <a:pos x="connsiteX114-229" y="connsiteY114-230"/>
                  </a:cxn>
                  <a:cxn ang="0">
                    <a:pos x="connsiteX115-231" y="connsiteY115-232"/>
                  </a:cxn>
                  <a:cxn ang="0">
                    <a:pos x="connsiteX116-233" y="connsiteY116-234"/>
                  </a:cxn>
                  <a:cxn ang="0">
                    <a:pos x="connsiteX117-235" y="connsiteY117-236"/>
                  </a:cxn>
                  <a:cxn ang="0">
                    <a:pos x="connsiteX118-237" y="connsiteY118-238"/>
                  </a:cxn>
                  <a:cxn ang="0">
                    <a:pos x="connsiteX119-239" y="connsiteY119-240"/>
                  </a:cxn>
                  <a:cxn ang="0">
                    <a:pos x="connsiteX120-241" y="connsiteY120-242"/>
                  </a:cxn>
                  <a:cxn ang="0">
                    <a:pos x="connsiteX121-243" y="connsiteY121-244"/>
                  </a:cxn>
                  <a:cxn ang="0">
                    <a:pos x="connsiteX122-245" y="connsiteY122-246"/>
                  </a:cxn>
                  <a:cxn ang="0">
                    <a:pos x="connsiteX123-247" y="connsiteY123-248"/>
                  </a:cxn>
                  <a:cxn ang="0">
                    <a:pos x="connsiteX124-249" y="connsiteY124-250"/>
                  </a:cxn>
                  <a:cxn ang="0">
                    <a:pos x="connsiteX125-251" y="connsiteY125-252"/>
                  </a:cxn>
                  <a:cxn ang="0">
                    <a:pos x="connsiteX126-253" y="connsiteY126-254"/>
                  </a:cxn>
                  <a:cxn ang="0">
                    <a:pos x="connsiteX127-255" y="connsiteY127-256"/>
                  </a:cxn>
                  <a:cxn ang="0">
                    <a:pos x="connsiteX128-257" y="connsiteY128-258"/>
                  </a:cxn>
                  <a:cxn ang="0">
                    <a:pos x="connsiteX129-259" y="connsiteY129-260"/>
                  </a:cxn>
                  <a:cxn ang="0">
                    <a:pos x="connsiteX130-261" y="connsiteY130-262"/>
                  </a:cxn>
                  <a:cxn ang="0">
                    <a:pos x="connsiteX131-263" y="connsiteY131-264"/>
                  </a:cxn>
                  <a:cxn ang="0">
                    <a:pos x="connsiteX132-265" y="connsiteY132-266"/>
                  </a:cxn>
                  <a:cxn ang="0">
                    <a:pos x="connsiteX133-267" y="connsiteY133-268"/>
                  </a:cxn>
                  <a:cxn ang="0">
                    <a:pos x="connsiteX134-269" y="connsiteY134-270"/>
                  </a:cxn>
                  <a:cxn ang="0">
                    <a:pos x="connsiteX135-271" y="connsiteY135-272"/>
                  </a:cxn>
                  <a:cxn ang="0">
                    <a:pos x="connsiteX136-273" y="connsiteY136-274"/>
                  </a:cxn>
                  <a:cxn ang="0">
                    <a:pos x="connsiteX137-275" y="connsiteY137-276"/>
                  </a:cxn>
                  <a:cxn ang="0">
                    <a:pos x="connsiteX138-277" y="connsiteY138-278"/>
                  </a:cxn>
                  <a:cxn ang="0">
                    <a:pos x="connsiteX139-279" y="connsiteY139-280"/>
                  </a:cxn>
                  <a:cxn ang="0">
                    <a:pos x="connsiteX140-281" y="connsiteY140-282"/>
                  </a:cxn>
                  <a:cxn ang="0">
                    <a:pos x="connsiteX141-283" y="connsiteY141-284"/>
                  </a:cxn>
                  <a:cxn ang="0">
                    <a:pos x="connsiteX142-285" y="connsiteY142-286"/>
                  </a:cxn>
                  <a:cxn ang="0">
                    <a:pos x="connsiteX143-287" y="connsiteY143-288"/>
                  </a:cxn>
                  <a:cxn ang="0">
                    <a:pos x="connsiteX144-289" y="connsiteY144-290"/>
                  </a:cxn>
                  <a:cxn ang="0">
                    <a:pos x="connsiteX145-291" y="connsiteY145-292"/>
                  </a:cxn>
                  <a:cxn ang="0">
                    <a:pos x="connsiteX146-293" y="connsiteY146-294"/>
                  </a:cxn>
                  <a:cxn ang="0">
                    <a:pos x="connsiteX147-295" y="connsiteY147-296"/>
                  </a:cxn>
                  <a:cxn ang="0">
                    <a:pos x="connsiteX148-297" y="connsiteY148-298"/>
                  </a:cxn>
                  <a:cxn ang="0">
                    <a:pos x="connsiteX149-299" y="connsiteY149-300"/>
                  </a:cxn>
                  <a:cxn ang="0">
                    <a:pos x="connsiteX150-301" y="connsiteY150-302"/>
                  </a:cxn>
                  <a:cxn ang="0">
                    <a:pos x="connsiteX151-303" y="connsiteY151-304"/>
                  </a:cxn>
                  <a:cxn ang="0">
                    <a:pos x="connsiteX152-305" y="connsiteY152-306"/>
                  </a:cxn>
                  <a:cxn ang="0">
                    <a:pos x="connsiteX153-307" y="connsiteY153-308"/>
                  </a:cxn>
                  <a:cxn ang="0">
                    <a:pos x="connsiteX154-309" y="connsiteY154-310"/>
                  </a:cxn>
                  <a:cxn ang="0">
                    <a:pos x="connsiteX155-311" y="connsiteY155-312"/>
                  </a:cxn>
                  <a:cxn ang="0">
                    <a:pos x="connsiteX156-313" y="connsiteY156-314"/>
                  </a:cxn>
                  <a:cxn ang="0">
                    <a:pos x="connsiteX157-315" y="connsiteY157-316"/>
                  </a:cxn>
                  <a:cxn ang="0">
                    <a:pos x="connsiteX158-317" y="connsiteY158-318"/>
                  </a:cxn>
                  <a:cxn ang="0">
                    <a:pos x="connsiteX159-319" y="connsiteY159-320"/>
                  </a:cxn>
                  <a:cxn ang="0">
                    <a:pos x="connsiteX160-321" y="connsiteY160-322"/>
                  </a:cxn>
                  <a:cxn ang="0">
                    <a:pos x="connsiteX161-323" y="connsiteY161-324"/>
                  </a:cxn>
                  <a:cxn ang="0">
                    <a:pos x="connsiteX162-325" y="connsiteY162-326"/>
                  </a:cxn>
                  <a:cxn ang="0">
                    <a:pos x="connsiteX163-327" y="connsiteY163-328"/>
                  </a:cxn>
                  <a:cxn ang="0">
                    <a:pos x="connsiteX164-329" y="connsiteY164-330"/>
                  </a:cxn>
                  <a:cxn ang="0">
                    <a:pos x="connsiteX165-331" y="connsiteY165-332"/>
                  </a:cxn>
                  <a:cxn ang="0">
                    <a:pos x="connsiteX166-333" y="connsiteY166-334"/>
                  </a:cxn>
                  <a:cxn ang="0">
                    <a:pos x="connsiteX167-335" y="connsiteY167-336"/>
                  </a:cxn>
                  <a:cxn ang="0">
                    <a:pos x="connsiteX168-337" y="connsiteY168-338"/>
                  </a:cxn>
                  <a:cxn ang="0">
                    <a:pos x="connsiteX169-339" y="connsiteY169-340"/>
                  </a:cxn>
                  <a:cxn ang="0">
                    <a:pos x="connsiteX170-341" y="connsiteY170-342"/>
                  </a:cxn>
                  <a:cxn ang="0">
                    <a:pos x="connsiteX171-343" y="connsiteY171-344"/>
                  </a:cxn>
                  <a:cxn ang="0">
                    <a:pos x="connsiteX172-345" y="connsiteY172-346"/>
                  </a:cxn>
                  <a:cxn ang="0">
                    <a:pos x="connsiteX173-347" y="connsiteY173-348"/>
                  </a:cxn>
                  <a:cxn ang="0">
                    <a:pos x="connsiteX174-349" y="connsiteY174-350"/>
                  </a:cxn>
                  <a:cxn ang="0">
                    <a:pos x="connsiteX175-351" y="connsiteY175-352"/>
                  </a:cxn>
                  <a:cxn ang="0">
                    <a:pos x="connsiteX176-353" y="connsiteY176-354"/>
                  </a:cxn>
                  <a:cxn ang="0">
                    <a:pos x="connsiteX177-355" y="connsiteY177-356"/>
                  </a:cxn>
                  <a:cxn ang="0">
                    <a:pos x="connsiteX178-357" y="connsiteY178-358"/>
                  </a:cxn>
                  <a:cxn ang="0">
                    <a:pos x="connsiteX179-359" y="connsiteY179-360"/>
                  </a:cxn>
                  <a:cxn ang="0">
                    <a:pos x="connsiteX180-361" y="connsiteY180-362"/>
                  </a:cxn>
                  <a:cxn ang="0">
                    <a:pos x="connsiteX181-363" y="connsiteY181-364"/>
                  </a:cxn>
                  <a:cxn ang="0">
                    <a:pos x="connsiteX182-365" y="connsiteY182-366"/>
                  </a:cxn>
                  <a:cxn ang="0">
                    <a:pos x="connsiteX183-367" y="connsiteY183-368"/>
                  </a:cxn>
                  <a:cxn ang="0">
                    <a:pos x="connsiteX184-369" y="connsiteY184-370"/>
                  </a:cxn>
                  <a:cxn ang="0">
                    <a:pos x="connsiteX185-371" y="connsiteY185-372"/>
                  </a:cxn>
                  <a:cxn ang="0">
                    <a:pos x="connsiteX186-373" y="connsiteY186-374"/>
                  </a:cxn>
                  <a:cxn ang="0">
                    <a:pos x="connsiteX187-375" y="connsiteY187-376"/>
                  </a:cxn>
                  <a:cxn ang="0">
                    <a:pos x="connsiteX188-377" y="connsiteY188-378"/>
                  </a:cxn>
                  <a:cxn ang="0">
                    <a:pos x="connsiteX189-379" y="connsiteY189-380"/>
                  </a:cxn>
                  <a:cxn ang="0">
                    <a:pos x="connsiteX190-381" y="connsiteY190-382"/>
                  </a:cxn>
                  <a:cxn ang="0">
                    <a:pos x="connsiteX191-383" y="connsiteY191-384"/>
                  </a:cxn>
                  <a:cxn ang="0">
                    <a:pos x="connsiteX192-385" y="connsiteY192-386"/>
                  </a:cxn>
                  <a:cxn ang="0">
                    <a:pos x="connsiteX193-387" y="connsiteY193-388"/>
                  </a:cxn>
                  <a:cxn ang="0">
                    <a:pos x="connsiteX194-389" y="connsiteY194-390"/>
                  </a:cxn>
                  <a:cxn ang="0">
                    <a:pos x="connsiteX195-391" y="connsiteY195-392"/>
                  </a:cxn>
                  <a:cxn ang="0">
                    <a:pos x="connsiteX196-393" y="connsiteY196-394"/>
                  </a:cxn>
                  <a:cxn ang="0">
                    <a:pos x="connsiteX197-395" y="connsiteY197-396"/>
                  </a:cxn>
                  <a:cxn ang="0">
                    <a:pos x="connsiteX198-397" y="connsiteY198-398"/>
                  </a:cxn>
                  <a:cxn ang="0">
                    <a:pos x="connsiteX199-399" y="connsiteY199-400"/>
                  </a:cxn>
                  <a:cxn ang="0">
                    <a:pos x="connsiteX200-401" y="connsiteY200-402"/>
                  </a:cxn>
                  <a:cxn ang="0">
                    <a:pos x="connsiteX201-403" y="connsiteY201-404"/>
                  </a:cxn>
                  <a:cxn ang="0">
                    <a:pos x="connsiteX202-405" y="connsiteY202-406"/>
                  </a:cxn>
                  <a:cxn ang="0">
                    <a:pos x="connsiteX203-407" y="connsiteY203-408"/>
                  </a:cxn>
                  <a:cxn ang="0">
                    <a:pos x="connsiteX204-409" y="connsiteY204-410"/>
                  </a:cxn>
                  <a:cxn ang="0">
                    <a:pos x="connsiteX205-411" y="connsiteY205-412"/>
                  </a:cxn>
                  <a:cxn ang="0">
                    <a:pos x="connsiteX206-413" y="connsiteY206-414"/>
                  </a:cxn>
                  <a:cxn ang="0">
                    <a:pos x="connsiteX207-415" y="connsiteY207-416"/>
                  </a:cxn>
                  <a:cxn ang="0">
                    <a:pos x="connsiteX208-417" y="connsiteY208-418"/>
                  </a:cxn>
                  <a:cxn ang="0">
                    <a:pos x="connsiteX209-419" y="connsiteY209-420"/>
                  </a:cxn>
                  <a:cxn ang="0">
                    <a:pos x="connsiteX210-421" y="connsiteY210-422"/>
                  </a:cxn>
                  <a:cxn ang="0">
                    <a:pos x="connsiteX211-423" y="connsiteY211-424"/>
                  </a:cxn>
                  <a:cxn ang="0">
                    <a:pos x="connsiteX212-425" y="connsiteY212-426"/>
                  </a:cxn>
                  <a:cxn ang="0">
                    <a:pos x="connsiteX213-427" y="connsiteY213-428"/>
                  </a:cxn>
                  <a:cxn ang="0">
                    <a:pos x="connsiteX214-429" y="connsiteY214-430"/>
                  </a:cxn>
                  <a:cxn ang="0">
                    <a:pos x="connsiteX215-431" y="connsiteY215-432"/>
                  </a:cxn>
                  <a:cxn ang="0">
                    <a:pos x="connsiteX216-433" y="connsiteY216-434"/>
                  </a:cxn>
                  <a:cxn ang="0">
                    <a:pos x="connsiteX217-435" y="connsiteY217-436"/>
                  </a:cxn>
                  <a:cxn ang="0">
                    <a:pos x="connsiteX218-437" y="connsiteY218-438"/>
                  </a:cxn>
                  <a:cxn ang="0">
                    <a:pos x="connsiteX219-439" y="connsiteY219-440"/>
                  </a:cxn>
                  <a:cxn ang="0">
                    <a:pos x="connsiteX220-441" y="connsiteY220-442"/>
                  </a:cxn>
                  <a:cxn ang="0">
                    <a:pos x="connsiteX221-443" y="connsiteY221-444"/>
                  </a:cxn>
                  <a:cxn ang="0">
                    <a:pos x="connsiteX222-445" y="connsiteY222-446"/>
                  </a:cxn>
                  <a:cxn ang="0">
                    <a:pos x="connsiteX223-447" y="connsiteY223-448"/>
                  </a:cxn>
                </a:cxnLst>
                <a:rect l="l" t="t" r="r" b="b"/>
                <a:pathLst>
                  <a:path w="10000" h="12290">
                    <a:moveTo>
                      <a:pt x="0" y="10000"/>
                    </a:moveTo>
                    <a:lnTo>
                      <a:pt x="0" y="12290"/>
                    </a:lnTo>
                    <a:lnTo>
                      <a:pt x="0" y="9926"/>
                    </a:lnTo>
                    <a:lnTo>
                      <a:pt x="0" y="9851"/>
                    </a:lnTo>
                    <a:lnTo>
                      <a:pt x="0" y="9814"/>
                    </a:lnTo>
                    <a:lnTo>
                      <a:pt x="0" y="9740"/>
                    </a:lnTo>
                    <a:lnTo>
                      <a:pt x="0" y="9703"/>
                    </a:lnTo>
                    <a:lnTo>
                      <a:pt x="0" y="9628"/>
                    </a:lnTo>
                    <a:cubicBezTo>
                      <a:pt x="40" y="9616"/>
                      <a:pt x="79" y="9603"/>
                      <a:pt x="119" y="9591"/>
                    </a:cubicBezTo>
                    <a:lnTo>
                      <a:pt x="119" y="9554"/>
                    </a:lnTo>
                    <a:lnTo>
                      <a:pt x="119" y="9480"/>
                    </a:lnTo>
                    <a:lnTo>
                      <a:pt x="119" y="9442"/>
                    </a:lnTo>
                    <a:lnTo>
                      <a:pt x="119" y="9368"/>
                    </a:lnTo>
                    <a:cubicBezTo>
                      <a:pt x="87" y="9504"/>
                      <a:pt x="55" y="9639"/>
                      <a:pt x="23" y="9775"/>
                    </a:cubicBezTo>
                    <a:lnTo>
                      <a:pt x="119" y="9331"/>
                    </a:lnTo>
                    <a:lnTo>
                      <a:pt x="119" y="9257"/>
                    </a:lnTo>
                    <a:lnTo>
                      <a:pt x="119" y="9219"/>
                    </a:lnTo>
                    <a:cubicBezTo>
                      <a:pt x="139" y="9207"/>
                      <a:pt x="159" y="9194"/>
                      <a:pt x="179" y="9182"/>
                    </a:cubicBezTo>
                    <a:lnTo>
                      <a:pt x="179" y="9071"/>
                    </a:lnTo>
                    <a:lnTo>
                      <a:pt x="179" y="8996"/>
                    </a:lnTo>
                    <a:lnTo>
                      <a:pt x="179" y="8959"/>
                    </a:lnTo>
                    <a:lnTo>
                      <a:pt x="179" y="8885"/>
                    </a:lnTo>
                    <a:lnTo>
                      <a:pt x="179" y="8848"/>
                    </a:lnTo>
                    <a:cubicBezTo>
                      <a:pt x="199" y="8823"/>
                      <a:pt x="218" y="8798"/>
                      <a:pt x="238" y="8773"/>
                    </a:cubicBezTo>
                    <a:lnTo>
                      <a:pt x="238" y="8736"/>
                    </a:lnTo>
                    <a:lnTo>
                      <a:pt x="238" y="8699"/>
                    </a:lnTo>
                    <a:lnTo>
                      <a:pt x="238" y="8625"/>
                    </a:lnTo>
                    <a:lnTo>
                      <a:pt x="238" y="8587"/>
                    </a:lnTo>
                    <a:lnTo>
                      <a:pt x="357" y="8513"/>
                    </a:lnTo>
                    <a:lnTo>
                      <a:pt x="357" y="8476"/>
                    </a:lnTo>
                    <a:lnTo>
                      <a:pt x="357" y="8401"/>
                    </a:lnTo>
                    <a:lnTo>
                      <a:pt x="357" y="8364"/>
                    </a:lnTo>
                    <a:lnTo>
                      <a:pt x="357" y="8327"/>
                    </a:lnTo>
                    <a:cubicBezTo>
                      <a:pt x="377" y="8302"/>
                      <a:pt x="397" y="8278"/>
                      <a:pt x="417" y="8253"/>
                    </a:cubicBezTo>
                    <a:lnTo>
                      <a:pt x="417" y="8216"/>
                    </a:lnTo>
                    <a:lnTo>
                      <a:pt x="417" y="8141"/>
                    </a:lnTo>
                    <a:lnTo>
                      <a:pt x="417" y="8104"/>
                    </a:lnTo>
                    <a:lnTo>
                      <a:pt x="536" y="8030"/>
                    </a:lnTo>
                    <a:lnTo>
                      <a:pt x="536" y="7993"/>
                    </a:lnTo>
                    <a:lnTo>
                      <a:pt x="536" y="7955"/>
                    </a:lnTo>
                    <a:lnTo>
                      <a:pt x="536" y="7881"/>
                    </a:lnTo>
                    <a:cubicBezTo>
                      <a:pt x="556" y="7869"/>
                      <a:pt x="575" y="7856"/>
                      <a:pt x="595" y="7844"/>
                    </a:cubicBezTo>
                    <a:lnTo>
                      <a:pt x="595" y="7770"/>
                    </a:lnTo>
                    <a:lnTo>
                      <a:pt x="595" y="7732"/>
                    </a:lnTo>
                    <a:lnTo>
                      <a:pt x="595" y="7658"/>
                    </a:lnTo>
                    <a:cubicBezTo>
                      <a:pt x="635" y="7646"/>
                      <a:pt x="674" y="7633"/>
                      <a:pt x="714" y="7621"/>
                    </a:cubicBezTo>
                    <a:lnTo>
                      <a:pt x="714" y="7546"/>
                    </a:lnTo>
                    <a:lnTo>
                      <a:pt x="714" y="7509"/>
                    </a:lnTo>
                    <a:cubicBezTo>
                      <a:pt x="734" y="7497"/>
                      <a:pt x="754" y="7484"/>
                      <a:pt x="774" y="7472"/>
                    </a:cubicBezTo>
                    <a:lnTo>
                      <a:pt x="774" y="7398"/>
                    </a:lnTo>
                    <a:lnTo>
                      <a:pt x="774" y="7361"/>
                    </a:lnTo>
                    <a:lnTo>
                      <a:pt x="774" y="7286"/>
                    </a:lnTo>
                    <a:cubicBezTo>
                      <a:pt x="814" y="7274"/>
                      <a:pt x="853" y="7261"/>
                      <a:pt x="893" y="7249"/>
                    </a:cubicBezTo>
                    <a:lnTo>
                      <a:pt x="893" y="7175"/>
                    </a:lnTo>
                    <a:lnTo>
                      <a:pt x="893" y="7138"/>
                    </a:lnTo>
                    <a:lnTo>
                      <a:pt x="952" y="7100"/>
                    </a:lnTo>
                    <a:lnTo>
                      <a:pt x="952" y="7026"/>
                    </a:lnTo>
                    <a:lnTo>
                      <a:pt x="952" y="6989"/>
                    </a:lnTo>
                    <a:lnTo>
                      <a:pt x="1012" y="6914"/>
                    </a:lnTo>
                    <a:lnTo>
                      <a:pt x="1012" y="6877"/>
                    </a:lnTo>
                    <a:lnTo>
                      <a:pt x="1012" y="6803"/>
                    </a:lnTo>
                    <a:cubicBezTo>
                      <a:pt x="1052" y="6791"/>
                      <a:pt x="1091" y="6778"/>
                      <a:pt x="1131" y="6766"/>
                    </a:cubicBezTo>
                    <a:lnTo>
                      <a:pt x="1131" y="6729"/>
                    </a:lnTo>
                    <a:lnTo>
                      <a:pt x="1131" y="6654"/>
                    </a:lnTo>
                    <a:cubicBezTo>
                      <a:pt x="1151" y="6642"/>
                      <a:pt x="1170" y="6629"/>
                      <a:pt x="1190" y="6617"/>
                    </a:cubicBezTo>
                    <a:lnTo>
                      <a:pt x="1190" y="6543"/>
                    </a:lnTo>
                    <a:lnTo>
                      <a:pt x="1190" y="6506"/>
                    </a:lnTo>
                    <a:lnTo>
                      <a:pt x="1310" y="6431"/>
                    </a:lnTo>
                    <a:lnTo>
                      <a:pt x="1310" y="6394"/>
                    </a:lnTo>
                    <a:lnTo>
                      <a:pt x="1369" y="6394"/>
                    </a:lnTo>
                    <a:lnTo>
                      <a:pt x="1369" y="6320"/>
                    </a:lnTo>
                    <a:lnTo>
                      <a:pt x="1369" y="6283"/>
                    </a:lnTo>
                    <a:lnTo>
                      <a:pt x="1488" y="6245"/>
                    </a:lnTo>
                    <a:lnTo>
                      <a:pt x="1488" y="6171"/>
                    </a:lnTo>
                    <a:lnTo>
                      <a:pt x="1488" y="6134"/>
                    </a:lnTo>
                    <a:lnTo>
                      <a:pt x="1548" y="6059"/>
                    </a:lnTo>
                    <a:lnTo>
                      <a:pt x="1548" y="6022"/>
                    </a:lnTo>
                    <a:lnTo>
                      <a:pt x="1607" y="5948"/>
                    </a:lnTo>
                    <a:lnTo>
                      <a:pt x="1607" y="5911"/>
                    </a:lnTo>
                    <a:cubicBezTo>
                      <a:pt x="1647" y="5899"/>
                      <a:pt x="1686" y="5886"/>
                      <a:pt x="1726" y="5874"/>
                    </a:cubicBezTo>
                    <a:lnTo>
                      <a:pt x="1726" y="5799"/>
                    </a:lnTo>
                    <a:lnTo>
                      <a:pt x="1726" y="5762"/>
                    </a:lnTo>
                    <a:cubicBezTo>
                      <a:pt x="1746" y="5737"/>
                      <a:pt x="1766" y="5713"/>
                      <a:pt x="1786" y="5688"/>
                    </a:cubicBezTo>
                    <a:lnTo>
                      <a:pt x="1786" y="5651"/>
                    </a:lnTo>
                    <a:lnTo>
                      <a:pt x="1905" y="5576"/>
                    </a:lnTo>
                    <a:lnTo>
                      <a:pt x="1905" y="5539"/>
                    </a:lnTo>
                    <a:cubicBezTo>
                      <a:pt x="1925" y="5527"/>
                      <a:pt x="1944" y="5514"/>
                      <a:pt x="1964" y="5502"/>
                    </a:cubicBezTo>
                    <a:lnTo>
                      <a:pt x="1964" y="5428"/>
                    </a:lnTo>
                    <a:lnTo>
                      <a:pt x="1964" y="5390"/>
                    </a:lnTo>
                    <a:lnTo>
                      <a:pt x="2083" y="5390"/>
                    </a:lnTo>
                    <a:lnTo>
                      <a:pt x="2083" y="5316"/>
                    </a:lnTo>
                    <a:cubicBezTo>
                      <a:pt x="2103" y="5304"/>
                      <a:pt x="2123" y="5291"/>
                      <a:pt x="2143" y="5279"/>
                    </a:cubicBezTo>
                    <a:lnTo>
                      <a:pt x="2143" y="5204"/>
                    </a:lnTo>
                    <a:cubicBezTo>
                      <a:pt x="2163" y="5192"/>
                      <a:pt x="2182" y="5179"/>
                      <a:pt x="2202" y="5167"/>
                    </a:cubicBezTo>
                    <a:lnTo>
                      <a:pt x="2202" y="5093"/>
                    </a:lnTo>
                    <a:cubicBezTo>
                      <a:pt x="2242" y="5081"/>
                      <a:pt x="2281" y="5068"/>
                      <a:pt x="2321" y="5056"/>
                    </a:cubicBezTo>
                    <a:lnTo>
                      <a:pt x="2321" y="5019"/>
                    </a:lnTo>
                    <a:lnTo>
                      <a:pt x="2381" y="4944"/>
                    </a:lnTo>
                    <a:lnTo>
                      <a:pt x="2381" y="4907"/>
                    </a:lnTo>
                    <a:lnTo>
                      <a:pt x="2500" y="4833"/>
                    </a:lnTo>
                    <a:lnTo>
                      <a:pt x="2500" y="4796"/>
                    </a:lnTo>
                    <a:lnTo>
                      <a:pt x="2560" y="4796"/>
                    </a:lnTo>
                    <a:lnTo>
                      <a:pt x="2560" y="4721"/>
                    </a:lnTo>
                    <a:cubicBezTo>
                      <a:pt x="2600" y="4709"/>
                      <a:pt x="2639" y="4696"/>
                      <a:pt x="2679" y="4684"/>
                    </a:cubicBezTo>
                    <a:lnTo>
                      <a:pt x="2679" y="4647"/>
                    </a:lnTo>
                    <a:cubicBezTo>
                      <a:pt x="2699" y="4622"/>
                      <a:pt x="2718" y="4597"/>
                      <a:pt x="2738" y="4572"/>
                    </a:cubicBezTo>
                    <a:lnTo>
                      <a:pt x="2738" y="4535"/>
                    </a:lnTo>
                    <a:lnTo>
                      <a:pt x="2857" y="4461"/>
                    </a:lnTo>
                    <a:lnTo>
                      <a:pt x="2857" y="4424"/>
                    </a:lnTo>
                    <a:lnTo>
                      <a:pt x="2917" y="4349"/>
                    </a:lnTo>
                    <a:lnTo>
                      <a:pt x="2917" y="4312"/>
                    </a:lnTo>
                    <a:lnTo>
                      <a:pt x="2976" y="4312"/>
                    </a:lnTo>
                    <a:cubicBezTo>
                      <a:pt x="3016" y="4300"/>
                      <a:pt x="3055" y="4287"/>
                      <a:pt x="3095" y="4275"/>
                    </a:cubicBezTo>
                    <a:lnTo>
                      <a:pt x="3095" y="4201"/>
                    </a:lnTo>
                    <a:cubicBezTo>
                      <a:pt x="3115" y="4189"/>
                      <a:pt x="3135" y="4176"/>
                      <a:pt x="3155" y="4164"/>
                    </a:cubicBezTo>
                    <a:lnTo>
                      <a:pt x="3155" y="4089"/>
                    </a:lnTo>
                    <a:cubicBezTo>
                      <a:pt x="3195" y="4077"/>
                      <a:pt x="3234" y="4064"/>
                      <a:pt x="3274" y="4052"/>
                    </a:cubicBezTo>
                    <a:lnTo>
                      <a:pt x="3274" y="3978"/>
                    </a:lnTo>
                    <a:cubicBezTo>
                      <a:pt x="3294" y="3966"/>
                      <a:pt x="3313" y="3953"/>
                      <a:pt x="3333" y="3941"/>
                    </a:cubicBezTo>
                    <a:lnTo>
                      <a:pt x="3333" y="3941"/>
                    </a:lnTo>
                    <a:lnTo>
                      <a:pt x="3452" y="3866"/>
                    </a:lnTo>
                    <a:cubicBezTo>
                      <a:pt x="3472" y="3854"/>
                      <a:pt x="3492" y="3841"/>
                      <a:pt x="3512" y="3829"/>
                    </a:cubicBezTo>
                    <a:lnTo>
                      <a:pt x="3512" y="3792"/>
                    </a:lnTo>
                    <a:cubicBezTo>
                      <a:pt x="3532" y="3767"/>
                      <a:pt x="3551" y="3742"/>
                      <a:pt x="3571" y="3717"/>
                    </a:cubicBezTo>
                    <a:lnTo>
                      <a:pt x="3571" y="3680"/>
                    </a:lnTo>
                    <a:lnTo>
                      <a:pt x="3690" y="3606"/>
                    </a:lnTo>
                    <a:lnTo>
                      <a:pt x="3750" y="3606"/>
                    </a:lnTo>
                    <a:lnTo>
                      <a:pt x="3750" y="3569"/>
                    </a:lnTo>
                    <a:lnTo>
                      <a:pt x="3869" y="3494"/>
                    </a:lnTo>
                    <a:lnTo>
                      <a:pt x="3869" y="3457"/>
                    </a:lnTo>
                    <a:cubicBezTo>
                      <a:pt x="3889" y="3445"/>
                      <a:pt x="3909" y="3432"/>
                      <a:pt x="3929" y="3420"/>
                    </a:cubicBezTo>
                    <a:lnTo>
                      <a:pt x="4048" y="3346"/>
                    </a:lnTo>
                    <a:lnTo>
                      <a:pt x="4048" y="3346"/>
                    </a:lnTo>
                    <a:cubicBezTo>
                      <a:pt x="4068" y="3334"/>
                      <a:pt x="4087" y="3321"/>
                      <a:pt x="4107" y="3309"/>
                    </a:cubicBezTo>
                    <a:lnTo>
                      <a:pt x="4167" y="3234"/>
                    </a:lnTo>
                    <a:lnTo>
                      <a:pt x="4167" y="3197"/>
                    </a:lnTo>
                    <a:lnTo>
                      <a:pt x="4286" y="3123"/>
                    </a:lnTo>
                    <a:lnTo>
                      <a:pt x="4286" y="3086"/>
                    </a:lnTo>
                    <a:lnTo>
                      <a:pt x="4345" y="3086"/>
                    </a:lnTo>
                    <a:lnTo>
                      <a:pt x="4464" y="3048"/>
                    </a:lnTo>
                    <a:lnTo>
                      <a:pt x="4464" y="2974"/>
                    </a:lnTo>
                    <a:cubicBezTo>
                      <a:pt x="4484" y="2962"/>
                      <a:pt x="4504" y="2949"/>
                      <a:pt x="4524" y="2937"/>
                    </a:cubicBezTo>
                    <a:lnTo>
                      <a:pt x="4643" y="2862"/>
                    </a:lnTo>
                    <a:lnTo>
                      <a:pt x="4643" y="2862"/>
                    </a:lnTo>
                    <a:cubicBezTo>
                      <a:pt x="4663" y="2850"/>
                      <a:pt x="4682" y="2837"/>
                      <a:pt x="4702" y="2825"/>
                    </a:cubicBezTo>
                    <a:lnTo>
                      <a:pt x="4821" y="2751"/>
                    </a:lnTo>
                    <a:lnTo>
                      <a:pt x="4821" y="2714"/>
                    </a:lnTo>
                    <a:lnTo>
                      <a:pt x="4881" y="2639"/>
                    </a:lnTo>
                    <a:lnTo>
                      <a:pt x="4940" y="2639"/>
                    </a:lnTo>
                    <a:lnTo>
                      <a:pt x="4940" y="2602"/>
                    </a:lnTo>
                    <a:lnTo>
                      <a:pt x="5060" y="2565"/>
                    </a:lnTo>
                    <a:lnTo>
                      <a:pt x="5119" y="2491"/>
                    </a:lnTo>
                    <a:lnTo>
                      <a:pt x="5119" y="2491"/>
                    </a:lnTo>
                    <a:cubicBezTo>
                      <a:pt x="5159" y="2479"/>
                      <a:pt x="5198" y="2466"/>
                      <a:pt x="5238" y="2454"/>
                    </a:cubicBezTo>
                    <a:lnTo>
                      <a:pt x="5298" y="2379"/>
                    </a:lnTo>
                    <a:cubicBezTo>
                      <a:pt x="5338" y="2367"/>
                      <a:pt x="5377" y="2354"/>
                      <a:pt x="5417" y="2342"/>
                    </a:cubicBezTo>
                    <a:lnTo>
                      <a:pt x="5417" y="2342"/>
                    </a:lnTo>
                    <a:lnTo>
                      <a:pt x="5476" y="2268"/>
                    </a:lnTo>
                    <a:cubicBezTo>
                      <a:pt x="5496" y="2255"/>
                      <a:pt x="5516" y="2243"/>
                      <a:pt x="5536" y="2230"/>
                    </a:cubicBezTo>
                    <a:lnTo>
                      <a:pt x="5536" y="2193"/>
                    </a:lnTo>
                    <a:lnTo>
                      <a:pt x="5655" y="2193"/>
                    </a:lnTo>
                    <a:lnTo>
                      <a:pt x="5714" y="2119"/>
                    </a:lnTo>
                    <a:cubicBezTo>
                      <a:pt x="5754" y="2107"/>
                      <a:pt x="5793" y="2094"/>
                      <a:pt x="5833" y="2082"/>
                    </a:cubicBezTo>
                    <a:lnTo>
                      <a:pt x="5833" y="2007"/>
                    </a:lnTo>
                    <a:lnTo>
                      <a:pt x="5893" y="2007"/>
                    </a:lnTo>
                    <a:cubicBezTo>
                      <a:pt x="5933" y="1995"/>
                      <a:pt x="5972" y="1982"/>
                      <a:pt x="6012" y="1970"/>
                    </a:cubicBezTo>
                    <a:lnTo>
                      <a:pt x="6071" y="1896"/>
                    </a:lnTo>
                    <a:lnTo>
                      <a:pt x="6071" y="1859"/>
                    </a:lnTo>
                    <a:lnTo>
                      <a:pt x="6131" y="1859"/>
                    </a:lnTo>
                    <a:cubicBezTo>
                      <a:pt x="6171" y="1847"/>
                      <a:pt x="6210" y="1834"/>
                      <a:pt x="6250" y="1822"/>
                    </a:cubicBezTo>
                    <a:lnTo>
                      <a:pt x="6250" y="1747"/>
                    </a:lnTo>
                    <a:cubicBezTo>
                      <a:pt x="6270" y="1735"/>
                      <a:pt x="6290" y="1722"/>
                      <a:pt x="6310" y="1710"/>
                    </a:cubicBezTo>
                    <a:lnTo>
                      <a:pt x="6429" y="1710"/>
                    </a:lnTo>
                    <a:lnTo>
                      <a:pt x="6488" y="1636"/>
                    </a:lnTo>
                    <a:cubicBezTo>
                      <a:pt x="6528" y="1624"/>
                      <a:pt x="6567" y="1611"/>
                      <a:pt x="6607" y="1599"/>
                    </a:cubicBezTo>
                    <a:lnTo>
                      <a:pt x="6607" y="1599"/>
                    </a:lnTo>
                    <a:lnTo>
                      <a:pt x="6667" y="1524"/>
                    </a:lnTo>
                    <a:cubicBezTo>
                      <a:pt x="6687" y="1512"/>
                      <a:pt x="6706" y="1499"/>
                      <a:pt x="6726" y="1487"/>
                    </a:cubicBezTo>
                    <a:lnTo>
                      <a:pt x="6845" y="1487"/>
                    </a:lnTo>
                    <a:lnTo>
                      <a:pt x="6845" y="1413"/>
                    </a:lnTo>
                    <a:cubicBezTo>
                      <a:pt x="6865" y="1400"/>
                      <a:pt x="6885" y="1388"/>
                      <a:pt x="6905" y="1375"/>
                    </a:cubicBezTo>
                    <a:lnTo>
                      <a:pt x="7024" y="1375"/>
                    </a:lnTo>
                    <a:cubicBezTo>
                      <a:pt x="7044" y="1363"/>
                      <a:pt x="7063" y="1350"/>
                      <a:pt x="7083" y="1338"/>
                    </a:cubicBezTo>
                    <a:lnTo>
                      <a:pt x="7202" y="1264"/>
                    </a:lnTo>
                    <a:lnTo>
                      <a:pt x="7202" y="1264"/>
                    </a:lnTo>
                    <a:cubicBezTo>
                      <a:pt x="7222" y="1252"/>
                      <a:pt x="7242" y="1239"/>
                      <a:pt x="7262" y="1227"/>
                    </a:cubicBezTo>
                    <a:lnTo>
                      <a:pt x="7381" y="1152"/>
                    </a:lnTo>
                    <a:lnTo>
                      <a:pt x="7440" y="1152"/>
                    </a:lnTo>
                    <a:cubicBezTo>
                      <a:pt x="7460" y="1140"/>
                      <a:pt x="7480" y="1127"/>
                      <a:pt x="7500" y="1115"/>
                    </a:cubicBezTo>
                    <a:lnTo>
                      <a:pt x="7500" y="1041"/>
                    </a:lnTo>
                    <a:lnTo>
                      <a:pt x="7619" y="1041"/>
                    </a:lnTo>
                    <a:cubicBezTo>
                      <a:pt x="7639" y="1029"/>
                      <a:pt x="7659" y="1016"/>
                      <a:pt x="7679" y="1004"/>
                    </a:cubicBezTo>
                    <a:cubicBezTo>
                      <a:pt x="7719" y="992"/>
                      <a:pt x="7758" y="979"/>
                      <a:pt x="7798" y="967"/>
                    </a:cubicBezTo>
                    <a:lnTo>
                      <a:pt x="7857" y="967"/>
                    </a:lnTo>
                    <a:lnTo>
                      <a:pt x="7857" y="892"/>
                    </a:lnTo>
                    <a:cubicBezTo>
                      <a:pt x="7897" y="880"/>
                      <a:pt x="7936" y="867"/>
                      <a:pt x="7976" y="855"/>
                    </a:cubicBezTo>
                    <a:lnTo>
                      <a:pt x="8036" y="855"/>
                    </a:lnTo>
                    <a:lnTo>
                      <a:pt x="8095" y="781"/>
                    </a:lnTo>
                    <a:lnTo>
                      <a:pt x="8214" y="743"/>
                    </a:lnTo>
                    <a:lnTo>
                      <a:pt x="8274" y="743"/>
                    </a:lnTo>
                    <a:lnTo>
                      <a:pt x="8274" y="669"/>
                    </a:lnTo>
                    <a:lnTo>
                      <a:pt x="8393" y="669"/>
                    </a:lnTo>
                    <a:cubicBezTo>
                      <a:pt x="8413" y="657"/>
                      <a:pt x="8432" y="644"/>
                      <a:pt x="8452" y="632"/>
                    </a:cubicBezTo>
                    <a:cubicBezTo>
                      <a:pt x="8492" y="620"/>
                      <a:pt x="8531" y="607"/>
                      <a:pt x="8571" y="595"/>
                    </a:cubicBezTo>
                    <a:lnTo>
                      <a:pt x="8631" y="595"/>
                    </a:lnTo>
                    <a:cubicBezTo>
                      <a:pt x="8651" y="570"/>
                      <a:pt x="8670" y="545"/>
                      <a:pt x="8690" y="520"/>
                    </a:cubicBezTo>
                    <a:lnTo>
                      <a:pt x="8690" y="520"/>
                    </a:lnTo>
                    <a:lnTo>
                      <a:pt x="8810" y="483"/>
                    </a:lnTo>
                    <a:lnTo>
                      <a:pt x="8869" y="409"/>
                    </a:lnTo>
                    <a:lnTo>
                      <a:pt x="8988" y="409"/>
                    </a:lnTo>
                    <a:cubicBezTo>
                      <a:pt x="9008" y="397"/>
                      <a:pt x="9028" y="384"/>
                      <a:pt x="9048" y="372"/>
                    </a:cubicBezTo>
                    <a:lnTo>
                      <a:pt x="9167" y="372"/>
                    </a:lnTo>
                    <a:cubicBezTo>
                      <a:pt x="9187" y="347"/>
                      <a:pt x="9206" y="322"/>
                      <a:pt x="9226" y="297"/>
                    </a:cubicBezTo>
                    <a:lnTo>
                      <a:pt x="9226" y="297"/>
                    </a:lnTo>
                    <a:cubicBezTo>
                      <a:pt x="9266" y="285"/>
                      <a:pt x="9305" y="272"/>
                      <a:pt x="9345" y="260"/>
                    </a:cubicBezTo>
                    <a:cubicBezTo>
                      <a:pt x="9365" y="235"/>
                      <a:pt x="9385" y="211"/>
                      <a:pt x="9405" y="186"/>
                    </a:cubicBezTo>
                    <a:lnTo>
                      <a:pt x="9464" y="186"/>
                    </a:lnTo>
                    <a:cubicBezTo>
                      <a:pt x="9504" y="174"/>
                      <a:pt x="9543" y="161"/>
                      <a:pt x="9583" y="149"/>
                    </a:cubicBezTo>
                    <a:lnTo>
                      <a:pt x="9643" y="149"/>
                    </a:lnTo>
                    <a:cubicBezTo>
                      <a:pt x="9683" y="137"/>
                      <a:pt x="9722" y="124"/>
                      <a:pt x="9762" y="112"/>
                    </a:cubicBezTo>
                    <a:lnTo>
                      <a:pt x="9821" y="112"/>
                    </a:lnTo>
                    <a:lnTo>
                      <a:pt x="9940" y="37"/>
                    </a:lnTo>
                    <a:lnTo>
                      <a:pt x="9940" y="37"/>
                    </a:lnTo>
                    <a:cubicBezTo>
                      <a:pt x="9960" y="25"/>
                      <a:pt x="9980" y="12"/>
                      <a:pt x="10000" y="0"/>
                    </a:cubicBezTo>
                  </a:path>
                </a:pathLst>
              </a:custGeom>
              <a:noFill/>
              <a:ln w="9525" cap="sq">
                <a:solidFill>
                  <a:srgbClr val="0070C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423" name="椭圆 422"/>
            <p:cNvSpPr/>
            <p:nvPr/>
          </p:nvSpPr>
          <p:spPr>
            <a:xfrm>
              <a:off x="5998497" y="491650"/>
              <a:ext cx="100013" cy="100013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24" name="椭圆 423"/>
            <p:cNvSpPr/>
            <p:nvPr/>
          </p:nvSpPr>
          <p:spPr>
            <a:xfrm>
              <a:off x="6459035" y="521771"/>
              <a:ext cx="100013" cy="100013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25" name="椭圆 424"/>
            <p:cNvSpPr/>
            <p:nvPr/>
          </p:nvSpPr>
          <p:spPr>
            <a:xfrm>
              <a:off x="6696327" y="574676"/>
              <a:ext cx="100013" cy="100013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26" name="椭圆 425"/>
            <p:cNvSpPr/>
            <p:nvPr/>
          </p:nvSpPr>
          <p:spPr>
            <a:xfrm>
              <a:off x="6921949" y="646907"/>
              <a:ext cx="100013" cy="100013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27" name="椭圆 426"/>
            <p:cNvSpPr/>
            <p:nvPr/>
          </p:nvSpPr>
          <p:spPr>
            <a:xfrm>
              <a:off x="6230938" y="499652"/>
              <a:ext cx="100013" cy="100013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28" name="椭圆 427"/>
            <p:cNvSpPr/>
            <p:nvPr/>
          </p:nvSpPr>
          <p:spPr>
            <a:xfrm>
              <a:off x="7147630" y="750888"/>
              <a:ext cx="100013" cy="100013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29" name="椭圆 428"/>
            <p:cNvSpPr/>
            <p:nvPr/>
          </p:nvSpPr>
          <p:spPr>
            <a:xfrm>
              <a:off x="7357088" y="850900"/>
              <a:ext cx="100013" cy="100013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30" name="椭圆 429"/>
            <p:cNvSpPr/>
            <p:nvPr/>
          </p:nvSpPr>
          <p:spPr>
            <a:xfrm>
              <a:off x="7561129" y="960352"/>
              <a:ext cx="100013" cy="100013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31" name="椭圆 430"/>
            <p:cNvSpPr/>
            <p:nvPr/>
          </p:nvSpPr>
          <p:spPr>
            <a:xfrm>
              <a:off x="7755968" y="1112770"/>
              <a:ext cx="100013" cy="100013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32" name="椭圆 431"/>
            <p:cNvSpPr/>
            <p:nvPr/>
          </p:nvSpPr>
          <p:spPr>
            <a:xfrm>
              <a:off x="8131175" y="1464083"/>
              <a:ext cx="100013" cy="100013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33" name="椭圆 432"/>
            <p:cNvSpPr/>
            <p:nvPr/>
          </p:nvSpPr>
          <p:spPr>
            <a:xfrm>
              <a:off x="7965951" y="1268868"/>
              <a:ext cx="100013" cy="100013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34" name="椭圆 433"/>
            <p:cNvSpPr/>
            <p:nvPr/>
          </p:nvSpPr>
          <p:spPr>
            <a:xfrm>
              <a:off x="8410186" y="1848644"/>
              <a:ext cx="100013" cy="100013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35" name="椭圆 434"/>
            <p:cNvSpPr/>
            <p:nvPr/>
          </p:nvSpPr>
          <p:spPr>
            <a:xfrm>
              <a:off x="8267141" y="1661728"/>
              <a:ext cx="100013" cy="100013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36" name="椭圆 435"/>
            <p:cNvSpPr/>
            <p:nvPr/>
          </p:nvSpPr>
          <p:spPr>
            <a:xfrm>
              <a:off x="8520113" y="2052617"/>
              <a:ext cx="100013" cy="100013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37" name="椭圆 436"/>
            <p:cNvSpPr/>
            <p:nvPr/>
          </p:nvSpPr>
          <p:spPr>
            <a:xfrm>
              <a:off x="8603400" y="2283500"/>
              <a:ext cx="100013" cy="100013"/>
            </a:xfrm>
            <a:prstGeom prst="ellipse">
              <a:avLst/>
            </a:prstGeom>
            <a:solidFill>
              <a:srgbClr val="FFFF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38" name="椭圆 437"/>
            <p:cNvSpPr/>
            <p:nvPr/>
          </p:nvSpPr>
          <p:spPr>
            <a:xfrm>
              <a:off x="8674504" y="2513847"/>
              <a:ext cx="100013" cy="100013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39" name="椭圆 438"/>
            <p:cNvSpPr/>
            <p:nvPr/>
          </p:nvSpPr>
          <p:spPr>
            <a:xfrm>
              <a:off x="8736012" y="2754313"/>
              <a:ext cx="100013" cy="100013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40" name="椭圆 439"/>
            <p:cNvSpPr/>
            <p:nvPr/>
          </p:nvSpPr>
          <p:spPr>
            <a:xfrm>
              <a:off x="8773248" y="2989105"/>
              <a:ext cx="100013" cy="100013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41" name="椭圆 440"/>
            <p:cNvSpPr/>
            <p:nvPr/>
          </p:nvSpPr>
          <p:spPr>
            <a:xfrm>
              <a:off x="8795459" y="3240105"/>
              <a:ext cx="100013" cy="100013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42" name="椭圆 441"/>
            <p:cNvSpPr/>
            <p:nvPr/>
          </p:nvSpPr>
          <p:spPr>
            <a:xfrm>
              <a:off x="8795458" y="3482181"/>
              <a:ext cx="100013" cy="100013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43" name="椭圆 442"/>
            <p:cNvSpPr/>
            <p:nvPr/>
          </p:nvSpPr>
          <p:spPr>
            <a:xfrm>
              <a:off x="8783201" y="3733801"/>
              <a:ext cx="100013" cy="100013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44" name="椭圆 443"/>
            <p:cNvSpPr/>
            <p:nvPr/>
          </p:nvSpPr>
          <p:spPr>
            <a:xfrm>
              <a:off x="8743950" y="3965576"/>
              <a:ext cx="100013" cy="100013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45" name="椭圆 444"/>
            <p:cNvSpPr/>
            <p:nvPr/>
          </p:nvSpPr>
          <p:spPr>
            <a:xfrm>
              <a:off x="8678128" y="4196703"/>
              <a:ext cx="100013" cy="100013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46" name="椭圆 445"/>
            <p:cNvSpPr/>
            <p:nvPr/>
          </p:nvSpPr>
          <p:spPr>
            <a:xfrm>
              <a:off x="8596802" y="4432938"/>
              <a:ext cx="100013" cy="100013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47" name="椭圆 446"/>
            <p:cNvSpPr/>
            <p:nvPr/>
          </p:nvSpPr>
          <p:spPr>
            <a:xfrm>
              <a:off x="8497888" y="4646613"/>
              <a:ext cx="100013" cy="100013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50" name="椭圆 449"/>
            <p:cNvSpPr/>
            <p:nvPr/>
          </p:nvSpPr>
          <p:spPr>
            <a:xfrm>
              <a:off x="8353536" y="4833938"/>
              <a:ext cx="100013" cy="100013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51" name="椭圆 450"/>
            <p:cNvSpPr/>
            <p:nvPr/>
          </p:nvSpPr>
          <p:spPr>
            <a:xfrm>
              <a:off x="8205788" y="5053014"/>
              <a:ext cx="100013" cy="100013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52" name="椭圆 451"/>
            <p:cNvSpPr/>
            <p:nvPr/>
          </p:nvSpPr>
          <p:spPr>
            <a:xfrm>
              <a:off x="8055621" y="5227639"/>
              <a:ext cx="100013" cy="100013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53" name="椭圆 452"/>
            <p:cNvSpPr/>
            <p:nvPr/>
          </p:nvSpPr>
          <p:spPr>
            <a:xfrm>
              <a:off x="7888358" y="5412082"/>
              <a:ext cx="100013" cy="100013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54" name="椭圆 453"/>
            <p:cNvSpPr/>
            <p:nvPr/>
          </p:nvSpPr>
          <p:spPr>
            <a:xfrm>
              <a:off x="7693818" y="5576496"/>
              <a:ext cx="100013" cy="100013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55" name="椭圆 454"/>
            <p:cNvSpPr/>
            <p:nvPr/>
          </p:nvSpPr>
          <p:spPr>
            <a:xfrm>
              <a:off x="7498556" y="5697539"/>
              <a:ext cx="100013" cy="100013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56" name="椭圆 455"/>
            <p:cNvSpPr/>
            <p:nvPr/>
          </p:nvSpPr>
          <p:spPr>
            <a:xfrm>
              <a:off x="7269162" y="5825061"/>
              <a:ext cx="100013" cy="100013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57" name="椭圆 456"/>
            <p:cNvSpPr/>
            <p:nvPr/>
          </p:nvSpPr>
          <p:spPr>
            <a:xfrm>
              <a:off x="7064375" y="5927770"/>
              <a:ext cx="100013" cy="100013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58" name="椭圆 457"/>
            <p:cNvSpPr/>
            <p:nvPr/>
          </p:nvSpPr>
          <p:spPr>
            <a:xfrm>
              <a:off x="6844118" y="6011067"/>
              <a:ext cx="100013" cy="100013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59" name="椭圆 458"/>
            <p:cNvSpPr/>
            <p:nvPr/>
          </p:nvSpPr>
          <p:spPr>
            <a:xfrm>
              <a:off x="6598150" y="6079330"/>
              <a:ext cx="100013" cy="100013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60" name="椭圆 459"/>
            <p:cNvSpPr/>
            <p:nvPr/>
          </p:nvSpPr>
          <p:spPr>
            <a:xfrm>
              <a:off x="6358390" y="6126957"/>
              <a:ext cx="100013" cy="100013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62" name="椭圆 461"/>
            <p:cNvSpPr/>
            <p:nvPr/>
          </p:nvSpPr>
          <p:spPr>
            <a:xfrm>
              <a:off x="6118312" y="6137061"/>
              <a:ext cx="100013" cy="100013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63" name="椭圆 462"/>
            <p:cNvSpPr/>
            <p:nvPr/>
          </p:nvSpPr>
          <p:spPr>
            <a:xfrm>
              <a:off x="5881881" y="6162401"/>
              <a:ext cx="100013" cy="100013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64" name="椭圆 463"/>
            <p:cNvSpPr/>
            <p:nvPr/>
          </p:nvSpPr>
          <p:spPr>
            <a:xfrm>
              <a:off x="5631656" y="6122682"/>
              <a:ext cx="100013" cy="100013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65" name="椭圆 464"/>
            <p:cNvSpPr/>
            <p:nvPr/>
          </p:nvSpPr>
          <p:spPr>
            <a:xfrm>
              <a:off x="5393546" y="6079330"/>
              <a:ext cx="100013" cy="100013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66" name="椭圆 465"/>
            <p:cNvSpPr/>
            <p:nvPr/>
          </p:nvSpPr>
          <p:spPr>
            <a:xfrm>
              <a:off x="5175108" y="6018391"/>
              <a:ext cx="100013" cy="100013"/>
            </a:xfrm>
            <a:prstGeom prst="ellipse">
              <a:avLst/>
            </a:prstGeom>
            <a:solidFill>
              <a:srgbClr val="FFFF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67" name="椭圆 466"/>
            <p:cNvSpPr/>
            <p:nvPr/>
          </p:nvSpPr>
          <p:spPr>
            <a:xfrm>
              <a:off x="4942762" y="5954103"/>
              <a:ext cx="100013" cy="100013"/>
            </a:xfrm>
            <a:prstGeom prst="ellipse">
              <a:avLst/>
            </a:prstGeom>
            <a:solidFill>
              <a:srgbClr val="FFFF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68" name="椭圆 467"/>
            <p:cNvSpPr/>
            <p:nvPr/>
          </p:nvSpPr>
          <p:spPr>
            <a:xfrm>
              <a:off x="4703590" y="5857874"/>
              <a:ext cx="100013" cy="100013"/>
            </a:xfrm>
            <a:prstGeom prst="ellipse">
              <a:avLst/>
            </a:prstGeom>
            <a:solidFill>
              <a:srgbClr val="FFFF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69" name="椭圆 468"/>
            <p:cNvSpPr/>
            <p:nvPr/>
          </p:nvSpPr>
          <p:spPr>
            <a:xfrm>
              <a:off x="4504728" y="5722145"/>
              <a:ext cx="100013" cy="100013"/>
            </a:xfrm>
            <a:prstGeom prst="ellipse">
              <a:avLst/>
            </a:prstGeom>
            <a:solidFill>
              <a:srgbClr val="FFFF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70" name="椭圆 469"/>
            <p:cNvSpPr/>
            <p:nvPr/>
          </p:nvSpPr>
          <p:spPr>
            <a:xfrm>
              <a:off x="4285840" y="5588726"/>
              <a:ext cx="100013" cy="100013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71" name="椭圆 470"/>
            <p:cNvSpPr/>
            <p:nvPr/>
          </p:nvSpPr>
          <p:spPr>
            <a:xfrm>
              <a:off x="4092435" y="5424135"/>
              <a:ext cx="100013" cy="100013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72" name="椭圆 471"/>
            <p:cNvSpPr/>
            <p:nvPr/>
          </p:nvSpPr>
          <p:spPr>
            <a:xfrm>
              <a:off x="3919109" y="5264944"/>
              <a:ext cx="100013" cy="100013"/>
            </a:xfrm>
            <a:prstGeom prst="ellipse">
              <a:avLst/>
            </a:prstGeom>
            <a:solidFill>
              <a:srgbClr val="FFFF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73" name="椭圆 472"/>
            <p:cNvSpPr/>
            <p:nvPr/>
          </p:nvSpPr>
          <p:spPr>
            <a:xfrm>
              <a:off x="3740200" y="5063331"/>
              <a:ext cx="100013" cy="100013"/>
            </a:xfrm>
            <a:prstGeom prst="ellipse">
              <a:avLst/>
            </a:prstGeom>
            <a:solidFill>
              <a:srgbClr val="FFFF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74" name="椭圆 473"/>
            <p:cNvSpPr/>
            <p:nvPr/>
          </p:nvSpPr>
          <p:spPr>
            <a:xfrm>
              <a:off x="3619672" y="4865516"/>
              <a:ext cx="100013" cy="100013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75" name="椭圆 474"/>
            <p:cNvSpPr/>
            <p:nvPr/>
          </p:nvSpPr>
          <p:spPr>
            <a:xfrm>
              <a:off x="3496610" y="4660680"/>
              <a:ext cx="100013" cy="100013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76" name="椭圆 475"/>
            <p:cNvSpPr/>
            <p:nvPr/>
          </p:nvSpPr>
          <p:spPr>
            <a:xfrm>
              <a:off x="3282951" y="4240843"/>
              <a:ext cx="100012" cy="100012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77" name="椭圆 476"/>
            <p:cNvSpPr/>
            <p:nvPr/>
          </p:nvSpPr>
          <p:spPr>
            <a:xfrm>
              <a:off x="3399117" y="4443740"/>
              <a:ext cx="100013" cy="100013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78" name="椭圆 477"/>
            <p:cNvSpPr/>
            <p:nvPr/>
          </p:nvSpPr>
          <p:spPr>
            <a:xfrm>
              <a:off x="3182657" y="3745376"/>
              <a:ext cx="100012" cy="100012"/>
            </a:xfrm>
            <a:prstGeom prst="ellipse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79" name="椭圆 478"/>
            <p:cNvSpPr/>
            <p:nvPr/>
          </p:nvSpPr>
          <p:spPr>
            <a:xfrm>
              <a:off x="3243961" y="3980998"/>
              <a:ext cx="100012" cy="100012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80" name="椭圆 479"/>
            <p:cNvSpPr/>
            <p:nvPr/>
          </p:nvSpPr>
          <p:spPr>
            <a:xfrm>
              <a:off x="3140573" y="3499644"/>
              <a:ext cx="100012" cy="100012"/>
            </a:xfrm>
            <a:prstGeom prst="ellipse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81" name="椭圆 480"/>
            <p:cNvSpPr/>
            <p:nvPr/>
          </p:nvSpPr>
          <p:spPr>
            <a:xfrm>
              <a:off x="3151060" y="3266233"/>
              <a:ext cx="100012" cy="100012"/>
            </a:xfrm>
            <a:prstGeom prst="ellipse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82" name="椭圆 481"/>
            <p:cNvSpPr/>
            <p:nvPr/>
          </p:nvSpPr>
          <p:spPr>
            <a:xfrm>
              <a:off x="3158871" y="3025481"/>
              <a:ext cx="100012" cy="100012"/>
            </a:xfrm>
            <a:prstGeom prst="ellipse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83" name="椭圆 482"/>
            <p:cNvSpPr/>
            <p:nvPr/>
          </p:nvSpPr>
          <p:spPr>
            <a:xfrm>
              <a:off x="3190002" y="2763674"/>
              <a:ext cx="100012" cy="100012"/>
            </a:xfrm>
            <a:prstGeom prst="ellipse">
              <a:avLst/>
            </a:prstGeom>
            <a:solidFill>
              <a:srgbClr val="FFFF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84" name="椭圆 483"/>
            <p:cNvSpPr/>
            <p:nvPr/>
          </p:nvSpPr>
          <p:spPr>
            <a:xfrm>
              <a:off x="3228795" y="2517775"/>
              <a:ext cx="100012" cy="100012"/>
            </a:xfrm>
            <a:prstGeom prst="ellipse">
              <a:avLst/>
            </a:prstGeom>
            <a:solidFill>
              <a:srgbClr val="FFFF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85" name="椭圆 484"/>
            <p:cNvSpPr/>
            <p:nvPr/>
          </p:nvSpPr>
          <p:spPr>
            <a:xfrm>
              <a:off x="3314304" y="2290540"/>
              <a:ext cx="100012" cy="100012"/>
            </a:xfrm>
            <a:prstGeom prst="ellipse">
              <a:avLst/>
            </a:prstGeom>
            <a:solidFill>
              <a:srgbClr val="FFFF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86" name="椭圆 485"/>
            <p:cNvSpPr/>
            <p:nvPr/>
          </p:nvSpPr>
          <p:spPr>
            <a:xfrm>
              <a:off x="3412650" y="2065735"/>
              <a:ext cx="100012" cy="100012"/>
            </a:xfrm>
            <a:prstGeom prst="ellipse">
              <a:avLst/>
            </a:prstGeom>
            <a:solidFill>
              <a:srgbClr val="FFFF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87" name="椭圆 486"/>
            <p:cNvSpPr/>
            <p:nvPr/>
          </p:nvSpPr>
          <p:spPr>
            <a:xfrm>
              <a:off x="3553831" y="1855789"/>
              <a:ext cx="100013" cy="100013"/>
            </a:xfrm>
            <a:prstGeom prst="ellipse">
              <a:avLst/>
            </a:prstGeom>
            <a:solidFill>
              <a:srgbClr val="FFFF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88" name="椭圆 487"/>
            <p:cNvSpPr/>
            <p:nvPr/>
          </p:nvSpPr>
          <p:spPr>
            <a:xfrm>
              <a:off x="3697500" y="1645048"/>
              <a:ext cx="100013" cy="100013"/>
            </a:xfrm>
            <a:prstGeom prst="ellipse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89" name="椭圆 488"/>
            <p:cNvSpPr/>
            <p:nvPr/>
          </p:nvSpPr>
          <p:spPr>
            <a:xfrm>
              <a:off x="3871006" y="1463698"/>
              <a:ext cx="100013" cy="100013"/>
            </a:xfrm>
            <a:prstGeom prst="ellipse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90" name="椭圆 489"/>
            <p:cNvSpPr/>
            <p:nvPr/>
          </p:nvSpPr>
          <p:spPr>
            <a:xfrm>
              <a:off x="4019551" y="1302730"/>
              <a:ext cx="100013" cy="100013"/>
            </a:xfrm>
            <a:prstGeom prst="ellipse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91" name="椭圆 490"/>
            <p:cNvSpPr/>
            <p:nvPr/>
          </p:nvSpPr>
          <p:spPr>
            <a:xfrm>
              <a:off x="4189999" y="1135742"/>
              <a:ext cx="100013" cy="100013"/>
            </a:xfrm>
            <a:prstGeom prst="ellipse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92" name="椭圆 491"/>
            <p:cNvSpPr/>
            <p:nvPr/>
          </p:nvSpPr>
          <p:spPr>
            <a:xfrm>
              <a:off x="4389483" y="987060"/>
              <a:ext cx="100013" cy="100013"/>
            </a:xfrm>
            <a:prstGeom prst="ellipse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93" name="椭圆 492"/>
            <p:cNvSpPr/>
            <p:nvPr/>
          </p:nvSpPr>
          <p:spPr>
            <a:xfrm>
              <a:off x="4614887" y="860395"/>
              <a:ext cx="100013" cy="100013"/>
            </a:xfrm>
            <a:prstGeom prst="ellipse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94" name="椭圆 493"/>
            <p:cNvSpPr/>
            <p:nvPr/>
          </p:nvSpPr>
          <p:spPr>
            <a:xfrm>
              <a:off x="4811194" y="729086"/>
              <a:ext cx="100013" cy="100013"/>
            </a:xfrm>
            <a:prstGeom prst="ellipse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95" name="椭圆 494"/>
            <p:cNvSpPr/>
            <p:nvPr/>
          </p:nvSpPr>
          <p:spPr>
            <a:xfrm>
              <a:off x="5028049" y="661988"/>
              <a:ext cx="100013" cy="100013"/>
            </a:xfrm>
            <a:prstGeom prst="ellipse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cxnSp>
        <p:nvCxnSpPr>
          <p:cNvPr id="4" name="直接连接符 3">
            <a:extLst>
              <a:ext uri="{FF2B5EF4-FFF2-40B4-BE49-F238E27FC236}">
                <a16:creationId xmlns:a16="http://schemas.microsoft.com/office/drawing/2014/main" id="{00D4F713-217E-4D3F-BEC7-F6CA0936C963}"/>
              </a:ext>
            </a:extLst>
          </p:cNvPr>
          <p:cNvCxnSpPr/>
          <p:nvPr/>
        </p:nvCxnSpPr>
        <p:spPr>
          <a:xfrm>
            <a:off x="2507468" y="6131157"/>
            <a:ext cx="63132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48" name="直接连接符 447">
            <a:extLst>
              <a:ext uri="{FF2B5EF4-FFF2-40B4-BE49-F238E27FC236}">
                <a16:creationId xmlns:a16="http://schemas.microsoft.com/office/drawing/2014/main" id="{F0087856-203A-49FF-8C45-E6BE50C85637}"/>
              </a:ext>
            </a:extLst>
          </p:cNvPr>
          <p:cNvCxnSpPr/>
          <p:nvPr/>
        </p:nvCxnSpPr>
        <p:spPr>
          <a:xfrm>
            <a:off x="4418873" y="6134469"/>
            <a:ext cx="631321" cy="0"/>
          </a:xfrm>
          <a:prstGeom prst="line">
            <a:avLst/>
          </a:prstGeom>
          <a:ln>
            <a:solidFill>
              <a:srgbClr val="0070C0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" name="文本框 4">
            <a:extLst>
              <a:ext uri="{FF2B5EF4-FFF2-40B4-BE49-F238E27FC236}">
                <a16:creationId xmlns:a16="http://schemas.microsoft.com/office/drawing/2014/main" id="{6AF5D65F-90AA-467C-87C8-20AA4F8F2DBF}"/>
              </a:ext>
            </a:extLst>
          </p:cNvPr>
          <p:cNvSpPr txBox="1"/>
          <p:nvPr/>
        </p:nvSpPr>
        <p:spPr>
          <a:xfrm>
            <a:off x="3147310" y="5979407"/>
            <a:ext cx="11391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ype A alleles 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9" name="文本框 448">
            <a:extLst>
              <a:ext uri="{FF2B5EF4-FFF2-40B4-BE49-F238E27FC236}">
                <a16:creationId xmlns:a16="http://schemas.microsoft.com/office/drawing/2014/main" id="{90D29C49-5EBC-42F6-B544-B0FA85662D2D}"/>
              </a:ext>
            </a:extLst>
          </p:cNvPr>
          <p:cNvSpPr txBox="1"/>
          <p:nvPr/>
        </p:nvSpPr>
        <p:spPr>
          <a:xfrm>
            <a:off x="5043340" y="5992657"/>
            <a:ext cx="15143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ype B and C alleles 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1" name="椭圆 460">
            <a:extLst>
              <a:ext uri="{FF2B5EF4-FFF2-40B4-BE49-F238E27FC236}">
                <a16:creationId xmlns:a16="http://schemas.microsoft.com/office/drawing/2014/main" id="{387A9E92-9835-400A-964E-8157CDFEF724}"/>
              </a:ext>
            </a:extLst>
          </p:cNvPr>
          <p:cNvSpPr/>
          <p:nvPr/>
        </p:nvSpPr>
        <p:spPr>
          <a:xfrm>
            <a:off x="2502954" y="6614210"/>
            <a:ext cx="83382" cy="83382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899C1F88-8B12-4BC1-BD12-FB385CC16529}"/>
              </a:ext>
            </a:extLst>
          </p:cNvPr>
          <p:cNvSpPr txBox="1"/>
          <p:nvPr/>
        </p:nvSpPr>
        <p:spPr>
          <a:xfrm>
            <a:off x="2588564" y="6500127"/>
            <a:ext cx="29713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rmplasms accumulate FRs except hybrids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6" name="椭圆 495">
            <a:extLst>
              <a:ext uri="{FF2B5EF4-FFF2-40B4-BE49-F238E27FC236}">
                <a16:creationId xmlns:a16="http://schemas.microsoft.com/office/drawing/2014/main" id="{6865B8B3-9A54-42CB-BF6B-AEDC3D078134}"/>
              </a:ext>
            </a:extLst>
          </p:cNvPr>
          <p:cNvSpPr/>
          <p:nvPr/>
        </p:nvSpPr>
        <p:spPr>
          <a:xfrm>
            <a:off x="5326654" y="6340110"/>
            <a:ext cx="83382" cy="83382"/>
          </a:xfrm>
          <a:prstGeom prst="ellipse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97" name="文本框 496">
            <a:extLst>
              <a:ext uri="{FF2B5EF4-FFF2-40B4-BE49-F238E27FC236}">
                <a16:creationId xmlns:a16="http://schemas.microsoft.com/office/drawing/2014/main" id="{C9A9079B-A8E0-4CB5-9B96-8FB07091CA94}"/>
              </a:ext>
            </a:extLst>
          </p:cNvPr>
          <p:cNvSpPr txBox="1"/>
          <p:nvPr/>
        </p:nvSpPr>
        <p:spPr>
          <a:xfrm>
            <a:off x="5502898" y="6246554"/>
            <a:ext cx="15143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ybrids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8" name="椭圆 497">
            <a:extLst>
              <a:ext uri="{FF2B5EF4-FFF2-40B4-BE49-F238E27FC236}">
                <a16:creationId xmlns:a16="http://schemas.microsoft.com/office/drawing/2014/main" id="{D6E4EBC0-B9F4-4FE9-B3A7-C87A96A0AA1B}"/>
              </a:ext>
            </a:extLst>
          </p:cNvPr>
          <p:cNvSpPr/>
          <p:nvPr/>
        </p:nvSpPr>
        <p:spPr>
          <a:xfrm>
            <a:off x="2502954" y="6340110"/>
            <a:ext cx="83382" cy="83382"/>
          </a:xfrm>
          <a:prstGeom prst="ellipse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99" name="文本框 498">
            <a:extLst>
              <a:ext uri="{FF2B5EF4-FFF2-40B4-BE49-F238E27FC236}">
                <a16:creationId xmlns:a16="http://schemas.microsoft.com/office/drawing/2014/main" id="{D7724682-A3C2-4914-8D44-7821DC397A18}"/>
              </a:ext>
            </a:extLst>
          </p:cNvPr>
          <p:cNvSpPr txBox="1"/>
          <p:nvPr/>
        </p:nvSpPr>
        <p:spPr>
          <a:xfrm>
            <a:off x="2579304" y="6249544"/>
            <a:ext cx="27440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rmplasms can not accumulate FRs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71</TotalTime>
  <Words>321</Words>
  <Application>Microsoft Office PowerPoint</Application>
  <PresentationFormat>宽屏</PresentationFormat>
  <Paragraphs>97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李 古</dc:creator>
  <cp:lastModifiedBy>李 古</cp:lastModifiedBy>
  <cp:revision>10</cp:revision>
  <dcterms:created xsi:type="dcterms:W3CDTF">2021-03-05T00:52:00Z</dcterms:created>
  <dcterms:modified xsi:type="dcterms:W3CDTF">2021-03-08T09:50:0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192</vt:lpwstr>
  </property>
</Properties>
</file>